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sldIdLst>
    <p:sldId id="347" r:id="rId2"/>
    <p:sldId id="346" r:id="rId3"/>
    <p:sldId id="328" r:id="rId4"/>
    <p:sldId id="342" r:id="rId5"/>
    <p:sldId id="343" r:id="rId6"/>
    <p:sldId id="329" r:id="rId7"/>
    <p:sldId id="330" r:id="rId8"/>
    <p:sldId id="344" r:id="rId9"/>
    <p:sldId id="331" r:id="rId10"/>
    <p:sldId id="349" r:id="rId11"/>
    <p:sldId id="333" r:id="rId12"/>
    <p:sldId id="332" r:id="rId13"/>
  </p:sldIdLst>
  <p:sldSz cx="7442200" cy="9740900"/>
  <p:notesSz cx="6985000" cy="92837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68" userDrawn="1">
          <p15:clr>
            <a:srgbClr val="A4A3A4"/>
          </p15:clr>
        </p15:guide>
        <p15:guide id="2" pos="234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B2B2B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9C9EDDB-5878-4E39-9C7D-77FA9AFFA3E5}" v="39" dt="2023-09-27T14:50:26.18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663" autoAdjust="0"/>
    <p:restoredTop sz="84005" autoAdjust="0"/>
  </p:normalViewPr>
  <p:slideViewPr>
    <p:cSldViewPr>
      <p:cViewPr>
        <p:scale>
          <a:sx n="70" d="100"/>
          <a:sy n="70" d="100"/>
        </p:scale>
        <p:origin x="2838" y="90"/>
      </p:cViewPr>
      <p:guideLst>
        <p:guide orient="horz" pos="3068"/>
        <p:guide pos="234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20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umar, Vinod" userId="a0710a6e-bffc-4971-8893-1c23addeb5b0" providerId="ADAL" clId="{922FE477-A091-45D2-9AFE-0801C4DD56C7}"/>
    <pc:docChg chg="undo redo custSel addSld delSld modSld sldOrd modMainMaster modNotesMaster">
      <pc:chgData name="Kumar, Vinod" userId="a0710a6e-bffc-4971-8893-1c23addeb5b0" providerId="ADAL" clId="{922FE477-A091-45D2-9AFE-0801C4DD56C7}" dt="2022-09-26T21:16:38.143" v="4346" actId="164"/>
      <pc:docMkLst>
        <pc:docMk/>
      </pc:docMkLst>
      <pc:sldChg chg="addSp delSp modSp mod">
        <pc:chgData name="Kumar, Vinod" userId="a0710a6e-bffc-4971-8893-1c23addeb5b0" providerId="ADAL" clId="{922FE477-A091-45D2-9AFE-0801C4DD56C7}" dt="2022-09-26T20:48:04.358" v="3890" actId="478"/>
        <pc:sldMkLst>
          <pc:docMk/>
          <pc:sldMk cId="2581851823" sldId="270"/>
        </pc:sldMkLst>
        <pc:spChg chg="del mod">
          <ac:chgData name="Kumar, Vinod" userId="a0710a6e-bffc-4971-8893-1c23addeb5b0" providerId="ADAL" clId="{922FE477-A091-45D2-9AFE-0801C4DD56C7}" dt="2022-09-20T19:02:13.604" v="938" actId="478"/>
          <ac:spMkLst>
            <pc:docMk/>
            <pc:sldMk cId="2581851823" sldId="270"/>
            <ac:spMk id="6" creationId="{00000000-0000-0000-0000-000000000000}"/>
          </ac:spMkLst>
        </pc:spChg>
        <pc:spChg chg="del mod">
          <ac:chgData name="Kumar, Vinod" userId="a0710a6e-bffc-4971-8893-1c23addeb5b0" providerId="ADAL" clId="{922FE477-A091-45D2-9AFE-0801C4DD56C7}" dt="2022-09-20T19:02:27.879" v="939" actId="478"/>
          <ac:spMkLst>
            <pc:docMk/>
            <pc:sldMk cId="2581851823" sldId="270"/>
            <ac:spMk id="7" creationId="{00000000-0000-0000-0000-000000000000}"/>
          </ac:spMkLst>
        </pc:spChg>
        <pc:spChg chg="del mod">
          <ac:chgData name="Kumar, Vinod" userId="a0710a6e-bffc-4971-8893-1c23addeb5b0" providerId="ADAL" clId="{922FE477-A091-45D2-9AFE-0801C4DD56C7}" dt="2022-09-20T19:02:13.604" v="938" actId="478"/>
          <ac:spMkLst>
            <pc:docMk/>
            <pc:sldMk cId="2581851823" sldId="270"/>
            <ac:spMk id="8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9:01:52.567" v="935" actId="20577"/>
          <ac:spMkLst>
            <pc:docMk/>
            <pc:sldMk cId="2581851823" sldId="270"/>
            <ac:spMk id="9" creationId="{00000000-0000-0000-0000-000000000000}"/>
          </ac:spMkLst>
        </pc:spChg>
        <pc:spChg chg="del mod">
          <ac:chgData name="Kumar, Vinod" userId="a0710a6e-bffc-4971-8893-1c23addeb5b0" providerId="ADAL" clId="{922FE477-A091-45D2-9AFE-0801C4DD56C7}" dt="2022-09-20T19:02:13.604" v="938" actId="478"/>
          <ac:spMkLst>
            <pc:docMk/>
            <pc:sldMk cId="2581851823" sldId="270"/>
            <ac:spMk id="15" creationId="{00000000-0000-0000-0000-000000000000}"/>
          </ac:spMkLst>
        </pc:spChg>
        <pc:spChg chg="add del mod">
          <ac:chgData name="Kumar, Vinod" userId="a0710a6e-bffc-4971-8893-1c23addeb5b0" providerId="ADAL" clId="{922FE477-A091-45D2-9AFE-0801C4DD56C7}" dt="2022-09-26T20:48:04.358" v="3890" actId="478"/>
          <ac:spMkLst>
            <pc:docMk/>
            <pc:sldMk cId="2581851823" sldId="270"/>
            <ac:spMk id="15" creationId="{EFB804DE-BDB0-64DD-8F44-1766BDC8051E}"/>
          </ac:spMkLst>
        </pc:spChg>
        <pc:spChg chg="del mod">
          <ac:chgData name="Kumar, Vinod" userId="a0710a6e-bffc-4971-8893-1c23addeb5b0" providerId="ADAL" clId="{922FE477-A091-45D2-9AFE-0801C4DD56C7}" dt="2022-09-20T19:02:13.604" v="938" actId="478"/>
          <ac:spMkLst>
            <pc:docMk/>
            <pc:sldMk cId="2581851823" sldId="270"/>
            <ac:spMk id="17" creationId="{00000000-0000-0000-0000-000000000000}"/>
          </ac:spMkLst>
        </pc:spChg>
        <pc:spChg chg="del mod">
          <ac:chgData name="Kumar, Vinod" userId="a0710a6e-bffc-4971-8893-1c23addeb5b0" providerId="ADAL" clId="{922FE477-A091-45D2-9AFE-0801C4DD56C7}" dt="2022-09-20T19:02:09.255" v="937" actId="478"/>
          <ac:spMkLst>
            <pc:docMk/>
            <pc:sldMk cId="2581851823" sldId="270"/>
            <ac:spMk id="18" creationId="{00000000-0000-0000-0000-000000000000}"/>
          </ac:spMkLst>
        </pc:spChg>
        <pc:spChg chg="del mod">
          <ac:chgData name="Kumar, Vinod" userId="a0710a6e-bffc-4971-8893-1c23addeb5b0" providerId="ADAL" clId="{922FE477-A091-45D2-9AFE-0801C4DD56C7}" dt="2022-09-20T19:02:13.604" v="938" actId="478"/>
          <ac:spMkLst>
            <pc:docMk/>
            <pc:sldMk cId="2581851823" sldId="270"/>
            <ac:spMk id="19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9:14:05.703" v="949"/>
          <ac:spMkLst>
            <pc:docMk/>
            <pc:sldMk cId="2581851823" sldId="270"/>
            <ac:spMk id="29" creationId="{C718B0E5-C6BF-AADE-84FF-0A6CFD5846E9}"/>
          </ac:spMkLst>
        </pc:spChg>
        <pc:spChg chg="mod">
          <ac:chgData name="Kumar, Vinod" userId="a0710a6e-bffc-4971-8893-1c23addeb5b0" providerId="ADAL" clId="{922FE477-A091-45D2-9AFE-0801C4DD56C7}" dt="2022-09-20T19:14:05.703" v="949"/>
          <ac:spMkLst>
            <pc:docMk/>
            <pc:sldMk cId="2581851823" sldId="270"/>
            <ac:spMk id="30" creationId="{60DB274C-B320-8945-C3EC-AAC7A9D1DB87}"/>
          </ac:spMkLst>
        </pc:spChg>
        <pc:spChg chg="mod">
          <ac:chgData name="Kumar, Vinod" userId="a0710a6e-bffc-4971-8893-1c23addeb5b0" providerId="ADAL" clId="{922FE477-A091-45D2-9AFE-0801C4DD56C7}" dt="2022-09-20T19:14:05.703" v="949"/>
          <ac:spMkLst>
            <pc:docMk/>
            <pc:sldMk cId="2581851823" sldId="270"/>
            <ac:spMk id="31" creationId="{D4936BDA-CEBC-1A20-B470-97C57EBC9211}"/>
          </ac:spMkLst>
        </pc:spChg>
        <pc:spChg chg="mod">
          <ac:chgData name="Kumar, Vinod" userId="a0710a6e-bffc-4971-8893-1c23addeb5b0" providerId="ADAL" clId="{922FE477-A091-45D2-9AFE-0801C4DD56C7}" dt="2022-09-20T19:14:05.703" v="949"/>
          <ac:spMkLst>
            <pc:docMk/>
            <pc:sldMk cId="2581851823" sldId="270"/>
            <ac:spMk id="33" creationId="{687A6A2D-FF94-D8CA-AB2B-10B414765729}"/>
          </ac:spMkLst>
        </pc:spChg>
        <pc:spChg chg="mod">
          <ac:chgData name="Kumar, Vinod" userId="a0710a6e-bffc-4971-8893-1c23addeb5b0" providerId="ADAL" clId="{922FE477-A091-45D2-9AFE-0801C4DD56C7}" dt="2022-09-20T19:14:05.703" v="949"/>
          <ac:spMkLst>
            <pc:docMk/>
            <pc:sldMk cId="2581851823" sldId="270"/>
            <ac:spMk id="36" creationId="{E1764945-A4C4-7B57-C142-F9EABE13FF97}"/>
          </ac:spMkLst>
        </pc:spChg>
        <pc:spChg chg="mod">
          <ac:chgData name="Kumar, Vinod" userId="a0710a6e-bffc-4971-8893-1c23addeb5b0" providerId="ADAL" clId="{922FE477-A091-45D2-9AFE-0801C4DD56C7}" dt="2022-09-20T19:14:05.703" v="949"/>
          <ac:spMkLst>
            <pc:docMk/>
            <pc:sldMk cId="2581851823" sldId="270"/>
            <ac:spMk id="38" creationId="{384BDDA6-90DE-779C-159A-F0566AED2FB8}"/>
          </ac:spMkLst>
        </pc:spChg>
        <pc:spChg chg="mod">
          <ac:chgData name="Kumar, Vinod" userId="a0710a6e-bffc-4971-8893-1c23addeb5b0" providerId="ADAL" clId="{922FE477-A091-45D2-9AFE-0801C4DD56C7}" dt="2022-09-20T19:14:05.703" v="949"/>
          <ac:spMkLst>
            <pc:docMk/>
            <pc:sldMk cId="2581851823" sldId="270"/>
            <ac:spMk id="39" creationId="{FE6F7F2D-A301-C2FD-4D0D-3179C194FBA6}"/>
          </ac:spMkLst>
        </pc:spChg>
        <pc:spChg chg="add mod">
          <ac:chgData name="Kumar, Vinod" userId="a0710a6e-bffc-4971-8893-1c23addeb5b0" providerId="ADAL" clId="{922FE477-A091-45D2-9AFE-0801C4DD56C7}" dt="2022-09-20T19:21:29.423" v="1152" actId="1037"/>
          <ac:spMkLst>
            <pc:docMk/>
            <pc:sldMk cId="2581851823" sldId="270"/>
            <ac:spMk id="40" creationId="{02877FFF-08CA-43DF-5844-4C20B3E3B98D}"/>
          </ac:spMkLst>
        </pc:spChg>
        <pc:spChg chg="add mod">
          <ac:chgData name="Kumar, Vinod" userId="a0710a6e-bffc-4971-8893-1c23addeb5b0" providerId="ADAL" clId="{922FE477-A091-45D2-9AFE-0801C4DD56C7}" dt="2022-09-26T20:47:40.381" v="3887" actId="1076"/>
          <ac:spMkLst>
            <pc:docMk/>
            <pc:sldMk cId="2581851823" sldId="270"/>
            <ac:spMk id="41" creationId="{075AF166-3D87-EC13-A4B3-8DE412562D74}"/>
          </ac:spMkLst>
        </pc:spChg>
        <pc:spChg chg="add mod">
          <ac:chgData name="Kumar, Vinod" userId="a0710a6e-bffc-4971-8893-1c23addeb5b0" providerId="ADAL" clId="{922FE477-A091-45D2-9AFE-0801C4DD56C7}" dt="2022-09-20T19:21:56.348" v="1159" actId="1076"/>
          <ac:spMkLst>
            <pc:docMk/>
            <pc:sldMk cId="2581851823" sldId="270"/>
            <ac:spMk id="42" creationId="{16DC128D-7391-9104-D36F-94A5E4919D28}"/>
          </ac:spMkLst>
        </pc:spChg>
        <pc:spChg chg="add mod">
          <ac:chgData name="Kumar, Vinod" userId="a0710a6e-bffc-4971-8893-1c23addeb5b0" providerId="ADAL" clId="{922FE477-A091-45D2-9AFE-0801C4DD56C7}" dt="2022-09-20T19:22:03.284" v="1160" actId="1076"/>
          <ac:spMkLst>
            <pc:docMk/>
            <pc:sldMk cId="2581851823" sldId="270"/>
            <ac:spMk id="43" creationId="{EFA3BA5F-8A3A-CB47-50F3-1A1EE0BF7CAB}"/>
          </ac:spMkLst>
        </pc:spChg>
        <pc:spChg chg="add mod">
          <ac:chgData name="Kumar, Vinod" userId="a0710a6e-bffc-4971-8893-1c23addeb5b0" providerId="ADAL" clId="{922FE477-A091-45D2-9AFE-0801C4DD56C7}" dt="2022-09-20T19:22:11.108" v="1161" actId="1076"/>
          <ac:spMkLst>
            <pc:docMk/>
            <pc:sldMk cId="2581851823" sldId="270"/>
            <ac:spMk id="44" creationId="{635FF346-A88B-92A6-1B45-E8D4AA8BE5F4}"/>
          </ac:spMkLst>
        </pc:spChg>
        <pc:spChg chg="add mod">
          <ac:chgData name="Kumar, Vinod" userId="a0710a6e-bffc-4971-8893-1c23addeb5b0" providerId="ADAL" clId="{922FE477-A091-45D2-9AFE-0801C4DD56C7}" dt="2022-09-21T14:07:43.928" v="1619" actId="20577"/>
          <ac:spMkLst>
            <pc:docMk/>
            <pc:sldMk cId="2581851823" sldId="270"/>
            <ac:spMk id="45" creationId="{90C79A45-3774-DF57-E47E-FDF4D887691A}"/>
          </ac:spMkLst>
        </pc:spChg>
        <pc:grpChg chg="add del mod">
          <ac:chgData name="Kumar, Vinod" userId="a0710a6e-bffc-4971-8893-1c23addeb5b0" providerId="ADAL" clId="{922FE477-A091-45D2-9AFE-0801C4DD56C7}" dt="2022-09-20T19:16:14.224" v="1049" actId="478"/>
          <ac:grpSpMkLst>
            <pc:docMk/>
            <pc:sldMk cId="2581851823" sldId="270"/>
            <ac:grpSpMk id="26" creationId="{A83B940B-E188-40EE-6D87-34335CD9B771}"/>
          </ac:grpSpMkLst>
        </pc:grpChg>
        <pc:graphicFrameChg chg="del mod">
          <ac:chgData name="Kumar, Vinod" userId="a0710a6e-bffc-4971-8893-1c23addeb5b0" providerId="ADAL" clId="{922FE477-A091-45D2-9AFE-0801C4DD56C7}" dt="2022-09-20T19:02:13.604" v="938" actId="478"/>
          <ac:graphicFrameMkLst>
            <pc:docMk/>
            <pc:sldMk cId="2581851823" sldId="270"/>
            <ac:graphicFrameMk id="12" creationId="{00000000-0000-0000-0000-000000000000}"/>
          </ac:graphicFrameMkLst>
        </pc:graphicFrameChg>
        <pc:graphicFrameChg chg="del mod">
          <ac:chgData name="Kumar, Vinod" userId="a0710a6e-bffc-4971-8893-1c23addeb5b0" providerId="ADAL" clId="{922FE477-A091-45D2-9AFE-0801C4DD56C7}" dt="2022-09-20T19:02:13.604" v="938" actId="478"/>
          <ac:graphicFrameMkLst>
            <pc:docMk/>
            <pc:sldMk cId="2581851823" sldId="270"/>
            <ac:graphicFrameMk id="14" creationId="{00000000-0000-0000-0000-000000000000}"/>
          </ac:graphicFrameMkLst>
        </pc:graphicFrameChg>
        <pc:graphicFrameChg chg="del mod">
          <ac:chgData name="Kumar, Vinod" userId="a0710a6e-bffc-4971-8893-1c23addeb5b0" providerId="ADAL" clId="{922FE477-A091-45D2-9AFE-0801C4DD56C7}" dt="2022-09-20T19:02:13.604" v="938" actId="478"/>
          <ac:graphicFrameMkLst>
            <pc:docMk/>
            <pc:sldMk cId="2581851823" sldId="270"/>
            <ac:graphicFrameMk id="16" creationId="{00000000-0000-0000-0000-000000000000}"/>
          </ac:graphicFrameMkLst>
        </pc:graphicFrameChg>
        <pc:graphicFrameChg chg="del mod">
          <ac:chgData name="Kumar, Vinod" userId="a0710a6e-bffc-4971-8893-1c23addeb5b0" providerId="ADAL" clId="{922FE477-A091-45D2-9AFE-0801C4DD56C7}" dt="2022-09-20T19:02:13.604" v="938" actId="478"/>
          <ac:graphicFrameMkLst>
            <pc:docMk/>
            <pc:sldMk cId="2581851823" sldId="270"/>
            <ac:graphicFrameMk id="25" creationId="{00000000-0000-0000-0000-000000000000}"/>
          </ac:graphicFrameMkLst>
        </pc:graphicFrameChg>
        <pc:picChg chg="add mod">
          <ac:chgData name="Kumar, Vinod" userId="a0710a6e-bffc-4971-8893-1c23addeb5b0" providerId="ADAL" clId="{922FE477-A091-45D2-9AFE-0801C4DD56C7}" dt="2022-09-20T19:48:13.968" v="1165" actId="1038"/>
          <ac:picMkLst>
            <pc:docMk/>
            <pc:sldMk cId="2581851823" sldId="270"/>
            <ac:picMk id="2" creationId="{1C40B368-7271-944F-5A0D-482A6E631169}"/>
          </ac:picMkLst>
        </pc:picChg>
        <pc:picChg chg="del mod">
          <ac:chgData name="Kumar, Vinod" userId="a0710a6e-bffc-4971-8893-1c23addeb5b0" providerId="ADAL" clId="{922FE477-A091-45D2-9AFE-0801C4DD56C7}" dt="2022-09-26T20:39:27.474" v="3841" actId="478"/>
          <ac:picMkLst>
            <pc:docMk/>
            <pc:sldMk cId="2581851823" sldId="270"/>
            <ac:picMk id="3" creationId="{16B1C24B-B1BB-1CF4-39B0-C965CB9B38D7}"/>
          </ac:picMkLst>
        </pc:picChg>
        <pc:picChg chg="del mod modCrop">
          <ac:chgData name="Kumar, Vinod" userId="a0710a6e-bffc-4971-8893-1c23addeb5b0" providerId="ADAL" clId="{922FE477-A091-45D2-9AFE-0801C4DD56C7}" dt="2022-09-26T20:47:54.614" v="3889" actId="478"/>
          <ac:picMkLst>
            <pc:docMk/>
            <pc:sldMk cId="2581851823" sldId="270"/>
            <ac:picMk id="4" creationId="{9B1CA19B-C58A-D78B-7C03-249EC8008CED}"/>
          </ac:picMkLst>
        </pc:picChg>
        <pc:picChg chg="add mod">
          <ac:chgData name="Kumar, Vinod" userId="a0710a6e-bffc-4971-8893-1c23addeb5b0" providerId="ADAL" clId="{922FE477-A091-45D2-9AFE-0801C4DD56C7}" dt="2022-09-26T20:47:25.477" v="3885" actId="1038"/>
          <ac:picMkLst>
            <pc:docMk/>
            <pc:sldMk cId="2581851823" sldId="270"/>
            <ac:picMk id="18" creationId="{94C80812-73CD-8D57-BA74-A51FD8C186C5}"/>
          </ac:picMkLst>
        </pc:picChg>
        <pc:picChg chg="add mod">
          <ac:chgData name="Kumar, Vinod" userId="a0710a6e-bffc-4971-8893-1c23addeb5b0" providerId="ADAL" clId="{922FE477-A091-45D2-9AFE-0801C4DD56C7}" dt="2022-09-26T20:47:33.790" v="3886" actId="1076"/>
          <ac:picMkLst>
            <pc:docMk/>
            <pc:sldMk cId="2581851823" sldId="270"/>
            <ac:picMk id="19" creationId="{D1526D6C-E2F5-D0AB-478D-4DAB790FC397}"/>
          </ac:picMkLst>
        </pc:picChg>
        <pc:picChg chg="add del mod">
          <ac:chgData name="Kumar, Vinod" userId="a0710a6e-bffc-4971-8893-1c23addeb5b0" providerId="ADAL" clId="{922FE477-A091-45D2-9AFE-0801C4DD56C7}" dt="2022-09-26T20:46:34.423" v="3853" actId="478"/>
          <ac:picMkLst>
            <pc:docMk/>
            <pc:sldMk cId="2581851823" sldId="270"/>
            <ac:picMk id="20" creationId="{F2EFC9FD-ED2A-D2FB-873E-B3E5527C7CAB}"/>
          </ac:picMkLst>
        </pc:picChg>
        <pc:picChg chg="add del mod">
          <ac:chgData name="Kumar, Vinod" userId="a0710a6e-bffc-4971-8893-1c23addeb5b0" providerId="ADAL" clId="{922FE477-A091-45D2-9AFE-0801C4DD56C7}" dt="2022-09-26T20:47:52.821" v="3888" actId="478"/>
          <ac:picMkLst>
            <pc:docMk/>
            <pc:sldMk cId="2581851823" sldId="270"/>
            <ac:picMk id="21" creationId="{B86E27B3-3C36-0384-4C9D-5C7CB1DF6FED}"/>
          </ac:picMkLst>
        </pc:picChg>
        <pc:picChg chg="add mod">
          <ac:chgData name="Kumar, Vinod" userId="a0710a6e-bffc-4971-8893-1c23addeb5b0" providerId="ADAL" clId="{922FE477-A091-45D2-9AFE-0801C4DD56C7}" dt="2022-09-20T19:19:44.222" v="1118" actId="1036"/>
          <ac:picMkLst>
            <pc:docMk/>
            <pc:sldMk cId="2581851823" sldId="270"/>
            <ac:picMk id="22" creationId="{33076018-5466-8581-6A2B-27627BC26283}"/>
          </ac:picMkLst>
        </pc:picChg>
        <pc:picChg chg="add mod">
          <ac:chgData name="Kumar, Vinod" userId="a0710a6e-bffc-4971-8893-1c23addeb5b0" providerId="ADAL" clId="{922FE477-A091-45D2-9AFE-0801C4DD56C7}" dt="2022-09-20T19:19:34.462" v="1107" actId="1036"/>
          <ac:picMkLst>
            <pc:docMk/>
            <pc:sldMk cId="2581851823" sldId="270"/>
            <ac:picMk id="23" creationId="{1D89F4DD-9BA8-FED4-BCA3-72E107254170}"/>
          </ac:picMkLst>
        </pc:picChg>
        <pc:picChg chg="add mod">
          <ac:chgData name="Kumar, Vinod" userId="a0710a6e-bffc-4971-8893-1c23addeb5b0" providerId="ADAL" clId="{922FE477-A091-45D2-9AFE-0801C4DD56C7}" dt="2022-09-20T19:18:37.094" v="1090" actId="1076"/>
          <ac:picMkLst>
            <pc:docMk/>
            <pc:sldMk cId="2581851823" sldId="270"/>
            <ac:picMk id="24" creationId="{5C19F2A6-0BA0-4F6B-2F78-0857983C2355}"/>
          </ac:picMkLst>
        </pc:picChg>
        <pc:picChg chg="mod">
          <ac:chgData name="Kumar, Vinod" userId="a0710a6e-bffc-4971-8893-1c23addeb5b0" providerId="ADAL" clId="{922FE477-A091-45D2-9AFE-0801C4DD56C7}" dt="2022-09-20T19:14:05.703" v="949"/>
          <ac:picMkLst>
            <pc:docMk/>
            <pc:sldMk cId="2581851823" sldId="270"/>
            <ac:picMk id="27" creationId="{0EA379B3-3DFA-4652-2417-A9F2C9CD98C8}"/>
          </ac:picMkLst>
        </pc:picChg>
        <pc:picChg chg="mod">
          <ac:chgData name="Kumar, Vinod" userId="a0710a6e-bffc-4971-8893-1c23addeb5b0" providerId="ADAL" clId="{922FE477-A091-45D2-9AFE-0801C4DD56C7}" dt="2022-09-20T19:14:05.703" v="949"/>
          <ac:picMkLst>
            <pc:docMk/>
            <pc:sldMk cId="2581851823" sldId="270"/>
            <ac:picMk id="28" creationId="{A3E59CF4-4096-917B-3428-2C704EE879EF}"/>
          </ac:picMkLst>
        </pc:picChg>
        <pc:picChg chg="mod">
          <ac:chgData name="Kumar, Vinod" userId="a0710a6e-bffc-4971-8893-1c23addeb5b0" providerId="ADAL" clId="{922FE477-A091-45D2-9AFE-0801C4DD56C7}" dt="2022-09-20T19:14:05.703" v="949"/>
          <ac:picMkLst>
            <pc:docMk/>
            <pc:sldMk cId="2581851823" sldId="270"/>
            <ac:picMk id="34" creationId="{DECEB4A3-718F-0181-4BC2-562A81929D9C}"/>
          </ac:picMkLst>
        </pc:picChg>
        <pc:picChg chg="mod">
          <ac:chgData name="Kumar, Vinod" userId="a0710a6e-bffc-4971-8893-1c23addeb5b0" providerId="ADAL" clId="{922FE477-A091-45D2-9AFE-0801C4DD56C7}" dt="2022-09-20T19:14:05.703" v="949"/>
          <ac:picMkLst>
            <pc:docMk/>
            <pc:sldMk cId="2581851823" sldId="270"/>
            <ac:picMk id="35" creationId="{F64B1A4F-0A4E-9DF5-5B0F-951A123AAE5A}"/>
          </ac:picMkLst>
        </pc:picChg>
        <pc:cxnChg chg="mod">
          <ac:chgData name="Kumar, Vinod" userId="a0710a6e-bffc-4971-8893-1c23addeb5b0" providerId="ADAL" clId="{922FE477-A091-45D2-9AFE-0801C4DD56C7}" dt="2022-09-20T19:14:05.703" v="949"/>
          <ac:cxnSpMkLst>
            <pc:docMk/>
            <pc:sldMk cId="2581851823" sldId="270"/>
            <ac:cxnSpMk id="32" creationId="{477CCDC0-1121-E65B-3FB7-0E71D8FEDC5E}"/>
          </ac:cxnSpMkLst>
        </pc:cxnChg>
        <pc:cxnChg chg="mod">
          <ac:chgData name="Kumar, Vinod" userId="a0710a6e-bffc-4971-8893-1c23addeb5b0" providerId="ADAL" clId="{922FE477-A091-45D2-9AFE-0801C4DD56C7}" dt="2022-09-20T19:14:05.703" v="949"/>
          <ac:cxnSpMkLst>
            <pc:docMk/>
            <pc:sldMk cId="2581851823" sldId="270"/>
            <ac:cxnSpMk id="37" creationId="{4378744B-7B1A-184A-BC08-6C17A0C87D97}"/>
          </ac:cxnSpMkLst>
        </pc:cxnChg>
      </pc:sldChg>
      <pc:sldChg chg="modSp del">
        <pc:chgData name="Kumar, Vinod" userId="a0710a6e-bffc-4971-8893-1c23addeb5b0" providerId="ADAL" clId="{922FE477-A091-45D2-9AFE-0801C4DD56C7}" dt="2022-09-22T15:58:07.939" v="2996" actId="47"/>
        <pc:sldMkLst>
          <pc:docMk/>
          <pc:sldMk cId="3312893227" sldId="271"/>
        </pc:sldMkLst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3312893227" sldId="271"/>
            <ac:spMk id="6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3312893227" sldId="271"/>
            <ac:spMk id="7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3312893227" sldId="271"/>
            <ac:spMk id="9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3312893227" sldId="271"/>
            <ac:spMk id="11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3312893227" sldId="271"/>
            <ac:spMk id="17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3312893227" sldId="271"/>
            <ac:spMk id="47" creationId="{00000000-0000-0000-0000-000000000000}"/>
          </ac:spMkLst>
        </pc:spChg>
        <pc:graphicFrameChg chg="mod">
          <ac:chgData name="Kumar, Vinod" userId="a0710a6e-bffc-4971-8893-1c23addeb5b0" providerId="ADAL" clId="{922FE477-A091-45D2-9AFE-0801C4DD56C7}" dt="2022-09-20T18:45:52.930" v="326"/>
          <ac:graphicFrameMkLst>
            <pc:docMk/>
            <pc:sldMk cId="3312893227" sldId="271"/>
            <ac:graphicFrameMk id="8" creationId="{00000000-0000-0000-0000-000000000000}"/>
          </ac:graphicFrameMkLst>
        </pc:graphicFrameChg>
        <pc:graphicFrameChg chg="mod">
          <ac:chgData name="Kumar, Vinod" userId="a0710a6e-bffc-4971-8893-1c23addeb5b0" providerId="ADAL" clId="{922FE477-A091-45D2-9AFE-0801C4DD56C7}" dt="2022-09-20T18:45:52.930" v="326"/>
          <ac:graphicFrameMkLst>
            <pc:docMk/>
            <pc:sldMk cId="3312893227" sldId="271"/>
            <ac:graphicFrameMk id="10" creationId="{00000000-0000-0000-0000-000000000000}"/>
          </ac:graphicFrameMkLst>
        </pc:graphicFrameChg>
        <pc:graphicFrameChg chg="mod">
          <ac:chgData name="Kumar, Vinod" userId="a0710a6e-bffc-4971-8893-1c23addeb5b0" providerId="ADAL" clId="{922FE477-A091-45D2-9AFE-0801C4DD56C7}" dt="2022-09-20T18:45:52.930" v="326"/>
          <ac:graphicFrameMkLst>
            <pc:docMk/>
            <pc:sldMk cId="3312893227" sldId="271"/>
            <ac:graphicFrameMk id="36" creationId="{00000000-0000-0000-0000-000000000000}"/>
          </ac:graphicFrameMkLst>
        </pc:graphicFrame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3312893227" sldId="271"/>
            <ac:picMk id="5" creationId="{00000000-0000-0000-0000-000000000000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3312893227" sldId="271"/>
            <ac:picMk id="37" creationId="{00000000-0000-0000-0000-000000000000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3312893227" sldId="271"/>
            <ac:picMk id="46" creationId="{00000000-0000-0000-0000-000000000000}"/>
          </ac:picMkLst>
        </pc:picChg>
        <pc:cxnChg chg="mod">
          <ac:chgData name="Kumar, Vinod" userId="a0710a6e-bffc-4971-8893-1c23addeb5b0" providerId="ADAL" clId="{922FE477-A091-45D2-9AFE-0801C4DD56C7}" dt="2022-09-20T18:45:52.930" v="326"/>
          <ac:cxnSpMkLst>
            <pc:docMk/>
            <pc:sldMk cId="3312893227" sldId="271"/>
            <ac:cxnSpMk id="3" creationId="{00000000-0000-0000-0000-000000000000}"/>
          </ac:cxnSpMkLst>
        </pc:cxnChg>
        <pc:cxnChg chg="mod">
          <ac:chgData name="Kumar, Vinod" userId="a0710a6e-bffc-4971-8893-1c23addeb5b0" providerId="ADAL" clId="{922FE477-A091-45D2-9AFE-0801C4DD56C7}" dt="2022-09-20T18:45:52.930" v="326"/>
          <ac:cxnSpMkLst>
            <pc:docMk/>
            <pc:sldMk cId="3312893227" sldId="271"/>
            <ac:cxnSpMk id="14" creationId="{00000000-0000-0000-0000-000000000000}"/>
          </ac:cxnSpMkLst>
        </pc:cxnChg>
      </pc:sldChg>
      <pc:sldChg chg="modSp del modNotes">
        <pc:chgData name="Kumar, Vinod" userId="a0710a6e-bffc-4971-8893-1c23addeb5b0" providerId="ADAL" clId="{922FE477-A091-45D2-9AFE-0801C4DD56C7}" dt="2022-09-22T15:58:13.318" v="2998" actId="47"/>
        <pc:sldMkLst>
          <pc:docMk/>
          <pc:sldMk cId="936297639" sldId="275"/>
        </pc:sldMkLst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936297639" sldId="275"/>
            <ac:spMk id="3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936297639" sldId="275"/>
            <ac:spMk id="4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936297639" sldId="275"/>
            <ac:spMk id="6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936297639" sldId="275"/>
            <ac:spMk id="7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936297639" sldId="275"/>
            <ac:spMk id="9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936297639" sldId="275"/>
            <ac:spMk id="15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936297639" sldId="275"/>
            <ac:spMk id="22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936297639" sldId="275"/>
            <ac:spMk id="38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936297639" sldId="275"/>
            <ac:spMk id="41" creationId="{00000000-0000-0000-0000-000000000000}"/>
          </ac:spMkLst>
        </pc:spChg>
        <pc:graphicFrameChg chg="mod">
          <ac:chgData name="Kumar, Vinod" userId="a0710a6e-bffc-4971-8893-1c23addeb5b0" providerId="ADAL" clId="{922FE477-A091-45D2-9AFE-0801C4DD56C7}" dt="2022-09-20T18:45:52.930" v="326"/>
          <ac:graphicFrameMkLst>
            <pc:docMk/>
            <pc:sldMk cId="936297639" sldId="275"/>
            <ac:graphicFrameMk id="2" creationId="{00000000-0000-0000-0000-000000000000}"/>
          </ac:graphicFrameMkLst>
        </pc:graphicFrameChg>
        <pc:graphicFrameChg chg="mod">
          <ac:chgData name="Kumar, Vinod" userId="a0710a6e-bffc-4971-8893-1c23addeb5b0" providerId="ADAL" clId="{922FE477-A091-45D2-9AFE-0801C4DD56C7}" dt="2022-09-20T18:45:52.930" v="326"/>
          <ac:graphicFrameMkLst>
            <pc:docMk/>
            <pc:sldMk cId="936297639" sldId="275"/>
            <ac:graphicFrameMk id="8" creationId="{00000000-0000-0000-0000-000000000000}"/>
          </ac:graphicFrameMkLst>
        </pc:graphicFrameChg>
        <pc:graphicFrameChg chg="mod">
          <ac:chgData name="Kumar, Vinod" userId="a0710a6e-bffc-4971-8893-1c23addeb5b0" providerId="ADAL" clId="{922FE477-A091-45D2-9AFE-0801C4DD56C7}" dt="2022-09-20T18:45:52.930" v="326"/>
          <ac:graphicFrameMkLst>
            <pc:docMk/>
            <pc:sldMk cId="936297639" sldId="275"/>
            <ac:graphicFrameMk id="10" creationId="{00000000-0000-0000-0000-000000000000}"/>
          </ac:graphicFrameMkLst>
        </pc:graphicFrameChg>
        <pc:graphicFrameChg chg="mod">
          <ac:chgData name="Kumar, Vinod" userId="a0710a6e-bffc-4971-8893-1c23addeb5b0" providerId="ADAL" clId="{922FE477-A091-45D2-9AFE-0801C4DD56C7}" dt="2022-09-20T18:45:52.930" v="326"/>
          <ac:graphicFrameMkLst>
            <pc:docMk/>
            <pc:sldMk cId="936297639" sldId="275"/>
            <ac:graphicFrameMk id="11" creationId="{00000000-0000-0000-0000-000000000000}"/>
          </ac:graphicFrameMkLst>
        </pc:graphicFrameChg>
        <pc:graphicFrameChg chg="mod">
          <ac:chgData name="Kumar, Vinod" userId="a0710a6e-bffc-4971-8893-1c23addeb5b0" providerId="ADAL" clId="{922FE477-A091-45D2-9AFE-0801C4DD56C7}" dt="2022-09-20T18:45:52.930" v="326"/>
          <ac:graphicFrameMkLst>
            <pc:docMk/>
            <pc:sldMk cId="936297639" sldId="275"/>
            <ac:graphicFrameMk id="40" creationId="{00000000-0000-0000-0000-000000000000}"/>
          </ac:graphicFrameMkLst>
        </pc:graphicFrame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936297639" sldId="275"/>
            <ac:picMk id="12" creationId="{00000000-0000-0000-0000-000000000000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936297639" sldId="275"/>
            <ac:picMk id="13" creationId="{00000000-0000-0000-0000-000000000000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936297639" sldId="275"/>
            <ac:picMk id="17" creationId="{00000000-0000-0000-0000-000000000000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936297639" sldId="275"/>
            <ac:picMk id="39" creationId="{00000000-0000-0000-0000-000000000000}"/>
          </ac:picMkLst>
        </pc:picChg>
      </pc:sldChg>
      <pc:sldChg chg="modSp del mod">
        <pc:chgData name="Kumar, Vinod" userId="a0710a6e-bffc-4971-8893-1c23addeb5b0" providerId="ADAL" clId="{922FE477-A091-45D2-9AFE-0801C4DD56C7}" dt="2022-09-20T18:34:43.357" v="8" actId="47"/>
        <pc:sldMkLst>
          <pc:docMk/>
          <pc:sldMk cId="548236368" sldId="280"/>
        </pc:sldMkLst>
        <pc:spChg chg="mod">
          <ac:chgData name="Kumar, Vinod" userId="a0710a6e-bffc-4971-8893-1c23addeb5b0" providerId="ADAL" clId="{922FE477-A091-45D2-9AFE-0801C4DD56C7}" dt="2022-09-20T18:32:54.249" v="5" actId="255"/>
          <ac:spMkLst>
            <pc:docMk/>
            <pc:sldMk cId="548236368" sldId="280"/>
            <ac:spMk id="3" creationId="{00000000-0000-0000-0000-000000000000}"/>
          </ac:spMkLst>
        </pc:spChg>
        <pc:graphicFrameChg chg="mod">
          <ac:chgData name="Kumar, Vinod" userId="a0710a6e-bffc-4971-8893-1c23addeb5b0" providerId="ADAL" clId="{922FE477-A091-45D2-9AFE-0801C4DD56C7}" dt="2022-09-20T18:30:51.008" v="1"/>
          <ac:graphicFrameMkLst>
            <pc:docMk/>
            <pc:sldMk cId="548236368" sldId="280"/>
            <ac:graphicFrameMk id="8" creationId="{00000000-0000-0000-0000-000000000000}"/>
          </ac:graphicFrameMkLst>
        </pc:graphicFrameChg>
      </pc:sldChg>
      <pc:sldChg chg="modSp del">
        <pc:chgData name="Kumar, Vinod" userId="a0710a6e-bffc-4971-8893-1c23addeb5b0" providerId="ADAL" clId="{922FE477-A091-45D2-9AFE-0801C4DD56C7}" dt="2022-09-22T15:58:16.032" v="3000" actId="47"/>
        <pc:sldMkLst>
          <pc:docMk/>
          <pc:sldMk cId="4035968979" sldId="288"/>
        </pc:sldMkLst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5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10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48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52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53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57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59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61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62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66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67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68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70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72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73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74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76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77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78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80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82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83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84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85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87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91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92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100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101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102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103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104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105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106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107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108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111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112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113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114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115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116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117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118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035968979" sldId="288"/>
            <ac:spMk id="119" creationId="{00000000-0000-0000-0000-000000000000}"/>
          </ac:spMkLst>
        </pc:spChg>
        <pc:grpChg chg="mod">
          <ac:chgData name="Kumar, Vinod" userId="a0710a6e-bffc-4971-8893-1c23addeb5b0" providerId="ADAL" clId="{922FE477-A091-45D2-9AFE-0801C4DD56C7}" dt="2022-09-20T18:45:52.930" v="326"/>
          <ac:grpSpMkLst>
            <pc:docMk/>
            <pc:sldMk cId="4035968979" sldId="288"/>
            <ac:grpSpMk id="3" creationId="{00000000-0000-0000-0000-000000000000}"/>
          </ac:grpSpMkLst>
        </pc:grpChg>
        <pc:grpChg chg="mod">
          <ac:chgData name="Kumar, Vinod" userId="a0710a6e-bffc-4971-8893-1c23addeb5b0" providerId="ADAL" clId="{922FE477-A091-45D2-9AFE-0801C4DD56C7}" dt="2022-09-20T18:45:52.930" v="326"/>
          <ac:grpSpMkLst>
            <pc:docMk/>
            <pc:sldMk cId="4035968979" sldId="288"/>
            <ac:grpSpMk id="8" creationId="{00000000-0000-0000-0000-000000000000}"/>
          </ac:grpSpMkLst>
        </pc:grpChg>
        <pc:grpChg chg="mod">
          <ac:chgData name="Kumar, Vinod" userId="a0710a6e-bffc-4971-8893-1c23addeb5b0" providerId="ADAL" clId="{922FE477-A091-45D2-9AFE-0801C4DD56C7}" dt="2022-09-20T18:45:52.930" v="326"/>
          <ac:grpSpMkLst>
            <pc:docMk/>
            <pc:sldMk cId="4035968979" sldId="288"/>
            <ac:grpSpMk id="9" creationId="{00000000-0000-0000-0000-000000000000}"/>
          </ac:grpSpMkLst>
        </pc:grpChg>
        <pc:grpChg chg="mod">
          <ac:chgData name="Kumar, Vinod" userId="a0710a6e-bffc-4971-8893-1c23addeb5b0" providerId="ADAL" clId="{922FE477-A091-45D2-9AFE-0801C4DD56C7}" dt="2022-09-20T18:45:52.930" v="326"/>
          <ac:grpSpMkLst>
            <pc:docMk/>
            <pc:sldMk cId="4035968979" sldId="288"/>
            <ac:grpSpMk id="46" creationId="{00000000-0000-0000-0000-000000000000}"/>
          </ac:grpSpMkLst>
        </pc:grpChg>
        <pc:grpChg chg="mod">
          <ac:chgData name="Kumar, Vinod" userId="a0710a6e-bffc-4971-8893-1c23addeb5b0" providerId="ADAL" clId="{922FE477-A091-45D2-9AFE-0801C4DD56C7}" dt="2022-09-20T18:45:52.930" v="326"/>
          <ac:grpSpMkLst>
            <pc:docMk/>
            <pc:sldMk cId="4035968979" sldId="288"/>
            <ac:grpSpMk id="47" creationId="{00000000-0000-0000-0000-000000000000}"/>
          </ac:grpSpMkLst>
        </pc:grpChg>
        <pc:grpChg chg="mod">
          <ac:chgData name="Kumar, Vinod" userId="a0710a6e-bffc-4971-8893-1c23addeb5b0" providerId="ADAL" clId="{922FE477-A091-45D2-9AFE-0801C4DD56C7}" dt="2022-09-20T18:45:52.930" v="326"/>
          <ac:grpSpMkLst>
            <pc:docMk/>
            <pc:sldMk cId="4035968979" sldId="288"/>
            <ac:grpSpMk id="49" creationId="{00000000-0000-0000-0000-000000000000}"/>
          </ac:grpSpMkLst>
        </pc:grpChg>
        <pc:grpChg chg="mod">
          <ac:chgData name="Kumar, Vinod" userId="a0710a6e-bffc-4971-8893-1c23addeb5b0" providerId="ADAL" clId="{922FE477-A091-45D2-9AFE-0801C4DD56C7}" dt="2022-09-20T18:45:52.930" v="326"/>
          <ac:grpSpMkLst>
            <pc:docMk/>
            <pc:sldMk cId="4035968979" sldId="288"/>
            <ac:grpSpMk id="50" creationId="{00000000-0000-0000-0000-000000000000}"/>
          </ac:grpSpMkLst>
        </pc:grpChg>
        <pc:grpChg chg="mod">
          <ac:chgData name="Kumar, Vinod" userId="a0710a6e-bffc-4971-8893-1c23addeb5b0" providerId="ADAL" clId="{922FE477-A091-45D2-9AFE-0801C4DD56C7}" dt="2022-09-20T18:45:52.930" v="326"/>
          <ac:grpSpMkLst>
            <pc:docMk/>
            <pc:sldMk cId="4035968979" sldId="288"/>
            <ac:grpSpMk id="51" creationId="{00000000-0000-0000-0000-000000000000}"/>
          </ac:grpSpMkLst>
        </pc:grpChg>
        <pc:grpChg chg="mod">
          <ac:chgData name="Kumar, Vinod" userId="a0710a6e-bffc-4971-8893-1c23addeb5b0" providerId="ADAL" clId="{922FE477-A091-45D2-9AFE-0801C4DD56C7}" dt="2022-09-20T18:45:52.930" v="326"/>
          <ac:grpSpMkLst>
            <pc:docMk/>
            <pc:sldMk cId="4035968979" sldId="288"/>
            <ac:grpSpMk id="54" creationId="{00000000-0000-0000-0000-000000000000}"/>
          </ac:grpSpMkLst>
        </pc:grpChg>
        <pc:grpChg chg="mod">
          <ac:chgData name="Kumar, Vinod" userId="a0710a6e-bffc-4971-8893-1c23addeb5b0" providerId="ADAL" clId="{922FE477-A091-45D2-9AFE-0801C4DD56C7}" dt="2022-09-20T18:45:52.930" v="326"/>
          <ac:grpSpMkLst>
            <pc:docMk/>
            <pc:sldMk cId="4035968979" sldId="288"/>
            <ac:grpSpMk id="55" creationId="{00000000-0000-0000-0000-000000000000}"/>
          </ac:grpSpMkLst>
        </pc:grpChg>
        <pc:grpChg chg="mod">
          <ac:chgData name="Kumar, Vinod" userId="a0710a6e-bffc-4971-8893-1c23addeb5b0" providerId="ADAL" clId="{922FE477-A091-45D2-9AFE-0801C4DD56C7}" dt="2022-09-20T18:45:52.930" v="326"/>
          <ac:grpSpMkLst>
            <pc:docMk/>
            <pc:sldMk cId="4035968979" sldId="288"/>
            <ac:grpSpMk id="63" creationId="{00000000-0000-0000-0000-000000000000}"/>
          </ac:grpSpMkLst>
        </pc:grpChg>
        <pc:grpChg chg="mod">
          <ac:chgData name="Kumar, Vinod" userId="a0710a6e-bffc-4971-8893-1c23addeb5b0" providerId="ADAL" clId="{922FE477-A091-45D2-9AFE-0801C4DD56C7}" dt="2022-09-20T18:45:52.930" v="326"/>
          <ac:grpSpMkLst>
            <pc:docMk/>
            <pc:sldMk cId="4035968979" sldId="288"/>
            <ac:grpSpMk id="64" creationId="{00000000-0000-0000-0000-000000000000}"/>
          </ac:grpSpMkLst>
        </pc:grpChg>
        <pc:grpChg chg="mod">
          <ac:chgData name="Kumar, Vinod" userId="a0710a6e-bffc-4971-8893-1c23addeb5b0" providerId="ADAL" clId="{922FE477-A091-45D2-9AFE-0801C4DD56C7}" dt="2022-09-20T18:45:52.930" v="326"/>
          <ac:grpSpMkLst>
            <pc:docMk/>
            <pc:sldMk cId="4035968979" sldId="288"/>
            <ac:grpSpMk id="75" creationId="{00000000-0000-0000-0000-000000000000}"/>
          </ac:grpSpMkLst>
        </pc:grpChg>
        <pc:grpChg chg="mod">
          <ac:chgData name="Kumar, Vinod" userId="a0710a6e-bffc-4971-8893-1c23addeb5b0" providerId="ADAL" clId="{922FE477-A091-45D2-9AFE-0801C4DD56C7}" dt="2022-09-20T18:45:52.930" v="326"/>
          <ac:grpSpMkLst>
            <pc:docMk/>
            <pc:sldMk cId="4035968979" sldId="288"/>
            <ac:grpSpMk id="79" creationId="{00000000-0000-0000-0000-000000000000}"/>
          </ac:grpSpMkLst>
        </pc:grpChg>
        <pc:grpChg chg="mod">
          <ac:chgData name="Kumar, Vinod" userId="a0710a6e-bffc-4971-8893-1c23addeb5b0" providerId="ADAL" clId="{922FE477-A091-45D2-9AFE-0801C4DD56C7}" dt="2022-09-20T18:45:52.930" v="326"/>
          <ac:grpSpMkLst>
            <pc:docMk/>
            <pc:sldMk cId="4035968979" sldId="288"/>
            <ac:grpSpMk id="81" creationId="{00000000-0000-0000-0000-000000000000}"/>
          </ac:grpSpMkLst>
        </pc:grp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4035968979" sldId="288"/>
            <ac:picMk id="4" creationId="{00000000-0000-0000-0000-000000000000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4035968979" sldId="288"/>
            <ac:picMk id="56" creationId="{00000000-0000-0000-0000-000000000000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4035968979" sldId="288"/>
            <ac:picMk id="58" creationId="{00000000-0000-0000-0000-000000000000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4035968979" sldId="288"/>
            <ac:picMk id="60" creationId="{00000000-0000-0000-0000-000000000000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4035968979" sldId="288"/>
            <ac:picMk id="65" creationId="{00000000-0000-0000-0000-000000000000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4035968979" sldId="288"/>
            <ac:picMk id="69" creationId="{00000000-0000-0000-0000-000000000000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4035968979" sldId="288"/>
            <ac:picMk id="71" creationId="{00000000-0000-0000-0000-000000000000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4035968979" sldId="288"/>
            <ac:picMk id="86" creationId="{00000000-0000-0000-0000-000000000000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4035968979" sldId="288"/>
            <ac:picMk id="88" creationId="{00000000-0000-0000-0000-000000000000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4035968979" sldId="288"/>
            <ac:picMk id="89" creationId="{00000000-0000-0000-0000-000000000000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4035968979" sldId="288"/>
            <ac:picMk id="90" creationId="{00000000-0000-0000-0000-000000000000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4035968979" sldId="288"/>
            <ac:picMk id="93" creationId="{00000000-0000-0000-0000-000000000000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4035968979" sldId="288"/>
            <ac:picMk id="94" creationId="{00000000-0000-0000-0000-000000000000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4035968979" sldId="288"/>
            <ac:picMk id="95" creationId="{00000000-0000-0000-0000-000000000000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4035968979" sldId="288"/>
            <ac:picMk id="96" creationId="{00000000-0000-0000-0000-000000000000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4035968979" sldId="288"/>
            <ac:picMk id="97" creationId="{00000000-0000-0000-0000-000000000000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4035968979" sldId="288"/>
            <ac:picMk id="98" creationId="{00000000-0000-0000-0000-000000000000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4035968979" sldId="288"/>
            <ac:picMk id="99" creationId="{00000000-0000-0000-0000-000000000000}"/>
          </ac:picMkLst>
        </pc:picChg>
      </pc:sldChg>
      <pc:sldChg chg="modSp del">
        <pc:chgData name="Kumar, Vinod" userId="a0710a6e-bffc-4971-8893-1c23addeb5b0" providerId="ADAL" clId="{922FE477-A091-45D2-9AFE-0801C4DD56C7}" dt="2022-09-22T15:58:16.642" v="3001" actId="47"/>
        <pc:sldMkLst>
          <pc:docMk/>
          <pc:sldMk cId="4182192784" sldId="290"/>
        </pc:sldMkLst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182192784" sldId="290"/>
            <ac:spMk id="8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182192784" sldId="290"/>
            <ac:spMk id="9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182192784" sldId="290"/>
            <ac:spMk id="10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182192784" sldId="290"/>
            <ac:spMk id="11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4182192784" sldId="290"/>
            <ac:spMk id="12" creationId="{00000000-0000-0000-0000-000000000000}"/>
          </ac:spMkLst>
        </pc:sp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4182192784" sldId="290"/>
            <ac:picMk id="2" creationId="{00000000-0000-0000-0000-000000000000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4182192784" sldId="290"/>
            <ac:picMk id="69" creationId="{00000000-0000-0000-0000-000000000000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4182192784" sldId="290"/>
            <ac:picMk id="70" creationId="{00000000-0000-0000-0000-000000000000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4182192784" sldId="290"/>
            <ac:picMk id="71" creationId="{00000000-0000-0000-0000-000000000000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4182192784" sldId="290"/>
            <ac:picMk id="72" creationId="{00000000-0000-0000-0000-000000000000}"/>
          </ac:picMkLst>
        </pc:picChg>
      </pc:sldChg>
      <pc:sldChg chg="modSp del">
        <pc:chgData name="Kumar, Vinod" userId="a0710a6e-bffc-4971-8893-1c23addeb5b0" providerId="ADAL" clId="{922FE477-A091-45D2-9AFE-0801C4DD56C7}" dt="2022-09-22T15:58:18.640" v="3002" actId="47"/>
        <pc:sldMkLst>
          <pc:docMk/>
          <pc:sldMk cId="3055867424" sldId="291"/>
        </pc:sldMkLst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3055867424" sldId="291"/>
            <ac:spMk id="2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3055867424" sldId="291"/>
            <ac:spMk id="7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3055867424" sldId="291"/>
            <ac:spMk id="8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3055867424" sldId="291"/>
            <ac:spMk id="12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3055867424" sldId="291"/>
            <ac:spMk id="14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3055867424" sldId="291"/>
            <ac:spMk id="15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3055867424" sldId="291"/>
            <ac:spMk id="16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3055867424" sldId="291"/>
            <ac:spMk id="17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3055867424" sldId="291"/>
            <ac:spMk id="23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3055867424" sldId="291"/>
            <ac:spMk id="24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3055867424" sldId="291"/>
            <ac:spMk id="25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3055867424" sldId="291"/>
            <ac:spMk id="26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3055867424" sldId="291"/>
            <ac:spMk id="27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3055867424" sldId="291"/>
            <ac:spMk id="28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3055867424" sldId="291"/>
            <ac:spMk id="29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3055867424" sldId="291"/>
            <ac:spMk id="30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3055867424" sldId="291"/>
            <ac:spMk id="31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3055867424" sldId="291"/>
            <ac:spMk id="32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3055867424" sldId="291"/>
            <ac:spMk id="33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3055867424" sldId="291"/>
            <ac:spMk id="34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3055867424" sldId="291"/>
            <ac:spMk id="35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3055867424" sldId="291"/>
            <ac:spMk id="36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3055867424" sldId="291"/>
            <ac:spMk id="37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3055867424" sldId="291"/>
            <ac:spMk id="38" creationId="{00000000-0000-0000-0000-000000000000}"/>
          </ac:spMkLst>
        </pc:spChg>
        <pc:grpChg chg="mod">
          <ac:chgData name="Kumar, Vinod" userId="a0710a6e-bffc-4971-8893-1c23addeb5b0" providerId="ADAL" clId="{922FE477-A091-45D2-9AFE-0801C4DD56C7}" dt="2022-09-20T18:45:52.930" v="326"/>
          <ac:grpSpMkLst>
            <pc:docMk/>
            <pc:sldMk cId="3055867424" sldId="291"/>
            <ac:grpSpMk id="5" creationId="{00000000-0000-0000-0000-000000000000}"/>
          </ac:grpSpMkLst>
        </pc:grpChg>
        <pc:grpChg chg="mod">
          <ac:chgData name="Kumar, Vinod" userId="a0710a6e-bffc-4971-8893-1c23addeb5b0" providerId="ADAL" clId="{922FE477-A091-45D2-9AFE-0801C4DD56C7}" dt="2022-09-20T18:45:52.930" v="326"/>
          <ac:grpSpMkLst>
            <pc:docMk/>
            <pc:sldMk cId="3055867424" sldId="291"/>
            <ac:grpSpMk id="6" creationId="{00000000-0000-0000-0000-000000000000}"/>
          </ac:grpSpMkLst>
        </pc:grp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3055867424" sldId="291"/>
            <ac:picMk id="3" creationId="{00000000-0000-0000-0000-000000000000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3055867424" sldId="291"/>
            <ac:picMk id="4" creationId="{00000000-0000-0000-0000-000000000000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3055867424" sldId="291"/>
            <ac:picMk id="9" creationId="{00000000-0000-0000-0000-000000000000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3055867424" sldId="291"/>
            <ac:picMk id="10" creationId="{00000000-0000-0000-0000-000000000000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3055867424" sldId="291"/>
            <ac:picMk id="18" creationId="{00000000-0000-0000-0000-000000000000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3055867424" sldId="291"/>
            <ac:picMk id="21" creationId="{00000000-0000-0000-0000-000000000000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3055867424" sldId="291"/>
            <ac:picMk id="22" creationId="{00000000-0000-0000-0000-000000000000}"/>
          </ac:picMkLst>
        </pc:picChg>
      </pc:sldChg>
      <pc:sldChg chg="modSp del">
        <pc:chgData name="Kumar, Vinod" userId="a0710a6e-bffc-4971-8893-1c23addeb5b0" providerId="ADAL" clId="{922FE477-A091-45D2-9AFE-0801C4DD56C7}" dt="2022-09-22T15:58:10.839" v="2997" actId="47"/>
        <pc:sldMkLst>
          <pc:docMk/>
          <pc:sldMk cId="25506909" sldId="293"/>
        </pc:sldMkLst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25506909" sldId="293"/>
            <ac:spMk id="2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25506909" sldId="293"/>
            <ac:spMk id="5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25506909" sldId="293"/>
            <ac:spMk id="6" creationId="{00000000-0000-0000-0000-000000000000}"/>
          </ac:spMkLst>
        </pc:spChg>
        <pc:graphicFrameChg chg="mod">
          <ac:chgData name="Kumar, Vinod" userId="a0710a6e-bffc-4971-8893-1c23addeb5b0" providerId="ADAL" clId="{922FE477-A091-45D2-9AFE-0801C4DD56C7}" dt="2022-09-20T18:45:52.930" v="326"/>
          <ac:graphicFrameMkLst>
            <pc:docMk/>
            <pc:sldMk cId="25506909" sldId="293"/>
            <ac:graphicFrameMk id="4" creationId="{00000000-0000-0000-0000-000000000000}"/>
          </ac:graphicFrameMkLst>
        </pc:graphicFrameChg>
        <pc:graphicFrameChg chg="mod">
          <ac:chgData name="Kumar, Vinod" userId="a0710a6e-bffc-4971-8893-1c23addeb5b0" providerId="ADAL" clId="{922FE477-A091-45D2-9AFE-0801C4DD56C7}" dt="2022-09-20T18:45:52.930" v="326"/>
          <ac:graphicFrameMkLst>
            <pc:docMk/>
            <pc:sldMk cId="25506909" sldId="293"/>
            <ac:graphicFrameMk id="7" creationId="{00000000-0000-0000-0000-000000000000}"/>
          </ac:graphicFrameMkLst>
        </pc:graphicFrameChg>
        <pc:graphicFrameChg chg="mod">
          <ac:chgData name="Kumar, Vinod" userId="a0710a6e-bffc-4971-8893-1c23addeb5b0" providerId="ADAL" clId="{922FE477-A091-45D2-9AFE-0801C4DD56C7}" dt="2022-09-20T18:45:52.930" v="326"/>
          <ac:graphicFrameMkLst>
            <pc:docMk/>
            <pc:sldMk cId="25506909" sldId="293"/>
            <ac:graphicFrameMk id="8" creationId="{00000000-0000-0000-0000-000000000000}"/>
          </ac:graphicFrameMkLst>
        </pc:graphicFrameChg>
      </pc:sldChg>
      <pc:sldChg chg="addSp delSp modSp mod">
        <pc:chgData name="Kumar, Vinod" userId="a0710a6e-bffc-4971-8893-1c23addeb5b0" providerId="ADAL" clId="{922FE477-A091-45D2-9AFE-0801C4DD56C7}" dt="2022-09-26T21:08:38.066" v="4234" actId="1076"/>
        <pc:sldMkLst>
          <pc:docMk/>
          <pc:sldMk cId="51599060" sldId="294"/>
        </pc:sldMkLst>
        <pc:spChg chg="add del mod">
          <ac:chgData name="Kumar, Vinod" userId="a0710a6e-bffc-4971-8893-1c23addeb5b0" providerId="ADAL" clId="{922FE477-A091-45D2-9AFE-0801C4DD56C7}" dt="2022-09-21T14:13:34.404" v="1634" actId="478"/>
          <ac:spMkLst>
            <pc:docMk/>
            <pc:sldMk cId="51599060" sldId="294"/>
            <ac:spMk id="2" creationId="{00000000-0000-0000-0000-000000000000}"/>
          </ac:spMkLst>
        </pc:spChg>
        <pc:spChg chg="add del mod">
          <ac:chgData name="Kumar, Vinod" userId="a0710a6e-bffc-4971-8893-1c23addeb5b0" providerId="ADAL" clId="{922FE477-A091-45D2-9AFE-0801C4DD56C7}" dt="2022-09-21T14:13:34.404" v="1634" actId="478"/>
          <ac:spMkLst>
            <pc:docMk/>
            <pc:sldMk cId="51599060" sldId="294"/>
            <ac:spMk id="5" creationId="{00000000-0000-0000-0000-000000000000}"/>
          </ac:spMkLst>
        </pc:spChg>
        <pc:spChg chg="add mod">
          <ac:chgData name="Kumar, Vinod" userId="a0710a6e-bffc-4971-8893-1c23addeb5b0" providerId="ADAL" clId="{922FE477-A091-45D2-9AFE-0801C4DD56C7}" dt="2022-09-21T16:04:06.380" v="1670" actId="1036"/>
          <ac:spMkLst>
            <pc:docMk/>
            <pc:sldMk cId="51599060" sldId="294"/>
            <ac:spMk id="7" creationId="{C56CA07C-310B-7CB3-A9A5-D9A9ED7A54FF}"/>
          </ac:spMkLst>
        </pc:spChg>
        <pc:spChg chg="add del mod">
          <ac:chgData name="Kumar, Vinod" userId="a0710a6e-bffc-4971-8893-1c23addeb5b0" providerId="ADAL" clId="{922FE477-A091-45D2-9AFE-0801C4DD56C7}" dt="2022-09-21T14:13:34.404" v="1634" actId="478"/>
          <ac:spMkLst>
            <pc:docMk/>
            <pc:sldMk cId="51599060" sldId="294"/>
            <ac:spMk id="10" creationId="{00000000-0000-0000-0000-000000000000}"/>
          </ac:spMkLst>
        </pc:spChg>
        <pc:spChg chg="add mod">
          <ac:chgData name="Kumar, Vinod" userId="a0710a6e-bffc-4971-8893-1c23addeb5b0" providerId="ADAL" clId="{922FE477-A091-45D2-9AFE-0801C4DD56C7}" dt="2022-09-26T21:08:00.490" v="4222" actId="1035"/>
          <ac:spMkLst>
            <pc:docMk/>
            <pc:sldMk cId="51599060" sldId="294"/>
            <ac:spMk id="18" creationId="{398F8A0C-194E-FF4D-7289-8864350071D4}"/>
          </ac:spMkLst>
        </pc:spChg>
        <pc:spChg chg="add mod">
          <ac:chgData name="Kumar, Vinod" userId="a0710a6e-bffc-4971-8893-1c23addeb5b0" providerId="ADAL" clId="{922FE477-A091-45D2-9AFE-0801C4DD56C7}" dt="2022-09-26T21:08:13.930" v="4231" actId="1036"/>
          <ac:spMkLst>
            <pc:docMk/>
            <pc:sldMk cId="51599060" sldId="294"/>
            <ac:spMk id="19" creationId="{3A4EBC49-37F4-D869-0996-BE21DB0E7ABD}"/>
          </ac:spMkLst>
        </pc:spChg>
        <pc:spChg chg="add mod">
          <ac:chgData name="Kumar, Vinod" userId="a0710a6e-bffc-4971-8893-1c23addeb5b0" providerId="ADAL" clId="{922FE477-A091-45D2-9AFE-0801C4DD56C7}" dt="2022-09-26T21:06:17.449" v="3991" actId="1036"/>
          <ac:spMkLst>
            <pc:docMk/>
            <pc:sldMk cId="51599060" sldId="294"/>
            <ac:spMk id="20" creationId="{50EABD4C-5A9D-7A62-CF2E-6C0640B39C2F}"/>
          </ac:spMkLst>
        </pc:spChg>
        <pc:spChg chg="add mod">
          <ac:chgData name="Kumar, Vinod" userId="a0710a6e-bffc-4971-8893-1c23addeb5b0" providerId="ADAL" clId="{922FE477-A091-45D2-9AFE-0801C4DD56C7}" dt="2022-09-26T21:08:00.490" v="4222" actId="1035"/>
          <ac:spMkLst>
            <pc:docMk/>
            <pc:sldMk cId="51599060" sldId="294"/>
            <ac:spMk id="21" creationId="{BA17C6E1-9E7E-0426-0C8C-C1A35E1C7DC3}"/>
          </ac:spMkLst>
        </pc:spChg>
        <pc:spChg chg="add mod">
          <ac:chgData name="Kumar, Vinod" userId="a0710a6e-bffc-4971-8893-1c23addeb5b0" providerId="ADAL" clId="{922FE477-A091-45D2-9AFE-0801C4DD56C7}" dt="2022-09-26T21:08:13.930" v="4231" actId="1036"/>
          <ac:spMkLst>
            <pc:docMk/>
            <pc:sldMk cId="51599060" sldId="294"/>
            <ac:spMk id="22" creationId="{89C3B8BA-B97C-4483-7DDA-C04CF0B7D5BD}"/>
          </ac:spMkLst>
        </pc:spChg>
        <pc:spChg chg="add mod">
          <ac:chgData name="Kumar, Vinod" userId="a0710a6e-bffc-4971-8893-1c23addeb5b0" providerId="ADAL" clId="{922FE477-A091-45D2-9AFE-0801C4DD56C7}" dt="2022-09-26T21:06:17.449" v="3991" actId="1036"/>
          <ac:spMkLst>
            <pc:docMk/>
            <pc:sldMk cId="51599060" sldId="294"/>
            <ac:spMk id="23" creationId="{9E9FD58F-64C2-0A03-90AD-E94581A8B3C0}"/>
          </ac:spMkLst>
        </pc:spChg>
        <pc:spChg chg="add mod">
          <ac:chgData name="Kumar, Vinod" userId="a0710a6e-bffc-4971-8893-1c23addeb5b0" providerId="ADAL" clId="{922FE477-A091-45D2-9AFE-0801C4DD56C7}" dt="2022-09-26T21:08:00.490" v="4222" actId="1035"/>
          <ac:spMkLst>
            <pc:docMk/>
            <pc:sldMk cId="51599060" sldId="294"/>
            <ac:spMk id="24" creationId="{3CC663BE-9D93-F87F-7818-C877356A5B1C}"/>
          </ac:spMkLst>
        </pc:spChg>
        <pc:spChg chg="add mod">
          <ac:chgData name="Kumar, Vinod" userId="a0710a6e-bffc-4971-8893-1c23addeb5b0" providerId="ADAL" clId="{922FE477-A091-45D2-9AFE-0801C4DD56C7}" dt="2022-09-26T21:08:00.490" v="4222" actId="1035"/>
          <ac:spMkLst>
            <pc:docMk/>
            <pc:sldMk cId="51599060" sldId="294"/>
            <ac:spMk id="25" creationId="{EEA2DED9-D02B-BD07-2DDB-1844946C07FC}"/>
          </ac:spMkLst>
        </pc:spChg>
        <pc:spChg chg="add mod">
          <ac:chgData name="Kumar, Vinod" userId="a0710a6e-bffc-4971-8893-1c23addeb5b0" providerId="ADAL" clId="{922FE477-A091-45D2-9AFE-0801C4DD56C7}" dt="2022-09-26T21:08:13.930" v="4231" actId="1036"/>
          <ac:spMkLst>
            <pc:docMk/>
            <pc:sldMk cId="51599060" sldId="294"/>
            <ac:spMk id="26" creationId="{F5C4C9A3-0A8D-5EF8-010D-CF3030AE0D95}"/>
          </ac:spMkLst>
        </pc:spChg>
        <pc:spChg chg="add mod">
          <ac:chgData name="Kumar, Vinod" userId="a0710a6e-bffc-4971-8893-1c23addeb5b0" providerId="ADAL" clId="{922FE477-A091-45D2-9AFE-0801C4DD56C7}" dt="2022-09-26T21:08:13.930" v="4231" actId="1036"/>
          <ac:spMkLst>
            <pc:docMk/>
            <pc:sldMk cId="51599060" sldId="294"/>
            <ac:spMk id="27" creationId="{27B17A2C-6532-2CB3-D392-3208B9A65094}"/>
          </ac:spMkLst>
        </pc:spChg>
        <pc:spChg chg="add mod">
          <ac:chgData name="Kumar, Vinod" userId="a0710a6e-bffc-4971-8893-1c23addeb5b0" providerId="ADAL" clId="{922FE477-A091-45D2-9AFE-0801C4DD56C7}" dt="2022-09-26T21:06:17.449" v="3991" actId="1036"/>
          <ac:spMkLst>
            <pc:docMk/>
            <pc:sldMk cId="51599060" sldId="294"/>
            <ac:spMk id="28" creationId="{2A61F1F1-2458-F05A-D6AC-BFB7017688BA}"/>
          </ac:spMkLst>
        </pc:spChg>
        <pc:spChg chg="add mod">
          <ac:chgData name="Kumar, Vinod" userId="a0710a6e-bffc-4971-8893-1c23addeb5b0" providerId="ADAL" clId="{922FE477-A091-45D2-9AFE-0801C4DD56C7}" dt="2022-09-26T21:06:17.449" v="3991" actId="1036"/>
          <ac:spMkLst>
            <pc:docMk/>
            <pc:sldMk cId="51599060" sldId="294"/>
            <ac:spMk id="29" creationId="{760CD5E2-7907-5398-3CE4-410188CBFD00}"/>
          </ac:spMkLst>
        </pc:spChg>
        <pc:spChg chg="add del mod">
          <ac:chgData name="Kumar, Vinod" userId="a0710a6e-bffc-4971-8893-1c23addeb5b0" providerId="ADAL" clId="{922FE477-A091-45D2-9AFE-0801C4DD56C7}" dt="2022-09-22T16:02:39.892" v="3035" actId="478"/>
          <ac:spMkLst>
            <pc:docMk/>
            <pc:sldMk cId="51599060" sldId="294"/>
            <ac:spMk id="30" creationId="{71C76269-5A7B-598A-11AA-1D782A33B6C8}"/>
          </ac:spMkLst>
        </pc:spChg>
        <pc:spChg chg="add del mod">
          <ac:chgData name="Kumar, Vinod" userId="a0710a6e-bffc-4971-8893-1c23addeb5b0" providerId="ADAL" clId="{922FE477-A091-45D2-9AFE-0801C4DD56C7}" dt="2022-09-22T16:02:39.892" v="3035" actId="478"/>
          <ac:spMkLst>
            <pc:docMk/>
            <pc:sldMk cId="51599060" sldId="294"/>
            <ac:spMk id="31" creationId="{9BC8A89B-6F2E-CF64-FE68-EB0CB5F7DB57}"/>
          </ac:spMkLst>
        </pc:spChg>
        <pc:spChg chg="mod">
          <ac:chgData name="Kumar, Vinod" userId="a0710a6e-bffc-4971-8893-1c23addeb5b0" providerId="ADAL" clId="{922FE477-A091-45D2-9AFE-0801C4DD56C7}" dt="2022-09-21T21:20:27.703" v="2748"/>
          <ac:spMkLst>
            <pc:docMk/>
            <pc:sldMk cId="51599060" sldId="294"/>
            <ac:spMk id="33" creationId="{42DB8910-A875-75C8-0219-27FE2CBD5EC6}"/>
          </ac:spMkLst>
        </pc:spChg>
        <pc:spChg chg="mod">
          <ac:chgData name="Kumar, Vinod" userId="a0710a6e-bffc-4971-8893-1c23addeb5b0" providerId="ADAL" clId="{922FE477-A091-45D2-9AFE-0801C4DD56C7}" dt="2022-09-21T21:20:27.703" v="2748"/>
          <ac:spMkLst>
            <pc:docMk/>
            <pc:sldMk cId="51599060" sldId="294"/>
            <ac:spMk id="34" creationId="{227801AD-0060-90E6-BD29-2E123108183F}"/>
          </ac:spMkLst>
        </pc:spChg>
        <pc:spChg chg="mod">
          <ac:chgData name="Kumar, Vinod" userId="a0710a6e-bffc-4971-8893-1c23addeb5b0" providerId="ADAL" clId="{922FE477-A091-45D2-9AFE-0801C4DD56C7}" dt="2022-09-21T21:20:27.703" v="2748"/>
          <ac:spMkLst>
            <pc:docMk/>
            <pc:sldMk cId="51599060" sldId="294"/>
            <ac:spMk id="35" creationId="{54A9B91D-2D2D-5292-3FF3-C55370EB9D71}"/>
          </ac:spMkLst>
        </pc:spChg>
        <pc:spChg chg="mod">
          <ac:chgData name="Kumar, Vinod" userId="a0710a6e-bffc-4971-8893-1c23addeb5b0" providerId="ADAL" clId="{922FE477-A091-45D2-9AFE-0801C4DD56C7}" dt="2022-09-21T21:20:27.703" v="2748"/>
          <ac:spMkLst>
            <pc:docMk/>
            <pc:sldMk cId="51599060" sldId="294"/>
            <ac:spMk id="36" creationId="{30B84FDD-C00C-7256-97B7-7B3608E9D403}"/>
          </ac:spMkLst>
        </pc:spChg>
        <pc:spChg chg="mod">
          <ac:chgData name="Kumar, Vinod" userId="a0710a6e-bffc-4971-8893-1c23addeb5b0" providerId="ADAL" clId="{922FE477-A091-45D2-9AFE-0801C4DD56C7}" dt="2022-09-21T21:20:27.703" v="2748"/>
          <ac:spMkLst>
            <pc:docMk/>
            <pc:sldMk cId="51599060" sldId="294"/>
            <ac:spMk id="37" creationId="{FF245554-A3E8-35EC-3922-264A4620A8F7}"/>
          </ac:spMkLst>
        </pc:spChg>
        <pc:spChg chg="mod">
          <ac:chgData name="Kumar, Vinod" userId="a0710a6e-bffc-4971-8893-1c23addeb5b0" providerId="ADAL" clId="{922FE477-A091-45D2-9AFE-0801C4DD56C7}" dt="2022-09-21T21:20:27.703" v="2748"/>
          <ac:spMkLst>
            <pc:docMk/>
            <pc:sldMk cId="51599060" sldId="294"/>
            <ac:spMk id="40" creationId="{76FC2455-CBE3-A212-3C17-A69775C38DD7}"/>
          </ac:spMkLst>
        </pc:spChg>
        <pc:spChg chg="mod">
          <ac:chgData name="Kumar, Vinod" userId="a0710a6e-bffc-4971-8893-1c23addeb5b0" providerId="ADAL" clId="{922FE477-A091-45D2-9AFE-0801C4DD56C7}" dt="2022-09-21T21:20:27.703" v="2748"/>
          <ac:spMkLst>
            <pc:docMk/>
            <pc:sldMk cId="51599060" sldId="294"/>
            <ac:spMk id="41" creationId="{A4BBCBCC-BC96-817E-F374-F01E4FBF603B}"/>
          </ac:spMkLst>
        </pc:spChg>
        <pc:spChg chg="mod">
          <ac:chgData name="Kumar, Vinod" userId="a0710a6e-bffc-4971-8893-1c23addeb5b0" providerId="ADAL" clId="{922FE477-A091-45D2-9AFE-0801C4DD56C7}" dt="2022-09-21T21:20:27.703" v="2748"/>
          <ac:spMkLst>
            <pc:docMk/>
            <pc:sldMk cId="51599060" sldId="294"/>
            <ac:spMk id="44" creationId="{603EB7FD-FC62-0B84-8511-1EE1130CCECA}"/>
          </ac:spMkLst>
        </pc:spChg>
        <pc:grpChg chg="add del mod">
          <ac:chgData name="Kumar, Vinod" userId="a0710a6e-bffc-4971-8893-1c23addeb5b0" providerId="ADAL" clId="{922FE477-A091-45D2-9AFE-0801C4DD56C7}" dt="2022-09-21T21:20:49.121" v="2754" actId="478"/>
          <ac:grpSpMkLst>
            <pc:docMk/>
            <pc:sldMk cId="51599060" sldId="294"/>
            <ac:grpSpMk id="30" creationId="{84C458D4-844C-698E-9710-343D8B95A5CD}"/>
          </ac:grpSpMkLst>
        </pc:grpChg>
        <pc:grpChg chg="add del mod">
          <ac:chgData name="Kumar, Vinod" userId="a0710a6e-bffc-4971-8893-1c23addeb5b0" providerId="ADAL" clId="{922FE477-A091-45D2-9AFE-0801C4DD56C7}" dt="2022-09-21T21:20:49.121" v="2754" actId="478"/>
          <ac:grpSpMkLst>
            <pc:docMk/>
            <pc:sldMk cId="51599060" sldId="294"/>
            <ac:grpSpMk id="42" creationId="{771F32CF-7CE3-765E-EEA6-89F107032C48}"/>
          </ac:grpSpMkLst>
        </pc:grpChg>
        <pc:graphicFrameChg chg="add del mod">
          <ac:chgData name="Kumar, Vinod" userId="a0710a6e-bffc-4971-8893-1c23addeb5b0" providerId="ADAL" clId="{922FE477-A091-45D2-9AFE-0801C4DD56C7}" dt="2022-09-21T16:03:36.154" v="1648" actId="478"/>
          <ac:graphicFrameMkLst>
            <pc:docMk/>
            <pc:sldMk cId="51599060" sldId="294"/>
            <ac:graphicFrameMk id="6" creationId="{2A9CE5B1-CDD5-4A9A-26EB-1446C60454DA}"/>
          </ac:graphicFrameMkLst>
        </pc:graphicFrameChg>
        <pc:picChg chg="del mod">
          <ac:chgData name="Kumar, Vinod" userId="a0710a6e-bffc-4971-8893-1c23addeb5b0" providerId="ADAL" clId="{922FE477-A091-45D2-9AFE-0801C4DD56C7}" dt="2022-09-22T13:13:43.546" v="2756" actId="478"/>
          <ac:picMkLst>
            <pc:docMk/>
            <pc:sldMk cId="51599060" sldId="294"/>
            <ac:picMk id="2" creationId="{4734DE80-6695-F395-BC6D-E1FB5A200350}"/>
          </ac:picMkLst>
        </pc:picChg>
        <pc:picChg chg="mod">
          <ac:chgData name="Kumar, Vinod" userId="a0710a6e-bffc-4971-8893-1c23addeb5b0" providerId="ADAL" clId="{922FE477-A091-45D2-9AFE-0801C4DD56C7}" dt="2022-09-26T21:08:26.346" v="4233" actId="1035"/>
          <ac:picMkLst>
            <pc:docMk/>
            <pc:sldMk cId="51599060" sldId="294"/>
            <ac:picMk id="2" creationId="{89B759E7-C5D6-9DAE-715D-F0293F1F50DA}"/>
          </ac:picMkLst>
        </pc:picChg>
        <pc:picChg chg="mod">
          <ac:chgData name="Kumar, Vinod" userId="a0710a6e-bffc-4971-8893-1c23addeb5b0" providerId="ADAL" clId="{922FE477-A091-45D2-9AFE-0801C4DD56C7}" dt="2022-09-26T21:08:22.441" v="4232" actId="1076"/>
          <ac:picMkLst>
            <pc:docMk/>
            <pc:sldMk cId="51599060" sldId="294"/>
            <ac:picMk id="3" creationId="{73758AC8-16FA-94B8-4DA8-AE833AE6A838}"/>
          </ac:picMkLst>
        </pc:picChg>
        <pc:picChg chg="del mod modCrop">
          <ac:chgData name="Kumar, Vinod" userId="a0710a6e-bffc-4971-8893-1c23addeb5b0" providerId="ADAL" clId="{922FE477-A091-45D2-9AFE-0801C4DD56C7}" dt="2022-09-22T14:08:42.029" v="2815" actId="478"/>
          <ac:picMkLst>
            <pc:docMk/>
            <pc:sldMk cId="51599060" sldId="294"/>
            <ac:picMk id="3" creationId="{AD1CFE25-4038-B1BD-5B93-AD75663689C8}"/>
          </ac:picMkLst>
        </pc:picChg>
        <pc:picChg chg="add del mod">
          <ac:chgData name="Kumar, Vinod" userId="a0710a6e-bffc-4971-8893-1c23addeb5b0" providerId="ADAL" clId="{922FE477-A091-45D2-9AFE-0801C4DD56C7}" dt="2022-09-21T16:02:54.493" v="1641"/>
          <ac:picMkLst>
            <pc:docMk/>
            <pc:sldMk cId="51599060" sldId="294"/>
            <ac:picMk id="3" creationId="{C3C15EEA-E917-04A0-65A5-AAF956DAA0FC}"/>
          </ac:picMkLst>
        </pc:picChg>
        <pc:picChg chg="add del mod">
          <ac:chgData name="Kumar, Vinod" userId="a0710a6e-bffc-4971-8893-1c23addeb5b0" providerId="ADAL" clId="{922FE477-A091-45D2-9AFE-0801C4DD56C7}" dt="2022-09-21T14:13:34.404" v="1634" actId="478"/>
          <ac:picMkLst>
            <pc:docMk/>
            <pc:sldMk cId="51599060" sldId="294"/>
            <ac:picMk id="4" creationId="{00000000-0000-0000-0000-000000000000}"/>
          </ac:picMkLst>
        </pc:picChg>
        <pc:picChg chg="mod">
          <ac:chgData name="Kumar, Vinod" userId="a0710a6e-bffc-4971-8893-1c23addeb5b0" providerId="ADAL" clId="{922FE477-A091-45D2-9AFE-0801C4DD56C7}" dt="2022-09-26T21:08:38.066" v="4234" actId="1076"/>
          <ac:picMkLst>
            <pc:docMk/>
            <pc:sldMk cId="51599060" sldId="294"/>
            <ac:picMk id="4" creationId="{0AB7334A-7D84-E21C-4840-A55B123B485F}"/>
          </ac:picMkLst>
        </pc:picChg>
        <pc:picChg chg="del mod">
          <ac:chgData name="Kumar, Vinod" userId="a0710a6e-bffc-4971-8893-1c23addeb5b0" providerId="ADAL" clId="{922FE477-A091-45D2-9AFE-0801C4DD56C7}" dt="2022-09-22T16:02:36.756" v="3034" actId="478"/>
          <ac:picMkLst>
            <pc:docMk/>
            <pc:sldMk cId="51599060" sldId="294"/>
            <ac:picMk id="4" creationId="{97A34B99-FA99-B1D3-873B-15A065B87313}"/>
          </ac:picMkLst>
        </pc:picChg>
        <pc:picChg chg="mod">
          <ac:chgData name="Kumar, Vinod" userId="a0710a6e-bffc-4971-8893-1c23addeb5b0" providerId="ADAL" clId="{922FE477-A091-45D2-9AFE-0801C4DD56C7}" dt="2022-09-26T21:08:38.066" v="4234" actId="1076"/>
          <ac:picMkLst>
            <pc:docMk/>
            <pc:sldMk cId="51599060" sldId="294"/>
            <ac:picMk id="5" creationId="{68015BC2-1828-B74E-A8EC-FAED8514FFEC}"/>
          </ac:picMkLst>
        </pc:picChg>
        <pc:picChg chg="del mod">
          <ac:chgData name="Kumar, Vinod" userId="a0710a6e-bffc-4971-8893-1c23addeb5b0" providerId="ADAL" clId="{922FE477-A091-45D2-9AFE-0801C4DD56C7}" dt="2022-09-22T16:02:36.756" v="3034" actId="478"/>
          <ac:picMkLst>
            <pc:docMk/>
            <pc:sldMk cId="51599060" sldId="294"/>
            <ac:picMk id="5" creationId="{C66BF237-614C-CE64-F147-832AB156FFA8}"/>
          </ac:picMkLst>
        </pc:picChg>
        <pc:picChg chg="add del mod">
          <ac:chgData name="Kumar, Vinod" userId="a0710a6e-bffc-4971-8893-1c23addeb5b0" providerId="ADAL" clId="{922FE477-A091-45D2-9AFE-0801C4DD56C7}" dt="2022-09-21T14:13:34.404" v="1634" actId="478"/>
          <ac:picMkLst>
            <pc:docMk/>
            <pc:sldMk cId="51599060" sldId="294"/>
            <ac:picMk id="8" creationId="{00000000-0000-0000-0000-000000000000}"/>
          </ac:picMkLst>
        </pc:picChg>
        <pc:picChg chg="add del mod">
          <ac:chgData name="Kumar, Vinod" userId="a0710a6e-bffc-4971-8893-1c23addeb5b0" providerId="ADAL" clId="{922FE477-A091-45D2-9AFE-0801C4DD56C7}" dt="2022-09-21T16:03:35.277" v="1647" actId="478"/>
          <ac:picMkLst>
            <pc:docMk/>
            <pc:sldMk cId="51599060" sldId="294"/>
            <ac:picMk id="9" creationId="{FC910ABD-A7AD-1073-EBA1-BC2A48C3EFE3}"/>
          </ac:picMkLst>
        </pc:picChg>
        <pc:picChg chg="del mod">
          <ac:chgData name="Kumar, Vinod" userId="a0710a6e-bffc-4971-8893-1c23addeb5b0" providerId="ADAL" clId="{922FE477-A091-45D2-9AFE-0801C4DD56C7}" dt="2022-09-21T21:04:38.601" v="2376" actId="478"/>
          <ac:picMkLst>
            <pc:docMk/>
            <pc:sldMk cId="51599060" sldId="294"/>
            <ac:picMk id="11" creationId="{1690D837-90D7-621C-05CE-8F8C79BC1C88}"/>
          </ac:picMkLst>
        </pc:picChg>
        <pc:picChg chg="del mod">
          <ac:chgData name="Kumar, Vinod" userId="a0710a6e-bffc-4971-8893-1c23addeb5b0" providerId="ADAL" clId="{922FE477-A091-45D2-9AFE-0801C4DD56C7}" dt="2022-09-26T21:04:58.332" v="3930" actId="478"/>
          <ac:picMkLst>
            <pc:docMk/>
            <pc:sldMk cId="51599060" sldId="294"/>
            <ac:picMk id="12" creationId="{55AC23B9-2D5B-7FAB-56F1-F91D37F4C9D8}"/>
          </ac:picMkLst>
        </pc:picChg>
        <pc:picChg chg="del mod">
          <ac:chgData name="Kumar, Vinod" userId="a0710a6e-bffc-4971-8893-1c23addeb5b0" providerId="ADAL" clId="{922FE477-A091-45D2-9AFE-0801C4DD56C7}" dt="2022-09-26T21:04:58.332" v="3930" actId="478"/>
          <ac:picMkLst>
            <pc:docMk/>
            <pc:sldMk cId="51599060" sldId="294"/>
            <ac:picMk id="13" creationId="{30975172-FCD7-69A5-A5A6-88E35B17E606}"/>
          </ac:picMkLst>
        </pc:picChg>
        <pc:picChg chg="del mod">
          <ac:chgData name="Kumar, Vinod" userId="a0710a6e-bffc-4971-8893-1c23addeb5b0" providerId="ADAL" clId="{922FE477-A091-45D2-9AFE-0801C4DD56C7}" dt="2022-09-26T21:05:40.012" v="3950" actId="478"/>
          <ac:picMkLst>
            <pc:docMk/>
            <pc:sldMk cId="51599060" sldId="294"/>
            <ac:picMk id="14" creationId="{CA13CF5C-A7A2-F8CE-F8EB-8229A33E864B}"/>
          </ac:picMkLst>
        </pc:picChg>
        <pc:picChg chg="del mod">
          <ac:chgData name="Kumar, Vinod" userId="a0710a6e-bffc-4971-8893-1c23addeb5b0" providerId="ADAL" clId="{922FE477-A091-45D2-9AFE-0801C4DD56C7}" dt="2022-09-26T21:05:40.012" v="3950" actId="478"/>
          <ac:picMkLst>
            <pc:docMk/>
            <pc:sldMk cId="51599060" sldId="294"/>
            <ac:picMk id="15" creationId="{929EA69C-BEA0-72C5-1C4F-496C248F2B95}"/>
          </ac:picMkLst>
        </pc:picChg>
        <pc:picChg chg="del mod">
          <ac:chgData name="Kumar, Vinod" userId="a0710a6e-bffc-4971-8893-1c23addeb5b0" providerId="ADAL" clId="{922FE477-A091-45D2-9AFE-0801C4DD56C7}" dt="2022-09-26T21:06:45.963" v="4012" actId="478"/>
          <ac:picMkLst>
            <pc:docMk/>
            <pc:sldMk cId="51599060" sldId="294"/>
            <ac:picMk id="16" creationId="{729524A9-F692-FAEC-77C5-91B09181D059}"/>
          </ac:picMkLst>
        </pc:picChg>
        <pc:picChg chg="del mod">
          <ac:chgData name="Kumar, Vinod" userId="a0710a6e-bffc-4971-8893-1c23addeb5b0" providerId="ADAL" clId="{922FE477-A091-45D2-9AFE-0801C4DD56C7}" dt="2022-09-26T21:06:45.963" v="4012" actId="478"/>
          <ac:picMkLst>
            <pc:docMk/>
            <pc:sldMk cId="51599060" sldId="294"/>
            <ac:picMk id="17" creationId="{457AFF3B-1F7E-22C2-EBBC-EA9706553906}"/>
          </ac:picMkLst>
        </pc:picChg>
        <pc:picChg chg="add mod">
          <ac:chgData name="Kumar, Vinod" userId="a0710a6e-bffc-4971-8893-1c23addeb5b0" providerId="ADAL" clId="{922FE477-A091-45D2-9AFE-0801C4DD56C7}" dt="2022-09-26T21:07:43.682" v="4215" actId="1076"/>
          <ac:picMkLst>
            <pc:docMk/>
            <pc:sldMk cId="51599060" sldId="294"/>
            <ac:picMk id="30" creationId="{60CB73A7-14FE-042F-5656-C468FC0E6FD9}"/>
          </ac:picMkLst>
        </pc:picChg>
        <pc:picChg chg="add mod">
          <ac:chgData name="Kumar, Vinod" userId="a0710a6e-bffc-4971-8893-1c23addeb5b0" providerId="ADAL" clId="{922FE477-A091-45D2-9AFE-0801C4DD56C7}" dt="2022-09-26T21:07:49.610" v="4219" actId="1038"/>
          <ac:picMkLst>
            <pc:docMk/>
            <pc:sldMk cId="51599060" sldId="294"/>
            <ac:picMk id="31" creationId="{386F0B05-F7BB-5932-D2EE-B54F705C16F0}"/>
          </ac:picMkLst>
        </pc:picChg>
        <pc:picChg chg="mod">
          <ac:chgData name="Kumar, Vinod" userId="a0710a6e-bffc-4971-8893-1c23addeb5b0" providerId="ADAL" clId="{922FE477-A091-45D2-9AFE-0801C4DD56C7}" dt="2022-09-21T21:20:27.703" v="2748"/>
          <ac:picMkLst>
            <pc:docMk/>
            <pc:sldMk cId="51599060" sldId="294"/>
            <ac:picMk id="31" creationId="{B615416E-5A01-9BAC-3E87-86B9304FD3B5}"/>
          </ac:picMkLst>
        </pc:picChg>
        <pc:picChg chg="mod">
          <ac:chgData name="Kumar, Vinod" userId="a0710a6e-bffc-4971-8893-1c23addeb5b0" providerId="ADAL" clId="{922FE477-A091-45D2-9AFE-0801C4DD56C7}" dt="2022-09-21T21:20:27.703" v="2748"/>
          <ac:picMkLst>
            <pc:docMk/>
            <pc:sldMk cId="51599060" sldId="294"/>
            <ac:picMk id="32" creationId="{91C83511-709A-26D4-9573-4D546AB22B64}"/>
          </ac:picMkLst>
        </pc:picChg>
        <pc:picChg chg="mod">
          <ac:chgData name="Kumar, Vinod" userId="a0710a6e-bffc-4971-8893-1c23addeb5b0" providerId="ADAL" clId="{922FE477-A091-45D2-9AFE-0801C4DD56C7}" dt="2022-09-21T21:20:27.703" v="2748"/>
          <ac:picMkLst>
            <pc:docMk/>
            <pc:sldMk cId="51599060" sldId="294"/>
            <ac:picMk id="43" creationId="{DD0E49D8-5ECA-96C5-AE20-702465F14CC3}"/>
          </ac:picMkLst>
        </pc:picChg>
        <pc:picChg chg="add del mod">
          <ac:chgData name="Kumar, Vinod" userId="a0710a6e-bffc-4971-8893-1c23addeb5b0" providerId="ADAL" clId="{922FE477-A091-45D2-9AFE-0801C4DD56C7}" dt="2022-09-21T21:20:49.121" v="2754" actId="478"/>
          <ac:picMkLst>
            <pc:docMk/>
            <pc:sldMk cId="51599060" sldId="294"/>
            <ac:picMk id="45" creationId="{7F64DACE-71F0-C209-116F-CFC3BED3410F}"/>
          </ac:picMkLst>
        </pc:picChg>
        <pc:picChg chg="add del mod">
          <ac:chgData name="Kumar, Vinod" userId="a0710a6e-bffc-4971-8893-1c23addeb5b0" providerId="ADAL" clId="{922FE477-A091-45D2-9AFE-0801C4DD56C7}" dt="2022-09-21T21:20:49.121" v="2754" actId="478"/>
          <ac:picMkLst>
            <pc:docMk/>
            <pc:sldMk cId="51599060" sldId="294"/>
            <ac:picMk id="46" creationId="{A6CE7116-B190-A2CB-26CA-5AA0D43279E2}"/>
          </ac:picMkLst>
        </pc:picChg>
        <pc:cxnChg chg="mod">
          <ac:chgData name="Kumar, Vinod" userId="a0710a6e-bffc-4971-8893-1c23addeb5b0" providerId="ADAL" clId="{922FE477-A091-45D2-9AFE-0801C4DD56C7}" dt="2022-09-21T21:20:27.703" v="2748"/>
          <ac:cxnSpMkLst>
            <pc:docMk/>
            <pc:sldMk cId="51599060" sldId="294"/>
            <ac:cxnSpMk id="38" creationId="{715FCA98-F342-583F-ED06-2698EB45202B}"/>
          </ac:cxnSpMkLst>
        </pc:cxnChg>
        <pc:cxnChg chg="mod">
          <ac:chgData name="Kumar, Vinod" userId="a0710a6e-bffc-4971-8893-1c23addeb5b0" providerId="ADAL" clId="{922FE477-A091-45D2-9AFE-0801C4DD56C7}" dt="2022-09-21T21:20:27.703" v="2748"/>
          <ac:cxnSpMkLst>
            <pc:docMk/>
            <pc:sldMk cId="51599060" sldId="294"/>
            <ac:cxnSpMk id="39" creationId="{A4053117-28FC-92ED-2C18-F79B6E660EAD}"/>
          </ac:cxnSpMkLst>
        </pc:cxnChg>
      </pc:sldChg>
      <pc:sldChg chg="modSp del">
        <pc:chgData name="Kumar, Vinod" userId="a0710a6e-bffc-4971-8893-1c23addeb5b0" providerId="ADAL" clId="{922FE477-A091-45D2-9AFE-0801C4DD56C7}" dt="2022-09-22T15:58:15.084" v="2999" actId="47"/>
        <pc:sldMkLst>
          <pc:docMk/>
          <pc:sldMk cId="1009668395" sldId="295"/>
        </pc:sldMkLst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009668395" sldId="295"/>
            <ac:spMk id="2" creationId="{00000000-0000-0000-0000-000000000000}"/>
          </ac:spMkLst>
        </pc:spChg>
        <pc:graphicFrameChg chg="mod">
          <ac:chgData name="Kumar, Vinod" userId="a0710a6e-bffc-4971-8893-1c23addeb5b0" providerId="ADAL" clId="{922FE477-A091-45D2-9AFE-0801C4DD56C7}" dt="2022-09-20T18:45:52.930" v="326"/>
          <ac:graphicFrameMkLst>
            <pc:docMk/>
            <pc:sldMk cId="1009668395" sldId="295"/>
            <ac:graphicFrameMk id="3" creationId="{00000000-0000-0000-0000-000000000000}"/>
          </ac:graphicFrameMkLst>
        </pc:graphicFrameChg>
      </pc:sldChg>
      <pc:sldChg chg="addSp delSp modSp new mod">
        <pc:chgData name="Kumar, Vinod" userId="a0710a6e-bffc-4971-8893-1c23addeb5b0" providerId="ADAL" clId="{922FE477-A091-45D2-9AFE-0801C4DD56C7}" dt="2022-09-22T18:32:03.889" v="3184" actId="14100"/>
        <pc:sldMkLst>
          <pc:docMk/>
          <pc:sldMk cId="1513429835" sldId="296"/>
        </pc:sldMkLst>
        <pc:spChg chg="add del mod">
          <ac:chgData name="Kumar, Vinod" userId="a0710a6e-bffc-4971-8893-1c23addeb5b0" providerId="ADAL" clId="{922FE477-A091-45D2-9AFE-0801C4DD56C7}" dt="2022-09-20T18:47:31.358" v="327" actId="478"/>
          <ac:spMkLst>
            <pc:docMk/>
            <pc:sldMk cId="1513429835" sldId="296"/>
            <ac:spMk id="2" creationId="{D4DAD4E8-951C-E854-C5BA-E582E3065432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4" creationId="{9788899E-4A3C-7071-A847-967F90F76737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5" creationId="{69CE3BDB-196E-40DA-0274-C6F853E535A8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6" creationId="{B617F9A1-833E-5908-CF5A-6974DA09004A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7" creationId="{5ADECC71-4014-E2F2-487D-E9EA778B3EA7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8" creationId="{1F7EA28D-CDF6-CF49-3D95-20C532BA4A21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12" creationId="{DB3B5290-46CE-218B-9754-DDDC56D55DC3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13" creationId="{F096A9D0-2A3F-A43B-23E7-6DDE16A6FA26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14" creationId="{26A48FAC-2E79-8E45-DD39-41DB47C400F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18" creationId="{CC029737-2AB0-97AA-1D71-C280A854C2B2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24" creationId="{93067238-EB66-DDD6-7FDE-7795639232B5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25" creationId="{685AFE4F-0A40-8C35-1079-81EF47E5CBE3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27" creationId="{36554307-910D-8280-3E81-1A112B5D3E19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28" creationId="{2EFF25B0-67F8-F52F-56EC-38B983FDA689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29" creationId="{CC51201B-DEDE-9431-828C-AA458955C15E}"/>
          </ac:spMkLst>
        </pc:spChg>
        <pc:spChg chg="mod">
          <ac:chgData name="Kumar, Vinod" userId="a0710a6e-bffc-4971-8893-1c23addeb5b0" providerId="ADAL" clId="{922FE477-A091-45D2-9AFE-0801C4DD56C7}" dt="2022-09-20T18:35:23.902" v="10"/>
          <ac:spMkLst>
            <pc:docMk/>
            <pc:sldMk cId="1513429835" sldId="296"/>
            <ac:spMk id="35" creationId="{0D5FBBE6-F4A0-3CC3-D89F-3FCB88D673CD}"/>
          </ac:spMkLst>
        </pc:spChg>
        <pc:spChg chg="mod">
          <ac:chgData name="Kumar, Vinod" userId="a0710a6e-bffc-4971-8893-1c23addeb5b0" providerId="ADAL" clId="{922FE477-A091-45D2-9AFE-0801C4DD56C7}" dt="2022-09-20T18:35:23.902" v="10"/>
          <ac:spMkLst>
            <pc:docMk/>
            <pc:sldMk cId="1513429835" sldId="296"/>
            <ac:spMk id="36" creationId="{43BB3516-B3A5-E725-82FB-1D458E76A4DC}"/>
          </ac:spMkLst>
        </pc:spChg>
        <pc:spChg chg="mod">
          <ac:chgData name="Kumar, Vinod" userId="a0710a6e-bffc-4971-8893-1c23addeb5b0" providerId="ADAL" clId="{922FE477-A091-45D2-9AFE-0801C4DD56C7}" dt="2022-09-20T18:35:23.902" v="10"/>
          <ac:spMkLst>
            <pc:docMk/>
            <pc:sldMk cId="1513429835" sldId="296"/>
            <ac:spMk id="37" creationId="{1138256D-3566-6B6C-F010-03CDE37DAFE6}"/>
          </ac:spMkLst>
        </pc:spChg>
        <pc:spChg chg="mod">
          <ac:chgData name="Kumar, Vinod" userId="a0710a6e-bffc-4971-8893-1c23addeb5b0" providerId="ADAL" clId="{922FE477-A091-45D2-9AFE-0801C4DD56C7}" dt="2022-09-20T18:35:23.902" v="10"/>
          <ac:spMkLst>
            <pc:docMk/>
            <pc:sldMk cId="1513429835" sldId="296"/>
            <ac:spMk id="39" creationId="{DDD891D7-1EB5-88E8-1E34-F8D71A42CFC0}"/>
          </ac:spMkLst>
        </pc:spChg>
        <pc:spChg chg="mod">
          <ac:chgData name="Kumar, Vinod" userId="a0710a6e-bffc-4971-8893-1c23addeb5b0" providerId="ADAL" clId="{922FE477-A091-45D2-9AFE-0801C4DD56C7}" dt="2022-09-20T18:35:23.902" v="10"/>
          <ac:spMkLst>
            <pc:docMk/>
            <pc:sldMk cId="1513429835" sldId="296"/>
            <ac:spMk id="40" creationId="{C8A82F6B-298D-8AA7-120A-CA33453471C4}"/>
          </ac:spMkLst>
        </pc:spChg>
        <pc:spChg chg="mod">
          <ac:chgData name="Kumar, Vinod" userId="a0710a6e-bffc-4971-8893-1c23addeb5b0" providerId="ADAL" clId="{922FE477-A091-45D2-9AFE-0801C4DD56C7}" dt="2022-09-20T18:35:23.902" v="10"/>
          <ac:spMkLst>
            <pc:docMk/>
            <pc:sldMk cId="1513429835" sldId="296"/>
            <ac:spMk id="41" creationId="{9F672D34-6A50-BBD5-1AAA-26476DFDC0B1}"/>
          </ac:spMkLst>
        </pc:spChg>
        <pc:spChg chg="add 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42" creationId="{1ED717A2-4F06-7AEA-962B-FDF389110D75}"/>
          </ac:spMkLst>
        </pc:spChg>
        <pc:spChg chg="add 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43" creationId="{5DCAFD05-5831-73A0-7BF0-69227CDC54C7}"/>
          </ac:spMkLst>
        </pc:spChg>
        <pc:spChg chg="add del mod">
          <ac:chgData name="Kumar, Vinod" userId="a0710a6e-bffc-4971-8893-1c23addeb5b0" providerId="ADAL" clId="{922FE477-A091-45D2-9AFE-0801C4DD56C7}" dt="2022-09-20T18:36:27.987" v="12" actId="478"/>
          <ac:spMkLst>
            <pc:docMk/>
            <pc:sldMk cId="1513429835" sldId="296"/>
            <ac:spMk id="44" creationId="{B7CA8EFF-2009-2EBE-E635-93BC19728062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48" creationId="{5BFA479C-DE82-F904-EF44-A15F82245F97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50" creationId="{7BE0068F-EB38-16B1-91D2-4193725D2E82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51" creationId="{ADF2725B-4025-16BB-80C8-4D83DDDAE524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54" creationId="{3C381526-F796-AC6F-E20A-886BC272767E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56" creationId="{51F0D1B0-9D04-F75C-BC1B-1C35BBC3842D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63" creationId="{4BDB4298-BF80-8552-C369-91E65CE6752D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64" creationId="{415B6E1F-669F-9933-C577-B3831D8C8889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65" creationId="{EE4530B1-243A-E94B-0EA6-ED88F67F1DA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67" creationId="{D06C7AEC-EBF6-D7B9-AC55-C97C025A5C27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68" creationId="{DD50D5E9-8063-F632-544A-69C529A3803F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69" creationId="{132B6EAC-95DB-64E8-BDC2-762DEEA82E10}"/>
          </ac:spMkLst>
        </pc:spChg>
        <pc:spChg chg="add 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70" creationId="{75BF95BB-B2FA-C821-8829-4B51585D52AD}"/>
          </ac:spMkLst>
        </pc:spChg>
        <pc:spChg chg="add 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71" creationId="{65C6D2CD-F489-18C6-C818-05F26E453A46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76" creationId="{8CA89DEC-4CEE-933F-0C00-EF184AF75B3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77" creationId="{4048029A-5B3F-250C-3545-A41B9B9FFC24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80" creationId="{9A679A11-3B62-3910-70D8-287307C5BC23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82" creationId="{868685C1-6580-7AB9-72E8-7B403EEDE873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84" creationId="{8EB369D4-8E99-DF08-FE38-C7C5D659066B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85" creationId="{07582DB8-3D5B-FB00-03FC-E6D395925276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89" creationId="{2C10A5E6-79F1-49F9-5450-A6F525EFA395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91" creationId="{0BAC75ED-9281-27C1-E3C2-3259235F622F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93" creationId="{B7AB9540-8540-DBFA-8E71-41757520CC77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94" creationId="{B7A6FCC1-F1F3-1B1A-D5CC-39A999093EDC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95" creationId="{915ED749-D4A7-C8E0-B391-04C12DE7E60F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k cId="1513429835" sldId="296"/>
            <ac:spMk id="96" creationId="{4D51FB54-220E-C731-B9A0-E5A00D07F660}"/>
          </ac:spMkLst>
        </pc:spChg>
        <pc:spChg chg="mod">
          <ac:chgData name="Kumar, Vinod" userId="a0710a6e-bffc-4971-8893-1c23addeb5b0" providerId="ADAL" clId="{922FE477-A091-45D2-9AFE-0801C4DD56C7}" dt="2022-09-20T18:45:05.875" v="295"/>
          <ac:spMkLst>
            <pc:docMk/>
            <pc:sldMk cId="1513429835" sldId="296"/>
            <ac:spMk id="102" creationId="{B76A37BA-D129-2BF6-C070-952649EB54A1}"/>
          </ac:spMkLst>
        </pc:spChg>
        <pc:spChg chg="add mod">
          <ac:chgData name="Kumar, Vinod" userId="a0710a6e-bffc-4971-8893-1c23addeb5b0" providerId="ADAL" clId="{922FE477-A091-45D2-9AFE-0801C4DD56C7}" dt="2022-09-22T18:32:03.889" v="3184" actId="14100"/>
          <ac:spMkLst>
            <pc:docMk/>
            <pc:sldMk cId="1513429835" sldId="296"/>
            <ac:spMk id="104" creationId="{DC972888-DDF4-E41C-CBBC-744976A85034}"/>
          </ac:spMkLst>
        </pc:spChg>
        <pc:spChg chg="mod">
          <ac:chgData name="Kumar, Vinod" userId="a0710a6e-bffc-4971-8893-1c23addeb5b0" providerId="ADAL" clId="{922FE477-A091-45D2-9AFE-0801C4DD56C7}" dt="2022-09-20T18:45:05.875" v="295"/>
          <ac:spMkLst>
            <pc:docMk/>
            <pc:sldMk cId="1513429835" sldId="296"/>
            <ac:spMk id="106" creationId="{DEC0EC40-8B00-8EF6-A598-D30FA8B0E2EF}"/>
          </ac:spMkLst>
        </pc:spChg>
        <pc:spChg chg="mod">
          <ac:chgData name="Kumar, Vinod" userId="a0710a6e-bffc-4971-8893-1c23addeb5b0" providerId="ADAL" clId="{922FE477-A091-45D2-9AFE-0801C4DD56C7}" dt="2022-09-20T18:45:05.875" v="295"/>
          <ac:spMkLst>
            <pc:docMk/>
            <pc:sldMk cId="1513429835" sldId="296"/>
            <ac:spMk id="107" creationId="{C8AD07EA-4C3F-7ACE-50C8-0BFB37B563EF}"/>
          </ac:spMkLst>
        </pc:spChg>
        <pc:spChg chg="mod">
          <ac:chgData name="Kumar, Vinod" userId="a0710a6e-bffc-4971-8893-1c23addeb5b0" providerId="ADAL" clId="{922FE477-A091-45D2-9AFE-0801C4DD56C7}" dt="2022-09-20T18:45:05.875" v="295"/>
          <ac:spMkLst>
            <pc:docMk/>
            <pc:sldMk cId="1513429835" sldId="296"/>
            <ac:spMk id="108" creationId="{7FFD5F29-8BDB-E815-E6F2-82486E323476}"/>
          </ac:spMkLst>
        </pc:spChg>
        <pc:spChg chg="mod">
          <ac:chgData name="Kumar, Vinod" userId="a0710a6e-bffc-4971-8893-1c23addeb5b0" providerId="ADAL" clId="{922FE477-A091-45D2-9AFE-0801C4DD56C7}" dt="2022-09-20T18:45:05.875" v="295"/>
          <ac:spMkLst>
            <pc:docMk/>
            <pc:sldMk cId="1513429835" sldId="296"/>
            <ac:spMk id="109" creationId="{395DC67E-8705-391A-0710-5C4799A9BA21}"/>
          </ac:spMkLst>
        </pc:spChg>
        <pc:spChg chg="mod">
          <ac:chgData name="Kumar, Vinod" userId="a0710a6e-bffc-4971-8893-1c23addeb5b0" providerId="ADAL" clId="{922FE477-A091-45D2-9AFE-0801C4DD56C7}" dt="2022-09-20T18:45:05.875" v="295"/>
          <ac:spMkLst>
            <pc:docMk/>
            <pc:sldMk cId="1513429835" sldId="296"/>
            <ac:spMk id="110" creationId="{DCB5FDE2-408E-09BA-8750-94A00911F76A}"/>
          </ac:spMkLst>
        </pc:spChg>
        <pc:spChg chg="add mod">
          <ac:chgData name="Kumar, Vinod" userId="a0710a6e-bffc-4971-8893-1c23addeb5b0" providerId="ADAL" clId="{922FE477-A091-45D2-9AFE-0801C4DD56C7}" dt="2022-09-20T18:50:33.484" v="358" actId="1038"/>
          <ac:spMkLst>
            <pc:docMk/>
            <pc:sldMk cId="1513429835" sldId="296"/>
            <ac:spMk id="111" creationId="{400131B4-D5AC-5B1B-C3E8-479483B6AFBF}"/>
          </ac:spMkLst>
        </pc:spChg>
        <pc:spChg chg="mod">
          <ac:chgData name="Kumar, Vinod" userId="a0710a6e-bffc-4971-8893-1c23addeb5b0" providerId="ADAL" clId="{922FE477-A091-45D2-9AFE-0801C4DD56C7}" dt="2022-09-20T19:00:31.670" v="926" actId="1035"/>
          <ac:spMkLst>
            <pc:docMk/>
            <pc:sldMk cId="1513429835" sldId="296"/>
            <ac:spMk id="114" creationId="{B67DACA4-5363-BFEE-AA45-269DFADDEE09}"/>
          </ac:spMkLst>
        </pc:spChg>
        <pc:spChg chg="mod">
          <ac:chgData name="Kumar, Vinod" userId="a0710a6e-bffc-4971-8893-1c23addeb5b0" providerId="ADAL" clId="{922FE477-A091-45D2-9AFE-0801C4DD56C7}" dt="2022-09-20T19:00:31.670" v="926" actId="1035"/>
          <ac:spMkLst>
            <pc:docMk/>
            <pc:sldMk cId="1513429835" sldId="296"/>
            <ac:spMk id="115" creationId="{478522AC-C3A6-DD59-AF23-F69235756BC8}"/>
          </ac:spMkLst>
        </pc:spChg>
        <pc:spChg chg="mod">
          <ac:chgData name="Kumar, Vinod" userId="a0710a6e-bffc-4971-8893-1c23addeb5b0" providerId="ADAL" clId="{922FE477-A091-45D2-9AFE-0801C4DD56C7}" dt="2022-09-20T19:00:31.670" v="926" actId="1035"/>
          <ac:spMkLst>
            <pc:docMk/>
            <pc:sldMk cId="1513429835" sldId="296"/>
            <ac:spMk id="116" creationId="{7231D7CF-29D8-93D8-2772-AAC22485556E}"/>
          </ac:spMkLst>
        </pc:spChg>
        <pc:spChg chg="mod">
          <ac:chgData name="Kumar, Vinod" userId="a0710a6e-bffc-4971-8893-1c23addeb5b0" providerId="ADAL" clId="{922FE477-A091-45D2-9AFE-0801C4DD56C7}" dt="2022-09-20T19:00:31.670" v="926" actId="1035"/>
          <ac:spMkLst>
            <pc:docMk/>
            <pc:sldMk cId="1513429835" sldId="296"/>
            <ac:spMk id="117" creationId="{9153A802-9404-EFC7-E2DC-31EAD1DB41A5}"/>
          </ac:spMkLst>
        </pc:spChg>
        <pc:spChg chg="mod">
          <ac:chgData name="Kumar, Vinod" userId="a0710a6e-bffc-4971-8893-1c23addeb5b0" providerId="ADAL" clId="{922FE477-A091-45D2-9AFE-0801C4DD56C7}" dt="2022-09-20T19:00:31.670" v="926" actId="1035"/>
          <ac:spMkLst>
            <pc:docMk/>
            <pc:sldMk cId="1513429835" sldId="296"/>
            <ac:spMk id="118" creationId="{9BA63CC1-92E1-11C8-51BE-4D99EB4B02FA}"/>
          </ac:spMkLst>
        </pc:spChg>
        <pc:spChg chg="mod">
          <ac:chgData name="Kumar, Vinod" userId="a0710a6e-bffc-4971-8893-1c23addeb5b0" providerId="ADAL" clId="{922FE477-A091-45D2-9AFE-0801C4DD56C7}" dt="2022-09-20T19:00:31.670" v="926" actId="1035"/>
          <ac:spMkLst>
            <pc:docMk/>
            <pc:sldMk cId="1513429835" sldId="296"/>
            <ac:spMk id="119" creationId="{99636659-6CB2-51C1-52EA-4B7BB124E9DD}"/>
          </ac:spMkLst>
        </pc:spChg>
        <pc:spChg chg="mod">
          <ac:chgData name="Kumar, Vinod" userId="a0710a6e-bffc-4971-8893-1c23addeb5b0" providerId="ADAL" clId="{922FE477-A091-45D2-9AFE-0801C4DD56C7}" dt="2022-09-20T19:00:31.670" v="926" actId="1035"/>
          <ac:spMkLst>
            <pc:docMk/>
            <pc:sldMk cId="1513429835" sldId="296"/>
            <ac:spMk id="123" creationId="{89E58ABA-EC09-A3C7-4300-ED1BCB567EA8}"/>
          </ac:spMkLst>
        </pc:spChg>
        <pc:spChg chg="mod">
          <ac:chgData name="Kumar, Vinod" userId="a0710a6e-bffc-4971-8893-1c23addeb5b0" providerId="ADAL" clId="{922FE477-A091-45D2-9AFE-0801C4DD56C7}" dt="2022-09-20T19:00:31.670" v="926" actId="1035"/>
          <ac:spMkLst>
            <pc:docMk/>
            <pc:sldMk cId="1513429835" sldId="296"/>
            <ac:spMk id="124" creationId="{AE72F1A3-B995-84FD-3ECD-CCF7819A28CD}"/>
          </ac:spMkLst>
        </pc:spChg>
        <pc:spChg chg="mod">
          <ac:chgData name="Kumar, Vinod" userId="a0710a6e-bffc-4971-8893-1c23addeb5b0" providerId="ADAL" clId="{922FE477-A091-45D2-9AFE-0801C4DD56C7}" dt="2022-09-20T19:00:31.670" v="926" actId="1035"/>
          <ac:spMkLst>
            <pc:docMk/>
            <pc:sldMk cId="1513429835" sldId="296"/>
            <ac:spMk id="125" creationId="{965AD607-535D-430D-0B05-3D882E458793}"/>
          </ac:spMkLst>
        </pc:spChg>
        <pc:spChg chg="mod">
          <ac:chgData name="Kumar, Vinod" userId="a0710a6e-bffc-4971-8893-1c23addeb5b0" providerId="ADAL" clId="{922FE477-A091-45D2-9AFE-0801C4DD56C7}" dt="2022-09-20T19:00:31.670" v="926" actId="1035"/>
          <ac:spMkLst>
            <pc:docMk/>
            <pc:sldMk cId="1513429835" sldId="296"/>
            <ac:spMk id="130" creationId="{F2792264-D490-56BD-6683-1C257E241F58}"/>
          </ac:spMkLst>
        </pc:spChg>
        <pc:spChg chg="mod">
          <ac:chgData name="Kumar, Vinod" userId="a0710a6e-bffc-4971-8893-1c23addeb5b0" providerId="ADAL" clId="{922FE477-A091-45D2-9AFE-0801C4DD56C7}" dt="2022-09-20T19:00:31.670" v="926" actId="1035"/>
          <ac:spMkLst>
            <pc:docMk/>
            <pc:sldMk cId="1513429835" sldId="296"/>
            <ac:spMk id="131" creationId="{341C3DAD-8831-6185-FB2F-EE49BB26467E}"/>
          </ac:spMkLst>
        </pc:spChg>
        <pc:spChg chg="mod">
          <ac:chgData name="Kumar, Vinod" userId="a0710a6e-bffc-4971-8893-1c23addeb5b0" providerId="ADAL" clId="{922FE477-A091-45D2-9AFE-0801C4DD56C7}" dt="2022-09-20T19:00:31.670" v="926" actId="1035"/>
          <ac:spMkLst>
            <pc:docMk/>
            <pc:sldMk cId="1513429835" sldId="296"/>
            <ac:spMk id="137" creationId="{C6A69B23-79A6-1696-C362-0FBD1C918743}"/>
          </ac:spMkLst>
        </pc:spChg>
        <pc:spChg chg="mod">
          <ac:chgData name="Kumar, Vinod" userId="a0710a6e-bffc-4971-8893-1c23addeb5b0" providerId="ADAL" clId="{922FE477-A091-45D2-9AFE-0801C4DD56C7}" dt="2022-09-20T19:00:31.670" v="926" actId="1035"/>
          <ac:spMkLst>
            <pc:docMk/>
            <pc:sldMk cId="1513429835" sldId="296"/>
            <ac:spMk id="138" creationId="{B5FB8C97-E6C4-2BD4-476C-48BE7A4BEAD9}"/>
          </ac:spMkLst>
        </pc:spChg>
        <pc:spChg chg="mod">
          <ac:chgData name="Kumar, Vinod" userId="a0710a6e-bffc-4971-8893-1c23addeb5b0" providerId="ADAL" clId="{922FE477-A091-45D2-9AFE-0801C4DD56C7}" dt="2022-09-20T19:00:31.670" v="926" actId="1035"/>
          <ac:spMkLst>
            <pc:docMk/>
            <pc:sldMk cId="1513429835" sldId="296"/>
            <ac:spMk id="140" creationId="{E3BB1FD9-3B87-02B4-E48F-330F0919D6E6}"/>
          </ac:spMkLst>
        </pc:spChg>
        <pc:spChg chg="mod">
          <ac:chgData name="Kumar, Vinod" userId="a0710a6e-bffc-4971-8893-1c23addeb5b0" providerId="ADAL" clId="{922FE477-A091-45D2-9AFE-0801C4DD56C7}" dt="2022-09-20T19:00:31.670" v="926" actId="1035"/>
          <ac:spMkLst>
            <pc:docMk/>
            <pc:sldMk cId="1513429835" sldId="296"/>
            <ac:spMk id="141" creationId="{9E634DCF-6CDE-7750-6F59-7137D7133759}"/>
          </ac:spMkLst>
        </pc:spChg>
        <pc:spChg chg="mod">
          <ac:chgData name="Kumar, Vinod" userId="a0710a6e-bffc-4971-8893-1c23addeb5b0" providerId="ADAL" clId="{922FE477-A091-45D2-9AFE-0801C4DD56C7}" dt="2022-09-20T19:00:31.670" v="926" actId="1035"/>
          <ac:spMkLst>
            <pc:docMk/>
            <pc:sldMk cId="1513429835" sldId="296"/>
            <ac:spMk id="142" creationId="{7A9EE77E-D552-2715-22BA-2D18900CAF25}"/>
          </ac:spMkLst>
        </pc:spChg>
        <pc:spChg chg="mod">
          <ac:chgData name="Kumar, Vinod" userId="a0710a6e-bffc-4971-8893-1c23addeb5b0" providerId="ADAL" clId="{922FE477-A091-45D2-9AFE-0801C4DD56C7}" dt="2022-09-20T18:50:58.820" v="364"/>
          <ac:spMkLst>
            <pc:docMk/>
            <pc:sldMk cId="1513429835" sldId="296"/>
            <ac:spMk id="145" creationId="{B4B54DA4-A9EA-620D-0527-DD35CC099908}"/>
          </ac:spMkLst>
        </pc:spChg>
        <pc:spChg chg="mod">
          <ac:chgData name="Kumar, Vinod" userId="a0710a6e-bffc-4971-8893-1c23addeb5b0" providerId="ADAL" clId="{922FE477-A091-45D2-9AFE-0801C4DD56C7}" dt="2022-09-20T18:50:58.820" v="364"/>
          <ac:spMkLst>
            <pc:docMk/>
            <pc:sldMk cId="1513429835" sldId="296"/>
            <ac:spMk id="150" creationId="{E2E6BA4F-5BD9-B259-D41C-A379B9A1EE79}"/>
          </ac:spMkLst>
        </pc:spChg>
        <pc:spChg chg="mod">
          <ac:chgData name="Kumar, Vinod" userId="a0710a6e-bffc-4971-8893-1c23addeb5b0" providerId="ADAL" clId="{922FE477-A091-45D2-9AFE-0801C4DD56C7}" dt="2022-09-20T18:50:58.820" v="364"/>
          <ac:spMkLst>
            <pc:docMk/>
            <pc:sldMk cId="1513429835" sldId="296"/>
            <ac:spMk id="151" creationId="{336F432C-5688-FF8D-65C8-93F8F13BE934}"/>
          </ac:spMkLst>
        </pc:spChg>
        <pc:spChg chg="mod">
          <ac:chgData name="Kumar, Vinod" userId="a0710a6e-bffc-4971-8893-1c23addeb5b0" providerId="ADAL" clId="{922FE477-A091-45D2-9AFE-0801C4DD56C7}" dt="2022-09-20T18:50:58.820" v="364"/>
          <ac:spMkLst>
            <pc:docMk/>
            <pc:sldMk cId="1513429835" sldId="296"/>
            <ac:spMk id="152" creationId="{57E57128-EBE7-36DC-83AA-F58A9788B7E5}"/>
          </ac:spMkLst>
        </pc:spChg>
        <pc:spChg chg="mod">
          <ac:chgData name="Kumar, Vinod" userId="a0710a6e-bffc-4971-8893-1c23addeb5b0" providerId="ADAL" clId="{922FE477-A091-45D2-9AFE-0801C4DD56C7}" dt="2022-09-20T18:50:58.820" v="364"/>
          <ac:spMkLst>
            <pc:docMk/>
            <pc:sldMk cId="1513429835" sldId="296"/>
            <ac:spMk id="154" creationId="{0C7CD436-2A9F-697F-B87D-2D72A587A9AA}"/>
          </ac:spMkLst>
        </pc:spChg>
        <pc:spChg chg="mod">
          <ac:chgData name="Kumar, Vinod" userId="a0710a6e-bffc-4971-8893-1c23addeb5b0" providerId="ADAL" clId="{922FE477-A091-45D2-9AFE-0801C4DD56C7}" dt="2022-09-20T18:50:58.820" v="364"/>
          <ac:spMkLst>
            <pc:docMk/>
            <pc:sldMk cId="1513429835" sldId="296"/>
            <ac:spMk id="155" creationId="{E47AF5EE-BB51-D42B-F948-E52B605D90F6}"/>
          </ac:spMkLst>
        </pc:spChg>
        <pc:spChg chg="mod">
          <ac:chgData name="Kumar, Vinod" userId="a0710a6e-bffc-4971-8893-1c23addeb5b0" providerId="ADAL" clId="{922FE477-A091-45D2-9AFE-0801C4DD56C7}" dt="2022-09-20T18:50:58.820" v="364"/>
          <ac:spMkLst>
            <pc:docMk/>
            <pc:sldMk cId="1513429835" sldId="296"/>
            <ac:spMk id="156" creationId="{D9791131-F062-13DC-36AF-C7465D33466E}"/>
          </ac:spMkLst>
        </pc:spChg>
        <pc:spChg chg="mod">
          <ac:chgData name="Kumar, Vinod" userId="a0710a6e-bffc-4971-8893-1c23addeb5b0" providerId="ADAL" clId="{922FE477-A091-45D2-9AFE-0801C4DD56C7}" dt="2022-09-20T18:50:58.820" v="364"/>
          <ac:spMkLst>
            <pc:docMk/>
            <pc:sldMk cId="1513429835" sldId="296"/>
            <ac:spMk id="159" creationId="{B4CD806E-9C91-32A0-396A-9C0871528E63}"/>
          </ac:spMkLst>
        </pc:spChg>
        <pc:spChg chg="mod">
          <ac:chgData name="Kumar, Vinod" userId="a0710a6e-bffc-4971-8893-1c23addeb5b0" providerId="ADAL" clId="{922FE477-A091-45D2-9AFE-0801C4DD56C7}" dt="2022-09-20T18:50:58.820" v="364"/>
          <ac:spMkLst>
            <pc:docMk/>
            <pc:sldMk cId="1513429835" sldId="296"/>
            <ac:spMk id="160" creationId="{5FD90C14-1D17-9F39-5BAB-AC5639DC52F5}"/>
          </ac:spMkLst>
        </pc:spChg>
        <pc:spChg chg="mod">
          <ac:chgData name="Kumar, Vinod" userId="a0710a6e-bffc-4971-8893-1c23addeb5b0" providerId="ADAL" clId="{922FE477-A091-45D2-9AFE-0801C4DD56C7}" dt="2022-09-20T18:50:58.820" v="364"/>
          <ac:spMkLst>
            <pc:docMk/>
            <pc:sldMk cId="1513429835" sldId="296"/>
            <ac:spMk id="162" creationId="{ABB4A628-7992-21C0-9233-F653C0BCC367}"/>
          </ac:spMkLst>
        </pc:spChg>
        <pc:spChg chg="mod">
          <ac:chgData name="Kumar, Vinod" userId="a0710a6e-bffc-4971-8893-1c23addeb5b0" providerId="ADAL" clId="{922FE477-A091-45D2-9AFE-0801C4DD56C7}" dt="2022-09-20T18:50:58.820" v="364"/>
          <ac:spMkLst>
            <pc:docMk/>
            <pc:sldMk cId="1513429835" sldId="296"/>
            <ac:spMk id="163" creationId="{9E6B5252-2E4F-9749-EE59-A473D4050F02}"/>
          </ac:spMkLst>
        </pc:spChg>
        <pc:spChg chg="mod">
          <ac:chgData name="Kumar, Vinod" userId="a0710a6e-bffc-4971-8893-1c23addeb5b0" providerId="ADAL" clId="{922FE477-A091-45D2-9AFE-0801C4DD56C7}" dt="2022-09-20T18:50:58.820" v="364"/>
          <ac:spMkLst>
            <pc:docMk/>
            <pc:sldMk cId="1513429835" sldId="296"/>
            <ac:spMk id="166" creationId="{A98D4340-727A-8F79-F268-A2F4027F09B0}"/>
          </ac:spMkLst>
        </pc:spChg>
        <pc:spChg chg="mod">
          <ac:chgData name="Kumar, Vinod" userId="a0710a6e-bffc-4971-8893-1c23addeb5b0" providerId="ADAL" clId="{922FE477-A091-45D2-9AFE-0801C4DD56C7}" dt="2022-09-20T18:50:58.820" v="364"/>
          <ac:spMkLst>
            <pc:docMk/>
            <pc:sldMk cId="1513429835" sldId="296"/>
            <ac:spMk id="168" creationId="{9A878616-04BA-7D07-A947-0BA5C2950AE4}"/>
          </ac:spMkLst>
        </pc:spChg>
        <pc:spChg chg="mod">
          <ac:chgData name="Kumar, Vinod" userId="a0710a6e-bffc-4971-8893-1c23addeb5b0" providerId="ADAL" clId="{922FE477-A091-45D2-9AFE-0801C4DD56C7}" dt="2022-09-20T18:51:46.948" v="510"/>
          <ac:spMkLst>
            <pc:docMk/>
            <pc:sldMk cId="1513429835" sldId="296"/>
            <ac:spMk id="172" creationId="{58D83DF8-E670-E733-C958-F860D457EF3F}"/>
          </ac:spMkLst>
        </pc:spChg>
        <pc:spChg chg="mod">
          <ac:chgData name="Kumar, Vinod" userId="a0710a6e-bffc-4971-8893-1c23addeb5b0" providerId="ADAL" clId="{922FE477-A091-45D2-9AFE-0801C4DD56C7}" dt="2022-09-20T18:51:46.948" v="510"/>
          <ac:spMkLst>
            <pc:docMk/>
            <pc:sldMk cId="1513429835" sldId="296"/>
            <ac:spMk id="173" creationId="{5EC89FEF-BA3D-BCF1-CECB-81479A527553}"/>
          </ac:spMkLst>
        </pc:spChg>
        <pc:spChg chg="mod">
          <ac:chgData name="Kumar, Vinod" userId="a0710a6e-bffc-4971-8893-1c23addeb5b0" providerId="ADAL" clId="{922FE477-A091-45D2-9AFE-0801C4DD56C7}" dt="2022-09-20T18:51:46.948" v="510"/>
          <ac:spMkLst>
            <pc:docMk/>
            <pc:sldMk cId="1513429835" sldId="296"/>
            <ac:spMk id="176" creationId="{22440C10-7CC2-6817-D9C4-6D236CC097C0}"/>
          </ac:spMkLst>
        </pc:spChg>
        <pc:spChg chg="mod">
          <ac:chgData name="Kumar, Vinod" userId="a0710a6e-bffc-4971-8893-1c23addeb5b0" providerId="ADAL" clId="{922FE477-A091-45D2-9AFE-0801C4DD56C7}" dt="2022-09-20T18:51:46.948" v="510"/>
          <ac:spMkLst>
            <pc:docMk/>
            <pc:sldMk cId="1513429835" sldId="296"/>
            <ac:spMk id="178" creationId="{7E771C5B-70F7-88DF-7011-8B51BF66E19A}"/>
          </ac:spMkLst>
        </pc:spChg>
        <pc:spChg chg="mod">
          <ac:chgData name="Kumar, Vinod" userId="a0710a6e-bffc-4971-8893-1c23addeb5b0" providerId="ADAL" clId="{922FE477-A091-45D2-9AFE-0801C4DD56C7}" dt="2022-09-20T18:51:46.948" v="510"/>
          <ac:spMkLst>
            <pc:docMk/>
            <pc:sldMk cId="1513429835" sldId="296"/>
            <ac:spMk id="180" creationId="{D9CBD619-58DE-BF43-1844-A148F4FA9D45}"/>
          </ac:spMkLst>
        </pc:spChg>
        <pc:spChg chg="mod">
          <ac:chgData name="Kumar, Vinod" userId="a0710a6e-bffc-4971-8893-1c23addeb5b0" providerId="ADAL" clId="{922FE477-A091-45D2-9AFE-0801C4DD56C7}" dt="2022-09-20T18:51:46.948" v="510"/>
          <ac:spMkLst>
            <pc:docMk/>
            <pc:sldMk cId="1513429835" sldId="296"/>
            <ac:spMk id="181" creationId="{F3100C3F-0AF7-7A98-C90C-7F69FF31E0D3}"/>
          </ac:spMkLst>
        </pc:spChg>
        <pc:spChg chg="mod">
          <ac:chgData name="Kumar, Vinod" userId="a0710a6e-bffc-4971-8893-1c23addeb5b0" providerId="ADAL" clId="{922FE477-A091-45D2-9AFE-0801C4DD56C7}" dt="2022-09-20T18:51:46.948" v="510"/>
          <ac:spMkLst>
            <pc:docMk/>
            <pc:sldMk cId="1513429835" sldId="296"/>
            <ac:spMk id="185" creationId="{9FEF310F-8C0D-844D-2FDD-E24B381C8A9A}"/>
          </ac:spMkLst>
        </pc:spChg>
        <pc:spChg chg="mod">
          <ac:chgData name="Kumar, Vinod" userId="a0710a6e-bffc-4971-8893-1c23addeb5b0" providerId="ADAL" clId="{922FE477-A091-45D2-9AFE-0801C4DD56C7}" dt="2022-09-20T18:53:45.028" v="591" actId="1037"/>
          <ac:spMkLst>
            <pc:docMk/>
            <pc:sldMk cId="1513429835" sldId="296"/>
            <ac:spMk id="187" creationId="{C9B01DA9-7A0C-6016-CF88-E6267FC3FD4D}"/>
          </ac:spMkLst>
        </pc:spChg>
        <pc:spChg chg="mod">
          <ac:chgData name="Kumar, Vinod" userId="a0710a6e-bffc-4971-8893-1c23addeb5b0" providerId="ADAL" clId="{922FE477-A091-45D2-9AFE-0801C4DD56C7}" dt="2022-09-20T18:51:46.948" v="510"/>
          <ac:spMkLst>
            <pc:docMk/>
            <pc:sldMk cId="1513429835" sldId="296"/>
            <ac:spMk id="189" creationId="{5B36D47B-EE25-7904-1F7F-8C6471D43E75}"/>
          </ac:spMkLst>
        </pc:spChg>
        <pc:spChg chg="mod">
          <ac:chgData name="Kumar, Vinod" userId="a0710a6e-bffc-4971-8893-1c23addeb5b0" providerId="ADAL" clId="{922FE477-A091-45D2-9AFE-0801C4DD56C7}" dt="2022-09-20T18:51:46.948" v="510"/>
          <ac:spMkLst>
            <pc:docMk/>
            <pc:sldMk cId="1513429835" sldId="296"/>
            <ac:spMk id="190" creationId="{80BCD534-A91A-F1AF-091B-3D5543A42AC9}"/>
          </ac:spMkLst>
        </pc:spChg>
        <pc:spChg chg="mod">
          <ac:chgData name="Kumar, Vinod" userId="a0710a6e-bffc-4971-8893-1c23addeb5b0" providerId="ADAL" clId="{922FE477-A091-45D2-9AFE-0801C4DD56C7}" dt="2022-09-20T18:59:28.697" v="901" actId="1038"/>
          <ac:spMkLst>
            <pc:docMk/>
            <pc:sldMk cId="1513429835" sldId="296"/>
            <ac:spMk id="191" creationId="{6EBDD917-5B03-B856-4D8F-699F54195551}"/>
          </ac:spMkLst>
        </pc:spChg>
        <pc:spChg chg="mod">
          <ac:chgData name="Kumar, Vinod" userId="a0710a6e-bffc-4971-8893-1c23addeb5b0" providerId="ADAL" clId="{922FE477-A091-45D2-9AFE-0801C4DD56C7}" dt="2022-09-20T18:59:28.697" v="901" actId="1038"/>
          <ac:spMkLst>
            <pc:docMk/>
            <pc:sldMk cId="1513429835" sldId="296"/>
            <ac:spMk id="192" creationId="{0B5B5A40-66FC-32A2-5E78-FF1E984F0A5B}"/>
          </ac:spMkLst>
        </pc:spChg>
        <pc:spChg chg="mod">
          <ac:chgData name="Kumar, Vinod" userId="a0710a6e-bffc-4971-8893-1c23addeb5b0" providerId="ADAL" clId="{922FE477-A091-45D2-9AFE-0801C4DD56C7}" dt="2022-09-20T18:52:24.081" v="554"/>
          <ac:spMkLst>
            <pc:docMk/>
            <pc:sldMk cId="1513429835" sldId="296"/>
            <ac:spMk id="198" creationId="{F748DA9B-E63A-3C71-685C-80C54CBC1442}"/>
          </ac:spMkLst>
        </pc:spChg>
        <pc:spChg chg="mod">
          <ac:chgData name="Kumar, Vinod" userId="a0710a6e-bffc-4971-8893-1c23addeb5b0" providerId="ADAL" clId="{922FE477-A091-45D2-9AFE-0801C4DD56C7}" dt="2022-09-20T18:54:52.409" v="608" actId="1037"/>
          <ac:spMkLst>
            <pc:docMk/>
            <pc:sldMk cId="1513429835" sldId="296"/>
            <ac:spMk id="202" creationId="{FFD12379-EDBE-EA2F-9F32-8D326AC16264}"/>
          </ac:spMkLst>
        </pc:spChg>
        <pc:spChg chg="mod">
          <ac:chgData name="Kumar, Vinod" userId="a0710a6e-bffc-4971-8893-1c23addeb5b0" providerId="ADAL" clId="{922FE477-A091-45D2-9AFE-0801C4DD56C7}" dt="2022-09-20T18:59:38.312" v="902" actId="1038"/>
          <ac:spMkLst>
            <pc:docMk/>
            <pc:sldMk cId="1513429835" sldId="296"/>
            <ac:spMk id="203" creationId="{878C0F07-696A-F865-EC7E-1868D0C7690C}"/>
          </ac:spMkLst>
        </pc:spChg>
        <pc:spChg chg="mod">
          <ac:chgData name="Kumar, Vinod" userId="a0710a6e-bffc-4971-8893-1c23addeb5b0" providerId="ADAL" clId="{922FE477-A091-45D2-9AFE-0801C4DD56C7}" dt="2022-09-20T18:52:24.081" v="554"/>
          <ac:spMkLst>
            <pc:docMk/>
            <pc:sldMk cId="1513429835" sldId="296"/>
            <ac:spMk id="204" creationId="{8687C1B9-EBFD-D552-ADCB-19A002A7A50D}"/>
          </ac:spMkLst>
        </pc:spChg>
        <pc:spChg chg="mod">
          <ac:chgData name="Kumar, Vinod" userId="a0710a6e-bffc-4971-8893-1c23addeb5b0" providerId="ADAL" clId="{922FE477-A091-45D2-9AFE-0801C4DD56C7}" dt="2022-09-20T18:59:38.312" v="902" actId="1038"/>
          <ac:spMkLst>
            <pc:docMk/>
            <pc:sldMk cId="1513429835" sldId="296"/>
            <ac:spMk id="205" creationId="{E4EFEAB7-5134-0026-C710-5FC3142E8895}"/>
          </ac:spMkLst>
        </pc:spChg>
        <pc:spChg chg="mod">
          <ac:chgData name="Kumar, Vinod" userId="a0710a6e-bffc-4971-8893-1c23addeb5b0" providerId="ADAL" clId="{922FE477-A091-45D2-9AFE-0801C4DD56C7}" dt="2022-09-20T18:54:56.539" v="610" actId="1037"/>
          <ac:spMkLst>
            <pc:docMk/>
            <pc:sldMk cId="1513429835" sldId="296"/>
            <ac:spMk id="206" creationId="{5C4D2A22-6DF8-B093-6D60-91E6CBC59CC8}"/>
          </ac:spMkLst>
        </pc:spChg>
        <pc:spChg chg="mod">
          <ac:chgData name="Kumar, Vinod" userId="a0710a6e-bffc-4971-8893-1c23addeb5b0" providerId="ADAL" clId="{922FE477-A091-45D2-9AFE-0801C4DD56C7}" dt="2022-09-20T18:56:25.440" v="611"/>
          <ac:spMkLst>
            <pc:docMk/>
            <pc:sldMk cId="1513429835" sldId="296"/>
            <ac:spMk id="209" creationId="{4ABE6BA9-D095-F6E8-A696-B61C1634FFDC}"/>
          </ac:spMkLst>
        </pc:spChg>
        <pc:spChg chg="mod">
          <ac:chgData name="Kumar, Vinod" userId="a0710a6e-bffc-4971-8893-1c23addeb5b0" providerId="ADAL" clId="{922FE477-A091-45D2-9AFE-0801C4DD56C7}" dt="2022-09-20T18:56:25.440" v="611"/>
          <ac:spMkLst>
            <pc:docMk/>
            <pc:sldMk cId="1513429835" sldId="296"/>
            <ac:spMk id="212" creationId="{B0AF491A-8F4C-2EE0-8E7A-31A0F4B77720}"/>
          </ac:spMkLst>
        </pc:spChg>
        <pc:grpChg chg="add mod">
          <ac:chgData name="Kumar, Vinod" userId="a0710a6e-bffc-4971-8893-1c23addeb5b0" providerId="ADAL" clId="{922FE477-A091-45D2-9AFE-0801C4DD56C7}" dt="2022-09-20T18:45:52.930" v="326"/>
          <ac:grpSpMkLst>
            <pc:docMk/>
            <pc:sldMk cId="1513429835" sldId="296"/>
            <ac:grpSpMk id="3" creationId="{A282FD7F-7FDA-2B83-008F-473336365728}"/>
          </ac:grpSpMkLst>
        </pc:grpChg>
        <pc:grpChg chg="mod">
          <ac:chgData name="Kumar, Vinod" userId="a0710a6e-bffc-4971-8893-1c23addeb5b0" providerId="ADAL" clId="{922FE477-A091-45D2-9AFE-0801C4DD56C7}" dt="2022-09-20T18:45:52.930" v="326"/>
          <ac:grpSpMkLst>
            <pc:docMk/>
            <pc:sldMk cId="1513429835" sldId="296"/>
            <ac:grpSpMk id="9" creationId="{6CC966AD-37CC-B8EC-FF7C-B1C6A48D2682}"/>
          </ac:grpSpMkLst>
        </pc:grpChg>
        <pc:grpChg chg="add mod">
          <ac:chgData name="Kumar, Vinod" userId="a0710a6e-bffc-4971-8893-1c23addeb5b0" providerId="ADAL" clId="{922FE477-A091-45D2-9AFE-0801C4DD56C7}" dt="2022-09-20T18:45:52.930" v="326"/>
          <ac:grpSpMkLst>
            <pc:docMk/>
            <pc:sldMk cId="1513429835" sldId="296"/>
            <ac:grpSpMk id="17" creationId="{4D41A662-8270-C12E-CBAC-D18375B09C23}"/>
          </ac:grpSpMkLst>
        </pc:grpChg>
        <pc:grpChg chg="mod">
          <ac:chgData name="Kumar, Vinod" userId="a0710a6e-bffc-4971-8893-1c23addeb5b0" providerId="ADAL" clId="{922FE477-A091-45D2-9AFE-0801C4DD56C7}" dt="2022-09-20T18:45:52.930" v="326"/>
          <ac:grpSpMkLst>
            <pc:docMk/>
            <pc:sldMk cId="1513429835" sldId="296"/>
            <ac:grpSpMk id="19" creationId="{4C7F4C22-3335-5754-A6B0-D97F594DEEF7}"/>
          </ac:grpSpMkLst>
        </pc:grpChg>
        <pc:grpChg chg="add del mod">
          <ac:chgData name="Kumar, Vinod" userId="a0710a6e-bffc-4971-8893-1c23addeb5b0" providerId="ADAL" clId="{922FE477-A091-45D2-9AFE-0801C4DD56C7}" dt="2022-09-20T18:36:23.733" v="11" actId="478"/>
          <ac:grpSpMkLst>
            <pc:docMk/>
            <pc:sldMk cId="1513429835" sldId="296"/>
            <ac:grpSpMk id="30" creationId="{6A08A842-8140-D8D3-33E5-12F4BD9E90EA}"/>
          </ac:grpSpMkLst>
        </pc:grpChg>
        <pc:grpChg chg="add del mod">
          <ac:chgData name="Kumar, Vinod" userId="a0710a6e-bffc-4971-8893-1c23addeb5b0" providerId="ADAL" clId="{922FE477-A091-45D2-9AFE-0801C4DD56C7}" dt="2022-09-20T18:47:31.358" v="327" actId="478"/>
          <ac:grpSpMkLst>
            <pc:docMk/>
            <pc:sldMk cId="1513429835" sldId="296"/>
            <ac:grpSpMk id="45" creationId="{FB6D5C5C-2C87-1BC0-4066-0AD6135AEF7E}"/>
          </ac:grpSpMkLst>
        </pc:grpChg>
        <pc:grpChg chg="add del mod">
          <ac:chgData name="Kumar, Vinod" userId="a0710a6e-bffc-4971-8893-1c23addeb5b0" providerId="ADAL" clId="{922FE477-A091-45D2-9AFE-0801C4DD56C7}" dt="2022-09-20T18:47:31.358" v="327" actId="478"/>
          <ac:grpSpMkLst>
            <pc:docMk/>
            <pc:sldMk cId="1513429835" sldId="296"/>
            <ac:grpSpMk id="46" creationId="{009CF25A-1A0E-0DB8-6C2B-0AC42BCA68BC}"/>
          </ac:grpSpMkLst>
        </pc:grpChg>
        <pc:grpChg chg="add mod">
          <ac:chgData name="Kumar, Vinod" userId="a0710a6e-bffc-4971-8893-1c23addeb5b0" providerId="ADAL" clId="{922FE477-A091-45D2-9AFE-0801C4DD56C7}" dt="2022-09-20T18:45:52.930" v="326"/>
          <ac:grpSpMkLst>
            <pc:docMk/>
            <pc:sldMk cId="1513429835" sldId="296"/>
            <ac:grpSpMk id="47" creationId="{D15B87B6-8F9E-ADCB-9CB2-D7B960EA97DA}"/>
          </ac:grpSpMkLst>
        </pc:grpChg>
        <pc:grpChg chg="mod">
          <ac:chgData name="Kumar, Vinod" userId="a0710a6e-bffc-4971-8893-1c23addeb5b0" providerId="ADAL" clId="{922FE477-A091-45D2-9AFE-0801C4DD56C7}" dt="2022-09-20T18:45:52.930" v="326"/>
          <ac:grpSpMkLst>
            <pc:docMk/>
            <pc:sldMk cId="1513429835" sldId="296"/>
            <ac:grpSpMk id="49" creationId="{75684E78-E200-34B8-94F9-1B490F93390A}"/>
          </ac:grpSpMkLst>
        </pc:grpChg>
        <pc:grpChg chg="add mod">
          <ac:chgData name="Kumar, Vinod" userId="a0710a6e-bffc-4971-8893-1c23addeb5b0" providerId="ADAL" clId="{922FE477-A091-45D2-9AFE-0801C4DD56C7}" dt="2022-09-20T18:45:52.930" v="326"/>
          <ac:grpSpMkLst>
            <pc:docMk/>
            <pc:sldMk cId="1513429835" sldId="296"/>
            <ac:grpSpMk id="58" creationId="{62BB0F0D-C803-0588-6466-6190B431DF1C}"/>
          </ac:grpSpMkLst>
        </pc:grpChg>
        <pc:grpChg chg="add del mod">
          <ac:chgData name="Kumar, Vinod" userId="a0710a6e-bffc-4971-8893-1c23addeb5b0" providerId="ADAL" clId="{922FE477-A091-45D2-9AFE-0801C4DD56C7}" dt="2022-09-20T18:47:31.358" v="327" actId="478"/>
          <ac:grpSpMkLst>
            <pc:docMk/>
            <pc:sldMk cId="1513429835" sldId="296"/>
            <ac:grpSpMk id="72" creationId="{8352CC1E-03D5-5E72-DA90-5A1442E46FBA}"/>
          </ac:grpSpMkLst>
        </pc:grpChg>
        <pc:grpChg chg="add del mod">
          <ac:chgData name="Kumar, Vinod" userId="a0710a6e-bffc-4971-8893-1c23addeb5b0" providerId="ADAL" clId="{922FE477-A091-45D2-9AFE-0801C4DD56C7}" dt="2022-09-20T18:47:31.358" v="327" actId="478"/>
          <ac:grpSpMkLst>
            <pc:docMk/>
            <pc:sldMk cId="1513429835" sldId="296"/>
            <ac:grpSpMk id="73" creationId="{A6609E87-9384-B9A2-10B3-DFB371DD008B}"/>
          </ac:grpSpMkLst>
        </pc:grpChg>
        <pc:grpChg chg="add del mod">
          <ac:chgData name="Kumar, Vinod" userId="a0710a6e-bffc-4971-8893-1c23addeb5b0" providerId="ADAL" clId="{922FE477-A091-45D2-9AFE-0801C4DD56C7}" dt="2022-09-20T18:47:31.358" v="327" actId="478"/>
          <ac:grpSpMkLst>
            <pc:docMk/>
            <pc:sldMk cId="1513429835" sldId="296"/>
            <ac:grpSpMk id="74" creationId="{B64DC47C-7D33-AB79-463E-0F62E54986D7}"/>
          </ac:grpSpMkLst>
        </pc:grpChg>
        <pc:grpChg chg="mod">
          <ac:chgData name="Kumar, Vinod" userId="a0710a6e-bffc-4971-8893-1c23addeb5b0" providerId="ADAL" clId="{922FE477-A091-45D2-9AFE-0801C4DD56C7}" dt="2022-09-20T18:45:52.930" v="326"/>
          <ac:grpSpMkLst>
            <pc:docMk/>
            <pc:sldMk cId="1513429835" sldId="296"/>
            <ac:grpSpMk id="75" creationId="{EB02021D-6098-4287-380C-F46946CADACB}"/>
          </ac:grpSpMkLst>
        </pc:grpChg>
        <pc:grpChg chg="add del mod">
          <ac:chgData name="Kumar, Vinod" userId="a0710a6e-bffc-4971-8893-1c23addeb5b0" providerId="ADAL" clId="{922FE477-A091-45D2-9AFE-0801C4DD56C7}" dt="2022-09-20T18:47:31.358" v="327" actId="478"/>
          <ac:grpSpMkLst>
            <pc:docMk/>
            <pc:sldMk cId="1513429835" sldId="296"/>
            <ac:grpSpMk id="87" creationId="{216E6E9F-1F08-97D0-96C0-F42FCF48D928}"/>
          </ac:grpSpMkLst>
        </pc:grpChg>
        <pc:grpChg chg="mod">
          <ac:chgData name="Kumar, Vinod" userId="a0710a6e-bffc-4971-8893-1c23addeb5b0" providerId="ADAL" clId="{922FE477-A091-45D2-9AFE-0801C4DD56C7}" dt="2022-09-20T18:45:52.930" v="326"/>
          <ac:grpSpMkLst>
            <pc:docMk/>
            <pc:sldMk cId="1513429835" sldId="296"/>
            <ac:grpSpMk id="88" creationId="{36F8D88D-4C70-724F-BBAA-AC21FB9DED1C}"/>
          </ac:grpSpMkLst>
        </pc:grpChg>
        <pc:grpChg chg="mod">
          <ac:chgData name="Kumar, Vinod" userId="a0710a6e-bffc-4971-8893-1c23addeb5b0" providerId="ADAL" clId="{922FE477-A091-45D2-9AFE-0801C4DD56C7}" dt="2022-09-20T18:45:52.930" v="326"/>
          <ac:grpSpMkLst>
            <pc:docMk/>
            <pc:sldMk cId="1513429835" sldId="296"/>
            <ac:grpSpMk id="90" creationId="{BBAAEA50-2969-1723-CCDD-3E042E9D3AE4}"/>
          </ac:grpSpMkLst>
        </pc:grpChg>
        <pc:grpChg chg="add del mod">
          <ac:chgData name="Kumar, Vinod" userId="a0710a6e-bffc-4971-8893-1c23addeb5b0" providerId="ADAL" clId="{922FE477-A091-45D2-9AFE-0801C4DD56C7}" dt="2022-09-20T18:45:07.022" v="297"/>
          <ac:grpSpMkLst>
            <pc:docMk/>
            <pc:sldMk cId="1513429835" sldId="296"/>
            <ac:grpSpMk id="100" creationId="{B970E97A-530C-FE49-8789-6523A8914DDA}"/>
          </ac:grpSpMkLst>
        </pc:grpChg>
        <pc:grpChg chg="mod">
          <ac:chgData name="Kumar, Vinod" userId="a0710a6e-bffc-4971-8893-1c23addeb5b0" providerId="ADAL" clId="{922FE477-A091-45D2-9AFE-0801C4DD56C7}" dt="2022-09-20T18:45:05.875" v="295"/>
          <ac:grpSpMkLst>
            <pc:docMk/>
            <pc:sldMk cId="1513429835" sldId="296"/>
            <ac:grpSpMk id="101" creationId="{08598809-6CA7-BA94-46DA-8AC142CB38E8}"/>
          </ac:grpSpMkLst>
        </pc:grpChg>
        <pc:grpChg chg="add mod">
          <ac:chgData name="Kumar, Vinod" userId="a0710a6e-bffc-4971-8893-1c23addeb5b0" providerId="ADAL" clId="{922FE477-A091-45D2-9AFE-0801C4DD56C7}" dt="2022-09-20T19:00:31.670" v="926" actId="1035"/>
          <ac:grpSpMkLst>
            <pc:docMk/>
            <pc:sldMk cId="1513429835" sldId="296"/>
            <ac:grpSpMk id="112" creationId="{C88EDF49-F37E-DF1E-E095-3677A2C09FE8}"/>
          </ac:grpSpMkLst>
        </pc:grpChg>
        <pc:grpChg chg="mod">
          <ac:chgData name="Kumar, Vinod" userId="a0710a6e-bffc-4971-8893-1c23addeb5b0" providerId="ADAL" clId="{922FE477-A091-45D2-9AFE-0801C4DD56C7}" dt="2022-09-20T19:00:31.670" v="926" actId="1035"/>
          <ac:grpSpMkLst>
            <pc:docMk/>
            <pc:sldMk cId="1513429835" sldId="296"/>
            <ac:grpSpMk id="113" creationId="{F614A824-DA7E-BC20-2BAE-70463796781D}"/>
          </ac:grpSpMkLst>
        </pc:grpChg>
        <pc:grpChg chg="mod">
          <ac:chgData name="Kumar, Vinod" userId="a0710a6e-bffc-4971-8893-1c23addeb5b0" providerId="ADAL" clId="{922FE477-A091-45D2-9AFE-0801C4DD56C7}" dt="2022-09-20T19:00:31.670" v="926" actId="1035"/>
          <ac:grpSpMkLst>
            <pc:docMk/>
            <pc:sldMk cId="1513429835" sldId="296"/>
            <ac:grpSpMk id="120" creationId="{39F7DA56-C40A-78AF-0877-C7B5A94F2A40}"/>
          </ac:grpSpMkLst>
        </pc:grpChg>
        <pc:grpChg chg="add mod">
          <ac:chgData name="Kumar, Vinod" userId="a0710a6e-bffc-4971-8893-1c23addeb5b0" providerId="ADAL" clId="{922FE477-A091-45D2-9AFE-0801C4DD56C7}" dt="2022-09-20T19:00:31.670" v="926" actId="1035"/>
          <ac:grpSpMkLst>
            <pc:docMk/>
            <pc:sldMk cId="1513429835" sldId="296"/>
            <ac:grpSpMk id="128" creationId="{6228B59E-FD9C-0BE1-64FA-048250B7B0F1}"/>
          </ac:grpSpMkLst>
        </pc:grpChg>
        <pc:grpChg chg="mod">
          <ac:chgData name="Kumar, Vinod" userId="a0710a6e-bffc-4971-8893-1c23addeb5b0" providerId="ADAL" clId="{922FE477-A091-45D2-9AFE-0801C4DD56C7}" dt="2022-09-20T19:00:31.670" v="926" actId="1035"/>
          <ac:grpSpMkLst>
            <pc:docMk/>
            <pc:sldMk cId="1513429835" sldId="296"/>
            <ac:grpSpMk id="129" creationId="{41E56A81-D948-C22A-AB51-22C588E72106}"/>
          </ac:grpSpMkLst>
        </pc:grpChg>
        <pc:grpChg chg="mod">
          <ac:chgData name="Kumar, Vinod" userId="a0710a6e-bffc-4971-8893-1c23addeb5b0" providerId="ADAL" clId="{922FE477-A091-45D2-9AFE-0801C4DD56C7}" dt="2022-09-20T19:00:31.670" v="926" actId="1035"/>
          <ac:grpSpMkLst>
            <pc:docMk/>
            <pc:sldMk cId="1513429835" sldId="296"/>
            <ac:grpSpMk id="132" creationId="{6DD4B7D7-1366-C818-C791-F8D8F6729D1C}"/>
          </ac:grpSpMkLst>
        </pc:grpChg>
        <pc:grpChg chg="add mod">
          <ac:chgData name="Kumar, Vinod" userId="a0710a6e-bffc-4971-8893-1c23addeb5b0" providerId="ADAL" clId="{922FE477-A091-45D2-9AFE-0801C4DD56C7}" dt="2022-09-20T19:00:18.141" v="919" actId="1036"/>
          <ac:grpSpMkLst>
            <pc:docMk/>
            <pc:sldMk cId="1513429835" sldId="296"/>
            <ac:grpSpMk id="143" creationId="{092825CF-5AF8-6F53-3DDC-811FBD39496E}"/>
          </ac:grpSpMkLst>
        </pc:grpChg>
        <pc:grpChg chg="mod">
          <ac:chgData name="Kumar, Vinod" userId="a0710a6e-bffc-4971-8893-1c23addeb5b0" providerId="ADAL" clId="{922FE477-A091-45D2-9AFE-0801C4DD56C7}" dt="2022-09-20T18:50:58.820" v="364"/>
          <ac:grpSpMkLst>
            <pc:docMk/>
            <pc:sldMk cId="1513429835" sldId="296"/>
            <ac:grpSpMk id="144" creationId="{219A7081-6BC6-3110-84E9-8C2DFC1C52A2}"/>
          </ac:grpSpMkLst>
        </pc:grpChg>
        <pc:grpChg chg="add mod">
          <ac:chgData name="Kumar, Vinod" userId="a0710a6e-bffc-4971-8893-1c23addeb5b0" providerId="ADAL" clId="{922FE477-A091-45D2-9AFE-0801C4DD56C7}" dt="2022-09-20T19:00:18.141" v="919" actId="1036"/>
          <ac:grpSpMkLst>
            <pc:docMk/>
            <pc:sldMk cId="1513429835" sldId="296"/>
            <ac:grpSpMk id="157" creationId="{AA3D57A1-3510-5912-4D1E-8BCF5C6B0EE5}"/>
          </ac:grpSpMkLst>
        </pc:grpChg>
        <pc:grpChg chg="mod">
          <ac:chgData name="Kumar, Vinod" userId="a0710a6e-bffc-4971-8893-1c23addeb5b0" providerId="ADAL" clId="{922FE477-A091-45D2-9AFE-0801C4DD56C7}" dt="2022-09-20T18:50:58.820" v="364"/>
          <ac:grpSpMkLst>
            <pc:docMk/>
            <pc:sldMk cId="1513429835" sldId="296"/>
            <ac:grpSpMk id="158" creationId="{CC97FC6C-4FAE-0D30-7835-E545987D49D5}"/>
          </ac:grpSpMkLst>
        </pc:grpChg>
        <pc:grpChg chg="mod">
          <ac:chgData name="Kumar, Vinod" userId="a0710a6e-bffc-4971-8893-1c23addeb5b0" providerId="ADAL" clId="{922FE477-A091-45D2-9AFE-0801C4DD56C7}" dt="2022-09-20T18:50:58.820" v="364"/>
          <ac:grpSpMkLst>
            <pc:docMk/>
            <pc:sldMk cId="1513429835" sldId="296"/>
            <ac:grpSpMk id="161" creationId="{9F1C7B66-FE79-1E43-FFDE-ECB99846F3F7}"/>
          </ac:grpSpMkLst>
        </pc:grpChg>
        <pc:grpChg chg="add mod">
          <ac:chgData name="Kumar, Vinod" userId="a0710a6e-bffc-4971-8893-1c23addeb5b0" providerId="ADAL" clId="{922FE477-A091-45D2-9AFE-0801C4DD56C7}" dt="2022-09-20T19:00:10.371" v="911" actId="1036"/>
          <ac:grpSpMkLst>
            <pc:docMk/>
            <pc:sldMk cId="1513429835" sldId="296"/>
            <ac:grpSpMk id="170" creationId="{6E2F71A3-5338-C2BF-CA23-0D2A148E14AE}"/>
          </ac:grpSpMkLst>
        </pc:grpChg>
        <pc:grpChg chg="mod">
          <ac:chgData name="Kumar, Vinod" userId="a0710a6e-bffc-4971-8893-1c23addeb5b0" providerId="ADAL" clId="{922FE477-A091-45D2-9AFE-0801C4DD56C7}" dt="2022-09-20T18:51:46.948" v="510"/>
          <ac:grpSpMkLst>
            <pc:docMk/>
            <pc:sldMk cId="1513429835" sldId="296"/>
            <ac:grpSpMk id="171" creationId="{73BABDFA-9595-0F4C-FDE5-F3DB909A320C}"/>
          </ac:grpSpMkLst>
        </pc:grpChg>
        <pc:grpChg chg="add mod">
          <ac:chgData name="Kumar, Vinod" userId="a0710a6e-bffc-4971-8893-1c23addeb5b0" providerId="ADAL" clId="{922FE477-A091-45D2-9AFE-0801C4DD56C7}" dt="2022-09-20T19:00:10.371" v="911" actId="1036"/>
          <ac:grpSpMkLst>
            <pc:docMk/>
            <pc:sldMk cId="1513429835" sldId="296"/>
            <ac:grpSpMk id="183" creationId="{1B7DE042-922A-7994-B103-57307CC27B6A}"/>
          </ac:grpSpMkLst>
        </pc:grpChg>
        <pc:grpChg chg="mod">
          <ac:chgData name="Kumar, Vinod" userId="a0710a6e-bffc-4971-8893-1c23addeb5b0" providerId="ADAL" clId="{922FE477-A091-45D2-9AFE-0801C4DD56C7}" dt="2022-09-20T18:51:46.948" v="510"/>
          <ac:grpSpMkLst>
            <pc:docMk/>
            <pc:sldMk cId="1513429835" sldId="296"/>
            <ac:grpSpMk id="184" creationId="{3726481C-FCCF-F40F-13AD-85325814045B}"/>
          </ac:grpSpMkLst>
        </pc:grpChg>
        <pc:grpChg chg="mod">
          <ac:chgData name="Kumar, Vinod" userId="a0710a6e-bffc-4971-8893-1c23addeb5b0" providerId="ADAL" clId="{922FE477-A091-45D2-9AFE-0801C4DD56C7}" dt="2022-09-20T18:51:46.948" v="510"/>
          <ac:grpSpMkLst>
            <pc:docMk/>
            <pc:sldMk cId="1513429835" sldId="296"/>
            <ac:grpSpMk id="186" creationId="{9B5CEFEA-0DBC-5553-008F-6CDCC1881B54}"/>
          </ac:grpSpMkLst>
        </pc:grpChg>
        <pc:grpChg chg="add mod">
          <ac:chgData name="Kumar, Vinod" userId="a0710a6e-bffc-4971-8893-1c23addeb5b0" providerId="ADAL" clId="{922FE477-A091-45D2-9AFE-0801C4DD56C7}" dt="2022-09-20T19:00:10.371" v="911" actId="1036"/>
          <ac:grpSpMkLst>
            <pc:docMk/>
            <pc:sldMk cId="1513429835" sldId="296"/>
            <ac:grpSpMk id="196" creationId="{2C4678AB-C3F5-9B96-5057-BBF941C1C877}"/>
          </ac:grpSpMkLst>
        </pc:grpChg>
        <pc:grpChg chg="mod">
          <ac:chgData name="Kumar, Vinod" userId="a0710a6e-bffc-4971-8893-1c23addeb5b0" providerId="ADAL" clId="{922FE477-A091-45D2-9AFE-0801C4DD56C7}" dt="2022-09-20T18:52:24.081" v="554"/>
          <ac:grpSpMkLst>
            <pc:docMk/>
            <pc:sldMk cId="1513429835" sldId="296"/>
            <ac:grpSpMk id="197" creationId="{08A95000-F8D0-CB11-684E-CD20AFB2EE56}"/>
          </ac:grpSpMkLst>
        </pc:grpChg>
        <pc:grpChg chg="add mod">
          <ac:chgData name="Kumar, Vinod" userId="a0710a6e-bffc-4971-8893-1c23addeb5b0" providerId="ADAL" clId="{922FE477-A091-45D2-9AFE-0801C4DD56C7}" dt="2022-09-20T19:00:40.552" v="930" actId="1035"/>
          <ac:grpSpMkLst>
            <pc:docMk/>
            <pc:sldMk cId="1513429835" sldId="296"/>
            <ac:grpSpMk id="207" creationId="{81E18EDB-5CE7-BF5F-398F-42F58D018FD3}"/>
          </ac:grpSpMkLst>
        </pc:grpChg>
        <pc:grpChg chg="add mod">
          <ac:chgData name="Kumar, Vinod" userId="a0710a6e-bffc-4971-8893-1c23addeb5b0" providerId="ADAL" clId="{922FE477-A091-45D2-9AFE-0801C4DD56C7}" dt="2022-09-20T19:00:40.552" v="930" actId="1035"/>
          <ac:grpSpMkLst>
            <pc:docMk/>
            <pc:sldMk cId="1513429835" sldId="296"/>
            <ac:grpSpMk id="210" creationId="{09C704EE-53C6-65F7-B0A6-AA85B9B3B7BE}"/>
          </ac:grpSpMkLst>
        </pc:grp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1513429835" sldId="296"/>
            <ac:picMk id="15" creationId="{CA802676-9839-B914-FF24-54917C112D0C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1513429835" sldId="296"/>
            <ac:picMk id="16" creationId="{48B85F96-1BF6-570A-03E0-CF1C84E50A12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1513429835" sldId="296"/>
            <ac:picMk id="20" creationId="{17AE4374-D958-C4E0-367D-B44EA15BCC14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1513429835" sldId="296"/>
            <ac:picMk id="21" creationId="{27312AAB-0A43-7550-BB12-1D2CD101E078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1513429835" sldId="296"/>
            <ac:picMk id="22" creationId="{1A253E48-D1AC-AA92-098E-71B7A5D31C2C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1513429835" sldId="296"/>
            <ac:picMk id="23" creationId="{FCA6172F-FE47-990D-1A38-701C63E6DD9A}"/>
          </ac:picMkLst>
        </pc:picChg>
        <pc:picChg chg="mod">
          <ac:chgData name="Kumar, Vinod" userId="a0710a6e-bffc-4971-8893-1c23addeb5b0" providerId="ADAL" clId="{922FE477-A091-45D2-9AFE-0801C4DD56C7}" dt="2022-09-20T18:35:23.902" v="10"/>
          <ac:picMkLst>
            <pc:docMk/>
            <pc:sldMk cId="1513429835" sldId="296"/>
            <ac:picMk id="31" creationId="{39F7C0CB-5446-CE0A-E5B3-BAF065D59955}"/>
          </ac:picMkLst>
        </pc:picChg>
        <pc:picChg chg="mod">
          <ac:chgData name="Kumar, Vinod" userId="a0710a6e-bffc-4971-8893-1c23addeb5b0" providerId="ADAL" clId="{922FE477-A091-45D2-9AFE-0801C4DD56C7}" dt="2022-09-20T18:35:23.902" v="10"/>
          <ac:picMkLst>
            <pc:docMk/>
            <pc:sldMk cId="1513429835" sldId="296"/>
            <ac:picMk id="32" creationId="{86385803-E9A5-E213-830B-4A52EF778B4F}"/>
          </ac:picMkLst>
        </pc:picChg>
        <pc:picChg chg="mod">
          <ac:chgData name="Kumar, Vinod" userId="a0710a6e-bffc-4971-8893-1c23addeb5b0" providerId="ADAL" clId="{922FE477-A091-45D2-9AFE-0801C4DD56C7}" dt="2022-09-20T18:35:23.902" v="10"/>
          <ac:picMkLst>
            <pc:docMk/>
            <pc:sldMk cId="1513429835" sldId="296"/>
            <ac:picMk id="33" creationId="{E0BE5ED3-211E-5D2E-396A-DC5220CAFDFA}"/>
          </ac:picMkLst>
        </pc:picChg>
        <pc:picChg chg="mod">
          <ac:chgData name="Kumar, Vinod" userId="a0710a6e-bffc-4971-8893-1c23addeb5b0" providerId="ADAL" clId="{922FE477-A091-45D2-9AFE-0801C4DD56C7}" dt="2022-09-20T18:35:23.902" v="10"/>
          <ac:picMkLst>
            <pc:docMk/>
            <pc:sldMk cId="1513429835" sldId="296"/>
            <ac:picMk id="34" creationId="{1E99854B-7ED5-34C6-4724-8921DC105F22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1513429835" sldId="296"/>
            <ac:picMk id="52" creationId="{EDB49547-77E9-254A-3FDE-A81F2CC795AE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1513429835" sldId="296"/>
            <ac:picMk id="53" creationId="{7EA556C9-17B8-EBD2-C0F5-0919A139890F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1513429835" sldId="296"/>
            <ac:picMk id="55" creationId="{067A6710-B5C0-2C38-73B3-6B946B329F00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1513429835" sldId="296"/>
            <ac:picMk id="59" creationId="{E43E35C8-CAB7-D7FA-F786-45A1364C9C0E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1513429835" sldId="296"/>
            <ac:picMk id="60" creationId="{18E58C50-0210-A572-7615-066255057F74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1513429835" sldId="296"/>
            <ac:picMk id="61" creationId="{358341CD-E27E-0133-DA1F-A347D67AAABA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1513429835" sldId="296"/>
            <ac:picMk id="62" creationId="{36DF0B09-4A17-1C1B-78DD-D9B8B4EB68D7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1513429835" sldId="296"/>
            <ac:picMk id="83" creationId="{488516C7-43B7-FD58-1968-90C98143209B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1513429835" sldId="296"/>
            <ac:picMk id="86" creationId="{775FBCA5-6492-67CF-91F0-1C3DCE6DA797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1513429835" sldId="296"/>
            <ac:picMk id="92" creationId="{9C205DD1-5785-863C-DF02-5865B3B62BDF}"/>
          </ac:picMkLst>
        </pc:picChg>
        <pc:picChg chg="mod">
          <ac:chgData name="Kumar, Vinod" userId="a0710a6e-bffc-4971-8893-1c23addeb5b0" providerId="ADAL" clId="{922FE477-A091-45D2-9AFE-0801C4DD56C7}" dt="2022-09-20T18:45:52.930" v="326"/>
          <ac:picMkLst>
            <pc:docMk/>
            <pc:sldMk cId="1513429835" sldId="296"/>
            <ac:picMk id="99" creationId="{950053F8-DCB1-7B0F-B20E-83757D0083B0}"/>
          </ac:picMkLst>
        </pc:picChg>
        <pc:picChg chg="mod">
          <ac:chgData name="Kumar, Vinod" userId="a0710a6e-bffc-4971-8893-1c23addeb5b0" providerId="ADAL" clId="{922FE477-A091-45D2-9AFE-0801C4DD56C7}" dt="2022-09-20T18:45:05.875" v="295"/>
          <ac:picMkLst>
            <pc:docMk/>
            <pc:sldMk cId="1513429835" sldId="296"/>
            <ac:picMk id="103" creationId="{CCE0592B-9236-E087-999E-0852F4D19193}"/>
          </ac:picMkLst>
        </pc:picChg>
        <pc:picChg chg="mod">
          <ac:chgData name="Kumar, Vinod" userId="a0710a6e-bffc-4971-8893-1c23addeb5b0" providerId="ADAL" clId="{922FE477-A091-45D2-9AFE-0801C4DD56C7}" dt="2022-09-20T18:45:05.875" v="295"/>
          <ac:picMkLst>
            <pc:docMk/>
            <pc:sldMk cId="1513429835" sldId="296"/>
            <ac:picMk id="104" creationId="{3592A05E-4080-6AC4-9D6D-CFA6F6E56BBF}"/>
          </ac:picMkLst>
        </pc:picChg>
        <pc:picChg chg="mod">
          <ac:chgData name="Kumar, Vinod" userId="a0710a6e-bffc-4971-8893-1c23addeb5b0" providerId="ADAL" clId="{922FE477-A091-45D2-9AFE-0801C4DD56C7}" dt="2022-09-20T18:45:05.875" v="295"/>
          <ac:picMkLst>
            <pc:docMk/>
            <pc:sldMk cId="1513429835" sldId="296"/>
            <ac:picMk id="105" creationId="{6AB57129-EBBD-2E8B-4476-1017007678AC}"/>
          </ac:picMkLst>
        </pc:picChg>
        <pc:picChg chg="mod">
          <ac:chgData name="Kumar, Vinod" userId="a0710a6e-bffc-4971-8893-1c23addeb5b0" providerId="ADAL" clId="{922FE477-A091-45D2-9AFE-0801C4DD56C7}" dt="2022-09-20T19:00:31.670" v="926" actId="1035"/>
          <ac:picMkLst>
            <pc:docMk/>
            <pc:sldMk cId="1513429835" sldId="296"/>
            <ac:picMk id="126" creationId="{8B5F09EB-3888-292D-2AAA-33A22B31FA63}"/>
          </ac:picMkLst>
        </pc:picChg>
        <pc:picChg chg="mod">
          <ac:chgData name="Kumar, Vinod" userId="a0710a6e-bffc-4971-8893-1c23addeb5b0" providerId="ADAL" clId="{922FE477-A091-45D2-9AFE-0801C4DD56C7}" dt="2022-09-20T19:00:31.670" v="926" actId="1035"/>
          <ac:picMkLst>
            <pc:docMk/>
            <pc:sldMk cId="1513429835" sldId="296"/>
            <ac:picMk id="127" creationId="{B4745E63-AAA6-C33D-645A-75213F9DC643}"/>
          </ac:picMkLst>
        </pc:picChg>
        <pc:picChg chg="mod">
          <ac:chgData name="Kumar, Vinod" userId="a0710a6e-bffc-4971-8893-1c23addeb5b0" providerId="ADAL" clId="{922FE477-A091-45D2-9AFE-0801C4DD56C7}" dt="2022-09-20T19:00:31.670" v="926" actId="1035"/>
          <ac:picMkLst>
            <pc:docMk/>
            <pc:sldMk cId="1513429835" sldId="296"/>
            <ac:picMk id="133" creationId="{6BB21D46-74AD-33DD-20B9-5B2345822439}"/>
          </ac:picMkLst>
        </pc:picChg>
        <pc:picChg chg="mod">
          <ac:chgData name="Kumar, Vinod" userId="a0710a6e-bffc-4971-8893-1c23addeb5b0" providerId="ADAL" clId="{922FE477-A091-45D2-9AFE-0801C4DD56C7}" dt="2022-09-20T19:00:31.670" v="926" actId="1035"/>
          <ac:picMkLst>
            <pc:docMk/>
            <pc:sldMk cId="1513429835" sldId="296"/>
            <ac:picMk id="134" creationId="{E4E11DEA-AC96-F4B9-9387-900AC134509F}"/>
          </ac:picMkLst>
        </pc:picChg>
        <pc:picChg chg="mod">
          <ac:chgData name="Kumar, Vinod" userId="a0710a6e-bffc-4971-8893-1c23addeb5b0" providerId="ADAL" clId="{922FE477-A091-45D2-9AFE-0801C4DD56C7}" dt="2022-09-20T19:00:31.670" v="926" actId="1035"/>
          <ac:picMkLst>
            <pc:docMk/>
            <pc:sldMk cId="1513429835" sldId="296"/>
            <ac:picMk id="135" creationId="{9EECE7A6-60F4-87A9-3708-673BABB77DBD}"/>
          </ac:picMkLst>
        </pc:picChg>
        <pc:picChg chg="mod">
          <ac:chgData name="Kumar, Vinod" userId="a0710a6e-bffc-4971-8893-1c23addeb5b0" providerId="ADAL" clId="{922FE477-A091-45D2-9AFE-0801C4DD56C7}" dt="2022-09-20T19:00:31.670" v="926" actId="1035"/>
          <ac:picMkLst>
            <pc:docMk/>
            <pc:sldMk cId="1513429835" sldId="296"/>
            <ac:picMk id="136" creationId="{5C9E7C40-7B09-628A-75B8-D1FC1EA21EB2}"/>
          </ac:picMkLst>
        </pc:picChg>
        <pc:picChg chg="mod">
          <ac:chgData name="Kumar, Vinod" userId="a0710a6e-bffc-4971-8893-1c23addeb5b0" providerId="ADAL" clId="{922FE477-A091-45D2-9AFE-0801C4DD56C7}" dt="2022-09-20T18:50:58.820" v="364"/>
          <ac:picMkLst>
            <pc:docMk/>
            <pc:sldMk cId="1513429835" sldId="296"/>
            <ac:picMk id="146" creationId="{A9B3B443-A127-1CFD-8EB8-F5E137063352}"/>
          </ac:picMkLst>
        </pc:picChg>
        <pc:picChg chg="mod">
          <ac:chgData name="Kumar, Vinod" userId="a0710a6e-bffc-4971-8893-1c23addeb5b0" providerId="ADAL" clId="{922FE477-A091-45D2-9AFE-0801C4DD56C7}" dt="2022-09-20T18:50:58.820" v="364"/>
          <ac:picMkLst>
            <pc:docMk/>
            <pc:sldMk cId="1513429835" sldId="296"/>
            <ac:picMk id="147" creationId="{9E4D7423-4221-BEA7-00D2-B6F406A48C85}"/>
          </ac:picMkLst>
        </pc:picChg>
        <pc:picChg chg="mod">
          <ac:chgData name="Kumar, Vinod" userId="a0710a6e-bffc-4971-8893-1c23addeb5b0" providerId="ADAL" clId="{922FE477-A091-45D2-9AFE-0801C4DD56C7}" dt="2022-09-20T18:50:58.820" v="364"/>
          <ac:picMkLst>
            <pc:docMk/>
            <pc:sldMk cId="1513429835" sldId="296"/>
            <ac:picMk id="148" creationId="{2524235C-475E-B8AA-303D-06735451E44E}"/>
          </ac:picMkLst>
        </pc:picChg>
        <pc:picChg chg="mod">
          <ac:chgData name="Kumar, Vinod" userId="a0710a6e-bffc-4971-8893-1c23addeb5b0" providerId="ADAL" clId="{922FE477-A091-45D2-9AFE-0801C4DD56C7}" dt="2022-09-20T18:50:58.820" v="364"/>
          <ac:picMkLst>
            <pc:docMk/>
            <pc:sldMk cId="1513429835" sldId="296"/>
            <ac:picMk id="149" creationId="{D31ABD3F-5AEF-08E2-881F-E78E2955477C}"/>
          </ac:picMkLst>
        </pc:picChg>
        <pc:picChg chg="mod">
          <ac:chgData name="Kumar, Vinod" userId="a0710a6e-bffc-4971-8893-1c23addeb5b0" providerId="ADAL" clId="{922FE477-A091-45D2-9AFE-0801C4DD56C7}" dt="2022-09-20T18:50:58.820" v="364"/>
          <ac:picMkLst>
            <pc:docMk/>
            <pc:sldMk cId="1513429835" sldId="296"/>
            <ac:picMk id="164" creationId="{ECA4E429-64D9-8987-40E7-807467843659}"/>
          </ac:picMkLst>
        </pc:picChg>
        <pc:picChg chg="mod">
          <ac:chgData name="Kumar, Vinod" userId="a0710a6e-bffc-4971-8893-1c23addeb5b0" providerId="ADAL" clId="{922FE477-A091-45D2-9AFE-0801C4DD56C7}" dt="2022-09-20T18:50:58.820" v="364"/>
          <ac:picMkLst>
            <pc:docMk/>
            <pc:sldMk cId="1513429835" sldId="296"/>
            <ac:picMk id="165" creationId="{1109FEFA-06B1-FC75-6BED-8DC550442DB8}"/>
          </ac:picMkLst>
        </pc:picChg>
        <pc:picChg chg="mod">
          <ac:chgData name="Kumar, Vinod" userId="a0710a6e-bffc-4971-8893-1c23addeb5b0" providerId="ADAL" clId="{922FE477-A091-45D2-9AFE-0801C4DD56C7}" dt="2022-09-20T18:50:58.820" v="364"/>
          <ac:picMkLst>
            <pc:docMk/>
            <pc:sldMk cId="1513429835" sldId="296"/>
            <ac:picMk id="167" creationId="{3177AAA6-8924-0000-4CAE-9A12920291B6}"/>
          </ac:picMkLst>
        </pc:picChg>
        <pc:picChg chg="mod">
          <ac:chgData name="Kumar, Vinod" userId="a0710a6e-bffc-4971-8893-1c23addeb5b0" providerId="ADAL" clId="{922FE477-A091-45D2-9AFE-0801C4DD56C7}" dt="2022-09-20T18:51:46.948" v="510"/>
          <ac:picMkLst>
            <pc:docMk/>
            <pc:sldMk cId="1513429835" sldId="296"/>
            <ac:picMk id="179" creationId="{7E3A8902-3D9A-1B3A-16E7-10FFD1326759}"/>
          </ac:picMkLst>
        </pc:picChg>
        <pc:picChg chg="mod">
          <ac:chgData name="Kumar, Vinod" userId="a0710a6e-bffc-4971-8893-1c23addeb5b0" providerId="ADAL" clId="{922FE477-A091-45D2-9AFE-0801C4DD56C7}" dt="2022-09-20T18:51:46.948" v="510"/>
          <ac:picMkLst>
            <pc:docMk/>
            <pc:sldMk cId="1513429835" sldId="296"/>
            <ac:picMk id="182" creationId="{450D1257-7022-0E83-3FC5-0074BC840755}"/>
          </ac:picMkLst>
        </pc:picChg>
        <pc:picChg chg="mod">
          <ac:chgData name="Kumar, Vinod" userId="a0710a6e-bffc-4971-8893-1c23addeb5b0" providerId="ADAL" clId="{922FE477-A091-45D2-9AFE-0801C4DD56C7}" dt="2022-09-20T18:51:46.948" v="510"/>
          <ac:picMkLst>
            <pc:docMk/>
            <pc:sldMk cId="1513429835" sldId="296"/>
            <ac:picMk id="188" creationId="{D8CC0F74-181B-D48B-4C0C-2976ABBC4439}"/>
          </ac:picMkLst>
        </pc:picChg>
        <pc:picChg chg="mod">
          <ac:chgData name="Kumar, Vinod" userId="a0710a6e-bffc-4971-8893-1c23addeb5b0" providerId="ADAL" clId="{922FE477-A091-45D2-9AFE-0801C4DD56C7}" dt="2022-09-20T18:51:46.948" v="510"/>
          <ac:picMkLst>
            <pc:docMk/>
            <pc:sldMk cId="1513429835" sldId="296"/>
            <ac:picMk id="195" creationId="{C1B4C22C-A06C-4B9A-BE29-9CE99FAFD77D}"/>
          </ac:picMkLst>
        </pc:picChg>
        <pc:picChg chg="mod">
          <ac:chgData name="Kumar, Vinod" userId="a0710a6e-bffc-4971-8893-1c23addeb5b0" providerId="ADAL" clId="{922FE477-A091-45D2-9AFE-0801C4DD56C7}" dt="2022-09-20T18:52:24.081" v="554"/>
          <ac:picMkLst>
            <pc:docMk/>
            <pc:sldMk cId="1513429835" sldId="296"/>
            <ac:picMk id="199" creationId="{D0F6B27C-CA07-F68A-34A8-052C9F35A54C}"/>
          </ac:picMkLst>
        </pc:picChg>
        <pc:picChg chg="mod">
          <ac:chgData name="Kumar, Vinod" userId="a0710a6e-bffc-4971-8893-1c23addeb5b0" providerId="ADAL" clId="{922FE477-A091-45D2-9AFE-0801C4DD56C7}" dt="2022-09-20T18:52:24.081" v="554"/>
          <ac:picMkLst>
            <pc:docMk/>
            <pc:sldMk cId="1513429835" sldId="296"/>
            <ac:picMk id="200" creationId="{1E420504-63E9-E940-D3A6-654A616DBA18}"/>
          </ac:picMkLst>
        </pc:picChg>
        <pc:picChg chg="mod">
          <ac:chgData name="Kumar, Vinod" userId="a0710a6e-bffc-4971-8893-1c23addeb5b0" providerId="ADAL" clId="{922FE477-A091-45D2-9AFE-0801C4DD56C7}" dt="2022-09-20T18:52:24.081" v="554"/>
          <ac:picMkLst>
            <pc:docMk/>
            <pc:sldMk cId="1513429835" sldId="296"/>
            <ac:picMk id="201" creationId="{159C432F-761C-AE0A-3AC5-B87F45BA0A89}"/>
          </ac:picMkLst>
        </pc:picChg>
        <pc:picChg chg="mod">
          <ac:chgData name="Kumar, Vinod" userId="a0710a6e-bffc-4971-8893-1c23addeb5b0" providerId="ADAL" clId="{922FE477-A091-45D2-9AFE-0801C4DD56C7}" dt="2022-09-20T18:56:25.440" v="611"/>
          <ac:picMkLst>
            <pc:docMk/>
            <pc:sldMk cId="1513429835" sldId="296"/>
            <ac:picMk id="208" creationId="{3169485E-7F97-7D3A-05E0-9D7B13B70C1A}"/>
          </ac:picMkLst>
        </pc:picChg>
        <pc:picChg chg="mod">
          <ac:chgData name="Kumar, Vinod" userId="a0710a6e-bffc-4971-8893-1c23addeb5b0" providerId="ADAL" clId="{922FE477-A091-45D2-9AFE-0801C4DD56C7}" dt="2022-09-20T18:56:25.440" v="611"/>
          <ac:picMkLst>
            <pc:docMk/>
            <pc:sldMk cId="1513429835" sldId="296"/>
            <ac:picMk id="211" creationId="{F54D56F9-3BA2-5618-1F99-5F5706F87163}"/>
          </ac:picMkLst>
        </pc:picChg>
        <pc:cxnChg chg="mod">
          <ac:chgData name="Kumar, Vinod" userId="a0710a6e-bffc-4971-8893-1c23addeb5b0" providerId="ADAL" clId="{922FE477-A091-45D2-9AFE-0801C4DD56C7}" dt="2022-09-20T18:45:52.930" v="326"/>
          <ac:cxnSpMkLst>
            <pc:docMk/>
            <pc:sldMk cId="1513429835" sldId="296"/>
            <ac:cxnSpMk id="10" creationId="{BA7C6D94-4A79-90D4-3869-F7D6A9ABF35D}"/>
          </ac:cxnSpMkLst>
        </pc:cxnChg>
        <pc:cxnChg chg="mod">
          <ac:chgData name="Kumar, Vinod" userId="a0710a6e-bffc-4971-8893-1c23addeb5b0" providerId="ADAL" clId="{922FE477-A091-45D2-9AFE-0801C4DD56C7}" dt="2022-09-20T18:45:52.930" v="326"/>
          <ac:cxnSpMkLst>
            <pc:docMk/>
            <pc:sldMk cId="1513429835" sldId="296"/>
            <ac:cxnSpMk id="11" creationId="{FEC7D964-8D92-176D-0DBE-FC78605A5885}"/>
          </ac:cxnSpMkLst>
        </pc:cxnChg>
        <pc:cxnChg chg="mod">
          <ac:chgData name="Kumar, Vinod" userId="a0710a6e-bffc-4971-8893-1c23addeb5b0" providerId="ADAL" clId="{922FE477-A091-45D2-9AFE-0801C4DD56C7}" dt="2022-09-20T18:45:52.930" v="326"/>
          <ac:cxnSpMkLst>
            <pc:docMk/>
            <pc:sldMk cId="1513429835" sldId="296"/>
            <ac:cxnSpMk id="26" creationId="{24AE6ED4-129C-D44C-B910-80B2142AE6BD}"/>
          </ac:cxnSpMkLst>
        </pc:cxnChg>
        <pc:cxnChg chg="mod">
          <ac:chgData name="Kumar, Vinod" userId="a0710a6e-bffc-4971-8893-1c23addeb5b0" providerId="ADAL" clId="{922FE477-A091-45D2-9AFE-0801C4DD56C7}" dt="2022-09-20T18:35:23.902" v="10"/>
          <ac:cxnSpMkLst>
            <pc:docMk/>
            <pc:sldMk cId="1513429835" sldId="296"/>
            <ac:cxnSpMk id="38" creationId="{2B852C86-1FC0-28F3-D965-80A0EAC4DCA0}"/>
          </ac:cxnSpMkLst>
        </pc:cxnChg>
        <pc:cxnChg chg="mod">
          <ac:chgData name="Kumar, Vinod" userId="a0710a6e-bffc-4971-8893-1c23addeb5b0" providerId="ADAL" clId="{922FE477-A091-45D2-9AFE-0801C4DD56C7}" dt="2022-09-20T18:45:52.930" v="326"/>
          <ac:cxnSpMkLst>
            <pc:docMk/>
            <pc:sldMk cId="1513429835" sldId="296"/>
            <ac:cxnSpMk id="57" creationId="{A2394C52-804B-63FB-66F3-D4A87829E906}"/>
          </ac:cxnSpMkLst>
        </pc:cxnChg>
        <pc:cxnChg chg="mod">
          <ac:chgData name="Kumar, Vinod" userId="a0710a6e-bffc-4971-8893-1c23addeb5b0" providerId="ADAL" clId="{922FE477-A091-45D2-9AFE-0801C4DD56C7}" dt="2022-09-20T18:45:52.930" v="326"/>
          <ac:cxnSpMkLst>
            <pc:docMk/>
            <pc:sldMk cId="1513429835" sldId="296"/>
            <ac:cxnSpMk id="66" creationId="{C28AFA18-C929-C07C-F0AE-88B7D09505C8}"/>
          </ac:cxnSpMkLst>
        </pc:cxnChg>
        <pc:cxnChg chg="mod">
          <ac:chgData name="Kumar, Vinod" userId="a0710a6e-bffc-4971-8893-1c23addeb5b0" providerId="ADAL" clId="{922FE477-A091-45D2-9AFE-0801C4DD56C7}" dt="2022-09-20T18:45:52.930" v="326"/>
          <ac:cxnSpMkLst>
            <pc:docMk/>
            <pc:sldMk cId="1513429835" sldId="296"/>
            <ac:cxnSpMk id="78" creationId="{09073433-C689-5141-892E-A98A306E5A3B}"/>
          </ac:cxnSpMkLst>
        </pc:cxnChg>
        <pc:cxnChg chg="mod">
          <ac:chgData name="Kumar, Vinod" userId="a0710a6e-bffc-4971-8893-1c23addeb5b0" providerId="ADAL" clId="{922FE477-A091-45D2-9AFE-0801C4DD56C7}" dt="2022-09-20T18:45:52.930" v="326"/>
          <ac:cxnSpMkLst>
            <pc:docMk/>
            <pc:sldMk cId="1513429835" sldId="296"/>
            <ac:cxnSpMk id="79" creationId="{0D0371F8-DEDB-4A55-56EC-70776D2A1AE7}"/>
          </ac:cxnSpMkLst>
        </pc:cxnChg>
        <pc:cxnChg chg="mod">
          <ac:chgData name="Kumar, Vinod" userId="a0710a6e-bffc-4971-8893-1c23addeb5b0" providerId="ADAL" clId="{922FE477-A091-45D2-9AFE-0801C4DD56C7}" dt="2022-09-20T18:45:52.930" v="326"/>
          <ac:cxnSpMkLst>
            <pc:docMk/>
            <pc:sldMk cId="1513429835" sldId="296"/>
            <ac:cxnSpMk id="81" creationId="{C86C4550-B786-A557-2E40-33F9A18CBACC}"/>
          </ac:cxnSpMkLst>
        </pc:cxnChg>
        <pc:cxnChg chg="mod">
          <ac:chgData name="Kumar, Vinod" userId="a0710a6e-bffc-4971-8893-1c23addeb5b0" providerId="ADAL" clId="{922FE477-A091-45D2-9AFE-0801C4DD56C7}" dt="2022-09-20T18:45:52.930" v="326"/>
          <ac:cxnSpMkLst>
            <pc:docMk/>
            <pc:sldMk cId="1513429835" sldId="296"/>
            <ac:cxnSpMk id="97" creationId="{53592EE5-8F68-3D81-6D11-C032A88650A6}"/>
          </ac:cxnSpMkLst>
        </pc:cxnChg>
        <pc:cxnChg chg="mod">
          <ac:chgData name="Kumar, Vinod" userId="a0710a6e-bffc-4971-8893-1c23addeb5b0" providerId="ADAL" clId="{922FE477-A091-45D2-9AFE-0801C4DD56C7}" dt="2022-09-20T18:45:52.930" v="326"/>
          <ac:cxnSpMkLst>
            <pc:docMk/>
            <pc:sldMk cId="1513429835" sldId="296"/>
            <ac:cxnSpMk id="98" creationId="{8CAAFAFB-5AE6-6D08-8A16-856FB7A9B925}"/>
          </ac:cxnSpMkLst>
        </pc:cxnChg>
        <pc:cxnChg chg="mod">
          <ac:chgData name="Kumar, Vinod" userId="a0710a6e-bffc-4971-8893-1c23addeb5b0" providerId="ADAL" clId="{922FE477-A091-45D2-9AFE-0801C4DD56C7}" dt="2022-09-20T19:00:31.670" v="926" actId="1035"/>
          <ac:cxnSpMkLst>
            <pc:docMk/>
            <pc:sldMk cId="1513429835" sldId="296"/>
            <ac:cxnSpMk id="121" creationId="{5F0BB2EE-45DA-D958-1ED9-099A50B57765}"/>
          </ac:cxnSpMkLst>
        </pc:cxnChg>
        <pc:cxnChg chg="mod">
          <ac:chgData name="Kumar, Vinod" userId="a0710a6e-bffc-4971-8893-1c23addeb5b0" providerId="ADAL" clId="{922FE477-A091-45D2-9AFE-0801C4DD56C7}" dt="2022-09-20T19:00:31.670" v="926" actId="1035"/>
          <ac:cxnSpMkLst>
            <pc:docMk/>
            <pc:sldMk cId="1513429835" sldId="296"/>
            <ac:cxnSpMk id="122" creationId="{DA28D257-E0E3-5E4E-7FFA-8AE42B9C8D08}"/>
          </ac:cxnSpMkLst>
        </pc:cxnChg>
        <pc:cxnChg chg="mod">
          <ac:chgData name="Kumar, Vinod" userId="a0710a6e-bffc-4971-8893-1c23addeb5b0" providerId="ADAL" clId="{922FE477-A091-45D2-9AFE-0801C4DD56C7}" dt="2022-09-20T19:00:31.670" v="926" actId="1035"/>
          <ac:cxnSpMkLst>
            <pc:docMk/>
            <pc:sldMk cId="1513429835" sldId="296"/>
            <ac:cxnSpMk id="139" creationId="{B3CC9BCE-D6C7-D1B0-C3AD-404517574B87}"/>
          </ac:cxnSpMkLst>
        </pc:cxnChg>
        <pc:cxnChg chg="mod">
          <ac:chgData name="Kumar, Vinod" userId="a0710a6e-bffc-4971-8893-1c23addeb5b0" providerId="ADAL" clId="{922FE477-A091-45D2-9AFE-0801C4DD56C7}" dt="2022-09-20T18:50:58.820" v="364"/>
          <ac:cxnSpMkLst>
            <pc:docMk/>
            <pc:sldMk cId="1513429835" sldId="296"/>
            <ac:cxnSpMk id="153" creationId="{246345EE-C72A-19C0-C5D4-E2701EE2401A}"/>
          </ac:cxnSpMkLst>
        </pc:cxnChg>
        <pc:cxnChg chg="mod">
          <ac:chgData name="Kumar, Vinod" userId="a0710a6e-bffc-4971-8893-1c23addeb5b0" providerId="ADAL" clId="{922FE477-A091-45D2-9AFE-0801C4DD56C7}" dt="2022-09-20T18:50:58.820" v="364"/>
          <ac:cxnSpMkLst>
            <pc:docMk/>
            <pc:sldMk cId="1513429835" sldId="296"/>
            <ac:cxnSpMk id="169" creationId="{632DBBC9-CC60-4279-E291-51DFDB2EFD8C}"/>
          </ac:cxnSpMkLst>
        </pc:cxnChg>
        <pc:cxnChg chg="mod">
          <ac:chgData name="Kumar, Vinod" userId="a0710a6e-bffc-4971-8893-1c23addeb5b0" providerId="ADAL" clId="{922FE477-A091-45D2-9AFE-0801C4DD56C7}" dt="2022-09-20T18:51:46.948" v="510"/>
          <ac:cxnSpMkLst>
            <pc:docMk/>
            <pc:sldMk cId="1513429835" sldId="296"/>
            <ac:cxnSpMk id="174" creationId="{E1771D5B-8B00-27F1-ED5C-8B0023A4F553}"/>
          </ac:cxnSpMkLst>
        </pc:cxnChg>
        <pc:cxnChg chg="mod">
          <ac:chgData name="Kumar, Vinod" userId="a0710a6e-bffc-4971-8893-1c23addeb5b0" providerId="ADAL" clId="{922FE477-A091-45D2-9AFE-0801C4DD56C7}" dt="2022-09-20T18:51:46.948" v="510"/>
          <ac:cxnSpMkLst>
            <pc:docMk/>
            <pc:sldMk cId="1513429835" sldId="296"/>
            <ac:cxnSpMk id="175" creationId="{C3521ED4-D907-B87A-477A-6954BC81927D}"/>
          </ac:cxnSpMkLst>
        </pc:cxnChg>
        <pc:cxnChg chg="mod">
          <ac:chgData name="Kumar, Vinod" userId="a0710a6e-bffc-4971-8893-1c23addeb5b0" providerId="ADAL" clId="{922FE477-A091-45D2-9AFE-0801C4DD56C7}" dt="2022-09-20T18:51:46.948" v="510"/>
          <ac:cxnSpMkLst>
            <pc:docMk/>
            <pc:sldMk cId="1513429835" sldId="296"/>
            <ac:cxnSpMk id="177" creationId="{9A4DD502-94C9-9EE7-8799-787550053A2F}"/>
          </ac:cxnSpMkLst>
        </pc:cxnChg>
        <pc:cxnChg chg="mod">
          <ac:chgData name="Kumar, Vinod" userId="a0710a6e-bffc-4971-8893-1c23addeb5b0" providerId="ADAL" clId="{922FE477-A091-45D2-9AFE-0801C4DD56C7}" dt="2022-09-20T18:51:46.948" v="510"/>
          <ac:cxnSpMkLst>
            <pc:docMk/>
            <pc:sldMk cId="1513429835" sldId="296"/>
            <ac:cxnSpMk id="193" creationId="{A5AFE87E-8013-B98C-BD5B-EB56A8A10678}"/>
          </ac:cxnSpMkLst>
        </pc:cxnChg>
        <pc:cxnChg chg="mod">
          <ac:chgData name="Kumar, Vinod" userId="a0710a6e-bffc-4971-8893-1c23addeb5b0" providerId="ADAL" clId="{922FE477-A091-45D2-9AFE-0801C4DD56C7}" dt="2022-09-20T18:51:46.948" v="510"/>
          <ac:cxnSpMkLst>
            <pc:docMk/>
            <pc:sldMk cId="1513429835" sldId="296"/>
            <ac:cxnSpMk id="194" creationId="{0267DAEA-E3AE-BCBE-53FA-B278E6BF51F8}"/>
          </ac:cxnSpMkLst>
        </pc:cxnChg>
      </pc:sldChg>
      <pc:sldChg chg="addSp delSp modSp new mod ord">
        <pc:chgData name="Kumar, Vinod" userId="a0710a6e-bffc-4971-8893-1c23addeb5b0" providerId="ADAL" clId="{922FE477-A091-45D2-9AFE-0801C4DD56C7}" dt="2022-09-26T21:16:38.143" v="4346" actId="164"/>
        <pc:sldMkLst>
          <pc:docMk/>
          <pc:sldMk cId="2940357804" sldId="297"/>
        </pc:sldMkLst>
        <pc:spChg chg="add mod">
          <ac:chgData name="Kumar, Vinod" userId="a0710a6e-bffc-4971-8893-1c23addeb5b0" providerId="ADAL" clId="{922FE477-A091-45D2-9AFE-0801C4DD56C7}" dt="2022-09-26T21:15:39.927" v="4337" actId="1036"/>
          <ac:spMkLst>
            <pc:docMk/>
            <pc:sldMk cId="2940357804" sldId="297"/>
            <ac:spMk id="2" creationId="{0B2B87A8-869C-4317-2DF0-7431E94D248E}"/>
          </ac:spMkLst>
        </pc:spChg>
        <pc:spChg chg="del">
          <ac:chgData name="Kumar, Vinod" userId="a0710a6e-bffc-4971-8893-1c23addeb5b0" providerId="ADAL" clId="{922FE477-A091-45D2-9AFE-0801C4DD56C7}" dt="2022-09-21T00:22:15.418" v="1167" actId="478"/>
          <ac:spMkLst>
            <pc:docMk/>
            <pc:sldMk cId="2940357804" sldId="297"/>
            <ac:spMk id="2" creationId="{780269DD-BE25-7EF4-E204-6162BD9FC6AF}"/>
          </ac:spMkLst>
        </pc:spChg>
        <pc:spChg chg="del">
          <ac:chgData name="Kumar, Vinod" userId="a0710a6e-bffc-4971-8893-1c23addeb5b0" providerId="ADAL" clId="{922FE477-A091-45D2-9AFE-0801C4DD56C7}" dt="2022-09-21T00:22:16.362" v="1168" actId="478"/>
          <ac:spMkLst>
            <pc:docMk/>
            <pc:sldMk cId="2940357804" sldId="297"/>
            <ac:spMk id="3" creationId="{11E2EB4C-A072-D1D1-84A1-5EC23E7B88D5}"/>
          </ac:spMkLst>
        </pc:spChg>
        <pc:spChg chg="mod">
          <ac:chgData name="Kumar, Vinod" userId="a0710a6e-bffc-4971-8893-1c23addeb5b0" providerId="ADAL" clId="{922FE477-A091-45D2-9AFE-0801C4DD56C7}" dt="2022-09-21T00:22:40.034" v="1169"/>
          <ac:spMkLst>
            <pc:docMk/>
            <pc:sldMk cId="2940357804" sldId="297"/>
            <ac:spMk id="8" creationId="{4D830F56-DA98-D4FA-1EE0-175D09D8ED66}"/>
          </ac:spMkLst>
        </pc:spChg>
        <pc:spChg chg="mod">
          <ac:chgData name="Kumar, Vinod" userId="a0710a6e-bffc-4971-8893-1c23addeb5b0" providerId="ADAL" clId="{922FE477-A091-45D2-9AFE-0801C4DD56C7}" dt="2022-09-21T00:22:40.034" v="1169"/>
          <ac:spMkLst>
            <pc:docMk/>
            <pc:sldMk cId="2940357804" sldId="297"/>
            <ac:spMk id="10" creationId="{9259D80F-85A1-0544-7B35-222998C3A7EC}"/>
          </ac:spMkLst>
        </pc:spChg>
        <pc:spChg chg="mod">
          <ac:chgData name="Kumar, Vinod" userId="a0710a6e-bffc-4971-8893-1c23addeb5b0" providerId="ADAL" clId="{922FE477-A091-45D2-9AFE-0801C4DD56C7}" dt="2022-09-21T00:22:40.034" v="1169"/>
          <ac:spMkLst>
            <pc:docMk/>
            <pc:sldMk cId="2940357804" sldId="297"/>
            <ac:spMk id="14" creationId="{7923CDEA-D7E3-D4F7-E165-4A606B13FEBB}"/>
          </ac:spMkLst>
        </pc:spChg>
        <pc:spChg chg="mod">
          <ac:chgData name="Kumar, Vinod" userId="a0710a6e-bffc-4971-8893-1c23addeb5b0" providerId="ADAL" clId="{922FE477-A091-45D2-9AFE-0801C4DD56C7}" dt="2022-09-21T00:22:40.034" v="1169"/>
          <ac:spMkLst>
            <pc:docMk/>
            <pc:sldMk cId="2940357804" sldId="297"/>
            <ac:spMk id="15" creationId="{4222B69E-D4C1-C7F2-51D0-1E996563E553}"/>
          </ac:spMkLst>
        </pc:spChg>
        <pc:spChg chg="mod">
          <ac:chgData name="Kumar, Vinod" userId="a0710a6e-bffc-4971-8893-1c23addeb5b0" providerId="ADAL" clId="{922FE477-A091-45D2-9AFE-0801C4DD56C7}" dt="2022-09-21T00:22:40.034" v="1169"/>
          <ac:spMkLst>
            <pc:docMk/>
            <pc:sldMk cId="2940357804" sldId="297"/>
            <ac:spMk id="16" creationId="{EA99345A-336A-98C3-78F1-7C03D7E62D09}"/>
          </ac:spMkLst>
        </pc:spChg>
        <pc:spChg chg="mod">
          <ac:chgData name="Kumar, Vinod" userId="a0710a6e-bffc-4971-8893-1c23addeb5b0" providerId="ADAL" clId="{922FE477-A091-45D2-9AFE-0801C4DD56C7}" dt="2022-09-21T00:22:40.034" v="1169"/>
          <ac:spMkLst>
            <pc:docMk/>
            <pc:sldMk cId="2940357804" sldId="297"/>
            <ac:spMk id="17" creationId="{5CE16DAB-9620-6F63-F62A-E9E938F94D70}"/>
          </ac:spMkLst>
        </pc:spChg>
        <pc:spChg chg="mod">
          <ac:chgData name="Kumar, Vinod" userId="a0710a6e-bffc-4971-8893-1c23addeb5b0" providerId="ADAL" clId="{922FE477-A091-45D2-9AFE-0801C4DD56C7}" dt="2022-09-21T00:22:40.034" v="1169"/>
          <ac:spMkLst>
            <pc:docMk/>
            <pc:sldMk cId="2940357804" sldId="297"/>
            <ac:spMk id="18" creationId="{42A9A233-49A1-99C8-B9DB-A4878F4A38B5}"/>
          </ac:spMkLst>
        </pc:spChg>
        <pc:spChg chg="mod">
          <ac:chgData name="Kumar, Vinod" userId="a0710a6e-bffc-4971-8893-1c23addeb5b0" providerId="ADAL" clId="{922FE477-A091-45D2-9AFE-0801C4DD56C7}" dt="2022-09-21T00:22:40.034" v="1169"/>
          <ac:spMkLst>
            <pc:docMk/>
            <pc:sldMk cId="2940357804" sldId="297"/>
            <ac:spMk id="19" creationId="{A8286D1B-2A13-A7D3-A46F-D5F7E9DA45F8}"/>
          </ac:spMkLst>
        </pc:spChg>
        <pc:spChg chg="mod">
          <ac:chgData name="Kumar, Vinod" userId="a0710a6e-bffc-4971-8893-1c23addeb5b0" providerId="ADAL" clId="{922FE477-A091-45D2-9AFE-0801C4DD56C7}" dt="2022-09-21T00:22:40.034" v="1169"/>
          <ac:spMkLst>
            <pc:docMk/>
            <pc:sldMk cId="2940357804" sldId="297"/>
            <ac:spMk id="20" creationId="{CAB484B7-A3DF-8888-F4F7-95B1E3E38310}"/>
          </ac:spMkLst>
        </pc:spChg>
        <pc:spChg chg="mod">
          <ac:chgData name="Kumar, Vinod" userId="a0710a6e-bffc-4971-8893-1c23addeb5b0" providerId="ADAL" clId="{922FE477-A091-45D2-9AFE-0801C4DD56C7}" dt="2022-09-21T00:22:40.034" v="1169"/>
          <ac:spMkLst>
            <pc:docMk/>
            <pc:sldMk cId="2940357804" sldId="297"/>
            <ac:spMk id="21" creationId="{019D3317-5F67-1DA5-9249-FFE29DFA53F0}"/>
          </ac:spMkLst>
        </pc:spChg>
        <pc:spChg chg="mod">
          <ac:chgData name="Kumar, Vinod" userId="a0710a6e-bffc-4971-8893-1c23addeb5b0" providerId="ADAL" clId="{922FE477-A091-45D2-9AFE-0801C4DD56C7}" dt="2022-09-21T00:22:40.034" v="1169"/>
          <ac:spMkLst>
            <pc:docMk/>
            <pc:sldMk cId="2940357804" sldId="297"/>
            <ac:spMk id="22" creationId="{7547D287-9F03-04FB-4228-1FC1F0866CFA}"/>
          </ac:spMkLst>
        </pc:spChg>
        <pc:spChg chg="add del mod">
          <ac:chgData name="Kumar, Vinod" userId="a0710a6e-bffc-4971-8893-1c23addeb5b0" providerId="ADAL" clId="{922FE477-A091-45D2-9AFE-0801C4DD56C7}" dt="2022-09-26T21:14:45.192" v="4314" actId="478"/>
          <ac:spMkLst>
            <pc:docMk/>
            <pc:sldMk cId="2940357804" sldId="297"/>
            <ac:spMk id="22" creationId="{DA5DBCA4-1F33-4548-6F30-F82D289430D9}"/>
          </ac:spMkLst>
        </pc:spChg>
        <pc:spChg chg="mod">
          <ac:chgData name="Kumar, Vinod" userId="a0710a6e-bffc-4971-8893-1c23addeb5b0" providerId="ADAL" clId="{922FE477-A091-45D2-9AFE-0801C4DD56C7}" dt="2022-09-21T00:22:40.034" v="1169"/>
          <ac:spMkLst>
            <pc:docMk/>
            <pc:sldMk cId="2940357804" sldId="297"/>
            <ac:spMk id="23" creationId="{D74F05AC-E020-343E-0394-4176E693060A}"/>
          </ac:spMkLst>
        </pc:spChg>
        <pc:spChg chg="add mod">
          <ac:chgData name="Kumar, Vinod" userId="a0710a6e-bffc-4971-8893-1c23addeb5b0" providerId="ADAL" clId="{922FE477-A091-45D2-9AFE-0801C4DD56C7}" dt="2022-09-26T21:16:38.143" v="4346" actId="164"/>
          <ac:spMkLst>
            <pc:docMk/>
            <pc:sldMk cId="2940357804" sldId="297"/>
            <ac:spMk id="23" creationId="{E34157A0-5335-7F3C-4DAB-1E2AE6466B29}"/>
          </ac:spMkLst>
        </pc:spChg>
        <pc:spChg chg="add mod">
          <ac:chgData name="Kumar, Vinod" userId="a0710a6e-bffc-4971-8893-1c23addeb5b0" providerId="ADAL" clId="{922FE477-A091-45D2-9AFE-0801C4DD56C7}" dt="2022-09-26T21:16:31.225" v="4345" actId="164"/>
          <ac:spMkLst>
            <pc:docMk/>
            <pc:sldMk cId="2940357804" sldId="297"/>
            <ac:spMk id="24" creationId="{69D40ED0-F8C8-D857-EC98-3C834355C7D0}"/>
          </ac:spMkLst>
        </pc:spChg>
        <pc:spChg chg="mod">
          <ac:chgData name="Kumar, Vinod" userId="a0710a6e-bffc-4971-8893-1c23addeb5b0" providerId="ADAL" clId="{922FE477-A091-45D2-9AFE-0801C4DD56C7}" dt="2022-09-21T00:22:40.034" v="1169"/>
          <ac:spMkLst>
            <pc:docMk/>
            <pc:sldMk cId="2940357804" sldId="297"/>
            <ac:spMk id="27" creationId="{DBFCDB37-8CFB-4707-E879-16E6849FA895}"/>
          </ac:spMkLst>
        </pc:spChg>
        <pc:spChg chg="mod">
          <ac:chgData name="Kumar, Vinod" userId="a0710a6e-bffc-4971-8893-1c23addeb5b0" providerId="ADAL" clId="{922FE477-A091-45D2-9AFE-0801C4DD56C7}" dt="2022-09-21T00:22:40.034" v="1169"/>
          <ac:spMkLst>
            <pc:docMk/>
            <pc:sldMk cId="2940357804" sldId="297"/>
            <ac:spMk id="29" creationId="{9CA72DA9-6BDF-CBA6-C34B-3914615A5FE8}"/>
          </ac:spMkLst>
        </pc:spChg>
        <pc:spChg chg="mod">
          <ac:chgData name="Kumar, Vinod" userId="a0710a6e-bffc-4971-8893-1c23addeb5b0" providerId="ADAL" clId="{922FE477-A091-45D2-9AFE-0801C4DD56C7}" dt="2022-09-21T00:22:40.034" v="1169"/>
          <ac:spMkLst>
            <pc:docMk/>
            <pc:sldMk cId="2940357804" sldId="297"/>
            <ac:spMk id="30" creationId="{F75E9E77-948A-A065-C1A0-D1A9FF549146}"/>
          </ac:spMkLst>
        </pc:spChg>
        <pc:spChg chg="mod">
          <ac:chgData name="Kumar, Vinod" userId="a0710a6e-bffc-4971-8893-1c23addeb5b0" providerId="ADAL" clId="{922FE477-A091-45D2-9AFE-0801C4DD56C7}" dt="2022-09-21T00:22:40.034" v="1169"/>
          <ac:spMkLst>
            <pc:docMk/>
            <pc:sldMk cId="2940357804" sldId="297"/>
            <ac:spMk id="31" creationId="{DCB8B576-3E64-3C24-8B4E-4C2043DDD70D}"/>
          </ac:spMkLst>
        </pc:spChg>
        <pc:spChg chg="mod">
          <ac:chgData name="Kumar, Vinod" userId="a0710a6e-bffc-4971-8893-1c23addeb5b0" providerId="ADAL" clId="{922FE477-A091-45D2-9AFE-0801C4DD56C7}" dt="2022-09-21T00:22:40.034" v="1169"/>
          <ac:spMkLst>
            <pc:docMk/>
            <pc:sldMk cId="2940357804" sldId="297"/>
            <ac:spMk id="36" creationId="{9CBC065B-2B9E-7590-A9A1-390019B3C01A}"/>
          </ac:spMkLst>
        </pc:spChg>
        <pc:spChg chg="mod">
          <ac:chgData name="Kumar, Vinod" userId="a0710a6e-bffc-4971-8893-1c23addeb5b0" providerId="ADAL" clId="{922FE477-A091-45D2-9AFE-0801C4DD56C7}" dt="2022-09-21T00:22:40.034" v="1169"/>
          <ac:spMkLst>
            <pc:docMk/>
            <pc:sldMk cId="2940357804" sldId="297"/>
            <ac:spMk id="38" creationId="{6B7B2BC4-2027-417D-D123-0042BE233641}"/>
          </ac:spMkLst>
        </pc:spChg>
        <pc:spChg chg="mod">
          <ac:chgData name="Kumar, Vinod" userId="a0710a6e-bffc-4971-8893-1c23addeb5b0" providerId="ADAL" clId="{922FE477-A091-45D2-9AFE-0801C4DD56C7}" dt="2022-09-21T00:23:59.113" v="1195" actId="1037"/>
          <ac:spMkLst>
            <pc:docMk/>
            <pc:sldMk cId="2940357804" sldId="297"/>
            <ac:spMk id="44" creationId="{0BDEA9C9-B6C1-B3C0-F0B2-ED135B81CD56}"/>
          </ac:spMkLst>
        </pc:spChg>
        <pc:spChg chg="mod">
          <ac:chgData name="Kumar, Vinod" userId="a0710a6e-bffc-4971-8893-1c23addeb5b0" providerId="ADAL" clId="{922FE477-A091-45D2-9AFE-0801C4DD56C7}" dt="2022-09-21T00:23:59.113" v="1195" actId="1037"/>
          <ac:spMkLst>
            <pc:docMk/>
            <pc:sldMk cId="2940357804" sldId="297"/>
            <ac:spMk id="46" creationId="{F52EE95C-2C97-3BF4-8060-00ADD69CA095}"/>
          </ac:spMkLst>
        </pc:spChg>
        <pc:spChg chg="mod">
          <ac:chgData name="Kumar, Vinod" userId="a0710a6e-bffc-4971-8893-1c23addeb5b0" providerId="ADAL" clId="{922FE477-A091-45D2-9AFE-0801C4DD56C7}" dt="2022-09-21T00:23:59.113" v="1195" actId="1037"/>
          <ac:spMkLst>
            <pc:docMk/>
            <pc:sldMk cId="2940357804" sldId="297"/>
            <ac:spMk id="50" creationId="{FBE69ADB-DAD8-A9F3-B5B1-6548041DBD42}"/>
          </ac:spMkLst>
        </pc:spChg>
        <pc:spChg chg="mod">
          <ac:chgData name="Kumar, Vinod" userId="a0710a6e-bffc-4971-8893-1c23addeb5b0" providerId="ADAL" clId="{922FE477-A091-45D2-9AFE-0801C4DD56C7}" dt="2022-09-21T00:23:59.113" v="1195" actId="1037"/>
          <ac:spMkLst>
            <pc:docMk/>
            <pc:sldMk cId="2940357804" sldId="297"/>
            <ac:spMk id="51" creationId="{81CC8EC2-5748-E852-C9BC-D6781470E6A3}"/>
          </ac:spMkLst>
        </pc:spChg>
        <pc:spChg chg="mod">
          <ac:chgData name="Kumar, Vinod" userId="a0710a6e-bffc-4971-8893-1c23addeb5b0" providerId="ADAL" clId="{922FE477-A091-45D2-9AFE-0801C4DD56C7}" dt="2022-09-21T00:23:59.113" v="1195" actId="1037"/>
          <ac:spMkLst>
            <pc:docMk/>
            <pc:sldMk cId="2940357804" sldId="297"/>
            <ac:spMk id="52" creationId="{A2A03F6F-B51A-BF8A-9678-88DD206B92BA}"/>
          </ac:spMkLst>
        </pc:spChg>
        <pc:spChg chg="mod">
          <ac:chgData name="Kumar, Vinod" userId="a0710a6e-bffc-4971-8893-1c23addeb5b0" providerId="ADAL" clId="{922FE477-A091-45D2-9AFE-0801C4DD56C7}" dt="2022-09-21T00:23:59.113" v="1195" actId="1037"/>
          <ac:spMkLst>
            <pc:docMk/>
            <pc:sldMk cId="2940357804" sldId="297"/>
            <ac:spMk id="53" creationId="{AEDA1979-CC96-33DF-7BA3-C1F43D605849}"/>
          </ac:spMkLst>
        </pc:spChg>
        <pc:spChg chg="mod">
          <ac:chgData name="Kumar, Vinod" userId="a0710a6e-bffc-4971-8893-1c23addeb5b0" providerId="ADAL" clId="{922FE477-A091-45D2-9AFE-0801C4DD56C7}" dt="2022-09-21T00:23:59.113" v="1195" actId="1037"/>
          <ac:spMkLst>
            <pc:docMk/>
            <pc:sldMk cId="2940357804" sldId="297"/>
            <ac:spMk id="54" creationId="{81098254-73EF-AEB4-C99C-CAD4BD04A59E}"/>
          </ac:spMkLst>
        </pc:spChg>
        <pc:spChg chg="mod">
          <ac:chgData name="Kumar, Vinod" userId="a0710a6e-bffc-4971-8893-1c23addeb5b0" providerId="ADAL" clId="{922FE477-A091-45D2-9AFE-0801C4DD56C7}" dt="2022-09-21T00:23:59.113" v="1195" actId="1037"/>
          <ac:spMkLst>
            <pc:docMk/>
            <pc:sldMk cId="2940357804" sldId="297"/>
            <ac:spMk id="55" creationId="{79DF9A06-7743-C875-714A-B58C4F7A0B69}"/>
          </ac:spMkLst>
        </pc:spChg>
        <pc:spChg chg="mod">
          <ac:chgData name="Kumar, Vinod" userId="a0710a6e-bffc-4971-8893-1c23addeb5b0" providerId="ADAL" clId="{922FE477-A091-45D2-9AFE-0801C4DD56C7}" dt="2022-09-21T00:23:59.113" v="1195" actId="1037"/>
          <ac:spMkLst>
            <pc:docMk/>
            <pc:sldMk cId="2940357804" sldId="297"/>
            <ac:spMk id="56" creationId="{6DDBD7E6-ECB8-8681-884A-C4FA7AA88071}"/>
          </ac:spMkLst>
        </pc:spChg>
        <pc:spChg chg="mod">
          <ac:chgData name="Kumar, Vinod" userId="a0710a6e-bffc-4971-8893-1c23addeb5b0" providerId="ADAL" clId="{922FE477-A091-45D2-9AFE-0801C4DD56C7}" dt="2022-09-21T00:23:59.113" v="1195" actId="1037"/>
          <ac:spMkLst>
            <pc:docMk/>
            <pc:sldMk cId="2940357804" sldId="297"/>
            <ac:spMk id="57" creationId="{5003A4BC-349B-D7D0-6C80-4E286D29CDA7}"/>
          </ac:spMkLst>
        </pc:spChg>
        <pc:spChg chg="mod">
          <ac:chgData name="Kumar, Vinod" userId="a0710a6e-bffc-4971-8893-1c23addeb5b0" providerId="ADAL" clId="{922FE477-A091-45D2-9AFE-0801C4DD56C7}" dt="2022-09-21T00:23:59.113" v="1195" actId="1037"/>
          <ac:spMkLst>
            <pc:docMk/>
            <pc:sldMk cId="2940357804" sldId="297"/>
            <ac:spMk id="58" creationId="{6622456B-8A3B-01E6-38A6-3A4BE1F01357}"/>
          </ac:spMkLst>
        </pc:spChg>
        <pc:spChg chg="mod">
          <ac:chgData name="Kumar, Vinod" userId="a0710a6e-bffc-4971-8893-1c23addeb5b0" providerId="ADAL" clId="{922FE477-A091-45D2-9AFE-0801C4DD56C7}" dt="2022-09-21T00:23:59.113" v="1195" actId="1037"/>
          <ac:spMkLst>
            <pc:docMk/>
            <pc:sldMk cId="2940357804" sldId="297"/>
            <ac:spMk id="59" creationId="{D5DD22F3-E419-E1F0-0F47-49A7E5A9A5EA}"/>
          </ac:spMkLst>
        </pc:spChg>
        <pc:spChg chg="mod">
          <ac:chgData name="Kumar, Vinod" userId="a0710a6e-bffc-4971-8893-1c23addeb5b0" providerId="ADAL" clId="{922FE477-A091-45D2-9AFE-0801C4DD56C7}" dt="2022-09-21T00:23:59.113" v="1195" actId="1037"/>
          <ac:spMkLst>
            <pc:docMk/>
            <pc:sldMk cId="2940357804" sldId="297"/>
            <ac:spMk id="63" creationId="{4A405A04-C205-EADB-A028-38272D126107}"/>
          </ac:spMkLst>
        </pc:spChg>
        <pc:spChg chg="mod">
          <ac:chgData name="Kumar, Vinod" userId="a0710a6e-bffc-4971-8893-1c23addeb5b0" providerId="ADAL" clId="{922FE477-A091-45D2-9AFE-0801C4DD56C7}" dt="2022-09-21T00:23:59.113" v="1195" actId="1037"/>
          <ac:spMkLst>
            <pc:docMk/>
            <pc:sldMk cId="2940357804" sldId="297"/>
            <ac:spMk id="65" creationId="{B0EE8F4D-1A03-B64B-2FB8-1928DD162A4F}"/>
          </ac:spMkLst>
        </pc:spChg>
        <pc:spChg chg="mod">
          <ac:chgData name="Kumar, Vinod" userId="a0710a6e-bffc-4971-8893-1c23addeb5b0" providerId="ADAL" clId="{922FE477-A091-45D2-9AFE-0801C4DD56C7}" dt="2022-09-21T00:23:59.113" v="1195" actId="1037"/>
          <ac:spMkLst>
            <pc:docMk/>
            <pc:sldMk cId="2940357804" sldId="297"/>
            <ac:spMk id="66" creationId="{C134DAB8-F8B5-939C-C4CF-41C580259892}"/>
          </ac:spMkLst>
        </pc:spChg>
        <pc:spChg chg="mod">
          <ac:chgData name="Kumar, Vinod" userId="a0710a6e-bffc-4971-8893-1c23addeb5b0" providerId="ADAL" clId="{922FE477-A091-45D2-9AFE-0801C4DD56C7}" dt="2022-09-21T00:23:59.113" v="1195" actId="1037"/>
          <ac:spMkLst>
            <pc:docMk/>
            <pc:sldMk cId="2940357804" sldId="297"/>
            <ac:spMk id="67" creationId="{C74148A3-AB99-6997-429E-B74A92251484}"/>
          </ac:spMkLst>
        </pc:spChg>
        <pc:spChg chg="mod">
          <ac:chgData name="Kumar, Vinod" userId="a0710a6e-bffc-4971-8893-1c23addeb5b0" providerId="ADAL" clId="{922FE477-A091-45D2-9AFE-0801C4DD56C7}" dt="2022-09-21T00:23:59.113" v="1195" actId="1037"/>
          <ac:spMkLst>
            <pc:docMk/>
            <pc:sldMk cId="2940357804" sldId="297"/>
            <ac:spMk id="72" creationId="{E671D253-0020-F5EE-5281-7625A426C9D0}"/>
          </ac:spMkLst>
        </pc:spChg>
        <pc:spChg chg="mod">
          <ac:chgData name="Kumar, Vinod" userId="a0710a6e-bffc-4971-8893-1c23addeb5b0" providerId="ADAL" clId="{922FE477-A091-45D2-9AFE-0801C4DD56C7}" dt="2022-09-21T00:23:59.113" v="1195" actId="1037"/>
          <ac:spMkLst>
            <pc:docMk/>
            <pc:sldMk cId="2940357804" sldId="297"/>
            <ac:spMk id="74" creationId="{6FE8517B-55BC-68A5-F33C-DB0CC8555DDF}"/>
          </ac:spMkLst>
        </pc:spChg>
        <pc:spChg chg="add mod">
          <ac:chgData name="Kumar, Vinod" userId="a0710a6e-bffc-4971-8893-1c23addeb5b0" providerId="ADAL" clId="{922FE477-A091-45D2-9AFE-0801C4DD56C7}" dt="2022-09-21T14:07:57.351" v="1620" actId="20577"/>
          <ac:spMkLst>
            <pc:docMk/>
            <pc:sldMk cId="2940357804" sldId="297"/>
            <ac:spMk id="83" creationId="{E58A24D0-96A1-E362-831F-90DFFC5F3F34}"/>
          </ac:spMkLst>
        </pc:spChg>
        <pc:spChg chg="add mod">
          <ac:chgData name="Kumar, Vinod" userId="a0710a6e-bffc-4971-8893-1c23addeb5b0" providerId="ADAL" clId="{922FE477-A091-45D2-9AFE-0801C4DD56C7}" dt="2022-09-21T14:08:37.640" v="1625" actId="164"/>
          <ac:spMkLst>
            <pc:docMk/>
            <pc:sldMk cId="2940357804" sldId="297"/>
            <ac:spMk id="84" creationId="{268AC11B-C4F9-2F6B-FF8F-192EAF443323}"/>
          </ac:spMkLst>
        </pc:spChg>
        <pc:spChg chg="add mod">
          <ac:chgData name="Kumar, Vinod" userId="a0710a6e-bffc-4971-8893-1c23addeb5b0" providerId="ADAL" clId="{922FE477-A091-45D2-9AFE-0801C4DD56C7}" dt="2022-09-21T14:13:32.949" v="1633" actId="164"/>
          <ac:spMkLst>
            <pc:docMk/>
            <pc:sldMk cId="2940357804" sldId="297"/>
            <ac:spMk id="85" creationId="{4A986DD3-D094-666C-684F-6F2016CC39D2}"/>
          </ac:spMkLst>
        </pc:spChg>
        <pc:spChg chg="add mod">
          <ac:chgData name="Kumar, Vinod" userId="a0710a6e-bffc-4971-8893-1c23addeb5b0" providerId="ADAL" clId="{922FE477-A091-45D2-9AFE-0801C4DD56C7}" dt="2022-09-21T14:08:30.096" v="1623" actId="164"/>
          <ac:spMkLst>
            <pc:docMk/>
            <pc:sldMk cId="2940357804" sldId="297"/>
            <ac:spMk id="86" creationId="{9C52924C-0B52-5997-C58D-2D1AA75640C5}"/>
          </ac:spMkLst>
        </pc:spChg>
        <pc:spChg chg="add mod">
          <ac:chgData name="Kumar, Vinod" userId="a0710a6e-bffc-4971-8893-1c23addeb5b0" providerId="ADAL" clId="{922FE477-A091-45D2-9AFE-0801C4DD56C7}" dt="2022-09-21T14:08:33.640" v="1624" actId="164"/>
          <ac:spMkLst>
            <pc:docMk/>
            <pc:sldMk cId="2940357804" sldId="297"/>
            <ac:spMk id="87" creationId="{94D37293-18A5-7325-6B95-B40A9B17B375}"/>
          </ac:spMkLst>
        </pc:spChg>
        <pc:spChg chg="add mod">
          <ac:chgData name="Kumar, Vinod" userId="a0710a6e-bffc-4971-8893-1c23addeb5b0" providerId="ADAL" clId="{922FE477-A091-45D2-9AFE-0801C4DD56C7}" dt="2022-09-21T14:08:22.088" v="1622" actId="164"/>
          <ac:spMkLst>
            <pc:docMk/>
            <pc:sldMk cId="2940357804" sldId="297"/>
            <ac:spMk id="88" creationId="{CAC2C618-7D71-1724-06E7-9F8AD47F396F}"/>
          </ac:spMkLst>
        </pc:spChg>
        <pc:spChg chg="add mod">
          <ac:chgData name="Kumar, Vinod" userId="a0710a6e-bffc-4971-8893-1c23addeb5b0" providerId="ADAL" clId="{922FE477-A091-45D2-9AFE-0801C4DD56C7}" dt="2022-09-21T14:08:16.881" v="1621" actId="164"/>
          <ac:spMkLst>
            <pc:docMk/>
            <pc:sldMk cId="2940357804" sldId="297"/>
            <ac:spMk id="89" creationId="{05532DAD-C191-1E14-3307-0B3021E5F901}"/>
          </ac:spMkLst>
        </pc:spChg>
        <pc:grpChg chg="add mod">
          <ac:chgData name="Kumar, Vinod" userId="a0710a6e-bffc-4971-8893-1c23addeb5b0" providerId="ADAL" clId="{922FE477-A091-45D2-9AFE-0801C4DD56C7}" dt="2022-09-26T21:16:31.225" v="4345" actId="164"/>
          <ac:grpSpMkLst>
            <pc:docMk/>
            <pc:sldMk cId="2940357804" sldId="297"/>
            <ac:grpSpMk id="3" creationId="{B0F9075D-59BD-1209-B16F-36CA6F970470}"/>
          </ac:grpSpMkLst>
        </pc:grpChg>
        <pc:grpChg chg="add del mod">
          <ac:chgData name="Kumar, Vinod" userId="a0710a6e-bffc-4971-8893-1c23addeb5b0" providerId="ADAL" clId="{922FE477-A091-45D2-9AFE-0801C4DD56C7}" dt="2022-09-21T00:22:47.410" v="1170"/>
          <ac:grpSpMkLst>
            <pc:docMk/>
            <pc:sldMk cId="2940357804" sldId="297"/>
            <ac:grpSpMk id="4" creationId="{BF47FB23-C7A3-EA0E-0F56-18805C36D8A0}"/>
          </ac:grpSpMkLst>
        </pc:grpChg>
        <pc:grpChg chg="add mod">
          <ac:chgData name="Kumar, Vinod" userId="a0710a6e-bffc-4971-8893-1c23addeb5b0" providerId="ADAL" clId="{922FE477-A091-45D2-9AFE-0801C4DD56C7}" dt="2022-09-26T21:16:38.143" v="4346" actId="164"/>
          <ac:grpSpMkLst>
            <pc:docMk/>
            <pc:sldMk cId="2940357804" sldId="297"/>
            <ac:grpSpMk id="4" creationId="{FD34A456-87AA-5503-691C-92893C8A2A08}"/>
          </ac:grpSpMkLst>
        </pc:grpChg>
        <pc:grpChg chg="mod">
          <ac:chgData name="Kumar, Vinod" userId="a0710a6e-bffc-4971-8893-1c23addeb5b0" providerId="ADAL" clId="{922FE477-A091-45D2-9AFE-0801C4DD56C7}" dt="2022-09-21T00:22:40.034" v="1169"/>
          <ac:grpSpMkLst>
            <pc:docMk/>
            <pc:sldMk cId="2940357804" sldId="297"/>
            <ac:grpSpMk id="6" creationId="{2A1C6254-DA90-E357-4EE3-853C69FD69AE}"/>
          </ac:grpSpMkLst>
        </pc:grpChg>
        <pc:grpChg chg="mod">
          <ac:chgData name="Kumar, Vinod" userId="a0710a6e-bffc-4971-8893-1c23addeb5b0" providerId="ADAL" clId="{922FE477-A091-45D2-9AFE-0801C4DD56C7}" dt="2022-09-21T00:22:40.034" v="1169"/>
          <ac:grpSpMkLst>
            <pc:docMk/>
            <pc:sldMk cId="2940357804" sldId="297"/>
            <ac:grpSpMk id="7" creationId="{0C332368-1E3E-4759-FC6E-3A3F0E0F69D7}"/>
          </ac:grpSpMkLst>
        </pc:grpChg>
        <pc:grpChg chg="mod">
          <ac:chgData name="Kumar, Vinod" userId="a0710a6e-bffc-4971-8893-1c23addeb5b0" providerId="ADAL" clId="{922FE477-A091-45D2-9AFE-0801C4DD56C7}" dt="2022-09-21T00:22:40.034" v="1169"/>
          <ac:grpSpMkLst>
            <pc:docMk/>
            <pc:sldMk cId="2940357804" sldId="297"/>
            <ac:grpSpMk id="9" creationId="{272B85E9-1B91-8C2D-B0FB-2A7B91CA223C}"/>
          </ac:grpSpMkLst>
        </pc:grpChg>
        <pc:grpChg chg="mod">
          <ac:chgData name="Kumar, Vinod" userId="a0710a6e-bffc-4971-8893-1c23addeb5b0" providerId="ADAL" clId="{922FE477-A091-45D2-9AFE-0801C4DD56C7}" dt="2022-09-21T00:22:40.034" v="1169"/>
          <ac:grpSpMkLst>
            <pc:docMk/>
            <pc:sldMk cId="2940357804" sldId="297"/>
            <ac:grpSpMk id="11" creationId="{B7A93C86-A223-69BE-71A7-A321796F2ABA}"/>
          </ac:grpSpMkLst>
        </pc:grpChg>
        <pc:grpChg chg="mod">
          <ac:chgData name="Kumar, Vinod" userId="a0710a6e-bffc-4971-8893-1c23addeb5b0" providerId="ADAL" clId="{922FE477-A091-45D2-9AFE-0801C4DD56C7}" dt="2022-09-21T00:22:40.034" v="1169"/>
          <ac:grpSpMkLst>
            <pc:docMk/>
            <pc:sldMk cId="2940357804" sldId="297"/>
            <ac:grpSpMk id="12" creationId="{59E7073B-58B6-EA9F-3968-CDC1527E0C70}"/>
          </ac:grpSpMkLst>
        </pc:grpChg>
        <pc:grpChg chg="mod">
          <ac:chgData name="Kumar, Vinod" userId="a0710a6e-bffc-4971-8893-1c23addeb5b0" providerId="ADAL" clId="{922FE477-A091-45D2-9AFE-0801C4DD56C7}" dt="2022-09-21T00:22:40.034" v="1169"/>
          <ac:grpSpMkLst>
            <pc:docMk/>
            <pc:sldMk cId="2940357804" sldId="297"/>
            <ac:grpSpMk id="13" creationId="{97331DC4-B84F-9365-7363-C967BFF0867F}"/>
          </ac:grpSpMkLst>
        </pc:grpChg>
        <pc:grpChg chg="mod">
          <ac:chgData name="Kumar, Vinod" userId="a0710a6e-bffc-4971-8893-1c23addeb5b0" providerId="ADAL" clId="{922FE477-A091-45D2-9AFE-0801C4DD56C7}" dt="2022-09-21T00:22:40.034" v="1169"/>
          <ac:grpSpMkLst>
            <pc:docMk/>
            <pc:sldMk cId="2940357804" sldId="297"/>
            <ac:grpSpMk id="26" creationId="{67991C38-7EB0-8607-F0C6-00BE65B501CC}"/>
          </ac:grpSpMkLst>
        </pc:grpChg>
        <pc:grpChg chg="add del mod">
          <ac:chgData name="Kumar, Vinod" userId="a0710a6e-bffc-4971-8893-1c23addeb5b0" providerId="ADAL" clId="{922FE477-A091-45D2-9AFE-0801C4DD56C7}" dt="2022-09-21T13:47:22.017" v="1196" actId="478"/>
          <ac:grpSpMkLst>
            <pc:docMk/>
            <pc:sldMk cId="2940357804" sldId="297"/>
            <ac:grpSpMk id="40" creationId="{0EDFAEF3-889B-40CE-9D33-CDED335D167B}"/>
          </ac:grpSpMkLst>
        </pc:grpChg>
        <pc:grpChg chg="mod">
          <ac:chgData name="Kumar, Vinod" userId="a0710a6e-bffc-4971-8893-1c23addeb5b0" providerId="ADAL" clId="{922FE477-A091-45D2-9AFE-0801C4DD56C7}" dt="2022-09-21T00:23:59.113" v="1195" actId="1037"/>
          <ac:grpSpMkLst>
            <pc:docMk/>
            <pc:sldMk cId="2940357804" sldId="297"/>
            <ac:grpSpMk id="42" creationId="{6F3EFB08-DB08-9A60-4456-5B042A162D8D}"/>
          </ac:grpSpMkLst>
        </pc:grpChg>
        <pc:grpChg chg="mod">
          <ac:chgData name="Kumar, Vinod" userId="a0710a6e-bffc-4971-8893-1c23addeb5b0" providerId="ADAL" clId="{922FE477-A091-45D2-9AFE-0801C4DD56C7}" dt="2022-09-21T00:23:59.113" v="1195" actId="1037"/>
          <ac:grpSpMkLst>
            <pc:docMk/>
            <pc:sldMk cId="2940357804" sldId="297"/>
            <ac:grpSpMk id="43" creationId="{666479CB-BE50-6F64-BF82-882B8A9D16CE}"/>
          </ac:grpSpMkLst>
        </pc:grpChg>
        <pc:grpChg chg="mod">
          <ac:chgData name="Kumar, Vinod" userId="a0710a6e-bffc-4971-8893-1c23addeb5b0" providerId="ADAL" clId="{922FE477-A091-45D2-9AFE-0801C4DD56C7}" dt="2022-09-21T00:23:59.113" v="1195" actId="1037"/>
          <ac:grpSpMkLst>
            <pc:docMk/>
            <pc:sldMk cId="2940357804" sldId="297"/>
            <ac:grpSpMk id="45" creationId="{56C42D35-62A7-B881-98F3-4059CD5E1DCF}"/>
          </ac:grpSpMkLst>
        </pc:grpChg>
        <pc:grpChg chg="mod">
          <ac:chgData name="Kumar, Vinod" userId="a0710a6e-bffc-4971-8893-1c23addeb5b0" providerId="ADAL" clId="{922FE477-A091-45D2-9AFE-0801C4DD56C7}" dt="2022-09-21T00:23:59.113" v="1195" actId="1037"/>
          <ac:grpSpMkLst>
            <pc:docMk/>
            <pc:sldMk cId="2940357804" sldId="297"/>
            <ac:grpSpMk id="47" creationId="{A6EC8E84-735F-89E3-C0C2-A784663EC20B}"/>
          </ac:grpSpMkLst>
        </pc:grpChg>
        <pc:grpChg chg="mod">
          <ac:chgData name="Kumar, Vinod" userId="a0710a6e-bffc-4971-8893-1c23addeb5b0" providerId="ADAL" clId="{922FE477-A091-45D2-9AFE-0801C4DD56C7}" dt="2022-09-21T00:23:59.113" v="1195" actId="1037"/>
          <ac:grpSpMkLst>
            <pc:docMk/>
            <pc:sldMk cId="2940357804" sldId="297"/>
            <ac:grpSpMk id="48" creationId="{1904D56B-DA68-15B5-3605-268C2FABBD93}"/>
          </ac:grpSpMkLst>
        </pc:grpChg>
        <pc:grpChg chg="mod">
          <ac:chgData name="Kumar, Vinod" userId="a0710a6e-bffc-4971-8893-1c23addeb5b0" providerId="ADAL" clId="{922FE477-A091-45D2-9AFE-0801C4DD56C7}" dt="2022-09-21T00:23:59.113" v="1195" actId="1037"/>
          <ac:grpSpMkLst>
            <pc:docMk/>
            <pc:sldMk cId="2940357804" sldId="297"/>
            <ac:grpSpMk id="49" creationId="{EDA30712-DB2F-7C20-B1F8-EEEFB48528CF}"/>
          </ac:grpSpMkLst>
        </pc:grpChg>
        <pc:grpChg chg="mod">
          <ac:chgData name="Kumar, Vinod" userId="a0710a6e-bffc-4971-8893-1c23addeb5b0" providerId="ADAL" clId="{922FE477-A091-45D2-9AFE-0801C4DD56C7}" dt="2022-09-21T00:23:59.113" v="1195" actId="1037"/>
          <ac:grpSpMkLst>
            <pc:docMk/>
            <pc:sldMk cId="2940357804" sldId="297"/>
            <ac:grpSpMk id="62" creationId="{0A0591CA-907E-E603-1106-25F268FF2CCB}"/>
          </ac:grpSpMkLst>
        </pc:grpChg>
        <pc:grpChg chg="add mod">
          <ac:chgData name="Kumar, Vinod" userId="a0710a6e-bffc-4971-8893-1c23addeb5b0" providerId="ADAL" clId="{922FE477-A091-45D2-9AFE-0801C4DD56C7}" dt="2022-09-26T21:16:31.225" v="4345" actId="164"/>
          <ac:grpSpMkLst>
            <pc:docMk/>
            <pc:sldMk cId="2940357804" sldId="297"/>
            <ac:grpSpMk id="90" creationId="{19680E52-21AF-9D52-43BC-15236EC729A7}"/>
          </ac:grpSpMkLst>
        </pc:grpChg>
        <pc:grpChg chg="add mod">
          <ac:chgData name="Kumar, Vinod" userId="a0710a6e-bffc-4971-8893-1c23addeb5b0" providerId="ADAL" clId="{922FE477-A091-45D2-9AFE-0801C4DD56C7}" dt="2022-09-26T21:16:38.143" v="4346" actId="164"/>
          <ac:grpSpMkLst>
            <pc:docMk/>
            <pc:sldMk cId="2940357804" sldId="297"/>
            <ac:grpSpMk id="91" creationId="{F3941455-4ECD-3715-E514-41131176D25A}"/>
          </ac:grpSpMkLst>
        </pc:grpChg>
        <pc:grpChg chg="add mod">
          <ac:chgData name="Kumar, Vinod" userId="a0710a6e-bffc-4971-8893-1c23addeb5b0" providerId="ADAL" clId="{922FE477-A091-45D2-9AFE-0801C4DD56C7}" dt="2022-09-21T14:08:30.096" v="1623" actId="164"/>
          <ac:grpSpMkLst>
            <pc:docMk/>
            <pc:sldMk cId="2940357804" sldId="297"/>
            <ac:grpSpMk id="92" creationId="{5D2984C5-8377-BC4D-A865-5E146A1E64C0}"/>
          </ac:grpSpMkLst>
        </pc:grpChg>
        <pc:grpChg chg="add mod">
          <ac:chgData name="Kumar, Vinod" userId="a0710a6e-bffc-4971-8893-1c23addeb5b0" providerId="ADAL" clId="{922FE477-A091-45D2-9AFE-0801C4DD56C7}" dt="2022-09-21T14:08:33.640" v="1624" actId="164"/>
          <ac:grpSpMkLst>
            <pc:docMk/>
            <pc:sldMk cId="2940357804" sldId="297"/>
            <ac:grpSpMk id="93" creationId="{B9649B43-ED41-AFB1-E79A-7343E909B5CF}"/>
          </ac:grpSpMkLst>
        </pc:grpChg>
        <pc:grpChg chg="add mod">
          <ac:chgData name="Kumar, Vinod" userId="a0710a6e-bffc-4971-8893-1c23addeb5b0" providerId="ADAL" clId="{922FE477-A091-45D2-9AFE-0801C4DD56C7}" dt="2022-09-21T14:08:37.640" v="1625" actId="164"/>
          <ac:grpSpMkLst>
            <pc:docMk/>
            <pc:sldMk cId="2940357804" sldId="297"/>
            <ac:grpSpMk id="94" creationId="{3DDC3DE9-7F9E-32D9-3AC0-4B69B597E2CC}"/>
          </ac:grpSpMkLst>
        </pc:grpChg>
        <pc:grpChg chg="add mod">
          <ac:chgData name="Kumar, Vinod" userId="a0710a6e-bffc-4971-8893-1c23addeb5b0" providerId="ADAL" clId="{922FE477-A091-45D2-9AFE-0801C4DD56C7}" dt="2022-09-26T21:15:18.263" v="4329" actId="1035"/>
          <ac:grpSpMkLst>
            <pc:docMk/>
            <pc:sldMk cId="2940357804" sldId="297"/>
            <ac:grpSpMk id="95" creationId="{AEFA5619-9516-B273-8660-38613101634B}"/>
          </ac:grpSpMkLst>
        </pc:grpChg>
        <pc:picChg chg="mod">
          <ac:chgData name="Kumar, Vinod" userId="a0710a6e-bffc-4971-8893-1c23addeb5b0" providerId="ADAL" clId="{922FE477-A091-45D2-9AFE-0801C4DD56C7}" dt="2022-09-21T00:22:40.034" v="1169"/>
          <ac:picMkLst>
            <pc:docMk/>
            <pc:sldMk cId="2940357804" sldId="297"/>
            <ac:picMk id="5" creationId="{7003551C-478B-8FE8-4D68-2A9D74F278D9}"/>
          </ac:picMkLst>
        </pc:picChg>
        <pc:picChg chg="mod">
          <ac:chgData name="Kumar, Vinod" userId="a0710a6e-bffc-4971-8893-1c23addeb5b0" providerId="ADAL" clId="{922FE477-A091-45D2-9AFE-0801C4DD56C7}" dt="2022-09-21T00:22:40.034" v="1169"/>
          <ac:picMkLst>
            <pc:docMk/>
            <pc:sldMk cId="2940357804" sldId="297"/>
            <ac:picMk id="24" creationId="{708B25E3-73F9-96FF-AA4A-8DF833140C4F}"/>
          </ac:picMkLst>
        </pc:picChg>
        <pc:picChg chg="mod">
          <ac:chgData name="Kumar, Vinod" userId="a0710a6e-bffc-4971-8893-1c23addeb5b0" providerId="ADAL" clId="{922FE477-A091-45D2-9AFE-0801C4DD56C7}" dt="2022-09-21T00:22:40.034" v="1169"/>
          <ac:picMkLst>
            <pc:docMk/>
            <pc:sldMk cId="2940357804" sldId="297"/>
            <ac:picMk id="25" creationId="{98063E50-E767-4083-F3B1-17C996A72F32}"/>
          </ac:picMkLst>
        </pc:picChg>
        <pc:picChg chg="mod">
          <ac:chgData name="Kumar, Vinod" userId="a0710a6e-bffc-4971-8893-1c23addeb5b0" providerId="ADAL" clId="{922FE477-A091-45D2-9AFE-0801C4DD56C7}" dt="2022-09-21T00:22:40.034" v="1169"/>
          <ac:picMkLst>
            <pc:docMk/>
            <pc:sldMk cId="2940357804" sldId="297"/>
            <ac:picMk id="28" creationId="{56431426-912D-AF86-E38D-D708EFA8FD6C}"/>
          </ac:picMkLst>
        </pc:picChg>
        <pc:picChg chg="mod">
          <ac:chgData name="Kumar, Vinod" userId="a0710a6e-bffc-4971-8893-1c23addeb5b0" providerId="ADAL" clId="{922FE477-A091-45D2-9AFE-0801C4DD56C7}" dt="2022-09-21T00:22:40.034" v="1169"/>
          <ac:picMkLst>
            <pc:docMk/>
            <pc:sldMk cId="2940357804" sldId="297"/>
            <ac:picMk id="32" creationId="{0B901587-AAB2-135E-6193-1A825CEBC5C0}"/>
          </ac:picMkLst>
        </pc:picChg>
        <pc:picChg chg="mod">
          <ac:chgData name="Kumar, Vinod" userId="a0710a6e-bffc-4971-8893-1c23addeb5b0" providerId="ADAL" clId="{922FE477-A091-45D2-9AFE-0801C4DD56C7}" dt="2022-09-21T00:22:40.034" v="1169"/>
          <ac:picMkLst>
            <pc:docMk/>
            <pc:sldMk cId="2940357804" sldId="297"/>
            <ac:picMk id="33" creationId="{BFD98846-555D-C02B-835E-AB5C2F5B439A}"/>
          </ac:picMkLst>
        </pc:picChg>
        <pc:picChg chg="mod">
          <ac:chgData name="Kumar, Vinod" userId="a0710a6e-bffc-4971-8893-1c23addeb5b0" providerId="ADAL" clId="{922FE477-A091-45D2-9AFE-0801C4DD56C7}" dt="2022-09-21T00:22:40.034" v="1169"/>
          <ac:picMkLst>
            <pc:docMk/>
            <pc:sldMk cId="2940357804" sldId="297"/>
            <ac:picMk id="34" creationId="{34174FCA-F8B8-E99A-BC8C-3EDCE7B8D46E}"/>
          </ac:picMkLst>
        </pc:picChg>
        <pc:picChg chg="mod">
          <ac:chgData name="Kumar, Vinod" userId="a0710a6e-bffc-4971-8893-1c23addeb5b0" providerId="ADAL" clId="{922FE477-A091-45D2-9AFE-0801C4DD56C7}" dt="2022-09-21T00:22:40.034" v="1169"/>
          <ac:picMkLst>
            <pc:docMk/>
            <pc:sldMk cId="2940357804" sldId="297"/>
            <ac:picMk id="35" creationId="{FE7373D6-CCCB-B1CC-588A-4EA8971DB8AF}"/>
          </ac:picMkLst>
        </pc:picChg>
        <pc:picChg chg="mod">
          <ac:chgData name="Kumar, Vinod" userId="a0710a6e-bffc-4971-8893-1c23addeb5b0" providerId="ADAL" clId="{922FE477-A091-45D2-9AFE-0801C4DD56C7}" dt="2022-09-21T00:22:40.034" v="1169"/>
          <ac:picMkLst>
            <pc:docMk/>
            <pc:sldMk cId="2940357804" sldId="297"/>
            <ac:picMk id="37" creationId="{3DDC70BF-EB95-50EC-387A-599796F6431B}"/>
          </ac:picMkLst>
        </pc:picChg>
        <pc:picChg chg="mod">
          <ac:chgData name="Kumar, Vinod" userId="a0710a6e-bffc-4971-8893-1c23addeb5b0" providerId="ADAL" clId="{922FE477-A091-45D2-9AFE-0801C4DD56C7}" dt="2022-09-21T00:22:40.034" v="1169"/>
          <ac:picMkLst>
            <pc:docMk/>
            <pc:sldMk cId="2940357804" sldId="297"/>
            <ac:picMk id="39" creationId="{3EFC68B7-B711-FF90-BD1C-012D652399B7}"/>
          </ac:picMkLst>
        </pc:picChg>
        <pc:picChg chg="mod">
          <ac:chgData name="Kumar, Vinod" userId="a0710a6e-bffc-4971-8893-1c23addeb5b0" providerId="ADAL" clId="{922FE477-A091-45D2-9AFE-0801C4DD56C7}" dt="2022-09-21T00:23:59.113" v="1195" actId="1037"/>
          <ac:picMkLst>
            <pc:docMk/>
            <pc:sldMk cId="2940357804" sldId="297"/>
            <ac:picMk id="41" creationId="{17743872-5917-164D-38E3-0DFB17069E23}"/>
          </ac:picMkLst>
        </pc:picChg>
        <pc:picChg chg="mod">
          <ac:chgData name="Kumar, Vinod" userId="a0710a6e-bffc-4971-8893-1c23addeb5b0" providerId="ADAL" clId="{922FE477-A091-45D2-9AFE-0801C4DD56C7}" dt="2022-09-21T00:23:59.113" v="1195" actId="1037"/>
          <ac:picMkLst>
            <pc:docMk/>
            <pc:sldMk cId="2940357804" sldId="297"/>
            <ac:picMk id="60" creationId="{4F552FD8-66E6-BA6D-DDFF-8A9994E3DF4D}"/>
          </ac:picMkLst>
        </pc:picChg>
        <pc:picChg chg="mod">
          <ac:chgData name="Kumar, Vinod" userId="a0710a6e-bffc-4971-8893-1c23addeb5b0" providerId="ADAL" clId="{922FE477-A091-45D2-9AFE-0801C4DD56C7}" dt="2022-09-21T00:23:59.113" v="1195" actId="1037"/>
          <ac:picMkLst>
            <pc:docMk/>
            <pc:sldMk cId="2940357804" sldId="297"/>
            <ac:picMk id="61" creationId="{109F7809-ECEB-8CF1-ED2A-A12585575460}"/>
          </ac:picMkLst>
        </pc:picChg>
        <pc:picChg chg="mod">
          <ac:chgData name="Kumar, Vinod" userId="a0710a6e-bffc-4971-8893-1c23addeb5b0" providerId="ADAL" clId="{922FE477-A091-45D2-9AFE-0801C4DD56C7}" dt="2022-09-21T00:23:59.113" v="1195" actId="1037"/>
          <ac:picMkLst>
            <pc:docMk/>
            <pc:sldMk cId="2940357804" sldId="297"/>
            <ac:picMk id="64" creationId="{6ED190E8-2C92-BD77-158A-EC6562654CB2}"/>
          </ac:picMkLst>
        </pc:picChg>
        <pc:picChg chg="mod">
          <ac:chgData name="Kumar, Vinod" userId="a0710a6e-bffc-4971-8893-1c23addeb5b0" providerId="ADAL" clId="{922FE477-A091-45D2-9AFE-0801C4DD56C7}" dt="2022-09-21T00:23:59.113" v="1195" actId="1037"/>
          <ac:picMkLst>
            <pc:docMk/>
            <pc:sldMk cId="2940357804" sldId="297"/>
            <ac:picMk id="68" creationId="{7225DEE0-982D-1532-1CC8-10D73394D444}"/>
          </ac:picMkLst>
        </pc:picChg>
        <pc:picChg chg="mod">
          <ac:chgData name="Kumar, Vinod" userId="a0710a6e-bffc-4971-8893-1c23addeb5b0" providerId="ADAL" clId="{922FE477-A091-45D2-9AFE-0801C4DD56C7}" dt="2022-09-21T00:23:59.113" v="1195" actId="1037"/>
          <ac:picMkLst>
            <pc:docMk/>
            <pc:sldMk cId="2940357804" sldId="297"/>
            <ac:picMk id="69" creationId="{AEA13239-456D-8A7E-9BC2-4295CC4F3B73}"/>
          </ac:picMkLst>
        </pc:picChg>
        <pc:picChg chg="mod">
          <ac:chgData name="Kumar, Vinod" userId="a0710a6e-bffc-4971-8893-1c23addeb5b0" providerId="ADAL" clId="{922FE477-A091-45D2-9AFE-0801C4DD56C7}" dt="2022-09-21T00:23:59.113" v="1195" actId="1037"/>
          <ac:picMkLst>
            <pc:docMk/>
            <pc:sldMk cId="2940357804" sldId="297"/>
            <ac:picMk id="70" creationId="{60D63AD3-4077-D953-71AE-377457FE905B}"/>
          </ac:picMkLst>
        </pc:picChg>
        <pc:picChg chg="mod">
          <ac:chgData name="Kumar, Vinod" userId="a0710a6e-bffc-4971-8893-1c23addeb5b0" providerId="ADAL" clId="{922FE477-A091-45D2-9AFE-0801C4DD56C7}" dt="2022-09-21T00:23:59.113" v="1195" actId="1037"/>
          <ac:picMkLst>
            <pc:docMk/>
            <pc:sldMk cId="2940357804" sldId="297"/>
            <ac:picMk id="71" creationId="{2B24F802-9B66-E02A-F9EF-6A6CD81D23BE}"/>
          </ac:picMkLst>
        </pc:picChg>
        <pc:picChg chg="mod">
          <ac:chgData name="Kumar, Vinod" userId="a0710a6e-bffc-4971-8893-1c23addeb5b0" providerId="ADAL" clId="{922FE477-A091-45D2-9AFE-0801C4DD56C7}" dt="2022-09-21T00:23:59.113" v="1195" actId="1037"/>
          <ac:picMkLst>
            <pc:docMk/>
            <pc:sldMk cId="2940357804" sldId="297"/>
            <ac:picMk id="73" creationId="{6E5334B7-97D3-503A-DF60-CEE096ACC426}"/>
          </ac:picMkLst>
        </pc:picChg>
        <pc:picChg chg="mod">
          <ac:chgData name="Kumar, Vinod" userId="a0710a6e-bffc-4971-8893-1c23addeb5b0" providerId="ADAL" clId="{922FE477-A091-45D2-9AFE-0801C4DD56C7}" dt="2022-09-21T00:23:59.113" v="1195" actId="1037"/>
          <ac:picMkLst>
            <pc:docMk/>
            <pc:sldMk cId="2940357804" sldId="297"/>
            <ac:picMk id="75" creationId="{18C758EB-FBFA-9990-15D6-FB0956786175}"/>
          </ac:picMkLst>
        </pc:picChg>
        <pc:picChg chg="add mod">
          <ac:chgData name="Kumar, Vinod" userId="a0710a6e-bffc-4971-8893-1c23addeb5b0" providerId="ADAL" clId="{922FE477-A091-45D2-9AFE-0801C4DD56C7}" dt="2022-09-21T14:08:37.640" v="1625" actId="164"/>
          <ac:picMkLst>
            <pc:docMk/>
            <pc:sldMk cId="2940357804" sldId="297"/>
            <ac:picMk id="76" creationId="{EB52B786-E2A1-E432-CD46-778E88D6EDB8}"/>
          </ac:picMkLst>
        </pc:picChg>
        <pc:picChg chg="add mod">
          <ac:chgData name="Kumar, Vinod" userId="a0710a6e-bffc-4971-8893-1c23addeb5b0" providerId="ADAL" clId="{922FE477-A091-45D2-9AFE-0801C4DD56C7}" dt="2022-09-21T14:13:32.949" v="1633" actId="164"/>
          <ac:picMkLst>
            <pc:docMk/>
            <pc:sldMk cId="2940357804" sldId="297"/>
            <ac:picMk id="77" creationId="{7E61A03E-C27B-DB9B-9516-4DBA7035F5CC}"/>
          </ac:picMkLst>
        </pc:picChg>
        <pc:picChg chg="add del mod">
          <ac:chgData name="Kumar, Vinod" userId="a0710a6e-bffc-4971-8893-1c23addeb5b0" providerId="ADAL" clId="{922FE477-A091-45D2-9AFE-0801C4DD56C7}" dt="2022-09-21T13:52:29.103" v="1210" actId="478"/>
          <ac:picMkLst>
            <pc:docMk/>
            <pc:sldMk cId="2940357804" sldId="297"/>
            <ac:picMk id="78" creationId="{21DA45A4-6C9B-D112-2C33-E935A089F290}"/>
          </ac:picMkLst>
        </pc:picChg>
        <pc:picChg chg="add mod">
          <ac:chgData name="Kumar, Vinod" userId="a0710a6e-bffc-4971-8893-1c23addeb5b0" providerId="ADAL" clId="{922FE477-A091-45D2-9AFE-0801C4DD56C7}" dt="2022-09-21T14:08:33.640" v="1624" actId="164"/>
          <ac:picMkLst>
            <pc:docMk/>
            <pc:sldMk cId="2940357804" sldId="297"/>
            <ac:picMk id="79" creationId="{E53C9645-1EDA-B6BA-8609-A858C25C26A2}"/>
          </ac:picMkLst>
        </pc:picChg>
        <pc:picChg chg="add mod">
          <ac:chgData name="Kumar, Vinod" userId="a0710a6e-bffc-4971-8893-1c23addeb5b0" providerId="ADAL" clId="{922FE477-A091-45D2-9AFE-0801C4DD56C7}" dt="2022-09-21T14:08:30.096" v="1623" actId="164"/>
          <ac:picMkLst>
            <pc:docMk/>
            <pc:sldMk cId="2940357804" sldId="297"/>
            <ac:picMk id="80" creationId="{2C091A8D-6090-0C3D-AE87-9D1561EFF26F}"/>
          </ac:picMkLst>
        </pc:picChg>
        <pc:picChg chg="add mod">
          <ac:chgData name="Kumar, Vinod" userId="a0710a6e-bffc-4971-8893-1c23addeb5b0" providerId="ADAL" clId="{922FE477-A091-45D2-9AFE-0801C4DD56C7}" dt="2022-09-21T14:08:22.088" v="1622" actId="164"/>
          <ac:picMkLst>
            <pc:docMk/>
            <pc:sldMk cId="2940357804" sldId="297"/>
            <ac:picMk id="81" creationId="{62E01015-B5CC-BCD8-66D9-A6ED93898AA7}"/>
          </ac:picMkLst>
        </pc:picChg>
        <pc:picChg chg="add mod">
          <ac:chgData name="Kumar, Vinod" userId="a0710a6e-bffc-4971-8893-1c23addeb5b0" providerId="ADAL" clId="{922FE477-A091-45D2-9AFE-0801C4DD56C7}" dt="2022-09-21T14:08:16.881" v="1621" actId="164"/>
          <ac:picMkLst>
            <pc:docMk/>
            <pc:sldMk cId="2940357804" sldId="297"/>
            <ac:picMk id="82" creationId="{B68CD34F-BDE4-3030-5CBE-91230EB15E7B}"/>
          </ac:picMkLst>
        </pc:picChg>
      </pc:sldChg>
      <pc:sldChg chg="new del">
        <pc:chgData name="Kumar, Vinod" userId="a0710a6e-bffc-4971-8893-1c23addeb5b0" providerId="ADAL" clId="{922FE477-A091-45D2-9AFE-0801C4DD56C7}" dt="2022-09-21T16:04:14.672" v="1672" actId="680"/>
        <pc:sldMkLst>
          <pc:docMk/>
          <pc:sldMk cId="3035988712" sldId="298"/>
        </pc:sldMkLst>
      </pc:sldChg>
      <pc:sldChg chg="addSp delSp modSp add mod">
        <pc:chgData name="Kumar, Vinod" userId="a0710a6e-bffc-4971-8893-1c23addeb5b0" providerId="ADAL" clId="{922FE477-A091-45D2-9AFE-0801C4DD56C7}" dt="2022-09-26T21:10:38.529" v="4258" actId="1076"/>
        <pc:sldMkLst>
          <pc:docMk/>
          <pc:sldMk cId="3985943826" sldId="298"/>
        </pc:sldMkLst>
        <pc:spChg chg="mod">
          <ac:chgData name="Kumar, Vinod" userId="a0710a6e-bffc-4971-8893-1c23addeb5b0" providerId="ADAL" clId="{922FE477-A091-45D2-9AFE-0801C4DD56C7}" dt="2022-09-21T21:01:25.914" v="2162" actId="1037"/>
          <ac:spMkLst>
            <pc:docMk/>
            <pc:sldMk cId="3985943826" sldId="298"/>
            <ac:spMk id="7" creationId="{C56CA07C-310B-7CB3-A9A5-D9A9ED7A54FF}"/>
          </ac:spMkLst>
        </pc:spChg>
        <pc:spChg chg="add mod topLvl">
          <ac:chgData name="Kumar, Vinod" userId="a0710a6e-bffc-4971-8893-1c23addeb5b0" providerId="ADAL" clId="{922FE477-A091-45D2-9AFE-0801C4DD56C7}" dt="2022-09-26T21:09:53.418" v="4250" actId="165"/>
          <ac:spMkLst>
            <pc:docMk/>
            <pc:sldMk cId="3985943826" sldId="298"/>
            <ac:spMk id="12" creationId="{B71961F2-19E2-1197-498E-C19AF204CD09}"/>
          </ac:spMkLst>
        </pc:spChg>
        <pc:spChg chg="add mod topLvl">
          <ac:chgData name="Kumar, Vinod" userId="a0710a6e-bffc-4971-8893-1c23addeb5b0" providerId="ADAL" clId="{922FE477-A091-45D2-9AFE-0801C4DD56C7}" dt="2022-09-26T21:10:18.967" v="4253" actId="165"/>
          <ac:spMkLst>
            <pc:docMk/>
            <pc:sldMk cId="3985943826" sldId="298"/>
            <ac:spMk id="13" creationId="{ACF2B04D-9C9F-02B2-2D66-E367899E64AC}"/>
          </ac:spMkLst>
        </pc:spChg>
        <pc:spChg chg="add mod topLvl">
          <ac:chgData name="Kumar, Vinod" userId="a0710a6e-bffc-4971-8893-1c23addeb5b0" providerId="ADAL" clId="{922FE477-A091-45D2-9AFE-0801C4DD56C7}" dt="2022-09-26T21:10:32.464" v="4256" actId="165"/>
          <ac:spMkLst>
            <pc:docMk/>
            <pc:sldMk cId="3985943826" sldId="298"/>
            <ac:spMk id="14" creationId="{4E7CC544-17E8-D9E7-9CE6-E4ACB6D489E4}"/>
          </ac:spMkLst>
        </pc:spChg>
        <pc:spChg chg="add mod">
          <ac:chgData name="Kumar, Vinod" userId="a0710a6e-bffc-4971-8893-1c23addeb5b0" providerId="ADAL" clId="{922FE477-A091-45D2-9AFE-0801C4DD56C7}" dt="2022-09-21T20:58:01.179" v="2063" actId="164"/>
          <ac:spMkLst>
            <pc:docMk/>
            <pc:sldMk cId="3985943826" sldId="298"/>
            <ac:spMk id="15" creationId="{C9966145-AF7F-3F24-8F5F-CE1575640C87}"/>
          </ac:spMkLst>
        </pc:spChg>
        <pc:spChg chg="add mod">
          <ac:chgData name="Kumar, Vinod" userId="a0710a6e-bffc-4971-8893-1c23addeb5b0" providerId="ADAL" clId="{922FE477-A091-45D2-9AFE-0801C4DD56C7}" dt="2022-09-21T20:58:07.917" v="2064" actId="164"/>
          <ac:spMkLst>
            <pc:docMk/>
            <pc:sldMk cId="3985943826" sldId="298"/>
            <ac:spMk id="16" creationId="{80E1D947-D1C1-3776-8B9C-0A300DA37F05}"/>
          </ac:spMkLst>
        </pc:spChg>
        <pc:spChg chg="add mod">
          <ac:chgData name="Kumar, Vinod" userId="a0710a6e-bffc-4971-8893-1c23addeb5b0" providerId="ADAL" clId="{922FE477-A091-45D2-9AFE-0801C4DD56C7}" dt="2022-09-21T20:58:12.852" v="2065" actId="164"/>
          <ac:spMkLst>
            <pc:docMk/>
            <pc:sldMk cId="3985943826" sldId="298"/>
            <ac:spMk id="17" creationId="{59E76DD2-DA34-C062-5482-409DC092B87A}"/>
          </ac:spMkLst>
        </pc:spChg>
        <pc:spChg chg="add mod">
          <ac:chgData name="Kumar, Vinod" userId="a0710a6e-bffc-4971-8893-1c23addeb5b0" providerId="ADAL" clId="{922FE477-A091-45D2-9AFE-0801C4DD56C7}" dt="2022-09-21T21:01:36.026" v="2167" actId="1036"/>
          <ac:spMkLst>
            <pc:docMk/>
            <pc:sldMk cId="3985943826" sldId="298"/>
            <ac:spMk id="25" creationId="{45A95E75-F17B-EC2F-8D43-49F7C6D0FAA3}"/>
          </ac:spMkLst>
        </pc:spChg>
        <pc:spChg chg="add mod">
          <ac:chgData name="Kumar, Vinod" userId="a0710a6e-bffc-4971-8893-1c23addeb5b0" providerId="ADAL" clId="{922FE477-A091-45D2-9AFE-0801C4DD56C7}" dt="2022-09-21T21:01:36.026" v="2167" actId="1036"/>
          <ac:spMkLst>
            <pc:docMk/>
            <pc:sldMk cId="3985943826" sldId="298"/>
            <ac:spMk id="26" creationId="{561178A7-B046-40D5-7854-03BC6BF5A350}"/>
          </ac:spMkLst>
        </pc:spChg>
        <pc:spChg chg="add mod">
          <ac:chgData name="Kumar, Vinod" userId="a0710a6e-bffc-4971-8893-1c23addeb5b0" providerId="ADAL" clId="{922FE477-A091-45D2-9AFE-0801C4DD56C7}" dt="2022-09-21T21:02:36.121" v="2172" actId="14100"/>
          <ac:spMkLst>
            <pc:docMk/>
            <pc:sldMk cId="3985943826" sldId="298"/>
            <ac:spMk id="27" creationId="{BD4E4445-28D2-4129-3036-3323644B16B0}"/>
          </ac:spMkLst>
        </pc:spChg>
        <pc:spChg chg="add mod">
          <ac:chgData name="Kumar, Vinod" userId="a0710a6e-bffc-4971-8893-1c23addeb5b0" providerId="ADAL" clId="{922FE477-A091-45D2-9AFE-0801C4DD56C7}" dt="2022-09-21T21:02:58.794" v="2240" actId="20577"/>
          <ac:spMkLst>
            <pc:docMk/>
            <pc:sldMk cId="3985943826" sldId="298"/>
            <ac:spMk id="28" creationId="{D35326DD-46F5-9DA1-F1F7-03BEB005F278}"/>
          </ac:spMkLst>
        </pc:spChg>
        <pc:spChg chg="add mod">
          <ac:chgData name="Kumar, Vinod" userId="a0710a6e-bffc-4971-8893-1c23addeb5b0" providerId="ADAL" clId="{922FE477-A091-45D2-9AFE-0801C4DD56C7}" dt="2022-09-21T21:03:18.507" v="2277" actId="20577"/>
          <ac:spMkLst>
            <pc:docMk/>
            <pc:sldMk cId="3985943826" sldId="298"/>
            <ac:spMk id="29" creationId="{A4071D75-1134-2EBD-EAD8-F25DEB96167F}"/>
          </ac:spMkLst>
        </pc:spChg>
        <pc:spChg chg="add mod">
          <ac:chgData name="Kumar, Vinod" userId="a0710a6e-bffc-4971-8893-1c23addeb5b0" providerId="ADAL" clId="{922FE477-A091-45D2-9AFE-0801C4DD56C7}" dt="2022-09-21T21:03:21.722" v="2278" actId="20577"/>
          <ac:spMkLst>
            <pc:docMk/>
            <pc:sldMk cId="3985943826" sldId="298"/>
            <ac:spMk id="30" creationId="{EB2A02B6-5496-BCBD-21D8-09AA872B21CF}"/>
          </ac:spMkLst>
        </pc:spChg>
        <pc:spChg chg="add mod">
          <ac:chgData name="Kumar, Vinod" userId="a0710a6e-bffc-4971-8893-1c23addeb5b0" providerId="ADAL" clId="{922FE477-A091-45D2-9AFE-0801C4DD56C7}" dt="2022-09-21T21:03:43.706" v="2374" actId="20577"/>
          <ac:spMkLst>
            <pc:docMk/>
            <pc:sldMk cId="3985943826" sldId="298"/>
            <ac:spMk id="31" creationId="{3E7F4159-1B76-3536-68DF-046BB2D1C7FB}"/>
          </ac:spMkLst>
        </pc:spChg>
        <pc:spChg chg="add mod">
          <ac:chgData name="Kumar, Vinod" userId="a0710a6e-bffc-4971-8893-1c23addeb5b0" providerId="ADAL" clId="{922FE477-A091-45D2-9AFE-0801C4DD56C7}" dt="2022-09-21T21:03:48.026" v="2375" actId="20577"/>
          <ac:spMkLst>
            <pc:docMk/>
            <pc:sldMk cId="3985943826" sldId="298"/>
            <ac:spMk id="32" creationId="{CAAB3955-9E5B-9C32-7E26-C30724BA6D94}"/>
          </ac:spMkLst>
        </pc:spChg>
        <pc:spChg chg="add mod">
          <ac:chgData name="Kumar, Vinod" userId="a0710a6e-bffc-4971-8893-1c23addeb5b0" providerId="ADAL" clId="{922FE477-A091-45D2-9AFE-0801C4DD56C7}" dt="2022-09-22T16:01:33.820" v="3028" actId="1076"/>
          <ac:spMkLst>
            <pc:docMk/>
            <pc:sldMk cId="3985943826" sldId="298"/>
            <ac:spMk id="37" creationId="{B1625E0F-F482-39FD-F251-9DD0433D9E04}"/>
          </ac:spMkLst>
        </pc:spChg>
        <pc:spChg chg="add mod">
          <ac:chgData name="Kumar, Vinod" userId="a0710a6e-bffc-4971-8893-1c23addeb5b0" providerId="ADAL" clId="{922FE477-A091-45D2-9AFE-0801C4DD56C7}" dt="2022-09-22T16:01:45.556" v="3030" actId="1037"/>
          <ac:spMkLst>
            <pc:docMk/>
            <pc:sldMk cId="3985943826" sldId="298"/>
            <ac:spMk id="38" creationId="{35F08F41-CCCA-E0B7-2278-A4458E754EF4}"/>
          </ac:spMkLst>
        </pc:spChg>
        <pc:spChg chg="add mod">
          <ac:chgData name="Kumar, Vinod" userId="a0710a6e-bffc-4971-8893-1c23addeb5b0" providerId="ADAL" clId="{922FE477-A091-45D2-9AFE-0801C4DD56C7}" dt="2022-09-22T16:02:05.717" v="3033" actId="20577"/>
          <ac:spMkLst>
            <pc:docMk/>
            <pc:sldMk cId="3985943826" sldId="298"/>
            <ac:spMk id="39" creationId="{30805481-0841-0FF4-CBB8-7147A95FE5AD}"/>
          </ac:spMkLst>
        </pc:spChg>
        <pc:grpChg chg="add del mod">
          <ac:chgData name="Kumar, Vinod" userId="a0710a6e-bffc-4971-8893-1c23addeb5b0" providerId="ADAL" clId="{922FE477-A091-45D2-9AFE-0801C4DD56C7}" dt="2022-09-26T21:10:32.464" v="4256" actId="165"/>
          <ac:grpSpMkLst>
            <pc:docMk/>
            <pc:sldMk cId="3985943826" sldId="298"/>
            <ac:grpSpMk id="10" creationId="{B9321A9B-D933-CDEC-D21A-8F190A3ED207}"/>
          </ac:grpSpMkLst>
        </pc:grpChg>
        <pc:grpChg chg="add del mod">
          <ac:chgData name="Kumar, Vinod" userId="a0710a6e-bffc-4971-8893-1c23addeb5b0" providerId="ADAL" clId="{922FE477-A091-45D2-9AFE-0801C4DD56C7}" dt="2022-09-26T21:10:18.967" v="4253" actId="165"/>
          <ac:grpSpMkLst>
            <pc:docMk/>
            <pc:sldMk cId="3985943826" sldId="298"/>
            <ac:grpSpMk id="18" creationId="{7ED9BADB-5104-BDD4-6B28-046908EED1DE}"/>
          </ac:grpSpMkLst>
        </pc:grpChg>
        <pc:grpChg chg="add del mod">
          <ac:chgData name="Kumar, Vinod" userId="a0710a6e-bffc-4971-8893-1c23addeb5b0" providerId="ADAL" clId="{922FE477-A091-45D2-9AFE-0801C4DD56C7}" dt="2022-09-26T21:09:53.418" v="4250" actId="165"/>
          <ac:grpSpMkLst>
            <pc:docMk/>
            <pc:sldMk cId="3985943826" sldId="298"/>
            <ac:grpSpMk id="19" creationId="{2B6E02B5-6D3C-6D23-9F34-6955A2B985B0}"/>
          </ac:grpSpMkLst>
        </pc:grpChg>
        <pc:grpChg chg="add mod">
          <ac:chgData name="Kumar, Vinod" userId="a0710a6e-bffc-4971-8893-1c23addeb5b0" providerId="ADAL" clId="{922FE477-A091-45D2-9AFE-0801C4DD56C7}" dt="2022-09-21T21:01:36.026" v="2167" actId="1036"/>
          <ac:grpSpMkLst>
            <pc:docMk/>
            <pc:sldMk cId="3985943826" sldId="298"/>
            <ac:grpSpMk id="20" creationId="{5DADFBA5-FF9F-DBD0-9156-3B77B03A6436}"/>
          </ac:grpSpMkLst>
        </pc:grpChg>
        <pc:grpChg chg="add mod">
          <ac:chgData name="Kumar, Vinod" userId="a0710a6e-bffc-4971-8893-1c23addeb5b0" providerId="ADAL" clId="{922FE477-A091-45D2-9AFE-0801C4DD56C7}" dt="2022-09-21T21:01:36.026" v="2167" actId="1036"/>
          <ac:grpSpMkLst>
            <pc:docMk/>
            <pc:sldMk cId="3985943826" sldId="298"/>
            <ac:grpSpMk id="21" creationId="{35AA0A0D-7F72-C711-6A2C-9FC8865DAAB7}"/>
          </ac:grpSpMkLst>
        </pc:grpChg>
        <pc:grpChg chg="add mod">
          <ac:chgData name="Kumar, Vinod" userId="a0710a6e-bffc-4971-8893-1c23addeb5b0" providerId="ADAL" clId="{922FE477-A091-45D2-9AFE-0801C4DD56C7}" dt="2022-09-21T21:01:36.026" v="2167" actId="1036"/>
          <ac:grpSpMkLst>
            <pc:docMk/>
            <pc:sldMk cId="3985943826" sldId="298"/>
            <ac:grpSpMk id="22" creationId="{D27A6A55-FC38-883A-5FD5-B78902EB220F}"/>
          </ac:grpSpMkLst>
        </pc:grpChg>
        <pc:picChg chg="del mod modCrop">
          <ac:chgData name="Kumar, Vinod" userId="a0710a6e-bffc-4971-8893-1c23addeb5b0" providerId="ADAL" clId="{922FE477-A091-45D2-9AFE-0801C4DD56C7}" dt="2022-09-22T17:47:25.953" v="3054" actId="478"/>
          <ac:picMkLst>
            <pc:docMk/>
            <pc:sldMk cId="3985943826" sldId="298"/>
            <ac:picMk id="2" creationId="{3BB96614-3315-1131-FC0E-9908756F232C}"/>
          </ac:picMkLst>
        </pc:picChg>
        <pc:picChg chg="mod">
          <ac:chgData name="Kumar, Vinod" userId="a0710a6e-bffc-4971-8893-1c23addeb5b0" providerId="ADAL" clId="{922FE477-A091-45D2-9AFE-0801C4DD56C7}" dt="2022-09-26T21:10:02.505" v="4252" actId="1076"/>
          <ac:picMkLst>
            <pc:docMk/>
            <pc:sldMk cId="3985943826" sldId="298"/>
            <ac:picMk id="2" creationId="{AC804B11-4759-2D94-11EA-934D8B41E27C}"/>
          </ac:picMkLst>
        </pc:picChg>
        <pc:picChg chg="del mod">
          <ac:chgData name="Kumar, Vinod" userId="a0710a6e-bffc-4971-8893-1c23addeb5b0" providerId="ADAL" clId="{922FE477-A091-45D2-9AFE-0801C4DD56C7}" dt="2022-09-21T20:33:20.542" v="1678" actId="478"/>
          <ac:picMkLst>
            <pc:docMk/>
            <pc:sldMk cId="3985943826" sldId="298"/>
            <ac:picMk id="2" creationId="{ED0C90A4-5929-5225-2918-C96492CC0CE9}"/>
          </ac:picMkLst>
        </pc:picChg>
        <pc:picChg chg="del mod topLvl">
          <ac:chgData name="Kumar, Vinod" userId="a0710a6e-bffc-4971-8893-1c23addeb5b0" providerId="ADAL" clId="{922FE477-A091-45D2-9AFE-0801C4DD56C7}" dt="2022-09-26T21:09:55.385" v="4251" actId="478"/>
          <ac:picMkLst>
            <pc:docMk/>
            <pc:sldMk cId="3985943826" sldId="298"/>
            <ac:picMk id="3" creationId="{8D89BB60-9333-0810-CEF4-B6E326B09AF1}"/>
          </ac:picMkLst>
        </pc:picChg>
        <pc:picChg chg="del mod topLvl">
          <ac:chgData name="Kumar, Vinod" userId="a0710a6e-bffc-4971-8893-1c23addeb5b0" providerId="ADAL" clId="{922FE477-A091-45D2-9AFE-0801C4DD56C7}" dt="2022-09-26T21:10:21.161" v="4254" actId="478"/>
          <ac:picMkLst>
            <pc:docMk/>
            <pc:sldMk cId="3985943826" sldId="298"/>
            <ac:picMk id="4" creationId="{CE2C9297-5241-6D67-47D9-5623FB9ED1D3}"/>
          </ac:picMkLst>
        </pc:picChg>
        <pc:picChg chg="del mod topLvl">
          <ac:chgData name="Kumar, Vinod" userId="a0710a6e-bffc-4971-8893-1c23addeb5b0" providerId="ADAL" clId="{922FE477-A091-45D2-9AFE-0801C4DD56C7}" dt="2022-09-26T21:10:34.377" v="4257" actId="478"/>
          <ac:picMkLst>
            <pc:docMk/>
            <pc:sldMk cId="3985943826" sldId="298"/>
            <ac:picMk id="5" creationId="{F4D627EE-C501-969E-5337-A95128055AB4}"/>
          </ac:picMkLst>
        </pc:picChg>
        <pc:picChg chg="mod">
          <ac:chgData name="Kumar, Vinod" userId="a0710a6e-bffc-4971-8893-1c23addeb5b0" providerId="ADAL" clId="{922FE477-A091-45D2-9AFE-0801C4DD56C7}" dt="2022-09-21T20:58:07.917" v="2064" actId="164"/>
          <ac:picMkLst>
            <pc:docMk/>
            <pc:sldMk cId="3985943826" sldId="298"/>
            <ac:picMk id="6" creationId="{F0FD9C0F-7287-3731-EA35-44C9ED0D6786}"/>
          </ac:picMkLst>
        </pc:picChg>
        <pc:picChg chg="mod">
          <ac:chgData name="Kumar, Vinod" userId="a0710a6e-bffc-4971-8893-1c23addeb5b0" providerId="ADAL" clId="{922FE477-A091-45D2-9AFE-0801C4DD56C7}" dt="2022-09-21T20:58:01.179" v="2063" actId="164"/>
          <ac:picMkLst>
            <pc:docMk/>
            <pc:sldMk cId="3985943826" sldId="298"/>
            <ac:picMk id="8" creationId="{F67BC46A-BF0B-3C21-D7AF-B86082BA552E}"/>
          </ac:picMkLst>
        </pc:picChg>
        <pc:picChg chg="mod">
          <ac:chgData name="Kumar, Vinod" userId="a0710a6e-bffc-4971-8893-1c23addeb5b0" providerId="ADAL" clId="{922FE477-A091-45D2-9AFE-0801C4DD56C7}" dt="2022-09-21T20:58:12.852" v="2065" actId="164"/>
          <ac:picMkLst>
            <pc:docMk/>
            <pc:sldMk cId="3985943826" sldId="298"/>
            <ac:picMk id="9" creationId="{50991457-B44B-9D80-8E5C-C9F802E41E1F}"/>
          </ac:picMkLst>
        </pc:picChg>
        <pc:picChg chg="mod">
          <ac:chgData name="Kumar, Vinod" userId="a0710a6e-bffc-4971-8893-1c23addeb5b0" providerId="ADAL" clId="{922FE477-A091-45D2-9AFE-0801C4DD56C7}" dt="2022-09-22T18:30:49.842" v="3069" actId="1076"/>
          <ac:picMkLst>
            <pc:docMk/>
            <pc:sldMk cId="3985943826" sldId="298"/>
            <ac:picMk id="11" creationId="{08982020-ED1D-F549-42A0-0D0118564230}"/>
          </ac:picMkLst>
        </pc:picChg>
        <pc:picChg chg="del">
          <ac:chgData name="Kumar, Vinod" userId="a0710a6e-bffc-4971-8893-1c23addeb5b0" providerId="ADAL" clId="{922FE477-A091-45D2-9AFE-0801C4DD56C7}" dt="2022-09-21T16:04:31.548" v="1676" actId="478"/>
          <ac:picMkLst>
            <pc:docMk/>
            <pc:sldMk cId="3985943826" sldId="298"/>
            <ac:picMk id="11" creationId="{1690D837-90D7-621C-05CE-8F8C79BC1C88}"/>
          </ac:picMkLst>
        </pc:picChg>
        <pc:picChg chg="del mod">
          <ac:chgData name="Kumar, Vinod" userId="a0710a6e-bffc-4971-8893-1c23addeb5b0" providerId="ADAL" clId="{922FE477-A091-45D2-9AFE-0801C4DD56C7}" dt="2022-09-26T21:00:35.343" v="3903" actId="478"/>
          <ac:picMkLst>
            <pc:docMk/>
            <pc:sldMk cId="3985943826" sldId="298"/>
            <ac:picMk id="23" creationId="{C29850C3-2323-7A97-5CFD-39C6D1CF6335}"/>
          </ac:picMkLst>
        </pc:picChg>
        <pc:picChg chg="add del mod">
          <ac:chgData name="Kumar, Vinod" userId="a0710a6e-bffc-4971-8893-1c23addeb5b0" providerId="ADAL" clId="{922FE477-A091-45D2-9AFE-0801C4DD56C7}" dt="2022-09-22T16:00:17.670" v="3013" actId="478"/>
          <ac:picMkLst>
            <pc:docMk/>
            <pc:sldMk cId="3985943826" sldId="298"/>
            <ac:picMk id="33" creationId="{44714DBC-05EE-8067-BA01-03188787BDBE}"/>
          </ac:picMkLst>
        </pc:picChg>
        <pc:picChg chg="del mod">
          <ac:chgData name="Kumar, Vinod" userId="a0710a6e-bffc-4971-8893-1c23addeb5b0" providerId="ADAL" clId="{922FE477-A091-45D2-9AFE-0801C4DD56C7}" dt="2022-09-26T21:00:35.343" v="3903" actId="478"/>
          <ac:picMkLst>
            <pc:docMk/>
            <pc:sldMk cId="3985943826" sldId="298"/>
            <ac:picMk id="33" creationId="{47A8AE3E-F0FF-3BF2-9609-490A263E770E}"/>
          </ac:picMkLst>
        </pc:picChg>
        <pc:picChg chg="add mod">
          <ac:chgData name="Kumar, Vinod" userId="a0710a6e-bffc-4971-8893-1c23addeb5b0" providerId="ADAL" clId="{922FE477-A091-45D2-9AFE-0801C4DD56C7}" dt="2022-09-22T16:01:00.613" v="3024" actId="1037"/>
          <ac:picMkLst>
            <pc:docMk/>
            <pc:sldMk cId="3985943826" sldId="298"/>
            <ac:picMk id="34" creationId="{CC0D3593-20DF-B4D7-78F8-CDF00F30AF3D}"/>
          </ac:picMkLst>
        </pc:picChg>
        <pc:picChg chg="add mod">
          <ac:chgData name="Kumar, Vinod" userId="a0710a6e-bffc-4971-8893-1c23addeb5b0" providerId="ADAL" clId="{922FE477-A091-45D2-9AFE-0801C4DD56C7}" dt="2022-09-22T16:01:00.613" v="3024" actId="1037"/>
          <ac:picMkLst>
            <pc:docMk/>
            <pc:sldMk cId="3985943826" sldId="298"/>
            <ac:picMk id="35" creationId="{21816893-D49C-6B58-A2AE-219B8522F605}"/>
          </ac:picMkLst>
        </pc:picChg>
        <pc:picChg chg="add mod">
          <ac:chgData name="Kumar, Vinod" userId="a0710a6e-bffc-4971-8893-1c23addeb5b0" providerId="ADAL" clId="{922FE477-A091-45D2-9AFE-0801C4DD56C7}" dt="2022-09-22T16:01:05.654" v="3025" actId="1037"/>
          <ac:picMkLst>
            <pc:docMk/>
            <pc:sldMk cId="3985943826" sldId="298"/>
            <ac:picMk id="36" creationId="{EE732089-F52C-DA84-94B3-A3B40C351BFB}"/>
          </ac:picMkLst>
        </pc:picChg>
        <pc:picChg chg="mod">
          <ac:chgData name="Kumar, Vinod" userId="a0710a6e-bffc-4971-8893-1c23addeb5b0" providerId="ADAL" clId="{922FE477-A091-45D2-9AFE-0801C4DD56C7}" dt="2022-09-26T21:10:28.217" v="4255" actId="1076"/>
          <ac:picMkLst>
            <pc:docMk/>
            <pc:sldMk cId="3985943826" sldId="298"/>
            <ac:picMk id="40" creationId="{1B8CB3C5-80DF-DD2F-1801-71DBEA63BFF5}"/>
          </ac:picMkLst>
        </pc:picChg>
        <pc:picChg chg="mod">
          <ac:chgData name="Kumar, Vinod" userId="a0710a6e-bffc-4971-8893-1c23addeb5b0" providerId="ADAL" clId="{922FE477-A091-45D2-9AFE-0801C4DD56C7}" dt="2022-09-26T21:10:38.529" v="4258" actId="1076"/>
          <ac:picMkLst>
            <pc:docMk/>
            <pc:sldMk cId="3985943826" sldId="298"/>
            <ac:picMk id="41" creationId="{86775F13-65FC-4079-797F-888F97247CE6}"/>
          </ac:picMkLst>
        </pc:picChg>
        <pc:cxnChg chg="add mod">
          <ac:chgData name="Kumar, Vinod" userId="a0710a6e-bffc-4971-8893-1c23addeb5b0" providerId="ADAL" clId="{922FE477-A091-45D2-9AFE-0801C4DD56C7}" dt="2022-09-21T21:01:36.026" v="2167" actId="1036"/>
          <ac:cxnSpMkLst>
            <pc:docMk/>
            <pc:sldMk cId="3985943826" sldId="298"/>
            <ac:cxnSpMk id="24" creationId="{75B74ABB-2E7B-067E-CB29-30936A17452F}"/>
          </ac:cxnSpMkLst>
        </pc:cxnChg>
      </pc:sldChg>
      <pc:sldChg chg="addSp modSp new mod">
        <pc:chgData name="Kumar, Vinod" userId="a0710a6e-bffc-4971-8893-1c23addeb5b0" providerId="ADAL" clId="{922FE477-A091-45D2-9AFE-0801C4DD56C7}" dt="2022-09-26T14:19:27.724" v="3707" actId="114"/>
        <pc:sldMkLst>
          <pc:docMk/>
          <pc:sldMk cId="2498213667" sldId="299"/>
        </pc:sldMkLst>
        <pc:spChg chg="add mod">
          <ac:chgData name="Kumar, Vinod" userId="a0710a6e-bffc-4971-8893-1c23addeb5b0" providerId="ADAL" clId="{922FE477-A091-45D2-9AFE-0801C4DD56C7}" dt="2022-09-22T18:35:47.215" v="3206" actId="14100"/>
          <ac:spMkLst>
            <pc:docMk/>
            <pc:sldMk cId="2498213667" sldId="299"/>
            <ac:spMk id="2" creationId="{51D40CE4-17B2-7A16-E7B1-F6DFB55A0FA0}"/>
          </ac:spMkLst>
        </pc:spChg>
        <pc:spChg chg="add mod">
          <ac:chgData name="Kumar, Vinod" userId="a0710a6e-bffc-4971-8893-1c23addeb5b0" providerId="ADAL" clId="{922FE477-A091-45D2-9AFE-0801C4DD56C7}" dt="2022-09-26T14:18:18.323" v="3637" actId="1076"/>
          <ac:spMkLst>
            <pc:docMk/>
            <pc:sldMk cId="2498213667" sldId="299"/>
            <ac:spMk id="12" creationId="{E8E8704C-584D-FA36-C26F-521F2E17A65D}"/>
          </ac:spMkLst>
        </pc:spChg>
        <pc:spChg chg="add mod">
          <ac:chgData name="Kumar, Vinod" userId="a0710a6e-bffc-4971-8893-1c23addeb5b0" providerId="ADAL" clId="{922FE477-A091-45D2-9AFE-0801C4DD56C7}" dt="2022-09-26T14:18:26.403" v="3638" actId="1076"/>
          <ac:spMkLst>
            <pc:docMk/>
            <pc:sldMk cId="2498213667" sldId="299"/>
            <ac:spMk id="13" creationId="{3B038702-7E51-64C2-B27E-5ADC07CCC1DE}"/>
          </ac:spMkLst>
        </pc:spChg>
        <pc:spChg chg="add mod">
          <ac:chgData name="Kumar, Vinod" userId="a0710a6e-bffc-4971-8893-1c23addeb5b0" providerId="ADAL" clId="{922FE477-A091-45D2-9AFE-0801C4DD56C7}" dt="2022-09-26T14:18:30.996" v="3639" actId="1076"/>
          <ac:spMkLst>
            <pc:docMk/>
            <pc:sldMk cId="2498213667" sldId="299"/>
            <ac:spMk id="14" creationId="{1BCDF35F-F838-B6D1-70E7-6D3B25B442CA}"/>
          </ac:spMkLst>
        </pc:spChg>
        <pc:spChg chg="add mod">
          <ac:chgData name="Kumar, Vinod" userId="a0710a6e-bffc-4971-8893-1c23addeb5b0" providerId="ADAL" clId="{922FE477-A091-45D2-9AFE-0801C4DD56C7}" dt="2022-09-26T14:18:36.115" v="3640" actId="1076"/>
          <ac:spMkLst>
            <pc:docMk/>
            <pc:sldMk cId="2498213667" sldId="299"/>
            <ac:spMk id="15" creationId="{25AF3F51-D911-F89E-54BF-BC566191F89F}"/>
          </ac:spMkLst>
        </pc:spChg>
        <pc:spChg chg="add mod">
          <ac:chgData name="Kumar, Vinod" userId="a0710a6e-bffc-4971-8893-1c23addeb5b0" providerId="ADAL" clId="{922FE477-A091-45D2-9AFE-0801C4DD56C7}" dt="2022-09-26T14:18:41.867" v="3641" actId="1076"/>
          <ac:spMkLst>
            <pc:docMk/>
            <pc:sldMk cId="2498213667" sldId="299"/>
            <ac:spMk id="16" creationId="{9C2C0DB9-6DFE-DB8A-A61A-CFEDB99B4720}"/>
          </ac:spMkLst>
        </pc:spChg>
        <pc:spChg chg="add mod">
          <ac:chgData name="Kumar, Vinod" userId="a0710a6e-bffc-4971-8893-1c23addeb5b0" providerId="ADAL" clId="{922FE477-A091-45D2-9AFE-0801C4DD56C7}" dt="2022-09-26T14:18:45.555" v="3642" actId="1076"/>
          <ac:spMkLst>
            <pc:docMk/>
            <pc:sldMk cId="2498213667" sldId="299"/>
            <ac:spMk id="17" creationId="{537E5210-E7C4-5358-C65B-CFB27F7A2AE3}"/>
          </ac:spMkLst>
        </pc:spChg>
        <pc:spChg chg="add mod">
          <ac:chgData name="Kumar, Vinod" userId="a0710a6e-bffc-4971-8893-1c23addeb5b0" providerId="ADAL" clId="{922FE477-A091-45D2-9AFE-0801C4DD56C7}" dt="2022-09-26T14:18:54.139" v="3643" actId="1076"/>
          <ac:spMkLst>
            <pc:docMk/>
            <pc:sldMk cId="2498213667" sldId="299"/>
            <ac:spMk id="18" creationId="{2701BE6B-644E-9CF3-4BFE-5B0395BB07AE}"/>
          </ac:spMkLst>
        </pc:spChg>
        <pc:spChg chg="add mod">
          <ac:chgData name="Kumar, Vinod" userId="a0710a6e-bffc-4971-8893-1c23addeb5b0" providerId="ADAL" clId="{922FE477-A091-45D2-9AFE-0801C4DD56C7}" dt="2022-09-26T14:18:58.051" v="3644" actId="1076"/>
          <ac:spMkLst>
            <pc:docMk/>
            <pc:sldMk cId="2498213667" sldId="299"/>
            <ac:spMk id="19" creationId="{9DC79C4B-E217-9AF7-7C48-4D0CDA074AA6}"/>
          </ac:spMkLst>
        </pc:spChg>
        <pc:spChg chg="add mod">
          <ac:chgData name="Kumar, Vinod" userId="a0710a6e-bffc-4971-8893-1c23addeb5b0" providerId="ADAL" clId="{922FE477-A091-45D2-9AFE-0801C4DD56C7}" dt="2022-09-26T14:19:27.724" v="3707" actId="114"/>
          <ac:spMkLst>
            <pc:docMk/>
            <pc:sldMk cId="2498213667" sldId="299"/>
            <ac:spMk id="20" creationId="{BDB3E1FD-D56E-AAB7-AAC1-D89F3C30A6C0}"/>
          </ac:spMkLst>
        </pc:spChg>
        <pc:picChg chg="mod">
          <ac:chgData name="Kumar, Vinod" userId="a0710a6e-bffc-4971-8893-1c23addeb5b0" providerId="ADAL" clId="{922FE477-A091-45D2-9AFE-0801C4DD56C7}" dt="2022-09-26T13:51:41.840" v="3274" actId="1076"/>
          <ac:picMkLst>
            <pc:docMk/>
            <pc:sldMk cId="2498213667" sldId="299"/>
            <ac:picMk id="3" creationId="{FBF35403-61AF-9C85-AFB2-D91B2E63184B}"/>
          </ac:picMkLst>
        </pc:picChg>
        <pc:picChg chg="mod">
          <ac:chgData name="Kumar, Vinod" userId="a0710a6e-bffc-4971-8893-1c23addeb5b0" providerId="ADAL" clId="{922FE477-A091-45D2-9AFE-0801C4DD56C7}" dt="2022-09-26T13:51:56.472" v="3281" actId="1037"/>
          <ac:picMkLst>
            <pc:docMk/>
            <pc:sldMk cId="2498213667" sldId="299"/>
            <ac:picMk id="4" creationId="{B7DE046C-470A-960C-E17F-D265CEC30111}"/>
          </ac:picMkLst>
        </pc:picChg>
        <pc:picChg chg="mod">
          <ac:chgData name="Kumar, Vinod" userId="a0710a6e-bffc-4971-8893-1c23addeb5b0" providerId="ADAL" clId="{922FE477-A091-45D2-9AFE-0801C4DD56C7}" dt="2022-09-26T13:51:53.273" v="3276" actId="1076"/>
          <ac:picMkLst>
            <pc:docMk/>
            <pc:sldMk cId="2498213667" sldId="299"/>
            <ac:picMk id="5" creationId="{D22CD06E-BB45-DAE6-41F1-E7CC9C42B9EA}"/>
          </ac:picMkLst>
        </pc:picChg>
        <pc:picChg chg="mod modCrop">
          <ac:chgData name="Kumar, Vinod" userId="a0710a6e-bffc-4971-8893-1c23addeb5b0" providerId="ADAL" clId="{922FE477-A091-45D2-9AFE-0801C4DD56C7}" dt="2022-09-26T14:02:52.355" v="3353" actId="1037"/>
          <ac:picMkLst>
            <pc:docMk/>
            <pc:sldMk cId="2498213667" sldId="299"/>
            <ac:picMk id="6" creationId="{2BCE7DFC-8741-815D-A3B6-292EA4C73E95}"/>
          </ac:picMkLst>
        </pc:picChg>
        <pc:picChg chg="mod modCrop">
          <ac:chgData name="Kumar, Vinod" userId="a0710a6e-bffc-4971-8893-1c23addeb5b0" providerId="ADAL" clId="{922FE477-A091-45D2-9AFE-0801C4DD56C7}" dt="2022-09-26T14:02:52.355" v="3353" actId="1037"/>
          <ac:picMkLst>
            <pc:docMk/>
            <pc:sldMk cId="2498213667" sldId="299"/>
            <ac:picMk id="7" creationId="{57223056-72AA-174F-6FA9-350A01BC7733}"/>
          </ac:picMkLst>
        </pc:picChg>
        <pc:picChg chg="mod modCrop">
          <ac:chgData name="Kumar, Vinod" userId="a0710a6e-bffc-4971-8893-1c23addeb5b0" providerId="ADAL" clId="{922FE477-A091-45D2-9AFE-0801C4DD56C7}" dt="2022-09-26T14:16:59.628" v="3570" actId="1036"/>
          <ac:picMkLst>
            <pc:docMk/>
            <pc:sldMk cId="2498213667" sldId="299"/>
            <ac:picMk id="8" creationId="{515372DD-085A-0CAC-9F58-3C8B198EACA0}"/>
          </ac:picMkLst>
        </pc:picChg>
        <pc:picChg chg="mod modCrop">
          <ac:chgData name="Kumar, Vinod" userId="a0710a6e-bffc-4971-8893-1c23addeb5b0" providerId="ADAL" clId="{922FE477-A091-45D2-9AFE-0801C4DD56C7}" dt="2022-09-26T14:16:39.460" v="3552" actId="1076"/>
          <ac:picMkLst>
            <pc:docMk/>
            <pc:sldMk cId="2498213667" sldId="299"/>
            <ac:picMk id="9" creationId="{E2D174D9-69F4-0136-FA01-1EBB88CC9824}"/>
          </ac:picMkLst>
        </pc:picChg>
        <pc:picChg chg="mod modCrop">
          <ac:chgData name="Kumar, Vinod" userId="a0710a6e-bffc-4971-8893-1c23addeb5b0" providerId="ADAL" clId="{922FE477-A091-45D2-9AFE-0801C4DD56C7}" dt="2022-09-26T14:16:41.980" v="3553" actId="1076"/>
          <ac:picMkLst>
            <pc:docMk/>
            <pc:sldMk cId="2498213667" sldId="299"/>
            <ac:picMk id="10" creationId="{C485C2EA-332D-FE9B-351D-AACA7B21C507}"/>
          </ac:picMkLst>
        </pc:picChg>
        <pc:picChg chg="mod modCrop">
          <ac:chgData name="Kumar, Vinod" userId="a0710a6e-bffc-4971-8893-1c23addeb5b0" providerId="ADAL" clId="{922FE477-A091-45D2-9AFE-0801C4DD56C7}" dt="2022-09-26T14:16:51.166" v="3566" actId="1038"/>
          <ac:picMkLst>
            <pc:docMk/>
            <pc:sldMk cId="2498213667" sldId="299"/>
            <ac:picMk id="11" creationId="{BBC8BE26-CE50-0E7B-5B74-3DABE34015C5}"/>
          </ac:picMkLst>
        </pc:picChg>
      </pc:sldChg>
      <pc:sldChg chg="modSp add del mod">
        <pc:chgData name="Kumar, Vinod" userId="a0710a6e-bffc-4971-8893-1c23addeb5b0" providerId="ADAL" clId="{922FE477-A091-45D2-9AFE-0801C4DD56C7}" dt="2022-09-21T20:49:22.655" v="1699" actId="47"/>
        <pc:sldMkLst>
          <pc:docMk/>
          <pc:sldMk cId="2739397021" sldId="299"/>
        </pc:sldMkLst>
        <pc:picChg chg="mod">
          <ac:chgData name="Kumar, Vinod" userId="a0710a6e-bffc-4971-8893-1c23addeb5b0" providerId="ADAL" clId="{922FE477-A091-45D2-9AFE-0801C4DD56C7}" dt="2022-09-21T20:48:44.840" v="1693" actId="1076"/>
          <ac:picMkLst>
            <pc:docMk/>
            <pc:sldMk cId="2739397021" sldId="299"/>
            <ac:picMk id="3" creationId="{8D89BB60-9333-0810-CEF4-B6E326B09AF1}"/>
          </ac:picMkLst>
        </pc:picChg>
        <pc:picChg chg="mod">
          <ac:chgData name="Kumar, Vinod" userId="a0710a6e-bffc-4971-8893-1c23addeb5b0" providerId="ADAL" clId="{922FE477-A091-45D2-9AFE-0801C4DD56C7}" dt="2022-09-21T20:48:47.145" v="1694" actId="1076"/>
          <ac:picMkLst>
            <pc:docMk/>
            <pc:sldMk cId="2739397021" sldId="299"/>
            <ac:picMk id="4" creationId="{CE2C9297-5241-6D67-47D9-5623FB9ED1D3}"/>
          </ac:picMkLst>
        </pc:picChg>
        <pc:picChg chg="mod">
          <ac:chgData name="Kumar, Vinod" userId="a0710a6e-bffc-4971-8893-1c23addeb5b0" providerId="ADAL" clId="{922FE477-A091-45D2-9AFE-0801C4DD56C7}" dt="2022-09-21T20:48:51.216" v="1695" actId="1076"/>
          <ac:picMkLst>
            <pc:docMk/>
            <pc:sldMk cId="2739397021" sldId="299"/>
            <ac:picMk id="5" creationId="{F4D627EE-C501-969E-5337-A95128055AB4}"/>
          </ac:picMkLst>
        </pc:picChg>
        <pc:picChg chg="mod">
          <ac:chgData name="Kumar, Vinod" userId="a0710a6e-bffc-4971-8893-1c23addeb5b0" providerId="ADAL" clId="{922FE477-A091-45D2-9AFE-0801C4DD56C7}" dt="2022-09-21T20:48:56.649" v="1697" actId="1076"/>
          <ac:picMkLst>
            <pc:docMk/>
            <pc:sldMk cId="2739397021" sldId="299"/>
            <ac:picMk id="6" creationId="{F0FD9C0F-7287-3731-EA35-44C9ED0D6786}"/>
          </ac:picMkLst>
        </pc:picChg>
        <pc:picChg chg="mod">
          <ac:chgData name="Kumar, Vinod" userId="a0710a6e-bffc-4971-8893-1c23addeb5b0" providerId="ADAL" clId="{922FE477-A091-45D2-9AFE-0801C4DD56C7}" dt="2022-09-21T20:48:54.312" v="1696" actId="1076"/>
          <ac:picMkLst>
            <pc:docMk/>
            <pc:sldMk cId="2739397021" sldId="299"/>
            <ac:picMk id="8" creationId="{F67BC46A-BF0B-3C21-D7AF-B86082BA552E}"/>
          </ac:picMkLst>
        </pc:picChg>
        <pc:picChg chg="mod">
          <ac:chgData name="Kumar, Vinod" userId="a0710a6e-bffc-4971-8893-1c23addeb5b0" providerId="ADAL" clId="{922FE477-A091-45D2-9AFE-0801C4DD56C7}" dt="2022-09-21T20:48:59.256" v="1698" actId="1076"/>
          <ac:picMkLst>
            <pc:docMk/>
            <pc:sldMk cId="2739397021" sldId="299"/>
            <ac:picMk id="9" creationId="{50991457-B44B-9D80-8E5C-C9F802E41E1F}"/>
          </ac:picMkLst>
        </pc:picChg>
      </pc:sldChg>
      <pc:sldChg chg="addSp delSp modSp new mod">
        <pc:chgData name="Kumar, Vinod" userId="a0710a6e-bffc-4971-8893-1c23addeb5b0" providerId="ADAL" clId="{922FE477-A091-45D2-9AFE-0801C4DD56C7}" dt="2022-09-26T14:20:42.267" v="3797" actId="478"/>
        <pc:sldMkLst>
          <pc:docMk/>
          <pc:sldMk cId="2313405284" sldId="300"/>
        </pc:sldMkLst>
        <pc:spChg chg="add mod">
          <ac:chgData name="Kumar, Vinod" userId="a0710a6e-bffc-4971-8893-1c23addeb5b0" providerId="ADAL" clId="{922FE477-A091-45D2-9AFE-0801C4DD56C7}" dt="2022-09-26T13:55:25.942" v="3285" actId="20577"/>
          <ac:spMkLst>
            <pc:docMk/>
            <pc:sldMk cId="2313405284" sldId="300"/>
            <ac:spMk id="2" creationId="{E836C5DC-7746-C954-BC1F-3B9F0DA30868}"/>
          </ac:spMkLst>
        </pc:spChg>
        <pc:spChg chg="add mod">
          <ac:chgData name="Kumar, Vinod" userId="a0710a6e-bffc-4971-8893-1c23addeb5b0" providerId="ADAL" clId="{922FE477-A091-45D2-9AFE-0801C4DD56C7}" dt="2022-09-26T14:20:01.139" v="3788" actId="1076"/>
          <ac:spMkLst>
            <pc:docMk/>
            <pc:sldMk cId="2313405284" sldId="300"/>
            <ac:spMk id="11" creationId="{C64871AB-6521-A550-17B9-FEE41DAD3B8D}"/>
          </ac:spMkLst>
        </pc:spChg>
        <pc:spChg chg="add mod">
          <ac:chgData name="Kumar, Vinod" userId="a0710a6e-bffc-4971-8893-1c23addeb5b0" providerId="ADAL" clId="{922FE477-A091-45D2-9AFE-0801C4DD56C7}" dt="2022-09-26T14:20:04.611" v="3789" actId="1076"/>
          <ac:spMkLst>
            <pc:docMk/>
            <pc:sldMk cId="2313405284" sldId="300"/>
            <ac:spMk id="12" creationId="{DE106EEB-BEC0-DFC6-0302-FA2E623AEC2C}"/>
          </ac:spMkLst>
        </pc:spChg>
        <pc:spChg chg="add mod">
          <ac:chgData name="Kumar, Vinod" userId="a0710a6e-bffc-4971-8893-1c23addeb5b0" providerId="ADAL" clId="{922FE477-A091-45D2-9AFE-0801C4DD56C7}" dt="2022-09-26T14:20:18.547" v="3792" actId="1076"/>
          <ac:spMkLst>
            <pc:docMk/>
            <pc:sldMk cId="2313405284" sldId="300"/>
            <ac:spMk id="13" creationId="{8933CC69-5A26-CFFF-CDF2-7629C88162CC}"/>
          </ac:spMkLst>
        </pc:spChg>
        <pc:spChg chg="add mod">
          <ac:chgData name="Kumar, Vinod" userId="a0710a6e-bffc-4971-8893-1c23addeb5b0" providerId="ADAL" clId="{922FE477-A091-45D2-9AFE-0801C4DD56C7}" dt="2022-09-26T14:20:15.674" v="3791" actId="1076"/>
          <ac:spMkLst>
            <pc:docMk/>
            <pc:sldMk cId="2313405284" sldId="300"/>
            <ac:spMk id="14" creationId="{500AC389-8A93-6C81-C33A-970A6A288B38}"/>
          </ac:spMkLst>
        </pc:spChg>
        <pc:spChg chg="add mod">
          <ac:chgData name="Kumar, Vinod" userId="a0710a6e-bffc-4971-8893-1c23addeb5b0" providerId="ADAL" clId="{922FE477-A091-45D2-9AFE-0801C4DD56C7}" dt="2022-09-26T14:20:23.458" v="3793" actId="1076"/>
          <ac:spMkLst>
            <pc:docMk/>
            <pc:sldMk cId="2313405284" sldId="300"/>
            <ac:spMk id="15" creationId="{12E43E6A-BC7F-1E66-77AD-0D7CCFDBED82}"/>
          </ac:spMkLst>
        </pc:spChg>
        <pc:spChg chg="add mod">
          <ac:chgData name="Kumar, Vinod" userId="a0710a6e-bffc-4971-8893-1c23addeb5b0" providerId="ADAL" clId="{922FE477-A091-45D2-9AFE-0801C4DD56C7}" dt="2022-09-26T14:20:27.810" v="3794" actId="1076"/>
          <ac:spMkLst>
            <pc:docMk/>
            <pc:sldMk cId="2313405284" sldId="300"/>
            <ac:spMk id="16" creationId="{F7E78BC5-387C-1374-456C-397866B099A1}"/>
          </ac:spMkLst>
        </pc:spChg>
        <pc:spChg chg="add mod">
          <ac:chgData name="Kumar, Vinod" userId="a0710a6e-bffc-4971-8893-1c23addeb5b0" providerId="ADAL" clId="{922FE477-A091-45D2-9AFE-0801C4DD56C7}" dt="2022-09-26T14:20:34.682" v="3795" actId="1076"/>
          <ac:spMkLst>
            <pc:docMk/>
            <pc:sldMk cId="2313405284" sldId="300"/>
            <ac:spMk id="17" creationId="{DE811E4C-18B9-AF7B-4E24-A0D0D5FB3A2B}"/>
          </ac:spMkLst>
        </pc:spChg>
        <pc:spChg chg="add mod">
          <ac:chgData name="Kumar, Vinod" userId="a0710a6e-bffc-4971-8893-1c23addeb5b0" providerId="ADAL" clId="{922FE477-A091-45D2-9AFE-0801C4DD56C7}" dt="2022-09-26T14:20:38.683" v="3796" actId="1076"/>
          <ac:spMkLst>
            <pc:docMk/>
            <pc:sldMk cId="2313405284" sldId="300"/>
            <ac:spMk id="18" creationId="{197D5A89-7757-9ED2-8EE0-4D250796B5BB}"/>
          </ac:spMkLst>
        </pc:spChg>
        <pc:spChg chg="add del mod">
          <ac:chgData name="Kumar, Vinod" userId="a0710a6e-bffc-4971-8893-1c23addeb5b0" providerId="ADAL" clId="{922FE477-A091-45D2-9AFE-0801C4DD56C7}" dt="2022-09-26T14:20:42.267" v="3797" actId="478"/>
          <ac:spMkLst>
            <pc:docMk/>
            <pc:sldMk cId="2313405284" sldId="300"/>
            <ac:spMk id="19" creationId="{92CD2E44-7E6C-68AC-438A-225A597E8C00}"/>
          </ac:spMkLst>
        </pc:spChg>
        <pc:picChg chg="mod modCrop">
          <ac:chgData name="Kumar, Vinod" userId="a0710a6e-bffc-4971-8893-1c23addeb5b0" providerId="ADAL" clId="{922FE477-A091-45D2-9AFE-0801C4DD56C7}" dt="2022-09-26T14:11:49.438" v="3532" actId="1036"/>
          <ac:picMkLst>
            <pc:docMk/>
            <pc:sldMk cId="2313405284" sldId="300"/>
            <ac:picMk id="3" creationId="{29DD6D63-398D-9D2D-9E3E-6E0239244671}"/>
          </ac:picMkLst>
        </pc:picChg>
        <pc:picChg chg="mod modCrop">
          <ac:chgData name="Kumar, Vinod" userId="a0710a6e-bffc-4971-8893-1c23addeb5b0" providerId="ADAL" clId="{922FE477-A091-45D2-9AFE-0801C4DD56C7}" dt="2022-09-26T14:11:49.438" v="3532" actId="1036"/>
          <ac:picMkLst>
            <pc:docMk/>
            <pc:sldMk cId="2313405284" sldId="300"/>
            <ac:picMk id="4" creationId="{0E6A30FA-1FCE-8E20-3A3D-C9977710E422}"/>
          </ac:picMkLst>
        </pc:picChg>
        <pc:picChg chg="mod modCrop">
          <ac:chgData name="Kumar, Vinod" userId="a0710a6e-bffc-4971-8893-1c23addeb5b0" providerId="ADAL" clId="{922FE477-A091-45D2-9AFE-0801C4DD56C7}" dt="2022-09-26T14:11:49.438" v="3532" actId="1036"/>
          <ac:picMkLst>
            <pc:docMk/>
            <pc:sldMk cId="2313405284" sldId="300"/>
            <ac:picMk id="5" creationId="{E571617C-7D69-5378-001F-634F214B4A17}"/>
          </ac:picMkLst>
        </pc:picChg>
        <pc:picChg chg="mod modCrop">
          <ac:chgData name="Kumar, Vinod" userId="a0710a6e-bffc-4971-8893-1c23addeb5b0" providerId="ADAL" clId="{922FE477-A091-45D2-9AFE-0801C4DD56C7}" dt="2022-09-26T14:11:49.438" v="3532" actId="1036"/>
          <ac:picMkLst>
            <pc:docMk/>
            <pc:sldMk cId="2313405284" sldId="300"/>
            <ac:picMk id="6" creationId="{54C9136E-B2EE-713C-206F-528275B3E923}"/>
          </ac:picMkLst>
        </pc:picChg>
        <pc:picChg chg="mod modCrop">
          <ac:chgData name="Kumar, Vinod" userId="a0710a6e-bffc-4971-8893-1c23addeb5b0" providerId="ADAL" clId="{922FE477-A091-45D2-9AFE-0801C4DD56C7}" dt="2022-09-26T14:11:49.438" v="3532" actId="1036"/>
          <ac:picMkLst>
            <pc:docMk/>
            <pc:sldMk cId="2313405284" sldId="300"/>
            <ac:picMk id="7" creationId="{F6D86FB7-83E1-07B1-6A6C-3A5DDE32D6B5}"/>
          </ac:picMkLst>
        </pc:picChg>
        <pc:picChg chg="mod modCrop">
          <ac:chgData name="Kumar, Vinod" userId="a0710a6e-bffc-4971-8893-1c23addeb5b0" providerId="ADAL" clId="{922FE477-A091-45D2-9AFE-0801C4DD56C7}" dt="2022-09-26T14:11:49.438" v="3532" actId="1036"/>
          <ac:picMkLst>
            <pc:docMk/>
            <pc:sldMk cId="2313405284" sldId="300"/>
            <ac:picMk id="8" creationId="{5DF73724-2E56-FF83-751A-F90FBC4935A9}"/>
          </ac:picMkLst>
        </pc:picChg>
        <pc:picChg chg="mod modCrop">
          <ac:chgData name="Kumar, Vinod" userId="a0710a6e-bffc-4971-8893-1c23addeb5b0" providerId="ADAL" clId="{922FE477-A091-45D2-9AFE-0801C4DD56C7}" dt="2022-09-26T14:11:56.534" v="3533" actId="1076"/>
          <ac:picMkLst>
            <pc:docMk/>
            <pc:sldMk cId="2313405284" sldId="300"/>
            <ac:picMk id="9" creationId="{BA586AAC-EA6F-0435-4C2A-DF34082B0031}"/>
          </ac:picMkLst>
        </pc:picChg>
        <pc:picChg chg="mod modCrop">
          <ac:chgData name="Kumar, Vinod" userId="a0710a6e-bffc-4971-8893-1c23addeb5b0" providerId="ADAL" clId="{922FE477-A091-45D2-9AFE-0801C4DD56C7}" dt="2022-09-26T14:12:02.750" v="3534" actId="1076"/>
          <ac:picMkLst>
            <pc:docMk/>
            <pc:sldMk cId="2313405284" sldId="300"/>
            <ac:picMk id="10" creationId="{50E22F7A-0AEA-69B1-4EBE-B57F9FBCB1F1}"/>
          </ac:picMkLst>
        </pc:picChg>
      </pc:sldChg>
      <pc:sldChg chg="addSp modSp new mod">
        <pc:chgData name="Kumar, Vinod" userId="a0710a6e-bffc-4971-8893-1c23addeb5b0" providerId="ADAL" clId="{922FE477-A091-45D2-9AFE-0801C4DD56C7}" dt="2022-09-26T15:36:53.173" v="3829" actId="1076"/>
        <pc:sldMkLst>
          <pc:docMk/>
          <pc:sldMk cId="1906182640" sldId="301"/>
        </pc:sldMkLst>
        <pc:spChg chg="add mod">
          <ac:chgData name="Kumar, Vinod" userId="a0710a6e-bffc-4971-8893-1c23addeb5b0" providerId="ADAL" clId="{922FE477-A091-45D2-9AFE-0801C4DD56C7}" dt="2022-09-26T14:22:18.554" v="3801" actId="20577"/>
          <ac:spMkLst>
            <pc:docMk/>
            <pc:sldMk cId="1906182640" sldId="301"/>
            <ac:spMk id="2" creationId="{2F989969-700A-D7EB-7E3D-52DE0231C0F0}"/>
          </ac:spMkLst>
        </pc:spChg>
        <pc:picChg chg="mod modCrop">
          <ac:chgData name="Kumar, Vinod" userId="a0710a6e-bffc-4971-8893-1c23addeb5b0" providerId="ADAL" clId="{922FE477-A091-45D2-9AFE-0801C4DD56C7}" dt="2022-09-26T15:32:55.295" v="3807" actId="1076"/>
          <ac:picMkLst>
            <pc:docMk/>
            <pc:sldMk cId="1906182640" sldId="301"/>
            <ac:picMk id="3" creationId="{F450301E-C110-A500-66DC-9DFF82D67E68}"/>
          </ac:picMkLst>
        </pc:picChg>
        <pc:picChg chg="mod modCrop">
          <ac:chgData name="Kumar, Vinod" userId="a0710a6e-bffc-4971-8893-1c23addeb5b0" providerId="ADAL" clId="{922FE477-A091-45D2-9AFE-0801C4DD56C7}" dt="2022-09-26T15:36:37.893" v="3826" actId="1076"/>
          <ac:picMkLst>
            <pc:docMk/>
            <pc:sldMk cId="1906182640" sldId="301"/>
            <ac:picMk id="4" creationId="{24CE3C75-504A-F2C4-D0C8-6091449C77F9}"/>
          </ac:picMkLst>
        </pc:picChg>
        <pc:picChg chg="mod modCrop">
          <ac:chgData name="Kumar, Vinod" userId="a0710a6e-bffc-4971-8893-1c23addeb5b0" providerId="ADAL" clId="{922FE477-A091-45D2-9AFE-0801C4DD56C7}" dt="2022-09-26T15:36:41.485" v="3827" actId="1076"/>
          <ac:picMkLst>
            <pc:docMk/>
            <pc:sldMk cId="1906182640" sldId="301"/>
            <ac:picMk id="5" creationId="{5E9660E9-283C-4EE3-03D9-022782801718}"/>
          </ac:picMkLst>
        </pc:picChg>
        <pc:picChg chg="mod modCrop">
          <ac:chgData name="Kumar, Vinod" userId="a0710a6e-bffc-4971-8893-1c23addeb5b0" providerId="ADAL" clId="{922FE477-A091-45D2-9AFE-0801C4DD56C7}" dt="2022-09-26T15:36:45.885" v="3828" actId="1076"/>
          <ac:picMkLst>
            <pc:docMk/>
            <pc:sldMk cId="1906182640" sldId="301"/>
            <ac:picMk id="6" creationId="{C2BE8F1A-3A90-90F3-8262-6BC91AEC0EEA}"/>
          </ac:picMkLst>
        </pc:picChg>
        <pc:picChg chg="mod">
          <ac:chgData name="Kumar, Vinod" userId="a0710a6e-bffc-4971-8893-1c23addeb5b0" providerId="ADAL" clId="{922FE477-A091-45D2-9AFE-0801C4DD56C7}" dt="2022-09-26T15:36:53.173" v="3829" actId="1076"/>
          <ac:picMkLst>
            <pc:docMk/>
            <pc:sldMk cId="1906182640" sldId="301"/>
            <ac:picMk id="7" creationId="{DDC91D9D-B267-6A98-49A0-7F314A8D786B}"/>
          </ac:picMkLst>
        </pc:picChg>
      </pc:sldChg>
      <pc:sldChg chg="addSp delSp modSp new mod">
        <pc:chgData name="Kumar, Vinod" userId="a0710a6e-bffc-4971-8893-1c23addeb5b0" providerId="ADAL" clId="{922FE477-A091-45D2-9AFE-0801C4DD56C7}" dt="2022-09-26T20:04:53.322" v="3839" actId="1076"/>
        <pc:sldMkLst>
          <pc:docMk/>
          <pc:sldMk cId="2244443222" sldId="302"/>
        </pc:sldMkLst>
        <pc:spChg chg="add mod">
          <ac:chgData name="Kumar, Vinod" userId="a0710a6e-bffc-4971-8893-1c23addeb5b0" providerId="ADAL" clId="{922FE477-A091-45D2-9AFE-0801C4DD56C7}" dt="2022-09-26T15:39:12.614" v="3832" actId="20577"/>
          <ac:spMkLst>
            <pc:docMk/>
            <pc:sldMk cId="2244443222" sldId="302"/>
            <ac:spMk id="2" creationId="{086F389C-2B07-5F00-EA2A-17A9729D565C}"/>
          </ac:spMkLst>
        </pc:spChg>
        <pc:picChg chg="add del mod">
          <ac:chgData name="Kumar, Vinod" userId="a0710a6e-bffc-4971-8893-1c23addeb5b0" providerId="ADAL" clId="{922FE477-A091-45D2-9AFE-0801C4DD56C7}" dt="2022-09-26T20:04:47.308" v="3837" actId="478"/>
          <ac:picMkLst>
            <pc:docMk/>
            <pc:sldMk cId="2244443222" sldId="302"/>
            <ac:picMk id="3" creationId="{CADBBC50-1E50-ED55-8FC7-88BEF2A17BA8}"/>
          </ac:picMkLst>
        </pc:picChg>
        <pc:picChg chg="mod">
          <ac:chgData name="Kumar, Vinod" userId="a0710a6e-bffc-4971-8893-1c23addeb5b0" providerId="ADAL" clId="{922FE477-A091-45D2-9AFE-0801C4DD56C7}" dt="2022-09-26T20:04:53.322" v="3839" actId="1076"/>
          <ac:picMkLst>
            <pc:docMk/>
            <pc:sldMk cId="2244443222" sldId="302"/>
            <ac:picMk id="4" creationId="{2F53E4B6-BBB8-C5F9-E0FB-6100B1C67A2D}"/>
          </ac:picMkLst>
        </pc:picChg>
      </pc:sldChg>
      <pc:sldMasterChg chg="modSp modSldLayout">
        <pc:chgData name="Kumar, Vinod" userId="a0710a6e-bffc-4971-8893-1c23addeb5b0" providerId="ADAL" clId="{922FE477-A091-45D2-9AFE-0801C4DD56C7}" dt="2022-09-20T18:45:52.930" v="326"/>
        <pc:sldMasterMkLst>
          <pc:docMk/>
          <pc:sldMasterMk cId="3914622585" sldId="2147483648"/>
        </pc:sldMasterMkLst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asterMk cId="3914622585" sldId="2147483648"/>
            <ac:spMk id="2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asterMk cId="3914622585" sldId="2147483648"/>
            <ac:spMk id="3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asterMk cId="3914622585" sldId="2147483648"/>
            <ac:spMk id="4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asterMk cId="3914622585" sldId="2147483648"/>
            <ac:spMk id="5" creationId="{00000000-0000-0000-0000-000000000000}"/>
          </ac:spMkLst>
        </pc:spChg>
        <pc:spChg chg="mod">
          <ac:chgData name="Kumar, Vinod" userId="a0710a6e-bffc-4971-8893-1c23addeb5b0" providerId="ADAL" clId="{922FE477-A091-45D2-9AFE-0801C4DD56C7}" dt="2022-09-20T18:45:52.930" v="326"/>
          <ac:spMkLst>
            <pc:docMk/>
            <pc:sldMasterMk cId="3914622585" sldId="2147483648"/>
            <ac:spMk id="6" creationId="{00000000-0000-0000-0000-000000000000}"/>
          </ac:spMkLst>
        </pc:spChg>
        <pc:sldLayoutChg chg="modSp">
          <pc:chgData name="Kumar, Vinod" userId="a0710a6e-bffc-4971-8893-1c23addeb5b0" providerId="ADAL" clId="{922FE477-A091-45D2-9AFE-0801C4DD56C7}" dt="2022-09-20T18:45:52.930" v="326"/>
          <pc:sldLayoutMkLst>
            <pc:docMk/>
            <pc:sldMasterMk cId="3914622585" sldId="2147483648"/>
            <pc:sldLayoutMk cId="2235332659" sldId="2147483649"/>
          </pc:sldLayoutMkLst>
          <pc:spChg chg="mod">
            <ac:chgData name="Kumar, Vinod" userId="a0710a6e-bffc-4971-8893-1c23addeb5b0" providerId="ADAL" clId="{922FE477-A091-45D2-9AFE-0801C4DD56C7}" dt="2022-09-20T18:45:52.930" v="326"/>
            <ac:spMkLst>
              <pc:docMk/>
              <pc:sldMasterMk cId="3914622585" sldId="2147483648"/>
              <pc:sldLayoutMk cId="2235332659" sldId="2147483649"/>
              <ac:spMk id="2" creationId="{00000000-0000-0000-0000-000000000000}"/>
            </ac:spMkLst>
          </pc:spChg>
          <pc:spChg chg="mod">
            <ac:chgData name="Kumar, Vinod" userId="a0710a6e-bffc-4971-8893-1c23addeb5b0" providerId="ADAL" clId="{922FE477-A091-45D2-9AFE-0801C4DD56C7}" dt="2022-09-20T18:45:52.930" v="326"/>
            <ac:spMkLst>
              <pc:docMk/>
              <pc:sldMasterMk cId="3914622585" sldId="2147483648"/>
              <pc:sldLayoutMk cId="2235332659" sldId="2147483649"/>
              <ac:spMk id="3" creationId="{00000000-0000-0000-0000-000000000000}"/>
            </ac:spMkLst>
          </pc:spChg>
        </pc:sldLayoutChg>
        <pc:sldLayoutChg chg="modSp">
          <pc:chgData name="Kumar, Vinod" userId="a0710a6e-bffc-4971-8893-1c23addeb5b0" providerId="ADAL" clId="{922FE477-A091-45D2-9AFE-0801C4DD56C7}" dt="2022-09-20T18:45:52.930" v="326"/>
          <pc:sldLayoutMkLst>
            <pc:docMk/>
            <pc:sldMasterMk cId="3914622585" sldId="2147483648"/>
            <pc:sldLayoutMk cId="1243618863" sldId="2147483651"/>
          </pc:sldLayoutMkLst>
          <pc:spChg chg="mod">
            <ac:chgData name="Kumar, Vinod" userId="a0710a6e-bffc-4971-8893-1c23addeb5b0" providerId="ADAL" clId="{922FE477-A091-45D2-9AFE-0801C4DD56C7}" dt="2022-09-20T18:45:52.930" v="326"/>
            <ac:spMkLst>
              <pc:docMk/>
              <pc:sldMasterMk cId="3914622585" sldId="2147483648"/>
              <pc:sldLayoutMk cId="1243618863" sldId="2147483651"/>
              <ac:spMk id="2" creationId="{00000000-0000-0000-0000-000000000000}"/>
            </ac:spMkLst>
          </pc:spChg>
          <pc:spChg chg="mod">
            <ac:chgData name="Kumar, Vinod" userId="a0710a6e-bffc-4971-8893-1c23addeb5b0" providerId="ADAL" clId="{922FE477-A091-45D2-9AFE-0801C4DD56C7}" dt="2022-09-20T18:45:52.930" v="326"/>
            <ac:spMkLst>
              <pc:docMk/>
              <pc:sldMasterMk cId="3914622585" sldId="2147483648"/>
              <pc:sldLayoutMk cId="1243618863" sldId="2147483651"/>
              <ac:spMk id="3" creationId="{00000000-0000-0000-0000-000000000000}"/>
            </ac:spMkLst>
          </pc:spChg>
        </pc:sldLayoutChg>
        <pc:sldLayoutChg chg="modSp">
          <pc:chgData name="Kumar, Vinod" userId="a0710a6e-bffc-4971-8893-1c23addeb5b0" providerId="ADAL" clId="{922FE477-A091-45D2-9AFE-0801C4DD56C7}" dt="2022-09-20T18:45:52.930" v="326"/>
          <pc:sldLayoutMkLst>
            <pc:docMk/>
            <pc:sldMasterMk cId="3914622585" sldId="2147483648"/>
            <pc:sldLayoutMk cId="1526335031" sldId="2147483652"/>
          </pc:sldLayoutMkLst>
          <pc:spChg chg="mod">
            <ac:chgData name="Kumar, Vinod" userId="a0710a6e-bffc-4971-8893-1c23addeb5b0" providerId="ADAL" clId="{922FE477-A091-45D2-9AFE-0801C4DD56C7}" dt="2022-09-20T18:45:52.930" v="326"/>
            <ac:spMkLst>
              <pc:docMk/>
              <pc:sldMasterMk cId="3914622585" sldId="2147483648"/>
              <pc:sldLayoutMk cId="1526335031" sldId="2147483652"/>
              <ac:spMk id="3" creationId="{00000000-0000-0000-0000-000000000000}"/>
            </ac:spMkLst>
          </pc:spChg>
          <pc:spChg chg="mod">
            <ac:chgData name="Kumar, Vinod" userId="a0710a6e-bffc-4971-8893-1c23addeb5b0" providerId="ADAL" clId="{922FE477-A091-45D2-9AFE-0801C4DD56C7}" dt="2022-09-20T18:45:52.930" v="326"/>
            <ac:spMkLst>
              <pc:docMk/>
              <pc:sldMasterMk cId="3914622585" sldId="2147483648"/>
              <pc:sldLayoutMk cId="1526335031" sldId="2147483652"/>
              <ac:spMk id="4" creationId="{00000000-0000-0000-0000-000000000000}"/>
            </ac:spMkLst>
          </pc:spChg>
        </pc:sldLayoutChg>
        <pc:sldLayoutChg chg="modSp">
          <pc:chgData name="Kumar, Vinod" userId="a0710a6e-bffc-4971-8893-1c23addeb5b0" providerId="ADAL" clId="{922FE477-A091-45D2-9AFE-0801C4DD56C7}" dt="2022-09-20T18:45:52.930" v="326"/>
          <pc:sldLayoutMkLst>
            <pc:docMk/>
            <pc:sldMasterMk cId="3914622585" sldId="2147483648"/>
            <pc:sldLayoutMk cId="3344597230" sldId="2147483653"/>
          </pc:sldLayoutMkLst>
          <pc:spChg chg="mod">
            <ac:chgData name="Kumar, Vinod" userId="a0710a6e-bffc-4971-8893-1c23addeb5b0" providerId="ADAL" clId="{922FE477-A091-45D2-9AFE-0801C4DD56C7}" dt="2022-09-20T18:45:52.930" v="326"/>
            <ac:spMkLst>
              <pc:docMk/>
              <pc:sldMasterMk cId="3914622585" sldId="2147483648"/>
              <pc:sldLayoutMk cId="3344597230" sldId="2147483653"/>
              <ac:spMk id="3" creationId="{00000000-0000-0000-0000-000000000000}"/>
            </ac:spMkLst>
          </pc:spChg>
          <pc:spChg chg="mod">
            <ac:chgData name="Kumar, Vinod" userId="a0710a6e-bffc-4971-8893-1c23addeb5b0" providerId="ADAL" clId="{922FE477-A091-45D2-9AFE-0801C4DD56C7}" dt="2022-09-20T18:45:52.930" v="326"/>
            <ac:spMkLst>
              <pc:docMk/>
              <pc:sldMasterMk cId="3914622585" sldId="2147483648"/>
              <pc:sldLayoutMk cId="3344597230" sldId="2147483653"/>
              <ac:spMk id="4" creationId="{00000000-0000-0000-0000-000000000000}"/>
            </ac:spMkLst>
          </pc:spChg>
          <pc:spChg chg="mod">
            <ac:chgData name="Kumar, Vinod" userId="a0710a6e-bffc-4971-8893-1c23addeb5b0" providerId="ADAL" clId="{922FE477-A091-45D2-9AFE-0801C4DD56C7}" dt="2022-09-20T18:45:52.930" v="326"/>
            <ac:spMkLst>
              <pc:docMk/>
              <pc:sldMasterMk cId="3914622585" sldId="2147483648"/>
              <pc:sldLayoutMk cId="3344597230" sldId="2147483653"/>
              <ac:spMk id="5" creationId="{00000000-0000-0000-0000-000000000000}"/>
            </ac:spMkLst>
          </pc:spChg>
          <pc:spChg chg="mod">
            <ac:chgData name="Kumar, Vinod" userId="a0710a6e-bffc-4971-8893-1c23addeb5b0" providerId="ADAL" clId="{922FE477-A091-45D2-9AFE-0801C4DD56C7}" dt="2022-09-20T18:45:52.930" v="326"/>
            <ac:spMkLst>
              <pc:docMk/>
              <pc:sldMasterMk cId="3914622585" sldId="2147483648"/>
              <pc:sldLayoutMk cId="3344597230" sldId="2147483653"/>
              <ac:spMk id="6" creationId="{00000000-0000-0000-0000-000000000000}"/>
            </ac:spMkLst>
          </pc:spChg>
        </pc:sldLayoutChg>
        <pc:sldLayoutChg chg="modSp">
          <pc:chgData name="Kumar, Vinod" userId="a0710a6e-bffc-4971-8893-1c23addeb5b0" providerId="ADAL" clId="{922FE477-A091-45D2-9AFE-0801C4DD56C7}" dt="2022-09-20T18:45:52.930" v="326"/>
          <pc:sldLayoutMkLst>
            <pc:docMk/>
            <pc:sldMasterMk cId="3914622585" sldId="2147483648"/>
            <pc:sldLayoutMk cId="885911509" sldId="2147483656"/>
          </pc:sldLayoutMkLst>
          <pc:spChg chg="mod">
            <ac:chgData name="Kumar, Vinod" userId="a0710a6e-bffc-4971-8893-1c23addeb5b0" providerId="ADAL" clId="{922FE477-A091-45D2-9AFE-0801C4DD56C7}" dt="2022-09-20T18:45:52.930" v="326"/>
            <ac:spMkLst>
              <pc:docMk/>
              <pc:sldMasterMk cId="3914622585" sldId="2147483648"/>
              <pc:sldLayoutMk cId="885911509" sldId="2147483656"/>
              <ac:spMk id="2" creationId="{00000000-0000-0000-0000-000000000000}"/>
            </ac:spMkLst>
          </pc:spChg>
          <pc:spChg chg="mod">
            <ac:chgData name="Kumar, Vinod" userId="a0710a6e-bffc-4971-8893-1c23addeb5b0" providerId="ADAL" clId="{922FE477-A091-45D2-9AFE-0801C4DD56C7}" dt="2022-09-20T18:45:52.930" v="326"/>
            <ac:spMkLst>
              <pc:docMk/>
              <pc:sldMasterMk cId="3914622585" sldId="2147483648"/>
              <pc:sldLayoutMk cId="885911509" sldId="2147483656"/>
              <ac:spMk id="3" creationId="{00000000-0000-0000-0000-000000000000}"/>
            </ac:spMkLst>
          </pc:spChg>
          <pc:spChg chg="mod">
            <ac:chgData name="Kumar, Vinod" userId="a0710a6e-bffc-4971-8893-1c23addeb5b0" providerId="ADAL" clId="{922FE477-A091-45D2-9AFE-0801C4DD56C7}" dt="2022-09-20T18:45:52.930" v="326"/>
            <ac:spMkLst>
              <pc:docMk/>
              <pc:sldMasterMk cId="3914622585" sldId="2147483648"/>
              <pc:sldLayoutMk cId="885911509" sldId="2147483656"/>
              <ac:spMk id="4" creationId="{00000000-0000-0000-0000-000000000000}"/>
            </ac:spMkLst>
          </pc:spChg>
        </pc:sldLayoutChg>
        <pc:sldLayoutChg chg="modSp">
          <pc:chgData name="Kumar, Vinod" userId="a0710a6e-bffc-4971-8893-1c23addeb5b0" providerId="ADAL" clId="{922FE477-A091-45D2-9AFE-0801C4DD56C7}" dt="2022-09-20T18:45:52.930" v="326"/>
          <pc:sldLayoutMkLst>
            <pc:docMk/>
            <pc:sldMasterMk cId="3914622585" sldId="2147483648"/>
            <pc:sldLayoutMk cId="2269585229" sldId="2147483657"/>
          </pc:sldLayoutMkLst>
          <pc:spChg chg="mod">
            <ac:chgData name="Kumar, Vinod" userId="a0710a6e-bffc-4971-8893-1c23addeb5b0" providerId="ADAL" clId="{922FE477-A091-45D2-9AFE-0801C4DD56C7}" dt="2022-09-20T18:45:52.930" v="326"/>
            <ac:spMkLst>
              <pc:docMk/>
              <pc:sldMasterMk cId="3914622585" sldId="2147483648"/>
              <pc:sldLayoutMk cId="2269585229" sldId="2147483657"/>
              <ac:spMk id="2" creationId="{00000000-0000-0000-0000-000000000000}"/>
            </ac:spMkLst>
          </pc:spChg>
          <pc:spChg chg="mod">
            <ac:chgData name="Kumar, Vinod" userId="a0710a6e-bffc-4971-8893-1c23addeb5b0" providerId="ADAL" clId="{922FE477-A091-45D2-9AFE-0801C4DD56C7}" dt="2022-09-20T18:45:52.930" v="326"/>
            <ac:spMkLst>
              <pc:docMk/>
              <pc:sldMasterMk cId="3914622585" sldId="2147483648"/>
              <pc:sldLayoutMk cId="2269585229" sldId="2147483657"/>
              <ac:spMk id="3" creationId="{00000000-0000-0000-0000-000000000000}"/>
            </ac:spMkLst>
          </pc:spChg>
          <pc:spChg chg="mod">
            <ac:chgData name="Kumar, Vinod" userId="a0710a6e-bffc-4971-8893-1c23addeb5b0" providerId="ADAL" clId="{922FE477-A091-45D2-9AFE-0801C4DD56C7}" dt="2022-09-20T18:45:52.930" v="326"/>
            <ac:spMkLst>
              <pc:docMk/>
              <pc:sldMasterMk cId="3914622585" sldId="2147483648"/>
              <pc:sldLayoutMk cId="2269585229" sldId="2147483657"/>
              <ac:spMk id="4" creationId="{00000000-0000-0000-0000-000000000000}"/>
            </ac:spMkLst>
          </pc:spChg>
        </pc:sldLayoutChg>
        <pc:sldLayoutChg chg="modSp">
          <pc:chgData name="Kumar, Vinod" userId="a0710a6e-bffc-4971-8893-1c23addeb5b0" providerId="ADAL" clId="{922FE477-A091-45D2-9AFE-0801C4DD56C7}" dt="2022-09-20T18:45:52.930" v="326"/>
          <pc:sldLayoutMkLst>
            <pc:docMk/>
            <pc:sldMasterMk cId="3914622585" sldId="2147483648"/>
            <pc:sldLayoutMk cId="3430517481" sldId="2147483659"/>
          </pc:sldLayoutMkLst>
          <pc:spChg chg="mod">
            <ac:chgData name="Kumar, Vinod" userId="a0710a6e-bffc-4971-8893-1c23addeb5b0" providerId="ADAL" clId="{922FE477-A091-45D2-9AFE-0801C4DD56C7}" dt="2022-09-20T18:45:52.930" v="326"/>
            <ac:spMkLst>
              <pc:docMk/>
              <pc:sldMasterMk cId="3914622585" sldId="2147483648"/>
              <pc:sldLayoutMk cId="3430517481" sldId="2147483659"/>
              <ac:spMk id="2" creationId="{00000000-0000-0000-0000-000000000000}"/>
            </ac:spMkLst>
          </pc:spChg>
          <pc:spChg chg="mod">
            <ac:chgData name="Kumar, Vinod" userId="a0710a6e-bffc-4971-8893-1c23addeb5b0" providerId="ADAL" clId="{922FE477-A091-45D2-9AFE-0801C4DD56C7}" dt="2022-09-20T18:45:52.930" v="326"/>
            <ac:spMkLst>
              <pc:docMk/>
              <pc:sldMasterMk cId="3914622585" sldId="2147483648"/>
              <pc:sldLayoutMk cId="3430517481" sldId="2147483659"/>
              <ac:spMk id="3" creationId="{00000000-0000-0000-0000-000000000000}"/>
            </ac:spMkLst>
          </pc:spChg>
        </pc:sldLayoutChg>
      </pc:sldMasterChg>
    </pc:docChg>
  </pc:docChgLst>
  <pc:docChgLst>
    <pc:chgData name="Kumar, Vinod" userId="a0710a6e-bffc-4971-8893-1c23addeb5b0" providerId="ADAL" clId="{F5D6EA11-585F-4AA1-B279-75820FE30650}"/>
    <pc:docChg chg="undo redo custSel addSld delSld modSld">
      <pc:chgData name="Kumar, Vinod" userId="a0710a6e-bffc-4971-8893-1c23addeb5b0" providerId="ADAL" clId="{F5D6EA11-585F-4AA1-B279-75820FE30650}" dt="2023-01-25T21:20:06.797" v="5133" actId="1037"/>
      <pc:docMkLst>
        <pc:docMk/>
      </pc:docMkLst>
      <pc:sldChg chg="del">
        <pc:chgData name="Kumar, Vinod" userId="a0710a6e-bffc-4971-8893-1c23addeb5b0" providerId="ADAL" clId="{F5D6EA11-585F-4AA1-B279-75820FE30650}" dt="2023-01-11T22:01:16.793" v="2820" actId="47"/>
        <pc:sldMkLst>
          <pc:docMk/>
          <pc:sldMk cId="2581851823" sldId="270"/>
        </pc:sldMkLst>
      </pc:sldChg>
      <pc:sldChg chg="modSp mod">
        <pc:chgData name="Kumar, Vinod" userId="a0710a6e-bffc-4971-8893-1c23addeb5b0" providerId="ADAL" clId="{F5D6EA11-585F-4AA1-B279-75820FE30650}" dt="2023-01-12T19:22:14.550" v="3999" actId="1035"/>
        <pc:sldMkLst>
          <pc:docMk/>
          <pc:sldMk cId="2313405284" sldId="300"/>
        </pc:sldMkLst>
        <pc:spChg chg="mod">
          <ac:chgData name="Kumar, Vinod" userId="a0710a6e-bffc-4971-8893-1c23addeb5b0" providerId="ADAL" clId="{F5D6EA11-585F-4AA1-B279-75820FE30650}" dt="2023-01-12T19:20:58.982" v="3945" actId="1037"/>
          <ac:spMkLst>
            <pc:docMk/>
            <pc:sldMk cId="2313405284" sldId="300"/>
            <ac:spMk id="20" creationId="{24400196-BCAC-9BA2-4B49-9C0650D949FE}"/>
          </ac:spMkLst>
        </pc:spChg>
        <pc:spChg chg="mod">
          <ac:chgData name="Kumar, Vinod" userId="a0710a6e-bffc-4971-8893-1c23addeb5b0" providerId="ADAL" clId="{F5D6EA11-585F-4AA1-B279-75820FE30650}" dt="2023-01-12T19:22:03.510" v="3980" actId="1038"/>
          <ac:spMkLst>
            <pc:docMk/>
            <pc:sldMk cId="2313405284" sldId="300"/>
            <ac:spMk id="21" creationId="{5CC265AF-7197-6A73-CFD5-2B69A8F31CE8}"/>
          </ac:spMkLst>
        </pc:spChg>
        <pc:spChg chg="mod">
          <ac:chgData name="Kumar, Vinod" userId="a0710a6e-bffc-4971-8893-1c23addeb5b0" providerId="ADAL" clId="{F5D6EA11-585F-4AA1-B279-75820FE30650}" dt="2023-01-12T19:21:40.552" v="3965" actId="1038"/>
          <ac:spMkLst>
            <pc:docMk/>
            <pc:sldMk cId="2313405284" sldId="300"/>
            <ac:spMk id="22" creationId="{3E43CA10-C496-3957-DE7D-2FE5CADA6483}"/>
          </ac:spMkLst>
        </pc:spChg>
        <pc:spChg chg="mod">
          <ac:chgData name="Kumar, Vinod" userId="a0710a6e-bffc-4971-8893-1c23addeb5b0" providerId="ADAL" clId="{F5D6EA11-585F-4AA1-B279-75820FE30650}" dt="2023-01-12T19:22:10.118" v="3993" actId="1038"/>
          <ac:spMkLst>
            <pc:docMk/>
            <pc:sldMk cId="2313405284" sldId="300"/>
            <ac:spMk id="23" creationId="{7ACFDAD4-CFAE-4293-2D1E-2E7069303D0D}"/>
          </ac:spMkLst>
        </pc:spChg>
        <pc:spChg chg="mod">
          <ac:chgData name="Kumar, Vinod" userId="a0710a6e-bffc-4971-8893-1c23addeb5b0" providerId="ADAL" clId="{F5D6EA11-585F-4AA1-B279-75820FE30650}" dt="2023-01-12T19:21:55.623" v="3972" actId="1035"/>
          <ac:spMkLst>
            <pc:docMk/>
            <pc:sldMk cId="2313405284" sldId="300"/>
            <ac:spMk id="24" creationId="{E2F78356-5DC0-07EC-252C-29848BFBDEBE}"/>
          </ac:spMkLst>
        </pc:spChg>
        <pc:spChg chg="mod">
          <ac:chgData name="Kumar, Vinod" userId="a0710a6e-bffc-4971-8893-1c23addeb5b0" providerId="ADAL" clId="{F5D6EA11-585F-4AA1-B279-75820FE30650}" dt="2023-01-12T19:22:14.550" v="3999" actId="1035"/>
          <ac:spMkLst>
            <pc:docMk/>
            <pc:sldMk cId="2313405284" sldId="300"/>
            <ac:spMk id="25" creationId="{203104D2-55F4-ADA5-9E39-AC4196EBFDF5}"/>
          </ac:spMkLst>
        </pc:spChg>
        <pc:spChg chg="mod">
          <ac:chgData name="Kumar, Vinod" userId="a0710a6e-bffc-4971-8893-1c23addeb5b0" providerId="ADAL" clId="{F5D6EA11-585F-4AA1-B279-75820FE30650}" dt="2023-01-12T19:20:38.136" v="3934" actId="1037"/>
          <ac:spMkLst>
            <pc:docMk/>
            <pc:sldMk cId="2313405284" sldId="300"/>
            <ac:spMk id="33" creationId="{F92D989F-07E3-DF99-0F1C-AE47DC3163C0}"/>
          </ac:spMkLst>
        </pc:spChg>
      </pc:sldChg>
      <pc:sldChg chg="addSp delSp modSp del mod">
        <pc:chgData name="Kumar, Vinod" userId="a0710a6e-bffc-4971-8893-1c23addeb5b0" providerId="ADAL" clId="{F5D6EA11-585F-4AA1-B279-75820FE30650}" dt="2023-01-10T21:02:14.844" v="941" actId="47"/>
        <pc:sldMkLst>
          <pc:docMk/>
          <pc:sldMk cId="1906182640" sldId="301"/>
        </pc:sldMkLst>
        <pc:picChg chg="del">
          <ac:chgData name="Kumar, Vinod" userId="a0710a6e-bffc-4971-8893-1c23addeb5b0" providerId="ADAL" clId="{F5D6EA11-585F-4AA1-B279-75820FE30650}" dt="2023-01-09T21:10:27.002" v="43" actId="478"/>
          <ac:picMkLst>
            <pc:docMk/>
            <pc:sldMk cId="1906182640" sldId="301"/>
            <ac:picMk id="8" creationId="{8A5A5937-66A3-3B8C-8492-B8E9EC095195}"/>
          </ac:picMkLst>
        </pc:picChg>
        <pc:picChg chg="add mod">
          <ac:chgData name="Kumar, Vinod" userId="a0710a6e-bffc-4971-8893-1c23addeb5b0" providerId="ADAL" clId="{F5D6EA11-585F-4AA1-B279-75820FE30650}" dt="2023-01-09T21:10:31.754" v="45" actId="1076"/>
          <ac:picMkLst>
            <pc:docMk/>
            <pc:sldMk cId="1906182640" sldId="301"/>
            <ac:picMk id="9" creationId="{0E5F70E1-ABF3-1AFC-3184-ED5C0A584307}"/>
          </ac:picMkLst>
        </pc:picChg>
        <pc:picChg chg="add del mod">
          <ac:chgData name="Kumar, Vinod" userId="a0710a6e-bffc-4971-8893-1c23addeb5b0" providerId="ADAL" clId="{F5D6EA11-585F-4AA1-B279-75820FE30650}" dt="2023-01-09T15:48:46.544" v="18" actId="478"/>
          <ac:picMkLst>
            <pc:docMk/>
            <pc:sldMk cId="1906182640" sldId="301"/>
            <ac:picMk id="9" creationId="{95EA148E-1A2C-A7C2-1971-1510B55300A2}"/>
          </ac:picMkLst>
        </pc:picChg>
      </pc:sldChg>
      <pc:sldChg chg="addSp delSp modSp mod">
        <pc:chgData name="Kumar, Vinod" userId="a0710a6e-bffc-4971-8893-1c23addeb5b0" providerId="ADAL" clId="{F5D6EA11-585F-4AA1-B279-75820FE30650}" dt="2023-01-10T21:25:27.001" v="1027" actId="1035"/>
        <pc:sldMkLst>
          <pc:docMk/>
          <pc:sldMk cId="2794359920" sldId="303"/>
        </pc:sldMkLst>
        <pc:spChg chg="mod">
          <ac:chgData name="Kumar, Vinod" userId="a0710a6e-bffc-4971-8893-1c23addeb5b0" providerId="ADAL" clId="{F5D6EA11-585F-4AA1-B279-75820FE30650}" dt="2023-01-10T16:31:11.591" v="260" actId="1035"/>
          <ac:spMkLst>
            <pc:docMk/>
            <pc:sldMk cId="2794359920" sldId="303"/>
            <ac:spMk id="2" creationId="{DFB14EE7-EEF6-61F7-41BC-5E90AAE62A50}"/>
          </ac:spMkLst>
        </pc:spChg>
        <pc:spChg chg="mod">
          <ac:chgData name="Kumar, Vinod" userId="a0710a6e-bffc-4971-8893-1c23addeb5b0" providerId="ADAL" clId="{F5D6EA11-585F-4AA1-B279-75820FE30650}" dt="2023-01-10T16:27:47.441" v="231" actId="14100"/>
          <ac:spMkLst>
            <pc:docMk/>
            <pc:sldMk cId="2794359920" sldId="303"/>
            <ac:spMk id="21" creationId="{D7D88FA0-6D0C-96BF-6837-CE8C7D2C18F7}"/>
          </ac:spMkLst>
        </pc:spChg>
        <pc:spChg chg="mod">
          <ac:chgData name="Kumar, Vinod" userId="a0710a6e-bffc-4971-8893-1c23addeb5b0" providerId="ADAL" clId="{F5D6EA11-585F-4AA1-B279-75820FE30650}" dt="2023-01-10T16:28:03.192" v="235" actId="1038"/>
          <ac:spMkLst>
            <pc:docMk/>
            <pc:sldMk cId="2794359920" sldId="303"/>
            <ac:spMk id="22" creationId="{56DBA533-46D5-F4DE-11B3-F9F694AA03DD}"/>
          </ac:spMkLst>
        </pc:spChg>
        <pc:spChg chg="del">
          <ac:chgData name="Kumar, Vinod" userId="a0710a6e-bffc-4971-8893-1c23addeb5b0" providerId="ADAL" clId="{F5D6EA11-585F-4AA1-B279-75820FE30650}" dt="2023-01-10T16:27:21.754" v="228" actId="478"/>
          <ac:spMkLst>
            <pc:docMk/>
            <pc:sldMk cId="2794359920" sldId="303"/>
            <ac:spMk id="24" creationId="{B6986ADE-E594-2EB1-24CD-9A678E12DE2C}"/>
          </ac:spMkLst>
        </pc:spChg>
        <pc:picChg chg="del mod">
          <ac:chgData name="Kumar, Vinod" userId="a0710a6e-bffc-4971-8893-1c23addeb5b0" providerId="ADAL" clId="{F5D6EA11-585F-4AA1-B279-75820FE30650}" dt="2023-01-10T21:25:20.713" v="1018" actId="478"/>
          <ac:picMkLst>
            <pc:docMk/>
            <pc:sldMk cId="2794359920" sldId="303"/>
            <ac:picMk id="15" creationId="{D28DCB59-05A2-686E-29D3-9BDE69DAA919}"/>
          </ac:picMkLst>
        </pc:picChg>
        <pc:picChg chg="mod">
          <ac:chgData name="Kumar, Vinod" userId="a0710a6e-bffc-4971-8893-1c23addeb5b0" providerId="ADAL" clId="{F5D6EA11-585F-4AA1-B279-75820FE30650}" dt="2023-01-10T16:27:40.057" v="229" actId="1076"/>
          <ac:picMkLst>
            <pc:docMk/>
            <pc:sldMk cId="2794359920" sldId="303"/>
            <ac:picMk id="19" creationId="{F42524B6-CD05-7E8E-53B3-CF6EDDB555D5}"/>
          </ac:picMkLst>
        </pc:picChg>
        <pc:picChg chg="mod modCrop">
          <ac:chgData name="Kumar, Vinod" userId="a0710a6e-bffc-4971-8893-1c23addeb5b0" providerId="ADAL" clId="{F5D6EA11-585F-4AA1-B279-75820FE30650}" dt="2023-01-10T21:25:27.001" v="1027" actId="1035"/>
          <ac:picMkLst>
            <pc:docMk/>
            <pc:sldMk cId="2794359920" sldId="303"/>
            <ac:picMk id="20" creationId="{38310B27-8663-8026-1D5F-5E1F2F91823A}"/>
          </ac:picMkLst>
        </pc:picChg>
        <pc:picChg chg="del mod">
          <ac:chgData name="Kumar, Vinod" userId="a0710a6e-bffc-4971-8893-1c23addeb5b0" providerId="ADAL" clId="{F5D6EA11-585F-4AA1-B279-75820FE30650}" dt="2023-01-10T16:27:21.754" v="228" actId="478"/>
          <ac:picMkLst>
            <pc:docMk/>
            <pc:sldMk cId="2794359920" sldId="303"/>
            <ac:picMk id="20" creationId="{BB21575B-0432-DC68-28A4-48661C4DD60A}"/>
          </ac:picMkLst>
        </pc:picChg>
        <pc:picChg chg="add del">
          <ac:chgData name="Kumar, Vinod" userId="a0710a6e-bffc-4971-8893-1c23addeb5b0" providerId="ADAL" clId="{F5D6EA11-585F-4AA1-B279-75820FE30650}" dt="2023-01-10T16:22:26.268" v="89" actId="478"/>
          <ac:picMkLst>
            <pc:docMk/>
            <pc:sldMk cId="2794359920" sldId="303"/>
            <ac:picMk id="25" creationId="{66B990EB-5342-F93A-4A84-55FAB50DC1FB}"/>
          </ac:picMkLst>
        </pc:picChg>
      </pc:sldChg>
      <pc:sldChg chg="addSp delSp modSp mod">
        <pc:chgData name="Kumar, Vinod" userId="a0710a6e-bffc-4971-8893-1c23addeb5b0" providerId="ADAL" clId="{F5D6EA11-585F-4AA1-B279-75820FE30650}" dt="2023-01-13T14:54:00.494" v="4486" actId="1038"/>
        <pc:sldMkLst>
          <pc:docMk/>
          <pc:sldMk cId="1231753045" sldId="306"/>
        </pc:sldMkLst>
        <pc:spChg chg="add mod">
          <ac:chgData name="Kumar, Vinod" userId="a0710a6e-bffc-4971-8893-1c23addeb5b0" providerId="ADAL" clId="{F5D6EA11-585F-4AA1-B279-75820FE30650}" dt="2023-01-13T14:54:00.494" v="4486" actId="1038"/>
          <ac:spMkLst>
            <pc:docMk/>
            <pc:sldMk cId="1231753045" sldId="306"/>
            <ac:spMk id="6" creationId="{6AC4EA1E-77D3-AF0F-9802-6AF75082BFD9}"/>
          </ac:spMkLst>
        </pc:spChg>
        <pc:spChg chg="mod">
          <ac:chgData name="Kumar, Vinod" userId="a0710a6e-bffc-4971-8893-1c23addeb5b0" providerId="ADAL" clId="{F5D6EA11-585F-4AA1-B279-75820FE30650}" dt="2023-01-10T21:03:03.029" v="948" actId="1036"/>
          <ac:spMkLst>
            <pc:docMk/>
            <pc:sldMk cId="1231753045" sldId="306"/>
            <ac:spMk id="7" creationId="{C56CA07C-310B-7CB3-A9A5-D9A9ED7A54FF}"/>
          </ac:spMkLst>
        </pc:spChg>
        <pc:spChg chg="mod">
          <ac:chgData name="Kumar, Vinod" userId="a0710a6e-bffc-4971-8893-1c23addeb5b0" providerId="ADAL" clId="{F5D6EA11-585F-4AA1-B279-75820FE30650}" dt="2023-01-10T21:03:22.565" v="956" actId="1036"/>
          <ac:spMkLst>
            <pc:docMk/>
            <pc:sldMk cId="1231753045" sldId="306"/>
            <ac:spMk id="18" creationId="{398F8A0C-194E-FF4D-7289-8864350071D4}"/>
          </ac:spMkLst>
        </pc:spChg>
        <pc:spChg chg="mod">
          <ac:chgData name="Kumar, Vinod" userId="a0710a6e-bffc-4971-8893-1c23addeb5b0" providerId="ADAL" clId="{F5D6EA11-585F-4AA1-B279-75820FE30650}" dt="2023-01-10T21:03:22.565" v="956" actId="1036"/>
          <ac:spMkLst>
            <pc:docMk/>
            <pc:sldMk cId="1231753045" sldId="306"/>
            <ac:spMk id="21" creationId="{BA17C6E1-9E7E-0426-0C8C-C1A35E1C7DC3}"/>
          </ac:spMkLst>
        </pc:spChg>
        <pc:spChg chg="mod">
          <ac:chgData name="Kumar, Vinod" userId="a0710a6e-bffc-4971-8893-1c23addeb5b0" providerId="ADAL" clId="{F5D6EA11-585F-4AA1-B279-75820FE30650}" dt="2023-01-10T21:03:22.565" v="956" actId="1036"/>
          <ac:spMkLst>
            <pc:docMk/>
            <pc:sldMk cId="1231753045" sldId="306"/>
            <ac:spMk id="24" creationId="{3CC663BE-9D93-F87F-7818-C877356A5B1C}"/>
          </ac:spMkLst>
        </pc:spChg>
        <pc:spChg chg="mod">
          <ac:chgData name="Kumar, Vinod" userId="a0710a6e-bffc-4971-8893-1c23addeb5b0" providerId="ADAL" clId="{F5D6EA11-585F-4AA1-B279-75820FE30650}" dt="2023-01-10T21:03:22.565" v="956" actId="1036"/>
          <ac:spMkLst>
            <pc:docMk/>
            <pc:sldMk cId="1231753045" sldId="306"/>
            <ac:spMk id="25" creationId="{EEA2DED9-D02B-BD07-2DDB-1844946C07FC}"/>
          </ac:spMkLst>
        </pc:spChg>
        <pc:spChg chg="del mod">
          <ac:chgData name="Kumar, Vinod" userId="a0710a6e-bffc-4971-8893-1c23addeb5b0" providerId="ADAL" clId="{F5D6EA11-585F-4AA1-B279-75820FE30650}" dt="2023-01-13T14:53:40.960" v="4377" actId="478"/>
          <ac:spMkLst>
            <pc:docMk/>
            <pc:sldMk cId="1231753045" sldId="306"/>
            <ac:spMk id="27" creationId="{27B17A2C-6532-2CB3-D392-3208B9A65094}"/>
          </ac:spMkLst>
        </pc:spChg>
        <pc:picChg chg="mod">
          <ac:chgData name="Kumar, Vinod" userId="a0710a6e-bffc-4971-8893-1c23addeb5b0" providerId="ADAL" clId="{F5D6EA11-585F-4AA1-B279-75820FE30650}" dt="2023-01-10T21:03:22.565" v="956" actId="1036"/>
          <ac:picMkLst>
            <pc:docMk/>
            <pc:sldMk cId="1231753045" sldId="306"/>
            <ac:picMk id="30" creationId="{60CB73A7-14FE-042F-5656-C468FC0E6FD9}"/>
          </ac:picMkLst>
        </pc:picChg>
        <pc:picChg chg="mod">
          <ac:chgData name="Kumar, Vinod" userId="a0710a6e-bffc-4971-8893-1c23addeb5b0" providerId="ADAL" clId="{F5D6EA11-585F-4AA1-B279-75820FE30650}" dt="2023-01-10T21:03:22.565" v="956" actId="1036"/>
          <ac:picMkLst>
            <pc:docMk/>
            <pc:sldMk cId="1231753045" sldId="306"/>
            <ac:picMk id="31" creationId="{386F0B05-F7BB-5932-D2EE-B54F705C16F0}"/>
          </ac:picMkLst>
        </pc:picChg>
      </pc:sldChg>
      <pc:sldChg chg="addSp delSp modSp mod">
        <pc:chgData name="Kumar, Vinod" userId="a0710a6e-bffc-4971-8893-1c23addeb5b0" providerId="ADAL" clId="{F5D6EA11-585F-4AA1-B279-75820FE30650}" dt="2023-01-12T19:17:27.561" v="3922" actId="1035"/>
        <pc:sldMkLst>
          <pc:docMk/>
          <pc:sldMk cId="1809220692" sldId="307"/>
        </pc:sldMkLst>
        <pc:spChg chg="mod">
          <ac:chgData name="Kumar, Vinod" userId="a0710a6e-bffc-4971-8893-1c23addeb5b0" providerId="ADAL" clId="{F5D6EA11-585F-4AA1-B279-75820FE30650}" dt="2023-01-12T19:17:27.561" v="3922" actId="1035"/>
          <ac:spMkLst>
            <pc:docMk/>
            <pc:sldMk cId="1809220692" sldId="307"/>
            <ac:spMk id="6" creationId="{501CC702-17BF-D791-E8BE-84429E05C972}"/>
          </ac:spMkLst>
        </pc:spChg>
        <pc:spChg chg="mod">
          <ac:chgData name="Kumar, Vinod" userId="a0710a6e-bffc-4971-8893-1c23addeb5b0" providerId="ADAL" clId="{F5D6EA11-585F-4AA1-B279-75820FE30650}" dt="2023-01-12T16:34:39.206" v="3798" actId="1076"/>
          <ac:spMkLst>
            <pc:docMk/>
            <pc:sldMk cId="1809220692" sldId="307"/>
            <ac:spMk id="7" creationId="{3A27B142-7348-D017-2365-F7521F3ECC2E}"/>
          </ac:spMkLst>
        </pc:spChg>
        <pc:spChg chg="mod">
          <ac:chgData name="Kumar, Vinod" userId="a0710a6e-bffc-4971-8893-1c23addeb5b0" providerId="ADAL" clId="{F5D6EA11-585F-4AA1-B279-75820FE30650}" dt="2023-01-12T16:34:41.006" v="3799" actId="1076"/>
          <ac:spMkLst>
            <pc:docMk/>
            <pc:sldMk cId="1809220692" sldId="307"/>
            <ac:spMk id="8" creationId="{8947D4B5-C798-5A24-4280-177C9063B94F}"/>
          </ac:spMkLst>
        </pc:spChg>
        <pc:spChg chg="mod">
          <ac:chgData name="Kumar, Vinod" userId="a0710a6e-bffc-4971-8893-1c23addeb5b0" providerId="ADAL" clId="{F5D6EA11-585F-4AA1-B279-75820FE30650}" dt="2023-01-12T19:17:27.561" v="3922" actId="1035"/>
          <ac:spMkLst>
            <pc:docMk/>
            <pc:sldMk cId="1809220692" sldId="307"/>
            <ac:spMk id="10" creationId="{DD47DA19-285A-FA16-01D5-518DC85E6200}"/>
          </ac:spMkLst>
        </pc:spChg>
        <pc:spChg chg="mod">
          <ac:chgData name="Kumar, Vinod" userId="a0710a6e-bffc-4971-8893-1c23addeb5b0" providerId="ADAL" clId="{F5D6EA11-585F-4AA1-B279-75820FE30650}" dt="2023-01-12T17:11:34.453" v="3906" actId="1036"/>
          <ac:spMkLst>
            <pc:docMk/>
            <pc:sldMk cId="1809220692" sldId="307"/>
            <ac:spMk id="11" creationId="{712A80BB-E33F-8F2A-B09E-A815DAAAE03D}"/>
          </ac:spMkLst>
        </pc:spChg>
        <pc:spChg chg="mod">
          <ac:chgData name="Kumar, Vinod" userId="a0710a6e-bffc-4971-8893-1c23addeb5b0" providerId="ADAL" clId="{F5D6EA11-585F-4AA1-B279-75820FE30650}" dt="2023-01-12T17:11:34.453" v="3906" actId="1036"/>
          <ac:spMkLst>
            <pc:docMk/>
            <pc:sldMk cId="1809220692" sldId="307"/>
            <ac:spMk id="12" creationId="{632FBD78-F81E-95DD-6334-3F55B1EDDCD0}"/>
          </ac:spMkLst>
        </pc:spChg>
        <pc:picChg chg="del mod">
          <ac:chgData name="Kumar, Vinod" userId="a0710a6e-bffc-4971-8893-1c23addeb5b0" providerId="ADAL" clId="{F5D6EA11-585F-4AA1-B279-75820FE30650}" dt="2023-01-12T17:01:33.178" v="3830" actId="478"/>
          <ac:picMkLst>
            <pc:docMk/>
            <pc:sldMk cId="1809220692" sldId="307"/>
            <ac:picMk id="2" creationId="{DC874DCB-A713-DD2B-01B1-4A6B1896CE38}"/>
          </ac:picMkLst>
        </pc:picChg>
        <pc:picChg chg="del mod">
          <ac:chgData name="Kumar, Vinod" userId="a0710a6e-bffc-4971-8893-1c23addeb5b0" providerId="ADAL" clId="{F5D6EA11-585F-4AA1-B279-75820FE30650}" dt="2023-01-12T17:01:33.178" v="3830" actId="478"/>
          <ac:picMkLst>
            <pc:docMk/>
            <pc:sldMk cId="1809220692" sldId="307"/>
            <ac:picMk id="3" creationId="{B1D773CC-E14D-3DFC-7D16-189DB77DD3A4}"/>
          </ac:picMkLst>
        </pc:picChg>
        <pc:picChg chg="del mod">
          <ac:chgData name="Kumar, Vinod" userId="a0710a6e-bffc-4971-8893-1c23addeb5b0" providerId="ADAL" clId="{F5D6EA11-585F-4AA1-B279-75820FE30650}" dt="2023-01-12T16:33:14.375" v="3766" actId="478"/>
          <ac:picMkLst>
            <pc:docMk/>
            <pc:sldMk cId="1809220692" sldId="307"/>
            <ac:picMk id="5" creationId="{9B5F3310-7D36-81A6-3D42-8CF6F0DFCFA1}"/>
          </ac:picMkLst>
        </pc:picChg>
        <pc:picChg chg="del">
          <ac:chgData name="Kumar, Vinod" userId="a0710a6e-bffc-4971-8893-1c23addeb5b0" providerId="ADAL" clId="{F5D6EA11-585F-4AA1-B279-75820FE30650}" dt="2023-01-12T16:33:14.375" v="3766" actId="478"/>
          <ac:picMkLst>
            <pc:docMk/>
            <pc:sldMk cId="1809220692" sldId="307"/>
            <ac:picMk id="9" creationId="{89D3091B-A961-6B1B-36C2-692E33D0DBE0}"/>
          </ac:picMkLst>
        </pc:picChg>
        <pc:picChg chg="del mod modCrop">
          <ac:chgData name="Kumar, Vinod" userId="a0710a6e-bffc-4971-8893-1c23addeb5b0" providerId="ADAL" clId="{F5D6EA11-585F-4AA1-B279-75820FE30650}" dt="2023-01-12T16:25:30.379" v="3737" actId="478"/>
          <ac:picMkLst>
            <pc:docMk/>
            <pc:sldMk cId="1809220692" sldId="307"/>
            <ac:picMk id="14" creationId="{C694E2E9-14FB-2917-6BF5-3A0E01916364}"/>
          </ac:picMkLst>
        </pc:picChg>
        <pc:picChg chg="add mod">
          <ac:chgData name="Kumar, Vinod" userId="a0710a6e-bffc-4971-8893-1c23addeb5b0" providerId="ADAL" clId="{F5D6EA11-585F-4AA1-B279-75820FE30650}" dt="2023-01-12T19:17:21.752" v="3920" actId="1036"/>
          <ac:picMkLst>
            <pc:docMk/>
            <pc:sldMk cId="1809220692" sldId="307"/>
            <ac:picMk id="15" creationId="{04C7DE19-86AD-B8B2-A7C4-7F175AC3C8EA}"/>
          </ac:picMkLst>
        </pc:picChg>
        <pc:picChg chg="del mod modCrop">
          <ac:chgData name="Kumar, Vinod" userId="a0710a6e-bffc-4971-8893-1c23addeb5b0" providerId="ADAL" clId="{F5D6EA11-585F-4AA1-B279-75820FE30650}" dt="2023-01-12T16:26:42.459" v="3743" actId="478"/>
          <ac:picMkLst>
            <pc:docMk/>
            <pc:sldMk cId="1809220692" sldId="307"/>
            <ac:picMk id="16" creationId="{C5205CCA-DF48-681A-4F58-231903337B62}"/>
          </ac:picMkLst>
        </pc:picChg>
        <pc:picChg chg="mod modCrop">
          <ac:chgData name="Kumar, Vinod" userId="a0710a6e-bffc-4971-8893-1c23addeb5b0" providerId="ADAL" clId="{F5D6EA11-585F-4AA1-B279-75820FE30650}" dt="2023-01-12T19:17:21.752" v="3920" actId="1036"/>
          <ac:picMkLst>
            <pc:docMk/>
            <pc:sldMk cId="1809220692" sldId="307"/>
            <ac:picMk id="17" creationId="{3BD22F53-1A6E-5E0F-F14C-FC8F4A0E55C7}"/>
          </ac:picMkLst>
        </pc:picChg>
        <pc:picChg chg="add del mod">
          <ac:chgData name="Kumar, Vinod" userId="a0710a6e-bffc-4971-8893-1c23addeb5b0" providerId="ADAL" clId="{F5D6EA11-585F-4AA1-B279-75820FE30650}" dt="2023-01-12T16:43:01.100" v="3819"/>
          <ac:picMkLst>
            <pc:docMk/>
            <pc:sldMk cId="1809220692" sldId="307"/>
            <ac:picMk id="18" creationId="{FF6B2A5E-3ED5-918E-BE1C-0304CFD595EA}"/>
          </ac:picMkLst>
        </pc:picChg>
        <pc:picChg chg="add del mod">
          <ac:chgData name="Kumar, Vinod" userId="a0710a6e-bffc-4971-8893-1c23addeb5b0" providerId="ADAL" clId="{F5D6EA11-585F-4AA1-B279-75820FE30650}" dt="2023-01-12T16:43:01.100" v="3819"/>
          <ac:picMkLst>
            <pc:docMk/>
            <pc:sldMk cId="1809220692" sldId="307"/>
            <ac:picMk id="19" creationId="{6E465E5A-1195-4574-1F26-9F8F00E870BF}"/>
          </ac:picMkLst>
        </pc:picChg>
        <pc:picChg chg="del mod modCrop">
          <ac:chgData name="Kumar, Vinod" userId="a0710a6e-bffc-4971-8893-1c23addeb5b0" providerId="ADAL" clId="{F5D6EA11-585F-4AA1-B279-75820FE30650}" dt="2023-01-12T17:02:02.218" v="3833" actId="478"/>
          <ac:picMkLst>
            <pc:docMk/>
            <pc:sldMk cId="1809220692" sldId="307"/>
            <ac:picMk id="20" creationId="{ED46C7D2-43EA-4003-F9BC-5DCD2CD26BFA}"/>
          </ac:picMkLst>
        </pc:picChg>
        <pc:picChg chg="del mod modCrop">
          <ac:chgData name="Kumar, Vinod" userId="a0710a6e-bffc-4971-8893-1c23addeb5b0" providerId="ADAL" clId="{F5D6EA11-585F-4AA1-B279-75820FE30650}" dt="2023-01-12T17:02:02.218" v="3833" actId="478"/>
          <ac:picMkLst>
            <pc:docMk/>
            <pc:sldMk cId="1809220692" sldId="307"/>
            <ac:picMk id="21" creationId="{152B5A12-2804-375F-4E4B-3866C02EB710}"/>
          </ac:picMkLst>
        </pc:picChg>
        <pc:picChg chg="del mod modCrop">
          <ac:chgData name="Kumar, Vinod" userId="a0710a6e-bffc-4971-8893-1c23addeb5b0" providerId="ADAL" clId="{F5D6EA11-585F-4AA1-B279-75820FE30650}" dt="2023-01-12T17:10:39.078" v="3873" actId="478"/>
          <ac:picMkLst>
            <pc:docMk/>
            <pc:sldMk cId="1809220692" sldId="307"/>
            <ac:picMk id="22" creationId="{13313CCB-9FC7-6A5E-C676-5B2B852DB96B}"/>
          </ac:picMkLst>
        </pc:picChg>
        <pc:picChg chg="del mod modCrop">
          <ac:chgData name="Kumar, Vinod" userId="a0710a6e-bffc-4971-8893-1c23addeb5b0" providerId="ADAL" clId="{F5D6EA11-585F-4AA1-B279-75820FE30650}" dt="2023-01-12T17:10:39.078" v="3873" actId="478"/>
          <ac:picMkLst>
            <pc:docMk/>
            <pc:sldMk cId="1809220692" sldId="307"/>
            <ac:picMk id="23" creationId="{68CA8D2A-E774-4799-DCC9-17901C95BD96}"/>
          </ac:picMkLst>
        </pc:picChg>
        <pc:picChg chg="mod modCrop">
          <ac:chgData name="Kumar, Vinod" userId="a0710a6e-bffc-4971-8893-1c23addeb5b0" providerId="ADAL" clId="{F5D6EA11-585F-4AA1-B279-75820FE30650}" dt="2023-01-12T19:17:16.329" v="3915" actId="1037"/>
          <ac:picMkLst>
            <pc:docMk/>
            <pc:sldMk cId="1809220692" sldId="307"/>
            <ac:picMk id="24" creationId="{24922CB3-EF6D-5199-F566-EF80A3603206}"/>
          </ac:picMkLst>
        </pc:picChg>
        <pc:picChg chg="mod modCrop">
          <ac:chgData name="Kumar, Vinod" userId="a0710a6e-bffc-4971-8893-1c23addeb5b0" providerId="ADAL" clId="{F5D6EA11-585F-4AA1-B279-75820FE30650}" dt="2023-01-12T19:17:10.457" v="3911" actId="1035"/>
          <ac:picMkLst>
            <pc:docMk/>
            <pc:sldMk cId="1809220692" sldId="307"/>
            <ac:picMk id="25" creationId="{4FE53A3B-5019-AEE6-C647-B4DA7D974256}"/>
          </ac:picMkLst>
        </pc:picChg>
      </pc:sldChg>
      <pc:sldChg chg="delSp modSp del mod">
        <pc:chgData name="Kumar, Vinod" userId="a0710a6e-bffc-4971-8893-1c23addeb5b0" providerId="ADAL" clId="{F5D6EA11-585F-4AA1-B279-75820FE30650}" dt="2023-01-10T21:01:56.944" v="940" actId="47"/>
        <pc:sldMkLst>
          <pc:docMk/>
          <pc:sldMk cId="3906571683" sldId="308"/>
        </pc:sldMkLst>
        <pc:spChg chg="del">
          <ac:chgData name="Kumar, Vinod" userId="a0710a6e-bffc-4971-8893-1c23addeb5b0" providerId="ADAL" clId="{F5D6EA11-585F-4AA1-B279-75820FE30650}" dt="2023-01-10T20:43:00.206" v="638" actId="478"/>
          <ac:spMkLst>
            <pc:docMk/>
            <pc:sldMk cId="3906571683" sldId="308"/>
            <ac:spMk id="2" creationId="{7B7025D5-C49D-0D71-E810-27CFFEAE8D76}"/>
          </ac:spMkLst>
        </pc:spChg>
        <pc:spChg chg="mod">
          <ac:chgData name="Kumar, Vinod" userId="a0710a6e-bffc-4971-8893-1c23addeb5b0" providerId="ADAL" clId="{F5D6EA11-585F-4AA1-B279-75820FE30650}" dt="2023-01-10T20:43:10.917" v="639" actId="1076"/>
          <ac:spMkLst>
            <pc:docMk/>
            <pc:sldMk cId="3906571683" sldId="308"/>
            <ac:spMk id="4" creationId="{774680A8-4D94-3CDC-D78E-6A2257750E7E}"/>
          </ac:spMkLst>
        </pc:spChg>
        <pc:picChg chg="del mod">
          <ac:chgData name="Kumar, Vinod" userId="a0710a6e-bffc-4971-8893-1c23addeb5b0" providerId="ADAL" clId="{F5D6EA11-585F-4AA1-B279-75820FE30650}" dt="2023-01-09T21:10:12.867" v="36" actId="478"/>
          <ac:picMkLst>
            <pc:docMk/>
            <pc:sldMk cId="3906571683" sldId="308"/>
            <ac:picMk id="3" creationId="{88941B8D-AB13-66F7-B960-9017A641D10F}"/>
          </ac:picMkLst>
        </pc:picChg>
        <pc:picChg chg="mod">
          <ac:chgData name="Kumar, Vinod" userId="a0710a6e-bffc-4971-8893-1c23addeb5b0" providerId="ADAL" clId="{F5D6EA11-585F-4AA1-B279-75820FE30650}" dt="2023-01-10T20:49:29.715" v="664" actId="1076"/>
          <ac:picMkLst>
            <pc:docMk/>
            <pc:sldMk cId="3906571683" sldId="308"/>
            <ac:picMk id="3" creationId="{EF9AD84E-08BB-E16B-12A0-86C45EF1E07F}"/>
          </ac:picMkLst>
        </pc:picChg>
        <pc:picChg chg="del mod modCrop">
          <ac:chgData name="Kumar, Vinod" userId="a0710a6e-bffc-4971-8893-1c23addeb5b0" providerId="ADAL" clId="{F5D6EA11-585F-4AA1-B279-75820FE30650}" dt="2023-01-10T20:43:00.206" v="638" actId="478"/>
          <ac:picMkLst>
            <pc:docMk/>
            <pc:sldMk cId="3906571683" sldId="308"/>
            <ac:picMk id="5" creationId="{63B7B625-DC49-CDD4-953E-505A16938B85}"/>
          </ac:picMkLst>
        </pc:picChg>
        <pc:picChg chg="del mod">
          <ac:chgData name="Kumar, Vinod" userId="a0710a6e-bffc-4971-8893-1c23addeb5b0" providerId="ADAL" clId="{F5D6EA11-585F-4AA1-B279-75820FE30650}" dt="2023-01-10T20:49:24.299" v="663" actId="478"/>
          <ac:picMkLst>
            <pc:docMk/>
            <pc:sldMk cId="3906571683" sldId="308"/>
            <ac:picMk id="10" creationId="{9B02A01A-5408-B536-4A8C-A06B5316EA58}"/>
          </ac:picMkLst>
        </pc:picChg>
      </pc:sldChg>
      <pc:sldChg chg="addSp modSp del mod">
        <pc:chgData name="Kumar, Vinod" userId="a0710a6e-bffc-4971-8893-1c23addeb5b0" providerId="ADAL" clId="{F5D6EA11-585F-4AA1-B279-75820FE30650}" dt="2023-01-11T17:10:30.400" v="2058" actId="47"/>
        <pc:sldMkLst>
          <pc:docMk/>
          <pc:sldMk cId="363523231" sldId="309"/>
        </pc:sldMkLst>
        <pc:spChg chg="add mod">
          <ac:chgData name="Kumar, Vinod" userId="a0710a6e-bffc-4971-8893-1c23addeb5b0" providerId="ADAL" clId="{F5D6EA11-585F-4AA1-B279-75820FE30650}" dt="2023-01-10T21:04:38.100" v="1013" actId="1035"/>
          <ac:spMkLst>
            <pc:docMk/>
            <pc:sldMk cId="363523231" sldId="309"/>
            <ac:spMk id="9" creationId="{6668A39F-012A-E58E-EBB5-08A035038FF8}"/>
          </ac:spMkLst>
        </pc:spChg>
        <pc:spChg chg="mod">
          <ac:chgData name="Kumar, Vinod" userId="a0710a6e-bffc-4971-8893-1c23addeb5b0" providerId="ADAL" clId="{F5D6EA11-585F-4AA1-B279-75820FE30650}" dt="2023-01-10T16:30:36.247" v="250" actId="1035"/>
          <ac:spMkLst>
            <pc:docMk/>
            <pc:sldMk cId="363523231" sldId="309"/>
            <ac:spMk id="12" creationId="{CB89E43C-D345-E71E-235D-A3F527A77971}"/>
          </ac:spMkLst>
        </pc:spChg>
        <pc:spChg chg="mod">
          <ac:chgData name="Kumar, Vinod" userId="a0710a6e-bffc-4971-8893-1c23addeb5b0" providerId="ADAL" clId="{F5D6EA11-585F-4AA1-B279-75820FE30650}" dt="2023-01-10T21:04:27.908" v="1003" actId="1036"/>
          <ac:spMkLst>
            <pc:docMk/>
            <pc:sldMk cId="363523231" sldId="309"/>
            <ac:spMk id="13" creationId="{2F5C69FE-8BBC-D30D-1B05-F82DAA14E149}"/>
          </ac:spMkLst>
        </pc:spChg>
        <pc:spChg chg="mod">
          <ac:chgData name="Kumar, Vinod" userId="a0710a6e-bffc-4971-8893-1c23addeb5b0" providerId="ADAL" clId="{F5D6EA11-585F-4AA1-B279-75820FE30650}" dt="2023-01-10T21:04:27.908" v="1003" actId="1036"/>
          <ac:spMkLst>
            <pc:docMk/>
            <pc:sldMk cId="363523231" sldId="309"/>
            <ac:spMk id="14" creationId="{DAB75DD1-567F-6F00-8AC6-BCC1C40187EE}"/>
          </ac:spMkLst>
        </pc:spChg>
        <pc:spChg chg="mod">
          <ac:chgData name="Kumar, Vinod" userId="a0710a6e-bffc-4971-8893-1c23addeb5b0" providerId="ADAL" clId="{F5D6EA11-585F-4AA1-B279-75820FE30650}" dt="2023-01-10T21:04:33.347" v="1008" actId="1035"/>
          <ac:spMkLst>
            <pc:docMk/>
            <pc:sldMk cId="363523231" sldId="309"/>
            <ac:spMk id="15" creationId="{610AFE8D-6F14-0B41-CFAF-B50ED829F5E3}"/>
          </ac:spMkLst>
        </pc:spChg>
        <pc:spChg chg="mod">
          <ac:chgData name="Kumar, Vinod" userId="a0710a6e-bffc-4971-8893-1c23addeb5b0" providerId="ADAL" clId="{F5D6EA11-585F-4AA1-B279-75820FE30650}" dt="2023-01-10T21:04:33.347" v="1008" actId="1035"/>
          <ac:spMkLst>
            <pc:docMk/>
            <pc:sldMk cId="363523231" sldId="309"/>
            <ac:spMk id="17" creationId="{4BA5D206-14F9-4C8F-570E-568E631E764E}"/>
          </ac:spMkLst>
        </pc:spChg>
        <pc:spChg chg="mod">
          <ac:chgData name="Kumar, Vinod" userId="a0710a6e-bffc-4971-8893-1c23addeb5b0" providerId="ADAL" clId="{F5D6EA11-585F-4AA1-B279-75820FE30650}" dt="2023-01-10T21:04:33.347" v="1008" actId="1035"/>
          <ac:spMkLst>
            <pc:docMk/>
            <pc:sldMk cId="363523231" sldId="309"/>
            <ac:spMk id="18" creationId="{F868BCCD-1693-01CC-7EB6-FF78E61E1CA6}"/>
          </ac:spMkLst>
        </pc:spChg>
        <pc:spChg chg="mod">
          <ac:chgData name="Kumar, Vinod" userId="a0710a6e-bffc-4971-8893-1c23addeb5b0" providerId="ADAL" clId="{F5D6EA11-585F-4AA1-B279-75820FE30650}" dt="2023-01-10T21:04:38.100" v="1013" actId="1035"/>
          <ac:spMkLst>
            <pc:docMk/>
            <pc:sldMk cId="363523231" sldId="309"/>
            <ac:spMk id="19" creationId="{7A6E65D4-7530-9F25-99BB-3E4A551CAB24}"/>
          </ac:spMkLst>
        </pc:spChg>
        <pc:spChg chg="mod">
          <ac:chgData name="Kumar, Vinod" userId="a0710a6e-bffc-4971-8893-1c23addeb5b0" providerId="ADAL" clId="{F5D6EA11-585F-4AA1-B279-75820FE30650}" dt="2023-01-10T21:04:27.908" v="1003" actId="1036"/>
          <ac:spMkLst>
            <pc:docMk/>
            <pc:sldMk cId="363523231" sldId="309"/>
            <ac:spMk id="21" creationId="{4A1FD6FF-624A-06CB-8B80-7E181D684B98}"/>
          </ac:spMkLst>
        </pc:spChg>
        <pc:picChg chg="mod">
          <ac:chgData name="Kumar, Vinod" userId="a0710a6e-bffc-4971-8893-1c23addeb5b0" providerId="ADAL" clId="{F5D6EA11-585F-4AA1-B279-75820FE30650}" dt="2023-01-10T21:04:27.908" v="1003" actId="1036"/>
          <ac:picMkLst>
            <pc:docMk/>
            <pc:sldMk cId="363523231" sldId="309"/>
            <ac:picMk id="2" creationId="{821457AD-B838-A9B5-FE77-286D2FC2EE7F}"/>
          </ac:picMkLst>
        </pc:picChg>
        <pc:picChg chg="mod">
          <ac:chgData name="Kumar, Vinod" userId="a0710a6e-bffc-4971-8893-1c23addeb5b0" providerId="ADAL" clId="{F5D6EA11-585F-4AA1-B279-75820FE30650}" dt="2023-01-10T21:04:27.908" v="1003" actId="1036"/>
          <ac:picMkLst>
            <pc:docMk/>
            <pc:sldMk cId="363523231" sldId="309"/>
            <ac:picMk id="3" creationId="{EE6D6DA0-B2C8-C062-6E93-1EAB0B1DB695}"/>
          </ac:picMkLst>
        </pc:picChg>
        <pc:picChg chg="mod">
          <ac:chgData name="Kumar, Vinod" userId="a0710a6e-bffc-4971-8893-1c23addeb5b0" providerId="ADAL" clId="{F5D6EA11-585F-4AA1-B279-75820FE30650}" dt="2023-01-10T21:04:27.908" v="1003" actId="1036"/>
          <ac:picMkLst>
            <pc:docMk/>
            <pc:sldMk cId="363523231" sldId="309"/>
            <ac:picMk id="4" creationId="{FEF77DA4-5EBA-204F-C216-45C4D4BAFC59}"/>
          </ac:picMkLst>
        </pc:picChg>
        <pc:picChg chg="mod">
          <ac:chgData name="Kumar, Vinod" userId="a0710a6e-bffc-4971-8893-1c23addeb5b0" providerId="ADAL" clId="{F5D6EA11-585F-4AA1-B279-75820FE30650}" dt="2023-01-10T21:04:33.347" v="1008" actId="1035"/>
          <ac:picMkLst>
            <pc:docMk/>
            <pc:sldMk cId="363523231" sldId="309"/>
            <ac:picMk id="5" creationId="{9BFF4654-44C7-681D-AE78-BB30710F7D35}"/>
          </ac:picMkLst>
        </pc:picChg>
        <pc:picChg chg="add mod">
          <ac:chgData name="Kumar, Vinod" userId="a0710a6e-bffc-4971-8893-1c23addeb5b0" providerId="ADAL" clId="{F5D6EA11-585F-4AA1-B279-75820FE30650}" dt="2023-01-10T21:04:38.100" v="1013" actId="1035"/>
          <ac:picMkLst>
            <pc:docMk/>
            <pc:sldMk cId="363523231" sldId="309"/>
            <ac:picMk id="6" creationId="{EDB87E28-9864-9E38-C719-D46F4B12AE52}"/>
          </ac:picMkLst>
        </pc:picChg>
        <pc:picChg chg="mod">
          <ac:chgData name="Kumar, Vinod" userId="a0710a6e-bffc-4971-8893-1c23addeb5b0" providerId="ADAL" clId="{F5D6EA11-585F-4AA1-B279-75820FE30650}" dt="2023-01-10T21:04:33.347" v="1008" actId="1035"/>
          <ac:picMkLst>
            <pc:docMk/>
            <pc:sldMk cId="363523231" sldId="309"/>
            <ac:picMk id="7" creationId="{F5618D52-7D96-8F92-5FE3-593C006CE318}"/>
          </ac:picMkLst>
        </pc:picChg>
        <pc:picChg chg="mod">
          <ac:chgData name="Kumar, Vinod" userId="a0710a6e-bffc-4971-8893-1c23addeb5b0" providerId="ADAL" clId="{F5D6EA11-585F-4AA1-B279-75820FE30650}" dt="2023-01-10T21:04:33.347" v="1008" actId="1035"/>
          <ac:picMkLst>
            <pc:docMk/>
            <pc:sldMk cId="363523231" sldId="309"/>
            <ac:picMk id="8" creationId="{0C4AC514-70B9-2E08-FC10-F47116B8336F}"/>
          </ac:picMkLst>
        </pc:picChg>
        <pc:picChg chg="mod">
          <ac:chgData name="Kumar, Vinod" userId="a0710a6e-bffc-4971-8893-1c23addeb5b0" providerId="ADAL" clId="{F5D6EA11-585F-4AA1-B279-75820FE30650}" dt="2023-01-10T21:04:38.100" v="1013" actId="1035"/>
          <ac:picMkLst>
            <pc:docMk/>
            <pc:sldMk cId="363523231" sldId="309"/>
            <ac:picMk id="10" creationId="{5BC61CC7-A994-BE81-FF4B-0830F771FB05}"/>
          </ac:picMkLst>
        </pc:picChg>
      </pc:sldChg>
      <pc:sldChg chg="addSp delSp modSp mod">
        <pc:chgData name="Kumar, Vinod" userId="a0710a6e-bffc-4971-8893-1c23addeb5b0" providerId="ADAL" clId="{F5D6EA11-585F-4AA1-B279-75820FE30650}" dt="2023-01-11T22:01:00.939" v="2819" actId="478"/>
        <pc:sldMkLst>
          <pc:docMk/>
          <pc:sldMk cId="1021580243" sldId="311"/>
        </pc:sldMkLst>
        <pc:spChg chg="mod">
          <ac:chgData name="Kumar, Vinod" userId="a0710a6e-bffc-4971-8893-1c23addeb5b0" providerId="ADAL" clId="{F5D6EA11-585F-4AA1-B279-75820FE30650}" dt="2023-01-10T16:31:45.543" v="267" actId="1037"/>
          <ac:spMkLst>
            <pc:docMk/>
            <pc:sldMk cId="1021580243" sldId="311"/>
            <ac:spMk id="5" creationId="{0706E1CA-626E-467D-593C-0057BB6A2FEA}"/>
          </ac:spMkLst>
        </pc:spChg>
        <pc:spChg chg="add del mod">
          <ac:chgData name="Kumar, Vinod" userId="a0710a6e-bffc-4971-8893-1c23addeb5b0" providerId="ADAL" clId="{F5D6EA11-585F-4AA1-B279-75820FE30650}" dt="2023-01-11T22:00:15.147" v="2711" actId="478"/>
          <ac:spMkLst>
            <pc:docMk/>
            <pc:sldMk cId="1021580243" sldId="311"/>
            <ac:spMk id="11" creationId="{1550A872-EB99-9490-4813-F5A8CA27057D}"/>
          </ac:spMkLst>
        </pc:spChg>
        <pc:spChg chg="mod">
          <ac:chgData name="Kumar, Vinod" userId="a0710a6e-bffc-4971-8893-1c23addeb5b0" providerId="ADAL" clId="{F5D6EA11-585F-4AA1-B279-75820FE30650}" dt="2023-01-11T22:00:41.883" v="2814" actId="1038"/>
          <ac:spMkLst>
            <pc:docMk/>
            <pc:sldMk cId="1021580243" sldId="311"/>
            <ac:spMk id="45" creationId="{026710EE-A656-3547-974F-F1654F7242CD}"/>
          </ac:spMkLst>
        </pc:spChg>
        <pc:picChg chg="del mod modCrop">
          <ac:chgData name="Kumar, Vinod" userId="a0710a6e-bffc-4971-8893-1c23addeb5b0" providerId="ADAL" clId="{F5D6EA11-585F-4AA1-B279-75820FE30650}" dt="2023-01-11T22:00:17.580" v="2712" actId="478"/>
          <ac:picMkLst>
            <pc:docMk/>
            <pc:sldMk cId="1021580243" sldId="311"/>
            <ac:picMk id="2" creationId="{6F82851E-5386-1C17-4993-2D9D1BD809A0}"/>
          </ac:picMkLst>
        </pc:picChg>
        <pc:picChg chg="add del mod modCrop">
          <ac:chgData name="Kumar, Vinod" userId="a0710a6e-bffc-4971-8893-1c23addeb5b0" providerId="ADAL" clId="{F5D6EA11-585F-4AA1-B279-75820FE30650}" dt="2023-01-11T22:00:17.580" v="2712" actId="478"/>
          <ac:picMkLst>
            <pc:docMk/>
            <pc:sldMk cId="1021580243" sldId="311"/>
            <ac:picMk id="3" creationId="{AB02CEB2-54D2-97C9-AED7-0C988DA37756}"/>
          </ac:picMkLst>
        </pc:picChg>
        <pc:picChg chg="add del mod">
          <ac:chgData name="Kumar, Vinod" userId="a0710a6e-bffc-4971-8893-1c23addeb5b0" providerId="ADAL" clId="{F5D6EA11-585F-4AA1-B279-75820FE30650}" dt="2023-01-11T22:00:57.483" v="2815" actId="478"/>
          <ac:picMkLst>
            <pc:docMk/>
            <pc:sldMk cId="1021580243" sldId="311"/>
            <ac:picMk id="4" creationId="{CA80D7B3-B42C-B284-3E63-BDB8565CC65A}"/>
          </ac:picMkLst>
        </pc:picChg>
        <pc:picChg chg="add del mod">
          <ac:chgData name="Kumar, Vinod" userId="a0710a6e-bffc-4971-8893-1c23addeb5b0" providerId="ADAL" clId="{F5D6EA11-585F-4AA1-B279-75820FE30650}" dt="2023-01-11T22:01:00.939" v="2819" actId="478"/>
          <ac:picMkLst>
            <pc:docMk/>
            <pc:sldMk cId="1021580243" sldId="311"/>
            <ac:picMk id="6" creationId="{B1BB59E8-6286-30CF-A014-FC691809D45F}"/>
          </ac:picMkLst>
        </pc:picChg>
        <pc:picChg chg="add del mod">
          <ac:chgData name="Kumar, Vinod" userId="a0710a6e-bffc-4971-8893-1c23addeb5b0" providerId="ADAL" clId="{F5D6EA11-585F-4AA1-B279-75820FE30650}" dt="2023-01-11T22:01:00.122" v="2818" actId="478"/>
          <ac:picMkLst>
            <pc:docMk/>
            <pc:sldMk cId="1021580243" sldId="311"/>
            <ac:picMk id="7" creationId="{7C44DE92-C28C-7FA5-1D99-B047C5C6642B}"/>
          </ac:picMkLst>
        </pc:picChg>
        <pc:picChg chg="add del mod">
          <ac:chgData name="Kumar, Vinod" userId="a0710a6e-bffc-4971-8893-1c23addeb5b0" providerId="ADAL" clId="{F5D6EA11-585F-4AA1-B279-75820FE30650}" dt="2023-01-11T22:00:58.443" v="2816" actId="478"/>
          <ac:picMkLst>
            <pc:docMk/>
            <pc:sldMk cId="1021580243" sldId="311"/>
            <ac:picMk id="8" creationId="{06457E6C-56EB-4996-1E52-F56AC93C620B}"/>
          </ac:picMkLst>
        </pc:picChg>
        <pc:picChg chg="del mod modCrop">
          <ac:chgData name="Kumar, Vinod" userId="a0710a6e-bffc-4971-8893-1c23addeb5b0" providerId="ADAL" clId="{F5D6EA11-585F-4AA1-B279-75820FE30650}" dt="2023-01-11T22:00:59.387" v="2817" actId="478"/>
          <ac:picMkLst>
            <pc:docMk/>
            <pc:sldMk cId="1021580243" sldId="311"/>
            <ac:picMk id="9" creationId="{5784B395-3D77-2943-D7C8-E46AEF293309}"/>
          </ac:picMkLst>
        </pc:picChg>
        <pc:picChg chg="mod">
          <ac:chgData name="Kumar, Vinod" userId="a0710a6e-bffc-4971-8893-1c23addeb5b0" providerId="ADAL" clId="{F5D6EA11-585F-4AA1-B279-75820FE30650}" dt="2023-01-11T22:00:28.874" v="2780" actId="1035"/>
          <ac:picMkLst>
            <pc:docMk/>
            <pc:sldMk cId="1021580243" sldId="311"/>
            <ac:picMk id="12" creationId="{482CDF10-2FE6-493B-D78B-BDA2C5FCB7C0}"/>
          </ac:picMkLst>
        </pc:picChg>
        <pc:picChg chg="mod">
          <ac:chgData name="Kumar, Vinod" userId="a0710a6e-bffc-4971-8893-1c23addeb5b0" providerId="ADAL" clId="{F5D6EA11-585F-4AA1-B279-75820FE30650}" dt="2023-01-11T22:00:35.291" v="2802" actId="1038"/>
          <ac:picMkLst>
            <pc:docMk/>
            <pc:sldMk cId="1021580243" sldId="311"/>
            <ac:picMk id="13" creationId="{DE3E22C3-029E-611F-7B63-DEAD49EBF0E0}"/>
          </ac:picMkLst>
        </pc:picChg>
        <pc:picChg chg="del">
          <ac:chgData name="Kumar, Vinod" userId="a0710a6e-bffc-4971-8893-1c23addeb5b0" providerId="ADAL" clId="{F5D6EA11-585F-4AA1-B279-75820FE30650}" dt="2023-01-10T21:39:37.587" v="1035" actId="478"/>
          <ac:picMkLst>
            <pc:docMk/>
            <pc:sldMk cId="1021580243" sldId="311"/>
            <ac:picMk id="42" creationId="{59CB2D69-3614-FCFE-8790-FADDCBBA4B1E}"/>
          </ac:picMkLst>
        </pc:picChg>
        <pc:picChg chg="del">
          <ac:chgData name="Kumar, Vinod" userId="a0710a6e-bffc-4971-8893-1c23addeb5b0" providerId="ADAL" clId="{F5D6EA11-585F-4AA1-B279-75820FE30650}" dt="2023-01-10T21:39:37.587" v="1035" actId="478"/>
          <ac:picMkLst>
            <pc:docMk/>
            <pc:sldMk cId="1021580243" sldId="311"/>
            <ac:picMk id="43" creationId="{D2379BED-B394-ABE7-6975-EC515FB3CC19}"/>
          </ac:picMkLst>
        </pc:picChg>
      </pc:sldChg>
      <pc:sldChg chg="addSp delSp modSp mod">
        <pc:chgData name="Kumar, Vinod" userId="a0710a6e-bffc-4971-8893-1c23addeb5b0" providerId="ADAL" clId="{F5D6EA11-585F-4AA1-B279-75820FE30650}" dt="2023-01-10T21:01:41.478" v="939" actId="20577"/>
        <pc:sldMkLst>
          <pc:docMk/>
          <pc:sldMk cId="2551874591" sldId="314"/>
        </pc:sldMkLst>
        <pc:spChg chg="mod">
          <ac:chgData name="Kumar, Vinod" userId="a0710a6e-bffc-4971-8893-1c23addeb5b0" providerId="ADAL" clId="{F5D6EA11-585F-4AA1-B279-75820FE30650}" dt="2023-01-10T20:59:55.094" v="751" actId="1035"/>
          <ac:spMkLst>
            <pc:docMk/>
            <pc:sldMk cId="2551874591" sldId="314"/>
            <ac:spMk id="7" creationId="{E9A5EDE8-83BF-C1F5-FE1F-C91A13ECAC86}"/>
          </ac:spMkLst>
        </pc:spChg>
        <pc:spChg chg="add mod">
          <ac:chgData name="Kumar, Vinod" userId="a0710a6e-bffc-4971-8893-1c23addeb5b0" providerId="ADAL" clId="{F5D6EA11-585F-4AA1-B279-75820FE30650}" dt="2023-01-10T21:00:49.350" v="833" actId="20577"/>
          <ac:spMkLst>
            <pc:docMk/>
            <pc:sldMk cId="2551874591" sldId="314"/>
            <ac:spMk id="12" creationId="{C27EE938-1CB7-E066-BFC9-1C59CA6B9DDF}"/>
          </ac:spMkLst>
        </pc:spChg>
        <pc:spChg chg="add mod">
          <ac:chgData name="Kumar, Vinod" userId="a0710a6e-bffc-4971-8893-1c23addeb5b0" providerId="ADAL" clId="{F5D6EA11-585F-4AA1-B279-75820FE30650}" dt="2023-01-10T21:01:10.565" v="877" actId="20577"/>
          <ac:spMkLst>
            <pc:docMk/>
            <pc:sldMk cId="2551874591" sldId="314"/>
            <ac:spMk id="13" creationId="{52B105F6-F840-377B-D976-C2AD8CB4C5F1}"/>
          </ac:spMkLst>
        </pc:spChg>
        <pc:spChg chg="add mod">
          <ac:chgData name="Kumar, Vinod" userId="a0710a6e-bffc-4971-8893-1c23addeb5b0" providerId="ADAL" clId="{F5D6EA11-585F-4AA1-B279-75820FE30650}" dt="2023-01-10T21:01:14.534" v="878" actId="20577"/>
          <ac:spMkLst>
            <pc:docMk/>
            <pc:sldMk cId="2551874591" sldId="314"/>
            <ac:spMk id="14" creationId="{068F6C60-C84D-779C-52D5-DFD694A8E9B5}"/>
          </ac:spMkLst>
        </pc:spChg>
        <pc:spChg chg="add mod">
          <ac:chgData name="Kumar, Vinod" userId="a0710a6e-bffc-4971-8893-1c23addeb5b0" providerId="ADAL" clId="{F5D6EA11-585F-4AA1-B279-75820FE30650}" dt="2023-01-10T21:01:37.799" v="938" actId="20577"/>
          <ac:spMkLst>
            <pc:docMk/>
            <pc:sldMk cId="2551874591" sldId="314"/>
            <ac:spMk id="15" creationId="{41775FC4-4D76-D18F-C620-DC49A6F16F19}"/>
          </ac:spMkLst>
        </pc:spChg>
        <pc:spChg chg="add mod">
          <ac:chgData name="Kumar, Vinod" userId="a0710a6e-bffc-4971-8893-1c23addeb5b0" providerId="ADAL" clId="{F5D6EA11-585F-4AA1-B279-75820FE30650}" dt="2023-01-10T21:01:41.478" v="939" actId="20577"/>
          <ac:spMkLst>
            <pc:docMk/>
            <pc:sldMk cId="2551874591" sldId="314"/>
            <ac:spMk id="16" creationId="{3B13C716-2734-A971-9A49-4B9A3B633355}"/>
          </ac:spMkLst>
        </pc:spChg>
        <pc:picChg chg="add del">
          <ac:chgData name="Kumar, Vinod" userId="a0710a6e-bffc-4971-8893-1c23addeb5b0" providerId="ADAL" clId="{F5D6EA11-585F-4AA1-B279-75820FE30650}" dt="2023-01-09T15:47:42.225" v="1"/>
          <ac:picMkLst>
            <pc:docMk/>
            <pc:sldMk cId="2551874591" sldId="314"/>
            <ac:picMk id="3" creationId="{3E2C3324-ED93-4359-F6B7-25C495ADB1BE}"/>
          </ac:picMkLst>
        </pc:picChg>
        <pc:picChg chg="mod modCrop">
          <ac:chgData name="Kumar, Vinod" userId="a0710a6e-bffc-4971-8893-1c23addeb5b0" providerId="ADAL" clId="{F5D6EA11-585F-4AA1-B279-75820FE30650}" dt="2023-01-10T21:00:02.534" v="760" actId="1036"/>
          <ac:picMkLst>
            <pc:docMk/>
            <pc:sldMk cId="2551874591" sldId="314"/>
            <ac:picMk id="3" creationId="{908EE6BE-26ED-084B-CFDA-83892522EEFD}"/>
          </ac:picMkLst>
        </pc:picChg>
        <pc:picChg chg="mod modCrop">
          <ac:chgData name="Kumar, Vinod" userId="a0710a6e-bffc-4971-8893-1c23addeb5b0" providerId="ADAL" clId="{F5D6EA11-585F-4AA1-B279-75820FE30650}" dt="2023-01-10T21:00:02.534" v="760" actId="1036"/>
          <ac:picMkLst>
            <pc:docMk/>
            <pc:sldMk cId="2551874591" sldId="314"/>
            <ac:picMk id="4" creationId="{27BB9DB2-7785-93BD-48B9-5493F2737312}"/>
          </ac:picMkLst>
        </pc:picChg>
        <pc:picChg chg="del mod modCrop">
          <ac:chgData name="Kumar, Vinod" userId="a0710a6e-bffc-4971-8893-1c23addeb5b0" providerId="ADAL" clId="{F5D6EA11-585F-4AA1-B279-75820FE30650}" dt="2023-01-09T15:48:50.841" v="19" actId="478"/>
          <ac:picMkLst>
            <pc:docMk/>
            <pc:sldMk cId="2551874591" sldId="314"/>
            <ac:picMk id="4" creationId="{94AD1E1A-7D93-11DE-B182-671EBC4267C3}"/>
          </ac:picMkLst>
        </pc:picChg>
        <pc:picChg chg="add del mod">
          <ac:chgData name="Kumar, Vinod" userId="a0710a6e-bffc-4971-8893-1c23addeb5b0" providerId="ADAL" clId="{F5D6EA11-585F-4AA1-B279-75820FE30650}" dt="2023-01-10T20:54:24.073" v="669" actId="478"/>
          <ac:picMkLst>
            <pc:docMk/>
            <pc:sldMk cId="2551874591" sldId="314"/>
            <ac:picMk id="5" creationId="{8EE4F814-F2C7-6598-196E-C33878432AAF}"/>
          </ac:picMkLst>
        </pc:picChg>
        <pc:picChg chg="mod">
          <ac:chgData name="Kumar, Vinod" userId="a0710a6e-bffc-4971-8893-1c23addeb5b0" providerId="ADAL" clId="{F5D6EA11-585F-4AA1-B279-75820FE30650}" dt="2023-01-10T20:59:47.894" v="738" actId="1035"/>
          <ac:picMkLst>
            <pc:docMk/>
            <pc:sldMk cId="2551874591" sldId="314"/>
            <ac:picMk id="6" creationId="{46602624-7F01-EC5F-7DCF-E4FD97D84904}"/>
          </ac:picMkLst>
        </pc:picChg>
        <pc:picChg chg="mod modCrop">
          <ac:chgData name="Kumar, Vinod" userId="a0710a6e-bffc-4971-8893-1c23addeb5b0" providerId="ADAL" clId="{F5D6EA11-585F-4AA1-B279-75820FE30650}" dt="2023-01-10T20:59:47.894" v="738" actId="1035"/>
          <ac:picMkLst>
            <pc:docMk/>
            <pc:sldMk cId="2551874591" sldId="314"/>
            <ac:picMk id="8" creationId="{D56EF732-3FB9-4B75-8022-CF8EBC176522}"/>
          </ac:picMkLst>
        </pc:picChg>
        <pc:picChg chg="mod modCrop">
          <ac:chgData name="Kumar, Vinod" userId="a0710a6e-bffc-4971-8893-1c23addeb5b0" providerId="ADAL" clId="{F5D6EA11-585F-4AA1-B279-75820FE30650}" dt="2023-01-10T21:00:31.813" v="779" actId="1036"/>
          <ac:picMkLst>
            <pc:docMk/>
            <pc:sldMk cId="2551874591" sldId="314"/>
            <ac:picMk id="9" creationId="{51589004-5581-8664-6C28-D36C9B661022}"/>
          </ac:picMkLst>
        </pc:picChg>
        <pc:picChg chg="add del mod">
          <ac:chgData name="Kumar, Vinod" userId="a0710a6e-bffc-4971-8893-1c23addeb5b0" providerId="ADAL" clId="{F5D6EA11-585F-4AA1-B279-75820FE30650}" dt="2023-01-10T20:58:43.334" v="736" actId="478"/>
          <ac:picMkLst>
            <pc:docMk/>
            <pc:sldMk cId="2551874591" sldId="314"/>
            <ac:picMk id="10" creationId="{A83384D1-C43E-6CC5-41CD-971C6F3AAB36}"/>
          </ac:picMkLst>
        </pc:picChg>
        <pc:picChg chg="add mod">
          <ac:chgData name="Kumar, Vinod" userId="a0710a6e-bffc-4971-8893-1c23addeb5b0" providerId="ADAL" clId="{F5D6EA11-585F-4AA1-B279-75820FE30650}" dt="2023-01-10T21:00:13.525" v="762" actId="1076"/>
          <ac:picMkLst>
            <pc:docMk/>
            <pc:sldMk cId="2551874591" sldId="314"/>
            <ac:picMk id="11" creationId="{0890E6BB-FCDC-AFAE-806A-AF99381940EC}"/>
          </ac:picMkLst>
        </pc:picChg>
      </pc:sldChg>
      <pc:sldChg chg="modSp mod">
        <pc:chgData name="Kumar, Vinod" userId="a0710a6e-bffc-4971-8893-1c23addeb5b0" providerId="ADAL" clId="{F5D6EA11-585F-4AA1-B279-75820FE30650}" dt="2023-01-10T21:02:53.349" v="947" actId="1036"/>
        <pc:sldMkLst>
          <pc:docMk/>
          <pc:sldMk cId="2153520942" sldId="315"/>
        </pc:sldMkLst>
        <pc:spChg chg="mod">
          <ac:chgData name="Kumar, Vinod" userId="a0710a6e-bffc-4971-8893-1c23addeb5b0" providerId="ADAL" clId="{F5D6EA11-585F-4AA1-B279-75820FE30650}" dt="2023-01-10T21:02:53.349" v="947" actId="1036"/>
          <ac:spMkLst>
            <pc:docMk/>
            <pc:sldMk cId="2153520942" sldId="315"/>
            <ac:spMk id="73" creationId="{3DC87012-760F-483C-9104-E6DEDCC490D2}"/>
          </ac:spMkLst>
        </pc:spChg>
      </pc:sldChg>
      <pc:sldChg chg="delSp modSp mod">
        <pc:chgData name="Kumar, Vinod" userId="a0710a6e-bffc-4971-8893-1c23addeb5b0" providerId="ADAL" clId="{F5D6EA11-585F-4AA1-B279-75820FE30650}" dt="2023-01-12T16:12:32.577" v="3706" actId="1037"/>
        <pc:sldMkLst>
          <pc:docMk/>
          <pc:sldMk cId="240031287" sldId="317"/>
        </pc:sldMkLst>
        <pc:spChg chg="mod">
          <ac:chgData name="Kumar, Vinod" userId="a0710a6e-bffc-4971-8893-1c23addeb5b0" providerId="ADAL" clId="{F5D6EA11-585F-4AA1-B279-75820FE30650}" dt="2023-01-10T16:31:57.271" v="275" actId="1038"/>
          <ac:spMkLst>
            <pc:docMk/>
            <pc:sldMk cId="240031287" sldId="317"/>
            <ac:spMk id="2" creationId="{51D40CE4-17B2-7A16-E7B1-F6DFB55A0FA0}"/>
          </ac:spMkLst>
        </pc:spChg>
        <pc:picChg chg="mod modCrop">
          <ac:chgData name="Kumar, Vinod" userId="a0710a6e-bffc-4971-8893-1c23addeb5b0" providerId="ADAL" clId="{F5D6EA11-585F-4AA1-B279-75820FE30650}" dt="2023-01-12T16:12:32.577" v="3706" actId="1037"/>
          <ac:picMkLst>
            <pc:docMk/>
            <pc:sldMk cId="240031287" sldId="317"/>
            <ac:picMk id="9" creationId="{9CE5BEA1-F838-7F0D-E418-4BEB3868898E}"/>
          </ac:picMkLst>
        </pc:picChg>
        <pc:picChg chg="mod modCrop">
          <ac:chgData name="Kumar, Vinod" userId="a0710a6e-bffc-4971-8893-1c23addeb5b0" providerId="ADAL" clId="{F5D6EA11-585F-4AA1-B279-75820FE30650}" dt="2023-01-12T16:11:05.217" v="3682" actId="1038"/>
          <ac:picMkLst>
            <pc:docMk/>
            <pc:sldMk cId="240031287" sldId="317"/>
            <ac:picMk id="10" creationId="{79A879C2-BF77-04C6-3CE1-B9DC453325F0}"/>
          </ac:picMkLst>
        </pc:picChg>
        <pc:picChg chg="mod modCrop">
          <ac:chgData name="Kumar, Vinod" userId="a0710a6e-bffc-4971-8893-1c23addeb5b0" providerId="ADAL" clId="{F5D6EA11-585F-4AA1-B279-75820FE30650}" dt="2023-01-12T16:11:34.610" v="3687" actId="1076"/>
          <ac:picMkLst>
            <pc:docMk/>
            <pc:sldMk cId="240031287" sldId="317"/>
            <ac:picMk id="11" creationId="{D7C98EA2-A972-0AC7-4180-6CAD504A3552}"/>
          </ac:picMkLst>
        </pc:picChg>
        <pc:picChg chg="del">
          <ac:chgData name="Kumar, Vinod" userId="a0710a6e-bffc-4971-8893-1c23addeb5b0" providerId="ADAL" clId="{F5D6EA11-585F-4AA1-B279-75820FE30650}" dt="2023-01-12T16:12:11.585" v="3693" actId="478"/>
          <ac:picMkLst>
            <pc:docMk/>
            <pc:sldMk cId="240031287" sldId="317"/>
            <ac:picMk id="79" creationId="{B03EF4E1-E5C2-04E5-8333-519887056FEF}"/>
          </ac:picMkLst>
        </pc:picChg>
        <pc:picChg chg="del">
          <ac:chgData name="Kumar, Vinod" userId="a0710a6e-bffc-4971-8893-1c23addeb5b0" providerId="ADAL" clId="{F5D6EA11-585F-4AA1-B279-75820FE30650}" dt="2023-01-12T16:10:28.770" v="3657" actId="478"/>
          <ac:picMkLst>
            <pc:docMk/>
            <pc:sldMk cId="240031287" sldId="317"/>
            <ac:picMk id="88" creationId="{4BE5039A-14EE-E51D-89E4-EDE17E568A68}"/>
          </ac:picMkLst>
        </pc:picChg>
        <pc:picChg chg="del">
          <ac:chgData name="Kumar, Vinod" userId="a0710a6e-bffc-4971-8893-1c23addeb5b0" providerId="ADAL" clId="{F5D6EA11-585F-4AA1-B279-75820FE30650}" dt="2023-01-12T16:11:24.481" v="3686" actId="478"/>
          <ac:picMkLst>
            <pc:docMk/>
            <pc:sldMk cId="240031287" sldId="317"/>
            <ac:picMk id="97" creationId="{BDA9227D-B5A4-9D55-3AEF-C552602BE279}"/>
          </ac:picMkLst>
        </pc:picChg>
      </pc:sldChg>
      <pc:sldChg chg="addSp delSp modSp del mod">
        <pc:chgData name="Kumar, Vinod" userId="a0710a6e-bffc-4971-8893-1c23addeb5b0" providerId="ADAL" clId="{F5D6EA11-585F-4AA1-B279-75820FE30650}" dt="2023-01-20T20:45:00.796" v="5119" actId="47"/>
        <pc:sldMkLst>
          <pc:docMk/>
          <pc:sldMk cId="2245635649" sldId="318"/>
        </pc:sldMkLst>
        <pc:spChg chg="mod">
          <ac:chgData name="Kumar, Vinod" userId="a0710a6e-bffc-4971-8893-1c23addeb5b0" providerId="ADAL" clId="{F5D6EA11-585F-4AA1-B279-75820FE30650}" dt="2023-01-10T21:03:58.323" v="988" actId="1035"/>
          <ac:spMkLst>
            <pc:docMk/>
            <pc:sldMk cId="2245635649" sldId="318"/>
            <ac:spMk id="2" creationId="{086F389C-2B07-5F00-EA2A-17A9729D565C}"/>
          </ac:spMkLst>
        </pc:spChg>
        <pc:spChg chg="mod">
          <ac:chgData name="Kumar, Vinod" userId="a0710a6e-bffc-4971-8893-1c23addeb5b0" providerId="ADAL" clId="{F5D6EA11-585F-4AA1-B279-75820FE30650}" dt="2023-01-11T15:12:26.686" v="1166" actId="1036"/>
          <ac:spMkLst>
            <pc:docMk/>
            <pc:sldMk cId="2245635649" sldId="318"/>
            <ac:spMk id="4" creationId="{807DDF8D-DD5A-C886-628E-44F7532EA59A}"/>
          </ac:spMkLst>
        </pc:spChg>
        <pc:spChg chg="mod">
          <ac:chgData name="Kumar, Vinod" userId="a0710a6e-bffc-4971-8893-1c23addeb5b0" providerId="ADAL" clId="{F5D6EA11-585F-4AA1-B279-75820FE30650}" dt="2023-01-11T15:12:26.686" v="1166" actId="1036"/>
          <ac:spMkLst>
            <pc:docMk/>
            <pc:sldMk cId="2245635649" sldId="318"/>
            <ac:spMk id="5" creationId="{29C8CD6C-A351-73DF-B87D-E3F61C730E27}"/>
          </ac:spMkLst>
        </pc:spChg>
        <pc:spChg chg="mod">
          <ac:chgData name="Kumar, Vinod" userId="a0710a6e-bffc-4971-8893-1c23addeb5b0" providerId="ADAL" clId="{F5D6EA11-585F-4AA1-B279-75820FE30650}" dt="2023-01-10T21:03:42.709" v="967" actId="1036"/>
          <ac:spMkLst>
            <pc:docMk/>
            <pc:sldMk cId="2245635649" sldId="318"/>
            <ac:spMk id="7" creationId="{CA245E9C-2D8C-31E6-8171-359297E8C881}"/>
          </ac:spMkLst>
        </pc:spChg>
        <pc:spChg chg="mod">
          <ac:chgData name="Kumar, Vinod" userId="a0710a6e-bffc-4971-8893-1c23addeb5b0" providerId="ADAL" clId="{F5D6EA11-585F-4AA1-B279-75820FE30650}" dt="2023-01-10T21:03:42.709" v="967" actId="1036"/>
          <ac:spMkLst>
            <pc:docMk/>
            <pc:sldMk cId="2245635649" sldId="318"/>
            <ac:spMk id="9" creationId="{BB09CE7D-0741-C326-B30F-1DC7AE58ED2F}"/>
          </ac:spMkLst>
        </pc:spChg>
        <pc:spChg chg="mod">
          <ac:chgData name="Kumar, Vinod" userId="a0710a6e-bffc-4971-8893-1c23addeb5b0" providerId="ADAL" clId="{F5D6EA11-585F-4AA1-B279-75820FE30650}" dt="2023-01-18T21:53:13.531" v="4507" actId="1037"/>
          <ac:spMkLst>
            <pc:docMk/>
            <pc:sldMk cId="2245635649" sldId="318"/>
            <ac:spMk id="11" creationId="{F1D6877B-352A-2260-0F6D-246D6666FE5D}"/>
          </ac:spMkLst>
        </pc:spChg>
        <pc:spChg chg="mod">
          <ac:chgData name="Kumar, Vinod" userId="a0710a6e-bffc-4971-8893-1c23addeb5b0" providerId="ADAL" clId="{F5D6EA11-585F-4AA1-B279-75820FE30650}" dt="2023-01-10T21:03:42.709" v="967" actId="1036"/>
          <ac:spMkLst>
            <pc:docMk/>
            <pc:sldMk cId="2245635649" sldId="318"/>
            <ac:spMk id="24" creationId="{2CB71B04-41F5-163C-2C79-A3B7B287BD9C}"/>
          </ac:spMkLst>
        </pc:spChg>
        <pc:spChg chg="mod">
          <ac:chgData name="Kumar, Vinod" userId="a0710a6e-bffc-4971-8893-1c23addeb5b0" providerId="ADAL" clId="{F5D6EA11-585F-4AA1-B279-75820FE30650}" dt="2023-01-10T21:03:42.709" v="967" actId="1036"/>
          <ac:spMkLst>
            <pc:docMk/>
            <pc:sldMk cId="2245635649" sldId="318"/>
            <ac:spMk id="27" creationId="{45B27FF7-15E8-87DE-69F0-B6032DD8E302}"/>
          </ac:spMkLst>
        </pc:spChg>
        <pc:spChg chg="mod">
          <ac:chgData name="Kumar, Vinod" userId="a0710a6e-bffc-4971-8893-1c23addeb5b0" providerId="ADAL" clId="{F5D6EA11-585F-4AA1-B279-75820FE30650}" dt="2023-01-11T15:11:43.263" v="1120" actId="1036"/>
          <ac:spMkLst>
            <pc:docMk/>
            <pc:sldMk cId="2245635649" sldId="318"/>
            <ac:spMk id="34" creationId="{A40DE553-6E10-0460-7D7D-46ACDCD58D3F}"/>
          </ac:spMkLst>
        </pc:spChg>
        <pc:spChg chg="mod">
          <ac:chgData name="Kumar, Vinod" userId="a0710a6e-bffc-4971-8893-1c23addeb5b0" providerId="ADAL" clId="{F5D6EA11-585F-4AA1-B279-75820FE30650}" dt="2023-01-10T21:03:42.709" v="967" actId="1036"/>
          <ac:spMkLst>
            <pc:docMk/>
            <pc:sldMk cId="2245635649" sldId="318"/>
            <ac:spMk id="48" creationId="{9C0A8C2F-F8D9-CDC4-90DB-A853D6A6D490}"/>
          </ac:spMkLst>
        </pc:spChg>
        <pc:spChg chg="mod">
          <ac:chgData name="Kumar, Vinod" userId="a0710a6e-bffc-4971-8893-1c23addeb5b0" providerId="ADAL" clId="{F5D6EA11-585F-4AA1-B279-75820FE30650}" dt="2023-01-10T21:03:42.709" v="967" actId="1036"/>
          <ac:spMkLst>
            <pc:docMk/>
            <pc:sldMk cId="2245635649" sldId="318"/>
            <ac:spMk id="49" creationId="{4D5C34F6-7B32-C42F-9835-65C4AEB72979}"/>
          </ac:spMkLst>
        </pc:spChg>
        <pc:spChg chg="mod">
          <ac:chgData name="Kumar, Vinod" userId="a0710a6e-bffc-4971-8893-1c23addeb5b0" providerId="ADAL" clId="{F5D6EA11-585F-4AA1-B279-75820FE30650}" dt="2023-01-10T21:03:42.709" v="967" actId="1036"/>
          <ac:spMkLst>
            <pc:docMk/>
            <pc:sldMk cId="2245635649" sldId="318"/>
            <ac:spMk id="50" creationId="{D2DAD5DD-CE35-E82A-55C0-A56182096E73}"/>
          </ac:spMkLst>
        </pc:spChg>
        <pc:spChg chg="mod">
          <ac:chgData name="Kumar, Vinod" userId="a0710a6e-bffc-4971-8893-1c23addeb5b0" providerId="ADAL" clId="{F5D6EA11-585F-4AA1-B279-75820FE30650}" dt="2023-01-10T21:03:49.923" v="975" actId="1036"/>
          <ac:spMkLst>
            <pc:docMk/>
            <pc:sldMk cId="2245635649" sldId="318"/>
            <ac:spMk id="55" creationId="{2D60AFF9-F775-763C-C2B6-E8AB7D8FACA5}"/>
          </ac:spMkLst>
        </pc:spChg>
        <pc:spChg chg="mod">
          <ac:chgData name="Kumar, Vinod" userId="a0710a6e-bffc-4971-8893-1c23addeb5b0" providerId="ADAL" clId="{F5D6EA11-585F-4AA1-B279-75820FE30650}" dt="2023-01-11T15:11:36.191" v="1115" actId="1036"/>
          <ac:spMkLst>
            <pc:docMk/>
            <pc:sldMk cId="2245635649" sldId="318"/>
            <ac:spMk id="56" creationId="{ABA256FF-FF80-1424-2C8A-024D97CA5E11}"/>
          </ac:spMkLst>
        </pc:spChg>
        <pc:spChg chg="mod">
          <ac:chgData name="Kumar, Vinod" userId="a0710a6e-bffc-4971-8893-1c23addeb5b0" providerId="ADAL" clId="{F5D6EA11-585F-4AA1-B279-75820FE30650}" dt="2023-01-11T15:11:36.191" v="1115" actId="1036"/>
          <ac:spMkLst>
            <pc:docMk/>
            <pc:sldMk cId="2245635649" sldId="318"/>
            <ac:spMk id="57" creationId="{7EAF74B5-4114-AE6D-87DB-84F7280CD5BB}"/>
          </ac:spMkLst>
        </pc:spChg>
        <pc:grpChg chg="add del">
          <ac:chgData name="Kumar, Vinod" userId="a0710a6e-bffc-4971-8893-1c23addeb5b0" providerId="ADAL" clId="{F5D6EA11-585F-4AA1-B279-75820FE30650}" dt="2023-01-10T21:44:02.976" v="1047" actId="478"/>
          <ac:grpSpMkLst>
            <pc:docMk/>
            <pc:sldMk cId="2245635649" sldId="318"/>
            <ac:grpSpMk id="35" creationId="{65FAC313-7570-42BD-7CB6-A83AFBCF6B48}"/>
          </ac:grpSpMkLst>
        </pc:grpChg>
        <pc:picChg chg="mod">
          <ac:chgData name="Kumar, Vinod" userId="a0710a6e-bffc-4971-8893-1c23addeb5b0" providerId="ADAL" clId="{F5D6EA11-585F-4AA1-B279-75820FE30650}" dt="2023-01-10T21:03:42.709" v="967" actId="1036"/>
          <ac:picMkLst>
            <pc:docMk/>
            <pc:sldMk cId="2245635649" sldId="318"/>
            <ac:picMk id="6" creationId="{597E1871-FDF9-1159-ED4A-45196F831B1A}"/>
          </ac:picMkLst>
        </pc:picChg>
        <pc:picChg chg="mod">
          <ac:chgData name="Kumar, Vinod" userId="a0710a6e-bffc-4971-8893-1c23addeb5b0" providerId="ADAL" clId="{F5D6EA11-585F-4AA1-B279-75820FE30650}" dt="2023-01-10T21:03:42.709" v="967" actId="1036"/>
          <ac:picMkLst>
            <pc:docMk/>
            <pc:sldMk cId="2245635649" sldId="318"/>
            <ac:picMk id="10" creationId="{27FE0B6C-4D51-6251-5956-EDC065D200A4}"/>
          </ac:picMkLst>
        </pc:picChg>
        <pc:picChg chg="mod">
          <ac:chgData name="Kumar, Vinod" userId="a0710a6e-bffc-4971-8893-1c23addeb5b0" providerId="ADAL" clId="{F5D6EA11-585F-4AA1-B279-75820FE30650}" dt="2023-01-11T15:12:03.374" v="1139" actId="1036"/>
          <ac:picMkLst>
            <pc:docMk/>
            <pc:sldMk cId="2245635649" sldId="318"/>
            <ac:picMk id="13" creationId="{2E681331-78BB-750C-D0C0-74379A16FE2B}"/>
          </ac:picMkLst>
        </pc:picChg>
        <pc:picChg chg="mod">
          <ac:chgData name="Kumar, Vinod" userId="a0710a6e-bffc-4971-8893-1c23addeb5b0" providerId="ADAL" clId="{F5D6EA11-585F-4AA1-B279-75820FE30650}" dt="2023-01-10T21:03:42.709" v="967" actId="1036"/>
          <ac:picMkLst>
            <pc:docMk/>
            <pc:sldMk cId="2245635649" sldId="318"/>
            <ac:picMk id="26" creationId="{49CEA3E8-0B46-054A-907F-8D68EEF930AF}"/>
          </ac:picMkLst>
        </pc:picChg>
        <pc:picChg chg="mod">
          <ac:chgData name="Kumar, Vinod" userId="a0710a6e-bffc-4971-8893-1c23addeb5b0" providerId="ADAL" clId="{F5D6EA11-585F-4AA1-B279-75820FE30650}" dt="2023-01-10T21:03:42.709" v="967" actId="1036"/>
          <ac:picMkLst>
            <pc:docMk/>
            <pc:sldMk cId="2245635649" sldId="318"/>
            <ac:picMk id="46" creationId="{77007D5B-7A46-298E-0459-207AB0020D3F}"/>
          </ac:picMkLst>
        </pc:picChg>
        <pc:picChg chg="mod">
          <ac:chgData name="Kumar, Vinod" userId="a0710a6e-bffc-4971-8893-1c23addeb5b0" providerId="ADAL" clId="{F5D6EA11-585F-4AA1-B279-75820FE30650}" dt="2023-01-10T21:03:42.709" v="967" actId="1036"/>
          <ac:picMkLst>
            <pc:docMk/>
            <pc:sldMk cId="2245635649" sldId="318"/>
            <ac:picMk id="47" creationId="{B0A8E4C3-F008-9B2A-077E-C0B4E3FC4DBC}"/>
          </ac:picMkLst>
        </pc:picChg>
        <pc:picChg chg="mod">
          <ac:chgData name="Kumar, Vinod" userId="a0710a6e-bffc-4971-8893-1c23addeb5b0" providerId="ADAL" clId="{F5D6EA11-585F-4AA1-B279-75820FE30650}" dt="2023-01-11T15:11:36.191" v="1115" actId="1036"/>
          <ac:picMkLst>
            <pc:docMk/>
            <pc:sldMk cId="2245635649" sldId="318"/>
            <ac:picMk id="54" creationId="{C00E93A4-7618-F523-3A6A-CBAE49E37107}"/>
          </ac:picMkLst>
        </pc:picChg>
        <pc:cxnChg chg="mod">
          <ac:chgData name="Kumar, Vinod" userId="a0710a6e-bffc-4971-8893-1c23addeb5b0" providerId="ADAL" clId="{F5D6EA11-585F-4AA1-B279-75820FE30650}" dt="2023-01-10T21:03:42.709" v="967" actId="1036"/>
          <ac:cxnSpMkLst>
            <pc:docMk/>
            <pc:sldMk cId="2245635649" sldId="318"/>
            <ac:cxnSpMk id="8" creationId="{4F05C120-46F7-8839-8431-93F15877B014}"/>
          </ac:cxnSpMkLst>
        </pc:cxnChg>
        <pc:cxnChg chg="mod">
          <ac:chgData name="Kumar, Vinod" userId="a0710a6e-bffc-4971-8893-1c23addeb5b0" providerId="ADAL" clId="{F5D6EA11-585F-4AA1-B279-75820FE30650}" dt="2023-01-11T15:12:11.343" v="1144" actId="1035"/>
          <ac:cxnSpMkLst>
            <pc:docMk/>
            <pc:sldMk cId="2245635649" sldId="318"/>
            <ac:cxnSpMk id="12" creationId="{51F9F63A-0D44-641C-CF9A-582577C69D78}"/>
          </ac:cxnSpMkLst>
        </pc:cxnChg>
        <pc:cxnChg chg="mod">
          <ac:chgData name="Kumar, Vinod" userId="a0710a6e-bffc-4971-8893-1c23addeb5b0" providerId="ADAL" clId="{F5D6EA11-585F-4AA1-B279-75820FE30650}" dt="2023-01-10T21:03:42.709" v="967" actId="1036"/>
          <ac:cxnSpMkLst>
            <pc:docMk/>
            <pc:sldMk cId="2245635649" sldId="318"/>
            <ac:cxnSpMk id="36" creationId="{25213125-5BFF-4858-A1CD-9F7F9A11C309}"/>
          </ac:cxnSpMkLst>
        </pc:cxnChg>
        <pc:cxnChg chg="del">
          <ac:chgData name="Kumar, Vinod" userId="a0710a6e-bffc-4971-8893-1c23addeb5b0" providerId="ADAL" clId="{F5D6EA11-585F-4AA1-B279-75820FE30650}" dt="2023-01-10T21:44:05.808" v="1048" actId="478"/>
          <ac:cxnSpMkLst>
            <pc:docMk/>
            <pc:sldMk cId="2245635649" sldId="318"/>
            <ac:cxnSpMk id="51" creationId="{95ADDECB-32DA-AF4B-CF9C-1662745A536A}"/>
          </ac:cxnSpMkLst>
        </pc:cxnChg>
      </pc:sldChg>
      <pc:sldChg chg="del">
        <pc:chgData name="Kumar, Vinod" userId="a0710a6e-bffc-4971-8893-1c23addeb5b0" providerId="ADAL" clId="{F5D6EA11-585F-4AA1-B279-75820FE30650}" dt="2023-01-12T15:48:15.079" v="3648" actId="47"/>
        <pc:sldMkLst>
          <pc:docMk/>
          <pc:sldMk cId="1412134880" sldId="319"/>
        </pc:sldMkLst>
      </pc:sldChg>
      <pc:sldChg chg="addSp delSp modSp add mod">
        <pc:chgData name="Kumar, Vinod" userId="a0710a6e-bffc-4971-8893-1c23addeb5b0" providerId="ADAL" clId="{F5D6EA11-585F-4AA1-B279-75820FE30650}" dt="2023-01-10T20:46:28.700" v="659" actId="1038"/>
        <pc:sldMkLst>
          <pc:docMk/>
          <pc:sldMk cId="2842090847" sldId="320"/>
        </pc:sldMkLst>
        <pc:spChg chg="mod">
          <ac:chgData name="Kumar, Vinod" userId="a0710a6e-bffc-4971-8893-1c23addeb5b0" providerId="ADAL" clId="{F5D6EA11-585F-4AA1-B279-75820FE30650}" dt="2023-01-10T20:17:35.499" v="287" actId="1036"/>
          <ac:spMkLst>
            <pc:docMk/>
            <pc:sldMk cId="2842090847" sldId="320"/>
            <ac:spMk id="2" creationId="{2F989969-700A-D7EB-7E3D-52DE0231C0F0}"/>
          </ac:spMkLst>
        </pc:spChg>
        <pc:spChg chg="mod">
          <ac:chgData name="Kumar, Vinod" userId="a0710a6e-bffc-4971-8893-1c23addeb5b0" providerId="ADAL" clId="{F5D6EA11-585F-4AA1-B279-75820FE30650}" dt="2023-01-10T20:40:26.167" v="613" actId="1076"/>
          <ac:spMkLst>
            <pc:docMk/>
            <pc:sldMk cId="2842090847" sldId="320"/>
            <ac:spMk id="13" creationId="{2AD0881F-DFA4-122C-8C0C-565629313CCB}"/>
          </ac:spMkLst>
        </pc:spChg>
        <pc:spChg chg="mod">
          <ac:chgData name="Kumar, Vinod" userId="a0710a6e-bffc-4971-8893-1c23addeb5b0" providerId="ADAL" clId="{F5D6EA11-585F-4AA1-B279-75820FE30650}" dt="2023-01-10T20:41:59.678" v="637" actId="1035"/>
          <ac:spMkLst>
            <pc:docMk/>
            <pc:sldMk cId="2842090847" sldId="320"/>
            <ac:spMk id="14" creationId="{927B8AC4-1BF7-4F33-CAF6-E15A421230D4}"/>
          </ac:spMkLst>
        </pc:spChg>
        <pc:spChg chg="mod">
          <ac:chgData name="Kumar, Vinod" userId="a0710a6e-bffc-4971-8893-1c23addeb5b0" providerId="ADAL" clId="{F5D6EA11-585F-4AA1-B279-75820FE30650}" dt="2023-01-10T20:41:13.358" v="625" actId="1037"/>
          <ac:spMkLst>
            <pc:docMk/>
            <pc:sldMk cId="2842090847" sldId="320"/>
            <ac:spMk id="15" creationId="{9DFC388E-DE0D-AE6C-385C-FD3003AC2203}"/>
          </ac:spMkLst>
        </pc:spChg>
        <pc:spChg chg="mod">
          <ac:chgData name="Kumar, Vinod" userId="a0710a6e-bffc-4971-8893-1c23addeb5b0" providerId="ADAL" clId="{F5D6EA11-585F-4AA1-B279-75820FE30650}" dt="2023-01-10T20:41:06.303" v="619" actId="1037"/>
          <ac:spMkLst>
            <pc:docMk/>
            <pc:sldMk cId="2842090847" sldId="320"/>
            <ac:spMk id="16" creationId="{D43D6E6D-7E71-3A47-7B6F-14ADACA5DD4F}"/>
          </ac:spMkLst>
        </pc:spChg>
        <pc:spChg chg="mod">
          <ac:chgData name="Kumar, Vinod" userId="a0710a6e-bffc-4971-8893-1c23addeb5b0" providerId="ADAL" clId="{F5D6EA11-585F-4AA1-B279-75820FE30650}" dt="2023-01-10T20:41:27.871" v="629" actId="1037"/>
          <ac:spMkLst>
            <pc:docMk/>
            <pc:sldMk cId="2842090847" sldId="320"/>
            <ac:spMk id="17" creationId="{132A6F4C-9B99-6D89-E28E-C82E07C5574C}"/>
          </ac:spMkLst>
        </pc:spChg>
        <pc:spChg chg="add mod">
          <ac:chgData name="Kumar, Vinod" userId="a0710a6e-bffc-4971-8893-1c23addeb5b0" providerId="ADAL" clId="{F5D6EA11-585F-4AA1-B279-75820FE30650}" dt="2023-01-10T20:40:45.558" v="616" actId="1076"/>
          <ac:spMkLst>
            <pc:docMk/>
            <pc:sldMk cId="2842090847" sldId="320"/>
            <ac:spMk id="21" creationId="{BD45C227-0820-ED39-9EFC-1ACD6CFD3CA7}"/>
          </ac:spMkLst>
        </pc:spChg>
        <pc:picChg chg="del mod">
          <ac:chgData name="Kumar, Vinod" userId="a0710a6e-bffc-4971-8893-1c23addeb5b0" providerId="ADAL" clId="{F5D6EA11-585F-4AA1-B279-75820FE30650}" dt="2023-01-10T20:36:06.688" v="521" actId="478"/>
          <ac:picMkLst>
            <pc:docMk/>
            <pc:sldMk cId="2842090847" sldId="320"/>
            <ac:picMk id="3" creationId="{F450301E-C110-A500-66DC-9DFF82D67E68}"/>
          </ac:picMkLst>
        </pc:picChg>
        <pc:picChg chg="del mod">
          <ac:chgData name="Kumar, Vinod" userId="a0710a6e-bffc-4971-8893-1c23addeb5b0" providerId="ADAL" clId="{F5D6EA11-585F-4AA1-B279-75820FE30650}" dt="2023-01-10T20:32:07.602" v="455" actId="478"/>
          <ac:picMkLst>
            <pc:docMk/>
            <pc:sldMk cId="2842090847" sldId="320"/>
            <ac:picMk id="4" creationId="{24CE3C75-504A-F2C4-D0C8-6091449C77F9}"/>
          </ac:picMkLst>
        </pc:picChg>
        <pc:picChg chg="del mod">
          <ac:chgData name="Kumar, Vinod" userId="a0710a6e-bffc-4971-8893-1c23addeb5b0" providerId="ADAL" clId="{F5D6EA11-585F-4AA1-B279-75820FE30650}" dt="2023-01-10T20:32:07.602" v="455" actId="478"/>
          <ac:picMkLst>
            <pc:docMk/>
            <pc:sldMk cId="2842090847" sldId="320"/>
            <ac:picMk id="5" creationId="{5E9660E9-283C-4EE3-03D9-022782801718}"/>
          </ac:picMkLst>
        </pc:picChg>
        <pc:picChg chg="del mod">
          <ac:chgData name="Kumar, Vinod" userId="a0710a6e-bffc-4971-8893-1c23addeb5b0" providerId="ADAL" clId="{F5D6EA11-585F-4AA1-B279-75820FE30650}" dt="2023-01-10T20:32:07.602" v="455" actId="478"/>
          <ac:picMkLst>
            <pc:docMk/>
            <pc:sldMk cId="2842090847" sldId="320"/>
            <ac:picMk id="6" creationId="{C2BE8F1A-3A90-90F3-8262-6BC91AEC0EEA}"/>
          </ac:picMkLst>
        </pc:picChg>
        <pc:picChg chg="del mod modCrop">
          <ac:chgData name="Kumar, Vinod" userId="a0710a6e-bffc-4971-8893-1c23addeb5b0" providerId="ADAL" clId="{F5D6EA11-585F-4AA1-B279-75820FE30650}" dt="2023-01-10T20:35:57.745" v="473" actId="478"/>
          <ac:picMkLst>
            <pc:docMk/>
            <pc:sldMk cId="2842090847" sldId="320"/>
            <ac:picMk id="7" creationId="{DDC91D9D-B267-6A98-49A0-7F314A8D786B}"/>
          </ac:picMkLst>
        </pc:picChg>
        <pc:picChg chg="del mod modCrop">
          <ac:chgData name="Kumar, Vinod" userId="a0710a6e-bffc-4971-8893-1c23addeb5b0" providerId="ADAL" clId="{F5D6EA11-585F-4AA1-B279-75820FE30650}" dt="2023-01-10T20:46:08.987" v="648" actId="478"/>
          <ac:picMkLst>
            <pc:docMk/>
            <pc:sldMk cId="2842090847" sldId="320"/>
            <ac:picMk id="8" creationId="{D67650FA-1153-C97A-389B-B56A1973A363}"/>
          </ac:picMkLst>
        </pc:picChg>
        <pc:picChg chg="del mod">
          <ac:chgData name="Kumar, Vinod" userId="a0710a6e-bffc-4971-8893-1c23addeb5b0" providerId="ADAL" clId="{F5D6EA11-585F-4AA1-B279-75820FE30650}" dt="2023-01-10T20:32:07.602" v="455" actId="478"/>
          <ac:picMkLst>
            <pc:docMk/>
            <pc:sldMk cId="2842090847" sldId="320"/>
            <ac:picMk id="9" creationId="{0E5F70E1-ABF3-1AFC-3184-ED5C0A584307}"/>
          </ac:picMkLst>
        </pc:picChg>
        <pc:picChg chg="mod modCrop">
          <ac:chgData name="Kumar, Vinod" userId="a0710a6e-bffc-4971-8893-1c23addeb5b0" providerId="ADAL" clId="{F5D6EA11-585F-4AA1-B279-75820FE30650}" dt="2023-01-10T20:40:02.735" v="610" actId="1036"/>
          <ac:picMkLst>
            <pc:docMk/>
            <pc:sldMk cId="2842090847" sldId="320"/>
            <ac:picMk id="10" creationId="{CBC73503-2007-EC1D-EB6C-FFD422C0DAF6}"/>
          </ac:picMkLst>
        </pc:picChg>
        <pc:picChg chg="mod modCrop">
          <ac:chgData name="Kumar, Vinod" userId="a0710a6e-bffc-4971-8893-1c23addeb5b0" providerId="ADAL" clId="{F5D6EA11-585F-4AA1-B279-75820FE30650}" dt="2023-01-10T20:40:02.735" v="610" actId="1036"/>
          <ac:picMkLst>
            <pc:docMk/>
            <pc:sldMk cId="2842090847" sldId="320"/>
            <ac:picMk id="11" creationId="{5DAF42C5-A9ED-71F3-1959-5294F9C514E8}"/>
          </ac:picMkLst>
        </pc:picChg>
        <pc:picChg chg="mod modCrop">
          <ac:chgData name="Kumar, Vinod" userId="a0710a6e-bffc-4971-8893-1c23addeb5b0" providerId="ADAL" clId="{F5D6EA11-585F-4AA1-B279-75820FE30650}" dt="2023-01-10T20:39:53.519" v="605" actId="1036"/>
          <ac:picMkLst>
            <pc:docMk/>
            <pc:sldMk cId="2842090847" sldId="320"/>
            <ac:picMk id="12" creationId="{B9DD4D07-C768-75B9-B236-F3805A4D998D}"/>
          </ac:picMkLst>
        </pc:picChg>
        <pc:picChg chg="del mod modCrop">
          <ac:chgData name="Kumar, Vinod" userId="a0710a6e-bffc-4971-8893-1c23addeb5b0" providerId="ADAL" clId="{F5D6EA11-585F-4AA1-B279-75820FE30650}" dt="2023-01-10T20:36:23.089" v="534" actId="478"/>
          <ac:picMkLst>
            <pc:docMk/>
            <pc:sldMk cId="2842090847" sldId="320"/>
            <ac:picMk id="18" creationId="{1E195D73-ED57-A587-4D41-FFA1B377CD7D}"/>
          </ac:picMkLst>
        </pc:picChg>
        <pc:picChg chg="mod modCrop">
          <ac:chgData name="Kumar, Vinod" userId="a0710a6e-bffc-4971-8893-1c23addeb5b0" providerId="ADAL" clId="{F5D6EA11-585F-4AA1-B279-75820FE30650}" dt="2023-01-10T20:40:07.375" v="612" actId="1035"/>
          <ac:picMkLst>
            <pc:docMk/>
            <pc:sldMk cId="2842090847" sldId="320"/>
            <ac:picMk id="19" creationId="{5304177B-B0A0-1B32-CA99-2DFD4FCB5B72}"/>
          </ac:picMkLst>
        </pc:picChg>
        <pc:picChg chg="add mod">
          <ac:chgData name="Kumar, Vinod" userId="a0710a6e-bffc-4971-8893-1c23addeb5b0" providerId="ADAL" clId="{F5D6EA11-585F-4AA1-B279-75820FE30650}" dt="2023-01-10T20:40:07.375" v="612" actId="1035"/>
          <ac:picMkLst>
            <pc:docMk/>
            <pc:sldMk cId="2842090847" sldId="320"/>
            <ac:picMk id="20" creationId="{F1AAC840-9DD3-600A-D11F-BD487C1B0043}"/>
          </ac:picMkLst>
        </pc:picChg>
        <pc:picChg chg="mod modCrop">
          <ac:chgData name="Kumar, Vinod" userId="a0710a6e-bffc-4971-8893-1c23addeb5b0" providerId="ADAL" clId="{F5D6EA11-585F-4AA1-B279-75820FE30650}" dt="2023-01-10T20:46:28.700" v="659" actId="1038"/>
          <ac:picMkLst>
            <pc:docMk/>
            <pc:sldMk cId="2842090847" sldId="320"/>
            <ac:picMk id="22" creationId="{182E052E-8CE2-CCA8-1CD0-316A5A45A19D}"/>
          </ac:picMkLst>
        </pc:picChg>
      </pc:sldChg>
      <pc:sldChg chg="addSp delSp modSp add mod">
        <pc:chgData name="Kumar, Vinod" userId="a0710a6e-bffc-4971-8893-1c23addeb5b0" providerId="ADAL" clId="{F5D6EA11-585F-4AA1-B279-75820FE30650}" dt="2023-01-25T21:20:06.797" v="5133" actId="1037"/>
        <pc:sldMkLst>
          <pc:docMk/>
          <pc:sldMk cId="2665136248" sldId="321"/>
        </pc:sldMkLst>
        <pc:spChg chg="mod">
          <ac:chgData name="Kumar, Vinod" userId="a0710a6e-bffc-4971-8893-1c23addeb5b0" providerId="ADAL" clId="{F5D6EA11-585F-4AA1-B279-75820FE30650}" dt="2023-01-11T17:09:39.624" v="2040" actId="1035"/>
          <ac:spMkLst>
            <pc:docMk/>
            <pc:sldMk cId="2665136248" sldId="321"/>
            <ac:spMk id="9" creationId="{6668A39F-012A-E58E-EBB5-08A035038FF8}"/>
          </ac:spMkLst>
        </pc:spChg>
        <pc:spChg chg="mod">
          <ac:chgData name="Kumar, Vinod" userId="a0710a6e-bffc-4971-8893-1c23addeb5b0" providerId="ADAL" clId="{F5D6EA11-585F-4AA1-B279-75820FE30650}" dt="2023-01-11T17:10:11.352" v="2057" actId="1035"/>
          <ac:spMkLst>
            <pc:docMk/>
            <pc:sldMk cId="2665136248" sldId="321"/>
            <ac:spMk id="13" creationId="{2F5C69FE-8BBC-D30D-1B05-F82DAA14E149}"/>
          </ac:spMkLst>
        </pc:spChg>
        <pc:spChg chg="mod">
          <ac:chgData name="Kumar, Vinod" userId="a0710a6e-bffc-4971-8893-1c23addeb5b0" providerId="ADAL" clId="{F5D6EA11-585F-4AA1-B279-75820FE30650}" dt="2023-01-11T17:10:11.352" v="2057" actId="1035"/>
          <ac:spMkLst>
            <pc:docMk/>
            <pc:sldMk cId="2665136248" sldId="321"/>
            <ac:spMk id="14" creationId="{DAB75DD1-567F-6F00-8AC6-BCC1C40187EE}"/>
          </ac:spMkLst>
        </pc:spChg>
        <pc:spChg chg="mod">
          <ac:chgData name="Kumar, Vinod" userId="a0710a6e-bffc-4971-8893-1c23addeb5b0" providerId="ADAL" clId="{F5D6EA11-585F-4AA1-B279-75820FE30650}" dt="2023-01-11T17:10:02.007" v="2049" actId="1035"/>
          <ac:spMkLst>
            <pc:docMk/>
            <pc:sldMk cId="2665136248" sldId="321"/>
            <ac:spMk id="15" creationId="{610AFE8D-6F14-0B41-CFAF-B50ED829F5E3}"/>
          </ac:spMkLst>
        </pc:spChg>
        <pc:spChg chg="mod">
          <ac:chgData name="Kumar, Vinod" userId="a0710a6e-bffc-4971-8893-1c23addeb5b0" providerId="ADAL" clId="{F5D6EA11-585F-4AA1-B279-75820FE30650}" dt="2023-01-11T17:10:02.007" v="2049" actId="1035"/>
          <ac:spMkLst>
            <pc:docMk/>
            <pc:sldMk cId="2665136248" sldId="321"/>
            <ac:spMk id="17" creationId="{4BA5D206-14F9-4C8F-570E-568E631E764E}"/>
          </ac:spMkLst>
        </pc:spChg>
        <pc:spChg chg="mod">
          <ac:chgData name="Kumar, Vinod" userId="a0710a6e-bffc-4971-8893-1c23addeb5b0" providerId="ADAL" clId="{F5D6EA11-585F-4AA1-B279-75820FE30650}" dt="2023-01-11T17:10:02.007" v="2049" actId="1035"/>
          <ac:spMkLst>
            <pc:docMk/>
            <pc:sldMk cId="2665136248" sldId="321"/>
            <ac:spMk id="18" creationId="{F868BCCD-1693-01CC-7EB6-FF78E61E1CA6}"/>
          </ac:spMkLst>
        </pc:spChg>
        <pc:spChg chg="mod">
          <ac:chgData name="Kumar, Vinod" userId="a0710a6e-bffc-4971-8893-1c23addeb5b0" providerId="ADAL" clId="{F5D6EA11-585F-4AA1-B279-75820FE30650}" dt="2023-01-11T17:09:39.624" v="2040" actId="1035"/>
          <ac:spMkLst>
            <pc:docMk/>
            <pc:sldMk cId="2665136248" sldId="321"/>
            <ac:spMk id="19" creationId="{7A6E65D4-7530-9F25-99BB-3E4A551CAB24}"/>
          </ac:spMkLst>
        </pc:spChg>
        <pc:spChg chg="mod">
          <ac:chgData name="Kumar, Vinod" userId="a0710a6e-bffc-4971-8893-1c23addeb5b0" providerId="ADAL" clId="{F5D6EA11-585F-4AA1-B279-75820FE30650}" dt="2023-01-11T17:10:11.352" v="2057" actId="1035"/>
          <ac:spMkLst>
            <pc:docMk/>
            <pc:sldMk cId="2665136248" sldId="321"/>
            <ac:spMk id="21" creationId="{4A1FD6FF-624A-06CB-8B80-7E181D684B98}"/>
          </ac:spMkLst>
        </pc:spChg>
        <pc:picChg chg="add mod modCrop">
          <ac:chgData name="Kumar, Vinod" userId="a0710a6e-bffc-4971-8893-1c23addeb5b0" providerId="ADAL" clId="{F5D6EA11-585F-4AA1-B279-75820FE30650}" dt="2023-01-25T21:19:56.589" v="5130" actId="1037"/>
          <ac:picMkLst>
            <pc:docMk/>
            <pc:sldMk cId="2665136248" sldId="321"/>
            <ac:picMk id="2" creationId="{232E32B6-0EBE-01C8-5200-6788610E504F}"/>
          </ac:picMkLst>
        </pc:picChg>
        <pc:picChg chg="del mod">
          <ac:chgData name="Kumar, Vinod" userId="a0710a6e-bffc-4971-8893-1c23addeb5b0" providerId="ADAL" clId="{F5D6EA11-585F-4AA1-B279-75820FE30650}" dt="2023-01-11T17:04:43.498" v="1969" actId="478"/>
          <ac:picMkLst>
            <pc:docMk/>
            <pc:sldMk cId="2665136248" sldId="321"/>
            <ac:picMk id="2" creationId="{821457AD-B838-A9B5-FE77-286D2FC2EE7F}"/>
          </ac:picMkLst>
        </pc:picChg>
        <pc:picChg chg="add mod modCrop">
          <ac:chgData name="Kumar, Vinod" userId="a0710a6e-bffc-4971-8893-1c23addeb5b0" providerId="ADAL" clId="{F5D6EA11-585F-4AA1-B279-75820FE30650}" dt="2023-01-25T21:19:56.589" v="5130" actId="1037"/>
          <ac:picMkLst>
            <pc:docMk/>
            <pc:sldMk cId="2665136248" sldId="321"/>
            <ac:picMk id="3" creationId="{A8524166-1742-B9EF-0041-7A798C299C58}"/>
          </ac:picMkLst>
        </pc:picChg>
        <pc:picChg chg="del mod">
          <ac:chgData name="Kumar, Vinod" userId="a0710a6e-bffc-4971-8893-1c23addeb5b0" providerId="ADAL" clId="{F5D6EA11-585F-4AA1-B279-75820FE30650}" dt="2023-01-11T17:04:43.498" v="1969" actId="478"/>
          <ac:picMkLst>
            <pc:docMk/>
            <pc:sldMk cId="2665136248" sldId="321"/>
            <ac:picMk id="3" creationId="{EE6D6DA0-B2C8-C062-6E93-1EAB0B1DB695}"/>
          </ac:picMkLst>
        </pc:picChg>
        <pc:picChg chg="add mod modCrop">
          <ac:chgData name="Kumar, Vinod" userId="a0710a6e-bffc-4971-8893-1c23addeb5b0" providerId="ADAL" clId="{F5D6EA11-585F-4AA1-B279-75820FE30650}" dt="2023-01-25T21:20:02.461" v="5131" actId="1037"/>
          <ac:picMkLst>
            <pc:docMk/>
            <pc:sldMk cId="2665136248" sldId="321"/>
            <ac:picMk id="4" creationId="{50176F60-C5A4-66C5-6E78-8A73AA65F691}"/>
          </ac:picMkLst>
        </pc:picChg>
        <pc:picChg chg="del mod">
          <ac:chgData name="Kumar, Vinod" userId="a0710a6e-bffc-4971-8893-1c23addeb5b0" providerId="ADAL" clId="{F5D6EA11-585F-4AA1-B279-75820FE30650}" dt="2023-01-11T17:04:43.498" v="1969" actId="478"/>
          <ac:picMkLst>
            <pc:docMk/>
            <pc:sldMk cId="2665136248" sldId="321"/>
            <ac:picMk id="4" creationId="{FEF77DA4-5EBA-204F-C216-45C4D4BAFC59}"/>
          </ac:picMkLst>
        </pc:picChg>
        <pc:picChg chg="del mod">
          <ac:chgData name="Kumar, Vinod" userId="a0710a6e-bffc-4971-8893-1c23addeb5b0" providerId="ADAL" clId="{F5D6EA11-585F-4AA1-B279-75820FE30650}" dt="2023-01-11T17:04:43.498" v="1969" actId="478"/>
          <ac:picMkLst>
            <pc:docMk/>
            <pc:sldMk cId="2665136248" sldId="321"/>
            <ac:picMk id="5" creationId="{9BFF4654-44C7-681D-AE78-BB30710F7D35}"/>
          </ac:picMkLst>
        </pc:picChg>
        <pc:picChg chg="mod modCrop">
          <ac:chgData name="Kumar, Vinod" userId="a0710a6e-bffc-4971-8893-1c23addeb5b0" providerId="ADAL" clId="{F5D6EA11-585F-4AA1-B279-75820FE30650}" dt="2023-01-25T21:20:06.797" v="5133" actId="1037"/>
          <ac:picMkLst>
            <pc:docMk/>
            <pc:sldMk cId="2665136248" sldId="321"/>
            <ac:picMk id="6" creationId="{EDB87E28-9864-9E38-C719-D46F4B12AE52}"/>
          </ac:picMkLst>
        </pc:picChg>
        <pc:picChg chg="del mod">
          <ac:chgData name="Kumar, Vinod" userId="a0710a6e-bffc-4971-8893-1c23addeb5b0" providerId="ADAL" clId="{F5D6EA11-585F-4AA1-B279-75820FE30650}" dt="2023-01-11T17:04:43.498" v="1969" actId="478"/>
          <ac:picMkLst>
            <pc:docMk/>
            <pc:sldMk cId="2665136248" sldId="321"/>
            <ac:picMk id="7" creationId="{F5618D52-7D96-8F92-5FE3-593C006CE318}"/>
          </ac:picMkLst>
        </pc:picChg>
        <pc:picChg chg="mod">
          <ac:chgData name="Kumar, Vinod" userId="a0710a6e-bffc-4971-8893-1c23addeb5b0" providerId="ADAL" clId="{F5D6EA11-585F-4AA1-B279-75820FE30650}" dt="2023-01-12T21:22:53.916" v="4283" actId="1035"/>
          <ac:picMkLst>
            <pc:docMk/>
            <pc:sldMk cId="2665136248" sldId="321"/>
            <ac:picMk id="8" creationId="{0C4AC514-70B9-2E08-FC10-F47116B8336F}"/>
          </ac:picMkLst>
        </pc:picChg>
        <pc:picChg chg="del mod">
          <ac:chgData name="Kumar, Vinod" userId="a0710a6e-bffc-4971-8893-1c23addeb5b0" providerId="ADAL" clId="{F5D6EA11-585F-4AA1-B279-75820FE30650}" dt="2023-01-11T17:04:43.498" v="1969" actId="478"/>
          <ac:picMkLst>
            <pc:docMk/>
            <pc:sldMk cId="2665136248" sldId="321"/>
            <ac:picMk id="10" creationId="{5BC61CC7-A994-BE81-FF4B-0830F771FB05}"/>
          </ac:picMkLst>
        </pc:picChg>
        <pc:picChg chg="del mod">
          <ac:chgData name="Kumar, Vinod" userId="a0710a6e-bffc-4971-8893-1c23addeb5b0" providerId="ADAL" clId="{F5D6EA11-585F-4AA1-B279-75820FE30650}" dt="2023-01-12T21:19:52.737" v="4140" actId="478"/>
          <ac:picMkLst>
            <pc:docMk/>
            <pc:sldMk cId="2665136248" sldId="321"/>
            <ac:picMk id="11" creationId="{C9367FDB-1337-C997-357B-7D2A09D12015}"/>
          </ac:picMkLst>
        </pc:picChg>
        <pc:picChg chg="del mod">
          <ac:chgData name="Kumar, Vinod" userId="a0710a6e-bffc-4971-8893-1c23addeb5b0" providerId="ADAL" clId="{F5D6EA11-585F-4AA1-B279-75820FE30650}" dt="2023-01-12T21:19:52.737" v="4140" actId="478"/>
          <ac:picMkLst>
            <pc:docMk/>
            <pc:sldMk cId="2665136248" sldId="321"/>
            <ac:picMk id="16" creationId="{7168A9F3-783A-0EAB-77CE-8EC48B7E85AB}"/>
          </ac:picMkLst>
        </pc:picChg>
        <pc:picChg chg="del mod">
          <ac:chgData name="Kumar, Vinod" userId="a0710a6e-bffc-4971-8893-1c23addeb5b0" providerId="ADAL" clId="{F5D6EA11-585F-4AA1-B279-75820FE30650}" dt="2023-01-12T21:19:52.737" v="4140" actId="478"/>
          <ac:picMkLst>
            <pc:docMk/>
            <pc:sldMk cId="2665136248" sldId="321"/>
            <ac:picMk id="20" creationId="{62451451-56F0-03EC-2D54-B352BB64D648}"/>
          </ac:picMkLst>
        </pc:picChg>
        <pc:picChg chg="mod modCrop">
          <ac:chgData name="Kumar, Vinod" userId="a0710a6e-bffc-4971-8893-1c23addeb5b0" providerId="ADAL" clId="{F5D6EA11-585F-4AA1-B279-75820FE30650}" dt="2023-01-12T21:22:53.916" v="4283" actId="1035"/>
          <ac:picMkLst>
            <pc:docMk/>
            <pc:sldMk cId="2665136248" sldId="321"/>
            <ac:picMk id="22" creationId="{93326A65-0AE2-49EF-2AF7-0D3D17147223}"/>
          </ac:picMkLst>
        </pc:picChg>
        <pc:picChg chg="mod modCrop">
          <ac:chgData name="Kumar, Vinod" userId="a0710a6e-bffc-4971-8893-1c23addeb5b0" providerId="ADAL" clId="{F5D6EA11-585F-4AA1-B279-75820FE30650}" dt="2023-01-12T21:22:53.916" v="4283" actId="1035"/>
          <ac:picMkLst>
            <pc:docMk/>
            <pc:sldMk cId="2665136248" sldId="321"/>
            <ac:picMk id="23" creationId="{C405D012-C4BD-CC24-33DC-4C2F3E73AE77}"/>
          </ac:picMkLst>
        </pc:picChg>
        <pc:picChg chg="mod modCrop">
          <ac:chgData name="Kumar, Vinod" userId="a0710a6e-bffc-4971-8893-1c23addeb5b0" providerId="ADAL" clId="{F5D6EA11-585F-4AA1-B279-75820FE30650}" dt="2023-01-12T21:23:56.396" v="4315" actId="1038"/>
          <ac:picMkLst>
            <pc:docMk/>
            <pc:sldMk cId="2665136248" sldId="321"/>
            <ac:picMk id="24" creationId="{C6CC3696-5967-5FEA-7C66-AE04139D33D5}"/>
          </ac:picMkLst>
        </pc:picChg>
      </pc:sldChg>
      <pc:sldChg chg="addSp delSp modSp new del mod">
        <pc:chgData name="Kumar, Vinod" userId="a0710a6e-bffc-4971-8893-1c23addeb5b0" providerId="ADAL" clId="{F5D6EA11-585F-4AA1-B279-75820FE30650}" dt="2023-01-11T17:05:34.768" v="1971" actId="47"/>
        <pc:sldMkLst>
          <pc:docMk/>
          <pc:sldMk cId="3157830896" sldId="322"/>
        </pc:sldMkLst>
        <pc:spChg chg="del mod topLvl">
          <ac:chgData name="Kumar, Vinod" userId="a0710a6e-bffc-4971-8893-1c23addeb5b0" providerId="ADAL" clId="{F5D6EA11-585F-4AA1-B279-75820FE30650}" dt="2023-01-11T16:20:41.134" v="1172" actId="478"/>
          <ac:spMkLst>
            <pc:docMk/>
            <pc:sldMk cId="3157830896" sldId="322"/>
            <ac:spMk id="9" creationId="{A62A9E65-39C1-A403-0602-08644B8F46BB}"/>
          </ac:spMkLst>
        </pc:spChg>
        <pc:spChg chg="mod">
          <ac:chgData name="Kumar, Vinod" userId="a0710a6e-bffc-4971-8893-1c23addeb5b0" providerId="ADAL" clId="{F5D6EA11-585F-4AA1-B279-75820FE30650}" dt="2023-01-11T17:05:32.114" v="1970" actId="1076"/>
          <ac:spMkLst>
            <pc:docMk/>
            <pc:sldMk cId="3157830896" sldId="322"/>
            <ac:spMk id="10" creationId="{6A28B601-77AF-F3AB-9AB6-31B97F58FA27}"/>
          </ac:spMkLst>
        </pc:spChg>
        <pc:spChg chg="mod">
          <ac:chgData name="Kumar, Vinod" userId="a0710a6e-bffc-4971-8893-1c23addeb5b0" providerId="ADAL" clId="{F5D6EA11-585F-4AA1-B279-75820FE30650}" dt="2023-01-11T17:05:32.114" v="1970" actId="1076"/>
          <ac:spMkLst>
            <pc:docMk/>
            <pc:sldMk cId="3157830896" sldId="322"/>
            <ac:spMk id="16" creationId="{695DE692-6DD8-5D88-FA95-A5577241FC71}"/>
          </ac:spMkLst>
        </pc:spChg>
        <pc:spChg chg="mod">
          <ac:chgData name="Kumar, Vinod" userId="a0710a6e-bffc-4971-8893-1c23addeb5b0" providerId="ADAL" clId="{F5D6EA11-585F-4AA1-B279-75820FE30650}" dt="2023-01-11T17:05:32.114" v="1970" actId="1076"/>
          <ac:spMkLst>
            <pc:docMk/>
            <pc:sldMk cId="3157830896" sldId="322"/>
            <ac:spMk id="17" creationId="{E2F7CF64-6A7E-4384-0262-7ADFD407B9CB}"/>
          </ac:spMkLst>
        </pc:spChg>
        <pc:spChg chg="mod">
          <ac:chgData name="Kumar, Vinod" userId="a0710a6e-bffc-4971-8893-1c23addeb5b0" providerId="ADAL" clId="{F5D6EA11-585F-4AA1-B279-75820FE30650}" dt="2023-01-11T17:05:32.114" v="1970" actId="1076"/>
          <ac:spMkLst>
            <pc:docMk/>
            <pc:sldMk cId="3157830896" sldId="322"/>
            <ac:spMk id="19" creationId="{B9BBD331-F96C-F443-EF22-C3793F30524A}"/>
          </ac:spMkLst>
        </pc:spChg>
        <pc:spChg chg="mod">
          <ac:chgData name="Kumar, Vinod" userId="a0710a6e-bffc-4971-8893-1c23addeb5b0" providerId="ADAL" clId="{F5D6EA11-585F-4AA1-B279-75820FE30650}" dt="2023-01-11T17:05:32.114" v="1970" actId="1076"/>
          <ac:spMkLst>
            <pc:docMk/>
            <pc:sldMk cId="3157830896" sldId="322"/>
            <ac:spMk id="20" creationId="{66E5ED54-0C9C-CB3E-C353-F8061C2C69CC}"/>
          </ac:spMkLst>
        </pc:spChg>
        <pc:spChg chg="mod">
          <ac:chgData name="Kumar, Vinod" userId="a0710a6e-bffc-4971-8893-1c23addeb5b0" providerId="ADAL" clId="{F5D6EA11-585F-4AA1-B279-75820FE30650}" dt="2023-01-11T17:05:32.114" v="1970" actId="1076"/>
          <ac:spMkLst>
            <pc:docMk/>
            <pc:sldMk cId="3157830896" sldId="322"/>
            <ac:spMk id="21" creationId="{4910BE6F-94A1-B443-C519-109CABD37096}"/>
          </ac:spMkLst>
        </pc:spChg>
        <pc:spChg chg="del mod topLvl">
          <ac:chgData name="Kumar, Vinod" userId="a0710a6e-bffc-4971-8893-1c23addeb5b0" providerId="ADAL" clId="{F5D6EA11-585F-4AA1-B279-75820FE30650}" dt="2023-01-11T16:24:44.045" v="1204" actId="478"/>
          <ac:spMkLst>
            <pc:docMk/>
            <pc:sldMk cId="3157830896" sldId="322"/>
            <ac:spMk id="24" creationId="{E5A84370-D379-0935-9883-88D91B534AC3}"/>
          </ac:spMkLst>
        </pc:spChg>
        <pc:spChg chg="mod">
          <ac:chgData name="Kumar, Vinod" userId="a0710a6e-bffc-4971-8893-1c23addeb5b0" providerId="ADAL" clId="{F5D6EA11-585F-4AA1-B279-75820FE30650}" dt="2023-01-11T17:05:32.114" v="1970" actId="1076"/>
          <ac:spMkLst>
            <pc:docMk/>
            <pc:sldMk cId="3157830896" sldId="322"/>
            <ac:spMk id="29" creationId="{FB1D6D30-476A-9F1F-EFA3-E5C55E00DF7E}"/>
          </ac:spMkLst>
        </pc:spChg>
        <pc:spChg chg="mod">
          <ac:chgData name="Kumar, Vinod" userId="a0710a6e-bffc-4971-8893-1c23addeb5b0" providerId="ADAL" clId="{F5D6EA11-585F-4AA1-B279-75820FE30650}" dt="2023-01-11T17:05:32.114" v="1970" actId="1076"/>
          <ac:spMkLst>
            <pc:docMk/>
            <pc:sldMk cId="3157830896" sldId="322"/>
            <ac:spMk id="30" creationId="{42FA79BF-EEA2-395A-F804-59D7481B3568}"/>
          </ac:spMkLst>
        </pc:spChg>
        <pc:spChg chg="mod">
          <ac:chgData name="Kumar, Vinod" userId="a0710a6e-bffc-4971-8893-1c23addeb5b0" providerId="ADAL" clId="{F5D6EA11-585F-4AA1-B279-75820FE30650}" dt="2023-01-11T17:05:32.114" v="1970" actId="1076"/>
          <ac:spMkLst>
            <pc:docMk/>
            <pc:sldMk cId="3157830896" sldId="322"/>
            <ac:spMk id="31" creationId="{5CAF8063-F408-0897-66DC-4ED34D417611}"/>
          </ac:spMkLst>
        </pc:spChg>
        <pc:spChg chg="mod">
          <ac:chgData name="Kumar, Vinod" userId="a0710a6e-bffc-4971-8893-1c23addeb5b0" providerId="ADAL" clId="{F5D6EA11-585F-4AA1-B279-75820FE30650}" dt="2023-01-11T17:05:32.114" v="1970" actId="1076"/>
          <ac:spMkLst>
            <pc:docMk/>
            <pc:sldMk cId="3157830896" sldId="322"/>
            <ac:spMk id="33" creationId="{3B2543F5-005C-548C-D698-732FFB467A1B}"/>
          </ac:spMkLst>
        </pc:spChg>
        <pc:spChg chg="mod">
          <ac:chgData name="Kumar, Vinod" userId="a0710a6e-bffc-4971-8893-1c23addeb5b0" providerId="ADAL" clId="{F5D6EA11-585F-4AA1-B279-75820FE30650}" dt="2023-01-11T17:05:32.114" v="1970" actId="1076"/>
          <ac:spMkLst>
            <pc:docMk/>
            <pc:sldMk cId="3157830896" sldId="322"/>
            <ac:spMk id="34" creationId="{B7BEA542-912E-4C1D-3B89-0DE1023E2A15}"/>
          </ac:spMkLst>
        </pc:spChg>
        <pc:spChg chg="mod">
          <ac:chgData name="Kumar, Vinod" userId="a0710a6e-bffc-4971-8893-1c23addeb5b0" providerId="ADAL" clId="{F5D6EA11-585F-4AA1-B279-75820FE30650}" dt="2023-01-11T17:05:32.114" v="1970" actId="1076"/>
          <ac:spMkLst>
            <pc:docMk/>
            <pc:sldMk cId="3157830896" sldId="322"/>
            <ac:spMk id="35" creationId="{76B46BC1-B842-4846-6216-8D27C139231E}"/>
          </ac:spMkLst>
        </pc:spChg>
        <pc:spChg chg="del mod topLvl">
          <ac:chgData name="Kumar, Vinod" userId="a0710a6e-bffc-4971-8893-1c23addeb5b0" providerId="ADAL" clId="{F5D6EA11-585F-4AA1-B279-75820FE30650}" dt="2023-01-11T16:25:50.060" v="1311" actId="478"/>
          <ac:spMkLst>
            <pc:docMk/>
            <pc:sldMk cId="3157830896" sldId="322"/>
            <ac:spMk id="38" creationId="{2DD74C48-FD37-0693-73E0-2F257C2DB50B}"/>
          </ac:spMkLst>
        </pc:spChg>
        <pc:spChg chg="mod">
          <ac:chgData name="Kumar, Vinod" userId="a0710a6e-bffc-4971-8893-1c23addeb5b0" providerId="ADAL" clId="{F5D6EA11-585F-4AA1-B279-75820FE30650}" dt="2023-01-11T17:05:32.114" v="1970" actId="1076"/>
          <ac:spMkLst>
            <pc:docMk/>
            <pc:sldMk cId="3157830896" sldId="322"/>
            <ac:spMk id="39" creationId="{20A8B839-D3F9-0442-B33E-148D901A58FD}"/>
          </ac:spMkLst>
        </pc:spChg>
        <pc:spChg chg="mod">
          <ac:chgData name="Kumar, Vinod" userId="a0710a6e-bffc-4971-8893-1c23addeb5b0" providerId="ADAL" clId="{F5D6EA11-585F-4AA1-B279-75820FE30650}" dt="2023-01-11T17:05:32.114" v="1970" actId="1076"/>
          <ac:spMkLst>
            <pc:docMk/>
            <pc:sldMk cId="3157830896" sldId="322"/>
            <ac:spMk id="41" creationId="{F6791CFA-0751-F1A6-0850-B65631A35A29}"/>
          </ac:spMkLst>
        </pc:spChg>
        <pc:spChg chg="mod">
          <ac:chgData name="Kumar, Vinod" userId="a0710a6e-bffc-4971-8893-1c23addeb5b0" providerId="ADAL" clId="{F5D6EA11-585F-4AA1-B279-75820FE30650}" dt="2023-01-11T17:05:32.114" v="1970" actId="1076"/>
          <ac:spMkLst>
            <pc:docMk/>
            <pc:sldMk cId="3157830896" sldId="322"/>
            <ac:spMk id="42" creationId="{E5719A8C-6277-C1CC-5400-F423C445853D}"/>
          </ac:spMkLst>
        </pc:spChg>
        <pc:spChg chg="mod">
          <ac:chgData name="Kumar, Vinod" userId="a0710a6e-bffc-4971-8893-1c23addeb5b0" providerId="ADAL" clId="{F5D6EA11-585F-4AA1-B279-75820FE30650}" dt="2023-01-11T17:05:32.114" v="1970" actId="1076"/>
          <ac:spMkLst>
            <pc:docMk/>
            <pc:sldMk cId="3157830896" sldId="322"/>
            <ac:spMk id="45" creationId="{8E24965B-8EFE-DB60-DC76-23E91F7C13FF}"/>
          </ac:spMkLst>
        </pc:spChg>
        <pc:spChg chg="mod">
          <ac:chgData name="Kumar, Vinod" userId="a0710a6e-bffc-4971-8893-1c23addeb5b0" providerId="ADAL" clId="{F5D6EA11-585F-4AA1-B279-75820FE30650}" dt="2023-01-11T17:05:32.114" v="1970" actId="1076"/>
          <ac:spMkLst>
            <pc:docMk/>
            <pc:sldMk cId="3157830896" sldId="322"/>
            <ac:spMk id="47" creationId="{5ECBA1D0-084E-A76B-FA46-9DBF8CADAEA9}"/>
          </ac:spMkLst>
        </pc:spChg>
        <pc:spChg chg="del mod topLvl">
          <ac:chgData name="Kumar, Vinod" userId="a0710a6e-bffc-4971-8893-1c23addeb5b0" providerId="ADAL" clId="{F5D6EA11-585F-4AA1-B279-75820FE30650}" dt="2023-01-11T16:27:43.691" v="1335" actId="478"/>
          <ac:spMkLst>
            <pc:docMk/>
            <pc:sldMk cId="3157830896" sldId="322"/>
            <ac:spMk id="51" creationId="{4F1BC3DA-E513-2EFD-BB02-FB5E27B4ECF9}"/>
          </ac:spMkLst>
        </pc:spChg>
        <pc:spChg chg="mod">
          <ac:chgData name="Kumar, Vinod" userId="a0710a6e-bffc-4971-8893-1c23addeb5b0" providerId="ADAL" clId="{F5D6EA11-585F-4AA1-B279-75820FE30650}" dt="2023-01-11T17:05:32.114" v="1970" actId="1076"/>
          <ac:spMkLst>
            <pc:docMk/>
            <pc:sldMk cId="3157830896" sldId="322"/>
            <ac:spMk id="52" creationId="{72DB8A71-4ABB-87FE-5DCE-FEB159E1E9C5}"/>
          </ac:spMkLst>
        </pc:spChg>
        <pc:spChg chg="mod">
          <ac:chgData name="Kumar, Vinod" userId="a0710a6e-bffc-4971-8893-1c23addeb5b0" providerId="ADAL" clId="{F5D6EA11-585F-4AA1-B279-75820FE30650}" dt="2023-01-11T17:05:32.114" v="1970" actId="1076"/>
          <ac:spMkLst>
            <pc:docMk/>
            <pc:sldMk cId="3157830896" sldId="322"/>
            <ac:spMk id="55" creationId="{878EF722-68DF-101A-5176-AFA4DE48434B}"/>
          </ac:spMkLst>
        </pc:spChg>
        <pc:spChg chg="mod">
          <ac:chgData name="Kumar, Vinod" userId="a0710a6e-bffc-4971-8893-1c23addeb5b0" providerId="ADAL" clId="{F5D6EA11-585F-4AA1-B279-75820FE30650}" dt="2023-01-11T17:05:32.114" v="1970" actId="1076"/>
          <ac:spMkLst>
            <pc:docMk/>
            <pc:sldMk cId="3157830896" sldId="322"/>
            <ac:spMk id="57" creationId="{FA581B69-A71E-18AE-447E-591836AE0B53}"/>
          </ac:spMkLst>
        </pc:spChg>
        <pc:spChg chg="mod">
          <ac:chgData name="Kumar, Vinod" userId="a0710a6e-bffc-4971-8893-1c23addeb5b0" providerId="ADAL" clId="{F5D6EA11-585F-4AA1-B279-75820FE30650}" dt="2023-01-11T17:05:32.114" v="1970" actId="1076"/>
          <ac:spMkLst>
            <pc:docMk/>
            <pc:sldMk cId="3157830896" sldId="322"/>
            <ac:spMk id="59" creationId="{D1B5599F-021F-C290-2E3C-9F40416A00B5}"/>
          </ac:spMkLst>
        </pc:spChg>
        <pc:spChg chg="mod">
          <ac:chgData name="Kumar, Vinod" userId="a0710a6e-bffc-4971-8893-1c23addeb5b0" providerId="ADAL" clId="{F5D6EA11-585F-4AA1-B279-75820FE30650}" dt="2023-01-11T17:05:32.114" v="1970" actId="1076"/>
          <ac:spMkLst>
            <pc:docMk/>
            <pc:sldMk cId="3157830896" sldId="322"/>
            <ac:spMk id="60" creationId="{598B4112-9454-F557-6519-36E94F1BEF2D}"/>
          </ac:spMkLst>
        </pc:spChg>
        <pc:spChg chg="del mod topLvl">
          <ac:chgData name="Kumar, Vinod" userId="a0710a6e-bffc-4971-8893-1c23addeb5b0" providerId="ADAL" clId="{F5D6EA11-585F-4AA1-B279-75820FE30650}" dt="2023-01-11T16:28:23.723" v="1339" actId="478"/>
          <ac:spMkLst>
            <pc:docMk/>
            <pc:sldMk cId="3157830896" sldId="322"/>
            <ac:spMk id="64" creationId="{090071B3-8F1E-8A75-0295-D8FFDDFC2C0C}"/>
          </ac:spMkLst>
        </pc:spChg>
        <pc:spChg chg="mod topLvl">
          <ac:chgData name="Kumar, Vinod" userId="a0710a6e-bffc-4971-8893-1c23addeb5b0" providerId="ADAL" clId="{F5D6EA11-585F-4AA1-B279-75820FE30650}" dt="2023-01-11T17:05:32.114" v="1970" actId="1076"/>
          <ac:spMkLst>
            <pc:docMk/>
            <pc:sldMk cId="3157830896" sldId="322"/>
            <ac:spMk id="68" creationId="{49EF4CDF-CC0A-4496-E266-EC619A958D93}"/>
          </ac:spMkLst>
        </pc:spChg>
        <pc:spChg chg="mod topLvl">
          <ac:chgData name="Kumar, Vinod" userId="a0710a6e-bffc-4971-8893-1c23addeb5b0" providerId="ADAL" clId="{F5D6EA11-585F-4AA1-B279-75820FE30650}" dt="2023-01-11T17:05:32.114" v="1970" actId="1076"/>
          <ac:spMkLst>
            <pc:docMk/>
            <pc:sldMk cId="3157830896" sldId="322"/>
            <ac:spMk id="69" creationId="{7EE24D92-9B2F-CF70-3192-20DA4B17F302}"/>
          </ac:spMkLst>
        </pc:spChg>
        <pc:spChg chg="mod topLvl">
          <ac:chgData name="Kumar, Vinod" userId="a0710a6e-bffc-4971-8893-1c23addeb5b0" providerId="ADAL" clId="{F5D6EA11-585F-4AA1-B279-75820FE30650}" dt="2023-01-11T17:05:32.114" v="1970" actId="1076"/>
          <ac:spMkLst>
            <pc:docMk/>
            <pc:sldMk cId="3157830896" sldId="322"/>
            <ac:spMk id="70" creationId="{D7FEC77F-A4E1-CD1A-D849-9348CC865F8F}"/>
          </ac:spMkLst>
        </pc:spChg>
        <pc:spChg chg="mod topLvl">
          <ac:chgData name="Kumar, Vinod" userId="a0710a6e-bffc-4971-8893-1c23addeb5b0" providerId="ADAL" clId="{F5D6EA11-585F-4AA1-B279-75820FE30650}" dt="2023-01-11T17:05:32.114" v="1970" actId="1076"/>
          <ac:spMkLst>
            <pc:docMk/>
            <pc:sldMk cId="3157830896" sldId="322"/>
            <ac:spMk id="71" creationId="{0694052D-FF38-A67B-B6F8-E52523A1D23D}"/>
          </ac:spMkLst>
        </pc:spChg>
        <pc:spChg chg="mod topLvl">
          <ac:chgData name="Kumar, Vinod" userId="a0710a6e-bffc-4971-8893-1c23addeb5b0" providerId="ADAL" clId="{F5D6EA11-585F-4AA1-B279-75820FE30650}" dt="2023-01-11T17:05:32.114" v="1970" actId="1076"/>
          <ac:spMkLst>
            <pc:docMk/>
            <pc:sldMk cId="3157830896" sldId="322"/>
            <ac:spMk id="72" creationId="{6FB31237-9BB3-2751-D602-88B5E1DF4DDE}"/>
          </ac:spMkLst>
        </pc:spChg>
        <pc:spChg chg="add mod">
          <ac:chgData name="Kumar, Vinod" userId="a0710a6e-bffc-4971-8893-1c23addeb5b0" providerId="ADAL" clId="{F5D6EA11-585F-4AA1-B279-75820FE30650}" dt="2023-01-11T17:05:32.114" v="1970" actId="1076"/>
          <ac:spMkLst>
            <pc:docMk/>
            <pc:sldMk cId="3157830896" sldId="322"/>
            <ac:spMk id="75" creationId="{CC51EC9A-7A57-637E-70FB-AE8553662A23}"/>
          </ac:spMkLst>
        </pc:spChg>
        <pc:spChg chg="add mod">
          <ac:chgData name="Kumar, Vinod" userId="a0710a6e-bffc-4971-8893-1c23addeb5b0" providerId="ADAL" clId="{F5D6EA11-585F-4AA1-B279-75820FE30650}" dt="2023-01-11T17:05:32.114" v="1970" actId="1076"/>
          <ac:spMkLst>
            <pc:docMk/>
            <pc:sldMk cId="3157830896" sldId="322"/>
            <ac:spMk id="76" creationId="{6FC6A79A-E9FD-CE91-0FA8-AA7A8E234EDD}"/>
          </ac:spMkLst>
        </pc:spChg>
        <pc:spChg chg="add mod">
          <ac:chgData name="Kumar, Vinod" userId="a0710a6e-bffc-4971-8893-1c23addeb5b0" providerId="ADAL" clId="{F5D6EA11-585F-4AA1-B279-75820FE30650}" dt="2023-01-11T17:05:32.114" v="1970" actId="1076"/>
          <ac:spMkLst>
            <pc:docMk/>
            <pc:sldMk cId="3157830896" sldId="322"/>
            <ac:spMk id="78" creationId="{4301C488-0B1A-7D4D-0F11-76C5B455A716}"/>
          </ac:spMkLst>
        </pc:spChg>
        <pc:spChg chg="add mod">
          <ac:chgData name="Kumar, Vinod" userId="a0710a6e-bffc-4971-8893-1c23addeb5b0" providerId="ADAL" clId="{F5D6EA11-585F-4AA1-B279-75820FE30650}" dt="2023-01-11T17:05:32.114" v="1970" actId="1076"/>
          <ac:spMkLst>
            <pc:docMk/>
            <pc:sldMk cId="3157830896" sldId="322"/>
            <ac:spMk id="79" creationId="{C55ED82E-F65F-7340-7793-83C3E96D337E}"/>
          </ac:spMkLst>
        </pc:spChg>
        <pc:spChg chg="add mod">
          <ac:chgData name="Kumar, Vinod" userId="a0710a6e-bffc-4971-8893-1c23addeb5b0" providerId="ADAL" clId="{F5D6EA11-585F-4AA1-B279-75820FE30650}" dt="2023-01-11T17:05:32.114" v="1970" actId="1076"/>
          <ac:spMkLst>
            <pc:docMk/>
            <pc:sldMk cId="3157830896" sldId="322"/>
            <ac:spMk id="81" creationId="{C5801B11-66A2-635D-A7B8-6790A6BA765C}"/>
          </ac:spMkLst>
        </pc:spChg>
        <pc:spChg chg="add mod">
          <ac:chgData name="Kumar, Vinod" userId="a0710a6e-bffc-4971-8893-1c23addeb5b0" providerId="ADAL" clId="{F5D6EA11-585F-4AA1-B279-75820FE30650}" dt="2023-01-11T17:05:32.114" v="1970" actId="1076"/>
          <ac:spMkLst>
            <pc:docMk/>
            <pc:sldMk cId="3157830896" sldId="322"/>
            <ac:spMk id="82" creationId="{E81F7729-02D3-7382-7DE8-DB498C4C9FEA}"/>
          </ac:spMkLst>
        </pc:spChg>
        <pc:grpChg chg="add del mod">
          <ac:chgData name="Kumar, Vinod" userId="a0710a6e-bffc-4971-8893-1c23addeb5b0" providerId="ADAL" clId="{F5D6EA11-585F-4AA1-B279-75820FE30650}" dt="2023-01-11T16:20:41.134" v="1172" actId="478"/>
          <ac:grpSpMkLst>
            <pc:docMk/>
            <pc:sldMk cId="3157830896" sldId="322"/>
            <ac:grpSpMk id="7" creationId="{7D8C7163-D973-9310-82C5-9A92AA04BEB6}"/>
          </ac:grpSpMkLst>
        </pc:grpChg>
        <pc:grpChg chg="mod topLvl">
          <ac:chgData name="Kumar, Vinod" userId="a0710a6e-bffc-4971-8893-1c23addeb5b0" providerId="ADAL" clId="{F5D6EA11-585F-4AA1-B279-75820FE30650}" dt="2023-01-11T17:05:32.114" v="1970" actId="1076"/>
          <ac:grpSpMkLst>
            <pc:docMk/>
            <pc:sldMk cId="3157830896" sldId="322"/>
            <ac:grpSpMk id="8" creationId="{345B0DE5-59F3-4C7A-6F9D-07344790E471}"/>
          </ac:grpSpMkLst>
        </pc:grpChg>
        <pc:grpChg chg="mod">
          <ac:chgData name="Kumar, Vinod" userId="a0710a6e-bffc-4971-8893-1c23addeb5b0" providerId="ADAL" clId="{F5D6EA11-585F-4AA1-B279-75820FE30650}" dt="2023-01-11T17:05:32.114" v="1970" actId="1076"/>
          <ac:grpSpMkLst>
            <pc:docMk/>
            <pc:sldMk cId="3157830896" sldId="322"/>
            <ac:grpSpMk id="11" creationId="{10A6671F-5EE6-B7DD-E917-DC3DCA36FA64}"/>
          </ac:grpSpMkLst>
        </pc:grpChg>
        <pc:grpChg chg="add del mod">
          <ac:chgData name="Kumar, Vinod" userId="a0710a6e-bffc-4971-8893-1c23addeb5b0" providerId="ADAL" clId="{F5D6EA11-585F-4AA1-B279-75820FE30650}" dt="2023-01-11T16:24:44.045" v="1204" actId="478"/>
          <ac:grpSpMkLst>
            <pc:docMk/>
            <pc:sldMk cId="3157830896" sldId="322"/>
            <ac:grpSpMk id="22" creationId="{FA87E5C5-9B8E-E169-47ED-537B9742607A}"/>
          </ac:grpSpMkLst>
        </pc:grpChg>
        <pc:grpChg chg="mod topLvl">
          <ac:chgData name="Kumar, Vinod" userId="a0710a6e-bffc-4971-8893-1c23addeb5b0" providerId="ADAL" clId="{F5D6EA11-585F-4AA1-B279-75820FE30650}" dt="2023-01-11T17:05:32.114" v="1970" actId="1076"/>
          <ac:grpSpMkLst>
            <pc:docMk/>
            <pc:sldMk cId="3157830896" sldId="322"/>
            <ac:grpSpMk id="23" creationId="{4326F53A-5CDB-517A-DF45-ADCA94DBE136}"/>
          </ac:grpSpMkLst>
        </pc:grpChg>
        <pc:grpChg chg="add del mod">
          <ac:chgData name="Kumar, Vinod" userId="a0710a6e-bffc-4971-8893-1c23addeb5b0" providerId="ADAL" clId="{F5D6EA11-585F-4AA1-B279-75820FE30650}" dt="2023-01-11T16:25:50.060" v="1311" actId="478"/>
          <ac:grpSpMkLst>
            <pc:docMk/>
            <pc:sldMk cId="3157830896" sldId="322"/>
            <ac:grpSpMk id="36" creationId="{17A2F9A3-27F2-75EE-F4D1-8C54714B3A96}"/>
          </ac:grpSpMkLst>
        </pc:grpChg>
        <pc:grpChg chg="mod topLvl">
          <ac:chgData name="Kumar, Vinod" userId="a0710a6e-bffc-4971-8893-1c23addeb5b0" providerId="ADAL" clId="{F5D6EA11-585F-4AA1-B279-75820FE30650}" dt="2023-01-11T17:05:32.114" v="1970" actId="1076"/>
          <ac:grpSpMkLst>
            <pc:docMk/>
            <pc:sldMk cId="3157830896" sldId="322"/>
            <ac:grpSpMk id="37" creationId="{FB4EBBFC-ADF5-00A0-6BED-2F6F42F428DA}"/>
          </ac:grpSpMkLst>
        </pc:grpChg>
        <pc:grpChg chg="mod">
          <ac:chgData name="Kumar, Vinod" userId="a0710a6e-bffc-4971-8893-1c23addeb5b0" providerId="ADAL" clId="{F5D6EA11-585F-4AA1-B279-75820FE30650}" dt="2023-01-11T17:05:32.114" v="1970" actId="1076"/>
          <ac:grpSpMkLst>
            <pc:docMk/>
            <pc:sldMk cId="3157830896" sldId="322"/>
            <ac:grpSpMk id="40" creationId="{0E90CE53-2F8E-7871-14F9-D4D410472145}"/>
          </ac:grpSpMkLst>
        </pc:grpChg>
        <pc:grpChg chg="add del mod">
          <ac:chgData name="Kumar, Vinod" userId="a0710a6e-bffc-4971-8893-1c23addeb5b0" providerId="ADAL" clId="{F5D6EA11-585F-4AA1-B279-75820FE30650}" dt="2023-01-11T16:27:43.691" v="1335" actId="478"/>
          <ac:grpSpMkLst>
            <pc:docMk/>
            <pc:sldMk cId="3157830896" sldId="322"/>
            <ac:grpSpMk id="49" creationId="{3BC56378-1654-407B-6CA6-05D90247F482}"/>
          </ac:grpSpMkLst>
        </pc:grpChg>
        <pc:grpChg chg="mod topLvl">
          <ac:chgData name="Kumar, Vinod" userId="a0710a6e-bffc-4971-8893-1c23addeb5b0" providerId="ADAL" clId="{F5D6EA11-585F-4AA1-B279-75820FE30650}" dt="2023-01-11T17:05:32.114" v="1970" actId="1076"/>
          <ac:grpSpMkLst>
            <pc:docMk/>
            <pc:sldMk cId="3157830896" sldId="322"/>
            <ac:grpSpMk id="50" creationId="{77BBD041-1C5A-5223-637A-59B0D146DA73}"/>
          </ac:grpSpMkLst>
        </pc:grpChg>
        <pc:grpChg chg="add del mod">
          <ac:chgData name="Kumar, Vinod" userId="a0710a6e-bffc-4971-8893-1c23addeb5b0" providerId="ADAL" clId="{F5D6EA11-585F-4AA1-B279-75820FE30650}" dt="2023-01-11T16:28:23.723" v="1339" actId="478"/>
          <ac:grpSpMkLst>
            <pc:docMk/>
            <pc:sldMk cId="3157830896" sldId="322"/>
            <ac:grpSpMk id="62" creationId="{FB7D1540-E0C1-4BA5-3807-218E1FDA8EB9}"/>
          </ac:grpSpMkLst>
        </pc:grpChg>
        <pc:grpChg chg="del mod topLvl">
          <ac:chgData name="Kumar, Vinod" userId="a0710a6e-bffc-4971-8893-1c23addeb5b0" providerId="ADAL" clId="{F5D6EA11-585F-4AA1-B279-75820FE30650}" dt="2023-01-11T16:28:44.854" v="1340" actId="165"/>
          <ac:grpSpMkLst>
            <pc:docMk/>
            <pc:sldMk cId="3157830896" sldId="322"/>
            <ac:grpSpMk id="63" creationId="{4D744B0A-0B77-DAA4-AD55-3FAE4D180815}"/>
          </ac:grpSpMkLst>
        </pc:grpChg>
        <pc:grpChg chg="add mod">
          <ac:chgData name="Kumar, Vinod" userId="a0710a6e-bffc-4971-8893-1c23addeb5b0" providerId="ADAL" clId="{F5D6EA11-585F-4AA1-B279-75820FE30650}" dt="2023-01-11T17:05:32.114" v="1970" actId="1076"/>
          <ac:grpSpMkLst>
            <pc:docMk/>
            <pc:sldMk cId="3157830896" sldId="322"/>
            <ac:grpSpMk id="83" creationId="{5D1EDE2B-1BDA-0A0F-6108-7A8A4B4DA1D3}"/>
          </ac:grpSpMkLst>
        </pc:grpChg>
        <pc:grpChg chg="add mod">
          <ac:chgData name="Kumar, Vinod" userId="a0710a6e-bffc-4971-8893-1c23addeb5b0" providerId="ADAL" clId="{F5D6EA11-585F-4AA1-B279-75820FE30650}" dt="2023-01-11T17:05:32.114" v="1970" actId="1076"/>
          <ac:grpSpMkLst>
            <pc:docMk/>
            <pc:sldMk cId="3157830896" sldId="322"/>
            <ac:grpSpMk id="84" creationId="{1098412F-A7EA-2E79-7A8B-A2BBAB153C1A}"/>
          </ac:grpSpMkLst>
        </pc:grpChg>
        <pc:picChg chg="add del mod">
          <ac:chgData name="Kumar, Vinod" userId="a0710a6e-bffc-4971-8893-1c23addeb5b0" providerId="ADAL" clId="{F5D6EA11-585F-4AA1-B279-75820FE30650}" dt="2023-01-11T16:49:37.665" v="1793" actId="478"/>
          <ac:picMkLst>
            <pc:docMk/>
            <pc:sldMk cId="3157830896" sldId="322"/>
            <ac:picMk id="2" creationId="{6C46ED9A-A7C7-5217-D2E4-C038D3D9FF4E}"/>
          </ac:picMkLst>
        </pc:picChg>
        <pc:picChg chg="add del mod">
          <ac:chgData name="Kumar, Vinod" userId="a0710a6e-bffc-4971-8893-1c23addeb5b0" providerId="ADAL" clId="{F5D6EA11-585F-4AA1-B279-75820FE30650}" dt="2023-01-11T16:49:37.665" v="1793" actId="478"/>
          <ac:picMkLst>
            <pc:docMk/>
            <pc:sldMk cId="3157830896" sldId="322"/>
            <ac:picMk id="3" creationId="{C8BA9D6F-7BC9-1CB7-1D69-0445BAC502AC}"/>
          </ac:picMkLst>
        </pc:picChg>
        <pc:picChg chg="add del mod">
          <ac:chgData name="Kumar, Vinod" userId="a0710a6e-bffc-4971-8893-1c23addeb5b0" providerId="ADAL" clId="{F5D6EA11-585F-4AA1-B279-75820FE30650}" dt="2023-01-11T16:49:37.665" v="1793" actId="478"/>
          <ac:picMkLst>
            <pc:docMk/>
            <pc:sldMk cId="3157830896" sldId="322"/>
            <ac:picMk id="4" creationId="{8539FC97-1AB2-147C-232E-C6C6B575D5F3}"/>
          </ac:picMkLst>
        </pc:picChg>
        <pc:picChg chg="add del mod">
          <ac:chgData name="Kumar, Vinod" userId="a0710a6e-bffc-4971-8893-1c23addeb5b0" providerId="ADAL" clId="{F5D6EA11-585F-4AA1-B279-75820FE30650}" dt="2023-01-11T16:49:37.665" v="1793" actId="478"/>
          <ac:picMkLst>
            <pc:docMk/>
            <pc:sldMk cId="3157830896" sldId="322"/>
            <ac:picMk id="5" creationId="{86D5AF93-B94F-AA20-36EC-DEECDC865FD7}"/>
          </ac:picMkLst>
        </pc:picChg>
        <pc:picChg chg="add del mod">
          <ac:chgData name="Kumar, Vinod" userId="a0710a6e-bffc-4971-8893-1c23addeb5b0" providerId="ADAL" clId="{F5D6EA11-585F-4AA1-B279-75820FE30650}" dt="2023-01-11T16:49:37.665" v="1793" actId="478"/>
          <ac:picMkLst>
            <pc:docMk/>
            <pc:sldMk cId="3157830896" sldId="322"/>
            <ac:picMk id="6" creationId="{110C52AA-9FD8-AC10-88CF-933E41F9AB71}"/>
          </ac:picMkLst>
        </pc:picChg>
        <pc:picChg chg="mod">
          <ac:chgData name="Kumar, Vinod" userId="a0710a6e-bffc-4971-8893-1c23addeb5b0" providerId="ADAL" clId="{F5D6EA11-585F-4AA1-B279-75820FE30650}" dt="2023-01-11T17:05:32.114" v="1970" actId="1076"/>
          <ac:picMkLst>
            <pc:docMk/>
            <pc:sldMk cId="3157830896" sldId="322"/>
            <ac:picMk id="12" creationId="{9DE419E3-403C-D82C-34EF-BDFFB94E3155}"/>
          </ac:picMkLst>
        </pc:picChg>
        <pc:picChg chg="mod">
          <ac:chgData name="Kumar, Vinod" userId="a0710a6e-bffc-4971-8893-1c23addeb5b0" providerId="ADAL" clId="{F5D6EA11-585F-4AA1-B279-75820FE30650}" dt="2023-01-11T17:05:32.114" v="1970" actId="1076"/>
          <ac:picMkLst>
            <pc:docMk/>
            <pc:sldMk cId="3157830896" sldId="322"/>
            <ac:picMk id="13" creationId="{1AB95DBF-5176-024E-9E3E-55199676AFA6}"/>
          </ac:picMkLst>
        </pc:picChg>
        <pc:picChg chg="mod">
          <ac:chgData name="Kumar, Vinod" userId="a0710a6e-bffc-4971-8893-1c23addeb5b0" providerId="ADAL" clId="{F5D6EA11-585F-4AA1-B279-75820FE30650}" dt="2023-01-11T17:05:32.114" v="1970" actId="1076"/>
          <ac:picMkLst>
            <pc:docMk/>
            <pc:sldMk cId="3157830896" sldId="322"/>
            <ac:picMk id="14" creationId="{8CEFDEF6-B2CA-3BF2-51C5-755C326F1733}"/>
          </ac:picMkLst>
        </pc:picChg>
        <pc:picChg chg="mod">
          <ac:chgData name="Kumar, Vinod" userId="a0710a6e-bffc-4971-8893-1c23addeb5b0" providerId="ADAL" clId="{F5D6EA11-585F-4AA1-B279-75820FE30650}" dt="2023-01-11T17:05:32.114" v="1970" actId="1076"/>
          <ac:picMkLst>
            <pc:docMk/>
            <pc:sldMk cId="3157830896" sldId="322"/>
            <ac:picMk id="15" creationId="{ECFED206-86DE-2C7E-4D95-4FCD8CE17845}"/>
          </ac:picMkLst>
        </pc:picChg>
        <pc:picChg chg="mod">
          <ac:chgData name="Kumar, Vinod" userId="a0710a6e-bffc-4971-8893-1c23addeb5b0" providerId="ADAL" clId="{F5D6EA11-585F-4AA1-B279-75820FE30650}" dt="2023-01-11T17:05:32.114" v="1970" actId="1076"/>
          <ac:picMkLst>
            <pc:docMk/>
            <pc:sldMk cId="3157830896" sldId="322"/>
            <ac:picMk id="25" creationId="{C36C9476-210F-9EC6-DBBE-28E09FFDC27E}"/>
          </ac:picMkLst>
        </pc:picChg>
        <pc:picChg chg="mod">
          <ac:chgData name="Kumar, Vinod" userId="a0710a6e-bffc-4971-8893-1c23addeb5b0" providerId="ADAL" clId="{F5D6EA11-585F-4AA1-B279-75820FE30650}" dt="2023-01-11T17:05:32.114" v="1970" actId="1076"/>
          <ac:picMkLst>
            <pc:docMk/>
            <pc:sldMk cId="3157830896" sldId="322"/>
            <ac:picMk id="26" creationId="{5B131BA8-97A0-D0F9-18A7-485FB9878DA4}"/>
          </ac:picMkLst>
        </pc:picChg>
        <pc:picChg chg="mod">
          <ac:chgData name="Kumar, Vinod" userId="a0710a6e-bffc-4971-8893-1c23addeb5b0" providerId="ADAL" clId="{F5D6EA11-585F-4AA1-B279-75820FE30650}" dt="2023-01-11T17:05:32.114" v="1970" actId="1076"/>
          <ac:picMkLst>
            <pc:docMk/>
            <pc:sldMk cId="3157830896" sldId="322"/>
            <ac:picMk id="27" creationId="{64898D00-0AE9-5BC4-1DFE-BD281C98DF4F}"/>
          </ac:picMkLst>
        </pc:picChg>
        <pc:picChg chg="mod">
          <ac:chgData name="Kumar, Vinod" userId="a0710a6e-bffc-4971-8893-1c23addeb5b0" providerId="ADAL" clId="{F5D6EA11-585F-4AA1-B279-75820FE30650}" dt="2023-01-11T17:05:32.114" v="1970" actId="1076"/>
          <ac:picMkLst>
            <pc:docMk/>
            <pc:sldMk cId="3157830896" sldId="322"/>
            <ac:picMk id="28" creationId="{64DEC6AC-A72B-60A6-1059-298D04C4261D}"/>
          </ac:picMkLst>
        </pc:picChg>
        <pc:picChg chg="mod">
          <ac:chgData name="Kumar, Vinod" userId="a0710a6e-bffc-4971-8893-1c23addeb5b0" providerId="ADAL" clId="{F5D6EA11-585F-4AA1-B279-75820FE30650}" dt="2023-01-11T17:05:32.114" v="1970" actId="1076"/>
          <ac:picMkLst>
            <pc:docMk/>
            <pc:sldMk cId="3157830896" sldId="322"/>
            <ac:picMk id="43" creationId="{1302DB00-D5CE-6D28-813A-948FACC2B9D1}"/>
          </ac:picMkLst>
        </pc:picChg>
        <pc:picChg chg="mod">
          <ac:chgData name="Kumar, Vinod" userId="a0710a6e-bffc-4971-8893-1c23addeb5b0" providerId="ADAL" clId="{F5D6EA11-585F-4AA1-B279-75820FE30650}" dt="2023-01-11T17:05:32.114" v="1970" actId="1076"/>
          <ac:picMkLst>
            <pc:docMk/>
            <pc:sldMk cId="3157830896" sldId="322"/>
            <ac:picMk id="44" creationId="{F75F1A6A-2632-376C-23DA-D30E7F0F47F1}"/>
          </ac:picMkLst>
        </pc:picChg>
        <pc:picChg chg="mod">
          <ac:chgData name="Kumar, Vinod" userId="a0710a6e-bffc-4971-8893-1c23addeb5b0" providerId="ADAL" clId="{F5D6EA11-585F-4AA1-B279-75820FE30650}" dt="2023-01-11T17:05:32.114" v="1970" actId="1076"/>
          <ac:picMkLst>
            <pc:docMk/>
            <pc:sldMk cId="3157830896" sldId="322"/>
            <ac:picMk id="46" creationId="{6D08C7B2-5301-CF36-60B4-B0E1390F52B5}"/>
          </ac:picMkLst>
        </pc:picChg>
        <pc:picChg chg="mod">
          <ac:chgData name="Kumar, Vinod" userId="a0710a6e-bffc-4971-8893-1c23addeb5b0" providerId="ADAL" clId="{F5D6EA11-585F-4AA1-B279-75820FE30650}" dt="2023-01-11T17:05:32.114" v="1970" actId="1076"/>
          <ac:picMkLst>
            <pc:docMk/>
            <pc:sldMk cId="3157830896" sldId="322"/>
            <ac:picMk id="58" creationId="{BF3B0381-DF67-7596-79BA-434D7D1ED30F}"/>
          </ac:picMkLst>
        </pc:picChg>
        <pc:picChg chg="mod">
          <ac:chgData name="Kumar, Vinod" userId="a0710a6e-bffc-4971-8893-1c23addeb5b0" providerId="ADAL" clId="{F5D6EA11-585F-4AA1-B279-75820FE30650}" dt="2023-01-11T17:05:32.114" v="1970" actId="1076"/>
          <ac:picMkLst>
            <pc:docMk/>
            <pc:sldMk cId="3157830896" sldId="322"/>
            <ac:picMk id="61" creationId="{EF6084D2-48B0-217B-2575-C6260F8F4DA2}"/>
          </ac:picMkLst>
        </pc:picChg>
        <pc:picChg chg="mod topLvl">
          <ac:chgData name="Kumar, Vinod" userId="a0710a6e-bffc-4971-8893-1c23addeb5b0" providerId="ADAL" clId="{F5D6EA11-585F-4AA1-B279-75820FE30650}" dt="2023-01-11T17:05:32.114" v="1970" actId="1076"/>
          <ac:picMkLst>
            <pc:docMk/>
            <pc:sldMk cId="3157830896" sldId="322"/>
            <ac:picMk id="65" creationId="{93F6D277-2F22-4D08-4B4A-52F3BAB573BE}"/>
          </ac:picMkLst>
        </pc:picChg>
        <pc:picChg chg="mod topLvl">
          <ac:chgData name="Kumar, Vinod" userId="a0710a6e-bffc-4971-8893-1c23addeb5b0" providerId="ADAL" clId="{F5D6EA11-585F-4AA1-B279-75820FE30650}" dt="2023-01-11T17:05:32.114" v="1970" actId="1076"/>
          <ac:picMkLst>
            <pc:docMk/>
            <pc:sldMk cId="3157830896" sldId="322"/>
            <ac:picMk id="66" creationId="{0F9EF6EF-F4F5-5D8F-30E5-F9E7B5F6C820}"/>
          </ac:picMkLst>
        </pc:picChg>
        <pc:picChg chg="mod topLvl">
          <ac:chgData name="Kumar, Vinod" userId="a0710a6e-bffc-4971-8893-1c23addeb5b0" providerId="ADAL" clId="{F5D6EA11-585F-4AA1-B279-75820FE30650}" dt="2023-01-11T17:05:32.114" v="1970" actId="1076"/>
          <ac:picMkLst>
            <pc:docMk/>
            <pc:sldMk cId="3157830896" sldId="322"/>
            <ac:picMk id="67" creationId="{9E66E166-5952-7CBD-369E-1D4654DA2DA7}"/>
          </ac:picMkLst>
        </pc:picChg>
        <pc:picChg chg="add mod">
          <ac:chgData name="Kumar, Vinod" userId="a0710a6e-bffc-4971-8893-1c23addeb5b0" providerId="ADAL" clId="{F5D6EA11-585F-4AA1-B279-75820FE30650}" dt="2023-01-11T17:05:32.114" v="1970" actId="1076"/>
          <ac:picMkLst>
            <pc:docMk/>
            <pc:sldMk cId="3157830896" sldId="322"/>
            <ac:picMk id="73" creationId="{28BFF2C7-8EDA-6F4E-4D29-C9B1A29D5CCE}"/>
          </ac:picMkLst>
        </pc:picChg>
        <pc:picChg chg="add mod">
          <ac:chgData name="Kumar, Vinod" userId="a0710a6e-bffc-4971-8893-1c23addeb5b0" providerId="ADAL" clId="{F5D6EA11-585F-4AA1-B279-75820FE30650}" dt="2023-01-11T17:05:32.114" v="1970" actId="1076"/>
          <ac:picMkLst>
            <pc:docMk/>
            <pc:sldMk cId="3157830896" sldId="322"/>
            <ac:picMk id="74" creationId="{9671F830-86A9-550D-1A9B-6D5F055F329E}"/>
          </ac:picMkLst>
        </pc:picChg>
        <pc:cxnChg chg="mod">
          <ac:chgData name="Kumar, Vinod" userId="a0710a6e-bffc-4971-8893-1c23addeb5b0" providerId="ADAL" clId="{F5D6EA11-585F-4AA1-B279-75820FE30650}" dt="2023-01-11T17:05:32.114" v="1970" actId="1076"/>
          <ac:cxnSpMkLst>
            <pc:docMk/>
            <pc:sldMk cId="3157830896" sldId="322"/>
            <ac:cxnSpMk id="18" creationId="{044E40B1-390F-CFCF-7633-BE67D33A445B}"/>
          </ac:cxnSpMkLst>
        </pc:cxnChg>
        <pc:cxnChg chg="mod">
          <ac:chgData name="Kumar, Vinod" userId="a0710a6e-bffc-4971-8893-1c23addeb5b0" providerId="ADAL" clId="{F5D6EA11-585F-4AA1-B279-75820FE30650}" dt="2023-01-11T17:05:32.114" v="1970" actId="1076"/>
          <ac:cxnSpMkLst>
            <pc:docMk/>
            <pc:sldMk cId="3157830896" sldId="322"/>
            <ac:cxnSpMk id="32" creationId="{AEEBCA9A-FF76-8E3D-70A7-76303914454C}"/>
          </ac:cxnSpMkLst>
        </pc:cxnChg>
        <pc:cxnChg chg="mod">
          <ac:chgData name="Kumar, Vinod" userId="a0710a6e-bffc-4971-8893-1c23addeb5b0" providerId="ADAL" clId="{F5D6EA11-585F-4AA1-B279-75820FE30650}" dt="2023-01-11T17:05:32.114" v="1970" actId="1076"/>
          <ac:cxnSpMkLst>
            <pc:docMk/>
            <pc:sldMk cId="3157830896" sldId="322"/>
            <ac:cxnSpMk id="48" creationId="{D63FF35A-D10E-70AE-E967-5BC380CE6F3E}"/>
          </ac:cxnSpMkLst>
        </pc:cxnChg>
        <pc:cxnChg chg="mod">
          <ac:chgData name="Kumar, Vinod" userId="a0710a6e-bffc-4971-8893-1c23addeb5b0" providerId="ADAL" clId="{F5D6EA11-585F-4AA1-B279-75820FE30650}" dt="2023-01-11T17:05:32.114" v="1970" actId="1076"/>
          <ac:cxnSpMkLst>
            <pc:docMk/>
            <pc:sldMk cId="3157830896" sldId="322"/>
            <ac:cxnSpMk id="53" creationId="{579EAB85-3068-42D0-BDDD-DFF605BF1919}"/>
          </ac:cxnSpMkLst>
        </pc:cxnChg>
        <pc:cxnChg chg="mod">
          <ac:chgData name="Kumar, Vinod" userId="a0710a6e-bffc-4971-8893-1c23addeb5b0" providerId="ADAL" clId="{F5D6EA11-585F-4AA1-B279-75820FE30650}" dt="2023-01-11T17:05:32.114" v="1970" actId="1076"/>
          <ac:cxnSpMkLst>
            <pc:docMk/>
            <pc:sldMk cId="3157830896" sldId="322"/>
            <ac:cxnSpMk id="54" creationId="{FF0C2886-A624-E9A3-F855-CBA8797E31D1}"/>
          </ac:cxnSpMkLst>
        </pc:cxnChg>
        <pc:cxnChg chg="mod">
          <ac:chgData name="Kumar, Vinod" userId="a0710a6e-bffc-4971-8893-1c23addeb5b0" providerId="ADAL" clId="{F5D6EA11-585F-4AA1-B279-75820FE30650}" dt="2023-01-11T17:05:32.114" v="1970" actId="1076"/>
          <ac:cxnSpMkLst>
            <pc:docMk/>
            <pc:sldMk cId="3157830896" sldId="322"/>
            <ac:cxnSpMk id="56" creationId="{AD7322C1-03EA-7DD7-DF7A-3472C72A386F}"/>
          </ac:cxnSpMkLst>
        </pc:cxnChg>
        <pc:cxnChg chg="add mod">
          <ac:chgData name="Kumar, Vinod" userId="a0710a6e-bffc-4971-8893-1c23addeb5b0" providerId="ADAL" clId="{F5D6EA11-585F-4AA1-B279-75820FE30650}" dt="2023-01-11T17:05:32.114" v="1970" actId="1076"/>
          <ac:cxnSpMkLst>
            <pc:docMk/>
            <pc:sldMk cId="3157830896" sldId="322"/>
            <ac:cxnSpMk id="77" creationId="{2BBF8F68-2F6E-3A62-10B0-FA7559F08C5F}"/>
          </ac:cxnSpMkLst>
        </pc:cxnChg>
        <pc:cxnChg chg="add mod">
          <ac:chgData name="Kumar, Vinod" userId="a0710a6e-bffc-4971-8893-1c23addeb5b0" providerId="ADAL" clId="{F5D6EA11-585F-4AA1-B279-75820FE30650}" dt="2023-01-11T17:05:32.114" v="1970" actId="1076"/>
          <ac:cxnSpMkLst>
            <pc:docMk/>
            <pc:sldMk cId="3157830896" sldId="322"/>
            <ac:cxnSpMk id="80" creationId="{EB1B98C5-8806-48DD-7B35-9BF63B56E788}"/>
          </ac:cxnSpMkLst>
        </pc:cxnChg>
      </pc:sldChg>
      <pc:sldChg chg="addSp delSp modSp add mod">
        <pc:chgData name="Kumar, Vinod" userId="a0710a6e-bffc-4971-8893-1c23addeb5b0" providerId="ADAL" clId="{F5D6EA11-585F-4AA1-B279-75820FE30650}" dt="2023-01-11T21:13:47.298" v="2647" actId="478"/>
        <pc:sldMkLst>
          <pc:docMk/>
          <pc:sldMk cId="4037451339" sldId="322"/>
        </pc:sldMkLst>
        <pc:spChg chg="mod">
          <ac:chgData name="Kumar, Vinod" userId="a0710a6e-bffc-4971-8893-1c23addeb5b0" providerId="ADAL" clId="{F5D6EA11-585F-4AA1-B279-75820FE30650}" dt="2023-01-11T21:13:03.186" v="2624" actId="1036"/>
          <ac:spMkLst>
            <pc:docMk/>
            <pc:sldMk cId="4037451339" sldId="322"/>
            <ac:spMk id="42" creationId="{16DC128D-7391-9104-D36F-94A5E4919D28}"/>
          </ac:spMkLst>
        </pc:spChg>
        <pc:spChg chg="mod">
          <ac:chgData name="Kumar, Vinod" userId="a0710a6e-bffc-4971-8893-1c23addeb5b0" providerId="ADAL" clId="{F5D6EA11-585F-4AA1-B279-75820FE30650}" dt="2023-01-11T21:13:03.186" v="2624" actId="1036"/>
          <ac:spMkLst>
            <pc:docMk/>
            <pc:sldMk cId="4037451339" sldId="322"/>
            <ac:spMk id="43" creationId="{EFA3BA5F-8A3A-CB47-50F3-1A1EE0BF7CAB}"/>
          </ac:spMkLst>
        </pc:spChg>
        <pc:spChg chg="mod">
          <ac:chgData name="Kumar, Vinod" userId="a0710a6e-bffc-4971-8893-1c23addeb5b0" providerId="ADAL" clId="{F5D6EA11-585F-4AA1-B279-75820FE30650}" dt="2023-01-11T21:13:14.274" v="2640" actId="1036"/>
          <ac:spMkLst>
            <pc:docMk/>
            <pc:sldMk cId="4037451339" sldId="322"/>
            <ac:spMk id="44" creationId="{635FF346-A88B-92A6-1B45-E8D4AA8BE5F4}"/>
          </ac:spMkLst>
        </pc:spChg>
        <pc:spChg chg="mod">
          <ac:chgData name="Kumar, Vinod" userId="a0710a6e-bffc-4971-8893-1c23addeb5b0" providerId="ADAL" clId="{F5D6EA11-585F-4AA1-B279-75820FE30650}" dt="2023-01-11T21:13:28.083" v="2643" actId="1037"/>
          <ac:spMkLst>
            <pc:docMk/>
            <pc:sldMk cId="4037451339" sldId="322"/>
            <ac:spMk id="45" creationId="{90C79A45-3774-DF57-E47E-FDF4D887691A}"/>
          </ac:spMkLst>
        </pc:spChg>
        <pc:picChg chg="mod">
          <ac:chgData name="Kumar, Vinod" userId="a0710a6e-bffc-4971-8893-1c23addeb5b0" providerId="ADAL" clId="{F5D6EA11-585F-4AA1-B279-75820FE30650}" dt="2023-01-11T21:12:52.690" v="2615" actId="1036"/>
          <ac:picMkLst>
            <pc:docMk/>
            <pc:sldMk cId="4037451339" sldId="322"/>
            <ac:picMk id="2" creationId="{1C40B368-7271-944F-5A0D-482A6E631169}"/>
          </ac:picMkLst>
        </pc:picChg>
        <pc:picChg chg="del mod modCrop">
          <ac:chgData name="Kumar, Vinod" userId="a0710a6e-bffc-4971-8893-1c23addeb5b0" providerId="ADAL" clId="{F5D6EA11-585F-4AA1-B279-75820FE30650}" dt="2023-01-11T21:08:03.508" v="2093" actId="478"/>
          <ac:picMkLst>
            <pc:docMk/>
            <pc:sldMk cId="4037451339" sldId="322"/>
            <ac:picMk id="3" creationId="{C7ABA78A-085A-1E35-6628-090FF421F26B}"/>
          </ac:picMkLst>
        </pc:picChg>
        <pc:picChg chg="del mod modCrop">
          <ac:chgData name="Kumar, Vinod" userId="a0710a6e-bffc-4971-8893-1c23addeb5b0" providerId="ADAL" clId="{F5D6EA11-585F-4AA1-B279-75820FE30650}" dt="2023-01-11T21:08:03.508" v="2093" actId="478"/>
          <ac:picMkLst>
            <pc:docMk/>
            <pc:sldMk cId="4037451339" sldId="322"/>
            <ac:picMk id="4" creationId="{A965FD42-264F-5F2A-E09A-0639D600908B}"/>
          </ac:picMkLst>
        </pc:picChg>
        <pc:picChg chg="del mod modCrop">
          <ac:chgData name="Kumar, Vinod" userId="a0710a6e-bffc-4971-8893-1c23addeb5b0" providerId="ADAL" clId="{F5D6EA11-585F-4AA1-B279-75820FE30650}" dt="2023-01-11T21:08:03.508" v="2093" actId="478"/>
          <ac:picMkLst>
            <pc:docMk/>
            <pc:sldMk cId="4037451339" sldId="322"/>
            <ac:picMk id="5" creationId="{4ABF66CB-0B56-DF93-C3E4-67EAE283E58C}"/>
          </ac:picMkLst>
        </pc:picChg>
        <pc:picChg chg="del mod modCrop">
          <ac:chgData name="Kumar, Vinod" userId="a0710a6e-bffc-4971-8893-1c23addeb5b0" providerId="ADAL" clId="{F5D6EA11-585F-4AA1-B279-75820FE30650}" dt="2023-01-11T21:08:03.508" v="2093" actId="478"/>
          <ac:picMkLst>
            <pc:docMk/>
            <pc:sldMk cId="4037451339" sldId="322"/>
            <ac:picMk id="6" creationId="{BA6BE2B1-F67A-259B-D6F8-6A157816110D}"/>
          </ac:picMkLst>
        </pc:picChg>
        <pc:picChg chg="del mod">
          <ac:chgData name="Kumar, Vinod" userId="a0710a6e-bffc-4971-8893-1c23addeb5b0" providerId="ADAL" clId="{F5D6EA11-585F-4AA1-B279-75820FE30650}" dt="2023-01-11T21:13:47.298" v="2647" actId="478"/>
          <ac:picMkLst>
            <pc:docMk/>
            <pc:sldMk cId="4037451339" sldId="322"/>
            <ac:picMk id="7" creationId="{EFC54EB2-B049-F2CD-90EF-F8D0D2CA9D92}"/>
          </ac:picMkLst>
        </pc:picChg>
        <pc:picChg chg="add mod">
          <ac:chgData name="Kumar, Vinod" userId="a0710a6e-bffc-4971-8893-1c23addeb5b0" providerId="ADAL" clId="{F5D6EA11-585F-4AA1-B279-75820FE30650}" dt="2023-01-11T21:10:37.059" v="2278" actId="1037"/>
          <ac:picMkLst>
            <pc:docMk/>
            <pc:sldMk cId="4037451339" sldId="322"/>
            <ac:picMk id="8" creationId="{6B4049F6-FFF5-F5A7-E7DA-FC2CC5E88423}"/>
          </ac:picMkLst>
        </pc:picChg>
        <pc:picChg chg="add mod">
          <ac:chgData name="Kumar, Vinod" userId="a0710a6e-bffc-4971-8893-1c23addeb5b0" providerId="ADAL" clId="{F5D6EA11-585F-4AA1-B279-75820FE30650}" dt="2023-01-11T21:11:47.874" v="2510" actId="1037"/>
          <ac:picMkLst>
            <pc:docMk/>
            <pc:sldMk cId="4037451339" sldId="322"/>
            <ac:picMk id="10" creationId="{FFB75687-B113-7332-9AD9-748220956441}"/>
          </ac:picMkLst>
        </pc:picChg>
        <pc:picChg chg="add mod">
          <ac:chgData name="Kumar, Vinod" userId="a0710a6e-bffc-4971-8893-1c23addeb5b0" providerId="ADAL" clId="{F5D6EA11-585F-4AA1-B279-75820FE30650}" dt="2023-01-11T21:12:52.690" v="2615" actId="1036"/>
          <ac:picMkLst>
            <pc:docMk/>
            <pc:sldMk cId="4037451339" sldId="322"/>
            <ac:picMk id="11" creationId="{40DF168E-4642-C214-86F3-1A1540C41A45}"/>
          </ac:picMkLst>
        </pc:picChg>
        <pc:picChg chg="add mod">
          <ac:chgData name="Kumar, Vinod" userId="a0710a6e-bffc-4971-8893-1c23addeb5b0" providerId="ADAL" clId="{F5D6EA11-585F-4AA1-B279-75820FE30650}" dt="2023-01-11T21:13:32.290" v="2646" actId="1037"/>
          <ac:picMkLst>
            <pc:docMk/>
            <pc:sldMk cId="4037451339" sldId="322"/>
            <ac:picMk id="12" creationId="{35136179-0675-6941-50F9-392FB08B8218}"/>
          </ac:picMkLst>
        </pc:picChg>
        <pc:picChg chg="add mod">
          <ac:chgData name="Kumar, Vinod" userId="a0710a6e-bffc-4971-8893-1c23addeb5b0" providerId="ADAL" clId="{F5D6EA11-585F-4AA1-B279-75820FE30650}" dt="2023-01-11T21:10:15.187" v="2199" actId="1037"/>
          <ac:picMkLst>
            <pc:docMk/>
            <pc:sldMk cId="4037451339" sldId="322"/>
            <ac:picMk id="13" creationId="{2A611F3F-6E79-FB02-7730-3B4EEF4288DB}"/>
          </ac:picMkLst>
        </pc:picChg>
        <pc:picChg chg="del mod">
          <ac:chgData name="Kumar, Vinod" userId="a0710a6e-bffc-4971-8893-1c23addeb5b0" providerId="ADAL" clId="{F5D6EA11-585F-4AA1-B279-75820FE30650}" dt="2023-01-11T21:13:47.298" v="2647" actId="478"/>
          <ac:picMkLst>
            <pc:docMk/>
            <pc:sldMk cId="4037451339" sldId="322"/>
            <ac:picMk id="19" creationId="{D1526D6C-E2F5-D0AB-478D-4DAB790FC397}"/>
          </ac:picMkLst>
        </pc:picChg>
        <pc:picChg chg="del mod">
          <ac:chgData name="Kumar, Vinod" userId="a0710a6e-bffc-4971-8893-1c23addeb5b0" providerId="ADAL" clId="{F5D6EA11-585F-4AA1-B279-75820FE30650}" dt="2023-01-11T21:13:47.298" v="2647" actId="478"/>
          <ac:picMkLst>
            <pc:docMk/>
            <pc:sldMk cId="4037451339" sldId="322"/>
            <ac:picMk id="22" creationId="{33076018-5466-8581-6A2B-27627BC26283}"/>
          </ac:picMkLst>
        </pc:picChg>
        <pc:picChg chg="del">
          <ac:chgData name="Kumar, Vinod" userId="a0710a6e-bffc-4971-8893-1c23addeb5b0" providerId="ADAL" clId="{F5D6EA11-585F-4AA1-B279-75820FE30650}" dt="2023-01-11T21:12:07.283" v="2577" actId="478"/>
          <ac:picMkLst>
            <pc:docMk/>
            <pc:sldMk cId="4037451339" sldId="322"/>
            <ac:picMk id="23" creationId="{1D89F4DD-9BA8-FED4-BCA3-72E107254170}"/>
          </ac:picMkLst>
        </pc:picChg>
        <pc:picChg chg="del">
          <ac:chgData name="Kumar, Vinod" userId="a0710a6e-bffc-4971-8893-1c23addeb5b0" providerId="ADAL" clId="{F5D6EA11-585F-4AA1-B279-75820FE30650}" dt="2023-01-11T21:12:07.283" v="2577" actId="478"/>
          <ac:picMkLst>
            <pc:docMk/>
            <pc:sldMk cId="4037451339" sldId="322"/>
            <ac:picMk id="24" creationId="{5C19F2A6-0BA0-4F6B-2F78-0857983C2355}"/>
          </ac:picMkLst>
        </pc:picChg>
      </pc:sldChg>
      <pc:sldChg chg="addSp delSp modSp add mod">
        <pc:chgData name="Kumar, Vinod" userId="a0710a6e-bffc-4971-8893-1c23addeb5b0" providerId="ADAL" clId="{F5D6EA11-585F-4AA1-B279-75820FE30650}" dt="2023-01-12T15:42:28.688" v="3647" actId="1035"/>
        <pc:sldMkLst>
          <pc:docMk/>
          <pc:sldMk cId="1020235566" sldId="323"/>
        </pc:sldMkLst>
        <pc:spChg chg="mod">
          <ac:chgData name="Kumar, Vinod" userId="a0710a6e-bffc-4971-8893-1c23addeb5b0" providerId="ADAL" clId="{F5D6EA11-585F-4AA1-B279-75820FE30650}" dt="2023-01-12T15:42:28.688" v="3647" actId="1035"/>
          <ac:spMkLst>
            <pc:docMk/>
            <pc:sldMk cId="1020235566" sldId="323"/>
            <ac:spMk id="2" creationId="{9C3F447A-BA77-912B-8E78-44F98688ECE7}"/>
          </ac:spMkLst>
        </pc:spChg>
        <pc:spChg chg="mod">
          <ac:chgData name="Kumar, Vinod" userId="a0710a6e-bffc-4971-8893-1c23addeb5b0" providerId="ADAL" clId="{F5D6EA11-585F-4AA1-B279-75820FE30650}" dt="2023-01-12T15:35:42.807" v="3136"/>
          <ac:spMkLst>
            <pc:docMk/>
            <pc:sldMk cId="1020235566" sldId="323"/>
            <ac:spMk id="13" creationId="{28E34A67-6789-D6E3-03C8-FACF874C2FEB}"/>
          </ac:spMkLst>
        </pc:spChg>
        <pc:spChg chg="mod">
          <ac:chgData name="Kumar, Vinod" userId="a0710a6e-bffc-4971-8893-1c23addeb5b0" providerId="ADAL" clId="{F5D6EA11-585F-4AA1-B279-75820FE30650}" dt="2023-01-12T15:42:28.688" v="3647" actId="1035"/>
          <ac:spMkLst>
            <pc:docMk/>
            <pc:sldMk cId="1020235566" sldId="323"/>
            <ac:spMk id="89" creationId="{05532DAD-C191-1E14-3307-0B3021E5F901}"/>
          </ac:spMkLst>
        </pc:spChg>
        <pc:grpChg chg="del">
          <ac:chgData name="Kumar, Vinod" userId="a0710a6e-bffc-4971-8893-1c23addeb5b0" providerId="ADAL" clId="{F5D6EA11-585F-4AA1-B279-75820FE30650}" dt="2023-01-12T15:35:59.699" v="3260" actId="478"/>
          <ac:grpSpMkLst>
            <pc:docMk/>
            <pc:sldMk cId="1020235566" sldId="323"/>
            <ac:grpSpMk id="4" creationId="{F5423992-F8A2-D828-1228-6E48F90FA37B}"/>
          </ac:grpSpMkLst>
        </pc:grpChg>
        <pc:grpChg chg="add mod">
          <ac:chgData name="Kumar, Vinod" userId="a0710a6e-bffc-4971-8893-1c23addeb5b0" providerId="ADAL" clId="{F5D6EA11-585F-4AA1-B279-75820FE30650}" dt="2023-01-12T15:41:14.017" v="3608" actId="1036"/>
          <ac:grpSpMkLst>
            <pc:docMk/>
            <pc:sldMk cId="1020235566" sldId="323"/>
            <ac:grpSpMk id="7" creationId="{966FCA75-8B23-CEF7-B07A-2BDAB313E768}"/>
          </ac:grpSpMkLst>
        </pc:grpChg>
        <pc:picChg chg="mod modCrop">
          <ac:chgData name="Kumar, Vinod" userId="a0710a6e-bffc-4971-8893-1c23addeb5b0" providerId="ADAL" clId="{F5D6EA11-585F-4AA1-B279-75820FE30650}" dt="2023-01-12T15:42:08.224" v="3644" actId="1037"/>
          <ac:picMkLst>
            <pc:docMk/>
            <pc:sldMk cId="1020235566" sldId="323"/>
            <ac:picMk id="5" creationId="{F8F87060-6BCF-CF01-5575-90A3595A3A48}"/>
          </ac:picMkLst>
        </pc:picChg>
        <pc:picChg chg="add mod">
          <ac:chgData name="Kumar, Vinod" userId="a0710a6e-bffc-4971-8893-1c23addeb5b0" providerId="ADAL" clId="{F5D6EA11-585F-4AA1-B279-75820FE30650}" dt="2023-01-12T15:36:14.915" v="3358" actId="1037"/>
          <ac:picMkLst>
            <pc:docMk/>
            <pc:sldMk cId="1020235566" sldId="323"/>
            <ac:picMk id="6" creationId="{362EC1FD-45C3-9B1F-17DF-EBE95777600F}"/>
          </ac:picMkLst>
        </pc:picChg>
        <pc:picChg chg="del">
          <ac:chgData name="Kumar, Vinod" userId="a0710a6e-bffc-4971-8893-1c23addeb5b0" providerId="ADAL" clId="{F5D6EA11-585F-4AA1-B279-75820FE30650}" dt="2023-01-12T15:38:32.194" v="3359" actId="478"/>
          <ac:picMkLst>
            <pc:docMk/>
            <pc:sldMk cId="1020235566" sldId="323"/>
            <ac:picMk id="9" creationId="{300ECDCE-7793-035A-4A52-E598C369621D}"/>
          </ac:picMkLst>
        </pc:picChg>
        <pc:picChg chg="mod modCrop">
          <ac:chgData name="Kumar, Vinod" userId="a0710a6e-bffc-4971-8893-1c23addeb5b0" providerId="ADAL" clId="{F5D6EA11-585F-4AA1-B279-75820FE30650}" dt="2023-01-12T15:41:45.584" v="3629" actId="1037"/>
          <ac:picMkLst>
            <pc:docMk/>
            <pc:sldMk cId="1020235566" sldId="323"/>
            <ac:picMk id="10" creationId="{F694DA6C-4FFF-B896-71AE-D2FE03F46AAF}"/>
          </ac:picMkLst>
        </pc:picChg>
        <pc:picChg chg="mod">
          <ac:chgData name="Kumar, Vinod" userId="a0710a6e-bffc-4971-8893-1c23addeb5b0" providerId="ADAL" clId="{F5D6EA11-585F-4AA1-B279-75820FE30650}" dt="2023-01-12T15:41:54.096" v="3643" actId="1036"/>
          <ac:picMkLst>
            <pc:docMk/>
            <pc:sldMk cId="1020235566" sldId="323"/>
            <ac:picMk id="11" creationId="{825455C6-07A7-ED30-3A78-8B334C2C3A9A}"/>
          </ac:picMkLst>
        </pc:picChg>
        <pc:picChg chg="mod">
          <ac:chgData name="Kumar, Vinod" userId="a0710a6e-bffc-4971-8893-1c23addeb5b0" providerId="ADAL" clId="{F5D6EA11-585F-4AA1-B279-75820FE30650}" dt="2023-01-12T15:35:42.807" v="3136"/>
          <ac:picMkLst>
            <pc:docMk/>
            <pc:sldMk cId="1020235566" sldId="323"/>
            <ac:picMk id="12" creationId="{1E6B7149-4971-7F33-2910-4FB341CD5A43}"/>
          </ac:picMkLst>
        </pc:picChg>
        <pc:picChg chg="del">
          <ac:chgData name="Kumar, Vinod" userId="a0710a6e-bffc-4971-8893-1c23addeb5b0" providerId="ADAL" clId="{F5D6EA11-585F-4AA1-B279-75820FE30650}" dt="2023-01-12T15:33:26.232" v="2855" actId="478"/>
          <ac:picMkLst>
            <pc:docMk/>
            <pc:sldMk cId="1020235566" sldId="323"/>
            <ac:picMk id="33" creationId="{006ED6EC-B6C0-F620-73A7-9787FCB0810A}"/>
          </ac:picMkLst>
        </pc:picChg>
        <pc:picChg chg="mod">
          <ac:chgData name="Kumar, Vinod" userId="a0710a6e-bffc-4971-8893-1c23addeb5b0" providerId="ADAL" clId="{F5D6EA11-585F-4AA1-B279-75820FE30650}" dt="2023-01-12T15:40:59.984" v="3606" actId="1037"/>
          <ac:picMkLst>
            <pc:docMk/>
            <pc:sldMk cId="1020235566" sldId="323"/>
            <ac:picMk id="34" creationId="{94187F1D-53CC-E202-F758-BF0BB2346A09}"/>
          </ac:picMkLst>
        </pc:picChg>
      </pc:sldChg>
      <pc:sldChg chg="addSp delSp modSp new mod">
        <pc:chgData name="Kumar, Vinod" userId="a0710a6e-bffc-4971-8893-1c23addeb5b0" providerId="ADAL" clId="{F5D6EA11-585F-4AA1-B279-75820FE30650}" dt="2023-01-12T22:13:30.289" v="4355" actId="1076"/>
        <pc:sldMkLst>
          <pc:docMk/>
          <pc:sldMk cId="695438752" sldId="324"/>
        </pc:sldMkLst>
        <pc:spChg chg="del">
          <ac:chgData name="Kumar, Vinod" userId="a0710a6e-bffc-4971-8893-1c23addeb5b0" providerId="ADAL" clId="{F5D6EA11-585F-4AA1-B279-75820FE30650}" dt="2023-01-12T22:12:34.706" v="4317" actId="478"/>
          <ac:spMkLst>
            <pc:docMk/>
            <pc:sldMk cId="695438752" sldId="324"/>
            <ac:spMk id="2" creationId="{E44CF948-D99F-EC77-02C9-E1090C078C25}"/>
          </ac:spMkLst>
        </pc:spChg>
        <pc:spChg chg="del">
          <ac:chgData name="Kumar, Vinod" userId="a0710a6e-bffc-4971-8893-1c23addeb5b0" providerId="ADAL" clId="{F5D6EA11-585F-4AA1-B279-75820FE30650}" dt="2023-01-12T22:12:36.236" v="4318" actId="478"/>
          <ac:spMkLst>
            <pc:docMk/>
            <pc:sldMk cId="695438752" sldId="324"/>
            <ac:spMk id="3" creationId="{4FEEEB12-1750-E6F7-1375-9FA6F4836883}"/>
          </ac:spMkLst>
        </pc:spChg>
        <pc:spChg chg="add mod">
          <ac:chgData name="Kumar, Vinod" userId="a0710a6e-bffc-4971-8893-1c23addeb5b0" providerId="ADAL" clId="{F5D6EA11-585F-4AA1-B279-75820FE30650}" dt="2023-01-12T22:12:54.692" v="4320" actId="20577"/>
          <ac:spMkLst>
            <pc:docMk/>
            <pc:sldMk cId="695438752" sldId="324"/>
            <ac:spMk id="4" creationId="{94CDFF40-B4A3-8581-A3D6-E06309630A95}"/>
          </ac:spMkLst>
        </pc:spChg>
        <pc:spChg chg="add mod">
          <ac:chgData name="Kumar, Vinod" userId="a0710a6e-bffc-4971-8893-1c23addeb5b0" providerId="ADAL" clId="{F5D6EA11-585F-4AA1-B279-75820FE30650}" dt="2023-01-12T22:13:30.289" v="4355" actId="1076"/>
          <ac:spMkLst>
            <pc:docMk/>
            <pc:sldMk cId="695438752" sldId="324"/>
            <ac:spMk id="5" creationId="{BA846168-C0A2-A036-1B00-A23719D654F1}"/>
          </ac:spMkLst>
        </pc:spChg>
      </pc:sldChg>
      <pc:sldChg chg="addSp delSp modSp add mod">
        <pc:chgData name="Kumar, Vinod" userId="a0710a6e-bffc-4971-8893-1c23addeb5b0" providerId="ADAL" clId="{F5D6EA11-585F-4AA1-B279-75820FE30650}" dt="2023-01-20T20:44:55.585" v="5118" actId="478"/>
        <pc:sldMkLst>
          <pc:docMk/>
          <pc:sldMk cId="2174313281" sldId="325"/>
        </pc:sldMkLst>
        <pc:spChg chg="mod">
          <ac:chgData name="Kumar, Vinod" userId="a0710a6e-bffc-4971-8893-1c23addeb5b0" providerId="ADAL" clId="{F5D6EA11-585F-4AA1-B279-75820FE30650}" dt="2023-01-20T20:35:12.789" v="4868" actId="1035"/>
          <ac:spMkLst>
            <pc:docMk/>
            <pc:sldMk cId="2174313281" sldId="325"/>
            <ac:spMk id="2" creationId="{086F389C-2B07-5F00-EA2A-17A9729D565C}"/>
          </ac:spMkLst>
        </pc:spChg>
        <pc:spChg chg="add mod">
          <ac:chgData name="Kumar, Vinod" userId="a0710a6e-bffc-4971-8893-1c23addeb5b0" providerId="ADAL" clId="{F5D6EA11-585F-4AA1-B279-75820FE30650}" dt="2023-01-20T20:40:18.014" v="5116" actId="164"/>
          <ac:spMkLst>
            <pc:docMk/>
            <pc:sldMk cId="2174313281" sldId="325"/>
            <ac:spMk id="19" creationId="{F02BF4F5-7A71-B45C-75F9-52E35D04E053}"/>
          </ac:spMkLst>
        </pc:spChg>
        <pc:spChg chg="add mod">
          <ac:chgData name="Kumar, Vinod" userId="a0710a6e-bffc-4971-8893-1c23addeb5b0" providerId="ADAL" clId="{F5D6EA11-585F-4AA1-B279-75820FE30650}" dt="2023-01-20T20:32:44.852" v="4819" actId="164"/>
          <ac:spMkLst>
            <pc:docMk/>
            <pc:sldMk cId="2174313281" sldId="325"/>
            <ac:spMk id="20" creationId="{3AFD755A-AEF9-D96E-D1C0-89AC7E454E41}"/>
          </ac:spMkLst>
        </pc:spChg>
        <pc:spChg chg="add del mod">
          <ac:chgData name="Kumar, Vinod" userId="a0710a6e-bffc-4971-8893-1c23addeb5b0" providerId="ADAL" clId="{F5D6EA11-585F-4AA1-B279-75820FE30650}" dt="2023-01-20T20:29:32.761" v="4689" actId="478"/>
          <ac:spMkLst>
            <pc:docMk/>
            <pc:sldMk cId="2174313281" sldId="325"/>
            <ac:spMk id="21" creationId="{5415DA6F-8142-E1F1-5F14-7E1CD8C7B50D}"/>
          </ac:spMkLst>
        </pc:spChg>
        <pc:spChg chg="mod">
          <ac:chgData name="Kumar, Vinod" userId="a0710a6e-bffc-4971-8893-1c23addeb5b0" providerId="ADAL" clId="{F5D6EA11-585F-4AA1-B279-75820FE30650}" dt="2023-01-20T20:34:05.350" v="4864" actId="1036"/>
          <ac:spMkLst>
            <pc:docMk/>
            <pc:sldMk cId="2174313281" sldId="325"/>
            <ac:spMk id="24" creationId="{2CB71B04-41F5-163C-2C79-A3B7B287BD9C}"/>
          </ac:spMkLst>
        </pc:spChg>
        <pc:spChg chg="del">
          <ac:chgData name="Kumar, Vinod" userId="a0710a6e-bffc-4971-8893-1c23addeb5b0" providerId="ADAL" clId="{F5D6EA11-585F-4AA1-B279-75820FE30650}" dt="2023-01-20T20:27:28.643" v="4623" actId="478"/>
          <ac:spMkLst>
            <pc:docMk/>
            <pc:sldMk cId="2174313281" sldId="325"/>
            <ac:spMk id="27" creationId="{45B27FF7-15E8-87DE-69F0-B6032DD8E302}"/>
          </ac:spMkLst>
        </pc:spChg>
        <pc:spChg chg="add mod">
          <ac:chgData name="Kumar, Vinod" userId="a0710a6e-bffc-4971-8893-1c23addeb5b0" providerId="ADAL" clId="{F5D6EA11-585F-4AA1-B279-75820FE30650}" dt="2023-01-20T20:39:00.259" v="4970" actId="20577"/>
          <ac:spMkLst>
            <pc:docMk/>
            <pc:sldMk cId="2174313281" sldId="325"/>
            <ac:spMk id="29" creationId="{269DF814-DAB2-98E2-0E08-18EEFE2AFC8C}"/>
          </ac:spMkLst>
        </pc:spChg>
        <pc:spChg chg="add mod">
          <ac:chgData name="Kumar, Vinod" userId="a0710a6e-bffc-4971-8893-1c23addeb5b0" providerId="ADAL" clId="{F5D6EA11-585F-4AA1-B279-75820FE30650}" dt="2023-01-20T20:39:23.540" v="5063" actId="20577"/>
          <ac:spMkLst>
            <pc:docMk/>
            <pc:sldMk cId="2174313281" sldId="325"/>
            <ac:spMk id="30" creationId="{50DB452C-CE39-CD4E-F45B-7F29D3F8A96D}"/>
          </ac:spMkLst>
        </pc:spChg>
        <pc:spChg chg="add mod">
          <ac:chgData name="Kumar, Vinod" userId="a0710a6e-bffc-4971-8893-1c23addeb5b0" providerId="ADAL" clId="{F5D6EA11-585F-4AA1-B279-75820FE30650}" dt="2023-01-20T20:39:41.412" v="5101" actId="20577"/>
          <ac:spMkLst>
            <pc:docMk/>
            <pc:sldMk cId="2174313281" sldId="325"/>
            <ac:spMk id="31" creationId="{32369EA7-91A1-B978-658F-DE9F18BE0ECA}"/>
          </ac:spMkLst>
        </pc:spChg>
        <pc:spChg chg="mod">
          <ac:chgData name="Kumar, Vinod" userId="a0710a6e-bffc-4971-8893-1c23addeb5b0" providerId="ADAL" clId="{F5D6EA11-585F-4AA1-B279-75820FE30650}" dt="2023-01-20T20:40:22.589" v="5117" actId="164"/>
          <ac:spMkLst>
            <pc:docMk/>
            <pc:sldMk cId="2174313281" sldId="325"/>
            <ac:spMk id="34" creationId="{A40DE553-6E10-0460-7D7D-46ACDCD58D3F}"/>
          </ac:spMkLst>
        </pc:spChg>
        <pc:spChg chg="mod">
          <ac:chgData name="Kumar, Vinod" userId="a0710a6e-bffc-4971-8893-1c23addeb5b0" providerId="ADAL" clId="{F5D6EA11-585F-4AA1-B279-75820FE30650}" dt="2023-01-20T20:32:44.852" v="4819" actId="164"/>
          <ac:spMkLst>
            <pc:docMk/>
            <pc:sldMk cId="2174313281" sldId="325"/>
            <ac:spMk id="48" creationId="{9C0A8C2F-F8D9-CDC4-90DB-A853D6A6D490}"/>
          </ac:spMkLst>
        </pc:spChg>
        <pc:spChg chg="mod">
          <ac:chgData name="Kumar, Vinod" userId="a0710a6e-bffc-4971-8893-1c23addeb5b0" providerId="ADAL" clId="{F5D6EA11-585F-4AA1-B279-75820FE30650}" dt="2023-01-20T20:32:44.852" v="4819" actId="164"/>
          <ac:spMkLst>
            <pc:docMk/>
            <pc:sldMk cId="2174313281" sldId="325"/>
            <ac:spMk id="49" creationId="{4D5C34F6-7B32-C42F-9835-65C4AEB72979}"/>
          </ac:spMkLst>
        </pc:spChg>
        <pc:spChg chg="mod">
          <ac:chgData name="Kumar, Vinod" userId="a0710a6e-bffc-4971-8893-1c23addeb5b0" providerId="ADAL" clId="{F5D6EA11-585F-4AA1-B279-75820FE30650}" dt="2023-01-20T20:33:55.174" v="4860" actId="1037"/>
          <ac:spMkLst>
            <pc:docMk/>
            <pc:sldMk cId="2174313281" sldId="325"/>
            <ac:spMk id="50" creationId="{D2DAD5DD-CE35-E82A-55C0-A56182096E73}"/>
          </ac:spMkLst>
        </pc:spChg>
        <pc:spChg chg="mod">
          <ac:chgData name="Kumar, Vinod" userId="a0710a6e-bffc-4971-8893-1c23addeb5b0" providerId="ADAL" clId="{F5D6EA11-585F-4AA1-B279-75820FE30650}" dt="2023-01-20T20:39:49.444" v="5102" actId="20577"/>
          <ac:spMkLst>
            <pc:docMk/>
            <pc:sldMk cId="2174313281" sldId="325"/>
            <ac:spMk id="56" creationId="{ABA256FF-FF80-1424-2C8A-024D97CA5E11}"/>
          </ac:spMkLst>
        </pc:spChg>
        <pc:spChg chg="mod">
          <ac:chgData name="Kumar, Vinod" userId="a0710a6e-bffc-4971-8893-1c23addeb5b0" providerId="ADAL" clId="{F5D6EA11-585F-4AA1-B279-75820FE30650}" dt="2023-01-20T20:39:53.252" v="5103" actId="20577"/>
          <ac:spMkLst>
            <pc:docMk/>
            <pc:sldMk cId="2174313281" sldId="325"/>
            <ac:spMk id="57" creationId="{7EAF74B5-4114-AE6D-87DB-84F7280CD5BB}"/>
          </ac:spMkLst>
        </pc:spChg>
        <pc:grpChg chg="add mod">
          <ac:chgData name="Kumar, Vinod" userId="a0710a6e-bffc-4971-8893-1c23addeb5b0" providerId="ADAL" clId="{F5D6EA11-585F-4AA1-B279-75820FE30650}" dt="2023-01-20T20:32:55.799" v="4824" actId="1035"/>
          <ac:grpSpMkLst>
            <pc:docMk/>
            <pc:sldMk cId="2174313281" sldId="325"/>
            <ac:grpSpMk id="28" creationId="{973C3DA5-6F23-9A10-883D-81D1DB306F18}"/>
          </ac:grpSpMkLst>
        </pc:grpChg>
        <pc:grpChg chg="add mod">
          <ac:chgData name="Kumar, Vinod" userId="a0710a6e-bffc-4971-8893-1c23addeb5b0" providerId="ADAL" clId="{F5D6EA11-585F-4AA1-B279-75820FE30650}" dt="2023-01-20T20:40:18.014" v="5116" actId="164"/>
          <ac:grpSpMkLst>
            <pc:docMk/>
            <pc:sldMk cId="2174313281" sldId="325"/>
            <ac:grpSpMk id="32" creationId="{5838A9AC-0DE5-2292-E5E8-7F3E7B1AE9AD}"/>
          </ac:grpSpMkLst>
        </pc:grpChg>
        <pc:grpChg chg="add mod">
          <ac:chgData name="Kumar, Vinod" userId="a0710a6e-bffc-4971-8893-1c23addeb5b0" providerId="ADAL" clId="{F5D6EA11-585F-4AA1-B279-75820FE30650}" dt="2023-01-20T20:40:22.589" v="5117" actId="164"/>
          <ac:grpSpMkLst>
            <pc:docMk/>
            <pc:sldMk cId="2174313281" sldId="325"/>
            <ac:grpSpMk id="33" creationId="{AD5AE7ED-E357-6749-DAAD-FAA604CDB79A}"/>
          </ac:grpSpMkLst>
        </pc:grpChg>
        <pc:picChg chg="add del mod">
          <ac:chgData name="Kumar, Vinod" userId="a0710a6e-bffc-4971-8893-1c23addeb5b0" providerId="ADAL" clId="{F5D6EA11-585F-4AA1-B279-75820FE30650}" dt="2023-01-20T20:44:55.585" v="5118" actId="478"/>
          <ac:picMkLst>
            <pc:docMk/>
            <pc:sldMk cId="2174313281" sldId="325"/>
            <ac:picMk id="3" creationId="{62BC7BD4-061F-BE9E-6A1E-9EE3D231D963}"/>
          </ac:picMkLst>
        </pc:picChg>
        <pc:picChg chg="mod">
          <ac:chgData name="Kumar, Vinod" userId="a0710a6e-bffc-4971-8893-1c23addeb5b0" providerId="ADAL" clId="{F5D6EA11-585F-4AA1-B279-75820FE30650}" dt="2023-01-20T20:40:22.589" v="5117" actId="164"/>
          <ac:picMkLst>
            <pc:docMk/>
            <pc:sldMk cId="2174313281" sldId="325"/>
            <ac:picMk id="13" creationId="{2E681331-78BB-750C-D0C0-74379A16FE2B}"/>
          </ac:picMkLst>
        </pc:picChg>
        <pc:picChg chg="add del mod">
          <ac:chgData name="Kumar, Vinod" userId="a0710a6e-bffc-4971-8893-1c23addeb5b0" providerId="ADAL" clId="{F5D6EA11-585F-4AA1-B279-75820FE30650}" dt="2023-01-20T20:44:55.585" v="5118" actId="478"/>
          <ac:picMkLst>
            <pc:docMk/>
            <pc:sldMk cId="2174313281" sldId="325"/>
            <ac:picMk id="14" creationId="{99FA570B-F9DC-57E3-04C1-3201542CE31B}"/>
          </ac:picMkLst>
        </pc:picChg>
        <pc:picChg chg="add del mod">
          <ac:chgData name="Kumar, Vinod" userId="a0710a6e-bffc-4971-8893-1c23addeb5b0" providerId="ADAL" clId="{F5D6EA11-585F-4AA1-B279-75820FE30650}" dt="2023-01-20T20:44:55.585" v="5118" actId="478"/>
          <ac:picMkLst>
            <pc:docMk/>
            <pc:sldMk cId="2174313281" sldId="325"/>
            <ac:picMk id="15" creationId="{DBE8C995-CCD2-582B-9832-73D7ADB3C2F4}"/>
          </ac:picMkLst>
        </pc:picChg>
        <pc:picChg chg="add del mod">
          <ac:chgData name="Kumar, Vinod" userId="a0710a6e-bffc-4971-8893-1c23addeb5b0" providerId="ADAL" clId="{F5D6EA11-585F-4AA1-B279-75820FE30650}" dt="2023-01-20T20:44:55.585" v="5118" actId="478"/>
          <ac:picMkLst>
            <pc:docMk/>
            <pc:sldMk cId="2174313281" sldId="325"/>
            <ac:picMk id="16" creationId="{35D47C41-2495-7237-B6E5-11FC7489B098}"/>
          </ac:picMkLst>
        </pc:picChg>
        <pc:picChg chg="mod">
          <ac:chgData name="Kumar, Vinod" userId="a0710a6e-bffc-4971-8893-1c23addeb5b0" providerId="ADAL" clId="{F5D6EA11-585F-4AA1-B279-75820FE30650}" dt="2023-01-20T20:32:44.852" v="4819" actId="164"/>
          <ac:picMkLst>
            <pc:docMk/>
            <pc:sldMk cId="2174313281" sldId="325"/>
            <ac:picMk id="17" creationId="{5376E2E1-A22A-97F3-BDB1-10AC6EF54305}"/>
          </ac:picMkLst>
        </pc:picChg>
        <pc:picChg chg="add mod">
          <ac:chgData name="Kumar, Vinod" userId="a0710a6e-bffc-4971-8893-1c23addeb5b0" providerId="ADAL" clId="{F5D6EA11-585F-4AA1-B279-75820FE30650}" dt="2023-01-20T20:40:18.014" v="5116" actId="164"/>
          <ac:picMkLst>
            <pc:docMk/>
            <pc:sldMk cId="2174313281" sldId="325"/>
            <ac:picMk id="18" creationId="{CA3BFF81-E993-560B-1E0E-960608807224}"/>
          </ac:picMkLst>
        </pc:picChg>
        <pc:picChg chg="del">
          <ac:chgData name="Kumar, Vinod" userId="a0710a6e-bffc-4971-8893-1c23addeb5b0" providerId="ADAL" clId="{F5D6EA11-585F-4AA1-B279-75820FE30650}" dt="2023-01-20T20:27:28.643" v="4623" actId="478"/>
          <ac:picMkLst>
            <pc:docMk/>
            <pc:sldMk cId="2174313281" sldId="325"/>
            <ac:picMk id="26" creationId="{49CEA3E8-0B46-054A-907F-8D68EEF930AF}"/>
          </ac:picMkLst>
        </pc:picChg>
        <pc:picChg chg="del">
          <ac:chgData name="Kumar, Vinod" userId="a0710a6e-bffc-4971-8893-1c23addeb5b0" providerId="ADAL" clId="{F5D6EA11-585F-4AA1-B279-75820FE30650}" dt="2023-01-20T20:27:43.962" v="4625" actId="478"/>
          <ac:picMkLst>
            <pc:docMk/>
            <pc:sldMk cId="2174313281" sldId="325"/>
            <ac:picMk id="46" creationId="{77007D5B-7A46-298E-0459-207AB0020D3F}"/>
          </ac:picMkLst>
        </pc:picChg>
        <pc:picChg chg="del">
          <ac:chgData name="Kumar, Vinod" userId="a0710a6e-bffc-4971-8893-1c23addeb5b0" providerId="ADAL" clId="{F5D6EA11-585F-4AA1-B279-75820FE30650}" dt="2023-01-20T20:27:43.962" v="4625" actId="478"/>
          <ac:picMkLst>
            <pc:docMk/>
            <pc:sldMk cId="2174313281" sldId="325"/>
            <ac:picMk id="47" creationId="{B0A8E4C3-F008-9B2A-077E-C0B4E3FC4DBC}"/>
          </ac:picMkLst>
        </pc:picChg>
        <pc:cxnChg chg="del mod">
          <ac:chgData name="Kumar, Vinod" userId="a0710a6e-bffc-4971-8893-1c23addeb5b0" providerId="ADAL" clId="{F5D6EA11-585F-4AA1-B279-75820FE30650}" dt="2023-01-20T20:38:14.885" v="4896" actId="478"/>
          <ac:cxnSpMkLst>
            <pc:docMk/>
            <pc:sldMk cId="2174313281" sldId="325"/>
            <ac:cxnSpMk id="12" creationId="{51F9F63A-0D44-641C-CF9A-582577C69D78}"/>
          </ac:cxnSpMkLst>
        </pc:cxnChg>
        <pc:cxnChg chg="add mod">
          <ac:chgData name="Kumar, Vinod" userId="a0710a6e-bffc-4971-8893-1c23addeb5b0" providerId="ADAL" clId="{F5D6EA11-585F-4AA1-B279-75820FE30650}" dt="2023-01-20T20:33:39.159" v="4859" actId="1038"/>
          <ac:cxnSpMkLst>
            <pc:docMk/>
            <pc:sldMk cId="2174313281" sldId="325"/>
            <ac:cxnSpMk id="23" creationId="{8FFA2FAD-500C-F3A6-EEC7-732A024C8F69}"/>
          </ac:cxnSpMkLst>
        </pc:cxnChg>
      </pc:sldChg>
      <pc:sldChg chg="addSp modSp new mod">
        <pc:chgData name="Kumar, Vinod" userId="a0710a6e-bffc-4971-8893-1c23addeb5b0" providerId="ADAL" clId="{F5D6EA11-585F-4AA1-B279-75820FE30650}" dt="2023-01-25T21:14:42.049" v="5129" actId="20577"/>
        <pc:sldMkLst>
          <pc:docMk/>
          <pc:sldMk cId="215799928" sldId="326"/>
        </pc:sldMkLst>
        <pc:spChg chg="add mod">
          <ac:chgData name="Kumar, Vinod" userId="a0710a6e-bffc-4971-8893-1c23addeb5b0" providerId="ADAL" clId="{F5D6EA11-585F-4AA1-B279-75820FE30650}" dt="2023-01-25T21:14:42.049" v="5129" actId="20577"/>
          <ac:spMkLst>
            <pc:docMk/>
            <pc:sldMk cId="215799928" sldId="326"/>
            <ac:spMk id="3" creationId="{0FCD93AF-30D8-D969-BC97-A2C54895EFE1}"/>
          </ac:spMkLst>
        </pc:spChg>
        <pc:picChg chg="add mod">
          <ac:chgData name="Kumar, Vinod" userId="a0710a6e-bffc-4971-8893-1c23addeb5b0" providerId="ADAL" clId="{F5D6EA11-585F-4AA1-B279-75820FE30650}" dt="2023-01-25T21:14:18.535" v="5127" actId="1076"/>
          <ac:picMkLst>
            <pc:docMk/>
            <pc:sldMk cId="215799928" sldId="326"/>
            <ac:picMk id="2" creationId="{05E6B2A6-AA6B-A3CE-D08B-B1D83B87DEC6}"/>
          </ac:picMkLst>
        </pc:picChg>
      </pc:sldChg>
    </pc:docChg>
  </pc:docChgLst>
  <pc:docChgLst>
    <pc:chgData name="Kumar, Vinod" userId="a0710a6e-bffc-4971-8893-1c23addeb5b0" providerId="ADAL" clId="{804748DF-446B-437F-AFFB-E1B8A8B41FF1}"/>
    <pc:docChg chg="undo redo custSel addSld delSld modSld">
      <pc:chgData name="Kumar, Vinod" userId="a0710a6e-bffc-4971-8893-1c23addeb5b0" providerId="ADAL" clId="{804748DF-446B-437F-AFFB-E1B8A8B41FF1}" dt="2023-02-06T16:52:33.638" v="8290" actId="1076"/>
      <pc:docMkLst>
        <pc:docMk/>
      </pc:docMkLst>
      <pc:sldChg chg="del">
        <pc:chgData name="Kumar, Vinod" userId="a0710a6e-bffc-4971-8893-1c23addeb5b0" providerId="ADAL" clId="{804748DF-446B-437F-AFFB-E1B8A8B41FF1}" dt="2023-01-26T18:35:02.985" v="1" actId="47"/>
        <pc:sldMkLst>
          <pc:docMk/>
          <pc:sldMk cId="2313405284" sldId="300"/>
        </pc:sldMkLst>
      </pc:sldChg>
      <pc:sldChg chg="del">
        <pc:chgData name="Kumar, Vinod" userId="a0710a6e-bffc-4971-8893-1c23addeb5b0" providerId="ADAL" clId="{804748DF-446B-437F-AFFB-E1B8A8B41FF1}" dt="2023-01-26T18:34:57.813" v="0" actId="47"/>
        <pc:sldMkLst>
          <pc:docMk/>
          <pc:sldMk cId="2794359920" sldId="303"/>
        </pc:sldMkLst>
      </pc:sldChg>
      <pc:sldChg chg="del">
        <pc:chgData name="Kumar, Vinod" userId="a0710a6e-bffc-4971-8893-1c23addeb5b0" providerId="ADAL" clId="{804748DF-446B-437F-AFFB-E1B8A8B41FF1}" dt="2023-01-26T18:35:09.726" v="3" actId="47"/>
        <pc:sldMkLst>
          <pc:docMk/>
          <pc:sldMk cId="1231753045" sldId="306"/>
        </pc:sldMkLst>
      </pc:sldChg>
      <pc:sldChg chg="del">
        <pc:chgData name="Kumar, Vinod" userId="a0710a6e-bffc-4971-8893-1c23addeb5b0" providerId="ADAL" clId="{804748DF-446B-437F-AFFB-E1B8A8B41FF1}" dt="2023-01-26T18:35:02.985" v="1" actId="47"/>
        <pc:sldMkLst>
          <pc:docMk/>
          <pc:sldMk cId="1809220692" sldId="307"/>
        </pc:sldMkLst>
      </pc:sldChg>
      <pc:sldChg chg="del">
        <pc:chgData name="Kumar, Vinod" userId="a0710a6e-bffc-4971-8893-1c23addeb5b0" providerId="ADAL" clId="{804748DF-446B-437F-AFFB-E1B8A8B41FF1}" dt="2023-01-26T18:34:57.813" v="0" actId="47"/>
        <pc:sldMkLst>
          <pc:docMk/>
          <pc:sldMk cId="1021580243" sldId="311"/>
        </pc:sldMkLst>
      </pc:sldChg>
      <pc:sldChg chg="del">
        <pc:chgData name="Kumar, Vinod" userId="a0710a6e-bffc-4971-8893-1c23addeb5b0" providerId="ADAL" clId="{804748DF-446B-437F-AFFB-E1B8A8B41FF1}" dt="2023-01-26T18:35:06.715" v="2" actId="47"/>
        <pc:sldMkLst>
          <pc:docMk/>
          <pc:sldMk cId="2814613315" sldId="313"/>
        </pc:sldMkLst>
      </pc:sldChg>
      <pc:sldChg chg="del">
        <pc:chgData name="Kumar, Vinod" userId="a0710a6e-bffc-4971-8893-1c23addeb5b0" providerId="ADAL" clId="{804748DF-446B-437F-AFFB-E1B8A8B41FF1}" dt="2023-01-26T18:35:06.715" v="2" actId="47"/>
        <pc:sldMkLst>
          <pc:docMk/>
          <pc:sldMk cId="2551874591" sldId="314"/>
        </pc:sldMkLst>
      </pc:sldChg>
      <pc:sldChg chg="del">
        <pc:chgData name="Kumar, Vinod" userId="a0710a6e-bffc-4971-8893-1c23addeb5b0" providerId="ADAL" clId="{804748DF-446B-437F-AFFB-E1B8A8B41FF1}" dt="2023-01-26T18:35:09.726" v="3" actId="47"/>
        <pc:sldMkLst>
          <pc:docMk/>
          <pc:sldMk cId="2153520942" sldId="315"/>
        </pc:sldMkLst>
      </pc:sldChg>
      <pc:sldChg chg="del">
        <pc:chgData name="Kumar, Vinod" userId="a0710a6e-bffc-4971-8893-1c23addeb5b0" providerId="ADAL" clId="{804748DF-446B-437F-AFFB-E1B8A8B41FF1}" dt="2023-01-26T18:35:09.726" v="3" actId="47"/>
        <pc:sldMkLst>
          <pc:docMk/>
          <pc:sldMk cId="2051417108" sldId="316"/>
        </pc:sldMkLst>
      </pc:sldChg>
      <pc:sldChg chg="del">
        <pc:chgData name="Kumar, Vinod" userId="a0710a6e-bffc-4971-8893-1c23addeb5b0" providerId="ADAL" clId="{804748DF-446B-437F-AFFB-E1B8A8B41FF1}" dt="2023-01-26T18:35:02.985" v="1" actId="47"/>
        <pc:sldMkLst>
          <pc:docMk/>
          <pc:sldMk cId="240031287" sldId="317"/>
        </pc:sldMkLst>
      </pc:sldChg>
      <pc:sldChg chg="del">
        <pc:chgData name="Kumar, Vinod" userId="a0710a6e-bffc-4971-8893-1c23addeb5b0" providerId="ADAL" clId="{804748DF-446B-437F-AFFB-E1B8A8B41FF1}" dt="2023-01-26T18:35:06.715" v="2" actId="47"/>
        <pc:sldMkLst>
          <pc:docMk/>
          <pc:sldMk cId="2842090847" sldId="320"/>
        </pc:sldMkLst>
      </pc:sldChg>
      <pc:sldChg chg="del">
        <pc:chgData name="Kumar, Vinod" userId="a0710a6e-bffc-4971-8893-1c23addeb5b0" providerId="ADAL" clId="{804748DF-446B-437F-AFFB-E1B8A8B41FF1}" dt="2023-01-26T18:34:57.813" v="0" actId="47"/>
        <pc:sldMkLst>
          <pc:docMk/>
          <pc:sldMk cId="2665136248" sldId="321"/>
        </pc:sldMkLst>
      </pc:sldChg>
      <pc:sldChg chg="del">
        <pc:chgData name="Kumar, Vinod" userId="a0710a6e-bffc-4971-8893-1c23addeb5b0" providerId="ADAL" clId="{804748DF-446B-437F-AFFB-E1B8A8B41FF1}" dt="2023-01-26T18:34:57.813" v="0" actId="47"/>
        <pc:sldMkLst>
          <pc:docMk/>
          <pc:sldMk cId="4037451339" sldId="322"/>
        </pc:sldMkLst>
      </pc:sldChg>
      <pc:sldChg chg="del">
        <pc:chgData name="Kumar, Vinod" userId="a0710a6e-bffc-4971-8893-1c23addeb5b0" providerId="ADAL" clId="{804748DF-446B-437F-AFFB-E1B8A8B41FF1}" dt="2023-01-26T18:34:57.813" v="0" actId="47"/>
        <pc:sldMkLst>
          <pc:docMk/>
          <pc:sldMk cId="1020235566" sldId="323"/>
        </pc:sldMkLst>
      </pc:sldChg>
      <pc:sldChg chg="del">
        <pc:chgData name="Kumar, Vinod" userId="a0710a6e-bffc-4971-8893-1c23addeb5b0" providerId="ADAL" clId="{804748DF-446B-437F-AFFB-E1B8A8B41FF1}" dt="2023-01-26T18:35:02.985" v="1" actId="47"/>
        <pc:sldMkLst>
          <pc:docMk/>
          <pc:sldMk cId="695438752" sldId="324"/>
        </pc:sldMkLst>
      </pc:sldChg>
      <pc:sldChg chg="del">
        <pc:chgData name="Kumar, Vinod" userId="a0710a6e-bffc-4971-8893-1c23addeb5b0" providerId="ADAL" clId="{804748DF-446B-437F-AFFB-E1B8A8B41FF1}" dt="2023-01-26T18:35:49.394" v="4" actId="47"/>
        <pc:sldMkLst>
          <pc:docMk/>
          <pc:sldMk cId="2174313281" sldId="325"/>
        </pc:sldMkLst>
      </pc:sldChg>
      <pc:sldChg chg="addSp delSp modSp del mod">
        <pc:chgData name="Kumar, Vinod" userId="a0710a6e-bffc-4971-8893-1c23addeb5b0" providerId="ADAL" clId="{804748DF-446B-437F-AFFB-E1B8A8B41FF1}" dt="2023-01-31T20:02:48.345" v="5665" actId="47"/>
        <pc:sldMkLst>
          <pc:docMk/>
          <pc:sldMk cId="215799928" sldId="326"/>
        </pc:sldMkLst>
        <pc:spChg chg="del">
          <ac:chgData name="Kumar, Vinod" userId="a0710a6e-bffc-4971-8893-1c23addeb5b0" providerId="ADAL" clId="{804748DF-446B-437F-AFFB-E1B8A8B41FF1}" dt="2023-01-26T18:35:53.302" v="6" actId="478"/>
          <ac:spMkLst>
            <pc:docMk/>
            <pc:sldMk cId="215799928" sldId="326"/>
            <ac:spMk id="3" creationId="{0FCD93AF-30D8-D969-BC97-A2C54895EFE1}"/>
          </ac:spMkLst>
        </pc:spChg>
        <pc:spChg chg="add mod">
          <ac:chgData name="Kumar, Vinod" userId="a0710a6e-bffc-4971-8893-1c23addeb5b0" providerId="ADAL" clId="{804748DF-446B-437F-AFFB-E1B8A8B41FF1}" dt="2023-01-30T15:14:23.347" v="797" actId="113"/>
          <ac:spMkLst>
            <pc:docMk/>
            <pc:sldMk cId="215799928" sldId="326"/>
            <ac:spMk id="4" creationId="{A268E69E-1A64-C70D-117D-C52D8B847D56}"/>
          </ac:spMkLst>
        </pc:spChg>
        <pc:spChg chg="add mod">
          <ac:chgData name="Kumar, Vinod" userId="a0710a6e-bffc-4971-8893-1c23addeb5b0" providerId="ADAL" clId="{804748DF-446B-437F-AFFB-E1B8A8B41FF1}" dt="2023-01-27T21:35:00.451" v="71" actId="164"/>
          <ac:spMkLst>
            <pc:docMk/>
            <pc:sldMk cId="215799928" sldId="326"/>
            <ac:spMk id="5" creationId="{F3FCF723-FC69-FB60-A6AB-D6E09DCA0168}"/>
          </ac:spMkLst>
        </pc:spChg>
        <pc:spChg chg="add mod">
          <ac:chgData name="Kumar, Vinod" userId="a0710a6e-bffc-4971-8893-1c23addeb5b0" providerId="ADAL" clId="{804748DF-446B-437F-AFFB-E1B8A8B41FF1}" dt="2023-01-30T15:14:53.694" v="799" actId="164"/>
          <ac:spMkLst>
            <pc:docMk/>
            <pc:sldMk cId="215799928" sldId="326"/>
            <ac:spMk id="7" creationId="{F1032A67-9D92-05B0-DE69-4A94EABD19A9}"/>
          </ac:spMkLst>
        </pc:spChg>
        <pc:spChg chg="add mod">
          <ac:chgData name="Kumar, Vinod" userId="a0710a6e-bffc-4971-8893-1c23addeb5b0" providerId="ADAL" clId="{804748DF-446B-437F-AFFB-E1B8A8B41FF1}" dt="2023-01-30T15:14:53.694" v="799" actId="164"/>
          <ac:spMkLst>
            <pc:docMk/>
            <pc:sldMk cId="215799928" sldId="326"/>
            <ac:spMk id="8" creationId="{47E820FA-25F5-AEA1-E191-950C71C0FCF3}"/>
          </ac:spMkLst>
        </pc:spChg>
        <pc:spChg chg="add mod">
          <ac:chgData name="Kumar, Vinod" userId="a0710a6e-bffc-4971-8893-1c23addeb5b0" providerId="ADAL" clId="{804748DF-446B-437F-AFFB-E1B8A8B41FF1}" dt="2023-01-30T15:14:39.897" v="798" actId="164"/>
          <ac:spMkLst>
            <pc:docMk/>
            <pc:sldMk cId="215799928" sldId="326"/>
            <ac:spMk id="12" creationId="{049CE177-B2AB-E2AB-1489-4F8BA53FFE42}"/>
          </ac:spMkLst>
        </pc:spChg>
        <pc:spChg chg="add mod">
          <ac:chgData name="Kumar, Vinod" userId="a0710a6e-bffc-4971-8893-1c23addeb5b0" providerId="ADAL" clId="{804748DF-446B-437F-AFFB-E1B8A8B41FF1}" dt="2023-01-30T15:14:39.897" v="798" actId="164"/>
          <ac:spMkLst>
            <pc:docMk/>
            <pc:sldMk cId="215799928" sldId="326"/>
            <ac:spMk id="13" creationId="{ED0439CE-0E9F-8F77-637D-D5B3F0935A7D}"/>
          </ac:spMkLst>
        </pc:spChg>
        <pc:spChg chg="add mod">
          <ac:chgData name="Kumar, Vinod" userId="a0710a6e-bffc-4971-8893-1c23addeb5b0" providerId="ADAL" clId="{804748DF-446B-437F-AFFB-E1B8A8B41FF1}" dt="2023-01-30T15:14:39.897" v="798" actId="164"/>
          <ac:spMkLst>
            <pc:docMk/>
            <pc:sldMk cId="215799928" sldId="326"/>
            <ac:spMk id="14" creationId="{C4DA97E1-1F8A-604C-58C4-C4FE123B8D38}"/>
          </ac:spMkLst>
        </pc:spChg>
        <pc:spChg chg="add mod">
          <ac:chgData name="Kumar, Vinod" userId="a0710a6e-bffc-4971-8893-1c23addeb5b0" providerId="ADAL" clId="{804748DF-446B-437F-AFFB-E1B8A8B41FF1}" dt="2023-01-30T15:16:18.225" v="814" actId="1037"/>
          <ac:spMkLst>
            <pc:docMk/>
            <pc:sldMk cId="215799928" sldId="326"/>
            <ac:spMk id="16" creationId="{BBC7DEC2-F316-00B8-C960-575417169EE0}"/>
          </ac:spMkLst>
        </pc:spChg>
        <pc:spChg chg="mod">
          <ac:chgData name="Kumar, Vinod" userId="a0710a6e-bffc-4971-8893-1c23addeb5b0" providerId="ADAL" clId="{804748DF-446B-437F-AFFB-E1B8A8B41FF1}" dt="2023-01-30T15:18:45.046" v="870"/>
          <ac:spMkLst>
            <pc:docMk/>
            <pc:sldMk cId="215799928" sldId="326"/>
            <ac:spMk id="19" creationId="{CF6CE95C-34FA-83E2-16D3-C61F92BC0CC4}"/>
          </ac:spMkLst>
        </pc:spChg>
        <pc:spChg chg="add mod">
          <ac:chgData name="Kumar, Vinod" userId="a0710a6e-bffc-4971-8893-1c23addeb5b0" providerId="ADAL" clId="{804748DF-446B-437F-AFFB-E1B8A8B41FF1}" dt="2023-01-27T21:55:14.884" v="284" actId="164"/>
          <ac:spMkLst>
            <pc:docMk/>
            <pc:sldMk cId="215799928" sldId="326"/>
            <ac:spMk id="21" creationId="{098D7C44-CDCD-7387-44C3-005D94FDE88A}"/>
          </ac:spMkLst>
        </pc:spChg>
        <pc:spChg chg="add mod">
          <ac:chgData name="Kumar, Vinod" userId="a0710a6e-bffc-4971-8893-1c23addeb5b0" providerId="ADAL" clId="{804748DF-446B-437F-AFFB-E1B8A8B41FF1}" dt="2023-01-27T21:55:07.340" v="282" actId="164"/>
          <ac:spMkLst>
            <pc:docMk/>
            <pc:sldMk cId="215799928" sldId="326"/>
            <ac:spMk id="22" creationId="{C4EACF49-813D-FD52-DD24-58A1CCC0A223}"/>
          </ac:spMkLst>
        </pc:spChg>
        <pc:spChg chg="add mod">
          <ac:chgData name="Kumar, Vinod" userId="a0710a6e-bffc-4971-8893-1c23addeb5b0" providerId="ADAL" clId="{804748DF-446B-437F-AFFB-E1B8A8B41FF1}" dt="2023-01-27T21:55:25.755" v="286" actId="164"/>
          <ac:spMkLst>
            <pc:docMk/>
            <pc:sldMk cId="215799928" sldId="326"/>
            <ac:spMk id="23" creationId="{5E13CA08-8A68-5A7D-20D1-A46E9B82C382}"/>
          </ac:spMkLst>
        </pc:spChg>
        <pc:spChg chg="add mod">
          <ac:chgData name="Kumar, Vinod" userId="a0710a6e-bffc-4971-8893-1c23addeb5b0" providerId="ADAL" clId="{804748DF-446B-437F-AFFB-E1B8A8B41FF1}" dt="2023-01-27T21:55:25.755" v="286" actId="164"/>
          <ac:spMkLst>
            <pc:docMk/>
            <pc:sldMk cId="215799928" sldId="326"/>
            <ac:spMk id="24" creationId="{C95EBCEB-94C0-B4DD-B0B8-5B913452F555}"/>
          </ac:spMkLst>
        </pc:spChg>
        <pc:spChg chg="add mod">
          <ac:chgData name="Kumar, Vinod" userId="a0710a6e-bffc-4971-8893-1c23addeb5b0" providerId="ADAL" clId="{804748DF-446B-437F-AFFB-E1B8A8B41FF1}" dt="2023-01-27T21:55:14.884" v="284" actId="164"/>
          <ac:spMkLst>
            <pc:docMk/>
            <pc:sldMk cId="215799928" sldId="326"/>
            <ac:spMk id="25" creationId="{83CE1257-A944-5C41-6042-CDF0D89B74A6}"/>
          </ac:spMkLst>
        </pc:spChg>
        <pc:spChg chg="add mod">
          <ac:chgData name="Kumar, Vinod" userId="a0710a6e-bffc-4971-8893-1c23addeb5b0" providerId="ADAL" clId="{804748DF-446B-437F-AFFB-E1B8A8B41FF1}" dt="2023-01-27T21:55:07.340" v="282" actId="164"/>
          <ac:spMkLst>
            <pc:docMk/>
            <pc:sldMk cId="215799928" sldId="326"/>
            <ac:spMk id="26" creationId="{FB23C346-0585-CC57-8C0C-6765E2F78DAF}"/>
          </ac:spMkLst>
        </pc:spChg>
        <pc:spChg chg="add mod">
          <ac:chgData name="Kumar, Vinod" userId="a0710a6e-bffc-4971-8893-1c23addeb5b0" providerId="ADAL" clId="{804748DF-446B-437F-AFFB-E1B8A8B41FF1}" dt="2023-01-27T21:55:25.755" v="286" actId="164"/>
          <ac:spMkLst>
            <pc:docMk/>
            <pc:sldMk cId="215799928" sldId="326"/>
            <ac:spMk id="27" creationId="{D634DB99-CE30-6D5A-67BE-2B19C9961E06}"/>
          </ac:spMkLst>
        </pc:spChg>
        <pc:spChg chg="add mod">
          <ac:chgData name="Kumar, Vinod" userId="a0710a6e-bffc-4971-8893-1c23addeb5b0" providerId="ADAL" clId="{804748DF-446B-437F-AFFB-E1B8A8B41FF1}" dt="2023-01-27T21:55:25.755" v="286" actId="164"/>
          <ac:spMkLst>
            <pc:docMk/>
            <pc:sldMk cId="215799928" sldId="326"/>
            <ac:spMk id="28" creationId="{F65F0C35-C6D4-AAD7-E670-43F4CAC3EFD3}"/>
          </ac:spMkLst>
        </pc:spChg>
        <pc:spChg chg="add mod">
          <ac:chgData name="Kumar, Vinod" userId="a0710a6e-bffc-4971-8893-1c23addeb5b0" providerId="ADAL" clId="{804748DF-446B-437F-AFFB-E1B8A8B41FF1}" dt="2023-01-27T21:55:14.884" v="284" actId="164"/>
          <ac:spMkLst>
            <pc:docMk/>
            <pc:sldMk cId="215799928" sldId="326"/>
            <ac:spMk id="29" creationId="{42B8BF23-F9F6-47BD-5CC4-EB449AA057EC}"/>
          </ac:spMkLst>
        </pc:spChg>
        <pc:spChg chg="add mod">
          <ac:chgData name="Kumar, Vinod" userId="a0710a6e-bffc-4971-8893-1c23addeb5b0" providerId="ADAL" clId="{804748DF-446B-437F-AFFB-E1B8A8B41FF1}" dt="2023-01-27T21:55:14.884" v="284" actId="164"/>
          <ac:spMkLst>
            <pc:docMk/>
            <pc:sldMk cId="215799928" sldId="326"/>
            <ac:spMk id="30" creationId="{0E40422E-8AE0-51C1-6633-CE16CDDBBDC6}"/>
          </ac:spMkLst>
        </pc:spChg>
        <pc:spChg chg="add mod">
          <ac:chgData name="Kumar, Vinod" userId="a0710a6e-bffc-4971-8893-1c23addeb5b0" providerId="ADAL" clId="{804748DF-446B-437F-AFFB-E1B8A8B41FF1}" dt="2023-01-27T21:55:07.340" v="282" actId="164"/>
          <ac:spMkLst>
            <pc:docMk/>
            <pc:sldMk cId="215799928" sldId="326"/>
            <ac:spMk id="31" creationId="{01C2F4E9-CF0C-1697-3E7D-6E09BED6006D}"/>
          </ac:spMkLst>
        </pc:spChg>
        <pc:spChg chg="add mod">
          <ac:chgData name="Kumar, Vinod" userId="a0710a6e-bffc-4971-8893-1c23addeb5b0" providerId="ADAL" clId="{804748DF-446B-437F-AFFB-E1B8A8B41FF1}" dt="2023-01-27T21:55:07.340" v="282" actId="164"/>
          <ac:spMkLst>
            <pc:docMk/>
            <pc:sldMk cId="215799928" sldId="326"/>
            <ac:spMk id="32" creationId="{4B54872C-480B-0F83-B5E3-9037D660CA47}"/>
          </ac:spMkLst>
        </pc:spChg>
        <pc:spChg chg="add mod">
          <ac:chgData name="Kumar, Vinod" userId="a0710a6e-bffc-4971-8893-1c23addeb5b0" providerId="ADAL" clId="{804748DF-446B-437F-AFFB-E1B8A8B41FF1}" dt="2023-01-30T15:16:53.393" v="860" actId="1037"/>
          <ac:spMkLst>
            <pc:docMk/>
            <pc:sldMk cId="215799928" sldId="326"/>
            <ac:spMk id="37" creationId="{B0DBD44B-947F-954F-1259-F8BD59E3BA39}"/>
          </ac:spMkLst>
        </pc:spChg>
        <pc:spChg chg="mod">
          <ac:chgData name="Kumar, Vinod" userId="a0710a6e-bffc-4971-8893-1c23addeb5b0" providerId="ADAL" clId="{804748DF-446B-437F-AFFB-E1B8A8B41FF1}" dt="2023-01-30T15:18:45.046" v="870"/>
          <ac:spMkLst>
            <pc:docMk/>
            <pc:sldMk cId="215799928" sldId="326"/>
            <ac:spMk id="38" creationId="{CCAFC8D1-778A-888F-ED58-C2B4D512D6FF}"/>
          </ac:spMkLst>
        </pc:spChg>
        <pc:spChg chg="mod">
          <ac:chgData name="Kumar, Vinod" userId="a0710a6e-bffc-4971-8893-1c23addeb5b0" providerId="ADAL" clId="{804748DF-446B-437F-AFFB-E1B8A8B41FF1}" dt="2023-01-30T15:18:45.046" v="870"/>
          <ac:spMkLst>
            <pc:docMk/>
            <pc:sldMk cId="215799928" sldId="326"/>
            <ac:spMk id="40" creationId="{F496ECE6-4F9B-91C7-E0C3-7CAF9E28C89A}"/>
          </ac:spMkLst>
        </pc:spChg>
        <pc:spChg chg="mod">
          <ac:chgData name="Kumar, Vinod" userId="a0710a6e-bffc-4971-8893-1c23addeb5b0" providerId="ADAL" clId="{804748DF-446B-437F-AFFB-E1B8A8B41FF1}" dt="2023-01-30T15:18:45.046" v="870"/>
          <ac:spMkLst>
            <pc:docMk/>
            <pc:sldMk cId="215799928" sldId="326"/>
            <ac:spMk id="42" creationId="{306ACACF-63A7-B53D-AE5C-387EE9E1A01F}"/>
          </ac:spMkLst>
        </pc:spChg>
        <pc:spChg chg="add mod">
          <ac:chgData name="Kumar, Vinod" userId="a0710a6e-bffc-4971-8893-1c23addeb5b0" providerId="ADAL" clId="{804748DF-446B-437F-AFFB-E1B8A8B41FF1}" dt="2023-01-30T15:19:07.858" v="875" actId="20577"/>
          <ac:spMkLst>
            <pc:docMk/>
            <pc:sldMk cId="215799928" sldId="326"/>
            <ac:spMk id="43" creationId="{7EFDEDFE-DB4B-089F-EFCE-126B6A2490A6}"/>
          </ac:spMkLst>
        </pc:spChg>
        <pc:spChg chg="add mod">
          <ac:chgData name="Kumar, Vinod" userId="a0710a6e-bffc-4971-8893-1c23addeb5b0" providerId="ADAL" clId="{804748DF-446B-437F-AFFB-E1B8A8B41FF1}" dt="2023-01-30T15:19:47.872" v="877" actId="1076"/>
          <ac:spMkLst>
            <pc:docMk/>
            <pc:sldMk cId="215799928" sldId="326"/>
            <ac:spMk id="44" creationId="{73C48193-FB68-FD31-289A-A97FE893EAF0}"/>
          </ac:spMkLst>
        </pc:spChg>
        <pc:spChg chg="add mod">
          <ac:chgData name="Kumar, Vinod" userId="a0710a6e-bffc-4971-8893-1c23addeb5b0" providerId="ADAL" clId="{804748DF-446B-437F-AFFB-E1B8A8B41FF1}" dt="2023-01-30T15:19:59.568" v="884" actId="20577"/>
          <ac:spMkLst>
            <pc:docMk/>
            <pc:sldMk cId="215799928" sldId="326"/>
            <ac:spMk id="45" creationId="{0C0EE3A7-F02D-8D0D-1922-2892F0087EAD}"/>
          </ac:spMkLst>
        </pc:spChg>
        <pc:grpChg chg="add mod">
          <ac:chgData name="Kumar, Vinod" userId="a0710a6e-bffc-4971-8893-1c23addeb5b0" providerId="ADAL" clId="{804748DF-446B-437F-AFFB-E1B8A8B41FF1}" dt="2023-01-30T15:14:58.225" v="803" actId="1038"/>
          <ac:grpSpMkLst>
            <pc:docMk/>
            <pc:sldMk cId="215799928" sldId="326"/>
            <ac:grpSpMk id="2" creationId="{21D2D1B7-B7FF-15BC-053E-428EF5120A2B}"/>
          </ac:grpSpMkLst>
        </pc:grpChg>
        <pc:grpChg chg="add mod">
          <ac:chgData name="Kumar, Vinod" userId="a0710a6e-bffc-4971-8893-1c23addeb5b0" providerId="ADAL" clId="{804748DF-446B-437F-AFFB-E1B8A8B41FF1}" dt="2023-01-30T15:14:53.694" v="799" actId="164"/>
          <ac:grpSpMkLst>
            <pc:docMk/>
            <pc:sldMk cId="215799928" sldId="326"/>
            <ac:grpSpMk id="6" creationId="{4497055C-E984-9441-36D9-F5323534E923}"/>
          </ac:grpSpMkLst>
        </pc:grpChg>
        <pc:grpChg chg="add mod">
          <ac:chgData name="Kumar, Vinod" userId="a0710a6e-bffc-4971-8893-1c23addeb5b0" providerId="ADAL" clId="{804748DF-446B-437F-AFFB-E1B8A8B41FF1}" dt="2023-01-30T15:14:53.694" v="799" actId="164"/>
          <ac:grpSpMkLst>
            <pc:docMk/>
            <pc:sldMk cId="215799928" sldId="326"/>
            <ac:grpSpMk id="9" creationId="{FA363314-F128-2C39-213E-056991186DD2}"/>
          </ac:grpSpMkLst>
        </pc:grpChg>
        <pc:grpChg chg="add mod">
          <ac:chgData name="Kumar, Vinod" userId="a0710a6e-bffc-4971-8893-1c23addeb5b0" providerId="ADAL" clId="{804748DF-446B-437F-AFFB-E1B8A8B41FF1}" dt="2023-01-30T15:18:55.128" v="872" actId="1076"/>
          <ac:grpSpMkLst>
            <pc:docMk/>
            <pc:sldMk cId="215799928" sldId="326"/>
            <ac:grpSpMk id="10" creationId="{FA7660C6-4774-ED96-45BB-3FBBDB8A75F1}"/>
          </ac:grpSpMkLst>
        </pc:grpChg>
        <pc:grpChg chg="add mod">
          <ac:chgData name="Kumar, Vinod" userId="a0710a6e-bffc-4971-8893-1c23addeb5b0" providerId="ADAL" clId="{804748DF-446B-437F-AFFB-E1B8A8B41FF1}" dt="2023-01-27T21:40:36.955" v="162" actId="164"/>
          <ac:grpSpMkLst>
            <pc:docMk/>
            <pc:sldMk cId="215799928" sldId="326"/>
            <ac:grpSpMk id="15" creationId="{AAB0F0AB-D4F5-C3A4-98D2-F108F0C8E173}"/>
          </ac:grpSpMkLst>
        </pc:grpChg>
        <pc:grpChg chg="add mod">
          <ac:chgData name="Kumar, Vinod" userId="a0710a6e-bffc-4971-8893-1c23addeb5b0" providerId="ADAL" clId="{804748DF-446B-437F-AFFB-E1B8A8B41FF1}" dt="2023-01-27T21:55:45.868" v="289" actId="164"/>
          <ac:grpSpMkLst>
            <pc:docMk/>
            <pc:sldMk cId="215799928" sldId="326"/>
            <ac:grpSpMk id="33" creationId="{75601909-1754-F22C-3E43-876550643757}"/>
          </ac:grpSpMkLst>
        </pc:grpChg>
        <pc:grpChg chg="add mod">
          <ac:chgData name="Kumar, Vinod" userId="a0710a6e-bffc-4971-8893-1c23addeb5b0" providerId="ADAL" clId="{804748DF-446B-437F-AFFB-E1B8A8B41FF1}" dt="2023-01-27T21:55:45.868" v="289" actId="164"/>
          <ac:grpSpMkLst>
            <pc:docMk/>
            <pc:sldMk cId="215799928" sldId="326"/>
            <ac:grpSpMk id="34" creationId="{21E7EA6F-6BAE-5522-8B36-9DCE9C49171A}"/>
          </ac:grpSpMkLst>
        </pc:grpChg>
        <pc:grpChg chg="add mod">
          <ac:chgData name="Kumar, Vinod" userId="a0710a6e-bffc-4971-8893-1c23addeb5b0" providerId="ADAL" clId="{804748DF-446B-437F-AFFB-E1B8A8B41FF1}" dt="2023-01-27T21:55:45.868" v="289" actId="164"/>
          <ac:grpSpMkLst>
            <pc:docMk/>
            <pc:sldMk cId="215799928" sldId="326"/>
            <ac:grpSpMk id="35" creationId="{8915A6AA-698D-721D-49CC-122DFB94C3F5}"/>
          </ac:grpSpMkLst>
        </pc:grpChg>
        <pc:grpChg chg="add mod">
          <ac:chgData name="Kumar, Vinod" userId="a0710a6e-bffc-4971-8893-1c23addeb5b0" providerId="ADAL" clId="{804748DF-446B-437F-AFFB-E1B8A8B41FF1}" dt="2023-01-27T21:55:45.868" v="289" actId="164"/>
          <ac:grpSpMkLst>
            <pc:docMk/>
            <pc:sldMk cId="215799928" sldId="326"/>
            <ac:grpSpMk id="36" creationId="{DF1805E8-48D6-A673-3B49-229C0586D687}"/>
          </ac:grpSpMkLst>
        </pc:grpChg>
        <pc:picChg chg="del">
          <ac:chgData name="Kumar, Vinod" userId="a0710a6e-bffc-4971-8893-1c23addeb5b0" providerId="ADAL" clId="{804748DF-446B-437F-AFFB-E1B8A8B41FF1}" dt="2023-01-26T18:35:51.824" v="5" actId="478"/>
          <ac:picMkLst>
            <pc:docMk/>
            <pc:sldMk cId="215799928" sldId="326"/>
            <ac:picMk id="2" creationId="{05E6B2A6-AA6B-A3CE-D08B-B1D83B87DEC6}"/>
          </ac:picMkLst>
        </pc:picChg>
        <pc:picChg chg="add mod modCrop">
          <ac:chgData name="Kumar, Vinod" userId="a0710a6e-bffc-4971-8893-1c23addeb5b0" providerId="ADAL" clId="{804748DF-446B-437F-AFFB-E1B8A8B41FF1}" dt="2023-01-27T21:35:00.451" v="71" actId="164"/>
          <ac:picMkLst>
            <pc:docMk/>
            <pc:sldMk cId="215799928" sldId="326"/>
            <ac:picMk id="3" creationId="{C51885F4-FC55-9876-C8EE-4ADE943B8B50}"/>
          </ac:picMkLst>
        </pc:picChg>
        <pc:picChg chg="add del mod modCrop">
          <ac:chgData name="Kumar, Vinod" userId="a0710a6e-bffc-4971-8893-1c23addeb5b0" providerId="ADAL" clId="{804748DF-446B-437F-AFFB-E1B8A8B41FF1}" dt="2023-01-27T21:39:06.413" v="138" actId="478"/>
          <ac:picMkLst>
            <pc:docMk/>
            <pc:sldMk cId="215799928" sldId="326"/>
            <ac:picMk id="10" creationId="{A3F601B5-0F1A-9337-77A3-7D95AC2BC8C2}"/>
          </ac:picMkLst>
        </pc:picChg>
        <pc:picChg chg="mod modCrop">
          <ac:chgData name="Kumar, Vinod" userId="a0710a6e-bffc-4971-8893-1c23addeb5b0" providerId="ADAL" clId="{804748DF-446B-437F-AFFB-E1B8A8B41FF1}" dt="2023-01-30T15:14:39.897" v="798" actId="164"/>
          <ac:picMkLst>
            <pc:docMk/>
            <pc:sldMk cId="215799928" sldId="326"/>
            <ac:picMk id="11" creationId="{A8597543-0F87-CE77-9D43-6CB435EB8758}"/>
          </ac:picMkLst>
        </pc:picChg>
        <pc:picChg chg="mod">
          <ac:chgData name="Kumar, Vinod" userId="a0710a6e-bffc-4971-8893-1c23addeb5b0" providerId="ADAL" clId="{804748DF-446B-437F-AFFB-E1B8A8B41FF1}" dt="2023-01-30T15:18:45.046" v="870"/>
          <ac:picMkLst>
            <pc:docMk/>
            <pc:sldMk cId="215799928" sldId="326"/>
            <ac:picMk id="15" creationId="{9474DBFB-215F-1601-59E9-E5D8179887E6}"/>
          </ac:picMkLst>
        </pc:picChg>
        <pc:picChg chg="add mod modCrop">
          <ac:chgData name="Kumar, Vinod" userId="a0710a6e-bffc-4971-8893-1c23addeb5b0" providerId="ADAL" clId="{804748DF-446B-437F-AFFB-E1B8A8B41FF1}" dt="2023-01-27T21:55:25.755" v="286" actId="164"/>
          <ac:picMkLst>
            <pc:docMk/>
            <pc:sldMk cId="215799928" sldId="326"/>
            <ac:picMk id="17" creationId="{E4DA5F10-74F6-DE53-8530-C1D3C3BC4975}"/>
          </ac:picMkLst>
        </pc:picChg>
        <pc:picChg chg="add mod modCrop">
          <ac:chgData name="Kumar, Vinod" userId="a0710a6e-bffc-4971-8893-1c23addeb5b0" providerId="ADAL" clId="{804748DF-446B-437F-AFFB-E1B8A8B41FF1}" dt="2023-01-27T21:55:14.884" v="284" actId="164"/>
          <ac:picMkLst>
            <pc:docMk/>
            <pc:sldMk cId="215799928" sldId="326"/>
            <ac:picMk id="18" creationId="{1A70C000-E76A-2422-82D1-6C93FFBA3F6B}"/>
          </ac:picMkLst>
        </pc:picChg>
        <pc:picChg chg="add mod modCrop">
          <ac:chgData name="Kumar, Vinod" userId="a0710a6e-bffc-4971-8893-1c23addeb5b0" providerId="ADAL" clId="{804748DF-446B-437F-AFFB-E1B8A8B41FF1}" dt="2023-01-27T21:55:07.340" v="282" actId="164"/>
          <ac:picMkLst>
            <pc:docMk/>
            <pc:sldMk cId="215799928" sldId="326"/>
            <ac:picMk id="20" creationId="{CE63F0C7-6DE4-0681-0540-8A357FE7B8EB}"/>
          </ac:picMkLst>
        </pc:picChg>
        <pc:cxnChg chg="mod">
          <ac:chgData name="Kumar, Vinod" userId="a0710a6e-bffc-4971-8893-1c23addeb5b0" providerId="ADAL" clId="{804748DF-446B-437F-AFFB-E1B8A8B41FF1}" dt="2023-01-30T15:18:45.046" v="870"/>
          <ac:cxnSpMkLst>
            <pc:docMk/>
            <pc:sldMk cId="215799928" sldId="326"/>
            <ac:cxnSpMk id="39" creationId="{80CFA77D-58D8-FA12-F0DA-DAA7848AB443}"/>
          </ac:cxnSpMkLst>
        </pc:cxnChg>
        <pc:cxnChg chg="mod">
          <ac:chgData name="Kumar, Vinod" userId="a0710a6e-bffc-4971-8893-1c23addeb5b0" providerId="ADAL" clId="{804748DF-446B-437F-AFFB-E1B8A8B41FF1}" dt="2023-01-30T15:18:45.046" v="870"/>
          <ac:cxnSpMkLst>
            <pc:docMk/>
            <pc:sldMk cId="215799928" sldId="326"/>
            <ac:cxnSpMk id="41" creationId="{1E83E249-FCBA-74FA-B34A-4FC2206DAED4}"/>
          </ac:cxnSpMkLst>
        </pc:cxnChg>
      </pc:sldChg>
      <pc:sldChg chg="modSp mod">
        <pc:chgData name="Kumar, Vinod" userId="a0710a6e-bffc-4971-8893-1c23addeb5b0" providerId="ADAL" clId="{804748DF-446B-437F-AFFB-E1B8A8B41FF1}" dt="2023-01-31T20:03:38.740" v="5668" actId="1035"/>
        <pc:sldMkLst>
          <pc:docMk/>
          <pc:sldMk cId="3704016793" sldId="327"/>
        </pc:sldMkLst>
        <pc:spChg chg="mod">
          <ac:chgData name="Kumar, Vinod" userId="a0710a6e-bffc-4971-8893-1c23addeb5b0" providerId="ADAL" clId="{804748DF-446B-437F-AFFB-E1B8A8B41FF1}" dt="2023-01-30T15:20:19.968" v="885" actId="20577"/>
          <ac:spMkLst>
            <pc:docMk/>
            <pc:sldMk cId="3704016793" sldId="327"/>
            <ac:spMk id="3" creationId="{DBD9AAD7-6400-684B-8E13-A6012FFFE663}"/>
          </ac:spMkLst>
        </pc:spChg>
        <pc:spChg chg="mod">
          <ac:chgData name="Kumar, Vinod" userId="a0710a6e-bffc-4971-8893-1c23addeb5b0" providerId="ADAL" clId="{804748DF-446B-437F-AFFB-E1B8A8B41FF1}" dt="2023-01-31T20:03:38.740" v="5668" actId="1035"/>
          <ac:spMkLst>
            <pc:docMk/>
            <pc:sldMk cId="3704016793" sldId="327"/>
            <ac:spMk id="5" creationId="{317D6DFB-616F-E947-B7CF-E14E30734E75}"/>
          </ac:spMkLst>
        </pc:spChg>
        <pc:spChg chg="mod">
          <ac:chgData name="Kumar, Vinod" userId="a0710a6e-bffc-4971-8893-1c23addeb5b0" providerId="ADAL" clId="{804748DF-446B-437F-AFFB-E1B8A8B41FF1}" dt="2023-01-31T20:03:14.339" v="5667" actId="1076"/>
          <ac:spMkLst>
            <pc:docMk/>
            <pc:sldMk cId="3704016793" sldId="327"/>
            <ac:spMk id="6" creationId="{F163FD9C-0AA5-8349-A58C-164ACEF5EAAA}"/>
          </ac:spMkLst>
        </pc:spChg>
        <pc:spChg chg="mod">
          <ac:chgData name="Kumar, Vinod" userId="a0710a6e-bffc-4971-8893-1c23addeb5b0" providerId="ADAL" clId="{804748DF-446B-437F-AFFB-E1B8A8B41FF1}" dt="2023-01-31T20:03:14.339" v="5667" actId="1076"/>
          <ac:spMkLst>
            <pc:docMk/>
            <pc:sldMk cId="3704016793" sldId="327"/>
            <ac:spMk id="7" creationId="{49A6DFC8-6040-524F-858C-11A4800C892F}"/>
          </ac:spMkLst>
        </pc:spChg>
        <pc:grpChg chg="mod">
          <ac:chgData name="Kumar, Vinod" userId="a0710a6e-bffc-4971-8893-1c23addeb5b0" providerId="ADAL" clId="{804748DF-446B-437F-AFFB-E1B8A8B41FF1}" dt="2023-01-31T20:03:14.339" v="5667" actId="1076"/>
          <ac:grpSpMkLst>
            <pc:docMk/>
            <pc:sldMk cId="3704016793" sldId="327"/>
            <ac:grpSpMk id="2" creationId="{BB1A6554-DBE2-6847-B2EE-B81FB10820AA}"/>
          </ac:grpSpMkLst>
        </pc:grpChg>
        <pc:picChg chg="mod">
          <ac:chgData name="Kumar, Vinod" userId="a0710a6e-bffc-4971-8893-1c23addeb5b0" providerId="ADAL" clId="{804748DF-446B-437F-AFFB-E1B8A8B41FF1}" dt="2023-01-31T20:03:14.339" v="5667" actId="1076"/>
          <ac:picMkLst>
            <pc:docMk/>
            <pc:sldMk cId="3704016793" sldId="327"/>
            <ac:picMk id="1025" creationId="{A9639EE4-AD92-324C-B861-E2EEE5D68EF0}"/>
          </ac:picMkLst>
        </pc:picChg>
      </pc:sldChg>
      <pc:sldChg chg="addSp delSp modSp mod">
        <pc:chgData name="Kumar, Vinod" userId="a0710a6e-bffc-4971-8893-1c23addeb5b0" providerId="ADAL" clId="{804748DF-446B-437F-AFFB-E1B8A8B41FF1}" dt="2023-01-31T20:05:21.874" v="5686" actId="20577"/>
        <pc:sldMkLst>
          <pc:docMk/>
          <pc:sldMk cId="3312243808" sldId="328"/>
        </pc:sldMkLst>
        <pc:spChg chg="mod topLvl">
          <ac:chgData name="Kumar, Vinod" userId="a0710a6e-bffc-4971-8893-1c23addeb5b0" providerId="ADAL" clId="{804748DF-446B-437F-AFFB-E1B8A8B41FF1}" dt="2023-01-31T20:04:06.557" v="5670" actId="113"/>
          <ac:spMkLst>
            <pc:docMk/>
            <pc:sldMk cId="3312243808" sldId="328"/>
            <ac:spMk id="5" creationId="{BD7E35FE-B506-3242-AE21-E8172EC54312}"/>
          </ac:spMkLst>
        </pc:spChg>
        <pc:spChg chg="mod topLvl">
          <ac:chgData name="Kumar, Vinod" userId="a0710a6e-bffc-4971-8893-1c23addeb5b0" providerId="ADAL" clId="{804748DF-446B-437F-AFFB-E1B8A8B41FF1}" dt="2023-01-31T20:04:06.557" v="5670" actId="113"/>
          <ac:spMkLst>
            <pc:docMk/>
            <pc:sldMk cId="3312243808" sldId="328"/>
            <ac:spMk id="6" creationId="{3C48920D-4915-A345-84E4-BF79A62FB398}"/>
          </ac:spMkLst>
        </pc:spChg>
        <pc:spChg chg="mod topLvl">
          <ac:chgData name="Kumar, Vinod" userId="a0710a6e-bffc-4971-8893-1c23addeb5b0" providerId="ADAL" clId="{804748DF-446B-437F-AFFB-E1B8A8B41FF1}" dt="2023-01-31T20:04:06.557" v="5670" actId="113"/>
          <ac:spMkLst>
            <pc:docMk/>
            <pc:sldMk cId="3312243808" sldId="328"/>
            <ac:spMk id="7" creationId="{153E14D5-0513-BB41-B8C3-327E2106CB4C}"/>
          </ac:spMkLst>
        </pc:spChg>
        <pc:spChg chg="mod topLvl">
          <ac:chgData name="Kumar, Vinod" userId="a0710a6e-bffc-4971-8893-1c23addeb5b0" providerId="ADAL" clId="{804748DF-446B-437F-AFFB-E1B8A8B41FF1}" dt="2023-01-31T20:04:06.557" v="5670" actId="113"/>
          <ac:spMkLst>
            <pc:docMk/>
            <pc:sldMk cId="3312243808" sldId="328"/>
            <ac:spMk id="8" creationId="{C33B0659-C21E-3A48-8169-69069B52AD51}"/>
          </ac:spMkLst>
        </pc:spChg>
        <pc:spChg chg="mod topLvl">
          <ac:chgData name="Kumar, Vinod" userId="a0710a6e-bffc-4971-8893-1c23addeb5b0" providerId="ADAL" clId="{804748DF-446B-437F-AFFB-E1B8A8B41FF1}" dt="2023-01-31T20:04:06.557" v="5670" actId="113"/>
          <ac:spMkLst>
            <pc:docMk/>
            <pc:sldMk cId="3312243808" sldId="328"/>
            <ac:spMk id="9" creationId="{F1AEECAE-A1D3-CE40-81C7-6F52F3AA576F}"/>
          </ac:spMkLst>
        </pc:spChg>
        <pc:spChg chg="mod topLvl">
          <ac:chgData name="Kumar, Vinod" userId="a0710a6e-bffc-4971-8893-1c23addeb5b0" providerId="ADAL" clId="{804748DF-446B-437F-AFFB-E1B8A8B41FF1}" dt="2023-01-31T20:04:06.557" v="5670" actId="113"/>
          <ac:spMkLst>
            <pc:docMk/>
            <pc:sldMk cId="3312243808" sldId="328"/>
            <ac:spMk id="11" creationId="{8305CE36-2129-C64F-A34A-C4E75B4AB41C}"/>
          </ac:spMkLst>
        </pc:spChg>
        <pc:spChg chg="mod topLvl">
          <ac:chgData name="Kumar, Vinod" userId="a0710a6e-bffc-4971-8893-1c23addeb5b0" providerId="ADAL" clId="{804748DF-446B-437F-AFFB-E1B8A8B41FF1}" dt="2023-01-31T20:04:06.557" v="5670" actId="113"/>
          <ac:spMkLst>
            <pc:docMk/>
            <pc:sldMk cId="3312243808" sldId="328"/>
            <ac:spMk id="13" creationId="{F14113A6-1E24-D945-9AC8-2A0EC57C6059}"/>
          </ac:spMkLst>
        </pc:spChg>
        <pc:spChg chg="mod topLvl">
          <ac:chgData name="Kumar, Vinod" userId="a0710a6e-bffc-4971-8893-1c23addeb5b0" providerId="ADAL" clId="{804748DF-446B-437F-AFFB-E1B8A8B41FF1}" dt="2023-01-31T20:04:06.557" v="5670" actId="113"/>
          <ac:spMkLst>
            <pc:docMk/>
            <pc:sldMk cId="3312243808" sldId="328"/>
            <ac:spMk id="14" creationId="{80D4D0D3-3773-8548-A561-66C0D1AD1EF8}"/>
          </ac:spMkLst>
        </pc:spChg>
        <pc:spChg chg="mod topLvl">
          <ac:chgData name="Kumar, Vinod" userId="a0710a6e-bffc-4971-8893-1c23addeb5b0" providerId="ADAL" clId="{804748DF-446B-437F-AFFB-E1B8A8B41FF1}" dt="2023-01-31T20:04:06.557" v="5670" actId="113"/>
          <ac:spMkLst>
            <pc:docMk/>
            <pc:sldMk cId="3312243808" sldId="328"/>
            <ac:spMk id="15" creationId="{DEF81E35-044B-8E46-BAA9-0CA8D827F7D1}"/>
          </ac:spMkLst>
        </pc:spChg>
        <pc:spChg chg="mod topLvl">
          <ac:chgData name="Kumar, Vinod" userId="a0710a6e-bffc-4971-8893-1c23addeb5b0" providerId="ADAL" clId="{804748DF-446B-437F-AFFB-E1B8A8B41FF1}" dt="2023-01-31T20:04:06.557" v="5670" actId="113"/>
          <ac:spMkLst>
            <pc:docMk/>
            <pc:sldMk cId="3312243808" sldId="328"/>
            <ac:spMk id="16" creationId="{03A802AD-66BF-1D4F-B84F-C30DFB31C09D}"/>
          </ac:spMkLst>
        </pc:spChg>
        <pc:spChg chg="mod topLvl">
          <ac:chgData name="Kumar, Vinod" userId="a0710a6e-bffc-4971-8893-1c23addeb5b0" providerId="ADAL" clId="{804748DF-446B-437F-AFFB-E1B8A8B41FF1}" dt="2023-01-31T20:04:06.557" v="5670" actId="113"/>
          <ac:spMkLst>
            <pc:docMk/>
            <pc:sldMk cId="3312243808" sldId="328"/>
            <ac:spMk id="17" creationId="{A2096BCC-91A0-0842-B7D0-C8B47AA6AA0A}"/>
          </ac:spMkLst>
        </pc:spChg>
        <pc:spChg chg="add mod">
          <ac:chgData name="Kumar, Vinod" userId="a0710a6e-bffc-4971-8893-1c23addeb5b0" providerId="ADAL" clId="{804748DF-446B-437F-AFFB-E1B8A8B41FF1}" dt="2023-01-31T20:04:06.557" v="5670" actId="113"/>
          <ac:spMkLst>
            <pc:docMk/>
            <pc:sldMk cId="3312243808" sldId="328"/>
            <ac:spMk id="20" creationId="{351485A9-6B72-3A68-73B3-F07FCA79E67B}"/>
          </ac:spMkLst>
        </pc:spChg>
        <pc:spChg chg="add mod">
          <ac:chgData name="Kumar, Vinod" userId="a0710a6e-bffc-4971-8893-1c23addeb5b0" providerId="ADAL" clId="{804748DF-446B-437F-AFFB-E1B8A8B41FF1}" dt="2023-01-30T15:13:47.783" v="795" actId="164"/>
          <ac:spMkLst>
            <pc:docMk/>
            <pc:sldMk cId="3312243808" sldId="328"/>
            <ac:spMk id="25" creationId="{66797F0B-9B03-6450-F309-A81B820EC9FE}"/>
          </ac:spMkLst>
        </pc:spChg>
        <pc:spChg chg="add mod">
          <ac:chgData name="Kumar, Vinod" userId="a0710a6e-bffc-4971-8893-1c23addeb5b0" providerId="ADAL" clId="{804748DF-446B-437F-AFFB-E1B8A8B41FF1}" dt="2023-01-30T15:13:47.783" v="795" actId="164"/>
          <ac:spMkLst>
            <pc:docMk/>
            <pc:sldMk cId="3312243808" sldId="328"/>
            <ac:spMk id="26" creationId="{48DCBD3B-1795-EC37-CA6F-5AFA5EC9DE52}"/>
          </ac:spMkLst>
        </pc:spChg>
        <pc:spChg chg="add mod">
          <ac:chgData name="Kumar, Vinod" userId="a0710a6e-bffc-4971-8893-1c23addeb5b0" providerId="ADAL" clId="{804748DF-446B-437F-AFFB-E1B8A8B41FF1}" dt="2023-01-30T15:13:47.783" v="795" actId="164"/>
          <ac:spMkLst>
            <pc:docMk/>
            <pc:sldMk cId="3312243808" sldId="328"/>
            <ac:spMk id="28" creationId="{A2655A59-097D-5217-6FFA-103762FA9A50}"/>
          </ac:spMkLst>
        </pc:spChg>
        <pc:spChg chg="add mod">
          <ac:chgData name="Kumar, Vinod" userId="a0710a6e-bffc-4971-8893-1c23addeb5b0" providerId="ADAL" clId="{804748DF-446B-437F-AFFB-E1B8A8B41FF1}" dt="2023-01-30T15:13:47.783" v="795" actId="164"/>
          <ac:spMkLst>
            <pc:docMk/>
            <pc:sldMk cId="3312243808" sldId="328"/>
            <ac:spMk id="30" creationId="{BFFDD5A8-5826-9F53-379F-947A467BB62E}"/>
          </ac:spMkLst>
        </pc:spChg>
        <pc:spChg chg="add mod">
          <ac:chgData name="Kumar, Vinod" userId="a0710a6e-bffc-4971-8893-1c23addeb5b0" providerId="ADAL" clId="{804748DF-446B-437F-AFFB-E1B8A8B41FF1}" dt="2023-01-31T20:05:21.874" v="5686" actId="20577"/>
          <ac:spMkLst>
            <pc:docMk/>
            <pc:sldMk cId="3312243808" sldId="328"/>
            <ac:spMk id="32" creationId="{C7A57016-B285-E7A4-4309-57286A85EEF6}"/>
          </ac:spMkLst>
        </pc:spChg>
        <pc:grpChg chg="del">
          <ac:chgData name="Kumar, Vinod" userId="a0710a6e-bffc-4971-8893-1c23addeb5b0" providerId="ADAL" clId="{804748DF-446B-437F-AFFB-E1B8A8B41FF1}" dt="2023-01-30T14:54:56.660" v="294" actId="165"/>
          <ac:grpSpMkLst>
            <pc:docMk/>
            <pc:sldMk cId="3312243808" sldId="328"/>
            <ac:grpSpMk id="18" creationId="{37515143-70E0-7B43-B2BE-4D8ECA8F838E}"/>
          </ac:grpSpMkLst>
        </pc:grpChg>
        <pc:grpChg chg="del">
          <ac:chgData name="Kumar, Vinod" userId="a0710a6e-bffc-4971-8893-1c23addeb5b0" providerId="ADAL" clId="{804748DF-446B-437F-AFFB-E1B8A8B41FF1}" dt="2023-01-30T14:54:53.448" v="293" actId="165"/>
          <ac:grpSpMkLst>
            <pc:docMk/>
            <pc:sldMk cId="3312243808" sldId="328"/>
            <ac:grpSpMk id="19" creationId="{26D3B823-D2A0-384A-8A31-54DC174AE32B}"/>
          </ac:grpSpMkLst>
        </pc:grpChg>
        <pc:grpChg chg="add mod">
          <ac:chgData name="Kumar, Vinod" userId="a0710a6e-bffc-4971-8893-1c23addeb5b0" providerId="ADAL" clId="{804748DF-446B-437F-AFFB-E1B8A8B41FF1}" dt="2023-01-31T20:04:58.515" v="5682" actId="1076"/>
          <ac:grpSpMkLst>
            <pc:docMk/>
            <pc:sldMk cId="3312243808" sldId="328"/>
            <ac:grpSpMk id="21" creationId="{B1D95BFB-6AB2-A07E-4595-1FA29804B442}"/>
          </ac:grpSpMkLst>
        </pc:grpChg>
        <pc:grpChg chg="add mod">
          <ac:chgData name="Kumar, Vinod" userId="a0710a6e-bffc-4971-8893-1c23addeb5b0" providerId="ADAL" clId="{804748DF-446B-437F-AFFB-E1B8A8B41FF1}" dt="2023-01-31T20:05:03.561" v="5683" actId="1076"/>
          <ac:grpSpMkLst>
            <pc:docMk/>
            <pc:sldMk cId="3312243808" sldId="328"/>
            <ac:grpSpMk id="22" creationId="{CA2B877A-1519-ABAA-9B4F-7F849712E67B}"/>
          </ac:grpSpMkLst>
        </pc:grpChg>
        <pc:grpChg chg="add del mod">
          <ac:chgData name="Kumar, Vinod" userId="a0710a6e-bffc-4971-8893-1c23addeb5b0" providerId="ADAL" clId="{804748DF-446B-437F-AFFB-E1B8A8B41FF1}" dt="2023-01-30T15:20:33.296" v="886" actId="478"/>
          <ac:grpSpMkLst>
            <pc:docMk/>
            <pc:sldMk cId="3312243808" sldId="328"/>
            <ac:grpSpMk id="31" creationId="{5F59AA4F-9FD9-9DAD-359B-60DB79B69C4C}"/>
          </ac:grpSpMkLst>
        </pc:grpChg>
        <pc:picChg chg="mod topLvl">
          <ac:chgData name="Kumar, Vinod" userId="a0710a6e-bffc-4971-8893-1c23addeb5b0" providerId="ADAL" clId="{804748DF-446B-437F-AFFB-E1B8A8B41FF1}" dt="2023-01-30T15:00:00.865" v="517" actId="164"/>
          <ac:picMkLst>
            <pc:docMk/>
            <pc:sldMk cId="3312243808" sldId="328"/>
            <ac:picMk id="2" creationId="{376CA672-4E95-1E4B-8A6C-C7BD32266B01}"/>
          </ac:picMkLst>
        </pc:picChg>
        <pc:picChg chg="mod topLvl">
          <ac:chgData name="Kumar, Vinod" userId="a0710a6e-bffc-4971-8893-1c23addeb5b0" providerId="ADAL" clId="{804748DF-446B-437F-AFFB-E1B8A8B41FF1}" dt="2023-01-30T15:00:00.865" v="517" actId="164"/>
          <ac:picMkLst>
            <pc:docMk/>
            <pc:sldMk cId="3312243808" sldId="328"/>
            <ac:picMk id="3" creationId="{86B9EE39-5309-1548-81A1-B3AC32DA713B}"/>
          </ac:picMkLst>
        </pc:picChg>
        <pc:picChg chg="mod topLvl">
          <ac:chgData name="Kumar, Vinod" userId="a0710a6e-bffc-4971-8893-1c23addeb5b0" providerId="ADAL" clId="{804748DF-446B-437F-AFFB-E1B8A8B41FF1}" dt="2023-01-30T15:00:05.873" v="518" actId="164"/>
          <ac:picMkLst>
            <pc:docMk/>
            <pc:sldMk cId="3312243808" sldId="328"/>
            <ac:picMk id="12" creationId="{CD1EA49D-8A63-B442-8402-7DFE6AA592F4}"/>
          </ac:picMkLst>
        </pc:picChg>
        <pc:picChg chg="add mod modCrop">
          <ac:chgData name="Kumar, Vinod" userId="a0710a6e-bffc-4971-8893-1c23addeb5b0" providerId="ADAL" clId="{804748DF-446B-437F-AFFB-E1B8A8B41FF1}" dt="2023-01-30T15:13:47.783" v="795" actId="164"/>
          <ac:picMkLst>
            <pc:docMk/>
            <pc:sldMk cId="3312243808" sldId="328"/>
            <ac:picMk id="24" creationId="{E6588407-F846-F21E-853A-F91CECABE7C4}"/>
          </ac:picMkLst>
        </pc:picChg>
        <pc:cxnChg chg="add mod">
          <ac:chgData name="Kumar, Vinod" userId="a0710a6e-bffc-4971-8893-1c23addeb5b0" providerId="ADAL" clId="{804748DF-446B-437F-AFFB-E1B8A8B41FF1}" dt="2023-01-30T15:00:05.873" v="518" actId="164"/>
          <ac:cxnSpMkLst>
            <pc:docMk/>
            <pc:sldMk cId="3312243808" sldId="328"/>
            <ac:cxnSpMk id="4" creationId="{C93BEA72-3AB1-5EC4-8AA5-F8DA6802A1B3}"/>
          </ac:cxnSpMkLst>
        </pc:cxnChg>
        <pc:cxnChg chg="mod topLvl">
          <ac:chgData name="Kumar, Vinod" userId="a0710a6e-bffc-4971-8893-1c23addeb5b0" providerId="ADAL" clId="{804748DF-446B-437F-AFFB-E1B8A8B41FF1}" dt="2023-01-30T15:00:00.865" v="517" actId="164"/>
          <ac:cxnSpMkLst>
            <pc:docMk/>
            <pc:sldMk cId="3312243808" sldId="328"/>
            <ac:cxnSpMk id="10" creationId="{6BB4AA93-37E6-104B-A801-5CAFDECE1118}"/>
          </ac:cxnSpMkLst>
        </pc:cxnChg>
        <pc:cxnChg chg="add mod">
          <ac:chgData name="Kumar, Vinod" userId="a0710a6e-bffc-4971-8893-1c23addeb5b0" providerId="ADAL" clId="{804748DF-446B-437F-AFFB-E1B8A8B41FF1}" dt="2023-01-30T15:13:47.783" v="795" actId="164"/>
          <ac:cxnSpMkLst>
            <pc:docMk/>
            <pc:sldMk cId="3312243808" sldId="328"/>
            <ac:cxnSpMk id="27" creationId="{189F90E3-93E0-B09D-F943-7D51994484F6}"/>
          </ac:cxnSpMkLst>
        </pc:cxnChg>
        <pc:cxnChg chg="add mod">
          <ac:chgData name="Kumar, Vinod" userId="a0710a6e-bffc-4971-8893-1c23addeb5b0" providerId="ADAL" clId="{804748DF-446B-437F-AFFB-E1B8A8B41FF1}" dt="2023-01-30T15:13:47.783" v="795" actId="164"/>
          <ac:cxnSpMkLst>
            <pc:docMk/>
            <pc:sldMk cId="3312243808" sldId="328"/>
            <ac:cxnSpMk id="29" creationId="{0093F24C-8760-692E-06DD-B721F1DAABE4}"/>
          </ac:cxnSpMkLst>
        </pc:cxnChg>
      </pc:sldChg>
      <pc:sldChg chg="addSp delSp modSp new mod">
        <pc:chgData name="Kumar, Vinod" userId="a0710a6e-bffc-4971-8893-1c23addeb5b0" providerId="ADAL" clId="{804748DF-446B-437F-AFFB-E1B8A8B41FF1}" dt="2023-01-31T20:13:18.462" v="5874" actId="1076"/>
        <pc:sldMkLst>
          <pc:docMk/>
          <pc:sldMk cId="3774057072" sldId="329"/>
        </pc:sldMkLst>
        <pc:spChg chg="add mod">
          <ac:chgData name="Kumar, Vinod" userId="a0710a6e-bffc-4971-8893-1c23addeb5b0" providerId="ADAL" clId="{804748DF-446B-437F-AFFB-E1B8A8B41FF1}" dt="2023-01-30T15:21:28.497" v="889" actId="20577"/>
          <ac:spMkLst>
            <pc:docMk/>
            <pc:sldMk cId="3774057072" sldId="329"/>
            <ac:spMk id="2" creationId="{A0FBC7C5-F52E-9A9B-D88B-A242D961AC1E}"/>
          </ac:spMkLst>
        </pc:spChg>
        <pc:spChg chg="add mod">
          <ac:chgData name="Kumar, Vinod" userId="a0710a6e-bffc-4971-8893-1c23addeb5b0" providerId="ADAL" clId="{804748DF-446B-437F-AFFB-E1B8A8B41FF1}" dt="2023-01-30T20:10:23.191" v="3017" actId="1038"/>
          <ac:spMkLst>
            <pc:docMk/>
            <pc:sldMk cId="3774057072" sldId="329"/>
            <ac:spMk id="3" creationId="{AD1A1433-8D8F-3402-0275-76840E948103}"/>
          </ac:spMkLst>
        </pc:spChg>
        <pc:spChg chg="add mod">
          <ac:chgData name="Kumar, Vinod" userId="a0710a6e-bffc-4971-8893-1c23addeb5b0" providerId="ADAL" clId="{804748DF-446B-437F-AFFB-E1B8A8B41FF1}" dt="2023-01-31T20:06:04.869" v="5688" actId="113"/>
          <ac:spMkLst>
            <pc:docMk/>
            <pc:sldMk cId="3774057072" sldId="329"/>
            <ac:spMk id="5" creationId="{CFF3B1DB-C8CA-ED66-9727-07890582971A}"/>
          </ac:spMkLst>
        </pc:spChg>
        <pc:spChg chg="add mod">
          <ac:chgData name="Kumar, Vinod" userId="a0710a6e-bffc-4971-8893-1c23addeb5b0" providerId="ADAL" clId="{804748DF-446B-437F-AFFB-E1B8A8B41FF1}" dt="2023-01-31T20:07:30.913" v="5732" actId="1036"/>
          <ac:spMkLst>
            <pc:docMk/>
            <pc:sldMk cId="3774057072" sldId="329"/>
            <ac:spMk id="6" creationId="{728262D2-FE74-61A8-8A48-31083EDC1E23}"/>
          </ac:spMkLst>
        </pc:spChg>
        <pc:spChg chg="add mod">
          <ac:chgData name="Kumar, Vinod" userId="a0710a6e-bffc-4971-8893-1c23addeb5b0" providerId="ADAL" clId="{804748DF-446B-437F-AFFB-E1B8A8B41FF1}" dt="2023-01-31T20:07:24.641" v="5714" actId="1037"/>
          <ac:spMkLst>
            <pc:docMk/>
            <pc:sldMk cId="3774057072" sldId="329"/>
            <ac:spMk id="7" creationId="{611E8C2B-CA39-F367-DC4F-0381C198BDDE}"/>
          </ac:spMkLst>
        </pc:spChg>
        <pc:spChg chg="add mod">
          <ac:chgData name="Kumar, Vinod" userId="a0710a6e-bffc-4971-8893-1c23addeb5b0" providerId="ADAL" clId="{804748DF-446B-437F-AFFB-E1B8A8B41FF1}" dt="2023-01-31T20:06:04.869" v="5688" actId="113"/>
          <ac:spMkLst>
            <pc:docMk/>
            <pc:sldMk cId="3774057072" sldId="329"/>
            <ac:spMk id="8" creationId="{0AD6F688-1FE6-62A9-7CE2-D6004C6C0EA4}"/>
          </ac:spMkLst>
        </pc:spChg>
        <pc:spChg chg="add mod">
          <ac:chgData name="Kumar, Vinod" userId="a0710a6e-bffc-4971-8893-1c23addeb5b0" providerId="ADAL" clId="{804748DF-446B-437F-AFFB-E1B8A8B41FF1}" dt="2023-01-31T20:06:04.869" v="5688" actId="113"/>
          <ac:spMkLst>
            <pc:docMk/>
            <pc:sldMk cId="3774057072" sldId="329"/>
            <ac:spMk id="9" creationId="{9C6645C5-102F-2731-05E1-A9F4C073E67C}"/>
          </ac:spMkLst>
        </pc:spChg>
        <pc:spChg chg="add mod">
          <ac:chgData name="Kumar, Vinod" userId="a0710a6e-bffc-4971-8893-1c23addeb5b0" providerId="ADAL" clId="{804748DF-446B-437F-AFFB-E1B8A8B41FF1}" dt="2023-01-31T20:06:04.869" v="5688" actId="113"/>
          <ac:spMkLst>
            <pc:docMk/>
            <pc:sldMk cId="3774057072" sldId="329"/>
            <ac:spMk id="11" creationId="{734C69EC-4203-4377-157B-3054DB75AB7E}"/>
          </ac:spMkLst>
        </pc:spChg>
        <pc:spChg chg="mod topLvl">
          <ac:chgData name="Kumar, Vinod" userId="a0710a6e-bffc-4971-8893-1c23addeb5b0" providerId="ADAL" clId="{804748DF-446B-437F-AFFB-E1B8A8B41FF1}" dt="2023-01-31T20:06:04.869" v="5688" actId="113"/>
          <ac:spMkLst>
            <pc:docMk/>
            <pc:sldMk cId="3774057072" sldId="329"/>
            <ac:spMk id="16" creationId="{845EF6DD-08AE-BEBA-CBFF-84CC9237103A}"/>
          </ac:spMkLst>
        </pc:spChg>
        <pc:spChg chg="mod topLvl">
          <ac:chgData name="Kumar, Vinod" userId="a0710a6e-bffc-4971-8893-1c23addeb5b0" providerId="ADAL" clId="{804748DF-446B-437F-AFFB-E1B8A8B41FF1}" dt="2023-01-31T20:06:04.869" v="5688" actId="113"/>
          <ac:spMkLst>
            <pc:docMk/>
            <pc:sldMk cId="3774057072" sldId="329"/>
            <ac:spMk id="18" creationId="{CC1AF8A6-BC3C-3C2E-D677-DE8C0E3C82D5}"/>
          </ac:spMkLst>
        </pc:spChg>
        <pc:spChg chg="del mod topLvl">
          <ac:chgData name="Kumar, Vinod" userId="a0710a6e-bffc-4971-8893-1c23addeb5b0" providerId="ADAL" clId="{804748DF-446B-437F-AFFB-E1B8A8B41FF1}" dt="2023-01-30T15:30:53.242" v="960" actId="478"/>
          <ac:spMkLst>
            <pc:docMk/>
            <pc:sldMk cId="3774057072" sldId="329"/>
            <ac:spMk id="19" creationId="{28419F4B-3919-7752-A01E-FE7116A07BB8}"/>
          </ac:spMkLst>
        </pc:spChg>
        <pc:spChg chg="mod topLvl">
          <ac:chgData name="Kumar, Vinod" userId="a0710a6e-bffc-4971-8893-1c23addeb5b0" providerId="ADAL" clId="{804748DF-446B-437F-AFFB-E1B8A8B41FF1}" dt="2023-01-31T20:07:04.913" v="5707" actId="1037"/>
          <ac:spMkLst>
            <pc:docMk/>
            <pc:sldMk cId="3774057072" sldId="329"/>
            <ac:spMk id="20" creationId="{6CC6F1C5-05E1-D250-6230-E894A0895998}"/>
          </ac:spMkLst>
        </pc:spChg>
        <pc:spChg chg="mod topLvl">
          <ac:chgData name="Kumar, Vinod" userId="a0710a6e-bffc-4971-8893-1c23addeb5b0" providerId="ADAL" clId="{804748DF-446B-437F-AFFB-E1B8A8B41FF1}" dt="2023-01-31T20:07:04.913" v="5707" actId="1037"/>
          <ac:spMkLst>
            <pc:docMk/>
            <pc:sldMk cId="3774057072" sldId="329"/>
            <ac:spMk id="21" creationId="{13801797-3EC6-017F-2FE4-70F6DD6CACFC}"/>
          </ac:spMkLst>
        </pc:spChg>
        <pc:spChg chg="add mod">
          <ac:chgData name="Kumar, Vinod" userId="a0710a6e-bffc-4971-8893-1c23addeb5b0" providerId="ADAL" clId="{804748DF-446B-437F-AFFB-E1B8A8B41FF1}" dt="2023-01-31T20:06:59.225" v="5699" actId="14100"/>
          <ac:spMkLst>
            <pc:docMk/>
            <pc:sldMk cId="3774057072" sldId="329"/>
            <ac:spMk id="22" creationId="{04D5F491-4895-C2C2-CE0E-14705CCE2526}"/>
          </ac:spMkLst>
        </pc:spChg>
        <pc:spChg chg="add mod">
          <ac:chgData name="Kumar, Vinod" userId="a0710a6e-bffc-4971-8893-1c23addeb5b0" providerId="ADAL" clId="{804748DF-446B-437F-AFFB-E1B8A8B41FF1}" dt="2023-01-31T20:06:51.490" v="5698" actId="1038"/>
          <ac:spMkLst>
            <pc:docMk/>
            <pc:sldMk cId="3774057072" sldId="329"/>
            <ac:spMk id="23" creationId="{5133D086-0C5A-620F-C04F-5386CE573F5C}"/>
          </ac:spMkLst>
        </pc:spChg>
        <pc:spChg chg="add mod">
          <ac:chgData name="Kumar, Vinod" userId="a0710a6e-bffc-4971-8893-1c23addeb5b0" providerId="ADAL" clId="{804748DF-446B-437F-AFFB-E1B8A8B41FF1}" dt="2023-01-31T20:06:04.869" v="5688" actId="113"/>
          <ac:spMkLst>
            <pc:docMk/>
            <pc:sldMk cId="3774057072" sldId="329"/>
            <ac:spMk id="27" creationId="{266E0286-71E7-1816-E896-7BAB3A4C4A83}"/>
          </ac:spMkLst>
        </pc:spChg>
        <pc:spChg chg="add mod">
          <ac:chgData name="Kumar, Vinod" userId="a0710a6e-bffc-4971-8893-1c23addeb5b0" providerId="ADAL" clId="{804748DF-446B-437F-AFFB-E1B8A8B41FF1}" dt="2023-01-31T20:07:44.977" v="5753" actId="1035"/>
          <ac:spMkLst>
            <pc:docMk/>
            <pc:sldMk cId="3774057072" sldId="329"/>
            <ac:spMk id="28" creationId="{8695357D-776D-03CE-85AB-1E8EDB13B6DC}"/>
          </ac:spMkLst>
        </pc:spChg>
        <pc:spChg chg="add mod">
          <ac:chgData name="Kumar, Vinod" userId="a0710a6e-bffc-4971-8893-1c23addeb5b0" providerId="ADAL" clId="{804748DF-446B-437F-AFFB-E1B8A8B41FF1}" dt="2023-01-31T20:07:50.913" v="5761" actId="1036"/>
          <ac:spMkLst>
            <pc:docMk/>
            <pc:sldMk cId="3774057072" sldId="329"/>
            <ac:spMk id="29" creationId="{C66F1703-919B-3287-E895-363F803BC2EE}"/>
          </ac:spMkLst>
        </pc:spChg>
        <pc:spChg chg="add mod">
          <ac:chgData name="Kumar, Vinod" userId="a0710a6e-bffc-4971-8893-1c23addeb5b0" providerId="ADAL" clId="{804748DF-446B-437F-AFFB-E1B8A8B41FF1}" dt="2023-01-31T20:06:04.869" v="5688" actId="113"/>
          <ac:spMkLst>
            <pc:docMk/>
            <pc:sldMk cId="3774057072" sldId="329"/>
            <ac:spMk id="30" creationId="{DF80C0CE-5CE8-F718-13B7-43C032DEBA07}"/>
          </ac:spMkLst>
        </pc:spChg>
        <pc:spChg chg="add mod">
          <ac:chgData name="Kumar, Vinod" userId="a0710a6e-bffc-4971-8893-1c23addeb5b0" providerId="ADAL" clId="{804748DF-446B-437F-AFFB-E1B8A8B41FF1}" dt="2023-01-31T20:06:04.869" v="5688" actId="113"/>
          <ac:spMkLst>
            <pc:docMk/>
            <pc:sldMk cId="3774057072" sldId="329"/>
            <ac:spMk id="31" creationId="{E44D37A2-2EA8-54A4-B64F-1ECFB93B78C4}"/>
          </ac:spMkLst>
        </pc:spChg>
        <pc:spChg chg="add mod">
          <ac:chgData name="Kumar, Vinod" userId="a0710a6e-bffc-4971-8893-1c23addeb5b0" providerId="ADAL" clId="{804748DF-446B-437F-AFFB-E1B8A8B41FF1}" dt="2023-01-31T20:07:57.585" v="5770" actId="1038"/>
          <ac:spMkLst>
            <pc:docMk/>
            <pc:sldMk cId="3774057072" sldId="329"/>
            <ac:spMk id="33" creationId="{707073B4-8491-B410-5598-EC1FCEE8FEF2}"/>
          </ac:spMkLst>
        </pc:spChg>
        <pc:spChg chg="add mod">
          <ac:chgData name="Kumar, Vinod" userId="a0710a6e-bffc-4971-8893-1c23addeb5b0" providerId="ADAL" clId="{804748DF-446B-437F-AFFB-E1B8A8B41FF1}" dt="2023-01-31T20:08:21.644" v="5797" actId="20577"/>
          <ac:spMkLst>
            <pc:docMk/>
            <pc:sldMk cId="3774057072" sldId="329"/>
            <ac:spMk id="36" creationId="{D2AB444E-E9BC-899E-F793-B1C055F3EFDA}"/>
          </ac:spMkLst>
        </pc:spChg>
        <pc:spChg chg="add del mod">
          <ac:chgData name="Kumar, Vinod" userId="a0710a6e-bffc-4971-8893-1c23addeb5b0" providerId="ADAL" clId="{804748DF-446B-437F-AFFB-E1B8A8B41FF1}" dt="2023-01-30T16:29:20.672" v="1666" actId="478"/>
          <ac:spMkLst>
            <pc:docMk/>
            <pc:sldMk cId="3774057072" sldId="329"/>
            <ac:spMk id="37" creationId="{2AD0116F-52D7-4595-C6AF-011CAD086E04}"/>
          </ac:spMkLst>
        </pc:spChg>
        <pc:spChg chg="add del mod topLvl">
          <ac:chgData name="Kumar, Vinod" userId="a0710a6e-bffc-4971-8893-1c23addeb5b0" providerId="ADAL" clId="{804748DF-446B-437F-AFFB-E1B8A8B41FF1}" dt="2023-01-31T20:11:36.070" v="5862" actId="164"/>
          <ac:spMkLst>
            <pc:docMk/>
            <pc:sldMk cId="3774057072" sldId="329"/>
            <ac:spMk id="38" creationId="{66343826-FC5D-988A-9F64-D4F19FE8DBD5}"/>
          </ac:spMkLst>
        </pc:spChg>
        <pc:spChg chg="add del mod topLvl">
          <ac:chgData name="Kumar, Vinod" userId="a0710a6e-bffc-4971-8893-1c23addeb5b0" providerId="ADAL" clId="{804748DF-446B-437F-AFFB-E1B8A8B41FF1}" dt="2023-01-31T20:11:36.070" v="5862" actId="164"/>
          <ac:spMkLst>
            <pc:docMk/>
            <pc:sldMk cId="3774057072" sldId="329"/>
            <ac:spMk id="39" creationId="{74357236-3129-95D0-11A8-BD84EB42DC3C}"/>
          </ac:spMkLst>
        </pc:spChg>
        <pc:spChg chg="add del mod topLvl">
          <ac:chgData name="Kumar, Vinod" userId="a0710a6e-bffc-4971-8893-1c23addeb5b0" providerId="ADAL" clId="{804748DF-446B-437F-AFFB-E1B8A8B41FF1}" dt="2023-01-31T20:11:36.070" v="5862" actId="164"/>
          <ac:spMkLst>
            <pc:docMk/>
            <pc:sldMk cId="3774057072" sldId="329"/>
            <ac:spMk id="43" creationId="{BD18DA10-E156-1F0B-5DB2-B95B7A16B264}"/>
          </ac:spMkLst>
        </pc:spChg>
        <pc:spChg chg="add del mod topLvl">
          <ac:chgData name="Kumar, Vinod" userId="a0710a6e-bffc-4971-8893-1c23addeb5b0" providerId="ADAL" clId="{804748DF-446B-437F-AFFB-E1B8A8B41FF1}" dt="2023-01-31T20:11:36.070" v="5862" actId="164"/>
          <ac:spMkLst>
            <pc:docMk/>
            <pc:sldMk cId="3774057072" sldId="329"/>
            <ac:spMk id="44" creationId="{0F9F7BC8-0B1B-DACD-E54E-E474547F09A3}"/>
          </ac:spMkLst>
        </pc:spChg>
        <pc:spChg chg="add del mod">
          <ac:chgData name="Kumar, Vinod" userId="a0710a6e-bffc-4971-8893-1c23addeb5b0" providerId="ADAL" clId="{804748DF-446B-437F-AFFB-E1B8A8B41FF1}" dt="2023-01-30T16:33:06.863" v="1893" actId="478"/>
          <ac:spMkLst>
            <pc:docMk/>
            <pc:sldMk cId="3774057072" sldId="329"/>
            <ac:spMk id="48" creationId="{1137B37C-9533-9753-3531-CEB99E422952}"/>
          </ac:spMkLst>
        </pc:spChg>
        <pc:spChg chg="add del mod">
          <ac:chgData name="Kumar, Vinod" userId="a0710a6e-bffc-4971-8893-1c23addeb5b0" providerId="ADAL" clId="{804748DF-446B-437F-AFFB-E1B8A8B41FF1}" dt="2023-01-30T16:30:54.544" v="1785" actId="478"/>
          <ac:spMkLst>
            <pc:docMk/>
            <pc:sldMk cId="3774057072" sldId="329"/>
            <ac:spMk id="49" creationId="{257F711C-A4B9-57D9-A10D-4498C92D7CA9}"/>
          </ac:spMkLst>
        </pc:spChg>
        <pc:spChg chg="add del mod topLvl">
          <ac:chgData name="Kumar, Vinod" userId="a0710a6e-bffc-4971-8893-1c23addeb5b0" providerId="ADAL" clId="{804748DF-446B-437F-AFFB-E1B8A8B41FF1}" dt="2023-01-31T20:11:44.991" v="5863" actId="164"/>
          <ac:spMkLst>
            <pc:docMk/>
            <pc:sldMk cId="3774057072" sldId="329"/>
            <ac:spMk id="50" creationId="{E4D13177-1827-E066-DC18-88705869F1CF}"/>
          </ac:spMkLst>
        </pc:spChg>
        <pc:spChg chg="add del mod topLvl">
          <ac:chgData name="Kumar, Vinod" userId="a0710a6e-bffc-4971-8893-1c23addeb5b0" providerId="ADAL" clId="{804748DF-446B-437F-AFFB-E1B8A8B41FF1}" dt="2023-01-31T20:11:36.070" v="5862" actId="164"/>
          <ac:spMkLst>
            <pc:docMk/>
            <pc:sldMk cId="3774057072" sldId="329"/>
            <ac:spMk id="51" creationId="{BAC8A5AC-3DCB-501E-DCA0-9724E3E895B3}"/>
          </ac:spMkLst>
        </pc:spChg>
        <pc:spChg chg="add del mod topLvl">
          <ac:chgData name="Kumar, Vinod" userId="a0710a6e-bffc-4971-8893-1c23addeb5b0" providerId="ADAL" clId="{804748DF-446B-437F-AFFB-E1B8A8B41FF1}" dt="2023-01-31T20:11:36.070" v="5862" actId="164"/>
          <ac:spMkLst>
            <pc:docMk/>
            <pc:sldMk cId="3774057072" sldId="329"/>
            <ac:spMk id="53" creationId="{6861DBF5-C698-0599-1C2E-2A09F5166DFE}"/>
          </ac:spMkLst>
        </pc:spChg>
        <pc:spChg chg="add del mod topLvl">
          <ac:chgData name="Kumar, Vinod" userId="a0710a6e-bffc-4971-8893-1c23addeb5b0" providerId="ADAL" clId="{804748DF-446B-437F-AFFB-E1B8A8B41FF1}" dt="2023-01-31T20:11:36.070" v="5862" actId="164"/>
          <ac:spMkLst>
            <pc:docMk/>
            <pc:sldMk cId="3774057072" sldId="329"/>
            <ac:spMk id="61" creationId="{07083F25-C2EA-BED3-50C3-996A6E9BF6A8}"/>
          </ac:spMkLst>
        </pc:spChg>
        <pc:spChg chg="add del mod topLvl">
          <ac:chgData name="Kumar, Vinod" userId="a0710a6e-bffc-4971-8893-1c23addeb5b0" providerId="ADAL" clId="{804748DF-446B-437F-AFFB-E1B8A8B41FF1}" dt="2023-01-31T20:11:36.070" v="5862" actId="164"/>
          <ac:spMkLst>
            <pc:docMk/>
            <pc:sldMk cId="3774057072" sldId="329"/>
            <ac:spMk id="62" creationId="{2BA85945-7B11-27EE-0538-7D3B6F589045}"/>
          </ac:spMkLst>
        </pc:spChg>
        <pc:spChg chg="add del mod topLvl">
          <ac:chgData name="Kumar, Vinod" userId="a0710a6e-bffc-4971-8893-1c23addeb5b0" providerId="ADAL" clId="{804748DF-446B-437F-AFFB-E1B8A8B41FF1}" dt="2023-01-31T20:11:36.070" v="5862" actId="164"/>
          <ac:spMkLst>
            <pc:docMk/>
            <pc:sldMk cId="3774057072" sldId="329"/>
            <ac:spMk id="63" creationId="{F83BA2B7-B2CB-EAA7-8970-7013C26F0EF4}"/>
          </ac:spMkLst>
        </pc:spChg>
        <pc:spChg chg="add del mod topLvl">
          <ac:chgData name="Kumar, Vinod" userId="a0710a6e-bffc-4971-8893-1c23addeb5b0" providerId="ADAL" clId="{804748DF-446B-437F-AFFB-E1B8A8B41FF1}" dt="2023-01-31T20:11:36.070" v="5862" actId="164"/>
          <ac:spMkLst>
            <pc:docMk/>
            <pc:sldMk cId="3774057072" sldId="329"/>
            <ac:spMk id="64" creationId="{3A16F362-32EB-C377-72A0-46C24139606C}"/>
          </ac:spMkLst>
        </pc:spChg>
        <pc:grpChg chg="add del mod">
          <ac:chgData name="Kumar, Vinod" userId="a0710a6e-bffc-4971-8893-1c23addeb5b0" providerId="ADAL" clId="{804748DF-446B-437F-AFFB-E1B8A8B41FF1}" dt="2023-01-30T15:30:48.685" v="959" actId="165"/>
          <ac:grpSpMkLst>
            <pc:docMk/>
            <pc:sldMk cId="3774057072" sldId="329"/>
            <ac:grpSpMk id="12" creationId="{84DE81FA-9380-16D9-51BA-9D74448B421C}"/>
          </ac:grpSpMkLst>
        </pc:grpChg>
        <pc:grpChg chg="add del mod">
          <ac:chgData name="Kumar, Vinod" userId="a0710a6e-bffc-4971-8893-1c23addeb5b0" providerId="ADAL" clId="{804748DF-446B-437F-AFFB-E1B8A8B41FF1}" dt="2023-01-31T20:10:00.448" v="5809" actId="165"/>
          <ac:grpSpMkLst>
            <pc:docMk/>
            <pc:sldMk cId="3774057072" sldId="329"/>
            <ac:grpSpMk id="12" creationId="{95E63788-2B08-7985-26D9-212FD7D7E19E}"/>
          </ac:grpSpMkLst>
        </pc:grpChg>
        <pc:grpChg chg="add mod">
          <ac:chgData name="Kumar, Vinod" userId="a0710a6e-bffc-4971-8893-1c23addeb5b0" providerId="ADAL" clId="{804748DF-446B-437F-AFFB-E1B8A8B41FF1}" dt="2023-01-31T20:11:44.991" v="5863" actId="164"/>
          <ac:grpSpMkLst>
            <pc:docMk/>
            <pc:sldMk cId="3774057072" sldId="329"/>
            <ac:grpSpMk id="15" creationId="{92B71164-2B03-D3DF-86ED-3D6DD6D554F7}"/>
          </ac:grpSpMkLst>
        </pc:grpChg>
        <pc:grpChg chg="add mod">
          <ac:chgData name="Kumar, Vinod" userId="a0710a6e-bffc-4971-8893-1c23addeb5b0" providerId="ADAL" clId="{804748DF-446B-437F-AFFB-E1B8A8B41FF1}" dt="2023-01-31T20:13:18.462" v="5874" actId="1076"/>
          <ac:grpSpMkLst>
            <pc:docMk/>
            <pc:sldMk cId="3774057072" sldId="329"/>
            <ac:grpSpMk id="19" creationId="{6970C0BE-8814-C445-6796-DD95F2120F7C}"/>
          </ac:grpSpMkLst>
        </pc:grpChg>
        <pc:grpChg chg="add mod">
          <ac:chgData name="Kumar, Vinod" userId="a0710a6e-bffc-4971-8893-1c23addeb5b0" providerId="ADAL" clId="{804748DF-446B-437F-AFFB-E1B8A8B41FF1}" dt="2023-01-31T20:06:36.162" v="5692" actId="14100"/>
          <ac:grpSpMkLst>
            <pc:docMk/>
            <pc:sldMk cId="3774057072" sldId="329"/>
            <ac:grpSpMk id="24" creationId="{D4C0077C-1EEB-D0CF-CB93-13C92A0180BE}"/>
          </ac:grpSpMkLst>
        </pc:grpChg>
        <pc:grpChg chg="add mod">
          <ac:chgData name="Kumar, Vinod" userId="a0710a6e-bffc-4971-8893-1c23addeb5b0" providerId="ADAL" clId="{804748DF-446B-437F-AFFB-E1B8A8B41FF1}" dt="2023-01-31T20:08:13.318" v="5789" actId="1037"/>
          <ac:grpSpMkLst>
            <pc:docMk/>
            <pc:sldMk cId="3774057072" sldId="329"/>
            <ac:grpSpMk id="34" creationId="{F54FCB98-7904-4A04-9578-5725393B565B}"/>
          </ac:grpSpMkLst>
        </pc:grpChg>
        <pc:grpChg chg="add mod">
          <ac:chgData name="Kumar, Vinod" userId="a0710a6e-bffc-4971-8893-1c23addeb5b0" providerId="ADAL" clId="{804748DF-446B-437F-AFFB-E1B8A8B41FF1}" dt="2023-01-31T20:08:10.112" v="5781" actId="1038"/>
          <ac:grpSpMkLst>
            <pc:docMk/>
            <pc:sldMk cId="3774057072" sldId="329"/>
            <ac:grpSpMk id="35" creationId="{84C818F3-34AB-A874-4F45-CF63E81D556B}"/>
          </ac:grpSpMkLst>
        </pc:grpChg>
        <pc:picChg chg="add mod modCrop">
          <ac:chgData name="Kumar, Vinod" userId="a0710a6e-bffc-4971-8893-1c23addeb5b0" providerId="ADAL" clId="{804748DF-446B-437F-AFFB-E1B8A8B41FF1}" dt="2023-01-30T16:20:09.894" v="1360" actId="164"/>
          <ac:picMkLst>
            <pc:docMk/>
            <pc:sldMk cId="3774057072" sldId="329"/>
            <ac:picMk id="4" creationId="{F7D5C3E1-046C-C954-8AFE-0601EA2D92D1}"/>
          </ac:picMkLst>
        </pc:picChg>
        <pc:picChg chg="mod topLvl">
          <ac:chgData name="Kumar, Vinod" userId="a0710a6e-bffc-4971-8893-1c23addeb5b0" providerId="ADAL" clId="{804748DF-446B-437F-AFFB-E1B8A8B41FF1}" dt="2023-01-30T15:34:35.230" v="1161" actId="164"/>
          <ac:picMkLst>
            <pc:docMk/>
            <pc:sldMk cId="3774057072" sldId="329"/>
            <ac:picMk id="13" creationId="{571AC455-6043-9740-FAEF-4ECA8736B293}"/>
          </ac:picMkLst>
        </pc:picChg>
        <pc:picChg chg="mod topLvl">
          <ac:chgData name="Kumar, Vinod" userId="a0710a6e-bffc-4971-8893-1c23addeb5b0" providerId="ADAL" clId="{804748DF-446B-437F-AFFB-E1B8A8B41FF1}" dt="2023-01-30T15:34:35.230" v="1161" actId="164"/>
          <ac:picMkLst>
            <pc:docMk/>
            <pc:sldMk cId="3774057072" sldId="329"/>
            <ac:picMk id="14" creationId="{F302FA9A-E832-E9B7-3208-97268D825F75}"/>
          </ac:picMkLst>
        </pc:picChg>
        <pc:picChg chg="del mod topLvl">
          <ac:chgData name="Kumar, Vinod" userId="a0710a6e-bffc-4971-8893-1c23addeb5b0" providerId="ADAL" clId="{804748DF-446B-437F-AFFB-E1B8A8B41FF1}" dt="2023-01-30T15:30:53.242" v="960" actId="478"/>
          <ac:picMkLst>
            <pc:docMk/>
            <pc:sldMk cId="3774057072" sldId="329"/>
            <ac:picMk id="15" creationId="{DBAD83FE-8F06-9F34-2417-AF0644A03A4D}"/>
          </ac:picMkLst>
        </pc:picChg>
        <pc:picChg chg="add mod modCrop">
          <ac:chgData name="Kumar, Vinod" userId="a0710a6e-bffc-4971-8893-1c23addeb5b0" providerId="ADAL" clId="{804748DF-446B-437F-AFFB-E1B8A8B41FF1}" dt="2023-01-30T16:19:54.486" v="1359" actId="164"/>
          <ac:picMkLst>
            <pc:docMk/>
            <pc:sldMk cId="3774057072" sldId="329"/>
            <ac:picMk id="26" creationId="{E07B2531-8B2C-E8DC-7E38-EA49EE6FA8CA}"/>
          </ac:picMkLst>
        </pc:picChg>
        <pc:picChg chg="add del mod">
          <ac:chgData name="Kumar, Vinod" userId="a0710a6e-bffc-4971-8893-1c23addeb5b0" providerId="ADAL" clId="{804748DF-446B-437F-AFFB-E1B8A8B41FF1}" dt="2023-01-30T16:29:18.208" v="1665" actId="478"/>
          <ac:picMkLst>
            <pc:docMk/>
            <pc:sldMk cId="3774057072" sldId="329"/>
            <ac:picMk id="40" creationId="{436521A8-35C2-41AE-DCE6-1944D7244E33}"/>
          </ac:picMkLst>
        </pc:picChg>
        <pc:picChg chg="add del mod topLvl">
          <ac:chgData name="Kumar, Vinod" userId="a0710a6e-bffc-4971-8893-1c23addeb5b0" providerId="ADAL" clId="{804748DF-446B-437F-AFFB-E1B8A8B41FF1}" dt="2023-01-31T20:11:36.070" v="5862" actId="164"/>
          <ac:picMkLst>
            <pc:docMk/>
            <pc:sldMk cId="3774057072" sldId="329"/>
            <ac:picMk id="41" creationId="{288CCA2E-E773-36E0-9A10-8252B43AFD5E}"/>
          </ac:picMkLst>
        </pc:picChg>
        <pc:picChg chg="add del mod topLvl">
          <ac:chgData name="Kumar, Vinod" userId="a0710a6e-bffc-4971-8893-1c23addeb5b0" providerId="ADAL" clId="{804748DF-446B-437F-AFFB-E1B8A8B41FF1}" dt="2023-01-31T20:11:36.070" v="5862" actId="164"/>
          <ac:picMkLst>
            <pc:docMk/>
            <pc:sldMk cId="3774057072" sldId="329"/>
            <ac:picMk id="42" creationId="{7AC2EDDA-9497-A706-ECB6-E4434BC0935A}"/>
          </ac:picMkLst>
        </pc:picChg>
        <pc:picChg chg="add del mod topLvl">
          <ac:chgData name="Kumar, Vinod" userId="a0710a6e-bffc-4971-8893-1c23addeb5b0" providerId="ADAL" clId="{804748DF-446B-437F-AFFB-E1B8A8B41FF1}" dt="2023-01-31T20:11:36.070" v="5862" actId="164"/>
          <ac:picMkLst>
            <pc:docMk/>
            <pc:sldMk cId="3774057072" sldId="329"/>
            <ac:picMk id="52" creationId="{7B48A15E-5FC3-8ECA-D818-D5974D5D574B}"/>
          </ac:picMkLst>
        </pc:picChg>
        <pc:picChg chg="add del mod topLvl">
          <ac:chgData name="Kumar, Vinod" userId="a0710a6e-bffc-4971-8893-1c23addeb5b0" providerId="ADAL" clId="{804748DF-446B-437F-AFFB-E1B8A8B41FF1}" dt="2023-01-31T20:11:36.070" v="5862" actId="164"/>
          <ac:picMkLst>
            <pc:docMk/>
            <pc:sldMk cId="3774057072" sldId="329"/>
            <ac:picMk id="54" creationId="{B5AC51C2-B49F-8C74-E465-C4E7879101DC}"/>
          </ac:picMkLst>
        </pc:picChg>
        <pc:cxnChg chg="add mod">
          <ac:chgData name="Kumar, Vinod" userId="a0710a6e-bffc-4971-8893-1c23addeb5b0" providerId="ADAL" clId="{804748DF-446B-437F-AFFB-E1B8A8B41FF1}" dt="2023-01-30T16:20:09.894" v="1360" actId="164"/>
          <ac:cxnSpMkLst>
            <pc:docMk/>
            <pc:sldMk cId="3774057072" sldId="329"/>
            <ac:cxnSpMk id="10" creationId="{0271B8A6-B34E-8D8C-7988-491AB73715D3}"/>
          </ac:cxnSpMkLst>
        </pc:cxnChg>
        <pc:cxnChg chg="mod topLvl">
          <ac:chgData name="Kumar, Vinod" userId="a0710a6e-bffc-4971-8893-1c23addeb5b0" providerId="ADAL" clId="{804748DF-446B-437F-AFFB-E1B8A8B41FF1}" dt="2023-01-30T15:34:35.230" v="1161" actId="164"/>
          <ac:cxnSpMkLst>
            <pc:docMk/>
            <pc:sldMk cId="3774057072" sldId="329"/>
            <ac:cxnSpMk id="17" creationId="{339146BF-7AF3-92FE-BCFE-A8526AE0EC49}"/>
          </ac:cxnSpMkLst>
        </pc:cxnChg>
        <pc:cxnChg chg="add mod">
          <ac:chgData name="Kumar, Vinod" userId="a0710a6e-bffc-4971-8893-1c23addeb5b0" providerId="ADAL" clId="{804748DF-446B-437F-AFFB-E1B8A8B41FF1}" dt="2023-01-30T16:19:54.486" v="1359" actId="164"/>
          <ac:cxnSpMkLst>
            <pc:docMk/>
            <pc:sldMk cId="3774057072" sldId="329"/>
            <ac:cxnSpMk id="32" creationId="{49060472-09C6-B6CB-0FF4-DAACC66DE239}"/>
          </ac:cxnSpMkLst>
        </pc:cxnChg>
        <pc:cxnChg chg="add del mod topLvl">
          <ac:chgData name="Kumar, Vinod" userId="a0710a6e-bffc-4971-8893-1c23addeb5b0" providerId="ADAL" clId="{804748DF-446B-437F-AFFB-E1B8A8B41FF1}" dt="2023-01-31T20:11:36.070" v="5862" actId="164"/>
          <ac:cxnSpMkLst>
            <pc:docMk/>
            <pc:sldMk cId="3774057072" sldId="329"/>
            <ac:cxnSpMk id="45" creationId="{D5FB7389-13C5-AD31-0929-5F2D15E93045}"/>
          </ac:cxnSpMkLst>
        </pc:cxnChg>
        <pc:cxnChg chg="add del mod topLvl">
          <ac:chgData name="Kumar, Vinod" userId="a0710a6e-bffc-4971-8893-1c23addeb5b0" providerId="ADAL" clId="{804748DF-446B-437F-AFFB-E1B8A8B41FF1}" dt="2023-01-31T20:11:36.070" v="5862" actId="164"/>
          <ac:cxnSpMkLst>
            <pc:docMk/>
            <pc:sldMk cId="3774057072" sldId="329"/>
            <ac:cxnSpMk id="46" creationId="{60577434-1E51-54EE-7280-B252633027B2}"/>
          </ac:cxnSpMkLst>
        </pc:cxnChg>
        <pc:cxnChg chg="add del mod topLvl">
          <ac:chgData name="Kumar, Vinod" userId="a0710a6e-bffc-4971-8893-1c23addeb5b0" providerId="ADAL" clId="{804748DF-446B-437F-AFFB-E1B8A8B41FF1}" dt="2023-01-31T20:11:36.070" v="5862" actId="164"/>
          <ac:cxnSpMkLst>
            <pc:docMk/>
            <pc:sldMk cId="3774057072" sldId="329"/>
            <ac:cxnSpMk id="47" creationId="{DBB36165-00D0-0A2E-7B04-E0A413E9BD5D}"/>
          </ac:cxnSpMkLst>
        </pc:cxnChg>
      </pc:sldChg>
      <pc:sldChg chg="addSp delSp modSp new mod">
        <pc:chgData name="Kumar, Vinod" userId="a0710a6e-bffc-4971-8893-1c23addeb5b0" providerId="ADAL" clId="{804748DF-446B-437F-AFFB-E1B8A8B41FF1}" dt="2023-01-31T20:17:32.420" v="5986" actId="1076"/>
        <pc:sldMkLst>
          <pc:docMk/>
          <pc:sldMk cId="796278249" sldId="330"/>
        </pc:sldMkLst>
        <pc:spChg chg="add mod topLvl">
          <ac:chgData name="Kumar, Vinod" userId="a0710a6e-bffc-4971-8893-1c23addeb5b0" providerId="ADAL" clId="{804748DF-446B-437F-AFFB-E1B8A8B41FF1}" dt="2023-01-31T20:13:47.253" v="5876" actId="14100"/>
          <ac:spMkLst>
            <pc:docMk/>
            <pc:sldMk cId="796278249" sldId="330"/>
            <ac:spMk id="6" creationId="{D47BC60C-C63D-03C8-0466-609E68106F37}"/>
          </ac:spMkLst>
        </pc:spChg>
        <pc:spChg chg="add mod topLvl">
          <ac:chgData name="Kumar, Vinod" userId="a0710a6e-bffc-4971-8893-1c23addeb5b0" providerId="ADAL" clId="{804748DF-446B-437F-AFFB-E1B8A8B41FF1}" dt="2023-01-31T20:14:11.549" v="5882" actId="1036"/>
          <ac:spMkLst>
            <pc:docMk/>
            <pc:sldMk cId="796278249" sldId="330"/>
            <ac:spMk id="7" creationId="{E8F52E95-6021-C775-50BC-BAC784092154}"/>
          </ac:spMkLst>
        </pc:spChg>
        <pc:spChg chg="add mod topLvl">
          <ac:chgData name="Kumar, Vinod" userId="a0710a6e-bffc-4971-8893-1c23addeb5b0" providerId="ADAL" clId="{804748DF-446B-437F-AFFB-E1B8A8B41FF1}" dt="2023-01-31T20:13:49.631" v="5877" actId="1037"/>
          <ac:spMkLst>
            <pc:docMk/>
            <pc:sldMk cId="796278249" sldId="330"/>
            <ac:spMk id="10" creationId="{B24A1674-70D8-1CEA-096B-1E05CFF7AA3A}"/>
          </ac:spMkLst>
        </pc:spChg>
        <pc:spChg chg="add mod topLvl">
          <ac:chgData name="Kumar, Vinod" userId="a0710a6e-bffc-4971-8893-1c23addeb5b0" providerId="ADAL" clId="{804748DF-446B-437F-AFFB-E1B8A8B41FF1}" dt="2023-01-31T20:14:55.566" v="5918" actId="1037"/>
          <ac:spMkLst>
            <pc:docMk/>
            <pc:sldMk cId="796278249" sldId="330"/>
            <ac:spMk id="11" creationId="{B837866C-D371-F4F0-8982-3157923780C9}"/>
          </ac:spMkLst>
        </pc:spChg>
        <pc:spChg chg="add mod topLvl">
          <ac:chgData name="Kumar, Vinod" userId="a0710a6e-bffc-4971-8893-1c23addeb5b0" providerId="ADAL" clId="{804748DF-446B-437F-AFFB-E1B8A8B41FF1}" dt="2023-01-31T20:14:38.254" v="5899" actId="20577"/>
          <ac:spMkLst>
            <pc:docMk/>
            <pc:sldMk cId="796278249" sldId="330"/>
            <ac:spMk id="15" creationId="{C10FAE3A-3E27-977C-9C9E-74714BC28EC6}"/>
          </ac:spMkLst>
        </pc:spChg>
        <pc:spChg chg="add mod topLvl">
          <ac:chgData name="Kumar, Vinod" userId="a0710a6e-bffc-4971-8893-1c23addeb5b0" providerId="ADAL" clId="{804748DF-446B-437F-AFFB-E1B8A8B41FF1}" dt="2023-01-31T20:15:08.094" v="5937" actId="1036"/>
          <ac:spMkLst>
            <pc:docMk/>
            <pc:sldMk cId="796278249" sldId="330"/>
            <ac:spMk id="16" creationId="{C15693CC-BFE8-0889-2EE0-B93CA0FCD96F}"/>
          </ac:spMkLst>
        </pc:spChg>
        <pc:spChg chg="add mod topLvl">
          <ac:chgData name="Kumar, Vinod" userId="a0710a6e-bffc-4971-8893-1c23addeb5b0" providerId="ADAL" clId="{804748DF-446B-437F-AFFB-E1B8A8B41FF1}" dt="2023-01-31T20:13:52.542" v="5878" actId="1037"/>
          <ac:spMkLst>
            <pc:docMk/>
            <pc:sldMk cId="796278249" sldId="330"/>
            <ac:spMk id="18" creationId="{CA55D5EE-E8DD-620D-9205-89DF36511B89}"/>
          </ac:spMkLst>
        </pc:spChg>
        <pc:spChg chg="add del mod">
          <ac:chgData name="Kumar, Vinod" userId="a0710a6e-bffc-4971-8893-1c23addeb5b0" providerId="ADAL" clId="{804748DF-446B-437F-AFFB-E1B8A8B41FF1}" dt="2023-01-30T17:12:53.452" v="2497" actId="478"/>
          <ac:spMkLst>
            <pc:docMk/>
            <pc:sldMk cId="796278249" sldId="330"/>
            <ac:spMk id="20" creationId="{D253F453-C958-3DB4-626D-047CB7341289}"/>
          </ac:spMkLst>
        </pc:spChg>
        <pc:spChg chg="add del mod">
          <ac:chgData name="Kumar, Vinod" userId="a0710a6e-bffc-4971-8893-1c23addeb5b0" providerId="ADAL" clId="{804748DF-446B-437F-AFFB-E1B8A8B41FF1}" dt="2023-01-30T17:12:53.452" v="2497" actId="478"/>
          <ac:spMkLst>
            <pc:docMk/>
            <pc:sldMk cId="796278249" sldId="330"/>
            <ac:spMk id="21" creationId="{D6F166B2-92E1-930E-7AD4-7EAD0C94000A}"/>
          </ac:spMkLst>
        </pc:spChg>
        <pc:spChg chg="add mod topLvl">
          <ac:chgData name="Kumar, Vinod" userId="a0710a6e-bffc-4971-8893-1c23addeb5b0" providerId="ADAL" clId="{804748DF-446B-437F-AFFB-E1B8A8B41FF1}" dt="2023-01-31T20:17:32.420" v="5986" actId="1076"/>
          <ac:spMkLst>
            <pc:docMk/>
            <pc:sldMk cId="796278249" sldId="330"/>
            <ac:spMk id="22" creationId="{54F712CC-0ECA-1CE2-3F13-A8951971109E}"/>
          </ac:spMkLst>
        </pc:spChg>
        <pc:spChg chg="add del mod">
          <ac:chgData name="Kumar, Vinod" userId="a0710a6e-bffc-4971-8893-1c23addeb5b0" providerId="ADAL" clId="{804748DF-446B-437F-AFFB-E1B8A8B41FF1}" dt="2023-01-30T17:12:53.452" v="2497" actId="478"/>
          <ac:spMkLst>
            <pc:docMk/>
            <pc:sldMk cId="796278249" sldId="330"/>
            <ac:spMk id="22" creationId="{9211583C-6D7C-F9F3-156B-61C0BFF93B9A}"/>
          </ac:spMkLst>
        </pc:spChg>
        <pc:spChg chg="add del mod">
          <ac:chgData name="Kumar, Vinod" userId="a0710a6e-bffc-4971-8893-1c23addeb5b0" providerId="ADAL" clId="{804748DF-446B-437F-AFFB-E1B8A8B41FF1}" dt="2023-01-30T17:12:53.452" v="2497" actId="478"/>
          <ac:spMkLst>
            <pc:docMk/>
            <pc:sldMk cId="796278249" sldId="330"/>
            <ac:spMk id="23" creationId="{5DD0F660-70AB-010F-AA81-7DF8978C2F48}"/>
          </ac:spMkLst>
        </pc:spChg>
        <pc:spChg chg="add mod topLvl">
          <ac:chgData name="Kumar, Vinod" userId="a0710a6e-bffc-4971-8893-1c23addeb5b0" providerId="ADAL" clId="{804748DF-446B-437F-AFFB-E1B8A8B41FF1}" dt="2023-01-31T20:17:17.594" v="5984" actId="164"/>
          <ac:spMkLst>
            <pc:docMk/>
            <pc:sldMk cId="796278249" sldId="330"/>
            <ac:spMk id="23" creationId="{86E92857-83A2-22DB-FC2D-AA2B8795D554}"/>
          </ac:spMkLst>
        </pc:spChg>
        <pc:spChg chg="add mod topLvl">
          <ac:chgData name="Kumar, Vinod" userId="a0710a6e-bffc-4971-8893-1c23addeb5b0" providerId="ADAL" clId="{804748DF-446B-437F-AFFB-E1B8A8B41FF1}" dt="2023-01-31T20:15:20.285" v="5942" actId="1038"/>
          <ac:spMkLst>
            <pc:docMk/>
            <pc:sldMk cId="796278249" sldId="330"/>
            <ac:spMk id="24" creationId="{8A5A8FFC-5ADD-A5B9-0B47-74F4D85B8BC5}"/>
          </ac:spMkLst>
        </pc:spChg>
        <pc:spChg chg="add del mod">
          <ac:chgData name="Kumar, Vinod" userId="a0710a6e-bffc-4971-8893-1c23addeb5b0" providerId="ADAL" clId="{804748DF-446B-437F-AFFB-E1B8A8B41FF1}" dt="2023-01-30T17:12:51.293" v="2496" actId="478"/>
          <ac:spMkLst>
            <pc:docMk/>
            <pc:sldMk cId="796278249" sldId="330"/>
            <ac:spMk id="25" creationId="{7F7F77A1-3D3E-1DC5-8DD0-C4AD2DC9060D}"/>
          </ac:spMkLst>
        </pc:spChg>
        <pc:spChg chg="add mod topLvl">
          <ac:chgData name="Kumar, Vinod" userId="a0710a6e-bffc-4971-8893-1c23addeb5b0" providerId="ADAL" clId="{804748DF-446B-437F-AFFB-E1B8A8B41FF1}" dt="2023-01-31T20:17:17.594" v="5984" actId="164"/>
          <ac:spMkLst>
            <pc:docMk/>
            <pc:sldMk cId="796278249" sldId="330"/>
            <ac:spMk id="25" creationId="{8392B23A-CE2D-1A57-F8CE-D46FD179E6B9}"/>
          </ac:spMkLst>
        </pc:spChg>
        <pc:spChg chg="add mod topLvl">
          <ac:chgData name="Kumar, Vinod" userId="a0710a6e-bffc-4971-8893-1c23addeb5b0" providerId="ADAL" clId="{804748DF-446B-437F-AFFB-E1B8A8B41FF1}" dt="2023-01-31T20:12:37.931" v="5865" actId="113"/>
          <ac:spMkLst>
            <pc:docMk/>
            <pc:sldMk cId="796278249" sldId="330"/>
            <ac:spMk id="26" creationId="{2A7D8791-FC58-455D-CEB2-E32ECCB85FEA}"/>
          </ac:spMkLst>
        </pc:spChg>
        <pc:spChg chg="add mod topLvl">
          <ac:chgData name="Kumar, Vinod" userId="a0710a6e-bffc-4971-8893-1c23addeb5b0" providerId="ADAL" clId="{804748DF-446B-437F-AFFB-E1B8A8B41FF1}" dt="2023-01-31T20:12:37.931" v="5865" actId="113"/>
          <ac:spMkLst>
            <pc:docMk/>
            <pc:sldMk cId="796278249" sldId="330"/>
            <ac:spMk id="27" creationId="{D47EE8A1-DD93-BD31-E306-430278893743}"/>
          </ac:spMkLst>
        </pc:spChg>
        <pc:spChg chg="add mod topLvl">
          <ac:chgData name="Kumar, Vinod" userId="a0710a6e-bffc-4971-8893-1c23addeb5b0" providerId="ADAL" clId="{804748DF-446B-437F-AFFB-E1B8A8B41FF1}" dt="2023-01-31T20:12:37.931" v="5865" actId="113"/>
          <ac:spMkLst>
            <pc:docMk/>
            <pc:sldMk cId="796278249" sldId="330"/>
            <ac:spMk id="28" creationId="{CDAD8D63-5834-9607-A89F-45D2EEA6F518}"/>
          </ac:spMkLst>
        </pc:spChg>
        <pc:spChg chg="add mod topLvl">
          <ac:chgData name="Kumar, Vinod" userId="a0710a6e-bffc-4971-8893-1c23addeb5b0" providerId="ADAL" clId="{804748DF-446B-437F-AFFB-E1B8A8B41FF1}" dt="2023-01-31T20:17:17.594" v="5984" actId="164"/>
          <ac:spMkLst>
            <pc:docMk/>
            <pc:sldMk cId="796278249" sldId="330"/>
            <ac:spMk id="30" creationId="{2E9A42EB-2EBE-1AEB-E214-9DDE4116096A}"/>
          </ac:spMkLst>
        </pc:spChg>
        <pc:spChg chg="add mod topLvl">
          <ac:chgData name="Kumar, Vinod" userId="a0710a6e-bffc-4971-8893-1c23addeb5b0" providerId="ADAL" clId="{804748DF-446B-437F-AFFB-E1B8A8B41FF1}" dt="2023-01-31T20:17:17.594" v="5984" actId="164"/>
          <ac:spMkLst>
            <pc:docMk/>
            <pc:sldMk cId="796278249" sldId="330"/>
            <ac:spMk id="31" creationId="{A3DC1A93-E6B3-EF42-B4E4-A13BE8F6417F}"/>
          </ac:spMkLst>
        </pc:spChg>
        <pc:spChg chg="add mod topLvl">
          <ac:chgData name="Kumar, Vinod" userId="a0710a6e-bffc-4971-8893-1c23addeb5b0" providerId="ADAL" clId="{804748DF-446B-437F-AFFB-E1B8A8B41FF1}" dt="2023-01-31T20:17:17.594" v="5984" actId="164"/>
          <ac:spMkLst>
            <pc:docMk/>
            <pc:sldMk cId="796278249" sldId="330"/>
            <ac:spMk id="35" creationId="{D6844B94-767B-1C7E-67FC-35CAFF7936C4}"/>
          </ac:spMkLst>
        </pc:spChg>
        <pc:spChg chg="add mod topLvl">
          <ac:chgData name="Kumar, Vinod" userId="a0710a6e-bffc-4971-8893-1c23addeb5b0" providerId="ADAL" clId="{804748DF-446B-437F-AFFB-E1B8A8B41FF1}" dt="2023-01-31T20:17:17.594" v="5984" actId="164"/>
          <ac:spMkLst>
            <pc:docMk/>
            <pc:sldMk cId="796278249" sldId="330"/>
            <ac:spMk id="36" creationId="{41BDE54D-F408-ABF4-B6F7-5ECCC4F48A20}"/>
          </ac:spMkLst>
        </pc:spChg>
        <pc:spChg chg="add mod topLvl">
          <ac:chgData name="Kumar, Vinod" userId="a0710a6e-bffc-4971-8893-1c23addeb5b0" providerId="ADAL" clId="{804748DF-446B-437F-AFFB-E1B8A8B41FF1}" dt="2023-01-31T20:17:17.594" v="5984" actId="164"/>
          <ac:spMkLst>
            <pc:docMk/>
            <pc:sldMk cId="796278249" sldId="330"/>
            <ac:spMk id="37" creationId="{63493FF4-96D3-D4D5-FD49-37956372C223}"/>
          </ac:spMkLst>
        </pc:spChg>
        <pc:spChg chg="add mod topLvl">
          <ac:chgData name="Kumar, Vinod" userId="a0710a6e-bffc-4971-8893-1c23addeb5b0" providerId="ADAL" clId="{804748DF-446B-437F-AFFB-E1B8A8B41FF1}" dt="2023-01-31T20:17:17.594" v="5984" actId="164"/>
          <ac:spMkLst>
            <pc:docMk/>
            <pc:sldMk cId="796278249" sldId="330"/>
            <ac:spMk id="38" creationId="{E06645C0-C812-1699-F4AA-8BDF5B1507BB}"/>
          </ac:spMkLst>
        </pc:spChg>
        <pc:spChg chg="add mod topLvl">
          <ac:chgData name="Kumar, Vinod" userId="a0710a6e-bffc-4971-8893-1c23addeb5b0" providerId="ADAL" clId="{804748DF-446B-437F-AFFB-E1B8A8B41FF1}" dt="2023-01-31T20:17:17.594" v="5984" actId="164"/>
          <ac:spMkLst>
            <pc:docMk/>
            <pc:sldMk cId="796278249" sldId="330"/>
            <ac:spMk id="39" creationId="{1146DFC6-139C-EEEE-494F-10B90057C8ED}"/>
          </ac:spMkLst>
        </pc:spChg>
        <pc:spChg chg="add mod topLvl">
          <ac:chgData name="Kumar, Vinod" userId="a0710a6e-bffc-4971-8893-1c23addeb5b0" providerId="ADAL" clId="{804748DF-446B-437F-AFFB-E1B8A8B41FF1}" dt="2023-01-31T20:17:17.594" v="5984" actId="164"/>
          <ac:spMkLst>
            <pc:docMk/>
            <pc:sldMk cId="796278249" sldId="330"/>
            <ac:spMk id="40" creationId="{4B516C57-7E5E-02B6-FB65-B1BD60D2AE4A}"/>
          </ac:spMkLst>
        </pc:spChg>
        <pc:spChg chg="add mod">
          <ac:chgData name="Kumar, Vinod" userId="a0710a6e-bffc-4971-8893-1c23addeb5b0" providerId="ADAL" clId="{804748DF-446B-437F-AFFB-E1B8A8B41FF1}" dt="2023-01-30T20:10:48.984" v="3021" actId="20577"/>
          <ac:spMkLst>
            <pc:docMk/>
            <pc:sldMk cId="796278249" sldId="330"/>
            <ac:spMk id="43" creationId="{7E7E787B-030F-473D-5955-C721124B4651}"/>
          </ac:spMkLst>
        </pc:spChg>
        <pc:spChg chg="add mod">
          <ac:chgData name="Kumar, Vinod" userId="a0710a6e-bffc-4971-8893-1c23addeb5b0" providerId="ADAL" clId="{804748DF-446B-437F-AFFB-E1B8A8B41FF1}" dt="2023-01-31T20:17:04.428" v="5983" actId="1038"/>
          <ac:spMkLst>
            <pc:docMk/>
            <pc:sldMk cId="796278249" sldId="330"/>
            <ac:spMk id="44" creationId="{DD6EB601-DE50-EE06-3534-B019AEE79561}"/>
          </ac:spMkLst>
        </pc:spChg>
        <pc:grpChg chg="add mod">
          <ac:chgData name="Kumar, Vinod" userId="a0710a6e-bffc-4971-8893-1c23addeb5b0" providerId="ADAL" clId="{804748DF-446B-437F-AFFB-E1B8A8B41FF1}" dt="2023-01-31T20:17:17.594" v="5984" actId="164"/>
          <ac:grpSpMkLst>
            <pc:docMk/>
            <pc:sldMk cId="796278249" sldId="330"/>
            <ac:grpSpMk id="19" creationId="{72A043E5-B7C8-0B88-DF7D-B6DAE3D08CF0}"/>
          </ac:grpSpMkLst>
        </pc:grpChg>
        <pc:grpChg chg="add del mod">
          <ac:chgData name="Kumar, Vinod" userId="a0710a6e-bffc-4971-8893-1c23addeb5b0" providerId="ADAL" clId="{804748DF-446B-437F-AFFB-E1B8A8B41FF1}" dt="2023-01-30T18:22:15.974" v="2593" actId="165"/>
          <ac:grpSpMkLst>
            <pc:docMk/>
            <pc:sldMk cId="796278249" sldId="330"/>
            <ac:grpSpMk id="29" creationId="{FDD57A9D-C1C0-EFFD-74D2-213F11FD0695}"/>
          </ac:grpSpMkLst>
        </pc:grpChg>
        <pc:grpChg chg="add del mod">
          <ac:chgData name="Kumar, Vinod" userId="a0710a6e-bffc-4971-8893-1c23addeb5b0" providerId="ADAL" clId="{804748DF-446B-437F-AFFB-E1B8A8B41FF1}" dt="2023-01-31T20:16:33.060" v="5957" actId="165"/>
          <ac:grpSpMkLst>
            <pc:docMk/>
            <pc:sldMk cId="796278249" sldId="330"/>
            <ac:grpSpMk id="41" creationId="{640BB4F0-DB4F-ACCC-383B-6479319F5167}"/>
          </ac:grpSpMkLst>
        </pc:grpChg>
        <pc:grpChg chg="add mod">
          <ac:chgData name="Kumar, Vinod" userId="a0710a6e-bffc-4971-8893-1c23addeb5b0" providerId="ADAL" clId="{804748DF-446B-437F-AFFB-E1B8A8B41FF1}" dt="2023-01-31T20:15:28.613" v="5943" actId="1076"/>
          <ac:grpSpMkLst>
            <pc:docMk/>
            <pc:sldMk cId="796278249" sldId="330"/>
            <ac:grpSpMk id="42" creationId="{688DA036-C315-3035-C46D-FF8674FC96FF}"/>
          </ac:grpSpMkLst>
        </pc:grpChg>
        <pc:picChg chg="add mod topLvl modCrop">
          <ac:chgData name="Kumar, Vinod" userId="a0710a6e-bffc-4971-8893-1c23addeb5b0" providerId="ADAL" clId="{804748DF-446B-437F-AFFB-E1B8A8B41FF1}" dt="2023-01-30T18:26:29.548" v="2991" actId="164"/>
          <ac:picMkLst>
            <pc:docMk/>
            <pc:sldMk cId="796278249" sldId="330"/>
            <ac:picMk id="2" creationId="{7F2057F9-AEDF-68A8-FC61-601D4C441B23}"/>
          </ac:picMkLst>
        </pc:picChg>
        <pc:picChg chg="add mod topLvl modCrop">
          <ac:chgData name="Kumar, Vinod" userId="a0710a6e-bffc-4971-8893-1c23addeb5b0" providerId="ADAL" clId="{804748DF-446B-437F-AFFB-E1B8A8B41FF1}" dt="2023-01-30T18:26:29.548" v="2991" actId="164"/>
          <ac:picMkLst>
            <pc:docMk/>
            <pc:sldMk cId="796278249" sldId="330"/>
            <ac:picMk id="3" creationId="{B45D334F-6E8E-A933-2CBD-422A12DBAE75}"/>
          </ac:picMkLst>
        </pc:picChg>
        <pc:picChg chg="add mod topLvl modCrop">
          <ac:chgData name="Kumar, Vinod" userId="a0710a6e-bffc-4971-8893-1c23addeb5b0" providerId="ADAL" clId="{804748DF-446B-437F-AFFB-E1B8A8B41FF1}" dt="2023-01-30T18:26:29.548" v="2991" actId="164"/>
          <ac:picMkLst>
            <pc:docMk/>
            <pc:sldMk cId="796278249" sldId="330"/>
            <ac:picMk id="4" creationId="{66315FDC-4F43-5CC4-F79C-7C975C12DB00}"/>
          </ac:picMkLst>
        </pc:picChg>
        <pc:picChg chg="add mod topLvl modCrop">
          <ac:chgData name="Kumar, Vinod" userId="a0710a6e-bffc-4971-8893-1c23addeb5b0" providerId="ADAL" clId="{804748DF-446B-437F-AFFB-E1B8A8B41FF1}" dt="2023-01-30T18:26:29.548" v="2991" actId="164"/>
          <ac:picMkLst>
            <pc:docMk/>
            <pc:sldMk cId="796278249" sldId="330"/>
            <ac:picMk id="5" creationId="{8CABFBBC-B250-13D5-D58A-8CA58A68B452}"/>
          </ac:picMkLst>
        </pc:picChg>
        <pc:picChg chg="add del mod">
          <ac:chgData name="Kumar, Vinod" userId="a0710a6e-bffc-4971-8893-1c23addeb5b0" providerId="ADAL" clId="{804748DF-446B-437F-AFFB-E1B8A8B41FF1}" dt="2023-01-30T17:12:51.293" v="2496" actId="478"/>
          <ac:picMkLst>
            <pc:docMk/>
            <pc:sldMk cId="796278249" sldId="330"/>
            <ac:picMk id="8" creationId="{35BF2350-8A80-0045-EB0A-7AAB863195B3}"/>
          </ac:picMkLst>
        </pc:picChg>
        <pc:picChg chg="add mod topLvl modCrop">
          <ac:chgData name="Kumar, Vinod" userId="a0710a6e-bffc-4971-8893-1c23addeb5b0" providerId="ADAL" clId="{804748DF-446B-437F-AFFB-E1B8A8B41FF1}" dt="2023-01-31T20:17:17.594" v="5984" actId="164"/>
          <ac:picMkLst>
            <pc:docMk/>
            <pc:sldMk cId="796278249" sldId="330"/>
            <ac:picMk id="8" creationId="{B7F1F312-E618-395B-9F98-00F4BC5D2106}"/>
          </ac:picMkLst>
        </pc:picChg>
        <pc:picChg chg="add del mod">
          <ac:chgData name="Kumar, Vinod" userId="a0710a6e-bffc-4971-8893-1c23addeb5b0" providerId="ADAL" clId="{804748DF-446B-437F-AFFB-E1B8A8B41FF1}" dt="2023-01-30T17:12:53.452" v="2497" actId="478"/>
          <ac:picMkLst>
            <pc:docMk/>
            <pc:sldMk cId="796278249" sldId="330"/>
            <ac:picMk id="9" creationId="{1761120C-5819-2A21-FBB1-B965C39F12E1}"/>
          </ac:picMkLst>
        </pc:picChg>
        <pc:picChg chg="add mod topLvl modCrop">
          <ac:chgData name="Kumar, Vinod" userId="a0710a6e-bffc-4971-8893-1c23addeb5b0" providerId="ADAL" clId="{804748DF-446B-437F-AFFB-E1B8A8B41FF1}" dt="2023-01-31T20:17:17.594" v="5984" actId="164"/>
          <ac:picMkLst>
            <pc:docMk/>
            <pc:sldMk cId="796278249" sldId="330"/>
            <ac:picMk id="9" creationId="{2AFEE81D-40DB-27A2-80FF-3353E9D267DE}"/>
          </ac:picMkLst>
        </pc:picChg>
        <pc:picChg chg="add mod topLvl modCrop">
          <ac:chgData name="Kumar, Vinod" userId="a0710a6e-bffc-4971-8893-1c23addeb5b0" providerId="ADAL" clId="{804748DF-446B-437F-AFFB-E1B8A8B41FF1}" dt="2023-01-31T20:17:17.594" v="5984" actId="164"/>
          <ac:picMkLst>
            <pc:docMk/>
            <pc:sldMk cId="796278249" sldId="330"/>
            <ac:picMk id="17" creationId="{2427F169-19F7-FA50-DACE-A4A2710F43B7}"/>
          </ac:picMkLst>
        </pc:picChg>
        <pc:picChg chg="add del mod">
          <ac:chgData name="Kumar, Vinod" userId="a0710a6e-bffc-4971-8893-1c23addeb5b0" providerId="ADAL" clId="{804748DF-446B-437F-AFFB-E1B8A8B41FF1}" dt="2023-01-30T17:12:53.452" v="2497" actId="478"/>
          <ac:picMkLst>
            <pc:docMk/>
            <pc:sldMk cId="796278249" sldId="330"/>
            <ac:picMk id="17" creationId="{E82586B2-EA17-C12B-581B-7625A245DF19}"/>
          </ac:picMkLst>
        </pc:picChg>
        <pc:picChg chg="add del mod">
          <ac:chgData name="Kumar, Vinod" userId="a0710a6e-bffc-4971-8893-1c23addeb5b0" providerId="ADAL" clId="{804748DF-446B-437F-AFFB-E1B8A8B41FF1}" dt="2023-01-30T17:12:53.452" v="2497" actId="478"/>
          <ac:picMkLst>
            <pc:docMk/>
            <pc:sldMk cId="796278249" sldId="330"/>
            <ac:picMk id="19" creationId="{6C1E3220-DB15-1267-552C-B70B00A06029}"/>
          </ac:picMkLst>
        </pc:picChg>
        <pc:picChg chg="add del mod">
          <ac:chgData name="Kumar, Vinod" userId="a0710a6e-bffc-4971-8893-1c23addeb5b0" providerId="ADAL" clId="{804748DF-446B-437F-AFFB-E1B8A8B41FF1}" dt="2023-01-30T18:25:25.034" v="2984" actId="478"/>
          <ac:picMkLst>
            <pc:docMk/>
            <pc:sldMk cId="796278249" sldId="330"/>
            <ac:picMk id="20" creationId="{C4FFD579-8B3E-0E0C-4483-D02971A8312E}"/>
          </ac:picMkLst>
        </pc:picChg>
        <pc:picChg chg="add mod topLvl modCrop">
          <ac:chgData name="Kumar, Vinod" userId="a0710a6e-bffc-4971-8893-1c23addeb5b0" providerId="ADAL" clId="{804748DF-446B-437F-AFFB-E1B8A8B41FF1}" dt="2023-01-31T20:17:17.594" v="5984" actId="164"/>
          <ac:picMkLst>
            <pc:docMk/>
            <pc:sldMk cId="796278249" sldId="330"/>
            <ac:picMk id="21" creationId="{3D1767C5-92C5-E935-2A19-CC28BF5EDCEE}"/>
          </ac:picMkLst>
        </pc:picChg>
        <pc:cxnChg chg="add mod topLvl">
          <ac:chgData name="Kumar, Vinod" userId="a0710a6e-bffc-4971-8893-1c23addeb5b0" providerId="ADAL" clId="{804748DF-446B-437F-AFFB-E1B8A8B41FF1}" dt="2023-01-31T20:15:03.086" v="5927" actId="1035"/>
          <ac:cxnSpMkLst>
            <pc:docMk/>
            <pc:sldMk cId="796278249" sldId="330"/>
            <ac:cxnSpMk id="12" creationId="{B9CFBABE-61D4-CC55-8891-B5D2CFA50DB3}"/>
          </ac:cxnSpMkLst>
        </pc:cxnChg>
        <pc:cxnChg chg="add mod topLvl">
          <ac:chgData name="Kumar, Vinod" userId="a0710a6e-bffc-4971-8893-1c23addeb5b0" providerId="ADAL" clId="{804748DF-446B-437F-AFFB-E1B8A8B41FF1}" dt="2023-01-31T20:14:48.877" v="5907" actId="1036"/>
          <ac:cxnSpMkLst>
            <pc:docMk/>
            <pc:sldMk cId="796278249" sldId="330"/>
            <ac:cxnSpMk id="13" creationId="{121C4601-6B5E-14A5-0C7D-AF48796F6402}"/>
          </ac:cxnSpMkLst>
        </pc:cxnChg>
        <pc:cxnChg chg="add mod topLvl">
          <ac:chgData name="Kumar, Vinod" userId="a0710a6e-bffc-4971-8893-1c23addeb5b0" providerId="ADAL" clId="{804748DF-446B-437F-AFFB-E1B8A8B41FF1}" dt="2023-01-31T20:14:48.877" v="5907" actId="1036"/>
          <ac:cxnSpMkLst>
            <pc:docMk/>
            <pc:sldMk cId="796278249" sldId="330"/>
            <ac:cxnSpMk id="14" creationId="{5DEF638E-DAAC-CA46-049A-FD4759EC4AF6}"/>
          </ac:cxnSpMkLst>
        </pc:cxnChg>
        <pc:cxnChg chg="add mod topLvl">
          <ac:chgData name="Kumar, Vinod" userId="a0710a6e-bffc-4971-8893-1c23addeb5b0" providerId="ADAL" clId="{804748DF-446B-437F-AFFB-E1B8A8B41FF1}" dt="2023-01-31T20:17:17.594" v="5984" actId="164"/>
          <ac:cxnSpMkLst>
            <pc:docMk/>
            <pc:sldMk cId="796278249" sldId="330"/>
            <ac:cxnSpMk id="32" creationId="{2DB6CB6B-E563-A5A6-F9EA-5C2A9D7A2A89}"/>
          </ac:cxnSpMkLst>
        </pc:cxnChg>
        <pc:cxnChg chg="add mod topLvl">
          <ac:chgData name="Kumar, Vinod" userId="a0710a6e-bffc-4971-8893-1c23addeb5b0" providerId="ADAL" clId="{804748DF-446B-437F-AFFB-E1B8A8B41FF1}" dt="2023-01-31T20:17:17.594" v="5984" actId="164"/>
          <ac:cxnSpMkLst>
            <pc:docMk/>
            <pc:sldMk cId="796278249" sldId="330"/>
            <ac:cxnSpMk id="33" creationId="{0202E4AA-1BC9-E958-8A63-25D16798D06B}"/>
          </ac:cxnSpMkLst>
        </pc:cxnChg>
        <pc:cxnChg chg="add mod topLvl">
          <ac:chgData name="Kumar, Vinod" userId="a0710a6e-bffc-4971-8893-1c23addeb5b0" providerId="ADAL" clId="{804748DF-446B-437F-AFFB-E1B8A8B41FF1}" dt="2023-01-31T20:17:17.594" v="5984" actId="164"/>
          <ac:cxnSpMkLst>
            <pc:docMk/>
            <pc:sldMk cId="796278249" sldId="330"/>
            <ac:cxnSpMk id="34" creationId="{1E3B3EF3-6207-EE63-D14F-8FCC5B332725}"/>
          </ac:cxnSpMkLst>
        </pc:cxnChg>
      </pc:sldChg>
      <pc:sldChg chg="addSp delSp modSp new mod">
        <pc:chgData name="Kumar, Vinod" userId="a0710a6e-bffc-4971-8893-1c23addeb5b0" providerId="ADAL" clId="{804748DF-446B-437F-AFFB-E1B8A8B41FF1}" dt="2023-01-31T20:22:19.626" v="6078" actId="1035"/>
        <pc:sldMkLst>
          <pc:docMk/>
          <pc:sldMk cId="3066716538" sldId="331"/>
        </pc:sldMkLst>
        <pc:spChg chg="add mod">
          <ac:chgData name="Kumar, Vinod" userId="a0710a6e-bffc-4971-8893-1c23addeb5b0" providerId="ADAL" clId="{804748DF-446B-437F-AFFB-E1B8A8B41FF1}" dt="2023-01-31T20:18:38.925" v="5989" actId="20577"/>
          <ac:spMkLst>
            <pc:docMk/>
            <pc:sldMk cId="3066716538" sldId="331"/>
            <ac:spMk id="6" creationId="{8594A58D-A230-9192-2A3C-2FCFB1AEF16C}"/>
          </ac:spMkLst>
        </pc:spChg>
        <pc:spChg chg="del mod topLvl">
          <ac:chgData name="Kumar, Vinod" userId="a0710a6e-bffc-4971-8893-1c23addeb5b0" providerId="ADAL" clId="{804748DF-446B-437F-AFFB-E1B8A8B41FF1}" dt="2023-01-30T20:30:38.367" v="3307" actId="478"/>
          <ac:spMkLst>
            <pc:docMk/>
            <pc:sldMk cId="3066716538" sldId="331"/>
            <ac:spMk id="11" creationId="{2FE1FAC7-72BA-4DA6-B806-EC437D42DA78}"/>
          </ac:spMkLst>
        </pc:spChg>
        <pc:spChg chg="mod topLvl">
          <ac:chgData name="Kumar, Vinod" userId="a0710a6e-bffc-4971-8893-1c23addeb5b0" providerId="ADAL" clId="{804748DF-446B-437F-AFFB-E1B8A8B41FF1}" dt="2023-01-31T20:21:20.619" v="6045" actId="1037"/>
          <ac:spMkLst>
            <pc:docMk/>
            <pc:sldMk cId="3066716538" sldId="331"/>
            <ac:spMk id="12" creationId="{00C2D1C5-A8B3-C524-DE43-B4BDBFADD40C}"/>
          </ac:spMkLst>
        </pc:spChg>
        <pc:spChg chg="mod topLvl">
          <ac:chgData name="Kumar, Vinod" userId="a0710a6e-bffc-4971-8893-1c23addeb5b0" providerId="ADAL" clId="{804748DF-446B-437F-AFFB-E1B8A8B41FF1}" dt="2023-01-31T20:21:20.619" v="6045" actId="1037"/>
          <ac:spMkLst>
            <pc:docMk/>
            <pc:sldMk cId="3066716538" sldId="331"/>
            <ac:spMk id="13" creationId="{67F284D0-475B-B4BF-C4C6-E3335A980A63}"/>
          </ac:spMkLst>
        </pc:spChg>
        <pc:spChg chg="mod topLvl">
          <ac:chgData name="Kumar, Vinod" userId="a0710a6e-bffc-4971-8893-1c23addeb5b0" providerId="ADAL" clId="{804748DF-446B-437F-AFFB-E1B8A8B41FF1}" dt="2023-01-31T20:19:24.444" v="5995" actId="164"/>
          <ac:spMkLst>
            <pc:docMk/>
            <pc:sldMk cId="3066716538" sldId="331"/>
            <ac:spMk id="14" creationId="{95CF44AB-5236-731C-0D4B-218B0FDF6E7A}"/>
          </ac:spMkLst>
        </pc:spChg>
        <pc:spChg chg="mod topLvl">
          <ac:chgData name="Kumar, Vinod" userId="a0710a6e-bffc-4971-8893-1c23addeb5b0" providerId="ADAL" clId="{804748DF-446B-437F-AFFB-E1B8A8B41FF1}" dt="2023-01-31T20:20:16.620" v="6016" actId="1038"/>
          <ac:spMkLst>
            <pc:docMk/>
            <pc:sldMk cId="3066716538" sldId="331"/>
            <ac:spMk id="18" creationId="{54074112-8F59-5275-40BB-87EEBCAE0746}"/>
          </ac:spMkLst>
        </pc:spChg>
        <pc:spChg chg="mod topLvl">
          <ac:chgData name="Kumar, Vinod" userId="a0710a6e-bffc-4971-8893-1c23addeb5b0" providerId="ADAL" clId="{804748DF-446B-437F-AFFB-E1B8A8B41FF1}" dt="2023-01-31T20:19:24.444" v="5995" actId="164"/>
          <ac:spMkLst>
            <pc:docMk/>
            <pc:sldMk cId="3066716538" sldId="331"/>
            <ac:spMk id="19" creationId="{1BCDC3C3-63CB-4A66-1D5E-F12D54C198F0}"/>
          </ac:spMkLst>
        </pc:spChg>
        <pc:spChg chg="mod topLvl">
          <ac:chgData name="Kumar, Vinod" userId="a0710a6e-bffc-4971-8893-1c23addeb5b0" providerId="ADAL" clId="{804748DF-446B-437F-AFFB-E1B8A8B41FF1}" dt="2023-01-31T20:21:20.619" v="6045" actId="1037"/>
          <ac:spMkLst>
            <pc:docMk/>
            <pc:sldMk cId="3066716538" sldId="331"/>
            <ac:spMk id="20" creationId="{E0D6AD99-83EC-9656-15F6-1D6B804DCE03}"/>
          </ac:spMkLst>
        </pc:spChg>
        <pc:spChg chg="mod topLvl">
          <ac:chgData name="Kumar, Vinod" userId="a0710a6e-bffc-4971-8893-1c23addeb5b0" providerId="ADAL" clId="{804748DF-446B-437F-AFFB-E1B8A8B41FF1}" dt="2023-01-31T20:19:24.444" v="5995" actId="164"/>
          <ac:spMkLst>
            <pc:docMk/>
            <pc:sldMk cId="3066716538" sldId="331"/>
            <ac:spMk id="21" creationId="{9B187CE4-CC00-C60F-A5E9-8D50849DE073}"/>
          </ac:spMkLst>
        </pc:spChg>
        <pc:spChg chg="mod topLvl">
          <ac:chgData name="Kumar, Vinod" userId="a0710a6e-bffc-4971-8893-1c23addeb5b0" providerId="ADAL" clId="{804748DF-446B-437F-AFFB-E1B8A8B41FF1}" dt="2023-01-31T20:19:24.444" v="5995" actId="164"/>
          <ac:spMkLst>
            <pc:docMk/>
            <pc:sldMk cId="3066716538" sldId="331"/>
            <ac:spMk id="22" creationId="{277614ED-DF93-F9AC-680A-28B6837F6115}"/>
          </ac:spMkLst>
        </pc:spChg>
        <pc:spChg chg="mod topLvl">
          <ac:chgData name="Kumar, Vinod" userId="a0710a6e-bffc-4971-8893-1c23addeb5b0" providerId="ADAL" clId="{804748DF-446B-437F-AFFB-E1B8A8B41FF1}" dt="2023-01-31T20:19:24.444" v="5995" actId="164"/>
          <ac:spMkLst>
            <pc:docMk/>
            <pc:sldMk cId="3066716538" sldId="331"/>
            <ac:spMk id="23" creationId="{E76E0884-1344-DF06-4B49-E171D1E2E465}"/>
          </ac:spMkLst>
        </pc:spChg>
        <pc:spChg chg="mod topLvl">
          <ac:chgData name="Kumar, Vinod" userId="a0710a6e-bffc-4971-8893-1c23addeb5b0" providerId="ADAL" clId="{804748DF-446B-437F-AFFB-E1B8A8B41FF1}" dt="2023-01-31T20:19:24.444" v="5995" actId="164"/>
          <ac:spMkLst>
            <pc:docMk/>
            <pc:sldMk cId="3066716538" sldId="331"/>
            <ac:spMk id="24" creationId="{0953A13E-CEE7-19EB-C5FF-89BA7EA7EC53}"/>
          </ac:spMkLst>
        </pc:spChg>
        <pc:spChg chg="add mod topLvl">
          <ac:chgData name="Kumar, Vinod" userId="a0710a6e-bffc-4971-8893-1c23addeb5b0" providerId="ADAL" clId="{804748DF-446B-437F-AFFB-E1B8A8B41FF1}" dt="2023-01-31T20:21:20.619" v="6045" actId="1037"/>
          <ac:spMkLst>
            <pc:docMk/>
            <pc:sldMk cId="3066716538" sldId="331"/>
            <ac:spMk id="25" creationId="{37595595-064E-20D1-DBC1-937A78F62681}"/>
          </ac:spMkLst>
        </pc:spChg>
        <pc:spChg chg="add mod topLvl">
          <ac:chgData name="Kumar, Vinod" userId="a0710a6e-bffc-4971-8893-1c23addeb5b0" providerId="ADAL" clId="{804748DF-446B-437F-AFFB-E1B8A8B41FF1}" dt="2023-01-31T20:21:01.467" v="6033" actId="1037"/>
          <ac:spMkLst>
            <pc:docMk/>
            <pc:sldMk cId="3066716538" sldId="331"/>
            <ac:spMk id="30" creationId="{AF59935B-CC8F-F598-B2F5-0D1EE7A0E713}"/>
          </ac:spMkLst>
        </pc:spChg>
        <pc:spChg chg="add mod topLvl">
          <ac:chgData name="Kumar, Vinod" userId="a0710a6e-bffc-4971-8893-1c23addeb5b0" providerId="ADAL" clId="{804748DF-446B-437F-AFFB-E1B8A8B41FF1}" dt="2023-01-31T20:21:06.875" v="6041" actId="1037"/>
          <ac:spMkLst>
            <pc:docMk/>
            <pc:sldMk cId="3066716538" sldId="331"/>
            <ac:spMk id="31" creationId="{9132462B-95F5-9967-B08E-2736D377A4FE}"/>
          </ac:spMkLst>
        </pc:spChg>
        <pc:spChg chg="add mod topLvl">
          <ac:chgData name="Kumar, Vinod" userId="a0710a6e-bffc-4971-8893-1c23addeb5b0" providerId="ADAL" clId="{804748DF-446B-437F-AFFB-E1B8A8B41FF1}" dt="2023-01-31T20:20:55.691" v="6028" actId="20577"/>
          <ac:spMkLst>
            <pc:docMk/>
            <pc:sldMk cId="3066716538" sldId="331"/>
            <ac:spMk id="32" creationId="{338FC74C-15A5-04B7-B24A-B3983A14C2DE}"/>
          </ac:spMkLst>
        </pc:spChg>
        <pc:spChg chg="add mod topLvl">
          <ac:chgData name="Kumar, Vinod" userId="a0710a6e-bffc-4971-8893-1c23addeb5b0" providerId="ADAL" clId="{804748DF-446B-437F-AFFB-E1B8A8B41FF1}" dt="2023-01-31T20:19:00.906" v="5992" actId="255"/>
          <ac:spMkLst>
            <pc:docMk/>
            <pc:sldMk cId="3066716538" sldId="331"/>
            <ac:spMk id="34" creationId="{89F43E97-B95C-9CB8-E14F-1F5D2CFE2CDA}"/>
          </ac:spMkLst>
        </pc:spChg>
        <pc:spChg chg="add mod topLvl">
          <ac:chgData name="Kumar, Vinod" userId="a0710a6e-bffc-4971-8893-1c23addeb5b0" providerId="ADAL" clId="{804748DF-446B-437F-AFFB-E1B8A8B41FF1}" dt="2023-01-31T20:19:00.906" v="5992" actId="255"/>
          <ac:spMkLst>
            <pc:docMk/>
            <pc:sldMk cId="3066716538" sldId="331"/>
            <ac:spMk id="35" creationId="{4DAFC16B-C43A-131C-A5E1-3F6034CF406D}"/>
          </ac:spMkLst>
        </pc:spChg>
        <pc:spChg chg="add mod topLvl">
          <ac:chgData name="Kumar, Vinod" userId="a0710a6e-bffc-4971-8893-1c23addeb5b0" providerId="ADAL" clId="{804748DF-446B-437F-AFFB-E1B8A8B41FF1}" dt="2023-01-31T20:19:00.906" v="5992" actId="255"/>
          <ac:spMkLst>
            <pc:docMk/>
            <pc:sldMk cId="3066716538" sldId="331"/>
            <ac:spMk id="36" creationId="{0BEDD98E-D19E-2227-5612-2EFCB7474B49}"/>
          </ac:spMkLst>
        </pc:spChg>
        <pc:spChg chg="add mod">
          <ac:chgData name="Kumar, Vinod" userId="a0710a6e-bffc-4971-8893-1c23addeb5b0" providerId="ADAL" clId="{804748DF-446B-437F-AFFB-E1B8A8B41FF1}" dt="2023-01-31T20:22:19.626" v="6078" actId="1035"/>
          <ac:spMkLst>
            <pc:docMk/>
            <pc:sldMk cId="3066716538" sldId="331"/>
            <ac:spMk id="40" creationId="{590C4091-DCD7-F77A-66A1-19275A5A0BA0}"/>
          </ac:spMkLst>
        </pc:spChg>
        <pc:spChg chg="add mod">
          <ac:chgData name="Kumar, Vinod" userId="a0710a6e-bffc-4971-8893-1c23addeb5b0" providerId="ADAL" clId="{804748DF-446B-437F-AFFB-E1B8A8B41FF1}" dt="2023-01-31T20:22:12.955" v="6067" actId="1037"/>
          <ac:spMkLst>
            <pc:docMk/>
            <pc:sldMk cId="3066716538" sldId="331"/>
            <ac:spMk id="41" creationId="{464BF5B9-9209-C313-51F9-CBDF5DBC32FF}"/>
          </ac:spMkLst>
        </pc:spChg>
        <pc:spChg chg="add mod">
          <ac:chgData name="Kumar, Vinod" userId="a0710a6e-bffc-4971-8893-1c23addeb5b0" providerId="ADAL" clId="{804748DF-446B-437F-AFFB-E1B8A8B41FF1}" dt="2023-01-31T20:21:48.453" v="6051" actId="20577"/>
          <ac:spMkLst>
            <pc:docMk/>
            <pc:sldMk cId="3066716538" sldId="331"/>
            <ac:spMk id="42" creationId="{6EF62D7B-EF91-4AB0-3C92-1545832FBB0C}"/>
          </ac:spMkLst>
        </pc:spChg>
        <pc:spChg chg="add mod">
          <ac:chgData name="Kumar, Vinod" userId="a0710a6e-bffc-4971-8893-1c23addeb5b0" providerId="ADAL" clId="{804748DF-446B-437F-AFFB-E1B8A8B41FF1}" dt="2023-01-31T20:22:05.562" v="6062" actId="1035"/>
          <ac:spMkLst>
            <pc:docMk/>
            <pc:sldMk cId="3066716538" sldId="331"/>
            <ac:spMk id="44" creationId="{08E4B454-FF7C-261A-91A4-E1C3B6967555}"/>
          </ac:spMkLst>
        </pc:spChg>
        <pc:spChg chg="add mod">
          <ac:chgData name="Kumar, Vinod" userId="a0710a6e-bffc-4971-8893-1c23addeb5b0" providerId="ADAL" clId="{804748DF-446B-437F-AFFB-E1B8A8B41FF1}" dt="2023-01-31T20:21:34.160" v="6048" actId="164"/>
          <ac:spMkLst>
            <pc:docMk/>
            <pc:sldMk cId="3066716538" sldId="331"/>
            <ac:spMk id="45" creationId="{CEBC6B2D-1BD2-1F1D-A738-031D1D9748F9}"/>
          </ac:spMkLst>
        </pc:spChg>
        <pc:spChg chg="add mod">
          <ac:chgData name="Kumar, Vinod" userId="a0710a6e-bffc-4971-8893-1c23addeb5b0" providerId="ADAL" clId="{804748DF-446B-437F-AFFB-E1B8A8B41FF1}" dt="2023-01-31T20:21:34.160" v="6048" actId="164"/>
          <ac:spMkLst>
            <pc:docMk/>
            <pc:sldMk cId="3066716538" sldId="331"/>
            <ac:spMk id="46" creationId="{D4D171FF-20C4-20AF-1BF7-4417E7AE5E58}"/>
          </ac:spMkLst>
        </pc:spChg>
        <pc:grpChg chg="add del mod">
          <ac:chgData name="Kumar, Vinod" userId="a0710a6e-bffc-4971-8893-1c23addeb5b0" providerId="ADAL" clId="{804748DF-446B-437F-AFFB-E1B8A8B41FF1}" dt="2023-01-30T20:27:15.663" v="3097" actId="165"/>
          <ac:grpSpMkLst>
            <pc:docMk/>
            <pc:sldMk cId="3066716538" sldId="331"/>
            <ac:grpSpMk id="6" creationId="{D97B4FE7-6E81-5EC3-02F8-9C7FBFA46ADA}"/>
          </ac:grpSpMkLst>
        </pc:grpChg>
        <pc:grpChg chg="add mod">
          <ac:chgData name="Kumar, Vinod" userId="a0710a6e-bffc-4971-8893-1c23addeb5b0" providerId="ADAL" clId="{804748DF-446B-437F-AFFB-E1B8A8B41FF1}" dt="2023-01-31T20:20:33.635" v="6019" actId="14100"/>
          <ac:grpSpMkLst>
            <pc:docMk/>
            <pc:sldMk cId="3066716538" sldId="331"/>
            <ac:grpSpMk id="7" creationId="{3DEB61DB-3F15-F60E-F9B3-CB138BA69DDE}"/>
          </ac:grpSpMkLst>
        </pc:grpChg>
        <pc:grpChg chg="add mod">
          <ac:chgData name="Kumar, Vinod" userId="a0710a6e-bffc-4971-8893-1c23addeb5b0" providerId="ADAL" clId="{804748DF-446B-437F-AFFB-E1B8A8B41FF1}" dt="2023-01-31T20:19:28.828" v="5996" actId="14100"/>
          <ac:grpSpMkLst>
            <pc:docMk/>
            <pc:sldMk cId="3066716538" sldId="331"/>
            <ac:grpSpMk id="8" creationId="{45B1E29C-9F33-D0AB-EA9A-340FCA1EAE09}"/>
          </ac:grpSpMkLst>
        </pc:grpChg>
        <pc:grpChg chg="add mod">
          <ac:chgData name="Kumar, Vinod" userId="a0710a6e-bffc-4971-8893-1c23addeb5b0" providerId="ADAL" clId="{804748DF-446B-437F-AFFB-E1B8A8B41FF1}" dt="2023-01-31T20:21:41.315" v="6050" actId="14100"/>
          <ac:grpSpMkLst>
            <pc:docMk/>
            <pc:sldMk cId="3066716538" sldId="331"/>
            <ac:grpSpMk id="9" creationId="{80C0B262-AFDA-79AE-6887-7378961A1943}"/>
          </ac:grpSpMkLst>
        </pc:grpChg>
        <pc:grpChg chg="add del mod">
          <ac:chgData name="Kumar, Vinod" userId="a0710a6e-bffc-4971-8893-1c23addeb5b0" providerId="ADAL" clId="{804748DF-446B-437F-AFFB-E1B8A8B41FF1}" dt="2023-01-30T20:40:57.929" v="3450" actId="165"/>
          <ac:grpSpMkLst>
            <pc:docMk/>
            <pc:sldMk cId="3066716538" sldId="331"/>
            <ac:grpSpMk id="26" creationId="{510D3B58-D440-8B4C-B013-BD80E1E0FBD5}"/>
          </ac:grpSpMkLst>
        </pc:grpChg>
        <pc:grpChg chg="add del mod">
          <ac:chgData name="Kumar, Vinod" userId="a0710a6e-bffc-4971-8893-1c23addeb5b0" providerId="ADAL" clId="{804748DF-446B-437F-AFFB-E1B8A8B41FF1}" dt="2023-01-30T20:47:16.512" v="3763" actId="165"/>
          <ac:grpSpMkLst>
            <pc:docMk/>
            <pc:sldMk cId="3066716538" sldId="331"/>
            <ac:grpSpMk id="37" creationId="{0B962493-1DD0-23FB-9ED1-0B33DEC0D655}"/>
          </ac:grpSpMkLst>
        </pc:grpChg>
        <pc:picChg chg="add mod topLvl modCrop">
          <ac:chgData name="Kumar, Vinod" userId="a0710a6e-bffc-4971-8893-1c23addeb5b0" providerId="ADAL" clId="{804748DF-446B-437F-AFFB-E1B8A8B41FF1}" dt="2023-01-31T20:19:24.444" v="5995" actId="164"/>
          <ac:picMkLst>
            <pc:docMk/>
            <pc:sldMk cId="3066716538" sldId="331"/>
            <ac:picMk id="2" creationId="{F11BF96D-42FC-929F-E425-00A05A7A1E66}"/>
          </ac:picMkLst>
        </pc:picChg>
        <pc:picChg chg="add mod topLvl modCrop">
          <ac:chgData name="Kumar, Vinod" userId="a0710a6e-bffc-4971-8893-1c23addeb5b0" providerId="ADAL" clId="{804748DF-446B-437F-AFFB-E1B8A8B41FF1}" dt="2023-01-31T20:19:24.444" v="5995" actId="164"/>
          <ac:picMkLst>
            <pc:docMk/>
            <pc:sldMk cId="3066716538" sldId="331"/>
            <ac:picMk id="3" creationId="{D6EE19D3-24BC-4BE7-9E84-E910FDD5F566}"/>
          </ac:picMkLst>
        </pc:picChg>
        <pc:picChg chg="add mod topLvl modCrop">
          <ac:chgData name="Kumar, Vinod" userId="a0710a6e-bffc-4971-8893-1c23addeb5b0" providerId="ADAL" clId="{804748DF-446B-437F-AFFB-E1B8A8B41FF1}" dt="2023-01-31T20:19:24.444" v="5995" actId="164"/>
          <ac:picMkLst>
            <pc:docMk/>
            <pc:sldMk cId="3066716538" sldId="331"/>
            <ac:picMk id="4" creationId="{A7213F4E-0A58-F833-3FAF-EFB29D5D1EBB}"/>
          </ac:picMkLst>
        </pc:picChg>
        <pc:picChg chg="add mod topLvl modCrop">
          <ac:chgData name="Kumar, Vinod" userId="a0710a6e-bffc-4971-8893-1c23addeb5b0" providerId="ADAL" clId="{804748DF-446B-437F-AFFB-E1B8A8B41FF1}" dt="2023-01-31T20:19:24.444" v="5995" actId="164"/>
          <ac:picMkLst>
            <pc:docMk/>
            <pc:sldMk cId="3066716538" sldId="331"/>
            <ac:picMk id="5" creationId="{C697701B-8A40-8714-3079-5EC906EE88CA}"/>
          </ac:picMkLst>
        </pc:picChg>
        <pc:picChg chg="del mod topLvl">
          <ac:chgData name="Kumar, Vinod" userId="a0710a6e-bffc-4971-8893-1c23addeb5b0" providerId="ADAL" clId="{804748DF-446B-437F-AFFB-E1B8A8B41FF1}" dt="2023-01-30T20:30:36.287" v="3306" actId="478"/>
          <ac:picMkLst>
            <pc:docMk/>
            <pc:sldMk cId="3066716538" sldId="331"/>
            <ac:picMk id="7" creationId="{6E690229-C66D-B4E9-DEFF-69C9E117CDAD}"/>
          </ac:picMkLst>
        </pc:picChg>
        <pc:picChg chg="del mod topLvl">
          <ac:chgData name="Kumar, Vinod" userId="a0710a6e-bffc-4971-8893-1c23addeb5b0" providerId="ADAL" clId="{804748DF-446B-437F-AFFB-E1B8A8B41FF1}" dt="2023-01-30T20:30:36.287" v="3306" actId="478"/>
          <ac:picMkLst>
            <pc:docMk/>
            <pc:sldMk cId="3066716538" sldId="331"/>
            <ac:picMk id="8" creationId="{C3A47649-629C-02D3-07D1-E4908284D11F}"/>
          </ac:picMkLst>
        </pc:picChg>
        <pc:picChg chg="del mod topLvl">
          <ac:chgData name="Kumar, Vinod" userId="a0710a6e-bffc-4971-8893-1c23addeb5b0" providerId="ADAL" clId="{804748DF-446B-437F-AFFB-E1B8A8B41FF1}" dt="2023-01-30T20:30:36.287" v="3306" actId="478"/>
          <ac:picMkLst>
            <pc:docMk/>
            <pc:sldMk cId="3066716538" sldId="331"/>
            <ac:picMk id="9" creationId="{2B410078-FDCE-BF4A-97A9-6FB7F8839ACC}"/>
          </ac:picMkLst>
        </pc:picChg>
        <pc:picChg chg="del mod topLvl">
          <ac:chgData name="Kumar, Vinod" userId="a0710a6e-bffc-4971-8893-1c23addeb5b0" providerId="ADAL" clId="{804748DF-446B-437F-AFFB-E1B8A8B41FF1}" dt="2023-01-30T20:30:36.287" v="3306" actId="478"/>
          <ac:picMkLst>
            <pc:docMk/>
            <pc:sldMk cId="3066716538" sldId="331"/>
            <ac:picMk id="10" creationId="{6362FFDF-B42A-D4E4-CA0E-45377C749B12}"/>
          </ac:picMkLst>
        </pc:picChg>
        <pc:picChg chg="add mod topLvl modCrop">
          <ac:chgData name="Kumar, Vinod" userId="a0710a6e-bffc-4971-8893-1c23addeb5b0" providerId="ADAL" clId="{804748DF-446B-437F-AFFB-E1B8A8B41FF1}" dt="2023-01-31T20:18:56.091" v="5990" actId="164"/>
          <ac:picMkLst>
            <pc:docMk/>
            <pc:sldMk cId="3066716538" sldId="331"/>
            <ac:picMk id="27" creationId="{D4AD556B-B6ED-5B22-C06B-4065AA093F88}"/>
          </ac:picMkLst>
        </pc:picChg>
        <pc:picChg chg="add del mod modCrop">
          <ac:chgData name="Kumar, Vinod" userId="a0710a6e-bffc-4971-8893-1c23addeb5b0" providerId="ADAL" clId="{804748DF-446B-437F-AFFB-E1B8A8B41FF1}" dt="2023-01-30T20:38:48.346" v="3402" actId="478"/>
          <ac:picMkLst>
            <pc:docMk/>
            <pc:sldMk cId="3066716538" sldId="331"/>
            <ac:picMk id="28" creationId="{AD5ECAAD-7814-F9F0-0304-FE18A1067FEC}"/>
          </ac:picMkLst>
        </pc:picChg>
        <pc:picChg chg="add mod topLvl modCrop">
          <ac:chgData name="Kumar, Vinod" userId="a0710a6e-bffc-4971-8893-1c23addeb5b0" providerId="ADAL" clId="{804748DF-446B-437F-AFFB-E1B8A8B41FF1}" dt="2023-01-31T20:18:56.091" v="5990" actId="164"/>
          <ac:picMkLst>
            <pc:docMk/>
            <pc:sldMk cId="3066716538" sldId="331"/>
            <ac:picMk id="29" creationId="{65B3E99A-CB4C-2994-F19F-F475D70BCD09}"/>
          </ac:picMkLst>
        </pc:picChg>
        <pc:picChg chg="add mod modCrop">
          <ac:chgData name="Kumar, Vinod" userId="a0710a6e-bffc-4971-8893-1c23addeb5b0" providerId="ADAL" clId="{804748DF-446B-437F-AFFB-E1B8A8B41FF1}" dt="2023-01-31T20:21:34.160" v="6048" actId="164"/>
          <ac:picMkLst>
            <pc:docMk/>
            <pc:sldMk cId="3066716538" sldId="331"/>
            <ac:picMk id="38" creationId="{C4E2E521-9E92-72AD-BD81-382D6D26EF3C}"/>
          </ac:picMkLst>
        </pc:picChg>
        <pc:picChg chg="add mod modCrop">
          <ac:chgData name="Kumar, Vinod" userId="a0710a6e-bffc-4971-8893-1c23addeb5b0" providerId="ADAL" clId="{804748DF-446B-437F-AFFB-E1B8A8B41FF1}" dt="2023-01-31T20:21:34.160" v="6048" actId="164"/>
          <ac:picMkLst>
            <pc:docMk/>
            <pc:sldMk cId="3066716538" sldId="331"/>
            <ac:picMk id="39" creationId="{B3F5966E-6974-E6DD-8CB3-9749C432356B}"/>
          </ac:picMkLst>
        </pc:picChg>
        <pc:cxnChg chg="mod topLvl">
          <ac:chgData name="Kumar, Vinod" userId="a0710a6e-bffc-4971-8893-1c23addeb5b0" providerId="ADAL" clId="{804748DF-446B-437F-AFFB-E1B8A8B41FF1}" dt="2023-01-31T20:19:24.444" v="5995" actId="164"/>
          <ac:cxnSpMkLst>
            <pc:docMk/>
            <pc:sldMk cId="3066716538" sldId="331"/>
            <ac:cxnSpMk id="15" creationId="{A48FAF25-A435-41AE-726A-798F62BC8DC4}"/>
          </ac:cxnSpMkLst>
        </pc:cxnChg>
        <pc:cxnChg chg="mod topLvl">
          <ac:chgData name="Kumar, Vinod" userId="a0710a6e-bffc-4971-8893-1c23addeb5b0" providerId="ADAL" clId="{804748DF-446B-437F-AFFB-E1B8A8B41FF1}" dt="2023-01-31T20:19:24.444" v="5995" actId="164"/>
          <ac:cxnSpMkLst>
            <pc:docMk/>
            <pc:sldMk cId="3066716538" sldId="331"/>
            <ac:cxnSpMk id="16" creationId="{D8B5AFF6-1073-D286-6152-06D53D72798D}"/>
          </ac:cxnSpMkLst>
        </pc:cxnChg>
        <pc:cxnChg chg="mod topLvl">
          <ac:chgData name="Kumar, Vinod" userId="a0710a6e-bffc-4971-8893-1c23addeb5b0" providerId="ADAL" clId="{804748DF-446B-437F-AFFB-E1B8A8B41FF1}" dt="2023-01-31T20:19:24.444" v="5995" actId="164"/>
          <ac:cxnSpMkLst>
            <pc:docMk/>
            <pc:sldMk cId="3066716538" sldId="331"/>
            <ac:cxnSpMk id="17" creationId="{3B59111B-FAFF-4713-62C7-B9E7AB68F1FC}"/>
          </ac:cxnSpMkLst>
        </pc:cxnChg>
        <pc:cxnChg chg="add mod topLvl">
          <ac:chgData name="Kumar, Vinod" userId="a0710a6e-bffc-4971-8893-1c23addeb5b0" providerId="ADAL" clId="{804748DF-446B-437F-AFFB-E1B8A8B41FF1}" dt="2023-01-31T20:18:56.091" v="5990" actId="164"/>
          <ac:cxnSpMkLst>
            <pc:docMk/>
            <pc:sldMk cId="3066716538" sldId="331"/>
            <ac:cxnSpMk id="33" creationId="{3FA06EFC-3A59-0BE4-664D-720F58858235}"/>
          </ac:cxnSpMkLst>
        </pc:cxnChg>
        <pc:cxnChg chg="add mod">
          <ac:chgData name="Kumar, Vinod" userId="a0710a6e-bffc-4971-8893-1c23addeb5b0" providerId="ADAL" clId="{804748DF-446B-437F-AFFB-E1B8A8B41FF1}" dt="2023-01-31T20:22:00.907" v="6057" actId="1035"/>
          <ac:cxnSpMkLst>
            <pc:docMk/>
            <pc:sldMk cId="3066716538" sldId="331"/>
            <ac:cxnSpMk id="43" creationId="{4437FF3C-6D5B-8007-5FBF-B38F6B2F2E3A}"/>
          </ac:cxnSpMkLst>
        </pc:cxnChg>
      </pc:sldChg>
      <pc:sldChg chg="addSp delSp modSp new mod">
        <pc:chgData name="Kumar, Vinod" userId="a0710a6e-bffc-4971-8893-1c23addeb5b0" providerId="ADAL" clId="{804748DF-446B-437F-AFFB-E1B8A8B41FF1}" dt="2023-01-31T20:39:54.161" v="6574" actId="1076"/>
        <pc:sldMkLst>
          <pc:docMk/>
          <pc:sldMk cId="752802638" sldId="332"/>
        </pc:sldMkLst>
        <pc:spChg chg="add mod">
          <ac:chgData name="Kumar, Vinod" userId="a0710a6e-bffc-4971-8893-1c23addeb5b0" providerId="ADAL" clId="{804748DF-446B-437F-AFFB-E1B8A8B41FF1}" dt="2023-01-31T20:39:45.442" v="6573" actId="164"/>
          <ac:spMkLst>
            <pc:docMk/>
            <pc:sldMk cId="752802638" sldId="332"/>
            <ac:spMk id="6" creationId="{64E1B31B-0768-D815-3636-CAA5DFF18EF5}"/>
          </ac:spMkLst>
        </pc:spChg>
        <pc:spChg chg="add mod">
          <ac:chgData name="Kumar, Vinod" userId="a0710a6e-bffc-4971-8893-1c23addeb5b0" providerId="ADAL" clId="{804748DF-446B-437F-AFFB-E1B8A8B41FF1}" dt="2023-01-31T20:39:45.442" v="6573" actId="164"/>
          <ac:spMkLst>
            <pc:docMk/>
            <pc:sldMk cId="752802638" sldId="332"/>
            <ac:spMk id="7" creationId="{B95D7A92-ABBC-CB49-A65C-7543A3394320}"/>
          </ac:spMkLst>
        </pc:spChg>
        <pc:spChg chg="add mod">
          <ac:chgData name="Kumar, Vinod" userId="a0710a6e-bffc-4971-8893-1c23addeb5b0" providerId="ADAL" clId="{804748DF-446B-437F-AFFB-E1B8A8B41FF1}" dt="2023-01-31T20:39:45.442" v="6573" actId="164"/>
          <ac:spMkLst>
            <pc:docMk/>
            <pc:sldMk cId="752802638" sldId="332"/>
            <ac:spMk id="8" creationId="{48DC8BAA-554F-2FEF-F0A4-4E4512BD1AD2}"/>
          </ac:spMkLst>
        </pc:spChg>
        <pc:spChg chg="add mod">
          <ac:chgData name="Kumar, Vinod" userId="a0710a6e-bffc-4971-8893-1c23addeb5b0" providerId="ADAL" clId="{804748DF-446B-437F-AFFB-E1B8A8B41FF1}" dt="2023-01-31T20:39:45.442" v="6573" actId="164"/>
          <ac:spMkLst>
            <pc:docMk/>
            <pc:sldMk cId="752802638" sldId="332"/>
            <ac:spMk id="10" creationId="{090B020E-48C5-90A1-DA9A-6A7774EA0415}"/>
          </ac:spMkLst>
        </pc:spChg>
        <pc:spChg chg="add mod">
          <ac:chgData name="Kumar, Vinod" userId="a0710a6e-bffc-4971-8893-1c23addeb5b0" providerId="ADAL" clId="{804748DF-446B-437F-AFFB-E1B8A8B41FF1}" dt="2023-01-31T20:39:45.442" v="6573" actId="164"/>
          <ac:spMkLst>
            <pc:docMk/>
            <pc:sldMk cId="752802638" sldId="332"/>
            <ac:spMk id="11" creationId="{173387DE-73F6-D7DA-FE8D-FD4981DBDEAF}"/>
          </ac:spMkLst>
        </pc:spChg>
        <pc:spChg chg="add mod">
          <ac:chgData name="Kumar, Vinod" userId="a0710a6e-bffc-4971-8893-1c23addeb5b0" providerId="ADAL" clId="{804748DF-446B-437F-AFFB-E1B8A8B41FF1}" dt="2023-01-31T20:39:45.442" v="6573" actId="164"/>
          <ac:spMkLst>
            <pc:docMk/>
            <pc:sldMk cId="752802638" sldId="332"/>
            <ac:spMk id="15" creationId="{11085032-8930-57D4-D262-FBB7BE1E72F8}"/>
          </ac:spMkLst>
        </pc:spChg>
        <pc:spChg chg="add mod">
          <ac:chgData name="Kumar, Vinod" userId="a0710a6e-bffc-4971-8893-1c23addeb5b0" providerId="ADAL" clId="{804748DF-446B-437F-AFFB-E1B8A8B41FF1}" dt="2023-01-31T20:39:45.442" v="6573" actId="164"/>
          <ac:spMkLst>
            <pc:docMk/>
            <pc:sldMk cId="752802638" sldId="332"/>
            <ac:spMk id="16" creationId="{133BE120-B6A6-91CB-57B1-08EDC326CDA8}"/>
          </ac:spMkLst>
        </pc:spChg>
        <pc:spChg chg="add mod">
          <ac:chgData name="Kumar, Vinod" userId="a0710a6e-bffc-4971-8893-1c23addeb5b0" providerId="ADAL" clId="{804748DF-446B-437F-AFFB-E1B8A8B41FF1}" dt="2023-01-31T20:39:45.442" v="6573" actId="164"/>
          <ac:spMkLst>
            <pc:docMk/>
            <pc:sldMk cId="752802638" sldId="332"/>
            <ac:spMk id="17" creationId="{DE646D07-2FA1-7834-B20B-4AC8B6F13B6C}"/>
          </ac:spMkLst>
        </pc:spChg>
        <pc:spChg chg="add mod">
          <ac:chgData name="Kumar, Vinod" userId="a0710a6e-bffc-4971-8893-1c23addeb5b0" providerId="ADAL" clId="{804748DF-446B-437F-AFFB-E1B8A8B41FF1}" dt="2023-01-31T20:39:45.442" v="6573" actId="164"/>
          <ac:spMkLst>
            <pc:docMk/>
            <pc:sldMk cId="752802638" sldId="332"/>
            <ac:spMk id="18" creationId="{C1795E18-8FE8-9609-ED1E-F3A87B9E05C8}"/>
          </ac:spMkLst>
        </pc:spChg>
        <pc:spChg chg="add mod">
          <ac:chgData name="Kumar, Vinod" userId="a0710a6e-bffc-4971-8893-1c23addeb5b0" providerId="ADAL" clId="{804748DF-446B-437F-AFFB-E1B8A8B41FF1}" dt="2023-01-31T20:35:57.314" v="6422" actId="164"/>
          <ac:spMkLst>
            <pc:docMk/>
            <pc:sldMk cId="752802638" sldId="332"/>
            <ac:spMk id="21" creationId="{85AC56EF-0807-1DB3-2CD9-41ECA5885F15}"/>
          </ac:spMkLst>
        </pc:spChg>
        <pc:spChg chg="add mod">
          <ac:chgData name="Kumar, Vinod" userId="a0710a6e-bffc-4971-8893-1c23addeb5b0" providerId="ADAL" clId="{804748DF-446B-437F-AFFB-E1B8A8B41FF1}" dt="2023-01-31T20:35:57.314" v="6422" actId="164"/>
          <ac:spMkLst>
            <pc:docMk/>
            <pc:sldMk cId="752802638" sldId="332"/>
            <ac:spMk id="22" creationId="{F7F5FCA5-078B-CD57-DAE2-F735585A93FF}"/>
          </ac:spMkLst>
        </pc:spChg>
        <pc:spChg chg="add mod">
          <ac:chgData name="Kumar, Vinod" userId="a0710a6e-bffc-4971-8893-1c23addeb5b0" providerId="ADAL" clId="{804748DF-446B-437F-AFFB-E1B8A8B41FF1}" dt="2023-01-31T20:35:57.314" v="6422" actId="164"/>
          <ac:spMkLst>
            <pc:docMk/>
            <pc:sldMk cId="752802638" sldId="332"/>
            <ac:spMk id="23" creationId="{4B115050-06D9-BFFE-CFA1-01B6BF4CB5A5}"/>
          </ac:spMkLst>
        </pc:spChg>
        <pc:spChg chg="add mod">
          <ac:chgData name="Kumar, Vinod" userId="a0710a6e-bffc-4971-8893-1c23addeb5b0" providerId="ADAL" clId="{804748DF-446B-437F-AFFB-E1B8A8B41FF1}" dt="2023-01-31T20:35:57.314" v="6422" actId="164"/>
          <ac:spMkLst>
            <pc:docMk/>
            <pc:sldMk cId="752802638" sldId="332"/>
            <ac:spMk id="26" creationId="{120A2F3A-727A-B78D-54C0-58BED44CD34A}"/>
          </ac:spMkLst>
        </pc:spChg>
        <pc:spChg chg="add mod">
          <ac:chgData name="Kumar, Vinod" userId="a0710a6e-bffc-4971-8893-1c23addeb5b0" providerId="ADAL" clId="{804748DF-446B-437F-AFFB-E1B8A8B41FF1}" dt="2023-01-31T20:35:57.314" v="6422" actId="164"/>
          <ac:spMkLst>
            <pc:docMk/>
            <pc:sldMk cId="752802638" sldId="332"/>
            <ac:spMk id="28" creationId="{5736D3F9-D856-D538-5B1B-5C64DE533249}"/>
          </ac:spMkLst>
        </pc:spChg>
        <pc:spChg chg="add mod">
          <ac:chgData name="Kumar, Vinod" userId="a0710a6e-bffc-4971-8893-1c23addeb5b0" providerId="ADAL" clId="{804748DF-446B-437F-AFFB-E1B8A8B41FF1}" dt="2023-01-31T20:35:57.314" v="6422" actId="164"/>
          <ac:spMkLst>
            <pc:docMk/>
            <pc:sldMk cId="752802638" sldId="332"/>
            <ac:spMk id="29" creationId="{1BA69D77-28D8-17A0-D9B9-92C0E634CC06}"/>
          </ac:spMkLst>
        </pc:spChg>
        <pc:spChg chg="add mod">
          <ac:chgData name="Kumar, Vinod" userId="a0710a6e-bffc-4971-8893-1c23addeb5b0" providerId="ADAL" clId="{804748DF-446B-437F-AFFB-E1B8A8B41FF1}" dt="2023-01-31T20:35:57.314" v="6422" actId="164"/>
          <ac:spMkLst>
            <pc:docMk/>
            <pc:sldMk cId="752802638" sldId="332"/>
            <ac:spMk id="30" creationId="{5201DD0F-27FD-FD53-9A6C-A28340C1AEBE}"/>
          </ac:spMkLst>
        </pc:spChg>
        <pc:grpChg chg="add mod">
          <ac:chgData name="Kumar, Vinod" userId="a0710a6e-bffc-4971-8893-1c23addeb5b0" providerId="ADAL" clId="{804748DF-446B-437F-AFFB-E1B8A8B41FF1}" dt="2023-01-31T20:39:54.161" v="6574" actId="1076"/>
          <ac:grpSpMkLst>
            <pc:docMk/>
            <pc:sldMk cId="752802638" sldId="332"/>
            <ac:grpSpMk id="35" creationId="{06BFD393-74E6-EEED-2BA3-3BE7BBAFEEF6}"/>
          </ac:grpSpMkLst>
        </pc:grpChg>
        <pc:grpChg chg="add mod">
          <ac:chgData name="Kumar, Vinod" userId="a0710a6e-bffc-4971-8893-1c23addeb5b0" providerId="ADAL" clId="{804748DF-446B-437F-AFFB-E1B8A8B41FF1}" dt="2023-01-31T20:39:45.442" v="6573" actId="164"/>
          <ac:grpSpMkLst>
            <pc:docMk/>
            <pc:sldMk cId="752802638" sldId="332"/>
            <ac:grpSpMk id="80" creationId="{FA9ABAF1-9E65-E0FB-8CEF-34CB4D6010F4}"/>
          </ac:grpSpMkLst>
        </pc:grpChg>
        <pc:picChg chg="add mod">
          <ac:chgData name="Kumar, Vinod" userId="a0710a6e-bffc-4971-8893-1c23addeb5b0" providerId="ADAL" clId="{804748DF-446B-437F-AFFB-E1B8A8B41FF1}" dt="2023-01-31T20:39:45.442" v="6573" actId="164"/>
          <ac:picMkLst>
            <pc:docMk/>
            <pc:sldMk cId="752802638" sldId="332"/>
            <ac:picMk id="2" creationId="{33BD9879-DDDD-AED8-3DED-BE9389448AB4}"/>
          </ac:picMkLst>
        </pc:picChg>
        <pc:picChg chg="add mod">
          <ac:chgData name="Kumar, Vinod" userId="a0710a6e-bffc-4971-8893-1c23addeb5b0" providerId="ADAL" clId="{804748DF-446B-437F-AFFB-E1B8A8B41FF1}" dt="2023-01-31T20:39:45.442" v="6573" actId="164"/>
          <ac:picMkLst>
            <pc:docMk/>
            <pc:sldMk cId="752802638" sldId="332"/>
            <ac:picMk id="3" creationId="{54DA45D4-4F89-44B2-B5FA-254748486A33}"/>
          </ac:picMkLst>
        </pc:picChg>
        <pc:picChg chg="add mod">
          <ac:chgData name="Kumar, Vinod" userId="a0710a6e-bffc-4971-8893-1c23addeb5b0" providerId="ADAL" clId="{804748DF-446B-437F-AFFB-E1B8A8B41FF1}" dt="2023-01-31T20:39:45.442" v="6573" actId="164"/>
          <ac:picMkLst>
            <pc:docMk/>
            <pc:sldMk cId="752802638" sldId="332"/>
            <ac:picMk id="4" creationId="{1F9CE798-AE80-A91F-E926-15077A570A72}"/>
          </ac:picMkLst>
        </pc:picChg>
        <pc:picChg chg="add del mod">
          <ac:chgData name="Kumar, Vinod" userId="a0710a6e-bffc-4971-8893-1c23addeb5b0" providerId="ADAL" clId="{804748DF-446B-437F-AFFB-E1B8A8B41FF1}" dt="2023-01-30T21:27:01.636" v="4775" actId="478"/>
          <ac:picMkLst>
            <pc:docMk/>
            <pc:sldMk cId="752802638" sldId="332"/>
            <ac:picMk id="5" creationId="{1B973FD0-6584-2D40-D401-F57B1856D4A5}"/>
          </ac:picMkLst>
        </pc:picChg>
        <pc:picChg chg="add mod">
          <ac:chgData name="Kumar, Vinod" userId="a0710a6e-bffc-4971-8893-1c23addeb5b0" providerId="ADAL" clId="{804748DF-446B-437F-AFFB-E1B8A8B41FF1}" dt="2023-01-31T20:35:57.314" v="6422" actId="164"/>
          <ac:picMkLst>
            <pc:docMk/>
            <pc:sldMk cId="752802638" sldId="332"/>
            <ac:picMk id="20" creationId="{1757194A-3944-8FE8-D182-537EA2DECE5F}"/>
          </ac:picMkLst>
        </pc:picChg>
        <pc:cxnChg chg="add mod">
          <ac:chgData name="Kumar, Vinod" userId="a0710a6e-bffc-4971-8893-1c23addeb5b0" providerId="ADAL" clId="{804748DF-446B-437F-AFFB-E1B8A8B41FF1}" dt="2023-01-31T20:39:45.442" v="6573" actId="164"/>
          <ac:cxnSpMkLst>
            <pc:docMk/>
            <pc:sldMk cId="752802638" sldId="332"/>
            <ac:cxnSpMk id="9" creationId="{36AEE693-365C-A2B0-B93C-1D6E9B71D2B9}"/>
          </ac:cxnSpMkLst>
        </pc:cxnChg>
        <pc:cxnChg chg="add mod">
          <ac:chgData name="Kumar, Vinod" userId="a0710a6e-bffc-4971-8893-1c23addeb5b0" providerId="ADAL" clId="{804748DF-446B-437F-AFFB-E1B8A8B41FF1}" dt="2023-01-31T20:39:45.442" v="6573" actId="164"/>
          <ac:cxnSpMkLst>
            <pc:docMk/>
            <pc:sldMk cId="752802638" sldId="332"/>
            <ac:cxnSpMk id="12" creationId="{6DE2DC25-A0EB-8B93-C924-E57433FEA195}"/>
          </ac:cxnSpMkLst>
        </pc:cxnChg>
        <pc:cxnChg chg="add mod">
          <ac:chgData name="Kumar, Vinod" userId="a0710a6e-bffc-4971-8893-1c23addeb5b0" providerId="ADAL" clId="{804748DF-446B-437F-AFFB-E1B8A8B41FF1}" dt="2023-01-31T20:39:45.442" v="6573" actId="164"/>
          <ac:cxnSpMkLst>
            <pc:docMk/>
            <pc:sldMk cId="752802638" sldId="332"/>
            <ac:cxnSpMk id="13" creationId="{94F5A3B9-C37F-D47F-EC8E-68066F973712}"/>
          </ac:cxnSpMkLst>
        </pc:cxnChg>
        <pc:cxnChg chg="add mod">
          <ac:chgData name="Kumar, Vinod" userId="a0710a6e-bffc-4971-8893-1c23addeb5b0" providerId="ADAL" clId="{804748DF-446B-437F-AFFB-E1B8A8B41FF1}" dt="2023-01-31T20:39:45.442" v="6573" actId="164"/>
          <ac:cxnSpMkLst>
            <pc:docMk/>
            <pc:sldMk cId="752802638" sldId="332"/>
            <ac:cxnSpMk id="14" creationId="{B78AC35E-70CA-C241-DF93-64D60EA45559}"/>
          </ac:cxnSpMkLst>
        </pc:cxnChg>
        <pc:cxnChg chg="add mod">
          <ac:chgData name="Kumar, Vinod" userId="a0710a6e-bffc-4971-8893-1c23addeb5b0" providerId="ADAL" clId="{804748DF-446B-437F-AFFB-E1B8A8B41FF1}" dt="2023-01-31T20:35:57.314" v="6422" actId="164"/>
          <ac:cxnSpMkLst>
            <pc:docMk/>
            <pc:sldMk cId="752802638" sldId="332"/>
            <ac:cxnSpMk id="24" creationId="{AAA415CA-049A-D6A4-8F5D-471FC2ADCAC8}"/>
          </ac:cxnSpMkLst>
        </pc:cxnChg>
        <pc:cxnChg chg="add mod">
          <ac:chgData name="Kumar, Vinod" userId="a0710a6e-bffc-4971-8893-1c23addeb5b0" providerId="ADAL" clId="{804748DF-446B-437F-AFFB-E1B8A8B41FF1}" dt="2023-01-31T20:35:57.314" v="6422" actId="164"/>
          <ac:cxnSpMkLst>
            <pc:docMk/>
            <pc:sldMk cId="752802638" sldId="332"/>
            <ac:cxnSpMk id="25" creationId="{CA9535ED-D6AE-EC11-1619-7D141042CEF9}"/>
          </ac:cxnSpMkLst>
        </pc:cxnChg>
        <pc:cxnChg chg="add mod">
          <ac:chgData name="Kumar, Vinod" userId="a0710a6e-bffc-4971-8893-1c23addeb5b0" providerId="ADAL" clId="{804748DF-446B-437F-AFFB-E1B8A8B41FF1}" dt="2023-01-31T20:35:57.314" v="6422" actId="164"/>
          <ac:cxnSpMkLst>
            <pc:docMk/>
            <pc:sldMk cId="752802638" sldId="332"/>
            <ac:cxnSpMk id="27" creationId="{E95CD7E9-E269-2A03-8CD9-D092DA6373BA}"/>
          </ac:cxnSpMkLst>
        </pc:cxnChg>
      </pc:sldChg>
      <pc:sldChg chg="addSp delSp modSp new mod">
        <pc:chgData name="Kumar, Vinod" userId="a0710a6e-bffc-4971-8893-1c23addeb5b0" providerId="ADAL" clId="{804748DF-446B-437F-AFFB-E1B8A8B41FF1}" dt="2023-01-31T20:34:08.827" v="6376" actId="1076"/>
        <pc:sldMkLst>
          <pc:docMk/>
          <pc:sldMk cId="2717138259" sldId="333"/>
        </pc:sldMkLst>
        <pc:spChg chg="add mod">
          <ac:chgData name="Kumar, Vinod" userId="a0710a6e-bffc-4971-8893-1c23addeb5b0" providerId="ADAL" clId="{804748DF-446B-437F-AFFB-E1B8A8B41FF1}" dt="2023-01-31T20:31:08.885" v="6248" actId="1076"/>
          <ac:spMkLst>
            <pc:docMk/>
            <pc:sldMk cId="2717138259" sldId="333"/>
            <ac:spMk id="2" creationId="{AAE1FA69-3576-CF10-27A3-42FC37A61688}"/>
          </ac:spMkLst>
        </pc:spChg>
        <pc:spChg chg="add mod topLvl">
          <ac:chgData name="Kumar, Vinod" userId="a0710a6e-bffc-4971-8893-1c23addeb5b0" providerId="ADAL" clId="{804748DF-446B-437F-AFFB-E1B8A8B41FF1}" dt="2023-01-31T20:30:59.732" v="6245" actId="164"/>
          <ac:spMkLst>
            <pc:docMk/>
            <pc:sldMk cId="2717138259" sldId="333"/>
            <ac:spMk id="9" creationId="{5F98B726-5A42-AED0-373E-C1D85BA585A6}"/>
          </ac:spMkLst>
        </pc:spChg>
        <pc:spChg chg="add mod topLvl">
          <ac:chgData name="Kumar, Vinod" userId="a0710a6e-bffc-4971-8893-1c23addeb5b0" providerId="ADAL" clId="{804748DF-446B-437F-AFFB-E1B8A8B41FF1}" dt="2023-01-31T20:30:59.732" v="6245" actId="164"/>
          <ac:spMkLst>
            <pc:docMk/>
            <pc:sldMk cId="2717138259" sldId="333"/>
            <ac:spMk id="10" creationId="{17056D23-064E-1999-C007-ABDDB45E7B10}"/>
          </ac:spMkLst>
        </pc:spChg>
        <pc:spChg chg="add del mod">
          <ac:chgData name="Kumar, Vinod" userId="a0710a6e-bffc-4971-8893-1c23addeb5b0" providerId="ADAL" clId="{804748DF-446B-437F-AFFB-E1B8A8B41FF1}" dt="2023-01-30T21:05:43.197" v="4296" actId="478"/>
          <ac:spMkLst>
            <pc:docMk/>
            <pc:sldMk cId="2717138259" sldId="333"/>
            <ac:spMk id="11" creationId="{9D679223-5E86-189B-89D7-E853E54D0849}"/>
          </ac:spMkLst>
        </pc:spChg>
        <pc:spChg chg="add del mod">
          <ac:chgData name="Kumar, Vinod" userId="a0710a6e-bffc-4971-8893-1c23addeb5b0" providerId="ADAL" clId="{804748DF-446B-437F-AFFB-E1B8A8B41FF1}" dt="2023-01-30T21:05:43.197" v="4296" actId="478"/>
          <ac:spMkLst>
            <pc:docMk/>
            <pc:sldMk cId="2717138259" sldId="333"/>
            <ac:spMk id="13" creationId="{64BDF4C1-0C78-2889-5E9E-8CA668095EC4}"/>
          </ac:spMkLst>
        </pc:spChg>
        <pc:spChg chg="add del mod">
          <ac:chgData name="Kumar, Vinod" userId="a0710a6e-bffc-4971-8893-1c23addeb5b0" providerId="ADAL" clId="{804748DF-446B-437F-AFFB-E1B8A8B41FF1}" dt="2023-01-30T21:05:44.990" v="4297" actId="478"/>
          <ac:spMkLst>
            <pc:docMk/>
            <pc:sldMk cId="2717138259" sldId="333"/>
            <ac:spMk id="14" creationId="{D24A16B3-09D3-8137-AFB9-601D64AA5433}"/>
          </ac:spMkLst>
        </pc:spChg>
        <pc:spChg chg="add del mod">
          <ac:chgData name="Kumar, Vinod" userId="a0710a6e-bffc-4971-8893-1c23addeb5b0" providerId="ADAL" clId="{804748DF-446B-437F-AFFB-E1B8A8B41FF1}" dt="2023-01-30T21:05:44.990" v="4297" actId="478"/>
          <ac:spMkLst>
            <pc:docMk/>
            <pc:sldMk cId="2717138259" sldId="333"/>
            <ac:spMk id="15" creationId="{75DDEFB0-7E02-0970-8F9A-86B60D1E0393}"/>
          </ac:spMkLst>
        </pc:spChg>
        <pc:spChg chg="add mod topLvl">
          <ac:chgData name="Kumar, Vinod" userId="a0710a6e-bffc-4971-8893-1c23addeb5b0" providerId="ADAL" clId="{804748DF-446B-437F-AFFB-E1B8A8B41FF1}" dt="2023-01-31T20:30:59.732" v="6245" actId="164"/>
          <ac:spMkLst>
            <pc:docMk/>
            <pc:sldMk cId="2717138259" sldId="333"/>
            <ac:spMk id="16" creationId="{77A4A686-AD1A-D200-9903-08B78CB77898}"/>
          </ac:spMkLst>
        </pc:spChg>
        <pc:spChg chg="add mod topLvl">
          <ac:chgData name="Kumar, Vinod" userId="a0710a6e-bffc-4971-8893-1c23addeb5b0" providerId="ADAL" clId="{804748DF-446B-437F-AFFB-E1B8A8B41FF1}" dt="2023-01-31T20:30:59.732" v="6245" actId="164"/>
          <ac:spMkLst>
            <pc:docMk/>
            <pc:sldMk cId="2717138259" sldId="333"/>
            <ac:spMk id="17" creationId="{E3BCF434-9F77-BFB1-FB7F-719B88E36435}"/>
          </ac:spMkLst>
        </pc:spChg>
        <pc:spChg chg="add mod topLvl">
          <ac:chgData name="Kumar, Vinod" userId="a0710a6e-bffc-4971-8893-1c23addeb5b0" providerId="ADAL" clId="{804748DF-446B-437F-AFFB-E1B8A8B41FF1}" dt="2023-01-31T20:30:59.732" v="6245" actId="164"/>
          <ac:spMkLst>
            <pc:docMk/>
            <pc:sldMk cId="2717138259" sldId="333"/>
            <ac:spMk id="18" creationId="{15E1D8C1-8479-E32E-9EBE-B61F61AA13D2}"/>
          </ac:spMkLst>
        </pc:spChg>
        <pc:spChg chg="add mod topLvl">
          <ac:chgData name="Kumar, Vinod" userId="a0710a6e-bffc-4971-8893-1c23addeb5b0" providerId="ADAL" clId="{804748DF-446B-437F-AFFB-E1B8A8B41FF1}" dt="2023-01-31T20:30:59.732" v="6245" actId="164"/>
          <ac:spMkLst>
            <pc:docMk/>
            <pc:sldMk cId="2717138259" sldId="333"/>
            <ac:spMk id="21" creationId="{3B7696FE-9D9C-73F0-17E4-0ADB01CBD778}"/>
          </ac:spMkLst>
        </pc:spChg>
        <pc:spChg chg="add mod topLvl">
          <ac:chgData name="Kumar, Vinod" userId="a0710a6e-bffc-4971-8893-1c23addeb5b0" providerId="ADAL" clId="{804748DF-446B-437F-AFFB-E1B8A8B41FF1}" dt="2023-01-31T20:30:59.732" v="6245" actId="164"/>
          <ac:spMkLst>
            <pc:docMk/>
            <pc:sldMk cId="2717138259" sldId="333"/>
            <ac:spMk id="22" creationId="{CA5B3FDE-C04C-71BC-2653-F3BB9688EF37}"/>
          </ac:spMkLst>
        </pc:spChg>
        <pc:spChg chg="add mod topLvl">
          <ac:chgData name="Kumar, Vinod" userId="a0710a6e-bffc-4971-8893-1c23addeb5b0" providerId="ADAL" clId="{804748DF-446B-437F-AFFB-E1B8A8B41FF1}" dt="2023-01-31T20:30:59.732" v="6245" actId="164"/>
          <ac:spMkLst>
            <pc:docMk/>
            <pc:sldMk cId="2717138259" sldId="333"/>
            <ac:spMk id="23" creationId="{D7276D83-9E44-5234-13CC-DDFCEFF16AAA}"/>
          </ac:spMkLst>
        </pc:spChg>
        <pc:spChg chg="add mod">
          <ac:chgData name="Kumar, Vinod" userId="a0710a6e-bffc-4971-8893-1c23addeb5b0" providerId="ADAL" clId="{804748DF-446B-437F-AFFB-E1B8A8B41FF1}" dt="2023-01-31T20:34:00.761" v="6375" actId="164"/>
          <ac:spMkLst>
            <pc:docMk/>
            <pc:sldMk cId="2717138259" sldId="333"/>
            <ac:spMk id="28" creationId="{1F66D1CD-9F75-4A67-A33A-47E4D0ED4242}"/>
          </ac:spMkLst>
        </pc:spChg>
        <pc:spChg chg="add mod">
          <ac:chgData name="Kumar, Vinod" userId="a0710a6e-bffc-4971-8893-1c23addeb5b0" providerId="ADAL" clId="{804748DF-446B-437F-AFFB-E1B8A8B41FF1}" dt="2023-01-31T20:34:00.761" v="6375" actId="164"/>
          <ac:spMkLst>
            <pc:docMk/>
            <pc:sldMk cId="2717138259" sldId="333"/>
            <ac:spMk id="29" creationId="{0887728D-8556-6046-11FF-59CAD3BEDF9A}"/>
          </ac:spMkLst>
        </pc:spChg>
        <pc:spChg chg="add mod">
          <ac:chgData name="Kumar, Vinod" userId="a0710a6e-bffc-4971-8893-1c23addeb5b0" providerId="ADAL" clId="{804748DF-446B-437F-AFFB-E1B8A8B41FF1}" dt="2023-01-31T20:34:00.761" v="6375" actId="164"/>
          <ac:spMkLst>
            <pc:docMk/>
            <pc:sldMk cId="2717138259" sldId="333"/>
            <ac:spMk id="30" creationId="{578DFA40-05C3-9D38-6D1D-48AC97518F36}"/>
          </ac:spMkLst>
        </pc:spChg>
        <pc:spChg chg="add mod">
          <ac:chgData name="Kumar, Vinod" userId="a0710a6e-bffc-4971-8893-1c23addeb5b0" providerId="ADAL" clId="{804748DF-446B-437F-AFFB-E1B8A8B41FF1}" dt="2023-01-31T20:34:00.761" v="6375" actId="164"/>
          <ac:spMkLst>
            <pc:docMk/>
            <pc:sldMk cId="2717138259" sldId="333"/>
            <ac:spMk id="32" creationId="{80656886-32F0-96AF-EA9E-3710C5BB4DED}"/>
          </ac:spMkLst>
        </pc:spChg>
        <pc:spChg chg="add mod">
          <ac:chgData name="Kumar, Vinod" userId="a0710a6e-bffc-4971-8893-1c23addeb5b0" providerId="ADAL" clId="{804748DF-446B-437F-AFFB-E1B8A8B41FF1}" dt="2023-01-31T20:34:00.761" v="6375" actId="164"/>
          <ac:spMkLst>
            <pc:docMk/>
            <pc:sldMk cId="2717138259" sldId="333"/>
            <ac:spMk id="33" creationId="{2943CED5-2316-2E97-C762-BBE2BE72F2B5}"/>
          </ac:spMkLst>
        </pc:spChg>
        <pc:spChg chg="add mod">
          <ac:chgData name="Kumar, Vinod" userId="a0710a6e-bffc-4971-8893-1c23addeb5b0" providerId="ADAL" clId="{804748DF-446B-437F-AFFB-E1B8A8B41FF1}" dt="2023-01-31T20:34:00.761" v="6375" actId="164"/>
          <ac:spMkLst>
            <pc:docMk/>
            <pc:sldMk cId="2717138259" sldId="333"/>
            <ac:spMk id="37" creationId="{6ADC91E2-4956-95E0-0320-8D6CE203DDBB}"/>
          </ac:spMkLst>
        </pc:spChg>
        <pc:spChg chg="add mod">
          <ac:chgData name="Kumar, Vinod" userId="a0710a6e-bffc-4971-8893-1c23addeb5b0" providerId="ADAL" clId="{804748DF-446B-437F-AFFB-E1B8A8B41FF1}" dt="2023-01-31T20:30:59.732" v="6245" actId="164"/>
          <ac:spMkLst>
            <pc:docMk/>
            <pc:sldMk cId="2717138259" sldId="333"/>
            <ac:spMk id="39" creationId="{8E6D78D3-51B5-C8A0-1C46-FAB8D2B4C652}"/>
          </ac:spMkLst>
        </pc:spChg>
        <pc:spChg chg="add mod">
          <ac:chgData name="Kumar, Vinod" userId="a0710a6e-bffc-4971-8893-1c23addeb5b0" providerId="ADAL" clId="{804748DF-446B-437F-AFFB-E1B8A8B41FF1}" dt="2023-01-31T20:34:00.761" v="6375" actId="164"/>
          <ac:spMkLst>
            <pc:docMk/>
            <pc:sldMk cId="2717138259" sldId="333"/>
            <ac:spMk id="40" creationId="{A112A49A-E17F-3202-125C-613B56FEB4A6}"/>
          </ac:spMkLst>
        </pc:spChg>
        <pc:spChg chg="add mod">
          <ac:chgData name="Kumar, Vinod" userId="a0710a6e-bffc-4971-8893-1c23addeb5b0" providerId="ADAL" clId="{804748DF-446B-437F-AFFB-E1B8A8B41FF1}" dt="2023-01-31T20:34:00.761" v="6375" actId="164"/>
          <ac:spMkLst>
            <pc:docMk/>
            <pc:sldMk cId="2717138259" sldId="333"/>
            <ac:spMk id="41" creationId="{E28368FB-C790-63FA-FC39-97EBF6F0614C}"/>
          </ac:spMkLst>
        </pc:spChg>
        <pc:spChg chg="add mod">
          <ac:chgData name="Kumar, Vinod" userId="a0710a6e-bffc-4971-8893-1c23addeb5b0" providerId="ADAL" clId="{804748DF-446B-437F-AFFB-E1B8A8B41FF1}" dt="2023-01-31T20:34:00.761" v="6375" actId="164"/>
          <ac:spMkLst>
            <pc:docMk/>
            <pc:sldMk cId="2717138259" sldId="333"/>
            <ac:spMk id="42" creationId="{FE4C2059-3D43-D1E4-FABA-B377898489A2}"/>
          </ac:spMkLst>
        </pc:spChg>
        <pc:grpChg chg="add mod">
          <ac:chgData name="Kumar, Vinod" userId="a0710a6e-bffc-4971-8893-1c23addeb5b0" providerId="ADAL" clId="{804748DF-446B-437F-AFFB-E1B8A8B41FF1}" dt="2023-01-31T20:25:35.472" v="6106" actId="164"/>
          <ac:grpSpMkLst>
            <pc:docMk/>
            <pc:sldMk cId="2717138259" sldId="333"/>
            <ac:grpSpMk id="3" creationId="{43065DBB-B410-9EF1-7052-11C2EE5F7EED}"/>
          </ac:grpSpMkLst>
        </pc:grpChg>
        <pc:grpChg chg="add del mod">
          <ac:chgData name="Kumar, Vinod" userId="a0710a6e-bffc-4971-8893-1c23addeb5b0" providerId="ADAL" clId="{804748DF-446B-437F-AFFB-E1B8A8B41FF1}" dt="2023-01-30T21:06:44.620" v="4300" actId="165"/>
          <ac:grpSpMkLst>
            <pc:docMk/>
            <pc:sldMk cId="2717138259" sldId="333"/>
            <ac:grpSpMk id="24" creationId="{852F9BBA-D239-A53E-42F7-7A4FF8864F76}"/>
          </ac:grpSpMkLst>
        </pc:grpChg>
        <pc:grpChg chg="add mod">
          <ac:chgData name="Kumar, Vinod" userId="a0710a6e-bffc-4971-8893-1c23addeb5b0" providerId="ADAL" clId="{804748DF-446B-437F-AFFB-E1B8A8B41FF1}" dt="2023-01-31T20:31:03.029" v="6246" actId="1076"/>
          <ac:grpSpMkLst>
            <pc:docMk/>
            <pc:sldMk cId="2717138259" sldId="333"/>
            <ac:grpSpMk id="82" creationId="{059C05DB-C9CD-58B1-5AA6-5C22D4B5E8B3}"/>
          </ac:grpSpMkLst>
        </pc:grpChg>
        <pc:grpChg chg="add mod">
          <ac:chgData name="Kumar, Vinod" userId="a0710a6e-bffc-4971-8893-1c23addeb5b0" providerId="ADAL" clId="{804748DF-446B-437F-AFFB-E1B8A8B41FF1}" dt="2023-01-31T20:34:08.827" v="6376" actId="1076"/>
          <ac:grpSpMkLst>
            <pc:docMk/>
            <pc:sldMk cId="2717138259" sldId="333"/>
            <ac:grpSpMk id="83" creationId="{CC01ADD8-13C6-4D59-0F2B-229F3061FB4F}"/>
          </ac:grpSpMkLst>
        </pc:grpChg>
        <pc:picChg chg="add del mod">
          <ac:chgData name="Kumar, Vinod" userId="a0710a6e-bffc-4971-8893-1c23addeb5b0" providerId="ADAL" clId="{804748DF-446B-437F-AFFB-E1B8A8B41FF1}" dt="2023-01-30T20:57:19.393" v="4076" actId="478"/>
          <ac:picMkLst>
            <pc:docMk/>
            <pc:sldMk cId="2717138259" sldId="333"/>
            <ac:picMk id="2" creationId="{02FEA9EA-0906-1F10-AF73-A08777C47C77}"/>
          </ac:picMkLst>
        </pc:picChg>
        <pc:picChg chg="add del mod">
          <ac:chgData name="Kumar, Vinod" userId="a0710a6e-bffc-4971-8893-1c23addeb5b0" providerId="ADAL" clId="{804748DF-446B-437F-AFFB-E1B8A8B41FF1}" dt="2023-01-30T20:56:51.842" v="4070" actId="478"/>
          <ac:picMkLst>
            <pc:docMk/>
            <pc:sldMk cId="2717138259" sldId="333"/>
            <ac:picMk id="3" creationId="{51476808-1620-3F57-C985-30D104879241}"/>
          </ac:picMkLst>
        </pc:picChg>
        <pc:picChg chg="mod topLvl modCrop">
          <ac:chgData name="Kumar, Vinod" userId="a0710a6e-bffc-4971-8893-1c23addeb5b0" providerId="ADAL" clId="{804748DF-446B-437F-AFFB-E1B8A8B41FF1}" dt="2023-01-31T20:30:59.732" v="6245" actId="164"/>
          <ac:picMkLst>
            <pc:docMk/>
            <pc:sldMk cId="2717138259" sldId="333"/>
            <ac:picMk id="4" creationId="{411C825B-C897-D719-A7AC-9C645A76B8B5}"/>
          </ac:picMkLst>
        </pc:picChg>
        <pc:picChg chg="add mod topLvl modCrop">
          <ac:chgData name="Kumar, Vinod" userId="a0710a6e-bffc-4971-8893-1c23addeb5b0" providerId="ADAL" clId="{804748DF-446B-437F-AFFB-E1B8A8B41FF1}" dt="2023-01-31T20:30:59.732" v="6245" actId="164"/>
          <ac:picMkLst>
            <pc:docMk/>
            <pc:sldMk cId="2717138259" sldId="333"/>
            <ac:picMk id="5" creationId="{EAB60DCA-3BA5-D97E-59F1-AFC79D0DB2BA}"/>
          </ac:picMkLst>
        </pc:picChg>
        <pc:picChg chg="add mod topLvl modCrop">
          <ac:chgData name="Kumar, Vinod" userId="a0710a6e-bffc-4971-8893-1c23addeb5b0" providerId="ADAL" clId="{804748DF-446B-437F-AFFB-E1B8A8B41FF1}" dt="2023-01-31T20:30:59.732" v="6245" actId="164"/>
          <ac:picMkLst>
            <pc:docMk/>
            <pc:sldMk cId="2717138259" sldId="333"/>
            <ac:picMk id="6" creationId="{F7588099-A934-83CB-6846-F5F644019001}"/>
          </ac:picMkLst>
        </pc:picChg>
        <pc:picChg chg="add del mod">
          <ac:chgData name="Kumar, Vinod" userId="a0710a6e-bffc-4971-8893-1c23addeb5b0" providerId="ADAL" clId="{804748DF-446B-437F-AFFB-E1B8A8B41FF1}" dt="2023-01-30T21:05:44.990" v="4297" actId="478"/>
          <ac:picMkLst>
            <pc:docMk/>
            <pc:sldMk cId="2717138259" sldId="333"/>
            <ac:picMk id="7" creationId="{B57CCEE3-4A19-5116-D26A-7CF75AFE6018}"/>
          </ac:picMkLst>
        </pc:picChg>
        <pc:picChg chg="add del mod">
          <ac:chgData name="Kumar, Vinod" userId="a0710a6e-bffc-4971-8893-1c23addeb5b0" providerId="ADAL" clId="{804748DF-446B-437F-AFFB-E1B8A8B41FF1}" dt="2023-01-30T21:05:44.990" v="4297" actId="478"/>
          <ac:picMkLst>
            <pc:docMk/>
            <pc:sldMk cId="2717138259" sldId="333"/>
            <ac:picMk id="8" creationId="{F38D9420-8117-248B-12EC-EFFA0C74C6E3}"/>
          </ac:picMkLst>
        </pc:picChg>
        <pc:picChg chg="add del mod">
          <ac:chgData name="Kumar, Vinod" userId="a0710a6e-bffc-4971-8893-1c23addeb5b0" providerId="ADAL" clId="{804748DF-446B-437F-AFFB-E1B8A8B41FF1}" dt="2023-01-30T21:08:37.099" v="4306" actId="478"/>
          <ac:picMkLst>
            <pc:docMk/>
            <pc:sldMk cId="2717138259" sldId="333"/>
            <ac:picMk id="25" creationId="{1E810BD2-70A7-920E-0A36-57E10BC0E90A}"/>
          </ac:picMkLst>
        </pc:picChg>
        <pc:picChg chg="add del mod">
          <ac:chgData name="Kumar, Vinod" userId="a0710a6e-bffc-4971-8893-1c23addeb5b0" providerId="ADAL" clId="{804748DF-446B-437F-AFFB-E1B8A8B41FF1}" dt="2023-01-30T21:09:05.339" v="4309" actId="478"/>
          <ac:picMkLst>
            <pc:docMk/>
            <pc:sldMk cId="2717138259" sldId="333"/>
            <ac:picMk id="26" creationId="{C6EA19BB-F072-8181-A9AE-188E4F664FF6}"/>
          </ac:picMkLst>
        </pc:picChg>
        <pc:picChg chg="mod modCrop">
          <ac:chgData name="Kumar, Vinod" userId="a0710a6e-bffc-4971-8893-1c23addeb5b0" providerId="ADAL" clId="{804748DF-446B-437F-AFFB-E1B8A8B41FF1}" dt="2023-01-31T20:34:00.761" v="6375" actId="164"/>
          <ac:picMkLst>
            <pc:docMk/>
            <pc:sldMk cId="2717138259" sldId="333"/>
            <ac:picMk id="27" creationId="{31613420-B9A4-231A-8A4B-D94CC5D41468}"/>
          </ac:picMkLst>
        </pc:picChg>
        <pc:cxnChg chg="add mod topLvl">
          <ac:chgData name="Kumar, Vinod" userId="a0710a6e-bffc-4971-8893-1c23addeb5b0" providerId="ADAL" clId="{804748DF-446B-437F-AFFB-E1B8A8B41FF1}" dt="2023-01-31T20:30:59.732" v="6245" actId="164"/>
          <ac:cxnSpMkLst>
            <pc:docMk/>
            <pc:sldMk cId="2717138259" sldId="333"/>
            <ac:cxnSpMk id="12" creationId="{8DF017F7-5C05-DAB2-3D1D-0631901CCA2D}"/>
          </ac:cxnSpMkLst>
        </pc:cxnChg>
        <pc:cxnChg chg="add mod topLvl">
          <ac:chgData name="Kumar, Vinod" userId="a0710a6e-bffc-4971-8893-1c23addeb5b0" providerId="ADAL" clId="{804748DF-446B-437F-AFFB-E1B8A8B41FF1}" dt="2023-01-31T20:30:59.732" v="6245" actId="164"/>
          <ac:cxnSpMkLst>
            <pc:docMk/>
            <pc:sldMk cId="2717138259" sldId="333"/>
            <ac:cxnSpMk id="19" creationId="{5AAB5AB6-8A8D-A531-A20C-D7A7556E3204}"/>
          </ac:cxnSpMkLst>
        </pc:cxnChg>
        <pc:cxnChg chg="add mod topLvl">
          <ac:chgData name="Kumar, Vinod" userId="a0710a6e-bffc-4971-8893-1c23addeb5b0" providerId="ADAL" clId="{804748DF-446B-437F-AFFB-E1B8A8B41FF1}" dt="2023-01-31T20:30:59.732" v="6245" actId="164"/>
          <ac:cxnSpMkLst>
            <pc:docMk/>
            <pc:sldMk cId="2717138259" sldId="333"/>
            <ac:cxnSpMk id="20" creationId="{511B59D3-A680-AE0D-A731-7C556D16AD54}"/>
          </ac:cxnSpMkLst>
        </pc:cxnChg>
        <pc:cxnChg chg="add mod">
          <ac:chgData name="Kumar, Vinod" userId="a0710a6e-bffc-4971-8893-1c23addeb5b0" providerId="ADAL" clId="{804748DF-446B-437F-AFFB-E1B8A8B41FF1}" dt="2023-01-31T20:34:00.761" v="6375" actId="164"/>
          <ac:cxnSpMkLst>
            <pc:docMk/>
            <pc:sldMk cId="2717138259" sldId="333"/>
            <ac:cxnSpMk id="31" creationId="{96269E67-E081-302B-8560-BF0606DF6CBE}"/>
          </ac:cxnSpMkLst>
        </pc:cxnChg>
        <pc:cxnChg chg="add mod">
          <ac:chgData name="Kumar, Vinod" userId="a0710a6e-bffc-4971-8893-1c23addeb5b0" providerId="ADAL" clId="{804748DF-446B-437F-AFFB-E1B8A8B41FF1}" dt="2023-01-31T20:34:00.761" v="6375" actId="164"/>
          <ac:cxnSpMkLst>
            <pc:docMk/>
            <pc:sldMk cId="2717138259" sldId="333"/>
            <ac:cxnSpMk id="34" creationId="{EFE9921A-D691-E6A1-8510-FDC4091FD01F}"/>
          </ac:cxnSpMkLst>
        </pc:cxnChg>
        <pc:cxnChg chg="add mod">
          <ac:chgData name="Kumar, Vinod" userId="a0710a6e-bffc-4971-8893-1c23addeb5b0" providerId="ADAL" clId="{804748DF-446B-437F-AFFB-E1B8A8B41FF1}" dt="2023-01-31T20:34:00.761" v="6375" actId="164"/>
          <ac:cxnSpMkLst>
            <pc:docMk/>
            <pc:sldMk cId="2717138259" sldId="333"/>
            <ac:cxnSpMk id="35" creationId="{1B8F4C9E-6DAD-6BB2-0D52-BA0EB26EDC00}"/>
          </ac:cxnSpMkLst>
        </pc:cxnChg>
        <pc:cxnChg chg="add mod">
          <ac:chgData name="Kumar, Vinod" userId="a0710a6e-bffc-4971-8893-1c23addeb5b0" providerId="ADAL" clId="{804748DF-446B-437F-AFFB-E1B8A8B41FF1}" dt="2023-01-31T20:34:00.761" v="6375" actId="164"/>
          <ac:cxnSpMkLst>
            <pc:docMk/>
            <pc:sldMk cId="2717138259" sldId="333"/>
            <ac:cxnSpMk id="36" creationId="{D44CB3E4-225D-FE7C-D781-5FD5D416F47D}"/>
          </ac:cxnSpMkLst>
        </pc:cxnChg>
        <pc:cxnChg chg="add mod">
          <ac:chgData name="Kumar, Vinod" userId="a0710a6e-bffc-4971-8893-1c23addeb5b0" providerId="ADAL" clId="{804748DF-446B-437F-AFFB-E1B8A8B41FF1}" dt="2023-01-31T20:30:59.732" v="6245" actId="164"/>
          <ac:cxnSpMkLst>
            <pc:docMk/>
            <pc:sldMk cId="2717138259" sldId="333"/>
            <ac:cxnSpMk id="38" creationId="{79FF08F4-482D-E38B-162F-8CCB35D54461}"/>
          </ac:cxnSpMkLst>
        </pc:cxnChg>
      </pc:sldChg>
      <pc:sldChg chg="addSp delSp modSp new mod">
        <pc:chgData name="Kumar, Vinod" userId="a0710a6e-bffc-4971-8893-1c23addeb5b0" providerId="ADAL" clId="{804748DF-446B-437F-AFFB-E1B8A8B41FF1}" dt="2023-01-31T20:23:15.017" v="6085" actId="1076"/>
        <pc:sldMkLst>
          <pc:docMk/>
          <pc:sldMk cId="465941897" sldId="334"/>
        </pc:sldMkLst>
        <pc:spChg chg="add mod">
          <ac:chgData name="Kumar, Vinod" userId="a0710a6e-bffc-4971-8893-1c23addeb5b0" providerId="ADAL" clId="{804748DF-446B-437F-AFFB-E1B8A8B41FF1}" dt="2023-01-31T20:22:45.880" v="6081" actId="164"/>
          <ac:spMkLst>
            <pc:docMk/>
            <pc:sldMk cId="465941897" sldId="334"/>
            <ac:spMk id="13" creationId="{E10FDB49-3AE5-7E13-D9E6-DB146078D4D5}"/>
          </ac:spMkLst>
        </pc:spChg>
        <pc:spChg chg="add mod">
          <ac:chgData name="Kumar, Vinod" userId="a0710a6e-bffc-4971-8893-1c23addeb5b0" providerId="ADAL" clId="{804748DF-446B-437F-AFFB-E1B8A8B41FF1}" dt="2023-01-31T20:22:45.880" v="6081" actId="164"/>
          <ac:spMkLst>
            <pc:docMk/>
            <pc:sldMk cId="465941897" sldId="334"/>
            <ac:spMk id="14" creationId="{11078AFD-D04E-469F-20BF-10AF687B7292}"/>
          </ac:spMkLst>
        </pc:spChg>
        <pc:spChg chg="add del mod">
          <ac:chgData name="Kumar, Vinod" userId="a0710a6e-bffc-4971-8893-1c23addeb5b0" providerId="ADAL" clId="{804748DF-446B-437F-AFFB-E1B8A8B41FF1}" dt="2023-01-30T22:09:48.303" v="5457" actId="478"/>
          <ac:spMkLst>
            <pc:docMk/>
            <pc:sldMk cId="465941897" sldId="334"/>
            <ac:spMk id="15" creationId="{CB7E28C2-6BAD-526C-0540-255A20B0EE55}"/>
          </ac:spMkLst>
        </pc:spChg>
        <pc:spChg chg="add mod">
          <ac:chgData name="Kumar, Vinod" userId="a0710a6e-bffc-4971-8893-1c23addeb5b0" providerId="ADAL" clId="{804748DF-446B-437F-AFFB-E1B8A8B41FF1}" dt="2023-01-31T20:22:45.880" v="6081" actId="164"/>
          <ac:spMkLst>
            <pc:docMk/>
            <pc:sldMk cId="465941897" sldId="334"/>
            <ac:spMk id="19" creationId="{C3152ED9-E6B1-4FD8-437E-3097BE0F7DD3}"/>
          </ac:spMkLst>
        </pc:spChg>
        <pc:spChg chg="add mod">
          <ac:chgData name="Kumar, Vinod" userId="a0710a6e-bffc-4971-8893-1c23addeb5b0" providerId="ADAL" clId="{804748DF-446B-437F-AFFB-E1B8A8B41FF1}" dt="2023-01-31T20:22:45.880" v="6081" actId="164"/>
          <ac:spMkLst>
            <pc:docMk/>
            <pc:sldMk cId="465941897" sldId="334"/>
            <ac:spMk id="20" creationId="{1F7AC974-6E30-7252-06C4-3C697A213010}"/>
          </ac:spMkLst>
        </pc:spChg>
        <pc:spChg chg="add mod">
          <ac:chgData name="Kumar, Vinod" userId="a0710a6e-bffc-4971-8893-1c23addeb5b0" providerId="ADAL" clId="{804748DF-446B-437F-AFFB-E1B8A8B41FF1}" dt="2023-01-31T20:22:45.880" v="6081" actId="164"/>
          <ac:spMkLst>
            <pc:docMk/>
            <pc:sldMk cId="465941897" sldId="334"/>
            <ac:spMk id="21" creationId="{58F092D7-2343-8F50-3E3E-D1D1909DB595}"/>
          </ac:spMkLst>
        </pc:spChg>
        <pc:spChg chg="add del mod">
          <ac:chgData name="Kumar, Vinod" userId="a0710a6e-bffc-4971-8893-1c23addeb5b0" providerId="ADAL" clId="{804748DF-446B-437F-AFFB-E1B8A8B41FF1}" dt="2023-01-30T22:09:48.303" v="5457" actId="478"/>
          <ac:spMkLst>
            <pc:docMk/>
            <pc:sldMk cId="465941897" sldId="334"/>
            <ac:spMk id="22" creationId="{0255995B-287C-7B29-DAC0-E2AC233113E7}"/>
          </ac:spMkLst>
        </pc:spChg>
        <pc:spChg chg="add del mod">
          <ac:chgData name="Kumar, Vinod" userId="a0710a6e-bffc-4971-8893-1c23addeb5b0" providerId="ADAL" clId="{804748DF-446B-437F-AFFB-E1B8A8B41FF1}" dt="2023-01-31T20:22:45.880" v="6081" actId="164"/>
          <ac:spMkLst>
            <pc:docMk/>
            <pc:sldMk cId="465941897" sldId="334"/>
            <ac:spMk id="23" creationId="{0BC8F653-9E24-99F8-9D90-54C4DE742387}"/>
          </ac:spMkLst>
        </pc:spChg>
        <pc:spChg chg="add del mod">
          <ac:chgData name="Kumar, Vinod" userId="a0710a6e-bffc-4971-8893-1c23addeb5b0" providerId="ADAL" clId="{804748DF-446B-437F-AFFB-E1B8A8B41FF1}" dt="2023-01-30T22:09:48.303" v="5457" actId="478"/>
          <ac:spMkLst>
            <pc:docMk/>
            <pc:sldMk cId="465941897" sldId="334"/>
            <ac:spMk id="24" creationId="{5DD64F4F-B8C8-B21D-0045-86D80328AC5C}"/>
          </ac:spMkLst>
        </pc:spChg>
        <pc:spChg chg="add del mod">
          <ac:chgData name="Kumar, Vinod" userId="a0710a6e-bffc-4971-8893-1c23addeb5b0" providerId="ADAL" clId="{804748DF-446B-437F-AFFB-E1B8A8B41FF1}" dt="2023-01-30T22:09:48.303" v="5457" actId="478"/>
          <ac:spMkLst>
            <pc:docMk/>
            <pc:sldMk cId="465941897" sldId="334"/>
            <ac:spMk id="25" creationId="{9BA13F0D-69B7-4D0A-3BC2-CAEE633C47E0}"/>
          </ac:spMkLst>
        </pc:spChg>
        <pc:spChg chg="add del mod">
          <ac:chgData name="Kumar, Vinod" userId="a0710a6e-bffc-4971-8893-1c23addeb5b0" providerId="ADAL" clId="{804748DF-446B-437F-AFFB-E1B8A8B41FF1}" dt="2023-01-30T22:09:48.303" v="5457" actId="478"/>
          <ac:spMkLst>
            <pc:docMk/>
            <pc:sldMk cId="465941897" sldId="334"/>
            <ac:spMk id="26" creationId="{5D4D2DFE-CFA0-EFB2-A225-42F6640E814E}"/>
          </ac:spMkLst>
        </pc:spChg>
        <pc:spChg chg="add mod">
          <ac:chgData name="Kumar, Vinod" userId="a0710a6e-bffc-4971-8893-1c23addeb5b0" providerId="ADAL" clId="{804748DF-446B-437F-AFFB-E1B8A8B41FF1}" dt="2023-01-31T20:22:45.880" v="6081" actId="164"/>
          <ac:spMkLst>
            <pc:docMk/>
            <pc:sldMk cId="465941897" sldId="334"/>
            <ac:spMk id="27" creationId="{1F2667CA-5FE8-4B79-3817-22E15B94DF67}"/>
          </ac:spMkLst>
        </pc:spChg>
        <pc:spChg chg="add mod">
          <ac:chgData name="Kumar, Vinod" userId="a0710a6e-bffc-4971-8893-1c23addeb5b0" providerId="ADAL" clId="{804748DF-446B-437F-AFFB-E1B8A8B41FF1}" dt="2023-01-31T20:22:45.880" v="6081" actId="164"/>
          <ac:spMkLst>
            <pc:docMk/>
            <pc:sldMk cId="465941897" sldId="334"/>
            <ac:spMk id="28" creationId="{4C842A21-BBEB-DD32-48CD-5BF96BDE5922}"/>
          </ac:spMkLst>
        </pc:spChg>
        <pc:spChg chg="add del mod">
          <ac:chgData name="Kumar, Vinod" userId="a0710a6e-bffc-4971-8893-1c23addeb5b0" providerId="ADAL" clId="{804748DF-446B-437F-AFFB-E1B8A8B41FF1}" dt="2023-01-30T22:07:25.728" v="5414" actId="478"/>
          <ac:spMkLst>
            <pc:docMk/>
            <pc:sldMk cId="465941897" sldId="334"/>
            <ac:spMk id="29" creationId="{ECBA8C9B-8769-0C59-4E77-4618693E2B37}"/>
          </ac:spMkLst>
        </pc:spChg>
        <pc:spChg chg="add mod">
          <ac:chgData name="Kumar, Vinod" userId="a0710a6e-bffc-4971-8893-1c23addeb5b0" providerId="ADAL" clId="{804748DF-446B-437F-AFFB-E1B8A8B41FF1}" dt="2023-01-31T20:22:45.880" v="6081" actId="164"/>
          <ac:spMkLst>
            <pc:docMk/>
            <pc:sldMk cId="465941897" sldId="334"/>
            <ac:spMk id="30" creationId="{BFC45917-A2C9-FB9A-DE9F-B91C56D1185A}"/>
          </ac:spMkLst>
        </pc:spChg>
        <pc:spChg chg="add mod">
          <ac:chgData name="Kumar, Vinod" userId="a0710a6e-bffc-4971-8893-1c23addeb5b0" providerId="ADAL" clId="{804748DF-446B-437F-AFFB-E1B8A8B41FF1}" dt="2023-01-31T20:22:45.880" v="6081" actId="164"/>
          <ac:spMkLst>
            <pc:docMk/>
            <pc:sldMk cId="465941897" sldId="334"/>
            <ac:spMk id="31" creationId="{7DF5A570-BEFC-F223-D6E5-C019AE58853F}"/>
          </ac:spMkLst>
        </pc:spChg>
        <pc:spChg chg="add mod">
          <ac:chgData name="Kumar, Vinod" userId="a0710a6e-bffc-4971-8893-1c23addeb5b0" providerId="ADAL" clId="{804748DF-446B-437F-AFFB-E1B8A8B41FF1}" dt="2023-01-31T20:22:45.880" v="6081" actId="164"/>
          <ac:spMkLst>
            <pc:docMk/>
            <pc:sldMk cId="465941897" sldId="334"/>
            <ac:spMk id="32" creationId="{B4E9C4F9-848D-DA21-9C38-6A7603C82B47}"/>
          </ac:spMkLst>
        </pc:spChg>
        <pc:grpChg chg="add mod">
          <ac:chgData name="Kumar, Vinod" userId="a0710a6e-bffc-4971-8893-1c23addeb5b0" providerId="ADAL" clId="{804748DF-446B-437F-AFFB-E1B8A8B41FF1}" dt="2023-01-31T20:23:15.017" v="6085" actId="1076"/>
          <ac:grpSpMkLst>
            <pc:docMk/>
            <pc:sldMk cId="465941897" sldId="334"/>
            <ac:grpSpMk id="2" creationId="{B9364634-BA86-54D7-F5E3-4345FF776018}"/>
          </ac:grpSpMkLst>
        </pc:grpChg>
        <pc:picChg chg="add del mod">
          <ac:chgData name="Kumar, Vinod" userId="a0710a6e-bffc-4971-8893-1c23addeb5b0" providerId="ADAL" clId="{804748DF-446B-437F-AFFB-E1B8A8B41FF1}" dt="2023-01-30T22:03:50.354" v="5201" actId="478"/>
          <ac:picMkLst>
            <pc:docMk/>
            <pc:sldMk cId="465941897" sldId="334"/>
            <ac:picMk id="3" creationId="{D5D6B1A5-3BF2-B6C4-9443-40E42A37655B}"/>
          </ac:picMkLst>
        </pc:picChg>
        <pc:picChg chg="add mod modCrop">
          <ac:chgData name="Kumar, Vinod" userId="a0710a6e-bffc-4971-8893-1c23addeb5b0" providerId="ADAL" clId="{804748DF-446B-437F-AFFB-E1B8A8B41FF1}" dt="2023-01-31T20:22:45.880" v="6081" actId="164"/>
          <ac:picMkLst>
            <pc:docMk/>
            <pc:sldMk cId="465941897" sldId="334"/>
            <ac:picMk id="4" creationId="{E8637B61-5038-8FBF-B1B2-6D7EA4B935B0}"/>
          </ac:picMkLst>
        </pc:picChg>
        <pc:picChg chg="add del mod">
          <ac:chgData name="Kumar, Vinod" userId="a0710a6e-bffc-4971-8893-1c23addeb5b0" providerId="ADAL" clId="{804748DF-446B-437F-AFFB-E1B8A8B41FF1}" dt="2023-01-30T22:00:04.092" v="5082"/>
          <ac:picMkLst>
            <pc:docMk/>
            <pc:sldMk cId="465941897" sldId="334"/>
            <ac:picMk id="5" creationId="{A1ABE10A-1FC7-286C-6E5B-2120F313E421}"/>
          </ac:picMkLst>
        </pc:picChg>
        <pc:picChg chg="add mod modCrop">
          <ac:chgData name="Kumar, Vinod" userId="a0710a6e-bffc-4971-8893-1c23addeb5b0" providerId="ADAL" clId="{804748DF-446B-437F-AFFB-E1B8A8B41FF1}" dt="2023-01-31T20:22:45.880" v="6081" actId="164"/>
          <ac:picMkLst>
            <pc:docMk/>
            <pc:sldMk cId="465941897" sldId="334"/>
            <ac:picMk id="6" creationId="{CE51CA57-786B-4A5B-C8F2-99E37D08B8D1}"/>
          </ac:picMkLst>
        </pc:picChg>
        <pc:picChg chg="add mod modCrop">
          <ac:chgData name="Kumar, Vinod" userId="a0710a6e-bffc-4971-8893-1c23addeb5b0" providerId="ADAL" clId="{804748DF-446B-437F-AFFB-E1B8A8B41FF1}" dt="2023-01-31T20:22:45.880" v="6081" actId="164"/>
          <ac:picMkLst>
            <pc:docMk/>
            <pc:sldMk cId="465941897" sldId="334"/>
            <ac:picMk id="8" creationId="{91CFED04-C380-B4C2-A615-3C40EF676AE4}"/>
          </ac:picMkLst>
        </pc:picChg>
        <pc:picChg chg="add del mod">
          <ac:chgData name="Kumar, Vinod" userId="a0710a6e-bffc-4971-8893-1c23addeb5b0" providerId="ADAL" clId="{804748DF-446B-437F-AFFB-E1B8A8B41FF1}" dt="2023-01-30T22:09:48.303" v="5457" actId="478"/>
          <ac:picMkLst>
            <pc:docMk/>
            <pc:sldMk cId="465941897" sldId="334"/>
            <ac:picMk id="9" creationId="{625EFCDB-BE0B-9A7D-9FA3-F78BA140FD28}"/>
          </ac:picMkLst>
        </pc:picChg>
        <pc:picChg chg="add del mod">
          <ac:chgData name="Kumar, Vinod" userId="a0710a6e-bffc-4971-8893-1c23addeb5b0" providerId="ADAL" clId="{804748DF-446B-437F-AFFB-E1B8A8B41FF1}" dt="2023-01-30T22:09:48.303" v="5457" actId="478"/>
          <ac:picMkLst>
            <pc:docMk/>
            <pc:sldMk cId="465941897" sldId="334"/>
            <ac:picMk id="10" creationId="{F1BD50D0-0FE4-8B1B-99A1-5CC1A2A1A406}"/>
          </ac:picMkLst>
        </pc:picChg>
        <pc:picChg chg="add del mod">
          <ac:chgData name="Kumar, Vinod" userId="a0710a6e-bffc-4971-8893-1c23addeb5b0" providerId="ADAL" clId="{804748DF-446B-437F-AFFB-E1B8A8B41FF1}" dt="2023-01-30T22:09:48.303" v="5457" actId="478"/>
          <ac:picMkLst>
            <pc:docMk/>
            <pc:sldMk cId="465941897" sldId="334"/>
            <ac:picMk id="11" creationId="{D707D868-B1E7-A4FF-4103-0F25C2E5C2C1}"/>
          </ac:picMkLst>
        </pc:picChg>
        <pc:picChg chg="add del mod">
          <ac:chgData name="Kumar, Vinod" userId="a0710a6e-bffc-4971-8893-1c23addeb5b0" providerId="ADAL" clId="{804748DF-446B-437F-AFFB-E1B8A8B41FF1}" dt="2023-01-30T22:09:48.303" v="5457" actId="478"/>
          <ac:picMkLst>
            <pc:docMk/>
            <pc:sldMk cId="465941897" sldId="334"/>
            <ac:picMk id="12" creationId="{2CDFDB5E-384D-1EF4-7994-47C62F7EF2D2}"/>
          </ac:picMkLst>
        </pc:picChg>
        <pc:cxnChg chg="add del mod">
          <ac:chgData name="Kumar, Vinod" userId="a0710a6e-bffc-4971-8893-1c23addeb5b0" providerId="ADAL" clId="{804748DF-446B-437F-AFFB-E1B8A8B41FF1}" dt="2023-01-30T22:09:48.303" v="5457" actId="478"/>
          <ac:cxnSpMkLst>
            <pc:docMk/>
            <pc:sldMk cId="465941897" sldId="334"/>
            <ac:cxnSpMk id="16" creationId="{F84A9434-563C-68DC-0E6A-E478C3BE41C3}"/>
          </ac:cxnSpMkLst>
        </pc:cxnChg>
        <pc:cxnChg chg="add del mod">
          <ac:chgData name="Kumar, Vinod" userId="a0710a6e-bffc-4971-8893-1c23addeb5b0" providerId="ADAL" clId="{804748DF-446B-437F-AFFB-E1B8A8B41FF1}" dt="2023-01-30T22:09:48.303" v="5457" actId="478"/>
          <ac:cxnSpMkLst>
            <pc:docMk/>
            <pc:sldMk cId="465941897" sldId="334"/>
            <ac:cxnSpMk id="17" creationId="{9D98D62A-0B28-A3D3-1339-8861F0ED8D31}"/>
          </ac:cxnSpMkLst>
        </pc:cxnChg>
        <pc:cxnChg chg="add del mod">
          <ac:chgData name="Kumar, Vinod" userId="a0710a6e-bffc-4971-8893-1c23addeb5b0" providerId="ADAL" clId="{804748DF-446B-437F-AFFB-E1B8A8B41FF1}" dt="2023-01-30T22:09:48.303" v="5457" actId="478"/>
          <ac:cxnSpMkLst>
            <pc:docMk/>
            <pc:sldMk cId="465941897" sldId="334"/>
            <ac:cxnSpMk id="18" creationId="{691C23AE-6E81-E384-EB9E-FCD37624D09B}"/>
          </ac:cxnSpMkLst>
        </pc:cxnChg>
      </pc:sldChg>
      <pc:sldChg chg="addSp delSp modSp add mod">
        <pc:chgData name="Kumar, Vinod" userId="a0710a6e-bffc-4971-8893-1c23addeb5b0" providerId="ADAL" clId="{804748DF-446B-437F-AFFB-E1B8A8B41FF1}" dt="2023-02-06T16:52:33.638" v="8290" actId="1076"/>
        <pc:sldMkLst>
          <pc:docMk/>
          <pc:sldMk cId="3426644829" sldId="335"/>
        </pc:sldMkLst>
        <pc:spChg chg="mod">
          <ac:chgData name="Kumar, Vinod" userId="a0710a6e-bffc-4971-8893-1c23addeb5b0" providerId="ADAL" clId="{804748DF-446B-437F-AFFB-E1B8A8B41FF1}" dt="2023-01-31T20:18:33.325" v="5988" actId="20577"/>
          <ac:spMkLst>
            <pc:docMk/>
            <pc:sldMk cId="3426644829" sldId="335"/>
            <ac:spMk id="4" creationId="{A268E69E-1A64-C70D-117D-C52D8B847D56}"/>
          </ac:spMkLst>
        </pc:spChg>
        <pc:spChg chg="mod">
          <ac:chgData name="Kumar, Vinod" userId="a0710a6e-bffc-4971-8893-1c23addeb5b0" providerId="ADAL" clId="{804748DF-446B-437F-AFFB-E1B8A8B41FF1}" dt="2023-01-31T19:44:01.756" v="5469" actId="1038"/>
          <ac:spMkLst>
            <pc:docMk/>
            <pc:sldMk cId="3426644829" sldId="335"/>
            <ac:spMk id="5" creationId="{F3FCF723-FC69-FB60-A6AB-D6E09DCA0168}"/>
          </ac:spMkLst>
        </pc:spChg>
        <pc:spChg chg="mod topLvl">
          <ac:chgData name="Kumar, Vinod" userId="a0710a6e-bffc-4971-8893-1c23addeb5b0" providerId="ADAL" clId="{804748DF-446B-437F-AFFB-E1B8A8B41FF1}" dt="2023-01-31T19:48:06.657" v="5550" actId="164"/>
          <ac:spMkLst>
            <pc:docMk/>
            <pc:sldMk cId="3426644829" sldId="335"/>
            <ac:spMk id="7" creationId="{F1032A67-9D92-05B0-DE69-4A94EABD19A9}"/>
          </ac:spMkLst>
        </pc:spChg>
        <pc:spChg chg="mod topLvl">
          <ac:chgData name="Kumar, Vinod" userId="a0710a6e-bffc-4971-8893-1c23addeb5b0" providerId="ADAL" clId="{804748DF-446B-437F-AFFB-E1B8A8B41FF1}" dt="2023-01-31T19:48:06.657" v="5550" actId="164"/>
          <ac:spMkLst>
            <pc:docMk/>
            <pc:sldMk cId="3426644829" sldId="335"/>
            <ac:spMk id="8" creationId="{47E820FA-25F5-AEA1-E191-950C71C0FCF3}"/>
          </ac:spMkLst>
        </pc:spChg>
        <pc:spChg chg="mod topLvl">
          <ac:chgData name="Kumar, Vinod" userId="a0710a6e-bffc-4971-8893-1c23addeb5b0" providerId="ADAL" clId="{804748DF-446B-437F-AFFB-E1B8A8B41FF1}" dt="2023-01-31T19:47:53.837" v="5548" actId="164"/>
          <ac:spMkLst>
            <pc:docMk/>
            <pc:sldMk cId="3426644829" sldId="335"/>
            <ac:spMk id="12" creationId="{049CE177-B2AB-E2AB-1489-4F8BA53FFE42}"/>
          </ac:spMkLst>
        </pc:spChg>
        <pc:spChg chg="mod topLvl">
          <ac:chgData name="Kumar, Vinod" userId="a0710a6e-bffc-4971-8893-1c23addeb5b0" providerId="ADAL" clId="{804748DF-446B-437F-AFFB-E1B8A8B41FF1}" dt="2023-01-31T19:47:53.837" v="5548" actId="164"/>
          <ac:spMkLst>
            <pc:docMk/>
            <pc:sldMk cId="3426644829" sldId="335"/>
            <ac:spMk id="13" creationId="{ED0439CE-0E9F-8F77-637D-D5B3F0935A7D}"/>
          </ac:spMkLst>
        </pc:spChg>
        <pc:spChg chg="mod topLvl">
          <ac:chgData name="Kumar, Vinod" userId="a0710a6e-bffc-4971-8893-1c23addeb5b0" providerId="ADAL" clId="{804748DF-446B-437F-AFFB-E1B8A8B41FF1}" dt="2023-01-31T19:47:53.837" v="5548" actId="164"/>
          <ac:spMkLst>
            <pc:docMk/>
            <pc:sldMk cId="3426644829" sldId="335"/>
            <ac:spMk id="14" creationId="{C4DA97E1-1F8A-604C-58C4-C4FE123B8D38}"/>
          </ac:spMkLst>
        </pc:spChg>
        <pc:spChg chg="mod topLvl">
          <ac:chgData name="Kumar, Vinod" userId="a0710a6e-bffc-4971-8893-1c23addeb5b0" providerId="ADAL" clId="{804748DF-446B-437F-AFFB-E1B8A8B41FF1}" dt="2023-02-06T15:00:56.855" v="7010" actId="1037"/>
          <ac:spMkLst>
            <pc:docMk/>
            <pc:sldMk cId="3426644829" sldId="335"/>
            <ac:spMk id="16" creationId="{BBC7DEC2-F316-00B8-C960-575417169EE0}"/>
          </ac:spMkLst>
        </pc:spChg>
        <pc:spChg chg="mod">
          <ac:chgData name="Kumar, Vinod" userId="a0710a6e-bffc-4971-8893-1c23addeb5b0" providerId="ADAL" clId="{804748DF-446B-437F-AFFB-E1B8A8B41FF1}" dt="2023-01-31T19:57:10.904" v="5554" actId="113"/>
          <ac:spMkLst>
            <pc:docMk/>
            <pc:sldMk cId="3426644829" sldId="335"/>
            <ac:spMk id="19" creationId="{CF6CE95C-34FA-83E2-16D3-C61F92BC0CC4}"/>
          </ac:spMkLst>
        </pc:spChg>
        <pc:spChg chg="mod">
          <ac:chgData name="Kumar, Vinod" userId="a0710a6e-bffc-4971-8893-1c23addeb5b0" providerId="ADAL" clId="{804748DF-446B-437F-AFFB-E1B8A8B41FF1}" dt="2023-01-31T19:58:53.350" v="5582" actId="165"/>
          <ac:spMkLst>
            <pc:docMk/>
            <pc:sldMk cId="3426644829" sldId="335"/>
            <ac:spMk id="21" creationId="{098D7C44-CDCD-7387-44C3-005D94FDE88A}"/>
          </ac:spMkLst>
        </pc:spChg>
        <pc:spChg chg="mod">
          <ac:chgData name="Kumar, Vinod" userId="a0710a6e-bffc-4971-8893-1c23addeb5b0" providerId="ADAL" clId="{804748DF-446B-437F-AFFB-E1B8A8B41FF1}" dt="2023-01-31T19:58:53.350" v="5582" actId="165"/>
          <ac:spMkLst>
            <pc:docMk/>
            <pc:sldMk cId="3426644829" sldId="335"/>
            <ac:spMk id="22" creationId="{C4EACF49-813D-FD52-DD24-58A1CCC0A223}"/>
          </ac:spMkLst>
        </pc:spChg>
        <pc:spChg chg="mod">
          <ac:chgData name="Kumar, Vinod" userId="a0710a6e-bffc-4971-8893-1c23addeb5b0" providerId="ADAL" clId="{804748DF-446B-437F-AFFB-E1B8A8B41FF1}" dt="2023-01-31T19:58:53.350" v="5582" actId="165"/>
          <ac:spMkLst>
            <pc:docMk/>
            <pc:sldMk cId="3426644829" sldId="335"/>
            <ac:spMk id="23" creationId="{5E13CA08-8A68-5A7D-20D1-A46E9B82C382}"/>
          </ac:spMkLst>
        </pc:spChg>
        <pc:spChg chg="mod">
          <ac:chgData name="Kumar, Vinod" userId="a0710a6e-bffc-4971-8893-1c23addeb5b0" providerId="ADAL" clId="{804748DF-446B-437F-AFFB-E1B8A8B41FF1}" dt="2023-01-31T19:58:53.350" v="5582" actId="165"/>
          <ac:spMkLst>
            <pc:docMk/>
            <pc:sldMk cId="3426644829" sldId="335"/>
            <ac:spMk id="24" creationId="{C95EBCEB-94C0-B4DD-B0B8-5B913452F555}"/>
          </ac:spMkLst>
        </pc:spChg>
        <pc:spChg chg="mod">
          <ac:chgData name="Kumar, Vinod" userId="a0710a6e-bffc-4971-8893-1c23addeb5b0" providerId="ADAL" clId="{804748DF-446B-437F-AFFB-E1B8A8B41FF1}" dt="2023-01-31T19:58:53.350" v="5582" actId="165"/>
          <ac:spMkLst>
            <pc:docMk/>
            <pc:sldMk cId="3426644829" sldId="335"/>
            <ac:spMk id="25" creationId="{83CE1257-A944-5C41-6042-CDF0D89B74A6}"/>
          </ac:spMkLst>
        </pc:spChg>
        <pc:spChg chg="mod">
          <ac:chgData name="Kumar, Vinod" userId="a0710a6e-bffc-4971-8893-1c23addeb5b0" providerId="ADAL" clId="{804748DF-446B-437F-AFFB-E1B8A8B41FF1}" dt="2023-01-31T19:58:53.350" v="5582" actId="165"/>
          <ac:spMkLst>
            <pc:docMk/>
            <pc:sldMk cId="3426644829" sldId="335"/>
            <ac:spMk id="26" creationId="{FB23C346-0585-CC57-8C0C-6765E2F78DAF}"/>
          </ac:spMkLst>
        </pc:spChg>
        <pc:spChg chg="mod">
          <ac:chgData name="Kumar, Vinod" userId="a0710a6e-bffc-4971-8893-1c23addeb5b0" providerId="ADAL" clId="{804748DF-446B-437F-AFFB-E1B8A8B41FF1}" dt="2023-01-31T19:58:53.350" v="5582" actId="165"/>
          <ac:spMkLst>
            <pc:docMk/>
            <pc:sldMk cId="3426644829" sldId="335"/>
            <ac:spMk id="27" creationId="{D634DB99-CE30-6D5A-67BE-2B19C9961E06}"/>
          </ac:spMkLst>
        </pc:spChg>
        <pc:spChg chg="mod">
          <ac:chgData name="Kumar, Vinod" userId="a0710a6e-bffc-4971-8893-1c23addeb5b0" providerId="ADAL" clId="{804748DF-446B-437F-AFFB-E1B8A8B41FF1}" dt="2023-01-31T19:58:53.350" v="5582" actId="165"/>
          <ac:spMkLst>
            <pc:docMk/>
            <pc:sldMk cId="3426644829" sldId="335"/>
            <ac:spMk id="28" creationId="{F65F0C35-C6D4-AAD7-E670-43F4CAC3EFD3}"/>
          </ac:spMkLst>
        </pc:spChg>
        <pc:spChg chg="mod">
          <ac:chgData name="Kumar, Vinod" userId="a0710a6e-bffc-4971-8893-1c23addeb5b0" providerId="ADAL" clId="{804748DF-446B-437F-AFFB-E1B8A8B41FF1}" dt="2023-01-31T19:58:53.350" v="5582" actId="165"/>
          <ac:spMkLst>
            <pc:docMk/>
            <pc:sldMk cId="3426644829" sldId="335"/>
            <ac:spMk id="29" creationId="{42B8BF23-F9F6-47BD-5CC4-EB449AA057EC}"/>
          </ac:spMkLst>
        </pc:spChg>
        <pc:spChg chg="mod">
          <ac:chgData name="Kumar, Vinod" userId="a0710a6e-bffc-4971-8893-1c23addeb5b0" providerId="ADAL" clId="{804748DF-446B-437F-AFFB-E1B8A8B41FF1}" dt="2023-01-31T19:58:53.350" v="5582" actId="165"/>
          <ac:spMkLst>
            <pc:docMk/>
            <pc:sldMk cId="3426644829" sldId="335"/>
            <ac:spMk id="30" creationId="{0E40422E-8AE0-51C1-6633-CE16CDDBBDC6}"/>
          </ac:spMkLst>
        </pc:spChg>
        <pc:spChg chg="mod">
          <ac:chgData name="Kumar, Vinod" userId="a0710a6e-bffc-4971-8893-1c23addeb5b0" providerId="ADAL" clId="{804748DF-446B-437F-AFFB-E1B8A8B41FF1}" dt="2023-01-31T19:58:53.350" v="5582" actId="165"/>
          <ac:spMkLst>
            <pc:docMk/>
            <pc:sldMk cId="3426644829" sldId="335"/>
            <ac:spMk id="31" creationId="{01C2F4E9-CF0C-1697-3E7D-6E09BED6006D}"/>
          </ac:spMkLst>
        </pc:spChg>
        <pc:spChg chg="mod">
          <ac:chgData name="Kumar, Vinod" userId="a0710a6e-bffc-4971-8893-1c23addeb5b0" providerId="ADAL" clId="{804748DF-446B-437F-AFFB-E1B8A8B41FF1}" dt="2023-01-31T19:58:53.350" v="5582" actId="165"/>
          <ac:spMkLst>
            <pc:docMk/>
            <pc:sldMk cId="3426644829" sldId="335"/>
            <ac:spMk id="32" creationId="{4B54872C-480B-0F83-B5E3-9037D660CA47}"/>
          </ac:spMkLst>
        </pc:spChg>
        <pc:spChg chg="mod">
          <ac:chgData name="Kumar, Vinod" userId="a0710a6e-bffc-4971-8893-1c23addeb5b0" providerId="ADAL" clId="{804748DF-446B-437F-AFFB-E1B8A8B41FF1}" dt="2023-02-06T16:00:24.977" v="7167" actId="1076"/>
          <ac:spMkLst>
            <pc:docMk/>
            <pc:sldMk cId="3426644829" sldId="335"/>
            <ac:spMk id="37" creationId="{B0DBD44B-947F-954F-1259-F8BD59E3BA39}"/>
          </ac:spMkLst>
        </pc:spChg>
        <pc:spChg chg="mod">
          <ac:chgData name="Kumar, Vinod" userId="a0710a6e-bffc-4971-8893-1c23addeb5b0" providerId="ADAL" clId="{804748DF-446B-437F-AFFB-E1B8A8B41FF1}" dt="2023-01-31T20:00:33.435" v="5642" actId="2"/>
          <ac:spMkLst>
            <pc:docMk/>
            <pc:sldMk cId="3426644829" sldId="335"/>
            <ac:spMk id="38" creationId="{CCAFC8D1-778A-888F-ED58-C2B4D512D6FF}"/>
          </ac:spMkLst>
        </pc:spChg>
        <pc:spChg chg="mod">
          <ac:chgData name="Kumar, Vinod" userId="a0710a6e-bffc-4971-8893-1c23addeb5b0" providerId="ADAL" clId="{804748DF-446B-437F-AFFB-E1B8A8B41FF1}" dt="2023-01-31T19:57:10.904" v="5554" actId="113"/>
          <ac:spMkLst>
            <pc:docMk/>
            <pc:sldMk cId="3426644829" sldId="335"/>
            <ac:spMk id="40" creationId="{F496ECE6-4F9B-91C7-E0C3-7CAF9E28C89A}"/>
          </ac:spMkLst>
        </pc:spChg>
        <pc:spChg chg="mod">
          <ac:chgData name="Kumar, Vinod" userId="a0710a6e-bffc-4971-8893-1c23addeb5b0" providerId="ADAL" clId="{804748DF-446B-437F-AFFB-E1B8A8B41FF1}" dt="2023-01-31T19:57:10.904" v="5554" actId="113"/>
          <ac:spMkLst>
            <pc:docMk/>
            <pc:sldMk cId="3426644829" sldId="335"/>
            <ac:spMk id="42" creationId="{306ACACF-63A7-B53D-AE5C-387EE9E1A01F}"/>
          </ac:spMkLst>
        </pc:spChg>
        <pc:spChg chg="mod">
          <ac:chgData name="Kumar, Vinod" userId="a0710a6e-bffc-4971-8893-1c23addeb5b0" providerId="ADAL" clId="{804748DF-446B-437F-AFFB-E1B8A8B41FF1}" dt="2023-02-06T16:00:30.664" v="7174" actId="1038"/>
          <ac:spMkLst>
            <pc:docMk/>
            <pc:sldMk cId="3426644829" sldId="335"/>
            <ac:spMk id="43" creationId="{7EFDEDFE-DB4B-089F-EFCE-126B6A2490A6}"/>
          </ac:spMkLst>
        </pc:spChg>
        <pc:spChg chg="mod">
          <ac:chgData name="Kumar, Vinod" userId="a0710a6e-bffc-4971-8893-1c23addeb5b0" providerId="ADAL" clId="{804748DF-446B-437F-AFFB-E1B8A8B41FF1}" dt="2023-02-06T15:58:45.801" v="7146" actId="1035"/>
          <ac:spMkLst>
            <pc:docMk/>
            <pc:sldMk cId="3426644829" sldId="335"/>
            <ac:spMk id="44" creationId="{73C48193-FB68-FD31-289A-A97FE893EAF0}"/>
          </ac:spMkLst>
        </pc:spChg>
        <pc:spChg chg="mod">
          <ac:chgData name="Kumar, Vinod" userId="a0710a6e-bffc-4971-8893-1c23addeb5b0" providerId="ADAL" clId="{804748DF-446B-437F-AFFB-E1B8A8B41FF1}" dt="2023-01-31T20:02:04.691" v="5663" actId="164"/>
          <ac:spMkLst>
            <pc:docMk/>
            <pc:sldMk cId="3426644829" sldId="335"/>
            <ac:spMk id="45" creationId="{0C0EE3A7-F02D-8D0D-1922-2892F0087EAD}"/>
          </ac:spMkLst>
        </pc:spChg>
        <pc:spChg chg="add mod">
          <ac:chgData name="Kumar, Vinod" userId="a0710a6e-bffc-4971-8893-1c23addeb5b0" providerId="ADAL" clId="{804748DF-446B-437F-AFFB-E1B8A8B41FF1}" dt="2023-01-31T20:02:04.691" v="5663" actId="164"/>
          <ac:spMkLst>
            <pc:docMk/>
            <pc:sldMk cId="3426644829" sldId="335"/>
            <ac:spMk id="48" creationId="{B6E6100D-2210-7D83-9AA9-E53CD81DC278}"/>
          </ac:spMkLst>
        </pc:spChg>
        <pc:spChg chg="add mod">
          <ac:chgData name="Kumar, Vinod" userId="a0710a6e-bffc-4971-8893-1c23addeb5b0" providerId="ADAL" clId="{804748DF-446B-437F-AFFB-E1B8A8B41FF1}" dt="2023-01-31T20:02:04.691" v="5663" actId="164"/>
          <ac:spMkLst>
            <pc:docMk/>
            <pc:sldMk cId="3426644829" sldId="335"/>
            <ac:spMk id="49" creationId="{33E7F6D3-6E7D-A2F0-835E-538CD77C302C}"/>
          </ac:spMkLst>
        </pc:spChg>
        <pc:spChg chg="add mod">
          <ac:chgData name="Kumar, Vinod" userId="a0710a6e-bffc-4971-8893-1c23addeb5b0" providerId="ADAL" clId="{804748DF-446B-437F-AFFB-E1B8A8B41FF1}" dt="2023-02-06T15:01:17.526" v="7022" actId="1037"/>
          <ac:spMkLst>
            <pc:docMk/>
            <pc:sldMk cId="3426644829" sldId="335"/>
            <ac:spMk id="51" creationId="{5C0FF62F-E495-CC6A-23B0-513F61DC8CA7}"/>
          </ac:spMkLst>
        </pc:spChg>
        <pc:spChg chg="add mod">
          <ac:chgData name="Kumar, Vinod" userId="a0710a6e-bffc-4971-8893-1c23addeb5b0" providerId="ADAL" clId="{804748DF-446B-437F-AFFB-E1B8A8B41FF1}" dt="2023-02-06T15:02:43.542" v="7047" actId="1035"/>
          <ac:spMkLst>
            <pc:docMk/>
            <pc:sldMk cId="3426644829" sldId="335"/>
            <ac:spMk id="52" creationId="{F45FA887-8466-2277-16B1-BED6D210A592}"/>
          </ac:spMkLst>
        </pc:spChg>
        <pc:spChg chg="add mod">
          <ac:chgData name="Kumar, Vinod" userId="a0710a6e-bffc-4971-8893-1c23addeb5b0" providerId="ADAL" clId="{804748DF-446B-437F-AFFB-E1B8A8B41FF1}" dt="2023-02-06T15:01:17.526" v="7022" actId="1037"/>
          <ac:spMkLst>
            <pc:docMk/>
            <pc:sldMk cId="3426644829" sldId="335"/>
            <ac:spMk id="53" creationId="{5C678BA4-1D51-D9E8-7580-EC00391FF50C}"/>
          </ac:spMkLst>
        </pc:spChg>
        <pc:spChg chg="add mod">
          <ac:chgData name="Kumar, Vinod" userId="a0710a6e-bffc-4971-8893-1c23addeb5b0" providerId="ADAL" clId="{804748DF-446B-437F-AFFB-E1B8A8B41FF1}" dt="2023-02-06T15:01:17.526" v="7022" actId="1037"/>
          <ac:spMkLst>
            <pc:docMk/>
            <pc:sldMk cId="3426644829" sldId="335"/>
            <ac:spMk id="54" creationId="{C3BD8E0D-6208-14D3-02F0-3E1B14A09EF3}"/>
          </ac:spMkLst>
        </pc:spChg>
        <pc:spChg chg="add mod">
          <ac:chgData name="Kumar, Vinod" userId="a0710a6e-bffc-4971-8893-1c23addeb5b0" providerId="ADAL" clId="{804748DF-446B-437F-AFFB-E1B8A8B41FF1}" dt="2023-02-06T15:02:43.542" v="7047" actId="1035"/>
          <ac:spMkLst>
            <pc:docMk/>
            <pc:sldMk cId="3426644829" sldId="335"/>
            <ac:spMk id="55" creationId="{C0772C3F-66C5-9F93-0F9C-F3A12144163B}"/>
          </ac:spMkLst>
        </pc:spChg>
        <pc:spChg chg="add mod">
          <ac:chgData name="Kumar, Vinod" userId="a0710a6e-bffc-4971-8893-1c23addeb5b0" providerId="ADAL" clId="{804748DF-446B-437F-AFFB-E1B8A8B41FF1}" dt="2023-02-06T15:01:17.526" v="7022" actId="1037"/>
          <ac:spMkLst>
            <pc:docMk/>
            <pc:sldMk cId="3426644829" sldId="335"/>
            <ac:spMk id="56" creationId="{A85E0CCC-BDF8-B837-FEB9-7DD31B1668CF}"/>
          </ac:spMkLst>
        </pc:spChg>
        <pc:spChg chg="add mod">
          <ac:chgData name="Kumar, Vinod" userId="a0710a6e-bffc-4971-8893-1c23addeb5b0" providerId="ADAL" clId="{804748DF-446B-437F-AFFB-E1B8A8B41FF1}" dt="2023-02-06T15:01:17.526" v="7022" actId="1037"/>
          <ac:spMkLst>
            <pc:docMk/>
            <pc:sldMk cId="3426644829" sldId="335"/>
            <ac:spMk id="57" creationId="{B4F2DE5E-1B07-5082-7E18-7CB952BEB57B}"/>
          </ac:spMkLst>
        </pc:spChg>
        <pc:spChg chg="add mod">
          <ac:chgData name="Kumar, Vinod" userId="a0710a6e-bffc-4971-8893-1c23addeb5b0" providerId="ADAL" clId="{804748DF-446B-437F-AFFB-E1B8A8B41FF1}" dt="2023-02-06T16:06:31.087" v="7447" actId="164"/>
          <ac:spMkLst>
            <pc:docMk/>
            <pc:sldMk cId="3426644829" sldId="335"/>
            <ac:spMk id="62" creationId="{6AD61A2A-E0B1-D9C1-67F5-B285EBDDC7EA}"/>
          </ac:spMkLst>
        </pc:spChg>
        <pc:spChg chg="add mod">
          <ac:chgData name="Kumar, Vinod" userId="a0710a6e-bffc-4971-8893-1c23addeb5b0" providerId="ADAL" clId="{804748DF-446B-437F-AFFB-E1B8A8B41FF1}" dt="2023-02-06T16:06:31.087" v="7447" actId="164"/>
          <ac:spMkLst>
            <pc:docMk/>
            <pc:sldMk cId="3426644829" sldId="335"/>
            <ac:spMk id="63" creationId="{46648BD4-E193-2B0B-2881-4732748103F7}"/>
          </ac:spMkLst>
        </pc:spChg>
        <pc:spChg chg="add mod">
          <ac:chgData name="Kumar, Vinod" userId="a0710a6e-bffc-4971-8893-1c23addeb5b0" providerId="ADAL" clId="{804748DF-446B-437F-AFFB-E1B8A8B41FF1}" dt="2023-02-06T16:06:31.087" v="7447" actId="164"/>
          <ac:spMkLst>
            <pc:docMk/>
            <pc:sldMk cId="3426644829" sldId="335"/>
            <ac:spMk id="64" creationId="{2C613B18-513F-E0DC-2620-C67ABD9A4555}"/>
          </ac:spMkLst>
        </pc:spChg>
        <pc:spChg chg="add mod">
          <ac:chgData name="Kumar, Vinod" userId="a0710a6e-bffc-4971-8893-1c23addeb5b0" providerId="ADAL" clId="{804748DF-446B-437F-AFFB-E1B8A8B41FF1}" dt="2023-02-06T16:06:43.644" v="7448" actId="164"/>
          <ac:spMkLst>
            <pc:docMk/>
            <pc:sldMk cId="3426644829" sldId="335"/>
            <ac:spMk id="65" creationId="{E74DE3D1-FAE3-8A98-F29B-0D9592A6012E}"/>
          </ac:spMkLst>
        </pc:spChg>
        <pc:spChg chg="add mod">
          <ac:chgData name="Kumar, Vinod" userId="a0710a6e-bffc-4971-8893-1c23addeb5b0" providerId="ADAL" clId="{804748DF-446B-437F-AFFB-E1B8A8B41FF1}" dt="2023-02-06T16:06:31.087" v="7447" actId="164"/>
          <ac:spMkLst>
            <pc:docMk/>
            <pc:sldMk cId="3426644829" sldId="335"/>
            <ac:spMk id="66" creationId="{B497DDD8-37EC-059D-C782-59B5B7425361}"/>
          </ac:spMkLst>
        </pc:spChg>
        <pc:spChg chg="add mod">
          <ac:chgData name="Kumar, Vinod" userId="a0710a6e-bffc-4971-8893-1c23addeb5b0" providerId="ADAL" clId="{804748DF-446B-437F-AFFB-E1B8A8B41FF1}" dt="2023-02-06T16:06:31.087" v="7447" actId="164"/>
          <ac:spMkLst>
            <pc:docMk/>
            <pc:sldMk cId="3426644829" sldId="335"/>
            <ac:spMk id="67" creationId="{6FA4D8A1-598D-921F-B36B-8031FA4579B8}"/>
          </ac:spMkLst>
        </pc:spChg>
        <pc:spChg chg="add mod">
          <ac:chgData name="Kumar, Vinod" userId="a0710a6e-bffc-4971-8893-1c23addeb5b0" providerId="ADAL" clId="{804748DF-446B-437F-AFFB-E1B8A8B41FF1}" dt="2023-02-06T16:06:31.087" v="7447" actId="164"/>
          <ac:spMkLst>
            <pc:docMk/>
            <pc:sldMk cId="3426644829" sldId="335"/>
            <ac:spMk id="68" creationId="{DEA2D342-A7E0-D5FC-531F-6C66E497E2EF}"/>
          </ac:spMkLst>
        </pc:spChg>
        <pc:spChg chg="add mod">
          <ac:chgData name="Kumar, Vinod" userId="a0710a6e-bffc-4971-8893-1c23addeb5b0" providerId="ADAL" clId="{804748DF-446B-437F-AFFB-E1B8A8B41FF1}" dt="2023-02-06T16:50:30.822" v="8047" actId="164"/>
          <ac:spMkLst>
            <pc:docMk/>
            <pc:sldMk cId="3426644829" sldId="335"/>
            <ac:spMk id="75" creationId="{C3D7C3F6-6527-D3CE-0951-FD582D32DF7C}"/>
          </ac:spMkLst>
        </pc:spChg>
        <pc:spChg chg="add mod">
          <ac:chgData name="Kumar, Vinod" userId="a0710a6e-bffc-4971-8893-1c23addeb5b0" providerId="ADAL" clId="{804748DF-446B-437F-AFFB-E1B8A8B41FF1}" dt="2023-02-06T16:50:30.822" v="8047" actId="164"/>
          <ac:spMkLst>
            <pc:docMk/>
            <pc:sldMk cId="3426644829" sldId="335"/>
            <ac:spMk id="76" creationId="{14BF7B91-62FE-14F1-5416-9FD028D05B70}"/>
          </ac:spMkLst>
        </pc:spChg>
        <pc:spChg chg="add mod">
          <ac:chgData name="Kumar, Vinod" userId="a0710a6e-bffc-4971-8893-1c23addeb5b0" providerId="ADAL" clId="{804748DF-446B-437F-AFFB-E1B8A8B41FF1}" dt="2023-02-06T16:50:30.822" v="8047" actId="164"/>
          <ac:spMkLst>
            <pc:docMk/>
            <pc:sldMk cId="3426644829" sldId="335"/>
            <ac:spMk id="77" creationId="{2022AC3B-9C11-7B0D-F5DB-5B47DC192215}"/>
          </ac:spMkLst>
        </pc:spChg>
        <pc:spChg chg="add del mod">
          <ac:chgData name="Kumar, Vinod" userId="a0710a6e-bffc-4971-8893-1c23addeb5b0" providerId="ADAL" clId="{804748DF-446B-437F-AFFB-E1B8A8B41FF1}" dt="2023-02-06T16:49:45.280" v="7984" actId="478"/>
          <ac:spMkLst>
            <pc:docMk/>
            <pc:sldMk cId="3426644829" sldId="335"/>
            <ac:spMk id="78" creationId="{118492EB-5E00-D5CF-419C-714C6AB7ACF7}"/>
          </ac:spMkLst>
        </pc:spChg>
        <pc:spChg chg="add mod">
          <ac:chgData name="Kumar, Vinod" userId="a0710a6e-bffc-4971-8893-1c23addeb5b0" providerId="ADAL" clId="{804748DF-446B-437F-AFFB-E1B8A8B41FF1}" dt="2023-02-06T16:50:30.822" v="8047" actId="164"/>
          <ac:spMkLst>
            <pc:docMk/>
            <pc:sldMk cId="3426644829" sldId="335"/>
            <ac:spMk id="79" creationId="{AEEBE5C5-1DAB-C9D2-0E93-E1AFF7032731}"/>
          </ac:spMkLst>
        </pc:spChg>
        <pc:spChg chg="add mod">
          <ac:chgData name="Kumar, Vinod" userId="a0710a6e-bffc-4971-8893-1c23addeb5b0" providerId="ADAL" clId="{804748DF-446B-437F-AFFB-E1B8A8B41FF1}" dt="2023-02-06T16:52:09.183" v="8289" actId="164"/>
          <ac:spMkLst>
            <pc:docMk/>
            <pc:sldMk cId="3426644829" sldId="335"/>
            <ac:spMk id="81" creationId="{EE12F3BB-E856-2838-BC6B-3C919A519FFA}"/>
          </ac:spMkLst>
        </pc:spChg>
        <pc:spChg chg="add mod">
          <ac:chgData name="Kumar, Vinod" userId="a0710a6e-bffc-4971-8893-1c23addeb5b0" providerId="ADAL" clId="{804748DF-446B-437F-AFFB-E1B8A8B41FF1}" dt="2023-02-06T16:52:09.183" v="8289" actId="164"/>
          <ac:spMkLst>
            <pc:docMk/>
            <pc:sldMk cId="3426644829" sldId="335"/>
            <ac:spMk id="82" creationId="{53F1E74E-7472-7AD1-9888-0640130C6947}"/>
          </ac:spMkLst>
        </pc:spChg>
        <pc:spChg chg="add mod">
          <ac:chgData name="Kumar, Vinod" userId="a0710a6e-bffc-4971-8893-1c23addeb5b0" providerId="ADAL" clId="{804748DF-446B-437F-AFFB-E1B8A8B41FF1}" dt="2023-02-06T16:52:09.183" v="8289" actId="164"/>
          <ac:spMkLst>
            <pc:docMk/>
            <pc:sldMk cId="3426644829" sldId="335"/>
            <ac:spMk id="83" creationId="{989F94FB-F79C-F2A3-8C78-43729F28A566}"/>
          </ac:spMkLst>
        </pc:spChg>
        <pc:spChg chg="add mod">
          <ac:chgData name="Kumar, Vinod" userId="a0710a6e-bffc-4971-8893-1c23addeb5b0" providerId="ADAL" clId="{804748DF-446B-437F-AFFB-E1B8A8B41FF1}" dt="2023-02-06T16:52:09.183" v="8289" actId="164"/>
          <ac:spMkLst>
            <pc:docMk/>
            <pc:sldMk cId="3426644829" sldId="335"/>
            <ac:spMk id="84" creationId="{31CFD8A3-205E-0F9D-B42D-A981F65502C1}"/>
          </ac:spMkLst>
        </pc:spChg>
        <pc:spChg chg="add mod">
          <ac:chgData name="Kumar, Vinod" userId="a0710a6e-bffc-4971-8893-1c23addeb5b0" providerId="ADAL" clId="{804748DF-446B-437F-AFFB-E1B8A8B41FF1}" dt="2023-02-06T16:52:09.183" v="8289" actId="164"/>
          <ac:spMkLst>
            <pc:docMk/>
            <pc:sldMk cId="3426644829" sldId="335"/>
            <ac:spMk id="85" creationId="{6923B5B3-6F66-CF99-167B-1F5D7C3A60BB}"/>
          </ac:spMkLst>
        </pc:spChg>
        <pc:grpChg chg="del mod">
          <ac:chgData name="Kumar, Vinod" userId="a0710a6e-bffc-4971-8893-1c23addeb5b0" providerId="ADAL" clId="{804748DF-446B-437F-AFFB-E1B8A8B41FF1}" dt="2023-01-31T19:46:42.501" v="5521" actId="165"/>
          <ac:grpSpMkLst>
            <pc:docMk/>
            <pc:sldMk cId="3426644829" sldId="335"/>
            <ac:grpSpMk id="2" creationId="{21D2D1B7-B7FF-15BC-053E-428EF5120A2B}"/>
          </ac:grpSpMkLst>
        </pc:grpChg>
        <pc:grpChg chg="mod topLvl">
          <ac:chgData name="Kumar, Vinod" userId="a0710a6e-bffc-4971-8893-1c23addeb5b0" providerId="ADAL" clId="{804748DF-446B-437F-AFFB-E1B8A8B41FF1}" dt="2023-01-31T19:48:06.657" v="5550" actId="164"/>
          <ac:grpSpMkLst>
            <pc:docMk/>
            <pc:sldMk cId="3426644829" sldId="335"/>
            <ac:grpSpMk id="6" creationId="{4497055C-E984-9441-36D9-F5323534E923}"/>
          </ac:grpSpMkLst>
        </pc:grpChg>
        <pc:grpChg chg="del">
          <ac:chgData name="Kumar, Vinod" userId="a0710a6e-bffc-4971-8893-1c23addeb5b0" providerId="ADAL" clId="{804748DF-446B-437F-AFFB-E1B8A8B41FF1}" dt="2023-01-31T19:42:05.533" v="5461" actId="165"/>
          <ac:grpSpMkLst>
            <pc:docMk/>
            <pc:sldMk cId="3426644829" sldId="335"/>
            <ac:grpSpMk id="9" creationId="{FA363314-F128-2C39-213E-056991186DD2}"/>
          </ac:grpSpMkLst>
        </pc:grpChg>
        <pc:grpChg chg="mod">
          <ac:chgData name="Kumar, Vinod" userId="a0710a6e-bffc-4971-8893-1c23addeb5b0" providerId="ADAL" clId="{804748DF-446B-437F-AFFB-E1B8A8B41FF1}" dt="2023-01-31T20:02:04.691" v="5663" actId="164"/>
          <ac:grpSpMkLst>
            <pc:docMk/>
            <pc:sldMk cId="3426644829" sldId="335"/>
            <ac:grpSpMk id="10" creationId="{FA7660C6-4774-ED96-45BB-3FBBDB8A75F1}"/>
          </ac:grpSpMkLst>
        </pc:grpChg>
        <pc:grpChg chg="mod topLvl">
          <ac:chgData name="Kumar, Vinod" userId="a0710a6e-bffc-4971-8893-1c23addeb5b0" providerId="ADAL" clId="{804748DF-446B-437F-AFFB-E1B8A8B41FF1}" dt="2023-02-06T16:00:24.977" v="7167" actId="1076"/>
          <ac:grpSpMkLst>
            <pc:docMk/>
            <pc:sldMk cId="3426644829" sldId="335"/>
            <ac:grpSpMk id="33" creationId="{75601909-1754-F22C-3E43-876550643757}"/>
          </ac:grpSpMkLst>
        </pc:grpChg>
        <pc:grpChg chg="mod topLvl">
          <ac:chgData name="Kumar, Vinod" userId="a0710a6e-bffc-4971-8893-1c23addeb5b0" providerId="ADAL" clId="{804748DF-446B-437F-AFFB-E1B8A8B41FF1}" dt="2023-02-06T16:00:24.977" v="7167" actId="1076"/>
          <ac:grpSpMkLst>
            <pc:docMk/>
            <pc:sldMk cId="3426644829" sldId="335"/>
            <ac:grpSpMk id="34" creationId="{21E7EA6F-6BAE-5522-8B36-9DCE9C49171A}"/>
          </ac:grpSpMkLst>
        </pc:grpChg>
        <pc:grpChg chg="mod topLvl">
          <ac:chgData name="Kumar, Vinod" userId="a0710a6e-bffc-4971-8893-1c23addeb5b0" providerId="ADAL" clId="{804748DF-446B-437F-AFFB-E1B8A8B41FF1}" dt="2023-02-06T16:00:24.977" v="7167" actId="1076"/>
          <ac:grpSpMkLst>
            <pc:docMk/>
            <pc:sldMk cId="3426644829" sldId="335"/>
            <ac:grpSpMk id="35" creationId="{8915A6AA-698D-721D-49CC-122DFB94C3F5}"/>
          </ac:grpSpMkLst>
        </pc:grpChg>
        <pc:grpChg chg="del mod">
          <ac:chgData name="Kumar, Vinod" userId="a0710a6e-bffc-4971-8893-1c23addeb5b0" providerId="ADAL" clId="{804748DF-446B-437F-AFFB-E1B8A8B41FF1}" dt="2023-01-31T19:58:53.350" v="5582" actId="165"/>
          <ac:grpSpMkLst>
            <pc:docMk/>
            <pc:sldMk cId="3426644829" sldId="335"/>
            <ac:grpSpMk id="36" creationId="{DF1805E8-48D6-A673-3B49-229C0586D687}"/>
          </ac:grpSpMkLst>
        </pc:grpChg>
        <pc:grpChg chg="add mod">
          <ac:chgData name="Kumar, Vinod" userId="a0710a6e-bffc-4971-8893-1c23addeb5b0" providerId="ADAL" clId="{804748DF-446B-437F-AFFB-E1B8A8B41FF1}" dt="2023-02-06T15:01:09.606" v="7018" actId="1038"/>
          <ac:grpSpMkLst>
            <pc:docMk/>
            <pc:sldMk cId="3426644829" sldId="335"/>
            <ac:grpSpMk id="46" creationId="{B9D9D27D-56CD-C3FA-5481-285BC2845719}"/>
          </ac:grpSpMkLst>
        </pc:grpChg>
        <pc:grpChg chg="add mod">
          <ac:chgData name="Kumar, Vinod" userId="a0710a6e-bffc-4971-8893-1c23addeb5b0" providerId="ADAL" clId="{804748DF-446B-437F-AFFB-E1B8A8B41FF1}" dt="2023-02-06T15:00:56.855" v="7010" actId="1037"/>
          <ac:grpSpMkLst>
            <pc:docMk/>
            <pc:sldMk cId="3426644829" sldId="335"/>
            <ac:grpSpMk id="47" creationId="{4E14227D-66B9-EC00-FF14-5196710CEF42}"/>
          </ac:grpSpMkLst>
        </pc:grpChg>
        <pc:grpChg chg="add mod">
          <ac:chgData name="Kumar, Vinod" userId="a0710a6e-bffc-4971-8893-1c23addeb5b0" providerId="ADAL" clId="{804748DF-446B-437F-AFFB-E1B8A8B41FF1}" dt="2023-02-06T16:00:03.155" v="7164" actId="164"/>
          <ac:grpSpMkLst>
            <pc:docMk/>
            <pc:sldMk cId="3426644829" sldId="335"/>
            <ac:grpSpMk id="50" creationId="{9287D548-B58B-05F1-B7C5-570FEFE2BDE3}"/>
          </ac:grpSpMkLst>
        </pc:grpChg>
        <pc:grpChg chg="add mod">
          <ac:chgData name="Kumar, Vinod" userId="a0710a6e-bffc-4971-8893-1c23addeb5b0" providerId="ADAL" clId="{804748DF-446B-437F-AFFB-E1B8A8B41FF1}" dt="2023-02-06T16:00:36.633" v="7186" actId="1035"/>
          <ac:grpSpMkLst>
            <pc:docMk/>
            <pc:sldMk cId="3426644829" sldId="335"/>
            <ac:grpSpMk id="61" creationId="{2C8F7144-F32F-234E-9CEA-E5D3C66964D9}"/>
          </ac:grpSpMkLst>
        </pc:grpChg>
        <pc:grpChg chg="add mod">
          <ac:chgData name="Kumar, Vinod" userId="a0710a6e-bffc-4971-8893-1c23addeb5b0" providerId="ADAL" clId="{804748DF-446B-437F-AFFB-E1B8A8B41FF1}" dt="2023-02-06T16:06:43.644" v="7448" actId="164"/>
          <ac:grpSpMkLst>
            <pc:docMk/>
            <pc:sldMk cId="3426644829" sldId="335"/>
            <ac:grpSpMk id="69" creationId="{39456897-A16A-355B-696E-FF6CCEDEF582}"/>
          </ac:grpSpMkLst>
        </pc:grpChg>
        <pc:grpChg chg="add mod">
          <ac:chgData name="Kumar, Vinod" userId="a0710a6e-bffc-4971-8893-1c23addeb5b0" providerId="ADAL" clId="{804748DF-446B-437F-AFFB-E1B8A8B41FF1}" dt="2023-02-06T16:07:52.293" v="7464" actId="1038"/>
          <ac:grpSpMkLst>
            <pc:docMk/>
            <pc:sldMk cId="3426644829" sldId="335"/>
            <ac:grpSpMk id="70" creationId="{5A2AD2FA-E460-6C1E-0DF6-FDF1F6715D72}"/>
          </ac:grpSpMkLst>
        </pc:grpChg>
        <pc:grpChg chg="add mod">
          <ac:chgData name="Kumar, Vinod" userId="a0710a6e-bffc-4971-8893-1c23addeb5b0" providerId="ADAL" clId="{804748DF-446B-437F-AFFB-E1B8A8B41FF1}" dt="2023-02-06T16:52:09.183" v="8289" actId="164"/>
          <ac:grpSpMkLst>
            <pc:docMk/>
            <pc:sldMk cId="3426644829" sldId="335"/>
            <ac:grpSpMk id="80" creationId="{BFF64DEC-2AD8-D775-6904-3389C87E6A2C}"/>
          </ac:grpSpMkLst>
        </pc:grpChg>
        <pc:grpChg chg="add mod">
          <ac:chgData name="Kumar, Vinod" userId="a0710a6e-bffc-4971-8893-1c23addeb5b0" providerId="ADAL" clId="{804748DF-446B-437F-AFFB-E1B8A8B41FF1}" dt="2023-02-06T16:52:33.638" v="8290" actId="1076"/>
          <ac:grpSpMkLst>
            <pc:docMk/>
            <pc:sldMk cId="3426644829" sldId="335"/>
            <ac:grpSpMk id="86" creationId="{0189D281-3135-20B2-0374-AEC9914C971E}"/>
          </ac:grpSpMkLst>
        </pc:grpChg>
        <pc:picChg chg="add mod">
          <ac:chgData name="Kumar, Vinod" userId="a0710a6e-bffc-4971-8893-1c23addeb5b0" providerId="ADAL" clId="{804748DF-446B-437F-AFFB-E1B8A8B41FF1}" dt="2023-02-06T15:01:17.526" v="7022" actId="1037"/>
          <ac:picMkLst>
            <pc:docMk/>
            <pc:sldMk cId="3426644829" sldId="335"/>
            <ac:picMk id="2" creationId="{C23741A6-C178-F36E-AC5E-FAF41F4969B4}"/>
          </ac:picMkLst>
        </pc:picChg>
        <pc:picChg chg="mod">
          <ac:chgData name="Kumar, Vinod" userId="a0710a6e-bffc-4971-8893-1c23addeb5b0" providerId="ADAL" clId="{804748DF-446B-437F-AFFB-E1B8A8B41FF1}" dt="2023-01-31T19:42:05.533" v="5461" actId="165"/>
          <ac:picMkLst>
            <pc:docMk/>
            <pc:sldMk cId="3426644829" sldId="335"/>
            <ac:picMk id="3" creationId="{C51885F4-FC55-9876-C8EE-4ADE943B8B50}"/>
          </ac:picMkLst>
        </pc:picChg>
        <pc:picChg chg="add mod">
          <ac:chgData name="Kumar, Vinod" userId="a0710a6e-bffc-4971-8893-1c23addeb5b0" providerId="ADAL" clId="{804748DF-446B-437F-AFFB-E1B8A8B41FF1}" dt="2023-02-06T15:01:17.526" v="7022" actId="1037"/>
          <ac:picMkLst>
            <pc:docMk/>
            <pc:sldMk cId="3426644829" sldId="335"/>
            <ac:picMk id="9" creationId="{E90AA583-2EF3-02DF-41E1-AB6C156E748B}"/>
          </ac:picMkLst>
        </pc:picChg>
        <pc:picChg chg="mod topLvl">
          <ac:chgData name="Kumar, Vinod" userId="a0710a6e-bffc-4971-8893-1c23addeb5b0" providerId="ADAL" clId="{804748DF-446B-437F-AFFB-E1B8A8B41FF1}" dt="2023-01-31T19:47:53.837" v="5548" actId="164"/>
          <ac:picMkLst>
            <pc:docMk/>
            <pc:sldMk cId="3426644829" sldId="335"/>
            <ac:picMk id="11" creationId="{A8597543-0F87-CE77-9D43-6CB435EB8758}"/>
          </ac:picMkLst>
        </pc:picChg>
        <pc:picChg chg="mod">
          <ac:chgData name="Kumar, Vinod" userId="a0710a6e-bffc-4971-8893-1c23addeb5b0" providerId="ADAL" clId="{804748DF-446B-437F-AFFB-E1B8A8B41FF1}" dt="2023-01-31T19:58:53.350" v="5582" actId="165"/>
          <ac:picMkLst>
            <pc:docMk/>
            <pc:sldMk cId="3426644829" sldId="335"/>
            <ac:picMk id="17" creationId="{E4DA5F10-74F6-DE53-8530-C1D3C3BC4975}"/>
          </ac:picMkLst>
        </pc:picChg>
        <pc:picChg chg="mod">
          <ac:chgData name="Kumar, Vinod" userId="a0710a6e-bffc-4971-8893-1c23addeb5b0" providerId="ADAL" clId="{804748DF-446B-437F-AFFB-E1B8A8B41FF1}" dt="2023-01-31T19:58:53.350" v="5582" actId="165"/>
          <ac:picMkLst>
            <pc:docMk/>
            <pc:sldMk cId="3426644829" sldId="335"/>
            <ac:picMk id="18" creationId="{1A70C000-E76A-2422-82D1-6C93FFBA3F6B}"/>
          </ac:picMkLst>
        </pc:picChg>
        <pc:picChg chg="mod">
          <ac:chgData name="Kumar, Vinod" userId="a0710a6e-bffc-4971-8893-1c23addeb5b0" providerId="ADAL" clId="{804748DF-446B-437F-AFFB-E1B8A8B41FF1}" dt="2023-01-31T19:58:53.350" v="5582" actId="165"/>
          <ac:picMkLst>
            <pc:docMk/>
            <pc:sldMk cId="3426644829" sldId="335"/>
            <ac:picMk id="20" creationId="{CE63F0C7-6DE4-0681-0540-8A357FE7B8EB}"/>
          </ac:picMkLst>
        </pc:picChg>
        <pc:picChg chg="add mod">
          <ac:chgData name="Kumar, Vinod" userId="a0710a6e-bffc-4971-8893-1c23addeb5b0" providerId="ADAL" clId="{804748DF-446B-437F-AFFB-E1B8A8B41FF1}" dt="2023-02-06T15:02:43.542" v="7047" actId="1035"/>
          <ac:picMkLst>
            <pc:docMk/>
            <pc:sldMk cId="3426644829" sldId="335"/>
            <ac:picMk id="36" creationId="{519C8745-A372-C9D2-E985-A2010EA2019E}"/>
          </ac:picMkLst>
        </pc:picChg>
        <pc:picChg chg="add mod modCrop">
          <ac:chgData name="Kumar, Vinod" userId="a0710a6e-bffc-4971-8893-1c23addeb5b0" providerId="ADAL" clId="{804748DF-446B-437F-AFFB-E1B8A8B41FF1}" dt="2023-02-06T16:06:31.087" v="7447" actId="164"/>
          <ac:picMkLst>
            <pc:docMk/>
            <pc:sldMk cId="3426644829" sldId="335"/>
            <ac:picMk id="58" creationId="{CCE6FA18-A13D-15FB-4822-82F303B1BEDA}"/>
          </ac:picMkLst>
        </pc:picChg>
        <pc:picChg chg="add mod modCrop">
          <ac:chgData name="Kumar, Vinod" userId="a0710a6e-bffc-4971-8893-1c23addeb5b0" providerId="ADAL" clId="{804748DF-446B-437F-AFFB-E1B8A8B41FF1}" dt="2023-02-06T16:06:31.087" v="7447" actId="164"/>
          <ac:picMkLst>
            <pc:docMk/>
            <pc:sldMk cId="3426644829" sldId="335"/>
            <ac:picMk id="59" creationId="{A1D00A61-C648-AF21-FD72-FC55ECC4A063}"/>
          </ac:picMkLst>
        </pc:picChg>
        <pc:picChg chg="add mod modCrop">
          <ac:chgData name="Kumar, Vinod" userId="a0710a6e-bffc-4971-8893-1c23addeb5b0" providerId="ADAL" clId="{804748DF-446B-437F-AFFB-E1B8A8B41FF1}" dt="2023-02-06T16:06:31.087" v="7447" actId="164"/>
          <ac:picMkLst>
            <pc:docMk/>
            <pc:sldMk cId="3426644829" sldId="335"/>
            <ac:picMk id="60" creationId="{9A834501-0B3E-088D-01E6-ED8FEFA4C07D}"/>
          </ac:picMkLst>
        </pc:picChg>
        <pc:picChg chg="add del mod">
          <ac:chgData name="Kumar, Vinod" userId="a0710a6e-bffc-4971-8893-1c23addeb5b0" providerId="ADAL" clId="{804748DF-446B-437F-AFFB-E1B8A8B41FF1}" dt="2023-02-06T16:50:30.822" v="8047" actId="164"/>
          <ac:picMkLst>
            <pc:docMk/>
            <pc:sldMk cId="3426644829" sldId="335"/>
            <ac:picMk id="71" creationId="{99EB5184-EABD-6175-BB7C-A2AEFE4A9692}"/>
          </ac:picMkLst>
        </pc:picChg>
        <pc:picChg chg="add del mod">
          <ac:chgData name="Kumar, Vinod" userId="a0710a6e-bffc-4971-8893-1c23addeb5b0" providerId="ADAL" clId="{804748DF-446B-437F-AFFB-E1B8A8B41FF1}" dt="2023-02-06T16:50:30.822" v="8047" actId="164"/>
          <ac:picMkLst>
            <pc:docMk/>
            <pc:sldMk cId="3426644829" sldId="335"/>
            <ac:picMk id="72" creationId="{A6FE2562-1945-AC14-12C9-79570359692B}"/>
          </ac:picMkLst>
        </pc:picChg>
        <pc:picChg chg="add del mod">
          <ac:chgData name="Kumar, Vinod" userId="a0710a6e-bffc-4971-8893-1c23addeb5b0" providerId="ADAL" clId="{804748DF-446B-437F-AFFB-E1B8A8B41FF1}" dt="2023-02-06T16:50:30.822" v="8047" actId="164"/>
          <ac:picMkLst>
            <pc:docMk/>
            <pc:sldMk cId="3426644829" sldId="335"/>
            <ac:picMk id="73" creationId="{A9AF78E0-228D-D800-D300-755BB11E48FE}"/>
          </ac:picMkLst>
        </pc:picChg>
        <pc:picChg chg="add del mod">
          <ac:chgData name="Kumar, Vinod" userId="a0710a6e-bffc-4971-8893-1c23addeb5b0" providerId="ADAL" clId="{804748DF-446B-437F-AFFB-E1B8A8B41FF1}" dt="2023-02-06T16:50:30.822" v="8047" actId="164"/>
          <ac:picMkLst>
            <pc:docMk/>
            <pc:sldMk cId="3426644829" sldId="335"/>
            <ac:picMk id="74" creationId="{A68E6DF1-D527-7574-D2F2-839BEF029176}"/>
          </ac:picMkLst>
        </pc:picChg>
      </pc:sldChg>
      <pc:sldChg chg="addSp modSp new mod">
        <pc:chgData name="Kumar, Vinod" userId="a0710a6e-bffc-4971-8893-1c23addeb5b0" providerId="ADAL" clId="{804748DF-446B-437F-AFFB-E1B8A8B41FF1}" dt="2023-02-06T15:44:46.232" v="7055" actId="1076"/>
        <pc:sldMkLst>
          <pc:docMk/>
          <pc:sldMk cId="461106370" sldId="336"/>
        </pc:sldMkLst>
        <pc:picChg chg="add mod modCrop">
          <ac:chgData name="Kumar, Vinod" userId="a0710a6e-bffc-4971-8893-1c23addeb5b0" providerId="ADAL" clId="{804748DF-446B-437F-AFFB-E1B8A8B41FF1}" dt="2023-02-06T14:51:11.619" v="6590" actId="1076"/>
          <ac:picMkLst>
            <pc:docMk/>
            <pc:sldMk cId="461106370" sldId="336"/>
            <ac:picMk id="2" creationId="{ACF7902D-DAB2-05C1-4BA4-DEA0DB0E7CD4}"/>
          </ac:picMkLst>
        </pc:picChg>
        <pc:picChg chg="add mod modCrop">
          <ac:chgData name="Kumar, Vinod" userId="a0710a6e-bffc-4971-8893-1c23addeb5b0" providerId="ADAL" clId="{804748DF-446B-437F-AFFB-E1B8A8B41FF1}" dt="2023-02-06T14:53:39.594" v="6613" actId="1076"/>
          <ac:picMkLst>
            <pc:docMk/>
            <pc:sldMk cId="461106370" sldId="336"/>
            <ac:picMk id="3" creationId="{5AC2468C-D42C-93FB-5C34-E6E67E946A1F}"/>
          </ac:picMkLst>
        </pc:picChg>
        <pc:picChg chg="add mod modCrop">
          <ac:chgData name="Kumar, Vinod" userId="a0710a6e-bffc-4971-8893-1c23addeb5b0" providerId="ADAL" clId="{804748DF-446B-437F-AFFB-E1B8A8B41FF1}" dt="2023-02-06T14:52:37.843" v="6600" actId="732"/>
          <ac:picMkLst>
            <pc:docMk/>
            <pc:sldMk cId="461106370" sldId="336"/>
            <ac:picMk id="4" creationId="{99F3AA3F-53B4-07C2-033D-8133C7959C3C}"/>
          </ac:picMkLst>
        </pc:picChg>
        <pc:picChg chg="add mod modCrop">
          <ac:chgData name="Kumar, Vinod" userId="a0710a6e-bffc-4971-8893-1c23addeb5b0" providerId="ADAL" clId="{804748DF-446B-437F-AFFB-E1B8A8B41FF1}" dt="2023-02-06T14:54:02.337" v="6617" actId="1076"/>
          <ac:picMkLst>
            <pc:docMk/>
            <pc:sldMk cId="461106370" sldId="336"/>
            <ac:picMk id="5" creationId="{78D90F21-F92F-0903-652D-927A9FA48CAC}"/>
          </ac:picMkLst>
        </pc:picChg>
        <pc:picChg chg="add mod">
          <ac:chgData name="Kumar, Vinod" userId="a0710a6e-bffc-4971-8893-1c23addeb5b0" providerId="ADAL" clId="{804748DF-446B-437F-AFFB-E1B8A8B41FF1}" dt="2023-02-06T15:44:46.232" v="7055" actId="1076"/>
          <ac:picMkLst>
            <pc:docMk/>
            <pc:sldMk cId="461106370" sldId="336"/>
            <ac:picMk id="6" creationId="{73BCB1CC-6F5E-D2D5-9B57-BFFFD24CEC5A}"/>
          </ac:picMkLst>
        </pc:picChg>
      </pc:sldChg>
      <pc:sldChg chg="add del">
        <pc:chgData name="Kumar, Vinod" userId="a0710a6e-bffc-4971-8893-1c23addeb5b0" providerId="ADAL" clId="{804748DF-446B-437F-AFFB-E1B8A8B41FF1}" dt="2023-01-31T20:01:18.622" v="5650"/>
        <pc:sldMkLst>
          <pc:docMk/>
          <pc:sldMk cId="3282684289" sldId="336"/>
        </pc:sldMkLst>
      </pc:sldChg>
      <pc:sldChg chg="addSp modSp new mod">
        <pc:chgData name="Kumar, Vinod" userId="a0710a6e-bffc-4971-8893-1c23addeb5b0" providerId="ADAL" clId="{804748DF-446B-437F-AFFB-E1B8A8B41FF1}" dt="2023-02-06T14:53:24.459" v="6609" actId="1076"/>
        <pc:sldMkLst>
          <pc:docMk/>
          <pc:sldMk cId="2077480537" sldId="337"/>
        </pc:sldMkLst>
        <pc:picChg chg="add mod">
          <ac:chgData name="Kumar, Vinod" userId="a0710a6e-bffc-4971-8893-1c23addeb5b0" providerId="ADAL" clId="{804748DF-446B-437F-AFFB-E1B8A8B41FF1}" dt="2023-02-06T14:53:24.459" v="6609" actId="1076"/>
          <ac:picMkLst>
            <pc:docMk/>
            <pc:sldMk cId="2077480537" sldId="337"/>
            <ac:picMk id="3" creationId="{5F4649DA-F5D4-DAFC-BCA1-4F76C9C6598F}"/>
          </ac:picMkLst>
        </pc:picChg>
      </pc:sldChg>
      <pc:sldChg chg="addSp modSp new mod">
        <pc:chgData name="Kumar, Vinod" userId="a0710a6e-bffc-4971-8893-1c23addeb5b0" providerId="ADAL" clId="{804748DF-446B-437F-AFFB-E1B8A8B41FF1}" dt="2023-02-06T15:55:12.539" v="7101" actId="1076"/>
        <pc:sldMkLst>
          <pc:docMk/>
          <pc:sldMk cId="1881287229" sldId="338"/>
        </pc:sldMkLst>
        <pc:picChg chg="add mod">
          <ac:chgData name="Kumar, Vinod" userId="a0710a6e-bffc-4971-8893-1c23addeb5b0" providerId="ADAL" clId="{804748DF-446B-437F-AFFB-E1B8A8B41FF1}" dt="2023-02-06T15:55:12.539" v="7101" actId="1076"/>
          <ac:picMkLst>
            <pc:docMk/>
            <pc:sldMk cId="1881287229" sldId="338"/>
            <ac:picMk id="2" creationId="{A42B35AC-234F-58E9-6D6C-962FF3AA3B46}"/>
          </ac:picMkLst>
        </pc:picChg>
        <pc:picChg chg="add mod modCrop">
          <ac:chgData name="Kumar, Vinod" userId="a0710a6e-bffc-4971-8893-1c23addeb5b0" providerId="ADAL" clId="{804748DF-446B-437F-AFFB-E1B8A8B41FF1}" dt="2023-02-06T15:47:51.815" v="7067" actId="1076"/>
          <ac:picMkLst>
            <pc:docMk/>
            <pc:sldMk cId="1881287229" sldId="338"/>
            <ac:picMk id="3" creationId="{CFF25D99-DE02-5663-D190-77809D4F4048}"/>
          </ac:picMkLst>
        </pc:picChg>
        <pc:picChg chg="add mod modCrop">
          <ac:chgData name="Kumar, Vinod" userId="a0710a6e-bffc-4971-8893-1c23addeb5b0" providerId="ADAL" clId="{804748DF-446B-437F-AFFB-E1B8A8B41FF1}" dt="2023-02-06T15:48:39.086" v="7075" actId="1076"/>
          <ac:picMkLst>
            <pc:docMk/>
            <pc:sldMk cId="1881287229" sldId="338"/>
            <ac:picMk id="4" creationId="{1483AEDE-7D6A-73C2-3CB9-6FF3B51C8554}"/>
          </ac:picMkLst>
        </pc:picChg>
        <pc:picChg chg="add mod">
          <ac:chgData name="Kumar, Vinod" userId="a0710a6e-bffc-4971-8893-1c23addeb5b0" providerId="ADAL" clId="{804748DF-446B-437F-AFFB-E1B8A8B41FF1}" dt="2023-02-06T15:54:56.907" v="7099" actId="1076"/>
          <ac:picMkLst>
            <pc:docMk/>
            <pc:sldMk cId="1881287229" sldId="338"/>
            <ac:picMk id="5" creationId="{8DF70060-49AD-E554-2791-C6AB7FD29D47}"/>
          </ac:picMkLst>
        </pc:picChg>
      </pc:sldChg>
      <pc:sldChg chg="addSp modSp new mod">
        <pc:chgData name="Kumar, Vinod" userId="a0710a6e-bffc-4971-8893-1c23addeb5b0" providerId="ADAL" clId="{804748DF-446B-437F-AFFB-E1B8A8B41FF1}" dt="2023-02-06T15:46:59.879" v="7056" actId="1076"/>
        <pc:sldMkLst>
          <pc:docMk/>
          <pc:sldMk cId="56293523" sldId="339"/>
        </pc:sldMkLst>
        <pc:picChg chg="add mod">
          <ac:chgData name="Kumar, Vinod" userId="a0710a6e-bffc-4971-8893-1c23addeb5b0" providerId="ADAL" clId="{804748DF-446B-437F-AFFB-E1B8A8B41FF1}" dt="2023-02-06T15:46:59.879" v="7056" actId="1076"/>
          <ac:picMkLst>
            <pc:docMk/>
            <pc:sldMk cId="56293523" sldId="339"/>
            <ac:picMk id="3" creationId="{B6E4D5FB-186E-61DF-D073-71A021D40BBD}"/>
          </ac:picMkLst>
        </pc:picChg>
      </pc:sldChg>
      <pc:sldChg chg="addSp modSp new mod">
        <pc:chgData name="Kumar, Vinod" userId="a0710a6e-bffc-4971-8893-1c23addeb5b0" providerId="ADAL" clId="{804748DF-446B-437F-AFFB-E1B8A8B41FF1}" dt="2023-02-06T15:54:48.291" v="7097" actId="1076"/>
        <pc:sldMkLst>
          <pc:docMk/>
          <pc:sldMk cId="2932005610" sldId="340"/>
        </pc:sldMkLst>
        <pc:picChg chg="add mod">
          <ac:chgData name="Kumar, Vinod" userId="a0710a6e-bffc-4971-8893-1c23addeb5b0" providerId="ADAL" clId="{804748DF-446B-437F-AFFB-E1B8A8B41FF1}" dt="2023-02-06T15:54:15.972" v="7088" actId="962"/>
          <ac:picMkLst>
            <pc:docMk/>
            <pc:sldMk cId="2932005610" sldId="340"/>
            <ac:picMk id="3" creationId="{1216A646-B529-5B34-B81F-04A61EEF79CB}"/>
          </ac:picMkLst>
        </pc:picChg>
        <pc:picChg chg="add mod modCrop">
          <ac:chgData name="Kumar, Vinod" userId="a0710a6e-bffc-4971-8893-1c23addeb5b0" providerId="ADAL" clId="{804748DF-446B-437F-AFFB-E1B8A8B41FF1}" dt="2023-02-06T15:54:48.291" v="7097" actId="1076"/>
          <ac:picMkLst>
            <pc:docMk/>
            <pc:sldMk cId="2932005610" sldId="340"/>
            <ac:picMk id="5" creationId="{AF1521B5-4B83-891D-456F-7CEF9874554F}"/>
          </ac:picMkLst>
        </pc:picChg>
      </pc:sldChg>
      <pc:sldChg chg="addSp modSp new mod">
        <pc:chgData name="Kumar, Vinod" userId="a0710a6e-bffc-4971-8893-1c23addeb5b0" providerId="ADAL" clId="{804748DF-446B-437F-AFFB-E1B8A8B41FF1}" dt="2023-02-06T16:47:08.954" v="7631" actId="1076"/>
        <pc:sldMkLst>
          <pc:docMk/>
          <pc:sldMk cId="4024231393" sldId="341"/>
        </pc:sldMkLst>
        <pc:picChg chg="add mod">
          <ac:chgData name="Kumar, Vinod" userId="a0710a6e-bffc-4971-8893-1c23addeb5b0" providerId="ADAL" clId="{804748DF-446B-437F-AFFB-E1B8A8B41FF1}" dt="2023-02-06T16:42:26.651" v="7512" actId="1076"/>
          <ac:picMkLst>
            <pc:docMk/>
            <pc:sldMk cId="4024231393" sldId="341"/>
            <ac:picMk id="3" creationId="{965BCC25-545D-EEE7-8550-E51946437764}"/>
          </ac:picMkLst>
        </pc:picChg>
        <pc:picChg chg="add mod modCrop">
          <ac:chgData name="Kumar, Vinod" userId="a0710a6e-bffc-4971-8893-1c23addeb5b0" providerId="ADAL" clId="{804748DF-446B-437F-AFFB-E1B8A8B41FF1}" dt="2023-02-06T16:44:43.097" v="7538" actId="1076"/>
          <ac:picMkLst>
            <pc:docMk/>
            <pc:sldMk cId="4024231393" sldId="341"/>
            <ac:picMk id="5" creationId="{87AC8D93-3B46-B621-39DD-EAB9BC9FE30A}"/>
          </ac:picMkLst>
        </pc:picChg>
        <pc:picChg chg="add mod modCrop">
          <ac:chgData name="Kumar, Vinod" userId="a0710a6e-bffc-4971-8893-1c23addeb5b0" providerId="ADAL" clId="{804748DF-446B-437F-AFFB-E1B8A8B41FF1}" dt="2023-02-06T16:16:30.825" v="7491" actId="1076"/>
          <ac:picMkLst>
            <pc:docMk/>
            <pc:sldMk cId="4024231393" sldId="341"/>
            <ac:picMk id="6" creationId="{7C932814-1CDB-78B7-9EE1-78728994EA86}"/>
          </ac:picMkLst>
        </pc:picChg>
        <pc:picChg chg="add mod modCrop">
          <ac:chgData name="Kumar, Vinod" userId="a0710a6e-bffc-4971-8893-1c23addeb5b0" providerId="ADAL" clId="{804748DF-446B-437F-AFFB-E1B8A8B41FF1}" dt="2023-02-06T16:19:03.399" v="7506" actId="1076"/>
          <ac:picMkLst>
            <pc:docMk/>
            <pc:sldMk cId="4024231393" sldId="341"/>
            <ac:picMk id="7" creationId="{3CB84C46-2F9E-CFF5-D8A0-67943EA1C379}"/>
          </ac:picMkLst>
        </pc:picChg>
        <pc:picChg chg="add mod">
          <ac:chgData name="Kumar, Vinod" userId="a0710a6e-bffc-4971-8893-1c23addeb5b0" providerId="ADAL" clId="{804748DF-446B-437F-AFFB-E1B8A8B41FF1}" dt="2023-02-06T16:47:08.954" v="7631" actId="1076"/>
          <ac:picMkLst>
            <pc:docMk/>
            <pc:sldMk cId="4024231393" sldId="341"/>
            <ac:picMk id="9" creationId="{BC46AA50-9693-0D05-5058-6E2696315D99}"/>
          </ac:picMkLst>
        </pc:picChg>
        <pc:picChg chg="add mod modCrop">
          <ac:chgData name="Kumar, Vinod" userId="a0710a6e-bffc-4971-8893-1c23addeb5b0" providerId="ADAL" clId="{804748DF-446B-437F-AFFB-E1B8A8B41FF1}" dt="2023-02-06T16:44:54.874" v="7541" actId="1076"/>
          <ac:picMkLst>
            <pc:docMk/>
            <pc:sldMk cId="4024231393" sldId="341"/>
            <ac:picMk id="10" creationId="{DEBA2F45-7B8E-4453-A5E9-923C6B936924}"/>
          </ac:picMkLst>
        </pc:picChg>
      </pc:sldChg>
    </pc:docChg>
  </pc:docChgLst>
  <pc:docChgLst>
    <pc:chgData name="Kumar, Vinod" userId="a0710a6e-bffc-4971-8893-1c23addeb5b0" providerId="ADAL" clId="{5EDA080F-2DA0-41E9-BDBC-F9DEF976E495}"/>
    <pc:docChg chg="undo redo custSel addSld delSld modSld modMainMaster modNotesMaster">
      <pc:chgData name="Kumar, Vinod" userId="a0710a6e-bffc-4971-8893-1c23addeb5b0" providerId="ADAL" clId="{5EDA080F-2DA0-41E9-BDBC-F9DEF976E495}" dt="2022-10-03T20:18:54.999" v="4657" actId="1076"/>
      <pc:docMkLst>
        <pc:docMk/>
      </pc:docMkLst>
      <pc:sldChg chg="modSp mod">
        <pc:chgData name="Kumar, Vinod" userId="a0710a6e-bffc-4971-8893-1c23addeb5b0" providerId="ADAL" clId="{5EDA080F-2DA0-41E9-BDBC-F9DEF976E495}" dt="2022-09-27T15:14:01.585" v="869" actId="554"/>
        <pc:sldMkLst>
          <pc:docMk/>
          <pc:sldMk cId="2581851823" sldId="270"/>
        </pc:sldMkLst>
        <pc:spChg chg="mod">
          <ac:chgData name="Kumar, Vinod" userId="a0710a6e-bffc-4971-8893-1c23addeb5b0" providerId="ADAL" clId="{5EDA080F-2DA0-41E9-BDBC-F9DEF976E495}" dt="2022-09-27T15:12:32.360" v="836" actId="1035"/>
          <ac:spMkLst>
            <pc:docMk/>
            <pc:sldMk cId="2581851823" sldId="270"/>
            <ac:spMk id="9" creationId="{00000000-0000-0000-0000-000000000000}"/>
          </ac:spMkLst>
        </pc:spChg>
        <pc:spChg chg="mod">
          <ac:chgData name="Kumar, Vinod" userId="a0710a6e-bffc-4971-8893-1c23addeb5b0" providerId="ADAL" clId="{5EDA080F-2DA0-41E9-BDBC-F9DEF976E495}" dt="2022-09-27T15:12:43.352" v="842" actId="1038"/>
          <ac:spMkLst>
            <pc:docMk/>
            <pc:sldMk cId="2581851823" sldId="270"/>
            <ac:spMk id="40" creationId="{02877FFF-08CA-43DF-5844-4C20B3E3B98D}"/>
          </ac:spMkLst>
        </pc:spChg>
        <pc:spChg chg="mod">
          <ac:chgData name="Kumar, Vinod" userId="a0710a6e-bffc-4971-8893-1c23addeb5b0" providerId="ADAL" clId="{5EDA080F-2DA0-41E9-BDBC-F9DEF976E495}" dt="2022-09-27T15:12:52.345" v="848" actId="1036"/>
          <ac:spMkLst>
            <pc:docMk/>
            <pc:sldMk cId="2581851823" sldId="270"/>
            <ac:spMk id="41" creationId="{075AF166-3D87-EC13-A4B3-8DE412562D74}"/>
          </ac:spMkLst>
        </pc:spChg>
        <pc:spChg chg="mod">
          <ac:chgData name="Kumar, Vinod" userId="a0710a6e-bffc-4971-8893-1c23addeb5b0" providerId="ADAL" clId="{5EDA080F-2DA0-41E9-BDBC-F9DEF976E495}" dt="2022-09-27T15:13:17.608" v="862" actId="1036"/>
          <ac:spMkLst>
            <pc:docMk/>
            <pc:sldMk cId="2581851823" sldId="270"/>
            <ac:spMk id="42" creationId="{16DC128D-7391-9104-D36F-94A5E4919D28}"/>
          </ac:spMkLst>
        </pc:spChg>
        <pc:spChg chg="mod">
          <ac:chgData name="Kumar, Vinod" userId="a0710a6e-bffc-4971-8893-1c23addeb5b0" providerId="ADAL" clId="{5EDA080F-2DA0-41E9-BDBC-F9DEF976E495}" dt="2022-09-27T15:13:12.088" v="856" actId="1076"/>
          <ac:spMkLst>
            <pc:docMk/>
            <pc:sldMk cId="2581851823" sldId="270"/>
            <ac:spMk id="43" creationId="{EFA3BA5F-8A3A-CB47-50F3-1A1EE0BF7CAB}"/>
          </ac:spMkLst>
        </pc:spChg>
        <pc:spChg chg="mod">
          <ac:chgData name="Kumar, Vinod" userId="a0710a6e-bffc-4971-8893-1c23addeb5b0" providerId="ADAL" clId="{5EDA080F-2DA0-41E9-BDBC-F9DEF976E495}" dt="2022-09-27T15:14:01.585" v="869" actId="554"/>
          <ac:spMkLst>
            <pc:docMk/>
            <pc:sldMk cId="2581851823" sldId="270"/>
            <ac:spMk id="44" creationId="{635FF346-A88B-92A6-1B45-E8D4AA8BE5F4}"/>
          </ac:spMkLst>
        </pc:spChg>
        <pc:spChg chg="mod">
          <ac:chgData name="Kumar, Vinod" userId="a0710a6e-bffc-4971-8893-1c23addeb5b0" providerId="ADAL" clId="{5EDA080F-2DA0-41E9-BDBC-F9DEF976E495}" dt="2022-09-27T15:14:01.585" v="869" actId="554"/>
          <ac:spMkLst>
            <pc:docMk/>
            <pc:sldMk cId="2581851823" sldId="270"/>
            <ac:spMk id="45" creationId="{90C79A45-3774-DF57-E47E-FDF4D887691A}"/>
          </ac:spMkLst>
        </pc:spChg>
        <pc:picChg chg="mod">
          <ac:chgData name="Kumar, Vinod" userId="a0710a6e-bffc-4971-8893-1c23addeb5b0" providerId="ADAL" clId="{5EDA080F-2DA0-41E9-BDBC-F9DEF976E495}" dt="2022-09-27T15:13:51.719" v="868" actId="1036"/>
          <ac:picMkLst>
            <pc:docMk/>
            <pc:sldMk cId="2581851823" sldId="270"/>
            <ac:picMk id="2" creationId="{1C40B368-7271-944F-5A0D-482A6E631169}"/>
          </ac:picMkLst>
        </pc:picChg>
        <pc:picChg chg="mod">
          <ac:chgData name="Kumar, Vinod" userId="a0710a6e-bffc-4971-8893-1c23addeb5b0" providerId="ADAL" clId="{5EDA080F-2DA0-41E9-BDBC-F9DEF976E495}" dt="2022-09-27T15:11:35.945" v="808" actId="1036"/>
          <ac:picMkLst>
            <pc:docMk/>
            <pc:sldMk cId="2581851823" sldId="270"/>
            <ac:picMk id="18" creationId="{94C80812-73CD-8D57-BA74-A51FD8C186C5}"/>
          </ac:picMkLst>
        </pc:picChg>
        <pc:picChg chg="mod">
          <ac:chgData name="Kumar, Vinod" userId="a0710a6e-bffc-4971-8893-1c23addeb5b0" providerId="ADAL" clId="{5EDA080F-2DA0-41E9-BDBC-F9DEF976E495}" dt="2022-09-27T15:11:50.200" v="815" actId="1037"/>
          <ac:picMkLst>
            <pc:docMk/>
            <pc:sldMk cId="2581851823" sldId="270"/>
            <ac:picMk id="19" creationId="{D1526D6C-E2F5-D0AB-478D-4DAB790FC397}"/>
          </ac:picMkLst>
        </pc:picChg>
        <pc:picChg chg="mod">
          <ac:chgData name="Kumar, Vinod" userId="a0710a6e-bffc-4971-8893-1c23addeb5b0" providerId="ADAL" clId="{5EDA080F-2DA0-41E9-BDBC-F9DEF976E495}" dt="2022-09-27T15:12:15.370" v="830" actId="1035"/>
          <ac:picMkLst>
            <pc:docMk/>
            <pc:sldMk cId="2581851823" sldId="270"/>
            <ac:picMk id="22" creationId="{33076018-5466-8581-6A2B-27627BC26283}"/>
          </ac:picMkLst>
        </pc:picChg>
        <pc:picChg chg="mod">
          <ac:chgData name="Kumar, Vinod" userId="a0710a6e-bffc-4971-8893-1c23addeb5b0" providerId="ADAL" clId="{5EDA080F-2DA0-41E9-BDBC-F9DEF976E495}" dt="2022-09-27T15:12:15.370" v="830" actId="1035"/>
          <ac:picMkLst>
            <pc:docMk/>
            <pc:sldMk cId="2581851823" sldId="270"/>
            <ac:picMk id="23" creationId="{1D89F4DD-9BA8-FED4-BCA3-72E107254170}"/>
          </ac:picMkLst>
        </pc:picChg>
        <pc:picChg chg="mod">
          <ac:chgData name="Kumar, Vinod" userId="a0710a6e-bffc-4971-8893-1c23addeb5b0" providerId="ADAL" clId="{5EDA080F-2DA0-41E9-BDBC-F9DEF976E495}" dt="2022-09-27T15:12:19.560" v="833" actId="1035"/>
          <ac:picMkLst>
            <pc:docMk/>
            <pc:sldMk cId="2581851823" sldId="270"/>
            <ac:picMk id="24" creationId="{5C19F2A6-0BA0-4F6B-2F78-0857983C2355}"/>
          </ac:picMkLst>
        </pc:picChg>
      </pc:sldChg>
      <pc:sldChg chg="addSp delSp modSp mod">
        <pc:chgData name="Kumar, Vinod" userId="a0710a6e-bffc-4971-8893-1c23addeb5b0" providerId="ADAL" clId="{5EDA080F-2DA0-41E9-BDBC-F9DEF976E495}" dt="2022-09-27T15:41:54.666" v="3690" actId="20577"/>
        <pc:sldMkLst>
          <pc:docMk/>
          <pc:sldMk cId="51599060" sldId="294"/>
        </pc:sldMkLst>
        <pc:spChg chg="mod">
          <ac:chgData name="Kumar, Vinod" userId="a0710a6e-bffc-4971-8893-1c23addeb5b0" providerId="ADAL" clId="{5EDA080F-2DA0-41E9-BDBC-F9DEF976E495}" dt="2022-09-27T15:36:27.419" v="3307" actId="1037"/>
          <ac:spMkLst>
            <pc:docMk/>
            <pc:sldMk cId="51599060" sldId="294"/>
            <ac:spMk id="7" creationId="{C56CA07C-310B-7CB3-A9A5-D9A9ED7A54FF}"/>
          </ac:spMkLst>
        </pc:spChg>
        <pc:spChg chg="mod">
          <ac:chgData name="Kumar, Vinod" userId="a0710a6e-bffc-4971-8893-1c23addeb5b0" providerId="ADAL" clId="{5EDA080F-2DA0-41E9-BDBC-F9DEF976E495}" dt="2022-09-27T15:40:58.223" v="3638" actId="1038"/>
          <ac:spMkLst>
            <pc:docMk/>
            <pc:sldMk cId="51599060" sldId="294"/>
            <ac:spMk id="18" creationId="{398F8A0C-194E-FF4D-7289-8864350071D4}"/>
          </ac:spMkLst>
        </pc:spChg>
        <pc:spChg chg="mod">
          <ac:chgData name="Kumar, Vinod" userId="a0710a6e-bffc-4971-8893-1c23addeb5b0" providerId="ADAL" clId="{5EDA080F-2DA0-41E9-BDBC-F9DEF976E495}" dt="2022-09-27T15:36:42.284" v="3319" actId="1036"/>
          <ac:spMkLst>
            <pc:docMk/>
            <pc:sldMk cId="51599060" sldId="294"/>
            <ac:spMk id="19" creationId="{3A4EBC49-37F4-D869-0996-BE21DB0E7ABD}"/>
          </ac:spMkLst>
        </pc:spChg>
        <pc:spChg chg="mod">
          <ac:chgData name="Kumar, Vinod" userId="a0710a6e-bffc-4971-8893-1c23addeb5b0" providerId="ADAL" clId="{5EDA080F-2DA0-41E9-BDBC-F9DEF976E495}" dt="2022-09-27T15:37:26.285" v="3347" actId="1035"/>
          <ac:spMkLst>
            <pc:docMk/>
            <pc:sldMk cId="51599060" sldId="294"/>
            <ac:spMk id="20" creationId="{50EABD4C-5A9D-7A62-CF2E-6C0640B39C2F}"/>
          </ac:spMkLst>
        </pc:spChg>
        <pc:spChg chg="mod">
          <ac:chgData name="Kumar, Vinod" userId="a0710a6e-bffc-4971-8893-1c23addeb5b0" providerId="ADAL" clId="{5EDA080F-2DA0-41E9-BDBC-F9DEF976E495}" dt="2022-09-27T15:40:47.851" v="3572" actId="1038"/>
          <ac:spMkLst>
            <pc:docMk/>
            <pc:sldMk cId="51599060" sldId="294"/>
            <ac:spMk id="21" creationId="{BA17C6E1-9E7E-0426-0C8C-C1A35E1C7DC3}"/>
          </ac:spMkLst>
        </pc:spChg>
        <pc:spChg chg="mod">
          <ac:chgData name="Kumar, Vinod" userId="a0710a6e-bffc-4971-8893-1c23addeb5b0" providerId="ADAL" clId="{5EDA080F-2DA0-41E9-BDBC-F9DEF976E495}" dt="2022-09-27T15:36:42.284" v="3319" actId="1036"/>
          <ac:spMkLst>
            <pc:docMk/>
            <pc:sldMk cId="51599060" sldId="294"/>
            <ac:spMk id="22" creationId="{89C3B8BA-B97C-4483-7DDA-C04CF0B7D5BD}"/>
          </ac:spMkLst>
        </pc:spChg>
        <pc:spChg chg="mod">
          <ac:chgData name="Kumar, Vinod" userId="a0710a6e-bffc-4971-8893-1c23addeb5b0" providerId="ADAL" clId="{5EDA080F-2DA0-41E9-BDBC-F9DEF976E495}" dt="2022-09-27T15:37:26.285" v="3347" actId="1035"/>
          <ac:spMkLst>
            <pc:docMk/>
            <pc:sldMk cId="51599060" sldId="294"/>
            <ac:spMk id="23" creationId="{9E9FD58F-64C2-0A03-90AD-E94581A8B3C0}"/>
          </ac:spMkLst>
        </pc:spChg>
        <pc:spChg chg="mod">
          <ac:chgData name="Kumar, Vinod" userId="a0710a6e-bffc-4971-8893-1c23addeb5b0" providerId="ADAL" clId="{5EDA080F-2DA0-41E9-BDBC-F9DEF976E495}" dt="2022-09-27T15:36:18.109" v="3300" actId="1035"/>
          <ac:spMkLst>
            <pc:docMk/>
            <pc:sldMk cId="51599060" sldId="294"/>
            <ac:spMk id="24" creationId="{3CC663BE-9D93-F87F-7818-C877356A5B1C}"/>
          </ac:spMkLst>
        </pc:spChg>
        <pc:spChg chg="mod">
          <ac:chgData name="Kumar, Vinod" userId="a0710a6e-bffc-4971-8893-1c23addeb5b0" providerId="ADAL" clId="{5EDA080F-2DA0-41E9-BDBC-F9DEF976E495}" dt="2022-09-27T15:36:18.109" v="3300" actId="1035"/>
          <ac:spMkLst>
            <pc:docMk/>
            <pc:sldMk cId="51599060" sldId="294"/>
            <ac:spMk id="25" creationId="{EEA2DED9-D02B-BD07-2DDB-1844946C07FC}"/>
          </ac:spMkLst>
        </pc:spChg>
        <pc:spChg chg="mod">
          <ac:chgData name="Kumar, Vinod" userId="a0710a6e-bffc-4971-8893-1c23addeb5b0" providerId="ADAL" clId="{5EDA080F-2DA0-41E9-BDBC-F9DEF976E495}" dt="2022-09-27T15:36:42.284" v="3319" actId="1036"/>
          <ac:spMkLst>
            <pc:docMk/>
            <pc:sldMk cId="51599060" sldId="294"/>
            <ac:spMk id="26" creationId="{F5C4C9A3-0A8D-5EF8-010D-CF3030AE0D95}"/>
          </ac:spMkLst>
        </pc:spChg>
        <pc:spChg chg="mod">
          <ac:chgData name="Kumar, Vinod" userId="a0710a6e-bffc-4971-8893-1c23addeb5b0" providerId="ADAL" clId="{5EDA080F-2DA0-41E9-BDBC-F9DEF976E495}" dt="2022-09-27T15:36:42.284" v="3319" actId="1036"/>
          <ac:spMkLst>
            <pc:docMk/>
            <pc:sldMk cId="51599060" sldId="294"/>
            <ac:spMk id="27" creationId="{27B17A2C-6532-2CB3-D392-3208B9A65094}"/>
          </ac:spMkLst>
        </pc:spChg>
        <pc:spChg chg="mod">
          <ac:chgData name="Kumar, Vinod" userId="a0710a6e-bffc-4971-8893-1c23addeb5b0" providerId="ADAL" clId="{5EDA080F-2DA0-41E9-BDBC-F9DEF976E495}" dt="2022-09-27T15:37:13.836" v="3341" actId="1035"/>
          <ac:spMkLst>
            <pc:docMk/>
            <pc:sldMk cId="51599060" sldId="294"/>
            <ac:spMk id="28" creationId="{2A61F1F1-2458-F05A-D6AC-BFB7017688BA}"/>
          </ac:spMkLst>
        </pc:spChg>
        <pc:spChg chg="mod">
          <ac:chgData name="Kumar, Vinod" userId="a0710a6e-bffc-4971-8893-1c23addeb5b0" providerId="ADAL" clId="{5EDA080F-2DA0-41E9-BDBC-F9DEF976E495}" dt="2022-09-27T15:37:13.836" v="3341" actId="1035"/>
          <ac:spMkLst>
            <pc:docMk/>
            <pc:sldMk cId="51599060" sldId="294"/>
            <ac:spMk id="29" creationId="{760CD5E2-7907-5398-3CE4-410188CBFD00}"/>
          </ac:spMkLst>
        </pc:spChg>
        <pc:spChg chg="add mod">
          <ac:chgData name="Kumar, Vinod" userId="a0710a6e-bffc-4971-8893-1c23addeb5b0" providerId="ADAL" clId="{5EDA080F-2DA0-41E9-BDBC-F9DEF976E495}" dt="2022-09-27T15:41:51.434" v="3689" actId="20577"/>
          <ac:spMkLst>
            <pc:docMk/>
            <pc:sldMk cId="51599060" sldId="294"/>
            <ac:spMk id="34" creationId="{2B6C7636-0898-60A7-0EFB-7BCB47A579CA}"/>
          </ac:spMkLst>
        </pc:spChg>
        <pc:spChg chg="add mod">
          <ac:chgData name="Kumar, Vinod" userId="a0710a6e-bffc-4971-8893-1c23addeb5b0" providerId="ADAL" clId="{5EDA080F-2DA0-41E9-BDBC-F9DEF976E495}" dt="2022-09-27T15:41:54.666" v="3690" actId="20577"/>
          <ac:spMkLst>
            <pc:docMk/>
            <pc:sldMk cId="51599060" sldId="294"/>
            <ac:spMk id="35" creationId="{CF814D77-3222-924D-96EB-DDE43FF62229}"/>
          </ac:spMkLst>
        </pc:spChg>
        <pc:picChg chg="mod">
          <ac:chgData name="Kumar, Vinod" userId="a0710a6e-bffc-4971-8893-1c23addeb5b0" providerId="ADAL" clId="{5EDA080F-2DA0-41E9-BDBC-F9DEF976E495}" dt="2022-09-27T15:36:42.284" v="3319" actId="1036"/>
          <ac:picMkLst>
            <pc:docMk/>
            <pc:sldMk cId="51599060" sldId="294"/>
            <ac:picMk id="2" creationId="{89B759E7-C5D6-9DAE-715D-F0293F1F50DA}"/>
          </ac:picMkLst>
        </pc:picChg>
        <pc:picChg chg="mod">
          <ac:chgData name="Kumar, Vinod" userId="a0710a6e-bffc-4971-8893-1c23addeb5b0" providerId="ADAL" clId="{5EDA080F-2DA0-41E9-BDBC-F9DEF976E495}" dt="2022-09-27T15:36:42.284" v="3319" actId="1036"/>
          <ac:picMkLst>
            <pc:docMk/>
            <pc:sldMk cId="51599060" sldId="294"/>
            <ac:picMk id="3" creationId="{73758AC8-16FA-94B8-4DA8-AE833AE6A838}"/>
          </ac:picMkLst>
        </pc:picChg>
        <pc:picChg chg="mod">
          <ac:chgData name="Kumar, Vinod" userId="a0710a6e-bffc-4971-8893-1c23addeb5b0" providerId="ADAL" clId="{5EDA080F-2DA0-41E9-BDBC-F9DEF976E495}" dt="2022-09-27T15:37:26.285" v="3347" actId="1035"/>
          <ac:picMkLst>
            <pc:docMk/>
            <pc:sldMk cId="51599060" sldId="294"/>
            <ac:picMk id="4" creationId="{0AB7334A-7D84-E21C-4840-A55B123B485F}"/>
          </ac:picMkLst>
        </pc:picChg>
        <pc:picChg chg="mod">
          <ac:chgData name="Kumar, Vinod" userId="a0710a6e-bffc-4971-8893-1c23addeb5b0" providerId="ADAL" clId="{5EDA080F-2DA0-41E9-BDBC-F9DEF976E495}" dt="2022-09-27T15:37:26.285" v="3347" actId="1035"/>
          <ac:picMkLst>
            <pc:docMk/>
            <pc:sldMk cId="51599060" sldId="294"/>
            <ac:picMk id="5" creationId="{68015BC2-1828-B74E-A8EC-FAED8514FFEC}"/>
          </ac:picMkLst>
        </pc:picChg>
        <pc:picChg chg="mod">
          <ac:chgData name="Kumar, Vinod" userId="a0710a6e-bffc-4971-8893-1c23addeb5b0" providerId="ADAL" clId="{5EDA080F-2DA0-41E9-BDBC-F9DEF976E495}" dt="2022-09-27T15:40:58.223" v="3638" actId="1038"/>
          <ac:picMkLst>
            <pc:docMk/>
            <pc:sldMk cId="51599060" sldId="294"/>
            <ac:picMk id="30" creationId="{60CB73A7-14FE-042F-5656-C468FC0E6FD9}"/>
          </ac:picMkLst>
        </pc:picChg>
        <pc:picChg chg="mod">
          <ac:chgData name="Kumar, Vinod" userId="a0710a6e-bffc-4971-8893-1c23addeb5b0" providerId="ADAL" clId="{5EDA080F-2DA0-41E9-BDBC-F9DEF976E495}" dt="2022-09-27T15:40:47.851" v="3572" actId="1038"/>
          <ac:picMkLst>
            <pc:docMk/>
            <pc:sldMk cId="51599060" sldId="294"/>
            <ac:picMk id="31" creationId="{386F0B05-F7BB-5932-D2EE-B54F705C16F0}"/>
          </ac:picMkLst>
        </pc:picChg>
        <pc:picChg chg="add del mod">
          <ac:chgData name="Kumar, Vinod" userId="a0710a6e-bffc-4971-8893-1c23addeb5b0" providerId="ADAL" clId="{5EDA080F-2DA0-41E9-BDBC-F9DEF976E495}" dt="2022-09-27T15:41:23.290" v="3647" actId="1038"/>
          <ac:picMkLst>
            <pc:docMk/>
            <pc:sldMk cId="51599060" sldId="294"/>
            <ac:picMk id="32" creationId="{E6DE9711-8ED1-7832-D742-5D0C043C5385}"/>
          </ac:picMkLst>
        </pc:picChg>
        <pc:picChg chg="add del mod">
          <ac:chgData name="Kumar, Vinod" userId="a0710a6e-bffc-4971-8893-1c23addeb5b0" providerId="ADAL" clId="{5EDA080F-2DA0-41E9-BDBC-F9DEF976E495}" dt="2022-09-27T15:41:28.170" v="3652" actId="1036"/>
          <ac:picMkLst>
            <pc:docMk/>
            <pc:sldMk cId="51599060" sldId="294"/>
            <ac:picMk id="33" creationId="{E66DF3B6-EBB2-377C-AA78-C44B645A9F1C}"/>
          </ac:picMkLst>
        </pc:picChg>
      </pc:sldChg>
      <pc:sldChg chg="addSp delSp modSp del mod">
        <pc:chgData name="Kumar, Vinod" userId="a0710a6e-bffc-4971-8893-1c23addeb5b0" providerId="ADAL" clId="{5EDA080F-2DA0-41E9-BDBC-F9DEF976E495}" dt="2022-09-27T15:08:16.441" v="421" actId="47"/>
        <pc:sldMkLst>
          <pc:docMk/>
          <pc:sldMk cId="1513429835" sldId="296"/>
        </pc:sldMkLst>
        <pc:spChg chg="del mod">
          <ac:chgData name="Kumar, Vinod" userId="a0710a6e-bffc-4971-8893-1c23addeb5b0" providerId="ADAL" clId="{5EDA080F-2DA0-41E9-BDBC-F9DEF976E495}" dt="2022-09-27T14:49:37.114" v="2" actId="478"/>
          <ac:spMkLst>
            <pc:docMk/>
            <pc:sldMk cId="1513429835" sldId="296"/>
            <ac:spMk id="104" creationId="{DC972888-DDF4-E41C-CBBC-744976A85034}"/>
          </ac:spMkLst>
        </pc:spChg>
        <pc:spChg chg="mod">
          <ac:chgData name="Kumar, Vinod" userId="a0710a6e-bffc-4971-8893-1c23addeb5b0" providerId="ADAL" clId="{5EDA080F-2DA0-41E9-BDBC-F9DEF976E495}" dt="2022-09-27T14:50:15.598" v="3"/>
          <ac:spMkLst>
            <pc:docMk/>
            <pc:sldMk cId="1513429835" sldId="296"/>
            <ac:spMk id="106" creationId="{1253AFB0-F16E-B111-268A-44C83B505F1A}"/>
          </ac:spMkLst>
        </pc:spChg>
        <pc:spChg chg="mod">
          <ac:chgData name="Kumar, Vinod" userId="a0710a6e-bffc-4971-8893-1c23addeb5b0" providerId="ADAL" clId="{5EDA080F-2DA0-41E9-BDBC-F9DEF976E495}" dt="2022-09-27T14:50:15.598" v="3"/>
          <ac:spMkLst>
            <pc:docMk/>
            <pc:sldMk cId="1513429835" sldId="296"/>
            <ac:spMk id="107" creationId="{25589A7B-40A9-1C3F-CA72-8E6823CA9C5D}"/>
          </ac:spMkLst>
        </pc:spChg>
        <pc:spChg chg="mod">
          <ac:chgData name="Kumar, Vinod" userId="a0710a6e-bffc-4971-8893-1c23addeb5b0" providerId="ADAL" clId="{5EDA080F-2DA0-41E9-BDBC-F9DEF976E495}" dt="2022-09-27T14:50:15.598" v="3"/>
          <ac:spMkLst>
            <pc:docMk/>
            <pc:sldMk cId="1513429835" sldId="296"/>
            <ac:spMk id="108" creationId="{0E3FF067-CDAE-FE5C-DC61-9CFD793BB7DE}"/>
          </ac:spMkLst>
        </pc:spChg>
        <pc:spChg chg="mod">
          <ac:chgData name="Kumar, Vinod" userId="a0710a6e-bffc-4971-8893-1c23addeb5b0" providerId="ADAL" clId="{5EDA080F-2DA0-41E9-BDBC-F9DEF976E495}" dt="2022-09-27T14:50:15.598" v="3"/>
          <ac:spMkLst>
            <pc:docMk/>
            <pc:sldMk cId="1513429835" sldId="296"/>
            <ac:spMk id="109" creationId="{3FEC5275-05AD-B763-F9D3-2DDDAC0790DF}"/>
          </ac:spMkLst>
        </pc:spChg>
        <pc:spChg chg="mod">
          <ac:chgData name="Kumar, Vinod" userId="a0710a6e-bffc-4971-8893-1c23addeb5b0" providerId="ADAL" clId="{5EDA080F-2DA0-41E9-BDBC-F9DEF976E495}" dt="2022-09-27T14:50:15.598" v="3"/>
          <ac:spMkLst>
            <pc:docMk/>
            <pc:sldMk cId="1513429835" sldId="296"/>
            <ac:spMk id="110" creationId="{D3508864-3E84-1171-B47C-3E5AE1B3196C}"/>
          </ac:spMkLst>
        </pc:spChg>
        <pc:spChg chg="mod">
          <ac:chgData name="Kumar, Vinod" userId="a0710a6e-bffc-4971-8893-1c23addeb5b0" providerId="ADAL" clId="{5EDA080F-2DA0-41E9-BDBC-F9DEF976E495}" dt="2022-09-27T14:47:56.106" v="1"/>
          <ac:spMkLst>
            <pc:docMk/>
            <pc:sldMk cId="1513429835" sldId="296"/>
            <ac:spMk id="111" creationId="{400131B4-D5AC-5B1B-C3E8-479483B6AFBF}"/>
          </ac:spMkLst>
        </pc:spChg>
        <pc:spChg chg="mod">
          <ac:chgData name="Kumar, Vinod" userId="a0710a6e-bffc-4971-8893-1c23addeb5b0" providerId="ADAL" clId="{5EDA080F-2DA0-41E9-BDBC-F9DEF976E495}" dt="2022-09-27T14:47:56.106" v="1"/>
          <ac:spMkLst>
            <pc:docMk/>
            <pc:sldMk cId="1513429835" sldId="296"/>
            <ac:spMk id="114" creationId="{B67DACA4-5363-BFEE-AA45-269DFADDEE09}"/>
          </ac:spMkLst>
        </pc:spChg>
        <pc:spChg chg="mod">
          <ac:chgData name="Kumar, Vinod" userId="a0710a6e-bffc-4971-8893-1c23addeb5b0" providerId="ADAL" clId="{5EDA080F-2DA0-41E9-BDBC-F9DEF976E495}" dt="2022-09-27T14:47:56.106" v="1"/>
          <ac:spMkLst>
            <pc:docMk/>
            <pc:sldMk cId="1513429835" sldId="296"/>
            <ac:spMk id="115" creationId="{478522AC-C3A6-DD59-AF23-F69235756BC8}"/>
          </ac:spMkLst>
        </pc:spChg>
        <pc:spChg chg="mod">
          <ac:chgData name="Kumar, Vinod" userId="a0710a6e-bffc-4971-8893-1c23addeb5b0" providerId="ADAL" clId="{5EDA080F-2DA0-41E9-BDBC-F9DEF976E495}" dt="2022-09-27T14:47:56.106" v="1"/>
          <ac:spMkLst>
            <pc:docMk/>
            <pc:sldMk cId="1513429835" sldId="296"/>
            <ac:spMk id="116" creationId="{7231D7CF-29D8-93D8-2772-AAC22485556E}"/>
          </ac:spMkLst>
        </pc:spChg>
        <pc:spChg chg="mod">
          <ac:chgData name="Kumar, Vinod" userId="a0710a6e-bffc-4971-8893-1c23addeb5b0" providerId="ADAL" clId="{5EDA080F-2DA0-41E9-BDBC-F9DEF976E495}" dt="2022-09-27T14:47:56.106" v="1"/>
          <ac:spMkLst>
            <pc:docMk/>
            <pc:sldMk cId="1513429835" sldId="296"/>
            <ac:spMk id="117" creationId="{9153A802-9404-EFC7-E2DC-31EAD1DB41A5}"/>
          </ac:spMkLst>
        </pc:spChg>
        <pc:spChg chg="mod">
          <ac:chgData name="Kumar, Vinod" userId="a0710a6e-bffc-4971-8893-1c23addeb5b0" providerId="ADAL" clId="{5EDA080F-2DA0-41E9-BDBC-F9DEF976E495}" dt="2022-09-27T14:47:56.106" v="1"/>
          <ac:spMkLst>
            <pc:docMk/>
            <pc:sldMk cId="1513429835" sldId="296"/>
            <ac:spMk id="118" creationId="{9BA63CC1-92E1-11C8-51BE-4D99EB4B02FA}"/>
          </ac:spMkLst>
        </pc:spChg>
        <pc:spChg chg="mod">
          <ac:chgData name="Kumar, Vinod" userId="a0710a6e-bffc-4971-8893-1c23addeb5b0" providerId="ADAL" clId="{5EDA080F-2DA0-41E9-BDBC-F9DEF976E495}" dt="2022-09-27T14:47:56.106" v="1"/>
          <ac:spMkLst>
            <pc:docMk/>
            <pc:sldMk cId="1513429835" sldId="296"/>
            <ac:spMk id="119" creationId="{99636659-6CB2-51C1-52EA-4B7BB124E9DD}"/>
          </ac:spMkLst>
        </pc:spChg>
        <pc:spChg chg="mod">
          <ac:chgData name="Kumar, Vinod" userId="a0710a6e-bffc-4971-8893-1c23addeb5b0" providerId="ADAL" clId="{5EDA080F-2DA0-41E9-BDBC-F9DEF976E495}" dt="2022-09-27T14:47:56.106" v="1"/>
          <ac:spMkLst>
            <pc:docMk/>
            <pc:sldMk cId="1513429835" sldId="296"/>
            <ac:spMk id="123" creationId="{89E58ABA-EC09-A3C7-4300-ED1BCB567EA8}"/>
          </ac:spMkLst>
        </pc:spChg>
        <pc:spChg chg="mod">
          <ac:chgData name="Kumar, Vinod" userId="a0710a6e-bffc-4971-8893-1c23addeb5b0" providerId="ADAL" clId="{5EDA080F-2DA0-41E9-BDBC-F9DEF976E495}" dt="2022-09-27T14:47:56.106" v="1"/>
          <ac:spMkLst>
            <pc:docMk/>
            <pc:sldMk cId="1513429835" sldId="296"/>
            <ac:spMk id="124" creationId="{AE72F1A3-B995-84FD-3ECD-CCF7819A28CD}"/>
          </ac:spMkLst>
        </pc:spChg>
        <pc:spChg chg="mod">
          <ac:chgData name="Kumar, Vinod" userId="a0710a6e-bffc-4971-8893-1c23addeb5b0" providerId="ADAL" clId="{5EDA080F-2DA0-41E9-BDBC-F9DEF976E495}" dt="2022-09-27T14:47:56.106" v="1"/>
          <ac:spMkLst>
            <pc:docMk/>
            <pc:sldMk cId="1513429835" sldId="296"/>
            <ac:spMk id="125" creationId="{965AD607-535D-430D-0B05-3D882E458793}"/>
          </ac:spMkLst>
        </pc:spChg>
        <pc:spChg chg="mod topLvl">
          <ac:chgData name="Kumar, Vinod" userId="a0710a6e-bffc-4971-8893-1c23addeb5b0" providerId="ADAL" clId="{5EDA080F-2DA0-41E9-BDBC-F9DEF976E495}" dt="2022-09-27T14:53:04.756" v="26" actId="165"/>
          <ac:spMkLst>
            <pc:docMk/>
            <pc:sldMk cId="1513429835" sldId="296"/>
            <ac:spMk id="130" creationId="{F2792264-D490-56BD-6683-1C257E241F58}"/>
          </ac:spMkLst>
        </pc:spChg>
        <pc:spChg chg="mod">
          <ac:chgData name="Kumar, Vinod" userId="a0710a6e-bffc-4971-8893-1c23addeb5b0" providerId="ADAL" clId="{5EDA080F-2DA0-41E9-BDBC-F9DEF976E495}" dt="2022-09-27T14:53:04.756" v="26" actId="165"/>
          <ac:spMkLst>
            <pc:docMk/>
            <pc:sldMk cId="1513429835" sldId="296"/>
            <ac:spMk id="131" creationId="{341C3DAD-8831-6185-FB2F-EE49BB26467E}"/>
          </ac:spMkLst>
        </pc:spChg>
        <pc:spChg chg="mod">
          <ac:chgData name="Kumar, Vinod" userId="a0710a6e-bffc-4971-8893-1c23addeb5b0" providerId="ADAL" clId="{5EDA080F-2DA0-41E9-BDBC-F9DEF976E495}" dt="2022-09-27T14:53:04.756" v="26" actId="165"/>
          <ac:spMkLst>
            <pc:docMk/>
            <pc:sldMk cId="1513429835" sldId="296"/>
            <ac:spMk id="137" creationId="{C6A69B23-79A6-1696-C362-0FBD1C918743}"/>
          </ac:spMkLst>
        </pc:spChg>
        <pc:spChg chg="mod">
          <ac:chgData name="Kumar, Vinod" userId="a0710a6e-bffc-4971-8893-1c23addeb5b0" providerId="ADAL" clId="{5EDA080F-2DA0-41E9-BDBC-F9DEF976E495}" dt="2022-09-27T14:53:04.756" v="26" actId="165"/>
          <ac:spMkLst>
            <pc:docMk/>
            <pc:sldMk cId="1513429835" sldId="296"/>
            <ac:spMk id="138" creationId="{B5FB8C97-E6C4-2BD4-476C-48BE7A4BEAD9}"/>
          </ac:spMkLst>
        </pc:spChg>
        <pc:spChg chg="mod">
          <ac:chgData name="Kumar, Vinod" userId="a0710a6e-bffc-4971-8893-1c23addeb5b0" providerId="ADAL" clId="{5EDA080F-2DA0-41E9-BDBC-F9DEF976E495}" dt="2022-09-27T14:53:04.756" v="26" actId="165"/>
          <ac:spMkLst>
            <pc:docMk/>
            <pc:sldMk cId="1513429835" sldId="296"/>
            <ac:spMk id="140" creationId="{E3BB1FD9-3B87-02B4-E48F-330F0919D6E6}"/>
          </ac:spMkLst>
        </pc:spChg>
        <pc:spChg chg="mod">
          <ac:chgData name="Kumar, Vinod" userId="a0710a6e-bffc-4971-8893-1c23addeb5b0" providerId="ADAL" clId="{5EDA080F-2DA0-41E9-BDBC-F9DEF976E495}" dt="2022-09-27T14:53:04.756" v="26" actId="165"/>
          <ac:spMkLst>
            <pc:docMk/>
            <pc:sldMk cId="1513429835" sldId="296"/>
            <ac:spMk id="141" creationId="{9E634DCF-6CDE-7750-6F59-7137D7133759}"/>
          </ac:spMkLst>
        </pc:spChg>
        <pc:spChg chg="mod">
          <ac:chgData name="Kumar, Vinod" userId="a0710a6e-bffc-4971-8893-1c23addeb5b0" providerId="ADAL" clId="{5EDA080F-2DA0-41E9-BDBC-F9DEF976E495}" dt="2022-09-27T14:53:04.756" v="26" actId="165"/>
          <ac:spMkLst>
            <pc:docMk/>
            <pc:sldMk cId="1513429835" sldId="296"/>
            <ac:spMk id="142" creationId="{7A9EE77E-D552-2715-22BA-2D18900CAF25}"/>
          </ac:spMkLst>
        </pc:spChg>
        <pc:spChg chg="mod topLvl">
          <ac:chgData name="Kumar, Vinod" userId="a0710a6e-bffc-4971-8893-1c23addeb5b0" providerId="ADAL" clId="{5EDA080F-2DA0-41E9-BDBC-F9DEF976E495}" dt="2022-09-27T14:53:09.589" v="27" actId="165"/>
          <ac:spMkLst>
            <pc:docMk/>
            <pc:sldMk cId="1513429835" sldId="296"/>
            <ac:spMk id="145" creationId="{B4B54DA4-A9EA-620D-0527-DD35CC099908}"/>
          </ac:spMkLst>
        </pc:spChg>
        <pc:spChg chg="mod">
          <ac:chgData name="Kumar, Vinod" userId="a0710a6e-bffc-4971-8893-1c23addeb5b0" providerId="ADAL" clId="{5EDA080F-2DA0-41E9-BDBC-F9DEF976E495}" dt="2022-09-27T14:53:09.589" v="27" actId="165"/>
          <ac:spMkLst>
            <pc:docMk/>
            <pc:sldMk cId="1513429835" sldId="296"/>
            <ac:spMk id="150" creationId="{E2E6BA4F-5BD9-B259-D41C-A379B9A1EE79}"/>
          </ac:spMkLst>
        </pc:spChg>
        <pc:spChg chg="mod">
          <ac:chgData name="Kumar, Vinod" userId="a0710a6e-bffc-4971-8893-1c23addeb5b0" providerId="ADAL" clId="{5EDA080F-2DA0-41E9-BDBC-F9DEF976E495}" dt="2022-09-27T14:53:09.589" v="27" actId="165"/>
          <ac:spMkLst>
            <pc:docMk/>
            <pc:sldMk cId="1513429835" sldId="296"/>
            <ac:spMk id="151" creationId="{336F432C-5688-FF8D-65C8-93F8F13BE934}"/>
          </ac:spMkLst>
        </pc:spChg>
        <pc:spChg chg="mod">
          <ac:chgData name="Kumar, Vinod" userId="a0710a6e-bffc-4971-8893-1c23addeb5b0" providerId="ADAL" clId="{5EDA080F-2DA0-41E9-BDBC-F9DEF976E495}" dt="2022-09-27T14:53:09.589" v="27" actId="165"/>
          <ac:spMkLst>
            <pc:docMk/>
            <pc:sldMk cId="1513429835" sldId="296"/>
            <ac:spMk id="152" creationId="{57E57128-EBE7-36DC-83AA-F58A9788B7E5}"/>
          </ac:spMkLst>
        </pc:spChg>
        <pc:spChg chg="mod">
          <ac:chgData name="Kumar, Vinod" userId="a0710a6e-bffc-4971-8893-1c23addeb5b0" providerId="ADAL" clId="{5EDA080F-2DA0-41E9-BDBC-F9DEF976E495}" dt="2022-09-27T14:53:09.589" v="27" actId="165"/>
          <ac:spMkLst>
            <pc:docMk/>
            <pc:sldMk cId="1513429835" sldId="296"/>
            <ac:spMk id="154" creationId="{0C7CD436-2A9F-697F-B87D-2D72A587A9AA}"/>
          </ac:spMkLst>
        </pc:spChg>
        <pc:spChg chg="mod">
          <ac:chgData name="Kumar, Vinod" userId="a0710a6e-bffc-4971-8893-1c23addeb5b0" providerId="ADAL" clId="{5EDA080F-2DA0-41E9-BDBC-F9DEF976E495}" dt="2022-09-27T14:53:09.589" v="27" actId="165"/>
          <ac:spMkLst>
            <pc:docMk/>
            <pc:sldMk cId="1513429835" sldId="296"/>
            <ac:spMk id="155" creationId="{E47AF5EE-BB51-D42B-F948-E52B605D90F6}"/>
          </ac:spMkLst>
        </pc:spChg>
        <pc:spChg chg="mod">
          <ac:chgData name="Kumar, Vinod" userId="a0710a6e-bffc-4971-8893-1c23addeb5b0" providerId="ADAL" clId="{5EDA080F-2DA0-41E9-BDBC-F9DEF976E495}" dt="2022-09-27T14:53:09.589" v="27" actId="165"/>
          <ac:spMkLst>
            <pc:docMk/>
            <pc:sldMk cId="1513429835" sldId="296"/>
            <ac:spMk id="156" creationId="{D9791131-F062-13DC-36AF-C7465D33466E}"/>
          </ac:spMkLst>
        </pc:spChg>
        <pc:spChg chg="mod topLvl">
          <ac:chgData name="Kumar, Vinod" userId="a0710a6e-bffc-4971-8893-1c23addeb5b0" providerId="ADAL" clId="{5EDA080F-2DA0-41E9-BDBC-F9DEF976E495}" dt="2022-09-27T14:53:12.261" v="28" actId="165"/>
          <ac:spMkLst>
            <pc:docMk/>
            <pc:sldMk cId="1513429835" sldId="296"/>
            <ac:spMk id="159" creationId="{B4CD806E-9C91-32A0-396A-9C0871528E63}"/>
          </ac:spMkLst>
        </pc:spChg>
        <pc:spChg chg="mod">
          <ac:chgData name="Kumar, Vinod" userId="a0710a6e-bffc-4971-8893-1c23addeb5b0" providerId="ADAL" clId="{5EDA080F-2DA0-41E9-BDBC-F9DEF976E495}" dt="2022-09-27T14:53:12.261" v="28" actId="165"/>
          <ac:spMkLst>
            <pc:docMk/>
            <pc:sldMk cId="1513429835" sldId="296"/>
            <ac:spMk id="160" creationId="{5FD90C14-1D17-9F39-5BAB-AC5639DC52F5}"/>
          </ac:spMkLst>
        </pc:spChg>
        <pc:spChg chg="mod">
          <ac:chgData name="Kumar, Vinod" userId="a0710a6e-bffc-4971-8893-1c23addeb5b0" providerId="ADAL" clId="{5EDA080F-2DA0-41E9-BDBC-F9DEF976E495}" dt="2022-09-27T14:53:12.261" v="28" actId="165"/>
          <ac:spMkLst>
            <pc:docMk/>
            <pc:sldMk cId="1513429835" sldId="296"/>
            <ac:spMk id="162" creationId="{ABB4A628-7992-21C0-9233-F653C0BCC367}"/>
          </ac:spMkLst>
        </pc:spChg>
        <pc:spChg chg="mod">
          <ac:chgData name="Kumar, Vinod" userId="a0710a6e-bffc-4971-8893-1c23addeb5b0" providerId="ADAL" clId="{5EDA080F-2DA0-41E9-BDBC-F9DEF976E495}" dt="2022-09-27T14:53:12.261" v="28" actId="165"/>
          <ac:spMkLst>
            <pc:docMk/>
            <pc:sldMk cId="1513429835" sldId="296"/>
            <ac:spMk id="163" creationId="{9E6B5252-2E4F-9749-EE59-A473D4050F02}"/>
          </ac:spMkLst>
        </pc:spChg>
        <pc:spChg chg="mod">
          <ac:chgData name="Kumar, Vinod" userId="a0710a6e-bffc-4971-8893-1c23addeb5b0" providerId="ADAL" clId="{5EDA080F-2DA0-41E9-BDBC-F9DEF976E495}" dt="2022-09-27T14:53:12.261" v="28" actId="165"/>
          <ac:spMkLst>
            <pc:docMk/>
            <pc:sldMk cId="1513429835" sldId="296"/>
            <ac:spMk id="166" creationId="{A98D4340-727A-8F79-F268-A2F4027F09B0}"/>
          </ac:spMkLst>
        </pc:spChg>
        <pc:spChg chg="mod">
          <ac:chgData name="Kumar, Vinod" userId="a0710a6e-bffc-4971-8893-1c23addeb5b0" providerId="ADAL" clId="{5EDA080F-2DA0-41E9-BDBC-F9DEF976E495}" dt="2022-09-27T14:53:12.261" v="28" actId="165"/>
          <ac:spMkLst>
            <pc:docMk/>
            <pc:sldMk cId="1513429835" sldId="296"/>
            <ac:spMk id="168" creationId="{9A878616-04BA-7D07-A947-0BA5C2950AE4}"/>
          </ac:spMkLst>
        </pc:spChg>
        <pc:spChg chg="mod topLvl">
          <ac:chgData name="Kumar, Vinod" userId="a0710a6e-bffc-4971-8893-1c23addeb5b0" providerId="ADAL" clId="{5EDA080F-2DA0-41E9-BDBC-F9DEF976E495}" dt="2022-09-27T14:53:15.204" v="29" actId="165"/>
          <ac:spMkLst>
            <pc:docMk/>
            <pc:sldMk cId="1513429835" sldId="296"/>
            <ac:spMk id="172" creationId="{58D83DF8-E670-E733-C958-F860D457EF3F}"/>
          </ac:spMkLst>
        </pc:spChg>
        <pc:spChg chg="mod">
          <ac:chgData name="Kumar, Vinod" userId="a0710a6e-bffc-4971-8893-1c23addeb5b0" providerId="ADAL" clId="{5EDA080F-2DA0-41E9-BDBC-F9DEF976E495}" dt="2022-09-27T14:53:15.204" v="29" actId="165"/>
          <ac:spMkLst>
            <pc:docMk/>
            <pc:sldMk cId="1513429835" sldId="296"/>
            <ac:spMk id="173" creationId="{5EC89FEF-BA3D-BCF1-CECB-81479A527553}"/>
          </ac:spMkLst>
        </pc:spChg>
        <pc:spChg chg="mod">
          <ac:chgData name="Kumar, Vinod" userId="a0710a6e-bffc-4971-8893-1c23addeb5b0" providerId="ADAL" clId="{5EDA080F-2DA0-41E9-BDBC-F9DEF976E495}" dt="2022-09-27T14:53:15.204" v="29" actId="165"/>
          <ac:spMkLst>
            <pc:docMk/>
            <pc:sldMk cId="1513429835" sldId="296"/>
            <ac:spMk id="176" creationId="{22440C10-7CC2-6817-D9C4-6D236CC097C0}"/>
          </ac:spMkLst>
        </pc:spChg>
        <pc:spChg chg="mod">
          <ac:chgData name="Kumar, Vinod" userId="a0710a6e-bffc-4971-8893-1c23addeb5b0" providerId="ADAL" clId="{5EDA080F-2DA0-41E9-BDBC-F9DEF976E495}" dt="2022-09-27T14:53:15.204" v="29" actId="165"/>
          <ac:spMkLst>
            <pc:docMk/>
            <pc:sldMk cId="1513429835" sldId="296"/>
            <ac:spMk id="178" creationId="{7E771C5B-70F7-88DF-7011-8B51BF66E19A}"/>
          </ac:spMkLst>
        </pc:spChg>
        <pc:spChg chg="mod">
          <ac:chgData name="Kumar, Vinod" userId="a0710a6e-bffc-4971-8893-1c23addeb5b0" providerId="ADAL" clId="{5EDA080F-2DA0-41E9-BDBC-F9DEF976E495}" dt="2022-09-27T14:53:15.204" v="29" actId="165"/>
          <ac:spMkLst>
            <pc:docMk/>
            <pc:sldMk cId="1513429835" sldId="296"/>
            <ac:spMk id="180" creationId="{D9CBD619-58DE-BF43-1844-A148F4FA9D45}"/>
          </ac:spMkLst>
        </pc:spChg>
        <pc:spChg chg="mod">
          <ac:chgData name="Kumar, Vinod" userId="a0710a6e-bffc-4971-8893-1c23addeb5b0" providerId="ADAL" clId="{5EDA080F-2DA0-41E9-BDBC-F9DEF976E495}" dt="2022-09-27T14:53:15.204" v="29" actId="165"/>
          <ac:spMkLst>
            <pc:docMk/>
            <pc:sldMk cId="1513429835" sldId="296"/>
            <ac:spMk id="181" creationId="{F3100C3F-0AF7-7A98-C90C-7F69FF31E0D3}"/>
          </ac:spMkLst>
        </pc:spChg>
        <pc:spChg chg="mod topLvl">
          <ac:chgData name="Kumar, Vinod" userId="a0710a6e-bffc-4971-8893-1c23addeb5b0" providerId="ADAL" clId="{5EDA080F-2DA0-41E9-BDBC-F9DEF976E495}" dt="2022-09-27T14:53:20.189" v="30" actId="165"/>
          <ac:spMkLst>
            <pc:docMk/>
            <pc:sldMk cId="1513429835" sldId="296"/>
            <ac:spMk id="185" creationId="{9FEF310F-8C0D-844D-2FDD-E24B381C8A9A}"/>
          </ac:spMkLst>
        </pc:spChg>
        <pc:spChg chg="mod">
          <ac:chgData name="Kumar, Vinod" userId="a0710a6e-bffc-4971-8893-1c23addeb5b0" providerId="ADAL" clId="{5EDA080F-2DA0-41E9-BDBC-F9DEF976E495}" dt="2022-09-27T14:53:20.189" v="30" actId="165"/>
          <ac:spMkLst>
            <pc:docMk/>
            <pc:sldMk cId="1513429835" sldId="296"/>
            <ac:spMk id="187" creationId="{C9B01DA9-7A0C-6016-CF88-E6267FC3FD4D}"/>
          </ac:spMkLst>
        </pc:spChg>
        <pc:spChg chg="mod">
          <ac:chgData name="Kumar, Vinod" userId="a0710a6e-bffc-4971-8893-1c23addeb5b0" providerId="ADAL" clId="{5EDA080F-2DA0-41E9-BDBC-F9DEF976E495}" dt="2022-09-27T14:53:20.189" v="30" actId="165"/>
          <ac:spMkLst>
            <pc:docMk/>
            <pc:sldMk cId="1513429835" sldId="296"/>
            <ac:spMk id="189" creationId="{5B36D47B-EE25-7904-1F7F-8C6471D43E75}"/>
          </ac:spMkLst>
        </pc:spChg>
        <pc:spChg chg="mod">
          <ac:chgData name="Kumar, Vinod" userId="a0710a6e-bffc-4971-8893-1c23addeb5b0" providerId="ADAL" clId="{5EDA080F-2DA0-41E9-BDBC-F9DEF976E495}" dt="2022-09-27T14:53:20.189" v="30" actId="165"/>
          <ac:spMkLst>
            <pc:docMk/>
            <pc:sldMk cId="1513429835" sldId="296"/>
            <ac:spMk id="190" creationId="{80BCD534-A91A-F1AF-091B-3D5543A42AC9}"/>
          </ac:spMkLst>
        </pc:spChg>
        <pc:spChg chg="mod">
          <ac:chgData name="Kumar, Vinod" userId="a0710a6e-bffc-4971-8893-1c23addeb5b0" providerId="ADAL" clId="{5EDA080F-2DA0-41E9-BDBC-F9DEF976E495}" dt="2022-09-27T14:53:20.189" v="30" actId="165"/>
          <ac:spMkLst>
            <pc:docMk/>
            <pc:sldMk cId="1513429835" sldId="296"/>
            <ac:spMk id="191" creationId="{6EBDD917-5B03-B856-4D8F-699F54195551}"/>
          </ac:spMkLst>
        </pc:spChg>
        <pc:spChg chg="mod">
          <ac:chgData name="Kumar, Vinod" userId="a0710a6e-bffc-4971-8893-1c23addeb5b0" providerId="ADAL" clId="{5EDA080F-2DA0-41E9-BDBC-F9DEF976E495}" dt="2022-09-27T14:53:20.189" v="30" actId="165"/>
          <ac:spMkLst>
            <pc:docMk/>
            <pc:sldMk cId="1513429835" sldId="296"/>
            <ac:spMk id="192" creationId="{0B5B5A40-66FC-32A2-5E78-FF1E984F0A5B}"/>
          </ac:spMkLst>
        </pc:spChg>
        <pc:spChg chg="mod topLvl">
          <ac:chgData name="Kumar, Vinod" userId="a0710a6e-bffc-4971-8893-1c23addeb5b0" providerId="ADAL" clId="{5EDA080F-2DA0-41E9-BDBC-F9DEF976E495}" dt="2022-09-27T14:53:23.380" v="31" actId="165"/>
          <ac:spMkLst>
            <pc:docMk/>
            <pc:sldMk cId="1513429835" sldId="296"/>
            <ac:spMk id="198" creationId="{F748DA9B-E63A-3C71-685C-80C54CBC1442}"/>
          </ac:spMkLst>
        </pc:spChg>
        <pc:spChg chg="mod">
          <ac:chgData name="Kumar, Vinod" userId="a0710a6e-bffc-4971-8893-1c23addeb5b0" providerId="ADAL" clId="{5EDA080F-2DA0-41E9-BDBC-F9DEF976E495}" dt="2022-09-27T14:53:23.380" v="31" actId="165"/>
          <ac:spMkLst>
            <pc:docMk/>
            <pc:sldMk cId="1513429835" sldId="296"/>
            <ac:spMk id="202" creationId="{FFD12379-EDBE-EA2F-9F32-8D326AC16264}"/>
          </ac:spMkLst>
        </pc:spChg>
        <pc:spChg chg="mod">
          <ac:chgData name="Kumar, Vinod" userId="a0710a6e-bffc-4971-8893-1c23addeb5b0" providerId="ADAL" clId="{5EDA080F-2DA0-41E9-BDBC-F9DEF976E495}" dt="2022-09-27T14:53:23.380" v="31" actId="165"/>
          <ac:spMkLst>
            <pc:docMk/>
            <pc:sldMk cId="1513429835" sldId="296"/>
            <ac:spMk id="203" creationId="{878C0F07-696A-F865-EC7E-1868D0C7690C}"/>
          </ac:spMkLst>
        </pc:spChg>
        <pc:spChg chg="mod">
          <ac:chgData name="Kumar, Vinod" userId="a0710a6e-bffc-4971-8893-1c23addeb5b0" providerId="ADAL" clId="{5EDA080F-2DA0-41E9-BDBC-F9DEF976E495}" dt="2022-09-27T14:53:23.380" v="31" actId="165"/>
          <ac:spMkLst>
            <pc:docMk/>
            <pc:sldMk cId="1513429835" sldId="296"/>
            <ac:spMk id="204" creationId="{8687C1B9-EBFD-D552-ADCB-19A002A7A50D}"/>
          </ac:spMkLst>
        </pc:spChg>
        <pc:spChg chg="mod">
          <ac:chgData name="Kumar, Vinod" userId="a0710a6e-bffc-4971-8893-1c23addeb5b0" providerId="ADAL" clId="{5EDA080F-2DA0-41E9-BDBC-F9DEF976E495}" dt="2022-09-27T14:53:23.380" v="31" actId="165"/>
          <ac:spMkLst>
            <pc:docMk/>
            <pc:sldMk cId="1513429835" sldId="296"/>
            <ac:spMk id="205" creationId="{E4EFEAB7-5134-0026-C710-5FC3142E8895}"/>
          </ac:spMkLst>
        </pc:spChg>
        <pc:spChg chg="mod">
          <ac:chgData name="Kumar, Vinod" userId="a0710a6e-bffc-4971-8893-1c23addeb5b0" providerId="ADAL" clId="{5EDA080F-2DA0-41E9-BDBC-F9DEF976E495}" dt="2022-09-27T14:53:23.380" v="31" actId="165"/>
          <ac:spMkLst>
            <pc:docMk/>
            <pc:sldMk cId="1513429835" sldId="296"/>
            <ac:spMk id="206" creationId="{5C4D2A22-6DF8-B093-6D60-91E6CBC59CC8}"/>
          </ac:spMkLst>
        </pc:spChg>
        <pc:spChg chg="mod topLvl">
          <ac:chgData name="Kumar, Vinod" userId="a0710a6e-bffc-4971-8893-1c23addeb5b0" providerId="ADAL" clId="{5EDA080F-2DA0-41E9-BDBC-F9DEF976E495}" dt="2022-09-27T14:53:28.715" v="32" actId="165"/>
          <ac:spMkLst>
            <pc:docMk/>
            <pc:sldMk cId="1513429835" sldId="296"/>
            <ac:spMk id="209" creationId="{4ABE6BA9-D095-F6E8-A696-B61C1634FFDC}"/>
          </ac:spMkLst>
        </pc:spChg>
        <pc:spChg chg="mod topLvl">
          <ac:chgData name="Kumar, Vinod" userId="a0710a6e-bffc-4971-8893-1c23addeb5b0" providerId="ADAL" clId="{5EDA080F-2DA0-41E9-BDBC-F9DEF976E495}" dt="2022-09-27T14:53:31.508" v="33" actId="165"/>
          <ac:spMkLst>
            <pc:docMk/>
            <pc:sldMk cId="1513429835" sldId="296"/>
            <ac:spMk id="212" creationId="{B0AF491A-8F4C-2EE0-8E7A-31A0F4B77720}"/>
          </ac:spMkLst>
        </pc:spChg>
        <pc:spChg chg="mod">
          <ac:chgData name="Kumar, Vinod" userId="a0710a6e-bffc-4971-8893-1c23addeb5b0" providerId="ADAL" clId="{5EDA080F-2DA0-41E9-BDBC-F9DEF976E495}" dt="2022-09-27T14:50:15.598" v="3"/>
          <ac:spMkLst>
            <pc:docMk/>
            <pc:sldMk cId="1513429835" sldId="296"/>
            <ac:spMk id="213" creationId="{22E4E6A0-4D3B-9E20-4E9C-6AED54B7B10F}"/>
          </ac:spMkLst>
        </pc:spChg>
        <pc:spChg chg="mod">
          <ac:chgData name="Kumar, Vinod" userId="a0710a6e-bffc-4971-8893-1c23addeb5b0" providerId="ADAL" clId="{5EDA080F-2DA0-41E9-BDBC-F9DEF976E495}" dt="2022-09-27T14:50:15.598" v="3"/>
          <ac:spMkLst>
            <pc:docMk/>
            <pc:sldMk cId="1513429835" sldId="296"/>
            <ac:spMk id="214" creationId="{9F8AEAFE-BCF6-7591-05E6-3E943E0FC296}"/>
          </ac:spMkLst>
        </pc:spChg>
        <pc:spChg chg="mod">
          <ac:chgData name="Kumar, Vinod" userId="a0710a6e-bffc-4971-8893-1c23addeb5b0" providerId="ADAL" clId="{5EDA080F-2DA0-41E9-BDBC-F9DEF976E495}" dt="2022-09-27T14:50:15.598" v="3"/>
          <ac:spMkLst>
            <pc:docMk/>
            <pc:sldMk cId="1513429835" sldId="296"/>
            <ac:spMk id="219" creationId="{57B52F97-9D31-511E-8C51-E82B8DE25EA9}"/>
          </ac:spMkLst>
        </pc:spChg>
        <pc:spChg chg="mod">
          <ac:chgData name="Kumar, Vinod" userId="a0710a6e-bffc-4971-8893-1c23addeb5b0" providerId="ADAL" clId="{5EDA080F-2DA0-41E9-BDBC-F9DEF976E495}" dt="2022-09-27T14:50:15.598" v="3"/>
          <ac:spMkLst>
            <pc:docMk/>
            <pc:sldMk cId="1513429835" sldId="296"/>
            <ac:spMk id="220" creationId="{1BCEF7A7-ABBA-DEF6-5AAA-6B88FFE4CA0C}"/>
          </ac:spMkLst>
        </pc:spChg>
        <pc:spChg chg="mod">
          <ac:chgData name="Kumar, Vinod" userId="a0710a6e-bffc-4971-8893-1c23addeb5b0" providerId="ADAL" clId="{5EDA080F-2DA0-41E9-BDBC-F9DEF976E495}" dt="2022-09-27T14:50:15.598" v="3"/>
          <ac:spMkLst>
            <pc:docMk/>
            <pc:sldMk cId="1513429835" sldId="296"/>
            <ac:spMk id="222" creationId="{D485D25B-7AFB-74E8-A076-325616418FE6}"/>
          </ac:spMkLst>
        </pc:spChg>
        <pc:grpChg chg="add del mod">
          <ac:chgData name="Kumar, Vinod" userId="a0710a6e-bffc-4971-8893-1c23addeb5b0" providerId="ADAL" clId="{5EDA080F-2DA0-41E9-BDBC-F9DEF976E495}" dt="2022-09-27T14:51:43.812" v="14" actId="478"/>
          <ac:grpSpMkLst>
            <pc:docMk/>
            <pc:sldMk cId="1513429835" sldId="296"/>
            <ac:grpSpMk id="105" creationId="{3279D4D2-C8D1-8D01-ACFA-92D0AB2B7B87}"/>
          </ac:grpSpMkLst>
        </pc:grpChg>
        <pc:grpChg chg="del mod">
          <ac:chgData name="Kumar, Vinod" userId="a0710a6e-bffc-4971-8893-1c23addeb5b0" providerId="ADAL" clId="{5EDA080F-2DA0-41E9-BDBC-F9DEF976E495}" dt="2022-09-27T14:52:00.307" v="15" actId="478"/>
          <ac:grpSpMkLst>
            <pc:docMk/>
            <pc:sldMk cId="1513429835" sldId="296"/>
            <ac:grpSpMk id="112" creationId="{C88EDF49-F37E-DF1E-E095-3677A2C09FE8}"/>
          </ac:grpSpMkLst>
        </pc:grpChg>
        <pc:grpChg chg="mod">
          <ac:chgData name="Kumar, Vinod" userId="a0710a6e-bffc-4971-8893-1c23addeb5b0" providerId="ADAL" clId="{5EDA080F-2DA0-41E9-BDBC-F9DEF976E495}" dt="2022-09-27T14:47:56.106" v="1"/>
          <ac:grpSpMkLst>
            <pc:docMk/>
            <pc:sldMk cId="1513429835" sldId="296"/>
            <ac:grpSpMk id="113" creationId="{F614A824-DA7E-BC20-2BAE-70463796781D}"/>
          </ac:grpSpMkLst>
        </pc:grpChg>
        <pc:grpChg chg="mod">
          <ac:chgData name="Kumar, Vinod" userId="a0710a6e-bffc-4971-8893-1c23addeb5b0" providerId="ADAL" clId="{5EDA080F-2DA0-41E9-BDBC-F9DEF976E495}" dt="2022-09-27T14:47:56.106" v="1"/>
          <ac:grpSpMkLst>
            <pc:docMk/>
            <pc:sldMk cId="1513429835" sldId="296"/>
            <ac:grpSpMk id="120" creationId="{39F7DA56-C40A-78AF-0877-C7B5A94F2A40}"/>
          </ac:grpSpMkLst>
        </pc:grpChg>
        <pc:grpChg chg="del mod">
          <ac:chgData name="Kumar, Vinod" userId="a0710a6e-bffc-4971-8893-1c23addeb5b0" providerId="ADAL" clId="{5EDA080F-2DA0-41E9-BDBC-F9DEF976E495}" dt="2022-09-27T14:53:04.756" v="26" actId="165"/>
          <ac:grpSpMkLst>
            <pc:docMk/>
            <pc:sldMk cId="1513429835" sldId="296"/>
            <ac:grpSpMk id="128" creationId="{6228B59E-FD9C-0BE1-64FA-048250B7B0F1}"/>
          </ac:grpSpMkLst>
        </pc:grpChg>
        <pc:grpChg chg="mod topLvl">
          <ac:chgData name="Kumar, Vinod" userId="a0710a6e-bffc-4971-8893-1c23addeb5b0" providerId="ADAL" clId="{5EDA080F-2DA0-41E9-BDBC-F9DEF976E495}" dt="2022-09-27T14:53:04.756" v="26" actId="165"/>
          <ac:grpSpMkLst>
            <pc:docMk/>
            <pc:sldMk cId="1513429835" sldId="296"/>
            <ac:grpSpMk id="129" creationId="{41E56A81-D948-C22A-AB51-22C588E72106}"/>
          </ac:grpSpMkLst>
        </pc:grpChg>
        <pc:grpChg chg="mod">
          <ac:chgData name="Kumar, Vinod" userId="a0710a6e-bffc-4971-8893-1c23addeb5b0" providerId="ADAL" clId="{5EDA080F-2DA0-41E9-BDBC-F9DEF976E495}" dt="2022-09-27T14:53:04.756" v="26" actId="165"/>
          <ac:grpSpMkLst>
            <pc:docMk/>
            <pc:sldMk cId="1513429835" sldId="296"/>
            <ac:grpSpMk id="132" creationId="{6DD4B7D7-1366-C818-C791-F8D8F6729D1C}"/>
          </ac:grpSpMkLst>
        </pc:grpChg>
        <pc:grpChg chg="del mod">
          <ac:chgData name="Kumar, Vinod" userId="a0710a6e-bffc-4971-8893-1c23addeb5b0" providerId="ADAL" clId="{5EDA080F-2DA0-41E9-BDBC-F9DEF976E495}" dt="2022-09-27T14:53:09.589" v="27" actId="165"/>
          <ac:grpSpMkLst>
            <pc:docMk/>
            <pc:sldMk cId="1513429835" sldId="296"/>
            <ac:grpSpMk id="143" creationId="{092825CF-5AF8-6F53-3DDC-811FBD39496E}"/>
          </ac:grpSpMkLst>
        </pc:grpChg>
        <pc:grpChg chg="mod topLvl">
          <ac:chgData name="Kumar, Vinod" userId="a0710a6e-bffc-4971-8893-1c23addeb5b0" providerId="ADAL" clId="{5EDA080F-2DA0-41E9-BDBC-F9DEF976E495}" dt="2022-09-27T14:54:01.426" v="35" actId="1076"/>
          <ac:grpSpMkLst>
            <pc:docMk/>
            <pc:sldMk cId="1513429835" sldId="296"/>
            <ac:grpSpMk id="144" creationId="{219A7081-6BC6-3110-84E9-8C2DFC1C52A2}"/>
          </ac:grpSpMkLst>
        </pc:grpChg>
        <pc:grpChg chg="del mod">
          <ac:chgData name="Kumar, Vinod" userId="a0710a6e-bffc-4971-8893-1c23addeb5b0" providerId="ADAL" clId="{5EDA080F-2DA0-41E9-BDBC-F9DEF976E495}" dt="2022-09-27T14:53:12.261" v="28" actId="165"/>
          <ac:grpSpMkLst>
            <pc:docMk/>
            <pc:sldMk cId="1513429835" sldId="296"/>
            <ac:grpSpMk id="157" creationId="{AA3D57A1-3510-5912-4D1E-8BCF5C6B0EE5}"/>
          </ac:grpSpMkLst>
        </pc:grpChg>
        <pc:grpChg chg="mod topLvl">
          <ac:chgData name="Kumar, Vinod" userId="a0710a6e-bffc-4971-8893-1c23addeb5b0" providerId="ADAL" clId="{5EDA080F-2DA0-41E9-BDBC-F9DEF976E495}" dt="2022-09-27T14:53:12.261" v="28" actId="165"/>
          <ac:grpSpMkLst>
            <pc:docMk/>
            <pc:sldMk cId="1513429835" sldId="296"/>
            <ac:grpSpMk id="158" creationId="{CC97FC6C-4FAE-0D30-7835-E545987D49D5}"/>
          </ac:grpSpMkLst>
        </pc:grpChg>
        <pc:grpChg chg="mod">
          <ac:chgData name="Kumar, Vinod" userId="a0710a6e-bffc-4971-8893-1c23addeb5b0" providerId="ADAL" clId="{5EDA080F-2DA0-41E9-BDBC-F9DEF976E495}" dt="2022-09-27T14:53:12.261" v="28" actId="165"/>
          <ac:grpSpMkLst>
            <pc:docMk/>
            <pc:sldMk cId="1513429835" sldId="296"/>
            <ac:grpSpMk id="161" creationId="{9F1C7B66-FE79-1E43-FFDE-ECB99846F3F7}"/>
          </ac:grpSpMkLst>
        </pc:grpChg>
        <pc:grpChg chg="del mod">
          <ac:chgData name="Kumar, Vinod" userId="a0710a6e-bffc-4971-8893-1c23addeb5b0" providerId="ADAL" clId="{5EDA080F-2DA0-41E9-BDBC-F9DEF976E495}" dt="2022-09-27T14:53:15.204" v="29" actId="165"/>
          <ac:grpSpMkLst>
            <pc:docMk/>
            <pc:sldMk cId="1513429835" sldId="296"/>
            <ac:grpSpMk id="170" creationId="{6E2F71A3-5338-C2BF-CA23-0D2A148E14AE}"/>
          </ac:grpSpMkLst>
        </pc:grpChg>
        <pc:grpChg chg="mod topLvl">
          <ac:chgData name="Kumar, Vinod" userId="a0710a6e-bffc-4971-8893-1c23addeb5b0" providerId="ADAL" clId="{5EDA080F-2DA0-41E9-BDBC-F9DEF976E495}" dt="2022-09-27T14:53:15.204" v="29" actId="165"/>
          <ac:grpSpMkLst>
            <pc:docMk/>
            <pc:sldMk cId="1513429835" sldId="296"/>
            <ac:grpSpMk id="171" creationId="{73BABDFA-9595-0F4C-FDE5-F3DB909A320C}"/>
          </ac:grpSpMkLst>
        </pc:grpChg>
        <pc:grpChg chg="del mod">
          <ac:chgData name="Kumar, Vinod" userId="a0710a6e-bffc-4971-8893-1c23addeb5b0" providerId="ADAL" clId="{5EDA080F-2DA0-41E9-BDBC-F9DEF976E495}" dt="2022-09-27T14:53:20.189" v="30" actId="165"/>
          <ac:grpSpMkLst>
            <pc:docMk/>
            <pc:sldMk cId="1513429835" sldId="296"/>
            <ac:grpSpMk id="183" creationId="{1B7DE042-922A-7994-B103-57307CC27B6A}"/>
          </ac:grpSpMkLst>
        </pc:grpChg>
        <pc:grpChg chg="mod topLvl">
          <ac:chgData name="Kumar, Vinod" userId="a0710a6e-bffc-4971-8893-1c23addeb5b0" providerId="ADAL" clId="{5EDA080F-2DA0-41E9-BDBC-F9DEF976E495}" dt="2022-09-27T14:53:20.189" v="30" actId="165"/>
          <ac:grpSpMkLst>
            <pc:docMk/>
            <pc:sldMk cId="1513429835" sldId="296"/>
            <ac:grpSpMk id="184" creationId="{3726481C-FCCF-F40F-13AD-85325814045B}"/>
          </ac:grpSpMkLst>
        </pc:grpChg>
        <pc:grpChg chg="mod">
          <ac:chgData name="Kumar, Vinod" userId="a0710a6e-bffc-4971-8893-1c23addeb5b0" providerId="ADAL" clId="{5EDA080F-2DA0-41E9-BDBC-F9DEF976E495}" dt="2022-09-27T14:53:20.189" v="30" actId="165"/>
          <ac:grpSpMkLst>
            <pc:docMk/>
            <pc:sldMk cId="1513429835" sldId="296"/>
            <ac:grpSpMk id="186" creationId="{9B5CEFEA-0DBC-5553-008F-6CDCC1881B54}"/>
          </ac:grpSpMkLst>
        </pc:grpChg>
        <pc:grpChg chg="del mod">
          <ac:chgData name="Kumar, Vinod" userId="a0710a6e-bffc-4971-8893-1c23addeb5b0" providerId="ADAL" clId="{5EDA080F-2DA0-41E9-BDBC-F9DEF976E495}" dt="2022-09-27T14:53:23.380" v="31" actId="165"/>
          <ac:grpSpMkLst>
            <pc:docMk/>
            <pc:sldMk cId="1513429835" sldId="296"/>
            <ac:grpSpMk id="196" creationId="{2C4678AB-C3F5-9B96-5057-BBF941C1C877}"/>
          </ac:grpSpMkLst>
        </pc:grpChg>
        <pc:grpChg chg="mod topLvl">
          <ac:chgData name="Kumar, Vinod" userId="a0710a6e-bffc-4971-8893-1c23addeb5b0" providerId="ADAL" clId="{5EDA080F-2DA0-41E9-BDBC-F9DEF976E495}" dt="2022-09-27T14:53:23.380" v="31" actId="165"/>
          <ac:grpSpMkLst>
            <pc:docMk/>
            <pc:sldMk cId="1513429835" sldId="296"/>
            <ac:grpSpMk id="197" creationId="{08A95000-F8D0-CB11-684E-CD20AFB2EE56}"/>
          </ac:grpSpMkLst>
        </pc:grpChg>
        <pc:grpChg chg="del mod">
          <ac:chgData name="Kumar, Vinod" userId="a0710a6e-bffc-4971-8893-1c23addeb5b0" providerId="ADAL" clId="{5EDA080F-2DA0-41E9-BDBC-F9DEF976E495}" dt="2022-09-27T14:53:28.715" v="32" actId="165"/>
          <ac:grpSpMkLst>
            <pc:docMk/>
            <pc:sldMk cId="1513429835" sldId="296"/>
            <ac:grpSpMk id="207" creationId="{81E18EDB-5CE7-BF5F-398F-42F58D018FD3}"/>
          </ac:grpSpMkLst>
        </pc:grpChg>
        <pc:grpChg chg="del mod">
          <ac:chgData name="Kumar, Vinod" userId="a0710a6e-bffc-4971-8893-1c23addeb5b0" providerId="ADAL" clId="{5EDA080F-2DA0-41E9-BDBC-F9DEF976E495}" dt="2022-09-27T14:53:31.508" v="33" actId="165"/>
          <ac:grpSpMkLst>
            <pc:docMk/>
            <pc:sldMk cId="1513429835" sldId="296"/>
            <ac:grpSpMk id="210" creationId="{09C704EE-53C6-65F7-B0A6-AA85B9B3B7BE}"/>
          </ac:grpSpMkLst>
        </pc:grpChg>
        <pc:picChg chg="mod">
          <ac:chgData name="Kumar, Vinod" userId="a0710a6e-bffc-4971-8893-1c23addeb5b0" providerId="ADAL" clId="{5EDA080F-2DA0-41E9-BDBC-F9DEF976E495}" dt="2022-09-27T14:47:56.106" v="1"/>
          <ac:picMkLst>
            <pc:docMk/>
            <pc:sldMk cId="1513429835" sldId="296"/>
            <ac:picMk id="126" creationId="{8B5F09EB-3888-292D-2AAA-33A22B31FA63}"/>
          </ac:picMkLst>
        </pc:picChg>
        <pc:picChg chg="mod">
          <ac:chgData name="Kumar, Vinod" userId="a0710a6e-bffc-4971-8893-1c23addeb5b0" providerId="ADAL" clId="{5EDA080F-2DA0-41E9-BDBC-F9DEF976E495}" dt="2022-09-27T14:47:56.106" v="1"/>
          <ac:picMkLst>
            <pc:docMk/>
            <pc:sldMk cId="1513429835" sldId="296"/>
            <ac:picMk id="127" creationId="{B4745E63-AAA6-C33D-645A-75213F9DC643}"/>
          </ac:picMkLst>
        </pc:picChg>
        <pc:picChg chg="mod">
          <ac:chgData name="Kumar, Vinod" userId="a0710a6e-bffc-4971-8893-1c23addeb5b0" providerId="ADAL" clId="{5EDA080F-2DA0-41E9-BDBC-F9DEF976E495}" dt="2022-09-27T14:53:04.756" v="26" actId="165"/>
          <ac:picMkLst>
            <pc:docMk/>
            <pc:sldMk cId="1513429835" sldId="296"/>
            <ac:picMk id="133" creationId="{6BB21D46-74AD-33DD-20B9-5B2345822439}"/>
          </ac:picMkLst>
        </pc:picChg>
        <pc:picChg chg="mod">
          <ac:chgData name="Kumar, Vinod" userId="a0710a6e-bffc-4971-8893-1c23addeb5b0" providerId="ADAL" clId="{5EDA080F-2DA0-41E9-BDBC-F9DEF976E495}" dt="2022-09-27T14:53:04.756" v="26" actId="165"/>
          <ac:picMkLst>
            <pc:docMk/>
            <pc:sldMk cId="1513429835" sldId="296"/>
            <ac:picMk id="134" creationId="{E4E11DEA-AC96-F4B9-9387-900AC134509F}"/>
          </ac:picMkLst>
        </pc:picChg>
        <pc:picChg chg="mod">
          <ac:chgData name="Kumar, Vinod" userId="a0710a6e-bffc-4971-8893-1c23addeb5b0" providerId="ADAL" clId="{5EDA080F-2DA0-41E9-BDBC-F9DEF976E495}" dt="2022-09-27T14:53:04.756" v="26" actId="165"/>
          <ac:picMkLst>
            <pc:docMk/>
            <pc:sldMk cId="1513429835" sldId="296"/>
            <ac:picMk id="135" creationId="{9EECE7A6-60F4-87A9-3708-673BABB77DBD}"/>
          </ac:picMkLst>
        </pc:picChg>
        <pc:picChg chg="mod">
          <ac:chgData name="Kumar, Vinod" userId="a0710a6e-bffc-4971-8893-1c23addeb5b0" providerId="ADAL" clId="{5EDA080F-2DA0-41E9-BDBC-F9DEF976E495}" dt="2022-09-27T14:53:04.756" v="26" actId="165"/>
          <ac:picMkLst>
            <pc:docMk/>
            <pc:sldMk cId="1513429835" sldId="296"/>
            <ac:picMk id="136" creationId="{5C9E7C40-7B09-628A-75B8-D1FC1EA21EB2}"/>
          </ac:picMkLst>
        </pc:picChg>
        <pc:picChg chg="mod">
          <ac:chgData name="Kumar, Vinod" userId="a0710a6e-bffc-4971-8893-1c23addeb5b0" providerId="ADAL" clId="{5EDA080F-2DA0-41E9-BDBC-F9DEF976E495}" dt="2022-09-27T14:53:09.589" v="27" actId="165"/>
          <ac:picMkLst>
            <pc:docMk/>
            <pc:sldMk cId="1513429835" sldId="296"/>
            <ac:picMk id="146" creationId="{A9B3B443-A127-1CFD-8EB8-F5E137063352}"/>
          </ac:picMkLst>
        </pc:picChg>
        <pc:picChg chg="mod">
          <ac:chgData name="Kumar, Vinod" userId="a0710a6e-bffc-4971-8893-1c23addeb5b0" providerId="ADAL" clId="{5EDA080F-2DA0-41E9-BDBC-F9DEF976E495}" dt="2022-09-27T14:53:09.589" v="27" actId="165"/>
          <ac:picMkLst>
            <pc:docMk/>
            <pc:sldMk cId="1513429835" sldId="296"/>
            <ac:picMk id="147" creationId="{9E4D7423-4221-BEA7-00D2-B6F406A48C85}"/>
          </ac:picMkLst>
        </pc:picChg>
        <pc:picChg chg="mod">
          <ac:chgData name="Kumar, Vinod" userId="a0710a6e-bffc-4971-8893-1c23addeb5b0" providerId="ADAL" clId="{5EDA080F-2DA0-41E9-BDBC-F9DEF976E495}" dt="2022-09-27T14:53:09.589" v="27" actId="165"/>
          <ac:picMkLst>
            <pc:docMk/>
            <pc:sldMk cId="1513429835" sldId="296"/>
            <ac:picMk id="148" creationId="{2524235C-475E-B8AA-303D-06735451E44E}"/>
          </ac:picMkLst>
        </pc:picChg>
        <pc:picChg chg="mod">
          <ac:chgData name="Kumar, Vinod" userId="a0710a6e-bffc-4971-8893-1c23addeb5b0" providerId="ADAL" clId="{5EDA080F-2DA0-41E9-BDBC-F9DEF976E495}" dt="2022-09-27T14:53:09.589" v="27" actId="165"/>
          <ac:picMkLst>
            <pc:docMk/>
            <pc:sldMk cId="1513429835" sldId="296"/>
            <ac:picMk id="149" creationId="{D31ABD3F-5AEF-08E2-881F-E78E2955477C}"/>
          </ac:picMkLst>
        </pc:picChg>
        <pc:picChg chg="mod">
          <ac:chgData name="Kumar, Vinod" userId="a0710a6e-bffc-4971-8893-1c23addeb5b0" providerId="ADAL" clId="{5EDA080F-2DA0-41E9-BDBC-F9DEF976E495}" dt="2022-09-27T14:53:12.261" v="28" actId="165"/>
          <ac:picMkLst>
            <pc:docMk/>
            <pc:sldMk cId="1513429835" sldId="296"/>
            <ac:picMk id="164" creationId="{ECA4E429-64D9-8987-40E7-807467843659}"/>
          </ac:picMkLst>
        </pc:picChg>
        <pc:picChg chg="mod">
          <ac:chgData name="Kumar, Vinod" userId="a0710a6e-bffc-4971-8893-1c23addeb5b0" providerId="ADAL" clId="{5EDA080F-2DA0-41E9-BDBC-F9DEF976E495}" dt="2022-09-27T14:53:12.261" v="28" actId="165"/>
          <ac:picMkLst>
            <pc:docMk/>
            <pc:sldMk cId="1513429835" sldId="296"/>
            <ac:picMk id="165" creationId="{1109FEFA-06B1-FC75-6BED-8DC550442DB8}"/>
          </ac:picMkLst>
        </pc:picChg>
        <pc:picChg chg="mod">
          <ac:chgData name="Kumar, Vinod" userId="a0710a6e-bffc-4971-8893-1c23addeb5b0" providerId="ADAL" clId="{5EDA080F-2DA0-41E9-BDBC-F9DEF976E495}" dt="2022-09-27T14:53:12.261" v="28" actId="165"/>
          <ac:picMkLst>
            <pc:docMk/>
            <pc:sldMk cId="1513429835" sldId="296"/>
            <ac:picMk id="167" creationId="{3177AAA6-8924-0000-4CAE-9A12920291B6}"/>
          </ac:picMkLst>
        </pc:picChg>
        <pc:picChg chg="mod">
          <ac:chgData name="Kumar, Vinod" userId="a0710a6e-bffc-4971-8893-1c23addeb5b0" providerId="ADAL" clId="{5EDA080F-2DA0-41E9-BDBC-F9DEF976E495}" dt="2022-09-27T14:53:15.204" v="29" actId="165"/>
          <ac:picMkLst>
            <pc:docMk/>
            <pc:sldMk cId="1513429835" sldId="296"/>
            <ac:picMk id="179" creationId="{7E3A8902-3D9A-1B3A-16E7-10FFD1326759}"/>
          </ac:picMkLst>
        </pc:picChg>
        <pc:picChg chg="mod">
          <ac:chgData name="Kumar, Vinod" userId="a0710a6e-bffc-4971-8893-1c23addeb5b0" providerId="ADAL" clId="{5EDA080F-2DA0-41E9-BDBC-F9DEF976E495}" dt="2022-09-27T14:53:15.204" v="29" actId="165"/>
          <ac:picMkLst>
            <pc:docMk/>
            <pc:sldMk cId="1513429835" sldId="296"/>
            <ac:picMk id="182" creationId="{450D1257-7022-0E83-3FC5-0074BC840755}"/>
          </ac:picMkLst>
        </pc:picChg>
        <pc:picChg chg="mod">
          <ac:chgData name="Kumar, Vinod" userId="a0710a6e-bffc-4971-8893-1c23addeb5b0" providerId="ADAL" clId="{5EDA080F-2DA0-41E9-BDBC-F9DEF976E495}" dt="2022-09-27T14:53:20.189" v="30" actId="165"/>
          <ac:picMkLst>
            <pc:docMk/>
            <pc:sldMk cId="1513429835" sldId="296"/>
            <ac:picMk id="188" creationId="{D8CC0F74-181B-D48B-4C0C-2976ABBC4439}"/>
          </ac:picMkLst>
        </pc:picChg>
        <pc:picChg chg="mod">
          <ac:chgData name="Kumar, Vinod" userId="a0710a6e-bffc-4971-8893-1c23addeb5b0" providerId="ADAL" clId="{5EDA080F-2DA0-41E9-BDBC-F9DEF976E495}" dt="2022-09-27T14:53:20.189" v="30" actId="165"/>
          <ac:picMkLst>
            <pc:docMk/>
            <pc:sldMk cId="1513429835" sldId="296"/>
            <ac:picMk id="195" creationId="{C1B4C22C-A06C-4B9A-BE29-9CE99FAFD77D}"/>
          </ac:picMkLst>
        </pc:picChg>
        <pc:picChg chg="mod">
          <ac:chgData name="Kumar, Vinod" userId="a0710a6e-bffc-4971-8893-1c23addeb5b0" providerId="ADAL" clId="{5EDA080F-2DA0-41E9-BDBC-F9DEF976E495}" dt="2022-09-27T14:53:23.380" v="31" actId="165"/>
          <ac:picMkLst>
            <pc:docMk/>
            <pc:sldMk cId="1513429835" sldId="296"/>
            <ac:picMk id="199" creationId="{D0F6B27C-CA07-F68A-34A8-052C9F35A54C}"/>
          </ac:picMkLst>
        </pc:picChg>
        <pc:picChg chg="mod">
          <ac:chgData name="Kumar, Vinod" userId="a0710a6e-bffc-4971-8893-1c23addeb5b0" providerId="ADAL" clId="{5EDA080F-2DA0-41E9-BDBC-F9DEF976E495}" dt="2022-09-27T14:53:23.380" v="31" actId="165"/>
          <ac:picMkLst>
            <pc:docMk/>
            <pc:sldMk cId="1513429835" sldId="296"/>
            <ac:picMk id="200" creationId="{1E420504-63E9-E940-D3A6-654A616DBA18}"/>
          </ac:picMkLst>
        </pc:picChg>
        <pc:picChg chg="mod">
          <ac:chgData name="Kumar, Vinod" userId="a0710a6e-bffc-4971-8893-1c23addeb5b0" providerId="ADAL" clId="{5EDA080F-2DA0-41E9-BDBC-F9DEF976E495}" dt="2022-09-27T14:53:23.380" v="31" actId="165"/>
          <ac:picMkLst>
            <pc:docMk/>
            <pc:sldMk cId="1513429835" sldId="296"/>
            <ac:picMk id="201" creationId="{159C432F-761C-AE0A-3AC5-B87F45BA0A89}"/>
          </ac:picMkLst>
        </pc:picChg>
        <pc:picChg chg="mod topLvl">
          <ac:chgData name="Kumar, Vinod" userId="a0710a6e-bffc-4971-8893-1c23addeb5b0" providerId="ADAL" clId="{5EDA080F-2DA0-41E9-BDBC-F9DEF976E495}" dt="2022-09-27T14:53:28.715" v="32" actId="165"/>
          <ac:picMkLst>
            <pc:docMk/>
            <pc:sldMk cId="1513429835" sldId="296"/>
            <ac:picMk id="208" creationId="{3169485E-7F97-7D3A-05E0-9D7B13B70C1A}"/>
          </ac:picMkLst>
        </pc:picChg>
        <pc:picChg chg="mod topLvl">
          <ac:chgData name="Kumar, Vinod" userId="a0710a6e-bffc-4971-8893-1c23addeb5b0" providerId="ADAL" clId="{5EDA080F-2DA0-41E9-BDBC-F9DEF976E495}" dt="2022-09-27T14:53:31.508" v="33" actId="165"/>
          <ac:picMkLst>
            <pc:docMk/>
            <pc:sldMk cId="1513429835" sldId="296"/>
            <ac:picMk id="211" creationId="{F54D56F9-3BA2-5618-1F99-5F5706F87163}"/>
          </ac:picMkLst>
        </pc:picChg>
        <pc:picChg chg="mod">
          <ac:chgData name="Kumar, Vinod" userId="a0710a6e-bffc-4971-8893-1c23addeb5b0" providerId="ADAL" clId="{5EDA080F-2DA0-41E9-BDBC-F9DEF976E495}" dt="2022-09-27T14:50:15.598" v="3"/>
          <ac:picMkLst>
            <pc:docMk/>
            <pc:sldMk cId="1513429835" sldId="296"/>
            <ac:picMk id="215" creationId="{64DB23B9-703B-EFD1-E4D1-D829C50ED806}"/>
          </ac:picMkLst>
        </pc:picChg>
        <pc:picChg chg="mod">
          <ac:chgData name="Kumar, Vinod" userId="a0710a6e-bffc-4971-8893-1c23addeb5b0" providerId="ADAL" clId="{5EDA080F-2DA0-41E9-BDBC-F9DEF976E495}" dt="2022-09-27T14:50:15.598" v="3"/>
          <ac:picMkLst>
            <pc:docMk/>
            <pc:sldMk cId="1513429835" sldId="296"/>
            <ac:picMk id="216" creationId="{7C7AA6A8-7735-0540-DB2D-5CC8B7E40E9F}"/>
          </ac:picMkLst>
        </pc:picChg>
        <pc:picChg chg="mod">
          <ac:chgData name="Kumar, Vinod" userId="a0710a6e-bffc-4971-8893-1c23addeb5b0" providerId="ADAL" clId="{5EDA080F-2DA0-41E9-BDBC-F9DEF976E495}" dt="2022-09-27T14:50:15.598" v="3"/>
          <ac:picMkLst>
            <pc:docMk/>
            <pc:sldMk cId="1513429835" sldId="296"/>
            <ac:picMk id="221" creationId="{5CA1623E-DB42-2609-3E1C-62611B7DA5A4}"/>
          </ac:picMkLst>
        </pc:picChg>
        <pc:cxnChg chg="mod">
          <ac:chgData name="Kumar, Vinod" userId="a0710a6e-bffc-4971-8893-1c23addeb5b0" providerId="ADAL" clId="{5EDA080F-2DA0-41E9-BDBC-F9DEF976E495}" dt="2022-09-27T14:47:56.106" v="1"/>
          <ac:cxnSpMkLst>
            <pc:docMk/>
            <pc:sldMk cId="1513429835" sldId="296"/>
            <ac:cxnSpMk id="121" creationId="{5F0BB2EE-45DA-D958-1ED9-099A50B57765}"/>
          </ac:cxnSpMkLst>
        </pc:cxnChg>
        <pc:cxnChg chg="mod">
          <ac:chgData name="Kumar, Vinod" userId="a0710a6e-bffc-4971-8893-1c23addeb5b0" providerId="ADAL" clId="{5EDA080F-2DA0-41E9-BDBC-F9DEF976E495}" dt="2022-09-27T14:47:56.106" v="1"/>
          <ac:cxnSpMkLst>
            <pc:docMk/>
            <pc:sldMk cId="1513429835" sldId="296"/>
            <ac:cxnSpMk id="122" creationId="{DA28D257-E0E3-5E4E-7FFA-8AE42B9C8D08}"/>
          </ac:cxnSpMkLst>
        </pc:cxnChg>
        <pc:cxnChg chg="mod">
          <ac:chgData name="Kumar, Vinod" userId="a0710a6e-bffc-4971-8893-1c23addeb5b0" providerId="ADAL" clId="{5EDA080F-2DA0-41E9-BDBC-F9DEF976E495}" dt="2022-09-27T14:53:04.756" v="26" actId="165"/>
          <ac:cxnSpMkLst>
            <pc:docMk/>
            <pc:sldMk cId="1513429835" sldId="296"/>
            <ac:cxnSpMk id="139" creationId="{B3CC9BCE-D6C7-D1B0-C3AD-404517574B87}"/>
          </ac:cxnSpMkLst>
        </pc:cxnChg>
        <pc:cxnChg chg="mod">
          <ac:chgData name="Kumar, Vinod" userId="a0710a6e-bffc-4971-8893-1c23addeb5b0" providerId="ADAL" clId="{5EDA080F-2DA0-41E9-BDBC-F9DEF976E495}" dt="2022-09-27T14:53:09.589" v="27" actId="165"/>
          <ac:cxnSpMkLst>
            <pc:docMk/>
            <pc:sldMk cId="1513429835" sldId="296"/>
            <ac:cxnSpMk id="153" creationId="{246345EE-C72A-19C0-C5D4-E2701EE2401A}"/>
          </ac:cxnSpMkLst>
        </pc:cxnChg>
        <pc:cxnChg chg="mod">
          <ac:chgData name="Kumar, Vinod" userId="a0710a6e-bffc-4971-8893-1c23addeb5b0" providerId="ADAL" clId="{5EDA080F-2DA0-41E9-BDBC-F9DEF976E495}" dt="2022-09-27T14:53:12.261" v="28" actId="165"/>
          <ac:cxnSpMkLst>
            <pc:docMk/>
            <pc:sldMk cId="1513429835" sldId="296"/>
            <ac:cxnSpMk id="169" creationId="{632DBBC9-CC60-4279-E291-51DFDB2EFD8C}"/>
          </ac:cxnSpMkLst>
        </pc:cxnChg>
        <pc:cxnChg chg="mod">
          <ac:chgData name="Kumar, Vinod" userId="a0710a6e-bffc-4971-8893-1c23addeb5b0" providerId="ADAL" clId="{5EDA080F-2DA0-41E9-BDBC-F9DEF976E495}" dt="2022-09-27T14:53:15.204" v="29" actId="165"/>
          <ac:cxnSpMkLst>
            <pc:docMk/>
            <pc:sldMk cId="1513429835" sldId="296"/>
            <ac:cxnSpMk id="174" creationId="{E1771D5B-8B00-27F1-ED5C-8B0023A4F553}"/>
          </ac:cxnSpMkLst>
        </pc:cxnChg>
        <pc:cxnChg chg="mod">
          <ac:chgData name="Kumar, Vinod" userId="a0710a6e-bffc-4971-8893-1c23addeb5b0" providerId="ADAL" clId="{5EDA080F-2DA0-41E9-BDBC-F9DEF976E495}" dt="2022-09-27T14:53:15.204" v="29" actId="165"/>
          <ac:cxnSpMkLst>
            <pc:docMk/>
            <pc:sldMk cId="1513429835" sldId="296"/>
            <ac:cxnSpMk id="175" creationId="{C3521ED4-D907-B87A-477A-6954BC81927D}"/>
          </ac:cxnSpMkLst>
        </pc:cxnChg>
        <pc:cxnChg chg="mod">
          <ac:chgData name="Kumar, Vinod" userId="a0710a6e-bffc-4971-8893-1c23addeb5b0" providerId="ADAL" clId="{5EDA080F-2DA0-41E9-BDBC-F9DEF976E495}" dt="2022-09-27T14:53:15.204" v="29" actId="165"/>
          <ac:cxnSpMkLst>
            <pc:docMk/>
            <pc:sldMk cId="1513429835" sldId="296"/>
            <ac:cxnSpMk id="177" creationId="{9A4DD502-94C9-9EE7-8799-787550053A2F}"/>
          </ac:cxnSpMkLst>
        </pc:cxnChg>
        <pc:cxnChg chg="mod">
          <ac:chgData name="Kumar, Vinod" userId="a0710a6e-bffc-4971-8893-1c23addeb5b0" providerId="ADAL" clId="{5EDA080F-2DA0-41E9-BDBC-F9DEF976E495}" dt="2022-09-27T14:53:20.189" v="30" actId="165"/>
          <ac:cxnSpMkLst>
            <pc:docMk/>
            <pc:sldMk cId="1513429835" sldId="296"/>
            <ac:cxnSpMk id="193" creationId="{A5AFE87E-8013-B98C-BD5B-EB56A8A10678}"/>
          </ac:cxnSpMkLst>
        </pc:cxnChg>
        <pc:cxnChg chg="mod">
          <ac:chgData name="Kumar, Vinod" userId="a0710a6e-bffc-4971-8893-1c23addeb5b0" providerId="ADAL" clId="{5EDA080F-2DA0-41E9-BDBC-F9DEF976E495}" dt="2022-09-27T14:53:20.189" v="30" actId="165"/>
          <ac:cxnSpMkLst>
            <pc:docMk/>
            <pc:sldMk cId="1513429835" sldId="296"/>
            <ac:cxnSpMk id="194" creationId="{0267DAEA-E3AE-BCBE-53FA-B278E6BF51F8}"/>
          </ac:cxnSpMkLst>
        </pc:cxnChg>
        <pc:cxnChg chg="mod">
          <ac:chgData name="Kumar, Vinod" userId="a0710a6e-bffc-4971-8893-1c23addeb5b0" providerId="ADAL" clId="{5EDA080F-2DA0-41E9-BDBC-F9DEF976E495}" dt="2022-09-27T14:50:15.598" v="3"/>
          <ac:cxnSpMkLst>
            <pc:docMk/>
            <pc:sldMk cId="1513429835" sldId="296"/>
            <ac:cxnSpMk id="217" creationId="{B14620FF-2EDF-194C-C6DA-9CC86744D1B1}"/>
          </ac:cxnSpMkLst>
        </pc:cxnChg>
        <pc:cxnChg chg="mod">
          <ac:chgData name="Kumar, Vinod" userId="a0710a6e-bffc-4971-8893-1c23addeb5b0" providerId="ADAL" clId="{5EDA080F-2DA0-41E9-BDBC-F9DEF976E495}" dt="2022-09-27T14:50:15.598" v="3"/>
          <ac:cxnSpMkLst>
            <pc:docMk/>
            <pc:sldMk cId="1513429835" sldId="296"/>
            <ac:cxnSpMk id="218" creationId="{25BBBB67-2A78-A1A1-EEEF-B0513A77FD3E}"/>
          </ac:cxnSpMkLst>
        </pc:cxnChg>
      </pc:sldChg>
      <pc:sldChg chg="addSp delSp modSp mod">
        <pc:chgData name="Kumar, Vinod" userId="a0710a6e-bffc-4971-8893-1c23addeb5b0" providerId="ADAL" clId="{5EDA080F-2DA0-41E9-BDBC-F9DEF976E495}" dt="2022-09-27T15:23:15.796" v="1883" actId="478"/>
        <pc:sldMkLst>
          <pc:docMk/>
          <pc:sldMk cId="2940357804" sldId="297"/>
        </pc:sldMkLst>
        <pc:spChg chg="mod">
          <ac:chgData name="Kumar, Vinod" userId="a0710a6e-bffc-4971-8893-1c23addeb5b0" providerId="ADAL" clId="{5EDA080F-2DA0-41E9-BDBC-F9DEF976E495}" dt="2022-09-27T15:16:28.456" v="999" actId="164"/>
          <ac:spMkLst>
            <pc:docMk/>
            <pc:sldMk cId="2940357804" sldId="297"/>
            <ac:spMk id="2" creationId="{0B2B87A8-869C-4317-2DF0-7431E94D248E}"/>
          </ac:spMkLst>
        </pc:spChg>
        <pc:spChg chg="mod topLvl">
          <ac:chgData name="Kumar, Vinod" userId="a0710a6e-bffc-4971-8893-1c23addeb5b0" providerId="ADAL" clId="{5EDA080F-2DA0-41E9-BDBC-F9DEF976E495}" dt="2022-09-27T15:16:02.752" v="903" actId="164"/>
          <ac:spMkLst>
            <pc:docMk/>
            <pc:sldMk cId="2940357804" sldId="297"/>
            <ac:spMk id="23" creationId="{E34157A0-5335-7F3C-4DAB-1E2AE6466B29}"/>
          </ac:spMkLst>
        </pc:spChg>
        <pc:spChg chg="mod topLvl">
          <ac:chgData name="Kumar, Vinod" userId="a0710a6e-bffc-4971-8893-1c23addeb5b0" providerId="ADAL" clId="{5EDA080F-2DA0-41E9-BDBC-F9DEF976E495}" dt="2022-09-27T15:16:06.704" v="904" actId="164"/>
          <ac:spMkLst>
            <pc:docMk/>
            <pc:sldMk cId="2940357804" sldId="297"/>
            <ac:spMk id="24" creationId="{69D40ED0-F8C8-D857-EC98-3C834355C7D0}"/>
          </ac:spMkLst>
        </pc:spChg>
        <pc:spChg chg="mod">
          <ac:chgData name="Kumar, Vinod" userId="a0710a6e-bffc-4971-8893-1c23addeb5b0" providerId="ADAL" clId="{5EDA080F-2DA0-41E9-BDBC-F9DEF976E495}" dt="2022-09-27T15:20:38.700" v="1502" actId="1076"/>
          <ac:spMkLst>
            <pc:docMk/>
            <pc:sldMk cId="2940357804" sldId="297"/>
            <ac:spMk id="83" creationId="{E58A24D0-96A1-E362-831F-90DFFC5F3F34}"/>
          </ac:spMkLst>
        </pc:spChg>
        <pc:spChg chg="mod topLvl">
          <ac:chgData name="Kumar, Vinod" userId="a0710a6e-bffc-4971-8893-1c23addeb5b0" providerId="ADAL" clId="{5EDA080F-2DA0-41E9-BDBC-F9DEF976E495}" dt="2022-09-27T15:20:58.324" v="1631" actId="1038"/>
          <ac:spMkLst>
            <pc:docMk/>
            <pc:sldMk cId="2940357804" sldId="297"/>
            <ac:spMk id="84" creationId="{268AC11B-C4F9-2F6B-FF8F-192EAF443323}"/>
          </ac:spMkLst>
        </pc:spChg>
        <pc:spChg chg="mod topLvl">
          <ac:chgData name="Kumar, Vinod" userId="a0710a6e-bffc-4971-8893-1c23addeb5b0" providerId="ADAL" clId="{5EDA080F-2DA0-41E9-BDBC-F9DEF976E495}" dt="2022-09-27T15:21:12.036" v="1641" actId="1037"/>
          <ac:spMkLst>
            <pc:docMk/>
            <pc:sldMk cId="2940357804" sldId="297"/>
            <ac:spMk id="85" creationId="{4A986DD3-D094-666C-684F-6F2016CC39D2}"/>
          </ac:spMkLst>
        </pc:spChg>
        <pc:spChg chg="mod topLvl">
          <ac:chgData name="Kumar, Vinod" userId="a0710a6e-bffc-4971-8893-1c23addeb5b0" providerId="ADAL" clId="{5EDA080F-2DA0-41E9-BDBC-F9DEF976E495}" dt="2022-09-27T15:22:13.603" v="1878" actId="1035"/>
          <ac:spMkLst>
            <pc:docMk/>
            <pc:sldMk cId="2940357804" sldId="297"/>
            <ac:spMk id="86" creationId="{9C52924C-0B52-5997-C58D-2D1AA75640C5}"/>
          </ac:spMkLst>
        </pc:spChg>
        <pc:spChg chg="mod topLvl">
          <ac:chgData name="Kumar, Vinod" userId="a0710a6e-bffc-4971-8893-1c23addeb5b0" providerId="ADAL" clId="{5EDA080F-2DA0-41E9-BDBC-F9DEF976E495}" dt="2022-09-27T15:22:09.636" v="1876" actId="1037"/>
          <ac:spMkLst>
            <pc:docMk/>
            <pc:sldMk cId="2940357804" sldId="297"/>
            <ac:spMk id="87" creationId="{94D37293-18A5-7325-6B95-B40A9B17B375}"/>
          </ac:spMkLst>
        </pc:spChg>
        <pc:spChg chg="mod topLvl">
          <ac:chgData name="Kumar, Vinod" userId="a0710a6e-bffc-4971-8893-1c23addeb5b0" providerId="ADAL" clId="{5EDA080F-2DA0-41E9-BDBC-F9DEF976E495}" dt="2022-09-27T15:21:58.804" v="1869" actId="1036"/>
          <ac:spMkLst>
            <pc:docMk/>
            <pc:sldMk cId="2940357804" sldId="297"/>
            <ac:spMk id="88" creationId="{CAC2C618-7D71-1724-06E7-9F8AD47F396F}"/>
          </ac:spMkLst>
        </pc:spChg>
        <pc:spChg chg="mod topLvl">
          <ac:chgData name="Kumar, Vinod" userId="a0710a6e-bffc-4971-8893-1c23addeb5b0" providerId="ADAL" clId="{5EDA080F-2DA0-41E9-BDBC-F9DEF976E495}" dt="2022-09-27T15:22:04.132" v="1872" actId="1038"/>
          <ac:spMkLst>
            <pc:docMk/>
            <pc:sldMk cId="2940357804" sldId="297"/>
            <ac:spMk id="89" creationId="{05532DAD-C191-1E14-3307-0B3021E5F901}"/>
          </ac:spMkLst>
        </pc:spChg>
        <pc:grpChg chg="del mod">
          <ac:chgData name="Kumar, Vinod" userId="a0710a6e-bffc-4971-8893-1c23addeb5b0" providerId="ADAL" clId="{5EDA080F-2DA0-41E9-BDBC-F9DEF976E495}" dt="2022-09-27T15:14:55.953" v="870" actId="165"/>
          <ac:grpSpMkLst>
            <pc:docMk/>
            <pc:sldMk cId="2940357804" sldId="297"/>
            <ac:grpSpMk id="3" creationId="{B0F9075D-59BD-1209-B16F-36CA6F970470}"/>
          </ac:grpSpMkLst>
        </pc:grpChg>
        <pc:grpChg chg="del mod">
          <ac:chgData name="Kumar, Vinod" userId="a0710a6e-bffc-4971-8893-1c23addeb5b0" providerId="ADAL" clId="{5EDA080F-2DA0-41E9-BDBC-F9DEF976E495}" dt="2022-09-27T15:14:55.953" v="870" actId="165"/>
          <ac:grpSpMkLst>
            <pc:docMk/>
            <pc:sldMk cId="2940357804" sldId="297"/>
            <ac:grpSpMk id="4" creationId="{FD34A456-87AA-5503-691C-92893C8A2A08}"/>
          </ac:grpSpMkLst>
        </pc:grpChg>
        <pc:grpChg chg="add del mod">
          <ac:chgData name="Kumar, Vinod" userId="a0710a6e-bffc-4971-8893-1c23addeb5b0" providerId="ADAL" clId="{5EDA080F-2DA0-41E9-BDBC-F9DEF976E495}" dt="2022-09-27T15:23:15.796" v="1883" actId="478"/>
          <ac:grpSpMkLst>
            <pc:docMk/>
            <pc:sldMk cId="2940357804" sldId="297"/>
            <ac:grpSpMk id="5" creationId="{FB272C96-716F-94A4-BD13-BE0351651D27}"/>
          </ac:grpSpMkLst>
        </pc:grpChg>
        <pc:grpChg chg="add del mod">
          <ac:chgData name="Kumar, Vinod" userId="a0710a6e-bffc-4971-8893-1c23addeb5b0" providerId="ADAL" clId="{5EDA080F-2DA0-41E9-BDBC-F9DEF976E495}" dt="2022-09-27T15:23:15.796" v="1883" actId="478"/>
          <ac:grpSpMkLst>
            <pc:docMk/>
            <pc:sldMk cId="2940357804" sldId="297"/>
            <ac:grpSpMk id="6" creationId="{86778B1E-F9D6-C9D2-B6FB-9E9FC637CA62}"/>
          </ac:grpSpMkLst>
        </pc:grpChg>
        <pc:grpChg chg="add del mod">
          <ac:chgData name="Kumar, Vinod" userId="a0710a6e-bffc-4971-8893-1c23addeb5b0" providerId="ADAL" clId="{5EDA080F-2DA0-41E9-BDBC-F9DEF976E495}" dt="2022-09-27T15:23:15.796" v="1883" actId="478"/>
          <ac:grpSpMkLst>
            <pc:docMk/>
            <pc:sldMk cId="2940357804" sldId="297"/>
            <ac:grpSpMk id="7" creationId="{E2C2B900-9600-00A4-B1CC-ABF7812B3FB6}"/>
          </ac:grpSpMkLst>
        </pc:grpChg>
        <pc:grpChg chg="add del mod topLvl">
          <ac:chgData name="Kumar, Vinod" userId="a0710a6e-bffc-4971-8893-1c23addeb5b0" providerId="ADAL" clId="{5EDA080F-2DA0-41E9-BDBC-F9DEF976E495}" dt="2022-09-27T15:15:53.881" v="902" actId="165"/>
          <ac:grpSpMkLst>
            <pc:docMk/>
            <pc:sldMk cId="2940357804" sldId="297"/>
            <ac:grpSpMk id="90" creationId="{19680E52-21AF-9D52-43BC-15236EC729A7}"/>
          </ac:grpSpMkLst>
        </pc:grpChg>
        <pc:grpChg chg="del mod topLvl">
          <ac:chgData name="Kumar, Vinod" userId="a0710a6e-bffc-4971-8893-1c23addeb5b0" providerId="ADAL" clId="{5EDA080F-2DA0-41E9-BDBC-F9DEF976E495}" dt="2022-09-27T15:15:35.400" v="871" actId="165"/>
          <ac:grpSpMkLst>
            <pc:docMk/>
            <pc:sldMk cId="2940357804" sldId="297"/>
            <ac:grpSpMk id="91" creationId="{F3941455-4ECD-3715-E514-41131176D25A}"/>
          </ac:grpSpMkLst>
        </pc:grpChg>
        <pc:grpChg chg="del mod">
          <ac:chgData name="Kumar, Vinod" userId="a0710a6e-bffc-4971-8893-1c23addeb5b0" providerId="ADAL" clId="{5EDA080F-2DA0-41E9-BDBC-F9DEF976E495}" dt="2022-09-27T15:14:55.953" v="870" actId="165"/>
          <ac:grpSpMkLst>
            <pc:docMk/>
            <pc:sldMk cId="2940357804" sldId="297"/>
            <ac:grpSpMk id="92" creationId="{5D2984C5-8377-BC4D-A865-5E146A1E64C0}"/>
          </ac:grpSpMkLst>
        </pc:grpChg>
        <pc:grpChg chg="del mod">
          <ac:chgData name="Kumar, Vinod" userId="a0710a6e-bffc-4971-8893-1c23addeb5b0" providerId="ADAL" clId="{5EDA080F-2DA0-41E9-BDBC-F9DEF976E495}" dt="2022-09-27T15:14:55.953" v="870" actId="165"/>
          <ac:grpSpMkLst>
            <pc:docMk/>
            <pc:sldMk cId="2940357804" sldId="297"/>
            <ac:grpSpMk id="93" creationId="{B9649B43-ED41-AFB1-E79A-7343E909B5CF}"/>
          </ac:grpSpMkLst>
        </pc:grpChg>
        <pc:grpChg chg="del mod">
          <ac:chgData name="Kumar, Vinod" userId="a0710a6e-bffc-4971-8893-1c23addeb5b0" providerId="ADAL" clId="{5EDA080F-2DA0-41E9-BDBC-F9DEF976E495}" dt="2022-09-27T15:14:55.953" v="870" actId="165"/>
          <ac:grpSpMkLst>
            <pc:docMk/>
            <pc:sldMk cId="2940357804" sldId="297"/>
            <ac:grpSpMk id="94" creationId="{3DDC3DE9-7F9E-32D9-3AC0-4B69B597E2CC}"/>
          </ac:grpSpMkLst>
        </pc:grpChg>
        <pc:grpChg chg="del mod">
          <ac:chgData name="Kumar, Vinod" userId="a0710a6e-bffc-4971-8893-1c23addeb5b0" providerId="ADAL" clId="{5EDA080F-2DA0-41E9-BDBC-F9DEF976E495}" dt="2022-09-27T15:14:55.953" v="870" actId="165"/>
          <ac:grpSpMkLst>
            <pc:docMk/>
            <pc:sldMk cId="2940357804" sldId="297"/>
            <ac:grpSpMk id="95" creationId="{AEFA5619-9516-B273-8660-38613101634B}"/>
          </ac:grpSpMkLst>
        </pc:grpChg>
        <pc:picChg chg="mod">
          <ac:chgData name="Kumar, Vinod" userId="a0710a6e-bffc-4971-8893-1c23addeb5b0" providerId="ADAL" clId="{5EDA080F-2DA0-41E9-BDBC-F9DEF976E495}" dt="2022-09-27T15:20:22.628" v="1489" actId="1036"/>
          <ac:picMkLst>
            <pc:docMk/>
            <pc:sldMk cId="2940357804" sldId="297"/>
            <ac:picMk id="8" creationId="{919DAE8E-7D35-8F40-D412-002BF3289D80}"/>
          </ac:picMkLst>
        </pc:picChg>
        <pc:picChg chg="mod">
          <ac:chgData name="Kumar, Vinod" userId="a0710a6e-bffc-4971-8893-1c23addeb5b0" providerId="ADAL" clId="{5EDA080F-2DA0-41E9-BDBC-F9DEF976E495}" dt="2022-09-27T15:22:53.683" v="1882" actId="1036"/>
          <ac:picMkLst>
            <pc:docMk/>
            <pc:sldMk cId="2940357804" sldId="297"/>
            <ac:picMk id="9" creationId="{300ECDCE-7793-035A-4A52-E598C369621D}"/>
          </ac:picMkLst>
        </pc:picChg>
        <pc:picChg chg="mod">
          <ac:chgData name="Kumar, Vinod" userId="a0710a6e-bffc-4971-8893-1c23addeb5b0" providerId="ADAL" clId="{5EDA080F-2DA0-41E9-BDBC-F9DEF976E495}" dt="2022-09-27T15:20:18.037" v="1482" actId="1035"/>
          <ac:picMkLst>
            <pc:docMk/>
            <pc:sldMk cId="2940357804" sldId="297"/>
            <ac:picMk id="10" creationId="{F694DA6C-4FFF-B896-71AE-D2FE03F46AAF}"/>
          </ac:picMkLst>
        </pc:picChg>
        <pc:picChg chg="mod">
          <ac:chgData name="Kumar, Vinod" userId="a0710a6e-bffc-4971-8893-1c23addeb5b0" providerId="ADAL" clId="{5EDA080F-2DA0-41E9-BDBC-F9DEF976E495}" dt="2022-09-27T15:20:18.037" v="1482" actId="1035"/>
          <ac:picMkLst>
            <pc:docMk/>
            <pc:sldMk cId="2940357804" sldId="297"/>
            <ac:picMk id="11" creationId="{825455C6-07A7-ED30-3A78-8B334C2C3A9A}"/>
          </ac:picMkLst>
        </pc:picChg>
        <pc:picChg chg="add mod">
          <ac:chgData name="Kumar, Vinod" userId="a0710a6e-bffc-4971-8893-1c23addeb5b0" providerId="ADAL" clId="{5EDA080F-2DA0-41E9-BDBC-F9DEF976E495}" dt="2022-09-27T15:20:33.957" v="1501" actId="1036"/>
          <ac:picMkLst>
            <pc:docMk/>
            <pc:sldMk cId="2940357804" sldId="297"/>
            <ac:picMk id="33" creationId="{006ED6EC-B6C0-F620-73A7-9787FCB0810A}"/>
          </ac:picMkLst>
        </pc:picChg>
        <pc:picChg chg="add mod">
          <ac:chgData name="Kumar, Vinod" userId="a0710a6e-bffc-4971-8893-1c23addeb5b0" providerId="ADAL" clId="{5EDA080F-2DA0-41E9-BDBC-F9DEF976E495}" dt="2022-09-27T15:22:42.195" v="1881" actId="1035"/>
          <ac:picMkLst>
            <pc:docMk/>
            <pc:sldMk cId="2940357804" sldId="297"/>
            <ac:picMk id="34" creationId="{94187F1D-53CC-E202-F758-BF0BB2346A09}"/>
          </ac:picMkLst>
        </pc:picChg>
        <pc:picChg chg="del mod topLvl">
          <ac:chgData name="Kumar, Vinod" userId="a0710a6e-bffc-4971-8893-1c23addeb5b0" providerId="ADAL" clId="{5EDA080F-2DA0-41E9-BDBC-F9DEF976E495}" dt="2022-09-27T15:23:15.796" v="1883" actId="478"/>
          <ac:picMkLst>
            <pc:docMk/>
            <pc:sldMk cId="2940357804" sldId="297"/>
            <ac:picMk id="76" creationId="{EB52B786-E2A1-E432-CD46-778E88D6EDB8}"/>
          </ac:picMkLst>
        </pc:picChg>
        <pc:picChg chg="del mod topLvl">
          <ac:chgData name="Kumar, Vinod" userId="a0710a6e-bffc-4971-8893-1c23addeb5b0" providerId="ADAL" clId="{5EDA080F-2DA0-41E9-BDBC-F9DEF976E495}" dt="2022-09-27T15:23:15.796" v="1883" actId="478"/>
          <ac:picMkLst>
            <pc:docMk/>
            <pc:sldMk cId="2940357804" sldId="297"/>
            <ac:picMk id="77" creationId="{7E61A03E-C27B-DB9B-9516-4DBA7035F5CC}"/>
          </ac:picMkLst>
        </pc:picChg>
        <pc:picChg chg="mod topLvl">
          <ac:chgData name="Kumar, Vinod" userId="a0710a6e-bffc-4971-8893-1c23addeb5b0" providerId="ADAL" clId="{5EDA080F-2DA0-41E9-BDBC-F9DEF976E495}" dt="2022-09-27T15:16:28.456" v="999" actId="164"/>
          <ac:picMkLst>
            <pc:docMk/>
            <pc:sldMk cId="2940357804" sldId="297"/>
            <ac:picMk id="79" creationId="{E53C9645-1EDA-B6BA-8609-A858C25C26A2}"/>
          </ac:picMkLst>
        </pc:picChg>
        <pc:picChg chg="del mod topLvl">
          <ac:chgData name="Kumar, Vinod" userId="a0710a6e-bffc-4971-8893-1c23addeb5b0" providerId="ADAL" clId="{5EDA080F-2DA0-41E9-BDBC-F9DEF976E495}" dt="2022-09-27T15:23:15.796" v="1883" actId="478"/>
          <ac:picMkLst>
            <pc:docMk/>
            <pc:sldMk cId="2940357804" sldId="297"/>
            <ac:picMk id="80" creationId="{2C091A8D-6090-0C3D-AE87-9D1561EFF26F}"/>
          </ac:picMkLst>
        </pc:picChg>
        <pc:picChg chg="mod topLvl">
          <ac:chgData name="Kumar, Vinod" userId="a0710a6e-bffc-4971-8893-1c23addeb5b0" providerId="ADAL" clId="{5EDA080F-2DA0-41E9-BDBC-F9DEF976E495}" dt="2022-09-27T15:16:02.752" v="903" actId="164"/>
          <ac:picMkLst>
            <pc:docMk/>
            <pc:sldMk cId="2940357804" sldId="297"/>
            <ac:picMk id="81" creationId="{62E01015-B5CC-BCD8-66D9-A6ED93898AA7}"/>
          </ac:picMkLst>
        </pc:picChg>
        <pc:picChg chg="mod topLvl">
          <ac:chgData name="Kumar, Vinod" userId="a0710a6e-bffc-4971-8893-1c23addeb5b0" providerId="ADAL" clId="{5EDA080F-2DA0-41E9-BDBC-F9DEF976E495}" dt="2022-09-27T15:16:06.704" v="904" actId="164"/>
          <ac:picMkLst>
            <pc:docMk/>
            <pc:sldMk cId="2940357804" sldId="297"/>
            <ac:picMk id="82" creationId="{B68CD34F-BDE4-3030-5CBE-91230EB15E7B}"/>
          </ac:picMkLst>
        </pc:picChg>
      </pc:sldChg>
      <pc:sldChg chg="addSp delSp modSp mod">
        <pc:chgData name="Kumar, Vinod" userId="a0710a6e-bffc-4971-8893-1c23addeb5b0" providerId="ADAL" clId="{5EDA080F-2DA0-41E9-BDBC-F9DEF976E495}" dt="2022-09-27T15:42:07.514" v="3692" actId="478"/>
        <pc:sldMkLst>
          <pc:docMk/>
          <pc:sldMk cId="3985943826" sldId="298"/>
        </pc:sldMkLst>
        <pc:spChg chg="del mod">
          <ac:chgData name="Kumar, Vinod" userId="a0710a6e-bffc-4971-8893-1c23addeb5b0" providerId="ADAL" clId="{5EDA080F-2DA0-41E9-BDBC-F9DEF976E495}" dt="2022-09-27T15:42:05.179" v="3691" actId="478"/>
          <ac:spMkLst>
            <pc:docMk/>
            <pc:sldMk cId="3985943826" sldId="298"/>
            <ac:spMk id="7" creationId="{C56CA07C-310B-7CB3-A9A5-D9A9ED7A54FF}"/>
          </ac:spMkLst>
        </pc:spChg>
        <pc:spChg chg="del mod">
          <ac:chgData name="Kumar, Vinod" userId="a0710a6e-bffc-4971-8893-1c23addeb5b0" providerId="ADAL" clId="{5EDA080F-2DA0-41E9-BDBC-F9DEF976E495}" dt="2022-09-27T15:42:05.179" v="3691" actId="478"/>
          <ac:spMkLst>
            <pc:docMk/>
            <pc:sldMk cId="3985943826" sldId="298"/>
            <ac:spMk id="12" creationId="{B71961F2-19E2-1197-498E-C19AF204CD09}"/>
          </ac:spMkLst>
        </pc:spChg>
        <pc:spChg chg="del mod">
          <ac:chgData name="Kumar, Vinod" userId="a0710a6e-bffc-4971-8893-1c23addeb5b0" providerId="ADAL" clId="{5EDA080F-2DA0-41E9-BDBC-F9DEF976E495}" dt="2022-09-27T15:42:05.179" v="3691" actId="478"/>
          <ac:spMkLst>
            <pc:docMk/>
            <pc:sldMk cId="3985943826" sldId="298"/>
            <ac:spMk id="13" creationId="{ACF2B04D-9C9F-02B2-2D66-E367899E64AC}"/>
          </ac:spMkLst>
        </pc:spChg>
        <pc:spChg chg="del mod">
          <ac:chgData name="Kumar, Vinod" userId="a0710a6e-bffc-4971-8893-1c23addeb5b0" providerId="ADAL" clId="{5EDA080F-2DA0-41E9-BDBC-F9DEF976E495}" dt="2022-09-27T15:42:05.179" v="3691" actId="478"/>
          <ac:spMkLst>
            <pc:docMk/>
            <pc:sldMk cId="3985943826" sldId="298"/>
            <ac:spMk id="14" creationId="{4E7CC544-17E8-D9E7-9CE6-E4ACB6D489E4}"/>
          </ac:spMkLst>
        </pc:spChg>
        <pc:spChg chg="mod">
          <ac:chgData name="Kumar, Vinod" userId="a0710a6e-bffc-4971-8893-1c23addeb5b0" providerId="ADAL" clId="{5EDA080F-2DA0-41E9-BDBC-F9DEF976E495}" dt="2022-09-27T14:47:56.106" v="1"/>
          <ac:spMkLst>
            <pc:docMk/>
            <pc:sldMk cId="3985943826" sldId="298"/>
            <ac:spMk id="15" creationId="{C9966145-AF7F-3F24-8F5F-CE1575640C87}"/>
          </ac:spMkLst>
        </pc:spChg>
        <pc:spChg chg="mod">
          <ac:chgData name="Kumar, Vinod" userId="a0710a6e-bffc-4971-8893-1c23addeb5b0" providerId="ADAL" clId="{5EDA080F-2DA0-41E9-BDBC-F9DEF976E495}" dt="2022-09-27T14:47:56.106" v="1"/>
          <ac:spMkLst>
            <pc:docMk/>
            <pc:sldMk cId="3985943826" sldId="298"/>
            <ac:spMk id="16" creationId="{80E1D947-D1C1-3776-8B9C-0A300DA37F05}"/>
          </ac:spMkLst>
        </pc:spChg>
        <pc:spChg chg="mod">
          <ac:chgData name="Kumar, Vinod" userId="a0710a6e-bffc-4971-8893-1c23addeb5b0" providerId="ADAL" clId="{5EDA080F-2DA0-41E9-BDBC-F9DEF976E495}" dt="2022-09-27T14:47:56.106" v="1"/>
          <ac:spMkLst>
            <pc:docMk/>
            <pc:sldMk cId="3985943826" sldId="298"/>
            <ac:spMk id="17" creationId="{59E76DD2-DA34-C062-5482-409DC092B87A}"/>
          </ac:spMkLst>
        </pc:spChg>
        <pc:spChg chg="del mod">
          <ac:chgData name="Kumar, Vinod" userId="a0710a6e-bffc-4971-8893-1c23addeb5b0" providerId="ADAL" clId="{5EDA080F-2DA0-41E9-BDBC-F9DEF976E495}" dt="2022-09-27T15:42:05.179" v="3691" actId="478"/>
          <ac:spMkLst>
            <pc:docMk/>
            <pc:sldMk cId="3985943826" sldId="298"/>
            <ac:spMk id="25" creationId="{45A95E75-F17B-EC2F-8D43-49F7C6D0FAA3}"/>
          </ac:spMkLst>
        </pc:spChg>
        <pc:spChg chg="del mod">
          <ac:chgData name="Kumar, Vinod" userId="a0710a6e-bffc-4971-8893-1c23addeb5b0" providerId="ADAL" clId="{5EDA080F-2DA0-41E9-BDBC-F9DEF976E495}" dt="2022-09-27T15:42:05.179" v="3691" actId="478"/>
          <ac:spMkLst>
            <pc:docMk/>
            <pc:sldMk cId="3985943826" sldId="298"/>
            <ac:spMk id="26" creationId="{561178A7-B046-40D5-7854-03BC6BF5A350}"/>
          </ac:spMkLst>
        </pc:spChg>
        <pc:spChg chg="del mod">
          <ac:chgData name="Kumar, Vinod" userId="a0710a6e-bffc-4971-8893-1c23addeb5b0" providerId="ADAL" clId="{5EDA080F-2DA0-41E9-BDBC-F9DEF976E495}" dt="2022-09-27T15:42:05.179" v="3691" actId="478"/>
          <ac:spMkLst>
            <pc:docMk/>
            <pc:sldMk cId="3985943826" sldId="298"/>
            <ac:spMk id="27" creationId="{BD4E4445-28D2-4129-3036-3323644B16B0}"/>
          </ac:spMkLst>
        </pc:spChg>
        <pc:spChg chg="del mod">
          <ac:chgData name="Kumar, Vinod" userId="a0710a6e-bffc-4971-8893-1c23addeb5b0" providerId="ADAL" clId="{5EDA080F-2DA0-41E9-BDBC-F9DEF976E495}" dt="2022-09-27T15:42:05.179" v="3691" actId="478"/>
          <ac:spMkLst>
            <pc:docMk/>
            <pc:sldMk cId="3985943826" sldId="298"/>
            <ac:spMk id="28" creationId="{D35326DD-46F5-9DA1-F1F7-03BEB005F278}"/>
          </ac:spMkLst>
        </pc:spChg>
        <pc:spChg chg="del mod">
          <ac:chgData name="Kumar, Vinod" userId="a0710a6e-bffc-4971-8893-1c23addeb5b0" providerId="ADAL" clId="{5EDA080F-2DA0-41E9-BDBC-F9DEF976E495}" dt="2022-09-27T15:42:05.179" v="3691" actId="478"/>
          <ac:spMkLst>
            <pc:docMk/>
            <pc:sldMk cId="3985943826" sldId="298"/>
            <ac:spMk id="29" creationId="{A4071D75-1134-2EBD-EAD8-F25DEB96167F}"/>
          </ac:spMkLst>
        </pc:spChg>
        <pc:spChg chg="del mod">
          <ac:chgData name="Kumar, Vinod" userId="a0710a6e-bffc-4971-8893-1c23addeb5b0" providerId="ADAL" clId="{5EDA080F-2DA0-41E9-BDBC-F9DEF976E495}" dt="2022-09-27T15:42:05.179" v="3691" actId="478"/>
          <ac:spMkLst>
            <pc:docMk/>
            <pc:sldMk cId="3985943826" sldId="298"/>
            <ac:spMk id="30" creationId="{EB2A02B6-5496-BCBD-21D8-09AA872B21CF}"/>
          </ac:spMkLst>
        </pc:spChg>
        <pc:spChg chg="del mod">
          <ac:chgData name="Kumar, Vinod" userId="a0710a6e-bffc-4971-8893-1c23addeb5b0" providerId="ADAL" clId="{5EDA080F-2DA0-41E9-BDBC-F9DEF976E495}" dt="2022-09-27T15:42:05.179" v="3691" actId="478"/>
          <ac:spMkLst>
            <pc:docMk/>
            <pc:sldMk cId="3985943826" sldId="298"/>
            <ac:spMk id="31" creationId="{3E7F4159-1B76-3536-68DF-046BB2D1C7FB}"/>
          </ac:spMkLst>
        </pc:spChg>
        <pc:spChg chg="del mod">
          <ac:chgData name="Kumar, Vinod" userId="a0710a6e-bffc-4971-8893-1c23addeb5b0" providerId="ADAL" clId="{5EDA080F-2DA0-41E9-BDBC-F9DEF976E495}" dt="2022-09-27T15:42:05.179" v="3691" actId="478"/>
          <ac:spMkLst>
            <pc:docMk/>
            <pc:sldMk cId="3985943826" sldId="298"/>
            <ac:spMk id="32" creationId="{CAAB3955-9E5B-9C32-7E26-C30724BA6D94}"/>
          </ac:spMkLst>
        </pc:spChg>
        <pc:spChg chg="del mod">
          <ac:chgData name="Kumar, Vinod" userId="a0710a6e-bffc-4971-8893-1c23addeb5b0" providerId="ADAL" clId="{5EDA080F-2DA0-41E9-BDBC-F9DEF976E495}" dt="2022-09-27T15:42:05.179" v="3691" actId="478"/>
          <ac:spMkLst>
            <pc:docMk/>
            <pc:sldMk cId="3985943826" sldId="298"/>
            <ac:spMk id="37" creationId="{B1625E0F-F482-39FD-F251-9DD0433D9E04}"/>
          </ac:spMkLst>
        </pc:spChg>
        <pc:spChg chg="del mod">
          <ac:chgData name="Kumar, Vinod" userId="a0710a6e-bffc-4971-8893-1c23addeb5b0" providerId="ADAL" clId="{5EDA080F-2DA0-41E9-BDBC-F9DEF976E495}" dt="2022-09-27T15:42:05.179" v="3691" actId="478"/>
          <ac:spMkLst>
            <pc:docMk/>
            <pc:sldMk cId="3985943826" sldId="298"/>
            <ac:spMk id="38" creationId="{35F08F41-CCCA-E0B7-2278-A4458E754EF4}"/>
          </ac:spMkLst>
        </pc:spChg>
        <pc:spChg chg="del mod">
          <ac:chgData name="Kumar, Vinod" userId="a0710a6e-bffc-4971-8893-1c23addeb5b0" providerId="ADAL" clId="{5EDA080F-2DA0-41E9-BDBC-F9DEF976E495}" dt="2022-09-27T15:42:05.179" v="3691" actId="478"/>
          <ac:spMkLst>
            <pc:docMk/>
            <pc:sldMk cId="3985943826" sldId="298"/>
            <ac:spMk id="39" creationId="{30805481-0841-0FF4-CBB8-7147A95FE5AD}"/>
          </ac:spMkLst>
        </pc:spChg>
        <pc:spChg chg="mod">
          <ac:chgData name="Kumar, Vinod" userId="a0710a6e-bffc-4971-8893-1c23addeb5b0" providerId="ADAL" clId="{5EDA080F-2DA0-41E9-BDBC-F9DEF976E495}" dt="2022-09-27T15:25:02.457" v="2016"/>
          <ac:spMkLst>
            <pc:docMk/>
            <pc:sldMk cId="3985943826" sldId="298"/>
            <ac:spMk id="44" creationId="{0FDEE741-E282-06A8-D31C-F5F277E6C4DD}"/>
          </ac:spMkLst>
        </pc:spChg>
        <pc:spChg chg="mod">
          <ac:chgData name="Kumar, Vinod" userId="a0710a6e-bffc-4971-8893-1c23addeb5b0" providerId="ADAL" clId="{5EDA080F-2DA0-41E9-BDBC-F9DEF976E495}" dt="2022-09-27T15:25:02.457" v="2016"/>
          <ac:spMkLst>
            <pc:docMk/>
            <pc:sldMk cId="3985943826" sldId="298"/>
            <ac:spMk id="47" creationId="{83E00672-8393-E5A4-EC16-98B9F0F02D95}"/>
          </ac:spMkLst>
        </pc:spChg>
        <pc:spChg chg="mod">
          <ac:chgData name="Kumar, Vinod" userId="a0710a6e-bffc-4971-8893-1c23addeb5b0" providerId="ADAL" clId="{5EDA080F-2DA0-41E9-BDBC-F9DEF976E495}" dt="2022-09-27T15:25:02.457" v="2016"/>
          <ac:spMkLst>
            <pc:docMk/>
            <pc:sldMk cId="3985943826" sldId="298"/>
            <ac:spMk id="50" creationId="{575DD9E8-ABE9-05E4-AE97-B1BAC73CDE61}"/>
          </ac:spMkLst>
        </pc:spChg>
        <pc:spChg chg="add mod">
          <ac:chgData name="Kumar, Vinod" userId="a0710a6e-bffc-4971-8893-1c23addeb5b0" providerId="ADAL" clId="{5EDA080F-2DA0-41E9-BDBC-F9DEF976E495}" dt="2022-09-27T15:33:06.511" v="2705" actId="1036"/>
          <ac:spMkLst>
            <pc:docMk/>
            <pc:sldMk cId="3985943826" sldId="298"/>
            <ac:spMk id="58" creationId="{07EC96D3-CD7D-6E70-3704-2E723E20E6B3}"/>
          </ac:spMkLst>
        </pc:spChg>
        <pc:spChg chg="add mod">
          <ac:chgData name="Kumar, Vinod" userId="a0710a6e-bffc-4971-8893-1c23addeb5b0" providerId="ADAL" clId="{5EDA080F-2DA0-41E9-BDBC-F9DEF976E495}" dt="2022-09-27T15:33:06.511" v="2705" actId="1036"/>
          <ac:spMkLst>
            <pc:docMk/>
            <pc:sldMk cId="3985943826" sldId="298"/>
            <ac:spMk id="59" creationId="{C3FC9619-994B-2C86-D051-57642D1E0A07}"/>
          </ac:spMkLst>
        </pc:spChg>
        <pc:spChg chg="add mod">
          <ac:chgData name="Kumar, Vinod" userId="a0710a6e-bffc-4971-8893-1c23addeb5b0" providerId="ADAL" clId="{5EDA080F-2DA0-41E9-BDBC-F9DEF976E495}" dt="2022-09-27T15:33:06.511" v="2705" actId="1036"/>
          <ac:spMkLst>
            <pc:docMk/>
            <pc:sldMk cId="3985943826" sldId="298"/>
            <ac:spMk id="60" creationId="{0C54D10B-BB99-2764-5BCA-447084C91BAE}"/>
          </ac:spMkLst>
        </pc:spChg>
        <pc:spChg chg="add mod">
          <ac:chgData name="Kumar, Vinod" userId="a0710a6e-bffc-4971-8893-1c23addeb5b0" providerId="ADAL" clId="{5EDA080F-2DA0-41E9-BDBC-F9DEF976E495}" dt="2022-09-27T15:33:06.511" v="2705" actId="1036"/>
          <ac:spMkLst>
            <pc:docMk/>
            <pc:sldMk cId="3985943826" sldId="298"/>
            <ac:spMk id="61" creationId="{723D7F5C-88B3-84BF-CB53-D2CED75CE33D}"/>
          </ac:spMkLst>
        </pc:spChg>
        <pc:spChg chg="add mod">
          <ac:chgData name="Kumar, Vinod" userId="a0710a6e-bffc-4971-8893-1c23addeb5b0" providerId="ADAL" clId="{5EDA080F-2DA0-41E9-BDBC-F9DEF976E495}" dt="2022-09-27T15:33:06.511" v="2705" actId="1036"/>
          <ac:spMkLst>
            <pc:docMk/>
            <pc:sldMk cId="3985943826" sldId="298"/>
            <ac:spMk id="62" creationId="{B82E76CC-AA60-5E47-5A4D-CFE89C7571FD}"/>
          </ac:spMkLst>
        </pc:spChg>
        <pc:spChg chg="add del mod">
          <ac:chgData name="Kumar, Vinod" userId="a0710a6e-bffc-4971-8893-1c23addeb5b0" providerId="ADAL" clId="{5EDA080F-2DA0-41E9-BDBC-F9DEF976E495}" dt="2022-09-27T15:33:47.614" v="2859" actId="478"/>
          <ac:spMkLst>
            <pc:docMk/>
            <pc:sldMk cId="3985943826" sldId="298"/>
            <ac:spMk id="63" creationId="{EA0B7E98-EE07-CA01-78E1-B246A84A819D}"/>
          </ac:spMkLst>
        </pc:spChg>
        <pc:spChg chg="add del mod">
          <ac:chgData name="Kumar, Vinod" userId="a0710a6e-bffc-4971-8893-1c23addeb5b0" providerId="ADAL" clId="{5EDA080F-2DA0-41E9-BDBC-F9DEF976E495}" dt="2022-09-27T15:33:47.614" v="2859" actId="478"/>
          <ac:spMkLst>
            <pc:docMk/>
            <pc:sldMk cId="3985943826" sldId="298"/>
            <ac:spMk id="64" creationId="{CC5E27FB-9BF3-7F53-8CF6-84E191D908D1}"/>
          </ac:spMkLst>
        </pc:spChg>
        <pc:spChg chg="add mod">
          <ac:chgData name="Kumar, Vinod" userId="a0710a6e-bffc-4971-8893-1c23addeb5b0" providerId="ADAL" clId="{5EDA080F-2DA0-41E9-BDBC-F9DEF976E495}" dt="2022-09-27T15:34:32.990" v="3014" actId="1035"/>
          <ac:spMkLst>
            <pc:docMk/>
            <pc:sldMk cId="3985943826" sldId="298"/>
            <ac:spMk id="65" creationId="{CA9AEFB4-1F1E-78ED-3BEE-8D4011DF8206}"/>
          </ac:spMkLst>
        </pc:spChg>
        <pc:spChg chg="add mod">
          <ac:chgData name="Kumar, Vinod" userId="a0710a6e-bffc-4971-8893-1c23addeb5b0" providerId="ADAL" clId="{5EDA080F-2DA0-41E9-BDBC-F9DEF976E495}" dt="2022-09-27T15:34:32.990" v="3014" actId="1035"/>
          <ac:spMkLst>
            <pc:docMk/>
            <pc:sldMk cId="3985943826" sldId="298"/>
            <ac:spMk id="66" creationId="{ECD109EE-DA3C-C44C-8754-27AD2C09A4FC}"/>
          </ac:spMkLst>
        </pc:spChg>
        <pc:spChg chg="add mod">
          <ac:chgData name="Kumar, Vinod" userId="a0710a6e-bffc-4971-8893-1c23addeb5b0" providerId="ADAL" clId="{5EDA080F-2DA0-41E9-BDBC-F9DEF976E495}" dt="2022-09-27T15:34:32.990" v="3014" actId="1035"/>
          <ac:spMkLst>
            <pc:docMk/>
            <pc:sldMk cId="3985943826" sldId="298"/>
            <ac:spMk id="67" creationId="{6C98B42E-FA91-63F9-93AB-5C9D69B51027}"/>
          </ac:spMkLst>
        </pc:spChg>
        <pc:spChg chg="add mod">
          <ac:chgData name="Kumar, Vinod" userId="a0710a6e-bffc-4971-8893-1c23addeb5b0" providerId="ADAL" clId="{5EDA080F-2DA0-41E9-BDBC-F9DEF976E495}" dt="2022-09-27T15:34:32.990" v="3014" actId="1035"/>
          <ac:spMkLst>
            <pc:docMk/>
            <pc:sldMk cId="3985943826" sldId="298"/>
            <ac:spMk id="68" creationId="{005730C1-1D48-12CD-3868-E22C263D3106}"/>
          </ac:spMkLst>
        </pc:spChg>
        <pc:spChg chg="add mod">
          <ac:chgData name="Kumar, Vinod" userId="a0710a6e-bffc-4971-8893-1c23addeb5b0" providerId="ADAL" clId="{5EDA080F-2DA0-41E9-BDBC-F9DEF976E495}" dt="2022-09-27T15:34:32.990" v="3014" actId="1035"/>
          <ac:spMkLst>
            <pc:docMk/>
            <pc:sldMk cId="3985943826" sldId="298"/>
            <ac:spMk id="69" creationId="{15DA2A9A-E91E-7411-3E5F-D398FA45D7E6}"/>
          </ac:spMkLst>
        </pc:spChg>
        <pc:spChg chg="add mod">
          <ac:chgData name="Kumar, Vinod" userId="a0710a6e-bffc-4971-8893-1c23addeb5b0" providerId="ADAL" clId="{5EDA080F-2DA0-41E9-BDBC-F9DEF976E495}" dt="2022-09-27T15:34:32.990" v="3014" actId="1035"/>
          <ac:spMkLst>
            <pc:docMk/>
            <pc:sldMk cId="3985943826" sldId="298"/>
            <ac:spMk id="70" creationId="{F63C9B63-4BA1-D70E-BF01-B84BCE9BBD50}"/>
          </ac:spMkLst>
        </pc:spChg>
        <pc:spChg chg="add mod">
          <ac:chgData name="Kumar, Vinod" userId="a0710a6e-bffc-4971-8893-1c23addeb5b0" providerId="ADAL" clId="{5EDA080F-2DA0-41E9-BDBC-F9DEF976E495}" dt="2022-09-27T15:34:48.957" v="3028" actId="1036"/>
          <ac:spMkLst>
            <pc:docMk/>
            <pc:sldMk cId="3985943826" sldId="298"/>
            <ac:spMk id="71" creationId="{FBB29273-058A-F81B-4735-90094311D47D}"/>
          </ac:spMkLst>
        </pc:spChg>
        <pc:spChg chg="add mod">
          <ac:chgData name="Kumar, Vinod" userId="a0710a6e-bffc-4971-8893-1c23addeb5b0" providerId="ADAL" clId="{5EDA080F-2DA0-41E9-BDBC-F9DEF976E495}" dt="2022-09-27T15:35:03.469" v="3121" actId="1037"/>
          <ac:spMkLst>
            <pc:docMk/>
            <pc:sldMk cId="3985943826" sldId="298"/>
            <ac:spMk id="72" creationId="{FF87E0A1-F6B7-735B-C62E-4E30BC972612}"/>
          </ac:spMkLst>
        </pc:spChg>
        <pc:spChg chg="add mod">
          <ac:chgData name="Kumar, Vinod" userId="a0710a6e-bffc-4971-8893-1c23addeb5b0" providerId="ADAL" clId="{5EDA080F-2DA0-41E9-BDBC-F9DEF976E495}" dt="2022-09-27T15:35:25.326" v="3265" actId="1038"/>
          <ac:spMkLst>
            <pc:docMk/>
            <pc:sldMk cId="3985943826" sldId="298"/>
            <ac:spMk id="73" creationId="{3DC87012-760F-483C-9104-E6DEDCC490D2}"/>
          </ac:spMkLst>
        </pc:spChg>
        <pc:grpChg chg="del mod">
          <ac:chgData name="Kumar, Vinod" userId="a0710a6e-bffc-4971-8893-1c23addeb5b0" providerId="ADAL" clId="{5EDA080F-2DA0-41E9-BDBC-F9DEF976E495}" dt="2022-09-27T15:42:05.179" v="3691" actId="478"/>
          <ac:grpSpMkLst>
            <pc:docMk/>
            <pc:sldMk cId="3985943826" sldId="298"/>
            <ac:grpSpMk id="20" creationId="{5DADFBA5-FF9F-DBD0-9156-3B77B03A6436}"/>
          </ac:grpSpMkLst>
        </pc:grpChg>
        <pc:grpChg chg="del mod">
          <ac:chgData name="Kumar, Vinod" userId="a0710a6e-bffc-4971-8893-1c23addeb5b0" providerId="ADAL" clId="{5EDA080F-2DA0-41E9-BDBC-F9DEF976E495}" dt="2022-09-27T15:42:05.179" v="3691" actId="478"/>
          <ac:grpSpMkLst>
            <pc:docMk/>
            <pc:sldMk cId="3985943826" sldId="298"/>
            <ac:grpSpMk id="21" creationId="{35AA0A0D-7F72-C711-6A2C-9FC8865DAAB7}"/>
          </ac:grpSpMkLst>
        </pc:grpChg>
        <pc:grpChg chg="del mod">
          <ac:chgData name="Kumar, Vinod" userId="a0710a6e-bffc-4971-8893-1c23addeb5b0" providerId="ADAL" clId="{5EDA080F-2DA0-41E9-BDBC-F9DEF976E495}" dt="2022-09-27T15:42:05.179" v="3691" actId="478"/>
          <ac:grpSpMkLst>
            <pc:docMk/>
            <pc:sldMk cId="3985943826" sldId="298"/>
            <ac:grpSpMk id="22" creationId="{D27A6A55-FC38-883A-5FD5-B78902EB220F}"/>
          </ac:grpSpMkLst>
        </pc:grpChg>
        <pc:grpChg chg="add mod">
          <ac:chgData name="Kumar, Vinod" userId="a0710a6e-bffc-4971-8893-1c23addeb5b0" providerId="ADAL" clId="{5EDA080F-2DA0-41E9-BDBC-F9DEF976E495}" dt="2022-09-27T15:33:06.511" v="2705" actId="1036"/>
          <ac:grpSpMkLst>
            <pc:docMk/>
            <pc:sldMk cId="3985943826" sldId="298"/>
            <ac:grpSpMk id="42" creationId="{ACD1F7E2-17CB-092F-370A-5BC092437F7A}"/>
          </ac:grpSpMkLst>
        </pc:grpChg>
        <pc:grpChg chg="add mod">
          <ac:chgData name="Kumar, Vinod" userId="a0710a6e-bffc-4971-8893-1c23addeb5b0" providerId="ADAL" clId="{5EDA080F-2DA0-41E9-BDBC-F9DEF976E495}" dt="2022-09-27T15:33:06.511" v="2705" actId="1036"/>
          <ac:grpSpMkLst>
            <pc:docMk/>
            <pc:sldMk cId="3985943826" sldId="298"/>
            <ac:grpSpMk id="45" creationId="{0BC00F63-F12C-0E90-D12A-84CC1F9755F4}"/>
          </ac:grpSpMkLst>
        </pc:grpChg>
        <pc:grpChg chg="add mod">
          <ac:chgData name="Kumar, Vinod" userId="a0710a6e-bffc-4971-8893-1c23addeb5b0" providerId="ADAL" clId="{5EDA080F-2DA0-41E9-BDBC-F9DEF976E495}" dt="2022-09-27T15:33:06.511" v="2705" actId="1036"/>
          <ac:grpSpMkLst>
            <pc:docMk/>
            <pc:sldMk cId="3985943826" sldId="298"/>
            <ac:grpSpMk id="48" creationId="{DA988982-3960-F2BC-0BB8-BF76EC7439E7}"/>
          </ac:grpSpMkLst>
        </pc:grpChg>
        <pc:picChg chg="del mod">
          <ac:chgData name="Kumar, Vinod" userId="a0710a6e-bffc-4971-8893-1c23addeb5b0" providerId="ADAL" clId="{5EDA080F-2DA0-41E9-BDBC-F9DEF976E495}" dt="2022-09-27T15:42:05.179" v="3691" actId="478"/>
          <ac:picMkLst>
            <pc:docMk/>
            <pc:sldMk cId="3985943826" sldId="298"/>
            <ac:picMk id="2" creationId="{AC804B11-4759-2D94-11EA-934D8B41E27C}"/>
          </ac:picMkLst>
        </pc:picChg>
        <pc:picChg chg="mod">
          <ac:chgData name="Kumar, Vinod" userId="a0710a6e-bffc-4971-8893-1c23addeb5b0" providerId="ADAL" clId="{5EDA080F-2DA0-41E9-BDBC-F9DEF976E495}" dt="2022-09-27T14:47:56.106" v="1"/>
          <ac:picMkLst>
            <pc:docMk/>
            <pc:sldMk cId="3985943826" sldId="298"/>
            <ac:picMk id="6" creationId="{F0FD9C0F-7287-3731-EA35-44C9ED0D6786}"/>
          </ac:picMkLst>
        </pc:picChg>
        <pc:picChg chg="mod">
          <ac:chgData name="Kumar, Vinod" userId="a0710a6e-bffc-4971-8893-1c23addeb5b0" providerId="ADAL" clId="{5EDA080F-2DA0-41E9-BDBC-F9DEF976E495}" dt="2022-09-27T14:47:56.106" v="1"/>
          <ac:picMkLst>
            <pc:docMk/>
            <pc:sldMk cId="3985943826" sldId="298"/>
            <ac:picMk id="8" creationId="{F67BC46A-BF0B-3C21-D7AF-B86082BA552E}"/>
          </ac:picMkLst>
        </pc:picChg>
        <pc:picChg chg="mod">
          <ac:chgData name="Kumar, Vinod" userId="a0710a6e-bffc-4971-8893-1c23addeb5b0" providerId="ADAL" clId="{5EDA080F-2DA0-41E9-BDBC-F9DEF976E495}" dt="2022-09-27T14:47:56.106" v="1"/>
          <ac:picMkLst>
            <pc:docMk/>
            <pc:sldMk cId="3985943826" sldId="298"/>
            <ac:picMk id="9" creationId="{50991457-B44B-9D80-8E5C-C9F802E41E1F}"/>
          </ac:picMkLst>
        </pc:picChg>
        <pc:picChg chg="del mod">
          <ac:chgData name="Kumar, Vinod" userId="a0710a6e-bffc-4971-8893-1c23addeb5b0" providerId="ADAL" clId="{5EDA080F-2DA0-41E9-BDBC-F9DEF976E495}" dt="2022-09-27T15:42:05.179" v="3691" actId="478"/>
          <ac:picMkLst>
            <pc:docMk/>
            <pc:sldMk cId="3985943826" sldId="298"/>
            <ac:picMk id="11" creationId="{08982020-ED1D-F549-42A0-0D0118564230}"/>
          </ac:picMkLst>
        </pc:picChg>
        <pc:picChg chg="del mod">
          <ac:chgData name="Kumar, Vinod" userId="a0710a6e-bffc-4971-8893-1c23addeb5b0" providerId="ADAL" clId="{5EDA080F-2DA0-41E9-BDBC-F9DEF976E495}" dt="2022-09-27T15:42:05.179" v="3691" actId="478"/>
          <ac:picMkLst>
            <pc:docMk/>
            <pc:sldMk cId="3985943826" sldId="298"/>
            <ac:picMk id="34" creationId="{CC0D3593-20DF-B4D7-78F8-CDF00F30AF3D}"/>
          </ac:picMkLst>
        </pc:picChg>
        <pc:picChg chg="del mod">
          <ac:chgData name="Kumar, Vinod" userId="a0710a6e-bffc-4971-8893-1c23addeb5b0" providerId="ADAL" clId="{5EDA080F-2DA0-41E9-BDBC-F9DEF976E495}" dt="2022-09-27T15:42:05.179" v="3691" actId="478"/>
          <ac:picMkLst>
            <pc:docMk/>
            <pc:sldMk cId="3985943826" sldId="298"/>
            <ac:picMk id="35" creationId="{21816893-D49C-6B58-A2AE-219B8522F605}"/>
          </ac:picMkLst>
        </pc:picChg>
        <pc:picChg chg="del mod">
          <ac:chgData name="Kumar, Vinod" userId="a0710a6e-bffc-4971-8893-1c23addeb5b0" providerId="ADAL" clId="{5EDA080F-2DA0-41E9-BDBC-F9DEF976E495}" dt="2022-09-27T15:42:05.179" v="3691" actId="478"/>
          <ac:picMkLst>
            <pc:docMk/>
            <pc:sldMk cId="3985943826" sldId="298"/>
            <ac:picMk id="36" creationId="{EE732089-F52C-DA84-94B3-A3B40C351BFB}"/>
          </ac:picMkLst>
        </pc:picChg>
        <pc:picChg chg="del mod">
          <ac:chgData name="Kumar, Vinod" userId="a0710a6e-bffc-4971-8893-1c23addeb5b0" providerId="ADAL" clId="{5EDA080F-2DA0-41E9-BDBC-F9DEF976E495}" dt="2022-09-27T15:42:05.179" v="3691" actId="478"/>
          <ac:picMkLst>
            <pc:docMk/>
            <pc:sldMk cId="3985943826" sldId="298"/>
            <ac:picMk id="40" creationId="{1B8CB3C5-80DF-DD2F-1801-71DBEA63BFF5}"/>
          </ac:picMkLst>
        </pc:picChg>
        <pc:picChg chg="del mod">
          <ac:chgData name="Kumar, Vinod" userId="a0710a6e-bffc-4971-8893-1c23addeb5b0" providerId="ADAL" clId="{5EDA080F-2DA0-41E9-BDBC-F9DEF976E495}" dt="2022-09-27T15:42:05.179" v="3691" actId="478"/>
          <ac:picMkLst>
            <pc:docMk/>
            <pc:sldMk cId="3985943826" sldId="298"/>
            <ac:picMk id="41" creationId="{86775F13-65FC-4079-797F-888F97247CE6}"/>
          </ac:picMkLst>
        </pc:picChg>
        <pc:picChg chg="mod">
          <ac:chgData name="Kumar, Vinod" userId="a0710a6e-bffc-4971-8893-1c23addeb5b0" providerId="ADAL" clId="{5EDA080F-2DA0-41E9-BDBC-F9DEF976E495}" dt="2022-09-27T15:25:02.457" v="2016"/>
          <ac:picMkLst>
            <pc:docMk/>
            <pc:sldMk cId="3985943826" sldId="298"/>
            <ac:picMk id="43" creationId="{049776EC-1ED0-AC9E-F482-A549BBBF65FA}"/>
          </ac:picMkLst>
        </pc:picChg>
        <pc:picChg chg="mod">
          <ac:chgData name="Kumar, Vinod" userId="a0710a6e-bffc-4971-8893-1c23addeb5b0" providerId="ADAL" clId="{5EDA080F-2DA0-41E9-BDBC-F9DEF976E495}" dt="2022-09-27T15:25:02.457" v="2016"/>
          <ac:picMkLst>
            <pc:docMk/>
            <pc:sldMk cId="3985943826" sldId="298"/>
            <ac:picMk id="46" creationId="{D1017826-4F6E-94BE-EA17-C6812DA4E632}"/>
          </ac:picMkLst>
        </pc:picChg>
        <pc:picChg chg="mod">
          <ac:chgData name="Kumar, Vinod" userId="a0710a6e-bffc-4971-8893-1c23addeb5b0" providerId="ADAL" clId="{5EDA080F-2DA0-41E9-BDBC-F9DEF976E495}" dt="2022-09-27T15:25:02.457" v="2016"/>
          <ac:picMkLst>
            <pc:docMk/>
            <pc:sldMk cId="3985943826" sldId="298"/>
            <ac:picMk id="49" creationId="{D3884787-1C9E-F0AB-B84B-86582428FA3A}"/>
          </ac:picMkLst>
        </pc:picChg>
        <pc:picChg chg="add mod">
          <ac:chgData name="Kumar, Vinod" userId="a0710a6e-bffc-4971-8893-1c23addeb5b0" providerId="ADAL" clId="{5EDA080F-2DA0-41E9-BDBC-F9DEF976E495}" dt="2022-09-27T15:33:06.511" v="2705" actId="1036"/>
          <ac:picMkLst>
            <pc:docMk/>
            <pc:sldMk cId="3985943826" sldId="298"/>
            <ac:picMk id="51" creationId="{CD145B98-AFEF-0D39-B5D5-CE187869F680}"/>
          </ac:picMkLst>
        </pc:picChg>
        <pc:picChg chg="add mod">
          <ac:chgData name="Kumar, Vinod" userId="a0710a6e-bffc-4971-8893-1c23addeb5b0" providerId="ADAL" clId="{5EDA080F-2DA0-41E9-BDBC-F9DEF976E495}" dt="2022-09-27T15:33:06.511" v="2705" actId="1036"/>
          <ac:picMkLst>
            <pc:docMk/>
            <pc:sldMk cId="3985943826" sldId="298"/>
            <ac:picMk id="52" creationId="{4C6E0920-B45A-AFA5-CC83-A757E6BD5EB7}"/>
          </ac:picMkLst>
        </pc:picChg>
        <pc:picChg chg="add mod">
          <ac:chgData name="Kumar, Vinod" userId="a0710a6e-bffc-4971-8893-1c23addeb5b0" providerId="ADAL" clId="{5EDA080F-2DA0-41E9-BDBC-F9DEF976E495}" dt="2022-09-27T15:33:06.511" v="2705" actId="1036"/>
          <ac:picMkLst>
            <pc:docMk/>
            <pc:sldMk cId="3985943826" sldId="298"/>
            <ac:picMk id="53" creationId="{91B5085D-8443-3015-0638-C1FBDC33DC53}"/>
          </ac:picMkLst>
        </pc:picChg>
        <pc:picChg chg="add del mod">
          <ac:chgData name="Kumar, Vinod" userId="a0710a6e-bffc-4971-8893-1c23addeb5b0" providerId="ADAL" clId="{5EDA080F-2DA0-41E9-BDBC-F9DEF976E495}" dt="2022-09-27T15:42:07.514" v="3692" actId="478"/>
          <ac:picMkLst>
            <pc:docMk/>
            <pc:sldMk cId="3985943826" sldId="298"/>
            <ac:picMk id="54" creationId="{6A6F1D1D-141B-798E-69C4-1047DFE75D2E}"/>
          </ac:picMkLst>
        </pc:picChg>
        <pc:picChg chg="add del mod">
          <ac:chgData name="Kumar, Vinod" userId="a0710a6e-bffc-4971-8893-1c23addeb5b0" providerId="ADAL" clId="{5EDA080F-2DA0-41E9-BDBC-F9DEF976E495}" dt="2022-09-27T15:42:07.514" v="3692" actId="478"/>
          <ac:picMkLst>
            <pc:docMk/>
            <pc:sldMk cId="3985943826" sldId="298"/>
            <ac:picMk id="55" creationId="{377F0AAA-7054-25E1-F615-B9D717F5497D}"/>
          </ac:picMkLst>
        </pc:picChg>
        <pc:picChg chg="add mod">
          <ac:chgData name="Kumar, Vinod" userId="a0710a6e-bffc-4971-8893-1c23addeb5b0" providerId="ADAL" clId="{5EDA080F-2DA0-41E9-BDBC-F9DEF976E495}" dt="2022-09-27T15:33:06.511" v="2705" actId="1036"/>
          <ac:picMkLst>
            <pc:docMk/>
            <pc:sldMk cId="3985943826" sldId="298"/>
            <ac:picMk id="56" creationId="{789A4ADC-CE66-328B-9319-43B0EE760873}"/>
          </ac:picMkLst>
        </pc:picChg>
        <pc:picChg chg="add mod">
          <ac:chgData name="Kumar, Vinod" userId="a0710a6e-bffc-4971-8893-1c23addeb5b0" providerId="ADAL" clId="{5EDA080F-2DA0-41E9-BDBC-F9DEF976E495}" dt="2022-09-27T15:33:06.511" v="2705" actId="1036"/>
          <ac:picMkLst>
            <pc:docMk/>
            <pc:sldMk cId="3985943826" sldId="298"/>
            <ac:picMk id="57" creationId="{E32FB097-48D8-EA98-7117-FA2DA78498DA}"/>
          </ac:picMkLst>
        </pc:picChg>
        <pc:cxnChg chg="del mod">
          <ac:chgData name="Kumar, Vinod" userId="a0710a6e-bffc-4971-8893-1c23addeb5b0" providerId="ADAL" clId="{5EDA080F-2DA0-41E9-BDBC-F9DEF976E495}" dt="2022-09-27T15:42:05.179" v="3691" actId="478"/>
          <ac:cxnSpMkLst>
            <pc:docMk/>
            <pc:sldMk cId="3985943826" sldId="298"/>
            <ac:cxnSpMk id="24" creationId="{75B74ABB-2E7B-067E-CB29-30936A17452F}"/>
          </ac:cxnSpMkLst>
        </pc:cxnChg>
      </pc:sldChg>
      <pc:sldChg chg="addSp delSp modSp mod">
        <pc:chgData name="Kumar, Vinod" userId="a0710a6e-bffc-4971-8893-1c23addeb5b0" providerId="ADAL" clId="{5EDA080F-2DA0-41E9-BDBC-F9DEF976E495}" dt="2022-09-27T15:53:32.948" v="4332" actId="478"/>
        <pc:sldMkLst>
          <pc:docMk/>
          <pc:sldMk cId="2498213667" sldId="299"/>
        </pc:sldMkLst>
        <pc:spChg chg="mod">
          <ac:chgData name="Kumar, Vinod" userId="a0710a6e-bffc-4971-8893-1c23addeb5b0" providerId="ADAL" clId="{5EDA080F-2DA0-41E9-BDBC-F9DEF976E495}" dt="2022-09-27T15:47:53.894" v="4110" actId="1035"/>
          <ac:spMkLst>
            <pc:docMk/>
            <pc:sldMk cId="2498213667" sldId="299"/>
            <ac:spMk id="2" creationId="{51D40CE4-17B2-7A16-E7B1-F6DFB55A0FA0}"/>
          </ac:spMkLst>
        </pc:spChg>
        <pc:spChg chg="mod">
          <ac:chgData name="Kumar, Vinod" userId="a0710a6e-bffc-4971-8893-1c23addeb5b0" providerId="ADAL" clId="{5EDA080F-2DA0-41E9-BDBC-F9DEF976E495}" dt="2022-09-27T15:48:19.398" v="4118" actId="1035"/>
          <ac:spMkLst>
            <pc:docMk/>
            <pc:sldMk cId="2498213667" sldId="299"/>
            <ac:spMk id="12" creationId="{E8E8704C-584D-FA36-C26F-521F2E17A65D}"/>
          </ac:spMkLst>
        </pc:spChg>
        <pc:spChg chg="mod">
          <ac:chgData name="Kumar, Vinod" userId="a0710a6e-bffc-4971-8893-1c23addeb5b0" providerId="ADAL" clId="{5EDA080F-2DA0-41E9-BDBC-F9DEF976E495}" dt="2022-09-27T15:48:17.174" v="4116" actId="1036"/>
          <ac:spMkLst>
            <pc:docMk/>
            <pc:sldMk cId="2498213667" sldId="299"/>
            <ac:spMk id="13" creationId="{3B038702-7E51-64C2-B27E-5ADC07CCC1DE}"/>
          </ac:spMkLst>
        </pc:spChg>
        <pc:spChg chg="mod">
          <ac:chgData name="Kumar, Vinod" userId="a0710a6e-bffc-4971-8893-1c23addeb5b0" providerId="ADAL" clId="{5EDA080F-2DA0-41E9-BDBC-F9DEF976E495}" dt="2022-09-27T15:48:12.085" v="4113" actId="1076"/>
          <ac:spMkLst>
            <pc:docMk/>
            <pc:sldMk cId="2498213667" sldId="299"/>
            <ac:spMk id="14" creationId="{1BCDF35F-F838-B6D1-70E7-6D3B25B442CA}"/>
          </ac:spMkLst>
        </pc:spChg>
        <pc:spChg chg="mod">
          <ac:chgData name="Kumar, Vinod" userId="a0710a6e-bffc-4971-8893-1c23addeb5b0" providerId="ADAL" clId="{5EDA080F-2DA0-41E9-BDBC-F9DEF976E495}" dt="2022-09-27T15:47:40.791" v="4084" actId="1036"/>
          <ac:spMkLst>
            <pc:docMk/>
            <pc:sldMk cId="2498213667" sldId="299"/>
            <ac:spMk id="15" creationId="{25AF3F51-D911-F89E-54BF-BC566191F89F}"/>
          </ac:spMkLst>
        </pc:spChg>
        <pc:spChg chg="mod">
          <ac:chgData name="Kumar, Vinod" userId="a0710a6e-bffc-4971-8893-1c23addeb5b0" providerId="ADAL" clId="{5EDA080F-2DA0-41E9-BDBC-F9DEF976E495}" dt="2022-09-27T15:47:35.190" v="4080" actId="1036"/>
          <ac:spMkLst>
            <pc:docMk/>
            <pc:sldMk cId="2498213667" sldId="299"/>
            <ac:spMk id="16" creationId="{9C2C0DB9-6DFE-DB8A-A61A-CFEDB99B4720}"/>
          </ac:spMkLst>
        </pc:spChg>
        <pc:spChg chg="mod">
          <ac:chgData name="Kumar, Vinod" userId="a0710a6e-bffc-4971-8893-1c23addeb5b0" providerId="ADAL" clId="{5EDA080F-2DA0-41E9-BDBC-F9DEF976E495}" dt="2022-09-27T15:45:11.224" v="3979" actId="1036"/>
          <ac:spMkLst>
            <pc:docMk/>
            <pc:sldMk cId="2498213667" sldId="299"/>
            <ac:spMk id="17" creationId="{537E5210-E7C4-5358-C65B-CFB27F7A2AE3}"/>
          </ac:spMkLst>
        </pc:spChg>
        <pc:spChg chg="mod">
          <ac:chgData name="Kumar, Vinod" userId="a0710a6e-bffc-4971-8893-1c23addeb5b0" providerId="ADAL" clId="{5EDA080F-2DA0-41E9-BDBC-F9DEF976E495}" dt="2022-09-27T15:45:11.224" v="3979" actId="1036"/>
          <ac:spMkLst>
            <pc:docMk/>
            <pc:sldMk cId="2498213667" sldId="299"/>
            <ac:spMk id="18" creationId="{2701BE6B-644E-9CF3-4BFE-5B0395BB07AE}"/>
          </ac:spMkLst>
        </pc:spChg>
        <pc:spChg chg="mod">
          <ac:chgData name="Kumar, Vinod" userId="a0710a6e-bffc-4971-8893-1c23addeb5b0" providerId="ADAL" clId="{5EDA080F-2DA0-41E9-BDBC-F9DEF976E495}" dt="2022-09-27T15:44:22.425" v="3863" actId="1036"/>
          <ac:spMkLst>
            <pc:docMk/>
            <pc:sldMk cId="2498213667" sldId="299"/>
            <ac:spMk id="19" creationId="{9DC79C4B-E217-9AF7-7C48-4D0CDA074AA6}"/>
          </ac:spMkLst>
        </pc:spChg>
        <pc:spChg chg="mod">
          <ac:chgData name="Kumar, Vinod" userId="a0710a6e-bffc-4971-8893-1c23addeb5b0" providerId="ADAL" clId="{5EDA080F-2DA0-41E9-BDBC-F9DEF976E495}" dt="2022-09-27T15:44:22.425" v="3863" actId="1036"/>
          <ac:spMkLst>
            <pc:docMk/>
            <pc:sldMk cId="2498213667" sldId="299"/>
            <ac:spMk id="20" creationId="{BDB3E1FD-D56E-AAB7-AAC1-D89F3C30A6C0}"/>
          </ac:spMkLst>
        </pc:spChg>
        <pc:spChg chg="add del mod">
          <ac:chgData name="Kumar, Vinod" userId="a0710a6e-bffc-4971-8893-1c23addeb5b0" providerId="ADAL" clId="{5EDA080F-2DA0-41E9-BDBC-F9DEF976E495}" dt="2022-09-27T15:53:32.948" v="4332" actId="478"/>
          <ac:spMkLst>
            <pc:docMk/>
            <pc:sldMk cId="2498213667" sldId="299"/>
            <ac:spMk id="21" creationId="{E9FC3712-B5F4-C22D-5C17-A9FF99E25A83}"/>
          </ac:spMkLst>
        </pc:spChg>
        <pc:spChg chg="add del mod">
          <ac:chgData name="Kumar, Vinod" userId="a0710a6e-bffc-4971-8893-1c23addeb5b0" providerId="ADAL" clId="{5EDA080F-2DA0-41E9-BDBC-F9DEF976E495}" dt="2022-09-27T15:53:32.948" v="4332" actId="478"/>
          <ac:spMkLst>
            <pc:docMk/>
            <pc:sldMk cId="2498213667" sldId="299"/>
            <ac:spMk id="31" creationId="{86CC18AD-9F4D-7EFC-0727-9199F2DF2B45}"/>
          </ac:spMkLst>
        </pc:spChg>
        <pc:spChg chg="add del mod">
          <ac:chgData name="Kumar, Vinod" userId="a0710a6e-bffc-4971-8893-1c23addeb5b0" providerId="ADAL" clId="{5EDA080F-2DA0-41E9-BDBC-F9DEF976E495}" dt="2022-09-27T15:53:32.948" v="4332" actId="478"/>
          <ac:spMkLst>
            <pc:docMk/>
            <pc:sldMk cId="2498213667" sldId="299"/>
            <ac:spMk id="32" creationId="{DA1CDA83-656D-683E-6CAA-0F0A1046F149}"/>
          </ac:spMkLst>
        </pc:spChg>
        <pc:spChg chg="add del mod">
          <ac:chgData name="Kumar, Vinod" userId="a0710a6e-bffc-4971-8893-1c23addeb5b0" providerId="ADAL" clId="{5EDA080F-2DA0-41E9-BDBC-F9DEF976E495}" dt="2022-09-27T15:53:32.948" v="4332" actId="478"/>
          <ac:spMkLst>
            <pc:docMk/>
            <pc:sldMk cId="2498213667" sldId="299"/>
            <ac:spMk id="33" creationId="{AA061669-74FE-7F6E-6581-9AF94FA18F93}"/>
          </ac:spMkLst>
        </pc:spChg>
        <pc:spChg chg="add del mod">
          <ac:chgData name="Kumar, Vinod" userId="a0710a6e-bffc-4971-8893-1c23addeb5b0" providerId="ADAL" clId="{5EDA080F-2DA0-41E9-BDBC-F9DEF976E495}" dt="2022-09-27T15:53:32.948" v="4332" actId="478"/>
          <ac:spMkLst>
            <pc:docMk/>
            <pc:sldMk cId="2498213667" sldId="299"/>
            <ac:spMk id="34" creationId="{13D090FD-2816-1C1F-1160-65C045EE0C0F}"/>
          </ac:spMkLst>
        </pc:spChg>
        <pc:spChg chg="add del mod">
          <ac:chgData name="Kumar, Vinod" userId="a0710a6e-bffc-4971-8893-1c23addeb5b0" providerId="ADAL" clId="{5EDA080F-2DA0-41E9-BDBC-F9DEF976E495}" dt="2022-09-27T15:53:32.948" v="4332" actId="478"/>
          <ac:spMkLst>
            <pc:docMk/>
            <pc:sldMk cId="2498213667" sldId="299"/>
            <ac:spMk id="35" creationId="{00E1FDB0-A056-7318-8BBC-682DBE2EF728}"/>
          </ac:spMkLst>
        </pc:spChg>
        <pc:spChg chg="add del mod">
          <ac:chgData name="Kumar, Vinod" userId="a0710a6e-bffc-4971-8893-1c23addeb5b0" providerId="ADAL" clId="{5EDA080F-2DA0-41E9-BDBC-F9DEF976E495}" dt="2022-09-27T15:53:32.948" v="4332" actId="478"/>
          <ac:spMkLst>
            <pc:docMk/>
            <pc:sldMk cId="2498213667" sldId="299"/>
            <ac:spMk id="36" creationId="{0F79583E-20A8-60F8-97A6-8D20C03C33C1}"/>
          </ac:spMkLst>
        </pc:spChg>
        <pc:spChg chg="add del mod">
          <ac:chgData name="Kumar, Vinod" userId="a0710a6e-bffc-4971-8893-1c23addeb5b0" providerId="ADAL" clId="{5EDA080F-2DA0-41E9-BDBC-F9DEF976E495}" dt="2022-09-27T15:53:32.948" v="4332" actId="478"/>
          <ac:spMkLst>
            <pc:docMk/>
            <pc:sldMk cId="2498213667" sldId="299"/>
            <ac:spMk id="37" creationId="{FF6D7CF6-A9E2-0F2C-21AA-665BDBA9BF1D}"/>
          </ac:spMkLst>
        </pc:spChg>
        <pc:spChg chg="add del mod">
          <ac:chgData name="Kumar, Vinod" userId="a0710a6e-bffc-4971-8893-1c23addeb5b0" providerId="ADAL" clId="{5EDA080F-2DA0-41E9-BDBC-F9DEF976E495}" dt="2022-09-27T15:53:32.948" v="4332" actId="478"/>
          <ac:spMkLst>
            <pc:docMk/>
            <pc:sldMk cId="2498213667" sldId="299"/>
            <ac:spMk id="38" creationId="{656F8A26-D333-B4DE-5AB6-E1BC9783CF63}"/>
          </ac:spMkLst>
        </pc:spChg>
        <pc:spChg chg="add del mod">
          <ac:chgData name="Kumar, Vinod" userId="a0710a6e-bffc-4971-8893-1c23addeb5b0" providerId="ADAL" clId="{5EDA080F-2DA0-41E9-BDBC-F9DEF976E495}" dt="2022-09-27T15:53:32.948" v="4332" actId="478"/>
          <ac:spMkLst>
            <pc:docMk/>
            <pc:sldMk cId="2498213667" sldId="299"/>
            <ac:spMk id="39" creationId="{AB97F194-E43B-FD36-ACBB-567F463752FA}"/>
          </ac:spMkLst>
        </pc:spChg>
        <pc:picChg chg="mod">
          <ac:chgData name="Kumar, Vinod" userId="a0710a6e-bffc-4971-8893-1c23addeb5b0" providerId="ADAL" clId="{5EDA080F-2DA0-41E9-BDBC-F9DEF976E495}" dt="2022-09-27T15:47:30.070" v="4076" actId="1036"/>
          <ac:picMkLst>
            <pc:docMk/>
            <pc:sldMk cId="2498213667" sldId="299"/>
            <ac:picMk id="3" creationId="{FBF35403-61AF-9C85-AFB2-D91B2E63184B}"/>
          </ac:picMkLst>
        </pc:picChg>
        <pc:picChg chg="mod">
          <ac:chgData name="Kumar, Vinod" userId="a0710a6e-bffc-4971-8893-1c23addeb5b0" providerId="ADAL" clId="{5EDA080F-2DA0-41E9-BDBC-F9DEF976E495}" dt="2022-09-27T15:47:26.294" v="4074" actId="1035"/>
          <ac:picMkLst>
            <pc:docMk/>
            <pc:sldMk cId="2498213667" sldId="299"/>
            <ac:picMk id="4" creationId="{B7DE046C-470A-960C-E17F-D265CEC30111}"/>
          </ac:picMkLst>
        </pc:picChg>
        <pc:picChg chg="mod">
          <ac:chgData name="Kumar, Vinod" userId="a0710a6e-bffc-4971-8893-1c23addeb5b0" providerId="ADAL" clId="{5EDA080F-2DA0-41E9-BDBC-F9DEF976E495}" dt="2022-09-27T15:47:26.294" v="4074" actId="1035"/>
          <ac:picMkLst>
            <pc:docMk/>
            <pc:sldMk cId="2498213667" sldId="299"/>
            <ac:picMk id="5" creationId="{D22CD06E-BB45-DAE6-41F1-E7CC9C42B9EA}"/>
          </ac:picMkLst>
        </pc:picChg>
        <pc:picChg chg="mod">
          <ac:chgData name="Kumar, Vinod" userId="a0710a6e-bffc-4971-8893-1c23addeb5b0" providerId="ADAL" clId="{5EDA080F-2DA0-41E9-BDBC-F9DEF976E495}" dt="2022-09-27T15:47:17.671" v="4070" actId="1036"/>
          <ac:picMkLst>
            <pc:docMk/>
            <pc:sldMk cId="2498213667" sldId="299"/>
            <ac:picMk id="6" creationId="{2BCE7DFC-8741-815D-A3B6-292EA4C73E95}"/>
          </ac:picMkLst>
        </pc:picChg>
        <pc:picChg chg="mod">
          <ac:chgData name="Kumar, Vinod" userId="a0710a6e-bffc-4971-8893-1c23addeb5b0" providerId="ADAL" clId="{5EDA080F-2DA0-41E9-BDBC-F9DEF976E495}" dt="2022-09-27T15:47:17.671" v="4070" actId="1036"/>
          <ac:picMkLst>
            <pc:docMk/>
            <pc:sldMk cId="2498213667" sldId="299"/>
            <ac:picMk id="7" creationId="{57223056-72AA-174F-6FA9-350A01BC7733}"/>
          </ac:picMkLst>
        </pc:picChg>
        <pc:picChg chg="mod">
          <ac:chgData name="Kumar, Vinod" userId="a0710a6e-bffc-4971-8893-1c23addeb5b0" providerId="ADAL" clId="{5EDA080F-2DA0-41E9-BDBC-F9DEF976E495}" dt="2022-09-27T15:45:05.432" v="3977" actId="1035"/>
          <ac:picMkLst>
            <pc:docMk/>
            <pc:sldMk cId="2498213667" sldId="299"/>
            <ac:picMk id="8" creationId="{515372DD-085A-0CAC-9F58-3C8B198EACA0}"/>
          </ac:picMkLst>
        </pc:picChg>
        <pc:picChg chg="mod">
          <ac:chgData name="Kumar, Vinod" userId="a0710a6e-bffc-4971-8893-1c23addeb5b0" providerId="ADAL" clId="{5EDA080F-2DA0-41E9-BDBC-F9DEF976E495}" dt="2022-09-27T15:45:00.055" v="3965" actId="1035"/>
          <ac:picMkLst>
            <pc:docMk/>
            <pc:sldMk cId="2498213667" sldId="299"/>
            <ac:picMk id="9" creationId="{E2D174D9-69F4-0136-FA01-1EBB88CC9824}"/>
          </ac:picMkLst>
        </pc:picChg>
        <pc:picChg chg="mod">
          <ac:chgData name="Kumar, Vinod" userId="a0710a6e-bffc-4971-8893-1c23addeb5b0" providerId="ADAL" clId="{5EDA080F-2DA0-41E9-BDBC-F9DEF976E495}" dt="2022-09-27T15:44:44.568" v="3936" actId="1038"/>
          <ac:picMkLst>
            <pc:docMk/>
            <pc:sldMk cId="2498213667" sldId="299"/>
            <ac:picMk id="10" creationId="{C485C2EA-332D-FE9B-351D-AACA7B21C507}"/>
          </ac:picMkLst>
        </pc:picChg>
        <pc:picChg chg="mod">
          <ac:chgData name="Kumar, Vinod" userId="a0710a6e-bffc-4971-8893-1c23addeb5b0" providerId="ADAL" clId="{5EDA080F-2DA0-41E9-BDBC-F9DEF976E495}" dt="2022-09-27T15:44:22.425" v="3863" actId="1036"/>
          <ac:picMkLst>
            <pc:docMk/>
            <pc:sldMk cId="2498213667" sldId="299"/>
            <ac:picMk id="11" creationId="{BBC8BE26-CE50-0E7B-5B74-3DABE34015C5}"/>
          </ac:picMkLst>
        </pc:picChg>
        <pc:picChg chg="add del mod">
          <ac:chgData name="Kumar, Vinod" userId="a0710a6e-bffc-4971-8893-1c23addeb5b0" providerId="ADAL" clId="{5EDA080F-2DA0-41E9-BDBC-F9DEF976E495}" dt="2022-09-27T15:53:32.948" v="4332" actId="478"/>
          <ac:picMkLst>
            <pc:docMk/>
            <pc:sldMk cId="2498213667" sldId="299"/>
            <ac:picMk id="22" creationId="{9ACA29E4-9BE3-F136-6FCC-25685ED0E1C4}"/>
          </ac:picMkLst>
        </pc:picChg>
        <pc:picChg chg="add del mod">
          <ac:chgData name="Kumar, Vinod" userId="a0710a6e-bffc-4971-8893-1c23addeb5b0" providerId="ADAL" clId="{5EDA080F-2DA0-41E9-BDBC-F9DEF976E495}" dt="2022-09-27T15:53:32.948" v="4332" actId="478"/>
          <ac:picMkLst>
            <pc:docMk/>
            <pc:sldMk cId="2498213667" sldId="299"/>
            <ac:picMk id="23" creationId="{BB54389F-D133-11BD-AB7B-4CA892A5D7DC}"/>
          </ac:picMkLst>
        </pc:picChg>
        <pc:picChg chg="add del mod">
          <ac:chgData name="Kumar, Vinod" userId="a0710a6e-bffc-4971-8893-1c23addeb5b0" providerId="ADAL" clId="{5EDA080F-2DA0-41E9-BDBC-F9DEF976E495}" dt="2022-09-27T15:53:32.948" v="4332" actId="478"/>
          <ac:picMkLst>
            <pc:docMk/>
            <pc:sldMk cId="2498213667" sldId="299"/>
            <ac:picMk id="24" creationId="{BAE825FA-7C98-3068-5F02-8097802C6D7E}"/>
          </ac:picMkLst>
        </pc:picChg>
        <pc:picChg chg="add del mod">
          <ac:chgData name="Kumar, Vinod" userId="a0710a6e-bffc-4971-8893-1c23addeb5b0" providerId="ADAL" clId="{5EDA080F-2DA0-41E9-BDBC-F9DEF976E495}" dt="2022-09-27T15:53:32.948" v="4332" actId="478"/>
          <ac:picMkLst>
            <pc:docMk/>
            <pc:sldMk cId="2498213667" sldId="299"/>
            <ac:picMk id="25" creationId="{8094D0FE-5232-7BBF-5213-DE73953EB85B}"/>
          </ac:picMkLst>
        </pc:picChg>
        <pc:picChg chg="add del mod">
          <ac:chgData name="Kumar, Vinod" userId="a0710a6e-bffc-4971-8893-1c23addeb5b0" providerId="ADAL" clId="{5EDA080F-2DA0-41E9-BDBC-F9DEF976E495}" dt="2022-09-27T15:53:32.948" v="4332" actId="478"/>
          <ac:picMkLst>
            <pc:docMk/>
            <pc:sldMk cId="2498213667" sldId="299"/>
            <ac:picMk id="26" creationId="{F44D19B4-AC3C-C994-E83F-741A34F0328C}"/>
          </ac:picMkLst>
        </pc:picChg>
        <pc:picChg chg="add del mod">
          <ac:chgData name="Kumar, Vinod" userId="a0710a6e-bffc-4971-8893-1c23addeb5b0" providerId="ADAL" clId="{5EDA080F-2DA0-41E9-BDBC-F9DEF976E495}" dt="2022-09-27T15:53:32.948" v="4332" actId="478"/>
          <ac:picMkLst>
            <pc:docMk/>
            <pc:sldMk cId="2498213667" sldId="299"/>
            <ac:picMk id="27" creationId="{F0B88DBE-911C-E749-1F0F-EB8DBF3D7719}"/>
          </ac:picMkLst>
        </pc:picChg>
        <pc:picChg chg="add del mod">
          <ac:chgData name="Kumar, Vinod" userId="a0710a6e-bffc-4971-8893-1c23addeb5b0" providerId="ADAL" clId="{5EDA080F-2DA0-41E9-BDBC-F9DEF976E495}" dt="2022-09-27T15:53:32.948" v="4332" actId="478"/>
          <ac:picMkLst>
            <pc:docMk/>
            <pc:sldMk cId="2498213667" sldId="299"/>
            <ac:picMk id="28" creationId="{1B2BC742-204E-C59D-7E06-83C54D876718}"/>
          </ac:picMkLst>
        </pc:picChg>
        <pc:picChg chg="add del mod">
          <ac:chgData name="Kumar, Vinod" userId="a0710a6e-bffc-4971-8893-1c23addeb5b0" providerId="ADAL" clId="{5EDA080F-2DA0-41E9-BDBC-F9DEF976E495}" dt="2022-09-27T15:53:32.948" v="4332" actId="478"/>
          <ac:picMkLst>
            <pc:docMk/>
            <pc:sldMk cId="2498213667" sldId="299"/>
            <ac:picMk id="29" creationId="{BCFC9B5A-83ED-2CA8-9EA6-F53DED670EAF}"/>
          </ac:picMkLst>
        </pc:picChg>
        <pc:picChg chg="add del mod">
          <ac:chgData name="Kumar, Vinod" userId="a0710a6e-bffc-4971-8893-1c23addeb5b0" providerId="ADAL" clId="{5EDA080F-2DA0-41E9-BDBC-F9DEF976E495}" dt="2022-09-27T15:53:32.948" v="4332" actId="478"/>
          <ac:picMkLst>
            <pc:docMk/>
            <pc:sldMk cId="2498213667" sldId="299"/>
            <ac:picMk id="30" creationId="{37704BF4-BC58-F422-9DC7-38301D797705}"/>
          </ac:picMkLst>
        </pc:picChg>
      </pc:sldChg>
      <pc:sldChg chg="modSp mod">
        <pc:chgData name="Kumar, Vinod" userId="a0710a6e-bffc-4971-8893-1c23addeb5b0" providerId="ADAL" clId="{5EDA080F-2DA0-41E9-BDBC-F9DEF976E495}" dt="2022-09-27T15:52:43.796" v="4331" actId="1036"/>
        <pc:sldMkLst>
          <pc:docMk/>
          <pc:sldMk cId="2313405284" sldId="300"/>
        </pc:sldMkLst>
        <pc:spChg chg="mod">
          <ac:chgData name="Kumar, Vinod" userId="a0710a6e-bffc-4971-8893-1c23addeb5b0" providerId="ADAL" clId="{5EDA080F-2DA0-41E9-BDBC-F9DEF976E495}" dt="2022-09-27T15:52:34.244" v="4324" actId="1037"/>
          <ac:spMkLst>
            <pc:docMk/>
            <pc:sldMk cId="2313405284" sldId="300"/>
            <ac:spMk id="2" creationId="{E836C5DC-7746-C954-BC1F-3B9F0DA30868}"/>
          </ac:spMkLst>
        </pc:spChg>
        <pc:spChg chg="mod">
          <ac:chgData name="Kumar, Vinod" userId="a0710a6e-bffc-4971-8893-1c23addeb5b0" providerId="ADAL" clId="{5EDA080F-2DA0-41E9-BDBC-F9DEF976E495}" dt="2022-09-27T15:52:43.796" v="4331" actId="1036"/>
          <ac:spMkLst>
            <pc:docMk/>
            <pc:sldMk cId="2313405284" sldId="300"/>
            <ac:spMk id="11" creationId="{C64871AB-6521-A550-17B9-FEE41DAD3B8D}"/>
          </ac:spMkLst>
        </pc:spChg>
        <pc:spChg chg="mod">
          <ac:chgData name="Kumar, Vinod" userId="a0710a6e-bffc-4971-8893-1c23addeb5b0" providerId="ADAL" clId="{5EDA080F-2DA0-41E9-BDBC-F9DEF976E495}" dt="2022-09-27T15:52:43.796" v="4331" actId="1036"/>
          <ac:spMkLst>
            <pc:docMk/>
            <pc:sldMk cId="2313405284" sldId="300"/>
            <ac:spMk id="12" creationId="{DE106EEB-BEC0-DFC6-0302-FA2E623AEC2C}"/>
          </ac:spMkLst>
        </pc:spChg>
        <pc:spChg chg="mod">
          <ac:chgData name="Kumar, Vinod" userId="a0710a6e-bffc-4971-8893-1c23addeb5b0" providerId="ADAL" clId="{5EDA080F-2DA0-41E9-BDBC-F9DEF976E495}" dt="2022-09-27T15:52:16.308" v="4287" actId="1035"/>
          <ac:spMkLst>
            <pc:docMk/>
            <pc:sldMk cId="2313405284" sldId="300"/>
            <ac:spMk id="13" creationId="{8933CC69-5A26-CFFF-CDF2-7629C88162CC}"/>
          </ac:spMkLst>
        </pc:spChg>
        <pc:spChg chg="mod">
          <ac:chgData name="Kumar, Vinod" userId="a0710a6e-bffc-4971-8893-1c23addeb5b0" providerId="ADAL" clId="{5EDA080F-2DA0-41E9-BDBC-F9DEF976E495}" dt="2022-09-27T15:52:16.308" v="4287" actId="1035"/>
          <ac:spMkLst>
            <pc:docMk/>
            <pc:sldMk cId="2313405284" sldId="300"/>
            <ac:spMk id="14" creationId="{500AC389-8A93-6C81-C33A-970A6A288B38}"/>
          </ac:spMkLst>
        </pc:spChg>
        <pc:spChg chg="mod">
          <ac:chgData name="Kumar, Vinod" userId="a0710a6e-bffc-4971-8893-1c23addeb5b0" providerId="ADAL" clId="{5EDA080F-2DA0-41E9-BDBC-F9DEF976E495}" dt="2022-09-27T15:52:01.972" v="4268" actId="1035"/>
          <ac:spMkLst>
            <pc:docMk/>
            <pc:sldMk cId="2313405284" sldId="300"/>
            <ac:spMk id="15" creationId="{12E43E6A-BC7F-1E66-77AD-0D7CCFDBED82}"/>
          </ac:spMkLst>
        </pc:spChg>
        <pc:spChg chg="mod">
          <ac:chgData name="Kumar, Vinod" userId="a0710a6e-bffc-4971-8893-1c23addeb5b0" providerId="ADAL" clId="{5EDA080F-2DA0-41E9-BDBC-F9DEF976E495}" dt="2022-09-27T15:52:01.972" v="4268" actId="1035"/>
          <ac:spMkLst>
            <pc:docMk/>
            <pc:sldMk cId="2313405284" sldId="300"/>
            <ac:spMk id="16" creationId="{F7E78BC5-387C-1374-456C-397866B099A1}"/>
          </ac:spMkLst>
        </pc:spChg>
        <pc:spChg chg="mod">
          <ac:chgData name="Kumar, Vinod" userId="a0710a6e-bffc-4971-8893-1c23addeb5b0" providerId="ADAL" clId="{5EDA080F-2DA0-41E9-BDBC-F9DEF976E495}" dt="2022-09-27T15:51:43.716" v="4252" actId="1035"/>
          <ac:spMkLst>
            <pc:docMk/>
            <pc:sldMk cId="2313405284" sldId="300"/>
            <ac:spMk id="17" creationId="{DE811E4C-18B9-AF7B-4E24-A0D0D5FB3A2B}"/>
          </ac:spMkLst>
        </pc:spChg>
        <pc:spChg chg="mod">
          <ac:chgData name="Kumar, Vinod" userId="a0710a6e-bffc-4971-8893-1c23addeb5b0" providerId="ADAL" clId="{5EDA080F-2DA0-41E9-BDBC-F9DEF976E495}" dt="2022-09-27T15:51:43.716" v="4252" actId="1035"/>
          <ac:spMkLst>
            <pc:docMk/>
            <pc:sldMk cId="2313405284" sldId="300"/>
            <ac:spMk id="18" creationId="{197D5A89-7757-9ED2-8EE0-4D250796B5BB}"/>
          </ac:spMkLst>
        </pc:spChg>
        <pc:picChg chg="mod">
          <ac:chgData name="Kumar, Vinod" userId="a0710a6e-bffc-4971-8893-1c23addeb5b0" providerId="ADAL" clId="{5EDA080F-2DA0-41E9-BDBC-F9DEF976E495}" dt="2022-09-27T15:52:16.308" v="4287" actId="1035"/>
          <ac:picMkLst>
            <pc:docMk/>
            <pc:sldMk cId="2313405284" sldId="300"/>
            <ac:picMk id="3" creationId="{29DD6D63-398D-9D2D-9E3E-6E0239244671}"/>
          </ac:picMkLst>
        </pc:picChg>
        <pc:picChg chg="mod">
          <ac:chgData name="Kumar, Vinod" userId="a0710a6e-bffc-4971-8893-1c23addeb5b0" providerId="ADAL" clId="{5EDA080F-2DA0-41E9-BDBC-F9DEF976E495}" dt="2022-09-27T15:52:16.308" v="4287" actId="1035"/>
          <ac:picMkLst>
            <pc:docMk/>
            <pc:sldMk cId="2313405284" sldId="300"/>
            <ac:picMk id="4" creationId="{0E6A30FA-1FCE-8E20-3A3D-C9977710E422}"/>
          </ac:picMkLst>
        </pc:picChg>
        <pc:picChg chg="mod">
          <ac:chgData name="Kumar, Vinod" userId="a0710a6e-bffc-4971-8893-1c23addeb5b0" providerId="ADAL" clId="{5EDA080F-2DA0-41E9-BDBC-F9DEF976E495}" dt="2022-09-27T15:52:01.972" v="4268" actId="1035"/>
          <ac:picMkLst>
            <pc:docMk/>
            <pc:sldMk cId="2313405284" sldId="300"/>
            <ac:picMk id="5" creationId="{E571617C-7D69-5378-001F-634F214B4A17}"/>
          </ac:picMkLst>
        </pc:picChg>
        <pc:picChg chg="mod">
          <ac:chgData name="Kumar, Vinod" userId="a0710a6e-bffc-4971-8893-1c23addeb5b0" providerId="ADAL" clId="{5EDA080F-2DA0-41E9-BDBC-F9DEF976E495}" dt="2022-09-27T15:52:01.972" v="4268" actId="1035"/>
          <ac:picMkLst>
            <pc:docMk/>
            <pc:sldMk cId="2313405284" sldId="300"/>
            <ac:picMk id="6" creationId="{54C9136E-B2EE-713C-206F-528275B3E923}"/>
          </ac:picMkLst>
        </pc:picChg>
        <pc:picChg chg="mod">
          <ac:chgData name="Kumar, Vinod" userId="a0710a6e-bffc-4971-8893-1c23addeb5b0" providerId="ADAL" clId="{5EDA080F-2DA0-41E9-BDBC-F9DEF976E495}" dt="2022-09-27T15:51:43.716" v="4252" actId="1035"/>
          <ac:picMkLst>
            <pc:docMk/>
            <pc:sldMk cId="2313405284" sldId="300"/>
            <ac:picMk id="7" creationId="{F6D86FB7-83E1-07B1-6A6C-3A5DDE32D6B5}"/>
          </ac:picMkLst>
        </pc:picChg>
        <pc:picChg chg="mod">
          <ac:chgData name="Kumar, Vinod" userId="a0710a6e-bffc-4971-8893-1c23addeb5b0" providerId="ADAL" clId="{5EDA080F-2DA0-41E9-BDBC-F9DEF976E495}" dt="2022-09-27T15:51:43.716" v="4252" actId="1035"/>
          <ac:picMkLst>
            <pc:docMk/>
            <pc:sldMk cId="2313405284" sldId="300"/>
            <ac:picMk id="8" creationId="{5DF73724-2E56-FF83-751A-F90FBC4935A9}"/>
          </ac:picMkLst>
        </pc:picChg>
        <pc:picChg chg="mod">
          <ac:chgData name="Kumar, Vinod" userId="a0710a6e-bffc-4971-8893-1c23addeb5b0" providerId="ADAL" clId="{5EDA080F-2DA0-41E9-BDBC-F9DEF976E495}" dt="2022-09-27T15:52:24.739" v="4298" actId="1035"/>
          <ac:picMkLst>
            <pc:docMk/>
            <pc:sldMk cId="2313405284" sldId="300"/>
            <ac:picMk id="9" creationId="{BA586AAC-EA6F-0435-4C2A-DF34082B0031}"/>
          </ac:picMkLst>
        </pc:picChg>
        <pc:picChg chg="mod">
          <ac:chgData name="Kumar, Vinod" userId="a0710a6e-bffc-4971-8893-1c23addeb5b0" providerId="ADAL" clId="{5EDA080F-2DA0-41E9-BDBC-F9DEF976E495}" dt="2022-09-27T15:52:24.739" v="4298" actId="1035"/>
          <ac:picMkLst>
            <pc:docMk/>
            <pc:sldMk cId="2313405284" sldId="300"/>
            <ac:picMk id="10" creationId="{50E22F7A-0AEA-69B1-4EBE-B57F9FBCB1F1}"/>
          </ac:picMkLst>
        </pc:picChg>
      </pc:sldChg>
      <pc:sldChg chg="addSp delSp modSp mod">
        <pc:chgData name="Kumar, Vinod" userId="a0710a6e-bffc-4971-8893-1c23addeb5b0" providerId="ADAL" clId="{5EDA080F-2DA0-41E9-BDBC-F9DEF976E495}" dt="2022-09-27T15:56:32.481" v="4644" actId="1076"/>
        <pc:sldMkLst>
          <pc:docMk/>
          <pc:sldMk cId="1906182640" sldId="301"/>
        </pc:sldMkLst>
        <pc:spChg chg="mod">
          <ac:chgData name="Kumar, Vinod" userId="a0710a6e-bffc-4971-8893-1c23addeb5b0" providerId="ADAL" clId="{5EDA080F-2DA0-41E9-BDBC-F9DEF976E495}" dt="2022-09-27T15:56:03.147" v="4618" actId="255"/>
          <ac:spMkLst>
            <pc:docMk/>
            <pc:sldMk cId="1906182640" sldId="301"/>
            <ac:spMk id="2" creationId="{2F989969-700A-D7EB-7E3D-52DE0231C0F0}"/>
          </ac:spMkLst>
        </pc:spChg>
        <pc:spChg chg="add mod">
          <ac:chgData name="Kumar, Vinod" userId="a0710a6e-bffc-4971-8893-1c23addeb5b0" providerId="ADAL" clId="{5EDA080F-2DA0-41E9-BDBC-F9DEF976E495}" dt="2022-09-27T15:56:09.129" v="4619" actId="1076"/>
          <ac:spMkLst>
            <pc:docMk/>
            <pc:sldMk cId="1906182640" sldId="301"/>
            <ac:spMk id="13" creationId="{2AD0881F-DFA4-122C-8C0C-565629313CCB}"/>
          </ac:spMkLst>
        </pc:spChg>
        <pc:spChg chg="add mod">
          <ac:chgData name="Kumar, Vinod" userId="a0710a6e-bffc-4971-8893-1c23addeb5b0" providerId="ADAL" clId="{5EDA080F-2DA0-41E9-BDBC-F9DEF976E495}" dt="2022-09-27T15:56:13.313" v="4627" actId="1037"/>
          <ac:spMkLst>
            <pc:docMk/>
            <pc:sldMk cId="1906182640" sldId="301"/>
            <ac:spMk id="14" creationId="{927B8AC4-1BF7-4F33-CAF6-E15A421230D4}"/>
          </ac:spMkLst>
        </pc:spChg>
        <pc:spChg chg="add mod">
          <ac:chgData name="Kumar, Vinod" userId="a0710a6e-bffc-4971-8893-1c23addeb5b0" providerId="ADAL" clId="{5EDA080F-2DA0-41E9-BDBC-F9DEF976E495}" dt="2022-09-27T15:56:21.217" v="4638" actId="1037"/>
          <ac:spMkLst>
            <pc:docMk/>
            <pc:sldMk cId="1906182640" sldId="301"/>
            <ac:spMk id="15" creationId="{9DFC388E-DE0D-AE6C-385C-FD3003AC2203}"/>
          </ac:spMkLst>
        </pc:spChg>
        <pc:spChg chg="add mod">
          <ac:chgData name="Kumar, Vinod" userId="a0710a6e-bffc-4971-8893-1c23addeb5b0" providerId="ADAL" clId="{5EDA080F-2DA0-41E9-BDBC-F9DEF976E495}" dt="2022-09-27T15:56:25.458" v="4643" actId="1035"/>
          <ac:spMkLst>
            <pc:docMk/>
            <pc:sldMk cId="1906182640" sldId="301"/>
            <ac:spMk id="16" creationId="{D43D6E6D-7E71-3A47-7B6F-14ADACA5DD4F}"/>
          </ac:spMkLst>
        </pc:spChg>
        <pc:spChg chg="add mod">
          <ac:chgData name="Kumar, Vinod" userId="a0710a6e-bffc-4971-8893-1c23addeb5b0" providerId="ADAL" clId="{5EDA080F-2DA0-41E9-BDBC-F9DEF976E495}" dt="2022-09-27T15:56:32.481" v="4644" actId="1076"/>
          <ac:spMkLst>
            <pc:docMk/>
            <pc:sldMk cId="1906182640" sldId="301"/>
            <ac:spMk id="17" creationId="{132A6F4C-9B99-6D89-E28E-C82E07C5574C}"/>
          </ac:spMkLst>
        </pc:spChg>
        <pc:picChg chg="mod">
          <ac:chgData name="Kumar, Vinod" userId="a0710a6e-bffc-4971-8893-1c23addeb5b0" providerId="ADAL" clId="{5EDA080F-2DA0-41E9-BDBC-F9DEF976E495}" dt="2022-09-27T15:55:01.266" v="4590" actId="1076"/>
          <ac:picMkLst>
            <pc:docMk/>
            <pc:sldMk cId="1906182640" sldId="301"/>
            <ac:picMk id="3" creationId="{F450301E-C110-A500-66DC-9DFF82D67E68}"/>
          </ac:picMkLst>
        </pc:picChg>
        <pc:picChg chg="mod">
          <ac:chgData name="Kumar, Vinod" userId="a0710a6e-bffc-4971-8893-1c23addeb5b0" providerId="ADAL" clId="{5EDA080F-2DA0-41E9-BDBC-F9DEF976E495}" dt="2022-09-27T15:54:56.002" v="4589" actId="1038"/>
          <ac:picMkLst>
            <pc:docMk/>
            <pc:sldMk cId="1906182640" sldId="301"/>
            <ac:picMk id="4" creationId="{24CE3C75-504A-F2C4-D0C8-6091449C77F9}"/>
          </ac:picMkLst>
        </pc:picChg>
        <pc:picChg chg="mod">
          <ac:chgData name="Kumar, Vinod" userId="a0710a6e-bffc-4971-8893-1c23addeb5b0" providerId="ADAL" clId="{5EDA080F-2DA0-41E9-BDBC-F9DEF976E495}" dt="2022-09-27T15:54:50.307" v="4571" actId="1037"/>
          <ac:picMkLst>
            <pc:docMk/>
            <pc:sldMk cId="1906182640" sldId="301"/>
            <ac:picMk id="5" creationId="{5E9660E9-283C-4EE3-03D9-022782801718}"/>
          </ac:picMkLst>
        </pc:picChg>
        <pc:picChg chg="mod">
          <ac:chgData name="Kumar, Vinod" userId="a0710a6e-bffc-4971-8893-1c23addeb5b0" providerId="ADAL" clId="{5EDA080F-2DA0-41E9-BDBC-F9DEF976E495}" dt="2022-09-27T15:54:50.307" v="4571" actId="1037"/>
          <ac:picMkLst>
            <pc:docMk/>
            <pc:sldMk cId="1906182640" sldId="301"/>
            <ac:picMk id="6" creationId="{C2BE8F1A-3A90-90F3-8262-6BC91AEC0EEA}"/>
          </ac:picMkLst>
        </pc:picChg>
        <pc:picChg chg="mod">
          <ac:chgData name="Kumar, Vinod" userId="a0710a6e-bffc-4971-8893-1c23addeb5b0" providerId="ADAL" clId="{5EDA080F-2DA0-41E9-BDBC-F9DEF976E495}" dt="2022-09-27T15:54:39.906" v="4550" actId="1035"/>
          <ac:picMkLst>
            <pc:docMk/>
            <pc:sldMk cId="1906182640" sldId="301"/>
            <ac:picMk id="7" creationId="{DDC91D9D-B267-6A98-49A0-7F314A8D786B}"/>
          </ac:picMkLst>
        </pc:picChg>
        <pc:picChg chg="add del mod">
          <ac:chgData name="Kumar, Vinod" userId="a0710a6e-bffc-4971-8893-1c23addeb5b0" providerId="ADAL" clId="{5EDA080F-2DA0-41E9-BDBC-F9DEF976E495}" dt="2022-09-27T15:54:03.854" v="4334"/>
          <ac:picMkLst>
            <pc:docMk/>
            <pc:sldMk cId="1906182640" sldId="301"/>
            <ac:picMk id="8" creationId="{8086C6CD-0D37-DCF9-BA9D-1B58AC034BB4}"/>
          </ac:picMkLst>
        </pc:picChg>
        <pc:picChg chg="add del mod">
          <ac:chgData name="Kumar, Vinod" userId="a0710a6e-bffc-4971-8893-1c23addeb5b0" providerId="ADAL" clId="{5EDA080F-2DA0-41E9-BDBC-F9DEF976E495}" dt="2022-09-27T15:54:03.854" v="4334"/>
          <ac:picMkLst>
            <pc:docMk/>
            <pc:sldMk cId="1906182640" sldId="301"/>
            <ac:picMk id="9" creationId="{9F21BB78-514F-AD19-D1F2-CB2849FFB6EF}"/>
          </ac:picMkLst>
        </pc:picChg>
        <pc:picChg chg="add del mod">
          <ac:chgData name="Kumar, Vinod" userId="a0710a6e-bffc-4971-8893-1c23addeb5b0" providerId="ADAL" clId="{5EDA080F-2DA0-41E9-BDBC-F9DEF976E495}" dt="2022-09-27T15:54:03.854" v="4334"/>
          <ac:picMkLst>
            <pc:docMk/>
            <pc:sldMk cId="1906182640" sldId="301"/>
            <ac:picMk id="10" creationId="{D08A2F52-8DEB-4997-E338-F4F7842DC2A9}"/>
          </ac:picMkLst>
        </pc:picChg>
        <pc:picChg chg="add del mod">
          <ac:chgData name="Kumar, Vinod" userId="a0710a6e-bffc-4971-8893-1c23addeb5b0" providerId="ADAL" clId="{5EDA080F-2DA0-41E9-BDBC-F9DEF976E495}" dt="2022-09-27T15:54:03.854" v="4334"/>
          <ac:picMkLst>
            <pc:docMk/>
            <pc:sldMk cId="1906182640" sldId="301"/>
            <ac:picMk id="11" creationId="{553F9E04-3570-2E3D-D155-BB881FAEA81B}"/>
          </ac:picMkLst>
        </pc:picChg>
        <pc:picChg chg="add del mod">
          <ac:chgData name="Kumar, Vinod" userId="a0710a6e-bffc-4971-8893-1c23addeb5b0" providerId="ADAL" clId="{5EDA080F-2DA0-41E9-BDBC-F9DEF976E495}" dt="2022-09-27T15:54:03.854" v="4334"/>
          <ac:picMkLst>
            <pc:docMk/>
            <pc:sldMk cId="1906182640" sldId="301"/>
            <ac:picMk id="12" creationId="{CEC2A64C-24C5-6B27-EBA6-775744348F3C}"/>
          </ac:picMkLst>
        </pc:picChg>
      </pc:sldChg>
      <pc:sldChg chg="delSp modSp mod">
        <pc:chgData name="Kumar, Vinod" userId="a0710a6e-bffc-4971-8893-1c23addeb5b0" providerId="ADAL" clId="{5EDA080F-2DA0-41E9-BDBC-F9DEF976E495}" dt="2022-10-03T20:18:54.999" v="4657" actId="1076"/>
        <pc:sldMkLst>
          <pc:docMk/>
          <pc:sldMk cId="2244443222" sldId="302"/>
        </pc:sldMkLst>
        <pc:spChg chg="mod">
          <ac:chgData name="Kumar, Vinod" userId="a0710a6e-bffc-4971-8893-1c23addeb5b0" providerId="ADAL" clId="{5EDA080F-2DA0-41E9-BDBC-F9DEF976E495}" dt="2022-09-27T15:57:08.297" v="4645" actId="1076"/>
          <ac:spMkLst>
            <pc:docMk/>
            <pc:sldMk cId="2244443222" sldId="302"/>
            <ac:spMk id="2" creationId="{086F389C-2B07-5F00-EA2A-17A9729D565C}"/>
          </ac:spMkLst>
        </pc:spChg>
        <pc:picChg chg="mod modCrop">
          <ac:chgData name="Kumar, Vinod" userId="a0710a6e-bffc-4971-8893-1c23addeb5b0" providerId="ADAL" clId="{5EDA080F-2DA0-41E9-BDBC-F9DEF976E495}" dt="2022-10-03T20:18:54.999" v="4657" actId="1076"/>
          <ac:picMkLst>
            <pc:docMk/>
            <pc:sldMk cId="2244443222" sldId="302"/>
            <ac:picMk id="3" creationId="{490D06AC-BA4C-E2D3-CA27-A10AF7D09D40}"/>
          </ac:picMkLst>
        </pc:picChg>
        <pc:picChg chg="del mod">
          <ac:chgData name="Kumar, Vinod" userId="a0710a6e-bffc-4971-8893-1c23addeb5b0" providerId="ADAL" clId="{5EDA080F-2DA0-41E9-BDBC-F9DEF976E495}" dt="2022-10-03T20:18:52.584" v="4656" actId="478"/>
          <ac:picMkLst>
            <pc:docMk/>
            <pc:sldMk cId="2244443222" sldId="302"/>
            <ac:picMk id="4" creationId="{2F53E4B6-BBB8-C5F9-E0FB-6100B1C67A2D}"/>
          </ac:picMkLst>
        </pc:picChg>
      </pc:sldChg>
      <pc:sldChg chg="addSp modSp new mod">
        <pc:chgData name="Kumar, Vinod" userId="a0710a6e-bffc-4971-8893-1c23addeb5b0" providerId="ADAL" clId="{5EDA080F-2DA0-41E9-BDBC-F9DEF976E495}" dt="2022-09-27T14:51:39.436" v="13" actId="1076"/>
        <pc:sldMkLst>
          <pc:docMk/>
          <pc:sldMk cId="2794359920" sldId="303"/>
        </pc:sldMkLst>
        <pc:spChg chg="add mod">
          <ac:chgData name="Kumar, Vinod" userId="a0710a6e-bffc-4971-8893-1c23addeb5b0" providerId="ADAL" clId="{5EDA080F-2DA0-41E9-BDBC-F9DEF976E495}" dt="2022-09-27T14:51:22.948" v="11" actId="14100"/>
          <ac:spMkLst>
            <pc:docMk/>
            <pc:sldMk cId="2794359920" sldId="303"/>
            <ac:spMk id="2" creationId="{DFB14EE7-EEF6-61F7-41BC-5E90AAE62A50}"/>
          </ac:spMkLst>
        </pc:spChg>
        <pc:spChg chg="mod">
          <ac:chgData name="Kumar, Vinod" userId="a0710a6e-bffc-4971-8893-1c23addeb5b0" providerId="ADAL" clId="{5EDA080F-2DA0-41E9-BDBC-F9DEF976E495}" dt="2022-09-27T14:51:35.484" v="12"/>
          <ac:spMkLst>
            <pc:docMk/>
            <pc:sldMk cId="2794359920" sldId="303"/>
            <ac:spMk id="4" creationId="{34897CEC-8788-4E23-A2EB-129E341C1E2C}"/>
          </ac:spMkLst>
        </pc:spChg>
        <pc:spChg chg="mod">
          <ac:chgData name="Kumar, Vinod" userId="a0710a6e-bffc-4971-8893-1c23addeb5b0" providerId="ADAL" clId="{5EDA080F-2DA0-41E9-BDBC-F9DEF976E495}" dt="2022-09-27T14:51:35.484" v="12"/>
          <ac:spMkLst>
            <pc:docMk/>
            <pc:sldMk cId="2794359920" sldId="303"/>
            <ac:spMk id="5" creationId="{EBE000ED-B1A1-3050-3231-53F952EF004E}"/>
          </ac:spMkLst>
        </pc:spChg>
        <pc:spChg chg="mod">
          <ac:chgData name="Kumar, Vinod" userId="a0710a6e-bffc-4971-8893-1c23addeb5b0" providerId="ADAL" clId="{5EDA080F-2DA0-41E9-BDBC-F9DEF976E495}" dt="2022-09-27T14:51:35.484" v="12"/>
          <ac:spMkLst>
            <pc:docMk/>
            <pc:sldMk cId="2794359920" sldId="303"/>
            <ac:spMk id="6" creationId="{D598E17B-EB7B-D68E-071E-EAF0ECE784BD}"/>
          </ac:spMkLst>
        </pc:spChg>
        <pc:spChg chg="mod">
          <ac:chgData name="Kumar, Vinod" userId="a0710a6e-bffc-4971-8893-1c23addeb5b0" providerId="ADAL" clId="{5EDA080F-2DA0-41E9-BDBC-F9DEF976E495}" dt="2022-09-27T14:51:35.484" v="12"/>
          <ac:spMkLst>
            <pc:docMk/>
            <pc:sldMk cId="2794359920" sldId="303"/>
            <ac:spMk id="7" creationId="{B6E398F8-4570-6114-9D17-E136BFDC1614}"/>
          </ac:spMkLst>
        </pc:spChg>
        <pc:spChg chg="mod">
          <ac:chgData name="Kumar, Vinod" userId="a0710a6e-bffc-4971-8893-1c23addeb5b0" providerId="ADAL" clId="{5EDA080F-2DA0-41E9-BDBC-F9DEF976E495}" dt="2022-09-27T14:51:35.484" v="12"/>
          <ac:spMkLst>
            <pc:docMk/>
            <pc:sldMk cId="2794359920" sldId="303"/>
            <ac:spMk id="8" creationId="{8B182684-1A9D-EEA6-5871-DD72E987E31A}"/>
          </ac:spMkLst>
        </pc:spChg>
        <pc:spChg chg="mod">
          <ac:chgData name="Kumar, Vinod" userId="a0710a6e-bffc-4971-8893-1c23addeb5b0" providerId="ADAL" clId="{5EDA080F-2DA0-41E9-BDBC-F9DEF976E495}" dt="2022-09-27T14:51:35.484" v="12"/>
          <ac:spMkLst>
            <pc:docMk/>
            <pc:sldMk cId="2794359920" sldId="303"/>
            <ac:spMk id="9" creationId="{B5482599-9DD0-C32C-1446-5E037C93065E}"/>
          </ac:spMkLst>
        </pc:spChg>
        <pc:spChg chg="mod">
          <ac:chgData name="Kumar, Vinod" userId="a0710a6e-bffc-4971-8893-1c23addeb5b0" providerId="ADAL" clId="{5EDA080F-2DA0-41E9-BDBC-F9DEF976E495}" dt="2022-09-27T14:51:35.484" v="12"/>
          <ac:spMkLst>
            <pc:docMk/>
            <pc:sldMk cId="2794359920" sldId="303"/>
            <ac:spMk id="10" creationId="{F88FF6F7-3F90-A2CD-FEF6-B15AC9DE672B}"/>
          </ac:spMkLst>
        </pc:spChg>
        <pc:spChg chg="mod">
          <ac:chgData name="Kumar, Vinod" userId="a0710a6e-bffc-4971-8893-1c23addeb5b0" providerId="ADAL" clId="{5EDA080F-2DA0-41E9-BDBC-F9DEF976E495}" dt="2022-09-27T14:51:35.484" v="12"/>
          <ac:spMkLst>
            <pc:docMk/>
            <pc:sldMk cId="2794359920" sldId="303"/>
            <ac:spMk id="15" creationId="{F91BF159-A8AB-AE76-1D16-1E285CB2F48B}"/>
          </ac:spMkLst>
        </pc:spChg>
        <pc:spChg chg="mod">
          <ac:chgData name="Kumar, Vinod" userId="a0710a6e-bffc-4971-8893-1c23addeb5b0" providerId="ADAL" clId="{5EDA080F-2DA0-41E9-BDBC-F9DEF976E495}" dt="2022-09-27T14:51:35.484" v="12"/>
          <ac:spMkLst>
            <pc:docMk/>
            <pc:sldMk cId="2794359920" sldId="303"/>
            <ac:spMk id="16" creationId="{D0745951-7BFA-ACAA-D3B9-F109297E6D86}"/>
          </ac:spMkLst>
        </pc:spChg>
        <pc:spChg chg="mod">
          <ac:chgData name="Kumar, Vinod" userId="a0710a6e-bffc-4971-8893-1c23addeb5b0" providerId="ADAL" clId="{5EDA080F-2DA0-41E9-BDBC-F9DEF976E495}" dt="2022-09-27T14:51:35.484" v="12"/>
          <ac:spMkLst>
            <pc:docMk/>
            <pc:sldMk cId="2794359920" sldId="303"/>
            <ac:spMk id="18" creationId="{6BDF7E7D-EC93-091B-3714-48C043BEAA7B}"/>
          </ac:spMkLst>
        </pc:spChg>
        <pc:grpChg chg="add mod">
          <ac:chgData name="Kumar, Vinod" userId="a0710a6e-bffc-4971-8893-1c23addeb5b0" providerId="ADAL" clId="{5EDA080F-2DA0-41E9-BDBC-F9DEF976E495}" dt="2022-09-27T14:51:39.436" v="13" actId="1076"/>
          <ac:grpSpMkLst>
            <pc:docMk/>
            <pc:sldMk cId="2794359920" sldId="303"/>
            <ac:grpSpMk id="3" creationId="{70B0986A-4D6C-049C-C1CF-F0F78EBD7BD5}"/>
          </ac:grpSpMkLst>
        </pc:grpChg>
        <pc:picChg chg="mod">
          <ac:chgData name="Kumar, Vinod" userId="a0710a6e-bffc-4971-8893-1c23addeb5b0" providerId="ADAL" clId="{5EDA080F-2DA0-41E9-BDBC-F9DEF976E495}" dt="2022-09-27T14:51:35.484" v="12"/>
          <ac:picMkLst>
            <pc:docMk/>
            <pc:sldMk cId="2794359920" sldId="303"/>
            <ac:picMk id="11" creationId="{548D93EB-C38F-65EF-4A59-4F410E66F21E}"/>
          </ac:picMkLst>
        </pc:picChg>
        <pc:picChg chg="mod">
          <ac:chgData name="Kumar, Vinod" userId="a0710a6e-bffc-4971-8893-1c23addeb5b0" providerId="ADAL" clId="{5EDA080F-2DA0-41E9-BDBC-F9DEF976E495}" dt="2022-09-27T14:51:35.484" v="12"/>
          <ac:picMkLst>
            <pc:docMk/>
            <pc:sldMk cId="2794359920" sldId="303"/>
            <ac:picMk id="12" creationId="{BCF04BB9-FA09-3864-9A77-BBDBC91583A6}"/>
          </ac:picMkLst>
        </pc:picChg>
        <pc:picChg chg="mod">
          <ac:chgData name="Kumar, Vinod" userId="a0710a6e-bffc-4971-8893-1c23addeb5b0" providerId="ADAL" clId="{5EDA080F-2DA0-41E9-BDBC-F9DEF976E495}" dt="2022-09-27T14:51:35.484" v="12"/>
          <ac:picMkLst>
            <pc:docMk/>
            <pc:sldMk cId="2794359920" sldId="303"/>
            <ac:picMk id="17" creationId="{212EC4EF-77B3-5368-6E6B-A75EF87935BA}"/>
          </ac:picMkLst>
        </pc:picChg>
        <pc:cxnChg chg="mod">
          <ac:chgData name="Kumar, Vinod" userId="a0710a6e-bffc-4971-8893-1c23addeb5b0" providerId="ADAL" clId="{5EDA080F-2DA0-41E9-BDBC-F9DEF976E495}" dt="2022-09-27T14:51:35.484" v="12"/>
          <ac:cxnSpMkLst>
            <pc:docMk/>
            <pc:sldMk cId="2794359920" sldId="303"/>
            <ac:cxnSpMk id="13" creationId="{7A471A29-F0CC-D035-4611-68861ABA1583}"/>
          </ac:cxnSpMkLst>
        </pc:cxnChg>
        <pc:cxnChg chg="mod">
          <ac:chgData name="Kumar, Vinod" userId="a0710a6e-bffc-4971-8893-1c23addeb5b0" providerId="ADAL" clId="{5EDA080F-2DA0-41E9-BDBC-F9DEF976E495}" dt="2022-09-27T14:51:35.484" v="12"/>
          <ac:cxnSpMkLst>
            <pc:docMk/>
            <pc:sldMk cId="2794359920" sldId="303"/>
            <ac:cxnSpMk id="14" creationId="{F72EE062-61B2-5D71-EE1F-16D26BC6BF5A}"/>
          </ac:cxnSpMkLst>
        </pc:cxnChg>
      </pc:sldChg>
      <pc:sldChg chg="addSp modSp new mod">
        <pc:chgData name="Kumar, Vinod" userId="a0710a6e-bffc-4971-8893-1c23addeb5b0" providerId="ADAL" clId="{5EDA080F-2DA0-41E9-BDBC-F9DEF976E495}" dt="2022-09-27T15:07:45.307" v="420" actId="1038"/>
        <pc:sldMkLst>
          <pc:docMk/>
          <pc:sldMk cId="1896129938" sldId="304"/>
        </pc:sldMkLst>
        <pc:spChg chg="add mod">
          <ac:chgData name="Kumar, Vinod" userId="a0710a6e-bffc-4971-8893-1c23addeb5b0" providerId="ADAL" clId="{5EDA080F-2DA0-41E9-BDBC-F9DEF976E495}" dt="2022-09-27T15:02:21.550" v="152" actId="1037"/>
          <ac:spMkLst>
            <pc:docMk/>
            <pc:sldMk cId="1896129938" sldId="304"/>
            <ac:spMk id="12" creationId="{CB89E43C-D345-E71E-235D-A3F527A77971}"/>
          </ac:spMkLst>
        </pc:spChg>
        <pc:spChg chg="add mod">
          <ac:chgData name="Kumar, Vinod" userId="a0710a6e-bffc-4971-8893-1c23addeb5b0" providerId="ADAL" clId="{5EDA080F-2DA0-41E9-BDBC-F9DEF976E495}" dt="2022-09-27T15:06:48.045" v="411" actId="554"/>
          <ac:spMkLst>
            <pc:docMk/>
            <pc:sldMk cId="1896129938" sldId="304"/>
            <ac:spMk id="13" creationId="{2F5C69FE-8BBC-D30D-1B05-F82DAA14E149}"/>
          </ac:spMkLst>
        </pc:spChg>
        <pc:spChg chg="add mod">
          <ac:chgData name="Kumar, Vinod" userId="a0710a6e-bffc-4971-8893-1c23addeb5b0" providerId="ADAL" clId="{5EDA080F-2DA0-41E9-BDBC-F9DEF976E495}" dt="2022-09-27T15:06:48.045" v="411" actId="554"/>
          <ac:spMkLst>
            <pc:docMk/>
            <pc:sldMk cId="1896129938" sldId="304"/>
            <ac:spMk id="14" creationId="{DAB75DD1-567F-6F00-8AC6-BCC1C40187EE}"/>
          </ac:spMkLst>
        </pc:spChg>
        <pc:spChg chg="add mod">
          <ac:chgData name="Kumar, Vinod" userId="a0710a6e-bffc-4971-8893-1c23addeb5b0" providerId="ADAL" clId="{5EDA080F-2DA0-41E9-BDBC-F9DEF976E495}" dt="2022-09-27T15:07:14.908" v="415" actId="1036"/>
          <ac:spMkLst>
            <pc:docMk/>
            <pc:sldMk cId="1896129938" sldId="304"/>
            <ac:spMk id="15" creationId="{610AFE8D-6F14-0B41-CFAF-B50ED829F5E3}"/>
          </ac:spMkLst>
        </pc:spChg>
        <pc:spChg chg="add mod">
          <ac:chgData name="Kumar, Vinod" userId="a0710a6e-bffc-4971-8893-1c23addeb5b0" providerId="ADAL" clId="{5EDA080F-2DA0-41E9-BDBC-F9DEF976E495}" dt="2022-09-27T15:07:14.908" v="415" actId="1036"/>
          <ac:spMkLst>
            <pc:docMk/>
            <pc:sldMk cId="1896129938" sldId="304"/>
            <ac:spMk id="16" creationId="{4C832ACE-FAEF-F2D8-3BA1-1504FDF54A88}"/>
          </ac:spMkLst>
        </pc:spChg>
        <pc:spChg chg="add mod">
          <ac:chgData name="Kumar, Vinod" userId="a0710a6e-bffc-4971-8893-1c23addeb5b0" providerId="ADAL" clId="{5EDA080F-2DA0-41E9-BDBC-F9DEF976E495}" dt="2022-09-27T15:07:14.908" v="415" actId="1036"/>
          <ac:spMkLst>
            <pc:docMk/>
            <pc:sldMk cId="1896129938" sldId="304"/>
            <ac:spMk id="17" creationId="{4BA5D206-14F9-4C8F-570E-568E631E764E}"/>
          </ac:spMkLst>
        </pc:spChg>
        <pc:spChg chg="add mod">
          <ac:chgData name="Kumar, Vinod" userId="a0710a6e-bffc-4971-8893-1c23addeb5b0" providerId="ADAL" clId="{5EDA080F-2DA0-41E9-BDBC-F9DEF976E495}" dt="2022-09-27T15:04:51.516" v="319" actId="1035"/>
          <ac:spMkLst>
            <pc:docMk/>
            <pc:sldMk cId="1896129938" sldId="304"/>
            <ac:spMk id="18" creationId="{F868BCCD-1693-01CC-7EB6-FF78E61E1CA6}"/>
          </ac:spMkLst>
        </pc:spChg>
        <pc:spChg chg="add mod">
          <ac:chgData name="Kumar, Vinod" userId="a0710a6e-bffc-4971-8893-1c23addeb5b0" providerId="ADAL" clId="{5EDA080F-2DA0-41E9-BDBC-F9DEF976E495}" dt="2022-09-27T15:05:05.052" v="327" actId="1037"/>
          <ac:spMkLst>
            <pc:docMk/>
            <pc:sldMk cId="1896129938" sldId="304"/>
            <ac:spMk id="19" creationId="{7A6E65D4-7530-9F25-99BB-3E4A551CAB24}"/>
          </ac:spMkLst>
        </pc:spChg>
        <pc:spChg chg="add mod">
          <ac:chgData name="Kumar, Vinod" userId="a0710a6e-bffc-4971-8893-1c23addeb5b0" providerId="ADAL" clId="{5EDA080F-2DA0-41E9-BDBC-F9DEF976E495}" dt="2022-09-27T15:07:39.150" v="416" actId="554"/>
          <ac:spMkLst>
            <pc:docMk/>
            <pc:sldMk cId="1896129938" sldId="304"/>
            <ac:spMk id="20" creationId="{17D19281-5FA8-2431-7654-3B702A1DB4F2}"/>
          </ac:spMkLst>
        </pc:spChg>
        <pc:spChg chg="add mod">
          <ac:chgData name="Kumar, Vinod" userId="a0710a6e-bffc-4971-8893-1c23addeb5b0" providerId="ADAL" clId="{5EDA080F-2DA0-41E9-BDBC-F9DEF976E495}" dt="2022-09-27T15:06:48.045" v="411" actId="554"/>
          <ac:spMkLst>
            <pc:docMk/>
            <pc:sldMk cId="1896129938" sldId="304"/>
            <ac:spMk id="21" creationId="{4A1FD6FF-624A-06CB-8B80-7E181D684B98}"/>
          </ac:spMkLst>
        </pc:spChg>
        <pc:spChg chg="add mod">
          <ac:chgData name="Kumar, Vinod" userId="a0710a6e-bffc-4971-8893-1c23addeb5b0" providerId="ADAL" clId="{5EDA080F-2DA0-41E9-BDBC-F9DEF976E495}" dt="2022-09-27T15:07:45.307" v="420" actId="1038"/>
          <ac:spMkLst>
            <pc:docMk/>
            <pc:sldMk cId="1896129938" sldId="304"/>
            <ac:spMk id="22" creationId="{25C74B3F-1680-A9B4-192A-76BD7FD094F6}"/>
          </ac:spMkLst>
        </pc:spChg>
        <pc:picChg chg="mod">
          <ac:chgData name="Kumar, Vinod" userId="a0710a6e-bffc-4971-8893-1c23addeb5b0" providerId="ADAL" clId="{5EDA080F-2DA0-41E9-BDBC-F9DEF976E495}" dt="2022-09-27T15:02:33.245" v="154" actId="1036"/>
          <ac:picMkLst>
            <pc:docMk/>
            <pc:sldMk cId="1896129938" sldId="304"/>
            <ac:picMk id="2" creationId="{821457AD-B838-A9B5-FE77-286D2FC2EE7F}"/>
          </ac:picMkLst>
        </pc:picChg>
        <pc:picChg chg="mod">
          <ac:chgData name="Kumar, Vinod" userId="a0710a6e-bffc-4971-8893-1c23addeb5b0" providerId="ADAL" clId="{5EDA080F-2DA0-41E9-BDBC-F9DEF976E495}" dt="2022-09-27T15:02:33.245" v="154" actId="1036"/>
          <ac:picMkLst>
            <pc:docMk/>
            <pc:sldMk cId="1896129938" sldId="304"/>
            <ac:picMk id="3" creationId="{EE6D6DA0-B2C8-C062-6E93-1EAB0B1DB695}"/>
          </ac:picMkLst>
        </pc:picChg>
        <pc:picChg chg="mod">
          <ac:chgData name="Kumar, Vinod" userId="a0710a6e-bffc-4971-8893-1c23addeb5b0" providerId="ADAL" clId="{5EDA080F-2DA0-41E9-BDBC-F9DEF976E495}" dt="2022-09-27T15:02:33.245" v="154" actId="1036"/>
          <ac:picMkLst>
            <pc:docMk/>
            <pc:sldMk cId="1896129938" sldId="304"/>
            <ac:picMk id="4" creationId="{FEF77DA4-5EBA-204F-C216-45C4D4BAFC59}"/>
          </ac:picMkLst>
        </pc:picChg>
        <pc:picChg chg="mod">
          <ac:chgData name="Kumar, Vinod" userId="a0710a6e-bffc-4971-8893-1c23addeb5b0" providerId="ADAL" clId="{5EDA080F-2DA0-41E9-BDBC-F9DEF976E495}" dt="2022-09-27T15:06:58.123" v="412" actId="1036"/>
          <ac:picMkLst>
            <pc:docMk/>
            <pc:sldMk cId="1896129938" sldId="304"/>
            <ac:picMk id="5" creationId="{9BFF4654-44C7-681D-AE78-BB30710F7D35}"/>
          </ac:picMkLst>
        </pc:picChg>
        <pc:picChg chg="mod">
          <ac:chgData name="Kumar, Vinod" userId="a0710a6e-bffc-4971-8893-1c23addeb5b0" providerId="ADAL" clId="{5EDA080F-2DA0-41E9-BDBC-F9DEF976E495}" dt="2022-09-27T15:02:48.318" v="160" actId="1035"/>
          <ac:picMkLst>
            <pc:docMk/>
            <pc:sldMk cId="1896129938" sldId="304"/>
            <ac:picMk id="6" creationId="{77B86128-5341-8C8D-B634-105ECB5031E9}"/>
          </ac:picMkLst>
        </pc:picChg>
        <pc:picChg chg="mod">
          <ac:chgData name="Kumar, Vinod" userId="a0710a6e-bffc-4971-8893-1c23addeb5b0" providerId="ADAL" clId="{5EDA080F-2DA0-41E9-BDBC-F9DEF976E495}" dt="2022-09-27T15:02:48.318" v="160" actId="1035"/>
          <ac:picMkLst>
            <pc:docMk/>
            <pc:sldMk cId="1896129938" sldId="304"/>
            <ac:picMk id="7" creationId="{F5618D52-7D96-8F92-5FE3-593C006CE318}"/>
          </ac:picMkLst>
        </pc:picChg>
        <pc:picChg chg="add mod">
          <ac:chgData name="Kumar, Vinod" userId="a0710a6e-bffc-4971-8893-1c23addeb5b0" providerId="ADAL" clId="{5EDA080F-2DA0-41E9-BDBC-F9DEF976E495}" dt="2022-09-27T15:03:09.821" v="194" actId="1036"/>
          <ac:picMkLst>
            <pc:docMk/>
            <pc:sldMk cId="1896129938" sldId="304"/>
            <ac:picMk id="8" creationId="{0C4AC514-70B9-2E08-FC10-F47116B8336F}"/>
          </ac:picMkLst>
        </pc:picChg>
        <pc:picChg chg="add mod">
          <ac:chgData name="Kumar, Vinod" userId="a0710a6e-bffc-4971-8893-1c23addeb5b0" providerId="ADAL" clId="{5EDA080F-2DA0-41E9-BDBC-F9DEF976E495}" dt="2022-09-27T15:03:04.429" v="188" actId="1037"/>
          <ac:picMkLst>
            <pc:docMk/>
            <pc:sldMk cId="1896129938" sldId="304"/>
            <ac:picMk id="9" creationId="{D1FC962E-10B2-373B-99E4-D8B804AFEF48}"/>
          </ac:picMkLst>
        </pc:picChg>
        <pc:picChg chg="mod">
          <ac:chgData name="Kumar, Vinod" userId="a0710a6e-bffc-4971-8893-1c23addeb5b0" providerId="ADAL" clId="{5EDA080F-2DA0-41E9-BDBC-F9DEF976E495}" dt="2022-09-27T15:06:15.100" v="410" actId="1037"/>
          <ac:picMkLst>
            <pc:docMk/>
            <pc:sldMk cId="1896129938" sldId="304"/>
            <ac:picMk id="10" creationId="{5BC61CC7-A994-BE81-FF4B-0830F771FB05}"/>
          </ac:picMkLst>
        </pc:picChg>
        <pc:picChg chg="add mod">
          <ac:chgData name="Kumar, Vinod" userId="a0710a6e-bffc-4971-8893-1c23addeb5b0" providerId="ADAL" clId="{5EDA080F-2DA0-41E9-BDBC-F9DEF976E495}" dt="2022-09-27T15:02:55.677" v="176" actId="1038"/>
          <ac:picMkLst>
            <pc:docMk/>
            <pc:sldMk cId="1896129938" sldId="304"/>
            <ac:picMk id="11" creationId="{AC942B19-435C-C329-C1CF-07D259C4A3EB}"/>
          </ac:picMkLst>
        </pc:picChg>
      </pc:sldChg>
      <pc:sldChg chg="new del">
        <pc:chgData name="Kumar, Vinod" userId="a0710a6e-bffc-4971-8893-1c23addeb5b0" providerId="ADAL" clId="{5EDA080F-2DA0-41E9-BDBC-F9DEF976E495}" dt="2022-09-27T15:33:56.438" v="2861" actId="680"/>
        <pc:sldMkLst>
          <pc:docMk/>
          <pc:sldMk cId="1646384783" sldId="305"/>
        </pc:sldMkLst>
      </pc:sldChg>
      <pc:sldMasterChg chg="modSp modSldLayout">
        <pc:chgData name="Kumar, Vinod" userId="a0710a6e-bffc-4971-8893-1c23addeb5b0" providerId="ADAL" clId="{5EDA080F-2DA0-41E9-BDBC-F9DEF976E495}" dt="2022-09-27T14:47:56.106" v="1"/>
        <pc:sldMasterMkLst>
          <pc:docMk/>
          <pc:sldMasterMk cId="3914622585" sldId="2147483648"/>
        </pc:sldMasterMkLst>
        <pc:spChg chg="mod">
          <ac:chgData name="Kumar, Vinod" userId="a0710a6e-bffc-4971-8893-1c23addeb5b0" providerId="ADAL" clId="{5EDA080F-2DA0-41E9-BDBC-F9DEF976E495}" dt="2022-09-27T14:47:56.106" v="1"/>
          <ac:spMkLst>
            <pc:docMk/>
            <pc:sldMasterMk cId="3914622585" sldId="2147483648"/>
            <ac:spMk id="2" creationId="{00000000-0000-0000-0000-000000000000}"/>
          </ac:spMkLst>
        </pc:spChg>
        <pc:spChg chg="mod">
          <ac:chgData name="Kumar, Vinod" userId="a0710a6e-bffc-4971-8893-1c23addeb5b0" providerId="ADAL" clId="{5EDA080F-2DA0-41E9-BDBC-F9DEF976E495}" dt="2022-09-27T14:47:56.106" v="1"/>
          <ac:spMkLst>
            <pc:docMk/>
            <pc:sldMasterMk cId="3914622585" sldId="2147483648"/>
            <ac:spMk id="3" creationId="{00000000-0000-0000-0000-000000000000}"/>
          </ac:spMkLst>
        </pc:spChg>
        <pc:spChg chg="mod">
          <ac:chgData name="Kumar, Vinod" userId="a0710a6e-bffc-4971-8893-1c23addeb5b0" providerId="ADAL" clId="{5EDA080F-2DA0-41E9-BDBC-F9DEF976E495}" dt="2022-09-27T14:47:56.106" v="1"/>
          <ac:spMkLst>
            <pc:docMk/>
            <pc:sldMasterMk cId="3914622585" sldId="2147483648"/>
            <ac:spMk id="4" creationId="{00000000-0000-0000-0000-000000000000}"/>
          </ac:spMkLst>
        </pc:spChg>
        <pc:spChg chg="mod">
          <ac:chgData name="Kumar, Vinod" userId="a0710a6e-bffc-4971-8893-1c23addeb5b0" providerId="ADAL" clId="{5EDA080F-2DA0-41E9-BDBC-F9DEF976E495}" dt="2022-09-27T14:47:56.106" v="1"/>
          <ac:spMkLst>
            <pc:docMk/>
            <pc:sldMasterMk cId="3914622585" sldId="2147483648"/>
            <ac:spMk id="5" creationId="{00000000-0000-0000-0000-000000000000}"/>
          </ac:spMkLst>
        </pc:spChg>
        <pc:spChg chg="mod">
          <ac:chgData name="Kumar, Vinod" userId="a0710a6e-bffc-4971-8893-1c23addeb5b0" providerId="ADAL" clId="{5EDA080F-2DA0-41E9-BDBC-F9DEF976E495}" dt="2022-09-27T14:47:56.106" v="1"/>
          <ac:spMkLst>
            <pc:docMk/>
            <pc:sldMasterMk cId="3914622585" sldId="2147483648"/>
            <ac:spMk id="6" creationId="{00000000-0000-0000-0000-000000000000}"/>
          </ac:spMkLst>
        </pc:spChg>
        <pc:sldLayoutChg chg="modSp">
          <pc:chgData name="Kumar, Vinod" userId="a0710a6e-bffc-4971-8893-1c23addeb5b0" providerId="ADAL" clId="{5EDA080F-2DA0-41E9-BDBC-F9DEF976E495}" dt="2022-09-27T14:47:56.106" v="1"/>
          <pc:sldLayoutMkLst>
            <pc:docMk/>
            <pc:sldMasterMk cId="3914622585" sldId="2147483648"/>
            <pc:sldLayoutMk cId="2235332659" sldId="2147483649"/>
          </pc:sldLayoutMkLst>
          <pc:spChg chg="mod">
            <ac:chgData name="Kumar, Vinod" userId="a0710a6e-bffc-4971-8893-1c23addeb5b0" providerId="ADAL" clId="{5EDA080F-2DA0-41E9-BDBC-F9DEF976E495}" dt="2022-09-27T14:47:56.106" v="1"/>
            <ac:spMkLst>
              <pc:docMk/>
              <pc:sldMasterMk cId="3914622585" sldId="2147483648"/>
              <pc:sldLayoutMk cId="2235332659" sldId="2147483649"/>
              <ac:spMk id="2" creationId="{00000000-0000-0000-0000-000000000000}"/>
            </ac:spMkLst>
          </pc:spChg>
          <pc:spChg chg="mod">
            <ac:chgData name="Kumar, Vinod" userId="a0710a6e-bffc-4971-8893-1c23addeb5b0" providerId="ADAL" clId="{5EDA080F-2DA0-41E9-BDBC-F9DEF976E495}" dt="2022-09-27T14:47:56.106" v="1"/>
            <ac:spMkLst>
              <pc:docMk/>
              <pc:sldMasterMk cId="3914622585" sldId="2147483648"/>
              <pc:sldLayoutMk cId="2235332659" sldId="2147483649"/>
              <ac:spMk id="3" creationId="{00000000-0000-0000-0000-000000000000}"/>
            </ac:spMkLst>
          </pc:spChg>
        </pc:sldLayoutChg>
        <pc:sldLayoutChg chg="modSp">
          <pc:chgData name="Kumar, Vinod" userId="a0710a6e-bffc-4971-8893-1c23addeb5b0" providerId="ADAL" clId="{5EDA080F-2DA0-41E9-BDBC-F9DEF976E495}" dt="2022-09-27T14:47:56.106" v="1"/>
          <pc:sldLayoutMkLst>
            <pc:docMk/>
            <pc:sldMasterMk cId="3914622585" sldId="2147483648"/>
            <pc:sldLayoutMk cId="1243618863" sldId="2147483651"/>
          </pc:sldLayoutMkLst>
          <pc:spChg chg="mod">
            <ac:chgData name="Kumar, Vinod" userId="a0710a6e-bffc-4971-8893-1c23addeb5b0" providerId="ADAL" clId="{5EDA080F-2DA0-41E9-BDBC-F9DEF976E495}" dt="2022-09-27T14:47:56.106" v="1"/>
            <ac:spMkLst>
              <pc:docMk/>
              <pc:sldMasterMk cId="3914622585" sldId="2147483648"/>
              <pc:sldLayoutMk cId="1243618863" sldId="2147483651"/>
              <ac:spMk id="2" creationId="{00000000-0000-0000-0000-000000000000}"/>
            </ac:spMkLst>
          </pc:spChg>
          <pc:spChg chg="mod">
            <ac:chgData name="Kumar, Vinod" userId="a0710a6e-bffc-4971-8893-1c23addeb5b0" providerId="ADAL" clId="{5EDA080F-2DA0-41E9-BDBC-F9DEF976E495}" dt="2022-09-27T14:47:56.106" v="1"/>
            <ac:spMkLst>
              <pc:docMk/>
              <pc:sldMasterMk cId="3914622585" sldId="2147483648"/>
              <pc:sldLayoutMk cId="1243618863" sldId="2147483651"/>
              <ac:spMk id="3" creationId="{00000000-0000-0000-0000-000000000000}"/>
            </ac:spMkLst>
          </pc:spChg>
        </pc:sldLayoutChg>
        <pc:sldLayoutChg chg="modSp">
          <pc:chgData name="Kumar, Vinod" userId="a0710a6e-bffc-4971-8893-1c23addeb5b0" providerId="ADAL" clId="{5EDA080F-2DA0-41E9-BDBC-F9DEF976E495}" dt="2022-09-27T14:47:56.106" v="1"/>
          <pc:sldLayoutMkLst>
            <pc:docMk/>
            <pc:sldMasterMk cId="3914622585" sldId="2147483648"/>
            <pc:sldLayoutMk cId="1526335031" sldId="2147483652"/>
          </pc:sldLayoutMkLst>
          <pc:spChg chg="mod">
            <ac:chgData name="Kumar, Vinod" userId="a0710a6e-bffc-4971-8893-1c23addeb5b0" providerId="ADAL" clId="{5EDA080F-2DA0-41E9-BDBC-F9DEF976E495}" dt="2022-09-27T14:47:56.106" v="1"/>
            <ac:spMkLst>
              <pc:docMk/>
              <pc:sldMasterMk cId="3914622585" sldId="2147483648"/>
              <pc:sldLayoutMk cId="1526335031" sldId="2147483652"/>
              <ac:spMk id="3" creationId="{00000000-0000-0000-0000-000000000000}"/>
            </ac:spMkLst>
          </pc:spChg>
          <pc:spChg chg="mod">
            <ac:chgData name="Kumar, Vinod" userId="a0710a6e-bffc-4971-8893-1c23addeb5b0" providerId="ADAL" clId="{5EDA080F-2DA0-41E9-BDBC-F9DEF976E495}" dt="2022-09-27T14:47:56.106" v="1"/>
            <ac:spMkLst>
              <pc:docMk/>
              <pc:sldMasterMk cId="3914622585" sldId="2147483648"/>
              <pc:sldLayoutMk cId="1526335031" sldId="2147483652"/>
              <ac:spMk id="4" creationId="{00000000-0000-0000-0000-000000000000}"/>
            </ac:spMkLst>
          </pc:spChg>
        </pc:sldLayoutChg>
        <pc:sldLayoutChg chg="modSp">
          <pc:chgData name="Kumar, Vinod" userId="a0710a6e-bffc-4971-8893-1c23addeb5b0" providerId="ADAL" clId="{5EDA080F-2DA0-41E9-BDBC-F9DEF976E495}" dt="2022-09-27T14:47:56.106" v="1"/>
          <pc:sldLayoutMkLst>
            <pc:docMk/>
            <pc:sldMasterMk cId="3914622585" sldId="2147483648"/>
            <pc:sldLayoutMk cId="3344597230" sldId="2147483653"/>
          </pc:sldLayoutMkLst>
          <pc:spChg chg="mod">
            <ac:chgData name="Kumar, Vinod" userId="a0710a6e-bffc-4971-8893-1c23addeb5b0" providerId="ADAL" clId="{5EDA080F-2DA0-41E9-BDBC-F9DEF976E495}" dt="2022-09-27T14:47:56.106" v="1"/>
            <ac:spMkLst>
              <pc:docMk/>
              <pc:sldMasterMk cId="3914622585" sldId="2147483648"/>
              <pc:sldLayoutMk cId="3344597230" sldId="2147483653"/>
              <ac:spMk id="3" creationId="{00000000-0000-0000-0000-000000000000}"/>
            </ac:spMkLst>
          </pc:spChg>
          <pc:spChg chg="mod">
            <ac:chgData name="Kumar, Vinod" userId="a0710a6e-bffc-4971-8893-1c23addeb5b0" providerId="ADAL" clId="{5EDA080F-2DA0-41E9-BDBC-F9DEF976E495}" dt="2022-09-27T14:47:56.106" v="1"/>
            <ac:spMkLst>
              <pc:docMk/>
              <pc:sldMasterMk cId="3914622585" sldId="2147483648"/>
              <pc:sldLayoutMk cId="3344597230" sldId="2147483653"/>
              <ac:spMk id="4" creationId="{00000000-0000-0000-0000-000000000000}"/>
            </ac:spMkLst>
          </pc:spChg>
          <pc:spChg chg="mod">
            <ac:chgData name="Kumar, Vinod" userId="a0710a6e-bffc-4971-8893-1c23addeb5b0" providerId="ADAL" clId="{5EDA080F-2DA0-41E9-BDBC-F9DEF976E495}" dt="2022-09-27T14:47:56.106" v="1"/>
            <ac:spMkLst>
              <pc:docMk/>
              <pc:sldMasterMk cId="3914622585" sldId="2147483648"/>
              <pc:sldLayoutMk cId="3344597230" sldId="2147483653"/>
              <ac:spMk id="5" creationId="{00000000-0000-0000-0000-000000000000}"/>
            </ac:spMkLst>
          </pc:spChg>
          <pc:spChg chg="mod">
            <ac:chgData name="Kumar, Vinod" userId="a0710a6e-bffc-4971-8893-1c23addeb5b0" providerId="ADAL" clId="{5EDA080F-2DA0-41E9-BDBC-F9DEF976E495}" dt="2022-09-27T14:47:56.106" v="1"/>
            <ac:spMkLst>
              <pc:docMk/>
              <pc:sldMasterMk cId="3914622585" sldId="2147483648"/>
              <pc:sldLayoutMk cId="3344597230" sldId="2147483653"/>
              <ac:spMk id="6" creationId="{00000000-0000-0000-0000-000000000000}"/>
            </ac:spMkLst>
          </pc:spChg>
        </pc:sldLayoutChg>
        <pc:sldLayoutChg chg="modSp">
          <pc:chgData name="Kumar, Vinod" userId="a0710a6e-bffc-4971-8893-1c23addeb5b0" providerId="ADAL" clId="{5EDA080F-2DA0-41E9-BDBC-F9DEF976E495}" dt="2022-09-27T14:47:56.106" v="1"/>
          <pc:sldLayoutMkLst>
            <pc:docMk/>
            <pc:sldMasterMk cId="3914622585" sldId="2147483648"/>
            <pc:sldLayoutMk cId="885911509" sldId="2147483656"/>
          </pc:sldLayoutMkLst>
          <pc:spChg chg="mod">
            <ac:chgData name="Kumar, Vinod" userId="a0710a6e-bffc-4971-8893-1c23addeb5b0" providerId="ADAL" clId="{5EDA080F-2DA0-41E9-BDBC-F9DEF976E495}" dt="2022-09-27T14:47:56.106" v="1"/>
            <ac:spMkLst>
              <pc:docMk/>
              <pc:sldMasterMk cId="3914622585" sldId="2147483648"/>
              <pc:sldLayoutMk cId="885911509" sldId="2147483656"/>
              <ac:spMk id="2" creationId="{00000000-0000-0000-0000-000000000000}"/>
            </ac:spMkLst>
          </pc:spChg>
          <pc:spChg chg="mod">
            <ac:chgData name="Kumar, Vinod" userId="a0710a6e-bffc-4971-8893-1c23addeb5b0" providerId="ADAL" clId="{5EDA080F-2DA0-41E9-BDBC-F9DEF976E495}" dt="2022-09-27T14:47:56.106" v="1"/>
            <ac:spMkLst>
              <pc:docMk/>
              <pc:sldMasterMk cId="3914622585" sldId="2147483648"/>
              <pc:sldLayoutMk cId="885911509" sldId="2147483656"/>
              <ac:spMk id="3" creationId="{00000000-0000-0000-0000-000000000000}"/>
            </ac:spMkLst>
          </pc:spChg>
          <pc:spChg chg="mod">
            <ac:chgData name="Kumar, Vinod" userId="a0710a6e-bffc-4971-8893-1c23addeb5b0" providerId="ADAL" clId="{5EDA080F-2DA0-41E9-BDBC-F9DEF976E495}" dt="2022-09-27T14:47:56.106" v="1"/>
            <ac:spMkLst>
              <pc:docMk/>
              <pc:sldMasterMk cId="3914622585" sldId="2147483648"/>
              <pc:sldLayoutMk cId="885911509" sldId="2147483656"/>
              <ac:spMk id="4" creationId="{00000000-0000-0000-0000-000000000000}"/>
            </ac:spMkLst>
          </pc:spChg>
        </pc:sldLayoutChg>
        <pc:sldLayoutChg chg="modSp">
          <pc:chgData name="Kumar, Vinod" userId="a0710a6e-bffc-4971-8893-1c23addeb5b0" providerId="ADAL" clId="{5EDA080F-2DA0-41E9-BDBC-F9DEF976E495}" dt="2022-09-27T14:47:56.106" v="1"/>
          <pc:sldLayoutMkLst>
            <pc:docMk/>
            <pc:sldMasterMk cId="3914622585" sldId="2147483648"/>
            <pc:sldLayoutMk cId="2269585229" sldId="2147483657"/>
          </pc:sldLayoutMkLst>
          <pc:spChg chg="mod">
            <ac:chgData name="Kumar, Vinod" userId="a0710a6e-bffc-4971-8893-1c23addeb5b0" providerId="ADAL" clId="{5EDA080F-2DA0-41E9-BDBC-F9DEF976E495}" dt="2022-09-27T14:47:56.106" v="1"/>
            <ac:spMkLst>
              <pc:docMk/>
              <pc:sldMasterMk cId="3914622585" sldId="2147483648"/>
              <pc:sldLayoutMk cId="2269585229" sldId="2147483657"/>
              <ac:spMk id="2" creationId="{00000000-0000-0000-0000-000000000000}"/>
            </ac:spMkLst>
          </pc:spChg>
          <pc:spChg chg="mod">
            <ac:chgData name="Kumar, Vinod" userId="a0710a6e-bffc-4971-8893-1c23addeb5b0" providerId="ADAL" clId="{5EDA080F-2DA0-41E9-BDBC-F9DEF976E495}" dt="2022-09-27T14:47:56.106" v="1"/>
            <ac:spMkLst>
              <pc:docMk/>
              <pc:sldMasterMk cId="3914622585" sldId="2147483648"/>
              <pc:sldLayoutMk cId="2269585229" sldId="2147483657"/>
              <ac:spMk id="3" creationId="{00000000-0000-0000-0000-000000000000}"/>
            </ac:spMkLst>
          </pc:spChg>
          <pc:spChg chg="mod">
            <ac:chgData name="Kumar, Vinod" userId="a0710a6e-bffc-4971-8893-1c23addeb5b0" providerId="ADAL" clId="{5EDA080F-2DA0-41E9-BDBC-F9DEF976E495}" dt="2022-09-27T14:47:56.106" v="1"/>
            <ac:spMkLst>
              <pc:docMk/>
              <pc:sldMasterMk cId="3914622585" sldId="2147483648"/>
              <pc:sldLayoutMk cId="2269585229" sldId="2147483657"/>
              <ac:spMk id="4" creationId="{00000000-0000-0000-0000-000000000000}"/>
            </ac:spMkLst>
          </pc:spChg>
        </pc:sldLayoutChg>
        <pc:sldLayoutChg chg="modSp">
          <pc:chgData name="Kumar, Vinod" userId="a0710a6e-bffc-4971-8893-1c23addeb5b0" providerId="ADAL" clId="{5EDA080F-2DA0-41E9-BDBC-F9DEF976E495}" dt="2022-09-27T14:47:56.106" v="1"/>
          <pc:sldLayoutMkLst>
            <pc:docMk/>
            <pc:sldMasterMk cId="3914622585" sldId="2147483648"/>
            <pc:sldLayoutMk cId="3430517481" sldId="2147483659"/>
          </pc:sldLayoutMkLst>
          <pc:spChg chg="mod">
            <ac:chgData name="Kumar, Vinod" userId="a0710a6e-bffc-4971-8893-1c23addeb5b0" providerId="ADAL" clId="{5EDA080F-2DA0-41E9-BDBC-F9DEF976E495}" dt="2022-09-27T14:47:56.106" v="1"/>
            <ac:spMkLst>
              <pc:docMk/>
              <pc:sldMasterMk cId="3914622585" sldId="2147483648"/>
              <pc:sldLayoutMk cId="3430517481" sldId="2147483659"/>
              <ac:spMk id="2" creationId="{00000000-0000-0000-0000-000000000000}"/>
            </ac:spMkLst>
          </pc:spChg>
          <pc:spChg chg="mod">
            <ac:chgData name="Kumar, Vinod" userId="a0710a6e-bffc-4971-8893-1c23addeb5b0" providerId="ADAL" clId="{5EDA080F-2DA0-41E9-BDBC-F9DEF976E495}" dt="2022-09-27T14:47:56.106" v="1"/>
            <ac:spMkLst>
              <pc:docMk/>
              <pc:sldMasterMk cId="3914622585" sldId="2147483648"/>
              <pc:sldLayoutMk cId="3430517481" sldId="2147483659"/>
              <ac:spMk id="3" creationId="{00000000-0000-0000-0000-000000000000}"/>
            </ac:spMkLst>
          </pc:spChg>
        </pc:sldLayoutChg>
      </pc:sldMasterChg>
    </pc:docChg>
  </pc:docChgLst>
  <pc:docChgLst>
    <pc:chgData name="Kumar, Vinod" userId="a0710a6e-bffc-4971-8893-1c23addeb5b0" providerId="ADAL" clId="{C5505734-0C3B-44E8-9046-CA4BB1B80E9C}"/>
    <pc:docChg chg="undo redo custSel addSld delSld modSld">
      <pc:chgData name="Kumar, Vinod" userId="a0710a6e-bffc-4971-8893-1c23addeb5b0" providerId="ADAL" clId="{C5505734-0C3B-44E8-9046-CA4BB1B80E9C}" dt="2022-11-18T15:08:41.571" v="1346" actId="1036"/>
      <pc:docMkLst>
        <pc:docMk/>
      </pc:docMkLst>
      <pc:sldChg chg="del">
        <pc:chgData name="Kumar, Vinod" userId="a0710a6e-bffc-4971-8893-1c23addeb5b0" providerId="ADAL" clId="{C5505734-0C3B-44E8-9046-CA4BB1B80E9C}" dt="2022-11-02T20:40:07.421" v="51" actId="47"/>
        <pc:sldMkLst>
          <pc:docMk/>
          <pc:sldMk cId="51599060" sldId="294"/>
        </pc:sldMkLst>
      </pc:sldChg>
      <pc:sldChg chg="del">
        <pc:chgData name="Kumar, Vinod" userId="a0710a6e-bffc-4971-8893-1c23addeb5b0" providerId="ADAL" clId="{C5505734-0C3B-44E8-9046-CA4BB1B80E9C}" dt="2022-11-02T20:40:07.421" v="51" actId="47"/>
        <pc:sldMkLst>
          <pc:docMk/>
          <pc:sldMk cId="3985943826" sldId="298"/>
        </pc:sldMkLst>
      </pc:sldChg>
      <pc:sldChg chg="modSp mod">
        <pc:chgData name="Kumar, Vinod" userId="a0710a6e-bffc-4971-8893-1c23addeb5b0" providerId="ADAL" clId="{C5505734-0C3B-44E8-9046-CA4BB1B80E9C}" dt="2022-11-02T20:40:16.508" v="52" actId="20577"/>
        <pc:sldMkLst>
          <pc:docMk/>
          <pc:sldMk cId="2498213667" sldId="299"/>
        </pc:sldMkLst>
        <pc:spChg chg="mod">
          <ac:chgData name="Kumar, Vinod" userId="a0710a6e-bffc-4971-8893-1c23addeb5b0" providerId="ADAL" clId="{C5505734-0C3B-44E8-9046-CA4BB1B80E9C}" dt="2022-11-02T20:40:16.508" v="52" actId="20577"/>
          <ac:spMkLst>
            <pc:docMk/>
            <pc:sldMk cId="2498213667" sldId="299"/>
            <ac:spMk id="2" creationId="{51D40CE4-17B2-7A16-E7B1-F6DFB55A0FA0}"/>
          </ac:spMkLst>
        </pc:spChg>
      </pc:sldChg>
      <pc:sldChg chg="modSp mod">
        <pc:chgData name="Kumar, Vinod" userId="a0710a6e-bffc-4971-8893-1c23addeb5b0" providerId="ADAL" clId="{C5505734-0C3B-44E8-9046-CA4BB1B80E9C}" dt="2022-11-02T20:40:26.987" v="54" actId="6549"/>
        <pc:sldMkLst>
          <pc:docMk/>
          <pc:sldMk cId="2313405284" sldId="300"/>
        </pc:sldMkLst>
        <pc:spChg chg="mod">
          <ac:chgData name="Kumar, Vinod" userId="a0710a6e-bffc-4971-8893-1c23addeb5b0" providerId="ADAL" clId="{C5505734-0C3B-44E8-9046-CA4BB1B80E9C}" dt="2022-11-02T20:40:26.987" v="54" actId="6549"/>
          <ac:spMkLst>
            <pc:docMk/>
            <pc:sldMk cId="2313405284" sldId="300"/>
            <ac:spMk id="2" creationId="{E836C5DC-7746-C954-BC1F-3B9F0DA30868}"/>
          </ac:spMkLst>
        </pc:spChg>
      </pc:sldChg>
      <pc:sldChg chg="modSp mod">
        <pc:chgData name="Kumar, Vinod" userId="a0710a6e-bffc-4971-8893-1c23addeb5b0" providerId="ADAL" clId="{C5505734-0C3B-44E8-9046-CA4BB1B80E9C}" dt="2022-11-02T20:40:34.635" v="55" actId="20577"/>
        <pc:sldMkLst>
          <pc:docMk/>
          <pc:sldMk cId="1906182640" sldId="301"/>
        </pc:sldMkLst>
        <pc:spChg chg="mod">
          <ac:chgData name="Kumar, Vinod" userId="a0710a6e-bffc-4971-8893-1c23addeb5b0" providerId="ADAL" clId="{C5505734-0C3B-44E8-9046-CA4BB1B80E9C}" dt="2022-11-02T20:40:34.635" v="55" actId="20577"/>
          <ac:spMkLst>
            <pc:docMk/>
            <pc:sldMk cId="1906182640" sldId="301"/>
            <ac:spMk id="2" creationId="{2F989969-700A-D7EB-7E3D-52DE0231C0F0}"/>
          </ac:spMkLst>
        </pc:spChg>
      </pc:sldChg>
      <pc:sldChg chg="addSp modSp mod">
        <pc:chgData name="Kumar, Vinod" userId="a0710a6e-bffc-4971-8893-1c23addeb5b0" providerId="ADAL" clId="{C5505734-0C3B-44E8-9046-CA4BB1B80E9C}" dt="2022-11-03T15:05:48.124" v="573" actId="1076"/>
        <pc:sldMkLst>
          <pc:docMk/>
          <pc:sldMk cId="2244443222" sldId="302"/>
        </pc:sldMkLst>
        <pc:spChg chg="add mod">
          <ac:chgData name="Kumar, Vinod" userId="a0710a6e-bffc-4971-8893-1c23addeb5b0" providerId="ADAL" clId="{C5505734-0C3B-44E8-9046-CA4BB1B80E9C}" dt="2022-11-03T15:05:48.124" v="573" actId="1076"/>
          <ac:spMkLst>
            <pc:docMk/>
            <pc:sldMk cId="2244443222" sldId="302"/>
            <ac:spMk id="4" creationId="{807DDF8D-DD5A-C886-628E-44F7532EA59A}"/>
          </ac:spMkLst>
        </pc:spChg>
        <pc:spChg chg="add mod">
          <ac:chgData name="Kumar, Vinod" userId="a0710a6e-bffc-4971-8893-1c23addeb5b0" providerId="ADAL" clId="{C5505734-0C3B-44E8-9046-CA4BB1B80E9C}" dt="2022-11-03T15:05:48.124" v="573" actId="1076"/>
          <ac:spMkLst>
            <pc:docMk/>
            <pc:sldMk cId="2244443222" sldId="302"/>
            <ac:spMk id="5" creationId="{29C8CD6C-A351-73DF-B87D-E3F61C730E27}"/>
          </ac:spMkLst>
        </pc:spChg>
      </pc:sldChg>
      <pc:sldChg chg="addSp delSp modSp mod">
        <pc:chgData name="Kumar, Vinod" userId="a0710a6e-bffc-4971-8893-1c23addeb5b0" providerId="ADAL" clId="{C5505734-0C3B-44E8-9046-CA4BB1B80E9C}" dt="2022-11-18T15:08:41.571" v="1346" actId="1036"/>
        <pc:sldMkLst>
          <pc:docMk/>
          <pc:sldMk cId="2794359920" sldId="303"/>
        </pc:sldMkLst>
        <pc:spChg chg="mod">
          <ac:chgData name="Kumar, Vinod" userId="a0710a6e-bffc-4971-8893-1c23addeb5b0" providerId="ADAL" clId="{C5505734-0C3B-44E8-9046-CA4BB1B80E9C}" dt="2022-11-02T20:29:08.081" v="5" actId="20577"/>
          <ac:spMkLst>
            <pc:docMk/>
            <pc:sldMk cId="2794359920" sldId="303"/>
            <ac:spMk id="2" creationId="{DFB14EE7-EEF6-61F7-41BC-5E90AAE62A50}"/>
          </ac:spMkLst>
        </pc:spChg>
        <pc:grpChg chg="add del mod">
          <ac:chgData name="Kumar, Vinod" userId="a0710a6e-bffc-4971-8893-1c23addeb5b0" providerId="ADAL" clId="{C5505734-0C3B-44E8-9046-CA4BB1B80E9C}" dt="2022-11-02T20:34:39.131" v="47" actId="478"/>
          <ac:grpSpMkLst>
            <pc:docMk/>
            <pc:sldMk cId="2794359920" sldId="303"/>
            <ac:grpSpMk id="29" creationId="{F86FD7FA-7627-5308-81D1-04D364DD212E}"/>
          </ac:grpSpMkLst>
        </pc:grpChg>
        <pc:picChg chg="del">
          <ac:chgData name="Kumar, Vinod" userId="a0710a6e-bffc-4971-8893-1c23addeb5b0" providerId="ADAL" clId="{C5505734-0C3B-44E8-9046-CA4BB1B80E9C}" dt="2022-11-02T20:34:40.125" v="48" actId="478"/>
          <ac:picMkLst>
            <pc:docMk/>
            <pc:sldMk cId="2794359920" sldId="303"/>
            <ac:picMk id="3" creationId="{10BF6C55-B762-3746-CE36-9162113619D0}"/>
          </ac:picMkLst>
        </pc:picChg>
        <pc:picChg chg="add mod">
          <ac:chgData name="Kumar, Vinod" userId="a0710a6e-bffc-4971-8893-1c23addeb5b0" providerId="ADAL" clId="{C5505734-0C3B-44E8-9046-CA4BB1B80E9C}" dt="2022-11-18T15:08:41.571" v="1346" actId="1036"/>
          <ac:picMkLst>
            <pc:docMk/>
            <pc:sldMk cId="2794359920" sldId="303"/>
            <ac:picMk id="3" creationId="{EEDE6CC3-057A-8BF6-60DE-B64F4803147C}"/>
          </ac:picMkLst>
        </pc:picChg>
        <pc:picChg chg="add mod">
          <ac:chgData name="Kumar, Vinod" userId="a0710a6e-bffc-4971-8893-1c23addeb5b0" providerId="ADAL" clId="{C5505734-0C3B-44E8-9046-CA4BB1B80E9C}" dt="2022-11-02T20:33:45.895" v="43" actId="164"/>
          <ac:picMkLst>
            <pc:docMk/>
            <pc:sldMk cId="2794359920" sldId="303"/>
            <ac:picMk id="25" creationId="{713B064F-EBC7-F1A3-7310-3AB4C7F79713}"/>
          </ac:picMkLst>
        </pc:picChg>
        <pc:picChg chg="add mod">
          <ac:chgData name="Kumar, Vinod" userId="a0710a6e-bffc-4971-8893-1c23addeb5b0" providerId="ADAL" clId="{C5505734-0C3B-44E8-9046-CA4BB1B80E9C}" dt="2022-11-02T20:33:45.895" v="43" actId="164"/>
          <ac:picMkLst>
            <pc:docMk/>
            <pc:sldMk cId="2794359920" sldId="303"/>
            <ac:picMk id="26" creationId="{05BC5512-580E-BA97-8C04-58D5FC143C18}"/>
          </ac:picMkLst>
        </pc:picChg>
        <pc:picChg chg="add mod">
          <ac:chgData name="Kumar, Vinod" userId="a0710a6e-bffc-4971-8893-1c23addeb5b0" providerId="ADAL" clId="{C5505734-0C3B-44E8-9046-CA4BB1B80E9C}" dt="2022-11-02T20:33:45.895" v="43" actId="164"/>
          <ac:picMkLst>
            <pc:docMk/>
            <pc:sldMk cId="2794359920" sldId="303"/>
            <ac:picMk id="27" creationId="{17D3B71B-F5B8-4BDE-36B4-46B30477B6A9}"/>
          </ac:picMkLst>
        </pc:picChg>
        <pc:picChg chg="add mod">
          <ac:chgData name="Kumar, Vinod" userId="a0710a6e-bffc-4971-8893-1c23addeb5b0" providerId="ADAL" clId="{C5505734-0C3B-44E8-9046-CA4BB1B80E9C}" dt="2022-11-02T20:33:45.895" v="43" actId="164"/>
          <ac:picMkLst>
            <pc:docMk/>
            <pc:sldMk cId="2794359920" sldId="303"/>
            <ac:picMk id="28" creationId="{21E72664-25EA-B4BC-88CD-6A6686809A18}"/>
          </ac:picMkLst>
        </pc:picChg>
        <pc:picChg chg="add del mod">
          <ac:chgData name="Kumar, Vinod" userId="a0710a6e-bffc-4971-8893-1c23addeb5b0" providerId="ADAL" clId="{C5505734-0C3B-44E8-9046-CA4BB1B80E9C}" dt="2022-11-18T15:08:30.804" v="1339" actId="478"/>
          <ac:picMkLst>
            <pc:docMk/>
            <pc:sldMk cId="2794359920" sldId="303"/>
            <ac:picMk id="30" creationId="{2E436E5B-0472-2443-AD03-9E318F9B27E6}"/>
          </ac:picMkLst>
        </pc:picChg>
      </pc:sldChg>
      <pc:sldChg chg="del">
        <pc:chgData name="Kumar, Vinod" userId="a0710a6e-bffc-4971-8893-1c23addeb5b0" providerId="ADAL" clId="{C5505734-0C3B-44E8-9046-CA4BB1B80E9C}" dt="2022-11-02T21:14:59.490" v="567" actId="47"/>
        <pc:sldMkLst>
          <pc:docMk/>
          <pc:sldMk cId="1896129938" sldId="304"/>
        </pc:sldMkLst>
      </pc:sldChg>
      <pc:sldChg chg="modSp add mod">
        <pc:chgData name="Kumar, Vinod" userId="a0710a6e-bffc-4971-8893-1c23addeb5b0" providerId="ADAL" clId="{C5505734-0C3B-44E8-9046-CA4BB1B80E9C}" dt="2022-11-02T20:40:48.059" v="56" actId="20577"/>
        <pc:sldMkLst>
          <pc:docMk/>
          <pc:sldMk cId="2374493231" sldId="305"/>
        </pc:sldMkLst>
        <pc:spChg chg="mod">
          <ac:chgData name="Kumar, Vinod" userId="a0710a6e-bffc-4971-8893-1c23addeb5b0" providerId="ADAL" clId="{C5505734-0C3B-44E8-9046-CA4BB1B80E9C}" dt="2022-11-02T20:40:48.059" v="56" actId="20577"/>
          <ac:spMkLst>
            <pc:docMk/>
            <pc:sldMk cId="2374493231" sldId="305"/>
            <ac:spMk id="73" creationId="{3DC87012-760F-483C-9104-E6DEDCC490D2}"/>
          </ac:spMkLst>
        </pc:spChg>
      </pc:sldChg>
      <pc:sldChg chg="modSp add mod">
        <pc:chgData name="Kumar, Vinod" userId="a0710a6e-bffc-4971-8893-1c23addeb5b0" providerId="ADAL" clId="{C5505734-0C3B-44E8-9046-CA4BB1B80E9C}" dt="2022-11-02T20:40:56.251" v="58" actId="6549"/>
        <pc:sldMkLst>
          <pc:docMk/>
          <pc:sldMk cId="1231753045" sldId="306"/>
        </pc:sldMkLst>
        <pc:spChg chg="mod">
          <ac:chgData name="Kumar, Vinod" userId="a0710a6e-bffc-4971-8893-1c23addeb5b0" providerId="ADAL" clId="{C5505734-0C3B-44E8-9046-CA4BB1B80E9C}" dt="2022-11-02T20:40:56.251" v="58" actId="6549"/>
          <ac:spMkLst>
            <pc:docMk/>
            <pc:sldMk cId="1231753045" sldId="306"/>
            <ac:spMk id="7" creationId="{C56CA07C-310B-7CB3-A9A5-D9A9ED7A54FF}"/>
          </ac:spMkLst>
        </pc:spChg>
      </pc:sldChg>
      <pc:sldChg chg="addSp delSp modSp new mod">
        <pc:chgData name="Kumar, Vinod" userId="a0710a6e-bffc-4971-8893-1c23addeb5b0" providerId="ADAL" clId="{C5505734-0C3B-44E8-9046-CA4BB1B80E9C}" dt="2022-11-03T14:44:10.427" v="571" actId="20577"/>
        <pc:sldMkLst>
          <pc:docMk/>
          <pc:sldMk cId="1809220692" sldId="307"/>
        </pc:sldMkLst>
        <pc:spChg chg="add mod">
          <ac:chgData name="Kumar, Vinod" userId="a0710a6e-bffc-4971-8893-1c23addeb5b0" providerId="ADAL" clId="{C5505734-0C3B-44E8-9046-CA4BB1B80E9C}" dt="2022-11-03T13:54:44.642" v="568" actId="20577"/>
          <ac:spMkLst>
            <pc:docMk/>
            <pc:sldMk cId="1809220692" sldId="307"/>
            <ac:spMk id="6" creationId="{501CC702-17BF-D791-E8BE-84429E05C972}"/>
          </ac:spMkLst>
        </pc:spChg>
        <pc:spChg chg="add mod">
          <ac:chgData name="Kumar, Vinod" userId="a0710a6e-bffc-4971-8893-1c23addeb5b0" providerId="ADAL" clId="{C5505734-0C3B-44E8-9046-CA4BB1B80E9C}" dt="2022-11-02T20:50:25.373" v="341" actId="14100"/>
          <ac:spMkLst>
            <pc:docMk/>
            <pc:sldMk cId="1809220692" sldId="307"/>
            <ac:spMk id="7" creationId="{3A27B142-7348-D017-2365-F7521F3ECC2E}"/>
          </ac:spMkLst>
        </pc:spChg>
        <pc:spChg chg="add mod">
          <ac:chgData name="Kumar, Vinod" userId="a0710a6e-bffc-4971-8893-1c23addeb5b0" providerId="ADAL" clId="{C5505734-0C3B-44E8-9046-CA4BB1B80E9C}" dt="2022-11-02T20:50:25.373" v="341" actId="14100"/>
          <ac:spMkLst>
            <pc:docMk/>
            <pc:sldMk cId="1809220692" sldId="307"/>
            <ac:spMk id="8" creationId="{8947D4B5-C798-5A24-4280-177C9063B94F}"/>
          </ac:spMkLst>
        </pc:spChg>
        <pc:spChg chg="add mod">
          <ac:chgData name="Kumar, Vinod" userId="a0710a6e-bffc-4971-8893-1c23addeb5b0" providerId="ADAL" clId="{C5505734-0C3B-44E8-9046-CA4BB1B80E9C}" dt="2022-11-03T13:54:48.709" v="569" actId="20577"/>
          <ac:spMkLst>
            <pc:docMk/>
            <pc:sldMk cId="1809220692" sldId="307"/>
            <ac:spMk id="10" creationId="{DD47DA19-285A-FA16-01D5-518DC85E6200}"/>
          </ac:spMkLst>
        </pc:spChg>
        <pc:spChg chg="add mod">
          <ac:chgData name="Kumar, Vinod" userId="a0710a6e-bffc-4971-8893-1c23addeb5b0" providerId="ADAL" clId="{C5505734-0C3B-44E8-9046-CA4BB1B80E9C}" dt="2022-11-03T14:44:05.564" v="570" actId="20577"/>
          <ac:spMkLst>
            <pc:docMk/>
            <pc:sldMk cId="1809220692" sldId="307"/>
            <ac:spMk id="11" creationId="{712A80BB-E33F-8F2A-B09E-A815DAAAE03D}"/>
          </ac:spMkLst>
        </pc:spChg>
        <pc:spChg chg="add mod">
          <ac:chgData name="Kumar, Vinod" userId="a0710a6e-bffc-4971-8893-1c23addeb5b0" providerId="ADAL" clId="{C5505734-0C3B-44E8-9046-CA4BB1B80E9C}" dt="2022-11-03T14:44:10.427" v="571" actId="20577"/>
          <ac:spMkLst>
            <pc:docMk/>
            <pc:sldMk cId="1809220692" sldId="307"/>
            <ac:spMk id="12" creationId="{632FBD78-F81E-95DD-6334-3F55B1EDDCD0}"/>
          </ac:spMkLst>
        </pc:spChg>
        <pc:graphicFrameChg chg="add del mod">
          <ac:chgData name="Kumar, Vinod" userId="a0710a6e-bffc-4971-8893-1c23addeb5b0" providerId="ADAL" clId="{C5505734-0C3B-44E8-9046-CA4BB1B80E9C}" dt="2022-11-02T20:45:04.069" v="67" actId="478"/>
          <ac:graphicFrameMkLst>
            <pc:docMk/>
            <pc:sldMk cId="1809220692" sldId="307"/>
            <ac:graphicFrameMk id="3" creationId="{6066B426-8A6B-5D1A-37B0-D9E67AB6A83A}"/>
          </ac:graphicFrameMkLst>
        </pc:graphicFrameChg>
        <pc:picChg chg="del mod">
          <ac:chgData name="Kumar, Vinod" userId="a0710a6e-bffc-4971-8893-1c23addeb5b0" providerId="ADAL" clId="{C5505734-0C3B-44E8-9046-CA4BB1B80E9C}" dt="2022-11-02T20:45:05.352" v="68" actId="478"/>
          <ac:picMkLst>
            <pc:docMk/>
            <pc:sldMk cId="1809220692" sldId="307"/>
            <ac:picMk id="2" creationId="{45D77666-4B4B-9D23-04A7-2DA032632397}"/>
          </ac:picMkLst>
        </pc:picChg>
        <pc:picChg chg="add del">
          <ac:chgData name="Kumar, Vinod" userId="a0710a6e-bffc-4971-8893-1c23addeb5b0" providerId="ADAL" clId="{C5505734-0C3B-44E8-9046-CA4BB1B80E9C}" dt="2022-11-02T20:45:14.264" v="70"/>
          <ac:picMkLst>
            <pc:docMk/>
            <pc:sldMk cId="1809220692" sldId="307"/>
            <ac:picMk id="4" creationId="{D633A6CE-9D06-98A7-AC26-982BBD8975C8}"/>
          </ac:picMkLst>
        </pc:picChg>
        <pc:picChg chg="mod">
          <ac:chgData name="Kumar, Vinod" userId="a0710a6e-bffc-4971-8893-1c23addeb5b0" providerId="ADAL" clId="{C5505734-0C3B-44E8-9046-CA4BB1B80E9C}" dt="2022-11-02T20:46:16.399" v="81" actId="1076"/>
          <ac:picMkLst>
            <pc:docMk/>
            <pc:sldMk cId="1809220692" sldId="307"/>
            <ac:picMk id="5" creationId="{9B5F3310-7D36-81A6-3D42-8CF6F0DFCFA1}"/>
          </ac:picMkLst>
        </pc:picChg>
        <pc:picChg chg="mod">
          <ac:chgData name="Kumar, Vinod" userId="a0710a6e-bffc-4971-8893-1c23addeb5b0" providerId="ADAL" clId="{C5505734-0C3B-44E8-9046-CA4BB1B80E9C}" dt="2022-11-02T20:48:19.422" v="121" actId="1076"/>
          <ac:picMkLst>
            <pc:docMk/>
            <pc:sldMk cId="1809220692" sldId="307"/>
            <ac:picMk id="9" creationId="{89D3091B-A961-6B1B-36C2-692E33D0DBE0}"/>
          </ac:picMkLst>
        </pc:picChg>
      </pc:sldChg>
      <pc:sldChg chg="addSp delSp modSp new mod">
        <pc:chgData name="Kumar, Vinod" userId="a0710a6e-bffc-4971-8893-1c23addeb5b0" providerId="ADAL" clId="{C5505734-0C3B-44E8-9046-CA4BB1B80E9C}" dt="2022-11-04T14:16:51.891" v="593" actId="1076"/>
        <pc:sldMkLst>
          <pc:docMk/>
          <pc:sldMk cId="3906571683" sldId="308"/>
        </pc:sldMkLst>
        <pc:spChg chg="add mod">
          <ac:chgData name="Kumar, Vinod" userId="a0710a6e-bffc-4971-8893-1c23addeb5b0" providerId="ADAL" clId="{C5505734-0C3B-44E8-9046-CA4BB1B80E9C}" dt="2022-11-02T21:02:28.481" v="356" actId="20577"/>
          <ac:spMkLst>
            <pc:docMk/>
            <pc:sldMk cId="3906571683" sldId="308"/>
            <ac:spMk id="2" creationId="{7B7025D5-C49D-0D71-E810-27CFFEAE8D76}"/>
          </ac:spMkLst>
        </pc:spChg>
        <pc:spChg chg="mod">
          <ac:chgData name="Kumar, Vinod" userId="a0710a6e-bffc-4971-8893-1c23addeb5b0" providerId="ADAL" clId="{C5505734-0C3B-44E8-9046-CA4BB1B80E9C}" dt="2022-11-02T21:01:20.677" v="346"/>
          <ac:spMkLst>
            <pc:docMk/>
            <pc:sldMk cId="3906571683" sldId="308"/>
            <ac:spMk id="6" creationId="{09B662F0-A61E-2D84-8D42-D8F4E0D5D354}"/>
          </ac:spMkLst>
        </pc:spChg>
        <pc:spChg chg="mod">
          <ac:chgData name="Kumar, Vinod" userId="a0710a6e-bffc-4971-8893-1c23addeb5b0" providerId="ADAL" clId="{C5505734-0C3B-44E8-9046-CA4BB1B80E9C}" dt="2022-11-02T21:01:20.677" v="346"/>
          <ac:spMkLst>
            <pc:docMk/>
            <pc:sldMk cId="3906571683" sldId="308"/>
            <ac:spMk id="7" creationId="{443EA77B-8324-8C4A-E468-A1229761626E}"/>
          </ac:spMkLst>
        </pc:spChg>
        <pc:spChg chg="mod">
          <ac:chgData name="Kumar, Vinod" userId="a0710a6e-bffc-4971-8893-1c23addeb5b0" providerId="ADAL" clId="{C5505734-0C3B-44E8-9046-CA4BB1B80E9C}" dt="2022-11-02T21:01:20.677" v="346"/>
          <ac:spMkLst>
            <pc:docMk/>
            <pc:sldMk cId="3906571683" sldId="308"/>
            <ac:spMk id="9" creationId="{749AC969-B3D1-A618-5A1A-ED324E0CBA4E}"/>
          </ac:spMkLst>
        </pc:spChg>
        <pc:grpChg chg="add del mod">
          <ac:chgData name="Kumar, Vinod" userId="a0710a6e-bffc-4971-8893-1c23addeb5b0" providerId="ADAL" clId="{C5505734-0C3B-44E8-9046-CA4BB1B80E9C}" dt="2022-11-02T21:02:09.936" v="354" actId="478"/>
          <ac:grpSpMkLst>
            <pc:docMk/>
            <pc:sldMk cId="3906571683" sldId="308"/>
            <ac:grpSpMk id="3" creationId="{E66C451C-7C71-BE1F-252A-0F097996FF62}"/>
          </ac:grpSpMkLst>
        </pc:grpChg>
        <pc:picChg chg="mod">
          <ac:chgData name="Kumar, Vinod" userId="a0710a6e-bffc-4971-8893-1c23addeb5b0" providerId="ADAL" clId="{C5505734-0C3B-44E8-9046-CA4BB1B80E9C}" dt="2022-11-02T21:01:20.677" v="346"/>
          <ac:picMkLst>
            <pc:docMk/>
            <pc:sldMk cId="3906571683" sldId="308"/>
            <ac:picMk id="4" creationId="{5B771AE1-3E68-BFAE-7DAC-BAA0D323C0BF}"/>
          </ac:picMkLst>
        </pc:picChg>
        <pc:picChg chg="mod">
          <ac:chgData name="Kumar, Vinod" userId="a0710a6e-bffc-4971-8893-1c23addeb5b0" providerId="ADAL" clId="{C5505734-0C3B-44E8-9046-CA4BB1B80E9C}" dt="2022-11-02T21:01:20.677" v="346"/>
          <ac:picMkLst>
            <pc:docMk/>
            <pc:sldMk cId="3906571683" sldId="308"/>
            <ac:picMk id="5" creationId="{3DA8686C-D1DF-4A73-09F3-E96BF3A60313}"/>
          </ac:picMkLst>
        </pc:picChg>
        <pc:picChg chg="add mod">
          <ac:chgData name="Kumar, Vinod" userId="a0710a6e-bffc-4971-8893-1c23addeb5b0" providerId="ADAL" clId="{C5505734-0C3B-44E8-9046-CA4BB1B80E9C}" dt="2022-11-04T14:16:51.891" v="593" actId="1076"/>
          <ac:picMkLst>
            <pc:docMk/>
            <pc:sldMk cId="3906571683" sldId="308"/>
            <ac:picMk id="10" creationId="{9B02A01A-5408-B536-4A8C-A06B5316EA58}"/>
          </ac:picMkLst>
        </pc:picChg>
        <pc:cxnChg chg="mod">
          <ac:chgData name="Kumar, Vinod" userId="a0710a6e-bffc-4971-8893-1c23addeb5b0" providerId="ADAL" clId="{C5505734-0C3B-44E8-9046-CA4BB1B80E9C}" dt="2022-11-02T21:01:20.677" v="346"/>
          <ac:cxnSpMkLst>
            <pc:docMk/>
            <pc:sldMk cId="3906571683" sldId="308"/>
            <ac:cxnSpMk id="8" creationId="{A3AD9AE8-E20C-A393-D916-54FAA3AA09A5}"/>
          </ac:cxnSpMkLst>
        </pc:cxnChg>
      </pc:sldChg>
      <pc:sldChg chg="addSp delSp modSp add mod">
        <pc:chgData name="Kumar, Vinod" userId="a0710a6e-bffc-4971-8893-1c23addeb5b0" providerId="ADAL" clId="{C5505734-0C3B-44E8-9046-CA4BB1B80E9C}" dt="2022-11-04T20:22:19.970" v="716" actId="20577"/>
        <pc:sldMkLst>
          <pc:docMk/>
          <pc:sldMk cId="363523231" sldId="309"/>
        </pc:sldMkLst>
        <pc:spChg chg="add del mod">
          <ac:chgData name="Kumar, Vinod" userId="a0710a6e-bffc-4971-8893-1c23addeb5b0" providerId="ADAL" clId="{C5505734-0C3B-44E8-9046-CA4BB1B80E9C}" dt="2022-11-04T20:20:23.475" v="595" actId="478"/>
          <ac:spMkLst>
            <pc:docMk/>
            <pc:sldMk cId="363523231" sldId="309"/>
            <ac:spMk id="11" creationId="{7F00C823-200C-93F8-FB59-359189145D20}"/>
          </ac:spMkLst>
        </pc:spChg>
        <pc:spChg chg="mod">
          <ac:chgData name="Kumar, Vinod" userId="a0710a6e-bffc-4971-8893-1c23addeb5b0" providerId="ADAL" clId="{C5505734-0C3B-44E8-9046-CA4BB1B80E9C}" dt="2022-11-04T20:21:18.099" v="684" actId="1036"/>
          <ac:spMkLst>
            <pc:docMk/>
            <pc:sldMk cId="363523231" sldId="309"/>
            <ac:spMk id="12" creationId="{CB89E43C-D345-E71E-235D-A3F527A77971}"/>
          </ac:spMkLst>
        </pc:spChg>
        <pc:spChg chg="mod">
          <ac:chgData name="Kumar, Vinod" userId="a0710a6e-bffc-4971-8893-1c23addeb5b0" providerId="ADAL" clId="{C5505734-0C3B-44E8-9046-CA4BB1B80E9C}" dt="2022-11-04T20:21:57.779" v="710" actId="20577"/>
          <ac:spMkLst>
            <pc:docMk/>
            <pc:sldMk cId="363523231" sldId="309"/>
            <ac:spMk id="13" creationId="{2F5C69FE-8BBC-D30D-1B05-F82DAA14E149}"/>
          </ac:spMkLst>
        </pc:spChg>
        <pc:spChg chg="mod">
          <ac:chgData name="Kumar, Vinod" userId="a0710a6e-bffc-4971-8893-1c23addeb5b0" providerId="ADAL" clId="{C5505734-0C3B-44E8-9046-CA4BB1B80E9C}" dt="2022-11-04T20:22:01.492" v="711" actId="20577"/>
          <ac:spMkLst>
            <pc:docMk/>
            <pc:sldMk cId="363523231" sldId="309"/>
            <ac:spMk id="14" creationId="{DAB75DD1-567F-6F00-8AC6-BCC1C40187EE}"/>
          </ac:spMkLst>
        </pc:spChg>
        <pc:spChg chg="mod">
          <ac:chgData name="Kumar, Vinod" userId="a0710a6e-bffc-4971-8893-1c23addeb5b0" providerId="ADAL" clId="{C5505734-0C3B-44E8-9046-CA4BB1B80E9C}" dt="2022-11-04T20:22:04.051" v="712" actId="20577"/>
          <ac:spMkLst>
            <pc:docMk/>
            <pc:sldMk cId="363523231" sldId="309"/>
            <ac:spMk id="15" creationId="{610AFE8D-6F14-0B41-CFAF-B50ED829F5E3}"/>
          </ac:spMkLst>
        </pc:spChg>
        <pc:spChg chg="mod">
          <ac:chgData name="Kumar, Vinod" userId="a0710a6e-bffc-4971-8893-1c23addeb5b0" providerId="ADAL" clId="{C5505734-0C3B-44E8-9046-CA4BB1B80E9C}" dt="2022-11-04T20:22:07.667" v="713" actId="20577"/>
          <ac:spMkLst>
            <pc:docMk/>
            <pc:sldMk cId="363523231" sldId="309"/>
            <ac:spMk id="16" creationId="{4C832ACE-FAEF-F2D8-3BA1-1504FDF54A88}"/>
          </ac:spMkLst>
        </pc:spChg>
        <pc:spChg chg="mod">
          <ac:chgData name="Kumar, Vinod" userId="a0710a6e-bffc-4971-8893-1c23addeb5b0" providerId="ADAL" clId="{C5505734-0C3B-44E8-9046-CA4BB1B80E9C}" dt="2022-11-04T20:22:11.764" v="714" actId="20577"/>
          <ac:spMkLst>
            <pc:docMk/>
            <pc:sldMk cId="363523231" sldId="309"/>
            <ac:spMk id="17" creationId="{4BA5D206-14F9-4C8F-570E-568E631E764E}"/>
          </ac:spMkLst>
        </pc:spChg>
        <pc:spChg chg="mod">
          <ac:chgData name="Kumar, Vinod" userId="a0710a6e-bffc-4971-8893-1c23addeb5b0" providerId="ADAL" clId="{C5505734-0C3B-44E8-9046-CA4BB1B80E9C}" dt="2022-11-04T20:22:15.556" v="715" actId="20577"/>
          <ac:spMkLst>
            <pc:docMk/>
            <pc:sldMk cId="363523231" sldId="309"/>
            <ac:spMk id="18" creationId="{F868BCCD-1693-01CC-7EB6-FF78E61E1CA6}"/>
          </ac:spMkLst>
        </pc:spChg>
        <pc:spChg chg="mod">
          <ac:chgData name="Kumar, Vinod" userId="a0710a6e-bffc-4971-8893-1c23addeb5b0" providerId="ADAL" clId="{C5505734-0C3B-44E8-9046-CA4BB1B80E9C}" dt="2022-11-04T20:22:19.970" v="716" actId="20577"/>
          <ac:spMkLst>
            <pc:docMk/>
            <pc:sldMk cId="363523231" sldId="309"/>
            <ac:spMk id="19" creationId="{7A6E65D4-7530-9F25-99BB-3E4A551CAB24}"/>
          </ac:spMkLst>
        </pc:spChg>
        <pc:spChg chg="mod">
          <ac:chgData name="Kumar, Vinod" userId="a0710a6e-bffc-4971-8893-1c23addeb5b0" providerId="ADAL" clId="{C5505734-0C3B-44E8-9046-CA4BB1B80E9C}" dt="2022-11-04T20:21:54.173" v="709" actId="20577"/>
          <ac:spMkLst>
            <pc:docMk/>
            <pc:sldMk cId="363523231" sldId="309"/>
            <ac:spMk id="21" creationId="{4A1FD6FF-624A-06CB-8B80-7E181D684B98}"/>
          </ac:spMkLst>
        </pc:spChg>
        <pc:picChg chg="mod">
          <ac:chgData name="Kumar, Vinod" userId="a0710a6e-bffc-4971-8893-1c23addeb5b0" providerId="ADAL" clId="{C5505734-0C3B-44E8-9046-CA4BB1B80E9C}" dt="2022-11-04T20:21:31.267" v="697" actId="1036"/>
          <ac:picMkLst>
            <pc:docMk/>
            <pc:sldMk cId="363523231" sldId="309"/>
            <ac:picMk id="2" creationId="{821457AD-B838-A9B5-FE77-286D2FC2EE7F}"/>
          </ac:picMkLst>
        </pc:picChg>
        <pc:picChg chg="mod">
          <ac:chgData name="Kumar, Vinod" userId="a0710a6e-bffc-4971-8893-1c23addeb5b0" providerId="ADAL" clId="{C5505734-0C3B-44E8-9046-CA4BB1B80E9C}" dt="2022-11-04T20:21:31.267" v="697" actId="1036"/>
          <ac:picMkLst>
            <pc:docMk/>
            <pc:sldMk cId="363523231" sldId="309"/>
            <ac:picMk id="3" creationId="{EE6D6DA0-B2C8-C062-6E93-1EAB0B1DB695}"/>
          </ac:picMkLst>
        </pc:picChg>
        <pc:picChg chg="mod">
          <ac:chgData name="Kumar, Vinod" userId="a0710a6e-bffc-4971-8893-1c23addeb5b0" providerId="ADAL" clId="{C5505734-0C3B-44E8-9046-CA4BB1B80E9C}" dt="2022-11-04T20:21:31.267" v="697" actId="1036"/>
          <ac:picMkLst>
            <pc:docMk/>
            <pc:sldMk cId="363523231" sldId="309"/>
            <ac:picMk id="4" creationId="{FEF77DA4-5EBA-204F-C216-45C4D4BAFC59}"/>
          </ac:picMkLst>
        </pc:picChg>
        <pc:picChg chg="mod">
          <ac:chgData name="Kumar, Vinod" userId="a0710a6e-bffc-4971-8893-1c23addeb5b0" providerId="ADAL" clId="{C5505734-0C3B-44E8-9046-CA4BB1B80E9C}" dt="2022-11-04T20:21:41.395" v="705" actId="1035"/>
          <ac:picMkLst>
            <pc:docMk/>
            <pc:sldMk cId="363523231" sldId="309"/>
            <ac:picMk id="5" creationId="{9BFF4654-44C7-681D-AE78-BB30710F7D35}"/>
          </ac:picMkLst>
        </pc:picChg>
        <pc:picChg chg="mod">
          <ac:chgData name="Kumar, Vinod" userId="a0710a6e-bffc-4971-8893-1c23addeb5b0" providerId="ADAL" clId="{C5505734-0C3B-44E8-9046-CA4BB1B80E9C}" dt="2022-11-04T20:21:41.395" v="705" actId="1035"/>
          <ac:picMkLst>
            <pc:docMk/>
            <pc:sldMk cId="363523231" sldId="309"/>
            <ac:picMk id="6" creationId="{77B86128-5341-8C8D-B634-105ECB5031E9}"/>
          </ac:picMkLst>
        </pc:picChg>
        <pc:picChg chg="mod">
          <ac:chgData name="Kumar, Vinod" userId="a0710a6e-bffc-4971-8893-1c23addeb5b0" providerId="ADAL" clId="{C5505734-0C3B-44E8-9046-CA4BB1B80E9C}" dt="2022-11-04T20:21:41.395" v="705" actId="1035"/>
          <ac:picMkLst>
            <pc:docMk/>
            <pc:sldMk cId="363523231" sldId="309"/>
            <ac:picMk id="7" creationId="{F5618D52-7D96-8F92-5FE3-593C006CE318}"/>
          </ac:picMkLst>
        </pc:picChg>
        <pc:picChg chg="mod">
          <ac:chgData name="Kumar, Vinod" userId="a0710a6e-bffc-4971-8893-1c23addeb5b0" providerId="ADAL" clId="{C5505734-0C3B-44E8-9046-CA4BB1B80E9C}" dt="2022-11-04T20:21:47.475" v="708" actId="1035"/>
          <ac:picMkLst>
            <pc:docMk/>
            <pc:sldMk cId="363523231" sldId="309"/>
            <ac:picMk id="8" creationId="{0C4AC514-70B9-2E08-FC10-F47116B8336F}"/>
          </ac:picMkLst>
        </pc:picChg>
        <pc:picChg chg="add del mod">
          <ac:chgData name="Kumar, Vinod" userId="a0710a6e-bffc-4971-8893-1c23addeb5b0" providerId="ADAL" clId="{C5505734-0C3B-44E8-9046-CA4BB1B80E9C}" dt="2022-11-03T17:51:36.100" v="579" actId="478"/>
          <ac:picMkLst>
            <pc:docMk/>
            <pc:sldMk cId="363523231" sldId="309"/>
            <ac:picMk id="9" creationId="{94699EB6-60B3-ADD9-67A2-4ACF6FA45D48}"/>
          </ac:picMkLst>
        </pc:picChg>
        <pc:picChg chg="mod">
          <ac:chgData name="Kumar, Vinod" userId="a0710a6e-bffc-4971-8893-1c23addeb5b0" providerId="ADAL" clId="{C5505734-0C3B-44E8-9046-CA4BB1B80E9C}" dt="2022-11-04T20:21:47.475" v="708" actId="1035"/>
          <ac:picMkLst>
            <pc:docMk/>
            <pc:sldMk cId="363523231" sldId="309"/>
            <ac:picMk id="10" creationId="{5BC61CC7-A994-BE81-FF4B-0830F771FB05}"/>
          </ac:picMkLst>
        </pc:picChg>
        <pc:picChg chg="add del mod modCrop">
          <ac:chgData name="Kumar, Vinod" userId="a0710a6e-bffc-4971-8893-1c23addeb5b0" providerId="ADAL" clId="{C5505734-0C3B-44E8-9046-CA4BB1B80E9C}" dt="2022-11-04T20:20:20.603" v="594" actId="478"/>
          <ac:picMkLst>
            <pc:docMk/>
            <pc:sldMk cId="363523231" sldId="309"/>
            <ac:picMk id="20" creationId="{509ED4E6-A713-A502-6067-EE197D248781}"/>
          </ac:picMkLst>
        </pc:picChg>
      </pc:sldChg>
      <pc:sldChg chg="new del">
        <pc:chgData name="Kumar, Vinod" userId="a0710a6e-bffc-4971-8893-1c23addeb5b0" providerId="ADAL" clId="{C5505734-0C3B-44E8-9046-CA4BB1B80E9C}" dt="2022-11-16T22:19:51.803" v="1100" actId="47"/>
        <pc:sldMkLst>
          <pc:docMk/>
          <pc:sldMk cId="3297159417" sldId="310"/>
        </pc:sldMkLst>
      </pc:sldChg>
      <pc:sldChg chg="addSp new del mod">
        <pc:chgData name="Kumar, Vinod" userId="a0710a6e-bffc-4971-8893-1c23addeb5b0" providerId="ADAL" clId="{C5505734-0C3B-44E8-9046-CA4BB1B80E9C}" dt="2022-11-11T15:21:02.072" v="719" actId="47"/>
        <pc:sldMkLst>
          <pc:docMk/>
          <pc:sldMk cId="3997577584" sldId="310"/>
        </pc:sldMkLst>
        <pc:picChg chg="add">
          <ac:chgData name="Kumar, Vinod" userId="a0710a6e-bffc-4971-8893-1c23addeb5b0" providerId="ADAL" clId="{C5505734-0C3B-44E8-9046-CA4BB1B80E9C}" dt="2022-11-10T22:30:46.560" v="718" actId="22"/>
          <ac:picMkLst>
            <pc:docMk/>
            <pc:sldMk cId="3997577584" sldId="310"/>
            <ac:picMk id="3" creationId="{E6EBA035-132B-93B0-03CA-D0C75FFA8BE3}"/>
          </ac:picMkLst>
        </pc:picChg>
      </pc:sldChg>
      <pc:sldChg chg="addSp delSp modSp new mod">
        <pc:chgData name="Kumar, Vinod" userId="a0710a6e-bffc-4971-8893-1c23addeb5b0" providerId="ADAL" clId="{C5505734-0C3B-44E8-9046-CA4BB1B80E9C}" dt="2022-11-16T22:29:35.628" v="1328" actId="478"/>
        <pc:sldMkLst>
          <pc:docMk/>
          <pc:sldMk cId="1021580243" sldId="311"/>
        </pc:sldMkLst>
        <pc:spChg chg="del">
          <ac:chgData name="Kumar, Vinod" userId="a0710a6e-bffc-4971-8893-1c23addeb5b0" providerId="ADAL" clId="{C5505734-0C3B-44E8-9046-CA4BB1B80E9C}" dt="2022-11-16T15:36:47.650" v="722" actId="478"/>
          <ac:spMkLst>
            <pc:docMk/>
            <pc:sldMk cId="1021580243" sldId="311"/>
            <ac:spMk id="2" creationId="{DE6AC0FA-145A-061C-F99F-D7E13ABDA57F}"/>
          </ac:spMkLst>
        </pc:spChg>
        <pc:spChg chg="del">
          <ac:chgData name="Kumar, Vinod" userId="a0710a6e-bffc-4971-8893-1c23addeb5b0" providerId="ADAL" clId="{C5505734-0C3B-44E8-9046-CA4BB1B80E9C}" dt="2022-11-16T15:36:49.757" v="723" actId="478"/>
          <ac:spMkLst>
            <pc:docMk/>
            <pc:sldMk cId="1021580243" sldId="311"/>
            <ac:spMk id="3" creationId="{B52962FB-9ABA-6E61-0BB8-8AF33EF0781B}"/>
          </ac:spMkLst>
        </pc:spChg>
        <pc:spChg chg="mod topLvl">
          <ac:chgData name="Kumar, Vinod" userId="a0710a6e-bffc-4971-8893-1c23addeb5b0" providerId="ADAL" clId="{C5505734-0C3B-44E8-9046-CA4BB1B80E9C}" dt="2022-11-16T22:18:55.393" v="1090" actId="1076"/>
          <ac:spMkLst>
            <pc:docMk/>
            <pc:sldMk cId="1021580243" sldId="311"/>
            <ac:spMk id="4" creationId="{4CAD2583-4822-D9B8-31C9-2BFD05BD367C}"/>
          </ac:spMkLst>
        </pc:spChg>
        <pc:spChg chg="add del mod">
          <ac:chgData name="Kumar, Vinod" userId="a0710a6e-bffc-4971-8893-1c23addeb5b0" providerId="ADAL" clId="{C5505734-0C3B-44E8-9046-CA4BB1B80E9C}" dt="2022-11-16T15:37:43.725" v="744" actId="478"/>
          <ac:spMkLst>
            <pc:docMk/>
            <pc:sldMk cId="1021580243" sldId="311"/>
            <ac:spMk id="4" creationId="{DBE2E1E6-398C-B52E-5322-6BE0A29BC13C}"/>
          </ac:spMkLst>
        </pc:spChg>
        <pc:spChg chg="add mod">
          <ac:chgData name="Kumar, Vinod" userId="a0710a6e-bffc-4971-8893-1c23addeb5b0" providerId="ADAL" clId="{C5505734-0C3B-44E8-9046-CA4BB1B80E9C}" dt="2022-11-16T15:37:58.548" v="748" actId="1076"/>
          <ac:spMkLst>
            <pc:docMk/>
            <pc:sldMk cId="1021580243" sldId="311"/>
            <ac:spMk id="5" creationId="{0706E1CA-626E-467D-593C-0057BB6A2FEA}"/>
          </ac:spMkLst>
        </pc:spChg>
        <pc:spChg chg="mod topLvl">
          <ac:chgData name="Kumar, Vinod" userId="a0710a6e-bffc-4971-8893-1c23addeb5b0" providerId="ADAL" clId="{C5505734-0C3B-44E8-9046-CA4BB1B80E9C}" dt="2022-11-16T21:55:23.677" v="851" actId="1036"/>
          <ac:spMkLst>
            <pc:docMk/>
            <pc:sldMk cId="1021580243" sldId="311"/>
            <ac:spMk id="7" creationId="{FB1D9751-58B9-B823-A2F9-8E213FCB1905}"/>
          </ac:spMkLst>
        </pc:spChg>
        <pc:spChg chg="mod topLvl">
          <ac:chgData name="Kumar, Vinod" userId="a0710a6e-bffc-4971-8893-1c23addeb5b0" providerId="ADAL" clId="{C5505734-0C3B-44E8-9046-CA4BB1B80E9C}" dt="2022-11-16T21:55:23.677" v="851" actId="1036"/>
          <ac:spMkLst>
            <pc:docMk/>
            <pc:sldMk cId="1021580243" sldId="311"/>
            <ac:spMk id="8" creationId="{7591B6BA-E52A-3E35-35F8-FE6C592A2D4D}"/>
          </ac:spMkLst>
        </pc:spChg>
        <pc:spChg chg="mod topLvl">
          <ac:chgData name="Kumar, Vinod" userId="a0710a6e-bffc-4971-8893-1c23addeb5b0" providerId="ADAL" clId="{C5505734-0C3B-44E8-9046-CA4BB1B80E9C}" dt="2022-11-16T21:55:23.677" v="851" actId="1036"/>
          <ac:spMkLst>
            <pc:docMk/>
            <pc:sldMk cId="1021580243" sldId="311"/>
            <ac:spMk id="9" creationId="{6809D947-F4AE-8A35-1C7C-66A95D239885}"/>
          </ac:spMkLst>
        </pc:spChg>
        <pc:spChg chg="mod topLvl">
          <ac:chgData name="Kumar, Vinod" userId="a0710a6e-bffc-4971-8893-1c23addeb5b0" providerId="ADAL" clId="{C5505734-0C3B-44E8-9046-CA4BB1B80E9C}" dt="2022-11-16T21:49:31.850" v="782" actId="165"/>
          <ac:spMkLst>
            <pc:docMk/>
            <pc:sldMk cId="1021580243" sldId="311"/>
            <ac:spMk id="10" creationId="{6F0F49C3-E870-BC75-C39E-3506B68D4EB7}"/>
          </ac:spMkLst>
        </pc:spChg>
        <pc:spChg chg="mod topLvl">
          <ac:chgData name="Kumar, Vinod" userId="a0710a6e-bffc-4971-8893-1c23addeb5b0" providerId="ADAL" clId="{C5505734-0C3B-44E8-9046-CA4BB1B80E9C}" dt="2022-11-16T21:55:39.469" v="857" actId="1037"/>
          <ac:spMkLst>
            <pc:docMk/>
            <pc:sldMk cId="1021580243" sldId="311"/>
            <ac:spMk id="11" creationId="{53207379-14D2-02C3-BC0C-C5CFD6DE75DA}"/>
          </ac:spMkLst>
        </pc:spChg>
        <pc:spChg chg="mod">
          <ac:chgData name="Kumar, Vinod" userId="a0710a6e-bffc-4971-8893-1c23addeb5b0" providerId="ADAL" clId="{C5505734-0C3B-44E8-9046-CA4BB1B80E9C}" dt="2022-11-16T22:16:53.234" v="1085" actId="1076"/>
          <ac:spMkLst>
            <pc:docMk/>
            <pc:sldMk cId="1021580243" sldId="311"/>
            <ac:spMk id="14" creationId="{F9640F02-6551-840D-FB5A-948D4C099DCD}"/>
          </ac:spMkLst>
        </pc:spChg>
        <pc:spChg chg="mod">
          <ac:chgData name="Kumar, Vinod" userId="a0710a6e-bffc-4971-8893-1c23addeb5b0" providerId="ADAL" clId="{C5505734-0C3B-44E8-9046-CA4BB1B80E9C}" dt="2022-11-16T22:16:53.234" v="1085" actId="1076"/>
          <ac:spMkLst>
            <pc:docMk/>
            <pc:sldMk cId="1021580243" sldId="311"/>
            <ac:spMk id="15" creationId="{33776172-3600-D957-6774-2CFC1FCCF25D}"/>
          </ac:spMkLst>
        </pc:spChg>
        <pc:spChg chg="mod">
          <ac:chgData name="Kumar, Vinod" userId="a0710a6e-bffc-4971-8893-1c23addeb5b0" providerId="ADAL" clId="{C5505734-0C3B-44E8-9046-CA4BB1B80E9C}" dt="2022-11-16T22:16:53.234" v="1085" actId="1076"/>
          <ac:spMkLst>
            <pc:docMk/>
            <pc:sldMk cId="1021580243" sldId="311"/>
            <ac:spMk id="16" creationId="{03E079E7-EB6A-8767-4908-3B13726CE290}"/>
          </ac:spMkLst>
        </pc:spChg>
        <pc:spChg chg="mod">
          <ac:chgData name="Kumar, Vinod" userId="a0710a6e-bffc-4971-8893-1c23addeb5b0" providerId="ADAL" clId="{C5505734-0C3B-44E8-9046-CA4BB1B80E9C}" dt="2022-11-16T22:16:53.234" v="1085" actId="1076"/>
          <ac:spMkLst>
            <pc:docMk/>
            <pc:sldMk cId="1021580243" sldId="311"/>
            <ac:spMk id="17" creationId="{91C43360-0D14-A449-3462-BF9C1F245365}"/>
          </ac:spMkLst>
        </pc:spChg>
        <pc:spChg chg="mod">
          <ac:chgData name="Kumar, Vinod" userId="a0710a6e-bffc-4971-8893-1c23addeb5b0" providerId="ADAL" clId="{C5505734-0C3B-44E8-9046-CA4BB1B80E9C}" dt="2022-11-16T22:16:53.234" v="1085" actId="1076"/>
          <ac:spMkLst>
            <pc:docMk/>
            <pc:sldMk cId="1021580243" sldId="311"/>
            <ac:spMk id="18" creationId="{9BDACDB2-4580-36DF-40DA-695AEFB25DFA}"/>
          </ac:spMkLst>
        </pc:spChg>
        <pc:spChg chg="mod topLvl">
          <ac:chgData name="Kumar, Vinod" userId="a0710a6e-bffc-4971-8893-1c23addeb5b0" providerId="ADAL" clId="{C5505734-0C3B-44E8-9046-CA4BB1B80E9C}" dt="2022-11-16T22:18:55.393" v="1090" actId="1076"/>
          <ac:spMkLst>
            <pc:docMk/>
            <pc:sldMk cId="1021580243" sldId="311"/>
            <ac:spMk id="20" creationId="{806C0891-EF5E-0D31-0430-0B36F7911224}"/>
          </ac:spMkLst>
        </pc:spChg>
        <pc:spChg chg="mod topLvl">
          <ac:chgData name="Kumar, Vinod" userId="a0710a6e-bffc-4971-8893-1c23addeb5b0" providerId="ADAL" clId="{C5505734-0C3B-44E8-9046-CA4BB1B80E9C}" dt="2022-11-16T22:18:55.393" v="1090" actId="1076"/>
          <ac:spMkLst>
            <pc:docMk/>
            <pc:sldMk cId="1021580243" sldId="311"/>
            <ac:spMk id="22" creationId="{2B432213-0B78-15C9-2B1D-079E728D2C4C}"/>
          </ac:spMkLst>
        </pc:spChg>
        <pc:spChg chg="mod topLvl">
          <ac:chgData name="Kumar, Vinod" userId="a0710a6e-bffc-4971-8893-1c23addeb5b0" providerId="ADAL" clId="{C5505734-0C3B-44E8-9046-CA4BB1B80E9C}" dt="2022-11-16T22:18:55.393" v="1090" actId="1076"/>
          <ac:spMkLst>
            <pc:docMk/>
            <pc:sldMk cId="1021580243" sldId="311"/>
            <ac:spMk id="23" creationId="{049B4985-43CA-3858-D36D-CBD7CE3DC0BA}"/>
          </ac:spMkLst>
        </pc:spChg>
        <pc:spChg chg="mod topLvl">
          <ac:chgData name="Kumar, Vinod" userId="a0710a6e-bffc-4971-8893-1c23addeb5b0" providerId="ADAL" clId="{C5505734-0C3B-44E8-9046-CA4BB1B80E9C}" dt="2022-11-16T22:18:55.393" v="1090" actId="1076"/>
          <ac:spMkLst>
            <pc:docMk/>
            <pc:sldMk cId="1021580243" sldId="311"/>
            <ac:spMk id="24" creationId="{43068EF9-889A-DB4E-5D09-9E0C0AAA84CA}"/>
          </ac:spMkLst>
        </pc:spChg>
        <pc:spChg chg="mod topLvl">
          <ac:chgData name="Kumar, Vinod" userId="a0710a6e-bffc-4971-8893-1c23addeb5b0" providerId="ADAL" clId="{C5505734-0C3B-44E8-9046-CA4BB1B80E9C}" dt="2022-11-16T22:18:55.393" v="1090" actId="1076"/>
          <ac:spMkLst>
            <pc:docMk/>
            <pc:sldMk cId="1021580243" sldId="311"/>
            <ac:spMk id="28" creationId="{EE87C42A-DE43-09A4-CAB7-53AC960DF80E}"/>
          </ac:spMkLst>
        </pc:spChg>
        <pc:spChg chg="mod topLvl">
          <ac:chgData name="Kumar, Vinod" userId="a0710a6e-bffc-4971-8893-1c23addeb5b0" providerId="ADAL" clId="{C5505734-0C3B-44E8-9046-CA4BB1B80E9C}" dt="2022-11-16T22:18:55.393" v="1090" actId="1076"/>
          <ac:spMkLst>
            <pc:docMk/>
            <pc:sldMk cId="1021580243" sldId="311"/>
            <ac:spMk id="29" creationId="{A2B46BCC-F10F-6D09-152D-D2D1FD0AFDF7}"/>
          </ac:spMkLst>
        </pc:spChg>
        <pc:spChg chg="mod topLvl">
          <ac:chgData name="Kumar, Vinod" userId="a0710a6e-bffc-4971-8893-1c23addeb5b0" providerId="ADAL" clId="{C5505734-0C3B-44E8-9046-CA4BB1B80E9C}" dt="2022-11-16T22:18:55.393" v="1090" actId="1076"/>
          <ac:spMkLst>
            <pc:docMk/>
            <pc:sldMk cId="1021580243" sldId="311"/>
            <ac:spMk id="30" creationId="{931D87A7-15C7-5F90-1CE3-AD41533BBDDD}"/>
          </ac:spMkLst>
        </pc:spChg>
        <pc:spChg chg="mod topLvl">
          <ac:chgData name="Kumar, Vinod" userId="a0710a6e-bffc-4971-8893-1c23addeb5b0" providerId="ADAL" clId="{C5505734-0C3B-44E8-9046-CA4BB1B80E9C}" dt="2022-11-16T22:18:55.393" v="1090" actId="1076"/>
          <ac:spMkLst>
            <pc:docMk/>
            <pc:sldMk cId="1021580243" sldId="311"/>
            <ac:spMk id="31" creationId="{4B3A29A7-1B4B-8BE3-3393-CF5981B5CE31}"/>
          </ac:spMkLst>
        </pc:spChg>
        <pc:spChg chg="mod topLvl">
          <ac:chgData name="Kumar, Vinod" userId="a0710a6e-bffc-4971-8893-1c23addeb5b0" providerId="ADAL" clId="{C5505734-0C3B-44E8-9046-CA4BB1B80E9C}" dt="2022-11-16T22:18:55.393" v="1090" actId="1076"/>
          <ac:spMkLst>
            <pc:docMk/>
            <pc:sldMk cId="1021580243" sldId="311"/>
            <ac:spMk id="32" creationId="{FD7B71FF-D28C-6A1E-5D8F-788B0514F698}"/>
          </ac:spMkLst>
        </pc:spChg>
        <pc:spChg chg="add mod topLvl">
          <ac:chgData name="Kumar, Vinod" userId="a0710a6e-bffc-4971-8893-1c23addeb5b0" providerId="ADAL" clId="{C5505734-0C3B-44E8-9046-CA4BB1B80E9C}" dt="2022-11-16T22:18:55.393" v="1090" actId="1076"/>
          <ac:spMkLst>
            <pc:docMk/>
            <pc:sldMk cId="1021580243" sldId="311"/>
            <ac:spMk id="37" creationId="{2CB25621-9B8A-6E69-E52A-710BBCAE7D02}"/>
          </ac:spMkLst>
        </pc:spChg>
        <pc:spChg chg="add mod topLvl">
          <ac:chgData name="Kumar, Vinod" userId="a0710a6e-bffc-4971-8893-1c23addeb5b0" providerId="ADAL" clId="{C5505734-0C3B-44E8-9046-CA4BB1B80E9C}" dt="2022-11-16T22:18:55.393" v="1090" actId="1076"/>
          <ac:spMkLst>
            <pc:docMk/>
            <pc:sldMk cId="1021580243" sldId="311"/>
            <ac:spMk id="38" creationId="{20EFE861-A449-7815-2E72-E31B1453034F}"/>
          </ac:spMkLst>
        </pc:spChg>
        <pc:spChg chg="add mod topLvl">
          <ac:chgData name="Kumar, Vinod" userId="a0710a6e-bffc-4971-8893-1c23addeb5b0" providerId="ADAL" clId="{C5505734-0C3B-44E8-9046-CA4BB1B80E9C}" dt="2022-11-16T22:18:55.393" v="1090" actId="1076"/>
          <ac:spMkLst>
            <pc:docMk/>
            <pc:sldMk cId="1021580243" sldId="311"/>
            <ac:spMk id="39" creationId="{B8A7EAF4-9225-65B7-BF86-64B8125B303D}"/>
          </ac:spMkLst>
        </pc:spChg>
        <pc:spChg chg="add mod">
          <ac:chgData name="Kumar, Vinod" userId="a0710a6e-bffc-4971-8893-1c23addeb5b0" providerId="ADAL" clId="{C5505734-0C3B-44E8-9046-CA4BB1B80E9C}" dt="2022-11-16T22:20:45.449" v="1106" actId="1076"/>
          <ac:spMkLst>
            <pc:docMk/>
            <pc:sldMk cId="1021580243" sldId="311"/>
            <ac:spMk id="44" creationId="{11B92327-31CB-614A-D505-DE770E18F202}"/>
          </ac:spMkLst>
        </pc:spChg>
        <pc:spChg chg="add mod">
          <ac:chgData name="Kumar, Vinod" userId="a0710a6e-bffc-4971-8893-1c23addeb5b0" providerId="ADAL" clId="{C5505734-0C3B-44E8-9046-CA4BB1B80E9C}" dt="2022-11-16T22:21:00.352" v="1201" actId="1037"/>
          <ac:spMkLst>
            <pc:docMk/>
            <pc:sldMk cId="1021580243" sldId="311"/>
            <ac:spMk id="45" creationId="{026710EE-A656-3547-974F-F1654F7242CD}"/>
          </ac:spMkLst>
        </pc:spChg>
        <pc:spChg chg="add del mod">
          <ac:chgData name="Kumar, Vinod" userId="a0710a6e-bffc-4971-8893-1c23addeb5b0" providerId="ADAL" clId="{C5505734-0C3B-44E8-9046-CA4BB1B80E9C}" dt="2022-11-16T22:29:35.628" v="1328" actId="478"/>
          <ac:spMkLst>
            <pc:docMk/>
            <pc:sldMk cId="1021580243" sldId="311"/>
            <ac:spMk id="46" creationId="{1ABB9FA5-AD4B-84FF-3A1F-581F8D675EF1}"/>
          </ac:spMkLst>
        </pc:spChg>
        <pc:grpChg chg="add del mod">
          <ac:chgData name="Kumar, Vinod" userId="a0710a6e-bffc-4971-8893-1c23addeb5b0" providerId="ADAL" clId="{C5505734-0C3B-44E8-9046-CA4BB1B80E9C}" dt="2022-11-16T21:49:43.753" v="789" actId="165"/>
          <ac:grpSpMkLst>
            <pc:docMk/>
            <pc:sldMk cId="1021580243" sldId="311"/>
            <ac:grpSpMk id="3" creationId="{E62C9F6A-592F-BCF1-1D2D-96FCF7AFD1DA}"/>
          </ac:grpSpMkLst>
        </pc:grpChg>
        <pc:grpChg chg="add del mod">
          <ac:chgData name="Kumar, Vinod" userId="a0710a6e-bffc-4971-8893-1c23addeb5b0" providerId="ADAL" clId="{C5505734-0C3B-44E8-9046-CA4BB1B80E9C}" dt="2022-11-16T22:18:46.657" v="1089" actId="478"/>
          <ac:grpSpMkLst>
            <pc:docMk/>
            <pc:sldMk cId="1021580243" sldId="311"/>
            <ac:grpSpMk id="6" creationId="{1C55CA2A-6EAF-05F7-43C7-3F992FCBDCC9}"/>
          </ac:grpSpMkLst>
        </pc:grpChg>
        <pc:grpChg chg="add del mod">
          <ac:chgData name="Kumar, Vinod" userId="a0710a6e-bffc-4971-8893-1c23addeb5b0" providerId="ADAL" clId="{C5505734-0C3B-44E8-9046-CA4BB1B80E9C}" dt="2022-11-16T22:18:43.585" v="1088" actId="478"/>
          <ac:grpSpMkLst>
            <pc:docMk/>
            <pc:sldMk cId="1021580243" sldId="311"/>
            <ac:grpSpMk id="13" creationId="{B93F06B6-B654-89CD-77C9-9267DA4CC3AF}"/>
          </ac:grpSpMkLst>
        </pc:grpChg>
        <pc:grpChg chg="add del mod">
          <ac:chgData name="Kumar, Vinod" userId="a0710a6e-bffc-4971-8893-1c23addeb5b0" providerId="ADAL" clId="{C5505734-0C3B-44E8-9046-CA4BB1B80E9C}" dt="2022-11-16T22:20:01.841" v="1102" actId="478"/>
          <ac:grpSpMkLst>
            <pc:docMk/>
            <pc:sldMk cId="1021580243" sldId="311"/>
            <ac:grpSpMk id="26" creationId="{2C6E7A9B-3AAE-3E6F-1EBF-F9592C965DE7}"/>
          </ac:grpSpMkLst>
        </pc:grpChg>
        <pc:grpChg chg="add del mod">
          <ac:chgData name="Kumar, Vinod" userId="a0710a6e-bffc-4971-8893-1c23addeb5b0" providerId="ADAL" clId="{C5505734-0C3B-44E8-9046-CA4BB1B80E9C}" dt="2022-11-16T21:52:03.457" v="820" actId="165"/>
          <ac:grpSpMkLst>
            <pc:docMk/>
            <pc:sldMk cId="1021580243" sldId="311"/>
            <ac:grpSpMk id="27" creationId="{8C37C4E0-879F-1F43-7F89-CAEB85F6CD77}"/>
          </ac:grpSpMkLst>
        </pc:grpChg>
        <pc:grpChg chg="add del mod">
          <ac:chgData name="Kumar, Vinod" userId="a0710a6e-bffc-4971-8893-1c23addeb5b0" providerId="ADAL" clId="{C5505734-0C3B-44E8-9046-CA4BB1B80E9C}" dt="2022-11-16T22:12:57.281" v="1031" actId="165"/>
          <ac:grpSpMkLst>
            <pc:docMk/>
            <pc:sldMk cId="1021580243" sldId="311"/>
            <ac:grpSpMk id="40" creationId="{297E5413-0CAF-D1D8-E410-A464D6FA7AC5}"/>
          </ac:grpSpMkLst>
        </pc:grpChg>
        <pc:grpChg chg="add del mod">
          <ac:chgData name="Kumar, Vinod" userId="a0710a6e-bffc-4971-8893-1c23addeb5b0" providerId="ADAL" clId="{C5505734-0C3B-44E8-9046-CA4BB1B80E9C}" dt="2022-11-16T22:20:00.880" v="1101" actId="478"/>
          <ac:grpSpMkLst>
            <pc:docMk/>
            <pc:sldMk cId="1021580243" sldId="311"/>
            <ac:grpSpMk id="41" creationId="{608671B7-238A-B440-3684-188D4F2AB00F}"/>
          </ac:grpSpMkLst>
        </pc:grpChg>
        <pc:picChg chg="add del mod">
          <ac:chgData name="Kumar, Vinod" userId="a0710a6e-bffc-4971-8893-1c23addeb5b0" providerId="ADAL" clId="{C5505734-0C3B-44E8-9046-CA4BB1B80E9C}" dt="2022-11-16T22:20:06.689" v="1103" actId="478"/>
          <ac:picMkLst>
            <pc:docMk/>
            <pc:sldMk cId="1021580243" sldId="311"/>
            <ac:picMk id="2" creationId="{64287E71-B5E8-C777-A36C-E3918D700AA0}"/>
          </ac:picMkLst>
        </pc:picChg>
        <pc:picChg chg="mod topLvl">
          <ac:chgData name="Kumar, Vinod" userId="a0710a6e-bffc-4971-8893-1c23addeb5b0" providerId="ADAL" clId="{C5505734-0C3B-44E8-9046-CA4BB1B80E9C}" dt="2022-11-16T21:49:31.850" v="782" actId="165"/>
          <ac:picMkLst>
            <pc:docMk/>
            <pc:sldMk cId="1021580243" sldId="311"/>
            <ac:picMk id="12" creationId="{2129CBF4-0809-8F7E-195A-4DDE8BE851AF}"/>
          </ac:picMkLst>
        </pc:picChg>
        <pc:picChg chg="mod">
          <ac:chgData name="Kumar, Vinod" userId="a0710a6e-bffc-4971-8893-1c23addeb5b0" providerId="ADAL" clId="{C5505734-0C3B-44E8-9046-CA4BB1B80E9C}" dt="2022-11-16T22:16:53.234" v="1085" actId="1076"/>
          <ac:picMkLst>
            <pc:docMk/>
            <pc:sldMk cId="1021580243" sldId="311"/>
            <ac:picMk id="19" creationId="{110C2D3E-92D8-C495-5A4C-E45801FEDEE6}"/>
          </ac:picMkLst>
        </pc:picChg>
        <pc:picChg chg="add del mod">
          <ac:chgData name="Kumar, Vinod" userId="a0710a6e-bffc-4971-8893-1c23addeb5b0" providerId="ADAL" clId="{C5505734-0C3B-44E8-9046-CA4BB1B80E9C}" dt="2022-11-16T15:44:34.106" v="756" actId="478"/>
          <ac:picMkLst>
            <pc:docMk/>
            <pc:sldMk cId="1021580243" sldId="311"/>
            <ac:picMk id="20" creationId="{7BF53D28-C47F-338E-0006-52CE5AC3B5A0}"/>
          </ac:picMkLst>
        </pc:picChg>
        <pc:picChg chg="add del mod modCrop">
          <ac:chgData name="Kumar, Vinod" userId="a0710a6e-bffc-4971-8893-1c23addeb5b0" providerId="ADAL" clId="{C5505734-0C3B-44E8-9046-CA4BB1B80E9C}" dt="2022-11-16T22:18:42.674" v="1087" actId="478"/>
          <ac:picMkLst>
            <pc:docMk/>
            <pc:sldMk cId="1021580243" sldId="311"/>
            <ac:picMk id="21" creationId="{E53AA982-B478-B2EB-CB94-6815B84DFEF2}"/>
          </ac:picMkLst>
        </pc:picChg>
        <pc:picChg chg="mod topLvl">
          <ac:chgData name="Kumar, Vinod" userId="a0710a6e-bffc-4971-8893-1c23addeb5b0" providerId="ADAL" clId="{C5505734-0C3B-44E8-9046-CA4BB1B80E9C}" dt="2022-11-16T22:18:55.393" v="1090" actId="1076"/>
          <ac:picMkLst>
            <pc:docMk/>
            <pc:sldMk cId="1021580243" sldId="311"/>
            <ac:picMk id="25" creationId="{CD0E8E42-E9B5-283E-A091-1A400C4654EF}"/>
          </ac:picMkLst>
        </pc:picChg>
        <pc:picChg chg="mod topLvl">
          <ac:chgData name="Kumar, Vinod" userId="a0710a6e-bffc-4971-8893-1c23addeb5b0" providerId="ADAL" clId="{C5505734-0C3B-44E8-9046-CA4BB1B80E9C}" dt="2022-11-16T22:18:55.393" v="1090" actId="1076"/>
          <ac:picMkLst>
            <pc:docMk/>
            <pc:sldMk cId="1021580243" sldId="311"/>
            <ac:picMk id="33" creationId="{2E2245F3-8462-FD70-A8FD-5C7CC64FE8DE}"/>
          </ac:picMkLst>
        </pc:picChg>
        <pc:picChg chg="add mod topLvl modCrop">
          <ac:chgData name="Kumar, Vinod" userId="a0710a6e-bffc-4971-8893-1c23addeb5b0" providerId="ADAL" clId="{C5505734-0C3B-44E8-9046-CA4BB1B80E9C}" dt="2022-11-16T22:18:55.393" v="1090" actId="1076"/>
          <ac:picMkLst>
            <pc:docMk/>
            <pc:sldMk cId="1021580243" sldId="311"/>
            <ac:picMk id="34" creationId="{91AB575E-F90B-C086-F8DB-C2AB71550483}"/>
          </ac:picMkLst>
        </pc:picChg>
        <pc:picChg chg="add mod topLvl modCrop">
          <ac:chgData name="Kumar, Vinod" userId="a0710a6e-bffc-4971-8893-1c23addeb5b0" providerId="ADAL" clId="{C5505734-0C3B-44E8-9046-CA4BB1B80E9C}" dt="2022-11-16T22:18:55.393" v="1090" actId="1076"/>
          <ac:picMkLst>
            <pc:docMk/>
            <pc:sldMk cId="1021580243" sldId="311"/>
            <ac:picMk id="35" creationId="{E38126C3-4224-A0D2-55E7-E7D89646ACFA}"/>
          </ac:picMkLst>
        </pc:picChg>
        <pc:picChg chg="add mod topLvl modCrop">
          <ac:chgData name="Kumar, Vinod" userId="a0710a6e-bffc-4971-8893-1c23addeb5b0" providerId="ADAL" clId="{C5505734-0C3B-44E8-9046-CA4BB1B80E9C}" dt="2022-11-16T22:18:55.393" v="1090" actId="1076"/>
          <ac:picMkLst>
            <pc:docMk/>
            <pc:sldMk cId="1021580243" sldId="311"/>
            <ac:picMk id="36" creationId="{960A4D0C-395C-7FAA-D606-4E9FC23AFCCD}"/>
          </ac:picMkLst>
        </pc:picChg>
        <pc:picChg chg="add mod">
          <ac:chgData name="Kumar, Vinod" userId="a0710a6e-bffc-4971-8893-1c23addeb5b0" providerId="ADAL" clId="{C5505734-0C3B-44E8-9046-CA4BB1B80E9C}" dt="2022-11-16T22:25:44.958" v="1323" actId="1036"/>
          <ac:picMkLst>
            <pc:docMk/>
            <pc:sldMk cId="1021580243" sldId="311"/>
            <ac:picMk id="42" creationId="{59CB2D69-3614-FCFE-8790-FADDCBBA4B1E}"/>
          </ac:picMkLst>
        </pc:picChg>
        <pc:picChg chg="add mod">
          <ac:chgData name="Kumar, Vinod" userId="a0710a6e-bffc-4971-8893-1c23addeb5b0" providerId="ADAL" clId="{C5505734-0C3B-44E8-9046-CA4BB1B80E9C}" dt="2022-11-16T22:25:44.958" v="1323" actId="1036"/>
          <ac:picMkLst>
            <pc:docMk/>
            <pc:sldMk cId="1021580243" sldId="311"/>
            <ac:picMk id="43" creationId="{D2379BED-B394-ABE7-6975-EC515FB3CC19}"/>
          </ac:picMkLst>
        </pc:picChg>
      </pc:sldChg>
    </pc:docChg>
  </pc:docChgLst>
  <pc:docChgLst>
    <pc:chgData name="Kumar, Vinod" userId="a0710a6e-bffc-4971-8893-1c23addeb5b0" providerId="ADAL" clId="{29C9EDDB-5878-4E39-9C7D-77FA9AFFA3E5}"/>
    <pc:docChg chg="undo redo custSel addSld delSld modSld sldOrd">
      <pc:chgData name="Kumar, Vinod" userId="a0710a6e-bffc-4971-8893-1c23addeb5b0" providerId="ADAL" clId="{29C9EDDB-5878-4E39-9C7D-77FA9AFFA3E5}" dt="2023-09-27T14:50:39.510" v="858" actId="20577"/>
      <pc:docMkLst>
        <pc:docMk/>
      </pc:docMkLst>
      <pc:sldChg chg="modSp mod ord">
        <pc:chgData name="Kumar, Vinod" userId="a0710a6e-bffc-4971-8893-1c23addeb5b0" providerId="ADAL" clId="{29C9EDDB-5878-4E39-9C7D-77FA9AFFA3E5}" dt="2023-09-26T19:49:54.580" v="302" actId="20577"/>
        <pc:sldMkLst>
          <pc:docMk/>
          <pc:sldMk cId="3312243808" sldId="328"/>
        </pc:sldMkLst>
        <pc:spChg chg="mod">
          <ac:chgData name="Kumar, Vinod" userId="a0710a6e-bffc-4971-8893-1c23addeb5b0" providerId="ADAL" clId="{29C9EDDB-5878-4E39-9C7D-77FA9AFFA3E5}" dt="2023-09-26T19:49:54.580" v="302" actId="20577"/>
          <ac:spMkLst>
            <pc:docMk/>
            <pc:sldMk cId="3312243808" sldId="328"/>
            <ac:spMk id="32" creationId="{C7A57016-B285-E7A4-4309-57286A85EEF6}"/>
          </ac:spMkLst>
        </pc:spChg>
      </pc:sldChg>
      <pc:sldChg chg="modSp mod">
        <pc:chgData name="Kumar, Vinod" userId="a0710a6e-bffc-4971-8893-1c23addeb5b0" providerId="ADAL" clId="{29C9EDDB-5878-4E39-9C7D-77FA9AFFA3E5}" dt="2023-09-14T16:06:44.829" v="278" actId="20577"/>
        <pc:sldMkLst>
          <pc:docMk/>
          <pc:sldMk cId="3066716538" sldId="331"/>
        </pc:sldMkLst>
        <pc:spChg chg="mod">
          <ac:chgData name="Kumar, Vinod" userId="a0710a6e-bffc-4971-8893-1c23addeb5b0" providerId="ADAL" clId="{29C9EDDB-5878-4E39-9C7D-77FA9AFFA3E5}" dt="2023-09-14T16:06:38.399" v="277" actId="20577"/>
          <ac:spMkLst>
            <pc:docMk/>
            <pc:sldMk cId="3066716538" sldId="331"/>
            <ac:spMk id="6" creationId="{8594A58D-A230-9192-2A3C-2FCFB1AEF16C}"/>
          </ac:spMkLst>
        </pc:spChg>
        <pc:spChg chg="mod">
          <ac:chgData name="Kumar, Vinod" userId="a0710a6e-bffc-4971-8893-1c23addeb5b0" providerId="ADAL" clId="{29C9EDDB-5878-4E39-9C7D-77FA9AFFA3E5}" dt="2023-09-14T16:06:44.829" v="278" actId="20577"/>
          <ac:spMkLst>
            <pc:docMk/>
            <pc:sldMk cId="3066716538" sldId="331"/>
            <ac:spMk id="26" creationId="{FB05195B-DE4E-86D0-3FC6-CC6A7BEFDFFC}"/>
          </ac:spMkLst>
        </pc:spChg>
      </pc:sldChg>
      <pc:sldChg chg="delSp modSp mod">
        <pc:chgData name="Kumar, Vinod" userId="a0710a6e-bffc-4971-8893-1c23addeb5b0" providerId="ADAL" clId="{29C9EDDB-5878-4E39-9C7D-77FA9AFFA3E5}" dt="2023-09-14T16:08:40.875" v="281" actId="478"/>
        <pc:sldMkLst>
          <pc:docMk/>
          <pc:sldMk cId="752802638" sldId="332"/>
        </pc:sldMkLst>
        <pc:spChg chg="mod">
          <ac:chgData name="Kumar, Vinod" userId="a0710a6e-bffc-4971-8893-1c23addeb5b0" providerId="ADAL" clId="{29C9EDDB-5878-4E39-9C7D-77FA9AFFA3E5}" dt="2023-09-14T16:08:04.157" v="280" actId="20577"/>
          <ac:spMkLst>
            <pc:docMk/>
            <pc:sldMk cId="752802638" sldId="332"/>
            <ac:spMk id="5" creationId="{3F373588-3A1B-DD47-08CE-7272F63CA8A7}"/>
          </ac:spMkLst>
        </pc:spChg>
        <pc:spChg chg="del">
          <ac:chgData name="Kumar, Vinod" userId="a0710a6e-bffc-4971-8893-1c23addeb5b0" providerId="ADAL" clId="{29C9EDDB-5878-4E39-9C7D-77FA9AFFA3E5}" dt="2023-09-14T16:08:40.875" v="281" actId="478"/>
          <ac:spMkLst>
            <pc:docMk/>
            <pc:sldMk cId="752802638" sldId="332"/>
            <ac:spMk id="31" creationId="{E3B980BD-5D74-6E5C-0086-66315F9B9921}"/>
          </ac:spMkLst>
        </pc:spChg>
        <pc:grpChg chg="del">
          <ac:chgData name="Kumar, Vinod" userId="a0710a6e-bffc-4971-8893-1c23addeb5b0" providerId="ADAL" clId="{29C9EDDB-5878-4E39-9C7D-77FA9AFFA3E5}" dt="2023-09-14T16:08:40.875" v="281" actId="478"/>
          <ac:grpSpMkLst>
            <pc:docMk/>
            <pc:sldMk cId="752802638" sldId="332"/>
            <ac:grpSpMk id="35" creationId="{06BFD393-74E6-EEED-2BA3-3BE7BBAFEEF6}"/>
          </ac:grpSpMkLst>
        </pc:grpChg>
      </pc:sldChg>
      <pc:sldChg chg="modSp mod">
        <pc:chgData name="Kumar, Vinod" userId="a0710a6e-bffc-4971-8893-1c23addeb5b0" providerId="ADAL" clId="{29C9EDDB-5878-4E39-9C7D-77FA9AFFA3E5}" dt="2023-09-14T16:07:19.981" v="279" actId="20577"/>
        <pc:sldMkLst>
          <pc:docMk/>
          <pc:sldMk cId="2717138259" sldId="333"/>
        </pc:sldMkLst>
        <pc:spChg chg="mod">
          <ac:chgData name="Kumar, Vinod" userId="a0710a6e-bffc-4971-8893-1c23addeb5b0" providerId="ADAL" clId="{29C9EDDB-5878-4E39-9C7D-77FA9AFFA3E5}" dt="2023-09-14T16:07:19.981" v="279" actId="20577"/>
          <ac:spMkLst>
            <pc:docMk/>
            <pc:sldMk cId="2717138259" sldId="333"/>
            <ac:spMk id="2" creationId="{AAE1FA69-3576-CF10-27A3-42FC37A61688}"/>
          </ac:spMkLst>
        </pc:spChg>
      </pc:sldChg>
      <pc:sldChg chg="modSp mod">
        <pc:chgData name="Kumar, Vinod" userId="a0710a6e-bffc-4971-8893-1c23addeb5b0" providerId="ADAL" clId="{29C9EDDB-5878-4E39-9C7D-77FA9AFFA3E5}" dt="2023-09-14T15:58:29.057" v="269" actId="20577"/>
        <pc:sldMkLst>
          <pc:docMk/>
          <pc:sldMk cId="3948585847" sldId="342"/>
        </pc:sldMkLst>
        <pc:spChg chg="mod">
          <ac:chgData name="Kumar, Vinod" userId="a0710a6e-bffc-4971-8893-1c23addeb5b0" providerId="ADAL" clId="{29C9EDDB-5878-4E39-9C7D-77FA9AFFA3E5}" dt="2023-09-14T15:58:29.057" v="269" actId="20577"/>
          <ac:spMkLst>
            <pc:docMk/>
            <pc:sldMk cId="3948585847" sldId="342"/>
            <ac:spMk id="4" creationId="{A268E69E-1A64-C70D-117D-C52D8B847D56}"/>
          </ac:spMkLst>
        </pc:spChg>
      </pc:sldChg>
      <pc:sldChg chg="delSp modSp mod">
        <pc:chgData name="Kumar, Vinod" userId="a0710a6e-bffc-4971-8893-1c23addeb5b0" providerId="ADAL" clId="{29C9EDDB-5878-4E39-9C7D-77FA9AFFA3E5}" dt="2023-09-14T15:59:03.311" v="271" actId="478"/>
        <pc:sldMkLst>
          <pc:docMk/>
          <pc:sldMk cId="3501267655" sldId="343"/>
        </pc:sldMkLst>
        <pc:spChg chg="mod">
          <ac:chgData name="Kumar, Vinod" userId="a0710a6e-bffc-4971-8893-1c23addeb5b0" providerId="ADAL" clId="{29C9EDDB-5878-4E39-9C7D-77FA9AFFA3E5}" dt="2023-09-14T15:58:58.529" v="270" actId="20577"/>
          <ac:spMkLst>
            <pc:docMk/>
            <pc:sldMk cId="3501267655" sldId="343"/>
            <ac:spMk id="28" creationId="{17098AA9-5907-8B57-98F4-D1AD2035DB66}"/>
          </ac:spMkLst>
        </pc:spChg>
        <pc:spChg chg="del">
          <ac:chgData name="Kumar, Vinod" userId="a0710a6e-bffc-4971-8893-1c23addeb5b0" providerId="ADAL" clId="{29C9EDDB-5878-4E39-9C7D-77FA9AFFA3E5}" dt="2023-09-14T15:59:03.311" v="271" actId="478"/>
          <ac:spMkLst>
            <pc:docMk/>
            <pc:sldMk cId="3501267655" sldId="343"/>
            <ac:spMk id="41" creationId="{4690E830-E056-EDC1-71EF-A2096B23503C}"/>
          </ac:spMkLst>
        </pc:spChg>
        <pc:spChg chg="del">
          <ac:chgData name="Kumar, Vinod" userId="a0710a6e-bffc-4971-8893-1c23addeb5b0" providerId="ADAL" clId="{29C9EDDB-5878-4E39-9C7D-77FA9AFFA3E5}" dt="2023-09-14T15:59:03.311" v="271" actId="478"/>
          <ac:spMkLst>
            <pc:docMk/>
            <pc:sldMk cId="3501267655" sldId="343"/>
            <ac:spMk id="47" creationId="{92E527C4-C4D4-5A67-E7AA-5D1746E413FF}"/>
          </ac:spMkLst>
        </pc:spChg>
        <pc:grpChg chg="del">
          <ac:chgData name="Kumar, Vinod" userId="a0710a6e-bffc-4971-8893-1c23addeb5b0" providerId="ADAL" clId="{29C9EDDB-5878-4E39-9C7D-77FA9AFFA3E5}" dt="2023-09-14T15:59:03.311" v="271" actId="478"/>
          <ac:grpSpMkLst>
            <pc:docMk/>
            <pc:sldMk cId="3501267655" sldId="343"/>
            <ac:grpSpMk id="42" creationId="{AE1ECFA1-4468-5FEA-F170-E2A7D3B21E12}"/>
          </ac:grpSpMkLst>
        </pc:grpChg>
      </pc:sldChg>
      <pc:sldChg chg="modSp mod">
        <pc:chgData name="Kumar, Vinod" userId="a0710a6e-bffc-4971-8893-1c23addeb5b0" providerId="ADAL" clId="{29C9EDDB-5878-4E39-9C7D-77FA9AFFA3E5}" dt="2023-09-26T19:50:58.484" v="303" actId="20577"/>
        <pc:sldMkLst>
          <pc:docMk/>
          <pc:sldMk cId="3077287310" sldId="344"/>
        </pc:sldMkLst>
        <pc:spChg chg="mod">
          <ac:chgData name="Kumar, Vinod" userId="a0710a6e-bffc-4971-8893-1c23addeb5b0" providerId="ADAL" clId="{29C9EDDB-5878-4E39-9C7D-77FA9AFFA3E5}" dt="2023-09-26T19:50:58.484" v="303" actId="20577"/>
          <ac:spMkLst>
            <pc:docMk/>
            <pc:sldMk cId="3077287310" sldId="344"/>
            <ac:spMk id="2" creationId="{FD7C0F74-9452-C4D9-2D19-088D7FEE2727}"/>
          </ac:spMkLst>
        </pc:spChg>
      </pc:sldChg>
      <pc:sldChg chg="del">
        <pc:chgData name="Kumar, Vinod" userId="a0710a6e-bffc-4971-8893-1c23addeb5b0" providerId="ADAL" clId="{29C9EDDB-5878-4E39-9C7D-77FA9AFFA3E5}" dt="2023-09-26T19:53:01.853" v="304" actId="47"/>
        <pc:sldMkLst>
          <pc:docMk/>
          <pc:sldMk cId="1703545616" sldId="345"/>
        </pc:sldMkLst>
      </pc:sldChg>
      <pc:sldChg chg="addSp delSp modSp new mod">
        <pc:chgData name="Kumar, Vinod" userId="a0710a6e-bffc-4971-8893-1c23addeb5b0" providerId="ADAL" clId="{29C9EDDB-5878-4E39-9C7D-77FA9AFFA3E5}" dt="2023-09-26T19:49:26.304" v="301" actId="20577"/>
        <pc:sldMkLst>
          <pc:docMk/>
          <pc:sldMk cId="1622202923" sldId="346"/>
        </pc:sldMkLst>
        <pc:spChg chg="del">
          <ac:chgData name="Kumar, Vinod" userId="a0710a6e-bffc-4971-8893-1c23addeb5b0" providerId="ADAL" clId="{29C9EDDB-5878-4E39-9C7D-77FA9AFFA3E5}" dt="2023-09-14T15:34:18.563" v="1" actId="478"/>
          <ac:spMkLst>
            <pc:docMk/>
            <pc:sldMk cId="1622202923" sldId="346"/>
            <ac:spMk id="2" creationId="{2CA4F9C1-A3E7-9589-010C-0575E889E6E8}"/>
          </ac:spMkLst>
        </pc:spChg>
        <pc:spChg chg="del">
          <ac:chgData name="Kumar, Vinod" userId="a0710a6e-bffc-4971-8893-1c23addeb5b0" providerId="ADAL" clId="{29C9EDDB-5878-4E39-9C7D-77FA9AFFA3E5}" dt="2023-09-14T15:34:18.563" v="1" actId="478"/>
          <ac:spMkLst>
            <pc:docMk/>
            <pc:sldMk cId="1622202923" sldId="346"/>
            <ac:spMk id="3" creationId="{E4945C9B-7B98-997F-B8BB-8EBD4888C159}"/>
          </ac:spMkLst>
        </pc:spChg>
        <pc:spChg chg="add mod">
          <ac:chgData name="Kumar, Vinod" userId="a0710a6e-bffc-4971-8893-1c23addeb5b0" providerId="ADAL" clId="{29C9EDDB-5878-4E39-9C7D-77FA9AFFA3E5}" dt="2023-09-26T19:49:26.304" v="301" actId="20577"/>
          <ac:spMkLst>
            <pc:docMk/>
            <pc:sldMk cId="1622202923" sldId="346"/>
            <ac:spMk id="4" creationId="{A93B1793-0837-4BA3-F82C-0556BA77DCE9}"/>
          </ac:spMkLst>
        </pc:spChg>
        <pc:spChg chg="mod">
          <ac:chgData name="Kumar, Vinod" userId="a0710a6e-bffc-4971-8893-1c23addeb5b0" providerId="ADAL" clId="{29C9EDDB-5878-4E39-9C7D-77FA9AFFA3E5}" dt="2023-09-14T15:36:19.104" v="8" actId="1076"/>
          <ac:spMkLst>
            <pc:docMk/>
            <pc:sldMk cId="1622202923" sldId="346"/>
            <ac:spMk id="7" creationId="{D3D1E62B-D48D-24DA-1B7E-BA8DDD0E4E09}"/>
          </ac:spMkLst>
        </pc:spChg>
        <pc:spChg chg="mod">
          <ac:chgData name="Kumar, Vinod" userId="a0710a6e-bffc-4971-8893-1c23addeb5b0" providerId="ADAL" clId="{29C9EDDB-5878-4E39-9C7D-77FA9AFFA3E5}" dt="2023-09-14T15:36:19.104" v="8" actId="1076"/>
          <ac:spMkLst>
            <pc:docMk/>
            <pc:sldMk cId="1622202923" sldId="346"/>
            <ac:spMk id="8" creationId="{57BA895A-A5FA-0375-4C90-294A326759B1}"/>
          </ac:spMkLst>
        </pc:spChg>
        <pc:spChg chg="mod">
          <ac:chgData name="Kumar, Vinod" userId="a0710a6e-bffc-4971-8893-1c23addeb5b0" providerId="ADAL" clId="{29C9EDDB-5878-4E39-9C7D-77FA9AFFA3E5}" dt="2023-09-14T15:36:19.104" v="8" actId="1076"/>
          <ac:spMkLst>
            <pc:docMk/>
            <pc:sldMk cId="1622202923" sldId="346"/>
            <ac:spMk id="9" creationId="{D8CD32FC-B2C3-51F3-D9BD-F04E0B9CBF2D}"/>
          </ac:spMkLst>
        </pc:spChg>
        <pc:spChg chg="add del mod">
          <ac:chgData name="Kumar, Vinod" userId="a0710a6e-bffc-4971-8893-1c23addeb5b0" providerId="ADAL" clId="{29C9EDDB-5878-4E39-9C7D-77FA9AFFA3E5}" dt="2023-09-14T15:52:17.011" v="237" actId="478"/>
          <ac:spMkLst>
            <pc:docMk/>
            <pc:sldMk cId="1622202923" sldId="346"/>
            <ac:spMk id="10" creationId="{90369139-2313-F13B-F72E-15E18F16ABF2}"/>
          </ac:spMkLst>
        </pc:spChg>
        <pc:spChg chg="mod">
          <ac:chgData name="Kumar, Vinod" userId="a0710a6e-bffc-4971-8893-1c23addeb5b0" providerId="ADAL" clId="{29C9EDDB-5878-4E39-9C7D-77FA9AFFA3E5}" dt="2023-09-14T15:36:04.611" v="4"/>
          <ac:spMkLst>
            <pc:docMk/>
            <pc:sldMk cId="1622202923" sldId="346"/>
            <ac:spMk id="15" creationId="{7DF983BC-2263-920A-D4AE-0203747320E7}"/>
          </ac:spMkLst>
        </pc:spChg>
        <pc:spChg chg="mod">
          <ac:chgData name="Kumar, Vinod" userId="a0710a6e-bffc-4971-8893-1c23addeb5b0" providerId="ADAL" clId="{29C9EDDB-5878-4E39-9C7D-77FA9AFFA3E5}" dt="2023-09-14T15:36:04.611" v="4"/>
          <ac:spMkLst>
            <pc:docMk/>
            <pc:sldMk cId="1622202923" sldId="346"/>
            <ac:spMk id="16" creationId="{B442FBD3-6207-8CAE-CF71-A140985037E6}"/>
          </ac:spMkLst>
        </pc:spChg>
        <pc:spChg chg="mod">
          <ac:chgData name="Kumar, Vinod" userId="a0710a6e-bffc-4971-8893-1c23addeb5b0" providerId="ADAL" clId="{29C9EDDB-5878-4E39-9C7D-77FA9AFFA3E5}" dt="2023-09-14T15:36:04.611" v="4"/>
          <ac:spMkLst>
            <pc:docMk/>
            <pc:sldMk cId="1622202923" sldId="346"/>
            <ac:spMk id="17" creationId="{D5B0F616-AF20-475E-0707-8683E74F9DE7}"/>
          </ac:spMkLst>
        </pc:spChg>
        <pc:spChg chg="mod">
          <ac:chgData name="Kumar, Vinod" userId="a0710a6e-bffc-4971-8893-1c23addeb5b0" providerId="ADAL" clId="{29C9EDDB-5878-4E39-9C7D-77FA9AFFA3E5}" dt="2023-09-14T15:36:04.611" v="4"/>
          <ac:spMkLst>
            <pc:docMk/>
            <pc:sldMk cId="1622202923" sldId="346"/>
            <ac:spMk id="18" creationId="{FC25F32E-9968-1AC4-15E3-30012F399049}"/>
          </ac:spMkLst>
        </pc:spChg>
        <pc:spChg chg="mod">
          <ac:chgData name="Kumar, Vinod" userId="a0710a6e-bffc-4971-8893-1c23addeb5b0" providerId="ADAL" clId="{29C9EDDB-5878-4E39-9C7D-77FA9AFFA3E5}" dt="2023-09-14T15:36:04.611" v="4"/>
          <ac:spMkLst>
            <pc:docMk/>
            <pc:sldMk cId="1622202923" sldId="346"/>
            <ac:spMk id="19" creationId="{F8A048CA-962C-5446-7CAD-4E592BFABCFF}"/>
          </ac:spMkLst>
        </pc:spChg>
        <pc:spChg chg="mod">
          <ac:chgData name="Kumar, Vinod" userId="a0710a6e-bffc-4971-8893-1c23addeb5b0" providerId="ADAL" clId="{29C9EDDB-5878-4E39-9C7D-77FA9AFFA3E5}" dt="2023-09-14T15:36:04.611" v="4"/>
          <ac:spMkLst>
            <pc:docMk/>
            <pc:sldMk cId="1622202923" sldId="346"/>
            <ac:spMk id="20" creationId="{C0DADCD5-E4BD-E066-9976-862D57688A89}"/>
          </ac:spMkLst>
        </pc:spChg>
        <pc:spChg chg="mod">
          <ac:chgData name="Kumar, Vinod" userId="a0710a6e-bffc-4971-8893-1c23addeb5b0" providerId="ADAL" clId="{29C9EDDB-5878-4E39-9C7D-77FA9AFFA3E5}" dt="2023-09-14T15:36:04.611" v="4"/>
          <ac:spMkLst>
            <pc:docMk/>
            <pc:sldMk cId="1622202923" sldId="346"/>
            <ac:spMk id="21" creationId="{C60A8D9D-ACA5-9A0F-CE4F-8BA0172C3DB2}"/>
          </ac:spMkLst>
        </pc:spChg>
        <pc:spChg chg="mod">
          <ac:chgData name="Kumar, Vinod" userId="a0710a6e-bffc-4971-8893-1c23addeb5b0" providerId="ADAL" clId="{29C9EDDB-5878-4E39-9C7D-77FA9AFFA3E5}" dt="2023-09-14T15:36:04.611" v="4"/>
          <ac:spMkLst>
            <pc:docMk/>
            <pc:sldMk cId="1622202923" sldId="346"/>
            <ac:spMk id="22" creationId="{C23FC534-4C8F-72B9-C0BE-6175933D2558}"/>
          </ac:spMkLst>
        </pc:spChg>
        <pc:spChg chg="mod">
          <ac:chgData name="Kumar, Vinod" userId="a0710a6e-bffc-4971-8893-1c23addeb5b0" providerId="ADAL" clId="{29C9EDDB-5878-4E39-9C7D-77FA9AFFA3E5}" dt="2023-09-14T15:36:04.611" v="4"/>
          <ac:spMkLst>
            <pc:docMk/>
            <pc:sldMk cId="1622202923" sldId="346"/>
            <ac:spMk id="23" creationId="{AF0029B3-5F71-FBFB-3DA2-3D8D58955FF0}"/>
          </ac:spMkLst>
        </pc:spChg>
        <pc:spChg chg="mod">
          <ac:chgData name="Kumar, Vinod" userId="a0710a6e-bffc-4971-8893-1c23addeb5b0" providerId="ADAL" clId="{29C9EDDB-5878-4E39-9C7D-77FA9AFFA3E5}" dt="2023-09-14T15:36:04.611" v="4"/>
          <ac:spMkLst>
            <pc:docMk/>
            <pc:sldMk cId="1622202923" sldId="346"/>
            <ac:spMk id="24" creationId="{E3F3F016-47E8-6C3B-6621-A2F63C840670}"/>
          </ac:spMkLst>
        </pc:spChg>
        <pc:spChg chg="mod">
          <ac:chgData name="Kumar, Vinod" userId="a0710a6e-bffc-4971-8893-1c23addeb5b0" providerId="ADAL" clId="{29C9EDDB-5878-4E39-9C7D-77FA9AFFA3E5}" dt="2023-09-14T15:36:04.611" v="4"/>
          <ac:spMkLst>
            <pc:docMk/>
            <pc:sldMk cId="1622202923" sldId="346"/>
            <ac:spMk id="25" creationId="{741A86F7-1B8C-273D-6FDF-7C06C3E0AEC3}"/>
          </ac:spMkLst>
        </pc:spChg>
        <pc:spChg chg="mod">
          <ac:chgData name="Kumar, Vinod" userId="a0710a6e-bffc-4971-8893-1c23addeb5b0" providerId="ADAL" clId="{29C9EDDB-5878-4E39-9C7D-77FA9AFFA3E5}" dt="2023-09-14T15:36:04.611" v="4"/>
          <ac:spMkLst>
            <pc:docMk/>
            <pc:sldMk cId="1622202923" sldId="346"/>
            <ac:spMk id="26" creationId="{89C36D76-374D-17DF-AE85-E7DB957D05D9}"/>
          </ac:spMkLst>
        </pc:spChg>
        <pc:spChg chg="mod">
          <ac:chgData name="Kumar, Vinod" userId="a0710a6e-bffc-4971-8893-1c23addeb5b0" providerId="ADAL" clId="{29C9EDDB-5878-4E39-9C7D-77FA9AFFA3E5}" dt="2023-09-14T15:36:04.611" v="4"/>
          <ac:spMkLst>
            <pc:docMk/>
            <pc:sldMk cId="1622202923" sldId="346"/>
            <ac:spMk id="27" creationId="{FF43A4F0-3B48-E108-7176-25D5F49BADC9}"/>
          </ac:spMkLst>
        </pc:spChg>
        <pc:spChg chg="mod">
          <ac:chgData name="Kumar, Vinod" userId="a0710a6e-bffc-4971-8893-1c23addeb5b0" providerId="ADAL" clId="{29C9EDDB-5878-4E39-9C7D-77FA9AFFA3E5}" dt="2023-09-14T15:36:04.611" v="4"/>
          <ac:spMkLst>
            <pc:docMk/>
            <pc:sldMk cId="1622202923" sldId="346"/>
            <ac:spMk id="28" creationId="{55326871-80DE-0C81-57B6-5306965B809F}"/>
          </ac:spMkLst>
        </pc:spChg>
        <pc:spChg chg="mod">
          <ac:chgData name="Kumar, Vinod" userId="a0710a6e-bffc-4971-8893-1c23addeb5b0" providerId="ADAL" clId="{29C9EDDB-5878-4E39-9C7D-77FA9AFFA3E5}" dt="2023-09-14T15:36:04.611" v="4"/>
          <ac:spMkLst>
            <pc:docMk/>
            <pc:sldMk cId="1622202923" sldId="346"/>
            <ac:spMk id="29" creationId="{A9A7513B-1AAD-77D7-E832-C0DEF3A8DE1B}"/>
          </ac:spMkLst>
        </pc:spChg>
        <pc:spChg chg="mod">
          <ac:chgData name="Kumar, Vinod" userId="a0710a6e-bffc-4971-8893-1c23addeb5b0" providerId="ADAL" clId="{29C9EDDB-5878-4E39-9C7D-77FA9AFFA3E5}" dt="2023-09-14T15:36:04.611" v="4"/>
          <ac:spMkLst>
            <pc:docMk/>
            <pc:sldMk cId="1622202923" sldId="346"/>
            <ac:spMk id="30" creationId="{0EBEDA5E-8F9C-9731-ED46-A509CED4E12D}"/>
          </ac:spMkLst>
        </pc:spChg>
        <pc:spChg chg="mod">
          <ac:chgData name="Kumar, Vinod" userId="a0710a6e-bffc-4971-8893-1c23addeb5b0" providerId="ADAL" clId="{29C9EDDB-5878-4E39-9C7D-77FA9AFFA3E5}" dt="2023-09-14T15:36:04.611" v="4"/>
          <ac:spMkLst>
            <pc:docMk/>
            <pc:sldMk cId="1622202923" sldId="346"/>
            <ac:spMk id="31" creationId="{D12591B8-F797-791F-734F-22049C8B6572}"/>
          </ac:spMkLst>
        </pc:spChg>
        <pc:spChg chg="mod">
          <ac:chgData name="Kumar, Vinod" userId="a0710a6e-bffc-4971-8893-1c23addeb5b0" providerId="ADAL" clId="{29C9EDDB-5878-4E39-9C7D-77FA9AFFA3E5}" dt="2023-09-14T15:36:04.611" v="4"/>
          <ac:spMkLst>
            <pc:docMk/>
            <pc:sldMk cId="1622202923" sldId="346"/>
            <ac:spMk id="32" creationId="{C68DB2C7-C839-C495-DDF6-388A9919B1ED}"/>
          </ac:spMkLst>
        </pc:spChg>
        <pc:spChg chg="mod">
          <ac:chgData name="Kumar, Vinod" userId="a0710a6e-bffc-4971-8893-1c23addeb5b0" providerId="ADAL" clId="{29C9EDDB-5878-4E39-9C7D-77FA9AFFA3E5}" dt="2023-09-14T15:36:04.611" v="4"/>
          <ac:spMkLst>
            <pc:docMk/>
            <pc:sldMk cId="1622202923" sldId="346"/>
            <ac:spMk id="33" creationId="{8FA46FA5-4B0E-2538-F7B7-51ED504BD48C}"/>
          </ac:spMkLst>
        </pc:spChg>
        <pc:spChg chg="mod">
          <ac:chgData name="Kumar, Vinod" userId="a0710a6e-bffc-4971-8893-1c23addeb5b0" providerId="ADAL" clId="{29C9EDDB-5878-4E39-9C7D-77FA9AFFA3E5}" dt="2023-09-14T15:36:04.611" v="4"/>
          <ac:spMkLst>
            <pc:docMk/>
            <pc:sldMk cId="1622202923" sldId="346"/>
            <ac:spMk id="34" creationId="{5394A1D1-2822-537A-E3E5-3C01E3C91510}"/>
          </ac:spMkLst>
        </pc:spChg>
        <pc:spChg chg="mod">
          <ac:chgData name="Kumar, Vinod" userId="a0710a6e-bffc-4971-8893-1c23addeb5b0" providerId="ADAL" clId="{29C9EDDB-5878-4E39-9C7D-77FA9AFFA3E5}" dt="2023-09-14T15:36:04.611" v="4"/>
          <ac:spMkLst>
            <pc:docMk/>
            <pc:sldMk cId="1622202923" sldId="346"/>
            <ac:spMk id="35" creationId="{34EF6727-B143-F11C-DC7E-307DD1839628}"/>
          </ac:spMkLst>
        </pc:spChg>
        <pc:spChg chg="mod">
          <ac:chgData name="Kumar, Vinod" userId="a0710a6e-bffc-4971-8893-1c23addeb5b0" providerId="ADAL" clId="{29C9EDDB-5878-4E39-9C7D-77FA9AFFA3E5}" dt="2023-09-14T15:36:04.611" v="4"/>
          <ac:spMkLst>
            <pc:docMk/>
            <pc:sldMk cId="1622202923" sldId="346"/>
            <ac:spMk id="36" creationId="{EDEA6E5B-B276-1998-5E18-96B55456F7E1}"/>
          </ac:spMkLst>
        </pc:spChg>
        <pc:spChg chg="mod">
          <ac:chgData name="Kumar, Vinod" userId="a0710a6e-bffc-4971-8893-1c23addeb5b0" providerId="ADAL" clId="{29C9EDDB-5878-4E39-9C7D-77FA9AFFA3E5}" dt="2023-09-14T15:36:04.611" v="4"/>
          <ac:spMkLst>
            <pc:docMk/>
            <pc:sldMk cId="1622202923" sldId="346"/>
            <ac:spMk id="37" creationId="{E7402B54-7B9F-36CE-BD1E-3C990FADAA3A}"/>
          </ac:spMkLst>
        </pc:spChg>
        <pc:spChg chg="mod">
          <ac:chgData name="Kumar, Vinod" userId="a0710a6e-bffc-4971-8893-1c23addeb5b0" providerId="ADAL" clId="{29C9EDDB-5878-4E39-9C7D-77FA9AFFA3E5}" dt="2023-09-14T15:36:04.611" v="4"/>
          <ac:spMkLst>
            <pc:docMk/>
            <pc:sldMk cId="1622202923" sldId="346"/>
            <ac:spMk id="38" creationId="{F62CC860-EAAC-0102-F396-C81EAC37F45A}"/>
          </ac:spMkLst>
        </pc:spChg>
        <pc:spChg chg="mod">
          <ac:chgData name="Kumar, Vinod" userId="a0710a6e-bffc-4971-8893-1c23addeb5b0" providerId="ADAL" clId="{29C9EDDB-5878-4E39-9C7D-77FA9AFFA3E5}" dt="2023-09-14T15:36:04.611" v="4"/>
          <ac:spMkLst>
            <pc:docMk/>
            <pc:sldMk cId="1622202923" sldId="346"/>
            <ac:spMk id="39" creationId="{C1ED7CA2-A5C1-3DE0-3E4B-6F4390BF4991}"/>
          </ac:spMkLst>
        </pc:spChg>
        <pc:spChg chg="add mod">
          <ac:chgData name="Kumar, Vinod" userId="a0710a6e-bffc-4971-8893-1c23addeb5b0" providerId="ADAL" clId="{29C9EDDB-5878-4E39-9C7D-77FA9AFFA3E5}" dt="2023-09-14T15:54:00.371" v="248" actId="6549"/>
          <ac:spMkLst>
            <pc:docMk/>
            <pc:sldMk cId="1622202923" sldId="346"/>
            <ac:spMk id="40" creationId="{E6A834EB-79B1-BF03-1BE9-9D3A2EFF92F7}"/>
          </ac:spMkLst>
        </pc:spChg>
        <pc:spChg chg="add mod">
          <ac:chgData name="Kumar, Vinod" userId="a0710a6e-bffc-4971-8893-1c23addeb5b0" providerId="ADAL" clId="{29C9EDDB-5878-4E39-9C7D-77FA9AFFA3E5}" dt="2023-09-14T15:54:05.330" v="249" actId="20577"/>
          <ac:spMkLst>
            <pc:docMk/>
            <pc:sldMk cId="1622202923" sldId="346"/>
            <ac:spMk id="42" creationId="{83FD5E39-A235-0B99-3F97-D276167E50B7}"/>
          </ac:spMkLst>
        </pc:spChg>
        <pc:spChg chg="add mod">
          <ac:chgData name="Kumar, Vinod" userId="a0710a6e-bffc-4971-8893-1c23addeb5b0" providerId="ADAL" clId="{29C9EDDB-5878-4E39-9C7D-77FA9AFFA3E5}" dt="2023-09-14T15:55:23.330" v="262" actId="20577"/>
          <ac:spMkLst>
            <pc:docMk/>
            <pc:sldMk cId="1622202923" sldId="346"/>
            <ac:spMk id="44" creationId="{089DF3ED-1BFF-F7EF-1F73-ECFE209A26FE}"/>
          </ac:spMkLst>
        </pc:spChg>
        <pc:grpChg chg="add mod">
          <ac:chgData name="Kumar, Vinod" userId="a0710a6e-bffc-4971-8893-1c23addeb5b0" providerId="ADAL" clId="{29C9EDDB-5878-4E39-9C7D-77FA9AFFA3E5}" dt="2023-09-14T15:36:19.104" v="8" actId="1076"/>
          <ac:grpSpMkLst>
            <pc:docMk/>
            <pc:sldMk cId="1622202923" sldId="346"/>
            <ac:grpSpMk id="5" creationId="{1AEF7DC7-AE66-2E15-5E63-272A84738904}"/>
          </ac:grpSpMkLst>
        </pc:grpChg>
        <pc:grpChg chg="add mod">
          <ac:chgData name="Kumar, Vinod" userId="a0710a6e-bffc-4971-8893-1c23addeb5b0" providerId="ADAL" clId="{29C9EDDB-5878-4E39-9C7D-77FA9AFFA3E5}" dt="2023-09-14T15:36:26.850" v="10" actId="1076"/>
          <ac:grpSpMkLst>
            <pc:docMk/>
            <pc:sldMk cId="1622202923" sldId="346"/>
            <ac:grpSpMk id="11" creationId="{188BB348-AFE5-0964-2251-D6E1EE58EB1E}"/>
          </ac:grpSpMkLst>
        </pc:grpChg>
        <pc:picChg chg="mod">
          <ac:chgData name="Kumar, Vinod" userId="a0710a6e-bffc-4971-8893-1c23addeb5b0" providerId="ADAL" clId="{29C9EDDB-5878-4E39-9C7D-77FA9AFFA3E5}" dt="2023-09-14T15:36:19.104" v="8" actId="1076"/>
          <ac:picMkLst>
            <pc:docMk/>
            <pc:sldMk cId="1622202923" sldId="346"/>
            <ac:picMk id="6" creationId="{9867B0F2-19C2-B84B-C3E9-3ABCF545DA33}"/>
          </ac:picMkLst>
        </pc:picChg>
        <pc:picChg chg="mod">
          <ac:chgData name="Kumar, Vinod" userId="a0710a6e-bffc-4971-8893-1c23addeb5b0" providerId="ADAL" clId="{29C9EDDB-5878-4E39-9C7D-77FA9AFFA3E5}" dt="2023-09-14T15:36:04.611" v="4"/>
          <ac:picMkLst>
            <pc:docMk/>
            <pc:sldMk cId="1622202923" sldId="346"/>
            <ac:picMk id="12" creationId="{7415CC10-4185-3B28-3CBD-B2A8C723DE3C}"/>
          </ac:picMkLst>
        </pc:picChg>
        <pc:picChg chg="mod">
          <ac:chgData name="Kumar, Vinod" userId="a0710a6e-bffc-4971-8893-1c23addeb5b0" providerId="ADAL" clId="{29C9EDDB-5878-4E39-9C7D-77FA9AFFA3E5}" dt="2023-09-14T15:36:04.611" v="4"/>
          <ac:picMkLst>
            <pc:docMk/>
            <pc:sldMk cId="1622202923" sldId="346"/>
            <ac:picMk id="13" creationId="{4012748C-C7C0-518E-1F92-6B24240DB94F}"/>
          </ac:picMkLst>
        </pc:picChg>
        <pc:picChg chg="mod">
          <ac:chgData name="Kumar, Vinod" userId="a0710a6e-bffc-4971-8893-1c23addeb5b0" providerId="ADAL" clId="{29C9EDDB-5878-4E39-9C7D-77FA9AFFA3E5}" dt="2023-09-14T15:36:04.611" v="4"/>
          <ac:picMkLst>
            <pc:docMk/>
            <pc:sldMk cId="1622202923" sldId="346"/>
            <ac:picMk id="14" creationId="{B7EC3118-3429-B21C-1C17-CAA44BBFEF42}"/>
          </ac:picMkLst>
        </pc:picChg>
      </pc:sldChg>
      <pc:sldChg chg="addSp delSp modSp new mod ord">
        <pc:chgData name="Kumar, Vinod" userId="a0710a6e-bffc-4971-8893-1c23addeb5b0" providerId="ADAL" clId="{29C9EDDB-5878-4E39-9C7D-77FA9AFFA3E5}" dt="2023-09-26T19:48:35.562" v="300" actId="164"/>
        <pc:sldMkLst>
          <pc:docMk/>
          <pc:sldMk cId="897604948" sldId="347"/>
        </pc:sldMkLst>
        <pc:spChg chg="del">
          <ac:chgData name="Kumar, Vinod" userId="a0710a6e-bffc-4971-8893-1c23addeb5b0" providerId="ADAL" clId="{29C9EDDB-5878-4E39-9C7D-77FA9AFFA3E5}" dt="2023-09-14T15:38:45.001" v="12" actId="478"/>
          <ac:spMkLst>
            <pc:docMk/>
            <pc:sldMk cId="897604948" sldId="347"/>
            <ac:spMk id="2" creationId="{55721D9B-1B5F-AF70-B05A-249BCCF440CF}"/>
          </ac:spMkLst>
        </pc:spChg>
        <pc:spChg chg="add mod">
          <ac:chgData name="Kumar, Vinod" userId="a0710a6e-bffc-4971-8893-1c23addeb5b0" providerId="ADAL" clId="{29C9EDDB-5878-4E39-9C7D-77FA9AFFA3E5}" dt="2023-09-26T19:48:35.562" v="300" actId="164"/>
          <ac:spMkLst>
            <pc:docMk/>
            <pc:sldMk cId="897604948" sldId="347"/>
            <ac:spMk id="2" creationId="{D8A1365D-EB1F-DF53-6F48-7E1338E79985}"/>
          </ac:spMkLst>
        </pc:spChg>
        <pc:spChg chg="del">
          <ac:chgData name="Kumar, Vinod" userId="a0710a6e-bffc-4971-8893-1c23addeb5b0" providerId="ADAL" clId="{29C9EDDB-5878-4E39-9C7D-77FA9AFFA3E5}" dt="2023-09-14T15:38:46.138" v="13" actId="478"/>
          <ac:spMkLst>
            <pc:docMk/>
            <pc:sldMk cId="897604948" sldId="347"/>
            <ac:spMk id="3" creationId="{742923CA-43E1-B7AD-5D58-7DFA93D4EE63}"/>
          </ac:spMkLst>
        </pc:spChg>
        <pc:spChg chg="add mod topLvl">
          <ac:chgData name="Kumar, Vinod" userId="a0710a6e-bffc-4971-8893-1c23addeb5b0" providerId="ADAL" clId="{29C9EDDB-5878-4E39-9C7D-77FA9AFFA3E5}" dt="2023-09-14T15:49:14.424" v="220" actId="164"/>
          <ac:spMkLst>
            <pc:docMk/>
            <pc:sldMk cId="897604948" sldId="347"/>
            <ac:spMk id="8" creationId="{BC052E28-6B9E-E87F-67FD-07BBD6334DB8}"/>
          </ac:spMkLst>
        </pc:spChg>
        <pc:spChg chg="add mod topLvl">
          <ac:chgData name="Kumar, Vinod" userId="a0710a6e-bffc-4971-8893-1c23addeb5b0" providerId="ADAL" clId="{29C9EDDB-5878-4E39-9C7D-77FA9AFFA3E5}" dt="2023-09-14T15:48:55.351" v="216" actId="164"/>
          <ac:spMkLst>
            <pc:docMk/>
            <pc:sldMk cId="897604948" sldId="347"/>
            <ac:spMk id="11" creationId="{8C888856-DFA8-ABBF-9309-94E478328078}"/>
          </ac:spMkLst>
        </pc:spChg>
        <pc:spChg chg="add mod topLvl">
          <ac:chgData name="Kumar, Vinod" userId="a0710a6e-bffc-4971-8893-1c23addeb5b0" providerId="ADAL" clId="{29C9EDDB-5878-4E39-9C7D-77FA9AFFA3E5}" dt="2023-09-14T15:49:14.424" v="220" actId="164"/>
          <ac:spMkLst>
            <pc:docMk/>
            <pc:sldMk cId="897604948" sldId="347"/>
            <ac:spMk id="12" creationId="{AD6452E2-C69E-4878-DE4D-05AC90B7AEB5}"/>
          </ac:spMkLst>
        </pc:spChg>
        <pc:spChg chg="add mod topLvl">
          <ac:chgData name="Kumar, Vinod" userId="a0710a6e-bffc-4971-8893-1c23addeb5b0" providerId="ADAL" clId="{29C9EDDB-5878-4E39-9C7D-77FA9AFFA3E5}" dt="2023-09-14T15:49:05.446" v="219" actId="164"/>
          <ac:spMkLst>
            <pc:docMk/>
            <pc:sldMk cId="897604948" sldId="347"/>
            <ac:spMk id="13" creationId="{FC92F670-9080-0DBC-D7F1-CC6140B2C6FE}"/>
          </ac:spMkLst>
        </pc:spChg>
        <pc:spChg chg="add mod topLvl">
          <ac:chgData name="Kumar, Vinod" userId="a0710a6e-bffc-4971-8893-1c23addeb5b0" providerId="ADAL" clId="{29C9EDDB-5878-4E39-9C7D-77FA9AFFA3E5}" dt="2023-09-14T15:48:55.351" v="216" actId="164"/>
          <ac:spMkLst>
            <pc:docMk/>
            <pc:sldMk cId="897604948" sldId="347"/>
            <ac:spMk id="14" creationId="{FA593DFC-9765-4005-FCDB-94EB93AAC9FE}"/>
          </ac:spMkLst>
        </pc:spChg>
        <pc:spChg chg="add del mod">
          <ac:chgData name="Kumar, Vinod" userId="a0710a6e-bffc-4971-8893-1c23addeb5b0" providerId="ADAL" clId="{29C9EDDB-5878-4E39-9C7D-77FA9AFFA3E5}" dt="2023-09-14T15:46:50.645" v="164" actId="478"/>
          <ac:spMkLst>
            <pc:docMk/>
            <pc:sldMk cId="897604948" sldId="347"/>
            <ac:spMk id="16" creationId="{57745420-B10E-4C5E-3B91-A81BD77BA792}"/>
          </ac:spMkLst>
        </pc:spChg>
        <pc:spChg chg="add mod">
          <ac:chgData name="Kumar, Vinod" userId="a0710a6e-bffc-4971-8893-1c23addeb5b0" providerId="ADAL" clId="{29C9EDDB-5878-4E39-9C7D-77FA9AFFA3E5}" dt="2023-09-14T15:48:11.011" v="214" actId="1076"/>
          <ac:spMkLst>
            <pc:docMk/>
            <pc:sldMk cId="897604948" sldId="347"/>
            <ac:spMk id="22" creationId="{DA274BA8-7926-0521-D37D-51FB0B7E1C26}"/>
          </ac:spMkLst>
        </pc:spChg>
        <pc:spChg chg="add mod">
          <ac:chgData name="Kumar, Vinod" userId="a0710a6e-bffc-4971-8893-1c23addeb5b0" providerId="ADAL" clId="{29C9EDDB-5878-4E39-9C7D-77FA9AFFA3E5}" dt="2023-09-14T15:47:58.405" v="206" actId="20577"/>
          <ac:spMkLst>
            <pc:docMk/>
            <pc:sldMk cId="897604948" sldId="347"/>
            <ac:spMk id="24" creationId="{9AEC2FDD-4234-F2A9-1117-A160B1A1930B}"/>
          </ac:spMkLst>
        </pc:spChg>
        <pc:spChg chg="add mod">
          <ac:chgData name="Kumar, Vinod" userId="a0710a6e-bffc-4971-8893-1c23addeb5b0" providerId="ADAL" clId="{29C9EDDB-5878-4E39-9C7D-77FA9AFFA3E5}" dt="2023-09-14T15:54:37.107" v="253" actId="20577"/>
          <ac:spMkLst>
            <pc:docMk/>
            <pc:sldMk cId="897604948" sldId="347"/>
            <ac:spMk id="28" creationId="{3D539217-E0AF-0E01-B4E6-16F5B57BEA3E}"/>
          </ac:spMkLst>
        </pc:spChg>
        <pc:spChg chg="add del mod">
          <ac:chgData name="Kumar, Vinod" userId="a0710a6e-bffc-4971-8893-1c23addeb5b0" providerId="ADAL" clId="{29C9EDDB-5878-4E39-9C7D-77FA9AFFA3E5}" dt="2023-09-14T15:51:14.995" v="227" actId="478"/>
          <ac:spMkLst>
            <pc:docMk/>
            <pc:sldMk cId="897604948" sldId="347"/>
            <ac:spMk id="29" creationId="{8DD5AD98-69A9-2A1D-7AED-6FE72560DC5D}"/>
          </ac:spMkLst>
        </pc:spChg>
        <pc:spChg chg="add mod">
          <ac:chgData name="Kumar, Vinod" userId="a0710a6e-bffc-4971-8893-1c23addeb5b0" providerId="ADAL" clId="{29C9EDDB-5878-4E39-9C7D-77FA9AFFA3E5}" dt="2023-09-14T15:54:11.234" v="250" actId="20577"/>
          <ac:spMkLst>
            <pc:docMk/>
            <pc:sldMk cId="897604948" sldId="347"/>
            <ac:spMk id="30" creationId="{FA68FC39-C4BF-2233-CB39-2F8C77358467}"/>
          </ac:spMkLst>
        </pc:spChg>
        <pc:grpChg chg="add mod">
          <ac:chgData name="Kumar, Vinod" userId="a0710a6e-bffc-4971-8893-1c23addeb5b0" providerId="ADAL" clId="{29C9EDDB-5878-4E39-9C7D-77FA9AFFA3E5}" dt="2023-09-26T19:48:35.562" v="300" actId="164"/>
          <ac:grpSpMkLst>
            <pc:docMk/>
            <pc:sldMk cId="897604948" sldId="347"/>
            <ac:grpSpMk id="3" creationId="{A5610D19-030B-CDB5-FAFD-93E4D14F0989}"/>
          </ac:grpSpMkLst>
        </pc:grpChg>
        <pc:grpChg chg="add del mod">
          <ac:chgData name="Kumar, Vinod" userId="a0710a6e-bffc-4971-8893-1c23addeb5b0" providerId="ADAL" clId="{29C9EDDB-5878-4E39-9C7D-77FA9AFFA3E5}" dt="2023-09-14T15:48:41.720" v="215" actId="165"/>
          <ac:grpSpMkLst>
            <pc:docMk/>
            <pc:sldMk cId="897604948" sldId="347"/>
            <ac:grpSpMk id="15" creationId="{FC80EE2F-F13E-4556-50F6-82A4822C28AE}"/>
          </ac:grpSpMkLst>
        </pc:grpChg>
        <pc:grpChg chg="add mod">
          <ac:chgData name="Kumar, Vinod" userId="a0710a6e-bffc-4971-8893-1c23addeb5b0" providerId="ADAL" clId="{29C9EDDB-5878-4E39-9C7D-77FA9AFFA3E5}" dt="2023-09-26T19:47:56.612" v="288" actId="1037"/>
          <ac:grpSpMkLst>
            <pc:docMk/>
            <pc:sldMk cId="897604948" sldId="347"/>
            <ac:grpSpMk id="25" creationId="{9E086076-D92B-91DC-B8E1-969BCC67124B}"/>
          </ac:grpSpMkLst>
        </pc:grpChg>
        <pc:grpChg chg="add mod">
          <ac:chgData name="Kumar, Vinod" userId="a0710a6e-bffc-4971-8893-1c23addeb5b0" providerId="ADAL" clId="{29C9EDDB-5878-4E39-9C7D-77FA9AFFA3E5}" dt="2023-09-26T19:48:35.562" v="300" actId="164"/>
          <ac:grpSpMkLst>
            <pc:docMk/>
            <pc:sldMk cId="897604948" sldId="347"/>
            <ac:grpSpMk id="26" creationId="{C3EAA5B2-10B8-8188-5841-632239315057}"/>
          </ac:grpSpMkLst>
        </pc:grpChg>
        <pc:grpChg chg="add mod">
          <ac:chgData name="Kumar, Vinod" userId="a0710a6e-bffc-4971-8893-1c23addeb5b0" providerId="ADAL" clId="{29C9EDDB-5878-4E39-9C7D-77FA9AFFA3E5}" dt="2023-09-14T15:49:14.424" v="220" actId="164"/>
          <ac:grpSpMkLst>
            <pc:docMk/>
            <pc:sldMk cId="897604948" sldId="347"/>
            <ac:grpSpMk id="27" creationId="{1176891C-508E-7132-3B49-9FF70EF97643}"/>
          </ac:grpSpMkLst>
        </pc:grpChg>
        <pc:picChg chg="add mod topLvl modCrop">
          <ac:chgData name="Kumar, Vinod" userId="a0710a6e-bffc-4971-8893-1c23addeb5b0" providerId="ADAL" clId="{29C9EDDB-5878-4E39-9C7D-77FA9AFFA3E5}" dt="2023-09-26T19:47:50.084" v="286" actId="732"/>
          <ac:picMkLst>
            <pc:docMk/>
            <pc:sldMk cId="897604948" sldId="347"/>
            <ac:picMk id="5" creationId="{3D84F7C0-1DA9-029D-F4D8-18F02B970851}"/>
          </ac:picMkLst>
        </pc:picChg>
        <pc:picChg chg="add mod topLvl modCrop">
          <ac:chgData name="Kumar, Vinod" userId="a0710a6e-bffc-4971-8893-1c23addeb5b0" providerId="ADAL" clId="{29C9EDDB-5878-4E39-9C7D-77FA9AFFA3E5}" dt="2023-09-26T19:47:35.332" v="284" actId="732"/>
          <ac:picMkLst>
            <pc:docMk/>
            <pc:sldMk cId="897604948" sldId="347"/>
            <ac:picMk id="7" creationId="{4EFD7E8C-B430-93B4-F523-4BF5B14F2A80}"/>
          </ac:picMkLst>
        </pc:picChg>
        <pc:picChg chg="add mod topLvl modCrop">
          <ac:chgData name="Kumar, Vinod" userId="a0710a6e-bffc-4971-8893-1c23addeb5b0" providerId="ADAL" clId="{29C9EDDB-5878-4E39-9C7D-77FA9AFFA3E5}" dt="2023-09-26T19:48:05.203" v="289" actId="732"/>
          <ac:picMkLst>
            <pc:docMk/>
            <pc:sldMk cId="897604948" sldId="347"/>
            <ac:picMk id="10" creationId="{B254126A-2C2C-6F57-474A-A182487FCB48}"/>
          </ac:picMkLst>
        </pc:picChg>
        <pc:cxnChg chg="add del mod">
          <ac:chgData name="Kumar, Vinod" userId="a0710a6e-bffc-4971-8893-1c23addeb5b0" providerId="ADAL" clId="{29C9EDDB-5878-4E39-9C7D-77FA9AFFA3E5}" dt="2023-09-14T15:46:45.189" v="161" actId="478"/>
          <ac:cxnSpMkLst>
            <pc:docMk/>
            <pc:sldMk cId="897604948" sldId="347"/>
            <ac:cxnSpMk id="17" creationId="{347F9B5A-8EA6-7B4E-CE05-C4068D4CF5DC}"/>
          </ac:cxnSpMkLst>
        </pc:cxnChg>
        <pc:cxnChg chg="add del mod">
          <ac:chgData name="Kumar, Vinod" userId="a0710a6e-bffc-4971-8893-1c23addeb5b0" providerId="ADAL" clId="{29C9EDDB-5878-4E39-9C7D-77FA9AFFA3E5}" dt="2023-09-14T15:46:47.285" v="162" actId="478"/>
          <ac:cxnSpMkLst>
            <pc:docMk/>
            <pc:sldMk cId="897604948" sldId="347"/>
            <ac:cxnSpMk id="18" creationId="{54FD8330-8837-E5D7-E1FA-33DBC5B9AA7E}"/>
          </ac:cxnSpMkLst>
        </pc:cxnChg>
        <pc:cxnChg chg="add del mod">
          <ac:chgData name="Kumar, Vinod" userId="a0710a6e-bffc-4971-8893-1c23addeb5b0" providerId="ADAL" clId="{29C9EDDB-5878-4E39-9C7D-77FA9AFFA3E5}" dt="2023-09-14T15:46:48.324" v="163" actId="478"/>
          <ac:cxnSpMkLst>
            <pc:docMk/>
            <pc:sldMk cId="897604948" sldId="347"/>
            <ac:cxnSpMk id="19" creationId="{0F8ED485-EEE6-8E37-F070-C6F36734125E}"/>
          </ac:cxnSpMkLst>
        </pc:cxnChg>
        <pc:cxnChg chg="add mod">
          <ac:chgData name="Kumar, Vinod" userId="a0710a6e-bffc-4971-8893-1c23addeb5b0" providerId="ADAL" clId="{29C9EDDB-5878-4E39-9C7D-77FA9AFFA3E5}" dt="2023-09-14T15:47:50.916" v="201" actId="1037"/>
          <ac:cxnSpMkLst>
            <pc:docMk/>
            <pc:sldMk cId="897604948" sldId="347"/>
            <ac:cxnSpMk id="20" creationId="{683C4018-BBDF-98CB-CEF1-92766218350E}"/>
          </ac:cxnSpMkLst>
        </pc:cxnChg>
        <pc:cxnChg chg="add mod">
          <ac:chgData name="Kumar, Vinod" userId="a0710a6e-bffc-4971-8893-1c23addeb5b0" providerId="ADAL" clId="{29C9EDDB-5878-4E39-9C7D-77FA9AFFA3E5}" dt="2023-09-14T15:47:43.171" v="196" actId="1037"/>
          <ac:cxnSpMkLst>
            <pc:docMk/>
            <pc:sldMk cId="897604948" sldId="347"/>
            <ac:cxnSpMk id="21" creationId="{698A0A2A-5320-1D7A-3648-1FEA491A014E}"/>
          </ac:cxnSpMkLst>
        </pc:cxnChg>
        <pc:cxnChg chg="add mod">
          <ac:chgData name="Kumar, Vinod" userId="a0710a6e-bffc-4971-8893-1c23addeb5b0" providerId="ADAL" clId="{29C9EDDB-5878-4E39-9C7D-77FA9AFFA3E5}" dt="2023-09-14T15:48:05.715" v="213" actId="1037"/>
          <ac:cxnSpMkLst>
            <pc:docMk/>
            <pc:sldMk cId="897604948" sldId="347"/>
            <ac:cxnSpMk id="23" creationId="{FE554BFE-91AF-6234-0C29-18C4CF9D8124}"/>
          </ac:cxnSpMkLst>
        </pc:cxnChg>
      </pc:sldChg>
      <pc:sldChg chg="addSp delSp modSp new del mod">
        <pc:chgData name="Kumar, Vinod" userId="a0710a6e-bffc-4971-8893-1c23addeb5b0" providerId="ADAL" clId="{29C9EDDB-5878-4E39-9C7D-77FA9AFFA3E5}" dt="2023-09-14T16:01:45.038" v="275" actId="47"/>
        <pc:sldMkLst>
          <pc:docMk/>
          <pc:sldMk cId="2103214057" sldId="348"/>
        </pc:sldMkLst>
        <pc:spChg chg="del">
          <ac:chgData name="Kumar, Vinod" userId="a0710a6e-bffc-4971-8893-1c23addeb5b0" providerId="ADAL" clId="{29C9EDDB-5878-4E39-9C7D-77FA9AFFA3E5}" dt="2023-09-14T15:57:01.840" v="264" actId="478"/>
          <ac:spMkLst>
            <pc:docMk/>
            <pc:sldMk cId="2103214057" sldId="348"/>
            <ac:spMk id="2" creationId="{BCF94236-C3A1-06D6-B6EB-8FD90964A38C}"/>
          </ac:spMkLst>
        </pc:spChg>
        <pc:spChg chg="del">
          <ac:chgData name="Kumar, Vinod" userId="a0710a6e-bffc-4971-8893-1c23addeb5b0" providerId="ADAL" clId="{29C9EDDB-5878-4E39-9C7D-77FA9AFFA3E5}" dt="2023-09-14T15:57:01.840" v="264" actId="478"/>
          <ac:spMkLst>
            <pc:docMk/>
            <pc:sldMk cId="2103214057" sldId="348"/>
            <ac:spMk id="3" creationId="{C17D489C-7D1A-E98F-37D9-EADC49E9E772}"/>
          </ac:spMkLst>
        </pc:spChg>
        <pc:spChg chg="add mod">
          <ac:chgData name="Kumar, Vinod" userId="a0710a6e-bffc-4971-8893-1c23addeb5b0" providerId="ADAL" clId="{29C9EDDB-5878-4E39-9C7D-77FA9AFFA3E5}" dt="2023-09-14T15:57:12.594" v="267" actId="20577"/>
          <ac:spMkLst>
            <pc:docMk/>
            <pc:sldMk cId="2103214057" sldId="348"/>
            <ac:spMk id="4" creationId="{57D9BA1B-5819-55D4-B429-A1DE60CBB3F1}"/>
          </ac:spMkLst>
        </pc:spChg>
        <pc:spChg chg="mod">
          <ac:chgData name="Kumar, Vinod" userId="a0710a6e-bffc-4971-8893-1c23addeb5b0" providerId="ADAL" clId="{29C9EDDB-5878-4E39-9C7D-77FA9AFFA3E5}" dt="2023-09-14T15:57:07.184" v="266" actId="1076"/>
          <ac:spMkLst>
            <pc:docMk/>
            <pc:sldMk cId="2103214057" sldId="348"/>
            <ac:spMk id="7" creationId="{41E461A8-EF6F-79F4-8F48-6E3FAD81B9F8}"/>
          </ac:spMkLst>
        </pc:spChg>
        <pc:spChg chg="mod">
          <ac:chgData name="Kumar, Vinod" userId="a0710a6e-bffc-4971-8893-1c23addeb5b0" providerId="ADAL" clId="{29C9EDDB-5878-4E39-9C7D-77FA9AFFA3E5}" dt="2023-09-14T15:57:07.184" v="266" actId="1076"/>
          <ac:spMkLst>
            <pc:docMk/>
            <pc:sldMk cId="2103214057" sldId="348"/>
            <ac:spMk id="8" creationId="{AA0C4103-ACBA-21EE-7055-4C6F062B730B}"/>
          </ac:spMkLst>
        </pc:spChg>
        <pc:spChg chg="mod">
          <ac:chgData name="Kumar, Vinod" userId="a0710a6e-bffc-4971-8893-1c23addeb5b0" providerId="ADAL" clId="{29C9EDDB-5878-4E39-9C7D-77FA9AFFA3E5}" dt="2023-09-14T15:57:07.184" v="266" actId="1076"/>
          <ac:spMkLst>
            <pc:docMk/>
            <pc:sldMk cId="2103214057" sldId="348"/>
            <ac:spMk id="9" creationId="{E4B376E7-3773-197B-6E46-9FB09C55FDD0}"/>
          </ac:spMkLst>
        </pc:spChg>
        <pc:spChg chg="add mod">
          <ac:chgData name="Kumar, Vinod" userId="a0710a6e-bffc-4971-8893-1c23addeb5b0" providerId="ADAL" clId="{29C9EDDB-5878-4E39-9C7D-77FA9AFFA3E5}" dt="2023-09-14T15:57:17.857" v="268" actId="20577"/>
          <ac:spMkLst>
            <pc:docMk/>
            <pc:sldMk cId="2103214057" sldId="348"/>
            <ac:spMk id="10" creationId="{61A9F3C2-AC2F-8E9A-402F-49AE2BF7FC42}"/>
          </ac:spMkLst>
        </pc:spChg>
        <pc:grpChg chg="add mod">
          <ac:chgData name="Kumar, Vinod" userId="a0710a6e-bffc-4971-8893-1c23addeb5b0" providerId="ADAL" clId="{29C9EDDB-5878-4E39-9C7D-77FA9AFFA3E5}" dt="2023-09-14T15:57:07.184" v="266" actId="1076"/>
          <ac:grpSpMkLst>
            <pc:docMk/>
            <pc:sldMk cId="2103214057" sldId="348"/>
            <ac:grpSpMk id="5" creationId="{C2A355D4-8B34-4664-37A8-AA542F9CA19A}"/>
          </ac:grpSpMkLst>
        </pc:grpChg>
        <pc:picChg chg="mod">
          <ac:chgData name="Kumar, Vinod" userId="a0710a6e-bffc-4971-8893-1c23addeb5b0" providerId="ADAL" clId="{29C9EDDB-5878-4E39-9C7D-77FA9AFFA3E5}" dt="2023-09-14T15:57:07.184" v="266" actId="1076"/>
          <ac:picMkLst>
            <pc:docMk/>
            <pc:sldMk cId="2103214057" sldId="348"/>
            <ac:picMk id="6" creationId="{79B11E0C-949D-D0DA-3237-743FA4179FDC}"/>
          </ac:picMkLst>
        </pc:picChg>
      </pc:sldChg>
      <pc:sldChg chg="addSp modSp new del mod">
        <pc:chgData name="Kumar, Vinod" userId="a0710a6e-bffc-4971-8893-1c23addeb5b0" providerId="ADAL" clId="{29C9EDDB-5878-4E39-9C7D-77FA9AFFA3E5}" dt="2023-09-27T14:49:44.708" v="791" actId="47"/>
        <pc:sldMkLst>
          <pc:docMk/>
          <pc:sldMk cId="3444559034" sldId="348"/>
        </pc:sldMkLst>
        <pc:picChg chg="add mod">
          <ac:chgData name="Kumar, Vinod" userId="a0710a6e-bffc-4971-8893-1c23addeb5b0" providerId="ADAL" clId="{29C9EDDB-5878-4E39-9C7D-77FA9AFFA3E5}" dt="2023-09-27T14:23:41.077" v="307" actId="1076"/>
          <ac:picMkLst>
            <pc:docMk/>
            <pc:sldMk cId="3444559034" sldId="348"/>
            <ac:picMk id="3" creationId="{417EB709-0828-8999-FCB7-3E440AB408CB}"/>
          </ac:picMkLst>
        </pc:picChg>
        <pc:picChg chg="add mod">
          <ac:chgData name="Kumar, Vinod" userId="a0710a6e-bffc-4971-8893-1c23addeb5b0" providerId="ADAL" clId="{29C9EDDB-5878-4E39-9C7D-77FA9AFFA3E5}" dt="2023-09-27T14:25:38.672" v="309" actId="1076"/>
          <ac:picMkLst>
            <pc:docMk/>
            <pc:sldMk cId="3444559034" sldId="348"/>
            <ac:picMk id="5" creationId="{7077F9AA-2D42-E213-4A5D-E3E9D6976D95}"/>
          </ac:picMkLst>
        </pc:picChg>
        <pc:picChg chg="add mod">
          <ac:chgData name="Kumar, Vinod" userId="a0710a6e-bffc-4971-8893-1c23addeb5b0" providerId="ADAL" clId="{29C9EDDB-5878-4E39-9C7D-77FA9AFFA3E5}" dt="2023-09-27T14:27:28.511" v="311" actId="1076"/>
          <ac:picMkLst>
            <pc:docMk/>
            <pc:sldMk cId="3444559034" sldId="348"/>
            <ac:picMk id="7" creationId="{258B83FE-3982-4220-0126-16CED7781B67}"/>
          </ac:picMkLst>
        </pc:picChg>
        <pc:picChg chg="add mod">
          <ac:chgData name="Kumar, Vinod" userId="a0710a6e-bffc-4971-8893-1c23addeb5b0" providerId="ADAL" clId="{29C9EDDB-5878-4E39-9C7D-77FA9AFFA3E5}" dt="2023-09-27T14:28:07.911" v="313" actId="1076"/>
          <ac:picMkLst>
            <pc:docMk/>
            <pc:sldMk cId="3444559034" sldId="348"/>
            <ac:picMk id="9" creationId="{36B69537-77CA-C72B-F3A3-B150186640EC}"/>
          </ac:picMkLst>
        </pc:picChg>
      </pc:sldChg>
      <pc:sldChg chg="addSp delSp modSp add mod">
        <pc:chgData name="Kumar, Vinod" userId="a0710a6e-bffc-4971-8893-1c23addeb5b0" providerId="ADAL" clId="{29C9EDDB-5878-4E39-9C7D-77FA9AFFA3E5}" dt="2023-09-27T14:50:39.510" v="858" actId="20577"/>
        <pc:sldMkLst>
          <pc:docMk/>
          <pc:sldMk cId="862395594" sldId="349"/>
        </pc:sldMkLst>
        <pc:spChg chg="del mod topLvl">
          <ac:chgData name="Kumar, Vinod" userId="a0710a6e-bffc-4971-8893-1c23addeb5b0" providerId="ADAL" clId="{29C9EDDB-5878-4E39-9C7D-77FA9AFFA3E5}" dt="2023-09-27T14:46:53.303" v="606" actId="478"/>
          <ac:spMkLst>
            <pc:docMk/>
            <pc:sldMk cId="862395594" sldId="349"/>
            <ac:spMk id="13" creationId="{6AF0443B-B0AA-3D29-F161-F7A34D1AA1F5}"/>
          </ac:spMkLst>
        </pc:spChg>
        <pc:spChg chg="mod topLvl">
          <ac:chgData name="Kumar, Vinod" userId="a0710a6e-bffc-4971-8893-1c23addeb5b0" providerId="ADAL" clId="{29C9EDDB-5878-4E39-9C7D-77FA9AFFA3E5}" dt="2023-09-27T14:49:53.337" v="796" actId="1036"/>
          <ac:spMkLst>
            <pc:docMk/>
            <pc:sldMk cId="862395594" sldId="349"/>
            <ac:spMk id="14" creationId="{B43B78FE-0F07-2D9A-E9E1-74818BDF4A17}"/>
          </ac:spMkLst>
        </pc:spChg>
        <pc:spChg chg="mod topLvl">
          <ac:chgData name="Kumar, Vinod" userId="a0710a6e-bffc-4971-8893-1c23addeb5b0" providerId="ADAL" clId="{29C9EDDB-5878-4E39-9C7D-77FA9AFFA3E5}" dt="2023-09-27T14:49:53.337" v="796" actId="1036"/>
          <ac:spMkLst>
            <pc:docMk/>
            <pc:sldMk cId="862395594" sldId="349"/>
            <ac:spMk id="15" creationId="{11188C26-25E8-F104-CC4A-310D3B13FDB6}"/>
          </ac:spMkLst>
        </pc:spChg>
        <pc:spChg chg="mod topLvl">
          <ac:chgData name="Kumar, Vinod" userId="a0710a6e-bffc-4971-8893-1c23addeb5b0" providerId="ADAL" clId="{29C9EDDB-5878-4E39-9C7D-77FA9AFFA3E5}" dt="2023-09-27T14:49:53.337" v="796" actId="1036"/>
          <ac:spMkLst>
            <pc:docMk/>
            <pc:sldMk cId="862395594" sldId="349"/>
            <ac:spMk id="19" creationId="{1B8446E1-2CE9-D057-3477-0CCEA8352363}"/>
          </ac:spMkLst>
        </pc:spChg>
        <pc:spChg chg="del mod topLvl">
          <ac:chgData name="Kumar, Vinod" userId="a0710a6e-bffc-4971-8893-1c23addeb5b0" providerId="ADAL" clId="{29C9EDDB-5878-4E39-9C7D-77FA9AFFA3E5}" dt="2023-09-27T14:43:46.232" v="539" actId="478"/>
          <ac:spMkLst>
            <pc:docMk/>
            <pc:sldMk cId="862395594" sldId="349"/>
            <ac:spMk id="20" creationId="{D58337B8-F31D-AF9A-ECF9-66BAF09BD6CB}"/>
          </ac:spMkLst>
        </pc:spChg>
        <pc:spChg chg="mod topLvl">
          <ac:chgData name="Kumar, Vinod" userId="a0710a6e-bffc-4971-8893-1c23addeb5b0" providerId="ADAL" clId="{29C9EDDB-5878-4E39-9C7D-77FA9AFFA3E5}" dt="2023-09-27T14:49:53.337" v="796" actId="1036"/>
          <ac:spMkLst>
            <pc:docMk/>
            <pc:sldMk cId="862395594" sldId="349"/>
            <ac:spMk id="21" creationId="{FA8AE191-F125-F6C1-A55B-2789C615E959}"/>
          </ac:spMkLst>
        </pc:spChg>
        <pc:spChg chg="del mod topLvl">
          <ac:chgData name="Kumar, Vinod" userId="a0710a6e-bffc-4971-8893-1c23addeb5b0" providerId="ADAL" clId="{29C9EDDB-5878-4E39-9C7D-77FA9AFFA3E5}" dt="2023-09-27T14:46:53.303" v="606" actId="478"/>
          <ac:spMkLst>
            <pc:docMk/>
            <pc:sldMk cId="862395594" sldId="349"/>
            <ac:spMk id="22" creationId="{4F831D07-E25F-DF86-96E7-420DA336FB25}"/>
          </ac:spMkLst>
        </pc:spChg>
        <pc:spChg chg="del mod topLvl">
          <ac:chgData name="Kumar, Vinod" userId="a0710a6e-bffc-4971-8893-1c23addeb5b0" providerId="ADAL" clId="{29C9EDDB-5878-4E39-9C7D-77FA9AFFA3E5}" dt="2023-09-27T14:46:53.303" v="606" actId="478"/>
          <ac:spMkLst>
            <pc:docMk/>
            <pc:sldMk cId="862395594" sldId="349"/>
            <ac:spMk id="23" creationId="{16F879D7-06AA-DB78-6C60-576FA73C6871}"/>
          </ac:spMkLst>
        </pc:spChg>
        <pc:spChg chg="del mod topLvl">
          <ac:chgData name="Kumar, Vinod" userId="a0710a6e-bffc-4971-8893-1c23addeb5b0" providerId="ADAL" clId="{29C9EDDB-5878-4E39-9C7D-77FA9AFFA3E5}" dt="2023-09-27T14:46:53.303" v="606" actId="478"/>
          <ac:spMkLst>
            <pc:docMk/>
            <pc:sldMk cId="862395594" sldId="349"/>
            <ac:spMk id="24" creationId="{014FE0D7-7763-5D44-0453-B5F549201C60}"/>
          </ac:spMkLst>
        </pc:spChg>
        <pc:spChg chg="mod topLvl">
          <ac:chgData name="Kumar, Vinod" userId="a0710a6e-bffc-4971-8893-1c23addeb5b0" providerId="ADAL" clId="{29C9EDDB-5878-4E39-9C7D-77FA9AFFA3E5}" dt="2023-09-27T14:49:53.337" v="796" actId="1036"/>
          <ac:spMkLst>
            <pc:docMk/>
            <pc:sldMk cId="862395594" sldId="349"/>
            <ac:spMk id="25" creationId="{1D17C279-0C83-19C9-A049-E939810CD48D}"/>
          </ac:spMkLst>
        </pc:spChg>
        <pc:spChg chg="mod topLvl">
          <ac:chgData name="Kumar, Vinod" userId="a0710a6e-bffc-4971-8893-1c23addeb5b0" providerId="ADAL" clId="{29C9EDDB-5878-4E39-9C7D-77FA9AFFA3E5}" dt="2023-09-27T14:49:53.337" v="796" actId="1036"/>
          <ac:spMkLst>
            <pc:docMk/>
            <pc:sldMk cId="862395594" sldId="349"/>
            <ac:spMk id="26" creationId="{42CDCFE3-6081-1557-56E5-306DA8E30EDA}"/>
          </ac:spMkLst>
        </pc:spChg>
        <pc:spChg chg="add del mod">
          <ac:chgData name="Kumar, Vinod" userId="a0710a6e-bffc-4971-8893-1c23addeb5b0" providerId="ADAL" clId="{29C9EDDB-5878-4E39-9C7D-77FA9AFFA3E5}" dt="2023-09-27T14:39:29.306" v="429" actId="478"/>
          <ac:spMkLst>
            <pc:docMk/>
            <pc:sldMk cId="862395594" sldId="349"/>
            <ac:spMk id="27" creationId="{563E2D52-53EA-BF17-A591-4884FB987115}"/>
          </ac:spMkLst>
        </pc:spChg>
        <pc:spChg chg="add mod">
          <ac:chgData name="Kumar, Vinod" userId="a0710a6e-bffc-4971-8893-1c23addeb5b0" providerId="ADAL" clId="{29C9EDDB-5878-4E39-9C7D-77FA9AFFA3E5}" dt="2023-09-27T14:49:53.337" v="796" actId="1036"/>
          <ac:spMkLst>
            <pc:docMk/>
            <pc:sldMk cId="862395594" sldId="349"/>
            <ac:spMk id="30" creationId="{8708EBF2-242D-C559-FA6F-44C3D5906293}"/>
          </ac:spMkLst>
        </pc:spChg>
        <pc:spChg chg="add mod">
          <ac:chgData name="Kumar, Vinod" userId="a0710a6e-bffc-4971-8893-1c23addeb5b0" providerId="ADAL" clId="{29C9EDDB-5878-4E39-9C7D-77FA9AFFA3E5}" dt="2023-09-27T14:49:53.337" v="796" actId="1036"/>
          <ac:spMkLst>
            <pc:docMk/>
            <pc:sldMk cId="862395594" sldId="349"/>
            <ac:spMk id="31" creationId="{37160273-4205-8339-AD79-1986D499369F}"/>
          </ac:spMkLst>
        </pc:spChg>
        <pc:spChg chg="add mod">
          <ac:chgData name="Kumar, Vinod" userId="a0710a6e-bffc-4971-8893-1c23addeb5b0" providerId="ADAL" clId="{29C9EDDB-5878-4E39-9C7D-77FA9AFFA3E5}" dt="2023-09-27T14:48:12.918" v="639" actId="1036"/>
          <ac:spMkLst>
            <pc:docMk/>
            <pc:sldMk cId="862395594" sldId="349"/>
            <ac:spMk id="32" creationId="{CC21E9D1-B717-F618-715B-0449C2116755}"/>
          </ac:spMkLst>
        </pc:spChg>
        <pc:spChg chg="add mod">
          <ac:chgData name="Kumar, Vinod" userId="a0710a6e-bffc-4971-8893-1c23addeb5b0" providerId="ADAL" clId="{29C9EDDB-5878-4E39-9C7D-77FA9AFFA3E5}" dt="2023-09-27T14:48:12.918" v="639" actId="1036"/>
          <ac:spMkLst>
            <pc:docMk/>
            <pc:sldMk cId="862395594" sldId="349"/>
            <ac:spMk id="35" creationId="{69379C97-F549-0F5C-0A5A-0BFD4A664B0A}"/>
          </ac:spMkLst>
        </pc:spChg>
        <pc:spChg chg="add mod">
          <ac:chgData name="Kumar, Vinod" userId="a0710a6e-bffc-4971-8893-1c23addeb5b0" providerId="ADAL" clId="{29C9EDDB-5878-4E39-9C7D-77FA9AFFA3E5}" dt="2023-09-27T14:48:34.205" v="701" actId="14100"/>
          <ac:spMkLst>
            <pc:docMk/>
            <pc:sldMk cId="862395594" sldId="349"/>
            <ac:spMk id="36" creationId="{9634F1AD-3286-44DD-8970-4AB6E3334911}"/>
          </ac:spMkLst>
        </pc:spChg>
        <pc:spChg chg="add mod">
          <ac:chgData name="Kumar, Vinod" userId="a0710a6e-bffc-4971-8893-1c23addeb5b0" providerId="ADAL" clId="{29C9EDDB-5878-4E39-9C7D-77FA9AFFA3E5}" dt="2023-09-27T14:48:53.381" v="707" actId="1037"/>
          <ac:spMkLst>
            <pc:docMk/>
            <pc:sldMk cId="862395594" sldId="349"/>
            <ac:spMk id="37" creationId="{F3196A90-E74C-80A7-5C18-757AAED9C71D}"/>
          </ac:spMkLst>
        </pc:spChg>
        <pc:spChg chg="add mod">
          <ac:chgData name="Kumar, Vinod" userId="a0710a6e-bffc-4971-8893-1c23addeb5b0" providerId="ADAL" clId="{29C9EDDB-5878-4E39-9C7D-77FA9AFFA3E5}" dt="2023-09-27T14:49:03.910" v="719" actId="1036"/>
          <ac:spMkLst>
            <pc:docMk/>
            <pc:sldMk cId="862395594" sldId="349"/>
            <ac:spMk id="38" creationId="{28BEDEE4-5368-AE31-8FF9-8C0A599CC254}"/>
          </ac:spMkLst>
        </pc:spChg>
        <pc:spChg chg="add mod">
          <ac:chgData name="Kumar, Vinod" userId="a0710a6e-bffc-4971-8893-1c23addeb5b0" providerId="ADAL" clId="{29C9EDDB-5878-4E39-9C7D-77FA9AFFA3E5}" dt="2023-09-27T14:49:39.734" v="790" actId="1037"/>
          <ac:spMkLst>
            <pc:docMk/>
            <pc:sldMk cId="862395594" sldId="349"/>
            <ac:spMk id="39" creationId="{C60C7BC6-09A2-0D9B-B70B-C73DCCC7FD64}"/>
          </ac:spMkLst>
        </pc:spChg>
        <pc:spChg chg="add mod">
          <ac:chgData name="Kumar, Vinod" userId="a0710a6e-bffc-4971-8893-1c23addeb5b0" providerId="ADAL" clId="{29C9EDDB-5878-4E39-9C7D-77FA9AFFA3E5}" dt="2023-09-27T14:49:39.734" v="790" actId="1037"/>
          <ac:spMkLst>
            <pc:docMk/>
            <pc:sldMk cId="862395594" sldId="349"/>
            <ac:spMk id="40" creationId="{9C7911AD-059F-10E8-2C1B-06C6EED880D0}"/>
          </ac:spMkLst>
        </pc:spChg>
        <pc:spChg chg="add mod">
          <ac:chgData name="Kumar, Vinod" userId="a0710a6e-bffc-4971-8893-1c23addeb5b0" providerId="ADAL" clId="{29C9EDDB-5878-4E39-9C7D-77FA9AFFA3E5}" dt="2023-09-27T14:49:39.734" v="790" actId="1037"/>
          <ac:spMkLst>
            <pc:docMk/>
            <pc:sldMk cId="862395594" sldId="349"/>
            <ac:spMk id="41" creationId="{BE9F969E-B3F1-DA9D-6F4C-66553A15EDE6}"/>
          </ac:spMkLst>
        </pc:spChg>
        <pc:spChg chg="add mod">
          <ac:chgData name="Kumar, Vinod" userId="a0710a6e-bffc-4971-8893-1c23addeb5b0" providerId="ADAL" clId="{29C9EDDB-5878-4E39-9C7D-77FA9AFFA3E5}" dt="2023-09-27T14:50:13.494" v="799" actId="20577"/>
          <ac:spMkLst>
            <pc:docMk/>
            <pc:sldMk cId="862395594" sldId="349"/>
            <ac:spMk id="42" creationId="{BEB1B798-C4F3-CD1C-B18F-1892BDC146E0}"/>
          </ac:spMkLst>
        </pc:spChg>
        <pc:spChg chg="add mod">
          <ac:chgData name="Kumar, Vinod" userId="a0710a6e-bffc-4971-8893-1c23addeb5b0" providerId="ADAL" clId="{29C9EDDB-5878-4E39-9C7D-77FA9AFFA3E5}" dt="2023-09-27T14:50:23.030" v="801" actId="20577"/>
          <ac:spMkLst>
            <pc:docMk/>
            <pc:sldMk cId="862395594" sldId="349"/>
            <ac:spMk id="43" creationId="{7028309D-BC92-B5F5-1C87-2AA00FA8EC8D}"/>
          </ac:spMkLst>
        </pc:spChg>
        <pc:spChg chg="add mod">
          <ac:chgData name="Kumar, Vinod" userId="a0710a6e-bffc-4971-8893-1c23addeb5b0" providerId="ADAL" clId="{29C9EDDB-5878-4E39-9C7D-77FA9AFFA3E5}" dt="2023-09-27T14:50:39.510" v="858" actId="20577"/>
          <ac:spMkLst>
            <pc:docMk/>
            <pc:sldMk cId="862395594" sldId="349"/>
            <ac:spMk id="44" creationId="{34EE8081-33F7-7F90-A494-144F697DB3E8}"/>
          </ac:spMkLst>
        </pc:spChg>
        <pc:grpChg chg="add del mod">
          <ac:chgData name="Kumar, Vinod" userId="a0710a6e-bffc-4971-8893-1c23addeb5b0" providerId="ADAL" clId="{29C9EDDB-5878-4E39-9C7D-77FA9AFFA3E5}" dt="2023-09-27T14:39:25.833" v="428" actId="165"/>
          <ac:grpSpMkLst>
            <pc:docMk/>
            <pc:sldMk cId="862395594" sldId="349"/>
            <ac:grpSpMk id="6" creationId="{72B6D94F-3D29-F999-D12A-8A9010CBB987}"/>
          </ac:grpSpMkLst>
        </pc:grpChg>
        <pc:picChg chg="mod modCrop">
          <ac:chgData name="Kumar, Vinod" userId="a0710a6e-bffc-4971-8893-1c23addeb5b0" providerId="ADAL" clId="{29C9EDDB-5878-4E39-9C7D-77FA9AFFA3E5}" dt="2023-09-27T14:49:53.337" v="796" actId="1036"/>
          <ac:picMkLst>
            <pc:docMk/>
            <pc:sldMk cId="862395594" sldId="349"/>
            <ac:picMk id="2" creationId="{458BB76A-849F-A8F1-E19C-769C4538EC38}"/>
          </ac:picMkLst>
        </pc:picChg>
        <pc:picChg chg="del mod">
          <ac:chgData name="Kumar, Vinod" userId="a0710a6e-bffc-4971-8893-1c23addeb5b0" providerId="ADAL" clId="{29C9EDDB-5878-4E39-9C7D-77FA9AFFA3E5}" dt="2023-09-27T14:37:41.361" v="403" actId="478"/>
          <ac:picMkLst>
            <pc:docMk/>
            <pc:sldMk cId="862395594" sldId="349"/>
            <ac:picMk id="3" creationId="{417EB709-0828-8999-FCB7-3E440AB408CB}"/>
          </ac:picMkLst>
        </pc:picChg>
        <pc:picChg chg="mod modCrop">
          <ac:chgData name="Kumar, Vinod" userId="a0710a6e-bffc-4971-8893-1c23addeb5b0" providerId="ADAL" clId="{29C9EDDB-5878-4E39-9C7D-77FA9AFFA3E5}" dt="2023-09-27T14:38:23.586" v="424" actId="1076"/>
          <ac:picMkLst>
            <pc:docMk/>
            <pc:sldMk cId="862395594" sldId="349"/>
            <ac:picMk id="4" creationId="{D8AD5F22-A9AC-77E3-D35F-E8AB8C6A3BB2}"/>
          </ac:picMkLst>
        </pc:picChg>
        <pc:picChg chg="del mod">
          <ac:chgData name="Kumar, Vinod" userId="a0710a6e-bffc-4971-8893-1c23addeb5b0" providerId="ADAL" clId="{29C9EDDB-5878-4E39-9C7D-77FA9AFFA3E5}" dt="2023-09-27T14:37:41.361" v="403" actId="478"/>
          <ac:picMkLst>
            <pc:docMk/>
            <pc:sldMk cId="862395594" sldId="349"/>
            <ac:picMk id="5" creationId="{7077F9AA-2D42-E213-4A5D-E3E9D6976D95}"/>
          </ac:picMkLst>
        </pc:picChg>
        <pc:picChg chg="mod modCrop">
          <ac:chgData name="Kumar, Vinod" userId="a0710a6e-bffc-4971-8893-1c23addeb5b0" providerId="ADAL" clId="{29C9EDDB-5878-4E39-9C7D-77FA9AFFA3E5}" dt="2023-09-27T14:49:53.337" v="796" actId="1036"/>
          <ac:picMkLst>
            <pc:docMk/>
            <pc:sldMk cId="862395594" sldId="349"/>
            <ac:picMk id="7" creationId="{258B83FE-3982-4220-0126-16CED7781B67}"/>
          </ac:picMkLst>
        </pc:picChg>
        <pc:picChg chg="del mod topLvl">
          <ac:chgData name="Kumar, Vinod" userId="a0710a6e-bffc-4971-8893-1c23addeb5b0" providerId="ADAL" clId="{29C9EDDB-5878-4E39-9C7D-77FA9AFFA3E5}" dt="2023-09-27T14:46:53.303" v="606" actId="478"/>
          <ac:picMkLst>
            <pc:docMk/>
            <pc:sldMk cId="862395594" sldId="349"/>
            <ac:picMk id="8" creationId="{28B74FB8-B8A9-3F98-1D4D-222D7884036C}"/>
          </ac:picMkLst>
        </pc:picChg>
        <pc:picChg chg="mod modCrop">
          <ac:chgData name="Kumar, Vinod" userId="a0710a6e-bffc-4971-8893-1c23addeb5b0" providerId="ADAL" clId="{29C9EDDB-5878-4E39-9C7D-77FA9AFFA3E5}" dt="2023-09-27T14:47:54.727" v="620" actId="1035"/>
          <ac:picMkLst>
            <pc:docMk/>
            <pc:sldMk cId="862395594" sldId="349"/>
            <ac:picMk id="9" creationId="{36B69537-77CA-C72B-F3A3-B150186640EC}"/>
          </ac:picMkLst>
        </pc:picChg>
        <pc:picChg chg="del mod topLvl">
          <ac:chgData name="Kumar, Vinod" userId="a0710a6e-bffc-4971-8893-1c23addeb5b0" providerId="ADAL" clId="{29C9EDDB-5878-4E39-9C7D-77FA9AFFA3E5}" dt="2023-09-27T14:46:53.303" v="606" actId="478"/>
          <ac:picMkLst>
            <pc:docMk/>
            <pc:sldMk cId="862395594" sldId="349"/>
            <ac:picMk id="10" creationId="{323AF394-2335-232C-ED48-303195E991F0}"/>
          </ac:picMkLst>
        </pc:picChg>
        <pc:picChg chg="del mod topLvl">
          <ac:chgData name="Kumar, Vinod" userId="a0710a6e-bffc-4971-8893-1c23addeb5b0" providerId="ADAL" clId="{29C9EDDB-5878-4E39-9C7D-77FA9AFFA3E5}" dt="2023-09-27T14:46:53.303" v="606" actId="478"/>
          <ac:picMkLst>
            <pc:docMk/>
            <pc:sldMk cId="862395594" sldId="349"/>
            <ac:picMk id="11" creationId="{FDA03E70-60DD-3573-2837-C8451A20F9CA}"/>
          </ac:picMkLst>
        </pc:picChg>
        <pc:picChg chg="del mod topLvl">
          <ac:chgData name="Kumar, Vinod" userId="a0710a6e-bffc-4971-8893-1c23addeb5b0" providerId="ADAL" clId="{29C9EDDB-5878-4E39-9C7D-77FA9AFFA3E5}" dt="2023-09-27T14:46:53.303" v="606" actId="478"/>
          <ac:picMkLst>
            <pc:docMk/>
            <pc:sldMk cId="862395594" sldId="349"/>
            <ac:picMk id="12" creationId="{D36AA69E-E2C5-6758-D49B-969D79932E07}"/>
          </ac:picMkLst>
        </pc:picChg>
        <pc:cxnChg chg="del mod topLvl">
          <ac:chgData name="Kumar, Vinod" userId="a0710a6e-bffc-4971-8893-1c23addeb5b0" providerId="ADAL" clId="{29C9EDDB-5878-4E39-9C7D-77FA9AFFA3E5}" dt="2023-09-27T14:43:44.776" v="538" actId="478"/>
          <ac:cxnSpMkLst>
            <pc:docMk/>
            <pc:sldMk cId="862395594" sldId="349"/>
            <ac:cxnSpMk id="16" creationId="{D4B6815F-218A-CBF2-2F68-EC5AFA1BF9B5}"/>
          </ac:cxnSpMkLst>
        </pc:cxnChg>
        <pc:cxnChg chg="mod topLvl">
          <ac:chgData name="Kumar, Vinod" userId="a0710a6e-bffc-4971-8893-1c23addeb5b0" providerId="ADAL" clId="{29C9EDDB-5878-4E39-9C7D-77FA9AFFA3E5}" dt="2023-09-27T14:49:53.337" v="796" actId="1036"/>
          <ac:cxnSpMkLst>
            <pc:docMk/>
            <pc:sldMk cId="862395594" sldId="349"/>
            <ac:cxnSpMk id="17" creationId="{8268FE9D-311D-B2C4-D52A-8BC747CB6606}"/>
          </ac:cxnSpMkLst>
        </pc:cxnChg>
        <pc:cxnChg chg="mod topLvl">
          <ac:chgData name="Kumar, Vinod" userId="a0710a6e-bffc-4971-8893-1c23addeb5b0" providerId="ADAL" clId="{29C9EDDB-5878-4E39-9C7D-77FA9AFFA3E5}" dt="2023-09-27T14:49:53.337" v="796" actId="1036"/>
          <ac:cxnSpMkLst>
            <pc:docMk/>
            <pc:sldMk cId="862395594" sldId="349"/>
            <ac:cxnSpMk id="18" creationId="{2FF9B7CE-E9F8-A119-9385-81709C06D87D}"/>
          </ac:cxnSpMkLst>
        </pc:cxnChg>
        <pc:cxnChg chg="add mod">
          <ac:chgData name="Kumar, Vinod" userId="a0710a6e-bffc-4971-8893-1c23addeb5b0" providerId="ADAL" clId="{29C9EDDB-5878-4E39-9C7D-77FA9AFFA3E5}" dt="2023-09-27T14:48:12.918" v="639" actId="1036"/>
          <ac:cxnSpMkLst>
            <pc:docMk/>
            <pc:sldMk cId="862395594" sldId="349"/>
            <ac:cxnSpMk id="33" creationId="{FE2E978C-6D70-6D37-1012-B395018DEE0A}"/>
          </ac:cxnSpMkLst>
        </pc:cxnChg>
        <pc:cxnChg chg="add mod">
          <ac:chgData name="Kumar, Vinod" userId="a0710a6e-bffc-4971-8893-1c23addeb5b0" providerId="ADAL" clId="{29C9EDDB-5878-4E39-9C7D-77FA9AFFA3E5}" dt="2023-09-27T14:48:12.918" v="639" actId="1036"/>
          <ac:cxnSpMkLst>
            <pc:docMk/>
            <pc:sldMk cId="862395594" sldId="349"/>
            <ac:cxnSpMk id="34" creationId="{10CD94F6-8B2B-35E0-C758-FFF31327EE04}"/>
          </ac:cxnSpMkLst>
        </pc:cxnChg>
      </pc:sldChg>
    </pc:docChg>
  </pc:docChgLst>
  <pc:docChgLst>
    <pc:chgData name="Kumar, Vinod" userId="a0710a6e-bffc-4971-8893-1c23addeb5b0" providerId="ADAL" clId="{3DFB5C1F-603B-4A37-8293-00F35C08F293}"/>
    <pc:docChg chg="undo redo custSel addSld delSld modSld">
      <pc:chgData name="Kumar, Vinod" userId="a0710a6e-bffc-4971-8893-1c23addeb5b0" providerId="ADAL" clId="{3DFB5C1F-603B-4A37-8293-00F35C08F293}" dt="2022-10-14T15:19:07.499" v="3271" actId="47"/>
      <pc:docMkLst>
        <pc:docMk/>
      </pc:docMkLst>
      <pc:sldChg chg="addSp delSp modSp mod">
        <pc:chgData name="Kumar, Vinod" userId="a0710a6e-bffc-4971-8893-1c23addeb5b0" providerId="ADAL" clId="{3DFB5C1F-603B-4A37-8293-00F35C08F293}" dt="2022-10-05T14:28:39.189" v="665" actId="478"/>
        <pc:sldMkLst>
          <pc:docMk/>
          <pc:sldMk cId="2581851823" sldId="270"/>
        </pc:sldMkLst>
        <pc:spChg chg="mod">
          <ac:chgData name="Kumar, Vinod" userId="a0710a6e-bffc-4971-8893-1c23addeb5b0" providerId="ADAL" clId="{3DFB5C1F-603B-4A37-8293-00F35C08F293}" dt="2022-10-05T14:27:05.492" v="615" actId="1038"/>
          <ac:spMkLst>
            <pc:docMk/>
            <pc:sldMk cId="2581851823" sldId="270"/>
            <ac:spMk id="43" creationId="{EFA3BA5F-8A3A-CB47-50F3-1A1EE0BF7CAB}"/>
          </ac:spMkLst>
        </pc:spChg>
        <pc:picChg chg="mod">
          <ac:chgData name="Kumar, Vinod" userId="a0710a6e-bffc-4971-8893-1c23addeb5b0" providerId="ADAL" clId="{3DFB5C1F-603B-4A37-8293-00F35C08F293}" dt="2022-10-05T14:26:57.589" v="610" actId="1038"/>
          <ac:picMkLst>
            <pc:docMk/>
            <pc:sldMk cId="2581851823" sldId="270"/>
            <ac:picMk id="2" creationId="{1C40B368-7271-944F-5A0D-482A6E631169}"/>
          </ac:picMkLst>
        </pc:picChg>
        <pc:picChg chg="mod">
          <ac:chgData name="Kumar, Vinod" userId="a0710a6e-bffc-4971-8893-1c23addeb5b0" providerId="ADAL" clId="{3DFB5C1F-603B-4A37-8293-00F35C08F293}" dt="2022-10-05T14:27:20.021" v="617" actId="1035"/>
          <ac:picMkLst>
            <pc:docMk/>
            <pc:sldMk cId="2581851823" sldId="270"/>
            <ac:picMk id="23" creationId="{1D89F4DD-9BA8-FED4-BCA3-72E107254170}"/>
          </ac:picMkLst>
        </pc:picChg>
        <pc:cxnChg chg="add del mod">
          <ac:chgData name="Kumar, Vinod" userId="a0710a6e-bffc-4971-8893-1c23addeb5b0" providerId="ADAL" clId="{3DFB5C1F-603B-4A37-8293-00F35C08F293}" dt="2022-10-05T14:28:39.189" v="665" actId="478"/>
          <ac:cxnSpMkLst>
            <pc:docMk/>
            <pc:sldMk cId="2581851823" sldId="270"/>
            <ac:cxnSpMk id="3" creationId="{E80B814F-BAFD-0E1E-B0C5-B746FF1B5EE5}"/>
          </ac:cxnSpMkLst>
        </pc:cxnChg>
      </pc:sldChg>
      <pc:sldChg chg="addSp delSp modSp mod">
        <pc:chgData name="Kumar, Vinod" userId="a0710a6e-bffc-4971-8893-1c23addeb5b0" providerId="ADAL" clId="{3DFB5C1F-603B-4A37-8293-00F35C08F293}" dt="2022-10-05T14:53:03.687" v="1738" actId="478"/>
        <pc:sldMkLst>
          <pc:docMk/>
          <pc:sldMk cId="51599060" sldId="294"/>
        </pc:sldMkLst>
        <pc:spChg chg="add mod">
          <ac:chgData name="Kumar, Vinod" userId="a0710a6e-bffc-4971-8893-1c23addeb5b0" providerId="ADAL" clId="{3DFB5C1F-603B-4A37-8293-00F35C08F293}" dt="2022-10-05T14:49:48.216" v="1646" actId="1035"/>
          <ac:spMkLst>
            <pc:docMk/>
            <pc:sldMk cId="51599060" sldId="294"/>
            <ac:spMk id="8" creationId="{71B118E8-7CDF-B7BF-4C99-2C803483AE33}"/>
          </ac:spMkLst>
        </pc:spChg>
        <pc:spChg chg="mod">
          <ac:chgData name="Kumar, Vinod" userId="a0710a6e-bffc-4971-8893-1c23addeb5b0" providerId="ADAL" clId="{3DFB5C1F-603B-4A37-8293-00F35C08F293}" dt="2022-10-05T14:47:25.627" v="1550" actId="1036"/>
          <ac:spMkLst>
            <pc:docMk/>
            <pc:sldMk cId="51599060" sldId="294"/>
            <ac:spMk id="18" creationId="{398F8A0C-194E-FF4D-7289-8864350071D4}"/>
          </ac:spMkLst>
        </pc:spChg>
        <pc:spChg chg="del mod">
          <ac:chgData name="Kumar, Vinod" userId="a0710a6e-bffc-4971-8893-1c23addeb5b0" providerId="ADAL" clId="{3DFB5C1F-603B-4A37-8293-00F35C08F293}" dt="2022-10-05T14:48:43.082" v="1599" actId="478"/>
          <ac:spMkLst>
            <pc:docMk/>
            <pc:sldMk cId="51599060" sldId="294"/>
            <ac:spMk id="19" creationId="{3A4EBC49-37F4-D869-0996-BE21DB0E7ABD}"/>
          </ac:spMkLst>
        </pc:spChg>
        <pc:spChg chg="mod">
          <ac:chgData name="Kumar, Vinod" userId="a0710a6e-bffc-4971-8893-1c23addeb5b0" providerId="ADAL" clId="{3DFB5C1F-603B-4A37-8293-00F35C08F293}" dt="2022-10-05T14:51:14.056" v="1686" actId="1035"/>
          <ac:spMkLst>
            <pc:docMk/>
            <pc:sldMk cId="51599060" sldId="294"/>
            <ac:spMk id="20" creationId="{50EABD4C-5A9D-7A62-CF2E-6C0640B39C2F}"/>
          </ac:spMkLst>
        </pc:spChg>
        <pc:spChg chg="mod">
          <ac:chgData name="Kumar, Vinod" userId="a0710a6e-bffc-4971-8893-1c23addeb5b0" providerId="ADAL" clId="{3DFB5C1F-603B-4A37-8293-00F35C08F293}" dt="2022-10-05T14:47:25.627" v="1550" actId="1036"/>
          <ac:spMkLst>
            <pc:docMk/>
            <pc:sldMk cId="51599060" sldId="294"/>
            <ac:spMk id="21" creationId="{BA17C6E1-9E7E-0426-0C8C-C1A35E1C7DC3}"/>
          </ac:spMkLst>
        </pc:spChg>
        <pc:spChg chg="mod">
          <ac:chgData name="Kumar, Vinod" userId="a0710a6e-bffc-4971-8893-1c23addeb5b0" providerId="ADAL" clId="{3DFB5C1F-603B-4A37-8293-00F35C08F293}" dt="2022-10-05T14:50:03.769" v="1649" actId="1036"/>
          <ac:spMkLst>
            <pc:docMk/>
            <pc:sldMk cId="51599060" sldId="294"/>
            <ac:spMk id="22" creationId="{89C3B8BA-B97C-4483-7DDA-C04CF0B7D5BD}"/>
          </ac:spMkLst>
        </pc:spChg>
        <pc:spChg chg="mod">
          <ac:chgData name="Kumar, Vinod" userId="a0710a6e-bffc-4971-8893-1c23addeb5b0" providerId="ADAL" clId="{3DFB5C1F-603B-4A37-8293-00F35C08F293}" dt="2022-10-05T14:50:43.512" v="1674" actId="1035"/>
          <ac:spMkLst>
            <pc:docMk/>
            <pc:sldMk cId="51599060" sldId="294"/>
            <ac:spMk id="23" creationId="{9E9FD58F-64C2-0A03-90AD-E94581A8B3C0}"/>
          </ac:spMkLst>
        </pc:spChg>
        <pc:spChg chg="mod">
          <ac:chgData name="Kumar, Vinod" userId="a0710a6e-bffc-4971-8893-1c23addeb5b0" providerId="ADAL" clId="{3DFB5C1F-603B-4A37-8293-00F35C08F293}" dt="2022-10-05T14:51:28.344" v="1689" actId="1036"/>
          <ac:spMkLst>
            <pc:docMk/>
            <pc:sldMk cId="51599060" sldId="294"/>
            <ac:spMk id="28" creationId="{2A61F1F1-2458-F05A-D6AC-BFB7017688BA}"/>
          </ac:spMkLst>
        </pc:spChg>
        <pc:spChg chg="mod">
          <ac:chgData name="Kumar, Vinod" userId="a0710a6e-bffc-4971-8893-1c23addeb5b0" providerId="ADAL" clId="{3DFB5C1F-603B-4A37-8293-00F35C08F293}" dt="2022-10-05T14:51:28.344" v="1689" actId="1036"/>
          <ac:spMkLst>
            <pc:docMk/>
            <pc:sldMk cId="51599060" sldId="294"/>
            <ac:spMk id="29" creationId="{760CD5E2-7907-5398-3CE4-410188CBFD00}"/>
          </ac:spMkLst>
        </pc:spChg>
        <pc:spChg chg="mod">
          <ac:chgData name="Kumar, Vinod" userId="a0710a6e-bffc-4971-8893-1c23addeb5b0" providerId="ADAL" clId="{3DFB5C1F-603B-4A37-8293-00F35C08F293}" dt="2022-10-05T14:52:10.359" v="1736" actId="1036"/>
          <ac:spMkLst>
            <pc:docMk/>
            <pc:sldMk cId="51599060" sldId="294"/>
            <ac:spMk id="34" creationId="{2B6C7636-0898-60A7-0EFB-7BCB47A579CA}"/>
          </ac:spMkLst>
        </pc:spChg>
        <pc:spChg chg="mod">
          <ac:chgData name="Kumar, Vinod" userId="a0710a6e-bffc-4971-8893-1c23addeb5b0" providerId="ADAL" clId="{3DFB5C1F-603B-4A37-8293-00F35C08F293}" dt="2022-10-05T14:52:10.359" v="1736" actId="1036"/>
          <ac:spMkLst>
            <pc:docMk/>
            <pc:sldMk cId="51599060" sldId="294"/>
            <ac:spMk id="35" creationId="{CF814D77-3222-924D-96EB-DDE43FF62229}"/>
          </ac:spMkLst>
        </pc:spChg>
        <pc:picChg chg="mod">
          <ac:chgData name="Kumar, Vinod" userId="a0710a6e-bffc-4971-8893-1c23addeb5b0" providerId="ADAL" clId="{3DFB5C1F-603B-4A37-8293-00F35C08F293}" dt="2022-10-05T14:49:48.216" v="1646" actId="1035"/>
          <ac:picMkLst>
            <pc:docMk/>
            <pc:sldMk cId="51599060" sldId="294"/>
            <ac:picMk id="3" creationId="{73758AC8-16FA-94B8-4DA8-AE833AE6A838}"/>
          </ac:picMkLst>
        </pc:picChg>
        <pc:picChg chg="mod">
          <ac:chgData name="Kumar, Vinod" userId="a0710a6e-bffc-4971-8893-1c23addeb5b0" providerId="ADAL" clId="{3DFB5C1F-603B-4A37-8293-00F35C08F293}" dt="2022-10-05T14:50:43.512" v="1674" actId="1035"/>
          <ac:picMkLst>
            <pc:docMk/>
            <pc:sldMk cId="51599060" sldId="294"/>
            <ac:picMk id="4" creationId="{0AB7334A-7D84-E21C-4840-A55B123B485F}"/>
          </ac:picMkLst>
        </pc:picChg>
        <pc:picChg chg="mod">
          <ac:chgData name="Kumar, Vinod" userId="a0710a6e-bffc-4971-8893-1c23addeb5b0" providerId="ADAL" clId="{3DFB5C1F-603B-4A37-8293-00F35C08F293}" dt="2022-10-05T14:50:43.512" v="1674" actId="1035"/>
          <ac:picMkLst>
            <pc:docMk/>
            <pc:sldMk cId="51599060" sldId="294"/>
            <ac:picMk id="5" creationId="{68015BC2-1828-B74E-A8EC-FAED8514FFEC}"/>
          </ac:picMkLst>
        </pc:picChg>
        <pc:picChg chg="mod">
          <ac:chgData name="Kumar, Vinod" userId="a0710a6e-bffc-4971-8893-1c23addeb5b0" providerId="ADAL" clId="{3DFB5C1F-603B-4A37-8293-00F35C08F293}" dt="2022-10-05T14:47:25.627" v="1550" actId="1036"/>
          <ac:picMkLst>
            <pc:docMk/>
            <pc:sldMk cId="51599060" sldId="294"/>
            <ac:picMk id="30" creationId="{60CB73A7-14FE-042F-5656-C468FC0E6FD9}"/>
          </ac:picMkLst>
        </pc:picChg>
        <pc:picChg chg="mod">
          <ac:chgData name="Kumar, Vinod" userId="a0710a6e-bffc-4971-8893-1c23addeb5b0" providerId="ADAL" clId="{3DFB5C1F-603B-4A37-8293-00F35C08F293}" dt="2022-10-05T14:47:25.627" v="1550" actId="1036"/>
          <ac:picMkLst>
            <pc:docMk/>
            <pc:sldMk cId="51599060" sldId="294"/>
            <ac:picMk id="31" creationId="{386F0B05-F7BB-5932-D2EE-B54F705C16F0}"/>
          </ac:picMkLst>
        </pc:picChg>
        <pc:picChg chg="mod">
          <ac:chgData name="Kumar, Vinod" userId="a0710a6e-bffc-4971-8893-1c23addeb5b0" providerId="ADAL" clId="{3DFB5C1F-603B-4A37-8293-00F35C08F293}" dt="2022-10-05T14:52:10.359" v="1736" actId="1036"/>
          <ac:picMkLst>
            <pc:docMk/>
            <pc:sldMk cId="51599060" sldId="294"/>
            <ac:picMk id="32" creationId="{E6DE9711-8ED1-7832-D742-5D0C043C5385}"/>
          </ac:picMkLst>
        </pc:picChg>
        <pc:picChg chg="mod">
          <ac:chgData name="Kumar, Vinod" userId="a0710a6e-bffc-4971-8893-1c23addeb5b0" providerId="ADAL" clId="{3DFB5C1F-603B-4A37-8293-00F35C08F293}" dt="2022-10-05T14:52:10.359" v="1736" actId="1036"/>
          <ac:picMkLst>
            <pc:docMk/>
            <pc:sldMk cId="51599060" sldId="294"/>
            <ac:picMk id="33" creationId="{E66DF3B6-EBB2-377C-AA78-C44B645A9F1C}"/>
          </ac:picMkLst>
        </pc:picChg>
        <pc:cxnChg chg="add del mod">
          <ac:chgData name="Kumar, Vinod" userId="a0710a6e-bffc-4971-8893-1c23addeb5b0" providerId="ADAL" clId="{3DFB5C1F-603B-4A37-8293-00F35C08F293}" dt="2022-10-05T14:53:03.687" v="1738" actId="478"/>
          <ac:cxnSpMkLst>
            <pc:docMk/>
            <pc:sldMk cId="51599060" sldId="294"/>
            <ac:cxnSpMk id="6" creationId="{007F92F5-0594-2155-2999-94FE966F3979}"/>
          </ac:cxnSpMkLst>
        </pc:cxnChg>
      </pc:sldChg>
      <pc:sldChg chg="addSp delSp modSp mod">
        <pc:chgData name="Kumar, Vinod" userId="a0710a6e-bffc-4971-8893-1c23addeb5b0" providerId="ADAL" clId="{3DFB5C1F-603B-4A37-8293-00F35C08F293}" dt="2022-10-05T14:41:53.679" v="1475" actId="478"/>
        <pc:sldMkLst>
          <pc:docMk/>
          <pc:sldMk cId="2940357804" sldId="297"/>
        </pc:sldMkLst>
        <pc:spChg chg="add mod">
          <ac:chgData name="Kumar, Vinod" userId="a0710a6e-bffc-4971-8893-1c23addeb5b0" providerId="ADAL" clId="{3DFB5C1F-603B-4A37-8293-00F35C08F293}" dt="2022-10-05T14:33:01.070" v="708" actId="164"/>
          <ac:spMkLst>
            <pc:docMk/>
            <pc:sldMk cId="2940357804" sldId="297"/>
            <ac:spMk id="3" creationId="{6753ED14-5A64-9BB5-471A-CDA2F8BDC518}"/>
          </ac:spMkLst>
        </pc:spChg>
        <pc:spChg chg="mod">
          <ac:chgData name="Kumar, Vinod" userId="a0710a6e-bffc-4971-8893-1c23addeb5b0" providerId="ADAL" clId="{3DFB5C1F-603B-4A37-8293-00F35C08F293}" dt="2022-10-05T14:39:21.055" v="1366" actId="1035"/>
          <ac:spMkLst>
            <pc:docMk/>
            <pc:sldMk cId="2940357804" sldId="297"/>
            <ac:spMk id="83" creationId="{E58A24D0-96A1-E362-831F-90DFFC5F3F34}"/>
          </ac:spMkLst>
        </pc:spChg>
        <pc:spChg chg="mod">
          <ac:chgData name="Kumar, Vinod" userId="a0710a6e-bffc-4971-8893-1c23addeb5b0" providerId="ADAL" clId="{3DFB5C1F-603B-4A37-8293-00F35C08F293}" dt="2022-10-05T14:37:48.735" v="1230" actId="1036"/>
          <ac:spMkLst>
            <pc:docMk/>
            <pc:sldMk cId="2940357804" sldId="297"/>
            <ac:spMk id="85" creationId="{4A986DD3-D094-666C-684F-6F2016CC39D2}"/>
          </ac:spMkLst>
        </pc:spChg>
        <pc:spChg chg="mod">
          <ac:chgData name="Kumar, Vinod" userId="a0710a6e-bffc-4971-8893-1c23addeb5b0" providerId="ADAL" clId="{3DFB5C1F-603B-4A37-8293-00F35C08F293}" dt="2022-10-05T14:39:35.726" v="1370" actId="1035"/>
          <ac:spMkLst>
            <pc:docMk/>
            <pc:sldMk cId="2940357804" sldId="297"/>
            <ac:spMk id="86" creationId="{9C52924C-0B52-5997-C58D-2D1AA75640C5}"/>
          </ac:spMkLst>
        </pc:spChg>
        <pc:spChg chg="mod">
          <ac:chgData name="Kumar, Vinod" userId="a0710a6e-bffc-4971-8893-1c23addeb5b0" providerId="ADAL" clId="{3DFB5C1F-603B-4A37-8293-00F35C08F293}" dt="2022-10-05T14:39:35.726" v="1370" actId="1035"/>
          <ac:spMkLst>
            <pc:docMk/>
            <pc:sldMk cId="2940357804" sldId="297"/>
            <ac:spMk id="87" creationId="{94D37293-18A5-7325-6B95-B40A9B17B375}"/>
          </ac:spMkLst>
        </pc:spChg>
        <pc:spChg chg="mod">
          <ac:chgData name="Kumar, Vinod" userId="a0710a6e-bffc-4971-8893-1c23addeb5b0" providerId="ADAL" clId="{3DFB5C1F-603B-4A37-8293-00F35C08F293}" dt="2022-10-05T14:41:04.877" v="1452" actId="1037"/>
          <ac:spMkLst>
            <pc:docMk/>
            <pc:sldMk cId="2940357804" sldId="297"/>
            <ac:spMk id="88" creationId="{CAC2C618-7D71-1724-06E7-9F8AD47F396F}"/>
          </ac:spMkLst>
        </pc:spChg>
        <pc:spChg chg="mod">
          <ac:chgData name="Kumar, Vinod" userId="a0710a6e-bffc-4971-8893-1c23addeb5b0" providerId="ADAL" clId="{3DFB5C1F-603B-4A37-8293-00F35C08F293}" dt="2022-10-05T14:40:39.646" v="1428" actId="1037"/>
          <ac:spMkLst>
            <pc:docMk/>
            <pc:sldMk cId="2940357804" sldId="297"/>
            <ac:spMk id="89" creationId="{05532DAD-C191-1E14-3307-0B3021E5F901}"/>
          </ac:spMkLst>
        </pc:spChg>
        <pc:grpChg chg="add mod">
          <ac:chgData name="Kumar, Vinod" userId="a0710a6e-bffc-4971-8893-1c23addeb5b0" providerId="ADAL" clId="{3DFB5C1F-603B-4A37-8293-00F35C08F293}" dt="2022-10-05T14:38:57.807" v="1350" actId="1038"/>
          <ac:grpSpMkLst>
            <pc:docMk/>
            <pc:sldMk cId="2940357804" sldId="297"/>
            <ac:grpSpMk id="4" creationId="{F5423992-F8A2-D828-1228-6E48F90FA37B}"/>
          </ac:grpSpMkLst>
        </pc:grpChg>
        <pc:picChg chg="mod">
          <ac:chgData name="Kumar, Vinod" userId="a0710a6e-bffc-4971-8893-1c23addeb5b0" providerId="ADAL" clId="{3DFB5C1F-603B-4A37-8293-00F35C08F293}" dt="2022-10-05T14:33:01.070" v="708" actId="164"/>
          <ac:picMkLst>
            <pc:docMk/>
            <pc:sldMk cId="2940357804" sldId="297"/>
            <ac:picMk id="8" creationId="{919DAE8E-7D35-8F40-D412-002BF3289D80}"/>
          </ac:picMkLst>
        </pc:picChg>
        <pc:picChg chg="mod">
          <ac:chgData name="Kumar, Vinod" userId="a0710a6e-bffc-4971-8893-1c23addeb5b0" providerId="ADAL" clId="{3DFB5C1F-603B-4A37-8293-00F35C08F293}" dt="2022-10-05T14:39:35.726" v="1370" actId="1035"/>
          <ac:picMkLst>
            <pc:docMk/>
            <pc:sldMk cId="2940357804" sldId="297"/>
            <ac:picMk id="9" creationId="{300ECDCE-7793-035A-4A52-E598C369621D}"/>
          </ac:picMkLst>
        </pc:picChg>
        <pc:picChg chg="mod">
          <ac:chgData name="Kumar, Vinod" userId="a0710a6e-bffc-4971-8893-1c23addeb5b0" providerId="ADAL" clId="{3DFB5C1F-603B-4A37-8293-00F35C08F293}" dt="2022-10-05T14:39:35.726" v="1370" actId="1035"/>
          <ac:picMkLst>
            <pc:docMk/>
            <pc:sldMk cId="2940357804" sldId="297"/>
            <ac:picMk id="10" creationId="{F694DA6C-4FFF-B896-71AE-D2FE03F46AAF}"/>
          </ac:picMkLst>
        </pc:picChg>
        <pc:picChg chg="mod modCrop">
          <ac:chgData name="Kumar, Vinod" userId="a0710a6e-bffc-4971-8893-1c23addeb5b0" providerId="ADAL" clId="{3DFB5C1F-603B-4A37-8293-00F35C08F293}" dt="2022-10-05T14:41:12.478" v="1465" actId="1038"/>
          <ac:picMkLst>
            <pc:docMk/>
            <pc:sldMk cId="2940357804" sldId="297"/>
            <ac:picMk id="11" creationId="{825455C6-07A7-ED30-3A78-8B334C2C3A9A}"/>
          </ac:picMkLst>
        </pc:picChg>
        <pc:picChg chg="mod">
          <ac:chgData name="Kumar, Vinod" userId="a0710a6e-bffc-4971-8893-1c23addeb5b0" providerId="ADAL" clId="{3DFB5C1F-603B-4A37-8293-00F35C08F293}" dt="2022-10-05T14:41:19.102" v="1468" actId="1038"/>
          <ac:picMkLst>
            <pc:docMk/>
            <pc:sldMk cId="2940357804" sldId="297"/>
            <ac:picMk id="33" creationId="{006ED6EC-B6C0-F620-73A7-9787FCB0810A}"/>
          </ac:picMkLst>
        </pc:picChg>
        <pc:picChg chg="mod">
          <ac:chgData name="Kumar, Vinod" userId="a0710a6e-bffc-4971-8893-1c23addeb5b0" providerId="ADAL" clId="{3DFB5C1F-603B-4A37-8293-00F35C08F293}" dt="2022-10-05T14:37:25.007" v="1202" actId="1036"/>
          <ac:picMkLst>
            <pc:docMk/>
            <pc:sldMk cId="2940357804" sldId="297"/>
            <ac:picMk id="34" creationId="{94187F1D-53CC-E202-F758-BF0BB2346A09}"/>
          </ac:picMkLst>
        </pc:picChg>
        <pc:cxnChg chg="add del mod">
          <ac:chgData name="Kumar, Vinod" userId="a0710a6e-bffc-4971-8893-1c23addeb5b0" providerId="ADAL" clId="{3DFB5C1F-603B-4A37-8293-00F35C08F293}" dt="2022-10-05T14:41:53.679" v="1475" actId="478"/>
          <ac:cxnSpMkLst>
            <pc:docMk/>
            <pc:sldMk cId="2940357804" sldId="297"/>
            <ac:cxnSpMk id="2" creationId="{4A9EE2EF-7F93-04C1-D6C6-C99CD125DE14}"/>
          </ac:cxnSpMkLst>
        </pc:cxnChg>
      </pc:sldChg>
      <pc:sldChg chg="addSp delSp modSp mod">
        <pc:chgData name="Kumar, Vinod" userId="a0710a6e-bffc-4971-8893-1c23addeb5b0" providerId="ADAL" clId="{3DFB5C1F-603B-4A37-8293-00F35C08F293}" dt="2022-10-05T14:46:34.699" v="1532" actId="478"/>
        <pc:sldMkLst>
          <pc:docMk/>
          <pc:sldMk cId="3985943826" sldId="298"/>
        </pc:sldMkLst>
        <pc:spChg chg="mod">
          <ac:chgData name="Kumar, Vinod" userId="a0710a6e-bffc-4971-8893-1c23addeb5b0" providerId="ADAL" clId="{3DFB5C1F-603B-4A37-8293-00F35C08F293}" dt="2022-10-05T14:44:10.716" v="1521" actId="1036"/>
          <ac:spMkLst>
            <pc:docMk/>
            <pc:sldMk cId="3985943826" sldId="298"/>
            <ac:spMk id="50" creationId="{575DD9E8-ABE9-05E4-AE97-B1BAC73CDE61}"/>
          </ac:spMkLst>
        </pc:spChg>
        <pc:grpChg chg="mod">
          <ac:chgData name="Kumar, Vinod" userId="a0710a6e-bffc-4971-8893-1c23addeb5b0" providerId="ADAL" clId="{3DFB5C1F-603B-4A37-8293-00F35C08F293}" dt="2022-10-05T14:43:12.573" v="1490" actId="1037"/>
          <ac:grpSpMkLst>
            <pc:docMk/>
            <pc:sldMk cId="3985943826" sldId="298"/>
            <ac:grpSpMk id="42" creationId="{ACD1F7E2-17CB-092F-370A-5BC092437F7A}"/>
          </ac:grpSpMkLst>
        </pc:grpChg>
        <pc:grpChg chg="mod">
          <ac:chgData name="Kumar, Vinod" userId="a0710a6e-bffc-4971-8893-1c23addeb5b0" providerId="ADAL" clId="{3DFB5C1F-603B-4A37-8293-00F35C08F293}" dt="2022-10-05T14:43:20.924" v="1500" actId="1037"/>
          <ac:grpSpMkLst>
            <pc:docMk/>
            <pc:sldMk cId="3985943826" sldId="298"/>
            <ac:grpSpMk id="45" creationId="{0BC00F63-F12C-0E90-D12A-84CC1F9755F4}"/>
          </ac:grpSpMkLst>
        </pc:grpChg>
        <pc:grpChg chg="mod">
          <ac:chgData name="Kumar, Vinod" userId="a0710a6e-bffc-4971-8893-1c23addeb5b0" providerId="ADAL" clId="{3DFB5C1F-603B-4A37-8293-00F35C08F293}" dt="2022-10-05T14:43:25.500" v="1505" actId="1037"/>
          <ac:grpSpMkLst>
            <pc:docMk/>
            <pc:sldMk cId="3985943826" sldId="298"/>
            <ac:grpSpMk id="48" creationId="{DA988982-3960-F2BC-0BB8-BF76EC7439E7}"/>
          </ac:grpSpMkLst>
        </pc:grpChg>
        <pc:cxnChg chg="add del mod">
          <ac:chgData name="Kumar, Vinod" userId="a0710a6e-bffc-4971-8893-1c23addeb5b0" providerId="ADAL" clId="{3DFB5C1F-603B-4A37-8293-00F35C08F293}" dt="2022-10-05T14:46:34.699" v="1532" actId="478"/>
          <ac:cxnSpMkLst>
            <pc:docMk/>
            <pc:sldMk cId="3985943826" sldId="298"/>
            <ac:cxnSpMk id="2" creationId="{150945B3-6E6D-C9A4-00BD-DB583399A43A}"/>
          </ac:cxnSpMkLst>
        </pc:cxnChg>
      </pc:sldChg>
      <pc:sldChg chg="addSp delSp modSp mod">
        <pc:chgData name="Kumar, Vinod" userId="a0710a6e-bffc-4971-8893-1c23addeb5b0" providerId="ADAL" clId="{3DFB5C1F-603B-4A37-8293-00F35C08F293}" dt="2022-10-05T15:03:49.478" v="2141" actId="21"/>
        <pc:sldMkLst>
          <pc:docMk/>
          <pc:sldMk cId="2498213667" sldId="299"/>
        </pc:sldMkLst>
        <pc:spChg chg="mod">
          <ac:chgData name="Kumar, Vinod" userId="a0710a6e-bffc-4971-8893-1c23addeb5b0" providerId="ADAL" clId="{3DFB5C1F-603B-4A37-8293-00F35C08F293}" dt="2022-10-05T15:01:57.842" v="2137" actId="1036"/>
          <ac:spMkLst>
            <pc:docMk/>
            <pc:sldMk cId="2498213667" sldId="299"/>
            <ac:spMk id="2" creationId="{51D40CE4-17B2-7A16-E7B1-F6DFB55A0FA0}"/>
          </ac:spMkLst>
        </pc:spChg>
        <pc:spChg chg="mod">
          <ac:chgData name="Kumar, Vinod" userId="a0710a6e-bffc-4971-8893-1c23addeb5b0" providerId="ADAL" clId="{3DFB5C1F-603B-4A37-8293-00F35C08F293}" dt="2022-10-05T15:02:09.074" v="2140" actId="1036"/>
          <ac:spMkLst>
            <pc:docMk/>
            <pc:sldMk cId="2498213667" sldId="299"/>
            <ac:spMk id="12" creationId="{E8E8704C-584D-FA36-C26F-521F2E17A65D}"/>
          </ac:spMkLst>
        </pc:spChg>
        <pc:spChg chg="mod">
          <ac:chgData name="Kumar, Vinod" userId="a0710a6e-bffc-4971-8893-1c23addeb5b0" providerId="ADAL" clId="{3DFB5C1F-603B-4A37-8293-00F35C08F293}" dt="2022-10-05T15:02:09.074" v="2140" actId="1036"/>
          <ac:spMkLst>
            <pc:docMk/>
            <pc:sldMk cId="2498213667" sldId="299"/>
            <ac:spMk id="13" creationId="{3B038702-7E51-64C2-B27E-5ADC07CCC1DE}"/>
          </ac:spMkLst>
        </pc:spChg>
        <pc:spChg chg="mod">
          <ac:chgData name="Kumar, Vinod" userId="a0710a6e-bffc-4971-8893-1c23addeb5b0" providerId="ADAL" clId="{3DFB5C1F-603B-4A37-8293-00F35C08F293}" dt="2022-10-05T15:02:09.074" v="2140" actId="1036"/>
          <ac:spMkLst>
            <pc:docMk/>
            <pc:sldMk cId="2498213667" sldId="299"/>
            <ac:spMk id="14" creationId="{1BCDF35F-F838-B6D1-70E7-6D3B25B442CA}"/>
          </ac:spMkLst>
        </pc:spChg>
        <pc:spChg chg="mod">
          <ac:chgData name="Kumar, Vinod" userId="a0710a6e-bffc-4971-8893-1c23addeb5b0" providerId="ADAL" clId="{3DFB5C1F-603B-4A37-8293-00F35C08F293}" dt="2022-10-05T15:00:22.723" v="2025" actId="1035"/>
          <ac:spMkLst>
            <pc:docMk/>
            <pc:sldMk cId="2498213667" sldId="299"/>
            <ac:spMk id="15" creationId="{25AF3F51-D911-F89E-54BF-BC566191F89F}"/>
          </ac:spMkLst>
        </pc:spChg>
        <pc:spChg chg="mod">
          <ac:chgData name="Kumar, Vinod" userId="a0710a6e-bffc-4971-8893-1c23addeb5b0" providerId="ADAL" clId="{3DFB5C1F-603B-4A37-8293-00F35C08F293}" dt="2022-10-05T15:00:16.083" v="2013" actId="1035"/>
          <ac:spMkLst>
            <pc:docMk/>
            <pc:sldMk cId="2498213667" sldId="299"/>
            <ac:spMk id="16" creationId="{9C2C0DB9-6DFE-DB8A-A61A-CFEDB99B4720}"/>
          </ac:spMkLst>
        </pc:spChg>
        <pc:spChg chg="add mod">
          <ac:chgData name="Kumar, Vinod" userId="a0710a6e-bffc-4971-8893-1c23addeb5b0" providerId="ADAL" clId="{3DFB5C1F-603B-4A37-8293-00F35C08F293}" dt="2022-10-05T15:00:30.810" v="2026" actId="164"/>
          <ac:spMkLst>
            <pc:docMk/>
            <pc:sldMk cId="2498213667" sldId="299"/>
            <ac:spMk id="22" creationId="{671BF9D1-0CAB-63A6-B737-5B7852C6D30A}"/>
          </ac:spMkLst>
        </pc:spChg>
        <pc:spChg chg="add mod">
          <ac:chgData name="Kumar, Vinod" userId="a0710a6e-bffc-4971-8893-1c23addeb5b0" providerId="ADAL" clId="{3DFB5C1F-603B-4A37-8293-00F35C08F293}" dt="2022-10-05T15:00:37.283" v="2027" actId="164"/>
          <ac:spMkLst>
            <pc:docMk/>
            <pc:sldMk cId="2498213667" sldId="299"/>
            <ac:spMk id="23" creationId="{32FBF7EC-4D6C-C573-F2FB-8F91AF23B81F}"/>
          </ac:spMkLst>
        </pc:spChg>
        <pc:spChg chg="add mod">
          <ac:chgData name="Kumar, Vinod" userId="a0710a6e-bffc-4971-8893-1c23addeb5b0" providerId="ADAL" clId="{3DFB5C1F-603B-4A37-8293-00F35C08F293}" dt="2022-10-05T15:01:12.519" v="2087" actId="164"/>
          <ac:spMkLst>
            <pc:docMk/>
            <pc:sldMk cId="2498213667" sldId="299"/>
            <ac:spMk id="24" creationId="{81258606-3EE4-FAB8-567F-B72E1585FD73}"/>
          </ac:spMkLst>
        </pc:spChg>
        <pc:grpChg chg="add mod">
          <ac:chgData name="Kumar, Vinod" userId="a0710a6e-bffc-4971-8893-1c23addeb5b0" providerId="ADAL" clId="{3DFB5C1F-603B-4A37-8293-00F35C08F293}" dt="2022-10-05T15:00:44.884" v="2044" actId="1035"/>
          <ac:grpSpMkLst>
            <pc:docMk/>
            <pc:sldMk cId="2498213667" sldId="299"/>
            <ac:grpSpMk id="25" creationId="{805A9B49-AAB6-C36F-99CD-3E09AE701FC4}"/>
          </ac:grpSpMkLst>
        </pc:grpChg>
        <pc:grpChg chg="add mod">
          <ac:chgData name="Kumar, Vinod" userId="a0710a6e-bffc-4971-8893-1c23addeb5b0" providerId="ADAL" clId="{3DFB5C1F-603B-4A37-8293-00F35C08F293}" dt="2022-10-05T15:00:37.283" v="2027" actId="164"/>
          <ac:grpSpMkLst>
            <pc:docMk/>
            <pc:sldMk cId="2498213667" sldId="299"/>
            <ac:grpSpMk id="26" creationId="{17484DF5-3BA7-DB77-1D73-F10E10D0A7DD}"/>
          </ac:grpSpMkLst>
        </pc:grpChg>
        <pc:grpChg chg="add mod">
          <ac:chgData name="Kumar, Vinod" userId="a0710a6e-bffc-4971-8893-1c23addeb5b0" providerId="ADAL" clId="{3DFB5C1F-603B-4A37-8293-00F35C08F293}" dt="2022-10-05T15:01:16.611" v="2092" actId="1035"/>
          <ac:grpSpMkLst>
            <pc:docMk/>
            <pc:sldMk cId="2498213667" sldId="299"/>
            <ac:grpSpMk id="27" creationId="{C4DFA242-5262-E07D-9618-81631B0832B2}"/>
          </ac:grpSpMkLst>
        </pc:grpChg>
        <pc:picChg chg="mod">
          <ac:chgData name="Kumar, Vinod" userId="a0710a6e-bffc-4971-8893-1c23addeb5b0" providerId="ADAL" clId="{3DFB5C1F-603B-4A37-8293-00F35C08F293}" dt="2022-10-05T15:02:09.074" v="2140" actId="1036"/>
          <ac:picMkLst>
            <pc:docMk/>
            <pc:sldMk cId="2498213667" sldId="299"/>
            <ac:picMk id="3" creationId="{FBF35403-61AF-9C85-AFB2-D91B2E63184B}"/>
          </ac:picMkLst>
        </pc:picChg>
        <pc:picChg chg="mod">
          <ac:chgData name="Kumar, Vinod" userId="a0710a6e-bffc-4971-8893-1c23addeb5b0" providerId="ADAL" clId="{3DFB5C1F-603B-4A37-8293-00F35C08F293}" dt="2022-10-05T15:02:09.074" v="2140" actId="1036"/>
          <ac:picMkLst>
            <pc:docMk/>
            <pc:sldMk cId="2498213667" sldId="299"/>
            <ac:picMk id="4" creationId="{B7DE046C-470A-960C-E17F-D265CEC30111}"/>
          </ac:picMkLst>
        </pc:picChg>
        <pc:picChg chg="mod">
          <ac:chgData name="Kumar, Vinod" userId="a0710a6e-bffc-4971-8893-1c23addeb5b0" providerId="ADAL" clId="{3DFB5C1F-603B-4A37-8293-00F35C08F293}" dt="2022-10-05T15:02:09.074" v="2140" actId="1036"/>
          <ac:picMkLst>
            <pc:docMk/>
            <pc:sldMk cId="2498213667" sldId="299"/>
            <ac:picMk id="5" creationId="{D22CD06E-BB45-DAE6-41F1-E7CC9C42B9EA}"/>
          </ac:picMkLst>
        </pc:picChg>
        <pc:picChg chg="mod">
          <ac:chgData name="Kumar, Vinod" userId="a0710a6e-bffc-4971-8893-1c23addeb5b0" providerId="ADAL" clId="{3DFB5C1F-603B-4A37-8293-00F35C08F293}" dt="2022-10-05T15:00:30.810" v="2026" actId="164"/>
          <ac:picMkLst>
            <pc:docMk/>
            <pc:sldMk cId="2498213667" sldId="299"/>
            <ac:picMk id="6" creationId="{2BCE7DFC-8741-815D-A3B6-292EA4C73E95}"/>
          </ac:picMkLst>
        </pc:picChg>
        <pc:picChg chg="mod">
          <ac:chgData name="Kumar, Vinod" userId="a0710a6e-bffc-4971-8893-1c23addeb5b0" providerId="ADAL" clId="{3DFB5C1F-603B-4A37-8293-00F35C08F293}" dt="2022-10-05T15:00:37.283" v="2027" actId="164"/>
          <ac:picMkLst>
            <pc:docMk/>
            <pc:sldMk cId="2498213667" sldId="299"/>
            <ac:picMk id="7" creationId="{57223056-72AA-174F-6FA9-350A01BC7733}"/>
          </ac:picMkLst>
        </pc:picChg>
        <pc:picChg chg="mod">
          <ac:chgData name="Kumar, Vinod" userId="a0710a6e-bffc-4971-8893-1c23addeb5b0" providerId="ADAL" clId="{3DFB5C1F-603B-4A37-8293-00F35C08F293}" dt="2022-10-05T15:01:12.519" v="2087" actId="164"/>
          <ac:picMkLst>
            <pc:docMk/>
            <pc:sldMk cId="2498213667" sldId="299"/>
            <ac:picMk id="8" creationId="{515372DD-085A-0CAC-9F58-3C8B198EACA0}"/>
          </ac:picMkLst>
        </pc:picChg>
        <pc:picChg chg="mod">
          <ac:chgData name="Kumar, Vinod" userId="a0710a6e-bffc-4971-8893-1c23addeb5b0" providerId="ADAL" clId="{3DFB5C1F-603B-4A37-8293-00F35C08F293}" dt="2022-10-05T15:01:00.994" v="2080" actId="1035"/>
          <ac:picMkLst>
            <pc:docMk/>
            <pc:sldMk cId="2498213667" sldId="299"/>
            <ac:picMk id="9" creationId="{E2D174D9-69F4-0136-FA01-1EBB88CC9824}"/>
          </ac:picMkLst>
        </pc:picChg>
        <pc:picChg chg="mod">
          <ac:chgData name="Kumar, Vinod" userId="a0710a6e-bffc-4971-8893-1c23addeb5b0" providerId="ADAL" clId="{3DFB5C1F-603B-4A37-8293-00F35C08F293}" dt="2022-10-05T14:56:11.621" v="1850" actId="1036"/>
          <ac:picMkLst>
            <pc:docMk/>
            <pc:sldMk cId="2498213667" sldId="299"/>
            <ac:picMk id="10" creationId="{C485C2EA-332D-FE9B-351D-AACA7B21C507}"/>
          </ac:picMkLst>
        </pc:picChg>
        <pc:picChg chg="mod">
          <ac:chgData name="Kumar, Vinod" userId="a0710a6e-bffc-4971-8893-1c23addeb5b0" providerId="ADAL" clId="{3DFB5C1F-603B-4A37-8293-00F35C08F293}" dt="2022-10-05T14:59:54.435" v="2006" actId="1036"/>
          <ac:picMkLst>
            <pc:docMk/>
            <pc:sldMk cId="2498213667" sldId="299"/>
            <ac:picMk id="11" creationId="{BBC8BE26-CE50-0E7B-5B74-3DABE34015C5}"/>
          </ac:picMkLst>
        </pc:picChg>
        <pc:cxnChg chg="add del mod">
          <ac:chgData name="Kumar, Vinod" userId="a0710a6e-bffc-4971-8893-1c23addeb5b0" providerId="ADAL" clId="{3DFB5C1F-603B-4A37-8293-00F35C08F293}" dt="2022-10-05T15:03:49.478" v="2141" actId="21"/>
          <ac:cxnSpMkLst>
            <pc:docMk/>
            <pc:sldMk cId="2498213667" sldId="299"/>
            <ac:cxnSpMk id="21" creationId="{438BD805-E3AB-0D86-B976-C74534E789BF}"/>
          </ac:cxnSpMkLst>
        </pc:cxnChg>
      </pc:sldChg>
      <pc:sldChg chg="addSp delSp modSp mod">
        <pc:chgData name="Kumar, Vinod" userId="a0710a6e-bffc-4971-8893-1c23addeb5b0" providerId="ADAL" clId="{3DFB5C1F-603B-4A37-8293-00F35C08F293}" dt="2022-10-10T18:43:55.773" v="3030" actId="1038"/>
        <pc:sldMkLst>
          <pc:docMk/>
          <pc:sldMk cId="2313405284" sldId="300"/>
        </pc:sldMkLst>
        <pc:spChg chg="mod">
          <ac:chgData name="Kumar, Vinod" userId="a0710a6e-bffc-4971-8893-1c23addeb5b0" providerId="ADAL" clId="{3DFB5C1F-603B-4A37-8293-00F35C08F293}" dt="2022-10-05T15:10:55.438" v="2711" actId="1035"/>
          <ac:spMkLst>
            <pc:docMk/>
            <pc:sldMk cId="2313405284" sldId="300"/>
            <ac:spMk id="11" creationId="{C64871AB-6521-A550-17B9-FEE41DAD3B8D}"/>
          </ac:spMkLst>
        </pc:spChg>
        <pc:spChg chg="mod">
          <ac:chgData name="Kumar, Vinod" userId="a0710a6e-bffc-4971-8893-1c23addeb5b0" providerId="ADAL" clId="{3DFB5C1F-603B-4A37-8293-00F35C08F293}" dt="2022-10-05T15:10:55.438" v="2711" actId="1035"/>
          <ac:spMkLst>
            <pc:docMk/>
            <pc:sldMk cId="2313405284" sldId="300"/>
            <ac:spMk id="12" creationId="{DE106EEB-BEC0-DFC6-0302-FA2E623AEC2C}"/>
          </ac:spMkLst>
        </pc:spChg>
        <pc:spChg chg="mod">
          <ac:chgData name="Kumar, Vinod" userId="a0710a6e-bffc-4971-8893-1c23addeb5b0" providerId="ADAL" clId="{3DFB5C1F-603B-4A37-8293-00F35C08F293}" dt="2022-10-05T15:11:17.454" v="2721" actId="1036"/>
          <ac:spMkLst>
            <pc:docMk/>
            <pc:sldMk cId="2313405284" sldId="300"/>
            <ac:spMk id="13" creationId="{8933CC69-5A26-CFFF-CDF2-7629C88162CC}"/>
          </ac:spMkLst>
        </pc:spChg>
        <pc:spChg chg="mod">
          <ac:chgData name="Kumar, Vinod" userId="a0710a6e-bffc-4971-8893-1c23addeb5b0" providerId="ADAL" clId="{3DFB5C1F-603B-4A37-8293-00F35C08F293}" dt="2022-10-05T15:11:11.870" v="2718" actId="1035"/>
          <ac:spMkLst>
            <pc:docMk/>
            <pc:sldMk cId="2313405284" sldId="300"/>
            <ac:spMk id="14" creationId="{500AC389-8A93-6C81-C33A-970A6A288B38}"/>
          </ac:spMkLst>
        </pc:spChg>
        <pc:spChg chg="mod">
          <ac:chgData name="Kumar, Vinod" userId="a0710a6e-bffc-4971-8893-1c23addeb5b0" providerId="ADAL" clId="{3DFB5C1F-603B-4A37-8293-00F35C08F293}" dt="2022-10-05T15:12:06.173" v="2783" actId="1036"/>
          <ac:spMkLst>
            <pc:docMk/>
            <pc:sldMk cId="2313405284" sldId="300"/>
            <ac:spMk id="15" creationId="{12E43E6A-BC7F-1E66-77AD-0D7CCFDBED82}"/>
          </ac:spMkLst>
        </pc:spChg>
        <pc:spChg chg="mod">
          <ac:chgData name="Kumar, Vinod" userId="a0710a6e-bffc-4971-8893-1c23addeb5b0" providerId="ADAL" clId="{3DFB5C1F-603B-4A37-8293-00F35C08F293}" dt="2022-10-05T15:11:52.205" v="2764" actId="1036"/>
          <ac:spMkLst>
            <pc:docMk/>
            <pc:sldMk cId="2313405284" sldId="300"/>
            <ac:spMk id="16" creationId="{F7E78BC5-387C-1374-456C-397866B099A1}"/>
          </ac:spMkLst>
        </pc:spChg>
        <pc:spChg chg="add mod">
          <ac:chgData name="Kumar, Vinod" userId="a0710a6e-bffc-4971-8893-1c23addeb5b0" providerId="ADAL" clId="{3DFB5C1F-603B-4A37-8293-00F35C08F293}" dt="2022-10-05T15:09:15.597" v="2501" actId="164"/>
          <ac:spMkLst>
            <pc:docMk/>
            <pc:sldMk cId="2313405284" sldId="300"/>
            <ac:spMk id="20" creationId="{24400196-BCAC-9BA2-4B49-9C0650D949FE}"/>
          </ac:spMkLst>
        </pc:spChg>
        <pc:spChg chg="add mod">
          <ac:chgData name="Kumar, Vinod" userId="a0710a6e-bffc-4971-8893-1c23addeb5b0" providerId="ADAL" clId="{3DFB5C1F-603B-4A37-8293-00F35C08F293}" dt="2022-10-05T15:09:06.999" v="2500" actId="164"/>
          <ac:spMkLst>
            <pc:docMk/>
            <pc:sldMk cId="2313405284" sldId="300"/>
            <ac:spMk id="21" creationId="{5CC265AF-7197-6A73-CFD5-2B69A8F31CE8}"/>
          </ac:spMkLst>
        </pc:spChg>
        <pc:spChg chg="add mod">
          <ac:chgData name="Kumar, Vinod" userId="a0710a6e-bffc-4971-8893-1c23addeb5b0" providerId="ADAL" clId="{3DFB5C1F-603B-4A37-8293-00F35C08F293}" dt="2022-10-05T15:11:40.157" v="2757" actId="1036"/>
          <ac:spMkLst>
            <pc:docMk/>
            <pc:sldMk cId="2313405284" sldId="300"/>
            <ac:spMk id="22" creationId="{3E43CA10-C496-3957-DE7D-2FE5CADA6483}"/>
          </ac:spMkLst>
        </pc:spChg>
        <pc:spChg chg="add mod">
          <ac:chgData name="Kumar, Vinod" userId="a0710a6e-bffc-4971-8893-1c23addeb5b0" providerId="ADAL" clId="{3DFB5C1F-603B-4A37-8293-00F35C08F293}" dt="2022-10-05T15:08:54.911" v="2498" actId="164"/>
          <ac:spMkLst>
            <pc:docMk/>
            <pc:sldMk cId="2313405284" sldId="300"/>
            <ac:spMk id="23" creationId="{7ACFDAD4-CFAE-4293-2D1E-2E7069303D0D}"/>
          </ac:spMkLst>
        </pc:spChg>
        <pc:spChg chg="add mod">
          <ac:chgData name="Kumar, Vinod" userId="a0710a6e-bffc-4971-8893-1c23addeb5b0" providerId="ADAL" clId="{3DFB5C1F-603B-4A37-8293-00F35C08F293}" dt="2022-10-05T15:08:50.189" v="2497" actId="164"/>
          <ac:spMkLst>
            <pc:docMk/>
            <pc:sldMk cId="2313405284" sldId="300"/>
            <ac:spMk id="24" creationId="{E2F78356-5DC0-07EC-252C-29848BFBDEBE}"/>
          </ac:spMkLst>
        </pc:spChg>
        <pc:spChg chg="add mod">
          <ac:chgData name="Kumar, Vinod" userId="a0710a6e-bffc-4971-8893-1c23addeb5b0" providerId="ADAL" clId="{3DFB5C1F-603B-4A37-8293-00F35C08F293}" dt="2022-10-05T15:08:43.093" v="2496" actId="164"/>
          <ac:spMkLst>
            <pc:docMk/>
            <pc:sldMk cId="2313405284" sldId="300"/>
            <ac:spMk id="25" creationId="{203104D2-55F4-ADA5-9E39-AC4196EBFDF5}"/>
          </ac:spMkLst>
        </pc:spChg>
        <pc:spChg chg="add mod">
          <ac:chgData name="Kumar, Vinod" userId="a0710a6e-bffc-4971-8893-1c23addeb5b0" providerId="ADAL" clId="{3DFB5C1F-603B-4A37-8293-00F35C08F293}" dt="2022-10-05T15:09:59.748" v="2697" actId="164"/>
          <ac:spMkLst>
            <pc:docMk/>
            <pc:sldMk cId="2313405284" sldId="300"/>
            <ac:spMk id="32" creationId="{D5BC2E56-2E3E-36E3-0FA3-67C96EA49A89}"/>
          </ac:spMkLst>
        </pc:spChg>
        <pc:spChg chg="add mod">
          <ac:chgData name="Kumar, Vinod" userId="a0710a6e-bffc-4971-8893-1c23addeb5b0" providerId="ADAL" clId="{3DFB5C1F-603B-4A37-8293-00F35C08F293}" dt="2022-10-05T15:10:08.983" v="2698" actId="164"/>
          <ac:spMkLst>
            <pc:docMk/>
            <pc:sldMk cId="2313405284" sldId="300"/>
            <ac:spMk id="33" creationId="{F92D989F-07E3-DF99-0F1C-AE47DC3163C0}"/>
          </ac:spMkLst>
        </pc:spChg>
        <pc:grpChg chg="add mod">
          <ac:chgData name="Kumar, Vinod" userId="a0710a6e-bffc-4971-8893-1c23addeb5b0" providerId="ADAL" clId="{3DFB5C1F-603B-4A37-8293-00F35C08F293}" dt="2022-10-05T15:12:25.853" v="2824" actId="1035"/>
          <ac:grpSpMkLst>
            <pc:docMk/>
            <pc:sldMk cId="2313405284" sldId="300"/>
            <ac:grpSpMk id="26" creationId="{54B17F00-0356-0926-27BE-A8E46FD045E6}"/>
          </ac:grpSpMkLst>
        </pc:grpChg>
        <pc:grpChg chg="add mod">
          <ac:chgData name="Kumar, Vinod" userId="a0710a6e-bffc-4971-8893-1c23addeb5b0" providerId="ADAL" clId="{3DFB5C1F-603B-4A37-8293-00F35C08F293}" dt="2022-10-10T18:43:55.773" v="3030" actId="1038"/>
          <ac:grpSpMkLst>
            <pc:docMk/>
            <pc:sldMk cId="2313405284" sldId="300"/>
            <ac:grpSpMk id="27" creationId="{D0B6DC18-3449-5500-FA84-0BB5842C8EE1}"/>
          </ac:grpSpMkLst>
        </pc:grpChg>
        <pc:grpChg chg="add mod">
          <ac:chgData name="Kumar, Vinod" userId="a0710a6e-bffc-4971-8893-1c23addeb5b0" providerId="ADAL" clId="{3DFB5C1F-603B-4A37-8293-00F35C08F293}" dt="2022-10-05T15:08:54.911" v="2498" actId="164"/>
          <ac:grpSpMkLst>
            <pc:docMk/>
            <pc:sldMk cId="2313405284" sldId="300"/>
            <ac:grpSpMk id="28" creationId="{58024AC3-3CAA-AE70-9F80-D889D4427085}"/>
          </ac:grpSpMkLst>
        </pc:grpChg>
        <pc:grpChg chg="add mod">
          <ac:chgData name="Kumar, Vinod" userId="a0710a6e-bffc-4971-8893-1c23addeb5b0" providerId="ADAL" clId="{3DFB5C1F-603B-4A37-8293-00F35C08F293}" dt="2022-10-05T15:08:59.949" v="2499" actId="164"/>
          <ac:grpSpMkLst>
            <pc:docMk/>
            <pc:sldMk cId="2313405284" sldId="300"/>
            <ac:grpSpMk id="29" creationId="{04B2C1A9-EB0C-406C-9E17-296446427152}"/>
          </ac:grpSpMkLst>
        </pc:grpChg>
        <pc:grpChg chg="add mod">
          <ac:chgData name="Kumar, Vinod" userId="a0710a6e-bffc-4971-8893-1c23addeb5b0" providerId="ADAL" clId="{3DFB5C1F-603B-4A37-8293-00F35C08F293}" dt="2022-10-05T15:09:06.999" v="2500" actId="164"/>
          <ac:grpSpMkLst>
            <pc:docMk/>
            <pc:sldMk cId="2313405284" sldId="300"/>
            <ac:grpSpMk id="30" creationId="{D49AB123-0B24-44D0-BBEC-64F7DAD6605F}"/>
          </ac:grpSpMkLst>
        </pc:grpChg>
        <pc:grpChg chg="add mod">
          <ac:chgData name="Kumar, Vinod" userId="a0710a6e-bffc-4971-8893-1c23addeb5b0" providerId="ADAL" clId="{3DFB5C1F-603B-4A37-8293-00F35C08F293}" dt="2022-10-05T15:09:23.054" v="2510" actId="1037"/>
          <ac:grpSpMkLst>
            <pc:docMk/>
            <pc:sldMk cId="2313405284" sldId="300"/>
            <ac:grpSpMk id="31" creationId="{FFA80ACD-6E47-C912-D959-62C82A221811}"/>
          </ac:grpSpMkLst>
        </pc:grpChg>
        <pc:grpChg chg="add mod">
          <ac:chgData name="Kumar, Vinod" userId="a0710a6e-bffc-4971-8893-1c23addeb5b0" providerId="ADAL" clId="{3DFB5C1F-603B-4A37-8293-00F35C08F293}" dt="2022-10-05T15:09:59.748" v="2697" actId="164"/>
          <ac:grpSpMkLst>
            <pc:docMk/>
            <pc:sldMk cId="2313405284" sldId="300"/>
            <ac:grpSpMk id="34" creationId="{5A7F8E08-0902-36DF-CC2A-98D5D838096B}"/>
          </ac:grpSpMkLst>
        </pc:grpChg>
        <pc:grpChg chg="add mod">
          <ac:chgData name="Kumar, Vinod" userId="a0710a6e-bffc-4971-8893-1c23addeb5b0" providerId="ADAL" clId="{3DFB5C1F-603B-4A37-8293-00F35C08F293}" dt="2022-10-05T15:10:40.845" v="2709" actId="1035"/>
          <ac:grpSpMkLst>
            <pc:docMk/>
            <pc:sldMk cId="2313405284" sldId="300"/>
            <ac:grpSpMk id="35" creationId="{48D14474-21BE-E3B9-27B2-6A46B84D7BB6}"/>
          </ac:grpSpMkLst>
        </pc:grpChg>
        <pc:picChg chg="mod">
          <ac:chgData name="Kumar, Vinod" userId="a0710a6e-bffc-4971-8893-1c23addeb5b0" providerId="ADAL" clId="{3DFB5C1F-603B-4A37-8293-00F35C08F293}" dt="2022-10-05T15:09:15.597" v="2501" actId="164"/>
          <ac:picMkLst>
            <pc:docMk/>
            <pc:sldMk cId="2313405284" sldId="300"/>
            <ac:picMk id="3" creationId="{29DD6D63-398D-9D2D-9E3E-6E0239244671}"/>
          </ac:picMkLst>
        </pc:picChg>
        <pc:picChg chg="mod">
          <ac:chgData name="Kumar, Vinod" userId="a0710a6e-bffc-4971-8893-1c23addeb5b0" providerId="ADAL" clId="{3DFB5C1F-603B-4A37-8293-00F35C08F293}" dt="2022-10-05T15:09:06.999" v="2500" actId="164"/>
          <ac:picMkLst>
            <pc:docMk/>
            <pc:sldMk cId="2313405284" sldId="300"/>
            <ac:picMk id="4" creationId="{0E6A30FA-1FCE-8E20-3A3D-C9977710E422}"/>
          </ac:picMkLst>
        </pc:picChg>
        <pc:picChg chg="mod">
          <ac:chgData name="Kumar, Vinod" userId="a0710a6e-bffc-4971-8893-1c23addeb5b0" providerId="ADAL" clId="{3DFB5C1F-603B-4A37-8293-00F35C08F293}" dt="2022-10-05T15:08:54.911" v="2498" actId="164"/>
          <ac:picMkLst>
            <pc:docMk/>
            <pc:sldMk cId="2313405284" sldId="300"/>
            <ac:picMk id="5" creationId="{E571617C-7D69-5378-001F-634F214B4A17}"/>
          </ac:picMkLst>
        </pc:picChg>
        <pc:picChg chg="mod">
          <ac:chgData name="Kumar, Vinod" userId="a0710a6e-bffc-4971-8893-1c23addeb5b0" providerId="ADAL" clId="{3DFB5C1F-603B-4A37-8293-00F35C08F293}" dt="2022-10-05T15:08:59.949" v="2499" actId="164"/>
          <ac:picMkLst>
            <pc:docMk/>
            <pc:sldMk cId="2313405284" sldId="300"/>
            <ac:picMk id="6" creationId="{54C9136E-B2EE-713C-206F-528275B3E923}"/>
          </ac:picMkLst>
        </pc:picChg>
        <pc:picChg chg="mod">
          <ac:chgData name="Kumar, Vinod" userId="a0710a6e-bffc-4971-8893-1c23addeb5b0" providerId="ADAL" clId="{3DFB5C1F-603B-4A37-8293-00F35C08F293}" dt="2022-10-05T15:08:50.189" v="2497" actId="164"/>
          <ac:picMkLst>
            <pc:docMk/>
            <pc:sldMk cId="2313405284" sldId="300"/>
            <ac:picMk id="7" creationId="{F6D86FB7-83E1-07B1-6A6C-3A5DDE32D6B5}"/>
          </ac:picMkLst>
        </pc:picChg>
        <pc:picChg chg="mod">
          <ac:chgData name="Kumar, Vinod" userId="a0710a6e-bffc-4971-8893-1c23addeb5b0" providerId="ADAL" clId="{3DFB5C1F-603B-4A37-8293-00F35C08F293}" dt="2022-10-05T15:08:43.093" v="2496" actId="164"/>
          <ac:picMkLst>
            <pc:docMk/>
            <pc:sldMk cId="2313405284" sldId="300"/>
            <ac:picMk id="8" creationId="{5DF73724-2E56-FF83-751A-F90FBC4935A9}"/>
          </ac:picMkLst>
        </pc:picChg>
        <pc:picChg chg="mod">
          <ac:chgData name="Kumar, Vinod" userId="a0710a6e-bffc-4971-8893-1c23addeb5b0" providerId="ADAL" clId="{3DFB5C1F-603B-4A37-8293-00F35C08F293}" dt="2022-10-05T15:10:08.983" v="2698" actId="164"/>
          <ac:picMkLst>
            <pc:docMk/>
            <pc:sldMk cId="2313405284" sldId="300"/>
            <ac:picMk id="9" creationId="{BA586AAC-EA6F-0435-4C2A-DF34082B0031}"/>
          </ac:picMkLst>
        </pc:picChg>
        <pc:picChg chg="mod">
          <ac:chgData name="Kumar, Vinod" userId="a0710a6e-bffc-4971-8893-1c23addeb5b0" providerId="ADAL" clId="{3DFB5C1F-603B-4A37-8293-00F35C08F293}" dt="2022-10-05T15:09:59.748" v="2697" actId="164"/>
          <ac:picMkLst>
            <pc:docMk/>
            <pc:sldMk cId="2313405284" sldId="300"/>
            <ac:picMk id="10" creationId="{50E22F7A-0AEA-69B1-4EBE-B57F9FBCB1F1}"/>
          </ac:picMkLst>
        </pc:picChg>
        <pc:cxnChg chg="add del mod">
          <ac:chgData name="Kumar, Vinod" userId="a0710a6e-bffc-4971-8893-1c23addeb5b0" providerId="ADAL" clId="{3DFB5C1F-603B-4A37-8293-00F35C08F293}" dt="2022-10-05T15:14:20.192" v="2825" actId="21"/>
          <ac:cxnSpMkLst>
            <pc:docMk/>
            <pc:sldMk cId="2313405284" sldId="300"/>
            <ac:cxnSpMk id="19" creationId="{9E34890F-CE7A-DD95-E7D6-D03C77C6FF7C}"/>
          </ac:cxnSpMkLst>
        </pc:cxnChg>
      </pc:sldChg>
      <pc:sldChg chg="addSp delSp modSp mod">
        <pc:chgData name="Kumar, Vinod" userId="a0710a6e-bffc-4971-8893-1c23addeb5b0" providerId="ADAL" clId="{3DFB5C1F-603B-4A37-8293-00F35C08F293}" dt="2022-10-05T15:16:41.450" v="2869" actId="478"/>
        <pc:sldMkLst>
          <pc:docMk/>
          <pc:sldMk cId="1906182640" sldId="301"/>
        </pc:sldMkLst>
        <pc:picChg chg="mod">
          <ac:chgData name="Kumar, Vinod" userId="a0710a6e-bffc-4971-8893-1c23addeb5b0" providerId="ADAL" clId="{3DFB5C1F-603B-4A37-8293-00F35C08F293}" dt="2022-10-05T15:15:15.851" v="2834" actId="1038"/>
          <ac:picMkLst>
            <pc:docMk/>
            <pc:sldMk cId="1906182640" sldId="301"/>
            <ac:picMk id="3" creationId="{F450301E-C110-A500-66DC-9DFF82D67E68}"/>
          </ac:picMkLst>
        </pc:picChg>
        <pc:picChg chg="mod">
          <ac:chgData name="Kumar, Vinod" userId="a0710a6e-bffc-4971-8893-1c23addeb5b0" providerId="ADAL" clId="{3DFB5C1F-603B-4A37-8293-00F35C08F293}" dt="2022-10-05T15:16:12.378" v="2855" actId="1038"/>
          <ac:picMkLst>
            <pc:docMk/>
            <pc:sldMk cId="1906182640" sldId="301"/>
            <ac:picMk id="6" creationId="{C2BE8F1A-3A90-90F3-8262-6BC91AEC0EEA}"/>
          </ac:picMkLst>
        </pc:picChg>
        <pc:picChg chg="mod">
          <ac:chgData name="Kumar, Vinod" userId="a0710a6e-bffc-4971-8893-1c23addeb5b0" providerId="ADAL" clId="{3DFB5C1F-603B-4A37-8293-00F35C08F293}" dt="2022-10-05T15:16:37.226" v="2868" actId="1038"/>
          <ac:picMkLst>
            <pc:docMk/>
            <pc:sldMk cId="1906182640" sldId="301"/>
            <ac:picMk id="7" creationId="{DDC91D9D-B267-6A98-49A0-7F314A8D786B}"/>
          </ac:picMkLst>
        </pc:picChg>
        <pc:cxnChg chg="add del mod">
          <ac:chgData name="Kumar, Vinod" userId="a0710a6e-bffc-4971-8893-1c23addeb5b0" providerId="ADAL" clId="{3DFB5C1F-603B-4A37-8293-00F35C08F293}" dt="2022-10-05T15:16:41.450" v="2869" actId="478"/>
          <ac:cxnSpMkLst>
            <pc:docMk/>
            <pc:sldMk cId="1906182640" sldId="301"/>
            <ac:cxnSpMk id="8" creationId="{88B2B804-1D6C-830A-A9FE-CE9D42C39C04}"/>
          </ac:cxnSpMkLst>
        </pc:cxnChg>
      </pc:sldChg>
      <pc:sldChg chg="addSp delSp modSp mod">
        <pc:chgData name="Kumar, Vinod" userId="a0710a6e-bffc-4971-8893-1c23addeb5b0" providerId="ADAL" clId="{3DFB5C1F-603B-4A37-8293-00F35C08F293}" dt="2022-10-14T15:18:56.766" v="3270" actId="20577"/>
        <pc:sldMkLst>
          <pc:docMk/>
          <pc:sldMk cId="2794359920" sldId="303"/>
        </pc:sldMkLst>
        <pc:spChg chg="mod topLvl">
          <ac:chgData name="Kumar, Vinod" userId="a0710a6e-bffc-4971-8893-1c23addeb5b0" providerId="ADAL" clId="{3DFB5C1F-603B-4A37-8293-00F35C08F293}" dt="2022-10-05T14:25:03.291" v="482" actId="164"/>
          <ac:spMkLst>
            <pc:docMk/>
            <pc:sldMk cId="2794359920" sldId="303"/>
            <ac:spMk id="4" creationId="{34897CEC-8788-4E23-A2EB-129E341C1E2C}"/>
          </ac:spMkLst>
        </pc:spChg>
        <pc:spChg chg="mod topLvl">
          <ac:chgData name="Kumar, Vinod" userId="a0710a6e-bffc-4971-8893-1c23addeb5b0" providerId="ADAL" clId="{3DFB5C1F-603B-4A37-8293-00F35C08F293}" dt="2022-10-05T14:25:03.291" v="482" actId="164"/>
          <ac:spMkLst>
            <pc:docMk/>
            <pc:sldMk cId="2794359920" sldId="303"/>
            <ac:spMk id="5" creationId="{EBE000ED-B1A1-3050-3231-53F952EF004E}"/>
          </ac:spMkLst>
        </pc:spChg>
        <pc:spChg chg="mod topLvl">
          <ac:chgData name="Kumar, Vinod" userId="a0710a6e-bffc-4971-8893-1c23addeb5b0" providerId="ADAL" clId="{3DFB5C1F-603B-4A37-8293-00F35C08F293}" dt="2022-10-05T14:25:03.291" v="482" actId="164"/>
          <ac:spMkLst>
            <pc:docMk/>
            <pc:sldMk cId="2794359920" sldId="303"/>
            <ac:spMk id="6" creationId="{D598E17B-EB7B-D68E-071E-EAF0ECE784BD}"/>
          </ac:spMkLst>
        </pc:spChg>
        <pc:spChg chg="mod topLvl">
          <ac:chgData name="Kumar, Vinod" userId="a0710a6e-bffc-4971-8893-1c23addeb5b0" providerId="ADAL" clId="{3DFB5C1F-603B-4A37-8293-00F35C08F293}" dt="2022-10-05T14:25:03.291" v="482" actId="164"/>
          <ac:spMkLst>
            <pc:docMk/>
            <pc:sldMk cId="2794359920" sldId="303"/>
            <ac:spMk id="7" creationId="{B6E398F8-4570-6114-9D17-E136BFDC1614}"/>
          </ac:spMkLst>
        </pc:spChg>
        <pc:spChg chg="mod topLvl">
          <ac:chgData name="Kumar, Vinod" userId="a0710a6e-bffc-4971-8893-1c23addeb5b0" providerId="ADAL" clId="{3DFB5C1F-603B-4A37-8293-00F35C08F293}" dt="2022-10-05T14:25:03.291" v="482" actId="164"/>
          <ac:spMkLst>
            <pc:docMk/>
            <pc:sldMk cId="2794359920" sldId="303"/>
            <ac:spMk id="8" creationId="{8B182684-1A9D-EEA6-5871-DD72E987E31A}"/>
          </ac:spMkLst>
        </pc:spChg>
        <pc:spChg chg="mod topLvl">
          <ac:chgData name="Kumar, Vinod" userId="a0710a6e-bffc-4971-8893-1c23addeb5b0" providerId="ADAL" clId="{3DFB5C1F-603B-4A37-8293-00F35C08F293}" dt="2022-10-05T14:25:03.291" v="482" actId="164"/>
          <ac:spMkLst>
            <pc:docMk/>
            <pc:sldMk cId="2794359920" sldId="303"/>
            <ac:spMk id="9" creationId="{B5482599-9DD0-C32C-1446-5E037C93065E}"/>
          </ac:spMkLst>
        </pc:spChg>
        <pc:spChg chg="mod topLvl">
          <ac:chgData name="Kumar, Vinod" userId="a0710a6e-bffc-4971-8893-1c23addeb5b0" providerId="ADAL" clId="{3DFB5C1F-603B-4A37-8293-00F35C08F293}" dt="2022-10-05T14:25:03.291" v="482" actId="164"/>
          <ac:spMkLst>
            <pc:docMk/>
            <pc:sldMk cId="2794359920" sldId="303"/>
            <ac:spMk id="10" creationId="{F88FF6F7-3F90-A2CD-FEF6-B15AC9DE672B}"/>
          </ac:spMkLst>
        </pc:spChg>
        <pc:spChg chg="mod topLvl">
          <ac:chgData name="Kumar, Vinod" userId="a0710a6e-bffc-4971-8893-1c23addeb5b0" providerId="ADAL" clId="{3DFB5C1F-603B-4A37-8293-00F35C08F293}" dt="2022-10-05T14:25:03.291" v="482" actId="164"/>
          <ac:spMkLst>
            <pc:docMk/>
            <pc:sldMk cId="2794359920" sldId="303"/>
            <ac:spMk id="15" creationId="{F91BF159-A8AB-AE76-1D16-1E285CB2F48B}"/>
          </ac:spMkLst>
        </pc:spChg>
        <pc:spChg chg="mod topLvl">
          <ac:chgData name="Kumar, Vinod" userId="a0710a6e-bffc-4971-8893-1c23addeb5b0" providerId="ADAL" clId="{3DFB5C1F-603B-4A37-8293-00F35C08F293}" dt="2022-10-05T14:24:45.261" v="481" actId="165"/>
          <ac:spMkLst>
            <pc:docMk/>
            <pc:sldMk cId="2794359920" sldId="303"/>
            <ac:spMk id="16" creationId="{D0745951-7BFA-ACAA-D3B9-F109297E6D86}"/>
          </ac:spMkLst>
        </pc:spChg>
        <pc:spChg chg="mod topLvl">
          <ac:chgData name="Kumar, Vinod" userId="a0710a6e-bffc-4971-8893-1c23addeb5b0" providerId="ADAL" clId="{3DFB5C1F-603B-4A37-8293-00F35C08F293}" dt="2022-10-05T14:25:03.291" v="482" actId="164"/>
          <ac:spMkLst>
            <pc:docMk/>
            <pc:sldMk cId="2794359920" sldId="303"/>
            <ac:spMk id="18" creationId="{6BDF7E7D-EC93-091B-3714-48C043BEAA7B}"/>
          </ac:spMkLst>
        </pc:spChg>
        <pc:spChg chg="add mod">
          <ac:chgData name="Kumar, Vinod" userId="a0710a6e-bffc-4971-8893-1c23addeb5b0" providerId="ADAL" clId="{3DFB5C1F-603B-4A37-8293-00F35C08F293}" dt="2022-10-14T15:18:53.550" v="3269" actId="20577"/>
          <ac:spMkLst>
            <pc:docMk/>
            <pc:sldMk cId="2794359920" sldId="303"/>
            <ac:spMk id="21" creationId="{D7D88FA0-6D0C-96BF-6837-CE8C7D2C18F7}"/>
          </ac:spMkLst>
        </pc:spChg>
        <pc:spChg chg="add mod">
          <ac:chgData name="Kumar, Vinod" userId="a0710a6e-bffc-4971-8893-1c23addeb5b0" providerId="ADAL" clId="{3DFB5C1F-603B-4A37-8293-00F35C08F293}" dt="2022-10-14T15:18:56.766" v="3270" actId="20577"/>
          <ac:spMkLst>
            <pc:docMk/>
            <pc:sldMk cId="2794359920" sldId="303"/>
            <ac:spMk id="22" creationId="{56DBA533-46D5-F4DE-11B3-F9F694AA03DD}"/>
          </ac:spMkLst>
        </pc:spChg>
        <pc:spChg chg="add mod">
          <ac:chgData name="Kumar, Vinod" userId="a0710a6e-bffc-4971-8893-1c23addeb5b0" providerId="ADAL" clId="{3DFB5C1F-603B-4A37-8293-00F35C08F293}" dt="2022-10-14T15:18:49.389" v="3268" actId="20577"/>
          <ac:spMkLst>
            <pc:docMk/>
            <pc:sldMk cId="2794359920" sldId="303"/>
            <ac:spMk id="24" creationId="{B6986ADE-E594-2EB1-24CD-9A678E12DE2C}"/>
          </ac:spMkLst>
        </pc:spChg>
        <pc:grpChg chg="del">
          <ac:chgData name="Kumar, Vinod" userId="a0710a6e-bffc-4971-8893-1c23addeb5b0" providerId="ADAL" clId="{3DFB5C1F-603B-4A37-8293-00F35C08F293}" dt="2022-10-05T14:24:45.261" v="481" actId="165"/>
          <ac:grpSpMkLst>
            <pc:docMk/>
            <pc:sldMk cId="2794359920" sldId="303"/>
            <ac:grpSpMk id="3" creationId="{70B0986A-4D6C-049C-C1CF-F0F78EBD7BD5}"/>
          </ac:grpSpMkLst>
        </pc:grpChg>
        <pc:grpChg chg="add mod">
          <ac:chgData name="Kumar, Vinod" userId="a0710a6e-bffc-4971-8893-1c23addeb5b0" providerId="ADAL" clId="{3DFB5C1F-603B-4A37-8293-00F35C08F293}" dt="2022-10-05T14:25:03.291" v="482" actId="164"/>
          <ac:grpSpMkLst>
            <pc:docMk/>
            <pc:sldMk cId="2794359920" sldId="303"/>
            <ac:grpSpMk id="23" creationId="{90B82DBD-4CF5-CAF2-9597-A015FE84D9BA}"/>
          </ac:grpSpMkLst>
        </pc:grpChg>
        <pc:picChg chg="add mod">
          <ac:chgData name="Kumar, Vinod" userId="a0710a6e-bffc-4971-8893-1c23addeb5b0" providerId="ADAL" clId="{3DFB5C1F-603B-4A37-8293-00F35C08F293}" dt="2022-10-14T15:18:26.941" v="3202" actId="1038"/>
          <ac:picMkLst>
            <pc:docMk/>
            <pc:sldMk cId="2794359920" sldId="303"/>
            <ac:picMk id="3" creationId="{10BF6C55-B762-3746-CE36-9162113619D0}"/>
          </ac:picMkLst>
        </pc:picChg>
        <pc:picChg chg="mod topLvl">
          <ac:chgData name="Kumar, Vinod" userId="a0710a6e-bffc-4971-8893-1c23addeb5b0" providerId="ADAL" clId="{3DFB5C1F-603B-4A37-8293-00F35C08F293}" dt="2022-10-05T14:25:03.291" v="482" actId="164"/>
          <ac:picMkLst>
            <pc:docMk/>
            <pc:sldMk cId="2794359920" sldId="303"/>
            <ac:picMk id="11" creationId="{548D93EB-C38F-65EF-4A59-4F410E66F21E}"/>
          </ac:picMkLst>
        </pc:picChg>
        <pc:picChg chg="mod topLvl">
          <ac:chgData name="Kumar, Vinod" userId="a0710a6e-bffc-4971-8893-1c23addeb5b0" providerId="ADAL" clId="{3DFB5C1F-603B-4A37-8293-00F35C08F293}" dt="2022-10-05T14:25:03.291" v="482" actId="164"/>
          <ac:picMkLst>
            <pc:docMk/>
            <pc:sldMk cId="2794359920" sldId="303"/>
            <ac:picMk id="12" creationId="{BCF04BB9-FA09-3864-9A77-BBDBC91583A6}"/>
          </ac:picMkLst>
        </pc:picChg>
        <pc:picChg chg="mod topLvl">
          <ac:chgData name="Kumar, Vinod" userId="a0710a6e-bffc-4971-8893-1c23addeb5b0" providerId="ADAL" clId="{3DFB5C1F-603B-4A37-8293-00F35C08F293}" dt="2022-10-05T14:25:03.291" v="482" actId="164"/>
          <ac:picMkLst>
            <pc:docMk/>
            <pc:sldMk cId="2794359920" sldId="303"/>
            <ac:picMk id="17" creationId="{212EC4EF-77B3-5368-6E6B-A75EF87935BA}"/>
          </ac:picMkLst>
        </pc:picChg>
        <pc:picChg chg="add mod">
          <ac:chgData name="Kumar, Vinod" userId="a0710a6e-bffc-4971-8893-1c23addeb5b0" providerId="ADAL" clId="{3DFB5C1F-603B-4A37-8293-00F35C08F293}" dt="2022-10-14T15:18:04.012" v="3194" actId="1036"/>
          <ac:picMkLst>
            <pc:docMk/>
            <pc:sldMk cId="2794359920" sldId="303"/>
            <ac:picMk id="19" creationId="{F42524B6-CD05-7E8E-53B3-CF6EDDB555D5}"/>
          </ac:picMkLst>
        </pc:picChg>
        <pc:picChg chg="add mod">
          <ac:chgData name="Kumar, Vinod" userId="a0710a6e-bffc-4971-8893-1c23addeb5b0" providerId="ADAL" clId="{3DFB5C1F-603B-4A37-8293-00F35C08F293}" dt="2022-10-14T15:18:04.012" v="3194" actId="1036"/>
          <ac:picMkLst>
            <pc:docMk/>
            <pc:sldMk cId="2794359920" sldId="303"/>
            <ac:picMk id="20" creationId="{1357654D-64D1-2FB8-B6BD-EAD2BF1F57E5}"/>
          </ac:picMkLst>
        </pc:picChg>
        <pc:cxnChg chg="mod topLvl">
          <ac:chgData name="Kumar, Vinod" userId="a0710a6e-bffc-4971-8893-1c23addeb5b0" providerId="ADAL" clId="{3DFB5C1F-603B-4A37-8293-00F35C08F293}" dt="2022-10-05T14:25:03.291" v="482" actId="164"/>
          <ac:cxnSpMkLst>
            <pc:docMk/>
            <pc:sldMk cId="2794359920" sldId="303"/>
            <ac:cxnSpMk id="13" creationId="{7A471A29-F0CC-D035-4611-68861ABA1583}"/>
          </ac:cxnSpMkLst>
        </pc:cxnChg>
        <pc:cxnChg chg="mod topLvl">
          <ac:chgData name="Kumar, Vinod" userId="a0710a6e-bffc-4971-8893-1c23addeb5b0" providerId="ADAL" clId="{3DFB5C1F-603B-4A37-8293-00F35C08F293}" dt="2022-10-05T14:25:03.291" v="482" actId="164"/>
          <ac:cxnSpMkLst>
            <pc:docMk/>
            <pc:sldMk cId="2794359920" sldId="303"/>
            <ac:cxnSpMk id="14" creationId="{F72EE062-61B2-5D71-EE1F-16D26BC6BF5A}"/>
          </ac:cxnSpMkLst>
        </pc:cxnChg>
      </pc:sldChg>
      <pc:sldChg chg="addSp delSp modSp mod">
        <pc:chgData name="Kumar, Vinod" userId="a0710a6e-bffc-4971-8893-1c23addeb5b0" providerId="ADAL" clId="{3DFB5C1F-603B-4A37-8293-00F35C08F293}" dt="2022-10-14T15:16:25.247" v="3156" actId="478"/>
        <pc:sldMkLst>
          <pc:docMk/>
          <pc:sldMk cId="1896129938" sldId="304"/>
        </pc:sldMkLst>
        <pc:spChg chg="mod">
          <ac:chgData name="Kumar, Vinod" userId="a0710a6e-bffc-4971-8893-1c23addeb5b0" providerId="ADAL" clId="{3DFB5C1F-603B-4A37-8293-00F35C08F293}" dt="2022-10-05T14:19:01.785" v="167" actId="1036"/>
          <ac:spMkLst>
            <pc:docMk/>
            <pc:sldMk cId="1896129938" sldId="304"/>
            <ac:spMk id="13" creationId="{2F5C69FE-8BBC-D30D-1B05-F82DAA14E149}"/>
          </ac:spMkLst>
        </pc:spChg>
        <pc:spChg chg="mod">
          <ac:chgData name="Kumar, Vinod" userId="a0710a6e-bffc-4971-8893-1c23addeb5b0" providerId="ADAL" clId="{3DFB5C1F-603B-4A37-8293-00F35C08F293}" dt="2022-10-05T14:19:01.785" v="167" actId="1036"/>
          <ac:spMkLst>
            <pc:docMk/>
            <pc:sldMk cId="1896129938" sldId="304"/>
            <ac:spMk id="14" creationId="{DAB75DD1-567F-6F00-8AC6-BCC1C40187EE}"/>
          </ac:spMkLst>
        </pc:spChg>
        <pc:spChg chg="mod">
          <ac:chgData name="Kumar, Vinod" userId="a0710a6e-bffc-4971-8893-1c23addeb5b0" providerId="ADAL" clId="{3DFB5C1F-603B-4A37-8293-00F35C08F293}" dt="2022-10-05T14:23:27.302" v="405" actId="1036"/>
          <ac:spMkLst>
            <pc:docMk/>
            <pc:sldMk cId="1896129938" sldId="304"/>
            <ac:spMk id="15" creationId="{610AFE8D-6F14-0B41-CFAF-B50ED829F5E3}"/>
          </ac:spMkLst>
        </pc:spChg>
        <pc:spChg chg="mod">
          <ac:chgData name="Kumar, Vinod" userId="a0710a6e-bffc-4971-8893-1c23addeb5b0" providerId="ADAL" clId="{3DFB5C1F-603B-4A37-8293-00F35C08F293}" dt="2022-10-05T14:23:27.302" v="405" actId="1036"/>
          <ac:spMkLst>
            <pc:docMk/>
            <pc:sldMk cId="1896129938" sldId="304"/>
            <ac:spMk id="16" creationId="{4C832ACE-FAEF-F2D8-3BA1-1504FDF54A88}"/>
          </ac:spMkLst>
        </pc:spChg>
        <pc:spChg chg="mod">
          <ac:chgData name="Kumar, Vinod" userId="a0710a6e-bffc-4971-8893-1c23addeb5b0" providerId="ADAL" clId="{3DFB5C1F-603B-4A37-8293-00F35C08F293}" dt="2022-10-05T14:23:27.302" v="405" actId="1036"/>
          <ac:spMkLst>
            <pc:docMk/>
            <pc:sldMk cId="1896129938" sldId="304"/>
            <ac:spMk id="17" creationId="{4BA5D206-14F9-4C8F-570E-568E631E764E}"/>
          </ac:spMkLst>
        </pc:spChg>
        <pc:spChg chg="mod">
          <ac:chgData name="Kumar, Vinod" userId="a0710a6e-bffc-4971-8893-1c23addeb5b0" providerId="ADAL" clId="{3DFB5C1F-603B-4A37-8293-00F35C08F293}" dt="2022-10-05T14:23:15.447" v="402" actId="1036"/>
          <ac:spMkLst>
            <pc:docMk/>
            <pc:sldMk cId="1896129938" sldId="304"/>
            <ac:spMk id="18" creationId="{F868BCCD-1693-01CC-7EB6-FF78E61E1CA6}"/>
          </ac:spMkLst>
        </pc:spChg>
        <pc:spChg chg="mod">
          <ac:chgData name="Kumar, Vinod" userId="a0710a6e-bffc-4971-8893-1c23addeb5b0" providerId="ADAL" clId="{3DFB5C1F-603B-4A37-8293-00F35C08F293}" dt="2022-10-05T14:23:15.447" v="402" actId="1036"/>
          <ac:spMkLst>
            <pc:docMk/>
            <pc:sldMk cId="1896129938" sldId="304"/>
            <ac:spMk id="19" creationId="{7A6E65D4-7530-9F25-99BB-3E4A551CAB24}"/>
          </ac:spMkLst>
        </pc:spChg>
        <pc:spChg chg="del">
          <ac:chgData name="Kumar, Vinod" userId="a0710a6e-bffc-4971-8893-1c23addeb5b0" providerId="ADAL" clId="{3DFB5C1F-603B-4A37-8293-00F35C08F293}" dt="2022-10-05T14:21:19.288" v="177" actId="478"/>
          <ac:spMkLst>
            <pc:docMk/>
            <pc:sldMk cId="1896129938" sldId="304"/>
            <ac:spMk id="20" creationId="{17D19281-5FA8-2431-7654-3B702A1DB4F2}"/>
          </ac:spMkLst>
        </pc:spChg>
        <pc:spChg chg="mod">
          <ac:chgData name="Kumar, Vinod" userId="a0710a6e-bffc-4971-8893-1c23addeb5b0" providerId="ADAL" clId="{3DFB5C1F-603B-4A37-8293-00F35C08F293}" dt="2022-10-05T14:18:07.194" v="87" actId="1037"/>
          <ac:spMkLst>
            <pc:docMk/>
            <pc:sldMk cId="1896129938" sldId="304"/>
            <ac:spMk id="21" creationId="{4A1FD6FF-624A-06CB-8B80-7E181D684B98}"/>
          </ac:spMkLst>
        </pc:spChg>
        <pc:spChg chg="del mod">
          <ac:chgData name="Kumar, Vinod" userId="a0710a6e-bffc-4971-8893-1c23addeb5b0" providerId="ADAL" clId="{3DFB5C1F-603B-4A37-8293-00F35C08F293}" dt="2022-10-05T14:21:17.353" v="176" actId="478"/>
          <ac:spMkLst>
            <pc:docMk/>
            <pc:sldMk cId="1896129938" sldId="304"/>
            <ac:spMk id="22" creationId="{25C74B3F-1680-A9B4-192A-76BD7FD094F6}"/>
          </ac:spMkLst>
        </pc:spChg>
        <pc:spChg chg="mod">
          <ac:chgData name="Kumar, Vinod" userId="a0710a6e-bffc-4971-8893-1c23addeb5b0" providerId="ADAL" clId="{3DFB5C1F-603B-4A37-8293-00F35C08F293}" dt="2022-10-14T15:08:55.183" v="3032"/>
          <ac:spMkLst>
            <pc:docMk/>
            <pc:sldMk cId="1896129938" sldId="304"/>
            <ac:spMk id="24" creationId="{7368FA72-E8E3-A1D7-D26E-7B77B1DAF764}"/>
          </ac:spMkLst>
        </pc:spChg>
        <pc:spChg chg="mod">
          <ac:chgData name="Kumar, Vinod" userId="a0710a6e-bffc-4971-8893-1c23addeb5b0" providerId="ADAL" clId="{3DFB5C1F-603B-4A37-8293-00F35C08F293}" dt="2022-10-14T15:08:55.183" v="3032"/>
          <ac:spMkLst>
            <pc:docMk/>
            <pc:sldMk cId="1896129938" sldId="304"/>
            <ac:spMk id="25" creationId="{CDABF4A0-8258-C071-66DD-AE757914B22A}"/>
          </ac:spMkLst>
        </pc:spChg>
        <pc:spChg chg="mod">
          <ac:chgData name="Kumar, Vinod" userId="a0710a6e-bffc-4971-8893-1c23addeb5b0" providerId="ADAL" clId="{3DFB5C1F-603B-4A37-8293-00F35C08F293}" dt="2022-10-14T15:08:55.183" v="3032"/>
          <ac:spMkLst>
            <pc:docMk/>
            <pc:sldMk cId="1896129938" sldId="304"/>
            <ac:spMk id="26" creationId="{90E3089A-11BE-DA65-E1E0-2B4257F23075}"/>
          </ac:spMkLst>
        </pc:spChg>
        <pc:spChg chg="add mod">
          <ac:chgData name="Kumar, Vinod" userId="a0710a6e-bffc-4971-8893-1c23addeb5b0" providerId="ADAL" clId="{3DFB5C1F-603B-4A37-8293-00F35C08F293}" dt="2022-10-14T15:16:05.326" v="3152" actId="1038"/>
          <ac:spMkLst>
            <pc:docMk/>
            <pc:sldMk cId="1896129938" sldId="304"/>
            <ac:spMk id="28" creationId="{71FD448A-AC8C-9FFF-7EE9-3A4836953D7A}"/>
          </ac:spMkLst>
        </pc:spChg>
        <pc:spChg chg="add mod">
          <ac:chgData name="Kumar, Vinod" userId="a0710a6e-bffc-4971-8893-1c23addeb5b0" providerId="ADAL" clId="{3DFB5C1F-603B-4A37-8293-00F35C08F293}" dt="2022-10-14T15:15:54.415" v="3136" actId="1036"/>
          <ac:spMkLst>
            <pc:docMk/>
            <pc:sldMk cId="1896129938" sldId="304"/>
            <ac:spMk id="29" creationId="{E3C7A5AB-9FFA-3F64-2E39-7957AA658DDE}"/>
          </ac:spMkLst>
        </pc:spChg>
        <pc:spChg chg="add mod">
          <ac:chgData name="Kumar, Vinod" userId="a0710a6e-bffc-4971-8893-1c23addeb5b0" providerId="ADAL" clId="{3DFB5C1F-603B-4A37-8293-00F35C08F293}" dt="2022-10-14T15:15:50.974" v="3134" actId="1037"/>
          <ac:spMkLst>
            <pc:docMk/>
            <pc:sldMk cId="1896129938" sldId="304"/>
            <ac:spMk id="30" creationId="{40D96937-343D-5D54-B22B-DD8E1A68C40E}"/>
          </ac:spMkLst>
        </pc:spChg>
        <pc:grpChg chg="add del mod">
          <ac:chgData name="Kumar, Vinod" userId="a0710a6e-bffc-4971-8893-1c23addeb5b0" providerId="ADAL" clId="{3DFB5C1F-603B-4A37-8293-00F35C08F293}" dt="2022-10-14T15:09:17.307" v="3035"/>
          <ac:grpSpMkLst>
            <pc:docMk/>
            <pc:sldMk cId="1896129938" sldId="304"/>
            <ac:grpSpMk id="9" creationId="{D3F9855A-DE1C-7D2C-9BA4-924A62BAC39E}"/>
          </ac:grpSpMkLst>
        </pc:grpChg>
        <pc:grpChg chg="add del mod">
          <ac:chgData name="Kumar, Vinod" userId="a0710a6e-bffc-4971-8893-1c23addeb5b0" providerId="ADAL" clId="{3DFB5C1F-603B-4A37-8293-00F35C08F293}" dt="2022-10-14T15:16:25.247" v="3156" actId="478"/>
          <ac:grpSpMkLst>
            <pc:docMk/>
            <pc:sldMk cId="1896129938" sldId="304"/>
            <ac:grpSpMk id="31" creationId="{1C03DE0F-D465-C864-3C5C-C86CCA306E0D}"/>
          </ac:grpSpMkLst>
        </pc:grpChg>
        <pc:picChg chg="mod">
          <ac:chgData name="Kumar, Vinod" userId="a0710a6e-bffc-4971-8893-1c23addeb5b0" providerId="ADAL" clId="{3DFB5C1F-603B-4A37-8293-00F35C08F293}" dt="2022-10-05T14:18:39.353" v="159" actId="1035"/>
          <ac:picMkLst>
            <pc:docMk/>
            <pc:sldMk cId="1896129938" sldId="304"/>
            <ac:picMk id="3" creationId="{EE6D6DA0-B2C8-C062-6E93-1EAB0B1DB695}"/>
          </ac:picMkLst>
        </pc:picChg>
        <pc:picChg chg="mod">
          <ac:chgData name="Kumar, Vinod" userId="a0710a6e-bffc-4971-8893-1c23addeb5b0" providerId="ADAL" clId="{3DFB5C1F-603B-4A37-8293-00F35C08F293}" dt="2022-10-05T14:18:47.465" v="164" actId="1035"/>
          <ac:picMkLst>
            <pc:docMk/>
            <pc:sldMk cId="1896129938" sldId="304"/>
            <ac:picMk id="4" creationId="{FEF77DA4-5EBA-204F-C216-45C4D4BAFC59}"/>
          </ac:picMkLst>
        </pc:picChg>
        <pc:picChg chg="mod">
          <ac:chgData name="Kumar, Vinod" userId="a0710a6e-bffc-4971-8893-1c23addeb5b0" providerId="ADAL" clId="{3DFB5C1F-603B-4A37-8293-00F35C08F293}" dt="2022-10-05T14:23:27.302" v="405" actId="1036"/>
          <ac:picMkLst>
            <pc:docMk/>
            <pc:sldMk cId="1896129938" sldId="304"/>
            <ac:picMk id="5" creationId="{9BFF4654-44C7-681D-AE78-BB30710F7D35}"/>
          </ac:picMkLst>
        </pc:picChg>
        <pc:picChg chg="mod">
          <ac:chgData name="Kumar, Vinod" userId="a0710a6e-bffc-4971-8893-1c23addeb5b0" providerId="ADAL" clId="{3DFB5C1F-603B-4A37-8293-00F35C08F293}" dt="2022-10-05T14:23:27.302" v="405" actId="1036"/>
          <ac:picMkLst>
            <pc:docMk/>
            <pc:sldMk cId="1896129938" sldId="304"/>
            <ac:picMk id="6" creationId="{77B86128-5341-8C8D-B634-105ECB5031E9}"/>
          </ac:picMkLst>
        </pc:picChg>
        <pc:picChg chg="mod">
          <ac:chgData name="Kumar, Vinod" userId="a0710a6e-bffc-4971-8893-1c23addeb5b0" providerId="ADAL" clId="{3DFB5C1F-603B-4A37-8293-00F35C08F293}" dt="2022-10-05T14:23:27.302" v="405" actId="1036"/>
          <ac:picMkLst>
            <pc:docMk/>
            <pc:sldMk cId="1896129938" sldId="304"/>
            <ac:picMk id="7" creationId="{F5618D52-7D96-8F92-5FE3-593C006CE318}"/>
          </ac:picMkLst>
        </pc:picChg>
        <pc:picChg chg="mod">
          <ac:chgData name="Kumar, Vinod" userId="a0710a6e-bffc-4971-8893-1c23addeb5b0" providerId="ADAL" clId="{3DFB5C1F-603B-4A37-8293-00F35C08F293}" dt="2022-10-05T14:23:15.447" v="402" actId="1036"/>
          <ac:picMkLst>
            <pc:docMk/>
            <pc:sldMk cId="1896129938" sldId="304"/>
            <ac:picMk id="8" creationId="{0C4AC514-70B9-2E08-FC10-F47116B8336F}"/>
          </ac:picMkLst>
        </pc:picChg>
        <pc:picChg chg="del">
          <ac:chgData name="Kumar, Vinod" userId="a0710a6e-bffc-4971-8893-1c23addeb5b0" providerId="ADAL" clId="{3DFB5C1F-603B-4A37-8293-00F35C08F293}" dt="2022-10-05T14:20:53.246" v="172" actId="478"/>
          <ac:picMkLst>
            <pc:docMk/>
            <pc:sldMk cId="1896129938" sldId="304"/>
            <ac:picMk id="9" creationId="{D1FC962E-10B2-373B-99E4-D8B804AFEF48}"/>
          </ac:picMkLst>
        </pc:picChg>
        <pc:picChg chg="mod">
          <ac:chgData name="Kumar, Vinod" userId="a0710a6e-bffc-4971-8893-1c23addeb5b0" providerId="ADAL" clId="{3DFB5C1F-603B-4A37-8293-00F35C08F293}" dt="2022-10-05T14:23:15.447" v="402" actId="1036"/>
          <ac:picMkLst>
            <pc:docMk/>
            <pc:sldMk cId="1896129938" sldId="304"/>
            <ac:picMk id="10" creationId="{5BC61CC7-A994-BE81-FF4B-0830F771FB05}"/>
          </ac:picMkLst>
        </pc:picChg>
        <pc:picChg chg="mod">
          <ac:chgData name="Kumar, Vinod" userId="a0710a6e-bffc-4971-8893-1c23addeb5b0" providerId="ADAL" clId="{3DFB5C1F-603B-4A37-8293-00F35C08F293}" dt="2022-10-14T15:08:55.183" v="3032"/>
          <ac:picMkLst>
            <pc:docMk/>
            <pc:sldMk cId="1896129938" sldId="304"/>
            <ac:picMk id="11" creationId="{7E9CA948-CA2D-B02F-7543-A5849049008E}"/>
          </ac:picMkLst>
        </pc:picChg>
        <pc:picChg chg="del">
          <ac:chgData name="Kumar, Vinod" userId="a0710a6e-bffc-4971-8893-1c23addeb5b0" providerId="ADAL" clId="{3DFB5C1F-603B-4A37-8293-00F35C08F293}" dt="2022-10-05T14:20:53.246" v="172" actId="478"/>
          <ac:picMkLst>
            <pc:docMk/>
            <pc:sldMk cId="1896129938" sldId="304"/>
            <ac:picMk id="11" creationId="{AC942B19-435C-C329-C1CF-07D259C4A3EB}"/>
          </ac:picMkLst>
        </pc:picChg>
        <pc:picChg chg="mod">
          <ac:chgData name="Kumar, Vinod" userId="a0710a6e-bffc-4971-8893-1c23addeb5b0" providerId="ADAL" clId="{3DFB5C1F-603B-4A37-8293-00F35C08F293}" dt="2022-10-14T15:08:55.183" v="3032"/>
          <ac:picMkLst>
            <pc:docMk/>
            <pc:sldMk cId="1896129938" sldId="304"/>
            <ac:picMk id="20" creationId="{19CC886C-177A-B2C0-F5FC-15B68D1EDA71}"/>
          </ac:picMkLst>
        </pc:picChg>
        <pc:picChg chg="mod">
          <ac:chgData name="Kumar, Vinod" userId="a0710a6e-bffc-4971-8893-1c23addeb5b0" providerId="ADAL" clId="{3DFB5C1F-603B-4A37-8293-00F35C08F293}" dt="2022-10-14T15:08:55.183" v="3032"/>
          <ac:picMkLst>
            <pc:docMk/>
            <pc:sldMk cId="1896129938" sldId="304"/>
            <ac:picMk id="22" creationId="{11585A4F-0C44-F23F-18EB-A854E59F2F8D}"/>
          </ac:picMkLst>
        </pc:picChg>
        <pc:picChg chg="mod">
          <ac:chgData name="Kumar, Vinod" userId="a0710a6e-bffc-4971-8893-1c23addeb5b0" providerId="ADAL" clId="{3DFB5C1F-603B-4A37-8293-00F35C08F293}" dt="2022-10-14T15:08:55.183" v="3032"/>
          <ac:picMkLst>
            <pc:docMk/>
            <pc:sldMk cId="1896129938" sldId="304"/>
            <ac:picMk id="23" creationId="{BC662A2D-8511-B4B0-0374-579789190E57}"/>
          </ac:picMkLst>
        </pc:picChg>
        <pc:picChg chg="add mod">
          <ac:chgData name="Kumar, Vinod" userId="a0710a6e-bffc-4971-8893-1c23addeb5b0" providerId="ADAL" clId="{3DFB5C1F-603B-4A37-8293-00F35C08F293}" dt="2022-10-14T15:14:14.763" v="3122" actId="164"/>
          <ac:picMkLst>
            <pc:docMk/>
            <pc:sldMk cId="1896129938" sldId="304"/>
            <ac:picMk id="27" creationId="{CD035AA4-4EFB-F09A-8F7A-D570C409E89B}"/>
          </ac:picMkLst>
        </pc:picChg>
        <pc:cxnChg chg="add del mod">
          <ac:chgData name="Kumar, Vinod" userId="a0710a6e-bffc-4971-8893-1c23addeb5b0" providerId="ADAL" clId="{3DFB5C1F-603B-4A37-8293-00F35C08F293}" dt="2022-10-05T14:24:23.959" v="480" actId="478"/>
          <ac:cxnSpMkLst>
            <pc:docMk/>
            <pc:sldMk cId="1896129938" sldId="304"/>
            <ac:cxnSpMk id="24" creationId="{8C8FCC1F-BD4A-766C-0494-B28F714C5C96}"/>
          </ac:cxnSpMkLst>
        </pc:cxnChg>
      </pc:sldChg>
      <pc:sldChg chg="modSp add del mod">
        <pc:chgData name="Kumar, Vinod" userId="a0710a6e-bffc-4971-8893-1c23addeb5b0" providerId="ADAL" clId="{3DFB5C1F-603B-4A37-8293-00F35C08F293}" dt="2022-10-05T15:18:10.453" v="2876" actId="47"/>
        <pc:sldMkLst>
          <pc:docMk/>
          <pc:sldMk cId="898929911" sldId="305"/>
        </pc:sldMkLst>
        <pc:grpChg chg="mod">
          <ac:chgData name="Kumar, Vinod" userId="a0710a6e-bffc-4971-8893-1c23addeb5b0" providerId="ADAL" clId="{3DFB5C1F-603B-4A37-8293-00F35C08F293}" dt="2022-10-05T15:18:01.666" v="2873" actId="1076"/>
          <ac:grpSpMkLst>
            <pc:docMk/>
            <pc:sldMk cId="898929911" sldId="305"/>
            <ac:grpSpMk id="26" creationId="{17484DF5-3BA7-DB77-1D73-F10E10D0A7DD}"/>
          </ac:grpSpMkLst>
        </pc:grpChg>
        <pc:grpChg chg="mod">
          <ac:chgData name="Kumar, Vinod" userId="a0710a6e-bffc-4971-8893-1c23addeb5b0" providerId="ADAL" clId="{3DFB5C1F-603B-4A37-8293-00F35C08F293}" dt="2022-10-05T15:17:46.834" v="2871" actId="1076"/>
          <ac:grpSpMkLst>
            <pc:docMk/>
            <pc:sldMk cId="898929911" sldId="305"/>
            <ac:grpSpMk id="27" creationId="{C4DFA242-5262-E07D-9618-81631B0832B2}"/>
          </ac:grpSpMkLst>
        </pc:grpChg>
        <pc:picChg chg="mod">
          <ac:chgData name="Kumar, Vinod" userId="a0710a6e-bffc-4971-8893-1c23addeb5b0" providerId="ADAL" clId="{3DFB5C1F-603B-4A37-8293-00F35C08F293}" dt="2022-10-05T15:17:52.065" v="2872" actId="1076"/>
          <ac:picMkLst>
            <pc:docMk/>
            <pc:sldMk cId="898929911" sldId="305"/>
            <ac:picMk id="9" creationId="{E2D174D9-69F4-0136-FA01-1EBB88CC9824}"/>
          </ac:picMkLst>
        </pc:picChg>
        <pc:picChg chg="mod">
          <ac:chgData name="Kumar, Vinod" userId="a0710a6e-bffc-4971-8893-1c23addeb5b0" providerId="ADAL" clId="{3DFB5C1F-603B-4A37-8293-00F35C08F293}" dt="2022-10-05T15:18:05.930" v="2874" actId="1076"/>
          <ac:picMkLst>
            <pc:docMk/>
            <pc:sldMk cId="898929911" sldId="305"/>
            <ac:picMk id="10" creationId="{C485C2EA-332D-FE9B-351D-AACA7B21C507}"/>
          </ac:picMkLst>
        </pc:picChg>
        <pc:picChg chg="mod">
          <ac:chgData name="Kumar, Vinod" userId="a0710a6e-bffc-4971-8893-1c23addeb5b0" providerId="ADAL" clId="{3DFB5C1F-603B-4A37-8293-00F35C08F293}" dt="2022-10-05T15:18:07.810" v="2875" actId="1076"/>
          <ac:picMkLst>
            <pc:docMk/>
            <pc:sldMk cId="898929911" sldId="305"/>
            <ac:picMk id="11" creationId="{BBC8BE26-CE50-0E7B-5B74-3DABE34015C5}"/>
          </ac:picMkLst>
        </pc:picChg>
      </pc:sldChg>
      <pc:sldChg chg="addSp delSp modSp new del mod">
        <pc:chgData name="Kumar, Vinod" userId="a0710a6e-bffc-4971-8893-1c23addeb5b0" providerId="ADAL" clId="{3DFB5C1F-603B-4A37-8293-00F35C08F293}" dt="2022-10-14T15:19:07.499" v="3271" actId="47"/>
        <pc:sldMkLst>
          <pc:docMk/>
          <pc:sldMk cId="2270427640" sldId="305"/>
        </pc:sldMkLst>
        <pc:picChg chg="del mod">
          <ac:chgData name="Kumar, Vinod" userId="a0710a6e-bffc-4971-8893-1c23addeb5b0" providerId="ADAL" clId="{3DFB5C1F-603B-4A37-8293-00F35C08F293}" dt="2022-10-14T15:12:20.641" v="3057" actId="478"/>
          <ac:picMkLst>
            <pc:docMk/>
            <pc:sldMk cId="2270427640" sldId="305"/>
            <ac:picMk id="2" creationId="{FEB91EE2-D294-09CC-3E21-B7234556B171}"/>
          </ac:picMkLst>
        </pc:picChg>
        <pc:picChg chg="add del mod">
          <ac:chgData name="Kumar, Vinod" userId="a0710a6e-bffc-4971-8893-1c23addeb5b0" providerId="ADAL" clId="{3DFB5C1F-603B-4A37-8293-00F35C08F293}" dt="2022-10-14T15:16:21.807" v="3155" actId="478"/>
          <ac:picMkLst>
            <pc:docMk/>
            <pc:sldMk cId="2270427640" sldId="305"/>
            <ac:picMk id="3" creationId="{CBACFE66-F857-022E-2EF1-1E6F58E17700}"/>
          </ac:picMkLst>
        </pc:picChg>
        <pc:picChg chg="add mod">
          <ac:chgData name="Kumar, Vinod" userId="a0710a6e-bffc-4971-8893-1c23addeb5b0" providerId="ADAL" clId="{3DFB5C1F-603B-4A37-8293-00F35C08F293}" dt="2022-10-14T15:16:42.238" v="3157" actId="1076"/>
          <ac:picMkLst>
            <pc:docMk/>
            <pc:sldMk cId="2270427640" sldId="305"/>
            <ac:picMk id="4" creationId="{D812F155-BE62-53CF-2794-66BCE4069A93}"/>
          </ac:picMkLst>
        </pc:picChg>
      </pc:sldChg>
      <pc:sldChg chg="addSp delSp modSp new del mod">
        <pc:chgData name="Kumar, Vinod" userId="a0710a6e-bffc-4971-8893-1c23addeb5b0" providerId="ADAL" clId="{3DFB5C1F-603B-4A37-8293-00F35C08F293}" dt="2022-10-05T14:41:44.097" v="1473" actId="47"/>
        <pc:sldMkLst>
          <pc:docMk/>
          <pc:sldMk cId="2469415072" sldId="305"/>
        </pc:sldMkLst>
        <pc:spChg chg="del">
          <ac:chgData name="Kumar, Vinod" userId="a0710a6e-bffc-4971-8893-1c23addeb5b0" providerId="ADAL" clId="{3DFB5C1F-603B-4A37-8293-00F35C08F293}" dt="2022-10-05T14:29:10.068" v="667" actId="478"/>
          <ac:spMkLst>
            <pc:docMk/>
            <pc:sldMk cId="2469415072" sldId="305"/>
            <ac:spMk id="2" creationId="{626CE322-42D5-0D35-AFD6-E40EAE48F9BD}"/>
          </ac:spMkLst>
        </pc:spChg>
        <pc:spChg chg="del">
          <ac:chgData name="Kumar, Vinod" userId="a0710a6e-bffc-4971-8893-1c23addeb5b0" providerId="ADAL" clId="{3DFB5C1F-603B-4A37-8293-00F35C08F293}" dt="2022-10-05T14:29:10.980" v="668" actId="478"/>
          <ac:spMkLst>
            <pc:docMk/>
            <pc:sldMk cId="2469415072" sldId="305"/>
            <ac:spMk id="3" creationId="{B75FF237-A3BA-19E4-9B1B-ED9E17EB4963}"/>
          </ac:spMkLst>
        </pc:spChg>
        <pc:spChg chg="add mod">
          <ac:chgData name="Kumar, Vinod" userId="a0710a6e-bffc-4971-8893-1c23addeb5b0" providerId="ADAL" clId="{3DFB5C1F-603B-4A37-8293-00F35C08F293}" dt="2022-10-05T14:29:27.055" v="670" actId="20577"/>
          <ac:spMkLst>
            <pc:docMk/>
            <pc:sldMk cId="2469415072" sldId="305"/>
            <ac:spMk id="4" creationId="{F58C8C8A-EDD8-4535-1E6D-6457866B0C37}"/>
          </ac:spMkLst>
        </pc:spChg>
        <pc:spChg chg="add mod">
          <ac:chgData name="Kumar, Vinod" userId="a0710a6e-bffc-4971-8893-1c23addeb5b0" providerId="ADAL" clId="{3DFB5C1F-603B-4A37-8293-00F35C08F293}" dt="2022-10-05T14:31:54.929" v="705" actId="164"/>
          <ac:spMkLst>
            <pc:docMk/>
            <pc:sldMk cId="2469415072" sldId="305"/>
            <ac:spMk id="6" creationId="{ADEDB5EB-44FB-EEEC-13DE-5928734438E5}"/>
          </ac:spMkLst>
        </pc:spChg>
        <pc:grpChg chg="add mod">
          <ac:chgData name="Kumar, Vinod" userId="a0710a6e-bffc-4971-8893-1c23addeb5b0" providerId="ADAL" clId="{3DFB5C1F-603B-4A37-8293-00F35C08F293}" dt="2022-10-05T14:31:54.929" v="705" actId="164"/>
          <ac:grpSpMkLst>
            <pc:docMk/>
            <pc:sldMk cId="2469415072" sldId="305"/>
            <ac:grpSpMk id="7" creationId="{6421DDDA-A969-A60E-A6D4-37C35F5A782F}"/>
          </ac:grpSpMkLst>
        </pc:grpChg>
        <pc:picChg chg="add mod">
          <ac:chgData name="Kumar, Vinod" userId="a0710a6e-bffc-4971-8893-1c23addeb5b0" providerId="ADAL" clId="{3DFB5C1F-603B-4A37-8293-00F35C08F293}" dt="2022-10-05T14:31:54.929" v="705" actId="164"/>
          <ac:picMkLst>
            <pc:docMk/>
            <pc:sldMk cId="2469415072" sldId="305"/>
            <ac:picMk id="5" creationId="{EDE8405C-DA8E-3969-B180-34A94A15E496}"/>
          </ac:picMkLst>
        </pc:picChg>
      </pc:sldChg>
    </pc:docChg>
  </pc:docChgLst>
  <pc:docChgLst>
    <pc:chgData name="Kumar, Vinod" userId="a0710a6e-bffc-4971-8893-1c23addeb5b0" providerId="ADAL" clId="{AD4E4DE1-9CB1-4771-A235-1540E1ED3060}"/>
    <pc:docChg chg="undo redo custSel addSld delSld modSld">
      <pc:chgData name="Kumar, Vinod" userId="a0710a6e-bffc-4971-8893-1c23addeb5b0" providerId="ADAL" clId="{AD4E4DE1-9CB1-4771-A235-1540E1ED3060}" dt="2023-01-06T23:20:58.132" v="8116" actId="47"/>
      <pc:docMkLst>
        <pc:docMk/>
      </pc:docMkLst>
      <pc:sldChg chg="addSp delSp modSp mod">
        <pc:chgData name="Kumar, Vinod" userId="a0710a6e-bffc-4971-8893-1c23addeb5b0" providerId="ADAL" clId="{AD4E4DE1-9CB1-4771-A235-1540E1ED3060}" dt="2022-12-22T19:11:38.262" v="523" actId="1037"/>
        <pc:sldMkLst>
          <pc:docMk/>
          <pc:sldMk cId="2581851823" sldId="270"/>
        </pc:sldMkLst>
        <pc:picChg chg="add del mod">
          <ac:chgData name="Kumar, Vinod" userId="a0710a6e-bffc-4971-8893-1c23addeb5b0" providerId="ADAL" clId="{AD4E4DE1-9CB1-4771-A235-1540E1ED3060}" dt="2022-12-22T19:05:14.386" v="449"/>
          <ac:picMkLst>
            <pc:docMk/>
            <pc:sldMk cId="2581851823" sldId="270"/>
            <ac:picMk id="3" creationId="{C7E6F71E-5733-9EC6-83E5-5E09C4379694}"/>
          </ac:picMkLst>
        </pc:picChg>
        <pc:picChg chg="add del mod">
          <ac:chgData name="Kumar, Vinod" userId="a0710a6e-bffc-4971-8893-1c23addeb5b0" providerId="ADAL" clId="{AD4E4DE1-9CB1-4771-A235-1540E1ED3060}" dt="2022-12-22T19:05:41.305" v="456" actId="478"/>
          <ac:picMkLst>
            <pc:docMk/>
            <pc:sldMk cId="2581851823" sldId="270"/>
            <ac:picMk id="4" creationId="{F03AB353-693C-124E-FCE1-6F440498B298}"/>
          </ac:picMkLst>
        </pc:picChg>
        <pc:picChg chg="del mod">
          <ac:chgData name="Kumar, Vinod" userId="a0710a6e-bffc-4971-8893-1c23addeb5b0" providerId="ADAL" clId="{AD4E4DE1-9CB1-4771-A235-1540E1ED3060}" dt="2022-12-22T19:06:31.032" v="460" actId="478"/>
          <ac:picMkLst>
            <pc:docMk/>
            <pc:sldMk cId="2581851823" sldId="270"/>
            <ac:picMk id="5" creationId="{3EEE5854-D4E1-38EC-8971-BE7DDDBECACA}"/>
          </ac:picMkLst>
        </pc:picChg>
        <pc:picChg chg="add del mod">
          <ac:chgData name="Kumar, Vinod" userId="a0710a6e-bffc-4971-8893-1c23addeb5b0" providerId="ADAL" clId="{AD4E4DE1-9CB1-4771-A235-1540E1ED3060}" dt="2022-12-22T19:06:46.009" v="464" actId="478"/>
          <ac:picMkLst>
            <pc:docMk/>
            <pc:sldMk cId="2581851823" sldId="270"/>
            <ac:picMk id="6" creationId="{1F8D5F75-CEF8-1421-BF86-6E97510DEC63}"/>
          </ac:picMkLst>
        </pc:picChg>
        <pc:picChg chg="add mod">
          <ac:chgData name="Kumar, Vinod" userId="a0710a6e-bffc-4971-8893-1c23addeb5b0" providerId="ADAL" clId="{AD4E4DE1-9CB1-4771-A235-1540E1ED3060}" dt="2022-12-22T19:11:38.262" v="523" actId="1037"/>
          <ac:picMkLst>
            <pc:docMk/>
            <pc:sldMk cId="2581851823" sldId="270"/>
            <ac:picMk id="7" creationId="{EFC54EB2-B049-F2CD-90EF-F8D0D2CA9D92}"/>
          </ac:picMkLst>
        </pc:picChg>
        <pc:picChg chg="del">
          <ac:chgData name="Kumar, Vinod" userId="a0710a6e-bffc-4971-8893-1c23addeb5b0" providerId="ADAL" clId="{AD4E4DE1-9CB1-4771-A235-1540E1ED3060}" dt="2022-12-22T19:11:19.159" v="509" actId="478"/>
          <ac:picMkLst>
            <pc:docMk/>
            <pc:sldMk cId="2581851823" sldId="270"/>
            <ac:picMk id="18" creationId="{94C80812-73CD-8D57-BA74-A51FD8C186C5}"/>
          </ac:picMkLst>
        </pc:picChg>
      </pc:sldChg>
      <pc:sldChg chg="del">
        <pc:chgData name="Kumar, Vinod" userId="a0710a6e-bffc-4971-8893-1c23addeb5b0" providerId="ADAL" clId="{AD4E4DE1-9CB1-4771-A235-1540E1ED3060}" dt="2023-01-06T23:20:58.132" v="8116" actId="47"/>
        <pc:sldMkLst>
          <pc:docMk/>
          <pc:sldMk cId="2940357804" sldId="297"/>
        </pc:sldMkLst>
      </pc:sldChg>
      <pc:sldChg chg="addSp delSp modSp add del mod">
        <pc:chgData name="Kumar, Vinod" userId="a0710a6e-bffc-4971-8893-1c23addeb5b0" providerId="ADAL" clId="{AD4E4DE1-9CB1-4771-A235-1540E1ED3060}" dt="2023-01-05T18:48:03.321" v="2050" actId="47"/>
        <pc:sldMkLst>
          <pc:docMk/>
          <pc:sldMk cId="2498213667" sldId="299"/>
        </pc:sldMkLst>
        <pc:picChg chg="del mod">
          <ac:chgData name="Kumar, Vinod" userId="a0710a6e-bffc-4971-8893-1c23addeb5b0" providerId="ADAL" clId="{AD4E4DE1-9CB1-4771-A235-1540E1ED3060}" dt="2022-12-23T21:00:16.831" v="550" actId="478"/>
          <ac:picMkLst>
            <pc:docMk/>
            <pc:sldMk cId="2498213667" sldId="299"/>
            <ac:picMk id="21" creationId="{A449FE10-EBF8-A67E-4397-F0D866EA7958}"/>
          </ac:picMkLst>
        </pc:picChg>
        <pc:picChg chg="add del mod">
          <ac:chgData name="Kumar, Vinod" userId="a0710a6e-bffc-4971-8893-1c23addeb5b0" providerId="ADAL" clId="{AD4E4DE1-9CB1-4771-A235-1540E1ED3060}" dt="2022-12-23T21:05:49.611" v="559" actId="478"/>
          <ac:picMkLst>
            <pc:docMk/>
            <pc:sldMk cId="2498213667" sldId="299"/>
            <ac:picMk id="28" creationId="{A9C9EBE0-1794-30FE-4AE3-3F0F079E79FA}"/>
          </ac:picMkLst>
        </pc:picChg>
        <pc:picChg chg="add del mod">
          <ac:chgData name="Kumar, Vinod" userId="a0710a6e-bffc-4971-8893-1c23addeb5b0" providerId="ADAL" clId="{AD4E4DE1-9CB1-4771-A235-1540E1ED3060}" dt="2022-12-23T21:08:17.210" v="568" actId="478"/>
          <ac:picMkLst>
            <pc:docMk/>
            <pc:sldMk cId="2498213667" sldId="299"/>
            <ac:picMk id="29" creationId="{63082C40-604B-10AD-C178-8ACC1225AC23}"/>
          </ac:picMkLst>
        </pc:picChg>
        <pc:picChg chg="add del mod">
          <ac:chgData name="Kumar, Vinod" userId="a0710a6e-bffc-4971-8893-1c23addeb5b0" providerId="ADAL" clId="{AD4E4DE1-9CB1-4771-A235-1540E1ED3060}" dt="2022-12-23T21:08:15.450" v="567" actId="478"/>
          <ac:picMkLst>
            <pc:docMk/>
            <pc:sldMk cId="2498213667" sldId="299"/>
            <ac:picMk id="30" creationId="{FF67A0DD-B37A-A2FC-74D9-B1C07154B182}"/>
          </ac:picMkLst>
        </pc:picChg>
      </pc:sldChg>
      <pc:sldChg chg="modSp mod">
        <pc:chgData name="Kumar, Vinod" userId="a0710a6e-bffc-4971-8893-1c23addeb5b0" providerId="ADAL" clId="{AD4E4DE1-9CB1-4771-A235-1540E1ED3060}" dt="2023-01-06T19:56:17.609" v="6701" actId="1036"/>
        <pc:sldMkLst>
          <pc:docMk/>
          <pc:sldMk cId="2313405284" sldId="300"/>
        </pc:sldMkLst>
        <pc:spChg chg="mod">
          <ac:chgData name="Kumar, Vinod" userId="a0710a6e-bffc-4971-8893-1c23addeb5b0" providerId="ADAL" clId="{AD4E4DE1-9CB1-4771-A235-1540E1ED3060}" dt="2023-01-06T19:55:46.328" v="6688" actId="1035"/>
          <ac:spMkLst>
            <pc:docMk/>
            <pc:sldMk cId="2313405284" sldId="300"/>
            <ac:spMk id="2" creationId="{E836C5DC-7746-C954-BC1F-3B9F0DA30868}"/>
          </ac:spMkLst>
        </pc:spChg>
        <pc:spChg chg="mod">
          <ac:chgData name="Kumar, Vinod" userId="a0710a6e-bffc-4971-8893-1c23addeb5b0" providerId="ADAL" clId="{AD4E4DE1-9CB1-4771-A235-1540E1ED3060}" dt="2023-01-06T19:56:04.058" v="6689" actId="255"/>
          <ac:spMkLst>
            <pc:docMk/>
            <pc:sldMk cId="2313405284" sldId="300"/>
            <ac:spMk id="11" creationId="{C64871AB-6521-A550-17B9-FEE41DAD3B8D}"/>
          </ac:spMkLst>
        </pc:spChg>
        <pc:spChg chg="mod">
          <ac:chgData name="Kumar, Vinod" userId="a0710a6e-bffc-4971-8893-1c23addeb5b0" providerId="ADAL" clId="{AD4E4DE1-9CB1-4771-A235-1540E1ED3060}" dt="2023-01-06T19:56:04.058" v="6689" actId="255"/>
          <ac:spMkLst>
            <pc:docMk/>
            <pc:sldMk cId="2313405284" sldId="300"/>
            <ac:spMk id="12" creationId="{DE106EEB-BEC0-DFC6-0302-FA2E623AEC2C}"/>
          </ac:spMkLst>
        </pc:spChg>
        <pc:spChg chg="mod">
          <ac:chgData name="Kumar, Vinod" userId="a0710a6e-bffc-4971-8893-1c23addeb5b0" providerId="ADAL" clId="{AD4E4DE1-9CB1-4771-A235-1540E1ED3060}" dt="2023-01-06T19:56:04.058" v="6689" actId="255"/>
          <ac:spMkLst>
            <pc:docMk/>
            <pc:sldMk cId="2313405284" sldId="300"/>
            <ac:spMk id="13" creationId="{8933CC69-5A26-CFFF-CDF2-7629C88162CC}"/>
          </ac:spMkLst>
        </pc:spChg>
        <pc:spChg chg="mod">
          <ac:chgData name="Kumar, Vinod" userId="a0710a6e-bffc-4971-8893-1c23addeb5b0" providerId="ADAL" clId="{AD4E4DE1-9CB1-4771-A235-1540E1ED3060}" dt="2023-01-06T19:56:04.058" v="6689" actId="255"/>
          <ac:spMkLst>
            <pc:docMk/>
            <pc:sldMk cId="2313405284" sldId="300"/>
            <ac:spMk id="14" creationId="{500AC389-8A93-6C81-C33A-970A6A288B38}"/>
          </ac:spMkLst>
        </pc:spChg>
        <pc:spChg chg="mod">
          <ac:chgData name="Kumar, Vinod" userId="a0710a6e-bffc-4971-8893-1c23addeb5b0" providerId="ADAL" clId="{AD4E4DE1-9CB1-4771-A235-1540E1ED3060}" dt="2023-01-06T19:56:04.058" v="6689" actId="255"/>
          <ac:spMkLst>
            <pc:docMk/>
            <pc:sldMk cId="2313405284" sldId="300"/>
            <ac:spMk id="15" creationId="{12E43E6A-BC7F-1E66-77AD-0D7CCFDBED82}"/>
          </ac:spMkLst>
        </pc:spChg>
        <pc:spChg chg="mod">
          <ac:chgData name="Kumar, Vinod" userId="a0710a6e-bffc-4971-8893-1c23addeb5b0" providerId="ADAL" clId="{AD4E4DE1-9CB1-4771-A235-1540E1ED3060}" dt="2023-01-06T19:56:04.058" v="6689" actId="255"/>
          <ac:spMkLst>
            <pc:docMk/>
            <pc:sldMk cId="2313405284" sldId="300"/>
            <ac:spMk id="16" creationId="{F7E78BC5-387C-1374-456C-397866B099A1}"/>
          </ac:spMkLst>
        </pc:spChg>
        <pc:spChg chg="mod">
          <ac:chgData name="Kumar, Vinod" userId="a0710a6e-bffc-4971-8893-1c23addeb5b0" providerId="ADAL" clId="{AD4E4DE1-9CB1-4771-A235-1540E1ED3060}" dt="2023-01-06T19:56:04.058" v="6689" actId="255"/>
          <ac:spMkLst>
            <pc:docMk/>
            <pc:sldMk cId="2313405284" sldId="300"/>
            <ac:spMk id="17" creationId="{DE811E4C-18B9-AF7B-4E24-A0D0D5FB3A2B}"/>
          </ac:spMkLst>
        </pc:spChg>
        <pc:spChg chg="mod">
          <ac:chgData name="Kumar, Vinod" userId="a0710a6e-bffc-4971-8893-1c23addeb5b0" providerId="ADAL" clId="{AD4E4DE1-9CB1-4771-A235-1540E1ED3060}" dt="2023-01-06T19:56:04.058" v="6689" actId="255"/>
          <ac:spMkLst>
            <pc:docMk/>
            <pc:sldMk cId="2313405284" sldId="300"/>
            <ac:spMk id="18" creationId="{197D5A89-7757-9ED2-8EE0-4D250796B5BB}"/>
          </ac:spMkLst>
        </pc:spChg>
        <pc:grpChg chg="mod">
          <ac:chgData name="Kumar, Vinod" userId="a0710a6e-bffc-4971-8893-1c23addeb5b0" providerId="ADAL" clId="{AD4E4DE1-9CB1-4771-A235-1540E1ED3060}" dt="2023-01-06T16:15:17.544" v="6294" actId="1038"/>
          <ac:grpSpMkLst>
            <pc:docMk/>
            <pc:sldMk cId="2313405284" sldId="300"/>
            <ac:grpSpMk id="26" creationId="{54B17F00-0356-0926-27BE-A8E46FD045E6}"/>
          </ac:grpSpMkLst>
        </pc:grpChg>
        <pc:grpChg chg="mod">
          <ac:chgData name="Kumar, Vinod" userId="a0710a6e-bffc-4971-8893-1c23addeb5b0" providerId="ADAL" clId="{AD4E4DE1-9CB1-4771-A235-1540E1ED3060}" dt="2023-01-06T16:15:25.016" v="6310" actId="1038"/>
          <ac:grpSpMkLst>
            <pc:docMk/>
            <pc:sldMk cId="2313405284" sldId="300"/>
            <ac:grpSpMk id="27" creationId="{D0B6DC18-3449-5500-FA84-0BB5842C8EE1}"/>
          </ac:grpSpMkLst>
        </pc:grpChg>
        <pc:grpChg chg="mod">
          <ac:chgData name="Kumar, Vinod" userId="a0710a6e-bffc-4971-8893-1c23addeb5b0" providerId="ADAL" clId="{AD4E4DE1-9CB1-4771-A235-1540E1ED3060}" dt="2023-01-06T16:15:17.544" v="6294" actId="1038"/>
          <ac:grpSpMkLst>
            <pc:docMk/>
            <pc:sldMk cId="2313405284" sldId="300"/>
            <ac:grpSpMk id="28" creationId="{58024AC3-3CAA-AE70-9F80-D889D4427085}"/>
          </ac:grpSpMkLst>
        </pc:grpChg>
        <pc:grpChg chg="mod">
          <ac:chgData name="Kumar, Vinod" userId="a0710a6e-bffc-4971-8893-1c23addeb5b0" providerId="ADAL" clId="{AD4E4DE1-9CB1-4771-A235-1540E1ED3060}" dt="2023-01-06T16:15:25.016" v="6310" actId="1038"/>
          <ac:grpSpMkLst>
            <pc:docMk/>
            <pc:sldMk cId="2313405284" sldId="300"/>
            <ac:grpSpMk id="29" creationId="{04B2C1A9-EB0C-406C-9E17-296446427152}"/>
          </ac:grpSpMkLst>
        </pc:grpChg>
        <pc:grpChg chg="mod">
          <ac:chgData name="Kumar, Vinod" userId="a0710a6e-bffc-4971-8893-1c23addeb5b0" providerId="ADAL" clId="{AD4E4DE1-9CB1-4771-A235-1540E1ED3060}" dt="2023-01-06T16:15:17.544" v="6294" actId="1038"/>
          <ac:grpSpMkLst>
            <pc:docMk/>
            <pc:sldMk cId="2313405284" sldId="300"/>
            <ac:grpSpMk id="30" creationId="{D49AB123-0B24-44D0-BBEC-64F7DAD6605F}"/>
          </ac:grpSpMkLst>
        </pc:grpChg>
        <pc:grpChg chg="mod">
          <ac:chgData name="Kumar, Vinod" userId="a0710a6e-bffc-4971-8893-1c23addeb5b0" providerId="ADAL" clId="{AD4E4DE1-9CB1-4771-A235-1540E1ED3060}" dt="2023-01-06T16:15:25.016" v="6310" actId="1038"/>
          <ac:grpSpMkLst>
            <pc:docMk/>
            <pc:sldMk cId="2313405284" sldId="300"/>
            <ac:grpSpMk id="31" creationId="{FFA80ACD-6E47-C912-D959-62C82A221811}"/>
          </ac:grpSpMkLst>
        </pc:grpChg>
        <pc:grpChg chg="mod">
          <ac:chgData name="Kumar, Vinod" userId="a0710a6e-bffc-4971-8893-1c23addeb5b0" providerId="ADAL" clId="{AD4E4DE1-9CB1-4771-A235-1540E1ED3060}" dt="2023-01-06T19:56:17.609" v="6701" actId="1036"/>
          <ac:grpSpMkLst>
            <pc:docMk/>
            <pc:sldMk cId="2313405284" sldId="300"/>
            <ac:grpSpMk id="34" creationId="{5A7F8E08-0902-36DF-CC2A-98D5D838096B}"/>
          </ac:grpSpMkLst>
        </pc:grpChg>
        <pc:grpChg chg="mod">
          <ac:chgData name="Kumar, Vinod" userId="a0710a6e-bffc-4971-8893-1c23addeb5b0" providerId="ADAL" clId="{AD4E4DE1-9CB1-4771-A235-1540E1ED3060}" dt="2023-01-06T19:56:13.609" v="6697" actId="1036"/>
          <ac:grpSpMkLst>
            <pc:docMk/>
            <pc:sldMk cId="2313405284" sldId="300"/>
            <ac:grpSpMk id="35" creationId="{48D14474-21BE-E3B9-27B2-6A46B84D7BB6}"/>
          </ac:grpSpMkLst>
        </pc:grpChg>
      </pc:sldChg>
      <pc:sldChg chg="addSp delSp modSp mod">
        <pc:chgData name="Kumar, Vinod" userId="a0710a6e-bffc-4971-8893-1c23addeb5b0" providerId="ADAL" clId="{AD4E4DE1-9CB1-4771-A235-1540E1ED3060}" dt="2023-01-06T19:01:12.149" v="6410" actId="1038"/>
        <pc:sldMkLst>
          <pc:docMk/>
          <pc:sldMk cId="1906182640" sldId="301"/>
        </pc:sldMkLst>
        <pc:spChg chg="add del mod">
          <ac:chgData name="Kumar, Vinod" userId="a0710a6e-bffc-4971-8893-1c23addeb5b0" providerId="ADAL" clId="{AD4E4DE1-9CB1-4771-A235-1540E1ED3060}" dt="2023-01-05T19:20:57.681" v="2558" actId="478"/>
          <ac:spMkLst>
            <pc:docMk/>
            <pc:sldMk cId="1906182640" sldId="301"/>
            <ac:spMk id="11" creationId="{9EE39B9F-7B6F-EA63-C77D-EC395E58E9E3}"/>
          </ac:spMkLst>
        </pc:spChg>
        <pc:spChg chg="add del mod">
          <ac:chgData name="Kumar, Vinod" userId="a0710a6e-bffc-4971-8893-1c23addeb5b0" providerId="ADAL" clId="{AD4E4DE1-9CB1-4771-A235-1540E1ED3060}" dt="2023-01-05T19:20:57.681" v="2558" actId="478"/>
          <ac:spMkLst>
            <pc:docMk/>
            <pc:sldMk cId="1906182640" sldId="301"/>
            <ac:spMk id="12" creationId="{F9BAB274-957F-7DE4-7A15-FEBC39E731C0}"/>
          </ac:spMkLst>
        </pc:spChg>
        <pc:spChg chg="add del mod">
          <ac:chgData name="Kumar, Vinod" userId="a0710a6e-bffc-4971-8893-1c23addeb5b0" providerId="ADAL" clId="{AD4E4DE1-9CB1-4771-A235-1540E1ED3060}" dt="2023-01-05T19:20:57.681" v="2558" actId="478"/>
          <ac:spMkLst>
            <pc:docMk/>
            <pc:sldMk cId="1906182640" sldId="301"/>
            <ac:spMk id="18" creationId="{D5F25E11-933D-9605-17F1-2ADA258F1922}"/>
          </ac:spMkLst>
        </pc:spChg>
        <pc:spChg chg="add del mod">
          <ac:chgData name="Kumar, Vinod" userId="a0710a6e-bffc-4971-8893-1c23addeb5b0" providerId="ADAL" clId="{AD4E4DE1-9CB1-4771-A235-1540E1ED3060}" dt="2023-01-05T19:20:57.681" v="2558" actId="478"/>
          <ac:spMkLst>
            <pc:docMk/>
            <pc:sldMk cId="1906182640" sldId="301"/>
            <ac:spMk id="20" creationId="{0F99F18C-83C0-B913-CCA4-61C96E7689B7}"/>
          </ac:spMkLst>
        </pc:spChg>
        <pc:spChg chg="add del mod">
          <ac:chgData name="Kumar, Vinod" userId="a0710a6e-bffc-4971-8893-1c23addeb5b0" providerId="ADAL" clId="{AD4E4DE1-9CB1-4771-A235-1540E1ED3060}" dt="2023-01-05T19:20:57.681" v="2558" actId="478"/>
          <ac:spMkLst>
            <pc:docMk/>
            <pc:sldMk cId="1906182640" sldId="301"/>
            <ac:spMk id="21" creationId="{19B67841-5350-49FD-F65A-58D83C25D982}"/>
          </ac:spMkLst>
        </pc:spChg>
        <pc:spChg chg="add del mod">
          <ac:chgData name="Kumar, Vinod" userId="a0710a6e-bffc-4971-8893-1c23addeb5b0" providerId="ADAL" clId="{AD4E4DE1-9CB1-4771-A235-1540E1ED3060}" dt="2023-01-05T19:15:34.067" v="2303" actId="478"/>
          <ac:spMkLst>
            <pc:docMk/>
            <pc:sldMk cId="1906182640" sldId="301"/>
            <ac:spMk id="24" creationId="{EA638E53-6737-770D-D6B2-7740CFAA3ECA}"/>
          </ac:spMkLst>
        </pc:spChg>
        <pc:spChg chg="add del mod">
          <ac:chgData name="Kumar, Vinod" userId="a0710a6e-bffc-4971-8893-1c23addeb5b0" providerId="ADAL" clId="{AD4E4DE1-9CB1-4771-A235-1540E1ED3060}" dt="2023-01-05T19:21:00.832" v="2559" actId="478"/>
          <ac:spMkLst>
            <pc:docMk/>
            <pc:sldMk cId="1906182640" sldId="301"/>
            <ac:spMk id="26" creationId="{F09678C4-265D-53CE-F4C7-48C748A6D1CB}"/>
          </ac:spMkLst>
        </pc:spChg>
        <pc:spChg chg="add del mod">
          <ac:chgData name="Kumar, Vinod" userId="a0710a6e-bffc-4971-8893-1c23addeb5b0" providerId="ADAL" clId="{AD4E4DE1-9CB1-4771-A235-1540E1ED3060}" dt="2023-01-05T19:15:25.219" v="2300" actId="478"/>
          <ac:spMkLst>
            <pc:docMk/>
            <pc:sldMk cId="1906182640" sldId="301"/>
            <ac:spMk id="27" creationId="{AD7E0796-31BF-AD34-00DE-3EDD58FBB5C8}"/>
          </ac:spMkLst>
        </pc:spChg>
        <pc:spChg chg="add del mod">
          <ac:chgData name="Kumar, Vinod" userId="a0710a6e-bffc-4971-8893-1c23addeb5b0" providerId="ADAL" clId="{AD4E4DE1-9CB1-4771-A235-1540E1ED3060}" dt="2023-01-05T19:21:00.832" v="2559" actId="478"/>
          <ac:spMkLst>
            <pc:docMk/>
            <pc:sldMk cId="1906182640" sldId="301"/>
            <ac:spMk id="28" creationId="{54B53E22-90EA-18AB-CAAE-D94E055385C0}"/>
          </ac:spMkLst>
        </pc:spChg>
        <pc:spChg chg="add del mod">
          <ac:chgData name="Kumar, Vinod" userId="a0710a6e-bffc-4971-8893-1c23addeb5b0" providerId="ADAL" clId="{AD4E4DE1-9CB1-4771-A235-1540E1ED3060}" dt="2023-01-05T19:21:00.832" v="2559" actId="478"/>
          <ac:spMkLst>
            <pc:docMk/>
            <pc:sldMk cId="1906182640" sldId="301"/>
            <ac:spMk id="29" creationId="{24842BBA-93B8-A900-992A-F39BBCA952EE}"/>
          </ac:spMkLst>
        </pc:spChg>
        <pc:spChg chg="add del mod">
          <ac:chgData name="Kumar, Vinod" userId="a0710a6e-bffc-4971-8893-1c23addeb5b0" providerId="ADAL" clId="{AD4E4DE1-9CB1-4771-A235-1540E1ED3060}" dt="2023-01-05T19:21:00.832" v="2559" actId="478"/>
          <ac:spMkLst>
            <pc:docMk/>
            <pc:sldMk cId="1906182640" sldId="301"/>
            <ac:spMk id="30" creationId="{9CB6608C-609D-AD74-7379-8F2C4044E1D3}"/>
          </ac:spMkLst>
        </pc:spChg>
        <pc:spChg chg="add del mod">
          <ac:chgData name="Kumar, Vinod" userId="a0710a6e-bffc-4971-8893-1c23addeb5b0" providerId="ADAL" clId="{AD4E4DE1-9CB1-4771-A235-1540E1ED3060}" dt="2023-01-05T19:21:00.832" v="2559" actId="478"/>
          <ac:spMkLst>
            <pc:docMk/>
            <pc:sldMk cId="1906182640" sldId="301"/>
            <ac:spMk id="31" creationId="{9088761A-C698-ED2C-33AB-84160963A32F}"/>
          </ac:spMkLst>
        </pc:spChg>
        <pc:spChg chg="add del mod">
          <ac:chgData name="Kumar, Vinod" userId="a0710a6e-bffc-4971-8893-1c23addeb5b0" providerId="ADAL" clId="{AD4E4DE1-9CB1-4771-A235-1540E1ED3060}" dt="2023-01-05T19:21:00.832" v="2559" actId="478"/>
          <ac:spMkLst>
            <pc:docMk/>
            <pc:sldMk cId="1906182640" sldId="301"/>
            <ac:spMk id="32" creationId="{D8A25150-2731-ED60-0667-AA162FD7B242}"/>
          </ac:spMkLst>
        </pc:spChg>
        <pc:spChg chg="add del mod">
          <ac:chgData name="Kumar, Vinod" userId="a0710a6e-bffc-4971-8893-1c23addeb5b0" providerId="ADAL" clId="{AD4E4DE1-9CB1-4771-A235-1540E1ED3060}" dt="2023-01-05T19:21:00.832" v="2559" actId="478"/>
          <ac:spMkLst>
            <pc:docMk/>
            <pc:sldMk cId="1906182640" sldId="301"/>
            <ac:spMk id="33" creationId="{5AD3D133-D25C-D327-13D9-4DE2847C498E}"/>
          </ac:spMkLst>
        </pc:spChg>
        <pc:picChg chg="add mod">
          <ac:chgData name="Kumar, Vinod" userId="a0710a6e-bffc-4971-8893-1c23addeb5b0" providerId="ADAL" clId="{AD4E4DE1-9CB1-4771-A235-1540E1ED3060}" dt="2023-01-06T19:01:12.149" v="6410" actId="1038"/>
          <ac:picMkLst>
            <pc:docMk/>
            <pc:sldMk cId="1906182640" sldId="301"/>
            <ac:picMk id="8" creationId="{8A5A5937-66A3-3B8C-8492-B8E9EC095195}"/>
          </ac:picMkLst>
        </pc:picChg>
        <pc:picChg chg="add del mod">
          <ac:chgData name="Kumar, Vinod" userId="a0710a6e-bffc-4971-8893-1c23addeb5b0" providerId="ADAL" clId="{AD4E4DE1-9CB1-4771-A235-1540E1ED3060}" dt="2023-01-05T19:20:53.857" v="2556" actId="478"/>
          <ac:picMkLst>
            <pc:docMk/>
            <pc:sldMk cId="1906182640" sldId="301"/>
            <ac:picMk id="8" creationId="{CC7360F1-29AD-AF1A-7E96-2BC9A5E588AA}"/>
          </ac:picMkLst>
        </pc:picChg>
        <pc:picChg chg="add del mod">
          <ac:chgData name="Kumar, Vinod" userId="a0710a6e-bffc-4971-8893-1c23addeb5b0" providerId="ADAL" clId="{AD4E4DE1-9CB1-4771-A235-1540E1ED3060}" dt="2023-01-05T19:20:54.896" v="2557" actId="478"/>
          <ac:picMkLst>
            <pc:docMk/>
            <pc:sldMk cId="1906182640" sldId="301"/>
            <ac:picMk id="9" creationId="{3BFB7B0D-1901-D49D-1C13-3FBE650D158F}"/>
          </ac:picMkLst>
        </pc:picChg>
        <pc:picChg chg="add del mod">
          <ac:chgData name="Kumar, Vinod" userId="a0710a6e-bffc-4971-8893-1c23addeb5b0" providerId="ADAL" clId="{AD4E4DE1-9CB1-4771-A235-1540E1ED3060}" dt="2023-01-05T19:20:57.681" v="2558" actId="478"/>
          <ac:picMkLst>
            <pc:docMk/>
            <pc:sldMk cId="1906182640" sldId="301"/>
            <ac:picMk id="10" creationId="{E035298D-7DE2-5CB7-D5D1-F3840899D14B}"/>
          </ac:picMkLst>
        </pc:picChg>
        <pc:picChg chg="add del mod">
          <ac:chgData name="Kumar, Vinod" userId="a0710a6e-bffc-4971-8893-1c23addeb5b0" providerId="ADAL" clId="{AD4E4DE1-9CB1-4771-A235-1540E1ED3060}" dt="2023-01-05T19:21:00.832" v="2559" actId="478"/>
          <ac:picMkLst>
            <pc:docMk/>
            <pc:sldMk cId="1906182640" sldId="301"/>
            <ac:picMk id="22" creationId="{A35A727B-DF9D-91C4-7FB6-D6216AA4B8C1}"/>
          </ac:picMkLst>
        </pc:picChg>
        <pc:picChg chg="add del mod">
          <ac:chgData name="Kumar, Vinod" userId="a0710a6e-bffc-4971-8893-1c23addeb5b0" providerId="ADAL" clId="{AD4E4DE1-9CB1-4771-A235-1540E1ED3060}" dt="2023-01-05T19:21:00.832" v="2559" actId="478"/>
          <ac:picMkLst>
            <pc:docMk/>
            <pc:sldMk cId="1906182640" sldId="301"/>
            <ac:picMk id="23" creationId="{AB757366-940A-BD61-67AA-4E00BEA0A194}"/>
          </ac:picMkLst>
        </pc:picChg>
        <pc:cxnChg chg="add del mod">
          <ac:chgData name="Kumar, Vinod" userId="a0710a6e-bffc-4971-8893-1c23addeb5b0" providerId="ADAL" clId="{AD4E4DE1-9CB1-4771-A235-1540E1ED3060}" dt="2023-01-05T19:20:57.681" v="2558" actId="478"/>
          <ac:cxnSpMkLst>
            <pc:docMk/>
            <pc:sldMk cId="1906182640" sldId="301"/>
            <ac:cxnSpMk id="19" creationId="{979B1187-DCCB-97A2-3C7D-4FF96D7F2E80}"/>
          </ac:cxnSpMkLst>
        </pc:cxnChg>
        <pc:cxnChg chg="add del mod">
          <ac:chgData name="Kumar, Vinod" userId="a0710a6e-bffc-4971-8893-1c23addeb5b0" providerId="ADAL" clId="{AD4E4DE1-9CB1-4771-A235-1540E1ED3060}" dt="2023-01-05T19:21:00.832" v="2559" actId="478"/>
          <ac:cxnSpMkLst>
            <pc:docMk/>
            <pc:sldMk cId="1906182640" sldId="301"/>
            <ac:cxnSpMk id="25" creationId="{60C78AA8-B059-85C6-02F7-26352D9C0138}"/>
          </ac:cxnSpMkLst>
        </pc:cxnChg>
      </pc:sldChg>
      <pc:sldChg chg="modSp del mod">
        <pc:chgData name="Kumar, Vinod" userId="a0710a6e-bffc-4971-8893-1c23addeb5b0" providerId="ADAL" clId="{AD4E4DE1-9CB1-4771-A235-1540E1ED3060}" dt="2023-01-06T20:33:00.756" v="7772" actId="47"/>
        <pc:sldMkLst>
          <pc:docMk/>
          <pc:sldMk cId="2244443222" sldId="302"/>
        </pc:sldMkLst>
        <pc:spChg chg="mod">
          <ac:chgData name="Kumar, Vinod" userId="a0710a6e-bffc-4971-8893-1c23addeb5b0" providerId="ADAL" clId="{AD4E4DE1-9CB1-4771-A235-1540E1ED3060}" dt="2023-01-06T19:53:22.602" v="6673" actId="1076"/>
          <ac:spMkLst>
            <pc:docMk/>
            <pc:sldMk cId="2244443222" sldId="302"/>
            <ac:spMk id="2" creationId="{086F389C-2B07-5F00-EA2A-17A9729D565C}"/>
          </ac:spMkLst>
        </pc:spChg>
      </pc:sldChg>
      <pc:sldChg chg="addSp delSp modSp mod">
        <pc:chgData name="Kumar, Vinod" userId="a0710a6e-bffc-4971-8893-1c23addeb5b0" providerId="ADAL" clId="{AD4E4DE1-9CB1-4771-A235-1540E1ED3060}" dt="2023-01-06T19:54:22.017" v="6680" actId="14100"/>
        <pc:sldMkLst>
          <pc:docMk/>
          <pc:sldMk cId="2794359920" sldId="303"/>
        </pc:sldMkLst>
        <pc:spChg chg="add mod">
          <ac:chgData name="Kumar, Vinod" userId="a0710a6e-bffc-4971-8893-1c23addeb5b0" providerId="ADAL" clId="{AD4E4DE1-9CB1-4771-A235-1540E1ED3060}" dt="2022-12-21T21:31:43.850" v="416" actId="122"/>
          <ac:spMkLst>
            <pc:docMk/>
            <pc:sldMk cId="2794359920" sldId="303"/>
            <ac:spMk id="3" creationId="{549D2B20-EC28-516E-1781-12FB854F9CC7}"/>
          </ac:spMkLst>
        </pc:spChg>
        <pc:spChg chg="mod topLvl">
          <ac:chgData name="Kumar, Vinod" userId="a0710a6e-bffc-4971-8893-1c23addeb5b0" providerId="ADAL" clId="{AD4E4DE1-9CB1-4771-A235-1540E1ED3060}" dt="2022-12-21T21:29:06.151" v="314" actId="165"/>
          <ac:spMkLst>
            <pc:docMk/>
            <pc:sldMk cId="2794359920" sldId="303"/>
            <ac:spMk id="4" creationId="{34897CEC-8788-4E23-A2EB-129E341C1E2C}"/>
          </ac:spMkLst>
        </pc:spChg>
        <pc:spChg chg="mod topLvl">
          <ac:chgData name="Kumar, Vinod" userId="a0710a6e-bffc-4971-8893-1c23addeb5b0" providerId="ADAL" clId="{AD4E4DE1-9CB1-4771-A235-1540E1ED3060}" dt="2022-12-21T21:29:06.151" v="314" actId="165"/>
          <ac:spMkLst>
            <pc:docMk/>
            <pc:sldMk cId="2794359920" sldId="303"/>
            <ac:spMk id="5" creationId="{EBE000ED-B1A1-3050-3231-53F952EF004E}"/>
          </ac:spMkLst>
        </pc:spChg>
        <pc:spChg chg="mod topLvl">
          <ac:chgData name="Kumar, Vinod" userId="a0710a6e-bffc-4971-8893-1c23addeb5b0" providerId="ADAL" clId="{AD4E4DE1-9CB1-4771-A235-1540E1ED3060}" dt="2022-12-21T21:29:06.151" v="314" actId="165"/>
          <ac:spMkLst>
            <pc:docMk/>
            <pc:sldMk cId="2794359920" sldId="303"/>
            <ac:spMk id="6" creationId="{D598E17B-EB7B-D68E-071E-EAF0ECE784BD}"/>
          </ac:spMkLst>
        </pc:spChg>
        <pc:spChg chg="mod topLvl">
          <ac:chgData name="Kumar, Vinod" userId="a0710a6e-bffc-4971-8893-1c23addeb5b0" providerId="ADAL" clId="{AD4E4DE1-9CB1-4771-A235-1540E1ED3060}" dt="2022-12-21T21:29:06.151" v="314" actId="165"/>
          <ac:spMkLst>
            <pc:docMk/>
            <pc:sldMk cId="2794359920" sldId="303"/>
            <ac:spMk id="7" creationId="{B6E398F8-4570-6114-9D17-E136BFDC1614}"/>
          </ac:spMkLst>
        </pc:spChg>
        <pc:spChg chg="mod topLvl">
          <ac:chgData name="Kumar, Vinod" userId="a0710a6e-bffc-4971-8893-1c23addeb5b0" providerId="ADAL" clId="{AD4E4DE1-9CB1-4771-A235-1540E1ED3060}" dt="2022-12-21T21:29:06.151" v="314" actId="165"/>
          <ac:spMkLst>
            <pc:docMk/>
            <pc:sldMk cId="2794359920" sldId="303"/>
            <ac:spMk id="8" creationId="{8B182684-1A9D-EEA6-5871-DD72E987E31A}"/>
          </ac:spMkLst>
        </pc:spChg>
        <pc:spChg chg="mod topLvl">
          <ac:chgData name="Kumar, Vinod" userId="a0710a6e-bffc-4971-8893-1c23addeb5b0" providerId="ADAL" clId="{AD4E4DE1-9CB1-4771-A235-1540E1ED3060}" dt="2022-12-21T21:29:06.151" v="314" actId="165"/>
          <ac:spMkLst>
            <pc:docMk/>
            <pc:sldMk cId="2794359920" sldId="303"/>
            <ac:spMk id="9" creationId="{B5482599-9DD0-C32C-1446-5E037C93065E}"/>
          </ac:spMkLst>
        </pc:spChg>
        <pc:spChg chg="mod topLvl">
          <ac:chgData name="Kumar, Vinod" userId="a0710a6e-bffc-4971-8893-1c23addeb5b0" providerId="ADAL" clId="{AD4E4DE1-9CB1-4771-A235-1540E1ED3060}" dt="2022-12-21T21:29:06.151" v="314" actId="165"/>
          <ac:spMkLst>
            <pc:docMk/>
            <pc:sldMk cId="2794359920" sldId="303"/>
            <ac:spMk id="10" creationId="{F88FF6F7-3F90-A2CD-FEF6-B15AC9DE672B}"/>
          </ac:spMkLst>
        </pc:spChg>
        <pc:spChg chg="del mod topLvl">
          <ac:chgData name="Kumar, Vinod" userId="a0710a6e-bffc-4971-8893-1c23addeb5b0" providerId="ADAL" clId="{AD4E4DE1-9CB1-4771-A235-1540E1ED3060}" dt="2022-12-21T21:30:49.210" v="389" actId="478"/>
          <ac:spMkLst>
            <pc:docMk/>
            <pc:sldMk cId="2794359920" sldId="303"/>
            <ac:spMk id="15" creationId="{F91BF159-A8AB-AE76-1D16-1E285CB2F48B}"/>
          </ac:spMkLst>
        </pc:spChg>
        <pc:spChg chg="mod">
          <ac:chgData name="Kumar, Vinod" userId="a0710a6e-bffc-4971-8893-1c23addeb5b0" providerId="ADAL" clId="{AD4E4DE1-9CB1-4771-A235-1540E1ED3060}" dt="2023-01-06T19:54:14.698" v="6678" actId="14100"/>
          <ac:spMkLst>
            <pc:docMk/>
            <pc:sldMk cId="2794359920" sldId="303"/>
            <ac:spMk id="16" creationId="{D0745951-7BFA-ACAA-D3B9-F109297E6D86}"/>
          </ac:spMkLst>
        </pc:spChg>
        <pc:spChg chg="mod topLvl">
          <ac:chgData name="Kumar, Vinod" userId="a0710a6e-bffc-4971-8893-1c23addeb5b0" providerId="ADAL" clId="{AD4E4DE1-9CB1-4771-A235-1540E1ED3060}" dt="2022-12-21T21:29:06.151" v="314" actId="165"/>
          <ac:spMkLst>
            <pc:docMk/>
            <pc:sldMk cId="2794359920" sldId="303"/>
            <ac:spMk id="18" creationId="{6BDF7E7D-EC93-091B-3714-48C043BEAA7B}"/>
          </ac:spMkLst>
        </pc:spChg>
        <pc:spChg chg="mod">
          <ac:chgData name="Kumar, Vinod" userId="a0710a6e-bffc-4971-8893-1c23addeb5b0" providerId="ADAL" clId="{AD4E4DE1-9CB1-4771-A235-1540E1ED3060}" dt="2023-01-06T19:54:10.809" v="6677" actId="255"/>
          <ac:spMkLst>
            <pc:docMk/>
            <pc:sldMk cId="2794359920" sldId="303"/>
            <ac:spMk id="21" creationId="{D7D88FA0-6D0C-96BF-6837-CE8C7D2C18F7}"/>
          </ac:spMkLst>
        </pc:spChg>
        <pc:spChg chg="mod">
          <ac:chgData name="Kumar, Vinod" userId="a0710a6e-bffc-4971-8893-1c23addeb5b0" providerId="ADAL" clId="{AD4E4DE1-9CB1-4771-A235-1540E1ED3060}" dt="2023-01-06T19:54:22.017" v="6680" actId="14100"/>
          <ac:spMkLst>
            <pc:docMk/>
            <pc:sldMk cId="2794359920" sldId="303"/>
            <ac:spMk id="22" creationId="{56DBA533-46D5-F4DE-11B3-F9F694AA03DD}"/>
          </ac:spMkLst>
        </pc:spChg>
        <pc:spChg chg="mod">
          <ac:chgData name="Kumar, Vinod" userId="a0710a6e-bffc-4971-8893-1c23addeb5b0" providerId="ADAL" clId="{AD4E4DE1-9CB1-4771-A235-1540E1ED3060}" dt="2023-01-06T19:54:17.722" v="6679" actId="14100"/>
          <ac:spMkLst>
            <pc:docMk/>
            <pc:sldMk cId="2794359920" sldId="303"/>
            <ac:spMk id="24" creationId="{B6986ADE-E594-2EB1-24CD-9A678E12DE2C}"/>
          </ac:spMkLst>
        </pc:spChg>
        <pc:spChg chg="add mod">
          <ac:chgData name="Kumar, Vinod" userId="a0710a6e-bffc-4971-8893-1c23addeb5b0" providerId="ADAL" clId="{AD4E4DE1-9CB1-4771-A235-1540E1ED3060}" dt="2022-12-21T21:31:55.356" v="420" actId="1038"/>
          <ac:spMkLst>
            <pc:docMk/>
            <pc:sldMk cId="2794359920" sldId="303"/>
            <ac:spMk id="26" creationId="{3FC68601-31B8-0469-A675-57F85B2832D4}"/>
          </ac:spMkLst>
        </pc:spChg>
        <pc:grpChg chg="del">
          <ac:chgData name="Kumar, Vinod" userId="a0710a6e-bffc-4971-8893-1c23addeb5b0" providerId="ADAL" clId="{AD4E4DE1-9CB1-4771-A235-1540E1ED3060}" dt="2022-12-21T21:29:06.151" v="314" actId="165"/>
          <ac:grpSpMkLst>
            <pc:docMk/>
            <pc:sldMk cId="2794359920" sldId="303"/>
            <ac:grpSpMk id="23" creationId="{90B82DBD-4CF5-CAF2-9597-A015FE84D9BA}"/>
          </ac:grpSpMkLst>
        </pc:grpChg>
        <pc:picChg chg="del">
          <ac:chgData name="Kumar, Vinod" userId="a0710a6e-bffc-4971-8893-1c23addeb5b0" providerId="ADAL" clId="{AD4E4DE1-9CB1-4771-A235-1540E1ED3060}" dt="2022-12-09T22:02:20.717" v="146" actId="478"/>
          <ac:picMkLst>
            <pc:docMk/>
            <pc:sldMk cId="2794359920" sldId="303"/>
            <ac:picMk id="3" creationId="{EEDE6CC3-057A-8BF6-60DE-B64F4803147C}"/>
          </ac:picMkLst>
        </pc:picChg>
        <pc:picChg chg="mod topLvl">
          <ac:chgData name="Kumar, Vinod" userId="a0710a6e-bffc-4971-8893-1c23addeb5b0" providerId="ADAL" clId="{AD4E4DE1-9CB1-4771-A235-1540E1ED3060}" dt="2022-12-21T21:29:06.151" v="314" actId="165"/>
          <ac:picMkLst>
            <pc:docMk/>
            <pc:sldMk cId="2794359920" sldId="303"/>
            <ac:picMk id="11" creationId="{548D93EB-C38F-65EF-4A59-4F410E66F21E}"/>
          </ac:picMkLst>
        </pc:picChg>
        <pc:picChg chg="mod topLvl">
          <ac:chgData name="Kumar, Vinod" userId="a0710a6e-bffc-4971-8893-1c23addeb5b0" providerId="ADAL" clId="{AD4E4DE1-9CB1-4771-A235-1540E1ED3060}" dt="2022-12-21T21:29:06.151" v="314" actId="165"/>
          <ac:picMkLst>
            <pc:docMk/>
            <pc:sldMk cId="2794359920" sldId="303"/>
            <ac:picMk id="12" creationId="{BCF04BB9-FA09-3864-9A77-BBDBC91583A6}"/>
          </ac:picMkLst>
        </pc:picChg>
        <pc:picChg chg="add mod">
          <ac:chgData name="Kumar, Vinod" userId="a0710a6e-bffc-4971-8893-1c23addeb5b0" providerId="ADAL" clId="{AD4E4DE1-9CB1-4771-A235-1540E1ED3060}" dt="2022-12-22T19:13:29.829" v="536" actId="1036"/>
          <ac:picMkLst>
            <pc:docMk/>
            <pc:sldMk cId="2794359920" sldId="303"/>
            <ac:picMk id="15" creationId="{D28DCB59-05A2-686E-29D3-9BDE69DAA919}"/>
          </ac:picMkLst>
        </pc:picChg>
        <pc:picChg chg="mod topLvl">
          <ac:chgData name="Kumar, Vinod" userId="a0710a6e-bffc-4971-8893-1c23addeb5b0" providerId="ADAL" clId="{AD4E4DE1-9CB1-4771-A235-1540E1ED3060}" dt="2022-12-21T21:29:06.151" v="314" actId="165"/>
          <ac:picMkLst>
            <pc:docMk/>
            <pc:sldMk cId="2794359920" sldId="303"/>
            <ac:picMk id="17" creationId="{212EC4EF-77B3-5368-6E6B-A75EF87935BA}"/>
          </ac:picMkLst>
        </pc:picChg>
        <pc:picChg chg="mod">
          <ac:chgData name="Kumar, Vinod" userId="a0710a6e-bffc-4971-8893-1c23addeb5b0" providerId="ADAL" clId="{AD4E4DE1-9CB1-4771-A235-1540E1ED3060}" dt="2022-12-22T19:13:39.893" v="540" actId="1036"/>
          <ac:picMkLst>
            <pc:docMk/>
            <pc:sldMk cId="2794359920" sldId="303"/>
            <ac:picMk id="19" creationId="{F42524B6-CD05-7E8E-53B3-CF6EDDB555D5}"/>
          </ac:picMkLst>
        </pc:picChg>
        <pc:picChg chg="del">
          <ac:chgData name="Kumar, Vinod" userId="a0710a6e-bffc-4971-8893-1c23addeb5b0" providerId="ADAL" clId="{AD4E4DE1-9CB1-4771-A235-1540E1ED3060}" dt="2022-12-21T21:33:48.776" v="426" actId="478"/>
          <ac:picMkLst>
            <pc:docMk/>
            <pc:sldMk cId="2794359920" sldId="303"/>
            <ac:picMk id="20" creationId="{1357654D-64D1-2FB8-B6BD-EAD2BF1F57E5}"/>
          </ac:picMkLst>
        </pc:picChg>
        <pc:picChg chg="add mod">
          <ac:chgData name="Kumar, Vinod" userId="a0710a6e-bffc-4971-8893-1c23addeb5b0" providerId="ADAL" clId="{AD4E4DE1-9CB1-4771-A235-1540E1ED3060}" dt="2022-12-09T22:02:24.394" v="166" actId="1035"/>
          <ac:picMkLst>
            <pc:docMk/>
            <pc:sldMk cId="2794359920" sldId="303"/>
            <ac:picMk id="25" creationId="{66B990EB-5342-F93A-4A84-55FAB50DC1FB}"/>
          </ac:picMkLst>
        </pc:picChg>
        <pc:picChg chg="add del mod">
          <ac:chgData name="Kumar, Vinod" userId="a0710a6e-bffc-4971-8893-1c23addeb5b0" providerId="ADAL" clId="{AD4E4DE1-9CB1-4771-A235-1540E1ED3060}" dt="2022-12-22T18:41:38.533" v="431" actId="478"/>
          <ac:picMkLst>
            <pc:docMk/>
            <pc:sldMk cId="2794359920" sldId="303"/>
            <ac:picMk id="27" creationId="{56ACEEB0-41C2-134F-BF52-E4FA2F21697E}"/>
          </ac:picMkLst>
        </pc:picChg>
        <pc:cxnChg chg="mod topLvl">
          <ac:chgData name="Kumar, Vinod" userId="a0710a6e-bffc-4971-8893-1c23addeb5b0" providerId="ADAL" clId="{AD4E4DE1-9CB1-4771-A235-1540E1ED3060}" dt="2022-12-21T21:30:28.897" v="383" actId="14100"/>
          <ac:cxnSpMkLst>
            <pc:docMk/>
            <pc:sldMk cId="2794359920" sldId="303"/>
            <ac:cxnSpMk id="13" creationId="{7A471A29-F0CC-D035-4611-68861ABA1583}"/>
          </ac:cxnSpMkLst>
        </pc:cxnChg>
        <pc:cxnChg chg="mod topLvl">
          <ac:chgData name="Kumar, Vinod" userId="a0710a6e-bffc-4971-8893-1c23addeb5b0" providerId="ADAL" clId="{AD4E4DE1-9CB1-4771-A235-1540E1ED3060}" dt="2022-12-21T21:30:36.561" v="386" actId="14100"/>
          <ac:cxnSpMkLst>
            <pc:docMk/>
            <pc:sldMk cId="2794359920" sldId="303"/>
            <ac:cxnSpMk id="14" creationId="{F72EE062-61B2-5D71-EE1F-16D26BC6BF5A}"/>
          </ac:cxnSpMkLst>
        </pc:cxnChg>
      </pc:sldChg>
      <pc:sldChg chg="addSp delSp modSp del mod">
        <pc:chgData name="Kumar, Vinod" userId="a0710a6e-bffc-4971-8893-1c23addeb5b0" providerId="ADAL" clId="{AD4E4DE1-9CB1-4771-A235-1540E1ED3060}" dt="2023-01-05T21:16:35.716" v="4346" actId="47"/>
        <pc:sldMkLst>
          <pc:docMk/>
          <pc:sldMk cId="2374493231" sldId="305"/>
        </pc:sldMkLst>
        <pc:spChg chg="mod">
          <ac:chgData name="Kumar, Vinod" userId="a0710a6e-bffc-4971-8893-1c23addeb5b0" providerId="ADAL" clId="{AD4E4DE1-9CB1-4771-A235-1540E1ED3060}" dt="2023-01-05T20:33:57.116" v="3597" actId="1035"/>
          <ac:spMkLst>
            <pc:docMk/>
            <pc:sldMk cId="2374493231" sldId="305"/>
            <ac:spMk id="44" creationId="{0FDEE741-E282-06A8-D31C-F5F277E6C4DD}"/>
          </ac:spMkLst>
        </pc:spChg>
        <pc:spChg chg="mod">
          <ac:chgData name="Kumar, Vinod" userId="a0710a6e-bffc-4971-8893-1c23addeb5b0" providerId="ADAL" clId="{AD4E4DE1-9CB1-4771-A235-1540E1ED3060}" dt="2023-01-05T20:34:11.884" v="3623" actId="1035"/>
          <ac:spMkLst>
            <pc:docMk/>
            <pc:sldMk cId="2374493231" sldId="305"/>
            <ac:spMk id="47" creationId="{83E00672-8393-E5A4-EC16-98B9F0F02D95}"/>
          </ac:spMkLst>
        </pc:spChg>
        <pc:spChg chg="mod">
          <ac:chgData name="Kumar, Vinod" userId="a0710a6e-bffc-4971-8893-1c23addeb5b0" providerId="ADAL" clId="{AD4E4DE1-9CB1-4771-A235-1540E1ED3060}" dt="2023-01-05T20:34:17.084" v="3630" actId="1036"/>
          <ac:spMkLst>
            <pc:docMk/>
            <pc:sldMk cId="2374493231" sldId="305"/>
            <ac:spMk id="50" creationId="{575DD9E8-ABE9-05E4-AE97-B1BAC73CDE61}"/>
          </ac:spMkLst>
        </pc:spChg>
        <pc:spChg chg="mod">
          <ac:chgData name="Kumar, Vinod" userId="a0710a6e-bffc-4971-8893-1c23addeb5b0" providerId="ADAL" clId="{AD4E4DE1-9CB1-4771-A235-1540E1ED3060}" dt="2023-01-05T20:35:53.324" v="3678" actId="1035"/>
          <ac:spMkLst>
            <pc:docMk/>
            <pc:sldMk cId="2374493231" sldId="305"/>
            <ac:spMk id="58" creationId="{07EC96D3-CD7D-6E70-3704-2E723E20E6B3}"/>
          </ac:spMkLst>
        </pc:spChg>
        <pc:spChg chg="mod">
          <ac:chgData name="Kumar, Vinod" userId="a0710a6e-bffc-4971-8893-1c23addeb5b0" providerId="ADAL" clId="{AD4E4DE1-9CB1-4771-A235-1540E1ED3060}" dt="2023-01-05T20:36:13.574" v="3679" actId="164"/>
          <ac:spMkLst>
            <pc:docMk/>
            <pc:sldMk cId="2374493231" sldId="305"/>
            <ac:spMk id="59" creationId="{C3FC9619-994B-2C86-D051-57642D1E0A07}"/>
          </ac:spMkLst>
        </pc:spChg>
        <pc:spChg chg="mod">
          <ac:chgData name="Kumar, Vinod" userId="a0710a6e-bffc-4971-8893-1c23addeb5b0" providerId="ADAL" clId="{AD4E4DE1-9CB1-4771-A235-1540E1ED3060}" dt="2023-01-05T20:39:52.150" v="3781" actId="1036"/>
          <ac:spMkLst>
            <pc:docMk/>
            <pc:sldMk cId="2374493231" sldId="305"/>
            <ac:spMk id="60" creationId="{0C54D10B-BB99-2764-5BCA-447084C91BAE}"/>
          </ac:spMkLst>
        </pc:spChg>
        <pc:spChg chg="mod">
          <ac:chgData name="Kumar, Vinod" userId="a0710a6e-bffc-4971-8893-1c23addeb5b0" providerId="ADAL" clId="{AD4E4DE1-9CB1-4771-A235-1540E1ED3060}" dt="2023-01-05T20:39:52.628" v="3782" actId="164"/>
          <ac:spMkLst>
            <pc:docMk/>
            <pc:sldMk cId="2374493231" sldId="305"/>
            <ac:spMk id="61" creationId="{723D7F5C-88B3-84BF-CB53-D2CED75CE33D}"/>
          </ac:spMkLst>
        </pc:spChg>
        <pc:spChg chg="mod">
          <ac:chgData name="Kumar, Vinod" userId="a0710a6e-bffc-4971-8893-1c23addeb5b0" providerId="ADAL" clId="{AD4E4DE1-9CB1-4771-A235-1540E1ED3060}" dt="2023-01-05T20:39:50.148" v="3777" actId="164"/>
          <ac:spMkLst>
            <pc:docMk/>
            <pc:sldMk cId="2374493231" sldId="305"/>
            <ac:spMk id="62" creationId="{B82E76CC-AA60-5E47-5A4D-CFE89C7571FD}"/>
          </ac:spMkLst>
        </pc:spChg>
        <pc:spChg chg="mod">
          <ac:chgData name="Kumar, Vinod" userId="a0710a6e-bffc-4971-8893-1c23addeb5b0" providerId="ADAL" clId="{AD4E4DE1-9CB1-4771-A235-1540E1ED3060}" dt="2023-01-05T20:35:34.988" v="3662" actId="1036"/>
          <ac:spMkLst>
            <pc:docMk/>
            <pc:sldMk cId="2374493231" sldId="305"/>
            <ac:spMk id="65" creationId="{CA9AEFB4-1F1E-78ED-3BEE-8D4011DF8206}"/>
          </ac:spMkLst>
        </pc:spChg>
        <pc:spChg chg="mod">
          <ac:chgData name="Kumar, Vinod" userId="a0710a6e-bffc-4971-8893-1c23addeb5b0" providerId="ADAL" clId="{AD4E4DE1-9CB1-4771-A235-1540E1ED3060}" dt="2023-01-05T20:35:34.988" v="3662" actId="1036"/>
          <ac:spMkLst>
            <pc:docMk/>
            <pc:sldMk cId="2374493231" sldId="305"/>
            <ac:spMk id="66" creationId="{ECD109EE-DA3C-C44C-8754-27AD2C09A4FC}"/>
          </ac:spMkLst>
        </pc:spChg>
        <pc:spChg chg="mod">
          <ac:chgData name="Kumar, Vinod" userId="a0710a6e-bffc-4971-8893-1c23addeb5b0" providerId="ADAL" clId="{AD4E4DE1-9CB1-4771-A235-1540E1ED3060}" dt="2023-01-05T20:43:39.655" v="3798" actId="1036"/>
          <ac:spMkLst>
            <pc:docMk/>
            <pc:sldMk cId="2374493231" sldId="305"/>
            <ac:spMk id="67" creationId="{6C98B42E-FA91-63F9-93AB-5C9D69B51027}"/>
          </ac:spMkLst>
        </pc:spChg>
        <pc:spChg chg="mod">
          <ac:chgData name="Kumar, Vinod" userId="a0710a6e-bffc-4971-8893-1c23addeb5b0" providerId="ADAL" clId="{AD4E4DE1-9CB1-4771-A235-1540E1ED3060}" dt="2023-01-05T20:43:39.655" v="3798" actId="1036"/>
          <ac:spMkLst>
            <pc:docMk/>
            <pc:sldMk cId="2374493231" sldId="305"/>
            <ac:spMk id="68" creationId="{005730C1-1D48-12CD-3868-E22C263D3106}"/>
          </ac:spMkLst>
        </pc:spChg>
        <pc:spChg chg="mod">
          <ac:chgData name="Kumar, Vinod" userId="a0710a6e-bffc-4971-8893-1c23addeb5b0" providerId="ADAL" clId="{AD4E4DE1-9CB1-4771-A235-1540E1ED3060}" dt="2023-01-05T20:43:48.536" v="3802" actId="1035"/>
          <ac:spMkLst>
            <pc:docMk/>
            <pc:sldMk cId="2374493231" sldId="305"/>
            <ac:spMk id="69" creationId="{15DA2A9A-E91E-7411-3E5F-D398FA45D7E6}"/>
          </ac:spMkLst>
        </pc:spChg>
        <pc:spChg chg="mod">
          <ac:chgData name="Kumar, Vinod" userId="a0710a6e-bffc-4971-8893-1c23addeb5b0" providerId="ADAL" clId="{AD4E4DE1-9CB1-4771-A235-1540E1ED3060}" dt="2023-01-05T20:43:48.536" v="3802" actId="1035"/>
          <ac:spMkLst>
            <pc:docMk/>
            <pc:sldMk cId="2374493231" sldId="305"/>
            <ac:spMk id="70" creationId="{F63C9B63-4BA1-D70E-BF01-B84BCE9BBD50}"/>
          </ac:spMkLst>
        </pc:spChg>
        <pc:spChg chg="mod">
          <ac:chgData name="Kumar, Vinod" userId="a0710a6e-bffc-4971-8893-1c23addeb5b0" providerId="ADAL" clId="{AD4E4DE1-9CB1-4771-A235-1540E1ED3060}" dt="2023-01-05T20:39:49.747" v="3776" actId="1035"/>
          <ac:spMkLst>
            <pc:docMk/>
            <pc:sldMk cId="2374493231" sldId="305"/>
            <ac:spMk id="71" creationId="{FBB29273-058A-F81B-4735-90094311D47D}"/>
          </ac:spMkLst>
        </pc:spChg>
        <pc:spChg chg="mod">
          <ac:chgData name="Kumar, Vinod" userId="a0710a6e-bffc-4971-8893-1c23addeb5b0" providerId="ADAL" clId="{AD4E4DE1-9CB1-4771-A235-1540E1ED3060}" dt="2023-01-05T20:35:42.204" v="3664" actId="1035"/>
          <ac:spMkLst>
            <pc:docMk/>
            <pc:sldMk cId="2374493231" sldId="305"/>
            <ac:spMk id="73" creationId="{3DC87012-760F-483C-9104-E6DEDCC490D2}"/>
          </ac:spMkLst>
        </pc:spChg>
        <pc:grpChg chg="add mod">
          <ac:chgData name="Kumar, Vinod" userId="a0710a6e-bffc-4971-8893-1c23addeb5b0" providerId="ADAL" clId="{AD4E4DE1-9CB1-4771-A235-1540E1ED3060}" dt="2023-01-05T20:43:32.136" v="3795" actId="1036"/>
          <ac:grpSpMkLst>
            <pc:docMk/>
            <pc:sldMk cId="2374493231" sldId="305"/>
            <ac:grpSpMk id="5" creationId="{F737B462-7539-7F1E-7C44-457709E8283A}"/>
          </ac:grpSpMkLst>
        </pc:grpChg>
        <pc:grpChg chg="add mod">
          <ac:chgData name="Kumar, Vinod" userId="a0710a6e-bffc-4971-8893-1c23addeb5b0" providerId="ADAL" clId="{AD4E4DE1-9CB1-4771-A235-1540E1ED3060}" dt="2023-01-05T20:43:48.536" v="3802" actId="1035"/>
          <ac:grpSpMkLst>
            <pc:docMk/>
            <pc:sldMk cId="2374493231" sldId="305"/>
            <ac:grpSpMk id="6" creationId="{7897164E-14EE-7EFA-F20B-3A25BF9EDF62}"/>
          </ac:grpSpMkLst>
        </pc:grpChg>
        <pc:grpChg chg="add mod">
          <ac:chgData name="Kumar, Vinod" userId="a0710a6e-bffc-4971-8893-1c23addeb5b0" providerId="ADAL" clId="{AD4E4DE1-9CB1-4771-A235-1540E1ED3060}" dt="2023-01-05T20:39:52.628" v="3782" actId="164"/>
          <ac:grpSpMkLst>
            <pc:docMk/>
            <pc:sldMk cId="2374493231" sldId="305"/>
            <ac:grpSpMk id="7" creationId="{59C4E9CD-141D-AF97-27E8-E7929A51A7FB}"/>
          </ac:grpSpMkLst>
        </pc:grpChg>
        <pc:grpChg chg="add mod">
          <ac:chgData name="Kumar, Vinod" userId="a0710a6e-bffc-4971-8893-1c23addeb5b0" providerId="ADAL" clId="{AD4E4DE1-9CB1-4771-A235-1540E1ED3060}" dt="2023-01-05T20:39:50.148" v="3777" actId="164"/>
          <ac:grpSpMkLst>
            <pc:docMk/>
            <pc:sldMk cId="2374493231" sldId="305"/>
            <ac:grpSpMk id="8" creationId="{F87EF4B6-7068-001C-5BC8-535A870AE6FC}"/>
          </ac:grpSpMkLst>
        </pc:grpChg>
        <pc:grpChg chg="mod">
          <ac:chgData name="Kumar, Vinod" userId="a0710a6e-bffc-4971-8893-1c23addeb5b0" providerId="ADAL" clId="{AD4E4DE1-9CB1-4771-A235-1540E1ED3060}" dt="2023-01-05T20:35:34.988" v="3662" actId="1036"/>
          <ac:grpSpMkLst>
            <pc:docMk/>
            <pc:sldMk cId="2374493231" sldId="305"/>
            <ac:grpSpMk id="42" creationId="{ACD1F7E2-17CB-092F-370A-5BC092437F7A}"/>
          </ac:grpSpMkLst>
        </pc:grpChg>
        <pc:grpChg chg="mod">
          <ac:chgData name="Kumar, Vinod" userId="a0710a6e-bffc-4971-8893-1c23addeb5b0" providerId="ADAL" clId="{AD4E4DE1-9CB1-4771-A235-1540E1ED3060}" dt="2023-01-05T20:43:32.136" v="3795" actId="1036"/>
          <ac:grpSpMkLst>
            <pc:docMk/>
            <pc:sldMk cId="2374493231" sldId="305"/>
            <ac:grpSpMk id="45" creationId="{0BC00F63-F12C-0E90-D12A-84CC1F9755F4}"/>
          </ac:grpSpMkLst>
        </pc:grpChg>
        <pc:grpChg chg="mod">
          <ac:chgData name="Kumar, Vinod" userId="a0710a6e-bffc-4971-8893-1c23addeb5b0" providerId="ADAL" clId="{AD4E4DE1-9CB1-4771-A235-1540E1ED3060}" dt="2023-01-05T20:43:48.536" v="3802" actId="1035"/>
          <ac:grpSpMkLst>
            <pc:docMk/>
            <pc:sldMk cId="2374493231" sldId="305"/>
            <ac:grpSpMk id="48" creationId="{DA988982-3960-F2BC-0BB8-BF76EC7439E7}"/>
          </ac:grpSpMkLst>
        </pc:grpChg>
        <pc:picChg chg="add del mod">
          <ac:chgData name="Kumar, Vinod" userId="a0710a6e-bffc-4971-8893-1c23addeb5b0" providerId="ADAL" clId="{AD4E4DE1-9CB1-4771-A235-1540E1ED3060}" dt="2023-01-05T19:28:04.460" v="2631" actId="478"/>
          <ac:picMkLst>
            <pc:docMk/>
            <pc:sldMk cId="2374493231" sldId="305"/>
            <ac:picMk id="2" creationId="{E6EC6C5E-1DB3-E030-6BB1-BAA37CFEE5E3}"/>
          </ac:picMkLst>
        </pc:picChg>
        <pc:picChg chg="add mod">
          <ac:chgData name="Kumar, Vinod" userId="a0710a6e-bffc-4971-8893-1c23addeb5b0" providerId="ADAL" clId="{AD4E4DE1-9CB1-4771-A235-1540E1ED3060}" dt="2023-01-05T20:33:31.013" v="3572" actId="1076"/>
          <ac:picMkLst>
            <pc:docMk/>
            <pc:sldMk cId="2374493231" sldId="305"/>
            <ac:picMk id="3" creationId="{76372DB3-D2F4-1F77-233A-08C1A430B2EB}"/>
          </ac:picMkLst>
        </pc:picChg>
        <pc:picChg chg="add mod">
          <ac:chgData name="Kumar, Vinod" userId="a0710a6e-bffc-4971-8893-1c23addeb5b0" providerId="ADAL" clId="{AD4E4DE1-9CB1-4771-A235-1540E1ED3060}" dt="2023-01-05T20:33:31.013" v="3572" actId="1076"/>
          <ac:picMkLst>
            <pc:docMk/>
            <pc:sldMk cId="2374493231" sldId="305"/>
            <ac:picMk id="4" creationId="{772B80AD-03DC-1A5C-1978-30A9C79421E9}"/>
          </ac:picMkLst>
        </pc:picChg>
        <pc:picChg chg="add del mod">
          <ac:chgData name="Kumar, Vinod" userId="a0710a6e-bffc-4971-8893-1c23addeb5b0" providerId="ADAL" clId="{AD4E4DE1-9CB1-4771-A235-1540E1ED3060}" dt="2023-01-05T20:39:44.827" v="3768"/>
          <ac:picMkLst>
            <pc:docMk/>
            <pc:sldMk cId="2374493231" sldId="305"/>
            <ac:picMk id="9" creationId="{84E1351F-B782-5ECE-FC86-E48EF238E039}"/>
          </ac:picMkLst>
        </pc:picChg>
        <pc:picChg chg="add del mod">
          <ac:chgData name="Kumar, Vinod" userId="a0710a6e-bffc-4971-8893-1c23addeb5b0" providerId="ADAL" clId="{AD4E4DE1-9CB1-4771-A235-1540E1ED3060}" dt="2023-01-05T20:39:44.827" v="3768"/>
          <ac:picMkLst>
            <pc:docMk/>
            <pc:sldMk cId="2374493231" sldId="305"/>
            <ac:picMk id="10" creationId="{5C7C0744-6A6A-C908-082F-CE0A771A7616}"/>
          </ac:picMkLst>
        </pc:picChg>
        <pc:picChg chg="mod">
          <ac:chgData name="Kumar, Vinod" userId="a0710a6e-bffc-4971-8893-1c23addeb5b0" providerId="ADAL" clId="{AD4E4DE1-9CB1-4771-A235-1540E1ED3060}" dt="2023-01-05T20:35:34.988" v="3662" actId="1036"/>
          <ac:picMkLst>
            <pc:docMk/>
            <pc:sldMk cId="2374493231" sldId="305"/>
            <ac:picMk id="51" creationId="{CD145B98-AFEF-0D39-B5D5-CE187869F680}"/>
          </ac:picMkLst>
        </pc:picChg>
        <pc:picChg chg="mod">
          <ac:chgData name="Kumar, Vinod" userId="a0710a6e-bffc-4971-8893-1c23addeb5b0" providerId="ADAL" clId="{AD4E4DE1-9CB1-4771-A235-1540E1ED3060}" dt="2023-01-05T20:36:13.574" v="3679" actId="164"/>
          <ac:picMkLst>
            <pc:docMk/>
            <pc:sldMk cId="2374493231" sldId="305"/>
            <ac:picMk id="52" creationId="{4C6E0920-B45A-AFA5-CC83-A757E6BD5EB7}"/>
          </ac:picMkLst>
        </pc:picChg>
        <pc:picChg chg="mod">
          <ac:chgData name="Kumar, Vinod" userId="a0710a6e-bffc-4971-8893-1c23addeb5b0" providerId="ADAL" clId="{AD4E4DE1-9CB1-4771-A235-1540E1ED3060}" dt="2023-01-05T20:36:46.442" v="3702" actId="164"/>
          <ac:picMkLst>
            <pc:docMk/>
            <pc:sldMk cId="2374493231" sldId="305"/>
            <ac:picMk id="53" creationId="{91B5085D-8443-3015-0638-C1FBDC33DC53}"/>
          </ac:picMkLst>
        </pc:picChg>
        <pc:picChg chg="mod">
          <ac:chgData name="Kumar, Vinod" userId="a0710a6e-bffc-4971-8893-1c23addeb5b0" providerId="ADAL" clId="{AD4E4DE1-9CB1-4771-A235-1540E1ED3060}" dt="2023-01-05T20:39:50.148" v="3777" actId="164"/>
          <ac:picMkLst>
            <pc:docMk/>
            <pc:sldMk cId="2374493231" sldId="305"/>
            <ac:picMk id="56" creationId="{789A4ADC-CE66-328B-9319-43B0EE760873}"/>
          </ac:picMkLst>
        </pc:picChg>
        <pc:picChg chg="mod">
          <ac:chgData name="Kumar, Vinod" userId="a0710a6e-bffc-4971-8893-1c23addeb5b0" providerId="ADAL" clId="{AD4E4DE1-9CB1-4771-A235-1540E1ED3060}" dt="2023-01-05T20:39:52.628" v="3782" actId="164"/>
          <ac:picMkLst>
            <pc:docMk/>
            <pc:sldMk cId="2374493231" sldId="305"/>
            <ac:picMk id="57" creationId="{E32FB097-48D8-EA98-7117-FA2DA78498DA}"/>
          </ac:picMkLst>
        </pc:picChg>
      </pc:sldChg>
      <pc:sldChg chg="addSp delSp modSp mod">
        <pc:chgData name="Kumar, Vinod" userId="a0710a6e-bffc-4971-8893-1c23addeb5b0" providerId="ADAL" clId="{AD4E4DE1-9CB1-4771-A235-1540E1ED3060}" dt="2023-01-06T19:53:05.274" v="6671" actId="1036"/>
        <pc:sldMkLst>
          <pc:docMk/>
          <pc:sldMk cId="1231753045" sldId="306"/>
        </pc:sldMkLst>
        <pc:spChg chg="mod">
          <ac:chgData name="Kumar, Vinod" userId="a0710a6e-bffc-4971-8893-1c23addeb5b0" providerId="ADAL" clId="{AD4E4DE1-9CB1-4771-A235-1540E1ED3060}" dt="2023-01-06T19:53:05.274" v="6671" actId="1036"/>
          <ac:spMkLst>
            <pc:docMk/>
            <pc:sldMk cId="1231753045" sldId="306"/>
            <ac:spMk id="7" creationId="{C56CA07C-310B-7CB3-A9A5-D9A9ED7A54FF}"/>
          </ac:spMkLst>
        </pc:spChg>
        <pc:spChg chg="del mod topLvl">
          <ac:chgData name="Kumar, Vinod" userId="a0710a6e-bffc-4971-8893-1c23addeb5b0" providerId="ADAL" clId="{AD4E4DE1-9CB1-4771-A235-1540E1ED3060}" dt="2023-01-05T20:18:35.477" v="3340" actId="478"/>
          <ac:spMkLst>
            <pc:docMk/>
            <pc:sldMk cId="1231753045" sldId="306"/>
            <ac:spMk id="12" creationId="{745A4AA6-B7EA-9915-DFEF-BECB77E26971}"/>
          </ac:spMkLst>
        </pc:spChg>
        <pc:spChg chg="del mod topLvl">
          <ac:chgData name="Kumar, Vinod" userId="a0710a6e-bffc-4971-8893-1c23addeb5b0" providerId="ADAL" clId="{AD4E4DE1-9CB1-4771-A235-1540E1ED3060}" dt="2023-01-05T20:18:33.172" v="3339" actId="478"/>
          <ac:spMkLst>
            <pc:docMk/>
            <pc:sldMk cId="1231753045" sldId="306"/>
            <ac:spMk id="16" creationId="{FCF2737C-C29D-A06A-2C93-9519D4CC359E}"/>
          </ac:spMkLst>
        </pc:spChg>
        <pc:spChg chg="del mod topLvl">
          <ac:chgData name="Kumar, Vinod" userId="a0710a6e-bffc-4971-8893-1c23addeb5b0" providerId="ADAL" clId="{AD4E4DE1-9CB1-4771-A235-1540E1ED3060}" dt="2023-01-05T20:18:33.172" v="3339" actId="478"/>
          <ac:spMkLst>
            <pc:docMk/>
            <pc:sldMk cId="1231753045" sldId="306"/>
            <ac:spMk id="19" creationId="{1BC9F0AB-0573-5676-F6C1-39A22B20F94A}"/>
          </ac:spMkLst>
        </pc:spChg>
        <pc:spChg chg="mod">
          <ac:chgData name="Kumar, Vinod" userId="a0710a6e-bffc-4971-8893-1c23addeb5b0" providerId="ADAL" clId="{AD4E4DE1-9CB1-4771-A235-1540E1ED3060}" dt="2023-01-06T19:51:00.252" v="6627" actId="1035"/>
          <ac:spMkLst>
            <pc:docMk/>
            <pc:sldMk cId="1231753045" sldId="306"/>
            <ac:spMk id="24" creationId="{3CC663BE-9D93-F87F-7818-C877356A5B1C}"/>
          </ac:spMkLst>
        </pc:spChg>
        <pc:spChg chg="mod">
          <ac:chgData name="Kumar, Vinod" userId="a0710a6e-bffc-4971-8893-1c23addeb5b0" providerId="ADAL" clId="{AD4E4DE1-9CB1-4771-A235-1540E1ED3060}" dt="2023-01-06T19:51:00.252" v="6627" actId="1035"/>
          <ac:spMkLst>
            <pc:docMk/>
            <pc:sldMk cId="1231753045" sldId="306"/>
            <ac:spMk id="25" creationId="{EEA2DED9-D02B-BD07-2DDB-1844946C07FC}"/>
          </ac:spMkLst>
        </pc:spChg>
        <pc:spChg chg="mod">
          <ac:chgData name="Kumar, Vinod" userId="a0710a6e-bffc-4971-8893-1c23addeb5b0" providerId="ADAL" clId="{AD4E4DE1-9CB1-4771-A235-1540E1ED3060}" dt="2023-01-06T19:51:10.891" v="6645" actId="1036"/>
          <ac:spMkLst>
            <pc:docMk/>
            <pc:sldMk cId="1231753045" sldId="306"/>
            <ac:spMk id="26" creationId="{F5C4C9A3-0A8D-5EF8-010D-CF3030AE0D95}"/>
          </ac:spMkLst>
        </pc:spChg>
        <pc:spChg chg="mod">
          <ac:chgData name="Kumar, Vinod" userId="a0710a6e-bffc-4971-8893-1c23addeb5b0" providerId="ADAL" clId="{AD4E4DE1-9CB1-4771-A235-1540E1ED3060}" dt="2023-01-06T19:51:10.891" v="6645" actId="1036"/>
          <ac:spMkLst>
            <pc:docMk/>
            <pc:sldMk cId="1231753045" sldId="306"/>
            <ac:spMk id="27" creationId="{27B17A2C-6532-2CB3-D392-3208B9A65094}"/>
          </ac:spMkLst>
        </pc:spChg>
        <pc:spChg chg="mod">
          <ac:chgData name="Kumar, Vinod" userId="a0710a6e-bffc-4971-8893-1c23addeb5b0" providerId="ADAL" clId="{AD4E4DE1-9CB1-4771-A235-1540E1ED3060}" dt="2023-01-06T19:51:24.891" v="6661" actId="1037"/>
          <ac:spMkLst>
            <pc:docMk/>
            <pc:sldMk cId="1231753045" sldId="306"/>
            <ac:spMk id="28" creationId="{2A61F1F1-2458-F05A-D6AC-BFB7017688BA}"/>
          </ac:spMkLst>
        </pc:spChg>
        <pc:spChg chg="mod">
          <ac:chgData name="Kumar, Vinod" userId="a0710a6e-bffc-4971-8893-1c23addeb5b0" providerId="ADAL" clId="{AD4E4DE1-9CB1-4771-A235-1540E1ED3060}" dt="2023-01-06T19:51:24.891" v="6661" actId="1037"/>
          <ac:spMkLst>
            <pc:docMk/>
            <pc:sldMk cId="1231753045" sldId="306"/>
            <ac:spMk id="29" creationId="{760CD5E2-7907-5398-3CE4-410188CBFD00}"/>
          </ac:spMkLst>
        </pc:spChg>
        <pc:spChg chg="mod">
          <ac:chgData name="Kumar, Vinod" userId="a0710a6e-bffc-4971-8893-1c23addeb5b0" providerId="ADAL" clId="{AD4E4DE1-9CB1-4771-A235-1540E1ED3060}" dt="2023-01-06T19:51:32.011" v="6663" actId="1035"/>
          <ac:spMkLst>
            <pc:docMk/>
            <pc:sldMk cId="1231753045" sldId="306"/>
            <ac:spMk id="34" creationId="{2B6C7636-0898-60A7-0EFB-7BCB47A579CA}"/>
          </ac:spMkLst>
        </pc:spChg>
        <pc:spChg chg="mod">
          <ac:chgData name="Kumar, Vinod" userId="a0710a6e-bffc-4971-8893-1c23addeb5b0" providerId="ADAL" clId="{AD4E4DE1-9CB1-4771-A235-1540E1ED3060}" dt="2023-01-06T19:51:32.011" v="6663" actId="1035"/>
          <ac:spMkLst>
            <pc:docMk/>
            <pc:sldMk cId="1231753045" sldId="306"/>
            <ac:spMk id="35" creationId="{CF814D77-3222-924D-96EB-DDE43FF62229}"/>
          </ac:spMkLst>
        </pc:spChg>
        <pc:spChg chg="add del mod">
          <ac:chgData name="Kumar, Vinod" userId="a0710a6e-bffc-4971-8893-1c23addeb5b0" providerId="ADAL" clId="{AD4E4DE1-9CB1-4771-A235-1540E1ED3060}" dt="2023-01-05T21:03:48.158" v="4136" actId="478"/>
          <ac:spMkLst>
            <pc:docMk/>
            <pc:sldMk cId="1231753045" sldId="306"/>
            <ac:spMk id="39" creationId="{6CE2F491-0014-01A6-582C-6DEEC4BC37A8}"/>
          </ac:spMkLst>
        </pc:spChg>
        <pc:spChg chg="add del mod">
          <ac:chgData name="Kumar, Vinod" userId="a0710a6e-bffc-4971-8893-1c23addeb5b0" providerId="ADAL" clId="{AD4E4DE1-9CB1-4771-A235-1540E1ED3060}" dt="2023-01-05T21:03:48.158" v="4136" actId="478"/>
          <ac:spMkLst>
            <pc:docMk/>
            <pc:sldMk cId="1231753045" sldId="306"/>
            <ac:spMk id="40" creationId="{0EAA50FE-3E84-28BB-0023-D43B89853F92}"/>
          </ac:spMkLst>
        </pc:spChg>
        <pc:spChg chg="add del mod">
          <ac:chgData name="Kumar, Vinod" userId="a0710a6e-bffc-4971-8893-1c23addeb5b0" providerId="ADAL" clId="{AD4E4DE1-9CB1-4771-A235-1540E1ED3060}" dt="2023-01-05T21:03:48.158" v="4136" actId="478"/>
          <ac:spMkLst>
            <pc:docMk/>
            <pc:sldMk cId="1231753045" sldId="306"/>
            <ac:spMk id="41" creationId="{B99FA20D-0E24-700A-742C-14D65912CDE8}"/>
          </ac:spMkLst>
        </pc:spChg>
        <pc:spChg chg="add del mod">
          <ac:chgData name="Kumar, Vinod" userId="a0710a6e-bffc-4971-8893-1c23addeb5b0" providerId="ADAL" clId="{AD4E4DE1-9CB1-4771-A235-1540E1ED3060}" dt="2023-01-05T21:03:48.158" v="4136" actId="478"/>
          <ac:spMkLst>
            <pc:docMk/>
            <pc:sldMk cId="1231753045" sldId="306"/>
            <ac:spMk id="42" creationId="{27676419-2001-3470-E6A9-8C45AD715697}"/>
          </ac:spMkLst>
        </pc:spChg>
        <pc:spChg chg="add del mod">
          <ac:chgData name="Kumar, Vinod" userId="a0710a6e-bffc-4971-8893-1c23addeb5b0" providerId="ADAL" clId="{AD4E4DE1-9CB1-4771-A235-1540E1ED3060}" dt="2023-01-05T21:03:48.158" v="4136" actId="478"/>
          <ac:spMkLst>
            <pc:docMk/>
            <pc:sldMk cId="1231753045" sldId="306"/>
            <ac:spMk id="46" creationId="{0B1CA3D4-0D89-C62A-3EF7-F290CDFF1BC6}"/>
          </ac:spMkLst>
        </pc:spChg>
        <pc:spChg chg="add del mod">
          <ac:chgData name="Kumar, Vinod" userId="a0710a6e-bffc-4971-8893-1c23addeb5b0" providerId="ADAL" clId="{AD4E4DE1-9CB1-4771-A235-1540E1ED3060}" dt="2023-01-05T21:03:48.158" v="4136" actId="478"/>
          <ac:spMkLst>
            <pc:docMk/>
            <pc:sldMk cId="1231753045" sldId="306"/>
            <ac:spMk id="48" creationId="{0A56456B-4F5E-FC7F-A34B-949F58F020E7}"/>
          </ac:spMkLst>
        </pc:spChg>
        <pc:spChg chg="add del mod">
          <ac:chgData name="Kumar, Vinod" userId="a0710a6e-bffc-4971-8893-1c23addeb5b0" providerId="ADAL" clId="{AD4E4DE1-9CB1-4771-A235-1540E1ED3060}" dt="2023-01-05T21:03:52.654" v="4137" actId="478"/>
          <ac:spMkLst>
            <pc:docMk/>
            <pc:sldMk cId="1231753045" sldId="306"/>
            <ac:spMk id="53" creationId="{C3A13CBC-AD46-268F-5EC7-6B1785A1B56A}"/>
          </ac:spMkLst>
        </pc:spChg>
        <pc:spChg chg="add del mod">
          <ac:chgData name="Kumar, Vinod" userId="a0710a6e-bffc-4971-8893-1c23addeb5b0" providerId="ADAL" clId="{AD4E4DE1-9CB1-4771-A235-1540E1ED3060}" dt="2023-01-05T21:03:52.654" v="4137" actId="478"/>
          <ac:spMkLst>
            <pc:docMk/>
            <pc:sldMk cId="1231753045" sldId="306"/>
            <ac:spMk id="54" creationId="{AF68B520-1890-8D7A-8A26-75275DC2373A}"/>
          </ac:spMkLst>
        </pc:spChg>
        <pc:spChg chg="add del mod">
          <ac:chgData name="Kumar, Vinod" userId="a0710a6e-bffc-4971-8893-1c23addeb5b0" providerId="ADAL" clId="{AD4E4DE1-9CB1-4771-A235-1540E1ED3060}" dt="2023-01-05T21:03:52.654" v="4137" actId="478"/>
          <ac:spMkLst>
            <pc:docMk/>
            <pc:sldMk cId="1231753045" sldId="306"/>
            <ac:spMk id="55" creationId="{8EB6433C-229F-DB44-351B-E1B334DD1DB5}"/>
          </ac:spMkLst>
        </pc:spChg>
        <pc:spChg chg="add del mod">
          <ac:chgData name="Kumar, Vinod" userId="a0710a6e-bffc-4971-8893-1c23addeb5b0" providerId="ADAL" clId="{AD4E4DE1-9CB1-4771-A235-1540E1ED3060}" dt="2023-01-05T21:03:52.654" v="4137" actId="478"/>
          <ac:spMkLst>
            <pc:docMk/>
            <pc:sldMk cId="1231753045" sldId="306"/>
            <ac:spMk id="57" creationId="{AECA025B-1ED1-C7E0-81DB-8879D80CE2DC}"/>
          </ac:spMkLst>
        </pc:spChg>
        <pc:spChg chg="add del mod">
          <ac:chgData name="Kumar, Vinod" userId="a0710a6e-bffc-4971-8893-1c23addeb5b0" providerId="ADAL" clId="{AD4E4DE1-9CB1-4771-A235-1540E1ED3060}" dt="2023-01-05T21:03:52.654" v="4137" actId="478"/>
          <ac:spMkLst>
            <pc:docMk/>
            <pc:sldMk cId="1231753045" sldId="306"/>
            <ac:spMk id="58" creationId="{4DE61D89-94C8-B587-9A83-67F895606DDB}"/>
          </ac:spMkLst>
        </pc:spChg>
        <pc:spChg chg="add del mod">
          <ac:chgData name="Kumar, Vinod" userId="a0710a6e-bffc-4971-8893-1c23addeb5b0" providerId="ADAL" clId="{AD4E4DE1-9CB1-4771-A235-1540E1ED3060}" dt="2023-01-05T21:03:52.654" v="4137" actId="478"/>
          <ac:spMkLst>
            <pc:docMk/>
            <pc:sldMk cId="1231753045" sldId="306"/>
            <ac:spMk id="59" creationId="{C0AED156-BFA5-AEC6-FB54-EC979B08B1DE}"/>
          </ac:spMkLst>
        </pc:spChg>
        <pc:spChg chg="add del mod">
          <ac:chgData name="Kumar, Vinod" userId="a0710a6e-bffc-4971-8893-1c23addeb5b0" providerId="ADAL" clId="{AD4E4DE1-9CB1-4771-A235-1540E1ED3060}" dt="2023-01-05T21:03:52.654" v="4137" actId="478"/>
          <ac:spMkLst>
            <pc:docMk/>
            <pc:sldMk cId="1231753045" sldId="306"/>
            <ac:spMk id="63" creationId="{51647943-FD26-6C0C-B5CA-FEB333E943D5}"/>
          </ac:spMkLst>
        </pc:spChg>
        <pc:spChg chg="del mod topLvl">
          <ac:chgData name="Kumar, Vinod" userId="a0710a6e-bffc-4971-8893-1c23addeb5b0" providerId="ADAL" clId="{AD4E4DE1-9CB1-4771-A235-1540E1ED3060}" dt="2023-01-05T21:07:40.029" v="4264" actId="478"/>
          <ac:spMkLst>
            <pc:docMk/>
            <pc:sldMk cId="1231753045" sldId="306"/>
            <ac:spMk id="67" creationId="{94E3F778-B880-F001-5A37-659FCF5B212A}"/>
          </ac:spMkLst>
        </pc:spChg>
        <pc:spChg chg="add del mod">
          <ac:chgData name="Kumar, Vinod" userId="a0710a6e-bffc-4971-8893-1c23addeb5b0" providerId="ADAL" clId="{AD4E4DE1-9CB1-4771-A235-1540E1ED3060}" dt="2023-01-05T21:07:15.005" v="4256" actId="478"/>
          <ac:spMkLst>
            <pc:docMk/>
            <pc:sldMk cId="1231753045" sldId="306"/>
            <ac:spMk id="70" creationId="{E27E1945-09CC-DEE3-58EC-DE219B189A1C}"/>
          </ac:spMkLst>
        </pc:spChg>
        <pc:spChg chg="add mod">
          <ac:chgData name="Kumar, Vinod" userId="a0710a6e-bffc-4971-8893-1c23addeb5b0" providerId="ADAL" clId="{AD4E4DE1-9CB1-4771-A235-1540E1ED3060}" dt="2023-01-05T21:07:23.014" v="4257" actId="164"/>
          <ac:spMkLst>
            <pc:docMk/>
            <pc:sldMk cId="1231753045" sldId="306"/>
            <ac:spMk id="72" creationId="{0E0007C8-9A4A-AE12-7316-A4193609E212}"/>
          </ac:spMkLst>
        </pc:spChg>
        <pc:spChg chg="add mod">
          <ac:chgData name="Kumar, Vinod" userId="a0710a6e-bffc-4971-8893-1c23addeb5b0" providerId="ADAL" clId="{AD4E4DE1-9CB1-4771-A235-1540E1ED3060}" dt="2023-01-05T21:09:48.053" v="4307" actId="164"/>
          <ac:spMkLst>
            <pc:docMk/>
            <pc:sldMk cId="1231753045" sldId="306"/>
            <ac:spMk id="76" creationId="{304AB04B-D2E9-D907-B678-CA907C9E7D2E}"/>
          </ac:spMkLst>
        </pc:spChg>
        <pc:spChg chg="add mod">
          <ac:chgData name="Kumar, Vinod" userId="a0710a6e-bffc-4971-8893-1c23addeb5b0" providerId="ADAL" clId="{AD4E4DE1-9CB1-4771-A235-1540E1ED3060}" dt="2023-01-05T21:13:48.609" v="4315" actId="14100"/>
          <ac:spMkLst>
            <pc:docMk/>
            <pc:sldMk cId="1231753045" sldId="306"/>
            <ac:spMk id="78" creationId="{C7DEFC74-5C8B-324C-067B-389707FE8CF2}"/>
          </ac:spMkLst>
        </pc:spChg>
        <pc:spChg chg="add mod">
          <ac:chgData name="Kumar, Vinod" userId="a0710a6e-bffc-4971-8893-1c23addeb5b0" providerId="ADAL" clId="{AD4E4DE1-9CB1-4771-A235-1540E1ED3060}" dt="2023-01-05T21:15:14.041" v="4345" actId="1035"/>
          <ac:spMkLst>
            <pc:docMk/>
            <pc:sldMk cId="1231753045" sldId="306"/>
            <ac:spMk id="79" creationId="{0B717167-A04A-9635-8E24-2CE62D70A68E}"/>
          </ac:spMkLst>
        </pc:spChg>
        <pc:spChg chg="add mod">
          <ac:chgData name="Kumar, Vinod" userId="a0710a6e-bffc-4971-8893-1c23addeb5b0" providerId="ADAL" clId="{AD4E4DE1-9CB1-4771-A235-1540E1ED3060}" dt="2023-01-05T21:14:54.937" v="4341" actId="1035"/>
          <ac:spMkLst>
            <pc:docMk/>
            <pc:sldMk cId="1231753045" sldId="306"/>
            <ac:spMk id="80" creationId="{2525AAE4-7B4D-17F2-D2C9-AA4869F4BE97}"/>
          </ac:spMkLst>
        </pc:spChg>
        <pc:grpChg chg="add del mod">
          <ac:chgData name="Kumar, Vinod" userId="a0710a6e-bffc-4971-8893-1c23addeb5b0" providerId="ADAL" clId="{AD4E4DE1-9CB1-4771-A235-1540E1ED3060}" dt="2023-01-05T20:12:56.671" v="2955" actId="165"/>
          <ac:grpSpMkLst>
            <pc:docMk/>
            <pc:sldMk cId="1231753045" sldId="306"/>
            <ac:grpSpMk id="6" creationId="{B679E8D7-0BA6-0F32-0BC6-88D4314B990F}"/>
          </ac:grpSpMkLst>
        </pc:grpChg>
        <pc:grpChg chg="add del mod">
          <ac:chgData name="Kumar, Vinod" userId="a0710a6e-bffc-4971-8893-1c23addeb5b0" providerId="ADAL" clId="{AD4E4DE1-9CB1-4771-A235-1540E1ED3060}" dt="2023-01-05T21:04:45.895" v="4158" actId="165"/>
          <ac:grpSpMkLst>
            <pc:docMk/>
            <pc:sldMk cId="1231753045" sldId="306"/>
            <ac:grpSpMk id="65" creationId="{00BA4D5D-30AA-B191-680B-5AD61473F407}"/>
          </ac:grpSpMkLst>
        </pc:grpChg>
        <pc:grpChg chg="add del mod">
          <ac:chgData name="Kumar, Vinod" userId="a0710a6e-bffc-4971-8893-1c23addeb5b0" providerId="ADAL" clId="{AD4E4DE1-9CB1-4771-A235-1540E1ED3060}" dt="2023-01-05T21:11:25.595" v="4308" actId="478"/>
          <ac:grpSpMkLst>
            <pc:docMk/>
            <pc:sldMk cId="1231753045" sldId="306"/>
            <ac:grpSpMk id="74" creationId="{4DC37456-29DB-1D58-2EBF-C92AFD3F659E}"/>
          </ac:grpSpMkLst>
        </pc:grpChg>
        <pc:grpChg chg="add mod">
          <ac:chgData name="Kumar, Vinod" userId="a0710a6e-bffc-4971-8893-1c23addeb5b0" providerId="ADAL" clId="{AD4E4DE1-9CB1-4771-A235-1540E1ED3060}" dt="2023-01-05T21:09:48.053" v="4307" actId="164"/>
          <ac:grpSpMkLst>
            <pc:docMk/>
            <pc:sldMk cId="1231753045" sldId="306"/>
            <ac:grpSpMk id="77" creationId="{8A3C7422-9CD4-FCE6-691B-A0F296110B82}"/>
          </ac:grpSpMkLst>
        </pc:grpChg>
        <pc:picChg chg="del mod topLvl">
          <ac:chgData name="Kumar, Vinod" userId="a0710a6e-bffc-4971-8893-1c23addeb5b0" providerId="ADAL" clId="{AD4E4DE1-9CB1-4771-A235-1540E1ED3060}" dt="2023-01-05T20:18:33.172" v="3339" actId="478"/>
          <ac:picMkLst>
            <pc:docMk/>
            <pc:sldMk cId="1231753045" sldId="306"/>
            <ac:picMk id="9" creationId="{79C96016-6A9F-5698-15E4-878ABF84C12E}"/>
          </ac:picMkLst>
        </pc:picChg>
        <pc:picChg chg="del mod topLvl">
          <ac:chgData name="Kumar, Vinod" userId="a0710a6e-bffc-4971-8893-1c23addeb5b0" providerId="ADAL" clId="{AD4E4DE1-9CB1-4771-A235-1540E1ED3060}" dt="2023-01-05T20:18:33.172" v="3339" actId="478"/>
          <ac:picMkLst>
            <pc:docMk/>
            <pc:sldMk cId="1231753045" sldId="306"/>
            <ac:picMk id="10" creationId="{F14B52CE-81DD-4CB0-CFE3-6EEBF0ECD2C4}"/>
          </ac:picMkLst>
        </pc:picChg>
        <pc:picChg chg="del mod topLvl">
          <ac:chgData name="Kumar, Vinod" userId="a0710a6e-bffc-4971-8893-1c23addeb5b0" providerId="ADAL" clId="{AD4E4DE1-9CB1-4771-A235-1540E1ED3060}" dt="2023-01-05T20:18:33.172" v="3339" actId="478"/>
          <ac:picMkLst>
            <pc:docMk/>
            <pc:sldMk cId="1231753045" sldId="306"/>
            <ac:picMk id="11" creationId="{2257B052-F5BD-8EA7-9544-3A8DDB38A05C}"/>
          </ac:picMkLst>
        </pc:picChg>
        <pc:picChg chg="mod">
          <ac:chgData name="Kumar, Vinod" userId="a0710a6e-bffc-4971-8893-1c23addeb5b0" providerId="ADAL" clId="{AD4E4DE1-9CB1-4771-A235-1540E1ED3060}" dt="2023-01-05T21:14:39.866" v="4330" actId="1076"/>
          <ac:picMkLst>
            <pc:docMk/>
            <pc:sldMk cId="1231753045" sldId="306"/>
            <ac:picMk id="32" creationId="{E6DE9711-8ED1-7832-D742-5D0C043C5385}"/>
          </ac:picMkLst>
        </pc:picChg>
        <pc:picChg chg="del">
          <ac:chgData name="Kumar, Vinod" userId="a0710a6e-bffc-4971-8893-1c23addeb5b0" providerId="ADAL" clId="{AD4E4DE1-9CB1-4771-A235-1540E1ED3060}" dt="2023-01-05T21:04:19.246" v="4140" actId="478"/>
          <ac:picMkLst>
            <pc:docMk/>
            <pc:sldMk cId="1231753045" sldId="306"/>
            <ac:picMk id="33" creationId="{E66DF3B6-EBB2-377C-AA78-C44B645A9F1C}"/>
          </ac:picMkLst>
        </pc:picChg>
        <pc:picChg chg="add del mod">
          <ac:chgData name="Kumar, Vinod" userId="a0710a6e-bffc-4971-8893-1c23addeb5b0" providerId="ADAL" clId="{AD4E4DE1-9CB1-4771-A235-1540E1ED3060}" dt="2023-01-05T21:03:45.582" v="4135" actId="478"/>
          <ac:picMkLst>
            <pc:docMk/>
            <pc:sldMk cId="1231753045" sldId="306"/>
            <ac:picMk id="36" creationId="{5B6C4F5B-A086-FC7D-A090-183BC303BE59}"/>
          </ac:picMkLst>
        </pc:picChg>
        <pc:picChg chg="add del mod">
          <ac:chgData name="Kumar, Vinod" userId="a0710a6e-bffc-4971-8893-1c23addeb5b0" providerId="ADAL" clId="{AD4E4DE1-9CB1-4771-A235-1540E1ED3060}" dt="2023-01-05T21:03:48.158" v="4136" actId="478"/>
          <ac:picMkLst>
            <pc:docMk/>
            <pc:sldMk cId="1231753045" sldId="306"/>
            <ac:picMk id="37" creationId="{727633EA-9C8C-00D9-ACAA-103C8B9933D5}"/>
          </ac:picMkLst>
        </pc:picChg>
        <pc:picChg chg="add del mod">
          <ac:chgData name="Kumar, Vinod" userId="a0710a6e-bffc-4971-8893-1c23addeb5b0" providerId="ADAL" clId="{AD4E4DE1-9CB1-4771-A235-1540E1ED3060}" dt="2023-01-05T21:03:48.158" v="4136" actId="478"/>
          <ac:picMkLst>
            <pc:docMk/>
            <pc:sldMk cId="1231753045" sldId="306"/>
            <ac:picMk id="38" creationId="{EE300D45-D6DA-1A87-2440-07C4ADB7B0F0}"/>
          </ac:picMkLst>
        </pc:picChg>
        <pc:picChg chg="add del mod">
          <ac:chgData name="Kumar, Vinod" userId="a0710a6e-bffc-4971-8893-1c23addeb5b0" providerId="ADAL" clId="{AD4E4DE1-9CB1-4771-A235-1540E1ED3060}" dt="2023-01-05T21:03:44.575" v="4134" actId="478"/>
          <ac:picMkLst>
            <pc:docMk/>
            <pc:sldMk cId="1231753045" sldId="306"/>
            <ac:picMk id="49" creationId="{144CDC5E-4C9F-C928-2D4B-FF23D7A89E75}"/>
          </ac:picMkLst>
        </pc:picChg>
        <pc:picChg chg="add del mod modCrop">
          <ac:chgData name="Kumar, Vinod" userId="a0710a6e-bffc-4971-8893-1c23addeb5b0" providerId="ADAL" clId="{AD4E4DE1-9CB1-4771-A235-1540E1ED3060}" dt="2023-01-05T21:03:52.654" v="4137" actId="478"/>
          <ac:picMkLst>
            <pc:docMk/>
            <pc:sldMk cId="1231753045" sldId="306"/>
            <ac:picMk id="50" creationId="{60326C1F-87CB-6306-F443-1A81FC113411}"/>
          </ac:picMkLst>
        </pc:picChg>
        <pc:picChg chg="add del mod modCrop">
          <ac:chgData name="Kumar, Vinod" userId="a0710a6e-bffc-4971-8893-1c23addeb5b0" providerId="ADAL" clId="{AD4E4DE1-9CB1-4771-A235-1540E1ED3060}" dt="2023-01-05T21:03:52.654" v="4137" actId="478"/>
          <ac:picMkLst>
            <pc:docMk/>
            <pc:sldMk cId="1231753045" sldId="306"/>
            <ac:picMk id="51" creationId="{E13F09C9-2992-37A1-5530-47928AFD7C5C}"/>
          </ac:picMkLst>
        </pc:picChg>
        <pc:picChg chg="add del mod modCrop">
          <ac:chgData name="Kumar, Vinod" userId="a0710a6e-bffc-4971-8893-1c23addeb5b0" providerId="ADAL" clId="{AD4E4DE1-9CB1-4771-A235-1540E1ED3060}" dt="2023-01-05T21:03:52.654" v="4137" actId="478"/>
          <ac:picMkLst>
            <pc:docMk/>
            <pc:sldMk cId="1231753045" sldId="306"/>
            <ac:picMk id="52" creationId="{84439855-873B-A848-9735-47332CA82093}"/>
          </ac:picMkLst>
        </pc:picChg>
        <pc:picChg chg="add del mod">
          <ac:chgData name="Kumar, Vinod" userId="a0710a6e-bffc-4971-8893-1c23addeb5b0" providerId="ADAL" clId="{AD4E4DE1-9CB1-4771-A235-1540E1ED3060}" dt="2023-01-05T21:03:52.654" v="4137" actId="478"/>
          <ac:picMkLst>
            <pc:docMk/>
            <pc:sldMk cId="1231753045" sldId="306"/>
            <ac:picMk id="64" creationId="{575DDDF5-9070-71F3-46FF-580FE33D82F2}"/>
          </ac:picMkLst>
        </pc:picChg>
        <pc:picChg chg="del mod topLvl">
          <ac:chgData name="Kumar, Vinod" userId="a0710a6e-bffc-4971-8893-1c23addeb5b0" providerId="ADAL" clId="{AD4E4DE1-9CB1-4771-A235-1540E1ED3060}" dt="2023-01-05T21:07:36.077" v="4262" actId="478"/>
          <ac:picMkLst>
            <pc:docMk/>
            <pc:sldMk cId="1231753045" sldId="306"/>
            <ac:picMk id="66" creationId="{EE50C9ED-B8C1-0538-EA46-95EC1CFE770A}"/>
          </ac:picMkLst>
        </pc:picChg>
        <pc:picChg chg="add mod">
          <ac:chgData name="Kumar, Vinod" userId="a0710a6e-bffc-4971-8893-1c23addeb5b0" providerId="ADAL" clId="{AD4E4DE1-9CB1-4771-A235-1540E1ED3060}" dt="2023-01-05T21:07:23.014" v="4257" actId="164"/>
          <ac:picMkLst>
            <pc:docMk/>
            <pc:sldMk cId="1231753045" sldId="306"/>
            <ac:picMk id="71" creationId="{006DF1A9-FC86-737F-872F-D2AA668C4775}"/>
          </ac:picMkLst>
        </pc:picChg>
        <pc:picChg chg="add mod modCrop">
          <ac:chgData name="Kumar, Vinod" userId="a0710a6e-bffc-4971-8893-1c23addeb5b0" providerId="ADAL" clId="{AD4E4DE1-9CB1-4771-A235-1540E1ED3060}" dt="2023-01-05T21:09:48.053" v="4307" actId="164"/>
          <ac:picMkLst>
            <pc:docMk/>
            <pc:sldMk cId="1231753045" sldId="306"/>
            <ac:picMk id="75" creationId="{64A27561-4ACE-BF2C-A6FC-BD96D66F7B1D}"/>
          </ac:picMkLst>
        </pc:picChg>
        <pc:cxnChg chg="del mod topLvl">
          <ac:chgData name="Kumar, Vinod" userId="a0710a6e-bffc-4971-8893-1c23addeb5b0" providerId="ADAL" clId="{AD4E4DE1-9CB1-4771-A235-1540E1ED3060}" dt="2023-01-05T20:18:33.172" v="3339" actId="478"/>
          <ac:cxnSpMkLst>
            <pc:docMk/>
            <pc:sldMk cId="1231753045" sldId="306"/>
            <ac:cxnSpMk id="13" creationId="{88C8806B-FE8A-A851-127C-68F84BB7FA80}"/>
          </ac:cxnSpMkLst>
        </pc:cxnChg>
        <pc:cxnChg chg="del mod topLvl">
          <ac:chgData name="Kumar, Vinod" userId="a0710a6e-bffc-4971-8893-1c23addeb5b0" providerId="ADAL" clId="{AD4E4DE1-9CB1-4771-A235-1540E1ED3060}" dt="2023-01-05T20:18:33.172" v="3339" actId="478"/>
          <ac:cxnSpMkLst>
            <pc:docMk/>
            <pc:sldMk cId="1231753045" sldId="306"/>
            <ac:cxnSpMk id="14" creationId="{C6832670-5F6C-121E-0B1F-1ED0E9E915DA}"/>
          </ac:cxnSpMkLst>
        </pc:cxnChg>
        <pc:cxnChg chg="del mod topLvl">
          <ac:chgData name="Kumar, Vinod" userId="a0710a6e-bffc-4971-8893-1c23addeb5b0" providerId="ADAL" clId="{AD4E4DE1-9CB1-4771-A235-1540E1ED3060}" dt="2023-01-05T20:18:33.172" v="3339" actId="478"/>
          <ac:cxnSpMkLst>
            <pc:docMk/>
            <pc:sldMk cId="1231753045" sldId="306"/>
            <ac:cxnSpMk id="15" creationId="{8E1CFA9A-3DF5-8B32-7C5A-660506B19E74}"/>
          </ac:cxnSpMkLst>
        </pc:cxnChg>
        <pc:cxnChg chg="del mod topLvl">
          <ac:chgData name="Kumar, Vinod" userId="a0710a6e-bffc-4971-8893-1c23addeb5b0" providerId="ADAL" clId="{AD4E4DE1-9CB1-4771-A235-1540E1ED3060}" dt="2023-01-05T20:18:33.172" v="3339" actId="478"/>
          <ac:cxnSpMkLst>
            <pc:docMk/>
            <pc:sldMk cId="1231753045" sldId="306"/>
            <ac:cxnSpMk id="17" creationId="{7AEE0808-4CB0-AE3F-713F-E9F78CAADFA8}"/>
          </ac:cxnSpMkLst>
        </pc:cxnChg>
        <pc:cxnChg chg="add del mod">
          <ac:chgData name="Kumar, Vinod" userId="a0710a6e-bffc-4971-8893-1c23addeb5b0" providerId="ADAL" clId="{AD4E4DE1-9CB1-4771-A235-1540E1ED3060}" dt="2023-01-05T21:03:48.158" v="4136" actId="478"/>
          <ac:cxnSpMkLst>
            <pc:docMk/>
            <pc:sldMk cId="1231753045" sldId="306"/>
            <ac:cxnSpMk id="43" creationId="{87850C3E-F20E-A1BE-A011-F8FD6D085420}"/>
          </ac:cxnSpMkLst>
        </pc:cxnChg>
        <pc:cxnChg chg="add del mod">
          <ac:chgData name="Kumar, Vinod" userId="a0710a6e-bffc-4971-8893-1c23addeb5b0" providerId="ADAL" clId="{AD4E4DE1-9CB1-4771-A235-1540E1ED3060}" dt="2023-01-05T21:03:48.158" v="4136" actId="478"/>
          <ac:cxnSpMkLst>
            <pc:docMk/>
            <pc:sldMk cId="1231753045" sldId="306"/>
            <ac:cxnSpMk id="44" creationId="{51867079-C437-648E-76A3-62A67DF66DBA}"/>
          </ac:cxnSpMkLst>
        </pc:cxnChg>
        <pc:cxnChg chg="add del mod">
          <ac:chgData name="Kumar, Vinod" userId="a0710a6e-bffc-4971-8893-1c23addeb5b0" providerId="ADAL" clId="{AD4E4DE1-9CB1-4771-A235-1540E1ED3060}" dt="2023-01-05T21:03:48.158" v="4136" actId="478"/>
          <ac:cxnSpMkLst>
            <pc:docMk/>
            <pc:sldMk cId="1231753045" sldId="306"/>
            <ac:cxnSpMk id="45" creationId="{D737EBD3-73E4-456A-C0F6-914C05DBB376}"/>
          </ac:cxnSpMkLst>
        </pc:cxnChg>
        <pc:cxnChg chg="add del mod">
          <ac:chgData name="Kumar, Vinod" userId="a0710a6e-bffc-4971-8893-1c23addeb5b0" providerId="ADAL" clId="{AD4E4DE1-9CB1-4771-A235-1540E1ED3060}" dt="2023-01-05T21:03:48.158" v="4136" actId="478"/>
          <ac:cxnSpMkLst>
            <pc:docMk/>
            <pc:sldMk cId="1231753045" sldId="306"/>
            <ac:cxnSpMk id="47" creationId="{6E542C0A-748B-DC9A-B705-FD49FF6E0CC4}"/>
          </ac:cxnSpMkLst>
        </pc:cxnChg>
        <pc:cxnChg chg="add del mod">
          <ac:chgData name="Kumar, Vinod" userId="a0710a6e-bffc-4971-8893-1c23addeb5b0" providerId="ADAL" clId="{AD4E4DE1-9CB1-4771-A235-1540E1ED3060}" dt="2023-01-05T21:03:52.654" v="4137" actId="478"/>
          <ac:cxnSpMkLst>
            <pc:docMk/>
            <pc:sldMk cId="1231753045" sldId="306"/>
            <ac:cxnSpMk id="56" creationId="{77F924B2-7D9A-33C1-C5ED-BE86B5588D38}"/>
          </ac:cxnSpMkLst>
        </pc:cxnChg>
        <pc:cxnChg chg="add del mod">
          <ac:chgData name="Kumar, Vinod" userId="a0710a6e-bffc-4971-8893-1c23addeb5b0" providerId="ADAL" clId="{AD4E4DE1-9CB1-4771-A235-1540E1ED3060}" dt="2023-01-05T21:03:52.654" v="4137" actId="478"/>
          <ac:cxnSpMkLst>
            <pc:docMk/>
            <pc:sldMk cId="1231753045" sldId="306"/>
            <ac:cxnSpMk id="60" creationId="{A6550AC5-CE6C-A12E-1ECA-890E6F86A0A7}"/>
          </ac:cxnSpMkLst>
        </pc:cxnChg>
        <pc:cxnChg chg="add del mod">
          <ac:chgData name="Kumar, Vinod" userId="a0710a6e-bffc-4971-8893-1c23addeb5b0" providerId="ADAL" clId="{AD4E4DE1-9CB1-4771-A235-1540E1ED3060}" dt="2023-01-05T21:03:52.654" v="4137" actId="478"/>
          <ac:cxnSpMkLst>
            <pc:docMk/>
            <pc:sldMk cId="1231753045" sldId="306"/>
            <ac:cxnSpMk id="61" creationId="{0D8EF1F6-C0F5-39CB-1D97-0104A3C38675}"/>
          </ac:cxnSpMkLst>
        </pc:cxnChg>
        <pc:cxnChg chg="add del mod">
          <ac:chgData name="Kumar, Vinod" userId="a0710a6e-bffc-4971-8893-1c23addeb5b0" providerId="ADAL" clId="{AD4E4DE1-9CB1-4771-A235-1540E1ED3060}" dt="2023-01-05T21:03:52.654" v="4137" actId="478"/>
          <ac:cxnSpMkLst>
            <pc:docMk/>
            <pc:sldMk cId="1231753045" sldId="306"/>
            <ac:cxnSpMk id="62" creationId="{C4A03EEE-E6D4-A929-07F9-278D1320FF89}"/>
          </ac:cxnSpMkLst>
        </pc:cxnChg>
        <pc:cxnChg chg="add del mod">
          <ac:chgData name="Kumar, Vinod" userId="a0710a6e-bffc-4971-8893-1c23addeb5b0" providerId="ADAL" clId="{AD4E4DE1-9CB1-4771-A235-1540E1ED3060}" dt="2023-01-05T21:07:38.684" v="4263" actId="478"/>
          <ac:cxnSpMkLst>
            <pc:docMk/>
            <pc:sldMk cId="1231753045" sldId="306"/>
            <ac:cxnSpMk id="69" creationId="{173E22B6-EDF6-8CFF-0B48-FEE8B74663DE}"/>
          </ac:cxnSpMkLst>
        </pc:cxnChg>
        <pc:cxnChg chg="add mod">
          <ac:chgData name="Kumar, Vinod" userId="a0710a6e-bffc-4971-8893-1c23addeb5b0" providerId="ADAL" clId="{AD4E4DE1-9CB1-4771-A235-1540E1ED3060}" dt="2023-01-05T21:07:23.014" v="4257" actId="164"/>
          <ac:cxnSpMkLst>
            <pc:docMk/>
            <pc:sldMk cId="1231753045" sldId="306"/>
            <ac:cxnSpMk id="73" creationId="{D99BDBA7-49EC-FC8A-B610-40F42D807F86}"/>
          </ac:cxnSpMkLst>
        </pc:cxnChg>
      </pc:sldChg>
      <pc:sldChg chg="addSp modSp mod">
        <pc:chgData name="Kumar, Vinod" userId="a0710a6e-bffc-4971-8893-1c23addeb5b0" providerId="ADAL" clId="{AD4E4DE1-9CB1-4771-A235-1540E1ED3060}" dt="2023-01-06T19:55:27.507" v="6683" actId="255"/>
        <pc:sldMkLst>
          <pc:docMk/>
          <pc:sldMk cId="1809220692" sldId="307"/>
        </pc:sldMkLst>
        <pc:spChg chg="add mod">
          <ac:chgData name="Kumar, Vinod" userId="a0710a6e-bffc-4971-8893-1c23addeb5b0" providerId="ADAL" clId="{AD4E4DE1-9CB1-4771-A235-1540E1ED3060}" dt="2023-01-06T19:55:27.507" v="6683" actId="255"/>
          <ac:spMkLst>
            <pc:docMk/>
            <pc:sldMk cId="1809220692" sldId="307"/>
            <ac:spMk id="4" creationId="{8AECCF5B-2E62-3EDD-C28A-63F1BB269FCA}"/>
          </ac:spMkLst>
        </pc:spChg>
        <pc:spChg chg="mod">
          <ac:chgData name="Kumar, Vinod" userId="a0710a6e-bffc-4971-8893-1c23addeb5b0" providerId="ADAL" clId="{AD4E4DE1-9CB1-4771-A235-1540E1ED3060}" dt="2023-01-06T19:55:27.507" v="6683" actId="255"/>
          <ac:spMkLst>
            <pc:docMk/>
            <pc:sldMk cId="1809220692" sldId="307"/>
            <ac:spMk id="6" creationId="{501CC702-17BF-D791-E8BE-84429E05C972}"/>
          </ac:spMkLst>
        </pc:spChg>
        <pc:spChg chg="mod">
          <ac:chgData name="Kumar, Vinod" userId="a0710a6e-bffc-4971-8893-1c23addeb5b0" providerId="ADAL" clId="{AD4E4DE1-9CB1-4771-A235-1540E1ED3060}" dt="2023-01-06T15:39:59.273" v="5798" actId="1036"/>
          <ac:spMkLst>
            <pc:docMk/>
            <pc:sldMk cId="1809220692" sldId="307"/>
            <ac:spMk id="7" creationId="{3A27B142-7348-D017-2365-F7521F3ECC2E}"/>
          </ac:spMkLst>
        </pc:spChg>
        <pc:spChg chg="mod">
          <ac:chgData name="Kumar, Vinod" userId="a0710a6e-bffc-4971-8893-1c23addeb5b0" providerId="ADAL" clId="{AD4E4DE1-9CB1-4771-A235-1540E1ED3060}" dt="2023-01-06T15:39:59.273" v="5798" actId="1036"/>
          <ac:spMkLst>
            <pc:docMk/>
            <pc:sldMk cId="1809220692" sldId="307"/>
            <ac:spMk id="8" creationId="{8947D4B5-C798-5A24-4280-177C9063B94F}"/>
          </ac:spMkLst>
        </pc:spChg>
        <pc:spChg chg="mod">
          <ac:chgData name="Kumar, Vinod" userId="a0710a6e-bffc-4971-8893-1c23addeb5b0" providerId="ADAL" clId="{AD4E4DE1-9CB1-4771-A235-1540E1ED3060}" dt="2023-01-06T19:55:27.507" v="6683" actId="255"/>
          <ac:spMkLst>
            <pc:docMk/>
            <pc:sldMk cId="1809220692" sldId="307"/>
            <ac:spMk id="10" creationId="{DD47DA19-285A-FA16-01D5-518DC85E6200}"/>
          </ac:spMkLst>
        </pc:spChg>
        <pc:spChg chg="mod">
          <ac:chgData name="Kumar, Vinod" userId="a0710a6e-bffc-4971-8893-1c23addeb5b0" providerId="ADAL" clId="{AD4E4DE1-9CB1-4771-A235-1540E1ED3060}" dt="2023-01-06T19:55:27.507" v="6683" actId="255"/>
          <ac:spMkLst>
            <pc:docMk/>
            <pc:sldMk cId="1809220692" sldId="307"/>
            <ac:spMk id="11" creationId="{712A80BB-E33F-8F2A-B09E-A815DAAAE03D}"/>
          </ac:spMkLst>
        </pc:spChg>
        <pc:spChg chg="mod">
          <ac:chgData name="Kumar, Vinod" userId="a0710a6e-bffc-4971-8893-1c23addeb5b0" providerId="ADAL" clId="{AD4E4DE1-9CB1-4771-A235-1540E1ED3060}" dt="2023-01-06T19:55:27.507" v="6683" actId="255"/>
          <ac:spMkLst>
            <pc:docMk/>
            <pc:sldMk cId="1809220692" sldId="307"/>
            <ac:spMk id="12" creationId="{632FBD78-F81E-95DD-6334-3F55B1EDDCD0}"/>
          </ac:spMkLst>
        </pc:spChg>
        <pc:spChg chg="add mod">
          <ac:chgData name="Kumar, Vinod" userId="a0710a6e-bffc-4971-8893-1c23addeb5b0" providerId="ADAL" clId="{AD4E4DE1-9CB1-4771-A235-1540E1ED3060}" dt="2023-01-06T19:55:27.507" v="6683" actId="255"/>
          <ac:spMkLst>
            <pc:docMk/>
            <pc:sldMk cId="1809220692" sldId="307"/>
            <ac:spMk id="13" creationId="{672C299C-73A4-FCAC-16C8-4AAF7A9565BB}"/>
          </ac:spMkLst>
        </pc:spChg>
        <pc:picChg chg="add mod">
          <ac:chgData name="Kumar, Vinod" userId="a0710a6e-bffc-4971-8893-1c23addeb5b0" providerId="ADAL" clId="{AD4E4DE1-9CB1-4771-A235-1540E1ED3060}" dt="2023-01-06T15:37:11.659" v="5689" actId="1036"/>
          <ac:picMkLst>
            <pc:docMk/>
            <pc:sldMk cId="1809220692" sldId="307"/>
            <ac:picMk id="2" creationId="{DC874DCB-A713-DD2B-01B1-4A6B1896CE38}"/>
          </ac:picMkLst>
        </pc:picChg>
        <pc:picChg chg="add mod modCrop">
          <ac:chgData name="Kumar, Vinod" userId="a0710a6e-bffc-4971-8893-1c23addeb5b0" providerId="ADAL" clId="{AD4E4DE1-9CB1-4771-A235-1540E1ED3060}" dt="2023-01-06T15:37:11.659" v="5689" actId="1036"/>
          <ac:picMkLst>
            <pc:docMk/>
            <pc:sldMk cId="1809220692" sldId="307"/>
            <ac:picMk id="3" creationId="{B1D773CC-E14D-3DFC-7D16-189DB77DD3A4}"/>
          </ac:picMkLst>
        </pc:picChg>
        <pc:picChg chg="mod">
          <ac:chgData name="Kumar, Vinod" userId="a0710a6e-bffc-4971-8893-1c23addeb5b0" providerId="ADAL" clId="{AD4E4DE1-9CB1-4771-A235-1540E1ED3060}" dt="2023-01-06T15:39:00.266" v="5787" actId="1036"/>
          <ac:picMkLst>
            <pc:docMk/>
            <pc:sldMk cId="1809220692" sldId="307"/>
            <ac:picMk id="5" creationId="{9B5F3310-7D36-81A6-3D42-8CF6F0DFCFA1}"/>
          </ac:picMkLst>
        </pc:picChg>
        <pc:picChg chg="mod">
          <ac:chgData name="Kumar, Vinod" userId="a0710a6e-bffc-4971-8893-1c23addeb5b0" providerId="ADAL" clId="{AD4E4DE1-9CB1-4771-A235-1540E1ED3060}" dt="2023-01-06T15:38:52.538" v="5784" actId="1036"/>
          <ac:picMkLst>
            <pc:docMk/>
            <pc:sldMk cId="1809220692" sldId="307"/>
            <ac:picMk id="9" creationId="{89D3091B-A961-6B1B-36C2-692E33D0DBE0}"/>
          </ac:picMkLst>
        </pc:picChg>
      </pc:sldChg>
      <pc:sldChg chg="addSp modSp mod">
        <pc:chgData name="Kumar, Vinod" userId="a0710a6e-bffc-4971-8893-1c23addeb5b0" providerId="ADAL" clId="{AD4E4DE1-9CB1-4771-A235-1540E1ED3060}" dt="2023-01-06T19:02:31.379" v="6620" actId="1037"/>
        <pc:sldMkLst>
          <pc:docMk/>
          <pc:sldMk cId="3906571683" sldId="308"/>
        </pc:sldMkLst>
        <pc:spChg chg="add mod">
          <ac:chgData name="Kumar, Vinod" userId="a0710a6e-bffc-4971-8893-1c23addeb5b0" providerId="ADAL" clId="{AD4E4DE1-9CB1-4771-A235-1540E1ED3060}" dt="2023-01-06T19:02:31.379" v="6620" actId="1037"/>
          <ac:spMkLst>
            <pc:docMk/>
            <pc:sldMk cId="3906571683" sldId="308"/>
            <ac:spMk id="4" creationId="{774680A8-4D94-3CDC-D78E-6A2257750E7E}"/>
          </ac:spMkLst>
        </pc:spChg>
        <pc:picChg chg="add mod">
          <ac:chgData name="Kumar, Vinod" userId="a0710a6e-bffc-4971-8893-1c23addeb5b0" providerId="ADAL" clId="{AD4E4DE1-9CB1-4771-A235-1540E1ED3060}" dt="2023-01-06T19:01:58.340" v="6549" actId="1036"/>
          <ac:picMkLst>
            <pc:docMk/>
            <pc:sldMk cId="3906571683" sldId="308"/>
            <ac:picMk id="3" creationId="{88941B8D-AB13-66F7-B960-9017A641D10F}"/>
          </ac:picMkLst>
        </pc:picChg>
        <pc:picChg chg="mod">
          <ac:chgData name="Kumar, Vinod" userId="a0710a6e-bffc-4971-8893-1c23addeb5b0" providerId="ADAL" clId="{AD4E4DE1-9CB1-4771-A235-1540E1ED3060}" dt="2023-01-06T19:02:03.236" v="6552" actId="1036"/>
          <ac:picMkLst>
            <pc:docMk/>
            <pc:sldMk cId="3906571683" sldId="308"/>
            <ac:picMk id="10" creationId="{9B02A01A-5408-B536-4A8C-A06B5316EA58}"/>
          </ac:picMkLst>
        </pc:picChg>
      </pc:sldChg>
      <pc:sldChg chg="delSp modSp mod">
        <pc:chgData name="Kumar, Vinod" userId="a0710a6e-bffc-4971-8893-1c23addeb5b0" providerId="ADAL" clId="{AD4E4DE1-9CB1-4771-A235-1540E1ED3060}" dt="2023-01-06T19:53:56.563" v="6676" actId="255"/>
        <pc:sldMkLst>
          <pc:docMk/>
          <pc:sldMk cId="363523231" sldId="309"/>
        </pc:sldMkLst>
        <pc:spChg chg="mod">
          <ac:chgData name="Kumar, Vinod" userId="a0710a6e-bffc-4971-8893-1c23addeb5b0" providerId="ADAL" clId="{AD4E4DE1-9CB1-4771-A235-1540E1ED3060}" dt="2023-01-06T19:53:42.346" v="6675" actId="255"/>
          <ac:spMkLst>
            <pc:docMk/>
            <pc:sldMk cId="363523231" sldId="309"/>
            <ac:spMk id="12" creationId="{CB89E43C-D345-E71E-235D-A3F527A77971}"/>
          </ac:spMkLst>
        </pc:spChg>
        <pc:spChg chg="mod">
          <ac:chgData name="Kumar, Vinod" userId="a0710a6e-bffc-4971-8893-1c23addeb5b0" providerId="ADAL" clId="{AD4E4DE1-9CB1-4771-A235-1540E1ED3060}" dt="2023-01-06T19:53:56.563" v="6676" actId="255"/>
          <ac:spMkLst>
            <pc:docMk/>
            <pc:sldMk cId="363523231" sldId="309"/>
            <ac:spMk id="13" creationId="{2F5C69FE-8BBC-D30D-1B05-F82DAA14E149}"/>
          </ac:spMkLst>
        </pc:spChg>
        <pc:spChg chg="mod">
          <ac:chgData name="Kumar, Vinod" userId="a0710a6e-bffc-4971-8893-1c23addeb5b0" providerId="ADAL" clId="{AD4E4DE1-9CB1-4771-A235-1540E1ED3060}" dt="2023-01-06T19:53:56.563" v="6676" actId="255"/>
          <ac:spMkLst>
            <pc:docMk/>
            <pc:sldMk cId="363523231" sldId="309"/>
            <ac:spMk id="14" creationId="{DAB75DD1-567F-6F00-8AC6-BCC1C40187EE}"/>
          </ac:spMkLst>
        </pc:spChg>
        <pc:spChg chg="mod">
          <ac:chgData name="Kumar, Vinod" userId="a0710a6e-bffc-4971-8893-1c23addeb5b0" providerId="ADAL" clId="{AD4E4DE1-9CB1-4771-A235-1540E1ED3060}" dt="2023-01-06T19:53:56.563" v="6676" actId="255"/>
          <ac:spMkLst>
            <pc:docMk/>
            <pc:sldMk cId="363523231" sldId="309"/>
            <ac:spMk id="15" creationId="{610AFE8D-6F14-0B41-CFAF-B50ED829F5E3}"/>
          </ac:spMkLst>
        </pc:spChg>
        <pc:spChg chg="del">
          <ac:chgData name="Kumar, Vinod" userId="a0710a6e-bffc-4971-8893-1c23addeb5b0" providerId="ADAL" clId="{AD4E4DE1-9CB1-4771-A235-1540E1ED3060}" dt="2022-12-21T20:55:54.860" v="168" actId="478"/>
          <ac:spMkLst>
            <pc:docMk/>
            <pc:sldMk cId="363523231" sldId="309"/>
            <ac:spMk id="16" creationId="{4C832ACE-FAEF-F2D8-3BA1-1504FDF54A88}"/>
          </ac:spMkLst>
        </pc:spChg>
        <pc:spChg chg="mod">
          <ac:chgData name="Kumar, Vinod" userId="a0710a6e-bffc-4971-8893-1c23addeb5b0" providerId="ADAL" clId="{AD4E4DE1-9CB1-4771-A235-1540E1ED3060}" dt="2023-01-06T19:53:56.563" v="6676" actId="255"/>
          <ac:spMkLst>
            <pc:docMk/>
            <pc:sldMk cId="363523231" sldId="309"/>
            <ac:spMk id="17" creationId="{4BA5D206-14F9-4C8F-570E-568E631E764E}"/>
          </ac:spMkLst>
        </pc:spChg>
        <pc:spChg chg="mod">
          <ac:chgData name="Kumar, Vinod" userId="a0710a6e-bffc-4971-8893-1c23addeb5b0" providerId="ADAL" clId="{AD4E4DE1-9CB1-4771-A235-1540E1ED3060}" dt="2023-01-06T19:53:56.563" v="6676" actId="255"/>
          <ac:spMkLst>
            <pc:docMk/>
            <pc:sldMk cId="363523231" sldId="309"/>
            <ac:spMk id="18" creationId="{F868BCCD-1693-01CC-7EB6-FF78E61E1CA6}"/>
          </ac:spMkLst>
        </pc:spChg>
        <pc:spChg chg="mod">
          <ac:chgData name="Kumar, Vinod" userId="a0710a6e-bffc-4971-8893-1c23addeb5b0" providerId="ADAL" clId="{AD4E4DE1-9CB1-4771-A235-1540E1ED3060}" dt="2023-01-06T19:53:56.563" v="6676" actId="255"/>
          <ac:spMkLst>
            <pc:docMk/>
            <pc:sldMk cId="363523231" sldId="309"/>
            <ac:spMk id="19" creationId="{7A6E65D4-7530-9F25-99BB-3E4A551CAB24}"/>
          </ac:spMkLst>
        </pc:spChg>
        <pc:spChg chg="mod">
          <ac:chgData name="Kumar, Vinod" userId="a0710a6e-bffc-4971-8893-1c23addeb5b0" providerId="ADAL" clId="{AD4E4DE1-9CB1-4771-A235-1540E1ED3060}" dt="2023-01-06T19:53:56.563" v="6676" actId="255"/>
          <ac:spMkLst>
            <pc:docMk/>
            <pc:sldMk cId="363523231" sldId="309"/>
            <ac:spMk id="21" creationId="{4A1FD6FF-624A-06CB-8B80-7E181D684B98}"/>
          </ac:spMkLst>
        </pc:spChg>
        <pc:picChg chg="del">
          <ac:chgData name="Kumar, Vinod" userId="a0710a6e-bffc-4971-8893-1c23addeb5b0" providerId="ADAL" clId="{AD4E4DE1-9CB1-4771-A235-1540E1ED3060}" dt="2022-12-21T20:55:52.589" v="167" actId="478"/>
          <ac:picMkLst>
            <pc:docMk/>
            <pc:sldMk cId="363523231" sldId="309"/>
            <ac:picMk id="6" creationId="{77B86128-5341-8C8D-B634-105ECB5031E9}"/>
          </ac:picMkLst>
        </pc:picChg>
        <pc:picChg chg="mod">
          <ac:chgData name="Kumar, Vinod" userId="a0710a6e-bffc-4971-8893-1c23addeb5b0" providerId="ADAL" clId="{AD4E4DE1-9CB1-4771-A235-1540E1ED3060}" dt="2022-12-21T20:56:28.507" v="206" actId="1076"/>
          <ac:picMkLst>
            <pc:docMk/>
            <pc:sldMk cId="363523231" sldId="309"/>
            <ac:picMk id="7" creationId="{F5618D52-7D96-8F92-5FE3-593C006CE318}"/>
          </ac:picMkLst>
        </pc:picChg>
        <pc:picChg chg="mod">
          <ac:chgData name="Kumar, Vinod" userId="a0710a6e-bffc-4971-8893-1c23addeb5b0" providerId="ADAL" clId="{AD4E4DE1-9CB1-4771-A235-1540E1ED3060}" dt="2022-12-21T20:57:17.868" v="264" actId="1038"/>
          <ac:picMkLst>
            <pc:docMk/>
            <pc:sldMk cId="363523231" sldId="309"/>
            <ac:picMk id="8" creationId="{0C4AC514-70B9-2E08-FC10-F47116B8336F}"/>
          </ac:picMkLst>
        </pc:picChg>
        <pc:picChg chg="mod">
          <ac:chgData name="Kumar, Vinod" userId="a0710a6e-bffc-4971-8893-1c23addeb5b0" providerId="ADAL" clId="{AD4E4DE1-9CB1-4771-A235-1540E1ED3060}" dt="2022-12-21T20:57:31.179" v="310" actId="1037"/>
          <ac:picMkLst>
            <pc:docMk/>
            <pc:sldMk cId="363523231" sldId="309"/>
            <ac:picMk id="10" creationId="{5BC61CC7-A994-BE81-FF4B-0830F771FB05}"/>
          </ac:picMkLst>
        </pc:picChg>
      </pc:sldChg>
      <pc:sldChg chg="addSp delSp modSp add del mod">
        <pc:chgData name="Kumar, Vinod" userId="a0710a6e-bffc-4971-8893-1c23addeb5b0" providerId="ADAL" clId="{AD4E4DE1-9CB1-4771-A235-1540E1ED3060}" dt="2023-01-06T15:41:00.738" v="5799" actId="47"/>
        <pc:sldMkLst>
          <pc:docMk/>
          <pc:sldMk cId="754505542" sldId="312"/>
        </pc:sldMkLst>
        <pc:spChg chg="del">
          <ac:chgData name="Kumar, Vinod" userId="a0710a6e-bffc-4971-8893-1c23addeb5b0" providerId="ADAL" clId="{AD4E4DE1-9CB1-4771-A235-1540E1ED3060}" dt="2023-01-05T17:11:11.647" v="1450" actId="478"/>
          <ac:spMkLst>
            <pc:docMk/>
            <pc:sldMk cId="754505542" sldId="312"/>
            <ac:spMk id="20" creationId="{BDB3E1FD-D56E-AAB7-AAC1-D89F3C30A6C0}"/>
          </ac:spMkLst>
        </pc:spChg>
        <pc:spChg chg="add del mod">
          <ac:chgData name="Kumar, Vinod" userId="a0710a6e-bffc-4971-8893-1c23addeb5b0" providerId="ADAL" clId="{AD4E4DE1-9CB1-4771-A235-1540E1ED3060}" dt="2023-01-05T18:32:55.688" v="1686" actId="478"/>
          <ac:spMkLst>
            <pc:docMk/>
            <pc:sldMk cId="754505542" sldId="312"/>
            <ac:spMk id="32" creationId="{E2D26F78-081A-95EF-395E-3CE8F9651DAC}"/>
          </ac:spMkLst>
        </pc:spChg>
        <pc:spChg chg="add del mod">
          <ac:chgData name="Kumar, Vinod" userId="a0710a6e-bffc-4971-8893-1c23addeb5b0" providerId="ADAL" clId="{AD4E4DE1-9CB1-4771-A235-1540E1ED3060}" dt="2023-01-05T18:32:55.688" v="1686" actId="478"/>
          <ac:spMkLst>
            <pc:docMk/>
            <pc:sldMk cId="754505542" sldId="312"/>
            <ac:spMk id="33" creationId="{F409F546-9C05-0247-9AEA-9460AABFF384}"/>
          </ac:spMkLst>
        </pc:spChg>
        <pc:spChg chg="add del mod">
          <ac:chgData name="Kumar, Vinod" userId="a0710a6e-bffc-4971-8893-1c23addeb5b0" providerId="ADAL" clId="{AD4E4DE1-9CB1-4771-A235-1540E1ED3060}" dt="2023-01-05T18:33:13.239" v="1691" actId="478"/>
          <ac:spMkLst>
            <pc:docMk/>
            <pc:sldMk cId="754505542" sldId="312"/>
            <ac:spMk id="34" creationId="{BEC43C83-F5DA-8F64-774B-D695AEF5C1D1}"/>
          </ac:spMkLst>
        </pc:spChg>
        <pc:spChg chg="add del mod">
          <ac:chgData name="Kumar, Vinod" userId="a0710a6e-bffc-4971-8893-1c23addeb5b0" providerId="ADAL" clId="{AD4E4DE1-9CB1-4771-A235-1540E1ED3060}" dt="2023-01-05T18:33:08.472" v="1689" actId="478"/>
          <ac:spMkLst>
            <pc:docMk/>
            <pc:sldMk cId="754505542" sldId="312"/>
            <ac:spMk id="35" creationId="{4D17A1DF-9CEA-DE86-2C41-E951CD74ADD5}"/>
          </ac:spMkLst>
        </pc:spChg>
        <pc:spChg chg="add del mod">
          <ac:chgData name="Kumar, Vinod" userId="a0710a6e-bffc-4971-8893-1c23addeb5b0" providerId="ADAL" clId="{AD4E4DE1-9CB1-4771-A235-1540E1ED3060}" dt="2023-01-05T18:32:55.688" v="1686" actId="478"/>
          <ac:spMkLst>
            <pc:docMk/>
            <pc:sldMk cId="754505542" sldId="312"/>
            <ac:spMk id="36" creationId="{D45693F3-9AE6-7200-6DCC-074DECD1E86F}"/>
          </ac:spMkLst>
        </pc:spChg>
        <pc:spChg chg="add del mod">
          <ac:chgData name="Kumar, Vinod" userId="a0710a6e-bffc-4971-8893-1c23addeb5b0" providerId="ADAL" clId="{AD4E4DE1-9CB1-4771-A235-1540E1ED3060}" dt="2023-01-05T18:33:04.536" v="1688" actId="478"/>
          <ac:spMkLst>
            <pc:docMk/>
            <pc:sldMk cId="754505542" sldId="312"/>
            <ac:spMk id="38" creationId="{FDC25AA5-2C4E-4293-0B40-4143391BC931}"/>
          </ac:spMkLst>
        </pc:spChg>
        <pc:spChg chg="add del mod">
          <ac:chgData name="Kumar, Vinod" userId="a0710a6e-bffc-4971-8893-1c23addeb5b0" providerId="ADAL" clId="{AD4E4DE1-9CB1-4771-A235-1540E1ED3060}" dt="2023-01-05T18:32:55.688" v="1686" actId="478"/>
          <ac:spMkLst>
            <pc:docMk/>
            <pc:sldMk cId="754505542" sldId="312"/>
            <ac:spMk id="42" creationId="{78BEC84D-CB0A-D33E-3A6C-1522668F5DD7}"/>
          </ac:spMkLst>
        </pc:spChg>
        <pc:spChg chg="add del mod">
          <ac:chgData name="Kumar, Vinod" userId="a0710a6e-bffc-4971-8893-1c23addeb5b0" providerId="ADAL" clId="{AD4E4DE1-9CB1-4771-A235-1540E1ED3060}" dt="2023-01-05T18:32:55.688" v="1686" actId="478"/>
          <ac:spMkLst>
            <pc:docMk/>
            <pc:sldMk cId="754505542" sldId="312"/>
            <ac:spMk id="43" creationId="{513C9A33-9D88-D183-42A8-54946E52C346}"/>
          </ac:spMkLst>
        </pc:spChg>
        <pc:spChg chg="add del mod">
          <ac:chgData name="Kumar, Vinod" userId="a0710a6e-bffc-4971-8893-1c23addeb5b0" providerId="ADAL" clId="{AD4E4DE1-9CB1-4771-A235-1540E1ED3060}" dt="2023-01-05T18:32:55.688" v="1686" actId="478"/>
          <ac:spMkLst>
            <pc:docMk/>
            <pc:sldMk cId="754505542" sldId="312"/>
            <ac:spMk id="44" creationId="{84E0487E-F987-2987-00A5-F77A9C340F54}"/>
          </ac:spMkLst>
        </pc:spChg>
        <pc:spChg chg="add del mod">
          <ac:chgData name="Kumar, Vinod" userId="a0710a6e-bffc-4971-8893-1c23addeb5b0" providerId="ADAL" clId="{AD4E4DE1-9CB1-4771-A235-1540E1ED3060}" dt="2023-01-05T18:32:55.688" v="1686" actId="478"/>
          <ac:spMkLst>
            <pc:docMk/>
            <pc:sldMk cId="754505542" sldId="312"/>
            <ac:spMk id="46" creationId="{A12874A1-63B3-12C1-A44C-45425FAE4E1B}"/>
          </ac:spMkLst>
        </pc:spChg>
        <pc:spChg chg="add del mod">
          <ac:chgData name="Kumar, Vinod" userId="a0710a6e-bffc-4971-8893-1c23addeb5b0" providerId="ADAL" clId="{AD4E4DE1-9CB1-4771-A235-1540E1ED3060}" dt="2023-01-05T18:32:55.688" v="1686" actId="478"/>
          <ac:spMkLst>
            <pc:docMk/>
            <pc:sldMk cId="754505542" sldId="312"/>
            <ac:spMk id="47" creationId="{0D057506-CC0E-131C-0AE8-DFF49BEDD4B4}"/>
          </ac:spMkLst>
        </pc:spChg>
        <pc:spChg chg="add del mod">
          <ac:chgData name="Kumar, Vinod" userId="a0710a6e-bffc-4971-8893-1c23addeb5b0" providerId="ADAL" clId="{AD4E4DE1-9CB1-4771-A235-1540E1ED3060}" dt="2023-01-05T18:32:55.688" v="1686" actId="478"/>
          <ac:spMkLst>
            <pc:docMk/>
            <pc:sldMk cId="754505542" sldId="312"/>
            <ac:spMk id="48" creationId="{63BD9828-BFE9-2E6C-21E2-9DCA31FC8D95}"/>
          </ac:spMkLst>
        </pc:spChg>
        <pc:spChg chg="add del mod">
          <ac:chgData name="Kumar, Vinod" userId="a0710a6e-bffc-4971-8893-1c23addeb5b0" providerId="ADAL" clId="{AD4E4DE1-9CB1-4771-A235-1540E1ED3060}" dt="2023-01-05T18:32:55.688" v="1686" actId="478"/>
          <ac:spMkLst>
            <pc:docMk/>
            <pc:sldMk cId="754505542" sldId="312"/>
            <ac:spMk id="49" creationId="{5F43C322-FF15-15B3-0046-8420185F6AFD}"/>
          </ac:spMkLst>
        </pc:spChg>
        <pc:spChg chg="add del mod">
          <ac:chgData name="Kumar, Vinod" userId="a0710a6e-bffc-4971-8893-1c23addeb5b0" providerId="ADAL" clId="{AD4E4DE1-9CB1-4771-A235-1540E1ED3060}" dt="2023-01-05T18:37:03.638" v="1701" actId="478"/>
          <ac:spMkLst>
            <pc:docMk/>
            <pc:sldMk cId="754505542" sldId="312"/>
            <ac:spMk id="53" creationId="{FFA44DC2-FAA5-AEAF-D330-CA4535234CE3}"/>
          </ac:spMkLst>
        </pc:spChg>
        <pc:spChg chg="add del mod">
          <ac:chgData name="Kumar, Vinod" userId="a0710a6e-bffc-4971-8893-1c23addeb5b0" providerId="ADAL" clId="{AD4E4DE1-9CB1-4771-A235-1540E1ED3060}" dt="2023-01-05T16:56:25.560" v="947" actId="478"/>
          <ac:spMkLst>
            <pc:docMk/>
            <pc:sldMk cId="754505542" sldId="312"/>
            <ac:spMk id="54" creationId="{874E528F-850C-744E-781D-E2B94020A264}"/>
          </ac:spMkLst>
        </pc:spChg>
        <pc:spChg chg="add del mod">
          <ac:chgData name="Kumar, Vinod" userId="a0710a6e-bffc-4971-8893-1c23addeb5b0" providerId="ADAL" clId="{AD4E4DE1-9CB1-4771-A235-1540E1ED3060}" dt="2023-01-05T18:37:03.638" v="1701" actId="478"/>
          <ac:spMkLst>
            <pc:docMk/>
            <pc:sldMk cId="754505542" sldId="312"/>
            <ac:spMk id="55" creationId="{F64C7DF9-604A-04CF-C232-06821F165006}"/>
          </ac:spMkLst>
        </pc:spChg>
        <pc:spChg chg="add del mod">
          <ac:chgData name="Kumar, Vinod" userId="a0710a6e-bffc-4971-8893-1c23addeb5b0" providerId="ADAL" clId="{AD4E4DE1-9CB1-4771-A235-1540E1ED3060}" dt="2023-01-05T18:37:03.638" v="1701" actId="478"/>
          <ac:spMkLst>
            <pc:docMk/>
            <pc:sldMk cId="754505542" sldId="312"/>
            <ac:spMk id="56" creationId="{DEFC1792-AE71-C26F-B008-5A57F9C02A24}"/>
          </ac:spMkLst>
        </pc:spChg>
        <pc:spChg chg="add del mod">
          <ac:chgData name="Kumar, Vinod" userId="a0710a6e-bffc-4971-8893-1c23addeb5b0" providerId="ADAL" clId="{AD4E4DE1-9CB1-4771-A235-1540E1ED3060}" dt="2023-01-05T18:37:03.638" v="1701" actId="478"/>
          <ac:spMkLst>
            <pc:docMk/>
            <pc:sldMk cId="754505542" sldId="312"/>
            <ac:spMk id="57" creationId="{5AFC5193-DB3B-0512-86F6-9AFE8C640C97}"/>
          </ac:spMkLst>
        </pc:spChg>
        <pc:spChg chg="add del mod">
          <ac:chgData name="Kumar, Vinod" userId="a0710a6e-bffc-4971-8893-1c23addeb5b0" providerId="ADAL" clId="{AD4E4DE1-9CB1-4771-A235-1540E1ED3060}" dt="2023-01-05T18:37:03.638" v="1701" actId="478"/>
          <ac:spMkLst>
            <pc:docMk/>
            <pc:sldMk cId="754505542" sldId="312"/>
            <ac:spMk id="58" creationId="{66C03D89-7921-8932-D0EB-3F5F7C443B62}"/>
          </ac:spMkLst>
        </pc:spChg>
        <pc:spChg chg="add del mod">
          <ac:chgData name="Kumar, Vinod" userId="a0710a6e-bffc-4971-8893-1c23addeb5b0" providerId="ADAL" clId="{AD4E4DE1-9CB1-4771-A235-1540E1ED3060}" dt="2023-01-05T18:37:03.638" v="1701" actId="478"/>
          <ac:spMkLst>
            <pc:docMk/>
            <pc:sldMk cId="754505542" sldId="312"/>
            <ac:spMk id="59" creationId="{D8962CE7-2E18-3715-9FEA-7DEDCB0078AC}"/>
          </ac:spMkLst>
        </pc:spChg>
        <pc:spChg chg="add del mod">
          <ac:chgData name="Kumar, Vinod" userId="a0710a6e-bffc-4971-8893-1c23addeb5b0" providerId="ADAL" clId="{AD4E4DE1-9CB1-4771-A235-1540E1ED3060}" dt="2023-01-05T18:37:03.638" v="1701" actId="478"/>
          <ac:spMkLst>
            <pc:docMk/>
            <pc:sldMk cId="754505542" sldId="312"/>
            <ac:spMk id="60" creationId="{DE55556E-3A94-C67E-B488-4A03B4F2C67C}"/>
          </ac:spMkLst>
        </pc:spChg>
        <pc:spChg chg="add del mod">
          <ac:chgData name="Kumar, Vinod" userId="a0710a6e-bffc-4971-8893-1c23addeb5b0" providerId="ADAL" clId="{AD4E4DE1-9CB1-4771-A235-1540E1ED3060}" dt="2023-01-05T18:37:03.638" v="1701" actId="478"/>
          <ac:spMkLst>
            <pc:docMk/>
            <pc:sldMk cId="754505542" sldId="312"/>
            <ac:spMk id="61" creationId="{2E6D7575-5E8B-EA6E-E2BF-6EBF8895424C}"/>
          </ac:spMkLst>
        </pc:spChg>
        <pc:spChg chg="add del mod">
          <ac:chgData name="Kumar, Vinod" userId="a0710a6e-bffc-4971-8893-1c23addeb5b0" providerId="ADAL" clId="{AD4E4DE1-9CB1-4771-A235-1540E1ED3060}" dt="2023-01-05T18:37:03.638" v="1701" actId="478"/>
          <ac:spMkLst>
            <pc:docMk/>
            <pc:sldMk cId="754505542" sldId="312"/>
            <ac:spMk id="62" creationId="{2159E38D-A246-DA7E-429C-7BAC3A1ED57F}"/>
          </ac:spMkLst>
        </pc:spChg>
        <pc:spChg chg="add del mod">
          <ac:chgData name="Kumar, Vinod" userId="a0710a6e-bffc-4971-8893-1c23addeb5b0" providerId="ADAL" clId="{AD4E4DE1-9CB1-4771-A235-1540E1ED3060}" dt="2023-01-05T18:37:03.638" v="1701" actId="478"/>
          <ac:spMkLst>
            <pc:docMk/>
            <pc:sldMk cId="754505542" sldId="312"/>
            <ac:spMk id="64" creationId="{9C5CF1BA-C805-6A94-5C00-A4912CA35965}"/>
          </ac:spMkLst>
        </pc:spChg>
        <pc:spChg chg="add del mod">
          <ac:chgData name="Kumar, Vinod" userId="a0710a6e-bffc-4971-8893-1c23addeb5b0" providerId="ADAL" clId="{AD4E4DE1-9CB1-4771-A235-1540E1ED3060}" dt="2023-01-05T18:37:03.638" v="1701" actId="478"/>
          <ac:spMkLst>
            <pc:docMk/>
            <pc:sldMk cId="754505542" sldId="312"/>
            <ac:spMk id="67" creationId="{B7B1E308-621F-292A-22D9-69EB6B7F7B15}"/>
          </ac:spMkLst>
        </pc:spChg>
        <pc:spChg chg="add del mod">
          <ac:chgData name="Kumar, Vinod" userId="a0710a6e-bffc-4971-8893-1c23addeb5b0" providerId="ADAL" clId="{AD4E4DE1-9CB1-4771-A235-1540E1ED3060}" dt="2023-01-05T18:37:03.638" v="1701" actId="478"/>
          <ac:spMkLst>
            <pc:docMk/>
            <pc:sldMk cId="754505542" sldId="312"/>
            <ac:spMk id="68" creationId="{9D72B927-F5C0-6764-94E7-2DAE844867E7}"/>
          </ac:spMkLst>
        </pc:spChg>
        <pc:spChg chg="add del mod">
          <ac:chgData name="Kumar, Vinod" userId="a0710a6e-bffc-4971-8893-1c23addeb5b0" providerId="ADAL" clId="{AD4E4DE1-9CB1-4771-A235-1540E1ED3060}" dt="2023-01-05T18:37:03.638" v="1701" actId="478"/>
          <ac:spMkLst>
            <pc:docMk/>
            <pc:sldMk cId="754505542" sldId="312"/>
            <ac:spMk id="69" creationId="{A13F64C7-B9F3-0CFE-94BC-F3E466A181E9}"/>
          </ac:spMkLst>
        </pc:spChg>
        <pc:spChg chg="add del mod">
          <ac:chgData name="Kumar, Vinod" userId="a0710a6e-bffc-4971-8893-1c23addeb5b0" providerId="ADAL" clId="{AD4E4DE1-9CB1-4771-A235-1540E1ED3060}" dt="2023-01-05T18:40:12.372" v="1757" actId="478"/>
          <ac:spMkLst>
            <pc:docMk/>
            <pc:sldMk cId="754505542" sldId="312"/>
            <ac:spMk id="81" creationId="{107E686F-4158-804A-CA91-C3B58B969738}"/>
          </ac:spMkLst>
        </pc:spChg>
        <pc:spChg chg="add del mod">
          <ac:chgData name="Kumar, Vinod" userId="a0710a6e-bffc-4971-8893-1c23addeb5b0" providerId="ADAL" clId="{AD4E4DE1-9CB1-4771-A235-1540E1ED3060}" dt="2023-01-05T18:40:12.372" v="1757" actId="478"/>
          <ac:spMkLst>
            <pc:docMk/>
            <pc:sldMk cId="754505542" sldId="312"/>
            <ac:spMk id="82" creationId="{BC689FC7-FD52-022D-01EA-155BB153EC48}"/>
          </ac:spMkLst>
        </pc:spChg>
        <pc:spChg chg="add del mod">
          <ac:chgData name="Kumar, Vinod" userId="a0710a6e-bffc-4971-8893-1c23addeb5b0" providerId="ADAL" clId="{AD4E4DE1-9CB1-4771-A235-1540E1ED3060}" dt="2023-01-05T18:40:12.372" v="1757" actId="478"/>
          <ac:spMkLst>
            <pc:docMk/>
            <pc:sldMk cId="754505542" sldId="312"/>
            <ac:spMk id="83" creationId="{B55545CD-97A6-CDBF-7D3A-420C73617965}"/>
          </ac:spMkLst>
        </pc:spChg>
        <pc:spChg chg="add del mod">
          <ac:chgData name="Kumar, Vinod" userId="a0710a6e-bffc-4971-8893-1c23addeb5b0" providerId="ADAL" clId="{AD4E4DE1-9CB1-4771-A235-1540E1ED3060}" dt="2023-01-05T18:40:12.372" v="1757" actId="478"/>
          <ac:spMkLst>
            <pc:docMk/>
            <pc:sldMk cId="754505542" sldId="312"/>
            <ac:spMk id="84" creationId="{AF5EB38E-F3B8-2581-0F28-EDF6407C17AB}"/>
          </ac:spMkLst>
        </pc:spChg>
        <pc:spChg chg="add del mod">
          <ac:chgData name="Kumar, Vinod" userId="a0710a6e-bffc-4971-8893-1c23addeb5b0" providerId="ADAL" clId="{AD4E4DE1-9CB1-4771-A235-1540E1ED3060}" dt="2023-01-05T18:40:12.372" v="1757" actId="478"/>
          <ac:spMkLst>
            <pc:docMk/>
            <pc:sldMk cId="754505542" sldId="312"/>
            <ac:spMk id="85" creationId="{58B9BE1B-DFC6-1B4B-13A5-9929A8CD5033}"/>
          </ac:spMkLst>
        </pc:spChg>
        <pc:spChg chg="add del mod">
          <ac:chgData name="Kumar, Vinod" userId="a0710a6e-bffc-4971-8893-1c23addeb5b0" providerId="ADAL" clId="{AD4E4DE1-9CB1-4771-A235-1540E1ED3060}" dt="2023-01-05T18:40:12.372" v="1757" actId="478"/>
          <ac:spMkLst>
            <pc:docMk/>
            <pc:sldMk cId="754505542" sldId="312"/>
            <ac:spMk id="86" creationId="{4C5C36A0-F94D-C5AF-1B7F-77F9FF2DB0BC}"/>
          </ac:spMkLst>
        </pc:spChg>
        <pc:spChg chg="add del mod">
          <ac:chgData name="Kumar, Vinod" userId="a0710a6e-bffc-4971-8893-1c23addeb5b0" providerId="ADAL" clId="{AD4E4DE1-9CB1-4771-A235-1540E1ED3060}" dt="2023-01-05T18:40:12.372" v="1757" actId="478"/>
          <ac:spMkLst>
            <pc:docMk/>
            <pc:sldMk cId="754505542" sldId="312"/>
            <ac:spMk id="87" creationId="{AC063C6B-2D7D-50B2-D0B4-6AA360A59E3B}"/>
          </ac:spMkLst>
        </pc:spChg>
        <pc:spChg chg="add del mod">
          <ac:chgData name="Kumar, Vinod" userId="a0710a6e-bffc-4971-8893-1c23addeb5b0" providerId="ADAL" clId="{AD4E4DE1-9CB1-4771-A235-1540E1ED3060}" dt="2023-01-05T18:40:12.372" v="1757" actId="478"/>
          <ac:spMkLst>
            <pc:docMk/>
            <pc:sldMk cId="754505542" sldId="312"/>
            <ac:spMk id="88" creationId="{52B0CEB3-C4BA-5DBE-1A51-38C4FDF055CE}"/>
          </ac:spMkLst>
        </pc:spChg>
        <pc:spChg chg="add del mod">
          <ac:chgData name="Kumar, Vinod" userId="a0710a6e-bffc-4971-8893-1c23addeb5b0" providerId="ADAL" clId="{AD4E4DE1-9CB1-4771-A235-1540E1ED3060}" dt="2023-01-05T18:40:12.372" v="1757" actId="478"/>
          <ac:spMkLst>
            <pc:docMk/>
            <pc:sldMk cId="754505542" sldId="312"/>
            <ac:spMk id="89" creationId="{D017E991-A4C3-8917-EB10-A9920810E2A7}"/>
          </ac:spMkLst>
        </pc:spChg>
        <pc:spChg chg="add del mod">
          <ac:chgData name="Kumar, Vinod" userId="a0710a6e-bffc-4971-8893-1c23addeb5b0" providerId="ADAL" clId="{AD4E4DE1-9CB1-4771-A235-1540E1ED3060}" dt="2023-01-05T18:40:12.372" v="1757" actId="478"/>
          <ac:spMkLst>
            <pc:docMk/>
            <pc:sldMk cId="754505542" sldId="312"/>
            <ac:spMk id="91" creationId="{46C203B8-06AE-75E3-55FC-D93050855753}"/>
          </ac:spMkLst>
        </pc:spChg>
        <pc:spChg chg="add del mod">
          <ac:chgData name="Kumar, Vinod" userId="a0710a6e-bffc-4971-8893-1c23addeb5b0" providerId="ADAL" clId="{AD4E4DE1-9CB1-4771-A235-1540E1ED3060}" dt="2023-01-05T18:40:12.372" v="1757" actId="478"/>
          <ac:spMkLst>
            <pc:docMk/>
            <pc:sldMk cId="754505542" sldId="312"/>
            <ac:spMk id="94" creationId="{D6E58C66-146C-8BDB-D011-9A5A100744F5}"/>
          </ac:spMkLst>
        </pc:spChg>
        <pc:spChg chg="add del mod">
          <ac:chgData name="Kumar, Vinod" userId="a0710a6e-bffc-4971-8893-1c23addeb5b0" providerId="ADAL" clId="{AD4E4DE1-9CB1-4771-A235-1540E1ED3060}" dt="2023-01-05T18:40:12.372" v="1757" actId="478"/>
          <ac:spMkLst>
            <pc:docMk/>
            <pc:sldMk cId="754505542" sldId="312"/>
            <ac:spMk id="95" creationId="{5196E132-B85D-7298-2E93-25A7FC1DC5BE}"/>
          </ac:spMkLst>
        </pc:spChg>
        <pc:spChg chg="add del mod">
          <ac:chgData name="Kumar, Vinod" userId="a0710a6e-bffc-4971-8893-1c23addeb5b0" providerId="ADAL" clId="{AD4E4DE1-9CB1-4771-A235-1540E1ED3060}" dt="2023-01-05T18:40:12.372" v="1757" actId="478"/>
          <ac:spMkLst>
            <pc:docMk/>
            <pc:sldMk cId="754505542" sldId="312"/>
            <ac:spMk id="96" creationId="{6608ECA0-BAAB-C1A6-3F2A-69956FA5B75B}"/>
          </ac:spMkLst>
        </pc:spChg>
        <pc:grpChg chg="mod">
          <ac:chgData name="Kumar, Vinod" userId="a0710a6e-bffc-4971-8893-1c23addeb5b0" providerId="ADAL" clId="{AD4E4DE1-9CB1-4771-A235-1540E1ED3060}" dt="2023-01-05T17:13:29.902" v="1492" actId="1037"/>
          <ac:grpSpMkLst>
            <pc:docMk/>
            <pc:sldMk cId="754505542" sldId="312"/>
            <ac:grpSpMk id="26" creationId="{17484DF5-3BA7-DB77-1D73-F10E10D0A7DD}"/>
          </ac:grpSpMkLst>
        </pc:grpChg>
        <pc:picChg chg="add del">
          <ac:chgData name="Kumar, Vinod" userId="a0710a6e-bffc-4971-8893-1c23addeb5b0" providerId="ADAL" clId="{AD4E4DE1-9CB1-4771-A235-1540E1ED3060}" dt="2023-01-05T17:10:59.328" v="1448" actId="478"/>
          <ac:picMkLst>
            <pc:docMk/>
            <pc:sldMk cId="754505542" sldId="312"/>
            <ac:picMk id="9" creationId="{E2D174D9-69F4-0136-FA01-1EBB88CC9824}"/>
          </ac:picMkLst>
        </pc:picChg>
        <pc:picChg chg="add del">
          <ac:chgData name="Kumar, Vinod" userId="a0710a6e-bffc-4971-8893-1c23addeb5b0" providerId="ADAL" clId="{AD4E4DE1-9CB1-4771-A235-1540E1ED3060}" dt="2023-01-05T17:10:59.328" v="1448" actId="478"/>
          <ac:picMkLst>
            <pc:docMk/>
            <pc:sldMk cId="754505542" sldId="312"/>
            <ac:picMk id="10" creationId="{C485C2EA-332D-FE9B-351D-AACA7B21C507}"/>
          </ac:picMkLst>
        </pc:picChg>
        <pc:picChg chg="add del">
          <ac:chgData name="Kumar, Vinod" userId="a0710a6e-bffc-4971-8893-1c23addeb5b0" providerId="ADAL" clId="{AD4E4DE1-9CB1-4771-A235-1540E1ED3060}" dt="2023-01-05T17:10:59.328" v="1448" actId="478"/>
          <ac:picMkLst>
            <pc:docMk/>
            <pc:sldMk cId="754505542" sldId="312"/>
            <ac:picMk id="11" creationId="{BBC8BE26-CE50-0E7B-5B74-3DABE34015C5}"/>
          </ac:picMkLst>
        </pc:picChg>
        <pc:picChg chg="add del mod">
          <ac:chgData name="Kumar, Vinod" userId="a0710a6e-bffc-4971-8893-1c23addeb5b0" providerId="ADAL" clId="{AD4E4DE1-9CB1-4771-A235-1540E1ED3060}" dt="2023-01-05T16:46:21.010" v="575" actId="478"/>
          <ac:picMkLst>
            <pc:docMk/>
            <pc:sldMk cId="754505542" sldId="312"/>
            <ac:picMk id="21" creationId="{50DCCF95-5EF4-AFD5-2253-F40588FAEFB4}"/>
          </ac:picMkLst>
        </pc:picChg>
        <pc:picChg chg="add del mod">
          <ac:chgData name="Kumar, Vinod" userId="a0710a6e-bffc-4971-8893-1c23addeb5b0" providerId="ADAL" clId="{AD4E4DE1-9CB1-4771-A235-1540E1ED3060}" dt="2023-01-05T18:32:59.208" v="1687" actId="478"/>
          <ac:picMkLst>
            <pc:docMk/>
            <pc:sldMk cId="754505542" sldId="312"/>
            <ac:picMk id="28" creationId="{ECD07FDE-774B-480A-ED44-C284D38F8FEB}"/>
          </ac:picMkLst>
        </pc:picChg>
        <pc:picChg chg="add del mod">
          <ac:chgData name="Kumar, Vinod" userId="a0710a6e-bffc-4971-8893-1c23addeb5b0" providerId="ADAL" clId="{AD4E4DE1-9CB1-4771-A235-1540E1ED3060}" dt="2023-01-05T18:32:59.208" v="1687" actId="478"/>
          <ac:picMkLst>
            <pc:docMk/>
            <pc:sldMk cId="754505542" sldId="312"/>
            <ac:picMk id="29" creationId="{7BC44580-6C24-EEE8-8626-576A3EC5BC1F}"/>
          </ac:picMkLst>
        </pc:picChg>
        <pc:picChg chg="add del mod">
          <ac:chgData name="Kumar, Vinod" userId="a0710a6e-bffc-4971-8893-1c23addeb5b0" providerId="ADAL" clId="{AD4E4DE1-9CB1-4771-A235-1540E1ED3060}" dt="2023-01-05T18:33:10.728" v="1690" actId="478"/>
          <ac:picMkLst>
            <pc:docMk/>
            <pc:sldMk cId="754505542" sldId="312"/>
            <ac:picMk id="30" creationId="{FC49D040-853C-8830-8292-0AA6270B1B8D}"/>
          </ac:picMkLst>
        </pc:picChg>
        <pc:picChg chg="add del mod">
          <ac:chgData name="Kumar, Vinod" userId="a0710a6e-bffc-4971-8893-1c23addeb5b0" providerId="ADAL" clId="{AD4E4DE1-9CB1-4771-A235-1540E1ED3060}" dt="2023-01-05T18:37:03.638" v="1701" actId="478"/>
          <ac:picMkLst>
            <pc:docMk/>
            <pc:sldMk cId="754505542" sldId="312"/>
            <ac:picMk id="31" creationId="{BCF53A87-592F-0BC1-B8F4-97898F4EFE5E}"/>
          </ac:picMkLst>
        </pc:picChg>
        <pc:picChg chg="add del mod">
          <ac:chgData name="Kumar, Vinod" userId="a0710a6e-bffc-4971-8893-1c23addeb5b0" providerId="ADAL" clId="{AD4E4DE1-9CB1-4771-A235-1540E1ED3060}" dt="2023-01-05T18:32:59.208" v="1687" actId="478"/>
          <ac:picMkLst>
            <pc:docMk/>
            <pc:sldMk cId="754505542" sldId="312"/>
            <ac:picMk id="41" creationId="{DE33F8F7-393E-416F-6C8A-291F25E88DB7}"/>
          </ac:picMkLst>
        </pc:picChg>
        <pc:picChg chg="add del mod">
          <ac:chgData name="Kumar, Vinod" userId="a0710a6e-bffc-4971-8893-1c23addeb5b0" providerId="ADAL" clId="{AD4E4DE1-9CB1-4771-A235-1540E1ED3060}" dt="2023-01-05T18:37:03.638" v="1701" actId="478"/>
          <ac:picMkLst>
            <pc:docMk/>
            <pc:sldMk cId="754505542" sldId="312"/>
            <ac:picMk id="50" creationId="{D1B7179D-235E-4355-3740-C7CC99974271}"/>
          </ac:picMkLst>
        </pc:picChg>
        <pc:picChg chg="add del mod">
          <ac:chgData name="Kumar, Vinod" userId="a0710a6e-bffc-4971-8893-1c23addeb5b0" providerId="ADAL" clId="{AD4E4DE1-9CB1-4771-A235-1540E1ED3060}" dt="2023-01-05T18:37:03.638" v="1701" actId="478"/>
          <ac:picMkLst>
            <pc:docMk/>
            <pc:sldMk cId="754505542" sldId="312"/>
            <ac:picMk id="51" creationId="{4DB8E98C-EE33-F671-6809-090C75316BED}"/>
          </ac:picMkLst>
        </pc:picChg>
        <pc:picChg chg="add del mod">
          <ac:chgData name="Kumar, Vinod" userId="a0710a6e-bffc-4971-8893-1c23addeb5b0" providerId="ADAL" clId="{AD4E4DE1-9CB1-4771-A235-1540E1ED3060}" dt="2023-01-05T18:37:03.638" v="1701" actId="478"/>
          <ac:picMkLst>
            <pc:docMk/>
            <pc:sldMk cId="754505542" sldId="312"/>
            <ac:picMk id="52" creationId="{A639250C-A88B-630A-9C12-54673ED2BCED}"/>
          </ac:picMkLst>
        </pc:picChg>
        <pc:picChg chg="add del mod">
          <ac:chgData name="Kumar, Vinod" userId="a0710a6e-bffc-4971-8893-1c23addeb5b0" providerId="ADAL" clId="{AD4E4DE1-9CB1-4771-A235-1540E1ED3060}" dt="2023-01-05T18:37:03.638" v="1701" actId="478"/>
          <ac:picMkLst>
            <pc:docMk/>
            <pc:sldMk cId="754505542" sldId="312"/>
            <ac:picMk id="71" creationId="{95F4FC26-41FC-DE50-8AE6-19A80621E69F}"/>
          </ac:picMkLst>
        </pc:picChg>
        <pc:picChg chg="add del mod">
          <ac:chgData name="Kumar, Vinod" userId="a0710a6e-bffc-4971-8893-1c23addeb5b0" providerId="ADAL" clId="{AD4E4DE1-9CB1-4771-A235-1540E1ED3060}" dt="2023-01-05T17:12:14.848" v="1474" actId="478"/>
          <ac:picMkLst>
            <pc:docMk/>
            <pc:sldMk cId="754505542" sldId="312"/>
            <ac:picMk id="72" creationId="{118CCEDF-785D-8E36-80E2-19B47D1896D6}"/>
          </ac:picMkLst>
        </pc:picChg>
        <pc:picChg chg="add del mod">
          <ac:chgData name="Kumar, Vinod" userId="a0710a6e-bffc-4971-8893-1c23addeb5b0" providerId="ADAL" clId="{AD4E4DE1-9CB1-4771-A235-1540E1ED3060}" dt="2023-01-05T18:37:00.389" v="1700" actId="478"/>
          <ac:picMkLst>
            <pc:docMk/>
            <pc:sldMk cId="754505542" sldId="312"/>
            <ac:picMk id="73" creationId="{1D4BBD8D-448C-BF85-D292-B4C5BDEE57C8}"/>
          </ac:picMkLst>
        </pc:picChg>
        <pc:picChg chg="add mod">
          <ac:chgData name="Kumar, Vinod" userId="a0710a6e-bffc-4971-8893-1c23addeb5b0" providerId="ADAL" clId="{AD4E4DE1-9CB1-4771-A235-1540E1ED3060}" dt="2023-01-05T18:40:38.787" v="1762" actId="1035"/>
          <ac:picMkLst>
            <pc:docMk/>
            <pc:sldMk cId="754505542" sldId="312"/>
            <ac:picMk id="74" creationId="{66E4FA49-58E7-1EA8-132C-7E27C31FD8A1}"/>
          </ac:picMkLst>
        </pc:picChg>
        <pc:picChg chg="add del mod">
          <ac:chgData name="Kumar, Vinod" userId="a0710a6e-bffc-4971-8893-1c23addeb5b0" providerId="ADAL" clId="{AD4E4DE1-9CB1-4771-A235-1540E1ED3060}" dt="2023-01-05T18:30:44.361" v="1631" actId="478"/>
          <ac:picMkLst>
            <pc:docMk/>
            <pc:sldMk cId="754505542" sldId="312"/>
            <ac:picMk id="75" creationId="{7EC2EDCF-8AFA-2D01-B6CB-F4204A2E9572}"/>
          </ac:picMkLst>
        </pc:picChg>
        <pc:picChg chg="add del mod">
          <ac:chgData name="Kumar, Vinod" userId="a0710a6e-bffc-4971-8893-1c23addeb5b0" providerId="ADAL" clId="{AD4E4DE1-9CB1-4771-A235-1540E1ED3060}" dt="2023-01-05T18:39:16.708" v="1712" actId="478"/>
          <ac:picMkLst>
            <pc:docMk/>
            <pc:sldMk cId="754505542" sldId="312"/>
            <ac:picMk id="76" creationId="{474E2A03-FA8B-ED3B-A24B-D71707D317B4}"/>
          </ac:picMkLst>
        </pc:picChg>
        <pc:picChg chg="add del mod">
          <ac:chgData name="Kumar, Vinod" userId="a0710a6e-bffc-4971-8893-1c23addeb5b0" providerId="ADAL" clId="{AD4E4DE1-9CB1-4771-A235-1540E1ED3060}" dt="2023-01-05T18:40:12.372" v="1757" actId="478"/>
          <ac:picMkLst>
            <pc:docMk/>
            <pc:sldMk cId="754505542" sldId="312"/>
            <ac:picMk id="77" creationId="{F92B907F-2136-C199-F9DE-0584FFACF8E9}"/>
          </ac:picMkLst>
        </pc:picChg>
        <pc:picChg chg="add del mod">
          <ac:chgData name="Kumar, Vinod" userId="a0710a6e-bffc-4971-8893-1c23addeb5b0" providerId="ADAL" clId="{AD4E4DE1-9CB1-4771-A235-1540E1ED3060}" dt="2023-01-05T18:40:12.372" v="1757" actId="478"/>
          <ac:picMkLst>
            <pc:docMk/>
            <pc:sldMk cId="754505542" sldId="312"/>
            <ac:picMk id="78" creationId="{ADB040F9-641E-7CB1-C195-341A5395D570}"/>
          </ac:picMkLst>
        </pc:picChg>
        <pc:picChg chg="add del mod">
          <ac:chgData name="Kumar, Vinod" userId="a0710a6e-bffc-4971-8893-1c23addeb5b0" providerId="ADAL" clId="{AD4E4DE1-9CB1-4771-A235-1540E1ED3060}" dt="2023-01-05T18:40:12.372" v="1757" actId="478"/>
          <ac:picMkLst>
            <pc:docMk/>
            <pc:sldMk cId="754505542" sldId="312"/>
            <ac:picMk id="79" creationId="{E80E188F-3BBC-E023-68C9-7F53CDF3DDB1}"/>
          </ac:picMkLst>
        </pc:picChg>
        <pc:picChg chg="add del mod">
          <ac:chgData name="Kumar, Vinod" userId="a0710a6e-bffc-4971-8893-1c23addeb5b0" providerId="ADAL" clId="{AD4E4DE1-9CB1-4771-A235-1540E1ED3060}" dt="2023-01-05T18:40:12.372" v="1757" actId="478"/>
          <ac:picMkLst>
            <pc:docMk/>
            <pc:sldMk cId="754505542" sldId="312"/>
            <ac:picMk id="80" creationId="{7D42FB66-3444-BD7A-CA00-AA8033F265C1}"/>
          </ac:picMkLst>
        </pc:picChg>
        <pc:picChg chg="add del mod">
          <ac:chgData name="Kumar, Vinod" userId="a0710a6e-bffc-4971-8893-1c23addeb5b0" providerId="ADAL" clId="{AD4E4DE1-9CB1-4771-A235-1540E1ED3060}" dt="2023-01-05T18:40:12.372" v="1757" actId="478"/>
          <ac:picMkLst>
            <pc:docMk/>
            <pc:sldMk cId="754505542" sldId="312"/>
            <ac:picMk id="98" creationId="{CC6BE2B4-D350-042E-7FEA-BD754308447C}"/>
          </ac:picMkLst>
        </pc:picChg>
        <pc:picChg chg="add del mod modCrop">
          <ac:chgData name="Kumar, Vinod" userId="a0710a6e-bffc-4971-8893-1c23addeb5b0" providerId="ADAL" clId="{AD4E4DE1-9CB1-4771-A235-1540E1ED3060}" dt="2023-01-05T18:42:58.547" v="1923" actId="478"/>
          <ac:picMkLst>
            <pc:docMk/>
            <pc:sldMk cId="754505542" sldId="312"/>
            <ac:picMk id="99" creationId="{8EE04A14-75D5-811D-B139-9533EAA51F71}"/>
          </ac:picMkLst>
        </pc:picChg>
        <pc:picChg chg="add del mod">
          <ac:chgData name="Kumar, Vinod" userId="a0710a6e-bffc-4971-8893-1c23addeb5b0" providerId="ADAL" clId="{AD4E4DE1-9CB1-4771-A235-1540E1ED3060}" dt="2023-01-05T18:42:16.306" v="1869" actId="478"/>
          <ac:picMkLst>
            <pc:docMk/>
            <pc:sldMk cId="754505542" sldId="312"/>
            <ac:picMk id="100" creationId="{20B02179-A5C6-9FD2-1FDB-FAA306DE3362}"/>
          </ac:picMkLst>
        </pc:picChg>
        <pc:picChg chg="add del mod">
          <ac:chgData name="Kumar, Vinod" userId="a0710a6e-bffc-4971-8893-1c23addeb5b0" providerId="ADAL" clId="{AD4E4DE1-9CB1-4771-A235-1540E1ED3060}" dt="2023-01-05T18:45:42.480" v="1969" actId="478"/>
          <ac:picMkLst>
            <pc:docMk/>
            <pc:sldMk cId="754505542" sldId="312"/>
            <ac:picMk id="101" creationId="{A7C86B62-6C8B-A16B-7D18-B61969A952DE}"/>
          </ac:picMkLst>
        </pc:picChg>
        <pc:picChg chg="add del mod modCrop">
          <ac:chgData name="Kumar, Vinod" userId="a0710a6e-bffc-4971-8893-1c23addeb5b0" providerId="ADAL" clId="{AD4E4DE1-9CB1-4771-A235-1540E1ED3060}" dt="2023-01-05T18:47:15.696" v="2018" actId="478"/>
          <ac:picMkLst>
            <pc:docMk/>
            <pc:sldMk cId="754505542" sldId="312"/>
            <ac:picMk id="102" creationId="{48E3C75D-4F98-201A-72B2-F7613389116A}"/>
          </ac:picMkLst>
        </pc:picChg>
        <pc:picChg chg="add mod">
          <ac:chgData name="Kumar, Vinod" userId="a0710a6e-bffc-4971-8893-1c23addeb5b0" providerId="ADAL" clId="{AD4E4DE1-9CB1-4771-A235-1540E1ED3060}" dt="2023-01-05T18:47:25.472" v="2047" actId="1036"/>
          <ac:picMkLst>
            <pc:docMk/>
            <pc:sldMk cId="754505542" sldId="312"/>
            <ac:picMk id="103" creationId="{40FD0B02-58ED-01BF-6D79-D816948B4DED}"/>
          </ac:picMkLst>
        </pc:picChg>
        <pc:cxnChg chg="add del mod">
          <ac:chgData name="Kumar, Vinod" userId="a0710a6e-bffc-4971-8893-1c23addeb5b0" providerId="ADAL" clId="{AD4E4DE1-9CB1-4771-A235-1540E1ED3060}" dt="2023-01-05T18:32:55.688" v="1686" actId="478"/>
          <ac:cxnSpMkLst>
            <pc:docMk/>
            <pc:sldMk cId="754505542" sldId="312"/>
            <ac:cxnSpMk id="37" creationId="{0FDF72BF-6310-050B-E5CD-8427B845B7FD}"/>
          </ac:cxnSpMkLst>
        </pc:cxnChg>
        <pc:cxnChg chg="add del mod">
          <ac:chgData name="Kumar, Vinod" userId="a0710a6e-bffc-4971-8893-1c23addeb5b0" providerId="ADAL" clId="{AD4E4DE1-9CB1-4771-A235-1540E1ED3060}" dt="2023-01-05T18:32:55.688" v="1686" actId="478"/>
          <ac:cxnSpMkLst>
            <pc:docMk/>
            <pc:sldMk cId="754505542" sldId="312"/>
            <ac:cxnSpMk id="39" creationId="{D1DEF3BC-1CEA-E7F0-0F79-E8E4D04CB1E5}"/>
          </ac:cxnSpMkLst>
        </pc:cxnChg>
        <pc:cxnChg chg="add del mod">
          <ac:chgData name="Kumar, Vinod" userId="a0710a6e-bffc-4971-8893-1c23addeb5b0" providerId="ADAL" clId="{AD4E4DE1-9CB1-4771-A235-1540E1ED3060}" dt="2023-01-05T18:32:55.688" v="1686" actId="478"/>
          <ac:cxnSpMkLst>
            <pc:docMk/>
            <pc:sldMk cId="754505542" sldId="312"/>
            <ac:cxnSpMk id="40" creationId="{9F382F14-A083-6EC8-7042-04980E222CC5}"/>
          </ac:cxnSpMkLst>
        </pc:cxnChg>
        <pc:cxnChg chg="add del mod">
          <ac:chgData name="Kumar, Vinod" userId="a0710a6e-bffc-4971-8893-1c23addeb5b0" providerId="ADAL" clId="{AD4E4DE1-9CB1-4771-A235-1540E1ED3060}" dt="2023-01-05T18:32:55.688" v="1686" actId="478"/>
          <ac:cxnSpMkLst>
            <pc:docMk/>
            <pc:sldMk cId="754505542" sldId="312"/>
            <ac:cxnSpMk id="45" creationId="{6A885FD3-5540-A949-C3E5-D47C82253374}"/>
          </ac:cxnSpMkLst>
        </pc:cxnChg>
        <pc:cxnChg chg="add del mod">
          <ac:chgData name="Kumar, Vinod" userId="a0710a6e-bffc-4971-8893-1c23addeb5b0" providerId="ADAL" clId="{AD4E4DE1-9CB1-4771-A235-1540E1ED3060}" dt="2023-01-05T18:37:03.638" v="1701" actId="478"/>
          <ac:cxnSpMkLst>
            <pc:docMk/>
            <pc:sldMk cId="754505542" sldId="312"/>
            <ac:cxnSpMk id="63" creationId="{8ABEF95F-1962-4F75-3937-3CDBC18F0C5B}"/>
          </ac:cxnSpMkLst>
        </pc:cxnChg>
        <pc:cxnChg chg="add del mod">
          <ac:chgData name="Kumar, Vinod" userId="a0710a6e-bffc-4971-8893-1c23addeb5b0" providerId="ADAL" clId="{AD4E4DE1-9CB1-4771-A235-1540E1ED3060}" dt="2023-01-05T18:37:03.638" v="1701" actId="478"/>
          <ac:cxnSpMkLst>
            <pc:docMk/>
            <pc:sldMk cId="754505542" sldId="312"/>
            <ac:cxnSpMk id="65" creationId="{12CFF77D-E953-C2D0-AE41-B203705DEF3C}"/>
          </ac:cxnSpMkLst>
        </pc:cxnChg>
        <pc:cxnChg chg="add del mod">
          <ac:chgData name="Kumar, Vinod" userId="a0710a6e-bffc-4971-8893-1c23addeb5b0" providerId="ADAL" clId="{AD4E4DE1-9CB1-4771-A235-1540E1ED3060}" dt="2023-01-05T18:37:03.638" v="1701" actId="478"/>
          <ac:cxnSpMkLst>
            <pc:docMk/>
            <pc:sldMk cId="754505542" sldId="312"/>
            <ac:cxnSpMk id="66" creationId="{A440CE8A-5BF3-77E7-D081-1857AF0BA566}"/>
          </ac:cxnSpMkLst>
        </pc:cxnChg>
        <pc:cxnChg chg="add del mod">
          <ac:chgData name="Kumar, Vinod" userId="a0710a6e-bffc-4971-8893-1c23addeb5b0" providerId="ADAL" clId="{AD4E4DE1-9CB1-4771-A235-1540E1ED3060}" dt="2023-01-05T18:37:03.638" v="1701" actId="478"/>
          <ac:cxnSpMkLst>
            <pc:docMk/>
            <pc:sldMk cId="754505542" sldId="312"/>
            <ac:cxnSpMk id="70" creationId="{E89EAF3B-2766-8A68-4CB7-B249710E9617}"/>
          </ac:cxnSpMkLst>
        </pc:cxnChg>
        <pc:cxnChg chg="add del mod">
          <ac:chgData name="Kumar, Vinod" userId="a0710a6e-bffc-4971-8893-1c23addeb5b0" providerId="ADAL" clId="{AD4E4DE1-9CB1-4771-A235-1540E1ED3060}" dt="2023-01-05T18:40:12.372" v="1757" actId="478"/>
          <ac:cxnSpMkLst>
            <pc:docMk/>
            <pc:sldMk cId="754505542" sldId="312"/>
            <ac:cxnSpMk id="90" creationId="{56F9FFCA-1605-D367-073E-F383E8D4D2A2}"/>
          </ac:cxnSpMkLst>
        </pc:cxnChg>
        <pc:cxnChg chg="add del mod">
          <ac:chgData name="Kumar, Vinod" userId="a0710a6e-bffc-4971-8893-1c23addeb5b0" providerId="ADAL" clId="{AD4E4DE1-9CB1-4771-A235-1540E1ED3060}" dt="2023-01-05T18:40:12.372" v="1757" actId="478"/>
          <ac:cxnSpMkLst>
            <pc:docMk/>
            <pc:sldMk cId="754505542" sldId="312"/>
            <ac:cxnSpMk id="92" creationId="{AA1AFAA6-71CE-7FF9-0727-D2BDF5AD1E13}"/>
          </ac:cxnSpMkLst>
        </pc:cxnChg>
        <pc:cxnChg chg="add del mod">
          <ac:chgData name="Kumar, Vinod" userId="a0710a6e-bffc-4971-8893-1c23addeb5b0" providerId="ADAL" clId="{AD4E4DE1-9CB1-4771-A235-1540E1ED3060}" dt="2023-01-05T18:40:12.372" v="1757" actId="478"/>
          <ac:cxnSpMkLst>
            <pc:docMk/>
            <pc:sldMk cId="754505542" sldId="312"/>
            <ac:cxnSpMk id="93" creationId="{E18FBAF2-A326-192D-FC07-3BAB385CC8A4}"/>
          </ac:cxnSpMkLst>
        </pc:cxnChg>
        <pc:cxnChg chg="add del mod">
          <ac:chgData name="Kumar, Vinod" userId="a0710a6e-bffc-4971-8893-1c23addeb5b0" providerId="ADAL" clId="{AD4E4DE1-9CB1-4771-A235-1540E1ED3060}" dt="2023-01-05T18:40:12.372" v="1757" actId="478"/>
          <ac:cxnSpMkLst>
            <pc:docMk/>
            <pc:sldMk cId="754505542" sldId="312"/>
            <ac:cxnSpMk id="97" creationId="{383DCC1C-716B-73D5-2467-CE01C40352AB}"/>
          </ac:cxnSpMkLst>
        </pc:cxnChg>
      </pc:sldChg>
      <pc:sldChg chg="addSp delSp modSp new del mod">
        <pc:chgData name="Kumar, Vinod" userId="a0710a6e-bffc-4971-8893-1c23addeb5b0" providerId="ADAL" clId="{AD4E4DE1-9CB1-4771-A235-1540E1ED3060}" dt="2022-12-22T19:11:48.633" v="524" actId="47"/>
        <pc:sldMkLst>
          <pc:docMk/>
          <pc:sldMk cId="755144092" sldId="312"/>
        </pc:sldMkLst>
        <pc:graphicFrameChg chg="add del mod">
          <ac:chgData name="Kumar, Vinod" userId="a0710a6e-bffc-4971-8893-1c23addeb5b0" providerId="ADAL" clId="{AD4E4DE1-9CB1-4771-A235-1540E1ED3060}" dt="2022-12-22T19:07:26.072" v="472" actId="478"/>
          <ac:graphicFrameMkLst>
            <pc:docMk/>
            <pc:sldMk cId="755144092" sldId="312"/>
            <ac:graphicFrameMk id="2" creationId="{3D1198D9-A09B-0638-E679-4C017704A865}"/>
          </ac:graphicFrameMkLst>
        </pc:graphicFrameChg>
        <pc:graphicFrameChg chg="add del mod">
          <ac:chgData name="Kumar, Vinod" userId="a0710a6e-bffc-4971-8893-1c23addeb5b0" providerId="ADAL" clId="{AD4E4DE1-9CB1-4771-A235-1540E1ED3060}" dt="2022-12-22T19:08:02.552" v="477" actId="478"/>
          <ac:graphicFrameMkLst>
            <pc:docMk/>
            <pc:sldMk cId="755144092" sldId="312"/>
            <ac:graphicFrameMk id="3" creationId="{8DD2D9D0-3C8C-5DF6-F477-4A6B8DD9B518}"/>
          </ac:graphicFrameMkLst>
        </pc:graphicFrameChg>
        <pc:graphicFrameChg chg="add del mod">
          <ac:chgData name="Kumar, Vinod" userId="a0710a6e-bffc-4971-8893-1c23addeb5b0" providerId="ADAL" clId="{AD4E4DE1-9CB1-4771-A235-1540E1ED3060}" dt="2022-12-22T19:08:59.998" v="479"/>
          <ac:graphicFrameMkLst>
            <pc:docMk/>
            <pc:sldMk cId="755144092" sldId="312"/>
            <ac:graphicFrameMk id="4" creationId="{90A77AB2-22F7-353D-5B86-87378354FF4E}"/>
          </ac:graphicFrameMkLst>
        </pc:graphicFrameChg>
        <pc:picChg chg="del mod">
          <ac:chgData name="Kumar, Vinod" userId="a0710a6e-bffc-4971-8893-1c23addeb5b0" providerId="ADAL" clId="{AD4E4DE1-9CB1-4771-A235-1540E1ED3060}" dt="2022-12-22T19:10:40.426" v="498" actId="478"/>
          <ac:picMkLst>
            <pc:docMk/>
            <pc:sldMk cId="755144092" sldId="312"/>
            <ac:picMk id="5" creationId="{E9C80DCD-6520-B5C7-0004-D3C27D3A8585}"/>
          </ac:picMkLst>
        </pc:picChg>
        <pc:picChg chg="del mod">
          <ac:chgData name="Kumar, Vinod" userId="a0710a6e-bffc-4971-8893-1c23addeb5b0" providerId="ADAL" clId="{AD4E4DE1-9CB1-4771-A235-1540E1ED3060}" dt="2022-12-22T19:10:39.543" v="497" actId="478"/>
          <ac:picMkLst>
            <pc:docMk/>
            <pc:sldMk cId="755144092" sldId="312"/>
            <ac:picMk id="6" creationId="{E7F49F51-9627-1033-A0FF-5C84952B2E9C}"/>
          </ac:picMkLst>
        </pc:picChg>
        <pc:picChg chg="mod">
          <ac:chgData name="Kumar, Vinod" userId="a0710a6e-bffc-4971-8893-1c23addeb5b0" providerId="ADAL" clId="{AD4E4DE1-9CB1-4771-A235-1540E1ED3060}" dt="2022-12-22T19:10:41.599" v="499" actId="1076"/>
          <ac:picMkLst>
            <pc:docMk/>
            <pc:sldMk cId="755144092" sldId="312"/>
            <ac:picMk id="7" creationId="{FA4092F5-09AC-E545-A7B9-44702F954401}"/>
          </ac:picMkLst>
        </pc:picChg>
      </pc:sldChg>
      <pc:sldChg chg="addSp delSp modSp new mod">
        <pc:chgData name="Kumar, Vinod" userId="a0710a6e-bffc-4971-8893-1c23addeb5b0" providerId="ADAL" clId="{AD4E4DE1-9CB1-4771-A235-1540E1ED3060}" dt="2023-01-06T19:56:52.280" v="6709" actId="1036"/>
        <pc:sldMkLst>
          <pc:docMk/>
          <pc:sldMk cId="2814613315" sldId="313"/>
        </pc:sldMkLst>
        <pc:spChg chg="add mod">
          <ac:chgData name="Kumar, Vinod" userId="a0710a6e-bffc-4971-8893-1c23addeb5b0" providerId="ADAL" clId="{AD4E4DE1-9CB1-4771-A235-1540E1ED3060}" dt="2023-01-06T19:56:37.745" v="6702" actId="255"/>
          <ac:spMkLst>
            <pc:docMk/>
            <pc:sldMk cId="2814613315" sldId="313"/>
            <ac:spMk id="3" creationId="{A6DD0B48-B345-CF1F-AC35-22438CCC0C8B}"/>
          </ac:spMkLst>
        </pc:spChg>
        <pc:spChg chg="mod">
          <ac:chgData name="Kumar, Vinod" userId="a0710a6e-bffc-4971-8893-1c23addeb5b0" providerId="ADAL" clId="{AD4E4DE1-9CB1-4771-A235-1540E1ED3060}" dt="2023-01-06T15:46:01.213" v="5806"/>
          <ac:spMkLst>
            <pc:docMk/>
            <pc:sldMk cId="2814613315" sldId="313"/>
            <ac:spMk id="7" creationId="{98708DB5-C12D-7A2C-9318-36623CAB6A6A}"/>
          </ac:spMkLst>
        </pc:spChg>
        <pc:spChg chg="mod">
          <ac:chgData name="Kumar, Vinod" userId="a0710a6e-bffc-4971-8893-1c23addeb5b0" providerId="ADAL" clId="{AD4E4DE1-9CB1-4771-A235-1540E1ED3060}" dt="2023-01-06T15:46:01.213" v="5806"/>
          <ac:spMkLst>
            <pc:docMk/>
            <pc:sldMk cId="2814613315" sldId="313"/>
            <ac:spMk id="8" creationId="{87120B7A-BA96-DDCF-4C18-B8188D8EE25D}"/>
          </ac:spMkLst>
        </pc:spChg>
        <pc:spChg chg="mod">
          <ac:chgData name="Kumar, Vinod" userId="a0710a6e-bffc-4971-8893-1c23addeb5b0" providerId="ADAL" clId="{AD4E4DE1-9CB1-4771-A235-1540E1ED3060}" dt="2023-01-06T15:46:01.213" v="5806"/>
          <ac:spMkLst>
            <pc:docMk/>
            <pc:sldMk cId="2814613315" sldId="313"/>
            <ac:spMk id="10" creationId="{D85A2A54-B42F-1F3E-2C3D-3B543E84E0E8}"/>
          </ac:spMkLst>
        </pc:spChg>
        <pc:spChg chg="mod">
          <ac:chgData name="Kumar, Vinod" userId="a0710a6e-bffc-4971-8893-1c23addeb5b0" providerId="ADAL" clId="{AD4E4DE1-9CB1-4771-A235-1540E1ED3060}" dt="2023-01-06T15:46:26.444" v="5808"/>
          <ac:spMkLst>
            <pc:docMk/>
            <pc:sldMk cId="2814613315" sldId="313"/>
            <ac:spMk id="14" creationId="{008E64C4-9AED-7A55-6A47-DBCD7570E7BE}"/>
          </ac:spMkLst>
        </pc:spChg>
        <pc:spChg chg="mod">
          <ac:chgData name="Kumar, Vinod" userId="a0710a6e-bffc-4971-8893-1c23addeb5b0" providerId="ADAL" clId="{AD4E4DE1-9CB1-4771-A235-1540E1ED3060}" dt="2023-01-06T15:46:26.444" v="5808"/>
          <ac:spMkLst>
            <pc:docMk/>
            <pc:sldMk cId="2814613315" sldId="313"/>
            <ac:spMk id="15" creationId="{D8FA2BF9-328A-2446-5122-E43C61E20A5B}"/>
          </ac:spMkLst>
        </pc:spChg>
        <pc:spChg chg="mod">
          <ac:chgData name="Kumar, Vinod" userId="a0710a6e-bffc-4971-8893-1c23addeb5b0" providerId="ADAL" clId="{AD4E4DE1-9CB1-4771-A235-1540E1ED3060}" dt="2023-01-06T15:46:26.444" v="5808"/>
          <ac:spMkLst>
            <pc:docMk/>
            <pc:sldMk cId="2814613315" sldId="313"/>
            <ac:spMk id="17" creationId="{42F3C2A8-682D-A1D2-2AD2-18519F9B65E3}"/>
          </ac:spMkLst>
        </pc:spChg>
        <pc:spChg chg="mod">
          <ac:chgData name="Kumar, Vinod" userId="a0710a6e-bffc-4971-8893-1c23addeb5b0" providerId="ADAL" clId="{AD4E4DE1-9CB1-4771-A235-1540E1ED3060}" dt="2023-01-06T15:46:51.294" v="5810"/>
          <ac:spMkLst>
            <pc:docMk/>
            <pc:sldMk cId="2814613315" sldId="313"/>
            <ac:spMk id="21" creationId="{9E86B641-475F-295F-56F3-07A40B5C01D1}"/>
          </ac:spMkLst>
        </pc:spChg>
        <pc:spChg chg="mod">
          <ac:chgData name="Kumar, Vinod" userId="a0710a6e-bffc-4971-8893-1c23addeb5b0" providerId="ADAL" clId="{AD4E4DE1-9CB1-4771-A235-1540E1ED3060}" dt="2023-01-06T15:46:51.294" v="5810"/>
          <ac:spMkLst>
            <pc:docMk/>
            <pc:sldMk cId="2814613315" sldId="313"/>
            <ac:spMk id="22" creationId="{50F79DB3-31BD-DCA7-D2CB-017C602BD0C6}"/>
          </ac:spMkLst>
        </pc:spChg>
        <pc:spChg chg="mod">
          <ac:chgData name="Kumar, Vinod" userId="a0710a6e-bffc-4971-8893-1c23addeb5b0" providerId="ADAL" clId="{AD4E4DE1-9CB1-4771-A235-1540E1ED3060}" dt="2023-01-06T15:46:51.294" v="5810"/>
          <ac:spMkLst>
            <pc:docMk/>
            <pc:sldMk cId="2814613315" sldId="313"/>
            <ac:spMk id="24" creationId="{8E1392BC-6971-8A65-9480-4D875820DB3F}"/>
          </ac:spMkLst>
        </pc:spChg>
        <pc:spChg chg="mod">
          <ac:chgData name="Kumar, Vinod" userId="a0710a6e-bffc-4971-8893-1c23addeb5b0" providerId="ADAL" clId="{AD4E4DE1-9CB1-4771-A235-1540E1ED3060}" dt="2023-01-06T15:48:43.660" v="5890"/>
          <ac:spMkLst>
            <pc:docMk/>
            <pc:sldMk cId="2814613315" sldId="313"/>
            <ac:spMk id="29" creationId="{EA84A4C4-5B5C-6C98-C65A-3BF087F77A31}"/>
          </ac:spMkLst>
        </pc:spChg>
        <pc:spChg chg="mod">
          <ac:chgData name="Kumar, Vinod" userId="a0710a6e-bffc-4971-8893-1c23addeb5b0" providerId="ADAL" clId="{AD4E4DE1-9CB1-4771-A235-1540E1ED3060}" dt="2023-01-06T15:48:43.660" v="5890"/>
          <ac:spMkLst>
            <pc:docMk/>
            <pc:sldMk cId="2814613315" sldId="313"/>
            <ac:spMk id="30" creationId="{C405DB87-CBAB-2F20-02BB-D7143F66E94B}"/>
          </ac:spMkLst>
        </pc:spChg>
        <pc:spChg chg="mod">
          <ac:chgData name="Kumar, Vinod" userId="a0710a6e-bffc-4971-8893-1c23addeb5b0" providerId="ADAL" clId="{AD4E4DE1-9CB1-4771-A235-1540E1ED3060}" dt="2023-01-06T15:48:43.660" v="5890"/>
          <ac:spMkLst>
            <pc:docMk/>
            <pc:sldMk cId="2814613315" sldId="313"/>
            <ac:spMk id="32" creationId="{488CF9E3-84A0-A8DC-B380-4A5863DF7A7C}"/>
          </ac:spMkLst>
        </pc:spChg>
        <pc:spChg chg="mod">
          <ac:chgData name="Kumar, Vinod" userId="a0710a6e-bffc-4971-8893-1c23addeb5b0" providerId="ADAL" clId="{AD4E4DE1-9CB1-4771-A235-1540E1ED3060}" dt="2023-01-06T15:49:00.379" v="5904"/>
          <ac:spMkLst>
            <pc:docMk/>
            <pc:sldMk cId="2814613315" sldId="313"/>
            <ac:spMk id="37" creationId="{54186768-971B-849B-419F-E64DCB62DC68}"/>
          </ac:spMkLst>
        </pc:spChg>
        <pc:spChg chg="mod">
          <ac:chgData name="Kumar, Vinod" userId="a0710a6e-bffc-4971-8893-1c23addeb5b0" providerId="ADAL" clId="{AD4E4DE1-9CB1-4771-A235-1540E1ED3060}" dt="2023-01-06T15:49:00.379" v="5904"/>
          <ac:spMkLst>
            <pc:docMk/>
            <pc:sldMk cId="2814613315" sldId="313"/>
            <ac:spMk id="38" creationId="{80FA54BF-B1A2-6772-5BDB-863DEB01B835}"/>
          </ac:spMkLst>
        </pc:spChg>
        <pc:spChg chg="mod">
          <ac:chgData name="Kumar, Vinod" userId="a0710a6e-bffc-4971-8893-1c23addeb5b0" providerId="ADAL" clId="{AD4E4DE1-9CB1-4771-A235-1540E1ED3060}" dt="2023-01-06T15:49:00.379" v="5904"/>
          <ac:spMkLst>
            <pc:docMk/>
            <pc:sldMk cId="2814613315" sldId="313"/>
            <ac:spMk id="40" creationId="{AC5B601E-C4A9-7A84-1882-253B20E8CF78}"/>
          </ac:spMkLst>
        </pc:spChg>
        <pc:spChg chg="add mod">
          <ac:chgData name="Kumar, Vinod" userId="a0710a6e-bffc-4971-8893-1c23addeb5b0" providerId="ADAL" clId="{AD4E4DE1-9CB1-4771-A235-1540E1ED3060}" dt="2023-01-06T19:56:37.745" v="6702" actId="255"/>
          <ac:spMkLst>
            <pc:docMk/>
            <pc:sldMk cId="2814613315" sldId="313"/>
            <ac:spMk id="42" creationId="{59665A96-21CF-3CB0-568D-F73C9511EFD8}"/>
          </ac:spMkLst>
        </pc:spChg>
        <pc:spChg chg="add mod">
          <ac:chgData name="Kumar, Vinod" userId="a0710a6e-bffc-4971-8893-1c23addeb5b0" providerId="ADAL" clId="{AD4E4DE1-9CB1-4771-A235-1540E1ED3060}" dt="2023-01-06T19:56:37.745" v="6702" actId="255"/>
          <ac:spMkLst>
            <pc:docMk/>
            <pc:sldMk cId="2814613315" sldId="313"/>
            <ac:spMk id="43" creationId="{85941A31-F9CC-2694-9DF5-562FECB4D269}"/>
          </ac:spMkLst>
        </pc:spChg>
        <pc:spChg chg="add mod">
          <ac:chgData name="Kumar, Vinod" userId="a0710a6e-bffc-4971-8893-1c23addeb5b0" providerId="ADAL" clId="{AD4E4DE1-9CB1-4771-A235-1540E1ED3060}" dt="2023-01-06T19:56:37.745" v="6702" actId="255"/>
          <ac:spMkLst>
            <pc:docMk/>
            <pc:sldMk cId="2814613315" sldId="313"/>
            <ac:spMk id="44" creationId="{B514ABBE-AC9F-7F63-CD41-1A43A7AD490F}"/>
          </ac:spMkLst>
        </pc:spChg>
        <pc:grpChg chg="add del mod">
          <ac:chgData name="Kumar, Vinod" userId="a0710a6e-bffc-4971-8893-1c23addeb5b0" providerId="ADAL" clId="{AD4E4DE1-9CB1-4771-A235-1540E1ED3060}" dt="2023-01-06T16:16:29.224" v="6311" actId="478"/>
          <ac:grpSpMkLst>
            <pc:docMk/>
            <pc:sldMk cId="2814613315" sldId="313"/>
            <ac:grpSpMk id="4" creationId="{F0BCAF7B-B937-54DF-FAB1-63B159D54E8A}"/>
          </ac:grpSpMkLst>
        </pc:grpChg>
        <pc:grpChg chg="add del mod">
          <ac:chgData name="Kumar, Vinod" userId="a0710a6e-bffc-4971-8893-1c23addeb5b0" providerId="ADAL" clId="{AD4E4DE1-9CB1-4771-A235-1540E1ED3060}" dt="2023-01-06T16:16:29.224" v="6311" actId="478"/>
          <ac:grpSpMkLst>
            <pc:docMk/>
            <pc:sldMk cId="2814613315" sldId="313"/>
            <ac:grpSpMk id="11" creationId="{884C9309-6E09-65A0-ACBB-5F16209B99C5}"/>
          </ac:grpSpMkLst>
        </pc:grpChg>
        <pc:grpChg chg="add del mod">
          <ac:chgData name="Kumar, Vinod" userId="a0710a6e-bffc-4971-8893-1c23addeb5b0" providerId="ADAL" clId="{AD4E4DE1-9CB1-4771-A235-1540E1ED3060}" dt="2023-01-06T16:16:29.224" v="6311" actId="478"/>
          <ac:grpSpMkLst>
            <pc:docMk/>
            <pc:sldMk cId="2814613315" sldId="313"/>
            <ac:grpSpMk id="18" creationId="{F51A5E58-6B7C-F99A-E4D4-68868433C2FE}"/>
          </ac:grpSpMkLst>
        </pc:grpChg>
        <pc:grpChg chg="add del mod">
          <ac:chgData name="Kumar, Vinod" userId="a0710a6e-bffc-4971-8893-1c23addeb5b0" providerId="ADAL" clId="{AD4E4DE1-9CB1-4771-A235-1540E1ED3060}" dt="2023-01-06T15:48:49.557" v="5901" actId="478"/>
          <ac:grpSpMkLst>
            <pc:docMk/>
            <pc:sldMk cId="2814613315" sldId="313"/>
            <ac:grpSpMk id="26" creationId="{6B3DE7CD-CA07-9BEA-0278-E9DF07850794}"/>
          </ac:grpSpMkLst>
        </pc:grpChg>
        <pc:grpChg chg="add del mod">
          <ac:chgData name="Kumar, Vinod" userId="a0710a6e-bffc-4971-8893-1c23addeb5b0" providerId="ADAL" clId="{AD4E4DE1-9CB1-4771-A235-1540E1ED3060}" dt="2023-01-06T15:49:03.366" v="5905"/>
          <ac:grpSpMkLst>
            <pc:docMk/>
            <pc:sldMk cId="2814613315" sldId="313"/>
            <ac:grpSpMk id="34" creationId="{B292FF31-734F-9DF8-173D-1D683129D72E}"/>
          </ac:grpSpMkLst>
        </pc:grpChg>
        <pc:picChg chg="add mod">
          <ac:chgData name="Kumar, Vinod" userId="a0710a6e-bffc-4971-8893-1c23addeb5b0" providerId="ADAL" clId="{AD4E4DE1-9CB1-4771-A235-1540E1ED3060}" dt="2023-01-06T15:45:27.655" v="5805" actId="1037"/>
          <ac:picMkLst>
            <pc:docMk/>
            <pc:sldMk cId="2814613315" sldId="313"/>
            <ac:picMk id="2" creationId="{847F1819-444C-8B7F-1403-160F673742AB}"/>
          </ac:picMkLst>
        </pc:picChg>
        <pc:picChg chg="mod">
          <ac:chgData name="Kumar, Vinod" userId="a0710a6e-bffc-4971-8893-1c23addeb5b0" providerId="ADAL" clId="{AD4E4DE1-9CB1-4771-A235-1540E1ED3060}" dt="2023-01-06T15:46:01.213" v="5806"/>
          <ac:picMkLst>
            <pc:docMk/>
            <pc:sldMk cId="2814613315" sldId="313"/>
            <ac:picMk id="5" creationId="{BBDC1256-57DE-C087-AAAF-21B091807519}"/>
          </ac:picMkLst>
        </pc:picChg>
        <pc:picChg chg="mod">
          <ac:chgData name="Kumar, Vinod" userId="a0710a6e-bffc-4971-8893-1c23addeb5b0" providerId="ADAL" clId="{AD4E4DE1-9CB1-4771-A235-1540E1ED3060}" dt="2023-01-06T15:46:01.213" v="5806"/>
          <ac:picMkLst>
            <pc:docMk/>
            <pc:sldMk cId="2814613315" sldId="313"/>
            <ac:picMk id="6" creationId="{EC944026-2967-0AAB-E91B-437E9C1C7B72}"/>
          </ac:picMkLst>
        </pc:picChg>
        <pc:picChg chg="mod">
          <ac:chgData name="Kumar, Vinod" userId="a0710a6e-bffc-4971-8893-1c23addeb5b0" providerId="ADAL" clId="{AD4E4DE1-9CB1-4771-A235-1540E1ED3060}" dt="2023-01-06T15:46:26.444" v="5808"/>
          <ac:picMkLst>
            <pc:docMk/>
            <pc:sldMk cId="2814613315" sldId="313"/>
            <ac:picMk id="12" creationId="{F6DDE607-2173-8236-5905-956D44E47BDF}"/>
          </ac:picMkLst>
        </pc:picChg>
        <pc:picChg chg="mod">
          <ac:chgData name="Kumar, Vinod" userId="a0710a6e-bffc-4971-8893-1c23addeb5b0" providerId="ADAL" clId="{AD4E4DE1-9CB1-4771-A235-1540E1ED3060}" dt="2023-01-06T15:46:26.444" v="5808"/>
          <ac:picMkLst>
            <pc:docMk/>
            <pc:sldMk cId="2814613315" sldId="313"/>
            <ac:picMk id="13" creationId="{4C67F770-0483-2913-A058-4B9FE1239F21}"/>
          </ac:picMkLst>
        </pc:picChg>
        <pc:picChg chg="mod">
          <ac:chgData name="Kumar, Vinod" userId="a0710a6e-bffc-4971-8893-1c23addeb5b0" providerId="ADAL" clId="{AD4E4DE1-9CB1-4771-A235-1540E1ED3060}" dt="2023-01-06T15:46:51.294" v="5810"/>
          <ac:picMkLst>
            <pc:docMk/>
            <pc:sldMk cId="2814613315" sldId="313"/>
            <ac:picMk id="19" creationId="{12AD5958-EC64-BD73-5054-CFD4E42FCE7C}"/>
          </ac:picMkLst>
        </pc:picChg>
        <pc:picChg chg="mod">
          <ac:chgData name="Kumar, Vinod" userId="a0710a6e-bffc-4971-8893-1c23addeb5b0" providerId="ADAL" clId="{AD4E4DE1-9CB1-4771-A235-1540E1ED3060}" dt="2023-01-06T15:46:51.294" v="5810"/>
          <ac:picMkLst>
            <pc:docMk/>
            <pc:sldMk cId="2814613315" sldId="313"/>
            <ac:picMk id="20" creationId="{02C11428-5F96-7FF8-63C1-A80FC58A63FD}"/>
          </ac:picMkLst>
        </pc:picChg>
        <pc:picChg chg="add mod">
          <ac:chgData name="Kumar, Vinod" userId="a0710a6e-bffc-4971-8893-1c23addeb5b0" providerId="ADAL" clId="{AD4E4DE1-9CB1-4771-A235-1540E1ED3060}" dt="2023-01-06T19:56:46.168" v="6704" actId="1036"/>
          <ac:picMkLst>
            <pc:docMk/>
            <pc:sldMk cId="2814613315" sldId="313"/>
            <ac:picMk id="25" creationId="{6CBAF858-50D9-8F7C-6DF5-67EBF5C98E72}"/>
          </ac:picMkLst>
        </pc:picChg>
        <pc:picChg chg="mod">
          <ac:chgData name="Kumar, Vinod" userId="a0710a6e-bffc-4971-8893-1c23addeb5b0" providerId="ADAL" clId="{AD4E4DE1-9CB1-4771-A235-1540E1ED3060}" dt="2023-01-06T15:48:43.660" v="5890"/>
          <ac:picMkLst>
            <pc:docMk/>
            <pc:sldMk cId="2814613315" sldId="313"/>
            <ac:picMk id="27" creationId="{131D7EDD-6C33-BD3D-0CA1-0155E867D28E}"/>
          </ac:picMkLst>
        </pc:picChg>
        <pc:picChg chg="mod">
          <ac:chgData name="Kumar, Vinod" userId="a0710a6e-bffc-4971-8893-1c23addeb5b0" providerId="ADAL" clId="{AD4E4DE1-9CB1-4771-A235-1540E1ED3060}" dt="2023-01-06T15:48:43.660" v="5890"/>
          <ac:picMkLst>
            <pc:docMk/>
            <pc:sldMk cId="2814613315" sldId="313"/>
            <ac:picMk id="28" creationId="{03152A0B-AC7B-C180-81AA-9CFAE63726C0}"/>
          </ac:picMkLst>
        </pc:picChg>
        <pc:picChg chg="add mod">
          <ac:chgData name="Kumar, Vinod" userId="a0710a6e-bffc-4971-8893-1c23addeb5b0" providerId="ADAL" clId="{AD4E4DE1-9CB1-4771-A235-1540E1ED3060}" dt="2023-01-06T19:56:52.280" v="6709" actId="1036"/>
          <ac:picMkLst>
            <pc:docMk/>
            <pc:sldMk cId="2814613315" sldId="313"/>
            <ac:picMk id="33" creationId="{963910ED-36A7-503E-D426-41AE7A8316BA}"/>
          </ac:picMkLst>
        </pc:picChg>
        <pc:picChg chg="mod">
          <ac:chgData name="Kumar, Vinod" userId="a0710a6e-bffc-4971-8893-1c23addeb5b0" providerId="ADAL" clId="{AD4E4DE1-9CB1-4771-A235-1540E1ED3060}" dt="2023-01-06T15:49:00.379" v="5904"/>
          <ac:picMkLst>
            <pc:docMk/>
            <pc:sldMk cId="2814613315" sldId="313"/>
            <ac:picMk id="35" creationId="{0BCAA9A8-7A7A-C23A-70A8-1E4E8A9E98B0}"/>
          </ac:picMkLst>
        </pc:picChg>
        <pc:picChg chg="mod">
          <ac:chgData name="Kumar, Vinod" userId="a0710a6e-bffc-4971-8893-1c23addeb5b0" providerId="ADAL" clId="{AD4E4DE1-9CB1-4771-A235-1540E1ED3060}" dt="2023-01-06T15:49:00.379" v="5904"/>
          <ac:picMkLst>
            <pc:docMk/>
            <pc:sldMk cId="2814613315" sldId="313"/>
            <ac:picMk id="36" creationId="{0719995B-3E5C-B4D3-DD8D-48EE0DEA8AD8}"/>
          </ac:picMkLst>
        </pc:picChg>
        <pc:picChg chg="add mod">
          <ac:chgData name="Kumar, Vinod" userId="a0710a6e-bffc-4971-8893-1c23addeb5b0" providerId="ADAL" clId="{AD4E4DE1-9CB1-4771-A235-1540E1ED3060}" dt="2023-01-06T19:56:52.280" v="6709" actId="1036"/>
          <ac:picMkLst>
            <pc:docMk/>
            <pc:sldMk cId="2814613315" sldId="313"/>
            <ac:picMk id="41" creationId="{AE750BBF-E519-06D9-A8B7-E559F7A7A805}"/>
          </ac:picMkLst>
        </pc:picChg>
        <pc:cxnChg chg="mod">
          <ac:chgData name="Kumar, Vinod" userId="a0710a6e-bffc-4971-8893-1c23addeb5b0" providerId="ADAL" clId="{AD4E4DE1-9CB1-4771-A235-1540E1ED3060}" dt="2023-01-06T15:46:01.213" v="5806"/>
          <ac:cxnSpMkLst>
            <pc:docMk/>
            <pc:sldMk cId="2814613315" sldId="313"/>
            <ac:cxnSpMk id="9" creationId="{BC6CD9E3-0687-A481-4310-60A60B5F391E}"/>
          </ac:cxnSpMkLst>
        </pc:cxnChg>
        <pc:cxnChg chg="mod">
          <ac:chgData name="Kumar, Vinod" userId="a0710a6e-bffc-4971-8893-1c23addeb5b0" providerId="ADAL" clId="{AD4E4DE1-9CB1-4771-A235-1540E1ED3060}" dt="2023-01-06T15:46:26.444" v="5808"/>
          <ac:cxnSpMkLst>
            <pc:docMk/>
            <pc:sldMk cId="2814613315" sldId="313"/>
            <ac:cxnSpMk id="16" creationId="{5C86B625-E0F5-9B34-552C-167595950D15}"/>
          </ac:cxnSpMkLst>
        </pc:cxnChg>
        <pc:cxnChg chg="mod">
          <ac:chgData name="Kumar, Vinod" userId="a0710a6e-bffc-4971-8893-1c23addeb5b0" providerId="ADAL" clId="{AD4E4DE1-9CB1-4771-A235-1540E1ED3060}" dt="2023-01-06T15:46:51.294" v="5810"/>
          <ac:cxnSpMkLst>
            <pc:docMk/>
            <pc:sldMk cId="2814613315" sldId="313"/>
            <ac:cxnSpMk id="23" creationId="{89A6C2B9-0540-B635-E66D-DDDB32E350D3}"/>
          </ac:cxnSpMkLst>
        </pc:cxnChg>
        <pc:cxnChg chg="mod">
          <ac:chgData name="Kumar, Vinod" userId="a0710a6e-bffc-4971-8893-1c23addeb5b0" providerId="ADAL" clId="{AD4E4DE1-9CB1-4771-A235-1540E1ED3060}" dt="2023-01-06T15:48:43.660" v="5890"/>
          <ac:cxnSpMkLst>
            <pc:docMk/>
            <pc:sldMk cId="2814613315" sldId="313"/>
            <ac:cxnSpMk id="31" creationId="{3E819B7D-D09A-661F-0E88-8B69988A8BCF}"/>
          </ac:cxnSpMkLst>
        </pc:cxnChg>
        <pc:cxnChg chg="mod">
          <ac:chgData name="Kumar, Vinod" userId="a0710a6e-bffc-4971-8893-1c23addeb5b0" providerId="ADAL" clId="{AD4E4DE1-9CB1-4771-A235-1540E1ED3060}" dt="2023-01-06T15:49:00.379" v="5904"/>
          <ac:cxnSpMkLst>
            <pc:docMk/>
            <pc:sldMk cId="2814613315" sldId="313"/>
            <ac:cxnSpMk id="39" creationId="{21A3BD2A-E0C1-A505-B3ED-B812326BF12F}"/>
          </ac:cxnSpMkLst>
        </pc:cxnChg>
      </pc:sldChg>
      <pc:sldChg chg="addSp delSp modSp new mod">
        <pc:chgData name="Kumar, Vinod" userId="a0710a6e-bffc-4971-8893-1c23addeb5b0" providerId="ADAL" clId="{AD4E4DE1-9CB1-4771-A235-1540E1ED3060}" dt="2023-01-06T19:51:57.722" v="6664" actId="255"/>
        <pc:sldMkLst>
          <pc:docMk/>
          <pc:sldMk cId="2551874591" sldId="314"/>
        </pc:sldMkLst>
        <pc:spChg chg="add mod">
          <ac:chgData name="Kumar, Vinod" userId="a0710a6e-bffc-4971-8893-1c23addeb5b0" providerId="ADAL" clId="{AD4E4DE1-9CB1-4771-A235-1540E1ED3060}" dt="2023-01-06T19:51:57.722" v="6664" actId="255"/>
          <ac:spMkLst>
            <pc:docMk/>
            <pc:sldMk cId="2551874591" sldId="314"/>
            <ac:spMk id="2" creationId="{73A89AD1-9494-8A53-6332-6DA335F33ECF}"/>
          </ac:spMkLst>
        </pc:spChg>
        <pc:spChg chg="add mod">
          <ac:chgData name="Kumar, Vinod" userId="a0710a6e-bffc-4971-8893-1c23addeb5b0" providerId="ADAL" clId="{AD4E4DE1-9CB1-4771-A235-1540E1ED3060}" dt="2023-01-05T19:20:47.585" v="2555" actId="1037"/>
          <ac:spMkLst>
            <pc:docMk/>
            <pc:sldMk cId="2551874591" sldId="314"/>
            <ac:spMk id="7" creationId="{E9A5EDE8-83BF-C1F5-FE1F-C91A13ECAC86}"/>
          </ac:spMkLst>
        </pc:spChg>
        <pc:picChg chg="add del mod">
          <ac:chgData name="Kumar, Vinod" userId="a0710a6e-bffc-4971-8893-1c23addeb5b0" providerId="ADAL" clId="{AD4E4DE1-9CB1-4771-A235-1540E1ED3060}" dt="2023-01-05T19:19:23.217" v="2537" actId="478"/>
          <ac:picMkLst>
            <pc:docMk/>
            <pc:sldMk cId="2551874591" sldId="314"/>
            <ac:picMk id="3" creationId="{AE9F7B8B-02FD-F98C-1F7E-8C542B00DE07}"/>
          </ac:picMkLst>
        </pc:picChg>
        <pc:picChg chg="add del mod">
          <ac:chgData name="Kumar, Vinod" userId="a0710a6e-bffc-4971-8893-1c23addeb5b0" providerId="ADAL" clId="{AD4E4DE1-9CB1-4771-A235-1540E1ED3060}" dt="2023-01-05T19:19:24.016" v="2538" actId="478"/>
          <ac:picMkLst>
            <pc:docMk/>
            <pc:sldMk cId="2551874591" sldId="314"/>
            <ac:picMk id="4" creationId="{7F6A454C-0BBB-0E69-BA50-E5A23E5F21C8}"/>
          </ac:picMkLst>
        </pc:picChg>
        <pc:picChg chg="add del mod">
          <ac:chgData name="Kumar, Vinod" userId="a0710a6e-bffc-4971-8893-1c23addeb5b0" providerId="ADAL" clId="{AD4E4DE1-9CB1-4771-A235-1540E1ED3060}" dt="2023-01-05T19:18:46.882" v="2482" actId="478"/>
          <ac:picMkLst>
            <pc:docMk/>
            <pc:sldMk cId="2551874591" sldId="314"/>
            <ac:picMk id="5" creationId="{F9ACA2F8-E489-95C7-B001-9BD69C61A3E3}"/>
          </ac:picMkLst>
        </pc:picChg>
        <pc:picChg chg="add mod">
          <ac:chgData name="Kumar, Vinod" userId="a0710a6e-bffc-4971-8893-1c23addeb5b0" providerId="ADAL" clId="{AD4E4DE1-9CB1-4771-A235-1540E1ED3060}" dt="2023-01-05T19:20:35.584" v="2545" actId="1037"/>
          <ac:picMkLst>
            <pc:docMk/>
            <pc:sldMk cId="2551874591" sldId="314"/>
            <ac:picMk id="6" creationId="{46602624-7F01-EC5F-7DCF-E4FD97D84904}"/>
          </ac:picMkLst>
        </pc:picChg>
      </pc:sldChg>
      <pc:sldChg chg="addSp modSp new del mod">
        <pc:chgData name="Kumar, Vinod" userId="a0710a6e-bffc-4971-8893-1c23addeb5b0" providerId="ADAL" clId="{AD4E4DE1-9CB1-4771-A235-1540E1ED3060}" dt="2023-01-05T20:58:41.314" v="4005" actId="47"/>
        <pc:sldMkLst>
          <pc:docMk/>
          <pc:sldMk cId="276055334" sldId="315"/>
        </pc:sldMkLst>
        <pc:picChg chg="add mod">
          <ac:chgData name="Kumar, Vinod" userId="a0710a6e-bffc-4971-8893-1c23addeb5b0" providerId="ADAL" clId="{AD4E4DE1-9CB1-4771-A235-1540E1ED3060}" dt="2023-01-05T20:58:17.808" v="4000" actId="1037"/>
          <ac:picMkLst>
            <pc:docMk/>
            <pc:sldMk cId="276055334" sldId="315"/>
            <ac:picMk id="2" creationId="{2C3AB6B7-9AAA-5BAF-8FBE-E9A4508E2418}"/>
          </ac:picMkLst>
        </pc:picChg>
        <pc:picChg chg="add mod">
          <ac:chgData name="Kumar, Vinod" userId="a0710a6e-bffc-4971-8893-1c23addeb5b0" providerId="ADAL" clId="{AD4E4DE1-9CB1-4771-A235-1540E1ED3060}" dt="2023-01-05T20:58:20.640" v="4004" actId="1036"/>
          <ac:picMkLst>
            <pc:docMk/>
            <pc:sldMk cId="276055334" sldId="315"/>
            <ac:picMk id="3" creationId="{CC351076-8701-5D50-66E8-F68F64C34778}"/>
          </ac:picMkLst>
        </pc:picChg>
      </pc:sldChg>
      <pc:sldChg chg="addSp delSp modSp add mod">
        <pc:chgData name="Kumar, Vinod" userId="a0710a6e-bffc-4971-8893-1c23addeb5b0" providerId="ADAL" clId="{AD4E4DE1-9CB1-4771-A235-1540E1ED3060}" dt="2023-01-06T19:52:28.895" v="6666" actId="255"/>
        <pc:sldMkLst>
          <pc:docMk/>
          <pc:sldMk cId="2153520942" sldId="315"/>
        </pc:sldMkLst>
        <pc:spChg chg="mod">
          <ac:chgData name="Kumar, Vinod" userId="a0710a6e-bffc-4971-8893-1c23addeb5b0" providerId="ADAL" clId="{AD4E4DE1-9CB1-4771-A235-1540E1ED3060}" dt="2023-01-05T21:00:08.798" v="4050" actId="164"/>
          <ac:spMkLst>
            <pc:docMk/>
            <pc:sldMk cId="2153520942" sldId="315"/>
            <ac:spMk id="61" creationId="{723D7F5C-88B3-84BF-CB53-D2CED75CE33D}"/>
          </ac:spMkLst>
        </pc:spChg>
        <pc:spChg chg="mod">
          <ac:chgData name="Kumar, Vinod" userId="a0710a6e-bffc-4971-8893-1c23addeb5b0" providerId="ADAL" clId="{AD4E4DE1-9CB1-4771-A235-1540E1ED3060}" dt="2023-01-05T20:59:22.689" v="4041" actId="1036"/>
          <ac:spMkLst>
            <pc:docMk/>
            <pc:sldMk cId="2153520942" sldId="315"/>
            <ac:spMk id="62" creationId="{B82E76CC-AA60-5E47-5A4D-CFE89C7571FD}"/>
          </ac:spMkLst>
        </pc:spChg>
        <pc:spChg chg="mod">
          <ac:chgData name="Kumar, Vinod" userId="a0710a6e-bffc-4971-8893-1c23addeb5b0" providerId="ADAL" clId="{AD4E4DE1-9CB1-4771-A235-1540E1ED3060}" dt="2023-01-06T19:52:28.895" v="6666" actId="255"/>
          <ac:spMkLst>
            <pc:docMk/>
            <pc:sldMk cId="2153520942" sldId="315"/>
            <ac:spMk id="65" creationId="{CA9AEFB4-1F1E-78ED-3BEE-8D4011DF8206}"/>
          </ac:spMkLst>
        </pc:spChg>
        <pc:spChg chg="mod">
          <ac:chgData name="Kumar, Vinod" userId="a0710a6e-bffc-4971-8893-1c23addeb5b0" providerId="ADAL" clId="{AD4E4DE1-9CB1-4771-A235-1540E1ED3060}" dt="2023-01-06T19:52:28.895" v="6666" actId="255"/>
          <ac:spMkLst>
            <pc:docMk/>
            <pc:sldMk cId="2153520942" sldId="315"/>
            <ac:spMk id="66" creationId="{ECD109EE-DA3C-C44C-8754-27AD2C09A4FC}"/>
          </ac:spMkLst>
        </pc:spChg>
        <pc:spChg chg="mod">
          <ac:chgData name="Kumar, Vinod" userId="a0710a6e-bffc-4971-8893-1c23addeb5b0" providerId="ADAL" clId="{AD4E4DE1-9CB1-4771-A235-1540E1ED3060}" dt="2023-01-06T19:52:28.895" v="6666" actId="255"/>
          <ac:spMkLst>
            <pc:docMk/>
            <pc:sldMk cId="2153520942" sldId="315"/>
            <ac:spMk id="67" creationId="{6C98B42E-FA91-63F9-93AB-5C9D69B51027}"/>
          </ac:spMkLst>
        </pc:spChg>
        <pc:spChg chg="mod">
          <ac:chgData name="Kumar, Vinod" userId="a0710a6e-bffc-4971-8893-1c23addeb5b0" providerId="ADAL" clId="{AD4E4DE1-9CB1-4771-A235-1540E1ED3060}" dt="2023-01-06T19:52:28.895" v="6666" actId="255"/>
          <ac:spMkLst>
            <pc:docMk/>
            <pc:sldMk cId="2153520942" sldId="315"/>
            <ac:spMk id="68" creationId="{005730C1-1D48-12CD-3868-E22C263D3106}"/>
          </ac:spMkLst>
        </pc:spChg>
        <pc:spChg chg="mod">
          <ac:chgData name="Kumar, Vinod" userId="a0710a6e-bffc-4971-8893-1c23addeb5b0" providerId="ADAL" clId="{AD4E4DE1-9CB1-4771-A235-1540E1ED3060}" dt="2023-01-06T19:52:28.895" v="6666" actId="255"/>
          <ac:spMkLst>
            <pc:docMk/>
            <pc:sldMk cId="2153520942" sldId="315"/>
            <ac:spMk id="69" creationId="{15DA2A9A-E91E-7411-3E5F-D398FA45D7E6}"/>
          </ac:spMkLst>
        </pc:spChg>
        <pc:spChg chg="mod">
          <ac:chgData name="Kumar, Vinod" userId="a0710a6e-bffc-4971-8893-1c23addeb5b0" providerId="ADAL" clId="{AD4E4DE1-9CB1-4771-A235-1540E1ED3060}" dt="2023-01-06T19:52:28.895" v="6666" actId="255"/>
          <ac:spMkLst>
            <pc:docMk/>
            <pc:sldMk cId="2153520942" sldId="315"/>
            <ac:spMk id="70" creationId="{F63C9B63-4BA1-D70E-BF01-B84BCE9BBD50}"/>
          </ac:spMkLst>
        </pc:spChg>
        <pc:spChg chg="mod">
          <ac:chgData name="Kumar, Vinod" userId="a0710a6e-bffc-4971-8893-1c23addeb5b0" providerId="ADAL" clId="{AD4E4DE1-9CB1-4771-A235-1540E1ED3060}" dt="2023-01-06T19:52:28.895" v="6666" actId="255"/>
          <ac:spMkLst>
            <pc:docMk/>
            <pc:sldMk cId="2153520942" sldId="315"/>
            <ac:spMk id="71" creationId="{FBB29273-058A-F81B-4735-90094311D47D}"/>
          </ac:spMkLst>
        </pc:spChg>
        <pc:spChg chg="mod">
          <ac:chgData name="Kumar, Vinod" userId="a0710a6e-bffc-4971-8893-1c23addeb5b0" providerId="ADAL" clId="{AD4E4DE1-9CB1-4771-A235-1540E1ED3060}" dt="2023-01-06T19:52:28.895" v="6666" actId="255"/>
          <ac:spMkLst>
            <pc:docMk/>
            <pc:sldMk cId="2153520942" sldId="315"/>
            <ac:spMk id="72" creationId="{FF87E0A1-F6B7-735B-C62E-4E30BC972612}"/>
          </ac:spMkLst>
        </pc:spChg>
        <pc:spChg chg="mod">
          <ac:chgData name="Kumar, Vinod" userId="a0710a6e-bffc-4971-8893-1c23addeb5b0" providerId="ADAL" clId="{AD4E4DE1-9CB1-4771-A235-1540E1ED3060}" dt="2023-01-06T19:52:08.482" v="6665" actId="255"/>
          <ac:spMkLst>
            <pc:docMk/>
            <pc:sldMk cId="2153520942" sldId="315"/>
            <ac:spMk id="73" creationId="{3DC87012-760F-483C-9104-E6DEDCC490D2}"/>
          </ac:spMkLst>
        </pc:spChg>
        <pc:grpChg chg="add del mod">
          <ac:chgData name="Kumar, Vinod" userId="a0710a6e-bffc-4971-8893-1c23addeb5b0" providerId="ADAL" clId="{AD4E4DE1-9CB1-4771-A235-1540E1ED3060}" dt="2023-01-05T21:16:42.921" v="4348" actId="478"/>
          <ac:grpSpMkLst>
            <pc:docMk/>
            <pc:sldMk cId="2153520942" sldId="315"/>
            <ac:grpSpMk id="2" creationId="{2A44019C-98BB-FF5E-572F-B00EDC45DF5E}"/>
          </ac:grpSpMkLst>
        </pc:grpChg>
        <pc:grpChg chg="mod">
          <ac:chgData name="Kumar, Vinod" userId="a0710a6e-bffc-4971-8893-1c23addeb5b0" providerId="ADAL" clId="{AD4E4DE1-9CB1-4771-A235-1540E1ED3060}" dt="2023-01-05T20:59:02.929" v="4016" actId="1035"/>
          <ac:grpSpMkLst>
            <pc:docMk/>
            <pc:sldMk cId="2153520942" sldId="315"/>
            <ac:grpSpMk id="5" creationId="{F737B462-7539-7F1E-7C44-457709E8283A}"/>
          </ac:grpSpMkLst>
        </pc:grpChg>
        <pc:grpChg chg="mod">
          <ac:chgData name="Kumar, Vinod" userId="a0710a6e-bffc-4971-8893-1c23addeb5b0" providerId="ADAL" clId="{AD4E4DE1-9CB1-4771-A235-1540E1ED3060}" dt="2023-01-05T21:01:58.304" v="4110" actId="1036"/>
          <ac:grpSpMkLst>
            <pc:docMk/>
            <pc:sldMk cId="2153520942" sldId="315"/>
            <ac:grpSpMk id="6" creationId="{7897164E-14EE-7EFA-F20B-3A25BF9EDF62}"/>
          </ac:grpSpMkLst>
        </pc:grpChg>
        <pc:grpChg chg="mod">
          <ac:chgData name="Kumar, Vinod" userId="a0710a6e-bffc-4971-8893-1c23addeb5b0" providerId="ADAL" clId="{AD4E4DE1-9CB1-4771-A235-1540E1ED3060}" dt="2023-01-05T20:59:02.929" v="4016" actId="1035"/>
          <ac:grpSpMkLst>
            <pc:docMk/>
            <pc:sldMk cId="2153520942" sldId="315"/>
            <ac:grpSpMk id="45" creationId="{0BC00F63-F12C-0E90-D12A-84CC1F9755F4}"/>
          </ac:grpSpMkLst>
        </pc:grpChg>
        <pc:grpChg chg="mod">
          <ac:chgData name="Kumar, Vinod" userId="a0710a6e-bffc-4971-8893-1c23addeb5b0" providerId="ADAL" clId="{AD4E4DE1-9CB1-4771-A235-1540E1ED3060}" dt="2023-01-05T21:01:58.304" v="4110" actId="1036"/>
          <ac:grpSpMkLst>
            <pc:docMk/>
            <pc:sldMk cId="2153520942" sldId="315"/>
            <ac:grpSpMk id="48" creationId="{DA988982-3960-F2BC-0BB8-BF76EC7439E7}"/>
          </ac:grpSpMkLst>
        </pc:grpChg>
        <pc:picChg chg="mod">
          <ac:chgData name="Kumar, Vinod" userId="a0710a6e-bffc-4971-8893-1c23addeb5b0" providerId="ADAL" clId="{AD4E4DE1-9CB1-4771-A235-1540E1ED3060}" dt="2023-01-05T21:01:14.815" v="4098" actId="1035"/>
          <ac:picMkLst>
            <pc:docMk/>
            <pc:sldMk cId="2153520942" sldId="315"/>
            <ac:picMk id="3" creationId="{76372DB3-D2F4-1F77-233A-08C1A430B2EB}"/>
          </ac:picMkLst>
        </pc:picChg>
        <pc:picChg chg="del">
          <ac:chgData name="Kumar, Vinod" userId="a0710a6e-bffc-4971-8893-1c23addeb5b0" providerId="ADAL" clId="{AD4E4DE1-9CB1-4771-A235-1540E1ED3060}" dt="2023-01-05T21:16:41.161" v="4347" actId="478"/>
          <ac:picMkLst>
            <pc:docMk/>
            <pc:sldMk cId="2153520942" sldId="315"/>
            <ac:picMk id="4" creationId="{772B80AD-03DC-1A5C-1978-30A9C79421E9}"/>
          </ac:picMkLst>
        </pc:picChg>
        <pc:picChg chg="mod">
          <ac:chgData name="Kumar, Vinod" userId="a0710a6e-bffc-4971-8893-1c23addeb5b0" providerId="ADAL" clId="{AD4E4DE1-9CB1-4771-A235-1540E1ED3060}" dt="2023-01-05T21:01:19.919" v="4103" actId="1037"/>
          <ac:picMkLst>
            <pc:docMk/>
            <pc:sldMk cId="2153520942" sldId="315"/>
            <ac:picMk id="56" creationId="{789A4ADC-CE66-328B-9319-43B0EE760873}"/>
          </ac:picMkLst>
        </pc:picChg>
        <pc:picChg chg="mod">
          <ac:chgData name="Kumar, Vinod" userId="a0710a6e-bffc-4971-8893-1c23addeb5b0" providerId="ADAL" clId="{AD4E4DE1-9CB1-4771-A235-1540E1ED3060}" dt="2023-01-05T21:00:08.798" v="4050" actId="164"/>
          <ac:picMkLst>
            <pc:docMk/>
            <pc:sldMk cId="2153520942" sldId="315"/>
            <ac:picMk id="57" creationId="{E32FB097-48D8-EA98-7117-FA2DA78498DA}"/>
          </ac:picMkLst>
        </pc:picChg>
      </pc:sldChg>
      <pc:sldChg chg="addSp modSp add del mod">
        <pc:chgData name="Kumar, Vinod" userId="a0710a6e-bffc-4971-8893-1c23addeb5b0" providerId="ADAL" clId="{AD4E4DE1-9CB1-4771-A235-1540E1ED3060}" dt="2023-01-05T20:57:44.907" v="3992" actId="47"/>
        <pc:sldMkLst>
          <pc:docMk/>
          <pc:sldMk cId="3237663203" sldId="315"/>
        </pc:sldMkLst>
        <pc:spChg chg="mod">
          <ac:chgData name="Kumar, Vinod" userId="a0710a6e-bffc-4971-8893-1c23addeb5b0" providerId="ADAL" clId="{AD4E4DE1-9CB1-4771-A235-1540E1ED3060}" dt="2023-01-05T20:56:10.340" v="3988" actId="164"/>
          <ac:spMkLst>
            <pc:docMk/>
            <pc:sldMk cId="3237663203" sldId="315"/>
            <ac:spMk id="61" creationId="{723D7F5C-88B3-84BF-CB53-D2CED75CE33D}"/>
          </ac:spMkLst>
        </pc:spChg>
        <pc:spChg chg="mod">
          <ac:chgData name="Kumar, Vinod" userId="a0710a6e-bffc-4971-8893-1c23addeb5b0" providerId="ADAL" clId="{AD4E4DE1-9CB1-4771-A235-1540E1ED3060}" dt="2023-01-05T20:45:51.041" v="3820" actId="164"/>
          <ac:spMkLst>
            <pc:docMk/>
            <pc:sldMk cId="3237663203" sldId="315"/>
            <ac:spMk id="62" creationId="{B82E76CC-AA60-5E47-5A4D-CFE89C7571FD}"/>
          </ac:spMkLst>
        </pc:spChg>
        <pc:spChg chg="mod">
          <ac:chgData name="Kumar, Vinod" userId="a0710a6e-bffc-4971-8893-1c23addeb5b0" providerId="ADAL" clId="{AD4E4DE1-9CB1-4771-A235-1540E1ED3060}" dt="2023-01-05T20:53:27.966" v="3934" actId="164"/>
          <ac:spMkLst>
            <pc:docMk/>
            <pc:sldMk cId="3237663203" sldId="315"/>
            <ac:spMk id="65" creationId="{CA9AEFB4-1F1E-78ED-3BEE-8D4011DF8206}"/>
          </ac:spMkLst>
        </pc:spChg>
        <pc:spChg chg="mod">
          <ac:chgData name="Kumar, Vinod" userId="a0710a6e-bffc-4971-8893-1c23addeb5b0" providerId="ADAL" clId="{AD4E4DE1-9CB1-4771-A235-1540E1ED3060}" dt="2023-01-05T20:53:27.966" v="3934" actId="164"/>
          <ac:spMkLst>
            <pc:docMk/>
            <pc:sldMk cId="3237663203" sldId="315"/>
            <ac:spMk id="66" creationId="{ECD109EE-DA3C-C44C-8754-27AD2C09A4FC}"/>
          </ac:spMkLst>
        </pc:spChg>
        <pc:spChg chg="mod">
          <ac:chgData name="Kumar, Vinod" userId="a0710a6e-bffc-4971-8893-1c23addeb5b0" providerId="ADAL" clId="{AD4E4DE1-9CB1-4771-A235-1540E1ED3060}" dt="2023-01-05T20:53:27.966" v="3934" actId="164"/>
          <ac:spMkLst>
            <pc:docMk/>
            <pc:sldMk cId="3237663203" sldId="315"/>
            <ac:spMk id="67" creationId="{6C98B42E-FA91-63F9-93AB-5C9D69B51027}"/>
          </ac:spMkLst>
        </pc:spChg>
        <pc:spChg chg="mod">
          <ac:chgData name="Kumar, Vinod" userId="a0710a6e-bffc-4971-8893-1c23addeb5b0" providerId="ADAL" clId="{AD4E4DE1-9CB1-4771-A235-1540E1ED3060}" dt="2023-01-05T20:53:27.966" v="3934" actId="164"/>
          <ac:spMkLst>
            <pc:docMk/>
            <pc:sldMk cId="3237663203" sldId="315"/>
            <ac:spMk id="68" creationId="{005730C1-1D48-12CD-3868-E22C263D3106}"/>
          </ac:spMkLst>
        </pc:spChg>
        <pc:spChg chg="mod">
          <ac:chgData name="Kumar, Vinod" userId="a0710a6e-bffc-4971-8893-1c23addeb5b0" providerId="ADAL" clId="{AD4E4DE1-9CB1-4771-A235-1540E1ED3060}" dt="2023-01-05T20:53:27.966" v="3934" actId="164"/>
          <ac:spMkLst>
            <pc:docMk/>
            <pc:sldMk cId="3237663203" sldId="315"/>
            <ac:spMk id="69" creationId="{15DA2A9A-E91E-7411-3E5F-D398FA45D7E6}"/>
          </ac:spMkLst>
        </pc:spChg>
        <pc:spChg chg="mod">
          <ac:chgData name="Kumar, Vinod" userId="a0710a6e-bffc-4971-8893-1c23addeb5b0" providerId="ADAL" clId="{AD4E4DE1-9CB1-4771-A235-1540E1ED3060}" dt="2023-01-05T20:53:27.966" v="3934" actId="164"/>
          <ac:spMkLst>
            <pc:docMk/>
            <pc:sldMk cId="3237663203" sldId="315"/>
            <ac:spMk id="70" creationId="{F63C9B63-4BA1-D70E-BF01-B84BCE9BBD50}"/>
          </ac:spMkLst>
        </pc:spChg>
        <pc:spChg chg="mod">
          <ac:chgData name="Kumar, Vinod" userId="a0710a6e-bffc-4971-8893-1c23addeb5b0" providerId="ADAL" clId="{AD4E4DE1-9CB1-4771-A235-1540E1ED3060}" dt="2023-01-05T20:53:27.966" v="3934" actId="164"/>
          <ac:spMkLst>
            <pc:docMk/>
            <pc:sldMk cId="3237663203" sldId="315"/>
            <ac:spMk id="71" creationId="{FBB29273-058A-F81B-4735-90094311D47D}"/>
          </ac:spMkLst>
        </pc:spChg>
        <pc:spChg chg="mod">
          <ac:chgData name="Kumar, Vinod" userId="a0710a6e-bffc-4971-8893-1c23addeb5b0" providerId="ADAL" clId="{AD4E4DE1-9CB1-4771-A235-1540E1ED3060}" dt="2023-01-05T20:53:27.966" v="3934" actId="164"/>
          <ac:spMkLst>
            <pc:docMk/>
            <pc:sldMk cId="3237663203" sldId="315"/>
            <ac:spMk id="72" creationId="{FF87E0A1-F6B7-735B-C62E-4E30BC972612}"/>
          </ac:spMkLst>
        </pc:spChg>
        <pc:grpChg chg="mod">
          <ac:chgData name="Kumar, Vinod" userId="a0710a6e-bffc-4971-8893-1c23addeb5b0" providerId="ADAL" clId="{AD4E4DE1-9CB1-4771-A235-1540E1ED3060}" dt="2023-01-05T20:53:04.115" v="3933" actId="1076"/>
          <ac:grpSpMkLst>
            <pc:docMk/>
            <pc:sldMk cId="3237663203" sldId="315"/>
            <ac:grpSpMk id="5" creationId="{F737B462-7539-7F1E-7C44-457709E8283A}"/>
          </ac:grpSpMkLst>
        </pc:grpChg>
        <pc:grpChg chg="mod">
          <ac:chgData name="Kumar, Vinod" userId="a0710a6e-bffc-4971-8893-1c23addeb5b0" providerId="ADAL" clId="{AD4E4DE1-9CB1-4771-A235-1540E1ED3060}" dt="2023-01-05T20:54:11.475" v="3944" actId="1038"/>
          <ac:grpSpMkLst>
            <pc:docMk/>
            <pc:sldMk cId="3237663203" sldId="315"/>
            <ac:grpSpMk id="6" creationId="{7897164E-14EE-7EFA-F20B-3A25BF9EDF62}"/>
          </ac:grpSpMkLst>
        </pc:grpChg>
        <pc:grpChg chg="add mod">
          <ac:chgData name="Kumar, Vinod" userId="a0710a6e-bffc-4971-8893-1c23addeb5b0" providerId="ADAL" clId="{AD4E4DE1-9CB1-4771-A235-1540E1ED3060}" dt="2023-01-05T20:50:38.110" v="3882" actId="1076"/>
          <ac:grpSpMkLst>
            <pc:docMk/>
            <pc:sldMk cId="3237663203" sldId="315"/>
            <ac:grpSpMk id="8" creationId="{B09803B9-7E99-B781-320D-BCA582FB1285}"/>
          </ac:grpSpMkLst>
        </pc:grpChg>
        <pc:grpChg chg="add mod">
          <ac:chgData name="Kumar, Vinod" userId="a0710a6e-bffc-4971-8893-1c23addeb5b0" providerId="ADAL" clId="{AD4E4DE1-9CB1-4771-A235-1540E1ED3060}" dt="2023-01-05T20:53:35.107" v="3935" actId="1076"/>
          <ac:grpSpMkLst>
            <pc:docMk/>
            <pc:sldMk cId="3237663203" sldId="315"/>
            <ac:grpSpMk id="9" creationId="{CE202D55-421D-8E26-12AC-5C1D0F8250FA}"/>
          </ac:grpSpMkLst>
        </pc:grpChg>
        <pc:grpChg chg="add mod">
          <ac:chgData name="Kumar, Vinod" userId="a0710a6e-bffc-4971-8893-1c23addeb5b0" providerId="ADAL" clId="{AD4E4DE1-9CB1-4771-A235-1540E1ED3060}" dt="2023-01-05T20:56:10.340" v="3988" actId="164"/>
          <ac:grpSpMkLst>
            <pc:docMk/>
            <pc:sldMk cId="3237663203" sldId="315"/>
            <ac:grpSpMk id="10" creationId="{0DB6A59B-DA5D-006C-23C5-5476704EEAE2}"/>
          </ac:grpSpMkLst>
        </pc:grpChg>
        <pc:grpChg chg="mod">
          <ac:chgData name="Kumar, Vinod" userId="a0710a6e-bffc-4971-8893-1c23addeb5b0" providerId="ADAL" clId="{AD4E4DE1-9CB1-4771-A235-1540E1ED3060}" dt="2023-01-05T20:57:11.665" v="3989" actId="1076"/>
          <ac:grpSpMkLst>
            <pc:docMk/>
            <pc:sldMk cId="3237663203" sldId="315"/>
            <ac:grpSpMk id="42" creationId="{ACD1F7E2-17CB-092F-370A-5BC092437F7A}"/>
          </ac:grpSpMkLst>
        </pc:grpChg>
        <pc:grpChg chg="mod">
          <ac:chgData name="Kumar, Vinod" userId="a0710a6e-bffc-4971-8893-1c23addeb5b0" providerId="ADAL" clId="{AD4E4DE1-9CB1-4771-A235-1540E1ED3060}" dt="2023-01-05T20:57:14.121" v="3990" actId="1076"/>
          <ac:grpSpMkLst>
            <pc:docMk/>
            <pc:sldMk cId="3237663203" sldId="315"/>
            <ac:grpSpMk id="45" creationId="{0BC00F63-F12C-0E90-D12A-84CC1F9755F4}"/>
          </ac:grpSpMkLst>
        </pc:grpChg>
        <pc:grpChg chg="mod">
          <ac:chgData name="Kumar, Vinod" userId="a0710a6e-bffc-4971-8893-1c23addeb5b0" providerId="ADAL" clId="{AD4E4DE1-9CB1-4771-A235-1540E1ED3060}" dt="2023-01-05T20:57:15.784" v="3991" actId="1076"/>
          <ac:grpSpMkLst>
            <pc:docMk/>
            <pc:sldMk cId="3237663203" sldId="315"/>
            <ac:grpSpMk id="48" creationId="{DA988982-3960-F2BC-0BB8-BF76EC7439E7}"/>
          </ac:grpSpMkLst>
        </pc:grpChg>
        <pc:picChg chg="add mod">
          <ac:chgData name="Kumar, Vinod" userId="a0710a6e-bffc-4971-8893-1c23addeb5b0" providerId="ADAL" clId="{AD4E4DE1-9CB1-4771-A235-1540E1ED3060}" dt="2023-01-05T20:52:47.203" v="3931" actId="1076"/>
          <ac:picMkLst>
            <pc:docMk/>
            <pc:sldMk cId="3237663203" sldId="315"/>
            <ac:picMk id="2" creationId="{5474E040-61F1-00C4-3E76-7E1213BA6B52}"/>
          </ac:picMkLst>
        </pc:picChg>
        <pc:picChg chg="mod">
          <ac:chgData name="Kumar, Vinod" userId="a0710a6e-bffc-4971-8893-1c23addeb5b0" providerId="ADAL" clId="{AD4E4DE1-9CB1-4771-A235-1540E1ED3060}" dt="2023-01-05T20:54:49.154" v="3967" actId="1035"/>
          <ac:picMkLst>
            <pc:docMk/>
            <pc:sldMk cId="3237663203" sldId="315"/>
            <ac:picMk id="3" creationId="{76372DB3-D2F4-1F77-233A-08C1A430B2EB}"/>
          </ac:picMkLst>
        </pc:picChg>
        <pc:picChg chg="mod">
          <ac:chgData name="Kumar, Vinod" userId="a0710a6e-bffc-4971-8893-1c23addeb5b0" providerId="ADAL" clId="{AD4E4DE1-9CB1-4771-A235-1540E1ED3060}" dt="2023-01-05T20:55:07.763" v="3980" actId="1036"/>
          <ac:picMkLst>
            <pc:docMk/>
            <pc:sldMk cId="3237663203" sldId="315"/>
            <ac:picMk id="4" creationId="{772B80AD-03DC-1A5C-1978-30A9C79421E9}"/>
          </ac:picMkLst>
        </pc:picChg>
        <pc:picChg chg="add mod">
          <ac:chgData name="Kumar, Vinod" userId="a0710a6e-bffc-4971-8893-1c23addeb5b0" providerId="ADAL" clId="{AD4E4DE1-9CB1-4771-A235-1540E1ED3060}" dt="2023-01-05T20:45:21.023" v="3819" actId="14100"/>
          <ac:picMkLst>
            <pc:docMk/>
            <pc:sldMk cId="3237663203" sldId="315"/>
            <ac:picMk id="7" creationId="{09CB4492-3FEF-3E11-2236-D146A7CEB122}"/>
          </ac:picMkLst>
        </pc:picChg>
        <pc:picChg chg="mod">
          <ac:chgData name="Kumar, Vinod" userId="a0710a6e-bffc-4971-8893-1c23addeb5b0" providerId="ADAL" clId="{AD4E4DE1-9CB1-4771-A235-1540E1ED3060}" dt="2023-01-05T20:54:11.475" v="3944" actId="1038"/>
          <ac:picMkLst>
            <pc:docMk/>
            <pc:sldMk cId="3237663203" sldId="315"/>
            <ac:picMk id="51" creationId="{CD145B98-AFEF-0D39-B5D5-CE187869F680}"/>
          </ac:picMkLst>
        </pc:picChg>
        <pc:picChg chg="mod">
          <ac:chgData name="Kumar, Vinod" userId="a0710a6e-bffc-4971-8893-1c23addeb5b0" providerId="ADAL" clId="{AD4E4DE1-9CB1-4771-A235-1540E1ED3060}" dt="2023-01-05T20:45:51.041" v="3820" actId="164"/>
          <ac:picMkLst>
            <pc:docMk/>
            <pc:sldMk cId="3237663203" sldId="315"/>
            <ac:picMk id="56" creationId="{789A4ADC-CE66-328B-9319-43B0EE760873}"/>
          </ac:picMkLst>
        </pc:picChg>
        <pc:picChg chg="mod">
          <ac:chgData name="Kumar, Vinod" userId="a0710a6e-bffc-4971-8893-1c23addeb5b0" providerId="ADAL" clId="{AD4E4DE1-9CB1-4771-A235-1540E1ED3060}" dt="2023-01-05T20:56:10.340" v="3988" actId="164"/>
          <ac:picMkLst>
            <pc:docMk/>
            <pc:sldMk cId="3237663203" sldId="315"/>
            <ac:picMk id="57" creationId="{E32FB097-48D8-EA98-7117-FA2DA78498DA}"/>
          </ac:picMkLst>
        </pc:picChg>
      </pc:sldChg>
      <pc:sldChg chg="addSp modSp new mod">
        <pc:chgData name="Kumar, Vinod" userId="a0710a6e-bffc-4971-8893-1c23addeb5b0" providerId="ADAL" clId="{AD4E4DE1-9CB1-4771-A235-1540E1ED3060}" dt="2023-01-06T19:52:44.897" v="6667" actId="255"/>
        <pc:sldMkLst>
          <pc:docMk/>
          <pc:sldMk cId="2051417108" sldId="316"/>
        </pc:sldMkLst>
        <pc:spChg chg="add mod">
          <ac:chgData name="Kumar, Vinod" userId="a0710a6e-bffc-4971-8893-1c23addeb5b0" providerId="ADAL" clId="{AD4E4DE1-9CB1-4771-A235-1540E1ED3060}" dt="2023-01-06T19:52:44.897" v="6667" actId="255"/>
          <ac:spMkLst>
            <pc:docMk/>
            <pc:sldMk cId="2051417108" sldId="316"/>
            <ac:spMk id="3" creationId="{5CABF1E3-EBFE-42C8-FE2E-39007811D966}"/>
          </ac:spMkLst>
        </pc:spChg>
        <pc:picChg chg="add mod">
          <ac:chgData name="Kumar, Vinod" userId="a0710a6e-bffc-4971-8893-1c23addeb5b0" providerId="ADAL" clId="{AD4E4DE1-9CB1-4771-A235-1540E1ED3060}" dt="2023-01-05T21:02:43.167" v="4130" actId="1037"/>
          <ac:picMkLst>
            <pc:docMk/>
            <pc:sldMk cId="2051417108" sldId="316"/>
            <ac:picMk id="2" creationId="{BBF70253-2B0F-71BD-E95E-A3963CA1915A}"/>
          </ac:picMkLst>
        </pc:picChg>
      </pc:sldChg>
      <pc:sldChg chg="addSp delSp modSp add mod">
        <pc:chgData name="Kumar, Vinod" userId="a0710a6e-bffc-4971-8893-1c23addeb5b0" providerId="ADAL" clId="{AD4E4DE1-9CB1-4771-A235-1540E1ED3060}" dt="2023-01-06T19:55:05.836" v="6682" actId="255"/>
        <pc:sldMkLst>
          <pc:docMk/>
          <pc:sldMk cId="240031287" sldId="317"/>
        </pc:sldMkLst>
        <pc:spChg chg="mod">
          <ac:chgData name="Kumar, Vinod" userId="a0710a6e-bffc-4971-8893-1c23addeb5b0" providerId="ADAL" clId="{AD4E4DE1-9CB1-4771-A235-1540E1ED3060}" dt="2023-01-06T19:54:48.312" v="6681" actId="255"/>
          <ac:spMkLst>
            <pc:docMk/>
            <pc:sldMk cId="240031287" sldId="317"/>
            <ac:spMk id="2" creationId="{51D40CE4-17B2-7A16-E7B1-F6DFB55A0FA0}"/>
          </ac:spMkLst>
        </pc:spChg>
        <pc:spChg chg="mod">
          <ac:chgData name="Kumar, Vinod" userId="a0710a6e-bffc-4971-8893-1c23addeb5b0" providerId="ADAL" clId="{AD4E4DE1-9CB1-4771-A235-1540E1ED3060}" dt="2023-01-06T19:55:05.836" v="6682" actId="255"/>
          <ac:spMkLst>
            <pc:docMk/>
            <pc:sldMk cId="240031287" sldId="317"/>
            <ac:spMk id="12" creationId="{E8E8704C-584D-FA36-C26F-521F2E17A65D}"/>
          </ac:spMkLst>
        </pc:spChg>
        <pc:spChg chg="mod">
          <ac:chgData name="Kumar, Vinod" userId="a0710a6e-bffc-4971-8893-1c23addeb5b0" providerId="ADAL" clId="{AD4E4DE1-9CB1-4771-A235-1540E1ED3060}" dt="2023-01-06T19:55:05.836" v="6682" actId="255"/>
          <ac:spMkLst>
            <pc:docMk/>
            <pc:sldMk cId="240031287" sldId="317"/>
            <ac:spMk id="13" creationId="{3B038702-7E51-64C2-B27E-5ADC07CCC1DE}"/>
          </ac:spMkLst>
        </pc:spChg>
        <pc:spChg chg="mod">
          <ac:chgData name="Kumar, Vinod" userId="a0710a6e-bffc-4971-8893-1c23addeb5b0" providerId="ADAL" clId="{AD4E4DE1-9CB1-4771-A235-1540E1ED3060}" dt="2023-01-06T19:55:05.836" v="6682" actId="255"/>
          <ac:spMkLst>
            <pc:docMk/>
            <pc:sldMk cId="240031287" sldId="317"/>
            <ac:spMk id="14" creationId="{1BCDF35F-F838-B6D1-70E7-6D3B25B442CA}"/>
          </ac:spMkLst>
        </pc:spChg>
        <pc:spChg chg="mod ord topLvl">
          <ac:chgData name="Kumar, Vinod" userId="a0710a6e-bffc-4971-8893-1c23addeb5b0" providerId="ADAL" clId="{AD4E4DE1-9CB1-4771-A235-1540E1ED3060}" dt="2023-01-06T19:55:05.836" v="6682" actId="255"/>
          <ac:spMkLst>
            <pc:docMk/>
            <pc:sldMk cId="240031287" sldId="317"/>
            <ac:spMk id="15" creationId="{25AF3F51-D911-F89E-54BF-BC566191F89F}"/>
          </ac:spMkLst>
        </pc:spChg>
        <pc:spChg chg="mod ord topLvl">
          <ac:chgData name="Kumar, Vinod" userId="a0710a6e-bffc-4971-8893-1c23addeb5b0" providerId="ADAL" clId="{AD4E4DE1-9CB1-4771-A235-1540E1ED3060}" dt="2023-01-06T19:55:05.836" v="6682" actId="255"/>
          <ac:spMkLst>
            <pc:docMk/>
            <pc:sldMk cId="240031287" sldId="317"/>
            <ac:spMk id="16" creationId="{9C2C0DB9-6DFE-DB8A-A61A-CFEDB99B4720}"/>
          </ac:spMkLst>
        </pc:spChg>
        <pc:spChg chg="mod ord topLvl">
          <ac:chgData name="Kumar, Vinod" userId="a0710a6e-bffc-4971-8893-1c23addeb5b0" providerId="ADAL" clId="{AD4E4DE1-9CB1-4771-A235-1540E1ED3060}" dt="2023-01-06T19:55:05.836" v="6682" actId="255"/>
          <ac:spMkLst>
            <pc:docMk/>
            <pc:sldMk cId="240031287" sldId="317"/>
            <ac:spMk id="17" creationId="{537E5210-E7C4-5358-C65B-CFB27F7A2AE3}"/>
          </ac:spMkLst>
        </pc:spChg>
        <pc:spChg chg="mod ord topLvl">
          <ac:chgData name="Kumar, Vinod" userId="a0710a6e-bffc-4971-8893-1c23addeb5b0" providerId="ADAL" clId="{AD4E4DE1-9CB1-4771-A235-1540E1ED3060}" dt="2023-01-06T19:55:05.836" v="6682" actId="255"/>
          <ac:spMkLst>
            <pc:docMk/>
            <pc:sldMk cId="240031287" sldId="317"/>
            <ac:spMk id="18" creationId="{2701BE6B-644E-9CF3-4BFE-5B0395BB07AE}"/>
          </ac:spMkLst>
        </pc:spChg>
        <pc:spChg chg="mod ord topLvl">
          <ac:chgData name="Kumar, Vinod" userId="a0710a6e-bffc-4971-8893-1c23addeb5b0" providerId="ADAL" clId="{AD4E4DE1-9CB1-4771-A235-1540E1ED3060}" dt="2023-01-06T19:55:05.836" v="6682" actId="255"/>
          <ac:spMkLst>
            <pc:docMk/>
            <pc:sldMk cId="240031287" sldId="317"/>
            <ac:spMk id="19" creationId="{9DC79C4B-E217-9AF7-7C48-4D0CDA074AA6}"/>
          </ac:spMkLst>
        </pc:spChg>
        <pc:spChg chg="mod">
          <ac:chgData name="Kumar, Vinod" userId="a0710a6e-bffc-4971-8893-1c23addeb5b0" providerId="ADAL" clId="{AD4E4DE1-9CB1-4771-A235-1540E1ED3060}" dt="2023-01-06T15:30:10.622" v="5239" actId="1035"/>
          <ac:spMkLst>
            <pc:docMk/>
            <pc:sldMk cId="240031287" sldId="317"/>
            <ac:spMk id="23" creationId="{32FBF7EC-4D6C-C573-F2FB-8F91AF23B81F}"/>
          </ac:spMkLst>
        </pc:spChg>
        <pc:spChg chg="mod">
          <ac:chgData name="Kumar, Vinod" userId="a0710a6e-bffc-4971-8893-1c23addeb5b0" providerId="ADAL" clId="{AD4E4DE1-9CB1-4771-A235-1540E1ED3060}" dt="2023-01-06T15:25:53.976" v="5120"/>
          <ac:spMkLst>
            <pc:docMk/>
            <pc:sldMk cId="240031287" sldId="317"/>
            <ac:spMk id="31" creationId="{D161139D-AE92-401E-0721-9DE4D5D4E63A}"/>
          </ac:spMkLst>
        </pc:spChg>
        <pc:spChg chg="mod">
          <ac:chgData name="Kumar, Vinod" userId="a0710a6e-bffc-4971-8893-1c23addeb5b0" providerId="ADAL" clId="{AD4E4DE1-9CB1-4771-A235-1540E1ED3060}" dt="2023-01-06T15:25:53.976" v="5120"/>
          <ac:spMkLst>
            <pc:docMk/>
            <pc:sldMk cId="240031287" sldId="317"/>
            <ac:spMk id="66" creationId="{DD0EFD19-3AE6-EA1E-6DB2-CEABAA3F8AB8}"/>
          </ac:spMkLst>
        </pc:spChg>
        <pc:spChg chg="mod">
          <ac:chgData name="Kumar, Vinod" userId="a0710a6e-bffc-4971-8893-1c23addeb5b0" providerId="ADAL" clId="{AD4E4DE1-9CB1-4771-A235-1540E1ED3060}" dt="2023-01-06T15:25:53.976" v="5120"/>
          <ac:spMkLst>
            <pc:docMk/>
            <pc:sldMk cId="240031287" sldId="317"/>
            <ac:spMk id="67" creationId="{D8AA62A8-E268-D101-2E47-C6AC64A457B7}"/>
          </ac:spMkLst>
        </pc:spChg>
        <pc:spChg chg="mod">
          <ac:chgData name="Kumar, Vinod" userId="a0710a6e-bffc-4971-8893-1c23addeb5b0" providerId="ADAL" clId="{AD4E4DE1-9CB1-4771-A235-1540E1ED3060}" dt="2023-01-06T15:25:53.976" v="5120"/>
          <ac:spMkLst>
            <pc:docMk/>
            <pc:sldMk cId="240031287" sldId="317"/>
            <ac:spMk id="68" creationId="{06977623-6A44-85DC-7C27-EE1692FF13F8}"/>
          </ac:spMkLst>
        </pc:spChg>
        <pc:spChg chg="mod">
          <ac:chgData name="Kumar, Vinod" userId="a0710a6e-bffc-4971-8893-1c23addeb5b0" providerId="ADAL" clId="{AD4E4DE1-9CB1-4771-A235-1540E1ED3060}" dt="2023-01-06T15:26:00.119" v="5122"/>
          <ac:spMkLst>
            <pc:docMk/>
            <pc:sldMk cId="240031287" sldId="317"/>
            <ac:spMk id="72" creationId="{7AF80116-5A1B-246D-BFAF-3E1775D8B3BD}"/>
          </ac:spMkLst>
        </pc:spChg>
        <pc:spChg chg="mod">
          <ac:chgData name="Kumar, Vinod" userId="a0710a6e-bffc-4971-8893-1c23addeb5b0" providerId="ADAL" clId="{AD4E4DE1-9CB1-4771-A235-1540E1ED3060}" dt="2023-01-06T15:26:00.119" v="5122"/>
          <ac:spMkLst>
            <pc:docMk/>
            <pc:sldMk cId="240031287" sldId="317"/>
            <ac:spMk id="76" creationId="{AF06F951-2190-0462-3B5F-1C10CF44EAEF}"/>
          </ac:spMkLst>
        </pc:spChg>
        <pc:spChg chg="mod">
          <ac:chgData name="Kumar, Vinod" userId="a0710a6e-bffc-4971-8893-1c23addeb5b0" providerId="ADAL" clId="{AD4E4DE1-9CB1-4771-A235-1540E1ED3060}" dt="2023-01-06T15:26:00.119" v="5122"/>
          <ac:spMkLst>
            <pc:docMk/>
            <pc:sldMk cId="240031287" sldId="317"/>
            <ac:spMk id="77" creationId="{F8BC2792-E44C-1346-5CD6-E504D1C8A73B}"/>
          </ac:spMkLst>
        </pc:spChg>
        <pc:spChg chg="mod">
          <ac:chgData name="Kumar, Vinod" userId="a0710a6e-bffc-4971-8893-1c23addeb5b0" providerId="ADAL" clId="{AD4E4DE1-9CB1-4771-A235-1540E1ED3060}" dt="2023-01-06T15:26:00.119" v="5122"/>
          <ac:spMkLst>
            <pc:docMk/>
            <pc:sldMk cId="240031287" sldId="317"/>
            <ac:spMk id="78" creationId="{2E6AC78C-01BB-60BE-C3E5-867F62D10C80}"/>
          </ac:spMkLst>
        </pc:spChg>
        <pc:spChg chg="mod">
          <ac:chgData name="Kumar, Vinod" userId="a0710a6e-bffc-4971-8893-1c23addeb5b0" providerId="ADAL" clId="{AD4E4DE1-9CB1-4771-A235-1540E1ED3060}" dt="2023-01-06T15:26:45.335" v="5127"/>
          <ac:spMkLst>
            <pc:docMk/>
            <pc:sldMk cId="240031287" sldId="317"/>
            <ac:spMk id="83" creationId="{F019C7E0-5470-3EEE-554E-C8B0DE879496}"/>
          </ac:spMkLst>
        </pc:spChg>
        <pc:spChg chg="mod">
          <ac:chgData name="Kumar, Vinod" userId="a0710a6e-bffc-4971-8893-1c23addeb5b0" providerId="ADAL" clId="{AD4E4DE1-9CB1-4771-A235-1540E1ED3060}" dt="2023-01-06T15:26:45.335" v="5127"/>
          <ac:spMkLst>
            <pc:docMk/>
            <pc:sldMk cId="240031287" sldId="317"/>
            <ac:spMk id="84" creationId="{AC3A599F-F4DA-E152-A597-298E6060208B}"/>
          </ac:spMkLst>
        </pc:spChg>
        <pc:spChg chg="mod">
          <ac:chgData name="Kumar, Vinod" userId="a0710a6e-bffc-4971-8893-1c23addeb5b0" providerId="ADAL" clId="{AD4E4DE1-9CB1-4771-A235-1540E1ED3060}" dt="2023-01-06T15:26:45.335" v="5127"/>
          <ac:spMkLst>
            <pc:docMk/>
            <pc:sldMk cId="240031287" sldId="317"/>
            <ac:spMk id="86" creationId="{BCFDA236-618C-1A44-4A63-209397DEE7B3}"/>
          </ac:spMkLst>
        </pc:spChg>
        <pc:spChg chg="mod">
          <ac:chgData name="Kumar, Vinod" userId="a0710a6e-bffc-4971-8893-1c23addeb5b0" providerId="ADAL" clId="{AD4E4DE1-9CB1-4771-A235-1540E1ED3060}" dt="2023-01-06T15:26:45.335" v="5127"/>
          <ac:spMkLst>
            <pc:docMk/>
            <pc:sldMk cId="240031287" sldId="317"/>
            <ac:spMk id="87" creationId="{B5E5731F-8EF0-54E9-82EA-9E822C35E087}"/>
          </ac:spMkLst>
        </pc:spChg>
        <pc:spChg chg="mod">
          <ac:chgData name="Kumar, Vinod" userId="a0710a6e-bffc-4971-8893-1c23addeb5b0" providerId="ADAL" clId="{AD4E4DE1-9CB1-4771-A235-1540E1ED3060}" dt="2023-01-06T15:27:28.646" v="5132"/>
          <ac:spMkLst>
            <pc:docMk/>
            <pc:sldMk cId="240031287" sldId="317"/>
            <ac:spMk id="92" creationId="{A85FAA33-15CB-6DF6-8A7D-39585449430D}"/>
          </ac:spMkLst>
        </pc:spChg>
        <pc:spChg chg="mod">
          <ac:chgData name="Kumar, Vinod" userId="a0710a6e-bffc-4971-8893-1c23addeb5b0" providerId="ADAL" clId="{AD4E4DE1-9CB1-4771-A235-1540E1ED3060}" dt="2023-01-06T15:27:28.646" v="5132"/>
          <ac:spMkLst>
            <pc:docMk/>
            <pc:sldMk cId="240031287" sldId="317"/>
            <ac:spMk id="93" creationId="{B5ECDCCF-8241-7DED-B01D-18268EFD59A7}"/>
          </ac:spMkLst>
        </pc:spChg>
        <pc:spChg chg="mod">
          <ac:chgData name="Kumar, Vinod" userId="a0710a6e-bffc-4971-8893-1c23addeb5b0" providerId="ADAL" clId="{AD4E4DE1-9CB1-4771-A235-1540E1ED3060}" dt="2023-01-06T15:27:28.646" v="5132"/>
          <ac:spMkLst>
            <pc:docMk/>
            <pc:sldMk cId="240031287" sldId="317"/>
            <ac:spMk id="95" creationId="{D17B746C-4C5E-0DD7-B2F7-6BAEC7D09ACB}"/>
          </ac:spMkLst>
        </pc:spChg>
        <pc:spChg chg="mod">
          <ac:chgData name="Kumar, Vinod" userId="a0710a6e-bffc-4971-8893-1c23addeb5b0" providerId="ADAL" clId="{AD4E4DE1-9CB1-4771-A235-1540E1ED3060}" dt="2023-01-06T15:27:28.646" v="5132"/>
          <ac:spMkLst>
            <pc:docMk/>
            <pc:sldMk cId="240031287" sldId="317"/>
            <ac:spMk id="96" creationId="{0994D80A-B3B6-2C63-F1C4-1AE98578A123}"/>
          </ac:spMkLst>
        </pc:spChg>
        <pc:spChg chg="add mod">
          <ac:chgData name="Kumar, Vinod" userId="a0710a6e-bffc-4971-8893-1c23addeb5b0" providerId="ADAL" clId="{AD4E4DE1-9CB1-4771-A235-1540E1ED3060}" dt="2023-01-06T19:55:05.836" v="6682" actId="255"/>
          <ac:spMkLst>
            <pc:docMk/>
            <pc:sldMk cId="240031287" sldId="317"/>
            <ac:spMk id="98" creationId="{6636987C-6AC5-8649-EF02-4BCC2F50FBF0}"/>
          </ac:spMkLst>
        </pc:spChg>
        <pc:grpChg chg="add del mod">
          <ac:chgData name="Kumar, Vinod" userId="a0710a6e-bffc-4971-8893-1c23addeb5b0" providerId="ADAL" clId="{AD4E4DE1-9CB1-4771-A235-1540E1ED3060}" dt="2023-01-06T15:33:18.402" v="5549" actId="165"/>
          <ac:grpSpMkLst>
            <pc:docMk/>
            <pc:sldMk cId="240031287" sldId="317"/>
            <ac:grpSpMk id="9" creationId="{D03AD717-A6F3-927A-C2CD-43EDA631D34A}"/>
          </ac:grpSpMkLst>
        </pc:grpChg>
        <pc:grpChg chg="add mod">
          <ac:chgData name="Kumar, Vinod" userId="a0710a6e-bffc-4971-8893-1c23addeb5b0" providerId="ADAL" clId="{AD4E4DE1-9CB1-4771-A235-1540E1ED3060}" dt="2023-01-06T15:25:12.212" v="5119" actId="164"/>
          <ac:grpSpMkLst>
            <pc:docMk/>
            <pc:sldMk cId="240031287" sldId="317"/>
            <ac:grpSpMk id="10" creationId="{5117FE9D-FF64-FD8B-609D-0363CB15E8E2}"/>
          </ac:grpSpMkLst>
        </pc:grpChg>
        <pc:grpChg chg="mod">
          <ac:chgData name="Kumar, Vinod" userId="a0710a6e-bffc-4971-8893-1c23addeb5b0" providerId="ADAL" clId="{AD4E4DE1-9CB1-4771-A235-1540E1ED3060}" dt="2023-01-06T15:29:50.351" v="5224" actId="1038"/>
          <ac:grpSpMkLst>
            <pc:docMk/>
            <pc:sldMk cId="240031287" sldId="317"/>
            <ac:grpSpMk id="25" creationId="{805A9B49-AAB6-C36F-99CD-3E09AE701FC4}"/>
          </ac:grpSpMkLst>
        </pc:grpChg>
        <pc:grpChg chg="mod">
          <ac:chgData name="Kumar, Vinod" userId="a0710a6e-bffc-4971-8893-1c23addeb5b0" providerId="ADAL" clId="{AD4E4DE1-9CB1-4771-A235-1540E1ED3060}" dt="2023-01-06T15:30:06.510" v="5232" actId="1036"/>
          <ac:grpSpMkLst>
            <pc:docMk/>
            <pc:sldMk cId="240031287" sldId="317"/>
            <ac:grpSpMk id="26" creationId="{17484DF5-3BA7-DB77-1D73-F10E10D0A7DD}"/>
          </ac:grpSpMkLst>
        </pc:grpChg>
        <pc:grpChg chg="mod">
          <ac:chgData name="Kumar, Vinod" userId="a0710a6e-bffc-4971-8893-1c23addeb5b0" providerId="ADAL" clId="{AD4E4DE1-9CB1-4771-A235-1540E1ED3060}" dt="2023-01-06T15:30:03.598" v="5227" actId="1036"/>
          <ac:grpSpMkLst>
            <pc:docMk/>
            <pc:sldMk cId="240031287" sldId="317"/>
            <ac:grpSpMk id="27" creationId="{C4DFA242-5262-E07D-9618-81631B0832B2}"/>
          </ac:grpSpMkLst>
        </pc:grpChg>
        <pc:grpChg chg="add del mod">
          <ac:chgData name="Kumar, Vinod" userId="a0710a6e-bffc-4971-8893-1c23addeb5b0" providerId="ADAL" clId="{AD4E4DE1-9CB1-4771-A235-1540E1ED3060}" dt="2023-01-06T15:34:59.613" v="5561" actId="478"/>
          <ac:grpSpMkLst>
            <pc:docMk/>
            <pc:sldMk cId="240031287" sldId="317"/>
            <ac:grpSpMk id="28" creationId="{52658CE9-ED4C-A7E3-FCF1-FACBD5F41B2D}"/>
          </ac:grpSpMkLst>
        </pc:grpChg>
        <pc:grpChg chg="mod">
          <ac:chgData name="Kumar, Vinod" userId="a0710a6e-bffc-4971-8893-1c23addeb5b0" providerId="ADAL" clId="{AD4E4DE1-9CB1-4771-A235-1540E1ED3060}" dt="2023-01-06T15:25:53.976" v="5120"/>
          <ac:grpSpMkLst>
            <pc:docMk/>
            <pc:sldMk cId="240031287" sldId="317"/>
            <ac:grpSpMk id="29" creationId="{D5544C50-321E-0C06-3F4A-0057CDC10DD9}"/>
          </ac:grpSpMkLst>
        </pc:grpChg>
        <pc:grpChg chg="add del mod">
          <ac:chgData name="Kumar, Vinod" userId="a0710a6e-bffc-4971-8893-1c23addeb5b0" providerId="ADAL" clId="{AD4E4DE1-9CB1-4771-A235-1540E1ED3060}" dt="2023-01-06T15:26:03.330" v="5123"/>
          <ac:grpSpMkLst>
            <pc:docMk/>
            <pc:sldMk cId="240031287" sldId="317"/>
            <ac:grpSpMk id="69" creationId="{7FBF6681-A20B-5D48-4A3D-FDBA01F284F0}"/>
          </ac:grpSpMkLst>
        </pc:grpChg>
        <pc:grpChg chg="mod">
          <ac:chgData name="Kumar, Vinod" userId="a0710a6e-bffc-4971-8893-1c23addeb5b0" providerId="ADAL" clId="{AD4E4DE1-9CB1-4771-A235-1540E1ED3060}" dt="2023-01-06T15:26:00.119" v="5122"/>
          <ac:grpSpMkLst>
            <pc:docMk/>
            <pc:sldMk cId="240031287" sldId="317"/>
            <ac:grpSpMk id="70" creationId="{EEE3A7CA-9716-381C-E2B2-9DF10B3DE729}"/>
          </ac:grpSpMkLst>
        </pc:grpChg>
        <pc:grpChg chg="add del mod">
          <ac:chgData name="Kumar, Vinod" userId="a0710a6e-bffc-4971-8893-1c23addeb5b0" providerId="ADAL" clId="{AD4E4DE1-9CB1-4771-A235-1540E1ED3060}" dt="2023-01-06T15:34:59.613" v="5561" actId="478"/>
          <ac:grpSpMkLst>
            <pc:docMk/>
            <pc:sldMk cId="240031287" sldId="317"/>
            <ac:grpSpMk id="80" creationId="{352FC16C-7B76-D1AF-6F8B-A40FE56159E9}"/>
          </ac:grpSpMkLst>
        </pc:grpChg>
        <pc:grpChg chg="add del mod">
          <ac:chgData name="Kumar, Vinod" userId="a0710a6e-bffc-4971-8893-1c23addeb5b0" providerId="ADAL" clId="{AD4E4DE1-9CB1-4771-A235-1540E1ED3060}" dt="2023-01-06T15:34:59.613" v="5561" actId="478"/>
          <ac:grpSpMkLst>
            <pc:docMk/>
            <pc:sldMk cId="240031287" sldId="317"/>
            <ac:grpSpMk id="89" creationId="{2A802938-FB4B-9144-4B10-4B22CE89A8C0}"/>
          </ac:grpSpMkLst>
        </pc:grpChg>
        <pc:picChg chg="mod">
          <ac:chgData name="Kumar, Vinod" userId="a0710a6e-bffc-4971-8893-1c23addeb5b0" providerId="ADAL" clId="{AD4E4DE1-9CB1-4771-A235-1540E1ED3060}" dt="2023-01-06T15:21:55.843" v="4816" actId="1036"/>
          <ac:picMkLst>
            <pc:docMk/>
            <pc:sldMk cId="240031287" sldId="317"/>
            <ac:picMk id="3" creationId="{FBF35403-61AF-9C85-AFB2-D91B2E63184B}"/>
          </ac:picMkLst>
        </pc:picChg>
        <pc:picChg chg="mod">
          <ac:chgData name="Kumar, Vinod" userId="a0710a6e-bffc-4971-8893-1c23addeb5b0" providerId="ADAL" clId="{AD4E4DE1-9CB1-4771-A235-1540E1ED3060}" dt="2023-01-06T15:21:55.843" v="4816" actId="1036"/>
          <ac:picMkLst>
            <pc:docMk/>
            <pc:sldMk cId="240031287" sldId="317"/>
            <ac:picMk id="4" creationId="{B7DE046C-470A-960C-E17F-D265CEC30111}"/>
          </ac:picMkLst>
        </pc:picChg>
        <pc:picChg chg="mod">
          <ac:chgData name="Kumar, Vinod" userId="a0710a6e-bffc-4971-8893-1c23addeb5b0" providerId="ADAL" clId="{AD4E4DE1-9CB1-4771-A235-1540E1ED3060}" dt="2023-01-06T15:24:33.592" v="5093" actId="1076"/>
          <ac:picMkLst>
            <pc:docMk/>
            <pc:sldMk cId="240031287" sldId="317"/>
            <ac:picMk id="5" creationId="{D22CD06E-BB45-DAE6-41F1-E7CC9C42B9EA}"/>
          </ac:picMkLst>
        </pc:picChg>
        <pc:picChg chg="add del mod">
          <ac:chgData name="Kumar, Vinod" userId="a0710a6e-bffc-4971-8893-1c23addeb5b0" providerId="ADAL" clId="{AD4E4DE1-9CB1-4771-A235-1540E1ED3060}" dt="2023-01-06T15:24:57.050" v="5109"/>
          <ac:picMkLst>
            <pc:docMk/>
            <pc:sldMk cId="240031287" sldId="317"/>
            <ac:picMk id="11" creationId="{A077CB7C-CADE-1FB7-13EB-A6B574EC6839}"/>
          </ac:picMkLst>
        </pc:picChg>
        <pc:picChg chg="add del mod">
          <ac:chgData name="Kumar, Vinod" userId="a0710a6e-bffc-4971-8893-1c23addeb5b0" providerId="ADAL" clId="{AD4E4DE1-9CB1-4771-A235-1540E1ED3060}" dt="2023-01-06T15:24:50.546" v="5099"/>
          <ac:picMkLst>
            <pc:docMk/>
            <pc:sldMk cId="240031287" sldId="317"/>
            <ac:picMk id="20" creationId="{FF39ADA8-B2F6-E1D7-9474-27126C9FBD56}"/>
          </ac:picMkLst>
        </pc:picChg>
        <pc:picChg chg="add del mod">
          <ac:chgData name="Kumar, Vinod" userId="a0710a6e-bffc-4971-8893-1c23addeb5b0" providerId="ADAL" clId="{AD4E4DE1-9CB1-4771-A235-1540E1ED3060}" dt="2023-01-06T15:24:49.819" v="5097"/>
          <ac:picMkLst>
            <pc:docMk/>
            <pc:sldMk cId="240031287" sldId="317"/>
            <ac:picMk id="21" creationId="{592A62B0-ECF8-DFB4-7EE7-A8122B9D9A2A}"/>
          </ac:picMkLst>
        </pc:picChg>
        <pc:picChg chg="mod">
          <ac:chgData name="Kumar, Vinod" userId="a0710a6e-bffc-4971-8893-1c23addeb5b0" providerId="ADAL" clId="{AD4E4DE1-9CB1-4771-A235-1540E1ED3060}" dt="2023-01-06T15:25:53.976" v="5120"/>
          <ac:picMkLst>
            <pc:docMk/>
            <pc:sldMk cId="240031287" sldId="317"/>
            <ac:picMk id="64" creationId="{C674F669-B4EB-0080-CEA2-49BCFB5DBD14}"/>
          </ac:picMkLst>
        </pc:picChg>
        <pc:picChg chg="mod">
          <ac:chgData name="Kumar, Vinod" userId="a0710a6e-bffc-4971-8893-1c23addeb5b0" providerId="ADAL" clId="{AD4E4DE1-9CB1-4771-A235-1540E1ED3060}" dt="2023-01-06T15:25:53.976" v="5120"/>
          <ac:picMkLst>
            <pc:docMk/>
            <pc:sldMk cId="240031287" sldId="317"/>
            <ac:picMk id="65" creationId="{D0FDD866-A4E4-DEE4-AD19-010231AB0ED6}"/>
          </ac:picMkLst>
        </pc:picChg>
        <pc:picChg chg="mod">
          <ac:chgData name="Kumar, Vinod" userId="a0710a6e-bffc-4971-8893-1c23addeb5b0" providerId="ADAL" clId="{AD4E4DE1-9CB1-4771-A235-1540E1ED3060}" dt="2023-01-06T15:26:00.119" v="5122"/>
          <ac:picMkLst>
            <pc:docMk/>
            <pc:sldMk cId="240031287" sldId="317"/>
            <ac:picMk id="73" creationId="{324BDA01-AD85-3296-6B3F-72154E66818F}"/>
          </ac:picMkLst>
        </pc:picChg>
        <pc:picChg chg="del">
          <ac:chgData name="Kumar, Vinod" userId="a0710a6e-bffc-4971-8893-1c23addeb5b0" providerId="ADAL" clId="{AD4E4DE1-9CB1-4771-A235-1540E1ED3060}" dt="2023-01-06T15:20:28.736" v="4563" actId="478"/>
          <ac:picMkLst>
            <pc:docMk/>
            <pc:sldMk cId="240031287" sldId="317"/>
            <ac:picMk id="74" creationId="{66E4FA49-58E7-1EA8-132C-7E27C31FD8A1}"/>
          </ac:picMkLst>
        </pc:picChg>
        <pc:picChg chg="mod">
          <ac:chgData name="Kumar, Vinod" userId="a0710a6e-bffc-4971-8893-1c23addeb5b0" providerId="ADAL" clId="{AD4E4DE1-9CB1-4771-A235-1540E1ED3060}" dt="2023-01-06T15:26:00.119" v="5122"/>
          <ac:picMkLst>
            <pc:docMk/>
            <pc:sldMk cId="240031287" sldId="317"/>
            <ac:picMk id="75" creationId="{DD1EA94A-5F19-19FE-2F2A-4B4A689409B1}"/>
          </ac:picMkLst>
        </pc:picChg>
        <pc:picChg chg="add mod">
          <ac:chgData name="Kumar, Vinod" userId="a0710a6e-bffc-4971-8893-1c23addeb5b0" providerId="ADAL" clId="{AD4E4DE1-9CB1-4771-A235-1540E1ED3060}" dt="2023-01-06T15:29:39.247" v="5199" actId="1036"/>
          <ac:picMkLst>
            <pc:docMk/>
            <pc:sldMk cId="240031287" sldId="317"/>
            <ac:picMk id="79" creationId="{B03EF4E1-E5C2-04E5-8333-519887056FEF}"/>
          </ac:picMkLst>
        </pc:picChg>
        <pc:picChg chg="mod">
          <ac:chgData name="Kumar, Vinod" userId="a0710a6e-bffc-4971-8893-1c23addeb5b0" providerId="ADAL" clId="{AD4E4DE1-9CB1-4771-A235-1540E1ED3060}" dt="2023-01-06T15:26:45.335" v="5127"/>
          <ac:picMkLst>
            <pc:docMk/>
            <pc:sldMk cId="240031287" sldId="317"/>
            <ac:picMk id="81" creationId="{118D5BA1-319A-7B9D-4D8D-71EA200B1636}"/>
          </ac:picMkLst>
        </pc:picChg>
        <pc:picChg chg="mod">
          <ac:chgData name="Kumar, Vinod" userId="a0710a6e-bffc-4971-8893-1c23addeb5b0" providerId="ADAL" clId="{AD4E4DE1-9CB1-4771-A235-1540E1ED3060}" dt="2023-01-06T15:26:45.335" v="5127"/>
          <ac:picMkLst>
            <pc:docMk/>
            <pc:sldMk cId="240031287" sldId="317"/>
            <ac:picMk id="82" creationId="{65073663-F61A-988A-46C0-E98833D53E5F}"/>
          </ac:picMkLst>
        </pc:picChg>
        <pc:picChg chg="add mod">
          <ac:chgData name="Kumar, Vinod" userId="a0710a6e-bffc-4971-8893-1c23addeb5b0" providerId="ADAL" clId="{AD4E4DE1-9CB1-4771-A235-1540E1ED3060}" dt="2023-01-06T15:34:59.068" v="5560" actId="1038"/>
          <ac:picMkLst>
            <pc:docMk/>
            <pc:sldMk cId="240031287" sldId="317"/>
            <ac:picMk id="88" creationId="{4BE5039A-14EE-E51D-89E4-EDE17E568A68}"/>
          </ac:picMkLst>
        </pc:picChg>
        <pc:picChg chg="mod">
          <ac:chgData name="Kumar, Vinod" userId="a0710a6e-bffc-4971-8893-1c23addeb5b0" providerId="ADAL" clId="{AD4E4DE1-9CB1-4771-A235-1540E1ED3060}" dt="2023-01-06T15:27:28.646" v="5132"/>
          <ac:picMkLst>
            <pc:docMk/>
            <pc:sldMk cId="240031287" sldId="317"/>
            <ac:picMk id="90" creationId="{9BB5DF4F-553E-C5A6-3A24-2955F3E9670E}"/>
          </ac:picMkLst>
        </pc:picChg>
        <pc:picChg chg="mod">
          <ac:chgData name="Kumar, Vinod" userId="a0710a6e-bffc-4971-8893-1c23addeb5b0" providerId="ADAL" clId="{AD4E4DE1-9CB1-4771-A235-1540E1ED3060}" dt="2023-01-06T15:27:28.646" v="5132"/>
          <ac:picMkLst>
            <pc:docMk/>
            <pc:sldMk cId="240031287" sldId="317"/>
            <ac:picMk id="91" creationId="{A84EFD20-1873-3713-770E-1CF95C47FB6D}"/>
          </ac:picMkLst>
        </pc:picChg>
        <pc:picChg chg="add mod">
          <ac:chgData name="Kumar, Vinod" userId="a0710a6e-bffc-4971-8893-1c23addeb5b0" providerId="ADAL" clId="{AD4E4DE1-9CB1-4771-A235-1540E1ED3060}" dt="2023-01-06T15:29:39.247" v="5199" actId="1036"/>
          <ac:picMkLst>
            <pc:docMk/>
            <pc:sldMk cId="240031287" sldId="317"/>
            <ac:picMk id="97" creationId="{BDA9227D-B5A4-9D55-3AEF-C552602BE279}"/>
          </ac:picMkLst>
        </pc:picChg>
        <pc:picChg chg="del">
          <ac:chgData name="Kumar, Vinod" userId="a0710a6e-bffc-4971-8893-1c23addeb5b0" providerId="ADAL" clId="{AD4E4DE1-9CB1-4771-A235-1540E1ED3060}" dt="2023-01-06T15:20:28.736" v="4563" actId="478"/>
          <ac:picMkLst>
            <pc:docMk/>
            <pc:sldMk cId="240031287" sldId="317"/>
            <ac:picMk id="103" creationId="{40FD0B02-58ED-01BF-6D79-D816948B4DED}"/>
          </ac:picMkLst>
        </pc:picChg>
        <pc:cxnChg chg="mod">
          <ac:chgData name="Kumar, Vinod" userId="a0710a6e-bffc-4971-8893-1c23addeb5b0" providerId="ADAL" clId="{AD4E4DE1-9CB1-4771-A235-1540E1ED3060}" dt="2023-01-06T15:25:53.976" v="5120"/>
          <ac:cxnSpMkLst>
            <pc:docMk/>
            <pc:sldMk cId="240031287" sldId="317"/>
            <ac:cxnSpMk id="30" creationId="{C23B9113-C838-6604-802B-F28E7A27FE6A}"/>
          </ac:cxnSpMkLst>
        </pc:cxnChg>
        <pc:cxnChg chg="mod">
          <ac:chgData name="Kumar, Vinod" userId="a0710a6e-bffc-4971-8893-1c23addeb5b0" providerId="ADAL" clId="{AD4E4DE1-9CB1-4771-A235-1540E1ED3060}" dt="2023-01-06T15:26:00.119" v="5122"/>
          <ac:cxnSpMkLst>
            <pc:docMk/>
            <pc:sldMk cId="240031287" sldId="317"/>
            <ac:cxnSpMk id="71" creationId="{D6612E24-6CA5-46BE-C4A3-FAC8C7CE60CE}"/>
          </ac:cxnSpMkLst>
        </pc:cxnChg>
        <pc:cxnChg chg="mod">
          <ac:chgData name="Kumar, Vinod" userId="a0710a6e-bffc-4971-8893-1c23addeb5b0" providerId="ADAL" clId="{AD4E4DE1-9CB1-4771-A235-1540E1ED3060}" dt="2023-01-06T15:26:45.335" v="5127"/>
          <ac:cxnSpMkLst>
            <pc:docMk/>
            <pc:sldMk cId="240031287" sldId="317"/>
            <ac:cxnSpMk id="85" creationId="{4E840A70-891C-8509-B651-AAF69AE65A0F}"/>
          </ac:cxnSpMkLst>
        </pc:cxnChg>
        <pc:cxnChg chg="mod">
          <ac:chgData name="Kumar, Vinod" userId="a0710a6e-bffc-4971-8893-1c23addeb5b0" providerId="ADAL" clId="{AD4E4DE1-9CB1-4771-A235-1540E1ED3060}" dt="2023-01-06T15:27:28.646" v="5132"/>
          <ac:cxnSpMkLst>
            <pc:docMk/>
            <pc:sldMk cId="240031287" sldId="317"/>
            <ac:cxnSpMk id="94" creationId="{67038FC5-FBD8-CEFE-BF7A-ED064D9B1C71}"/>
          </ac:cxnSpMkLst>
        </pc:cxnChg>
      </pc:sldChg>
      <pc:sldChg chg="addSp modSp add del mod">
        <pc:chgData name="Kumar, Vinod" userId="a0710a6e-bffc-4971-8893-1c23addeb5b0" providerId="ADAL" clId="{AD4E4DE1-9CB1-4771-A235-1540E1ED3060}" dt="2023-01-06T15:16:58.233" v="4410" actId="47"/>
        <pc:sldMkLst>
          <pc:docMk/>
          <pc:sldMk cId="2045324388" sldId="317"/>
        </pc:sldMkLst>
        <pc:spChg chg="mod">
          <ac:chgData name="Kumar, Vinod" userId="a0710a6e-bffc-4971-8893-1c23addeb5b0" providerId="ADAL" clId="{AD4E4DE1-9CB1-4771-A235-1540E1ED3060}" dt="2023-01-06T15:05:20.628" v="4350"/>
          <ac:spMkLst>
            <pc:docMk/>
            <pc:sldMk cId="2045324388" sldId="317"/>
            <ac:spMk id="20" creationId="{49AC461D-139C-4A97-3C8B-DBEF0E3C863A}"/>
          </ac:spMkLst>
        </pc:spChg>
        <pc:spChg chg="mod">
          <ac:chgData name="Kumar, Vinod" userId="a0710a6e-bffc-4971-8893-1c23addeb5b0" providerId="ADAL" clId="{AD4E4DE1-9CB1-4771-A235-1540E1ED3060}" dt="2023-01-06T15:05:20.628" v="4350"/>
          <ac:spMkLst>
            <pc:docMk/>
            <pc:sldMk cId="2045324388" sldId="317"/>
            <ac:spMk id="29" creationId="{E214DFC6-A7F2-77CA-4A52-E53620B583E7}"/>
          </ac:spMkLst>
        </pc:spChg>
        <pc:spChg chg="mod">
          <ac:chgData name="Kumar, Vinod" userId="a0710a6e-bffc-4971-8893-1c23addeb5b0" providerId="ADAL" clId="{AD4E4DE1-9CB1-4771-A235-1540E1ED3060}" dt="2023-01-06T15:05:20.628" v="4350"/>
          <ac:spMkLst>
            <pc:docMk/>
            <pc:sldMk cId="2045324388" sldId="317"/>
            <ac:spMk id="30" creationId="{31557FC4-E0E1-E643-A982-AEFD06FC6B30}"/>
          </ac:spMkLst>
        </pc:spChg>
        <pc:spChg chg="mod">
          <ac:chgData name="Kumar, Vinod" userId="a0710a6e-bffc-4971-8893-1c23addeb5b0" providerId="ADAL" clId="{AD4E4DE1-9CB1-4771-A235-1540E1ED3060}" dt="2023-01-06T15:05:20.628" v="4350"/>
          <ac:spMkLst>
            <pc:docMk/>
            <pc:sldMk cId="2045324388" sldId="317"/>
            <ac:spMk id="31" creationId="{E97A0285-5B99-AA6F-6BF2-585FB832FA6F}"/>
          </ac:spMkLst>
        </pc:spChg>
        <pc:spChg chg="mod">
          <ac:chgData name="Kumar, Vinod" userId="a0710a6e-bffc-4971-8893-1c23addeb5b0" providerId="ADAL" clId="{AD4E4DE1-9CB1-4771-A235-1540E1ED3060}" dt="2023-01-06T15:08:38.720" v="4353"/>
          <ac:spMkLst>
            <pc:docMk/>
            <pc:sldMk cId="2045324388" sldId="317"/>
            <ac:spMk id="67" creationId="{C80AB22F-B14C-071C-BBA4-A70F71F07835}"/>
          </ac:spMkLst>
        </pc:spChg>
        <pc:spChg chg="mod">
          <ac:chgData name="Kumar, Vinod" userId="a0710a6e-bffc-4971-8893-1c23addeb5b0" providerId="ADAL" clId="{AD4E4DE1-9CB1-4771-A235-1540E1ED3060}" dt="2023-01-06T15:08:38.720" v="4353"/>
          <ac:spMkLst>
            <pc:docMk/>
            <pc:sldMk cId="2045324388" sldId="317"/>
            <ac:spMk id="68" creationId="{1F62A1EE-86AF-9816-247D-4D1BCE7DE5BB}"/>
          </ac:spMkLst>
        </pc:spChg>
        <pc:spChg chg="mod">
          <ac:chgData name="Kumar, Vinod" userId="a0710a6e-bffc-4971-8893-1c23addeb5b0" providerId="ADAL" clId="{AD4E4DE1-9CB1-4771-A235-1540E1ED3060}" dt="2023-01-06T15:08:38.720" v="4353"/>
          <ac:spMkLst>
            <pc:docMk/>
            <pc:sldMk cId="2045324388" sldId="317"/>
            <ac:spMk id="70" creationId="{2941F411-56CE-83AD-F1BC-32A89E632294}"/>
          </ac:spMkLst>
        </pc:spChg>
        <pc:spChg chg="mod">
          <ac:chgData name="Kumar, Vinod" userId="a0710a6e-bffc-4971-8893-1c23addeb5b0" providerId="ADAL" clId="{AD4E4DE1-9CB1-4771-A235-1540E1ED3060}" dt="2023-01-06T15:08:38.720" v="4353"/>
          <ac:spMkLst>
            <pc:docMk/>
            <pc:sldMk cId="2045324388" sldId="317"/>
            <ac:spMk id="71" creationId="{782FD787-62D6-A8CE-3EAF-DA310585173A}"/>
          </ac:spMkLst>
        </pc:spChg>
        <pc:spChg chg="mod">
          <ac:chgData name="Kumar, Vinod" userId="a0710a6e-bffc-4971-8893-1c23addeb5b0" providerId="ADAL" clId="{AD4E4DE1-9CB1-4771-A235-1540E1ED3060}" dt="2023-01-06T15:09:00.591" v="4355"/>
          <ac:spMkLst>
            <pc:docMk/>
            <pc:sldMk cId="2045324388" sldId="317"/>
            <ac:spMk id="76" creationId="{AB8A9968-C049-4BD1-D0CB-93CE00C4D4C6}"/>
          </ac:spMkLst>
        </pc:spChg>
        <pc:spChg chg="mod">
          <ac:chgData name="Kumar, Vinod" userId="a0710a6e-bffc-4971-8893-1c23addeb5b0" providerId="ADAL" clId="{AD4E4DE1-9CB1-4771-A235-1540E1ED3060}" dt="2023-01-06T15:09:00.591" v="4355"/>
          <ac:spMkLst>
            <pc:docMk/>
            <pc:sldMk cId="2045324388" sldId="317"/>
            <ac:spMk id="77" creationId="{C8D7AB77-242D-76B0-4782-228F88D73BA2}"/>
          </ac:spMkLst>
        </pc:spChg>
        <pc:spChg chg="mod">
          <ac:chgData name="Kumar, Vinod" userId="a0710a6e-bffc-4971-8893-1c23addeb5b0" providerId="ADAL" clId="{AD4E4DE1-9CB1-4771-A235-1540E1ED3060}" dt="2023-01-06T15:09:00.591" v="4355"/>
          <ac:spMkLst>
            <pc:docMk/>
            <pc:sldMk cId="2045324388" sldId="317"/>
            <ac:spMk id="79" creationId="{2DAB5F6E-B13F-08AC-F211-AF3BD507F9EB}"/>
          </ac:spMkLst>
        </pc:spChg>
        <pc:spChg chg="mod">
          <ac:chgData name="Kumar, Vinod" userId="a0710a6e-bffc-4971-8893-1c23addeb5b0" providerId="ADAL" clId="{AD4E4DE1-9CB1-4771-A235-1540E1ED3060}" dt="2023-01-06T15:09:00.591" v="4355"/>
          <ac:spMkLst>
            <pc:docMk/>
            <pc:sldMk cId="2045324388" sldId="317"/>
            <ac:spMk id="80" creationId="{29E295F1-775A-AB3E-F581-5D898682AD0D}"/>
          </ac:spMkLst>
        </pc:spChg>
        <pc:grpChg chg="add mod">
          <ac:chgData name="Kumar, Vinod" userId="a0710a6e-bffc-4971-8893-1c23addeb5b0" providerId="ADAL" clId="{AD4E4DE1-9CB1-4771-A235-1540E1ED3060}" dt="2023-01-06T15:14:04.846" v="4392" actId="1076"/>
          <ac:grpSpMkLst>
            <pc:docMk/>
            <pc:sldMk cId="2045324388" sldId="317"/>
            <ac:grpSpMk id="9" creationId="{185D235E-B1E9-3E74-77B9-94BF8F90259B}"/>
          </ac:grpSpMkLst>
        </pc:grpChg>
        <pc:grpChg chg="mod">
          <ac:chgData name="Kumar, Vinod" userId="a0710a6e-bffc-4971-8893-1c23addeb5b0" providerId="ADAL" clId="{AD4E4DE1-9CB1-4771-A235-1540E1ED3060}" dt="2023-01-06T15:05:20.628" v="4350"/>
          <ac:grpSpMkLst>
            <pc:docMk/>
            <pc:sldMk cId="2045324388" sldId="317"/>
            <ac:grpSpMk id="10" creationId="{878E049B-C5F8-290A-2626-E29A809A4D11}"/>
          </ac:grpSpMkLst>
        </pc:grpChg>
        <pc:grpChg chg="mod">
          <ac:chgData name="Kumar, Vinod" userId="a0710a6e-bffc-4971-8893-1c23addeb5b0" providerId="ADAL" clId="{AD4E4DE1-9CB1-4771-A235-1540E1ED3060}" dt="2023-01-06T15:14:40.558" v="4398" actId="1076"/>
          <ac:grpSpMkLst>
            <pc:docMk/>
            <pc:sldMk cId="2045324388" sldId="317"/>
            <ac:grpSpMk id="26" creationId="{17484DF5-3BA7-DB77-1D73-F10E10D0A7DD}"/>
          </ac:grpSpMkLst>
        </pc:grpChg>
        <pc:grpChg chg="mod">
          <ac:chgData name="Kumar, Vinod" userId="a0710a6e-bffc-4971-8893-1c23addeb5b0" providerId="ADAL" clId="{AD4E4DE1-9CB1-4771-A235-1540E1ED3060}" dt="2023-01-06T15:14:56.734" v="4402" actId="1076"/>
          <ac:grpSpMkLst>
            <pc:docMk/>
            <pc:sldMk cId="2045324388" sldId="317"/>
            <ac:grpSpMk id="27" creationId="{C4DFA242-5262-E07D-9618-81631B0832B2}"/>
          </ac:grpSpMkLst>
        </pc:grpChg>
        <pc:grpChg chg="add mod">
          <ac:chgData name="Kumar, Vinod" userId="a0710a6e-bffc-4971-8893-1c23addeb5b0" providerId="ADAL" clId="{AD4E4DE1-9CB1-4771-A235-1540E1ED3060}" dt="2023-01-06T15:09:42.241" v="4357" actId="1076"/>
          <ac:grpSpMkLst>
            <pc:docMk/>
            <pc:sldMk cId="2045324388" sldId="317"/>
            <ac:grpSpMk id="64" creationId="{74B6FE50-12DA-3F75-B8C7-E83A19D1160A}"/>
          </ac:grpSpMkLst>
        </pc:grpChg>
        <pc:grpChg chg="add mod">
          <ac:chgData name="Kumar, Vinod" userId="a0710a6e-bffc-4971-8893-1c23addeb5b0" providerId="ADAL" clId="{AD4E4DE1-9CB1-4771-A235-1540E1ED3060}" dt="2023-01-06T15:09:45.197" v="4358" actId="1076"/>
          <ac:grpSpMkLst>
            <pc:docMk/>
            <pc:sldMk cId="2045324388" sldId="317"/>
            <ac:grpSpMk id="72" creationId="{B134D57B-1CF7-C471-64AD-194507F1A144}"/>
          </ac:grpSpMkLst>
        </pc:grpChg>
        <pc:picChg chg="mod">
          <ac:chgData name="Kumar, Vinod" userId="a0710a6e-bffc-4971-8893-1c23addeb5b0" providerId="ADAL" clId="{AD4E4DE1-9CB1-4771-A235-1540E1ED3060}" dt="2023-01-06T15:05:20.628" v="4350"/>
          <ac:picMkLst>
            <pc:docMk/>
            <pc:sldMk cId="2045324388" sldId="317"/>
            <ac:picMk id="21" creationId="{29AA15C3-10A3-FD46-0C7A-989ECE260613}"/>
          </ac:picMkLst>
        </pc:picChg>
        <pc:picChg chg="mod">
          <ac:chgData name="Kumar, Vinod" userId="a0710a6e-bffc-4971-8893-1c23addeb5b0" providerId="ADAL" clId="{AD4E4DE1-9CB1-4771-A235-1540E1ED3060}" dt="2023-01-06T15:05:20.628" v="4350"/>
          <ac:picMkLst>
            <pc:docMk/>
            <pc:sldMk cId="2045324388" sldId="317"/>
            <ac:picMk id="28" creationId="{CA35A900-3E20-DEB6-BE16-A215035E7244}"/>
          </ac:picMkLst>
        </pc:picChg>
        <pc:picChg chg="mod">
          <ac:chgData name="Kumar, Vinod" userId="a0710a6e-bffc-4971-8893-1c23addeb5b0" providerId="ADAL" clId="{AD4E4DE1-9CB1-4771-A235-1540E1ED3060}" dt="2023-01-06T15:08:38.720" v="4353"/>
          <ac:picMkLst>
            <pc:docMk/>
            <pc:sldMk cId="2045324388" sldId="317"/>
            <ac:picMk id="65" creationId="{37E5806B-D202-6075-3EF4-7F6004E0ADDE}"/>
          </ac:picMkLst>
        </pc:picChg>
        <pc:picChg chg="mod">
          <ac:chgData name="Kumar, Vinod" userId="a0710a6e-bffc-4971-8893-1c23addeb5b0" providerId="ADAL" clId="{AD4E4DE1-9CB1-4771-A235-1540E1ED3060}" dt="2023-01-06T15:08:38.720" v="4353"/>
          <ac:picMkLst>
            <pc:docMk/>
            <pc:sldMk cId="2045324388" sldId="317"/>
            <ac:picMk id="66" creationId="{BB87ED7D-8251-1F7C-D5C4-BF9B0A9B87E7}"/>
          </ac:picMkLst>
        </pc:picChg>
        <pc:picChg chg="mod">
          <ac:chgData name="Kumar, Vinod" userId="a0710a6e-bffc-4971-8893-1c23addeb5b0" providerId="ADAL" clId="{AD4E4DE1-9CB1-4771-A235-1540E1ED3060}" dt="2023-01-06T15:09:00.591" v="4355"/>
          <ac:picMkLst>
            <pc:docMk/>
            <pc:sldMk cId="2045324388" sldId="317"/>
            <ac:picMk id="73" creationId="{0F563C96-B83E-7074-B058-0697774FE68E}"/>
          </ac:picMkLst>
        </pc:picChg>
        <pc:picChg chg="mod">
          <ac:chgData name="Kumar, Vinod" userId="a0710a6e-bffc-4971-8893-1c23addeb5b0" providerId="ADAL" clId="{AD4E4DE1-9CB1-4771-A235-1540E1ED3060}" dt="2023-01-06T15:15:00.533" v="4404" actId="1076"/>
          <ac:picMkLst>
            <pc:docMk/>
            <pc:sldMk cId="2045324388" sldId="317"/>
            <ac:picMk id="74" creationId="{66E4FA49-58E7-1EA8-132C-7E27C31FD8A1}"/>
          </ac:picMkLst>
        </pc:picChg>
        <pc:picChg chg="mod">
          <ac:chgData name="Kumar, Vinod" userId="a0710a6e-bffc-4971-8893-1c23addeb5b0" providerId="ADAL" clId="{AD4E4DE1-9CB1-4771-A235-1540E1ED3060}" dt="2023-01-06T15:09:00.591" v="4355"/>
          <ac:picMkLst>
            <pc:docMk/>
            <pc:sldMk cId="2045324388" sldId="317"/>
            <ac:picMk id="75" creationId="{E0A0591D-1FC2-D718-CC5A-923D6F40708A}"/>
          </ac:picMkLst>
        </pc:picChg>
        <pc:picChg chg="add mod">
          <ac:chgData name="Kumar, Vinod" userId="a0710a6e-bffc-4971-8893-1c23addeb5b0" providerId="ADAL" clId="{AD4E4DE1-9CB1-4771-A235-1540E1ED3060}" dt="2023-01-06T15:16:28.821" v="4409" actId="14100"/>
          <ac:picMkLst>
            <pc:docMk/>
            <pc:sldMk cId="2045324388" sldId="317"/>
            <ac:picMk id="81" creationId="{9B3550DE-5C59-653F-3B60-14686848806D}"/>
          </ac:picMkLst>
        </pc:picChg>
        <pc:picChg chg="add mod">
          <ac:chgData name="Kumar, Vinod" userId="a0710a6e-bffc-4971-8893-1c23addeb5b0" providerId="ADAL" clId="{AD4E4DE1-9CB1-4771-A235-1540E1ED3060}" dt="2023-01-06T15:14:38.710" v="4397" actId="1076"/>
          <ac:picMkLst>
            <pc:docMk/>
            <pc:sldMk cId="2045324388" sldId="317"/>
            <ac:picMk id="82" creationId="{448F1AD9-48CD-4112-E3FE-7899D93E6627}"/>
          </ac:picMkLst>
        </pc:picChg>
        <pc:picChg chg="add mod">
          <ac:chgData name="Kumar, Vinod" userId="a0710a6e-bffc-4971-8893-1c23addeb5b0" providerId="ADAL" clId="{AD4E4DE1-9CB1-4771-A235-1540E1ED3060}" dt="2023-01-06T15:15:29.126" v="4405" actId="1076"/>
          <ac:picMkLst>
            <pc:docMk/>
            <pc:sldMk cId="2045324388" sldId="317"/>
            <ac:picMk id="83" creationId="{B9FDDF71-D249-1CFD-BE7D-A523990FC068}"/>
          </ac:picMkLst>
        </pc:picChg>
        <pc:picChg chg="mod">
          <ac:chgData name="Kumar, Vinod" userId="a0710a6e-bffc-4971-8893-1c23addeb5b0" providerId="ADAL" clId="{AD4E4DE1-9CB1-4771-A235-1540E1ED3060}" dt="2023-01-06T15:10:19.831" v="4365" actId="1076"/>
          <ac:picMkLst>
            <pc:docMk/>
            <pc:sldMk cId="2045324388" sldId="317"/>
            <ac:picMk id="103" creationId="{40FD0B02-58ED-01BF-6D79-D816948B4DED}"/>
          </ac:picMkLst>
        </pc:picChg>
        <pc:cxnChg chg="mod">
          <ac:chgData name="Kumar, Vinod" userId="a0710a6e-bffc-4971-8893-1c23addeb5b0" providerId="ADAL" clId="{AD4E4DE1-9CB1-4771-A235-1540E1ED3060}" dt="2023-01-06T15:05:20.628" v="4350"/>
          <ac:cxnSpMkLst>
            <pc:docMk/>
            <pc:sldMk cId="2045324388" sldId="317"/>
            <ac:cxnSpMk id="11" creationId="{93E91787-F636-387B-3838-CBB234FA8789}"/>
          </ac:cxnSpMkLst>
        </pc:cxnChg>
        <pc:cxnChg chg="mod">
          <ac:chgData name="Kumar, Vinod" userId="a0710a6e-bffc-4971-8893-1c23addeb5b0" providerId="ADAL" clId="{AD4E4DE1-9CB1-4771-A235-1540E1ED3060}" dt="2023-01-06T15:08:38.720" v="4353"/>
          <ac:cxnSpMkLst>
            <pc:docMk/>
            <pc:sldMk cId="2045324388" sldId="317"/>
            <ac:cxnSpMk id="69" creationId="{F623A4F5-3949-CAB2-FD35-C6479E21BA34}"/>
          </ac:cxnSpMkLst>
        </pc:cxnChg>
        <pc:cxnChg chg="mod">
          <ac:chgData name="Kumar, Vinod" userId="a0710a6e-bffc-4971-8893-1c23addeb5b0" providerId="ADAL" clId="{AD4E4DE1-9CB1-4771-A235-1540E1ED3060}" dt="2023-01-06T15:09:00.591" v="4355"/>
          <ac:cxnSpMkLst>
            <pc:docMk/>
            <pc:sldMk cId="2045324388" sldId="317"/>
            <ac:cxnSpMk id="78" creationId="{0EEB6864-C769-FC0A-092B-1CD2DD869D62}"/>
          </ac:cxnSpMkLst>
        </pc:cxnChg>
      </pc:sldChg>
      <pc:sldChg chg="addSp delSp modSp add mod">
        <pc:chgData name="Kumar, Vinod" userId="a0710a6e-bffc-4971-8893-1c23addeb5b0" providerId="ADAL" clId="{AD4E4DE1-9CB1-4771-A235-1540E1ED3060}" dt="2023-01-06T23:15:54.136" v="8115" actId="114"/>
        <pc:sldMkLst>
          <pc:docMk/>
          <pc:sldMk cId="2245635649" sldId="318"/>
        </pc:sldMkLst>
        <pc:spChg chg="mod">
          <ac:chgData name="Kumar, Vinod" userId="a0710a6e-bffc-4971-8893-1c23addeb5b0" providerId="ADAL" clId="{AD4E4DE1-9CB1-4771-A235-1540E1ED3060}" dt="2023-01-06T20:31:32.438" v="7669" actId="1037"/>
          <ac:spMkLst>
            <pc:docMk/>
            <pc:sldMk cId="2245635649" sldId="318"/>
            <ac:spMk id="2" creationId="{086F389C-2B07-5F00-EA2A-17A9729D565C}"/>
          </ac:spMkLst>
        </pc:spChg>
        <pc:spChg chg="mod">
          <ac:chgData name="Kumar, Vinod" userId="a0710a6e-bffc-4971-8893-1c23addeb5b0" providerId="ADAL" clId="{AD4E4DE1-9CB1-4771-A235-1540E1ED3060}" dt="2023-01-06T20:32:46.830" v="7768" actId="1076"/>
          <ac:spMkLst>
            <pc:docMk/>
            <pc:sldMk cId="2245635649" sldId="318"/>
            <ac:spMk id="4" creationId="{807DDF8D-DD5A-C886-628E-44F7532EA59A}"/>
          </ac:spMkLst>
        </pc:spChg>
        <pc:spChg chg="mod">
          <ac:chgData name="Kumar, Vinod" userId="a0710a6e-bffc-4971-8893-1c23addeb5b0" providerId="ADAL" clId="{AD4E4DE1-9CB1-4771-A235-1540E1ED3060}" dt="2023-01-06T20:32:50.661" v="7770" actId="14100"/>
          <ac:spMkLst>
            <pc:docMk/>
            <pc:sldMk cId="2245635649" sldId="318"/>
            <ac:spMk id="5" creationId="{29C8CD6C-A351-73DF-B87D-E3F61C730E27}"/>
          </ac:spMkLst>
        </pc:spChg>
        <pc:spChg chg="add mod">
          <ac:chgData name="Kumar, Vinod" userId="a0710a6e-bffc-4971-8893-1c23addeb5b0" providerId="ADAL" clId="{AD4E4DE1-9CB1-4771-A235-1540E1ED3060}" dt="2023-01-06T20:23:27.132" v="7497" actId="1035"/>
          <ac:spMkLst>
            <pc:docMk/>
            <pc:sldMk cId="2245635649" sldId="318"/>
            <ac:spMk id="7" creationId="{CA245E9C-2D8C-31E6-8171-359297E8C881}"/>
          </ac:spMkLst>
        </pc:spChg>
        <pc:spChg chg="add mod">
          <ac:chgData name="Kumar, Vinod" userId="a0710a6e-bffc-4971-8893-1c23addeb5b0" providerId="ADAL" clId="{AD4E4DE1-9CB1-4771-A235-1540E1ED3060}" dt="2023-01-06T20:23:27.132" v="7497" actId="1035"/>
          <ac:spMkLst>
            <pc:docMk/>
            <pc:sldMk cId="2245635649" sldId="318"/>
            <ac:spMk id="9" creationId="{BB09CE7D-0741-C326-B30F-1DC7AE58ED2F}"/>
          </ac:spMkLst>
        </pc:spChg>
        <pc:spChg chg="add mod">
          <ac:chgData name="Kumar, Vinod" userId="a0710a6e-bffc-4971-8893-1c23addeb5b0" providerId="ADAL" clId="{AD4E4DE1-9CB1-4771-A235-1540E1ED3060}" dt="2023-01-06T20:23:27.132" v="7497" actId="1035"/>
          <ac:spMkLst>
            <pc:docMk/>
            <pc:sldMk cId="2245635649" sldId="318"/>
            <ac:spMk id="11" creationId="{F1D6877B-352A-2260-0F6D-246D6666FE5D}"/>
          </ac:spMkLst>
        </pc:spChg>
        <pc:spChg chg="add mod">
          <ac:chgData name="Kumar, Vinod" userId="a0710a6e-bffc-4971-8893-1c23addeb5b0" providerId="ADAL" clId="{AD4E4DE1-9CB1-4771-A235-1540E1ED3060}" dt="2023-01-06T20:31:00.368" v="7661" actId="1076"/>
          <ac:spMkLst>
            <pc:docMk/>
            <pc:sldMk cId="2245635649" sldId="318"/>
            <ac:spMk id="14" creationId="{1B100470-407D-FB8C-FE76-0FF21F5ED1D6}"/>
          </ac:spMkLst>
        </pc:spChg>
        <pc:spChg chg="add mod">
          <ac:chgData name="Kumar, Vinod" userId="a0710a6e-bffc-4971-8893-1c23addeb5b0" providerId="ADAL" clId="{AD4E4DE1-9CB1-4771-A235-1540E1ED3060}" dt="2023-01-06T20:25:38.746" v="7569" actId="1076"/>
          <ac:spMkLst>
            <pc:docMk/>
            <pc:sldMk cId="2245635649" sldId="318"/>
            <ac:spMk id="21" creationId="{8D601254-1CAF-0C62-398B-8430CEE2C3E0}"/>
          </ac:spMkLst>
        </pc:spChg>
        <pc:spChg chg="mod topLvl">
          <ac:chgData name="Kumar, Vinod" userId="a0710a6e-bffc-4971-8893-1c23addeb5b0" providerId="ADAL" clId="{AD4E4DE1-9CB1-4771-A235-1540E1ED3060}" dt="2023-01-06T20:23:27.132" v="7497" actId="1035"/>
          <ac:spMkLst>
            <pc:docMk/>
            <pc:sldMk cId="2245635649" sldId="318"/>
            <ac:spMk id="24" creationId="{2CB71B04-41F5-163C-2C79-A3B7B287BD9C}"/>
          </ac:spMkLst>
        </pc:spChg>
        <pc:spChg chg="mod topLvl">
          <ac:chgData name="Kumar, Vinod" userId="a0710a6e-bffc-4971-8893-1c23addeb5b0" providerId="ADAL" clId="{AD4E4DE1-9CB1-4771-A235-1540E1ED3060}" dt="2023-01-06T20:23:27.132" v="7497" actId="1035"/>
          <ac:spMkLst>
            <pc:docMk/>
            <pc:sldMk cId="2245635649" sldId="318"/>
            <ac:spMk id="27" creationId="{45B27FF7-15E8-87DE-69F0-B6032DD8E302}"/>
          </ac:spMkLst>
        </pc:spChg>
        <pc:spChg chg="add mod">
          <ac:chgData name="Kumar, Vinod" userId="a0710a6e-bffc-4971-8893-1c23addeb5b0" providerId="ADAL" clId="{AD4E4DE1-9CB1-4771-A235-1540E1ED3060}" dt="2023-01-06T23:15:54.136" v="8115" actId="114"/>
          <ac:spMkLst>
            <pc:docMk/>
            <pc:sldMk cId="2245635649" sldId="318"/>
            <ac:spMk id="34" creationId="{A40DE553-6E10-0460-7D7D-46ACDCD58D3F}"/>
          </ac:spMkLst>
        </pc:spChg>
        <pc:spChg chg="del mod topLvl">
          <ac:chgData name="Kumar, Vinod" userId="a0710a6e-bffc-4971-8893-1c23addeb5b0" providerId="ADAL" clId="{AD4E4DE1-9CB1-4771-A235-1540E1ED3060}" dt="2023-01-06T20:31:06.984" v="7662" actId="478"/>
          <ac:spMkLst>
            <pc:docMk/>
            <pc:sldMk cId="2245635649" sldId="318"/>
            <ac:spMk id="41" creationId="{FF041B5A-AC96-6684-B97B-AACC3ADADF71}"/>
          </ac:spMkLst>
        </pc:spChg>
        <pc:spChg chg="del mod topLvl">
          <ac:chgData name="Kumar, Vinod" userId="a0710a6e-bffc-4971-8893-1c23addeb5b0" providerId="ADAL" clId="{AD4E4DE1-9CB1-4771-A235-1540E1ED3060}" dt="2023-01-06T20:31:06.984" v="7662" actId="478"/>
          <ac:spMkLst>
            <pc:docMk/>
            <pc:sldMk cId="2245635649" sldId="318"/>
            <ac:spMk id="42" creationId="{3A90473B-3AE2-DC5A-E5F2-12B00695F4D0}"/>
          </ac:spMkLst>
        </pc:spChg>
        <pc:spChg chg="del mod topLvl">
          <ac:chgData name="Kumar, Vinod" userId="a0710a6e-bffc-4971-8893-1c23addeb5b0" providerId="ADAL" clId="{AD4E4DE1-9CB1-4771-A235-1540E1ED3060}" dt="2023-01-06T20:31:06.984" v="7662" actId="478"/>
          <ac:spMkLst>
            <pc:docMk/>
            <pc:sldMk cId="2245635649" sldId="318"/>
            <ac:spMk id="43" creationId="{197D153D-C44B-1157-3C8D-A75FBF9AE835}"/>
          </ac:spMkLst>
        </pc:spChg>
        <pc:spChg chg="add mod">
          <ac:chgData name="Kumar, Vinod" userId="a0710a6e-bffc-4971-8893-1c23addeb5b0" providerId="ADAL" clId="{AD4E4DE1-9CB1-4771-A235-1540E1ED3060}" dt="2023-01-06T20:23:27.132" v="7497" actId="1035"/>
          <ac:spMkLst>
            <pc:docMk/>
            <pc:sldMk cId="2245635649" sldId="318"/>
            <ac:spMk id="48" creationId="{9C0A8C2F-F8D9-CDC4-90DB-A853D6A6D490}"/>
          </ac:spMkLst>
        </pc:spChg>
        <pc:spChg chg="add mod">
          <ac:chgData name="Kumar, Vinod" userId="a0710a6e-bffc-4971-8893-1c23addeb5b0" providerId="ADAL" clId="{AD4E4DE1-9CB1-4771-A235-1540E1ED3060}" dt="2023-01-06T20:23:27.132" v="7497" actId="1035"/>
          <ac:spMkLst>
            <pc:docMk/>
            <pc:sldMk cId="2245635649" sldId="318"/>
            <ac:spMk id="49" creationId="{4D5C34F6-7B32-C42F-9835-65C4AEB72979}"/>
          </ac:spMkLst>
        </pc:spChg>
        <pc:spChg chg="add mod">
          <ac:chgData name="Kumar, Vinod" userId="a0710a6e-bffc-4971-8893-1c23addeb5b0" providerId="ADAL" clId="{AD4E4DE1-9CB1-4771-A235-1540E1ED3060}" dt="2023-01-06T20:23:27.132" v="7497" actId="1035"/>
          <ac:spMkLst>
            <pc:docMk/>
            <pc:sldMk cId="2245635649" sldId="318"/>
            <ac:spMk id="50" creationId="{D2DAD5DD-CE35-E82A-55C0-A56182096E73}"/>
          </ac:spMkLst>
        </pc:spChg>
        <pc:spChg chg="add mod">
          <ac:chgData name="Kumar, Vinod" userId="a0710a6e-bffc-4971-8893-1c23addeb5b0" providerId="ADAL" clId="{AD4E4DE1-9CB1-4771-A235-1540E1ED3060}" dt="2023-01-06T20:31:53.014" v="7688" actId="1035"/>
          <ac:spMkLst>
            <pc:docMk/>
            <pc:sldMk cId="2245635649" sldId="318"/>
            <ac:spMk id="55" creationId="{2D60AFF9-F775-763C-C2B6-E8AB7D8FACA5}"/>
          </ac:spMkLst>
        </pc:spChg>
        <pc:spChg chg="add mod">
          <ac:chgData name="Kumar, Vinod" userId="a0710a6e-bffc-4971-8893-1c23addeb5b0" providerId="ADAL" clId="{AD4E4DE1-9CB1-4771-A235-1540E1ED3060}" dt="2023-01-06T20:32:19.912" v="7697" actId="1076"/>
          <ac:spMkLst>
            <pc:docMk/>
            <pc:sldMk cId="2245635649" sldId="318"/>
            <ac:spMk id="56" creationId="{ABA256FF-FF80-1424-2C8A-024D97CA5E11}"/>
          </ac:spMkLst>
        </pc:spChg>
        <pc:spChg chg="add mod">
          <ac:chgData name="Kumar, Vinod" userId="a0710a6e-bffc-4971-8893-1c23addeb5b0" providerId="ADAL" clId="{AD4E4DE1-9CB1-4771-A235-1540E1ED3060}" dt="2023-01-06T20:32:42.615" v="7767" actId="20577"/>
          <ac:spMkLst>
            <pc:docMk/>
            <pc:sldMk cId="2245635649" sldId="318"/>
            <ac:spMk id="57" creationId="{7EAF74B5-4114-AE6D-87DB-84F7280CD5BB}"/>
          </ac:spMkLst>
        </pc:spChg>
        <pc:grpChg chg="add del mod">
          <ac:chgData name="Kumar, Vinod" userId="a0710a6e-bffc-4971-8893-1c23addeb5b0" providerId="ADAL" clId="{AD4E4DE1-9CB1-4771-A235-1540E1ED3060}" dt="2023-01-06T20:16:52.284" v="7210" actId="165"/>
          <ac:grpSpMkLst>
            <pc:docMk/>
            <pc:sldMk cId="2245635649" sldId="318"/>
            <ac:grpSpMk id="22" creationId="{1259A59D-90AD-C9BC-4510-B499AB713F68}"/>
          </ac:grpSpMkLst>
        </pc:grpChg>
        <pc:grpChg chg="add del mod">
          <ac:chgData name="Kumar, Vinod" userId="a0710a6e-bffc-4971-8893-1c23addeb5b0" providerId="ADAL" clId="{AD4E4DE1-9CB1-4771-A235-1540E1ED3060}" dt="2023-01-06T20:19:02.491" v="7304" actId="165"/>
          <ac:grpSpMkLst>
            <pc:docMk/>
            <pc:sldMk cId="2245635649" sldId="318"/>
            <ac:grpSpMk id="25" creationId="{95BB48CA-D5B6-8E63-1455-2969A30EC744}"/>
          </ac:grpSpMkLst>
        </pc:grpChg>
        <pc:grpChg chg="add mod">
          <ac:chgData name="Kumar, Vinod" userId="a0710a6e-bffc-4971-8893-1c23addeb5b0" providerId="ADAL" clId="{AD4E4DE1-9CB1-4771-A235-1540E1ED3060}" dt="2023-01-06T20:29:45.704" v="7638" actId="1036"/>
          <ac:grpSpMkLst>
            <pc:docMk/>
            <pc:sldMk cId="2245635649" sldId="318"/>
            <ac:grpSpMk id="35" creationId="{65FAC313-7570-42BD-7CB6-A83AFBCF6B48}"/>
          </ac:grpSpMkLst>
        </pc:grpChg>
        <pc:grpChg chg="add del mod">
          <ac:chgData name="Kumar, Vinod" userId="a0710a6e-bffc-4971-8893-1c23addeb5b0" providerId="ADAL" clId="{AD4E4DE1-9CB1-4771-A235-1540E1ED3060}" dt="2023-01-06T20:19:14.211" v="7305" actId="165"/>
          <ac:grpSpMkLst>
            <pc:docMk/>
            <pc:sldMk cId="2245635649" sldId="318"/>
            <ac:grpSpMk id="38" creationId="{12E09C72-F81F-46D5-4BF4-56AFF181630E}"/>
          </ac:grpSpMkLst>
        </pc:grpChg>
        <pc:picChg chg="del mod">
          <ac:chgData name="Kumar, Vinod" userId="a0710a6e-bffc-4971-8893-1c23addeb5b0" providerId="ADAL" clId="{AD4E4DE1-9CB1-4771-A235-1540E1ED3060}" dt="2023-01-06T20:28:28.521" v="7599" actId="478"/>
          <ac:picMkLst>
            <pc:docMk/>
            <pc:sldMk cId="2245635649" sldId="318"/>
            <ac:picMk id="3" creationId="{490D06AC-BA4C-E2D3-CA27-A10AF7D09D40}"/>
          </ac:picMkLst>
        </pc:picChg>
        <pc:picChg chg="add mod">
          <ac:chgData name="Kumar, Vinod" userId="a0710a6e-bffc-4971-8893-1c23addeb5b0" providerId="ADAL" clId="{AD4E4DE1-9CB1-4771-A235-1540E1ED3060}" dt="2023-01-06T20:23:27.132" v="7497" actId="1035"/>
          <ac:picMkLst>
            <pc:docMk/>
            <pc:sldMk cId="2245635649" sldId="318"/>
            <ac:picMk id="6" creationId="{597E1871-FDF9-1159-ED4A-45196F831B1A}"/>
          </ac:picMkLst>
        </pc:picChg>
        <pc:picChg chg="add mod">
          <ac:chgData name="Kumar, Vinod" userId="a0710a6e-bffc-4971-8893-1c23addeb5b0" providerId="ADAL" clId="{AD4E4DE1-9CB1-4771-A235-1540E1ED3060}" dt="2023-01-06T20:23:27.132" v="7497" actId="1035"/>
          <ac:picMkLst>
            <pc:docMk/>
            <pc:sldMk cId="2245635649" sldId="318"/>
            <ac:picMk id="10" creationId="{27FE0B6C-4D51-6251-5956-EDC065D200A4}"/>
          </ac:picMkLst>
        </pc:picChg>
        <pc:picChg chg="add mod">
          <ac:chgData name="Kumar, Vinod" userId="a0710a6e-bffc-4971-8893-1c23addeb5b0" providerId="ADAL" clId="{AD4E4DE1-9CB1-4771-A235-1540E1ED3060}" dt="2023-01-06T20:29:09.577" v="7628" actId="1076"/>
          <ac:picMkLst>
            <pc:docMk/>
            <pc:sldMk cId="2245635649" sldId="318"/>
            <ac:picMk id="13" creationId="{2E681331-78BB-750C-D0C0-74379A16FE2B}"/>
          </ac:picMkLst>
        </pc:picChg>
        <pc:picChg chg="add mod">
          <ac:chgData name="Kumar, Vinod" userId="a0710a6e-bffc-4971-8893-1c23addeb5b0" providerId="ADAL" clId="{AD4E4DE1-9CB1-4771-A235-1540E1ED3060}" dt="2023-01-06T20:25:23.803" v="7567" actId="1035"/>
          <ac:picMkLst>
            <pc:docMk/>
            <pc:sldMk cId="2245635649" sldId="318"/>
            <ac:picMk id="15" creationId="{0BD94F79-FBE3-F18B-B6B4-093351AD5D5E}"/>
          </ac:picMkLst>
        </pc:picChg>
        <pc:picChg chg="add mod">
          <ac:chgData name="Kumar, Vinod" userId="a0710a6e-bffc-4971-8893-1c23addeb5b0" providerId="ADAL" clId="{AD4E4DE1-9CB1-4771-A235-1540E1ED3060}" dt="2023-01-06T20:05:18.867" v="6892" actId="164"/>
          <ac:picMkLst>
            <pc:docMk/>
            <pc:sldMk cId="2245635649" sldId="318"/>
            <ac:picMk id="17" creationId="{0F3852E0-AB7D-59E7-BAFB-95F1BE7D7AA6}"/>
          </ac:picMkLst>
        </pc:picChg>
        <pc:picChg chg="add mod">
          <ac:chgData name="Kumar, Vinod" userId="a0710a6e-bffc-4971-8893-1c23addeb5b0" providerId="ADAL" clId="{AD4E4DE1-9CB1-4771-A235-1540E1ED3060}" dt="2023-01-06T20:05:18.867" v="6892" actId="164"/>
          <ac:picMkLst>
            <pc:docMk/>
            <pc:sldMk cId="2245635649" sldId="318"/>
            <ac:picMk id="18" creationId="{CA143F4E-07C9-38BF-2DD1-CFCEAF69139D}"/>
          </ac:picMkLst>
        </pc:picChg>
        <pc:picChg chg="add mod">
          <ac:chgData name="Kumar, Vinod" userId="a0710a6e-bffc-4971-8893-1c23addeb5b0" providerId="ADAL" clId="{AD4E4DE1-9CB1-4771-A235-1540E1ED3060}" dt="2023-01-06T20:05:18.867" v="6892" actId="164"/>
          <ac:picMkLst>
            <pc:docMk/>
            <pc:sldMk cId="2245635649" sldId="318"/>
            <ac:picMk id="19" creationId="{A03E6792-DE93-2013-CC81-60CF2510F28B}"/>
          </ac:picMkLst>
        </pc:picChg>
        <pc:picChg chg="add del mod">
          <ac:chgData name="Kumar, Vinod" userId="a0710a6e-bffc-4971-8893-1c23addeb5b0" providerId="ADAL" clId="{AD4E4DE1-9CB1-4771-A235-1540E1ED3060}" dt="2023-01-06T20:25:14.538" v="7565" actId="478"/>
          <ac:picMkLst>
            <pc:docMk/>
            <pc:sldMk cId="2245635649" sldId="318"/>
            <ac:picMk id="20" creationId="{BE883CF3-E884-CCA7-641B-904FB9BD15CD}"/>
          </ac:picMkLst>
        </pc:picChg>
        <pc:picChg chg="del mod topLvl">
          <ac:chgData name="Kumar, Vinod" userId="a0710a6e-bffc-4971-8893-1c23addeb5b0" providerId="ADAL" clId="{AD4E4DE1-9CB1-4771-A235-1540E1ED3060}" dt="2023-01-06T20:16:54.686" v="7211" actId="478"/>
          <ac:picMkLst>
            <pc:docMk/>
            <pc:sldMk cId="2245635649" sldId="318"/>
            <ac:picMk id="23" creationId="{327EA904-5D8B-09C5-8D83-1FBDA36B166A}"/>
          </ac:picMkLst>
        </pc:picChg>
        <pc:picChg chg="mod topLvl">
          <ac:chgData name="Kumar, Vinod" userId="a0710a6e-bffc-4971-8893-1c23addeb5b0" providerId="ADAL" clId="{AD4E4DE1-9CB1-4771-A235-1540E1ED3060}" dt="2023-01-06T20:23:27.132" v="7497" actId="1035"/>
          <ac:picMkLst>
            <pc:docMk/>
            <pc:sldMk cId="2245635649" sldId="318"/>
            <ac:picMk id="26" creationId="{49CEA3E8-0B46-054A-907F-8D68EEF930AF}"/>
          </ac:picMkLst>
        </pc:picChg>
        <pc:picChg chg="del mod topLvl">
          <ac:chgData name="Kumar, Vinod" userId="a0710a6e-bffc-4971-8893-1c23addeb5b0" providerId="ADAL" clId="{AD4E4DE1-9CB1-4771-A235-1540E1ED3060}" dt="2023-01-06T20:31:06.984" v="7662" actId="478"/>
          <ac:picMkLst>
            <pc:docMk/>
            <pc:sldMk cId="2245635649" sldId="318"/>
            <ac:picMk id="39" creationId="{DEEF2231-3145-60A4-B8D3-1CD5F54C77E6}"/>
          </ac:picMkLst>
        </pc:picChg>
        <pc:picChg chg="del mod topLvl">
          <ac:chgData name="Kumar, Vinod" userId="a0710a6e-bffc-4971-8893-1c23addeb5b0" providerId="ADAL" clId="{AD4E4DE1-9CB1-4771-A235-1540E1ED3060}" dt="2023-01-06T20:31:06.984" v="7662" actId="478"/>
          <ac:picMkLst>
            <pc:docMk/>
            <pc:sldMk cId="2245635649" sldId="318"/>
            <ac:picMk id="40" creationId="{3713F0E2-E517-A63A-C9A9-D67FE696AC52}"/>
          </ac:picMkLst>
        </pc:picChg>
        <pc:picChg chg="add del mod">
          <ac:chgData name="Kumar, Vinod" userId="a0710a6e-bffc-4971-8893-1c23addeb5b0" providerId="ADAL" clId="{AD4E4DE1-9CB1-4771-A235-1540E1ED3060}" dt="2023-01-06T20:21:18.637" v="7427" actId="478"/>
          <ac:picMkLst>
            <pc:docMk/>
            <pc:sldMk cId="2245635649" sldId="318"/>
            <ac:picMk id="44" creationId="{5B09119B-E1B1-8E4D-1EF2-17D05408D283}"/>
          </ac:picMkLst>
        </pc:picChg>
        <pc:picChg chg="add del mod">
          <ac:chgData name="Kumar, Vinod" userId="a0710a6e-bffc-4971-8893-1c23addeb5b0" providerId="ADAL" clId="{AD4E4DE1-9CB1-4771-A235-1540E1ED3060}" dt="2023-01-06T20:21:18.637" v="7427" actId="478"/>
          <ac:picMkLst>
            <pc:docMk/>
            <pc:sldMk cId="2245635649" sldId="318"/>
            <ac:picMk id="45" creationId="{B56B2174-CDD2-9688-B879-5CB20BE8D672}"/>
          </ac:picMkLst>
        </pc:picChg>
        <pc:picChg chg="add mod">
          <ac:chgData name="Kumar, Vinod" userId="a0710a6e-bffc-4971-8893-1c23addeb5b0" providerId="ADAL" clId="{AD4E4DE1-9CB1-4771-A235-1540E1ED3060}" dt="2023-01-06T20:23:27.132" v="7497" actId="1035"/>
          <ac:picMkLst>
            <pc:docMk/>
            <pc:sldMk cId="2245635649" sldId="318"/>
            <ac:picMk id="46" creationId="{77007D5B-7A46-298E-0459-207AB0020D3F}"/>
          </ac:picMkLst>
        </pc:picChg>
        <pc:picChg chg="add mod">
          <ac:chgData name="Kumar, Vinod" userId="a0710a6e-bffc-4971-8893-1c23addeb5b0" providerId="ADAL" clId="{AD4E4DE1-9CB1-4771-A235-1540E1ED3060}" dt="2023-01-06T20:23:27.132" v="7497" actId="1035"/>
          <ac:picMkLst>
            <pc:docMk/>
            <pc:sldMk cId="2245635649" sldId="318"/>
            <ac:picMk id="47" creationId="{B0A8E4C3-F008-9B2A-077E-C0B4E3FC4DBC}"/>
          </ac:picMkLst>
        </pc:picChg>
        <pc:picChg chg="add del mod">
          <ac:chgData name="Kumar, Vinod" userId="a0710a6e-bffc-4971-8893-1c23addeb5b0" providerId="ADAL" clId="{AD4E4DE1-9CB1-4771-A235-1540E1ED3060}" dt="2023-01-06T20:27:39.017" v="7586" actId="478"/>
          <ac:picMkLst>
            <pc:docMk/>
            <pc:sldMk cId="2245635649" sldId="318"/>
            <ac:picMk id="52" creationId="{C6345E38-9B9F-D8B6-ACA2-57DAEC362BB5}"/>
          </ac:picMkLst>
        </pc:picChg>
        <pc:picChg chg="del mod">
          <ac:chgData name="Kumar, Vinod" userId="a0710a6e-bffc-4971-8893-1c23addeb5b0" providerId="ADAL" clId="{AD4E4DE1-9CB1-4771-A235-1540E1ED3060}" dt="2023-01-06T20:28:02.760" v="7592" actId="478"/>
          <ac:picMkLst>
            <pc:docMk/>
            <pc:sldMk cId="2245635649" sldId="318"/>
            <ac:picMk id="53" creationId="{8CCDDD72-F583-8B6F-53F9-3F8E017D19D3}"/>
          </ac:picMkLst>
        </pc:picChg>
        <pc:picChg chg="mod">
          <ac:chgData name="Kumar, Vinod" userId="a0710a6e-bffc-4971-8893-1c23addeb5b0" providerId="ADAL" clId="{AD4E4DE1-9CB1-4771-A235-1540E1ED3060}" dt="2023-01-06T20:30:38.375" v="7653" actId="1035"/>
          <ac:picMkLst>
            <pc:docMk/>
            <pc:sldMk cId="2245635649" sldId="318"/>
            <ac:picMk id="54" creationId="{C00E93A4-7618-F523-3A6A-CBAE49E37107}"/>
          </ac:picMkLst>
        </pc:picChg>
        <pc:cxnChg chg="add mod">
          <ac:chgData name="Kumar, Vinod" userId="a0710a6e-bffc-4971-8893-1c23addeb5b0" providerId="ADAL" clId="{AD4E4DE1-9CB1-4771-A235-1540E1ED3060}" dt="2023-01-06T20:23:27.132" v="7497" actId="1035"/>
          <ac:cxnSpMkLst>
            <pc:docMk/>
            <pc:sldMk cId="2245635649" sldId="318"/>
            <ac:cxnSpMk id="8" creationId="{4F05C120-46F7-8839-8431-93F15877B014}"/>
          </ac:cxnSpMkLst>
        </pc:cxnChg>
        <pc:cxnChg chg="add mod">
          <ac:chgData name="Kumar, Vinod" userId="a0710a6e-bffc-4971-8893-1c23addeb5b0" providerId="ADAL" clId="{AD4E4DE1-9CB1-4771-A235-1540E1ED3060}" dt="2023-01-06T20:23:44.971" v="7525" actId="1035"/>
          <ac:cxnSpMkLst>
            <pc:docMk/>
            <pc:sldMk cId="2245635649" sldId="318"/>
            <ac:cxnSpMk id="12" creationId="{51F9F63A-0D44-641C-CF9A-582577C69D78}"/>
          </ac:cxnSpMkLst>
        </pc:cxnChg>
        <pc:cxnChg chg="add mod">
          <ac:chgData name="Kumar, Vinod" userId="a0710a6e-bffc-4971-8893-1c23addeb5b0" providerId="ADAL" clId="{AD4E4DE1-9CB1-4771-A235-1540E1ED3060}" dt="2023-01-06T20:24:56.740" v="7561" actId="14100"/>
          <ac:cxnSpMkLst>
            <pc:docMk/>
            <pc:sldMk cId="2245635649" sldId="318"/>
            <ac:cxnSpMk id="16" creationId="{1AB5994F-8240-C142-ABBF-2EE0CB36AF00}"/>
          </ac:cxnSpMkLst>
        </pc:cxnChg>
        <pc:cxnChg chg="add del mod">
          <ac:chgData name="Kumar, Vinod" userId="a0710a6e-bffc-4971-8893-1c23addeb5b0" providerId="ADAL" clId="{AD4E4DE1-9CB1-4771-A235-1540E1ED3060}" dt="2023-01-06T20:22:28.140" v="7464" actId="478"/>
          <ac:cxnSpMkLst>
            <pc:docMk/>
            <pc:sldMk cId="2245635649" sldId="318"/>
            <ac:cxnSpMk id="28" creationId="{927B9F69-6D0D-6AF4-B752-29E79841B748}"/>
          </ac:cxnSpMkLst>
        </pc:cxnChg>
        <pc:cxnChg chg="add mod">
          <ac:chgData name="Kumar, Vinod" userId="a0710a6e-bffc-4971-8893-1c23addeb5b0" providerId="ADAL" clId="{AD4E4DE1-9CB1-4771-A235-1540E1ED3060}" dt="2023-01-06T20:29:42.472" v="7637" actId="1037"/>
          <ac:cxnSpMkLst>
            <pc:docMk/>
            <pc:sldMk cId="2245635649" sldId="318"/>
            <ac:cxnSpMk id="29" creationId="{63B977F3-2651-247C-28DF-E66C2736020A}"/>
          </ac:cxnSpMkLst>
        </pc:cxnChg>
        <pc:cxnChg chg="add mod">
          <ac:chgData name="Kumar, Vinod" userId="a0710a6e-bffc-4971-8893-1c23addeb5b0" providerId="ADAL" clId="{AD4E4DE1-9CB1-4771-A235-1540E1ED3060}" dt="2023-01-06T20:05:18.867" v="6892" actId="164"/>
          <ac:cxnSpMkLst>
            <pc:docMk/>
            <pc:sldMk cId="2245635649" sldId="318"/>
            <ac:cxnSpMk id="30" creationId="{6CBB6900-D899-09B2-FCCF-72210F142D8D}"/>
          </ac:cxnSpMkLst>
        </pc:cxnChg>
        <pc:cxnChg chg="add mod">
          <ac:chgData name="Kumar, Vinod" userId="a0710a6e-bffc-4971-8893-1c23addeb5b0" providerId="ADAL" clId="{AD4E4DE1-9CB1-4771-A235-1540E1ED3060}" dt="2023-01-06T20:05:18.867" v="6892" actId="164"/>
          <ac:cxnSpMkLst>
            <pc:docMk/>
            <pc:sldMk cId="2245635649" sldId="318"/>
            <ac:cxnSpMk id="31" creationId="{61A67C30-0605-F90C-1C39-4941EF1BEEFD}"/>
          </ac:cxnSpMkLst>
        </pc:cxnChg>
        <pc:cxnChg chg="add mod">
          <ac:chgData name="Kumar, Vinod" userId="a0710a6e-bffc-4971-8893-1c23addeb5b0" providerId="ADAL" clId="{AD4E4DE1-9CB1-4771-A235-1540E1ED3060}" dt="2023-01-06T20:25:07.915" v="7564" actId="1037"/>
          <ac:cxnSpMkLst>
            <pc:docMk/>
            <pc:sldMk cId="2245635649" sldId="318"/>
            <ac:cxnSpMk id="32" creationId="{980201EC-C7B6-4D48-77DE-1718119440E3}"/>
          </ac:cxnSpMkLst>
        </pc:cxnChg>
        <pc:cxnChg chg="add del mod">
          <ac:chgData name="Kumar, Vinod" userId="a0710a6e-bffc-4971-8893-1c23addeb5b0" providerId="ADAL" clId="{AD4E4DE1-9CB1-4771-A235-1540E1ED3060}" dt="2023-01-06T20:24:49.259" v="7555" actId="478"/>
          <ac:cxnSpMkLst>
            <pc:docMk/>
            <pc:sldMk cId="2245635649" sldId="318"/>
            <ac:cxnSpMk id="33" creationId="{B7100169-1505-CFB6-9CA3-97ACC88819AC}"/>
          </ac:cxnSpMkLst>
        </pc:cxnChg>
        <pc:cxnChg chg="add mod">
          <ac:chgData name="Kumar, Vinod" userId="a0710a6e-bffc-4971-8893-1c23addeb5b0" providerId="ADAL" clId="{AD4E4DE1-9CB1-4771-A235-1540E1ED3060}" dt="2023-01-06T20:23:27.132" v="7497" actId="1035"/>
          <ac:cxnSpMkLst>
            <pc:docMk/>
            <pc:sldMk cId="2245635649" sldId="318"/>
            <ac:cxnSpMk id="36" creationId="{25213125-5BFF-4858-A1CD-9F7F9A11C309}"/>
          </ac:cxnSpMkLst>
        </pc:cxnChg>
        <pc:cxnChg chg="add del mod">
          <ac:chgData name="Kumar, Vinod" userId="a0710a6e-bffc-4971-8893-1c23addeb5b0" providerId="ADAL" clId="{AD4E4DE1-9CB1-4771-A235-1540E1ED3060}" dt="2023-01-06T20:22:39.308" v="7466" actId="478"/>
          <ac:cxnSpMkLst>
            <pc:docMk/>
            <pc:sldMk cId="2245635649" sldId="318"/>
            <ac:cxnSpMk id="37" creationId="{1F178ED6-EAFF-E9A4-C940-76056B025961}"/>
          </ac:cxnSpMkLst>
        </pc:cxnChg>
        <pc:cxnChg chg="add mod">
          <ac:chgData name="Kumar, Vinod" userId="a0710a6e-bffc-4971-8893-1c23addeb5b0" providerId="ADAL" clId="{AD4E4DE1-9CB1-4771-A235-1540E1ED3060}" dt="2023-01-06T20:29:24.656" v="7632" actId="1076"/>
          <ac:cxnSpMkLst>
            <pc:docMk/>
            <pc:sldMk cId="2245635649" sldId="318"/>
            <ac:cxnSpMk id="51" creationId="{95ADDECB-32DA-AF4B-CF9C-1662745A536A}"/>
          </ac:cxnSpMkLst>
        </pc:cxnChg>
      </pc:sldChg>
      <pc:sldChg chg="addSp delSp modSp add mod">
        <pc:chgData name="Kumar, Vinod" userId="a0710a6e-bffc-4971-8893-1c23addeb5b0" providerId="ADAL" clId="{AD4E4DE1-9CB1-4771-A235-1540E1ED3060}" dt="2023-01-06T22:15:28.115" v="8114" actId="1036"/>
        <pc:sldMkLst>
          <pc:docMk/>
          <pc:sldMk cId="1412134880" sldId="319"/>
        </pc:sldMkLst>
        <pc:spChg chg="add mod">
          <ac:chgData name="Kumar, Vinod" userId="a0710a6e-bffc-4971-8893-1c23addeb5b0" providerId="ADAL" clId="{AD4E4DE1-9CB1-4771-A235-1540E1ED3060}" dt="2023-01-06T22:15:21.556" v="8108" actId="1038"/>
          <ac:spMkLst>
            <pc:docMk/>
            <pc:sldMk cId="1412134880" sldId="319"/>
            <ac:spMk id="2" creationId="{9C3F447A-BA77-912B-8E78-44F98688ECE7}"/>
          </ac:spMkLst>
        </pc:spChg>
        <pc:spChg chg="del">
          <ac:chgData name="Kumar, Vinod" userId="a0710a6e-bffc-4971-8893-1c23addeb5b0" providerId="ADAL" clId="{AD4E4DE1-9CB1-4771-A235-1540E1ED3060}" dt="2023-01-06T22:15:17.108" v="8100" actId="478"/>
          <ac:spMkLst>
            <pc:docMk/>
            <pc:sldMk cId="1412134880" sldId="319"/>
            <ac:spMk id="88" creationId="{CAC2C618-7D71-1724-06E7-9F8AD47F396F}"/>
          </ac:spMkLst>
        </pc:spChg>
        <pc:picChg chg="mod">
          <ac:chgData name="Kumar, Vinod" userId="a0710a6e-bffc-4971-8893-1c23addeb5b0" providerId="ADAL" clId="{AD4E4DE1-9CB1-4771-A235-1540E1ED3060}" dt="2023-01-06T22:15:01.076" v="8094" actId="1035"/>
          <ac:picMkLst>
            <pc:docMk/>
            <pc:sldMk cId="1412134880" sldId="319"/>
            <ac:picMk id="9" creationId="{300ECDCE-7793-035A-4A52-E598C369621D}"/>
          </ac:picMkLst>
        </pc:picChg>
        <pc:picChg chg="mod modCrop">
          <ac:chgData name="Kumar, Vinod" userId="a0710a6e-bffc-4971-8893-1c23addeb5b0" providerId="ADAL" clId="{AD4E4DE1-9CB1-4771-A235-1540E1ED3060}" dt="2023-01-06T22:15:28.115" v="8114" actId="1036"/>
          <ac:picMkLst>
            <pc:docMk/>
            <pc:sldMk cId="1412134880" sldId="319"/>
            <ac:picMk id="10" creationId="{F694DA6C-4FFF-B896-71AE-D2FE03F46AAF}"/>
          </ac:picMkLst>
        </pc:picChg>
        <pc:picChg chg="mod">
          <ac:chgData name="Kumar, Vinod" userId="a0710a6e-bffc-4971-8893-1c23addeb5b0" providerId="ADAL" clId="{AD4E4DE1-9CB1-4771-A235-1540E1ED3060}" dt="2023-01-06T22:13:49.028" v="8077" actId="1036"/>
          <ac:picMkLst>
            <pc:docMk/>
            <pc:sldMk cId="1412134880" sldId="319"/>
            <ac:picMk id="11" creationId="{825455C6-07A7-ED30-3A78-8B334C2C3A9A}"/>
          </ac:picMkLst>
        </pc:picChg>
        <pc:picChg chg="mod">
          <ac:chgData name="Kumar, Vinod" userId="a0710a6e-bffc-4971-8893-1c23addeb5b0" providerId="ADAL" clId="{AD4E4DE1-9CB1-4771-A235-1540E1ED3060}" dt="2023-01-06T22:14:55.347" v="8089" actId="1035"/>
          <ac:picMkLst>
            <pc:docMk/>
            <pc:sldMk cId="1412134880" sldId="319"/>
            <ac:picMk id="34" creationId="{94187F1D-53CC-E202-F758-BF0BB2346A09}"/>
          </ac:picMkLst>
        </pc:picChg>
      </pc:sldChg>
      <pc:sldChg chg="addSp delSp modSp new del mod">
        <pc:chgData name="Kumar, Vinod" userId="a0710a6e-bffc-4971-8893-1c23addeb5b0" providerId="ADAL" clId="{AD4E4DE1-9CB1-4771-A235-1540E1ED3060}" dt="2023-01-06T20:32:57.204" v="7771" actId="47"/>
        <pc:sldMkLst>
          <pc:docMk/>
          <pc:sldMk cId="1419368654" sldId="319"/>
        </pc:sldMkLst>
        <pc:spChg chg="mod">
          <ac:chgData name="Kumar, Vinod" userId="a0710a6e-bffc-4971-8893-1c23addeb5b0" providerId="ADAL" clId="{AD4E4DE1-9CB1-4771-A235-1540E1ED3060}" dt="2023-01-06T20:11:58.039" v="7105"/>
          <ac:spMkLst>
            <pc:docMk/>
            <pc:sldMk cId="1419368654" sldId="319"/>
            <ac:spMk id="4" creationId="{93A45D43-8D94-7F12-3DC0-99B310C5CCAF}"/>
          </ac:spMkLst>
        </pc:spChg>
        <pc:spChg chg="del mod topLvl">
          <ac:chgData name="Kumar, Vinod" userId="a0710a6e-bffc-4971-8893-1c23addeb5b0" providerId="ADAL" clId="{AD4E4DE1-9CB1-4771-A235-1540E1ED3060}" dt="2023-01-06T20:15:32.176" v="7205" actId="478"/>
          <ac:spMkLst>
            <pc:docMk/>
            <pc:sldMk cId="1419368654" sldId="319"/>
            <ac:spMk id="7" creationId="{8715AD7A-A5E4-04AE-A817-0E09EC1065EE}"/>
          </ac:spMkLst>
        </pc:spChg>
        <pc:spChg chg="del mod topLvl">
          <ac:chgData name="Kumar, Vinod" userId="a0710a6e-bffc-4971-8893-1c23addeb5b0" providerId="ADAL" clId="{AD4E4DE1-9CB1-4771-A235-1540E1ED3060}" dt="2023-01-06T20:12:48.728" v="7119" actId="478"/>
          <ac:spMkLst>
            <pc:docMk/>
            <pc:sldMk cId="1419368654" sldId="319"/>
            <ac:spMk id="10" creationId="{9B6BF7CC-F7CF-9432-62BA-C5E3D951DF20}"/>
          </ac:spMkLst>
        </pc:spChg>
        <pc:spChg chg="add mod">
          <ac:chgData name="Kumar, Vinod" userId="a0710a6e-bffc-4971-8893-1c23addeb5b0" providerId="ADAL" clId="{AD4E4DE1-9CB1-4771-A235-1540E1ED3060}" dt="2023-01-06T20:15:39.770" v="7207" actId="164"/>
          <ac:spMkLst>
            <pc:docMk/>
            <pc:sldMk cId="1419368654" sldId="319"/>
            <ac:spMk id="11" creationId="{A9D859A4-34D4-5959-EDCC-E1591BE4062D}"/>
          </ac:spMkLst>
        </pc:spChg>
        <pc:spChg chg="add del mod">
          <ac:chgData name="Kumar, Vinod" userId="a0710a6e-bffc-4971-8893-1c23addeb5b0" providerId="ADAL" clId="{AD4E4DE1-9CB1-4771-A235-1540E1ED3060}" dt="2023-01-06T20:15:33.520" v="7206" actId="478"/>
          <ac:spMkLst>
            <pc:docMk/>
            <pc:sldMk cId="1419368654" sldId="319"/>
            <ac:spMk id="12" creationId="{73204094-3912-7694-8EB0-5C122BB2C7C0}"/>
          </ac:spMkLst>
        </pc:spChg>
        <pc:spChg chg="add mod">
          <ac:chgData name="Kumar, Vinod" userId="a0710a6e-bffc-4971-8893-1c23addeb5b0" providerId="ADAL" clId="{AD4E4DE1-9CB1-4771-A235-1540E1ED3060}" dt="2023-01-06T20:15:39.770" v="7207" actId="164"/>
          <ac:spMkLst>
            <pc:docMk/>
            <pc:sldMk cId="1419368654" sldId="319"/>
            <ac:spMk id="13" creationId="{9D1196FC-4251-DF63-6181-5905B6D42CBA}"/>
          </ac:spMkLst>
        </pc:spChg>
        <pc:spChg chg="add mod">
          <ac:chgData name="Kumar, Vinod" userId="a0710a6e-bffc-4971-8893-1c23addeb5b0" providerId="ADAL" clId="{AD4E4DE1-9CB1-4771-A235-1540E1ED3060}" dt="2023-01-06T20:15:39.770" v="7207" actId="164"/>
          <ac:spMkLst>
            <pc:docMk/>
            <pc:sldMk cId="1419368654" sldId="319"/>
            <ac:spMk id="14" creationId="{AF38D8DA-620C-4A71-6927-51F6EDD4744B}"/>
          </ac:spMkLst>
        </pc:spChg>
        <pc:grpChg chg="add mod">
          <ac:chgData name="Kumar, Vinod" userId="a0710a6e-bffc-4971-8893-1c23addeb5b0" providerId="ADAL" clId="{AD4E4DE1-9CB1-4771-A235-1540E1ED3060}" dt="2023-01-06T20:12:00.401" v="7107" actId="1076"/>
          <ac:grpSpMkLst>
            <pc:docMk/>
            <pc:sldMk cId="1419368654" sldId="319"/>
            <ac:grpSpMk id="2" creationId="{C2EBB09C-1B86-3C32-60FF-60C9C17D55F8}"/>
          </ac:grpSpMkLst>
        </pc:grpChg>
        <pc:grpChg chg="add del mod">
          <ac:chgData name="Kumar, Vinod" userId="a0710a6e-bffc-4971-8893-1c23addeb5b0" providerId="ADAL" clId="{AD4E4DE1-9CB1-4771-A235-1540E1ED3060}" dt="2023-01-06T20:12:23.991" v="7112" actId="165"/>
          <ac:grpSpMkLst>
            <pc:docMk/>
            <pc:sldMk cId="1419368654" sldId="319"/>
            <ac:grpSpMk id="5" creationId="{46303468-F568-B92A-8536-80F8476BD51A}"/>
          </ac:grpSpMkLst>
        </pc:grpChg>
        <pc:grpChg chg="add del mod">
          <ac:chgData name="Kumar, Vinod" userId="a0710a6e-bffc-4971-8893-1c23addeb5b0" providerId="ADAL" clId="{AD4E4DE1-9CB1-4771-A235-1540E1ED3060}" dt="2023-01-06T20:12:48.728" v="7119" actId="478"/>
          <ac:grpSpMkLst>
            <pc:docMk/>
            <pc:sldMk cId="1419368654" sldId="319"/>
            <ac:grpSpMk id="8" creationId="{F1FDCB61-91CB-567A-2E19-3BC17FDE2A79}"/>
          </ac:grpSpMkLst>
        </pc:grpChg>
        <pc:grpChg chg="add mod">
          <ac:chgData name="Kumar, Vinod" userId="a0710a6e-bffc-4971-8893-1c23addeb5b0" providerId="ADAL" clId="{AD4E4DE1-9CB1-4771-A235-1540E1ED3060}" dt="2023-01-06T20:15:39.770" v="7207" actId="164"/>
          <ac:grpSpMkLst>
            <pc:docMk/>
            <pc:sldMk cId="1419368654" sldId="319"/>
            <ac:grpSpMk id="15" creationId="{24D15263-479E-E0E5-939A-C70C8519922A}"/>
          </ac:grpSpMkLst>
        </pc:grpChg>
        <pc:picChg chg="mod">
          <ac:chgData name="Kumar, Vinod" userId="a0710a6e-bffc-4971-8893-1c23addeb5b0" providerId="ADAL" clId="{AD4E4DE1-9CB1-4771-A235-1540E1ED3060}" dt="2023-01-06T20:11:58.039" v="7105"/>
          <ac:picMkLst>
            <pc:docMk/>
            <pc:sldMk cId="1419368654" sldId="319"/>
            <ac:picMk id="3" creationId="{DE3BAA96-6EA5-113A-E414-305E33345259}"/>
          </ac:picMkLst>
        </pc:picChg>
        <pc:picChg chg="mod topLvl modCrop">
          <ac:chgData name="Kumar, Vinod" userId="a0710a6e-bffc-4971-8893-1c23addeb5b0" providerId="ADAL" clId="{AD4E4DE1-9CB1-4771-A235-1540E1ED3060}" dt="2023-01-06T20:15:39.770" v="7207" actId="164"/>
          <ac:picMkLst>
            <pc:docMk/>
            <pc:sldMk cId="1419368654" sldId="319"/>
            <ac:picMk id="6" creationId="{073C41C1-223D-E928-4A5A-E378AE8A885E}"/>
          </ac:picMkLst>
        </pc:picChg>
        <pc:picChg chg="mod topLvl modCrop">
          <ac:chgData name="Kumar, Vinod" userId="a0710a6e-bffc-4971-8893-1c23addeb5b0" providerId="ADAL" clId="{AD4E4DE1-9CB1-4771-A235-1540E1ED3060}" dt="2023-01-06T20:15:39.770" v="7207" actId="164"/>
          <ac:picMkLst>
            <pc:docMk/>
            <pc:sldMk cId="1419368654" sldId="319"/>
            <ac:picMk id="9" creationId="{3CDDA1D4-B92A-9A40-CDAB-01659CBCBAC9}"/>
          </ac:picMkLst>
        </pc:picChg>
      </pc:sldChg>
    </pc:docChg>
  </pc:docChgLst>
  <pc:docChgLst>
    <pc:chgData name="Kumar, Vinod" userId="a0710a6e-bffc-4971-8893-1c23addeb5b0" providerId="ADAL" clId="{A867779D-3C18-41E4-A938-BAAB7B3A31EE}"/>
    <pc:docChg chg="undo custSel addSld delSld modSld">
      <pc:chgData name="Kumar, Vinod" userId="a0710a6e-bffc-4971-8893-1c23addeb5b0" providerId="ADAL" clId="{A867779D-3C18-41E4-A938-BAAB7B3A31EE}" dt="2023-04-06T19:37:47.462" v="1439" actId="1076"/>
      <pc:docMkLst>
        <pc:docMk/>
      </pc:docMkLst>
      <pc:sldChg chg="del">
        <pc:chgData name="Kumar, Vinod" userId="a0710a6e-bffc-4971-8893-1c23addeb5b0" providerId="ADAL" clId="{A867779D-3C18-41E4-A938-BAAB7B3A31EE}" dt="2023-02-14T16:00:01.300" v="918" actId="47"/>
        <pc:sldMkLst>
          <pc:docMk/>
          <pc:sldMk cId="3704016793" sldId="327"/>
        </pc:sldMkLst>
      </pc:sldChg>
      <pc:sldChg chg="addSp delSp modSp mod">
        <pc:chgData name="Kumar, Vinod" userId="a0710a6e-bffc-4971-8893-1c23addeb5b0" providerId="ADAL" clId="{A867779D-3C18-41E4-A938-BAAB7B3A31EE}" dt="2023-03-23T19:33:50.133" v="1242" actId="164"/>
        <pc:sldMkLst>
          <pc:docMk/>
          <pc:sldMk cId="3312243808" sldId="328"/>
        </pc:sldMkLst>
        <pc:spChg chg="mod topLvl">
          <ac:chgData name="Kumar, Vinod" userId="a0710a6e-bffc-4971-8893-1c23addeb5b0" providerId="ADAL" clId="{A867779D-3C18-41E4-A938-BAAB7B3A31EE}" dt="2023-03-23T19:33:50.133" v="1242" actId="164"/>
          <ac:spMkLst>
            <pc:docMk/>
            <pc:sldMk cId="3312243808" sldId="328"/>
            <ac:spMk id="13" creationId="{F14113A6-1E24-D945-9AC8-2A0EC57C6059}"/>
          </ac:spMkLst>
        </pc:spChg>
        <pc:spChg chg="mod topLvl">
          <ac:chgData name="Kumar, Vinod" userId="a0710a6e-bffc-4971-8893-1c23addeb5b0" providerId="ADAL" clId="{A867779D-3C18-41E4-A938-BAAB7B3A31EE}" dt="2023-03-23T19:33:50.133" v="1242" actId="164"/>
          <ac:spMkLst>
            <pc:docMk/>
            <pc:sldMk cId="3312243808" sldId="328"/>
            <ac:spMk id="14" creationId="{80D4D0D3-3773-8548-A561-66C0D1AD1EF8}"/>
          </ac:spMkLst>
        </pc:spChg>
        <pc:spChg chg="mod topLvl">
          <ac:chgData name="Kumar, Vinod" userId="a0710a6e-bffc-4971-8893-1c23addeb5b0" providerId="ADAL" clId="{A867779D-3C18-41E4-A938-BAAB7B3A31EE}" dt="2023-03-23T19:33:50.133" v="1242" actId="164"/>
          <ac:spMkLst>
            <pc:docMk/>
            <pc:sldMk cId="3312243808" sldId="328"/>
            <ac:spMk id="15" creationId="{DEF81E35-044B-8E46-BAA9-0CA8D827F7D1}"/>
          </ac:spMkLst>
        </pc:spChg>
        <pc:spChg chg="del mod topLvl">
          <ac:chgData name="Kumar, Vinod" userId="a0710a6e-bffc-4971-8893-1c23addeb5b0" providerId="ADAL" clId="{A867779D-3C18-41E4-A938-BAAB7B3A31EE}" dt="2023-03-23T19:32:36.338" v="1220" actId="478"/>
          <ac:spMkLst>
            <pc:docMk/>
            <pc:sldMk cId="3312243808" sldId="328"/>
            <ac:spMk id="16" creationId="{03A802AD-66BF-1D4F-B84F-C30DFB31C09D}"/>
          </ac:spMkLst>
        </pc:spChg>
        <pc:spChg chg="del mod topLvl">
          <ac:chgData name="Kumar, Vinod" userId="a0710a6e-bffc-4971-8893-1c23addeb5b0" providerId="ADAL" clId="{A867779D-3C18-41E4-A938-BAAB7B3A31EE}" dt="2023-03-23T19:32:37.410" v="1221" actId="478"/>
          <ac:spMkLst>
            <pc:docMk/>
            <pc:sldMk cId="3312243808" sldId="328"/>
            <ac:spMk id="17" creationId="{A2096BCC-91A0-0842-B7D0-C8B47AA6AA0A}"/>
          </ac:spMkLst>
        </pc:spChg>
        <pc:spChg chg="mod topLvl">
          <ac:chgData name="Kumar, Vinod" userId="a0710a6e-bffc-4971-8893-1c23addeb5b0" providerId="ADAL" clId="{A867779D-3C18-41E4-A938-BAAB7B3A31EE}" dt="2023-03-23T19:33:50.133" v="1242" actId="164"/>
          <ac:spMkLst>
            <pc:docMk/>
            <pc:sldMk cId="3312243808" sldId="328"/>
            <ac:spMk id="20" creationId="{351485A9-6B72-3A68-73B3-F07FCA79E67B}"/>
          </ac:spMkLst>
        </pc:spChg>
        <pc:spChg chg="add mod">
          <ac:chgData name="Kumar, Vinod" userId="a0710a6e-bffc-4971-8893-1c23addeb5b0" providerId="ADAL" clId="{A867779D-3C18-41E4-A938-BAAB7B3A31EE}" dt="2023-03-23T19:33:50.133" v="1242" actId="164"/>
          <ac:spMkLst>
            <pc:docMk/>
            <pc:sldMk cId="3312243808" sldId="328"/>
            <ac:spMk id="23" creationId="{2C71C362-C2E3-EEC4-4413-132D765E6C6B}"/>
          </ac:spMkLst>
        </pc:spChg>
        <pc:spChg chg="add mod">
          <ac:chgData name="Kumar, Vinod" userId="a0710a6e-bffc-4971-8893-1c23addeb5b0" providerId="ADAL" clId="{A867779D-3C18-41E4-A938-BAAB7B3A31EE}" dt="2023-03-23T19:33:50.133" v="1242" actId="164"/>
          <ac:spMkLst>
            <pc:docMk/>
            <pc:sldMk cId="3312243808" sldId="328"/>
            <ac:spMk id="24" creationId="{67455D94-3A08-7F50-94BD-2F52D0F80185}"/>
          </ac:spMkLst>
        </pc:spChg>
        <pc:spChg chg="mod">
          <ac:chgData name="Kumar, Vinod" userId="a0710a6e-bffc-4971-8893-1c23addeb5b0" providerId="ADAL" clId="{A867779D-3C18-41E4-A938-BAAB7B3A31EE}" dt="2023-02-14T16:13:30.309" v="1205" actId="20577"/>
          <ac:spMkLst>
            <pc:docMk/>
            <pc:sldMk cId="3312243808" sldId="328"/>
            <ac:spMk id="32" creationId="{C7A57016-B285-E7A4-4309-57286A85EEF6}"/>
          </ac:spMkLst>
        </pc:spChg>
        <pc:grpChg chg="del mod">
          <ac:chgData name="Kumar, Vinod" userId="a0710a6e-bffc-4971-8893-1c23addeb5b0" providerId="ADAL" clId="{A867779D-3C18-41E4-A938-BAAB7B3A31EE}" dt="2023-03-23T19:31:56.959" v="1212" actId="165"/>
          <ac:grpSpMkLst>
            <pc:docMk/>
            <pc:sldMk cId="3312243808" sldId="328"/>
            <ac:grpSpMk id="22" creationId="{CA2B877A-1519-ABAA-9B4F-7F849712E67B}"/>
          </ac:grpSpMkLst>
        </pc:grpChg>
        <pc:grpChg chg="add mod">
          <ac:chgData name="Kumar, Vinod" userId="a0710a6e-bffc-4971-8893-1c23addeb5b0" providerId="ADAL" clId="{A867779D-3C18-41E4-A938-BAAB7B3A31EE}" dt="2023-03-23T19:33:50.133" v="1242" actId="164"/>
          <ac:grpSpMkLst>
            <pc:docMk/>
            <pc:sldMk cId="3312243808" sldId="328"/>
            <ac:grpSpMk id="25" creationId="{CD0ECC31-C3D2-8DB9-3933-25798E6F5632}"/>
          </ac:grpSpMkLst>
        </pc:grpChg>
        <pc:picChg chg="del mod topLvl">
          <ac:chgData name="Kumar, Vinod" userId="a0710a6e-bffc-4971-8893-1c23addeb5b0" providerId="ADAL" clId="{A867779D-3C18-41E4-A938-BAAB7B3A31EE}" dt="2023-03-23T19:32:34.953" v="1219" actId="478"/>
          <ac:picMkLst>
            <pc:docMk/>
            <pc:sldMk cId="3312243808" sldId="328"/>
            <ac:picMk id="12" creationId="{CD1EA49D-8A63-B442-8402-7DFE6AA592F4}"/>
          </ac:picMkLst>
        </pc:picChg>
        <pc:picChg chg="add mod">
          <ac:chgData name="Kumar, Vinod" userId="a0710a6e-bffc-4971-8893-1c23addeb5b0" providerId="ADAL" clId="{A867779D-3C18-41E4-A938-BAAB7B3A31EE}" dt="2023-03-23T19:33:50.133" v="1242" actId="164"/>
          <ac:picMkLst>
            <pc:docMk/>
            <pc:sldMk cId="3312243808" sldId="328"/>
            <ac:picMk id="18" creationId="{41064A42-A171-DF9F-19DB-948201984283}"/>
          </ac:picMkLst>
        </pc:picChg>
        <pc:picChg chg="add mod">
          <ac:chgData name="Kumar, Vinod" userId="a0710a6e-bffc-4971-8893-1c23addeb5b0" providerId="ADAL" clId="{A867779D-3C18-41E4-A938-BAAB7B3A31EE}" dt="2023-03-23T19:33:50.133" v="1242" actId="164"/>
          <ac:picMkLst>
            <pc:docMk/>
            <pc:sldMk cId="3312243808" sldId="328"/>
            <ac:picMk id="19" creationId="{6361F3F1-E0EE-C056-9553-FEFE0A9D0B48}"/>
          </ac:picMkLst>
        </pc:picChg>
        <pc:cxnChg chg="mod topLvl">
          <ac:chgData name="Kumar, Vinod" userId="a0710a6e-bffc-4971-8893-1c23addeb5b0" providerId="ADAL" clId="{A867779D-3C18-41E4-A938-BAAB7B3A31EE}" dt="2023-03-23T19:33:50.133" v="1242" actId="164"/>
          <ac:cxnSpMkLst>
            <pc:docMk/>
            <pc:sldMk cId="3312243808" sldId="328"/>
            <ac:cxnSpMk id="4" creationId="{C93BEA72-3AB1-5EC4-8AA5-F8DA6802A1B3}"/>
          </ac:cxnSpMkLst>
        </pc:cxnChg>
      </pc:sldChg>
      <pc:sldChg chg="modSp mod">
        <pc:chgData name="Kumar, Vinod" userId="a0710a6e-bffc-4971-8893-1c23addeb5b0" providerId="ADAL" clId="{A867779D-3C18-41E4-A938-BAAB7B3A31EE}" dt="2023-02-14T16:13:19.909" v="1204" actId="20577"/>
        <pc:sldMkLst>
          <pc:docMk/>
          <pc:sldMk cId="3774057072" sldId="329"/>
        </pc:sldMkLst>
        <pc:spChg chg="mod">
          <ac:chgData name="Kumar, Vinod" userId="a0710a6e-bffc-4971-8893-1c23addeb5b0" providerId="ADAL" clId="{A867779D-3C18-41E4-A938-BAAB7B3A31EE}" dt="2023-02-14T16:13:19.909" v="1204" actId="20577"/>
          <ac:spMkLst>
            <pc:docMk/>
            <pc:sldMk cId="3774057072" sldId="329"/>
            <ac:spMk id="2" creationId="{A0FBC7C5-F52E-9A9B-D88B-A242D961AC1E}"/>
          </ac:spMkLst>
        </pc:spChg>
      </pc:sldChg>
      <pc:sldChg chg="delSp mod">
        <pc:chgData name="Kumar, Vinod" userId="a0710a6e-bffc-4971-8893-1c23addeb5b0" providerId="ADAL" clId="{A867779D-3C18-41E4-A938-BAAB7B3A31EE}" dt="2023-02-14T16:05:24.077" v="943" actId="21"/>
        <pc:sldMkLst>
          <pc:docMk/>
          <pc:sldMk cId="796278249" sldId="330"/>
        </pc:sldMkLst>
        <pc:spChg chg="del">
          <ac:chgData name="Kumar, Vinod" userId="a0710a6e-bffc-4971-8893-1c23addeb5b0" providerId="ADAL" clId="{A867779D-3C18-41E4-A938-BAAB7B3A31EE}" dt="2023-02-14T16:05:24.077" v="943" actId="21"/>
          <ac:spMkLst>
            <pc:docMk/>
            <pc:sldMk cId="796278249" sldId="330"/>
            <ac:spMk id="44" creationId="{DD6EB601-DE50-EE06-3534-B019AEE79561}"/>
          </ac:spMkLst>
        </pc:spChg>
        <pc:grpChg chg="del">
          <ac:chgData name="Kumar, Vinod" userId="a0710a6e-bffc-4971-8893-1c23addeb5b0" providerId="ADAL" clId="{A867779D-3C18-41E4-A938-BAAB7B3A31EE}" dt="2023-02-14T16:05:24.077" v="943" actId="21"/>
          <ac:grpSpMkLst>
            <pc:docMk/>
            <pc:sldMk cId="796278249" sldId="330"/>
            <ac:grpSpMk id="19" creationId="{72A043E5-B7C8-0B88-DF7D-B6DAE3D08CF0}"/>
          </ac:grpSpMkLst>
        </pc:grpChg>
      </pc:sldChg>
      <pc:sldChg chg="addSp modSp mod">
        <pc:chgData name="Kumar, Vinod" userId="a0710a6e-bffc-4971-8893-1c23addeb5b0" providerId="ADAL" clId="{A867779D-3C18-41E4-A938-BAAB7B3A31EE}" dt="2023-02-14T16:09:16.456" v="1074" actId="20577"/>
        <pc:sldMkLst>
          <pc:docMk/>
          <pc:sldMk cId="3066716538" sldId="331"/>
        </pc:sldMkLst>
        <pc:spChg chg="mod">
          <ac:chgData name="Kumar, Vinod" userId="a0710a6e-bffc-4971-8893-1c23addeb5b0" providerId="ADAL" clId="{A867779D-3C18-41E4-A938-BAAB7B3A31EE}" dt="2023-02-14T16:09:16.456" v="1074" actId="20577"/>
          <ac:spMkLst>
            <pc:docMk/>
            <pc:sldMk cId="3066716538" sldId="331"/>
            <ac:spMk id="6" creationId="{8594A58D-A230-9192-2A3C-2FCFB1AEF16C}"/>
          </ac:spMkLst>
        </pc:spChg>
        <pc:spChg chg="add mod">
          <ac:chgData name="Kumar, Vinod" userId="a0710a6e-bffc-4971-8893-1c23addeb5b0" providerId="ADAL" clId="{A867779D-3C18-41E4-A938-BAAB7B3A31EE}" dt="2023-02-14T16:07:09.640" v="1035" actId="20577"/>
          <ac:spMkLst>
            <pc:docMk/>
            <pc:sldMk cId="3066716538" sldId="331"/>
            <ac:spMk id="10" creationId="{4186FA0A-D205-DB98-74A3-748A2410CCFE}"/>
          </ac:spMkLst>
        </pc:spChg>
        <pc:spChg chg="add mod">
          <ac:chgData name="Kumar, Vinod" userId="a0710a6e-bffc-4971-8893-1c23addeb5b0" providerId="ADAL" clId="{A867779D-3C18-41E4-A938-BAAB7B3A31EE}" dt="2023-02-14T16:07:39.689" v="1044" actId="20577"/>
          <ac:spMkLst>
            <pc:docMk/>
            <pc:sldMk cId="3066716538" sldId="331"/>
            <ac:spMk id="11" creationId="{057A0C40-FDE2-CA25-3526-706E7BAD8832}"/>
          </ac:spMkLst>
        </pc:spChg>
        <pc:spChg chg="add mod">
          <ac:chgData name="Kumar, Vinod" userId="a0710a6e-bffc-4971-8893-1c23addeb5b0" providerId="ADAL" clId="{A867779D-3C18-41E4-A938-BAAB7B3A31EE}" dt="2023-02-14T16:09:11.321" v="1073" actId="20577"/>
          <ac:spMkLst>
            <pc:docMk/>
            <pc:sldMk cId="3066716538" sldId="331"/>
            <ac:spMk id="26" creationId="{FB05195B-DE4E-86D0-3FC6-CC6A7BEFDFFC}"/>
          </ac:spMkLst>
        </pc:spChg>
        <pc:grpChg chg="mod">
          <ac:chgData name="Kumar, Vinod" userId="a0710a6e-bffc-4971-8893-1c23addeb5b0" providerId="ADAL" clId="{A867779D-3C18-41E4-A938-BAAB7B3A31EE}" dt="2023-02-14T16:07:20.360" v="1040" actId="1035"/>
          <ac:grpSpMkLst>
            <pc:docMk/>
            <pc:sldMk cId="3066716538" sldId="331"/>
            <ac:grpSpMk id="8" creationId="{45B1E29C-9F33-D0AB-EA9A-340FCA1EAE09}"/>
          </ac:grpSpMkLst>
        </pc:grpChg>
      </pc:sldChg>
      <pc:sldChg chg="addSp modSp mod">
        <pc:chgData name="Kumar, Vinod" userId="a0710a6e-bffc-4971-8893-1c23addeb5b0" providerId="ADAL" clId="{A867779D-3C18-41E4-A938-BAAB7B3A31EE}" dt="2023-03-23T20:57:37.580" v="1244" actId="20577"/>
        <pc:sldMkLst>
          <pc:docMk/>
          <pc:sldMk cId="752802638" sldId="332"/>
        </pc:sldMkLst>
        <pc:spChg chg="add mod">
          <ac:chgData name="Kumar, Vinod" userId="a0710a6e-bffc-4971-8893-1c23addeb5b0" providerId="ADAL" clId="{A867779D-3C18-41E4-A938-BAAB7B3A31EE}" dt="2023-03-23T20:57:37.580" v="1244" actId="20577"/>
          <ac:spMkLst>
            <pc:docMk/>
            <pc:sldMk cId="752802638" sldId="332"/>
            <ac:spMk id="5" creationId="{3F373588-3A1B-DD47-08CE-7272F63CA8A7}"/>
          </ac:spMkLst>
        </pc:spChg>
        <pc:spChg chg="add mod">
          <ac:chgData name="Kumar, Vinod" userId="a0710a6e-bffc-4971-8893-1c23addeb5b0" providerId="ADAL" clId="{A867779D-3C18-41E4-A938-BAAB7B3A31EE}" dt="2023-02-14T16:12:03.477" v="1135" actId="1038"/>
          <ac:spMkLst>
            <pc:docMk/>
            <pc:sldMk cId="752802638" sldId="332"/>
            <ac:spMk id="19" creationId="{68F360F6-B474-FAF4-A52C-8AD515507DE1}"/>
          </ac:spMkLst>
        </pc:spChg>
        <pc:spChg chg="add mod">
          <ac:chgData name="Kumar, Vinod" userId="a0710a6e-bffc-4971-8893-1c23addeb5b0" providerId="ADAL" clId="{A867779D-3C18-41E4-A938-BAAB7B3A31EE}" dt="2023-02-14T16:12:37.303" v="1202" actId="20577"/>
          <ac:spMkLst>
            <pc:docMk/>
            <pc:sldMk cId="752802638" sldId="332"/>
            <ac:spMk id="31" creationId="{E3B980BD-5D74-6E5C-0086-66315F9B9921}"/>
          </ac:spMkLst>
        </pc:spChg>
        <pc:grpChg chg="mod">
          <ac:chgData name="Kumar, Vinod" userId="a0710a6e-bffc-4971-8893-1c23addeb5b0" providerId="ADAL" clId="{A867779D-3C18-41E4-A938-BAAB7B3A31EE}" dt="2023-02-14T16:12:19.526" v="1152" actId="1036"/>
          <ac:grpSpMkLst>
            <pc:docMk/>
            <pc:sldMk cId="752802638" sldId="332"/>
            <ac:grpSpMk id="35" creationId="{06BFD393-74E6-EEED-2BA3-3BE7BBAFEEF6}"/>
          </ac:grpSpMkLst>
        </pc:grpChg>
        <pc:grpChg chg="mod">
          <ac:chgData name="Kumar, Vinod" userId="a0710a6e-bffc-4971-8893-1c23addeb5b0" providerId="ADAL" clId="{A867779D-3C18-41E4-A938-BAAB7B3A31EE}" dt="2023-02-14T16:12:12.118" v="1144" actId="1035"/>
          <ac:grpSpMkLst>
            <pc:docMk/>
            <pc:sldMk cId="752802638" sldId="332"/>
            <ac:grpSpMk id="80" creationId="{FA9ABAF1-9E65-E0FB-8CEF-34CB4D6010F4}"/>
          </ac:grpSpMkLst>
        </pc:grpChg>
      </pc:sldChg>
      <pc:sldChg chg="addSp modSp mod">
        <pc:chgData name="Kumar, Vinod" userId="a0710a6e-bffc-4971-8893-1c23addeb5b0" providerId="ADAL" clId="{A867779D-3C18-41E4-A938-BAAB7B3A31EE}" dt="2023-02-14T16:10:53.750" v="1106" actId="20577"/>
        <pc:sldMkLst>
          <pc:docMk/>
          <pc:sldMk cId="2717138259" sldId="333"/>
        </pc:sldMkLst>
        <pc:spChg chg="mod">
          <ac:chgData name="Kumar, Vinod" userId="a0710a6e-bffc-4971-8893-1c23addeb5b0" providerId="ADAL" clId="{A867779D-3C18-41E4-A938-BAAB7B3A31EE}" dt="2023-02-14T16:09:42.904" v="1076" actId="20577"/>
          <ac:spMkLst>
            <pc:docMk/>
            <pc:sldMk cId="2717138259" sldId="333"/>
            <ac:spMk id="2" creationId="{AAE1FA69-3576-CF10-27A3-42FC37A61688}"/>
          </ac:spMkLst>
        </pc:spChg>
        <pc:spChg chg="add mod">
          <ac:chgData name="Kumar, Vinod" userId="a0710a6e-bffc-4971-8893-1c23addeb5b0" providerId="ADAL" clId="{A867779D-3C18-41E4-A938-BAAB7B3A31EE}" dt="2023-02-14T16:10:11.526" v="1086" actId="1037"/>
          <ac:spMkLst>
            <pc:docMk/>
            <pc:sldMk cId="2717138259" sldId="333"/>
            <ac:spMk id="3" creationId="{ABAB09F6-73EF-40AB-A4ED-FBDAE3A29A84}"/>
          </ac:spMkLst>
        </pc:spChg>
        <pc:spChg chg="add mod">
          <ac:chgData name="Kumar, Vinod" userId="a0710a6e-bffc-4971-8893-1c23addeb5b0" providerId="ADAL" clId="{A867779D-3C18-41E4-A938-BAAB7B3A31EE}" dt="2023-02-14T16:10:53.750" v="1106" actId="20577"/>
          <ac:spMkLst>
            <pc:docMk/>
            <pc:sldMk cId="2717138259" sldId="333"/>
            <ac:spMk id="7" creationId="{D1FCE51D-0161-4083-0A65-2A43E64B7EAD}"/>
          </ac:spMkLst>
        </pc:spChg>
        <pc:grpChg chg="mod">
          <ac:chgData name="Kumar, Vinod" userId="a0710a6e-bffc-4971-8893-1c23addeb5b0" providerId="ADAL" clId="{A867779D-3C18-41E4-A938-BAAB7B3A31EE}" dt="2023-02-14T16:10:16.583" v="1093" actId="1036"/>
          <ac:grpSpMkLst>
            <pc:docMk/>
            <pc:sldMk cId="2717138259" sldId="333"/>
            <ac:grpSpMk id="82" creationId="{059C05DB-C9CD-58B1-5AA6-5C22D4B5E8B3}"/>
          </ac:grpSpMkLst>
        </pc:grpChg>
      </pc:sldChg>
      <pc:sldChg chg="del">
        <pc:chgData name="Kumar, Vinod" userId="a0710a6e-bffc-4971-8893-1c23addeb5b0" providerId="ADAL" clId="{A867779D-3C18-41E4-A938-BAAB7B3A31EE}" dt="2023-02-14T16:09:36.626" v="1075" actId="47"/>
        <pc:sldMkLst>
          <pc:docMk/>
          <pc:sldMk cId="465941897" sldId="334"/>
        </pc:sldMkLst>
      </pc:sldChg>
      <pc:sldChg chg="del">
        <pc:chgData name="Kumar, Vinod" userId="a0710a6e-bffc-4971-8893-1c23addeb5b0" providerId="ADAL" clId="{A867779D-3C18-41E4-A938-BAAB7B3A31EE}" dt="2023-02-14T15:53:42.590" v="673" actId="47"/>
        <pc:sldMkLst>
          <pc:docMk/>
          <pc:sldMk cId="3426644829" sldId="335"/>
        </pc:sldMkLst>
      </pc:sldChg>
      <pc:sldChg chg="del">
        <pc:chgData name="Kumar, Vinod" userId="a0710a6e-bffc-4971-8893-1c23addeb5b0" providerId="ADAL" clId="{A867779D-3C18-41E4-A938-BAAB7B3A31EE}" dt="2023-02-14T15:59:50.704" v="912" actId="47"/>
        <pc:sldMkLst>
          <pc:docMk/>
          <pc:sldMk cId="461106370" sldId="336"/>
        </pc:sldMkLst>
      </pc:sldChg>
      <pc:sldChg chg="del">
        <pc:chgData name="Kumar, Vinod" userId="a0710a6e-bffc-4971-8893-1c23addeb5b0" providerId="ADAL" clId="{A867779D-3C18-41E4-A938-BAAB7B3A31EE}" dt="2023-02-14T15:59:52.640" v="913" actId="47"/>
        <pc:sldMkLst>
          <pc:docMk/>
          <pc:sldMk cId="2077480537" sldId="337"/>
        </pc:sldMkLst>
      </pc:sldChg>
      <pc:sldChg chg="del">
        <pc:chgData name="Kumar, Vinod" userId="a0710a6e-bffc-4971-8893-1c23addeb5b0" providerId="ADAL" clId="{A867779D-3C18-41E4-A938-BAAB7B3A31EE}" dt="2023-02-14T15:59:56.528" v="915" actId="47"/>
        <pc:sldMkLst>
          <pc:docMk/>
          <pc:sldMk cId="1881287229" sldId="338"/>
        </pc:sldMkLst>
      </pc:sldChg>
      <pc:sldChg chg="del">
        <pc:chgData name="Kumar, Vinod" userId="a0710a6e-bffc-4971-8893-1c23addeb5b0" providerId="ADAL" clId="{A867779D-3C18-41E4-A938-BAAB7B3A31EE}" dt="2023-02-14T15:59:55.136" v="914" actId="47"/>
        <pc:sldMkLst>
          <pc:docMk/>
          <pc:sldMk cId="56293523" sldId="339"/>
        </pc:sldMkLst>
      </pc:sldChg>
      <pc:sldChg chg="del">
        <pc:chgData name="Kumar, Vinod" userId="a0710a6e-bffc-4971-8893-1c23addeb5b0" providerId="ADAL" clId="{A867779D-3C18-41E4-A938-BAAB7B3A31EE}" dt="2023-02-14T15:59:57.584" v="916" actId="47"/>
        <pc:sldMkLst>
          <pc:docMk/>
          <pc:sldMk cId="2932005610" sldId="340"/>
        </pc:sldMkLst>
      </pc:sldChg>
      <pc:sldChg chg="del">
        <pc:chgData name="Kumar, Vinod" userId="a0710a6e-bffc-4971-8893-1c23addeb5b0" providerId="ADAL" clId="{A867779D-3C18-41E4-A938-BAAB7B3A31EE}" dt="2023-02-14T15:59:59.537" v="917" actId="47"/>
        <pc:sldMkLst>
          <pc:docMk/>
          <pc:sldMk cId="4024231393" sldId="341"/>
        </pc:sldMkLst>
      </pc:sldChg>
      <pc:sldChg chg="addSp delSp modSp add mod">
        <pc:chgData name="Kumar, Vinod" userId="a0710a6e-bffc-4971-8893-1c23addeb5b0" providerId="ADAL" clId="{A867779D-3C18-41E4-A938-BAAB7B3A31EE}" dt="2023-02-14T16:13:51.413" v="1207" actId="20577"/>
        <pc:sldMkLst>
          <pc:docMk/>
          <pc:sldMk cId="3948585847" sldId="342"/>
        </pc:sldMkLst>
        <pc:spChg chg="mod">
          <ac:chgData name="Kumar, Vinod" userId="a0710a6e-bffc-4971-8893-1c23addeb5b0" providerId="ADAL" clId="{A867779D-3C18-41E4-A938-BAAB7B3A31EE}" dt="2023-02-14T16:13:51.413" v="1207" actId="20577"/>
          <ac:spMkLst>
            <pc:docMk/>
            <pc:sldMk cId="3948585847" sldId="342"/>
            <ac:spMk id="4" creationId="{A268E69E-1A64-C70D-117D-C52D8B847D56}"/>
          </ac:spMkLst>
        </pc:spChg>
        <pc:spChg chg="mod">
          <ac:chgData name="Kumar, Vinod" userId="a0710a6e-bffc-4971-8893-1c23addeb5b0" providerId="ADAL" clId="{A867779D-3C18-41E4-A938-BAAB7B3A31EE}" dt="2023-02-14T15:46:11.796" v="536" actId="165"/>
          <ac:spMkLst>
            <pc:docMk/>
            <pc:sldMk cId="3948585847" sldId="342"/>
            <ac:spMk id="5" creationId="{F3FCF723-FC69-FB60-A6AB-D6E09DCA0168}"/>
          </ac:spMkLst>
        </pc:spChg>
        <pc:spChg chg="mod">
          <ac:chgData name="Kumar, Vinod" userId="a0710a6e-bffc-4971-8893-1c23addeb5b0" providerId="ADAL" clId="{A867779D-3C18-41E4-A938-BAAB7B3A31EE}" dt="2023-02-14T15:46:11.796" v="536" actId="165"/>
          <ac:spMkLst>
            <pc:docMk/>
            <pc:sldMk cId="3948585847" sldId="342"/>
            <ac:spMk id="7" creationId="{F1032A67-9D92-05B0-DE69-4A94EABD19A9}"/>
          </ac:spMkLst>
        </pc:spChg>
        <pc:spChg chg="mod">
          <ac:chgData name="Kumar, Vinod" userId="a0710a6e-bffc-4971-8893-1c23addeb5b0" providerId="ADAL" clId="{A867779D-3C18-41E4-A938-BAAB7B3A31EE}" dt="2023-02-14T15:46:11.796" v="536" actId="165"/>
          <ac:spMkLst>
            <pc:docMk/>
            <pc:sldMk cId="3948585847" sldId="342"/>
            <ac:spMk id="8" creationId="{47E820FA-25F5-AEA1-E191-950C71C0FCF3}"/>
          </ac:spMkLst>
        </pc:spChg>
        <pc:spChg chg="mod">
          <ac:chgData name="Kumar, Vinod" userId="a0710a6e-bffc-4971-8893-1c23addeb5b0" providerId="ADAL" clId="{A867779D-3C18-41E4-A938-BAAB7B3A31EE}" dt="2023-02-14T15:46:11.796" v="536" actId="165"/>
          <ac:spMkLst>
            <pc:docMk/>
            <pc:sldMk cId="3948585847" sldId="342"/>
            <ac:spMk id="12" creationId="{049CE177-B2AB-E2AB-1489-4F8BA53FFE42}"/>
          </ac:spMkLst>
        </pc:spChg>
        <pc:spChg chg="mod">
          <ac:chgData name="Kumar, Vinod" userId="a0710a6e-bffc-4971-8893-1c23addeb5b0" providerId="ADAL" clId="{A867779D-3C18-41E4-A938-BAAB7B3A31EE}" dt="2023-02-14T15:46:11.796" v="536" actId="165"/>
          <ac:spMkLst>
            <pc:docMk/>
            <pc:sldMk cId="3948585847" sldId="342"/>
            <ac:spMk id="13" creationId="{ED0439CE-0E9F-8F77-637D-D5B3F0935A7D}"/>
          </ac:spMkLst>
        </pc:spChg>
        <pc:spChg chg="del mod">
          <ac:chgData name="Kumar, Vinod" userId="a0710a6e-bffc-4971-8893-1c23addeb5b0" providerId="ADAL" clId="{A867779D-3C18-41E4-A938-BAAB7B3A31EE}" dt="2023-02-14T15:46:30.761" v="538" actId="478"/>
          <ac:spMkLst>
            <pc:docMk/>
            <pc:sldMk cId="3948585847" sldId="342"/>
            <ac:spMk id="14" creationId="{C4DA97E1-1F8A-604C-58C4-C4FE123B8D38}"/>
          </ac:spMkLst>
        </pc:spChg>
        <pc:spChg chg="mod topLvl">
          <ac:chgData name="Kumar, Vinod" userId="a0710a6e-bffc-4971-8893-1c23addeb5b0" providerId="ADAL" clId="{A867779D-3C18-41E4-A938-BAAB7B3A31EE}" dt="2023-02-14T15:57:25.964" v="900" actId="1035"/>
          <ac:spMkLst>
            <pc:docMk/>
            <pc:sldMk cId="3948585847" sldId="342"/>
            <ac:spMk id="16" creationId="{BBC7DEC2-F316-00B8-C960-575417169EE0}"/>
          </ac:spMkLst>
        </pc:spChg>
        <pc:spChg chg="mod">
          <ac:chgData name="Kumar, Vinod" userId="a0710a6e-bffc-4971-8893-1c23addeb5b0" providerId="ADAL" clId="{A867779D-3C18-41E4-A938-BAAB7B3A31EE}" dt="2023-02-14T15:41:11.743" v="153" actId="164"/>
          <ac:spMkLst>
            <pc:docMk/>
            <pc:sldMk cId="3948585847" sldId="342"/>
            <ac:spMk id="37" creationId="{B0DBD44B-947F-954F-1259-F8BD59E3BA39}"/>
          </ac:spMkLst>
        </pc:spChg>
        <pc:spChg chg="mod">
          <ac:chgData name="Kumar, Vinod" userId="a0710a6e-bffc-4971-8893-1c23addeb5b0" providerId="ADAL" clId="{A867779D-3C18-41E4-A938-BAAB7B3A31EE}" dt="2023-02-14T15:40:54.943" v="151" actId="164"/>
          <ac:spMkLst>
            <pc:docMk/>
            <pc:sldMk cId="3948585847" sldId="342"/>
            <ac:spMk id="44" creationId="{73C48193-FB68-FD31-289A-A97FE893EAF0}"/>
          </ac:spMkLst>
        </pc:spChg>
        <pc:spChg chg="mod">
          <ac:chgData name="Kumar, Vinod" userId="a0710a6e-bffc-4971-8893-1c23addeb5b0" providerId="ADAL" clId="{A867779D-3C18-41E4-A938-BAAB7B3A31EE}" dt="2023-02-14T15:38:43.847" v="34" actId="164"/>
          <ac:spMkLst>
            <pc:docMk/>
            <pc:sldMk cId="3948585847" sldId="342"/>
            <ac:spMk id="51" creationId="{5C0FF62F-E495-CC6A-23B0-513F61DC8CA7}"/>
          </ac:spMkLst>
        </pc:spChg>
        <pc:spChg chg="mod">
          <ac:chgData name="Kumar, Vinod" userId="a0710a6e-bffc-4971-8893-1c23addeb5b0" providerId="ADAL" clId="{A867779D-3C18-41E4-A938-BAAB7B3A31EE}" dt="2023-02-14T15:38:43.847" v="34" actId="164"/>
          <ac:spMkLst>
            <pc:docMk/>
            <pc:sldMk cId="3948585847" sldId="342"/>
            <ac:spMk id="52" creationId="{F45FA887-8466-2277-16B1-BED6D210A592}"/>
          </ac:spMkLst>
        </pc:spChg>
        <pc:spChg chg="mod">
          <ac:chgData name="Kumar, Vinod" userId="a0710a6e-bffc-4971-8893-1c23addeb5b0" providerId="ADAL" clId="{A867779D-3C18-41E4-A938-BAAB7B3A31EE}" dt="2023-02-14T15:38:43.847" v="34" actId="164"/>
          <ac:spMkLst>
            <pc:docMk/>
            <pc:sldMk cId="3948585847" sldId="342"/>
            <ac:spMk id="53" creationId="{5C678BA4-1D51-D9E8-7580-EC00391FF50C}"/>
          </ac:spMkLst>
        </pc:spChg>
        <pc:spChg chg="mod">
          <ac:chgData name="Kumar, Vinod" userId="a0710a6e-bffc-4971-8893-1c23addeb5b0" providerId="ADAL" clId="{A867779D-3C18-41E4-A938-BAAB7B3A31EE}" dt="2023-02-14T15:38:43.847" v="34" actId="164"/>
          <ac:spMkLst>
            <pc:docMk/>
            <pc:sldMk cId="3948585847" sldId="342"/>
            <ac:spMk id="54" creationId="{C3BD8E0D-6208-14D3-02F0-3E1B14A09EF3}"/>
          </ac:spMkLst>
        </pc:spChg>
        <pc:spChg chg="mod">
          <ac:chgData name="Kumar, Vinod" userId="a0710a6e-bffc-4971-8893-1c23addeb5b0" providerId="ADAL" clId="{A867779D-3C18-41E4-A938-BAAB7B3A31EE}" dt="2023-02-14T15:38:43.847" v="34" actId="164"/>
          <ac:spMkLst>
            <pc:docMk/>
            <pc:sldMk cId="3948585847" sldId="342"/>
            <ac:spMk id="55" creationId="{C0772C3F-66C5-9F93-0F9C-F3A12144163B}"/>
          </ac:spMkLst>
        </pc:spChg>
        <pc:spChg chg="mod">
          <ac:chgData name="Kumar, Vinod" userId="a0710a6e-bffc-4971-8893-1c23addeb5b0" providerId="ADAL" clId="{A867779D-3C18-41E4-A938-BAAB7B3A31EE}" dt="2023-02-14T15:38:43.847" v="34" actId="164"/>
          <ac:spMkLst>
            <pc:docMk/>
            <pc:sldMk cId="3948585847" sldId="342"/>
            <ac:spMk id="56" creationId="{A85E0CCC-BDF8-B837-FEB9-7DD31B1668CF}"/>
          </ac:spMkLst>
        </pc:spChg>
        <pc:spChg chg="mod">
          <ac:chgData name="Kumar, Vinod" userId="a0710a6e-bffc-4971-8893-1c23addeb5b0" providerId="ADAL" clId="{A867779D-3C18-41E4-A938-BAAB7B3A31EE}" dt="2023-02-14T15:38:43.847" v="34" actId="164"/>
          <ac:spMkLst>
            <pc:docMk/>
            <pc:sldMk cId="3948585847" sldId="342"/>
            <ac:spMk id="57" creationId="{B4F2DE5E-1B07-5082-7E18-7CB952BEB57B}"/>
          </ac:spMkLst>
        </pc:spChg>
        <pc:spChg chg="mod">
          <ac:chgData name="Kumar, Vinod" userId="a0710a6e-bffc-4971-8893-1c23addeb5b0" providerId="ADAL" clId="{A867779D-3C18-41E4-A938-BAAB7B3A31EE}" dt="2023-02-14T15:43:48.542" v="375" actId="165"/>
          <ac:spMkLst>
            <pc:docMk/>
            <pc:sldMk cId="3948585847" sldId="342"/>
            <ac:spMk id="62" creationId="{6AD61A2A-E0B1-D9C1-67F5-B285EBDDC7EA}"/>
          </ac:spMkLst>
        </pc:spChg>
        <pc:spChg chg="mod">
          <ac:chgData name="Kumar, Vinod" userId="a0710a6e-bffc-4971-8893-1c23addeb5b0" providerId="ADAL" clId="{A867779D-3C18-41E4-A938-BAAB7B3A31EE}" dt="2023-02-14T15:43:48.542" v="375" actId="165"/>
          <ac:spMkLst>
            <pc:docMk/>
            <pc:sldMk cId="3948585847" sldId="342"/>
            <ac:spMk id="63" creationId="{46648BD4-E193-2B0B-2881-4732748103F7}"/>
          </ac:spMkLst>
        </pc:spChg>
        <pc:spChg chg="mod">
          <ac:chgData name="Kumar, Vinod" userId="a0710a6e-bffc-4971-8893-1c23addeb5b0" providerId="ADAL" clId="{A867779D-3C18-41E4-A938-BAAB7B3A31EE}" dt="2023-02-14T15:43:48.542" v="375" actId="165"/>
          <ac:spMkLst>
            <pc:docMk/>
            <pc:sldMk cId="3948585847" sldId="342"/>
            <ac:spMk id="64" creationId="{2C613B18-513F-E0DC-2620-C67ABD9A4555}"/>
          </ac:spMkLst>
        </pc:spChg>
        <pc:spChg chg="mod topLvl">
          <ac:chgData name="Kumar, Vinod" userId="a0710a6e-bffc-4971-8893-1c23addeb5b0" providerId="ADAL" clId="{A867779D-3C18-41E4-A938-BAAB7B3A31EE}" dt="2023-02-14T15:45:31.758" v="534" actId="164"/>
          <ac:spMkLst>
            <pc:docMk/>
            <pc:sldMk cId="3948585847" sldId="342"/>
            <ac:spMk id="65" creationId="{E74DE3D1-FAE3-8A98-F29B-0D9592A6012E}"/>
          </ac:spMkLst>
        </pc:spChg>
        <pc:spChg chg="mod">
          <ac:chgData name="Kumar, Vinod" userId="a0710a6e-bffc-4971-8893-1c23addeb5b0" providerId="ADAL" clId="{A867779D-3C18-41E4-A938-BAAB7B3A31EE}" dt="2023-02-14T15:43:48.542" v="375" actId="165"/>
          <ac:spMkLst>
            <pc:docMk/>
            <pc:sldMk cId="3948585847" sldId="342"/>
            <ac:spMk id="66" creationId="{B497DDD8-37EC-059D-C782-59B5B7425361}"/>
          </ac:spMkLst>
        </pc:spChg>
        <pc:spChg chg="mod">
          <ac:chgData name="Kumar, Vinod" userId="a0710a6e-bffc-4971-8893-1c23addeb5b0" providerId="ADAL" clId="{A867779D-3C18-41E4-A938-BAAB7B3A31EE}" dt="2023-02-14T15:43:48.542" v="375" actId="165"/>
          <ac:spMkLst>
            <pc:docMk/>
            <pc:sldMk cId="3948585847" sldId="342"/>
            <ac:spMk id="67" creationId="{6FA4D8A1-598D-921F-B36B-8031FA4579B8}"/>
          </ac:spMkLst>
        </pc:spChg>
        <pc:spChg chg="mod">
          <ac:chgData name="Kumar, Vinod" userId="a0710a6e-bffc-4971-8893-1c23addeb5b0" providerId="ADAL" clId="{A867779D-3C18-41E4-A938-BAAB7B3A31EE}" dt="2023-02-14T15:43:48.542" v="375" actId="165"/>
          <ac:spMkLst>
            <pc:docMk/>
            <pc:sldMk cId="3948585847" sldId="342"/>
            <ac:spMk id="68" creationId="{DEA2D342-A7E0-D5FC-531F-6C66E497E2EF}"/>
          </ac:spMkLst>
        </pc:spChg>
        <pc:spChg chg="mod">
          <ac:chgData name="Kumar, Vinod" userId="a0710a6e-bffc-4971-8893-1c23addeb5b0" providerId="ADAL" clId="{A867779D-3C18-41E4-A938-BAAB7B3A31EE}" dt="2023-02-14T15:41:27.627" v="155" actId="165"/>
          <ac:spMkLst>
            <pc:docMk/>
            <pc:sldMk cId="3948585847" sldId="342"/>
            <ac:spMk id="75" creationId="{C3D7C3F6-6527-D3CE-0951-FD582D32DF7C}"/>
          </ac:spMkLst>
        </pc:spChg>
        <pc:spChg chg="mod">
          <ac:chgData name="Kumar, Vinod" userId="a0710a6e-bffc-4971-8893-1c23addeb5b0" providerId="ADAL" clId="{A867779D-3C18-41E4-A938-BAAB7B3A31EE}" dt="2023-02-14T15:41:27.627" v="155" actId="165"/>
          <ac:spMkLst>
            <pc:docMk/>
            <pc:sldMk cId="3948585847" sldId="342"/>
            <ac:spMk id="76" creationId="{14BF7B91-62FE-14F1-5416-9FD028D05B70}"/>
          </ac:spMkLst>
        </pc:spChg>
        <pc:spChg chg="mod">
          <ac:chgData name="Kumar, Vinod" userId="a0710a6e-bffc-4971-8893-1c23addeb5b0" providerId="ADAL" clId="{A867779D-3C18-41E4-A938-BAAB7B3A31EE}" dt="2023-02-14T15:41:27.627" v="155" actId="165"/>
          <ac:spMkLst>
            <pc:docMk/>
            <pc:sldMk cId="3948585847" sldId="342"/>
            <ac:spMk id="77" creationId="{2022AC3B-9C11-7B0D-F5DB-5B47DC192215}"/>
          </ac:spMkLst>
        </pc:spChg>
        <pc:spChg chg="mod">
          <ac:chgData name="Kumar, Vinod" userId="a0710a6e-bffc-4971-8893-1c23addeb5b0" providerId="ADAL" clId="{A867779D-3C18-41E4-A938-BAAB7B3A31EE}" dt="2023-02-14T15:41:27.627" v="155" actId="165"/>
          <ac:spMkLst>
            <pc:docMk/>
            <pc:sldMk cId="3948585847" sldId="342"/>
            <ac:spMk id="79" creationId="{AEEBE5C5-1DAB-C9D2-0E93-E1AFF7032731}"/>
          </ac:spMkLst>
        </pc:spChg>
        <pc:spChg chg="mod topLvl">
          <ac:chgData name="Kumar, Vinod" userId="a0710a6e-bffc-4971-8893-1c23addeb5b0" providerId="ADAL" clId="{A867779D-3C18-41E4-A938-BAAB7B3A31EE}" dt="2023-02-14T15:42:32.391" v="230" actId="164"/>
          <ac:spMkLst>
            <pc:docMk/>
            <pc:sldMk cId="3948585847" sldId="342"/>
            <ac:spMk id="81" creationId="{EE12F3BB-E856-2838-BC6B-3C919A519FFA}"/>
          </ac:spMkLst>
        </pc:spChg>
        <pc:spChg chg="mod topLvl">
          <ac:chgData name="Kumar, Vinod" userId="a0710a6e-bffc-4971-8893-1c23addeb5b0" providerId="ADAL" clId="{A867779D-3C18-41E4-A938-BAAB7B3A31EE}" dt="2023-02-14T15:42:32.391" v="230" actId="164"/>
          <ac:spMkLst>
            <pc:docMk/>
            <pc:sldMk cId="3948585847" sldId="342"/>
            <ac:spMk id="82" creationId="{53F1E74E-7472-7AD1-9888-0640130C6947}"/>
          </ac:spMkLst>
        </pc:spChg>
        <pc:spChg chg="mod topLvl">
          <ac:chgData name="Kumar, Vinod" userId="a0710a6e-bffc-4971-8893-1c23addeb5b0" providerId="ADAL" clId="{A867779D-3C18-41E4-A938-BAAB7B3A31EE}" dt="2023-02-14T15:42:32.391" v="230" actId="164"/>
          <ac:spMkLst>
            <pc:docMk/>
            <pc:sldMk cId="3948585847" sldId="342"/>
            <ac:spMk id="83" creationId="{989F94FB-F79C-F2A3-8C78-43729F28A566}"/>
          </ac:spMkLst>
        </pc:spChg>
        <pc:spChg chg="mod topLvl">
          <ac:chgData name="Kumar, Vinod" userId="a0710a6e-bffc-4971-8893-1c23addeb5b0" providerId="ADAL" clId="{A867779D-3C18-41E4-A938-BAAB7B3A31EE}" dt="2023-02-14T15:42:32.391" v="230" actId="164"/>
          <ac:spMkLst>
            <pc:docMk/>
            <pc:sldMk cId="3948585847" sldId="342"/>
            <ac:spMk id="84" creationId="{31CFD8A3-205E-0F9D-B42D-A981F65502C1}"/>
          </ac:spMkLst>
        </pc:spChg>
        <pc:spChg chg="mod topLvl">
          <ac:chgData name="Kumar, Vinod" userId="a0710a6e-bffc-4971-8893-1c23addeb5b0" providerId="ADAL" clId="{A867779D-3C18-41E4-A938-BAAB7B3A31EE}" dt="2023-02-14T15:42:32.391" v="230" actId="164"/>
          <ac:spMkLst>
            <pc:docMk/>
            <pc:sldMk cId="3948585847" sldId="342"/>
            <ac:spMk id="85" creationId="{6923B5B3-6F66-CF99-167B-1F5D7C3A60BB}"/>
          </ac:spMkLst>
        </pc:spChg>
        <pc:spChg chg="add mod">
          <ac:chgData name="Kumar, Vinod" userId="a0710a6e-bffc-4971-8893-1c23addeb5b0" providerId="ADAL" clId="{A867779D-3C18-41E4-A938-BAAB7B3A31EE}" dt="2023-02-14T15:38:43.847" v="34" actId="164"/>
          <ac:spMkLst>
            <pc:docMk/>
            <pc:sldMk cId="3948585847" sldId="342"/>
            <ac:spMk id="88" creationId="{08B2E07E-229C-65EE-5C95-704EF3CC8E50}"/>
          </ac:spMkLst>
        </pc:spChg>
        <pc:spChg chg="add mod">
          <ac:chgData name="Kumar, Vinod" userId="a0710a6e-bffc-4971-8893-1c23addeb5b0" providerId="ADAL" clId="{A867779D-3C18-41E4-A938-BAAB7B3A31EE}" dt="2023-02-14T15:39:05.783" v="38" actId="20577"/>
          <ac:spMkLst>
            <pc:docMk/>
            <pc:sldMk cId="3948585847" sldId="342"/>
            <ac:spMk id="90" creationId="{F2DEDC8C-3E54-3357-D73A-F325861B832F}"/>
          </ac:spMkLst>
        </pc:spChg>
        <pc:spChg chg="add mod">
          <ac:chgData name="Kumar, Vinod" userId="a0710a6e-bffc-4971-8893-1c23addeb5b0" providerId="ADAL" clId="{A867779D-3C18-41E4-A938-BAAB7B3A31EE}" dt="2023-02-14T15:39:56.470" v="100" actId="20577"/>
          <ac:spMkLst>
            <pc:docMk/>
            <pc:sldMk cId="3948585847" sldId="342"/>
            <ac:spMk id="91" creationId="{EC016C40-6E4D-009B-34C3-70DB5A0E7D35}"/>
          </ac:spMkLst>
        </pc:spChg>
        <pc:spChg chg="add mod">
          <ac:chgData name="Kumar, Vinod" userId="a0710a6e-bffc-4971-8893-1c23addeb5b0" providerId="ADAL" clId="{A867779D-3C18-41E4-A938-BAAB7B3A31EE}" dt="2023-02-14T15:42:13.934" v="229" actId="164"/>
          <ac:spMkLst>
            <pc:docMk/>
            <pc:sldMk cId="3948585847" sldId="342"/>
            <ac:spMk id="96" creationId="{FD190A32-EC43-FBED-3AE1-8DCCD1F38CDB}"/>
          </ac:spMkLst>
        </pc:spChg>
        <pc:spChg chg="add mod">
          <ac:chgData name="Kumar, Vinod" userId="a0710a6e-bffc-4971-8893-1c23addeb5b0" providerId="ADAL" clId="{A867779D-3C18-41E4-A938-BAAB7B3A31EE}" dt="2023-02-14T15:45:20.162" v="533" actId="1035"/>
          <ac:spMkLst>
            <pc:docMk/>
            <pc:sldMk cId="3948585847" sldId="342"/>
            <ac:spMk id="99" creationId="{104B538F-93FA-A7FA-5172-1BDCE4BBF5D4}"/>
          </ac:spMkLst>
        </pc:spChg>
        <pc:spChg chg="add mod">
          <ac:chgData name="Kumar, Vinod" userId="a0710a6e-bffc-4971-8893-1c23addeb5b0" providerId="ADAL" clId="{A867779D-3C18-41E4-A938-BAAB7B3A31EE}" dt="2023-02-14T15:45:31.758" v="534" actId="164"/>
          <ac:spMkLst>
            <pc:docMk/>
            <pc:sldMk cId="3948585847" sldId="342"/>
            <ac:spMk id="101" creationId="{A26C14D9-BA78-E651-1E24-5C78311EA87F}"/>
          </ac:spMkLst>
        </pc:spChg>
        <pc:spChg chg="mod">
          <ac:chgData name="Kumar, Vinod" userId="a0710a6e-bffc-4971-8893-1c23addeb5b0" providerId="ADAL" clId="{A867779D-3C18-41E4-A938-BAAB7B3A31EE}" dt="2023-02-14T15:54:34.773" v="676"/>
          <ac:spMkLst>
            <pc:docMk/>
            <pc:sldMk cId="3948585847" sldId="342"/>
            <ac:spMk id="105" creationId="{0EC93771-85C5-AFF0-7C70-177D6D4D9EF5}"/>
          </ac:spMkLst>
        </pc:spChg>
        <pc:spChg chg="mod">
          <ac:chgData name="Kumar, Vinod" userId="a0710a6e-bffc-4971-8893-1c23addeb5b0" providerId="ADAL" clId="{A867779D-3C18-41E4-A938-BAAB7B3A31EE}" dt="2023-02-14T15:54:34.773" v="676"/>
          <ac:spMkLst>
            <pc:docMk/>
            <pc:sldMk cId="3948585847" sldId="342"/>
            <ac:spMk id="106" creationId="{895F4887-387E-BC0B-A53E-38546596AC21}"/>
          </ac:spMkLst>
        </pc:spChg>
        <pc:spChg chg="mod">
          <ac:chgData name="Kumar, Vinod" userId="a0710a6e-bffc-4971-8893-1c23addeb5b0" providerId="ADAL" clId="{A867779D-3C18-41E4-A938-BAAB7B3A31EE}" dt="2023-02-14T15:54:34.773" v="676"/>
          <ac:spMkLst>
            <pc:docMk/>
            <pc:sldMk cId="3948585847" sldId="342"/>
            <ac:spMk id="107" creationId="{90AB94A7-D75D-416E-7815-FFFE1A4C2BFB}"/>
          </ac:spMkLst>
        </pc:spChg>
        <pc:spChg chg="add mod">
          <ac:chgData name="Kumar, Vinod" userId="a0710a6e-bffc-4971-8893-1c23addeb5b0" providerId="ADAL" clId="{A867779D-3C18-41E4-A938-BAAB7B3A31EE}" dt="2023-02-14T15:57:38.584" v="901" actId="164"/>
          <ac:spMkLst>
            <pc:docMk/>
            <pc:sldMk cId="3948585847" sldId="342"/>
            <ac:spMk id="109" creationId="{23DA51BC-46D7-C714-BAD0-DDEA0C48DD04}"/>
          </ac:spMkLst>
        </pc:spChg>
        <pc:spChg chg="add mod">
          <ac:chgData name="Kumar, Vinod" userId="a0710a6e-bffc-4971-8893-1c23addeb5b0" providerId="ADAL" clId="{A867779D-3C18-41E4-A938-BAAB7B3A31EE}" dt="2023-02-14T15:57:38.584" v="901" actId="164"/>
          <ac:spMkLst>
            <pc:docMk/>
            <pc:sldMk cId="3948585847" sldId="342"/>
            <ac:spMk id="111" creationId="{796A20B1-F33F-6E94-C0A3-64B78D5437E6}"/>
          </ac:spMkLst>
        </pc:spChg>
        <pc:grpChg chg="mod">
          <ac:chgData name="Kumar, Vinod" userId="a0710a6e-bffc-4971-8893-1c23addeb5b0" providerId="ADAL" clId="{A867779D-3C18-41E4-A938-BAAB7B3A31EE}" dt="2023-02-14T15:46:11.796" v="536" actId="165"/>
          <ac:grpSpMkLst>
            <pc:docMk/>
            <pc:sldMk cId="3948585847" sldId="342"/>
            <ac:grpSpMk id="6" creationId="{4497055C-E984-9441-36D9-F5323534E923}"/>
          </ac:grpSpMkLst>
        </pc:grpChg>
        <pc:grpChg chg="mod">
          <ac:chgData name="Kumar, Vinod" userId="a0710a6e-bffc-4971-8893-1c23addeb5b0" providerId="ADAL" clId="{A867779D-3C18-41E4-A938-BAAB7B3A31EE}" dt="2023-02-14T15:41:11.743" v="153" actId="164"/>
          <ac:grpSpMkLst>
            <pc:docMk/>
            <pc:sldMk cId="3948585847" sldId="342"/>
            <ac:grpSpMk id="33" creationId="{75601909-1754-F22C-3E43-876550643757}"/>
          </ac:grpSpMkLst>
        </pc:grpChg>
        <pc:grpChg chg="mod">
          <ac:chgData name="Kumar, Vinod" userId="a0710a6e-bffc-4971-8893-1c23addeb5b0" providerId="ADAL" clId="{A867779D-3C18-41E4-A938-BAAB7B3A31EE}" dt="2023-02-14T15:41:11.743" v="153" actId="164"/>
          <ac:grpSpMkLst>
            <pc:docMk/>
            <pc:sldMk cId="3948585847" sldId="342"/>
            <ac:grpSpMk id="34" creationId="{21E7EA6F-6BAE-5522-8B36-9DCE9C49171A}"/>
          </ac:grpSpMkLst>
        </pc:grpChg>
        <pc:grpChg chg="mod">
          <ac:chgData name="Kumar, Vinod" userId="a0710a6e-bffc-4971-8893-1c23addeb5b0" providerId="ADAL" clId="{A867779D-3C18-41E4-A938-BAAB7B3A31EE}" dt="2023-02-14T15:41:11.743" v="153" actId="164"/>
          <ac:grpSpMkLst>
            <pc:docMk/>
            <pc:sldMk cId="3948585847" sldId="342"/>
            <ac:grpSpMk id="35" creationId="{8915A6AA-698D-721D-49CC-122DFB94C3F5}"/>
          </ac:grpSpMkLst>
        </pc:grpChg>
        <pc:grpChg chg="mod topLvl">
          <ac:chgData name="Kumar, Vinod" userId="a0710a6e-bffc-4971-8893-1c23addeb5b0" providerId="ADAL" clId="{A867779D-3C18-41E4-A938-BAAB7B3A31EE}" dt="2023-02-14T15:57:38.584" v="901" actId="164"/>
          <ac:grpSpMkLst>
            <pc:docMk/>
            <pc:sldMk cId="3948585847" sldId="342"/>
            <ac:grpSpMk id="46" creationId="{B9D9D27D-56CD-C3FA-5481-285BC2845719}"/>
          </ac:grpSpMkLst>
        </pc:grpChg>
        <pc:grpChg chg="mod topLvl">
          <ac:chgData name="Kumar, Vinod" userId="a0710a6e-bffc-4971-8893-1c23addeb5b0" providerId="ADAL" clId="{A867779D-3C18-41E4-A938-BAAB7B3A31EE}" dt="2023-02-14T15:57:38.584" v="901" actId="164"/>
          <ac:grpSpMkLst>
            <pc:docMk/>
            <pc:sldMk cId="3948585847" sldId="342"/>
            <ac:grpSpMk id="47" creationId="{4E14227D-66B9-EC00-FF14-5196710CEF42}"/>
          </ac:grpSpMkLst>
        </pc:grpChg>
        <pc:grpChg chg="mod">
          <ac:chgData name="Kumar, Vinod" userId="a0710a6e-bffc-4971-8893-1c23addeb5b0" providerId="ADAL" clId="{A867779D-3C18-41E4-A938-BAAB7B3A31EE}" dt="2023-02-14T15:40:54.943" v="151" actId="164"/>
          <ac:grpSpMkLst>
            <pc:docMk/>
            <pc:sldMk cId="3948585847" sldId="342"/>
            <ac:grpSpMk id="61" creationId="{2C8F7144-F32F-234E-9CEA-E5D3C66964D9}"/>
          </ac:grpSpMkLst>
        </pc:grpChg>
        <pc:grpChg chg="mod topLvl">
          <ac:chgData name="Kumar, Vinod" userId="a0710a6e-bffc-4971-8893-1c23addeb5b0" providerId="ADAL" clId="{A867779D-3C18-41E4-A938-BAAB7B3A31EE}" dt="2023-02-14T15:45:31.758" v="534" actId="164"/>
          <ac:grpSpMkLst>
            <pc:docMk/>
            <pc:sldMk cId="3948585847" sldId="342"/>
            <ac:grpSpMk id="69" creationId="{39456897-A16A-355B-696E-FF6CCEDEF582}"/>
          </ac:grpSpMkLst>
        </pc:grpChg>
        <pc:grpChg chg="del mod">
          <ac:chgData name="Kumar, Vinod" userId="a0710a6e-bffc-4971-8893-1c23addeb5b0" providerId="ADAL" clId="{A867779D-3C18-41E4-A938-BAAB7B3A31EE}" dt="2023-02-14T15:43:48.542" v="375" actId="165"/>
          <ac:grpSpMkLst>
            <pc:docMk/>
            <pc:sldMk cId="3948585847" sldId="342"/>
            <ac:grpSpMk id="70" creationId="{5A2AD2FA-E460-6C1E-0DF6-FDF1F6715D72}"/>
          </ac:grpSpMkLst>
        </pc:grpChg>
        <pc:grpChg chg="mod topLvl">
          <ac:chgData name="Kumar, Vinod" userId="a0710a6e-bffc-4971-8893-1c23addeb5b0" providerId="ADAL" clId="{A867779D-3C18-41E4-A938-BAAB7B3A31EE}" dt="2023-02-14T15:42:13.934" v="229" actId="164"/>
          <ac:grpSpMkLst>
            <pc:docMk/>
            <pc:sldMk cId="3948585847" sldId="342"/>
            <ac:grpSpMk id="80" creationId="{BFF64DEC-2AD8-D775-6904-3389C87E6A2C}"/>
          </ac:grpSpMkLst>
        </pc:grpChg>
        <pc:grpChg chg="del mod">
          <ac:chgData name="Kumar, Vinod" userId="a0710a6e-bffc-4971-8893-1c23addeb5b0" providerId="ADAL" clId="{A867779D-3C18-41E4-A938-BAAB7B3A31EE}" dt="2023-02-14T15:41:27.627" v="155" actId="165"/>
          <ac:grpSpMkLst>
            <pc:docMk/>
            <pc:sldMk cId="3948585847" sldId="342"/>
            <ac:grpSpMk id="86" creationId="{0189D281-3135-20B2-0374-AEC9914C971E}"/>
          </ac:grpSpMkLst>
        </pc:grpChg>
        <pc:grpChg chg="add mod">
          <ac:chgData name="Kumar, Vinod" userId="a0710a6e-bffc-4971-8893-1c23addeb5b0" providerId="ADAL" clId="{A867779D-3C18-41E4-A938-BAAB7B3A31EE}" dt="2023-02-14T15:38:43.847" v="34" actId="164"/>
          <ac:grpSpMkLst>
            <pc:docMk/>
            <pc:sldMk cId="3948585847" sldId="342"/>
            <ac:grpSpMk id="89" creationId="{D2EEE6D8-30D6-54F7-E518-352F2C68F55F}"/>
          </ac:grpSpMkLst>
        </pc:grpChg>
        <pc:grpChg chg="add del mod">
          <ac:chgData name="Kumar, Vinod" userId="a0710a6e-bffc-4971-8893-1c23addeb5b0" providerId="ADAL" clId="{A867779D-3C18-41E4-A938-BAAB7B3A31EE}" dt="2023-02-14T15:46:11.796" v="536" actId="165"/>
          <ac:grpSpMkLst>
            <pc:docMk/>
            <pc:sldMk cId="3948585847" sldId="342"/>
            <ac:grpSpMk id="92" creationId="{E322B462-EA27-5605-4A8C-72521583E3C6}"/>
          </ac:grpSpMkLst>
        </pc:grpChg>
        <pc:grpChg chg="add del mod">
          <ac:chgData name="Kumar, Vinod" userId="a0710a6e-bffc-4971-8893-1c23addeb5b0" providerId="ADAL" clId="{A867779D-3C18-41E4-A938-BAAB7B3A31EE}" dt="2023-02-14T15:54:01.585" v="675" actId="478"/>
          <ac:grpSpMkLst>
            <pc:docMk/>
            <pc:sldMk cId="3948585847" sldId="342"/>
            <ac:grpSpMk id="93" creationId="{1A97FB04-15A4-4111-186B-1DAA582AD4F9}"/>
          </ac:grpSpMkLst>
        </pc:grpChg>
        <pc:grpChg chg="add del mod">
          <ac:chgData name="Kumar, Vinod" userId="a0710a6e-bffc-4971-8893-1c23addeb5b0" providerId="ADAL" clId="{A867779D-3C18-41E4-A938-BAAB7B3A31EE}" dt="2023-02-14T15:53:54.495" v="674" actId="478"/>
          <ac:grpSpMkLst>
            <pc:docMk/>
            <pc:sldMk cId="3948585847" sldId="342"/>
            <ac:grpSpMk id="94" creationId="{729147D2-BAD7-1E78-279F-1737C864AE96}"/>
          </ac:grpSpMkLst>
        </pc:grpChg>
        <pc:grpChg chg="add mod">
          <ac:chgData name="Kumar, Vinod" userId="a0710a6e-bffc-4971-8893-1c23addeb5b0" providerId="ADAL" clId="{A867779D-3C18-41E4-A938-BAAB7B3A31EE}" dt="2023-02-14T15:42:32.391" v="230" actId="164"/>
          <ac:grpSpMkLst>
            <pc:docMk/>
            <pc:sldMk cId="3948585847" sldId="342"/>
            <ac:grpSpMk id="97" creationId="{2BB44B52-981D-A175-DAC4-FDC388F1B9A9}"/>
          </ac:grpSpMkLst>
        </pc:grpChg>
        <pc:grpChg chg="add mod">
          <ac:chgData name="Kumar, Vinod" userId="a0710a6e-bffc-4971-8893-1c23addeb5b0" providerId="ADAL" clId="{A867779D-3C18-41E4-A938-BAAB7B3A31EE}" dt="2023-02-14T15:42:44.133" v="249" actId="1037"/>
          <ac:grpSpMkLst>
            <pc:docMk/>
            <pc:sldMk cId="3948585847" sldId="342"/>
            <ac:grpSpMk id="98" creationId="{5F772684-8D08-545A-D6A1-FCA5BAD1104B}"/>
          </ac:grpSpMkLst>
        </pc:grpChg>
        <pc:grpChg chg="add mod">
          <ac:chgData name="Kumar, Vinod" userId="a0710a6e-bffc-4971-8893-1c23addeb5b0" providerId="ADAL" clId="{A867779D-3C18-41E4-A938-BAAB7B3A31EE}" dt="2023-02-14T15:45:31.758" v="534" actId="164"/>
          <ac:grpSpMkLst>
            <pc:docMk/>
            <pc:sldMk cId="3948585847" sldId="342"/>
            <ac:grpSpMk id="102" creationId="{D326074B-49E5-A275-7E99-2355077F7F6A}"/>
          </ac:grpSpMkLst>
        </pc:grpChg>
        <pc:grpChg chg="add del mod">
          <ac:chgData name="Kumar, Vinod" userId="a0710a6e-bffc-4971-8893-1c23addeb5b0" providerId="ADAL" clId="{A867779D-3C18-41E4-A938-BAAB7B3A31EE}" dt="2023-02-14T15:54:37.590" v="677"/>
          <ac:grpSpMkLst>
            <pc:docMk/>
            <pc:sldMk cId="3948585847" sldId="342"/>
            <ac:grpSpMk id="103" creationId="{1DDE03DD-5097-3FE4-77BA-01C9AA38B35B}"/>
          </ac:grpSpMkLst>
        </pc:grpChg>
        <pc:grpChg chg="add mod">
          <ac:chgData name="Kumar, Vinod" userId="a0710a6e-bffc-4971-8893-1c23addeb5b0" providerId="ADAL" clId="{A867779D-3C18-41E4-A938-BAAB7B3A31EE}" dt="2023-02-14T15:57:38.584" v="901" actId="164"/>
          <ac:grpSpMkLst>
            <pc:docMk/>
            <pc:sldMk cId="3948585847" sldId="342"/>
            <ac:grpSpMk id="113" creationId="{DD51F9FB-9D7C-FCE5-E721-B4B6DA85268C}"/>
          </ac:grpSpMkLst>
        </pc:grpChg>
        <pc:picChg chg="mod">
          <ac:chgData name="Kumar, Vinod" userId="a0710a6e-bffc-4971-8893-1c23addeb5b0" providerId="ADAL" clId="{A867779D-3C18-41E4-A938-BAAB7B3A31EE}" dt="2023-02-14T15:38:43.847" v="34" actId="164"/>
          <ac:picMkLst>
            <pc:docMk/>
            <pc:sldMk cId="3948585847" sldId="342"/>
            <ac:picMk id="2" creationId="{C23741A6-C178-F36E-AC5E-FAF41F4969B4}"/>
          </ac:picMkLst>
        </pc:picChg>
        <pc:picChg chg="mod">
          <ac:chgData name="Kumar, Vinod" userId="a0710a6e-bffc-4971-8893-1c23addeb5b0" providerId="ADAL" clId="{A867779D-3C18-41E4-A938-BAAB7B3A31EE}" dt="2023-02-14T15:46:11.796" v="536" actId="165"/>
          <ac:picMkLst>
            <pc:docMk/>
            <pc:sldMk cId="3948585847" sldId="342"/>
            <ac:picMk id="3" creationId="{C51885F4-FC55-9876-C8EE-4ADE943B8B50}"/>
          </ac:picMkLst>
        </pc:picChg>
        <pc:picChg chg="mod">
          <ac:chgData name="Kumar, Vinod" userId="a0710a6e-bffc-4971-8893-1c23addeb5b0" providerId="ADAL" clId="{A867779D-3C18-41E4-A938-BAAB7B3A31EE}" dt="2023-02-14T15:38:43.847" v="34" actId="164"/>
          <ac:picMkLst>
            <pc:docMk/>
            <pc:sldMk cId="3948585847" sldId="342"/>
            <ac:picMk id="9" creationId="{E90AA583-2EF3-02DF-41E1-AB6C156E748B}"/>
          </ac:picMkLst>
        </pc:picChg>
        <pc:picChg chg="mod">
          <ac:chgData name="Kumar, Vinod" userId="a0710a6e-bffc-4971-8893-1c23addeb5b0" providerId="ADAL" clId="{A867779D-3C18-41E4-A938-BAAB7B3A31EE}" dt="2023-02-14T15:46:11.796" v="536" actId="165"/>
          <ac:picMkLst>
            <pc:docMk/>
            <pc:sldMk cId="3948585847" sldId="342"/>
            <ac:picMk id="11" creationId="{A8597543-0F87-CE77-9D43-6CB435EB8758}"/>
          </ac:picMkLst>
        </pc:picChg>
        <pc:picChg chg="mod">
          <ac:chgData name="Kumar, Vinod" userId="a0710a6e-bffc-4971-8893-1c23addeb5b0" providerId="ADAL" clId="{A867779D-3C18-41E4-A938-BAAB7B3A31EE}" dt="2023-02-14T15:38:43.847" v="34" actId="164"/>
          <ac:picMkLst>
            <pc:docMk/>
            <pc:sldMk cId="3948585847" sldId="342"/>
            <ac:picMk id="36" creationId="{519C8745-A372-C9D2-E985-A2010EA2019E}"/>
          </ac:picMkLst>
        </pc:picChg>
        <pc:picChg chg="mod">
          <ac:chgData name="Kumar, Vinod" userId="a0710a6e-bffc-4971-8893-1c23addeb5b0" providerId="ADAL" clId="{A867779D-3C18-41E4-A938-BAAB7B3A31EE}" dt="2023-02-14T15:43:48.542" v="375" actId="165"/>
          <ac:picMkLst>
            <pc:docMk/>
            <pc:sldMk cId="3948585847" sldId="342"/>
            <ac:picMk id="58" creationId="{CCE6FA18-A13D-15FB-4822-82F303B1BEDA}"/>
          </ac:picMkLst>
        </pc:picChg>
        <pc:picChg chg="mod">
          <ac:chgData name="Kumar, Vinod" userId="a0710a6e-bffc-4971-8893-1c23addeb5b0" providerId="ADAL" clId="{A867779D-3C18-41E4-A938-BAAB7B3A31EE}" dt="2023-02-14T15:43:48.542" v="375" actId="165"/>
          <ac:picMkLst>
            <pc:docMk/>
            <pc:sldMk cId="3948585847" sldId="342"/>
            <ac:picMk id="59" creationId="{A1D00A61-C648-AF21-FD72-FC55ECC4A063}"/>
          </ac:picMkLst>
        </pc:picChg>
        <pc:picChg chg="mod">
          <ac:chgData name="Kumar, Vinod" userId="a0710a6e-bffc-4971-8893-1c23addeb5b0" providerId="ADAL" clId="{A867779D-3C18-41E4-A938-BAAB7B3A31EE}" dt="2023-02-14T15:43:48.542" v="375" actId="165"/>
          <ac:picMkLst>
            <pc:docMk/>
            <pc:sldMk cId="3948585847" sldId="342"/>
            <ac:picMk id="60" creationId="{9A834501-0B3E-088D-01E6-ED8FEFA4C07D}"/>
          </ac:picMkLst>
        </pc:picChg>
        <pc:picChg chg="mod">
          <ac:chgData name="Kumar, Vinod" userId="a0710a6e-bffc-4971-8893-1c23addeb5b0" providerId="ADAL" clId="{A867779D-3C18-41E4-A938-BAAB7B3A31EE}" dt="2023-02-14T15:41:27.627" v="155" actId="165"/>
          <ac:picMkLst>
            <pc:docMk/>
            <pc:sldMk cId="3948585847" sldId="342"/>
            <ac:picMk id="71" creationId="{99EB5184-EABD-6175-BB7C-A2AEFE4A9692}"/>
          </ac:picMkLst>
        </pc:picChg>
        <pc:picChg chg="mod">
          <ac:chgData name="Kumar, Vinod" userId="a0710a6e-bffc-4971-8893-1c23addeb5b0" providerId="ADAL" clId="{A867779D-3C18-41E4-A938-BAAB7B3A31EE}" dt="2023-02-14T15:41:27.627" v="155" actId="165"/>
          <ac:picMkLst>
            <pc:docMk/>
            <pc:sldMk cId="3948585847" sldId="342"/>
            <ac:picMk id="72" creationId="{A6FE2562-1945-AC14-12C9-79570359692B}"/>
          </ac:picMkLst>
        </pc:picChg>
        <pc:picChg chg="mod">
          <ac:chgData name="Kumar, Vinod" userId="a0710a6e-bffc-4971-8893-1c23addeb5b0" providerId="ADAL" clId="{A867779D-3C18-41E4-A938-BAAB7B3A31EE}" dt="2023-02-14T15:41:27.627" v="155" actId="165"/>
          <ac:picMkLst>
            <pc:docMk/>
            <pc:sldMk cId="3948585847" sldId="342"/>
            <ac:picMk id="73" creationId="{A9AF78E0-228D-D800-D300-755BB11E48FE}"/>
          </ac:picMkLst>
        </pc:picChg>
        <pc:picChg chg="mod">
          <ac:chgData name="Kumar, Vinod" userId="a0710a6e-bffc-4971-8893-1c23addeb5b0" providerId="ADAL" clId="{A867779D-3C18-41E4-A938-BAAB7B3A31EE}" dt="2023-02-14T15:41:27.627" v="155" actId="165"/>
          <ac:picMkLst>
            <pc:docMk/>
            <pc:sldMk cId="3948585847" sldId="342"/>
            <ac:picMk id="74" creationId="{A68E6DF1-D527-7574-D2F2-839BEF029176}"/>
          </ac:picMkLst>
        </pc:picChg>
        <pc:picChg chg="mod">
          <ac:chgData name="Kumar, Vinod" userId="a0710a6e-bffc-4971-8893-1c23addeb5b0" providerId="ADAL" clId="{A867779D-3C18-41E4-A938-BAAB7B3A31EE}" dt="2023-02-14T15:54:34.773" v="676"/>
          <ac:picMkLst>
            <pc:docMk/>
            <pc:sldMk cId="3948585847" sldId="342"/>
            <ac:picMk id="104" creationId="{4DC61708-26DF-7D0A-2F0F-FF1919EA6255}"/>
          </ac:picMkLst>
        </pc:picChg>
        <pc:cxnChg chg="add mod">
          <ac:chgData name="Kumar, Vinod" userId="a0710a6e-bffc-4971-8893-1c23addeb5b0" providerId="ADAL" clId="{A867779D-3C18-41E4-A938-BAAB7B3A31EE}" dt="2023-02-14T15:38:43.847" v="34" actId="164"/>
          <ac:cxnSpMkLst>
            <pc:docMk/>
            <pc:sldMk cId="3948585847" sldId="342"/>
            <ac:cxnSpMk id="87" creationId="{C6A228B4-5F8D-1AE0-EB3E-D100E8E63490}"/>
          </ac:cxnSpMkLst>
        </pc:cxnChg>
        <pc:cxnChg chg="add mod">
          <ac:chgData name="Kumar, Vinod" userId="a0710a6e-bffc-4971-8893-1c23addeb5b0" providerId="ADAL" clId="{A867779D-3C18-41E4-A938-BAAB7B3A31EE}" dt="2023-02-14T15:42:13.934" v="229" actId="164"/>
          <ac:cxnSpMkLst>
            <pc:docMk/>
            <pc:sldMk cId="3948585847" sldId="342"/>
            <ac:cxnSpMk id="95" creationId="{B7669CB6-E0C2-1CA1-D936-DB94F115EE83}"/>
          </ac:cxnSpMkLst>
        </pc:cxnChg>
        <pc:cxnChg chg="add mod">
          <ac:chgData name="Kumar, Vinod" userId="a0710a6e-bffc-4971-8893-1c23addeb5b0" providerId="ADAL" clId="{A867779D-3C18-41E4-A938-BAAB7B3A31EE}" dt="2023-02-14T15:45:31.758" v="534" actId="164"/>
          <ac:cxnSpMkLst>
            <pc:docMk/>
            <pc:sldMk cId="3948585847" sldId="342"/>
            <ac:cxnSpMk id="100" creationId="{E06C800B-A6D4-C5C2-9A5C-178488EB8C21}"/>
          </ac:cxnSpMkLst>
        </pc:cxnChg>
        <pc:cxnChg chg="add mod">
          <ac:chgData name="Kumar, Vinod" userId="a0710a6e-bffc-4971-8893-1c23addeb5b0" providerId="ADAL" clId="{A867779D-3C18-41E4-A938-BAAB7B3A31EE}" dt="2023-02-14T15:57:38.584" v="901" actId="164"/>
          <ac:cxnSpMkLst>
            <pc:docMk/>
            <pc:sldMk cId="3948585847" sldId="342"/>
            <ac:cxnSpMk id="108" creationId="{7B1C985C-BFE8-5463-5688-2A63490548A2}"/>
          </ac:cxnSpMkLst>
        </pc:cxnChg>
        <pc:cxnChg chg="add mod">
          <ac:chgData name="Kumar, Vinod" userId="a0710a6e-bffc-4971-8893-1c23addeb5b0" providerId="ADAL" clId="{A867779D-3C18-41E4-A938-BAAB7B3A31EE}" dt="2023-02-14T15:57:38.584" v="901" actId="164"/>
          <ac:cxnSpMkLst>
            <pc:docMk/>
            <pc:sldMk cId="3948585847" sldId="342"/>
            <ac:cxnSpMk id="110" creationId="{3863EE04-D6D1-13D2-AACD-D1C99E4BD074}"/>
          </ac:cxnSpMkLst>
        </pc:cxnChg>
        <pc:cxnChg chg="add mod">
          <ac:chgData name="Kumar, Vinod" userId="a0710a6e-bffc-4971-8893-1c23addeb5b0" providerId="ADAL" clId="{A867779D-3C18-41E4-A938-BAAB7B3A31EE}" dt="2023-02-14T15:57:38.584" v="901" actId="164"/>
          <ac:cxnSpMkLst>
            <pc:docMk/>
            <pc:sldMk cId="3948585847" sldId="342"/>
            <ac:cxnSpMk id="112" creationId="{E40145F0-6C88-FA95-D3F9-F268C502C6C8}"/>
          </ac:cxnSpMkLst>
        </pc:cxnChg>
      </pc:sldChg>
      <pc:sldChg chg="addSp delSp modSp new mod">
        <pc:chgData name="Kumar, Vinod" userId="a0710a6e-bffc-4971-8893-1c23addeb5b0" providerId="ADAL" clId="{A867779D-3C18-41E4-A938-BAAB7B3A31EE}" dt="2023-02-14T16:13:37.749" v="1206" actId="20577"/>
        <pc:sldMkLst>
          <pc:docMk/>
          <pc:sldMk cId="3501267655" sldId="343"/>
        </pc:sldMkLst>
        <pc:spChg chg="mod topLvl">
          <ac:chgData name="Kumar, Vinod" userId="a0710a6e-bffc-4971-8893-1c23addeb5b0" providerId="ADAL" clId="{A867779D-3C18-41E4-A938-BAAB7B3A31EE}" dt="2023-02-14T15:48:18.929" v="583" actId="1076"/>
          <ac:spMkLst>
            <pc:docMk/>
            <pc:sldMk cId="3501267655" sldId="343"/>
            <ac:spMk id="6" creationId="{7B7E5254-1B7D-D55A-311A-48F62AF978BE}"/>
          </ac:spMkLst>
        </pc:spChg>
        <pc:spChg chg="mod">
          <ac:chgData name="Kumar, Vinod" userId="a0710a6e-bffc-4971-8893-1c23addeb5b0" providerId="ADAL" clId="{A867779D-3C18-41E4-A938-BAAB7B3A31EE}" dt="2023-02-14T15:48:09.556" v="582" actId="165"/>
          <ac:spMkLst>
            <pc:docMk/>
            <pc:sldMk cId="3501267655" sldId="343"/>
            <ac:spMk id="8" creationId="{693E03BA-EF77-CF81-CB71-59C480978A52}"/>
          </ac:spMkLst>
        </pc:spChg>
        <pc:spChg chg="mod">
          <ac:chgData name="Kumar, Vinod" userId="a0710a6e-bffc-4971-8893-1c23addeb5b0" providerId="ADAL" clId="{A867779D-3C18-41E4-A938-BAAB7B3A31EE}" dt="2023-02-14T15:48:09.556" v="582" actId="165"/>
          <ac:spMkLst>
            <pc:docMk/>
            <pc:sldMk cId="3501267655" sldId="343"/>
            <ac:spMk id="9" creationId="{604F25AB-FC54-E7E6-86F6-D5138EE3A745}"/>
          </ac:spMkLst>
        </pc:spChg>
        <pc:spChg chg="del mod">
          <ac:chgData name="Kumar, Vinod" userId="a0710a6e-bffc-4971-8893-1c23addeb5b0" providerId="ADAL" clId="{A867779D-3C18-41E4-A938-BAAB7B3A31EE}" dt="2023-02-14T15:49:26.193" v="607" actId="478"/>
          <ac:spMkLst>
            <pc:docMk/>
            <pc:sldMk cId="3501267655" sldId="343"/>
            <ac:spMk id="10" creationId="{4AA08F2C-66B2-79EA-F8AE-2D551F294450}"/>
          </ac:spMkLst>
        </pc:spChg>
        <pc:spChg chg="del mod">
          <ac:chgData name="Kumar, Vinod" userId="a0710a6e-bffc-4971-8893-1c23addeb5b0" providerId="ADAL" clId="{A867779D-3C18-41E4-A938-BAAB7B3A31EE}" dt="2023-02-14T15:49:28.912" v="608" actId="478"/>
          <ac:spMkLst>
            <pc:docMk/>
            <pc:sldMk cId="3501267655" sldId="343"/>
            <ac:spMk id="11" creationId="{E5EE74B5-7E74-9007-0716-943C83115E65}"/>
          </ac:spMkLst>
        </pc:spChg>
        <pc:spChg chg="mod">
          <ac:chgData name="Kumar, Vinod" userId="a0710a6e-bffc-4971-8893-1c23addeb5b0" providerId="ADAL" clId="{A867779D-3C18-41E4-A938-BAAB7B3A31EE}" dt="2023-02-14T15:48:45.548" v="587" actId="571"/>
          <ac:spMkLst>
            <pc:docMk/>
            <pc:sldMk cId="3501267655" sldId="343"/>
            <ac:spMk id="13" creationId="{E4563F4B-FB3D-0A22-6828-6F82882A5B2B}"/>
          </ac:spMkLst>
        </pc:spChg>
        <pc:spChg chg="mod">
          <ac:chgData name="Kumar, Vinod" userId="a0710a6e-bffc-4971-8893-1c23addeb5b0" providerId="ADAL" clId="{A867779D-3C18-41E4-A938-BAAB7B3A31EE}" dt="2023-02-14T15:48:45.548" v="587" actId="571"/>
          <ac:spMkLst>
            <pc:docMk/>
            <pc:sldMk cId="3501267655" sldId="343"/>
            <ac:spMk id="14" creationId="{F6ADA623-1118-6DF1-878A-393A100C3CDD}"/>
          </ac:spMkLst>
        </pc:spChg>
        <pc:spChg chg="del mod">
          <ac:chgData name="Kumar, Vinod" userId="a0710a6e-bffc-4971-8893-1c23addeb5b0" providerId="ADAL" clId="{A867779D-3C18-41E4-A938-BAAB7B3A31EE}" dt="2023-02-14T15:48:58.833" v="592" actId="478"/>
          <ac:spMkLst>
            <pc:docMk/>
            <pc:sldMk cId="3501267655" sldId="343"/>
            <ac:spMk id="15" creationId="{4EFAAE6D-D963-9C23-3BEE-458E49D3A046}"/>
          </ac:spMkLst>
        </pc:spChg>
        <pc:spChg chg="del mod">
          <ac:chgData name="Kumar, Vinod" userId="a0710a6e-bffc-4971-8893-1c23addeb5b0" providerId="ADAL" clId="{A867779D-3C18-41E4-A938-BAAB7B3A31EE}" dt="2023-02-14T15:49:04.625" v="594" actId="478"/>
          <ac:spMkLst>
            <pc:docMk/>
            <pc:sldMk cId="3501267655" sldId="343"/>
            <ac:spMk id="16" creationId="{EEE6B829-1653-658E-A22A-D0C13F161E2C}"/>
          </ac:spMkLst>
        </pc:spChg>
        <pc:spChg chg="mod topLvl">
          <ac:chgData name="Kumar, Vinod" userId="a0710a6e-bffc-4971-8893-1c23addeb5b0" providerId="ADAL" clId="{A867779D-3C18-41E4-A938-BAAB7B3A31EE}" dt="2023-02-14T15:49:53.002" v="619" actId="164"/>
          <ac:spMkLst>
            <pc:docMk/>
            <pc:sldMk cId="3501267655" sldId="343"/>
            <ac:spMk id="18" creationId="{B8532D2A-0FDD-1C6E-2C99-2425266E51E7}"/>
          </ac:spMkLst>
        </pc:spChg>
        <pc:spChg chg="mod topLvl">
          <ac:chgData name="Kumar, Vinod" userId="a0710a6e-bffc-4971-8893-1c23addeb5b0" providerId="ADAL" clId="{A867779D-3C18-41E4-A938-BAAB7B3A31EE}" dt="2023-02-14T15:49:53.002" v="619" actId="164"/>
          <ac:spMkLst>
            <pc:docMk/>
            <pc:sldMk cId="3501267655" sldId="343"/>
            <ac:spMk id="19" creationId="{88EBB550-8AC8-691D-E3DD-33A0E9E508CD}"/>
          </ac:spMkLst>
        </pc:spChg>
        <pc:spChg chg="mod topLvl">
          <ac:chgData name="Kumar, Vinod" userId="a0710a6e-bffc-4971-8893-1c23addeb5b0" providerId="ADAL" clId="{A867779D-3C18-41E4-A938-BAAB7B3A31EE}" dt="2023-02-14T15:49:53.002" v="619" actId="164"/>
          <ac:spMkLst>
            <pc:docMk/>
            <pc:sldMk cId="3501267655" sldId="343"/>
            <ac:spMk id="20" creationId="{76A4F3AF-7BD0-BF89-8B54-1A2A286BD64D}"/>
          </ac:spMkLst>
        </pc:spChg>
        <pc:spChg chg="mod topLvl">
          <ac:chgData name="Kumar, Vinod" userId="a0710a6e-bffc-4971-8893-1c23addeb5b0" providerId="ADAL" clId="{A867779D-3C18-41E4-A938-BAAB7B3A31EE}" dt="2023-02-14T15:49:53.002" v="619" actId="164"/>
          <ac:spMkLst>
            <pc:docMk/>
            <pc:sldMk cId="3501267655" sldId="343"/>
            <ac:spMk id="21" creationId="{5DBBD448-57A1-10A0-B354-F79F11B03804}"/>
          </ac:spMkLst>
        </pc:spChg>
        <pc:spChg chg="add del mod">
          <ac:chgData name="Kumar, Vinod" userId="a0710a6e-bffc-4971-8893-1c23addeb5b0" providerId="ADAL" clId="{A867779D-3C18-41E4-A938-BAAB7B3A31EE}" dt="2023-02-14T15:48:55.521" v="590" actId="478"/>
          <ac:spMkLst>
            <pc:docMk/>
            <pc:sldMk cId="3501267655" sldId="343"/>
            <ac:spMk id="22" creationId="{8C344923-EF18-BF5D-8985-3A13D0D5CCCF}"/>
          </ac:spMkLst>
        </pc:spChg>
        <pc:spChg chg="add del mod">
          <ac:chgData name="Kumar, Vinod" userId="a0710a6e-bffc-4971-8893-1c23addeb5b0" providerId="ADAL" clId="{A867779D-3C18-41E4-A938-BAAB7B3A31EE}" dt="2023-02-14T15:49:02.385" v="593" actId="478"/>
          <ac:spMkLst>
            <pc:docMk/>
            <pc:sldMk cId="3501267655" sldId="343"/>
            <ac:spMk id="23" creationId="{5DAA112E-404E-AB7E-F209-FDC4905C99D8}"/>
          </ac:spMkLst>
        </pc:spChg>
        <pc:spChg chg="mod">
          <ac:chgData name="Kumar, Vinod" userId="a0710a6e-bffc-4971-8893-1c23addeb5b0" providerId="ADAL" clId="{A867779D-3C18-41E4-A938-BAAB7B3A31EE}" dt="2023-02-14T15:50:40.071" v="621"/>
          <ac:spMkLst>
            <pc:docMk/>
            <pc:sldMk cId="3501267655" sldId="343"/>
            <ac:spMk id="26" creationId="{0D27D2C5-C5D9-C3A6-8264-CFB8BF0C74B7}"/>
          </ac:spMkLst>
        </pc:spChg>
        <pc:spChg chg="mod">
          <ac:chgData name="Kumar, Vinod" userId="a0710a6e-bffc-4971-8893-1c23addeb5b0" providerId="ADAL" clId="{A867779D-3C18-41E4-A938-BAAB7B3A31EE}" dt="2023-02-14T15:51:16.848" v="648" actId="1036"/>
          <ac:spMkLst>
            <pc:docMk/>
            <pc:sldMk cId="3501267655" sldId="343"/>
            <ac:spMk id="28" creationId="{17098AA9-5907-8B57-98F4-D1AD2035DB66}"/>
          </ac:spMkLst>
        </pc:spChg>
        <pc:spChg chg="mod">
          <ac:chgData name="Kumar, Vinod" userId="a0710a6e-bffc-4971-8893-1c23addeb5b0" providerId="ADAL" clId="{A867779D-3C18-41E4-A938-BAAB7B3A31EE}" dt="2023-02-14T15:50:40.071" v="621"/>
          <ac:spMkLst>
            <pc:docMk/>
            <pc:sldMk cId="3501267655" sldId="343"/>
            <ac:spMk id="31" creationId="{279C7BB5-42BF-B0D3-1496-DBBCF25816C7}"/>
          </ac:spMkLst>
        </pc:spChg>
        <pc:spChg chg="mod">
          <ac:chgData name="Kumar, Vinod" userId="a0710a6e-bffc-4971-8893-1c23addeb5b0" providerId="ADAL" clId="{A867779D-3C18-41E4-A938-BAAB7B3A31EE}" dt="2023-02-14T15:50:40.071" v="621"/>
          <ac:spMkLst>
            <pc:docMk/>
            <pc:sldMk cId="3501267655" sldId="343"/>
            <ac:spMk id="32" creationId="{3564D752-2DF0-04C8-04BA-A83178BE0407}"/>
          </ac:spMkLst>
        </pc:spChg>
        <pc:spChg chg="mod">
          <ac:chgData name="Kumar, Vinod" userId="a0710a6e-bffc-4971-8893-1c23addeb5b0" providerId="ADAL" clId="{A867779D-3C18-41E4-A938-BAAB7B3A31EE}" dt="2023-02-14T15:50:40.071" v="621"/>
          <ac:spMkLst>
            <pc:docMk/>
            <pc:sldMk cId="3501267655" sldId="343"/>
            <ac:spMk id="33" creationId="{AD11164D-D201-0157-2006-394755B511A2}"/>
          </ac:spMkLst>
        </pc:spChg>
        <pc:spChg chg="mod">
          <ac:chgData name="Kumar, Vinod" userId="a0710a6e-bffc-4971-8893-1c23addeb5b0" providerId="ADAL" clId="{A867779D-3C18-41E4-A938-BAAB7B3A31EE}" dt="2023-02-14T15:50:40.071" v="621"/>
          <ac:spMkLst>
            <pc:docMk/>
            <pc:sldMk cId="3501267655" sldId="343"/>
            <ac:spMk id="35" creationId="{665B57D5-3CDA-42FF-6A8A-24560BFA5E8F}"/>
          </ac:spMkLst>
        </pc:spChg>
        <pc:spChg chg="mod">
          <ac:chgData name="Kumar, Vinod" userId="a0710a6e-bffc-4971-8893-1c23addeb5b0" providerId="ADAL" clId="{A867779D-3C18-41E4-A938-BAAB7B3A31EE}" dt="2023-02-14T15:50:40.071" v="621"/>
          <ac:spMkLst>
            <pc:docMk/>
            <pc:sldMk cId="3501267655" sldId="343"/>
            <ac:spMk id="36" creationId="{8711DB53-0DF7-C23C-5732-7E382E60FCFA}"/>
          </ac:spMkLst>
        </pc:spChg>
        <pc:spChg chg="mod">
          <ac:chgData name="Kumar, Vinod" userId="a0710a6e-bffc-4971-8893-1c23addeb5b0" providerId="ADAL" clId="{A867779D-3C18-41E4-A938-BAAB7B3A31EE}" dt="2023-02-14T15:50:40.071" v="621"/>
          <ac:spMkLst>
            <pc:docMk/>
            <pc:sldMk cId="3501267655" sldId="343"/>
            <ac:spMk id="38" creationId="{5AD03A3D-8D26-BF1E-6180-D22E7191C388}"/>
          </ac:spMkLst>
        </pc:spChg>
        <pc:spChg chg="mod">
          <ac:chgData name="Kumar, Vinod" userId="a0710a6e-bffc-4971-8893-1c23addeb5b0" providerId="ADAL" clId="{A867779D-3C18-41E4-A938-BAAB7B3A31EE}" dt="2023-02-14T15:50:40.071" v="621"/>
          <ac:spMkLst>
            <pc:docMk/>
            <pc:sldMk cId="3501267655" sldId="343"/>
            <ac:spMk id="40" creationId="{E5C55098-2813-26AD-6496-18CC2572C1BE}"/>
          </ac:spMkLst>
        </pc:spChg>
        <pc:spChg chg="add mod">
          <ac:chgData name="Kumar, Vinod" userId="a0710a6e-bffc-4971-8893-1c23addeb5b0" providerId="ADAL" clId="{A867779D-3C18-41E4-A938-BAAB7B3A31EE}" dt="2023-02-14T16:13:37.749" v="1206" actId="20577"/>
          <ac:spMkLst>
            <pc:docMk/>
            <pc:sldMk cId="3501267655" sldId="343"/>
            <ac:spMk id="41" creationId="{4690E830-E056-EDC1-71EF-A2096B23503C}"/>
          </ac:spMkLst>
        </pc:spChg>
        <pc:spChg chg="mod">
          <ac:chgData name="Kumar, Vinod" userId="a0710a6e-bffc-4971-8893-1c23addeb5b0" providerId="ADAL" clId="{A867779D-3C18-41E4-A938-BAAB7B3A31EE}" dt="2023-02-14T15:53:16.535" v="672" actId="1076"/>
          <ac:spMkLst>
            <pc:docMk/>
            <pc:sldMk cId="3501267655" sldId="343"/>
            <ac:spMk id="44" creationId="{06A223AB-5DF2-6B95-E9EF-D7104D625CD8}"/>
          </ac:spMkLst>
        </pc:spChg>
        <pc:spChg chg="mod">
          <ac:chgData name="Kumar, Vinod" userId="a0710a6e-bffc-4971-8893-1c23addeb5b0" providerId="ADAL" clId="{A867779D-3C18-41E4-A938-BAAB7B3A31EE}" dt="2023-02-14T15:53:16.535" v="672" actId="1076"/>
          <ac:spMkLst>
            <pc:docMk/>
            <pc:sldMk cId="3501267655" sldId="343"/>
            <ac:spMk id="45" creationId="{A1CC13E7-8CB4-8B33-E589-DADB53DCB6FB}"/>
          </ac:spMkLst>
        </pc:spChg>
        <pc:spChg chg="mod">
          <ac:chgData name="Kumar, Vinod" userId="a0710a6e-bffc-4971-8893-1c23addeb5b0" providerId="ADAL" clId="{A867779D-3C18-41E4-A938-BAAB7B3A31EE}" dt="2023-02-14T15:53:16.535" v="672" actId="1076"/>
          <ac:spMkLst>
            <pc:docMk/>
            <pc:sldMk cId="3501267655" sldId="343"/>
            <ac:spMk id="46" creationId="{B5DC9FAD-560F-D247-1D86-28AADE8DB50E}"/>
          </ac:spMkLst>
        </pc:spChg>
        <pc:spChg chg="add mod">
          <ac:chgData name="Kumar, Vinod" userId="a0710a6e-bffc-4971-8893-1c23addeb5b0" providerId="ADAL" clId="{A867779D-3C18-41E4-A938-BAAB7B3A31EE}" dt="2023-02-14T15:59:07.532" v="911" actId="1037"/>
          <ac:spMkLst>
            <pc:docMk/>
            <pc:sldMk cId="3501267655" sldId="343"/>
            <ac:spMk id="47" creationId="{92E527C4-C4D4-5A67-E7AA-5D1746E413FF}"/>
          </ac:spMkLst>
        </pc:spChg>
        <pc:grpChg chg="add del mod">
          <ac:chgData name="Kumar, Vinod" userId="a0710a6e-bffc-4971-8893-1c23addeb5b0" providerId="ADAL" clId="{A867779D-3C18-41E4-A938-BAAB7B3A31EE}" dt="2023-02-14T15:48:09.556" v="582" actId="165"/>
          <ac:grpSpMkLst>
            <pc:docMk/>
            <pc:sldMk cId="3501267655" sldId="343"/>
            <ac:grpSpMk id="2" creationId="{0977A7A7-C6ED-CCAB-56D0-A814CA5CFA1E}"/>
          </ac:grpSpMkLst>
        </pc:grpChg>
        <pc:grpChg chg="del mod topLvl">
          <ac:chgData name="Kumar, Vinod" userId="a0710a6e-bffc-4971-8893-1c23addeb5b0" providerId="ADAL" clId="{A867779D-3C18-41E4-A938-BAAB7B3A31EE}" dt="2023-02-14T15:48:37.244" v="585" actId="165"/>
          <ac:grpSpMkLst>
            <pc:docMk/>
            <pc:sldMk cId="3501267655" sldId="343"/>
            <ac:grpSpMk id="3" creationId="{AA870934-3FBF-C7A6-A4AA-481538BC3833}"/>
          </ac:grpSpMkLst>
        </pc:grpChg>
        <pc:grpChg chg="mod topLvl">
          <ac:chgData name="Kumar, Vinod" userId="a0710a6e-bffc-4971-8893-1c23addeb5b0" providerId="ADAL" clId="{A867779D-3C18-41E4-A938-BAAB7B3A31EE}" dt="2023-02-14T15:49:53.002" v="619" actId="164"/>
          <ac:grpSpMkLst>
            <pc:docMk/>
            <pc:sldMk cId="3501267655" sldId="343"/>
            <ac:grpSpMk id="4" creationId="{3239D883-063A-B99D-F8A2-292BA66087A0}"/>
          </ac:grpSpMkLst>
        </pc:grpChg>
        <pc:grpChg chg="mod topLvl">
          <ac:chgData name="Kumar, Vinod" userId="a0710a6e-bffc-4971-8893-1c23addeb5b0" providerId="ADAL" clId="{A867779D-3C18-41E4-A938-BAAB7B3A31EE}" dt="2023-02-14T15:49:53.002" v="619" actId="164"/>
          <ac:grpSpMkLst>
            <pc:docMk/>
            <pc:sldMk cId="3501267655" sldId="343"/>
            <ac:grpSpMk id="5" creationId="{61E9AFC6-6F7F-9A88-78A2-598F96749174}"/>
          </ac:grpSpMkLst>
        </pc:grpChg>
        <pc:grpChg chg="add mod">
          <ac:chgData name="Kumar, Vinod" userId="a0710a6e-bffc-4971-8893-1c23addeb5b0" providerId="ADAL" clId="{A867779D-3C18-41E4-A938-BAAB7B3A31EE}" dt="2023-02-14T15:49:56.872" v="620" actId="1076"/>
          <ac:grpSpMkLst>
            <pc:docMk/>
            <pc:sldMk cId="3501267655" sldId="343"/>
            <ac:grpSpMk id="24" creationId="{9C9840C6-9420-1F49-A00C-2275A649CDD2}"/>
          </ac:grpSpMkLst>
        </pc:grpChg>
        <pc:grpChg chg="add mod">
          <ac:chgData name="Kumar, Vinod" userId="a0710a6e-bffc-4971-8893-1c23addeb5b0" providerId="ADAL" clId="{A867779D-3C18-41E4-A938-BAAB7B3A31EE}" dt="2023-02-14T15:51:10.160" v="638" actId="1076"/>
          <ac:grpSpMkLst>
            <pc:docMk/>
            <pc:sldMk cId="3501267655" sldId="343"/>
            <ac:grpSpMk id="25" creationId="{249E9BD1-79CF-9930-4562-A8825301E5B0}"/>
          </ac:grpSpMkLst>
        </pc:grpChg>
        <pc:grpChg chg="mod">
          <ac:chgData name="Kumar, Vinod" userId="a0710a6e-bffc-4971-8893-1c23addeb5b0" providerId="ADAL" clId="{A867779D-3C18-41E4-A938-BAAB7B3A31EE}" dt="2023-02-14T15:50:40.071" v="621"/>
          <ac:grpSpMkLst>
            <pc:docMk/>
            <pc:sldMk cId="3501267655" sldId="343"/>
            <ac:grpSpMk id="27" creationId="{C81E436A-EC79-8259-540D-F872A552285B}"/>
          </ac:grpSpMkLst>
        </pc:grpChg>
        <pc:grpChg chg="mod">
          <ac:chgData name="Kumar, Vinod" userId="a0710a6e-bffc-4971-8893-1c23addeb5b0" providerId="ADAL" clId="{A867779D-3C18-41E4-A938-BAAB7B3A31EE}" dt="2023-02-14T15:50:40.071" v="621"/>
          <ac:grpSpMkLst>
            <pc:docMk/>
            <pc:sldMk cId="3501267655" sldId="343"/>
            <ac:grpSpMk id="29" creationId="{AB87AD35-4563-CFA3-F25E-E22E933CA773}"/>
          </ac:grpSpMkLst>
        </pc:grpChg>
        <pc:grpChg chg="mod">
          <ac:chgData name="Kumar, Vinod" userId="a0710a6e-bffc-4971-8893-1c23addeb5b0" providerId="ADAL" clId="{A867779D-3C18-41E4-A938-BAAB7B3A31EE}" dt="2023-02-14T15:50:40.071" v="621"/>
          <ac:grpSpMkLst>
            <pc:docMk/>
            <pc:sldMk cId="3501267655" sldId="343"/>
            <ac:grpSpMk id="30" creationId="{518B1922-D75A-56CB-B320-E2D781EBC137}"/>
          </ac:grpSpMkLst>
        </pc:grpChg>
        <pc:grpChg chg="add mod">
          <ac:chgData name="Kumar, Vinod" userId="a0710a6e-bffc-4971-8893-1c23addeb5b0" providerId="ADAL" clId="{A867779D-3C18-41E4-A938-BAAB7B3A31EE}" dt="2023-02-14T15:53:16.535" v="672" actId="1076"/>
          <ac:grpSpMkLst>
            <pc:docMk/>
            <pc:sldMk cId="3501267655" sldId="343"/>
            <ac:grpSpMk id="42" creationId="{AE1ECFA1-4468-5FEA-F170-E2A7D3B21E12}"/>
          </ac:grpSpMkLst>
        </pc:grpChg>
        <pc:picChg chg="mod">
          <ac:chgData name="Kumar, Vinod" userId="a0710a6e-bffc-4971-8893-1c23addeb5b0" providerId="ADAL" clId="{A867779D-3C18-41E4-A938-BAAB7B3A31EE}" dt="2023-02-14T15:48:09.556" v="582" actId="165"/>
          <ac:picMkLst>
            <pc:docMk/>
            <pc:sldMk cId="3501267655" sldId="343"/>
            <ac:picMk id="7" creationId="{8CF03B62-80B2-7250-2360-BE8DAE117570}"/>
          </ac:picMkLst>
        </pc:picChg>
        <pc:picChg chg="mod">
          <ac:chgData name="Kumar, Vinod" userId="a0710a6e-bffc-4971-8893-1c23addeb5b0" providerId="ADAL" clId="{A867779D-3C18-41E4-A938-BAAB7B3A31EE}" dt="2023-02-14T15:48:45.548" v="587" actId="571"/>
          <ac:picMkLst>
            <pc:docMk/>
            <pc:sldMk cId="3501267655" sldId="343"/>
            <ac:picMk id="12" creationId="{F454653B-927D-B5FC-C8EB-16ABE33B132E}"/>
          </ac:picMkLst>
        </pc:picChg>
        <pc:picChg chg="mod topLvl">
          <ac:chgData name="Kumar, Vinod" userId="a0710a6e-bffc-4971-8893-1c23addeb5b0" providerId="ADAL" clId="{A867779D-3C18-41E4-A938-BAAB7B3A31EE}" dt="2023-02-14T15:49:53.002" v="619" actId="164"/>
          <ac:picMkLst>
            <pc:docMk/>
            <pc:sldMk cId="3501267655" sldId="343"/>
            <ac:picMk id="17" creationId="{C40D50FF-53B1-B7C3-CF2D-16D8BCB28134}"/>
          </ac:picMkLst>
        </pc:picChg>
        <pc:picChg chg="mod">
          <ac:chgData name="Kumar, Vinod" userId="a0710a6e-bffc-4971-8893-1c23addeb5b0" providerId="ADAL" clId="{A867779D-3C18-41E4-A938-BAAB7B3A31EE}" dt="2023-02-14T15:50:40.071" v="621"/>
          <ac:picMkLst>
            <pc:docMk/>
            <pc:sldMk cId="3501267655" sldId="343"/>
            <ac:picMk id="34" creationId="{1AE09EBA-E394-67C0-F719-C8CC28CA067D}"/>
          </ac:picMkLst>
        </pc:picChg>
        <pc:picChg chg="mod">
          <ac:chgData name="Kumar, Vinod" userId="a0710a6e-bffc-4971-8893-1c23addeb5b0" providerId="ADAL" clId="{A867779D-3C18-41E4-A938-BAAB7B3A31EE}" dt="2023-02-14T15:53:16.535" v="672" actId="1076"/>
          <ac:picMkLst>
            <pc:docMk/>
            <pc:sldMk cId="3501267655" sldId="343"/>
            <ac:picMk id="43" creationId="{023F2C0A-6850-E932-72EF-4716C5A36F9D}"/>
          </ac:picMkLst>
        </pc:picChg>
        <pc:cxnChg chg="mod">
          <ac:chgData name="Kumar, Vinod" userId="a0710a6e-bffc-4971-8893-1c23addeb5b0" providerId="ADAL" clId="{A867779D-3C18-41E4-A938-BAAB7B3A31EE}" dt="2023-02-14T15:50:40.071" v="621"/>
          <ac:cxnSpMkLst>
            <pc:docMk/>
            <pc:sldMk cId="3501267655" sldId="343"/>
            <ac:cxnSpMk id="37" creationId="{AAFCCD0B-30C3-7572-B96C-FB51A04E7206}"/>
          </ac:cxnSpMkLst>
        </pc:cxnChg>
        <pc:cxnChg chg="mod">
          <ac:chgData name="Kumar, Vinod" userId="a0710a6e-bffc-4971-8893-1c23addeb5b0" providerId="ADAL" clId="{A867779D-3C18-41E4-A938-BAAB7B3A31EE}" dt="2023-02-14T15:50:40.071" v="621"/>
          <ac:cxnSpMkLst>
            <pc:docMk/>
            <pc:sldMk cId="3501267655" sldId="343"/>
            <ac:cxnSpMk id="39" creationId="{83CF0F19-8BE4-C6C0-A661-52DD164D8E41}"/>
          </ac:cxnSpMkLst>
        </pc:cxnChg>
      </pc:sldChg>
      <pc:sldChg chg="addSp delSp modSp new mod">
        <pc:chgData name="Kumar, Vinod" userId="a0710a6e-bffc-4971-8893-1c23addeb5b0" providerId="ADAL" clId="{A867779D-3C18-41E4-A938-BAAB7B3A31EE}" dt="2023-03-23T20:57:28.350" v="1243" actId="20577"/>
        <pc:sldMkLst>
          <pc:docMk/>
          <pc:sldMk cId="3077287310" sldId="344"/>
        </pc:sldMkLst>
        <pc:spChg chg="add mod">
          <ac:chgData name="Kumar, Vinod" userId="a0710a6e-bffc-4971-8893-1c23addeb5b0" providerId="ADAL" clId="{A867779D-3C18-41E4-A938-BAAB7B3A31EE}" dt="2023-03-23T20:57:28.350" v="1243" actId="20577"/>
          <ac:spMkLst>
            <pc:docMk/>
            <pc:sldMk cId="3077287310" sldId="344"/>
            <ac:spMk id="2" creationId="{FD7C0F74-9452-C4D9-2D19-088D7FEE2727}"/>
          </ac:spMkLst>
        </pc:spChg>
        <pc:spChg chg="add mod">
          <ac:chgData name="Kumar, Vinod" userId="a0710a6e-bffc-4971-8893-1c23addeb5b0" providerId="ADAL" clId="{A867779D-3C18-41E4-A938-BAAB7B3A31EE}" dt="2023-02-14T16:04:21.546" v="938" actId="20577"/>
          <ac:spMkLst>
            <pc:docMk/>
            <pc:sldMk cId="3077287310" sldId="344"/>
            <ac:spMk id="3" creationId="{377800B5-5BAC-660E-8C3B-E1DDB2034E65}"/>
          </ac:spMkLst>
        </pc:spChg>
        <pc:spChg chg="add del mod">
          <ac:chgData name="Kumar, Vinod" userId="a0710a6e-bffc-4971-8893-1c23addeb5b0" providerId="ADAL" clId="{A867779D-3C18-41E4-A938-BAAB7B3A31EE}" dt="2023-02-14T16:04:31.386" v="940" actId="478"/>
          <ac:spMkLst>
            <pc:docMk/>
            <pc:sldMk cId="3077287310" sldId="344"/>
            <ac:spMk id="4" creationId="{E23DDBB4-EE3A-16D4-9B99-3D7A440FC1DD}"/>
          </ac:spMkLst>
        </pc:spChg>
        <pc:spChg chg="mod">
          <ac:chgData name="Kumar, Vinod" userId="a0710a6e-bffc-4971-8893-1c23addeb5b0" providerId="ADAL" clId="{A867779D-3C18-41E4-A938-BAAB7B3A31EE}" dt="2023-02-14T16:04:42.831" v="941"/>
          <ac:spMkLst>
            <pc:docMk/>
            <pc:sldMk cId="3077287310" sldId="344"/>
            <ac:spMk id="9" creationId="{26B2C41F-EB45-5C07-B07F-014944536F53}"/>
          </ac:spMkLst>
        </pc:spChg>
        <pc:spChg chg="mod">
          <ac:chgData name="Kumar, Vinod" userId="a0710a6e-bffc-4971-8893-1c23addeb5b0" providerId="ADAL" clId="{A867779D-3C18-41E4-A938-BAAB7B3A31EE}" dt="2023-02-14T16:04:42.831" v="941"/>
          <ac:spMkLst>
            <pc:docMk/>
            <pc:sldMk cId="3077287310" sldId="344"/>
            <ac:spMk id="10" creationId="{549433BA-A009-9C74-08F6-F9410C780635}"/>
          </ac:spMkLst>
        </pc:spChg>
        <pc:spChg chg="mod">
          <ac:chgData name="Kumar, Vinod" userId="a0710a6e-bffc-4971-8893-1c23addeb5b0" providerId="ADAL" clId="{A867779D-3C18-41E4-A938-BAAB7B3A31EE}" dt="2023-02-14T16:04:42.831" v="941"/>
          <ac:spMkLst>
            <pc:docMk/>
            <pc:sldMk cId="3077287310" sldId="344"/>
            <ac:spMk id="11" creationId="{25DDC87D-EB21-C7D6-0813-35BB8D3FA855}"/>
          </ac:spMkLst>
        </pc:spChg>
        <pc:spChg chg="mod">
          <ac:chgData name="Kumar, Vinod" userId="a0710a6e-bffc-4971-8893-1c23addeb5b0" providerId="ADAL" clId="{A867779D-3C18-41E4-A938-BAAB7B3A31EE}" dt="2023-02-14T16:04:42.831" v="941"/>
          <ac:spMkLst>
            <pc:docMk/>
            <pc:sldMk cId="3077287310" sldId="344"/>
            <ac:spMk id="12" creationId="{EBFA6F46-1C4B-37B4-E4D0-862691678FCC}"/>
          </ac:spMkLst>
        </pc:spChg>
        <pc:spChg chg="mod">
          <ac:chgData name="Kumar, Vinod" userId="a0710a6e-bffc-4971-8893-1c23addeb5b0" providerId="ADAL" clId="{A867779D-3C18-41E4-A938-BAAB7B3A31EE}" dt="2023-02-14T16:04:42.831" v="941"/>
          <ac:spMkLst>
            <pc:docMk/>
            <pc:sldMk cId="3077287310" sldId="344"/>
            <ac:spMk id="13" creationId="{90E8F1B5-475F-6996-A098-E633E439947D}"/>
          </ac:spMkLst>
        </pc:spChg>
        <pc:spChg chg="mod">
          <ac:chgData name="Kumar, Vinod" userId="a0710a6e-bffc-4971-8893-1c23addeb5b0" providerId="ADAL" clId="{A867779D-3C18-41E4-A938-BAAB7B3A31EE}" dt="2023-02-14T16:04:42.831" v="941"/>
          <ac:spMkLst>
            <pc:docMk/>
            <pc:sldMk cId="3077287310" sldId="344"/>
            <ac:spMk id="14" creationId="{763A6950-3E92-6A74-C882-C9C0254FFD79}"/>
          </ac:spMkLst>
        </pc:spChg>
        <pc:spChg chg="mod">
          <ac:chgData name="Kumar, Vinod" userId="a0710a6e-bffc-4971-8893-1c23addeb5b0" providerId="ADAL" clId="{A867779D-3C18-41E4-A938-BAAB7B3A31EE}" dt="2023-02-14T16:04:42.831" v="941"/>
          <ac:spMkLst>
            <pc:docMk/>
            <pc:sldMk cId="3077287310" sldId="344"/>
            <ac:spMk id="15" creationId="{B8E71907-F3A0-6054-2545-CEC488F2D4E8}"/>
          </ac:spMkLst>
        </pc:spChg>
        <pc:spChg chg="mod">
          <ac:chgData name="Kumar, Vinod" userId="a0710a6e-bffc-4971-8893-1c23addeb5b0" providerId="ADAL" clId="{A867779D-3C18-41E4-A938-BAAB7B3A31EE}" dt="2023-02-14T16:04:42.831" v="941"/>
          <ac:spMkLst>
            <pc:docMk/>
            <pc:sldMk cId="3077287310" sldId="344"/>
            <ac:spMk id="16" creationId="{441209A7-A2D5-9EFD-1851-216535C3979B}"/>
          </ac:spMkLst>
        </pc:spChg>
        <pc:spChg chg="mod">
          <ac:chgData name="Kumar, Vinod" userId="a0710a6e-bffc-4971-8893-1c23addeb5b0" providerId="ADAL" clId="{A867779D-3C18-41E4-A938-BAAB7B3A31EE}" dt="2023-02-14T16:04:42.831" v="941"/>
          <ac:spMkLst>
            <pc:docMk/>
            <pc:sldMk cId="3077287310" sldId="344"/>
            <ac:spMk id="17" creationId="{B4940A41-F726-382F-9AFF-89021304BF0A}"/>
          </ac:spMkLst>
        </pc:spChg>
        <pc:spChg chg="mod">
          <ac:chgData name="Kumar, Vinod" userId="a0710a6e-bffc-4971-8893-1c23addeb5b0" providerId="ADAL" clId="{A867779D-3C18-41E4-A938-BAAB7B3A31EE}" dt="2023-02-14T16:04:42.831" v="941"/>
          <ac:spMkLst>
            <pc:docMk/>
            <pc:sldMk cId="3077287310" sldId="344"/>
            <ac:spMk id="18" creationId="{A3A19EF3-37D4-0EE3-45CE-C2D62028F1AC}"/>
          </ac:spMkLst>
        </pc:spChg>
        <pc:spChg chg="mod">
          <ac:chgData name="Kumar, Vinod" userId="a0710a6e-bffc-4971-8893-1c23addeb5b0" providerId="ADAL" clId="{A867779D-3C18-41E4-A938-BAAB7B3A31EE}" dt="2023-02-14T16:04:42.831" v="941"/>
          <ac:spMkLst>
            <pc:docMk/>
            <pc:sldMk cId="3077287310" sldId="344"/>
            <ac:spMk id="19" creationId="{E7541DBC-305A-A6B9-8AF3-4909A0C46123}"/>
          </ac:spMkLst>
        </pc:spChg>
        <pc:spChg chg="mod">
          <ac:chgData name="Kumar, Vinod" userId="a0710a6e-bffc-4971-8893-1c23addeb5b0" providerId="ADAL" clId="{A867779D-3C18-41E4-A938-BAAB7B3A31EE}" dt="2023-02-14T16:05:27.231" v="944"/>
          <ac:spMkLst>
            <pc:docMk/>
            <pc:sldMk cId="3077287310" sldId="344"/>
            <ac:spMk id="25" creationId="{642D9092-AF96-9775-94AC-BA05D4CB15B4}"/>
          </ac:spMkLst>
        </pc:spChg>
        <pc:spChg chg="mod">
          <ac:chgData name="Kumar, Vinod" userId="a0710a6e-bffc-4971-8893-1c23addeb5b0" providerId="ADAL" clId="{A867779D-3C18-41E4-A938-BAAB7B3A31EE}" dt="2023-02-14T16:05:27.231" v="944"/>
          <ac:spMkLst>
            <pc:docMk/>
            <pc:sldMk cId="3077287310" sldId="344"/>
            <ac:spMk id="26" creationId="{413ABC43-19D1-0380-50F5-8408C5C3F750}"/>
          </ac:spMkLst>
        </pc:spChg>
        <pc:spChg chg="mod">
          <ac:chgData name="Kumar, Vinod" userId="a0710a6e-bffc-4971-8893-1c23addeb5b0" providerId="ADAL" clId="{A867779D-3C18-41E4-A938-BAAB7B3A31EE}" dt="2023-02-14T16:05:27.231" v="944"/>
          <ac:spMkLst>
            <pc:docMk/>
            <pc:sldMk cId="3077287310" sldId="344"/>
            <ac:spMk id="27" creationId="{67F81C8B-680C-08F6-291E-C55379895EDC}"/>
          </ac:spMkLst>
        </pc:spChg>
        <pc:spChg chg="mod">
          <ac:chgData name="Kumar, Vinod" userId="a0710a6e-bffc-4971-8893-1c23addeb5b0" providerId="ADAL" clId="{A867779D-3C18-41E4-A938-BAAB7B3A31EE}" dt="2023-02-14T16:05:27.231" v="944"/>
          <ac:spMkLst>
            <pc:docMk/>
            <pc:sldMk cId="3077287310" sldId="344"/>
            <ac:spMk id="28" creationId="{D3F257EA-F0F8-54DE-4A67-CA7B6F88858E}"/>
          </ac:spMkLst>
        </pc:spChg>
        <pc:spChg chg="mod">
          <ac:chgData name="Kumar, Vinod" userId="a0710a6e-bffc-4971-8893-1c23addeb5b0" providerId="ADAL" clId="{A867779D-3C18-41E4-A938-BAAB7B3A31EE}" dt="2023-02-14T16:05:27.231" v="944"/>
          <ac:spMkLst>
            <pc:docMk/>
            <pc:sldMk cId="3077287310" sldId="344"/>
            <ac:spMk id="29" creationId="{849FD1B5-DDB1-7ECF-B8AE-44DCE97367FB}"/>
          </ac:spMkLst>
        </pc:spChg>
        <pc:spChg chg="mod">
          <ac:chgData name="Kumar, Vinod" userId="a0710a6e-bffc-4971-8893-1c23addeb5b0" providerId="ADAL" clId="{A867779D-3C18-41E4-A938-BAAB7B3A31EE}" dt="2023-02-14T16:05:27.231" v="944"/>
          <ac:spMkLst>
            <pc:docMk/>
            <pc:sldMk cId="3077287310" sldId="344"/>
            <ac:spMk id="33" creationId="{2C3514AA-210A-20CF-2B48-7DE15BF47FFA}"/>
          </ac:spMkLst>
        </pc:spChg>
        <pc:spChg chg="mod">
          <ac:chgData name="Kumar, Vinod" userId="a0710a6e-bffc-4971-8893-1c23addeb5b0" providerId="ADAL" clId="{A867779D-3C18-41E4-A938-BAAB7B3A31EE}" dt="2023-02-14T16:05:27.231" v="944"/>
          <ac:spMkLst>
            <pc:docMk/>
            <pc:sldMk cId="3077287310" sldId="344"/>
            <ac:spMk id="34" creationId="{7F0F63F5-EEEC-0A74-67EB-08085F6A3FC6}"/>
          </ac:spMkLst>
        </pc:spChg>
        <pc:spChg chg="mod">
          <ac:chgData name="Kumar, Vinod" userId="a0710a6e-bffc-4971-8893-1c23addeb5b0" providerId="ADAL" clId="{A867779D-3C18-41E4-A938-BAAB7B3A31EE}" dt="2023-02-14T16:05:27.231" v="944"/>
          <ac:spMkLst>
            <pc:docMk/>
            <pc:sldMk cId="3077287310" sldId="344"/>
            <ac:spMk id="35" creationId="{D5FF7EA4-82A8-DFEA-F893-F9D926275B96}"/>
          </ac:spMkLst>
        </pc:spChg>
        <pc:spChg chg="mod">
          <ac:chgData name="Kumar, Vinod" userId="a0710a6e-bffc-4971-8893-1c23addeb5b0" providerId="ADAL" clId="{A867779D-3C18-41E4-A938-BAAB7B3A31EE}" dt="2023-02-14T16:05:27.231" v="944"/>
          <ac:spMkLst>
            <pc:docMk/>
            <pc:sldMk cId="3077287310" sldId="344"/>
            <ac:spMk id="36" creationId="{180C4396-BC58-48C9-552F-D9CDF4154CA4}"/>
          </ac:spMkLst>
        </pc:spChg>
        <pc:spChg chg="mod">
          <ac:chgData name="Kumar, Vinod" userId="a0710a6e-bffc-4971-8893-1c23addeb5b0" providerId="ADAL" clId="{A867779D-3C18-41E4-A938-BAAB7B3A31EE}" dt="2023-02-14T16:05:27.231" v="944"/>
          <ac:spMkLst>
            <pc:docMk/>
            <pc:sldMk cId="3077287310" sldId="344"/>
            <ac:spMk id="37" creationId="{ADA4F771-770D-476D-763A-5E94D041F625}"/>
          </ac:spMkLst>
        </pc:spChg>
        <pc:spChg chg="mod">
          <ac:chgData name="Kumar, Vinod" userId="a0710a6e-bffc-4971-8893-1c23addeb5b0" providerId="ADAL" clId="{A867779D-3C18-41E4-A938-BAAB7B3A31EE}" dt="2023-02-14T16:05:27.231" v="944"/>
          <ac:spMkLst>
            <pc:docMk/>
            <pc:sldMk cId="3077287310" sldId="344"/>
            <ac:spMk id="38" creationId="{EA479018-29FA-0867-F7B1-DA31590782CF}"/>
          </ac:spMkLst>
        </pc:spChg>
        <pc:spChg chg="add mod">
          <ac:chgData name="Kumar, Vinod" userId="a0710a6e-bffc-4971-8893-1c23addeb5b0" providerId="ADAL" clId="{A867779D-3C18-41E4-A938-BAAB7B3A31EE}" dt="2023-02-14T16:05:31.073" v="945" actId="1076"/>
          <ac:spMkLst>
            <pc:docMk/>
            <pc:sldMk cId="3077287310" sldId="344"/>
            <ac:spMk id="39" creationId="{91A48592-4B7D-F3E9-BBC3-51E8CBAFD18B}"/>
          </ac:spMkLst>
        </pc:spChg>
        <pc:grpChg chg="add mod">
          <ac:chgData name="Kumar, Vinod" userId="a0710a6e-bffc-4971-8893-1c23addeb5b0" providerId="ADAL" clId="{A867779D-3C18-41E4-A938-BAAB7B3A31EE}" dt="2023-02-14T16:04:45.801" v="942" actId="1076"/>
          <ac:grpSpMkLst>
            <pc:docMk/>
            <pc:sldMk cId="3077287310" sldId="344"/>
            <ac:grpSpMk id="5" creationId="{5C057C27-A70D-2A55-9A4E-F09395ECFDC1}"/>
          </ac:grpSpMkLst>
        </pc:grpChg>
        <pc:grpChg chg="add mod">
          <ac:chgData name="Kumar, Vinod" userId="a0710a6e-bffc-4971-8893-1c23addeb5b0" providerId="ADAL" clId="{A867779D-3C18-41E4-A938-BAAB7B3A31EE}" dt="2023-02-14T16:05:31.073" v="945" actId="1076"/>
          <ac:grpSpMkLst>
            <pc:docMk/>
            <pc:sldMk cId="3077287310" sldId="344"/>
            <ac:grpSpMk id="20" creationId="{F276BB61-BBB4-3BE4-B110-A4608ACCB020}"/>
          </ac:grpSpMkLst>
        </pc:grpChg>
        <pc:picChg chg="mod">
          <ac:chgData name="Kumar, Vinod" userId="a0710a6e-bffc-4971-8893-1c23addeb5b0" providerId="ADAL" clId="{A867779D-3C18-41E4-A938-BAAB7B3A31EE}" dt="2023-02-14T16:04:42.831" v="941"/>
          <ac:picMkLst>
            <pc:docMk/>
            <pc:sldMk cId="3077287310" sldId="344"/>
            <ac:picMk id="6" creationId="{33B26AD9-75E3-8B74-A52E-A5340DB2409A}"/>
          </ac:picMkLst>
        </pc:picChg>
        <pc:picChg chg="mod">
          <ac:chgData name="Kumar, Vinod" userId="a0710a6e-bffc-4971-8893-1c23addeb5b0" providerId="ADAL" clId="{A867779D-3C18-41E4-A938-BAAB7B3A31EE}" dt="2023-02-14T16:04:42.831" v="941"/>
          <ac:picMkLst>
            <pc:docMk/>
            <pc:sldMk cId="3077287310" sldId="344"/>
            <ac:picMk id="7" creationId="{3490288A-A360-0D11-ECB9-EAD39CBA25A9}"/>
          </ac:picMkLst>
        </pc:picChg>
        <pc:picChg chg="mod">
          <ac:chgData name="Kumar, Vinod" userId="a0710a6e-bffc-4971-8893-1c23addeb5b0" providerId="ADAL" clId="{A867779D-3C18-41E4-A938-BAAB7B3A31EE}" dt="2023-02-14T16:04:42.831" v="941"/>
          <ac:picMkLst>
            <pc:docMk/>
            <pc:sldMk cId="3077287310" sldId="344"/>
            <ac:picMk id="8" creationId="{807B3613-B52A-8A62-231C-3C87A9B5B1B7}"/>
          </ac:picMkLst>
        </pc:picChg>
        <pc:picChg chg="mod">
          <ac:chgData name="Kumar, Vinod" userId="a0710a6e-bffc-4971-8893-1c23addeb5b0" providerId="ADAL" clId="{A867779D-3C18-41E4-A938-BAAB7B3A31EE}" dt="2023-02-14T16:05:27.231" v="944"/>
          <ac:picMkLst>
            <pc:docMk/>
            <pc:sldMk cId="3077287310" sldId="344"/>
            <ac:picMk id="21" creationId="{970B1C5B-D01D-6B22-E528-B1BDCD0990BE}"/>
          </ac:picMkLst>
        </pc:picChg>
        <pc:picChg chg="mod">
          <ac:chgData name="Kumar, Vinod" userId="a0710a6e-bffc-4971-8893-1c23addeb5b0" providerId="ADAL" clId="{A867779D-3C18-41E4-A938-BAAB7B3A31EE}" dt="2023-02-14T16:05:27.231" v="944"/>
          <ac:picMkLst>
            <pc:docMk/>
            <pc:sldMk cId="3077287310" sldId="344"/>
            <ac:picMk id="22" creationId="{1807E21A-1207-CFF0-31E8-C084D735611A}"/>
          </ac:picMkLst>
        </pc:picChg>
        <pc:picChg chg="mod">
          <ac:chgData name="Kumar, Vinod" userId="a0710a6e-bffc-4971-8893-1c23addeb5b0" providerId="ADAL" clId="{A867779D-3C18-41E4-A938-BAAB7B3A31EE}" dt="2023-02-14T16:05:27.231" v="944"/>
          <ac:picMkLst>
            <pc:docMk/>
            <pc:sldMk cId="3077287310" sldId="344"/>
            <ac:picMk id="23" creationId="{32C70CE8-8B99-9F02-5FAA-8744822490CA}"/>
          </ac:picMkLst>
        </pc:picChg>
        <pc:picChg chg="mod">
          <ac:chgData name="Kumar, Vinod" userId="a0710a6e-bffc-4971-8893-1c23addeb5b0" providerId="ADAL" clId="{A867779D-3C18-41E4-A938-BAAB7B3A31EE}" dt="2023-02-14T16:05:27.231" v="944"/>
          <ac:picMkLst>
            <pc:docMk/>
            <pc:sldMk cId="3077287310" sldId="344"/>
            <ac:picMk id="24" creationId="{CDC139CC-0F37-26DF-8E01-76B12927AD47}"/>
          </ac:picMkLst>
        </pc:picChg>
        <pc:cxnChg chg="mod">
          <ac:chgData name="Kumar, Vinod" userId="a0710a6e-bffc-4971-8893-1c23addeb5b0" providerId="ADAL" clId="{A867779D-3C18-41E4-A938-BAAB7B3A31EE}" dt="2023-02-14T16:05:27.231" v="944"/>
          <ac:cxnSpMkLst>
            <pc:docMk/>
            <pc:sldMk cId="3077287310" sldId="344"/>
            <ac:cxnSpMk id="30" creationId="{AB391853-AD13-CD11-212E-1B7F29C6D4F7}"/>
          </ac:cxnSpMkLst>
        </pc:cxnChg>
        <pc:cxnChg chg="mod">
          <ac:chgData name="Kumar, Vinod" userId="a0710a6e-bffc-4971-8893-1c23addeb5b0" providerId="ADAL" clId="{A867779D-3C18-41E4-A938-BAAB7B3A31EE}" dt="2023-02-14T16:05:27.231" v="944"/>
          <ac:cxnSpMkLst>
            <pc:docMk/>
            <pc:sldMk cId="3077287310" sldId="344"/>
            <ac:cxnSpMk id="31" creationId="{4A0C4552-47D4-8E76-87D9-C980D963F5DA}"/>
          </ac:cxnSpMkLst>
        </pc:cxnChg>
        <pc:cxnChg chg="mod">
          <ac:chgData name="Kumar, Vinod" userId="a0710a6e-bffc-4971-8893-1c23addeb5b0" providerId="ADAL" clId="{A867779D-3C18-41E4-A938-BAAB7B3A31EE}" dt="2023-02-14T16:05:27.231" v="944"/>
          <ac:cxnSpMkLst>
            <pc:docMk/>
            <pc:sldMk cId="3077287310" sldId="344"/>
            <ac:cxnSpMk id="32" creationId="{86B25556-84C6-BC1D-5859-F396E95C1902}"/>
          </ac:cxnSpMkLst>
        </pc:cxnChg>
      </pc:sldChg>
      <pc:sldChg chg="addSp delSp modSp new mod">
        <pc:chgData name="Kumar, Vinod" userId="a0710a6e-bffc-4971-8893-1c23addeb5b0" providerId="ADAL" clId="{A867779D-3C18-41E4-A938-BAAB7B3A31EE}" dt="2023-04-06T19:37:47.462" v="1439" actId="1076"/>
        <pc:sldMkLst>
          <pc:docMk/>
          <pc:sldMk cId="1703545616" sldId="345"/>
        </pc:sldMkLst>
        <pc:spChg chg="add mod">
          <ac:chgData name="Kumar, Vinod" userId="a0710a6e-bffc-4971-8893-1c23addeb5b0" providerId="ADAL" clId="{A867779D-3C18-41E4-A938-BAAB7B3A31EE}" dt="2023-04-06T19:37:44.967" v="1438" actId="164"/>
          <ac:spMkLst>
            <pc:docMk/>
            <pc:sldMk cId="1703545616" sldId="345"/>
            <ac:spMk id="5" creationId="{2F9E6FF2-C75C-B049-B79F-D171808E1AB1}"/>
          </ac:spMkLst>
        </pc:spChg>
        <pc:spChg chg="add mod">
          <ac:chgData name="Kumar, Vinod" userId="a0710a6e-bffc-4971-8893-1c23addeb5b0" providerId="ADAL" clId="{A867779D-3C18-41E4-A938-BAAB7B3A31EE}" dt="2023-04-06T19:37:44.967" v="1438" actId="164"/>
          <ac:spMkLst>
            <pc:docMk/>
            <pc:sldMk cId="1703545616" sldId="345"/>
            <ac:spMk id="6" creationId="{4AD9EF76-B774-5DE8-0482-875049FB8E15}"/>
          </ac:spMkLst>
        </pc:spChg>
        <pc:spChg chg="add mod">
          <ac:chgData name="Kumar, Vinod" userId="a0710a6e-bffc-4971-8893-1c23addeb5b0" providerId="ADAL" clId="{A867779D-3C18-41E4-A938-BAAB7B3A31EE}" dt="2023-04-06T19:37:44.967" v="1438" actId="164"/>
          <ac:spMkLst>
            <pc:docMk/>
            <pc:sldMk cId="1703545616" sldId="345"/>
            <ac:spMk id="7" creationId="{349778E2-BE45-2F63-FF2F-588189ACBA40}"/>
          </ac:spMkLst>
        </pc:spChg>
        <pc:spChg chg="add mod">
          <ac:chgData name="Kumar, Vinod" userId="a0710a6e-bffc-4971-8893-1c23addeb5b0" providerId="ADAL" clId="{A867779D-3C18-41E4-A938-BAAB7B3A31EE}" dt="2023-04-06T19:26:12.203" v="1259" actId="20577"/>
          <ac:spMkLst>
            <pc:docMk/>
            <pc:sldMk cId="1703545616" sldId="345"/>
            <ac:spMk id="8" creationId="{DA834806-6245-F2DA-8232-2A6223B54745}"/>
          </ac:spMkLst>
        </pc:spChg>
        <pc:spChg chg="mod topLvl">
          <ac:chgData name="Kumar, Vinod" userId="a0710a6e-bffc-4971-8893-1c23addeb5b0" providerId="ADAL" clId="{A867779D-3C18-41E4-A938-BAAB7B3A31EE}" dt="2023-04-06T19:37:44.967" v="1438" actId="164"/>
          <ac:spMkLst>
            <pc:docMk/>
            <pc:sldMk cId="1703545616" sldId="345"/>
            <ac:spMk id="12" creationId="{743366DB-C161-577E-2136-C4A596BACC9B}"/>
          </ac:spMkLst>
        </pc:spChg>
        <pc:spChg chg="del mod">
          <ac:chgData name="Kumar, Vinod" userId="a0710a6e-bffc-4971-8893-1c23addeb5b0" providerId="ADAL" clId="{A867779D-3C18-41E4-A938-BAAB7B3A31EE}" dt="2023-04-06T19:30:43.082" v="1273" actId="478"/>
          <ac:spMkLst>
            <pc:docMk/>
            <pc:sldMk cId="1703545616" sldId="345"/>
            <ac:spMk id="13" creationId="{1548C867-7A00-F434-163E-77C001CED09B}"/>
          </ac:spMkLst>
        </pc:spChg>
        <pc:spChg chg="mod topLvl">
          <ac:chgData name="Kumar, Vinod" userId="a0710a6e-bffc-4971-8893-1c23addeb5b0" providerId="ADAL" clId="{A867779D-3C18-41E4-A938-BAAB7B3A31EE}" dt="2023-04-06T19:37:44.967" v="1438" actId="164"/>
          <ac:spMkLst>
            <pc:docMk/>
            <pc:sldMk cId="1703545616" sldId="345"/>
            <ac:spMk id="14" creationId="{7C12A4A7-9167-E33F-EFEC-19FE9642353B}"/>
          </ac:spMkLst>
        </pc:spChg>
        <pc:spChg chg="mod topLvl">
          <ac:chgData name="Kumar, Vinod" userId="a0710a6e-bffc-4971-8893-1c23addeb5b0" providerId="ADAL" clId="{A867779D-3C18-41E4-A938-BAAB7B3A31EE}" dt="2023-04-06T19:37:44.967" v="1438" actId="164"/>
          <ac:spMkLst>
            <pc:docMk/>
            <pc:sldMk cId="1703545616" sldId="345"/>
            <ac:spMk id="15" creationId="{A2FE1ACA-8BCC-12E3-9F8B-8850C26BFD1A}"/>
          </ac:spMkLst>
        </pc:spChg>
        <pc:spChg chg="mod topLvl">
          <ac:chgData name="Kumar, Vinod" userId="a0710a6e-bffc-4971-8893-1c23addeb5b0" providerId="ADAL" clId="{A867779D-3C18-41E4-A938-BAAB7B3A31EE}" dt="2023-04-06T19:37:44.967" v="1438" actId="164"/>
          <ac:spMkLst>
            <pc:docMk/>
            <pc:sldMk cId="1703545616" sldId="345"/>
            <ac:spMk id="16" creationId="{BC7F57BB-2A92-3C8C-3FAE-741D75B94827}"/>
          </ac:spMkLst>
        </pc:spChg>
        <pc:spChg chg="mod topLvl">
          <ac:chgData name="Kumar, Vinod" userId="a0710a6e-bffc-4971-8893-1c23addeb5b0" providerId="ADAL" clId="{A867779D-3C18-41E4-A938-BAAB7B3A31EE}" dt="2023-04-06T19:37:44.967" v="1438" actId="164"/>
          <ac:spMkLst>
            <pc:docMk/>
            <pc:sldMk cId="1703545616" sldId="345"/>
            <ac:spMk id="17" creationId="{571A5A6D-9AA8-63C4-6F89-AFFBC71E07BB}"/>
          </ac:spMkLst>
        </pc:spChg>
        <pc:spChg chg="mod topLvl">
          <ac:chgData name="Kumar, Vinod" userId="a0710a6e-bffc-4971-8893-1c23addeb5b0" providerId="ADAL" clId="{A867779D-3C18-41E4-A938-BAAB7B3A31EE}" dt="2023-04-06T19:37:44.967" v="1438" actId="164"/>
          <ac:spMkLst>
            <pc:docMk/>
            <pc:sldMk cId="1703545616" sldId="345"/>
            <ac:spMk id="18" creationId="{5C3A4866-7518-F716-B7A8-293F4682A5BE}"/>
          </ac:spMkLst>
        </pc:spChg>
        <pc:spChg chg="mod topLvl">
          <ac:chgData name="Kumar, Vinod" userId="a0710a6e-bffc-4971-8893-1c23addeb5b0" providerId="ADAL" clId="{A867779D-3C18-41E4-A938-BAAB7B3A31EE}" dt="2023-04-06T19:37:44.967" v="1438" actId="164"/>
          <ac:spMkLst>
            <pc:docMk/>
            <pc:sldMk cId="1703545616" sldId="345"/>
            <ac:spMk id="19" creationId="{8573B515-CA0B-8EC8-8314-60B15F13D653}"/>
          </ac:spMkLst>
        </pc:spChg>
        <pc:spChg chg="del mod">
          <ac:chgData name="Kumar, Vinod" userId="a0710a6e-bffc-4971-8893-1c23addeb5b0" providerId="ADAL" clId="{A867779D-3C18-41E4-A938-BAAB7B3A31EE}" dt="2023-04-06T19:30:45.945" v="1274" actId="478"/>
          <ac:spMkLst>
            <pc:docMk/>
            <pc:sldMk cId="1703545616" sldId="345"/>
            <ac:spMk id="24" creationId="{8C7E5307-BC2B-96BC-A4A7-2E1B27E22E64}"/>
          </ac:spMkLst>
        </pc:spChg>
        <pc:spChg chg="mod topLvl">
          <ac:chgData name="Kumar, Vinod" userId="a0710a6e-bffc-4971-8893-1c23addeb5b0" providerId="ADAL" clId="{A867779D-3C18-41E4-A938-BAAB7B3A31EE}" dt="2023-04-06T19:37:44.967" v="1438" actId="164"/>
          <ac:spMkLst>
            <pc:docMk/>
            <pc:sldMk cId="1703545616" sldId="345"/>
            <ac:spMk id="27" creationId="{B56435B9-224B-5713-92B1-97BDCD5030A2}"/>
          </ac:spMkLst>
        </pc:spChg>
        <pc:spChg chg="mod topLvl">
          <ac:chgData name="Kumar, Vinod" userId="a0710a6e-bffc-4971-8893-1c23addeb5b0" providerId="ADAL" clId="{A867779D-3C18-41E4-A938-BAAB7B3A31EE}" dt="2023-04-06T19:37:44.967" v="1438" actId="164"/>
          <ac:spMkLst>
            <pc:docMk/>
            <pc:sldMk cId="1703545616" sldId="345"/>
            <ac:spMk id="28" creationId="{906CB819-8B04-5ABC-93EC-ED03CEFDE8C9}"/>
          </ac:spMkLst>
        </pc:spChg>
        <pc:spChg chg="mod topLvl">
          <ac:chgData name="Kumar, Vinod" userId="a0710a6e-bffc-4971-8893-1c23addeb5b0" providerId="ADAL" clId="{A867779D-3C18-41E4-A938-BAAB7B3A31EE}" dt="2023-04-06T19:37:44.967" v="1438" actId="164"/>
          <ac:spMkLst>
            <pc:docMk/>
            <pc:sldMk cId="1703545616" sldId="345"/>
            <ac:spMk id="29" creationId="{EF1B5EFF-4B4A-54FE-55E9-93946D0BDFF2}"/>
          </ac:spMkLst>
        </pc:spChg>
        <pc:spChg chg="mod topLvl">
          <ac:chgData name="Kumar, Vinod" userId="a0710a6e-bffc-4971-8893-1c23addeb5b0" providerId="ADAL" clId="{A867779D-3C18-41E4-A938-BAAB7B3A31EE}" dt="2023-04-06T19:37:44.967" v="1438" actId="164"/>
          <ac:spMkLst>
            <pc:docMk/>
            <pc:sldMk cId="1703545616" sldId="345"/>
            <ac:spMk id="30" creationId="{F2263742-AC2E-E6ED-51F9-CE490DD9F178}"/>
          </ac:spMkLst>
        </pc:spChg>
        <pc:spChg chg="mod topLvl">
          <ac:chgData name="Kumar, Vinod" userId="a0710a6e-bffc-4971-8893-1c23addeb5b0" providerId="ADAL" clId="{A867779D-3C18-41E4-A938-BAAB7B3A31EE}" dt="2023-04-06T19:37:44.967" v="1438" actId="164"/>
          <ac:spMkLst>
            <pc:docMk/>
            <pc:sldMk cId="1703545616" sldId="345"/>
            <ac:spMk id="31" creationId="{51F8557A-2CC7-80FE-A711-719455CA9807}"/>
          </ac:spMkLst>
        </pc:spChg>
        <pc:spChg chg="mod topLvl">
          <ac:chgData name="Kumar, Vinod" userId="a0710a6e-bffc-4971-8893-1c23addeb5b0" providerId="ADAL" clId="{A867779D-3C18-41E4-A938-BAAB7B3A31EE}" dt="2023-04-06T19:37:44.967" v="1438" actId="164"/>
          <ac:spMkLst>
            <pc:docMk/>
            <pc:sldMk cId="1703545616" sldId="345"/>
            <ac:spMk id="32" creationId="{46EAD6C3-F57C-6DBE-62ED-A917FBFC7449}"/>
          </ac:spMkLst>
        </pc:spChg>
        <pc:spChg chg="mod topLvl">
          <ac:chgData name="Kumar, Vinod" userId="a0710a6e-bffc-4971-8893-1c23addeb5b0" providerId="ADAL" clId="{A867779D-3C18-41E4-A938-BAAB7B3A31EE}" dt="2023-04-06T19:37:44.967" v="1438" actId="164"/>
          <ac:spMkLst>
            <pc:docMk/>
            <pc:sldMk cId="1703545616" sldId="345"/>
            <ac:spMk id="33" creationId="{187E815E-443A-7C14-EF0A-8A4B6100374A}"/>
          </ac:spMkLst>
        </pc:spChg>
        <pc:spChg chg="mod topLvl">
          <ac:chgData name="Kumar, Vinod" userId="a0710a6e-bffc-4971-8893-1c23addeb5b0" providerId="ADAL" clId="{A867779D-3C18-41E4-A938-BAAB7B3A31EE}" dt="2023-04-06T19:37:44.967" v="1438" actId="164"/>
          <ac:spMkLst>
            <pc:docMk/>
            <pc:sldMk cId="1703545616" sldId="345"/>
            <ac:spMk id="34" creationId="{5CACD010-85E3-9CA0-BBA0-C8F187ED0CFA}"/>
          </ac:spMkLst>
        </pc:spChg>
        <pc:spChg chg="mod topLvl">
          <ac:chgData name="Kumar, Vinod" userId="a0710a6e-bffc-4971-8893-1c23addeb5b0" providerId="ADAL" clId="{A867779D-3C18-41E4-A938-BAAB7B3A31EE}" dt="2023-04-06T19:37:44.967" v="1438" actId="164"/>
          <ac:spMkLst>
            <pc:docMk/>
            <pc:sldMk cId="1703545616" sldId="345"/>
            <ac:spMk id="35" creationId="{32E8CA79-3F19-238D-00A5-4A4204740172}"/>
          </ac:spMkLst>
        </pc:spChg>
        <pc:spChg chg="mod topLvl">
          <ac:chgData name="Kumar, Vinod" userId="a0710a6e-bffc-4971-8893-1c23addeb5b0" providerId="ADAL" clId="{A867779D-3C18-41E4-A938-BAAB7B3A31EE}" dt="2023-04-06T19:37:44.967" v="1438" actId="164"/>
          <ac:spMkLst>
            <pc:docMk/>
            <pc:sldMk cId="1703545616" sldId="345"/>
            <ac:spMk id="36" creationId="{90DC03A3-790D-CA43-33A7-D2D4EA110D2A}"/>
          </ac:spMkLst>
        </pc:spChg>
        <pc:spChg chg="mod">
          <ac:chgData name="Kumar, Vinod" userId="a0710a6e-bffc-4971-8893-1c23addeb5b0" providerId="ADAL" clId="{A867779D-3C18-41E4-A938-BAAB7B3A31EE}" dt="2023-04-06T19:29:21.731" v="1266" actId="165"/>
          <ac:spMkLst>
            <pc:docMk/>
            <pc:sldMk cId="1703545616" sldId="345"/>
            <ac:spMk id="46" creationId="{CE70B3BB-E1A1-1476-4787-49F68ABB94A3}"/>
          </ac:spMkLst>
        </pc:spChg>
        <pc:spChg chg="mod">
          <ac:chgData name="Kumar, Vinod" userId="a0710a6e-bffc-4971-8893-1c23addeb5b0" providerId="ADAL" clId="{A867779D-3C18-41E4-A938-BAAB7B3A31EE}" dt="2023-04-06T19:29:21.731" v="1266" actId="165"/>
          <ac:spMkLst>
            <pc:docMk/>
            <pc:sldMk cId="1703545616" sldId="345"/>
            <ac:spMk id="47" creationId="{93CB8E31-CA46-EBFB-9910-B6FD45A5BEA8}"/>
          </ac:spMkLst>
        </pc:spChg>
        <pc:spChg chg="mod">
          <ac:chgData name="Kumar, Vinod" userId="a0710a6e-bffc-4971-8893-1c23addeb5b0" providerId="ADAL" clId="{A867779D-3C18-41E4-A938-BAAB7B3A31EE}" dt="2023-04-06T19:29:21.731" v="1266" actId="165"/>
          <ac:spMkLst>
            <pc:docMk/>
            <pc:sldMk cId="1703545616" sldId="345"/>
            <ac:spMk id="48" creationId="{52F56041-2196-5C22-35D7-7BDB4A7986F9}"/>
          </ac:spMkLst>
        </pc:spChg>
        <pc:spChg chg="mod">
          <ac:chgData name="Kumar, Vinod" userId="a0710a6e-bffc-4971-8893-1c23addeb5b0" providerId="ADAL" clId="{A867779D-3C18-41E4-A938-BAAB7B3A31EE}" dt="2023-04-06T19:29:21.731" v="1266" actId="165"/>
          <ac:spMkLst>
            <pc:docMk/>
            <pc:sldMk cId="1703545616" sldId="345"/>
            <ac:spMk id="49" creationId="{D14B19FD-B113-5319-F05D-9B2F700D63C0}"/>
          </ac:spMkLst>
        </pc:spChg>
        <pc:spChg chg="mod">
          <ac:chgData name="Kumar, Vinod" userId="a0710a6e-bffc-4971-8893-1c23addeb5b0" providerId="ADAL" clId="{A867779D-3C18-41E4-A938-BAAB7B3A31EE}" dt="2023-04-06T19:29:21.731" v="1266" actId="165"/>
          <ac:spMkLst>
            <pc:docMk/>
            <pc:sldMk cId="1703545616" sldId="345"/>
            <ac:spMk id="50" creationId="{3C9B44A2-E69F-5C88-7509-77C4E2867960}"/>
          </ac:spMkLst>
        </pc:spChg>
        <pc:spChg chg="mod">
          <ac:chgData name="Kumar, Vinod" userId="a0710a6e-bffc-4971-8893-1c23addeb5b0" providerId="ADAL" clId="{A867779D-3C18-41E4-A938-BAAB7B3A31EE}" dt="2023-04-06T19:29:21.731" v="1266" actId="165"/>
          <ac:spMkLst>
            <pc:docMk/>
            <pc:sldMk cId="1703545616" sldId="345"/>
            <ac:spMk id="51" creationId="{614DA849-C355-890F-6A45-C76073E7B939}"/>
          </ac:spMkLst>
        </pc:spChg>
        <pc:spChg chg="mod">
          <ac:chgData name="Kumar, Vinod" userId="a0710a6e-bffc-4971-8893-1c23addeb5b0" providerId="ADAL" clId="{A867779D-3C18-41E4-A938-BAAB7B3A31EE}" dt="2023-04-06T19:29:21.731" v="1266" actId="165"/>
          <ac:spMkLst>
            <pc:docMk/>
            <pc:sldMk cId="1703545616" sldId="345"/>
            <ac:spMk id="52" creationId="{2C720BD0-95B2-B8FE-A7A2-1D20D52B90F3}"/>
          </ac:spMkLst>
        </pc:spChg>
        <pc:spChg chg="mod">
          <ac:chgData name="Kumar, Vinod" userId="a0710a6e-bffc-4971-8893-1c23addeb5b0" providerId="ADAL" clId="{A867779D-3C18-41E4-A938-BAAB7B3A31EE}" dt="2023-04-06T19:29:21.731" v="1266" actId="165"/>
          <ac:spMkLst>
            <pc:docMk/>
            <pc:sldMk cId="1703545616" sldId="345"/>
            <ac:spMk id="53" creationId="{A119A863-C14E-54BD-E764-1370E5DA93B3}"/>
          </ac:spMkLst>
        </pc:spChg>
        <pc:spChg chg="add mod">
          <ac:chgData name="Kumar, Vinod" userId="a0710a6e-bffc-4971-8893-1c23addeb5b0" providerId="ADAL" clId="{A867779D-3C18-41E4-A938-BAAB7B3A31EE}" dt="2023-04-06T19:37:44.967" v="1438" actId="164"/>
          <ac:spMkLst>
            <pc:docMk/>
            <pc:sldMk cId="1703545616" sldId="345"/>
            <ac:spMk id="55" creationId="{154DFE4D-0AA5-3486-DB8A-74F26C686769}"/>
          </ac:spMkLst>
        </pc:spChg>
        <pc:spChg chg="add mod">
          <ac:chgData name="Kumar, Vinod" userId="a0710a6e-bffc-4971-8893-1c23addeb5b0" providerId="ADAL" clId="{A867779D-3C18-41E4-A938-BAAB7B3A31EE}" dt="2023-04-06T19:37:44.967" v="1438" actId="164"/>
          <ac:spMkLst>
            <pc:docMk/>
            <pc:sldMk cId="1703545616" sldId="345"/>
            <ac:spMk id="56" creationId="{4F75431E-827E-EEF8-0C7E-0EA21530E5C8}"/>
          </ac:spMkLst>
        </pc:spChg>
        <pc:spChg chg="add mod">
          <ac:chgData name="Kumar, Vinod" userId="a0710a6e-bffc-4971-8893-1c23addeb5b0" providerId="ADAL" clId="{A867779D-3C18-41E4-A938-BAAB7B3A31EE}" dt="2023-04-06T19:37:44.967" v="1438" actId="164"/>
          <ac:spMkLst>
            <pc:docMk/>
            <pc:sldMk cId="1703545616" sldId="345"/>
            <ac:spMk id="57" creationId="{B099D442-5B05-0576-AE2C-E7E69020E61D}"/>
          </ac:spMkLst>
        </pc:spChg>
        <pc:spChg chg="add mod">
          <ac:chgData name="Kumar, Vinod" userId="a0710a6e-bffc-4971-8893-1c23addeb5b0" providerId="ADAL" clId="{A867779D-3C18-41E4-A938-BAAB7B3A31EE}" dt="2023-04-06T19:37:44.967" v="1438" actId="164"/>
          <ac:spMkLst>
            <pc:docMk/>
            <pc:sldMk cId="1703545616" sldId="345"/>
            <ac:spMk id="58" creationId="{F329CD19-556A-BD17-D770-1930F08176D7}"/>
          </ac:spMkLst>
        </pc:spChg>
        <pc:spChg chg="add mod">
          <ac:chgData name="Kumar, Vinod" userId="a0710a6e-bffc-4971-8893-1c23addeb5b0" providerId="ADAL" clId="{A867779D-3C18-41E4-A938-BAAB7B3A31EE}" dt="2023-04-06T19:37:44.967" v="1438" actId="164"/>
          <ac:spMkLst>
            <pc:docMk/>
            <pc:sldMk cId="1703545616" sldId="345"/>
            <ac:spMk id="59" creationId="{B8B05E31-95D0-5DB3-9D18-781728204626}"/>
          </ac:spMkLst>
        </pc:spChg>
        <pc:grpChg chg="add del mod">
          <ac:chgData name="Kumar, Vinod" userId="a0710a6e-bffc-4971-8893-1c23addeb5b0" providerId="ADAL" clId="{A867779D-3C18-41E4-A938-BAAB7B3A31EE}" dt="2023-04-06T19:29:08.548" v="1263" actId="165"/>
          <ac:grpSpMkLst>
            <pc:docMk/>
            <pc:sldMk cId="1703545616" sldId="345"/>
            <ac:grpSpMk id="9" creationId="{50F9D135-EF84-EED9-C25A-5E129AC061CD}"/>
          </ac:grpSpMkLst>
        </pc:grpChg>
        <pc:grpChg chg="add del mod topLvl">
          <ac:chgData name="Kumar, Vinod" userId="a0710a6e-bffc-4971-8893-1c23addeb5b0" providerId="ADAL" clId="{A867779D-3C18-41E4-A938-BAAB7B3A31EE}" dt="2023-04-06T19:29:21.731" v="1266" actId="165"/>
          <ac:grpSpMkLst>
            <pc:docMk/>
            <pc:sldMk cId="1703545616" sldId="345"/>
            <ac:grpSpMk id="10" creationId="{F5A507FA-4C31-0260-30D3-2524DB7194D4}"/>
          </ac:grpSpMkLst>
        </pc:grpChg>
        <pc:grpChg chg="del mod topLvl">
          <ac:chgData name="Kumar, Vinod" userId="a0710a6e-bffc-4971-8893-1c23addeb5b0" providerId="ADAL" clId="{A867779D-3C18-41E4-A938-BAAB7B3A31EE}" dt="2023-04-06T19:30:54.875" v="1275" actId="165"/>
          <ac:grpSpMkLst>
            <pc:docMk/>
            <pc:sldMk cId="1703545616" sldId="345"/>
            <ac:grpSpMk id="11" creationId="{4BAD8C7C-ED07-9202-ADA1-F1663DBB544D}"/>
          </ac:grpSpMkLst>
        </pc:grpChg>
        <pc:grpChg chg="del mod topLvl">
          <ac:chgData name="Kumar, Vinod" userId="a0710a6e-bffc-4971-8893-1c23addeb5b0" providerId="ADAL" clId="{A867779D-3C18-41E4-A938-BAAB7B3A31EE}" dt="2023-04-06T19:29:25.178" v="1267" actId="478"/>
          <ac:grpSpMkLst>
            <pc:docMk/>
            <pc:sldMk cId="1703545616" sldId="345"/>
            <ac:grpSpMk id="25" creationId="{D4ECFA5D-C139-07EB-6A49-A366C8EA12BF}"/>
          </ac:grpSpMkLst>
        </pc:grpChg>
        <pc:grpChg chg="del mod topLvl">
          <ac:chgData name="Kumar, Vinod" userId="a0710a6e-bffc-4971-8893-1c23addeb5b0" providerId="ADAL" clId="{A867779D-3C18-41E4-A938-BAAB7B3A31EE}" dt="2023-04-06T19:30:30.060" v="1272" actId="165"/>
          <ac:grpSpMkLst>
            <pc:docMk/>
            <pc:sldMk cId="1703545616" sldId="345"/>
            <ac:grpSpMk id="26" creationId="{05AB94A4-F53D-DAE9-FBD3-6324B100301D}"/>
          </ac:grpSpMkLst>
        </pc:grpChg>
        <pc:grpChg chg="mod">
          <ac:chgData name="Kumar, Vinod" userId="a0710a6e-bffc-4971-8893-1c23addeb5b0" providerId="ADAL" clId="{A867779D-3C18-41E4-A938-BAAB7B3A31EE}" dt="2023-04-06T19:29:21.731" v="1266" actId="165"/>
          <ac:grpSpMkLst>
            <pc:docMk/>
            <pc:sldMk cId="1703545616" sldId="345"/>
            <ac:grpSpMk id="45" creationId="{DC5AD3D5-4EF4-869A-DD03-D96B84564627}"/>
          </ac:grpSpMkLst>
        </pc:grpChg>
        <pc:grpChg chg="add mod">
          <ac:chgData name="Kumar, Vinod" userId="a0710a6e-bffc-4971-8893-1c23addeb5b0" providerId="ADAL" clId="{A867779D-3C18-41E4-A938-BAAB7B3A31EE}" dt="2023-04-06T19:37:47.462" v="1439" actId="1076"/>
          <ac:grpSpMkLst>
            <pc:docMk/>
            <pc:sldMk cId="1703545616" sldId="345"/>
            <ac:grpSpMk id="60" creationId="{467C84BF-4189-A138-07B7-4958BCF9A41B}"/>
          </ac:grpSpMkLst>
        </pc:grpChg>
        <pc:picChg chg="add mod">
          <ac:chgData name="Kumar, Vinod" userId="a0710a6e-bffc-4971-8893-1c23addeb5b0" providerId="ADAL" clId="{A867779D-3C18-41E4-A938-BAAB7B3A31EE}" dt="2023-04-06T19:37:44.967" v="1438" actId="164"/>
          <ac:picMkLst>
            <pc:docMk/>
            <pc:sldMk cId="1703545616" sldId="345"/>
            <ac:picMk id="2" creationId="{4121A021-B99A-2DF0-BC3F-E3BC33819111}"/>
          </ac:picMkLst>
        </pc:picChg>
        <pc:picChg chg="add mod">
          <ac:chgData name="Kumar, Vinod" userId="a0710a6e-bffc-4971-8893-1c23addeb5b0" providerId="ADAL" clId="{A867779D-3C18-41E4-A938-BAAB7B3A31EE}" dt="2023-04-06T19:37:44.967" v="1438" actId="164"/>
          <ac:picMkLst>
            <pc:docMk/>
            <pc:sldMk cId="1703545616" sldId="345"/>
            <ac:picMk id="3" creationId="{53E4CFBC-5A19-0EF7-EB6F-87833F1B59E1}"/>
          </ac:picMkLst>
        </pc:picChg>
        <pc:picChg chg="add mod">
          <ac:chgData name="Kumar, Vinod" userId="a0710a6e-bffc-4971-8893-1c23addeb5b0" providerId="ADAL" clId="{A867779D-3C18-41E4-A938-BAAB7B3A31EE}" dt="2023-04-06T19:37:44.967" v="1438" actId="164"/>
          <ac:picMkLst>
            <pc:docMk/>
            <pc:sldMk cId="1703545616" sldId="345"/>
            <ac:picMk id="4" creationId="{89721569-9423-A366-AE6A-1AC546585933}"/>
          </ac:picMkLst>
        </pc:picChg>
        <pc:picChg chg="mod">
          <ac:chgData name="Kumar, Vinod" userId="a0710a6e-bffc-4971-8893-1c23addeb5b0" providerId="ADAL" clId="{A867779D-3C18-41E4-A938-BAAB7B3A31EE}" dt="2023-04-06T19:29:21.731" v="1266" actId="165"/>
          <ac:picMkLst>
            <pc:docMk/>
            <pc:sldMk cId="1703545616" sldId="345"/>
            <ac:picMk id="37" creationId="{60A9CBA1-32E0-10F2-0458-124837C4A7AF}"/>
          </ac:picMkLst>
        </pc:picChg>
        <pc:picChg chg="mod">
          <ac:chgData name="Kumar, Vinod" userId="a0710a6e-bffc-4971-8893-1c23addeb5b0" providerId="ADAL" clId="{A867779D-3C18-41E4-A938-BAAB7B3A31EE}" dt="2023-04-06T19:29:21.731" v="1266" actId="165"/>
          <ac:picMkLst>
            <pc:docMk/>
            <pc:sldMk cId="1703545616" sldId="345"/>
            <ac:picMk id="38" creationId="{58D3A0B3-3A91-CB09-129B-1FC01A88D682}"/>
          </ac:picMkLst>
        </pc:picChg>
        <pc:picChg chg="mod">
          <ac:chgData name="Kumar, Vinod" userId="a0710a6e-bffc-4971-8893-1c23addeb5b0" providerId="ADAL" clId="{A867779D-3C18-41E4-A938-BAAB7B3A31EE}" dt="2023-04-06T19:29:21.731" v="1266" actId="165"/>
          <ac:picMkLst>
            <pc:docMk/>
            <pc:sldMk cId="1703545616" sldId="345"/>
            <ac:picMk id="39" creationId="{A2E7187A-1095-30F1-4662-BE07878D9CCE}"/>
          </ac:picMkLst>
        </pc:picChg>
        <pc:picChg chg="mod">
          <ac:chgData name="Kumar, Vinod" userId="a0710a6e-bffc-4971-8893-1c23addeb5b0" providerId="ADAL" clId="{A867779D-3C18-41E4-A938-BAAB7B3A31EE}" dt="2023-04-06T19:29:21.731" v="1266" actId="165"/>
          <ac:picMkLst>
            <pc:docMk/>
            <pc:sldMk cId="1703545616" sldId="345"/>
            <ac:picMk id="40" creationId="{9086BB30-1A48-2B6C-F591-C89FBCFEEF85}"/>
          </ac:picMkLst>
        </pc:picChg>
        <pc:picChg chg="mod">
          <ac:chgData name="Kumar, Vinod" userId="a0710a6e-bffc-4971-8893-1c23addeb5b0" providerId="ADAL" clId="{A867779D-3C18-41E4-A938-BAAB7B3A31EE}" dt="2023-04-06T19:29:21.731" v="1266" actId="165"/>
          <ac:picMkLst>
            <pc:docMk/>
            <pc:sldMk cId="1703545616" sldId="345"/>
            <ac:picMk id="41" creationId="{55865772-D1B1-3CB8-7F58-65A30AB529FD}"/>
          </ac:picMkLst>
        </pc:picChg>
        <pc:picChg chg="mod">
          <ac:chgData name="Kumar, Vinod" userId="a0710a6e-bffc-4971-8893-1c23addeb5b0" providerId="ADAL" clId="{A867779D-3C18-41E4-A938-BAAB7B3A31EE}" dt="2023-04-06T19:29:21.731" v="1266" actId="165"/>
          <ac:picMkLst>
            <pc:docMk/>
            <pc:sldMk cId="1703545616" sldId="345"/>
            <ac:picMk id="42" creationId="{FA503B7E-881C-BDEA-837A-37EBA470FD55}"/>
          </ac:picMkLst>
        </pc:picChg>
        <pc:picChg chg="mod">
          <ac:chgData name="Kumar, Vinod" userId="a0710a6e-bffc-4971-8893-1c23addeb5b0" providerId="ADAL" clId="{A867779D-3C18-41E4-A938-BAAB7B3A31EE}" dt="2023-04-06T19:29:21.731" v="1266" actId="165"/>
          <ac:picMkLst>
            <pc:docMk/>
            <pc:sldMk cId="1703545616" sldId="345"/>
            <ac:picMk id="43" creationId="{7BE81262-7D8F-FE52-C9E0-81A524A9214C}"/>
          </ac:picMkLst>
        </pc:picChg>
        <pc:picChg chg="mod">
          <ac:chgData name="Kumar, Vinod" userId="a0710a6e-bffc-4971-8893-1c23addeb5b0" providerId="ADAL" clId="{A867779D-3C18-41E4-A938-BAAB7B3A31EE}" dt="2023-04-06T19:29:21.731" v="1266" actId="165"/>
          <ac:picMkLst>
            <pc:docMk/>
            <pc:sldMk cId="1703545616" sldId="345"/>
            <ac:picMk id="44" creationId="{D89DC940-0425-4E80-CF6A-BC9E205B845C}"/>
          </ac:picMkLst>
        </pc:picChg>
        <pc:picChg chg="add del mod">
          <ac:chgData name="Kumar, Vinod" userId="a0710a6e-bffc-4971-8893-1c23addeb5b0" providerId="ADAL" clId="{A867779D-3C18-41E4-A938-BAAB7B3A31EE}" dt="2023-04-06T19:37:36.838" v="1437" actId="478"/>
          <ac:picMkLst>
            <pc:docMk/>
            <pc:sldMk cId="1703545616" sldId="345"/>
            <ac:picMk id="54" creationId="{FD2B9841-AC37-402C-41FE-6BC9F8601494}"/>
          </ac:picMkLst>
        </pc:picChg>
        <pc:cxnChg chg="del mod topLvl">
          <ac:chgData name="Kumar, Vinod" userId="a0710a6e-bffc-4971-8893-1c23addeb5b0" providerId="ADAL" clId="{A867779D-3C18-41E4-A938-BAAB7B3A31EE}" dt="2023-04-06T19:31:29.145" v="1313" actId="478"/>
          <ac:cxnSpMkLst>
            <pc:docMk/>
            <pc:sldMk cId="1703545616" sldId="345"/>
            <ac:cxnSpMk id="20" creationId="{8913AE74-D95C-1D01-66A8-65320687A501}"/>
          </ac:cxnSpMkLst>
        </pc:cxnChg>
        <pc:cxnChg chg="del mod topLvl">
          <ac:chgData name="Kumar, Vinod" userId="a0710a6e-bffc-4971-8893-1c23addeb5b0" providerId="ADAL" clId="{A867779D-3C18-41E4-A938-BAAB7B3A31EE}" dt="2023-04-06T19:32:24.330" v="1351" actId="478"/>
          <ac:cxnSpMkLst>
            <pc:docMk/>
            <pc:sldMk cId="1703545616" sldId="345"/>
            <ac:cxnSpMk id="21" creationId="{682B4371-B1C6-F5B9-20FC-057D270F282B}"/>
          </ac:cxnSpMkLst>
        </pc:cxnChg>
        <pc:cxnChg chg="del mod topLvl">
          <ac:chgData name="Kumar, Vinod" userId="a0710a6e-bffc-4971-8893-1c23addeb5b0" providerId="ADAL" clId="{A867779D-3C18-41E4-A938-BAAB7B3A31EE}" dt="2023-04-06T19:32:41.754" v="1382" actId="478"/>
          <ac:cxnSpMkLst>
            <pc:docMk/>
            <pc:sldMk cId="1703545616" sldId="345"/>
            <ac:cxnSpMk id="22" creationId="{76AA2930-6258-D31F-C480-7792B6F5FADC}"/>
          </ac:cxnSpMkLst>
        </pc:cxnChg>
        <pc:cxnChg chg="del mod topLvl">
          <ac:chgData name="Kumar, Vinod" userId="a0710a6e-bffc-4971-8893-1c23addeb5b0" providerId="ADAL" clId="{A867779D-3C18-41E4-A938-BAAB7B3A31EE}" dt="2023-04-06T19:33:00.921" v="1396" actId="478"/>
          <ac:cxnSpMkLst>
            <pc:docMk/>
            <pc:sldMk cId="1703545616" sldId="345"/>
            <ac:cxnSpMk id="23" creationId="{1CFF2921-00AE-93FC-F574-88974D46E585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27363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56050" y="0"/>
            <a:ext cx="3027363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8145967-F332-4C76-936E-591AC2206752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5525" y="1160463"/>
            <a:ext cx="2393950" cy="31337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8500" y="4467225"/>
            <a:ext cx="5588000" cy="365601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18563"/>
            <a:ext cx="3027363" cy="4651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56050" y="8818563"/>
            <a:ext cx="3027363" cy="4651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8EB94F1-CF9C-4D63-BFA2-8C28093D83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46780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58165" y="3025996"/>
            <a:ext cx="6325870" cy="208798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16331" y="5519845"/>
            <a:ext cx="5209540" cy="2489341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599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1980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797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6396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2995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9594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6193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2792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AE006E-699A-4BA2-836F-5A58D9682716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40FC4-ED06-41EF-886A-E977EAC9D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53326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AE006E-699A-4BA2-836F-5A58D9682716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40FC4-ED06-41EF-886A-E977EAC9D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1083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95595" y="390094"/>
            <a:ext cx="1674495" cy="83113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2110" y="390094"/>
            <a:ext cx="4899448" cy="83113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AE006E-699A-4BA2-836F-5A58D9682716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40FC4-ED06-41EF-886A-E977EAC9D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5174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AE006E-699A-4BA2-836F-5A58D9682716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40FC4-ED06-41EF-886A-E977EAC9D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452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7883" y="6259433"/>
            <a:ext cx="6325870" cy="1934651"/>
          </a:xfrm>
        </p:spPr>
        <p:txBody>
          <a:bodyPr anchor="t"/>
          <a:lstStyle>
            <a:lvl1pPr algn="l">
              <a:defRPr sz="5773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87883" y="4128616"/>
            <a:ext cx="6325870" cy="2130821"/>
          </a:xfrm>
        </p:spPr>
        <p:txBody>
          <a:bodyPr anchor="b"/>
          <a:lstStyle>
            <a:lvl1pPr marL="0" indent="0">
              <a:buNone/>
              <a:defRPr sz="2887">
                <a:solidFill>
                  <a:schemeClr val="tx1">
                    <a:tint val="75000"/>
                  </a:schemeClr>
                </a:solidFill>
              </a:defRPr>
            </a:lvl1pPr>
            <a:lvl2pPr marL="659903" indent="0">
              <a:buNone/>
              <a:defRPr sz="2598">
                <a:solidFill>
                  <a:schemeClr val="tx1">
                    <a:tint val="75000"/>
                  </a:schemeClr>
                </a:solidFill>
              </a:defRPr>
            </a:lvl2pPr>
            <a:lvl3pPr marL="1319806" indent="0">
              <a:buNone/>
              <a:defRPr sz="2309">
                <a:solidFill>
                  <a:schemeClr val="tx1">
                    <a:tint val="75000"/>
                  </a:schemeClr>
                </a:solidFill>
              </a:defRPr>
            </a:lvl3pPr>
            <a:lvl4pPr marL="1979708" indent="0">
              <a:buNone/>
              <a:defRPr sz="2021">
                <a:solidFill>
                  <a:schemeClr val="tx1">
                    <a:tint val="75000"/>
                  </a:schemeClr>
                </a:solidFill>
              </a:defRPr>
            </a:lvl4pPr>
            <a:lvl5pPr marL="2639611" indent="0">
              <a:buNone/>
              <a:defRPr sz="2021">
                <a:solidFill>
                  <a:schemeClr val="tx1">
                    <a:tint val="75000"/>
                  </a:schemeClr>
                </a:solidFill>
              </a:defRPr>
            </a:lvl5pPr>
            <a:lvl6pPr marL="3299516" indent="0">
              <a:buNone/>
              <a:defRPr sz="2021">
                <a:solidFill>
                  <a:schemeClr val="tx1">
                    <a:tint val="75000"/>
                  </a:schemeClr>
                </a:solidFill>
              </a:defRPr>
            </a:lvl6pPr>
            <a:lvl7pPr marL="3959416" indent="0">
              <a:buNone/>
              <a:defRPr sz="2021">
                <a:solidFill>
                  <a:schemeClr val="tx1">
                    <a:tint val="75000"/>
                  </a:schemeClr>
                </a:solidFill>
              </a:defRPr>
            </a:lvl7pPr>
            <a:lvl8pPr marL="4619318" indent="0">
              <a:buNone/>
              <a:defRPr sz="2021">
                <a:solidFill>
                  <a:schemeClr val="tx1">
                    <a:tint val="75000"/>
                  </a:schemeClr>
                </a:solidFill>
              </a:defRPr>
            </a:lvl8pPr>
            <a:lvl9pPr marL="5279223" indent="0">
              <a:buNone/>
              <a:defRPr sz="202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AE006E-699A-4BA2-836F-5A58D9682716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40FC4-ED06-41EF-886A-E977EAC9D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36188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2110" y="2272883"/>
            <a:ext cx="3286972" cy="6428542"/>
          </a:xfrm>
        </p:spPr>
        <p:txBody>
          <a:bodyPr/>
          <a:lstStyle>
            <a:lvl1pPr>
              <a:defRPr sz="4041"/>
            </a:lvl1pPr>
            <a:lvl2pPr>
              <a:defRPr sz="3464"/>
            </a:lvl2pPr>
            <a:lvl3pPr>
              <a:defRPr sz="2887"/>
            </a:lvl3pPr>
            <a:lvl4pPr>
              <a:defRPr sz="2598"/>
            </a:lvl4pPr>
            <a:lvl5pPr>
              <a:defRPr sz="2598"/>
            </a:lvl5pPr>
            <a:lvl6pPr>
              <a:defRPr sz="2598"/>
            </a:lvl6pPr>
            <a:lvl7pPr>
              <a:defRPr sz="2598"/>
            </a:lvl7pPr>
            <a:lvl8pPr>
              <a:defRPr sz="2598"/>
            </a:lvl8pPr>
            <a:lvl9pPr>
              <a:defRPr sz="2598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83118" y="2272883"/>
            <a:ext cx="3286972" cy="6428542"/>
          </a:xfrm>
        </p:spPr>
        <p:txBody>
          <a:bodyPr/>
          <a:lstStyle>
            <a:lvl1pPr>
              <a:defRPr sz="4041"/>
            </a:lvl1pPr>
            <a:lvl2pPr>
              <a:defRPr sz="3464"/>
            </a:lvl2pPr>
            <a:lvl3pPr>
              <a:defRPr sz="2887"/>
            </a:lvl3pPr>
            <a:lvl4pPr>
              <a:defRPr sz="2598"/>
            </a:lvl4pPr>
            <a:lvl5pPr>
              <a:defRPr sz="2598"/>
            </a:lvl5pPr>
            <a:lvl6pPr>
              <a:defRPr sz="2598"/>
            </a:lvl6pPr>
            <a:lvl7pPr>
              <a:defRPr sz="2598"/>
            </a:lvl7pPr>
            <a:lvl8pPr>
              <a:defRPr sz="2598"/>
            </a:lvl8pPr>
            <a:lvl9pPr>
              <a:defRPr sz="2598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AE006E-699A-4BA2-836F-5A58D9682716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40FC4-ED06-41EF-886A-E977EAC9D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3350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2112" y="2180432"/>
            <a:ext cx="3288264" cy="908699"/>
          </a:xfrm>
        </p:spPr>
        <p:txBody>
          <a:bodyPr anchor="b"/>
          <a:lstStyle>
            <a:lvl1pPr marL="0" indent="0">
              <a:buNone/>
              <a:defRPr sz="3464" b="1"/>
            </a:lvl1pPr>
            <a:lvl2pPr marL="659903" indent="0">
              <a:buNone/>
              <a:defRPr sz="2887" b="1"/>
            </a:lvl2pPr>
            <a:lvl3pPr marL="1319806" indent="0">
              <a:buNone/>
              <a:defRPr sz="2598" b="1"/>
            </a:lvl3pPr>
            <a:lvl4pPr marL="1979708" indent="0">
              <a:buNone/>
              <a:defRPr sz="2309" b="1"/>
            </a:lvl4pPr>
            <a:lvl5pPr marL="2639611" indent="0">
              <a:buNone/>
              <a:defRPr sz="2309" b="1"/>
            </a:lvl5pPr>
            <a:lvl6pPr marL="3299516" indent="0">
              <a:buNone/>
              <a:defRPr sz="2309" b="1"/>
            </a:lvl6pPr>
            <a:lvl7pPr marL="3959416" indent="0">
              <a:buNone/>
              <a:defRPr sz="2309" b="1"/>
            </a:lvl7pPr>
            <a:lvl8pPr marL="4619318" indent="0">
              <a:buNone/>
              <a:defRPr sz="2309" b="1"/>
            </a:lvl8pPr>
            <a:lvl9pPr marL="5279223" indent="0">
              <a:buNone/>
              <a:defRPr sz="230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2112" y="3089131"/>
            <a:ext cx="3288264" cy="5612292"/>
          </a:xfrm>
        </p:spPr>
        <p:txBody>
          <a:bodyPr/>
          <a:lstStyle>
            <a:lvl1pPr>
              <a:defRPr sz="3464"/>
            </a:lvl1pPr>
            <a:lvl2pPr>
              <a:defRPr sz="2887"/>
            </a:lvl2pPr>
            <a:lvl3pPr>
              <a:defRPr sz="2598"/>
            </a:lvl3pPr>
            <a:lvl4pPr>
              <a:defRPr sz="2309"/>
            </a:lvl4pPr>
            <a:lvl5pPr>
              <a:defRPr sz="2309"/>
            </a:lvl5pPr>
            <a:lvl6pPr>
              <a:defRPr sz="2309"/>
            </a:lvl6pPr>
            <a:lvl7pPr>
              <a:defRPr sz="2309"/>
            </a:lvl7pPr>
            <a:lvl8pPr>
              <a:defRPr sz="2309"/>
            </a:lvl8pPr>
            <a:lvl9pPr>
              <a:defRPr sz="230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80546" y="2180432"/>
            <a:ext cx="3289555" cy="908699"/>
          </a:xfrm>
        </p:spPr>
        <p:txBody>
          <a:bodyPr anchor="b"/>
          <a:lstStyle>
            <a:lvl1pPr marL="0" indent="0">
              <a:buNone/>
              <a:defRPr sz="3464" b="1"/>
            </a:lvl1pPr>
            <a:lvl2pPr marL="659903" indent="0">
              <a:buNone/>
              <a:defRPr sz="2887" b="1"/>
            </a:lvl2pPr>
            <a:lvl3pPr marL="1319806" indent="0">
              <a:buNone/>
              <a:defRPr sz="2598" b="1"/>
            </a:lvl3pPr>
            <a:lvl4pPr marL="1979708" indent="0">
              <a:buNone/>
              <a:defRPr sz="2309" b="1"/>
            </a:lvl4pPr>
            <a:lvl5pPr marL="2639611" indent="0">
              <a:buNone/>
              <a:defRPr sz="2309" b="1"/>
            </a:lvl5pPr>
            <a:lvl6pPr marL="3299516" indent="0">
              <a:buNone/>
              <a:defRPr sz="2309" b="1"/>
            </a:lvl6pPr>
            <a:lvl7pPr marL="3959416" indent="0">
              <a:buNone/>
              <a:defRPr sz="2309" b="1"/>
            </a:lvl7pPr>
            <a:lvl8pPr marL="4619318" indent="0">
              <a:buNone/>
              <a:defRPr sz="2309" b="1"/>
            </a:lvl8pPr>
            <a:lvl9pPr marL="5279223" indent="0">
              <a:buNone/>
              <a:defRPr sz="230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80546" y="3089131"/>
            <a:ext cx="3289555" cy="5612292"/>
          </a:xfrm>
        </p:spPr>
        <p:txBody>
          <a:bodyPr/>
          <a:lstStyle>
            <a:lvl1pPr>
              <a:defRPr sz="3464"/>
            </a:lvl1pPr>
            <a:lvl2pPr>
              <a:defRPr sz="2887"/>
            </a:lvl2pPr>
            <a:lvl3pPr>
              <a:defRPr sz="2598"/>
            </a:lvl3pPr>
            <a:lvl4pPr>
              <a:defRPr sz="2309"/>
            </a:lvl4pPr>
            <a:lvl5pPr>
              <a:defRPr sz="2309"/>
            </a:lvl5pPr>
            <a:lvl6pPr>
              <a:defRPr sz="2309"/>
            </a:lvl6pPr>
            <a:lvl7pPr>
              <a:defRPr sz="2309"/>
            </a:lvl7pPr>
            <a:lvl8pPr>
              <a:defRPr sz="2309"/>
            </a:lvl8pPr>
            <a:lvl9pPr>
              <a:defRPr sz="230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AE006E-699A-4BA2-836F-5A58D9682716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40FC4-ED06-41EF-886A-E977EAC9D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45972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AE006E-699A-4BA2-836F-5A58D9682716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40FC4-ED06-41EF-886A-E977EAC9D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01112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AE006E-699A-4BA2-836F-5A58D9682716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40FC4-ED06-41EF-886A-E977EAC9D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30175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121" y="387834"/>
            <a:ext cx="2448433" cy="1650541"/>
          </a:xfrm>
        </p:spPr>
        <p:txBody>
          <a:bodyPr anchor="b"/>
          <a:lstStyle>
            <a:lvl1pPr algn="l">
              <a:defRPr sz="2887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09704" y="387838"/>
            <a:ext cx="4160397" cy="8313588"/>
          </a:xfrm>
        </p:spPr>
        <p:txBody>
          <a:bodyPr/>
          <a:lstStyle>
            <a:lvl1pPr>
              <a:defRPr sz="4619"/>
            </a:lvl1pPr>
            <a:lvl2pPr>
              <a:defRPr sz="4041"/>
            </a:lvl2pPr>
            <a:lvl3pPr>
              <a:defRPr sz="3464"/>
            </a:lvl3pPr>
            <a:lvl4pPr>
              <a:defRPr sz="2887"/>
            </a:lvl4pPr>
            <a:lvl5pPr>
              <a:defRPr sz="2887"/>
            </a:lvl5pPr>
            <a:lvl6pPr>
              <a:defRPr sz="2887"/>
            </a:lvl6pPr>
            <a:lvl7pPr>
              <a:defRPr sz="2887"/>
            </a:lvl7pPr>
            <a:lvl8pPr>
              <a:defRPr sz="2887"/>
            </a:lvl8pPr>
            <a:lvl9pPr>
              <a:defRPr sz="288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2121" y="2038380"/>
            <a:ext cx="2448433" cy="6663047"/>
          </a:xfrm>
        </p:spPr>
        <p:txBody>
          <a:bodyPr/>
          <a:lstStyle>
            <a:lvl1pPr marL="0" indent="0">
              <a:buNone/>
              <a:defRPr sz="2021"/>
            </a:lvl1pPr>
            <a:lvl2pPr marL="659903" indent="0">
              <a:buNone/>
              <a:defRPr sz="1732"/>
            </a:lvl2pPr>
            <a:lvl3pPr marL="1319806" indent="0">
              <a:buNone/>
              <a:defRPr sz="1443"/>
            </a:lvl3pPr>
            <a:lvl4pPr marL="1979708" indent="0">
              <a:buNone/>
              <a:defRPr sz="1299"/>
            </a:lvl4pPr>
            <a:lvl5pPr marL="2639611" indent="0">
              <a:buNone/>
              <a:defRPr sz="1299"/>
            </a:lvl5pPr>
            <a:lvl6pPr marL="3299516" indent="0">
              <a:buNone/>
              <a:defRPr sz="1299"/>
            </a:lvl6pPr>
            <a:lvl7pPr marL="3959416" indent="0">
              <a:buNone/>
              <a:defRPr sz="1299"/>
            </a:lvl7pPr>
            <a:lvl8pPr marL="4619318" indent="0">
              <a:buNone/>
              <a:defRPr sz="1299"/>
            </a:lvl8pPr>
            <a:lvl9pPr marL="5279223" indent="0">
              <a:buNone/>
              <a:defRPr sz="129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AE006E-699A-4BA2-836F-5A58D9682716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40FC4-ED06-41EF-886A-E977EAC9D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59115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58723" y="6818636"/>
            <a:ext cx="4465320" cy="804978"/>
          </a:xfrm>
        </p:spPr>
        <p:txBody>
          <a:bodyPr anchor="b"/>
          <a:lstStyle>
            <a:lvl1pPr algn="l">
              <a:defRPr sz="2887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58723" y="870368"/>
            <a:ext cx="4465320" cy="5844540"/>
          </a:xfrm>
        </p:spPr>
        <p:txBody>
          <a:bodyPr/>
          <a:lstStyle>
            <a:lvl1pPr marL="0" indent="0">
              <a:buNone/>
              <a:defRPr sz="4619"/>
            </a:lvl1pPr>
            <a:lvl2pPr marL="659903" indent="0">
              <a:buNone/>
              <a:defRPr sz="4041"/>
            </a:lvl2pPr>
            <a:lvl3pPr marL="1319806" indent="0">
              <a:buNone/>
              <a:defRPr sz="3464"/>
            </a:lvl3pPr>
            <a:lvl4pPr marL="1979708" indent="0">
              <a:buNone/>
              <a:defRPr sz="2887"/>
            </a:lvl4pPr>
            <a:lvl5pPr marL="2639611" indent="0">
              <a:buNone/>
              <a:defRPr sz="2887"/>
            </a:lvl5pPr>
            <a:lvl6pPr marL="3299516" indent="0">
              <a:buNone/>
              <a:defRPr sz="2887"/>
            </a:lvl6pPr>
            <a:lvl7pPr marL="3959416" indent="0">
              <a:buNone/>
              <a:defRPr sz="2887"/>
            </a:lvl7pPr>
            <a:lvl8pPr marL="4619318" indent="0">
              <a:buNone/>
              <a:defRPr sz="2887"/>
            </a:lvl8pPr>
            <a:lvl9pPr marL="5279223" indent="0">
              <a:buNone/>
              <a:defRPr sz="2887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58723" y="7623613"/>
            <a:ext cx="4465320" cy="1143202"/>
          </a:xfrm>
        </p:spPr>
        <p:txBody>
          <a:bodyPr/>
          <a:lstStyle>
            <a:lvl1pPr marL="0" indent="0">
              <a:buNone/>
              <a:defRPr sz="2021"/>
            </a:lvl1pPr>
            <a:lvl2pPr marL="659903" indent="0">
              <a:buNone/>
              <a:defRPr sz="1732"/>
            </a:lvl2pPr>
            <a:lvl3pPr marL="1319806" indent="0">
              <a:buNone/>
              <a:defRPr sz="1443"/>
            </a:lvl3pPr>
            <a:lvl4pPr marL="1979708" indent="0">
              <a:buNone/>
              <a:defRPr sz="1299"/>
            </a:lvl4pPr>
            <a:lvl5pPr marL="2639611" indent="0">
              <a:buNone/>
              <a:defRPr sz="1299"/>
            </a:lvl5pPr>
            <a:lvl6pPr marL="3299516" indent="0">
              <a:buNone/>
              <a:defRPr sz="1299"/>
            </a:lvl6pPr>
            <a:lvl7pPr marL="3959416" indent="0">
              <a:buNone/>
              <a:defRPr sz="1299"/>
            </a:lvl7pPr>
            <a:lvl8pPr marL="4619318" indent="0">
              <a:buNone/>
              <a:defRPr sz="1299"/>
            </a:lvl8pPr>
            <a:lvl9pPr marL="5279223" indent="0">
              <a:buNone/>
              <a:defRPr sz="129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AE006E-699A-4BA2-836F-5A58D9682716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40FC4-ED06-41EF-886A-E977EAC9D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95852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72110" y="390088"/>
            <a:ext cx="6697980" cy="162348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2110" y="2272883"/>
            <a:ext cx="6697980" cy="642854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72110" y="9028376"/>
            <a:ext cx="1736513" cy="51861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AE006E-699A-4BA2-836F-5A58D9682716}" type="datetimeFigureOut">
              <a:rPr lang="en-US" smtClean="0"/>
              <a:t>1/1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42753" y="9028376"/>
            <a:ext cx="2356697" cy="51861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3577" y="9028376"/>
            <a:ext cx="1736513" cy="51861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140FC4-ED06-41EF-886A-E977EAC9D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46225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319806" rtl="0" eaLnBrk="1" latinLnBrk="0" hangingPunct="1">
        <a:spcBef>
          <a:spcPct val="0"/>
        </a:spcBef>
        <a:buNone/>
        <a:defRPr sz="635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94926" indent="-494926" algn="l" defTabSz="1319806" rtl="0" eaLnBrk="1" latinLnBrk="0" hangingPunct="1">
        <a:spcBef>
          <a:spcPct val="20000"/>
        </a:spcBef>
        <a:buFont typeface="Arial" panose="020B0604020202020204" pitchFamily="34" charset="0"/>
        <a:buChar char="•"/>
        <a:defRPr sz="4619" kern="1200">
          <a:solidFill>
            <a:schemeClr val="tx1"/>
          </a:solidFill>
          <a:latin typeface="+mn-lt"/>
          <a:ea typeface="+mn-ea"/>
          <a:cs typeface="+mn-cs"/>
        </a:defRPr>
      </a:lvl1pPr>
      <a:lvl2pPr marL="1072340" indent="-412441" algn="l" defTabSz="1319806" rtl="0" eaLnBrk="1" latinLnBrk="0" hangingPunct="1">
        <a:spcBef>
          <a:spcPct val="20000"/>
        </a:spcBef>
        <a:buFont typeface="Arial" panose="020B0604020202020204" pitchFamily="34" charset="0"/>
        <a:buChar char="–"/>
        <a:defRPr sz="4041" kern="1200">
          <a:solidFill>
            <a:schemeClr val="tx1"/>
          </a:solidFill>
          <a:latin typeface="+mn-lt"/>
          <a:ea typeface="+mn-ea"/>
          <a:cs typeface="+mn-cs"/>
        </a:defRPr>
      </a:lvl2pPr>
      <a:lvl3pPr marL="1649757" indent="-329951" algn="l" defTabSz="1319806" rtl="0" eaLnBrk="1" latinLnBrk="0" hangingPunct="1">
        <a:spcBef>
          <a:spcPct val="20000"/>
        </a:spcBef>
        <a:buFont typeface="Arial" panose="020B0604020202020204" pitchFamily="34" charset="0"/>
        <a:buChar char="•"/>
        <a:defRPr sz="3464" kern="1200">
          <a:solidFill>
            <a:schemeClr val="tx1"/>
          </a:solidFill>
          <a:latin typeface="+mn-lt"/>
          <a:ea typeface="+mn-ea"/>
          <a:cs typeface="+mn-cs"/>
        </a:defRPr>
      </a:lvl3pPr>
      <a:lvl4pPr marL="2309660" indent="-329951" algn="l" defTabSz="1319806" rtl="0" eaLnBrk="1" latinLnBrk="0" hangingPunct="1">
        <a:spcBef>
          <a:spcPct val="20000"/>
        </a:spcBef>
        <a:buFont typeface="Arial" panose="020B0604020202020204" pitchFamily="34" charset="0"/>
        <a:buChar char="–"/>
        <a:defRPr sz="2887" kern="1200">
          <a:solidFill>
            <a:schemeClr val="tx1"/>
          </a:solidFill>
          <a:latin typeface="+mn-lt"/>
          <a:ea typeface="+mn-ea"/>
          <a:cs typeface="+mn-cs"/>
        </a:defRPr>
      </a:lvl4pPr>
      <a:lvl5pPr marL="2969564" indent="-329951" algn="l" defTabSz="1319806" rtl="0" eaLnBrk="1" latinLnBrk="0" hangingPunct="1">
        <a:spcBef>
          <a:spcPct val="20000"/>
        </a:spcBef>
        <a:buFont typeface="Arial" panose="020B0604020202020204" pitchFamily="34" charset="0"/>
        <a:buChar char="»"/>
        <a:defRPr sz="2887" kern="1200">
          <a:solidFill>
            <a:schemeClr val="tx1"/>
          </a:solidFill>
          <a:latin typeface="+mn-lt"/>
          <a:ea typeface="+mn-ea"/>
          <a:cs typeface="+mn-cs"/>
        </a:defRPr>
      </a:lvl5pPr>
      <a:lvl6pPr marL="3629466" indent="-329951" algn="l" defTabSz="1319806" rtl="0" eaLnBrk="1" latinLnBrk="0" hangingPunct="1">
        <a:spcBef>
          <a:spcPct val="20000"/>
        </a:spcBef>
        <a:buFont typeface="Arial" panose="020B0604020202020204" pitchFamily="34" charset="0"/>
        <a:buChar char="•"/>
        <a:defRPr sz="2887" kern="1200">
          <a:solidFill>
            <a:schemeClr val="tx1"/>
          </a:solidFill>
          <a:latin typeface="+mn-lt"/>
          <a:ea typeface="+mn-ea"/>
          <a:cs typeface="+mn-cs"/>
        </a:defRPr>
      </a:lvl6pPr>
      <a:lvl7pPr marL="4289367" indent="-329951" algn="l" defTabSz="1319806" rtl="0" eaLnBrk="1" latinLnBrk="0" hangingPunct="1">
        <a:spcBef>
          <a:spcPct val="20000"/>
        </a:spcBef>
        <a:buFont typeface="Arial" panose="020B0604020202020204" pitchFamily="34" charset="0"/>
        <a:buChar char="•"/>
        <a:defRPr sz="2887" kern="1200">
          <a:solidFill>
            <a:schemeClr val="tx1"/>
          </a:solidFill>
          <a:latin typeface="+mn-lt"/>
          <a:ea typeface="+mn-ea"/>
          <a:cs typeface="+mn-cs"/>
        </a:defRPr>
      </a:lvl7pPr>
      <a:lvl8pPr marL="4949272" indent="-329951" algn="l" defTabSz="1319806" rtl="0" eaLnBrk="1" latinLnBrk="0" hangingPunct="1">
        <a:spcBef>
          <a:spcPct val="20000"/>
        </a:spcBef>
        <a:buFont typeface="Arial" panose="020B0604020202020204" pitchFamily="34" charset="0"/>
        <a:buChar char="•"/>
        <a:defRPr sz="2887" kern="1200">
          <a:solidFill>
            <a:schemeClr val="tx1"/>
          </a:solidFill>
          <a:latin typeface="+mn-lt"/>
          <a:ea typeface="+mn-ea"/>
          <a:cs typeface="+mn-cs"/>
        </a:defRPr>
      </a:lvl8pPr>
      <a:lvl9pPr marL="5609176" indent="-329951" algn="l" defTabSz="1319806" rtl="0" eaLnBrk="1" latinLnBrk="0" hangingPunct="1">
        <a:spcBef>
          <a:spcPct val="20000"/>
        </a:spcBef>
        <a:buFont typeface="Arial" panose="020B0604020202020204" pitchFamily="34" charset="0"/>
        <a:buChar char="•"/>
        <a:defRPr sz="288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19806" rtl="0" eaLnBrk="1" latinLnBrk="0" hangingPunct="1">
        <a:defRPr sz="2598" kern="1200">
          <a:solidFill>
            <a:schemeClr val="tx1"/>
          </a:solidFill>
          <a:latin typeface="+mn-lt"/>
          <a:ea typeface="+mn-ea"/>
          <a:cs typeface="+mn-cs"/>
        </a:defRPr>
      </a:lvl1pPr>
      <a:lvl2pPr marL="659903" algn="l" defTabSz="1319806" rtl="0" eaLnBrk="1" latinLnBrk="0" hangingPunct="1">
        <a:defRPr sz="2598" kern="1200">
          <a:solidFill>
            <a:schemeClr val="tx1"/>
          </a:solidFill>
          <a:latin typeface="+mn-lt"/>
          <a:ea typeface="+mn-ea"/>
          <a:cs typeface="+mn-cs"/>
        </a:defRPr>
      </a:lvl2pPr>
      <a:lvl3pPr marL="1319806" algn="l" defTabSz="1319806" rtl="0" eaLnBrk="1" latinLnBrk="0" hangingPunct="1">
        <a:defRPr sz="2598" kern="1200">
          <a:solidFill>
            <a:schemeClr val="tx1"/>
          </a:solidFill>
          <a:latin typeface="+mn-lt"/>
          <a:ea typeface="+mn-ea"/>
          <a:cs typeface="+mn-cs"/>
        </a:defRPr>
      </a:lvl3pPr>
      <a:lvl4pPr marL="1979708" algn="l" defTabSz="1319806" rtl="0" eaLnBrk="1" latinLnBrk="0" hangingPunct="1">
        <a:defRPr sz="2598" kern="1200">
          <a:solidFill>
            <a:schemeClr val="tx1"/>
          </a:solidFill>
          <a:latin typeface="+mn-lt"/>
          <a:ea typeface="+mn-ea"/>
          <a:cs typeface="+mn-cs"/>
        </a:defRPr>
      </a:lvl4pPr>
      <a:lvl5pPr marL="2639611" algn="l" defTabSz="1319806" rtl="0" eaLnBrk="1" latinLnBrk="0" hangingPunct="1">
        <a:defRPr sz="2598" kern="1200">
          <a:solidFill>
            <a:schemeClr val="tx1"/>
          </a:solidFill>
          <a:latin typeface="+mn-lt"/>
          <a:ea typeface="+mn-ea"/>
          <a:cs typeface="+mn-cs"/>
        </a:defRPr>
      </a:lvl5pPr>
      <a:lvl6pPr marL="3299516" algn="l" defTabSz="1319806" rtl="0" eaLnBrk="1" latinLnBrk="0" hangingPunct="1">
        <a:defRPr sz="2598" kern="1200">
          <a:solidFill>
            <a:schemeClr val="tx1"/>
          </a:solidFill>
          <a:latin typeface="+mn-lt"/>
          <a:ea typeface="+mn-ea"/>
          <a:cs typeface="+mn-cs"/>
        </a:defRPr>
      </a:lvl6pPr>
      <a:lvl7pPr marL="3959416" algn="l" defTabSz="1319806" rtl="0" eaLnBrk="1" latinLnBrk="0" hangingPunct="1">
        <a:defRPr sz="2598" kern="1200">
          <a:solidFill>
            <a:schemeClr val="tx1"/>
          </a:solidFill>
          <a:latin typeface="+mn-lt"/>
          <a:ea typeface="+mn-ea"/>
          <a:cs typeface="+mn-cs"/>
        </a:defRPr>
      </a:lvl7pPr>
      <a:lvl8pPr marL="4619318" algn="l" defTabSz="1319806" rtl="0" eaLnBrk="1" latinLnBrk="0" hangingPunct="1">
        <a:defRPr sz="2598" kern="1200">
          <a:solidFill>
            <a:schemeClr val="tx1"/>
          </a:solidFill>
          <a:latin typeface="+mn-lt"/>
          <a:ea typeface="+mn-ea"/>
          <a:cs typeface="+mn-cs"/>
        </a:defRPr>
      </a:lvl8pPr>
      <a:lvl9pPr marL="5279223" algn="l" defTabSz="1319806" rtl="0" eaLnBrk="1" latinLnBrk="0" hangingPunct="1">
        <a:defRPr sz="259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emf"/><Relationship Id="rId2" Type="http://schemas.openxmlformats.org/officeDocument/2006/relationships/image" Target="../media/image49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2.jpeg"/><Relationship Id="rId4" Type="http://schemas.openxmlformats.org/officeDocument/2006/relationships/image" Target="../media/image51.jpe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emf"/><Relationship Id="rId2" Type="http://schemas.openxmlformats.org/officeDocument/2006/relationships/image" Target="../media/image53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6.jpeg"/><Relationship Id="rId4" Type="http://schemas.openxmlformats.org/officeDocument/2006/relationships/image" Target="../media/image55.em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jpeg"/><Relationship Id="rId2" Type="http://schemas.openxmlformats.org/officeDocument/2006/relationships/image" Target="../media/image57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emf"/><Relationship Id="rId4" Type="http://schemas.openxmlformats.org/officeDocument/2006/relationships/image" Target="../media/image9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2.jpg"/><Relationship Id="rId7" Type="http://schemas.openxmlformats.org/officeDocument/2006/relationships/image" Target="../media/image16.emf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jpeg"/><Relationship Id="rId5" Type="http://schemas.openxmlformats.org/officeDocument/2006/relationships/image" Target="../media/image14.jpg"/><Relationship Id="rId10" Type="http://schemas.openxmlformats.org/officeDocument/2006/relationships/image" Target="../media/image19.jpeg"/><Relationship Id="rId4" Type="http://schemas.openxmlformats.org/officeDocument/2006/relationships/image" Target="../media/image13.jpg"/><Relationship Id="rId9" Type="http://schemas.openxmlformats.org/officeDocument/2006/relationships/image" Target="../media/image1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2.emf"/><Relationship Id="rId4" Type="http://schemas.openxmlformats.org/officeDocument/2006/relationships/image" Target="../media/image21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emf"/><Relationship Id="rId3" Type="http://schemas.openxmlformats.org/officeDocument/2006/relationships/image" Target="../media/image24.emf"/><Relationship Id="rId7" Type="http://schemas.openxmlformats.org/officeDocument/2006/relationships/image" Target="../media/image28.emf"/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emf"/><Relationship Id="rId5" Type="http://schemas.openxmlformats.org/officeDocument/2006/relationships/image" Target="../media/image26.emf"/><Relationship Id="rId4" Type="http://schemas.openxmlformats.org/officeDocument/2006/relationships/image" Target="../media/image25.emf"/><Relationship Id="rId9" Type="http://schemas.openxmlformats.org/officeDocument/2006/relationships/image" Target="../media/image30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emf"/><Relationship Id="rId2" Type="http://schemas.openxmlformats.org/officeDocument/2006/relationships/image" Target="../media/image3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4.emf"/><Relationship Id="rId4" Type="http://schemas.openxmlformats.org/officeDocument/2006/relationships/image" Target="../media/image33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emf"/><Relationship Id="rId7" Type="http://schemas.openxmlformats.org/officeDocument/2006/relationships/image" Target="../media/image40.png"/><Relationship Id="rId2" Type="http://schemas.openxmlformats.org/officeDocument/2006/relationships/image" Target="../media/image35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9.emf"/><Relationship Id="rId5" Type="http://schemas.openxmlformats.org/officeDocument/2006/relationships/image" Target="../media/image38.emf"/><Relationship Id="rId4" Type="http://schemas.openxmlformats.org/officeDocument/2006/relationships/image" Target="../media/image37.em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emf"/><Relationship Id="rId3" Type="http://schemas.openxmlformats.org/officeDocument/2006/relationships/image" Target="../media/image42.jpeg"/><Relationship Id="rId7" Type="http://schemas.openxmlformats.org/officeDocument/2006/relationships/image" Target="../media/image46.png"/><Relationship Id="rId2" Type="http://schemas.openxmlformats.org/officeDocument/2006/relationships/image" Target="../media/image4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5.emf"/><Relationship Id="rId5" Type="http://schemas.openxmlformats.org/officeDocument/2006/relationships/image" Target="../media/image44.emf"/><Relationship Id="rId4" Type="http://schemas.openxmlformats.org/officeDocument/2006/relationships/image" Target="../media/image43.emf"/><Relationship Id="rId9" Type="http://schemas.openxmlformats.org/officeDocument/2006/relationships/image" Target="../media/image4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26">
            <a:extLst>
              <a:ext uri="{FF2B5EF4-FFF2-40B4-BE49-F238E27FC236}">
                <a16:creationId xmlns:a16="http://schemas.microsoft.com/office/drawing/2014/main" id="{1176891C-508E-7132-3B49-9FF70EF97643}"/>
              </a:ext>
            </a:extLst>
          </p:cNvPr>
          <p:cNvGrpSpPr/>
          <p:nvPr/>
        </p:nvGrpSpPr>
        <p:grpSpPr>
          <a:xfrm>
            <a:off x="749300" y="2584450"/>
            <a:ext cx="5562600" cy="1494443"/>
            <a:chOff x="749300" y="2584450"/>
            <a:chExt cx="5562600" cy="1494443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4EFD7E8C-B430-93B4-F523-4BF5B14F2A8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7278" t="26742" r="14046" b="14034"/>
            <a:stretch/>
          </p:blipFill>
          <p:spPr>
            <a:xfrm>
              <a:off x="749300" y="2584450"/>
              <a:ext cx="4487718" cy="1494443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BC052E28-6B9E-E87F-67FD-07BBD6334DB8}"/>
                </a:ext>
              </a:extLst>
            </p:cNvPr>
            <p:cNvSpPr txBox="1"/>
            <p:nvPr/>
          </p:nvSpPr>
          <p:spPr>
            <a:xfrm>
              <a:off x="5473700" y="2965450"/>
              <a:ext cx="838200" cy="381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p-MET</a:t>
              </a:r>
            </a:p>
          </p:txBody>
        </p:sp>
        <p:sp>
          <p:nvSpPr>
            <p:cNvPr id="12" name="Rectangle: Rounded Corners 11">
              <a:extLst>
                <a:ext uri="{FF2B5EF4-FFF2-40B4-BE49-F238E27FC236}">
                  <a16:creationId xmlns:a16="http://schemas.microsoft.com/office/drawing/2014/main" id="{AD6452E2-C69E-4878-DE4D-05AC90B7AEB5}"/>
                </a:ext>
              </a:extLst>
            </p:cNvPr>
            <p:cNvSpPr/>
            <p:nvPr/>
          </p:nvSpPr>
          <p:spPr>
            <a:xfrm>
              <a:off x="1861671" y="2965450"/>
              <a:ext cx="1828800" cy="381000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9E086076-D92B-91DC-B8E1-969BCC67124B}"/>
              </a:ext>
            </a:extLst>
          </p:cNvPr>
          <p:cNvGrpSpPr/>
          <p:nvPr/>
        </p:nvGrpSpPr>
        <p:grpSpPr>
          <a:xfrm>
            <a:off x="749300" y="5556250"/>
            <a:ext cx="5562600" cy="1433012"/>
            <a:chOff x="901700" y="5708650"/>
            <a:chExt cx="5562600" cy="1433012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B254126A-2C2C-6F57-474A-A182487FCB4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9214" t="9609" r="20306"/>
            <a:stretch/>
          </p:blipFill>
          <p:spPr>
            <a:xfrm>
              <a:off x="901700" y="5708650"/>
              <a:ext cx="4640118" cy="1433012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8C888856-DFA8-ABBF-9309-94E478328078}"/>
                </a:ext>
              </a:extLst>
            </p:cNvPr>
            <p:cNvSpPr txBox="1"/>
            <p:nvPr/>
          </p:nvSpPr>
          <p:spPr>
            <a:xfrm>
              <a:off x="5626100" y="6165850"/>
              <a:ext cx="838200" cy="381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Actin</a:t>
              </a:r>
            </a:p>
          </p:txBody>
        </p:sp>
        <p:sp>
          <p:nvSpPr>
            <p:cNvPr id="14" name="Rectangle: Rounded Corners 13">
              <a:extLst>
                <a:ext uri="{FF2B5EF4-FFF2-40B4-BE49-F238E27FC236}">
                  <a16:creationId xmlns:a16="http://schemas.microsoft.com/office/drawing/2014/main" id="{FA593DFC-9765-4005-FCDB-94EB93AAC9FE}"/>
                </a:ext>
              </a:extLst>
            </p:cNvPr>
            <p:cNvSpPr/>
            <p:nvPr/>
          </p:nvSpPr>
          <p:spPr>
            <a:xfrm>
              <a:off x="1928906" y="6318250"/>
              <a:ext cx="1876612" cy="381000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683C4018-BBDF-98CB-CEF1-92766218350E}"/>
              </a:ext>
            </a:extLst>
          </p:cNvPr>
          <p:cNvCxnSpPr/>
          <p:nvPr/>
        </p:nvCxnSpPr>
        <p:spPr>
          <a:xfrm>
            <a:off x="1802653" y="2460188"/>
            <a:ext cx="914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698A0A2A-5320-1D7A-3648-1FEA491A014E}"/>
              </a:ext>
            </a:extLst>
          </p:cNvPr>
          <p:cNvCxnSpPr/>
          <p:nvPr/>
        </p:nvCxnSpPr>
        <p:spPr>
          <a:xfrm>
            <a:off x="2806700" y="2460187"/>
            <a:ext cx="8229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DA274BA8-7926-0521-D37D-51FB0B7E1C26}"/>
              </a:ext>
            </a:extLst>
          </p:cNvPr>
          <p:cNvSpPr txBox="1"/>
          <p:nvPr/>
        </p:nvSpPr>
        <p:spPr>
          <a:xfrm>
            <a:off x="1816100" y="1670050"/>
            <a:ext cx="23717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UW-21 Lung PDXs 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FE554BFE-91AF-6234-0C29-18C4CF9D8124}"/>
              </a:ext>
            </a:extLst>
          </p:cNvPr>
          <p:cNvCxnSpPr/>
          <p:nvPr/>
        </p:nvCxnSpPr>
        <p:spPr>
          <a:xfrm>
            <a:off x="1511300" y="2051050"/>
            <a:ext cx="256032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9AEC2FDD-4234-F2A9-1117-A160B1A1930B}"/>
              </a:ext>
            </a:extLst>
          </p:cNvPr>
          <p:cNvSpPr txBox="1"/>
          <p:nvPr/>
        </p:nvSpPr>
        <p:spPr>
          <a:xfrm>
            <a:off x="1282700" y="2051050"/>
            <a:ext cx="31856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       Wild type   Cap resistant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D539217-E0AF-0E01-B4E6-16F5B57BEA3E}"/>
              </a:ext>
            </a:extLst>
          </p:cNvPr>
          <p:cNvSpPr txBox="1"/>
          <p:nvPr/>
        </p:nvSpPr>
        <p:spPr>
          <a:xfrm>
            <a:off x="0" y="22627"/>
            <a:ext cx="43994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Western blot full image related to Figure 1 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A68FC39-C4BF-2233-CB39-2F8C77358467}"/>
              </a:ext>
            </a:extLst>
          </p:cNvPr>
          <p:cNvSpPr txBox="1"/>
          <p:nvPr/>
        </p:nvSpPr>
        <p:spPr>
          <a:xfrm>
            <a:off x="53790" y="527050"/>
            <a:ext cx="3754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.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A5610D19-030B-CDB5-FAFD-93E4D14F0989}"/>
              </a:ext>
            </a:extLst>
          </p:cNvPr>
          <p:cNvGrpSpPr/>
          <p:nvPr/>
        </p:nvGrpSpPr>
        <p:grpSpPr>
          <a:xfrm>
            <a:off x="748145" y="4209245"/>
            <a:ext cx="5335155" cy="1322409"/>
            <a:chOff x="748145" y="4209245"/>
            <a:chExt cx="5335155" cy="1322409"/>
          </a:xfrm>
        </p:grpSpPr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C3EAA5B2-10B8-8188-5841-632239315057}"/>
                </a:ext>
              </a:extLst>
            </p:cNvPr>
            <p:cNvGrpSpPr/>
            <p:nvPr/>
          </p:nvGrpSpPr>
          <p:grpSpPr>
            <a:xfrm>
              <a:off x="748145" y="4209245"/>
              <a:ext cx="4419600" cy="1322409"/>
              <a:chOff x="748145" y="4209245"/>
              <a:chExt cx="4419600" cy="1322409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3D84F7C0-1DA9-029D-F4D8-18F02B97085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10053" r="30562"/>
              <a:stretch/>
            </p:blipFill>
            <p:spPr>
              <a:xfrm>
                <a:off x="748145" y="4209245"/>
                <a:ext cx="4419600" cy="1322409"/>
              </a:xfrm>
              <a:prstGeom prst="rect">
                <a:avLst/>
              </a:prstGeom>
            </p:spPr>
          </p:pic>
          <p:sp>
            <p:nvSpPr>
              <p:cNvPr id="13" name="Rectangle: Rounded Corners 12">
                <a:extLst>
                  <a:ext uri="{FF2B5EF4-FFF2-40B4-BE49-F238E27FC236}">
                    <a16:creationId xmlns:a16="http://schemas.microsoft.com/office/drawing/2014/main" id="{FC92F670-9080-0DBC-D7F1-CC6140B2C6FE}"/>
                  </a:ext>
                </a:extLst>
              </p:cNvPr>
              <p:cNvSpPr/>
              <p:nvPr/>
            </p:nvSpPr>
            <p:spPr>
              <a:xfrm>
                <a:off x="1435100" y="4451724"/>
                <a:ext cx="1828800" cy="381000"/>
              </a:xfrm>
              <a:prstGeom prst="roundRect">
                <a:avLst/>
              </a:prstGeom>
              <a:noFill/>
              <a:ln w="285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D8A1365D-EB1F-DF53-6F48-7E1338E79985}"/>
                </a:ext>
              </a:extLst>
            </p:cNvPr>
            <p:cNvSpPr txBox="1"/>
            <p:nvPr/>
          </p:nvSpPr>
          <p:spPr>
            <a:xfrm>
              <a:off x="5092700" y="4413250"/>
              <a:ext cx="990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TWIST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9760494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258B83FE-3982-4220-0126-16CED7781B6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4043" r="27155" b="37140"/>
          <a:stretch/>
        </p:blipFill>
        <p:spPr>
          <a:xfrm>
            <a:off x="2722740" y="1698125"/>
            <a:ext cx="2684694" cy="1189804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6B69537-77CA-C72B-F3A3-B150186640E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472" r="32674"/>
          <a:stretch/>
        </p:blipFill>
        <p:spPr>
          <a:xfrm>
            <a:off x="2820967" y="5664533"/>
            <a:ext cx="2650958" cy="135385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458BB76A-849F-A8F1-E19C-769C4538EC3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6162" t="17804" r="7742" b="17626"/>
          <a:stretch/>
        </p:blipFill>
        <p:spPr>
          <a:xfrm>
            <a:off x="2730500" y="2965451"/>
            <a:ext cx="2677268" cy="160019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D8AD5F22-A9AC-77E3-D35F-E8AB8C6A3BB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2242" t="8715" r="8218" b="8021"/>
          <a:stretch/>
        </p:blipFill>
        <p:spPr>
          <a:xfrm>
            <a:off x="2806700" y="7080250"/>
            <a:ext cx="2647616" cy="1884214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B43B78FE-0F07-2D9A-E9E1-74818BDF4A17}"/>
              </a:ext>
            </a:extLst>
          </p:cNvPr>
          <p:cNvSpPr txBox="1"/>
          <p:nvPr/>
        </p:nvSpPr>
        <p:spPr>
          <a:xfrm>
            <a:off x="2273300" y="3879851"/>
            <a:ext cx="6274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p27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1188C26-25E8-F104-CC4A-310D3B13FDB6}"/>
              </a:ext>
            </a:extLst>
          </p:cNvPr>
          <p:cNvSpPr txBox="1"/>
          <p:nvPr/>
        </p:nvSpPr>
        <p:spPr>
          <a:xfrm>
            <a:off x="2867291" y="1088252"/>
            <a:ext cx="30315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  H1993 WT    </a:t>
            </a:r>
            <a:r>
              <a:rPr lang="en-US" sz="1600" b="1" dirty="0">
                <a:solidFill>
                  <a:srgbClr val="FF0000"/>
                </a:solidFill>
              </a:rPr>
              <a:t>H1993 CR500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8268FE9D-311D-B2C4-D52A-8BC747CB6606}"/>
              </a:ext>
            </a:extLst>
          </p:cNvPr>
          <p:cNvCxnSpPr>
            <a:cxnSpLocks/>
          </p:cNvCxnSpPr>
          <p:nvPr/>
        </p:nvCxnSpPr>
        <p:spPr>
          <a:xfrm>
            <a:off x="2983496" y="1441451"/>
            <a:ext cx="914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2FF9B7CE-E9F8-A119-9385-81709C06D87D}"/>
              </a:ext>
            </a:extLst>
          </p:cNvPr>
          <p:cNvCxnSpPr>
            <a:cxnSpLocks/>
          </p:cNvCxnSpPr>
          <p:nvPr/>
        </p:nvCxnSpPr>
        <p:spPr>
          <a:xfrm>
            <a:off x="4025900" y="1441451"/>
            <a:ext cx="914400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1B8446E1-2CE9-D057-3477-0CCEA8352363}"/>
              </a:ext>
            </a:extLst>
          </p:cNvPr>
          <p:cNvSpPr txBox="1"/>
          <p:nvPr/>
        </p:nvSpPr>
        <p:spPr>
          <a:xfrm>
            <a:off x="1647655" y="1413379"/>
            <a:ext cx="48768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    Cap (</a:t>
            </a:r>
            <a:r>
              <a:rPr lang="en-US" sz="1600" b="1" dirty="0" err="1"/>
              <a:t>nM</a:t>
            </a:r>
            <a:r>
              <a:rPr lang="en-US" sz="1600" b="1" dirty="0"/>
              <a:t>)      0     50  100  0    50   10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A8AE191-F125-F6C1-A55B-2789C615E959}"/>
              </a:ext>
            </a:extLst>
          </p:cNvPr>
          <p:cNvSpPr txBox="1"/>
          <p:nvPr/>
        </p:nvSpPr>
        <p:spPr>
          <a:xfrm>
            <a:off x="2120900" y="3346451"/>
            <a:ext cx="7039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Actin</a:t>
            </a:r>
          </a:p>
        </p:txBody>
      </p:sp>
      <p:sp>
        <p:nvSpPr>
          <p:cNvPr id="25" name="Rectangle: Rounded Corners 24">
            <a:extLst>
              <a:ext uri="{FF2B5EF4-FFF2-40B4-BE49-F238E27FC236}">
                <a16:creationId xmlns:a16="http://schemas.microsoft.com/office/drawing/2014/main" id="{1D17C279-0C83-19C9-A049-E939810CD48D}"/>
              </a:ext>
            </a:extLst>
          </p:cNvPr>
          <p:cNvSpPr/>
          <p:nvPr/>
        </p:nvSpPr>
        <p:spPr>
          <a:xfrm>
            <a:off x="2730500" y="2203451"/>
            <a:ext cx="2286000" cy="609600"/>
          </a:xfrm>
          <a:prstGeom prst="round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 b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2CDCFE3-6081-1557-56E5-306DA8E30EDA}"/>
              </a:ext>
            </a:extLst>
          </p:cNvPr>
          <p:cNvSpPr txBox="1"/>
          <p:nvPr/>
        </p:nvSpPr>
        <p:spPr>
          <a:xfrm>
            <a:off x="1950613" y="2355851"/>
            <a:ext cx="8560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p-MET</a:t>
            </a:r>
          </a:p>
        </p:txBody>
      </p:sp>
      <p:sp>
        <p:nvSpPr>
          <p:cNvPr id="30" name="Rectangle: Rounded Corners 29">
            <a:extLst>
              <a:ext uri="{FF2B5EF4-FFF2-40B4-BE49-F238E27FC236}">
                <a16:creationId xmlns:a16="http://schemas.microsoft.com/office/drawing/2014/main" id="{8708EBF2-242D-C559-FA6F-44C3D5906293}"/>
              </a:ext>
            </a:extLst>
          </p:cNvPr>
          <p:cNvSpPr/>
          <p:nvPr/>
        </p:nvSpPr>
        <p:spPr>
          <a:xfrm>
            <a:off x="2806700" y="3218115"/>
            <a:ext cx="2209800" cy="609600"/>
          </a:xfrm>
          <a:prstGeom prst="round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 b="1" dirty="0"/>
          </a:p>
        </p:txBody>
      </p:sp>
      <p:sp>
        <p:nvSpPr>
          <p:cNvPr id="31" name="Rectangle: Rounded Corners 30">
            <a:extLst>
              <a:ext uri="{FF2B5EF4-FFF2-40B4-BE49-F238E27FC236}">
                <a16:creationId xmlns:a16="http://schemas.microsoft.com/office/drawing/2014/main" id="{37160273-4205-8339-AD79-1986D499369F}"/>
              </a:ext>
            </a:extLst>
          </p:cNvPr>
          <p:cNvSpPr/>
          <p:nvPr/>
        </p:nvSpPr>
        <p:spPr>
          <a:xfrm>
            <a:off x="2882900" y="3879851"/>
            <a:ext cx="2133600" cy="609600"/>
          </a:xfrm>
          <a:prstGeom prst="round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 b="1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C21E9D1-B717-F618-715B-0449C2116755}"/>
              </a:ext>
            </a:extLst>
          </p:cNvPr>
          <p:cNvSpPr txBox="1"/>
          <p:nvPr/>
        </p:nvSpPr>
        <p:spPr>
          <a:xfrm>
            <a:off x="2959536" y="5046914"/>
            <a:ext cx="30315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  H1993 WT    </a:t>
            </a:r>
            <a:r>
              <a:rPr lang="en-US" sz="1600" b="1" dirty="0">
                <a:solidFill>
                  <a:srgbClr val="FF0000"/>
                </a:solidFill>
              </a:rPr>
              <a:t>H1993 CR500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FE2E978C-6D70-6D37-1012-B395018DEE0A}"/>
              </a:ext>
            </a:extLst>
          </p:cNvPr>
          <p:cNvCxnSpPr>
            <a:cxnSpLocks/>
          </p:cNvCxnSpPr>
          <p:nvPr/>
        </p:nvCxnSpPr>
        <p:spPr>
          <a:xfrm>
            <a:off x="3075741" y="5400113"/>
            <a:ext cx="914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10CD94F6-8B2B-35E0-C758-FFF31327EE04}"/>
              </a:ext>
            </a:extLst>
          </p:cNvPr>
          <p:cNvCxnSpPr>
            <a:cxnSpLocks/>
          </p:cNvCxnSpPr>
          <p:nvPr/>
        </p:nvCxnSpPr>
        <p:spPr>
          <a:xfrm>
            <a:off x="4118145" y="5400113"/>
            <a:ext cx="914400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69379C97-F549-0F5C-0A5A-0BFD4A664B0A}"/>
              </a:ext>
            </a:extLst>
          </p:cNvPr>
          <p:cNvSpPr txBox="1"/>
          <p:nvPr/>
        </p:nvSpPr>
        <p:spPr>
          <a:xfrm>
            <a:off x="1739900" y="5372041"/>
            <a:ext cx="48768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    </a:t>
            </a:r>
            <a:r>
              <a:rPr lang="en-US" sz="1600" b="1" dirty="0" err="1"/>
              <a:t>Criz</a:t>
            </a:r>
            <a:r>
              <a:rPr lang="en-US" sz="1600" b="1" dirty="0"/>
              <a:t> (</a:t>
            </a:r>
            <a:r>
              <a:rPr lang="en-US" sz="1600" b="1" dirty="0" err="1"/>
              <a:t>nM</a:t>
            </a:r>
            <a:r>
              <a:rPr lang="en-US" sz="1600" b="1" dirty="0"/>
              <a:t>)      0     50  100   0    50  100</a:t>
            </a:r>
          </a:p>
        </p:txBody>
      </p:sp>
      <p:sp>
        <p:nvSpPr>
          <p:cNvPr id="36" name="Rectangle: Rounded Corners 35">
            <a:extLst>
              <a:ext uri="{FF2B5EF4-FFF2-40B4-BE49-F238E27FC236}">
                <a16:creationId xmlns:a16="http://schemas.microsoft.com/office/drawing/2014/main" id="{9634F1AD-3286-44DD-8970-4AB6E3334911}"/>
              </a:ext>
            </a:extLst>
          </p:cNvPr>
          <p:cNvSpPr/>
          <p:nvPr/>
        </p:nvSpPr>
        <p:spPr>
          <a:xfrm>
            <a:off x="2882900" y="6354346"/>
            <a:ext cx="2286000" cy="609600"/>
          </a:xfrm>
          <a:prstGeom prst="round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 b="1" dirty="0"/>
          </a:p>
        </p:txBody>
      </p:sp>
      <p:sp>
        <p:nvSpPr>
          <p:cNvPr id="37" name="Rectangle: Rounded Corners 36">
            <a:extLst>
              <a:ext uri="{FF2B5EF4-FFF2-40B4-BE49-F238E27FC236}">
                <a16:creationId xmlns:a16="http://schemas.microsoft.com/office/drawing/2014/main" id="{F3196A90-E74C-80A7-5C18-757AAED9C71D}"/>
              </a:ext>
            </a:extLst>
          </p:cNvPr>
          <p:cNvSpPr/>
          <p:nvPr/>
        </p:nvSpPr>
        <p:spPr>
          <a:xfrm>
            <a:off x="2846804" y="7461250"/>
            <a:ext cx="2286000" cy="609600"/>
          </a:xfrm>
          <a:prstGeom prst="round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 b="1" dirty="0"/>
          </a:p>
        </p:txBody>
      </p:sp>
      <p:sp>
        <p:nvSpPr>
          <p:cNvPr id="38" name="Rectangle: Rounded Corners 37">
            <a:extLst>
              <a:ext uri="{FF2B5EF4-FFF2-40B4-BE49-F238E27FC236}">
                <a16:creationId xmlns:a16="http://schemas.microsoft.com/office/drawing/2014/main" id="{28BEDEE4-5368-AE31-8FF9-8C0A599CC254}"/>
              </a:ext>
            </a:extLst>
          </p:cNvPr>
          <p:cNvSpPr/>
          <p:nvPr/>
        </p:nvSpPr>
        <p:spPr>
          <a:xfrm>
            <a:off x="2894932" y="8159082"/>
            <a:ext cx="2286000" cy="609600"/>
          </a:xfrm>
          <a:prstGeom prst="round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 b="1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60C7BC6-09A2-0D9B-B70B-C73DCCC7FD64}"/>
              </a:ext>
            </a:extLst>
          </p:cNvPr>
          <p:cNvSpPr txBox="1"/>
          <p:nvPr/>
        </p:nvSpPr>
        <p:spPr>
          <a:xfrm>
            <a:off x="2313404" y="8299450"/>
            <a:ext cx="6274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p27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9C7911AD-059F-10E8-2C1B-06C6EED880D0}"/>
              </a:ext>
            </a:extLst>
          </p:cNvPr>
          <p:cNvSpPr txBox="1"/>
          <p:nvPr/>
        </p:nvSpPr>
        <p:spPr>
          <a:xfrm>
            <a:off x="2237204" y="7641722"/>
            <a:ext cx="7039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Actin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BE9F969E-B3F1-DA9D-6F4C-66553A15EDE6}"/>
              </a:ext>
            </a:extLst>
          </p:cNvPr>
          <p:cNvSpPr txBox="1"/>
          <p:nvPr/>
        </p:nvSpPr>
        <p:spPr>
          <a:xfrm>
            <a:off x="2066917" y="6498451"/>
            <a:ext cx="8560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p-MET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BEB1B798-C4F3-CD1C-B18F-1892BDC146E0}"/>
              </a:ext>
            </a:extLst>
          </p:cNvPr>
          <p:cNvSpPr txBox="1"/>
          <p:nvPr/>
        </p:nvSpPr>
        <p:spPr>
          <a:xfrm>
            <a:off x="78023" y="22627"/>
            <a:ext cx="43288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Western blot full image related to Figure 6 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028309D-BC92-B5F5-1C87-2AA00FA8EC8D}"/>
              </a:ext>
            </a:extLst>
          </p:cNvPr>
          <p:cNvSpPr txBox="1"/>
          <p:nvPr/>
        </p:nvSpPr>
        <p:spPr>
          <a:xfrm>
            <a:off x="749300" y="984250"/>
            <a:ext cx="9885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E.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34EE8081-33F7-7F90-A494-144F697DB3E8}"/>
              </a:ext>
            </a:extLst>
          </p:cNvPr>
          <p:cNvSpPr txBox="1"/>
          <p:nvPr/>
        </p:nvSpPr>
        <p:spPr>
          <a:xfrm>
            <a:off x="749300" y="5065296"/>
            <a:ext cx="9885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F.</a:t>
            </a:r>
          </a:p>
        </p:txBody>
      </p:sp>
    </p:spTree>
    <p:extLst>
      <p:ext uri="{BB962C8B-B14F-4D97-AF65-F5344CB8AC3E}">
        <p14:creationId xmlns:p14="http://schemas.microsoft.com/office/powerpoint/2010/main" val="86239559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2" name="Group 81">
            <a:extLst>
              <a:ext uri="{FF2B5EF4-FFF2-40B4-BE49-F238E27FC236}">
                <a16:creationId xmlns:a16="http://schemas.microsoft.com/office/drawing/2014/main" id="{059C05DB-C9CD-58B1-5AA6-5C22D4B5E8B3}"/>
              </a:ext>
            </a:extLst>
          </p:cNvPr>
          <p:cNvGrpSpPr/>
          <p:nvPr/>
        </p:nvGrpSpPr>
        <p:grpSpPr>
          <a:xfrm>
            <a:off x="475175" y="561301"/>
            <a:ext cx="5608125" cy="3318549"/>
            <a:chOff x="1015361" y="333706"/>
            <a:chExt cx="5608125" cy="3318549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411C825B-C897-D719-A7AC-9C645A76B8B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5703" t="12330" r="10308" b="12630"/>
            <a:stretch/>
          </p:blipFill>
          <p:spPr>
            <a:xfrm>
              <a:off x="2558870" y="2121562"/>
              <a:ext cx="2653437" cy="733677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EAB60DCA-3BA5-D97E-59F1-AFC79D0DB2B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0523" t="19131" r="13076" b="12738"/>
            <a:stretch/>
          </p:blipFill>
          <p:spPr>
            <a:xfrm>
              <a:off x="2559908" y="2910858"/>
              <a:ext cx="2657895" cy="741397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F7588099-A934-83CB-6846-F5F64401900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2391" r="-1"/>
            <a:stretch/>
          </p:blipFill>
          <p:spPr>
            <a:xfrm>
              <a:off x="2548360" y="1367231"/>
              <a:ext cx="2680757" cy="692446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5F98B726-5A42-AED0-373E-C1D85BA585A6}"/>
                </a:ext>
              </a:extLst>
            </p:cNvPr>
            <p:cNvSpPr txBox="1"/>
            <p:nvPr/>
          </p:nvSpPr>
          <p:spPr>
            <a:xfrm>
              <a:off x="2036740" y="2271982"/>
              <a:ext cx="58853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p27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17056D23-064E-1999-C007-ABDDB45E7B10}"/>
                </a:ext>
              </a:extLst>
            </p:cNvPr>
            <p:cNvSpPr txBox="1"/>
            <p:nvPr/>
          </p:nvSpPr>
          <p:spPr>
            <a:xfrm>
              <a:off x="1870692" y="3096534"/>
              <a:ext cx="66022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Actin</a:t>
              </a:r>
            </a:p>
          </p:txBody>
        </p: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8DF017F7-5C05-DAB2-3D1D-0631901CCA2D}"/>
                </a:ext>
              </a:extLst>
            </p:cNvPr>
            <p:cNvCxnSpPr>
              <a:cxnSpLocks/>
            </p:cNvCxnSpPr>
            <p:nvPr/>
          </p:nvCxnSpPr>
          <p:spPr>
            <a:xfrm>
              <a:off x="2725057" y="1013526"/>
              <a:ext cx="741739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77A4A686-AD1A-D200-9903-08B78CB77898}"/>
                </a:ext>
              </a:extLst>
            </p:cNvPr>
            <p:cNvSpPr txBox="1"/>
            <p:nvPr/>
          </p:nvSpPr>
          <p:spPr>
            <a:xfrm>
              <a:off x="1677348" y="1607498"/>
              <a:ext cx="99239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cl-PARP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3BCF434-9F77-BFB1-FB7F-719B88E36435}"/>
                </a:ext>
              </a:extLst>
            </p:cNvPr>
            <p:cNvSpPr txBox="1"/>
            <p:nvPr/>
          </p:nvSpPr>
          <p:spPr>
            <a:xfrm>
              <a:off x="2793052" y="679450"/>
              <a:ext cx="383043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err="1"/>
                <a:t>Scr</a:t>
              </a:r>
              <a:r>
                <a:rPr lang="en-US" sz="1600" b="1" dirty="0"/>
                <a:t>       </a:t>
              </a:r>
              <a:r>
                <a:rPr lang="en-US" sz="1600" b="1" dirty="0" err="1"/>
                <a:t>sh</a:t>
              </a:r>
              <a:r>
                <a:rPr lang="en-US" sz="1600" b="1" dirty="0"/>
                <a:t> TWIST1-2  </a:t>
              </a:r>
              <a:r>
                <a:rPr lang="en-US" sz="1600" b="1" dirty="0" err="1"/>
                <a:t>sh</a:t>
              </a:r>
              <a:r>
                <a:rPr lang="en-US" sz="1600" b="1" dirty="0"/>
                <a:t> TWIST1-1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5E1D8C1-8479-E32E-9EBE-B61F61AA13D2}"/>
                </a:ext>
              </a:extLst>
            </p:cNvPr>
            <p:cNvSpPr txBox="1"/>
            <p:nvPr/>
          </p:nvSpPr>
          <p:spPr>
            <a:xfrm>
              <a:off x="1015361" y="1003018"/>
              <a:ext cx="426499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Capmatinib (µM)      0    1    5   0   1   5   0    1    5</a:t>
              </a:r>
            </a:p>
          </p:txBody>
        </p: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5AAB5AB6-8A8D-A531-A20C-D7A7556E3204}"/>
                </a:ext>
              </a:extLst>
            </p:cNvPr>
            <p:cNvCxnSpPr>
              <a:cxnSpLocks/>
            </p:cNvCxnSpPr>
            <p:nvPr/>
          </p:nvCxnSpPr>
          <p:spPr>
            <a:xfrm>
              <a:off x="3583520" y="999878"/>
              <a:ext cx="667564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511B59D3-A680-AE0D-A731-7C556D16AD54}"/>
                </a:ext>
              </a:extLst>
            </p:cNvPr>
            <p:cNvCxnSpPr>
              <a:cxnSpLocks/>
            </p:cNvCxnSpPr>
            <p:nvPr/>
          </p:nvCxnSpPr>
          <p:spPr>
            <a:xfrm>
              <a:off x="4406900" y="991918"/>
              <a:ext cx="667564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Rectangle: Rounded Corners 20">
              <a:extLst>
                <a:ext uri="{FF2B5EF4-FFF2-40B4-BE49-F238E27FC236}">
                  <a16:creationId xmlns:a16="http://schemas.microsoft.com/office/drawing/2014/main" id="{3B7696FE-9D9C-73F0-17E4-0ADB01CBD778}"/>
                </a:ext>
              </a:extLst>
            </p:cNvPr>
            <p:cNvSpPr/>
            <p:nvPr/>
          </p:nvSpPr>
          <p:spPr>
            <a:xfrm>
              <a:off x="2525392" y="3139459"/>
              <a:ext cx="2719707" cy="287510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  <p:sp>
          <p:nvSpPr>
            <p:cNvPr id="22" name="Rectangle: Rounded Corners 21">
              <a:extLst>
                <a:ext uri="{FF2B5EF4-FFF2-40B4-BE49-F238E27FC236}">
                  <a16:creationId xmlns:a16="http://schemas.microsoft.com/office/drawing/2014/main" id="{CA5B3FDE-C04C-71BC-2653-F3BB9688EF37}"/>
                </a:ext>
              </a:extLst>
            </p:cNvPr>
            <p:cNvSpPr/>
            <p:nvPr/>
          </p:nvSpPr>
          <p:spPr>
            <a:xfrm>
              <a:off x="2525392" y="2336515"/>
              <a:ext cx="2719707" cy="287510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  <p:sp>
          <p:nvSpPr>
            <p:cNvPr id="23" name="Rectangle: Rounded Corners 22">
              <a:extLst>
                <a:ext uri="{FF2B5EF4-FFF2-40B4-BE49-F238E27FC236}">
                  <a16:creationId xmlns:a16="http://schemas.microsoft.com/office/drawing/2014/main" id="{D7276D83-9E44-5234-13CC-DDFCEFF16AAA}"/>
                </a:ext>
              </a:extLst>
            </p:cNvPr>
            <p:cNvSpPr/>
            <p:nvPr/>
          </p:nvSpPr>
          <p:spPr>
            <a:xfrm>
              <a:off x="2525392" y="1621146"/>
              <a:ext cx="2719707" cy="287510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79FF08F4-482D-E38B-162F-8CCB35D54461}"/>
                </a:ext>
              </a:extLst>
            </p:cNvPr>
            <p:cNvCxnSpPr>
              <a:cxnSpLocks/>
            </p:cNvCxnSpPr>
            <p:nvPr/>
          </p:nvCxnSpPr>
          <p:spPr>
            <a:xfrm>
              <a:off x="2654300" y="679450"/>
              <a:ext cx="24477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8E6D78D3-51B5-C8A0-1C46-FAB8D2B4C652}"/>
                </a:ext>
              </a:extLst>
            </p:cNvPr>
            <p:cNvSpPr txBox="1"/>
            <p:nvPr/>
          </p:nvSpPr>
          <p:spPr>
            <a:xfrm>
              <a:off x="3492500" y="333706"/>
              <a:ext cx="80354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H596</a:t>
              </a:r>
            </a:p>
          </p:txBody>
        </p:sp>
      </p:grpSp>
      <p:grpSp>
        <p:nvGrpSpPr>
          <p:cNvPr id="83" name="Group 82">
            <a:extLst>
              <a:ext uri="{FF2B5EF4-FFF2-40B4-BE49-F238E27FC236}">
                <a16:creationId xmlns:a16="http://schemas.microsoft.com/office/drawing/2014/main" id="{CC01ADD8-13C6-4D59-0F2B-229F3061FB4F}"/>
              </a:ext>
            </a:extLst>
          </p:cNvPr>
          <p:cNvGrpSpPr/>
          <p:nvPr/>
        </p:nvGrpSpPr>
        <p:grpSpPr>
          <a:xfrm>
            <a:off x="139700" y="4718050"/>
            <a:ext cx="5184240" cy="3244592"/>
            <a:chOff x="899060" y="4718050"/>
            <a:chExt cx="5184240" cy="3244592"/>
          </a:xfrm>
        </p:grpSpPr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31613420-B9A4-231A-8A4B-D94CC5D4146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8365" t="16576" r="13368" b="7261"/>
            <a:stretch/>
          </p:blipFill>
          <p:spPr>
            <a:xfrm>
              <a:off x="2425700" y="5861050"/>
              <a:ext cx="2618781" cy="2101592"/>
            </a:xfrm>
            <a:prstGeom prst="rect">
              <a:avLst/>
            </a:prstGeom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1F66D1CD-9F75-4A67-A33A-47E4D0ED4242}"/>
                </a:ext>
              </a:extLst>
            </p:cNvPr>
            <p:cNvSpPr txBox="1"/>
            <p:nvPr/>
          </p:nvSpPr>
          <p:spPr>
            <a:xfrm>
              <a:off x="1892300" y="7336146"/>
              <a:ext cx="58853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p27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0887728D-8556-6046-11FF-59CAD3BEDF9A}"/>
                </a:ext>
              </a:extLst>
            </p:cNvPr>
            <p:cNvSpPr txBox="1"/>
            <p:nvPr/>
          </p:nvSpPr>
          <p:spPr>
            <a:xfrm>
              <a:off x="1761508" y="6851650"/>
              <a:ext cx="66022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Actin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578DFA40-05C3-9D38-6D1D-48AC97518F36}"/>
                </a:ext>
              </a:extLst>
            </p:cNvPr>
            <p:cNvSpPr txBox="1"/>
            <p:nvPr/>
          </p:nvSpPr>
          <p:spPr>
            <a:xfrm>
              <a:off x="1622756" y="6193146"/>
              <a:ext cx="118421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cl-PARP</a:t>
              </a:r>
            </a:p>
          </p:txBody>
        </p: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96269E67-E081-302B-8560-BF0606DF6CBE}"/>
                </a:ext>
              </a:extLst>
            </p:cNvPr>
            <p:cNvCxnSpPr>
              <a:cxnSpLocks/>
            </p:cNvCxnSpPr>
            <p:nvPr/>
          </p:nvCxnSpPr>
          <p:spPr>
            <a:xfrm>
              <a:off x="2627929" y="5523834"/>
              <a:ext cx="54864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80656886-32F0-96AF-EA9E-3710C5BB4DED}"/>
                </a:ext>
              </a:extLst>
            </p:cNvPr>
            <p:cNvSpPr txBox="1"/>
            <p:nvPr/>
          </p:nvSpPr>
          <p:spPr>
            <a:xfrm>
              <a:off x="2449580" y="5140854"/>
              <a:ext cx="363372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  </a:t>
              </a:r>
              <a:r>
                <a:rPr lang="en-US" sz="1600" b="1" dirty="0" err="1"/>
                <a:t>Scr</a:t>
              </a:r>
              <a:r>
                <a:rPr lang="en-US" sz="1600" b="1" dirty="0"/>
                <a:t>       </a:t>
              </a:r>
              <a:r>
                <a:rPr lang="en-US" sz="1600" b="1" dirty="0" err="1"/>
                <a:t>sh</a:t>
              </a:r>
              <a:r>
                <a:rPr lang="en-US" sz="1600" b="1" dirty="0"/>
                <a:t> TWIST1-2   </a:t>
              </a:r>
              <a:r>
                <a:rPr lang="en-US" sz="1600" b="1" dirty="0" err="1"/>
                <a:t>sh</a:t>
              </a:r>
              <a:r>
                <a:rPr lang="en-US" sz="1600" b="1" dirty="0"/>
                <a:t> TWIST1-1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2943CED5-2316-2E97-C762-BBE2BE72F2B5}"/>
                </a:ext>
              </a:extLst>
            </p:cNvPr>
            <p:cNvSpPr txBox="1"/>
            <p:nvPr/>
          </p:nvSpPr>
          <p:spPr>
            <a:xfrm>
              <a:off x="899060" y="5540622"/>
              <a:ext cx="464173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Capmatinib (µM)     0   1    5   0   1    5   0   1    5</a:t>
              </a:r>
            </a:p>
          </p:txBody>
        </p: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EFE9921A-D691-E6A1-8510-FDC4091FD01F}"/>
                </a:ext>
              </a:extLst>
            </p:cNvPr>
            <p:cNvCxnSpPr>
              <a:cxnSpLocks/>
            </p:cNvCxnSpPr>
            <p:nvPr/>
          </p:nvCxnSpPr>
          <p:spPr>
            <a:xfrm>
              <a:off x="3408340" y="5510186"/>
              <a:ext cx="593391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1B8F4C9E-6DAD-6BB2-0D52-BA0EB26EDC00}"/>
                </a:ext>
              </a:extLst>
            </p:cNvPr>
            <p:cNvCxnSpPr>
              <a:cxnSpLocks/>
            </p:cNvCxnSpPr>
            <p:nvPr/>
          </p:nvCxnSpPr>
          <p:spPr>
            <a:xfrm>
              <a:off x="4231792" y="5502226"/>
              <a:ext cx="667564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D44CB3E4-225D-FE7C-D781-5FD5D416F47D}"/>
                </a:ext>
              </a:extLst>
            </p:cNvPr>
            <p:cNvCxnSpPr>
              <a:cxnSpLocks/>
            </p:cNvCxnSpPr>
            <p:nvPr/>
          </p:nvCxnSpPr>
          <p:spPr>
            <a:xfrm>
              <a:off x="2538284" y="5099050"/>
              <a:ext cx="24477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6ADC91E2-4956-95E0-0320-8D6CE203DDBB}"/>
                </a:ext>
              </a:extLst>
            </p:cNvPr>
            <p:cNvSpPr txBox="1"/>
            <p:nvPr/>
          </p:nvSpPr>
          <p:spPr>
            <a:xfrm>
              <a:off x="3492500" y="4718050"/>
              <a:ext cx="80354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H1648</a:t>
              </a:r>
            </a:p>
          </p:txBody>
        </p:sp>
        <p:sp>
          <p:nvSpPr>
            <p:cNvPr id="40" name="Rectangle: Rounded Corners 39">
              <a:extLst>
                <a:ext uri="{FF2B5EF4-FFF2-40B4-BE49-F238E27FC236}">
                  <a16:creationId xmlns:a16="http://schemas.microsoft.com/office/drawing/2014/main" id="{A112A49A-E17F-3202-125C-613B56FEB4A6}"/>
                </a:ext>
              </a:extLst>
            </p:cNvPr>
            <p:cNvSpPr/>
            <p:nvPr/>
          </p:nvSpPr>
          <p:spPr>
            <a:xfrm>
              <a:off x="2486434" y="7385050"/>
              <a:ext cx="2410649" cy="287510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  <p:sp>
          <p:nvSpPr>
            <p:cNvPr id="41" name="Rectangle: Rounded Corners 40">
              <a:extLst>
                <a:ext uri="{FF2B5EF4-FFF2-40B4-BE49-F238E27FC236}">
                  <a16:creationId xmlns:a16="http://schemas.microsoft.com/office/drawing/2014/main" id="{E28368FB-C790-63FA-FC39-97EBF6F0614C}"/>
                </a:ext>
              </a:extLst>
            </p:cNvPr>
            <p:cNvSpPr/>
            <p:nvPr/>
          </p:nvSpPr>
          <p:spPr>
            <a:xfrm>
              <a:off x="2508042" y="6892594"/>
              <a:ext cx="2410649" cy="287510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  <p:sp>
          <p:nvSpPr>
            <p:cNvPr id="42" name="Rectangle: Rounded Corners 41">
              <a:extLst>
                <a:ext uri="{FF2B5EF4-FFF2-40B4-BE49-F238E27FC236}">
                  <a16:creationId xmlns:a16="http://schemas.microsoft.com/office/drawing/2014/main" id="{FE4C2059-3D43-D1E4-FABA-B377898489A2}"/>
                </a:ext>
              </a:extLst>
            </p:cNvPr>
            <p:cNvSpPr/>
            <p:nvPr/>
          </p:nvSpPr>
          <p:spPr>
            <a:xfrm>
              <a:off x="2529650" y="6232044"/>
              <a:ext cx="2410649" cy="287510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AAE1FA69-3576-CF10-27A3-42FC37A61688}"/>
              </a:ext>
            </a:extLst>
          </p:cNvPr>
          <p:cNvSpPr txBox="1"/>
          <p:nvPr/>
        </p:nvSpPr>
        <p:spPr>
          <a:xfrm>
            <a:off x="0" y="0"/>
            <a:ext cx="43288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Western blot full image related to Figure 7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BAB09F6-73EF-40AB-A4ED-FBDAE3A29A84}"/>
              </a:ext>
            </a:extLst>
          </p:cNvPr>
          <p:cNvSpPr txBox="1"/>
          <p:nvPr/>
        </p:nvSpPr>
        <p:spPr>
          <a:xfrm>
            <a:off x="63500" y="298450"/>
            <a:ext cx="3914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H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1FCE51D-0161-4083-0A65-2A43E64B7EAD}"/>
              </a:ext>
            </a:extLst>
          </p:cNvPr>
          <p:cNvSpPr txBox="1"/>
          <p:nvPr/>
        </p:nvSpPr>
        <p:spPr>
          <a:xfrm>
            <a:off x="63500" y="4489450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I.</a:t>
            </a:r>
          </a:p>
        </p:txBody>
      </p:sp>
    </p:spTree>
    <p:extLst>
      <p:ext uri="{BB962C8B-B14F-4D97-AF65-F5344CB8AC3E}">
        <p14:creationId xmlns:p14="http://schemas.microsoft.com/office/powerpoint/2010/main" val="271713825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0" name="Group 79">
            <a:extLst>
              <a:ext uri="{FF2B5EF4-FFF2-40B4-BE49-F238E27FC236}">
                <a16:creationId xmlns:a16="http://schemas.microsoft.com/office/drawing/2014/main" id="{FA9ABAF1-9E65-E0FB-8CEF-34CB4D6010F4}"/>
              </a:ext>
            </a:extLst>
          </p:cNvPr>
          <p:cNvGrpSpPr/>
          <p:nvPr/>
        </p:nvGrpSpPr>
        <p:grpSpPr>
          <a:xfrm>
            <a:off x="180388" y="510389"/>
            <a:ext cx="5293312" cy="2487145"/>
            <a:chOff x="20282" y="276843"/>
            <a:chExt cx="5293312" cy="2487145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33BD9879-DDDD-AED8-3DED-BE9389448AB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9434" t="48731" r="14943" b="35870"/>
            <a:stretch/>
          </p:blipFill>
          <p:spPr>
            <a:xfrm>
              <a:off x="1574753" y="1814491"/>
              <a:ext cx="3025820" cy="429375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54DA45D4-4F89-44B2-B5FA-254748486A3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7682" t="32610" r="11657" b="50181"/>
            <a:stretch/>
          </p:blipFill>
          <p:spPr>
            <a:xfrm>
              <a:off x="1579794" y="2314906"/>
              <a:ext cx="3049038" cy="449082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1F9CE798-AE80-A91F-E926-15077A570A7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423" t="26602" r="6423" b="39103"/>
            <a:stretch/>
          </p:blipFill>
          <p:spPr>
            <a:xfrm>
              <a:off x="1580674" y="1343643"/>
              <a:ext cx="3053090" cy="405311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4E1B31B-0768-D815-3636-CAA5DFF18EF5}"/>
                </a:ext>
              </a:extLst>
            </p:cNvPr>
            <p:cNvSpPr txBox="1"/>
            <p:nvPr/>
          </p:nvSpPr>
          <p:spPr>
            <a:xfrm>
              <a:off x="1046394" y="1890690"/>
              <a:ext cx="59612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p27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B95D7A92-ABBC-CB49-A65C-7543A3394320}"/>
                </a:ext>
              </a:extLst>
            </p:cNvPr>
            <p:cNvSpPr txBox="1"/>
            <p:nvPr/>
          </p:nvSpPr>
          <p:spPr>
            <a:xfrm>
              <a:off x="970194" y="2322866"/>
              <a:ext cx="66873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Actin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8DC8BAA-554F-2FEF-F0A4-4E4512BD1AD2}"/>
                </a:ext>
              </a:extLst>
            </p:cNvPr>
            <p:cNvSpPr txBox="1"/>
            <p:nvPr/>
          </p:nvSpPr>
          <p:spPr>
            <a:xfrm>
              <a:off x="796186" y="1370939"/>
              <a:ext cx="117070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cl-PARP</a:t>
              </a:r>
            </a:p>
          </p:txBody>
        </p: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36AEE693-365C-A2B0-B93C-1D6E9B71D2B9}"/>
                </a:ext>
              </a:extLst>
            </p:cNvPr>
            <p:cNvCxnSpPr>
              <a:cxnSpLocks/>
            </p:cNvCxnSpPr>
            <p:nvPr/>
          </p:nvCxnSpPr>
          <p:spPr>
            <a:xfrm>
              <a:off x="1707638" y="1040823"/>
              <a:ext cx="7513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90B020E-48C5-90A1-DA9A-6A7774EA0415}"/>
                </a:ext>
              </a:extLst>
            </p:cNvPr>
            <p:cNvSpPr txBox="1"/>
            <p:nvPr/>
          </p:nvSpPr>
          <p:spPr>
            <a:xfrm>
              <a:off x="1503594" y="641923"/>
              <a:ext cx="3810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       </a:t>
              </a:r>
              <a:r>
                <a:rPr lang="en-US" sz="1600" b="1" dirty="0" err="1"/>
                <a:t>Scr</a:t>
              </a:r>
              <a:r>
                <a:rPr lang="en-US" sz="1600" b="1" dirty="0"/>
                <a:t>         </a:t>
              </a:r>
              <a:r>
                <a:rPr lang="en-US" sz="1600" b="1" dirty="0" err="1"/>
                <a:t>sh</a:t>
              </a:r>
              <a:r>
                <a:rPr lang="en-US" sz="1600" b="1" dirty="0"/>
                <a:t> TWIST1-2   </a:t>
              </a:r>
              <a:r>
                <a:rPr lang="en-US" sz="1600" b="1" dirty="0" err="1"/>
                <a:t>sh</a:t>
              </a:r>
              <a:r>
                <a:rPr lang="en-US" sz="1600" b="1" dirty="0"/>
                <a:t> TWIST1-1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73387DE-73F6-D7DA-FE8D-FD4981DBDEAF}"/>
                </a:ext>
              </a:extLst>
            </p:cNvPr>
            <p:cNvSpPr txBox="1"/>
            <p:nvPr/>
          </p:nvSpPr>
          <p:spPr>
            <a:xfrm>
              <a:off x="20282" y="1066139"/>
              <a:ext cx="528193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Capmatinib (µM)     0      1   5     0     1     5    0     1      5</a:t>
              </a:r>
            </a:p>
          </p:txBody>
        </p: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6DE2DC25-A0EB-8B93-C924-E57433FEA195}"/>
                </a:ext>
              </a:extLst>
            </p:cNvPr>
            <p:cNvCxnSpPr>
              <a:cxnSpLocks/>
            </p:cNvCxnSpPr>
            <p:nvPr/>
          </p:nvCxnSpPr>
          <p:spPr>
            <a:xfrm>
              <a:off x="2785946" y="1027175"/>
              <a:ext cx="60104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94F5A3B9-C37F-D47F-EC8E-68066F973712}"/>
                </a:ext>
              </a:extLst>
            </p:cNvPr>
            <p:cNvCxnSpPr>
              <a:cxnSpLocks/>
            </p:cNvCxnSpPr>
            <p:nvPr/>
          </p:nvCxnSpPr>
          <p:spPr>
            <a:xfrm>
              <a:off x="3744632" y="1019215"/>
              <a:ext cx="67617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B78AC35E-70CA-C241-DF93-64D60EA45559}"/>
                </a:ext>
              </a:extLst>
            </p:cNvPr>
            <p:cNvCxnSpPr>
              <a:cxnSpLocks/>
            </p:cNvCxnSpPr>
            <p:nvPr/>
          </p:nvCxnSpPr>
          <p:spPr>
            <a:xfrm>
              <a:off x="1733638" y="657843"/>
              <a:ext cx="270468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11085032-8930-57D4-D262-FBB7BE1E72F8}"/>
                </a:ext>
              </a:extLst>
            </p:cNvPr>
            <p:cNvSpPr txBox="1"/>
            <p:nvPr/>
          </p:nvSpPr>
          <p:spPr>
            <a:xfrm>
              <a:off x="2875194" y="276843"/>
              <a:ext cx="81390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H1437</a:t>
              </a:r>
            </a:p>
          </p:txBody>
        </p:sp>
        <p:sp>
          <p:nvSpPr>
            <p:cNvPr id="16" name="Rectangle: Rounded Corners 15">
              <a:extLst>
                <a:ext uri="{FF2B5EF4-FFF2-40B4-BE49-F238E27FC236}">
                  <a16:creationId xmlns:a16="http://schemas.microsoft.com/office/drawing/2014/main" id="{133BE120-B6A6-91CB-57B1-08EDC326CDA8}"/>
                </a:ext>
              </a:extLst>
            </p:cNvPr>
            <p:cNvSpPr/>
            <p:nvPr/>
          </p:nvSpPr>
          <p:spPr>
            <a:xfrm>
              <a:off x="1574792" y="2355850"/>
              <a:ext cx="3025992" cy="300998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  <p:sp>
          <p:nvSpPr>
            <p:cNvPr id="17" name="Rectangle: Rounded Corners 16">
              <a:extLst>
                <a:ext uri="{FF2B5EF4-FFF2-40B4-BE49-F238E27FC236}">
                  <a16:creationId xmlns:a16="http://schemas.microsoft.com/office/drawing/2014/main" id="{DE646D07-2FA1-7834-B20B-4AC8B6F13B6C}"/>
                </a:ext>
              </a:extLst>
            </p:cNvPr>
            <p:cNvSpPr/>
            <p:nvPr/>
          </p:nvSpPr>
          <p:spPr>
            <a:xfrm>
              <a:off x="1570278" y="1890690"/>
              <a:ext cx="3005199" cy="300998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  <p:sp>
          <p:nvSpPr>
            <p:cNvPr id="18" name="Rectangle: Rounded Corners 17">
              <a:extLst>
                <a:ext uri="{FF2B5EF4-FFF2-40B4-BE49-F238E27FC236}">
                  <a16:creationId xmlns:a16="http://schemas.microsoft.com/office/drawing/2014/main" id="{C1795E18-8FE8-9609-ED1E-F3A87B9E05C8}"/>
                </a:ext>
              </a:extLst>
            </p:cNvPr>
            <p:cNvSpPr/>
            <p:nvPr/>
          </p:nvSpPr>
          <p:spPr>
            <a:xfrm>
              <a:off x="1583870" y="1384587"/>
              <a:ext cx="3067808" cy="300998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3F373588-3A1B-DD47-08CE-7272F63CA8A7}"/>
              </a:ext>
            </a:extLst>
          </p:cNvPr>
          <p:cNvSpPr txBox="1"/>
          <p:nvPr/>
        </p:nvSpPr>
        <p:spPr>
          <a:xfrm>
            <a:off x="63500" y="0"/>
            <a:ext cx="57281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Western blot full image related to Supplementary Figure 6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8F360F6-B474-FAF4-A52C-8AD515507DE1}"/>
              </a:ext>
            </a:extLst>
          </p:cNvPr>
          <p:cNvSpPr txBox="1"/>
          <p:nvPr/>
        </p:nvSpPr>
        <p:spPr>
          <a:xfrm>
            <a:off x="83552" y="298450"/>
            <a:ext cx="3930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G.</a:t>
            </a:r>
          </a:p>
        </p:txBody>
      </p:sp>
    </p:spTree>
    <p:extLst>
      <p:ext uri="{BB962C8B-B14F-4D97-AF65-F5344CB8AC3E}">
        <p14:creationId xmlns:p14="http://schemas.microsoft.com/office/powerpoint/2010/main" val="7528026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93B1793-0837-4BA3-F82C-0556BA77DCE9}"/>
              </a:ext>
            </a:extLst>
          </p:cNvPr>
          <p:cNvSpPr txBox="1"/>
          <p:nvPr/>
        </p:nvSpPr>
        <p:spPr>
          <a:xfrm>
            <a:off x="749300" y="6242050"/>
            <a:ext cx="421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Western blot full image related to Figure 1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1AEF7DC7-AE66-2E15-5E63-272A84738904}"/>
              </a:ext>
            </a:extLst>
          </p:cNvPr>
          <p:cNvGrpSpPr/>
          <p:nvPr/>
        </p:nvGrpSpPr>
        <p:grpSpPr>
          <a:xfrm>
            <a:off x="1653456" y="7004050"/>
            <a:ext cx="2743200" cy="2514600"/>
            <a:chOff x="749300" y="984250"/>
            <a:chExt cx="3505200" cy="3160426"/>
          </a:xfrm>
        </p:grpSpPr>
        <p:pic>
          <p:nvPicPr>
            <p:cNvPr id="6" name="Picture 1" descr="page1image51249984">
              <a:extLst>
                <a:ext uri="{FF2B5EF4-FFF2-40B4-BE49-F238E27FC236}">
                  <a16:creationId xmlns:a16="http://schemas.microsoft.com/office/drawing/2014/main" id="{9867B0F2-19C2-B84B-C3E9-3ABCF545DA33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407" t="6798" r="11494" b="51271"/>
            <a:stretch/>
          </p:blipFill>
          <p:spPr bwMode="auto">
            <a:xfrm>
              <a:off x="749300" y="984250"/>
              <a:ext cx="3505200" cy="316042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" name="Rectangle: Rounded Corners 11">
              <a:extLst>
                <a:ext uri="{FF2B5EF4-FFF2-40B4-BE49-F238E27FC236}">
                  <a16:creationId xmlns:a16="http://schemas.microsoft.com/office/drawing/2014/main" id="{D3D1E62B-D48D-24DA-1B7E-BA8DDD0E4E09}"/>
                </a:ext>
              </a:extLst>
            </p:cNvPr>
            <p:cNvSpPr/>
            <p:nvPr/>
          </p:nvSpPr>
          <p:spPr>
            <a:xfrm>
              <a:off x="1130300" y="2340728"/>
              <a:ext cx="1295400" cy="208612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" name="Rectangle: Rounded Corners 11">
              <a:extLst>
                <a:ext uri="{FF2B5EF4-FFF2-40B4-BE49-F238E27FC236}">
                  <a16:creationId xmlns:a16="http://schemas.microsoft.com/office/drawing/2014/main" id="{57BA895A-A5FA-0375-4C90-294A326759B1}"/>
                </a:ext>
              </a:extLst>
            </p:cNvPr>
            <p:cNvSpPr/>
            <p:nvPr/>
          </p:nvSpPr>
          <p:spPr>
            <a:xfrm>
              <a:off x="1130300" y="2813050"/>
              <a:ext cx="1295400" cy="208613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" name="Rectangle: Rounded Corners 11">
              <a:extLst>
                <a:ext uri="{FF2B5EF4-FFF2-40B4-BE49-F238E27FC236}">
                  <a16:creationId xmlns:a16="http://schemas.microsoft.com/office/drawing/2014/main" id="{D8CD32FC-B2C3-51F3-D9BD-F04E0B9CBF2D}"/>
                </a:ext>
              </a:extLst>
            </p:cNvPr>
            <p:cNvSpPr/>
            <p:nvPr/>
          </p:nvSpPr>
          <p:spPr>
            <a:xfrm>
              <a:off x="1130300" y="3346450"/>
              <a:ext cx="1295400" cy="208613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188BB348-AFE5-0964-2251-D6E1EE58EB1E}"/>
              </a:ext>
            </a:extLst>
          </p:cNvPr>
          <p:cNvGrpSpPr/>
          <p:nvPr/>
        </p:nvGrpSpPr>
        <p:grpSpPr>
          <a:xfrm>
            <a:off x="673100" y="336552"/>
            <a:ext cx="4838701" cy="4533898"/>
            <a:chOff x="1301749" y="603250"/>
            <a:chExt cx="4838701" cy="4533898"/>
          </a:xfrm>
        </p:grpSpPr>
        <p:pic>
          <p:nvPicPr>
            <p:cNvPr id="12" name="Picture 11" descr="A picture containing text&#10;&#10;Description automatically generated">
              <a:extLst>
                <a:ext uri="{FF2B5EF4-FFF2-40B4-BE49-F238E27FC236}">
                  <a16:creationId xmlns:a16="http://schemas.microsoft.com/office/drawing/2014/main" id="{7415CC10-4185-3B28-3CBD-B2A8C723DE3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437" t="58210" r="37958" b="6528"/>
            <a:stretch/>
          </p:blipFill>
          <p:spPr>
            <a:xfrm rot="16200000">
              <a:off x="2860870" y="2939857"/>
              <a:ext cx="828674" cy="3565907"/>
            </a:xfrm>
            <a:prstGeom prst="rect">
              <a:avLst/>
            </a:prstGeom>
          </p:spPr>
        </p:pic>
        <p:pic>
          <p:nvPicPr>
            <p:cNvPr id="13" name="Picture 12" descr="A picture containing text&#10;&#10;Description automatically generated">
              <a:extLst>
                <a:ext uri="{FF2B5EF4-FFF2-40B4-BE49-F238E27FC236}">
                  <a16:creationId xmlns:a16="http://schemas.microsoft.com/office/drawing/2014/main" id="{4012748C-C7C0-518E-1F92-6B24240DB94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791" t="14069" r="62941" b="52916"/>
            <a:stretch/>
          </p:blipFill>
          <p:spPr>
            <a:xfrm rot="16200000">
              <a:off x="3320616" y="336986"/>
              <a:ext cx="904873" cy="4675900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B7EC3118-3429-B21C-1C17-CAA44BBFEF4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1143" t="19777" r="3035" b="19227"/>
            <a:stretch/>
          </p:blipFill>
          <p:spPr>
            <a:xfrm>
              <a:off x="1301749" y="3194050"/>
              <a:ext cx="4838701" cy="1057275"/>
            </a:xfrm>
            <a:prstGeom prst="rect">
              <a:avLst/>
            </a:prstGeom>
          </p:spPr>
        </p:pic>
        <p:sp>
          <p:nvSpPr>
            <p:cNvPr id="15" name="Rectangle: Rounded Corners 14">
              <a:extLst>
                <a:ext uri="{FF2B5EF4-FFF2-40B4-BE49-F238E27FC236}">
                  <a16:creationId xmlns:a16="http://schemas.microsoft.com/office/drawing/2014/main" id="{7DF983BC-2263-920A-D4AE-0203747320E7}"/>
                </a:ext>
              </a:extLst>
            </p:cNvPr>
            <p:cNvSpPr/>
            <p:nvPr/>
          </p:nvSpPr>
          <p:spPr>
            <a:xfrm>
              <a:off x="1425575" y="2479675"/>
              <a:ext cx="2800350" cy="438150"/>
            </a:xfrm>
            <a:prstGeom prst="round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: Rounded Corners 15">
              <a:extLst>
                <a:ext uri="{FF2B5EF4-FFF2-40B4-BE49-F238E27FC236}">
                  <a16:creationId xmlns:a16="http://schemas.microsoft.com/office/drawing/2014/main" id="{B442FBD3-6207-8CAE-CF71-A140985037E6}"/>
                </a:ext>
              </a:extLst>
            </p:cNvPr>
            <p:cNvSpPr/>
            <p:nvPr/>
          </p:nvSpPr>
          <p:spPr>
            <a:xfrm>
              <a:off x="1825625" y="3632200"/>
              <a:ext cx="2028825" cy="295275"/>
            </a:xfrm>
            <a:prstGeom prst="round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tangle: Rounded Corners 16">
              <a:extLst>
                <a:ext uri="{FF2B5EF4-FFF2-40B4-BE49-F238E27FC236}">
                  <a16:creationId xmlns:a16="http://schemas.microsoft.com/office/drawing/2014/main" id="{D5B0F616-AF20-475E-0707-8683E74F9DE7}"/>
                </a:ext>
              </a:extLst>
            </p:cNvPr>
            <p:cNvSpPr/>
            <p:nvPr/>
          </p:nvSpPr>
          <p:spPr>
            <a:xfrm>
              <a:off x="1749425" y="4537075"/>
              <a:ext cx="2247900" cy="295275"/>
            </a:xfrm>
            <a:prstGeom prst="round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FC25F32E-9968-1AC4-15E3-30012F399049}"/>
                </a:ext>
              </a:extLst>
            </p:cNvPr>
            <p:cNvSpPr txBox="1"/>
            <p:nvPr/>
          </p:nvSpPr>
          <p:spPr>
            <a:xfrm rot="16200000">
              <a:off x="1220836" y="1644406"/>
              <a:ext cx="8579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M 04-14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F8A048CA-962C-5446-7CAD-4E592BFABCFF}"/>
                </a:ext>
              </a:extLst>
            </p:cNvPr>
            <p:cNvSpPr txBox="1"/>
            <p:nvPr/>
          </p:nvSpPr>
          <p:spPr>
            <a:xfrm rot="16200000">
              <a:off x="1469590" y="1644405"/>
              <a:ext cx="8579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M 12-15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C0DADCD5-E4BD-E066-9976-862D57688A89}"/>
                </a:ext>
              </a:extLst>
            </p:cNvPr>
            <p:cNvSpPr txBox="1"/>
            <p:nvPr/>
          </p:nvSpPr>
          <p:spPr>
            <a:xfrm rot="16200000">
              <a:off x="1794304" y="1699708"/>
              <a:ext cx="7473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SK-29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C60A8D9D-ACA5-9A0F-CE4F-8BA0172C3DB2}"/>
                </a:ext>
              </a:extLst>
            </p:cNvPr>
            <p:cNvSpPr txBox="1"/>
            <p:nvPr/>
          </p:nvSpPr>
          <p:spPr>
            <a:xfrm rot="16200000">
              <a:off x="2011728" y="1645492"/>
              <a:ext cx="8579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M 18-17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C23FC534-4C8F-72B9-C0BE-6175933D2558}"/>
                </a:ext>
              </a:extLst>
            </p:cNvPr>
            <p:cNvSpPr txBox="1"/>
            <p:nvPr/>
          </p:nvSpPr>
          <p:spPr>
            <a:xfrm rot="16200000">
              <a:off x="2298449" y="1644405"/>
              <a:ext cx="8579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M 15-16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AF0029B3-5F71-FBFB-3DA2-3D8D58955FF0}"/>
                </a:ext>
              </a:extLst>
            </p:cNvPr>
            <p:cNvSpPr txBox="1"/>
            <p:nvPr/>
          </p:nvSpPr>
          <p:spPr>
            <a:xfrm rot="16200000">
              <a:off x="2559303" y="1644404"/>
              <a:ext cx="8579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M 16-16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E3F3F016-47E8-6C3B-6621-A2F63C840670}"/>
                </a:ext>
              </a:extLst>
            </p:cNvPr>
            <p:cNvSpPr txBox="1"/>
            <p:nvPr/>
          </p:nvSpPr>
          <p:spPr>
            <a:xfrm rot="16200000">
              <a:off x="2840587" y="1644403"/>
              <a:ext cx="8579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M 20-17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741A86F7-1B8C-273D-6FDF-7C06C3E0AEC3}"/>
                </a:ext>
              </a:extLst>
            </p:cNvPr>
            <p:cNvSpPr txBox="1"/>
            <p:nvPr/>
          </p:nvSpPr>
          <p:spPr>
            <a:xfrm rot="16200000">
              <a:off x="3115395" y="1644402"/>
              <a:ext cx="8494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M 11-15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89C36D76-374D-17DF-AE85-E7DB957D05D9}"/>
                </a:ext>
              </a:extLst>
            </p:cNvPr>
            <p:cNvSpPr txBox="1"/>
            <p:nvPr/>
          </p:nvSpPr>
          <p:spPr>
            <a:xfrm rot="16200000">
              <a:off x="3381747" y="1644833"/>
              <a:ext cx="8579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accent6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M 08-15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FF43A4F0-3B48-E108-7176-25D5F49BADC9}"/>
                </a:ext>
              </a:extLst>
            </p:cNvPr>
            <p:cNvSpPr txBox="1"/>
            <p:nvPr/>
          </p:nvSpPr>
          <p:spPr>
            <a:xfrm rot="16200000">
              <a:off x="3649016" y="1640170"/>
              <a:ext cx="8579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accent5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M 07-15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55326871-80DE-0C81-57B6-5306965B809F}"/>
                </a:ext>
              </a:extLst>
            </p:cNvPr>
            <p:cNvSpPr txBox="1"/>
            <p:nvPr/>
          </p:nvSpPr>
          <p:spPr>
            <a:xfrm rot="16200000">
              <a:off x="1487231" y="896119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i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-</a:t>
              </a:r>
              <a:r>
                <a:rPr lang="en-US" sz="1200" b="1" i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as</a:t>
              </a:r>
              <a:endParaRPr lang="en-US" sz="1200" b="1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A9A7513B-1AAD-77D7-E832-C0DEF3A8DE1B}"/>
                </a:ext>
              </a:extLst>
            </p:cNvPr>
            <p:cNvSpPr txBox="1"/>
            <p:nvPr/>
          </p:nvSpPr>
          <p:spPr>
            <a:xfrm rot="16200000">
              <a:off x="2731095" y="944289"/>
              <a:ext cx="5164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DC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0EBEDA5E-8F9C-9731-ED46-A509CED4E12D}"/>
                </a:ext>
              </a:extLst>
            </p:cNvPr>
            <p:cNvSpPr txBox="1"/>
            <p:nvPr/>
          </p:nvSpPr>
          <p:spPr>
            <a:xfrm rot="16200000">
              <a:off x="3273051" y="970601"/>
              <a:ext cx="50847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C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D12591B8-F797-791F-734F-22049C8B6572}"/>
                </a:ext>
              </a:extLst>
            </p:cNvPr>
            <p:cNvSpPr txBox="1"/>
            <p:nvPr/>
          </p:nvSpPr>
          <p:spPr>
            <a:xfrm rot="16200000">
              <a:off x="3504280" y="917534"/>
              <a:ext cx="6030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accent6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NEC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C68DB2C7-C839-C495-DDF6-388A9919B1ED}"/>
                </a:ext>
              </a:extLst>
            </p:cNvPr>
            <p:cNvSpPr txBox="1"/>
            <p:nvPr/>
          </p:nvSpPr>
          <p:spPr>
            <a:xfrm rot="16200000">
              <a:off x="3713738" y="839212"/>
              <a:ext cx="7489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accent5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NDIFF</a:t>
              </a:r>
            </a:p>
          </p:txBody>
        </p:sp>
        <p:sp>
          <p:nvSpPr>
            <p:cNvPr id="33" name="Left Brace 32">
              <a:extLst>
                <a:ext uri="{FF2B5EF4-FFF2-40B4-BE49-F238E27FC236}">
                  <a16:creationId xmlns:a16="http://schemas.microsoft.com/office/drawing/2014/main" id="{8FA46FA5-4B0E-2538-F7B7-51ED504BD48C}"/>
                </a:ext>
              </a:extLst>
            </p:cNvPr>
            <p:cNvSpPr/>
            <p:nvPr/>
          </p:nvSpPr>
          <p:spPr>
            <a:xfrm rot="5400000">
              <a:off x="1733156" y="1256370"/>
              <a:ext cx="91762" cy="267343"/>
            </a:xfrm>
            <a:prstGeom prst="leftBrac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n>
                  <a:solidFill>
                    <a:schemeClr val="tx1"/>
                  </a:solidFill>
                </a:ln>
                <a:solidFill>
                  <a:srgbClr val="FF0000"/>
                </a:solidFill>
              </a:endParaRPr>
            </a:p>
          </p:txBody>
        </p:sp>
        <p:sp>
          <p:nvSpPr>
            <p:cNvPr id="34" name="Left Brace 33">
              <a:extLst>
                <a:ext uri="{FF2B5EF4-FFF2-40B4-BE49-F238E27FC236}">
                  <a16:creationId xmlns:a16="http://schemas.microsoft.com/office/drawing/2014/main" id="{5394A1D1-2822-537A-E3E5-3C01E3C91510}"/>
                </a:ext>
              </a:extLst>
            </p:cNvPr>
            <p:cNvSpPr/>
            <p:nvPr/>
          </p:nvSpPr>
          <p:spPr>
            <a:xfrm rot="5400000">
              <a:off x="2949859" y="1094775"/>
              <a:ext cx="85443" cy="577962"/>
            </a:xfrm>
            <a:prstGeom prst="leftBrace">
              <a:avLst/>
            </a:prstGeom>
            <a:ln w="1905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n>
                  <a:solidFill>
                    <a:schemeClr val="tx1"/>
                  </a:solidFill>
                </a:ln>
                <a:solidFill>
                  <a:srgbClr val="00B050"/>
                </a:solidFill>
              </a:endParaRPr>
            </a:p>
          </p:txBody>
        </p:sp>
        <p:sp>
          <p:nvSpPr>
            <p:cNvPr id="35" name="Left Brace 34">
              <a:extLst>
                <a:ext uri="{FF2B5EF4-FFF2-40B4-BE49-F238E27FC236}">
                  <a16:creationId xmlns:a16="http://schemas.microsoft.com/office/drawing/2014/main" id="{34EF6727-B143-F11C-DC7E-307DD1839628}"/>
                </a:ext>
              </a:extLst>
            </p:cNvPr>
            <p:cNvSpPr/>
            <p:nvPr/>
          </p:nvSpPr>
          <p:spPr>
            <a:xfrm rot="5400000">
              <a:off x="2238849" y="1197144"/>
              <a:ext cx="91762" cy="365760"/>
            </a:xfrm>
            <a:prstGeom prst="leftBrace">
              <a:avLst/>
            </a:prstGeom>
            <a:ln w="1905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n>
                  <a:solidFill>
                    <a:schemeClr val="tx1"/>
                  </a:solidFill>
                </a:ln>
                <a:solidFill>
                  <a:srgbClr val="0000FF"/>
                </a:solidFill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EDEA6E5B-B276-1998-5E18-96B55456F7E1}"/>
                </a:ext>
              </a:extLst>
            </p:cNvPr>
            <p:cNvSpPr txBox="1"/>
            <p:nvPr/>
          </p:nvSpPr>
          <p:spPr>
            <a:xfrm rot="16200000">
              <a:off x="1940475" y="918296"/>
              <a:ext cx="6126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GFR</a:t>
              </a:r>
            </a:p>
          </p:txBody>
        </p:sp>
        <p:sp>
          <p:nvSpPr>
            <p:cNvPr id="37" name="Left Brace 36">
              <a:extLst>
                <a:ext uri="{FF2B5EF4-FFF2-40B4-BE49-F238E27FC236}">
                  <a16:creationId xmlns:a16="http://schemas.microsoft.com/office/drawing/2014/main" id="{E7402B54-7B9F-36CE-BD1E-3C990FADAA3A}"/>
                </a:ext>
              </a:extLst>
            </p:cNvPr>
            <p:cNvSpPr/>
            <p:nvPr/>
          </p:nvSpPr>
          <p:spPr>
            <a:xfrm rot="5400000">
              <a:off x="3465347" y="1246353"/>
              <a:ext cx="91762" cy="267343"/>
            </a:xfrm>
            <a:prstGeom prst="leftBrac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n>
                  <a:solidFill>
                    <a:schemeClr val="tx1"/>
                  </a:solidFill>
                </a:ln>
              </a:endParaRPr>
            </a:p>
          </p:txBody>
        </p:sp>
        <p:sp>
          <p:nvSpPr>
            <p:cNvPr id="38" name="Left Brace 37">
              <a:extLst>
                <a:ext uri="{FF2B5EF4-FFF2-40B4-BE49-F238E27FC236}">
                  <a16:creationId xmlns:a16="http://schemas.microsoft.com/office/drawing/2014/main" id="{F62CC860-EAAC-0102-F396-C81EAC37F45A}"/>
                </a:ext>
              </a:extLst>
            </p:cNvPr>
            <p:cNvSpPr/>
            <p:nvPr/>
          </p:nvSpPr>
          <p:spPr>
            <a:xfrm rot="5400000">
              <a:off x="3812218" y="1229370"/>
              <a:ext cx="45720" cy="267343"/>
            </a:xfrm>
            <a:prstGeom prst="leftBrace">
              <a:avLst/>
            </a:prstGeom>
            <a:ln w="1905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n>
                  <a:solidFill>
                    <a:schemeClr val="tx1"/>
                  </a:solidFill>
                </a:ln>
                <a:solidFill>
                  <a:schemeClr val="accent6">
                    <a:lumMod val="75000"/>
                  </a:schemeClr>
                </a:solidFill>
              </a:endParaRPr>
            </a:p>
          </p:txBody>
        </p:sp>
        <p:sp>
          <p:nvSpPr>
            <p:cNvPr id="39" name="Left Brace 38">
              <a:extLst>
                <a:ext uri="{FF2B5EF4-FFF2-40B4-BE49-F238E27FC236}">
                  <a16:creationId xmlns:a16="http://schemas.microsoft.com/office/drawing/2014/main" id="{C1ED7CA2-A5C1-3DE0-3E4B-6F4390BF4991}"/>
                </a:ext>
              </a:extLst>
            </p:cNvPr>
            <p:cNvSpPr/>
            <p:nvPr/>
          </p:nvSpPr>
          <p:spPr>
            <a:xfrm rot="5400000">
              <a:off x="4113690" y="1236828"/>
              <a:ext cx="91762" cy="267343"/>
            </a:xfrm>
            <a:prstGeom prst="leftBrace">
              <a:avLst/>
            </a:prstGeom>
            <a:ln w="19050">
              <a:solidFill>
                <a:schemeClr val="accent5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n>
                  <a:solidFill>
                    <a:schemeClr val="tx1"/>
                  </a:solidFill>
                </a:ln>
              </a:endParaRPr>
            </a:p>
          </p:txBody>
        </p:sp>
      </p:grpSp>
      <p:sp>
        <p:nvSpPr>
          <p:cNvPr id="40" name="TextBox 39">
            <a:extLst>
              <a:ext uri="{FF2B5EF4-FFF2-40B4-BE49-F238E27FC236}">
                <a16:creationId xmlns:a16="http://schemas.microsoft.com/office/drawing/2014/main" id="{E6A834EB-79B1-BF03-1BE9-9D3A2EFF92F7}"/>
              </a:ext>
            </a:extLst>
          </p:cNvPr>
          <p:cNvSpPr txBox="1"/>
          <p:nvPr/>
        </p:nvSpPr>
        <p:spPr>
          <a:xfrm>
            <a:off x="215900" y="68071"/>
            <a:ext cx="57281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Western blot full image related to Supplementary Figure 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83FD5E39-A235-0B99-3F97-D276167E50B7}"/>
              </a:ext>
            </a:extLst>
          </p:cNvPr>
          <p:cNvSpPr txBox="1"/>
          <p:nvPr/>
        </p:nvSpPr>
        <p:spPr>
          <a:xfrm>
            <a:off x="39594" y="450850"/>
            <a:ext cx="48110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C.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89DF3ED-1BFF-F7EF-1F73-ECFE209A26FE}"/>
              </a:ext>
            </a:extLst>
          </p:cNvPr>
          <p:cNvSpPr txBox="1"/>
          <p:nvPr/>
        </p:nvSpPr>
        <p:spPr>
          <a:xfrm>
            <a:off x="520700" y="6775450"/>
            <a:ext cx="4572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D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222029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>
            <a:extLst>
              <a:ext uri="{FF2B5EF4-FFF2-40B4-BE49-F238E27FC236}">
                <a16:creationId xmlns:a16="http://schemas.microsoft.com/office/drawing/2014/main" id="{B1D95BFB-6AB2-A07E-4595-1FA29804B442}"/>
              </a:ext>
            </a:extLst>
          </p:cNvPr>
          <p:cNvGrpSpPr/>
          <p:nvPr/>
        </p:nvGrpSpPr>
        <p:grpSpPr>
          <a:xfrm>
            <a:off x="215900" y="755650"/>
            <a:ext cx="2971800" cy="2874136"/>
            <a:chOff x="148283" y="374650"/>
            <a:chExt cx="3268017" cy="3178936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376CA672-4E95-1E4B-8A6C-C7BD32266B0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48809" t="71019" r="44101" b="20392"/>
            <a:stretch/>
          </p:blipFill>
          <p:spPr>
            <a:xfrm>
              <a:off x="1576571" y="2410586"/>
              <a:ext cx="1677447" cy="1143000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86B9EE39-5309-1548-81A1-B3AC32DA713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53217" t="47508" r="39702" b="43261"/>
            <a:stretch/>
          </p:blipFill>
          <p:spPr>
            <a:xfrm>
              <a:off x="1559791" y="1136649"/>
              <a:ext cx="1700330" cy="1246909"/>
            </a:xfrm>
            <a:prstGeom prst="rect">
              <a:avLst/>
            </a:prstGeom>
          </p:spPr>
        </p:pic>
        <p:sp>
          <p:nvSpPr>
            <p:cNvPr id="5" name="Rectangle: Rounded Corners 20">
              <a:extLst>
                <a:ext uri="{FF2B5EF4-FFF2-40B4-BE49-F238E27FC236}">
                  <a16:creationId xmlns:a16="http://schemas.microsoft.com/office/drawing/2014/main" id="{BD7E35FE-B506-3242-AE21-E8172EC54312}"/>
                </a:ext>
              </a:extLst>
            </p:cNvPr>
            <p:cNvSpPr/>
            <p:nvPr/>
          </p:nvSpPr>
          <p:spPr>
            <a:xfrm>
              <a:off x="1559496" y="2562986"/>
              <a:ext cx="1704404" cy="304800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  <p:sp>
          <p:nvSpPr>
            <p:cNvPr id="6" name="Rectangle: Rounded Corners 20">
              <a:extLst>
                <a:ext uri="{FF2B5EF4-FFF2-40B4-BE49-F238E27FC236}">
                  <a16:creationId xmlns:a16="http://schemas.microsoft.com/office/drawing/2014/main" id="{3C48920D-4915-A345-84E4-BF79A62FB398}"/>
                </a:ext>
              </a:extLst>
            </p:cNvPr>
            <p:cNvSpPr/>
            <p:nvPr/>
          </p:nvSpPr>
          <p:spPr>
            <a:xfrm>
              <a:off x="1587500" y="1386724"/>
              <a:ext cx="1600200" cy="461483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53E14D5-0513-BB41-B8C3-327E2106CB4C}"/>
                </a:ext>
              </a:extLst>
            </p:cNvPr>
            <p:cNvSpPr txBox="1"/>
            <p:nvPr/>
          </p:nvSpPr>
          <p:spPr>
            <a:xfrm>
              <a:off x="673100" y="2558692"/>
              <a:ext cx="9144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TWIST1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33B0659-C21E-3A48-8169-69069B52AD51}"/>
                </a:ext>
              </a:extLst>
            </p:cNvPr>
            <p:cNvSpPr txBox="1"/>
            <p:nvPr/>
          </p:nvSpPr>
          <p:spPr>
            <a:xfrm>
              <a:off x="710663" y="1441450"/>
              <a:ext cx="9906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GAPDH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F1AEECAE-A1D3-CE40-81C7-6F52F3AA576F}"/>
                </a:ext>
              </a:extLst>
            </p:cNvPr>
            <p:cNvSpPr txBox="1"/>
            <p:nvPr/>
          </p:nvSpPr>
          <p:spPr>
            <a:xfrm>
              <a:off x="148283" y="828873"/>
              <a:ext cx="326801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Harmine (µM)   0    1     5    7.5</a:t>
              </a:r>
            </a:p>
          </p:txBody>
        </p: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6BB4AA93-37E6-104B-A801-5CAFDECE1118}"/>
                </a:ext>
              </a:extLst>
            </p:cNvPr>
            <p:cNvCxnSpPr/>
            <p:nvPr/>
          </p:nvCxnSpPr>
          <p:spPr>
            <a:xfrm>
              <a:off x="1633220" y="773075"/>
              <a:ext cx="155448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8305CE36-2129-C64F-A34A-C4E75B4AB41C}"/>
                </a:ext>
              </a:extLst>
            </p:cNvPr>
            <p:cNvSpPr txBox="1"/>
            <p:nvPr/>
          </p:nvSpPr>
          <p:spPr>
            <a:xfrm>
              <a:off x="1816100" y="374650"/>
              <a:ext cx="12954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FVBW-17</a:t>
              </a:r>
            </a:p>
          </p:txBody>
        </p:sp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id="{C7A57016-B285-E7A4-4309-57286A85EEF6}"/>
              </a:ext>
            </a:extLst>
          </p:cNvPr>
          <p:cNvSpPr txBox="1"/>
          <p:nvPr/>
        </p:nvSpPr>
        <p:spPr>
          <a:xfrm>
            <a:off x="0" y="22627"/>
            <a:ext cx="4346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Western blot full image related to Figure 2I </a:t>
            </a:r>
          </a:p>
        </p:txBody>
      </p:sp>
      <p:grpSp>
        <p:nvGrpSpPr>
          <p:cNvPr id="25" name="Group 24">
            <a:extLst>
              <a:ext uri="{FF2B5EF4-FFF2-40B4-BE49-F238E27FC236}">
                <a16:creationId xmlns:a16="http://schemas.microsoft.com/office/drawing/2014/main" id="{CD0ECC31-C3D2-8DB9-3933-25798E6F5632}"/>
              </a:ext>
            </a:extLst>
          </p:cNvPr>
          <p:cNvGrpSpPr/>
          <p:nvPr/>
        </p:nvGrpSpPr>
        <p:grpSpPr>
          <a:xfrm>
            <a:off x="3568700" y="908050"/>
            <a:ext cx="3326071" cy="2105032"/>
            <a:chOff x="3568700" y="908050"/>
            <a:chExt cx="3326071" cy="2105032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F14113A6-1E24-D945-9AC8-2A0EC57C6059}"/>
                </a:ext>
              </a:extLst>
            </p:cNvPr>
            <p:cNvSpPr txBox="1"/>
            <p:nvPr/>
          </p:nvSpPr>
          <p:spPr>
            <a:xfrm>
              <a:off x="4025900" y="1822450"/>
              <a:ext cx="1177983" cy="30609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TWIST1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80D4D0D3-3773-8548-A561-66C0D1AD1EF8}"/>
                </a:ext>
              </a:extLst>
            </p:cNvPr>
            <p:cNvSpPr txBox="1"/>
            <p:nvPr/>
          </p:nvSpPr>
          <p:spPr>
            <a:xfrm>
              <a:off x="4191889" y="2508250"/>
              <a:ext cx="90081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ACTIN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DEF81E35-044B-8E46-BAA9-0CA8D827F7D1}"/>
                </a:ext>
              </a:extLst>
            </p:cNvPr>
            <p:cNvSpPr txBox="1"/>
            <p:nvPr/>
          </p:nvSpPr>
          <p:spPr>
            <a:xfrm>
              <a:off x="3568700" y="1306106"/>
              <a:ext cx="3326071" cy="30609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Harmine (µM)    0      1     5    7.5</a:t>
              </a:r>
            </a:p>
          </p:txBody>
        </p:sp>
        <p:cxnSp>
          <p:nvCxnSpPr>
            <p:cNvPr id="4" name="Straight Connector 3">
              <a:extLst>
                <a:ext uri="{FF2B5EF4-FFF2-40B4-BE49-F238E27FC236}">
                  <a16:creationId xmlns:a16="http://schemas.microsoft.com/office/drawing/2014/main" id="{C93BEA72-3AB1-5EC4-8AA5-F8DA6802A1B3}"/>
                </a:ext>
              </a:extLst>
            </p:cNvPr>
            <p:cNvCxnSpPr/>
            <p:nvPr/>
          </p:nvCxnSpPr>
          <p:spPr>
            <a:xfrm>
              <a:off x="4942464" y="1268274"/>
              <a:ext cx="141358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351485A9-6B72-3A68-73B3-F07FCA79E67B}"/>
                </a:ext>
              </a:extLst>
            </p:cNvPr>
            <p:cNvSpPr txBox="1"/>
            <p:nvPr/>
          </p:nvSpPr>
          <p:spPr>
            <a:xfrm>
              <a:off x="5108767" y="908050"/>
              <a:ext cx="1177983" cy="30609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FVBCH-17</a:t>
              </a:r>
            </a:p>
          </p:txBody>
        </p:sp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41064A42-A171-DF9F-19DB-94820198428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0556" t="22865" r="20130" b="31130"/>
            <a:stretch/>
          </p:blipFill>
          <p:spPr>
            <a:xfrm rot="5400000">
              <a:off x="5283198" y="1174752"/>
              <a:ext cx="752478" cy="1590675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6361F3F1-E0EE-C056-9553-FEFE0A9D0B4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9821" t="18841" r="33701" b="34507"/>
            <a:stretch/>
          </p:blipFill>
          <p:spPr>
            <a:xfrm rot="5400000">
              <a:off x="5335586" y="1903418"/>
              <a:ext cx="647703" cy="1571625"/>
            </a:xfrm>
            <a:prstGeom prst="rect">
              <a:avLst/>
            </a:prstGeom>
          </p:spPr>
        </p:pic>
        <p:sp>
          <p:nvSpPr>
            <p:cNvPr id="23" name="Rectangle: Rounded Corners 20">
              <a:extLst>
                <a:ext uri="{FF2B5EF4-FFF2-40B4-BE49-F238E27FC236}">
                  <a16:creationId xmlns:a16="http://schemas.microsoft.com/office/drawing/2014/main" id="{2C71C362-C2E3-EEC4-4413-132D765E6C6B}"/>
                </a:ext>
              </a:extLst>
            </p:cNvPr>
            <p:cNvSpPr/>
            <p:nvPr/>
          </p:nvSpPr>
          <p:spPr>
            <a:xfrm>
              <a:off x="4940300" y="1822450"/>
              <a:ext cx="1549646" cy="344469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  <p:sp>
          <p:nvSpPr>
            <p:cNvPr id="24" name="Rectangle: Rounded Corners 20">
              <a:extLst>
                <a:ext uri="{FF2B5EF4-FFF2-40B4-BE49-F238E27FC236}">
                  <a16:creationId xmlns:a16="http://schemas.microsoft.com/office/drawing/2014/main" id="{67455D94-3A08-7F50-94BD-2F52D0F80185}"/>
                </a:ext>
              </a:extLst>
            </p:cNvPr>
            <p:cNvSpPr/>
            <p:nvPr/>
          </p:nvSpPr>
          <p:spPr>
            <a:xfrm>
              <a:off x="4914654" y="2508250"/>
              <a:ext cx="1549646" cy="344469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3122438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268E69E-1A64-C70D-117D-C52D8B847D56}"/>
              </a:ext>
            </a:extLst>
          </p:cNvPr>
          <p:cNvSpPr txBox="1"/>
          <p:nvPr/>
        </p:nvSpPr>
        <p:spPr>
          <a:xfrm>
            <a:off x="0" y="22627"/>
            <a:ext cx="43288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Western blot full image related to Figure 3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BC7DEC2-F316-00B8-C960-575417169EE0}"/>
              </a:ext>
            </a:extLst>
          </p:cNvPr>
          <p:cNvSpPr txBox="1"/>
          <p:nvPr/>
        </p:nvSpPr>
        <p:spPr>
          <a:xfrm>
            <a:off x="3914444" y="5937250"/>
            <a:ext cx="4392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D. </a:t>
            </a:r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519C8745-A372-C9D2-E985-A2010EA2019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0554" t="11076" r="49452" b="77740"/>
          <a:stretch/>
        </p:blipFill>
        <p:spPr>
          <a:xfrm>
            <a:off x="1130300" y="3194050"/>
            <a:ext cx="1622738" cy="862884"/>
          </a:xfrm>
          <a:prstGeom prst="rect">
            <a:avLst/>
          </a:prstGeom>
        </p:spPr>
      </p:pic>
      <p:sp>
        <p:nvSpPr>
          <p:cNvPr id="51" name="TextBox 50">
            <a:extLst>
              <a:ext uri="{FF2B5EF4-FFF2-40B4-BE49-F238E27FC236}">
                <a16:creationId xmlns:a16="http://schemas.microsoft.com/office/drawing/2014/main" id="{5C0FF62F-E495-CC6A-23B0-513F61DC8CA7}"/>
              </a:ext>
            </a:extLst>
          </p:cNvPr>
          <p:cNvSpPr txBox="1"/>
          <p:nvPr/>
        </p:nvSpPr>
        <p:spPr>
          <a:xfrm>
            <a:off x="504422" y="820045"/>
            <a:ext cx="22486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HGF (h)     0   24 48  72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F45FA887-8466-2277-16B1-BED6D210A592}"/>
              </a:ext>
            </a:extLst>
          </p:cNvPr>
          <p:cNvSpPr txBox="1"/>
          <p:nvPr/>
        </p:nvSpPr>
        <p:spPr>
          <a:xfrm>
            <a:off x="497245" y="3425385"/>
            <a:ext cx="858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Actin</a:t>
            </a:r>
          </a:p>
        </p:txBody>
      </p:sp>
      <p:sp>
        <p:nvSpPr>
          <p:cNvPr id="55" name="Rectangle: Rounded Corners 54">
            <a:extLst>
              <a:ext uri="{FF2B5EF4-FFF2-40B4-BE49-F238E27FC236}">
                <a16:creationId xmlns:a16="http://schemas.microsoft.com/office/drawing/2014/main" id="{C0772C3F-66C5-9F93-0F9C-F3A12144163B}"/>
              </a:ext>
            </a:extLst>
          </p:cNvPr>
          <p:cNvSpPr/>
          <p:nvPr/>
        </p:nvSpPr>
        <p:spPr>
          <a:xfrm>
            <a:off x="1254711" y="3447334"/>
            <a:ext cx="1467382" cy="376457"/>
          </a:xfrm>
          <a:prstGeom prst="round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C6A228B4-5F8D-1AE0-EB3E-D100E8E63490}"/>
              </a:ext>
            </a:extLst>
          </p:cNvPr>
          <p:cNvCxnSpPr/>
          <p:nvPr/>
        </p:nvCxnSpPr>
        <p:spPr>
          <a:xfrm>
            <a:off x="1299845" y="831850"/>
            <a:ext cx="11887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08B2E07E-229C-65EE-5C95-704EF3CC8E50}"/>
              </a:ext>
            </a:extLst>
          </p:cNvPr>
          <p:cNvSpPr txBox="1"/>
          <p:nvPr/>
        </p:nvSpPr>
        <p:spPr>
          <a:xfrm>
            <a:off x="1587500" y="527050"/>
            <a:ext cx="858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H23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F2DEDC8C-3E54-3357-D73A-F325861B832F}"/>
              </a:ext>
            </a:extLst>
          </p:cNvPr>
          <p:cNvSpPr txBox="1"/>
          <p:nvPr/>
        </p:nvSpPr>
        <p:spPr>
          <a:xfrm>
            <a:off x="15875" y="374650"/>
            <a:ext cx="386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.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EC016C40-6E4D-009B-34C3-70DB5A0E7D35}"/>
              </a:ext>
            </a:extLst>
          </p:cNvPr>
          <p:cNvSpPr txBox="1"/>
          <p:nvPr/>
        </p:nvSpPr>
        <p:spPr>
          <a:xfrm>
            <a:off x="3791591" y="374650"/>
            <a:ext cx="386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.</a:t>
            </a:r>
          </a:p>
        </p:txBody>
      </p:sp>
      <p:grpSp>
        <p:nvGrpSpPr>
          <p:cNvPr id="98" name="Group 97">
            <a:extLst>
              <a:ext uri="{FF2B5EF4-FFF2-40B4-BE49-F238E27FC236}">
                <a16:creationId xmlns:a16="http://schemas.microsoft.com/office/drawing/2014/main" id="{5F772684-8D08-545A-D6A1-FCA5BAD1104B}"/>
              </a:ext>
            </a:extLst>
          </p:cNvPr>
          <p:cNvGrpSpPr/>
          <p:nvPr/>
        </p:nvGrpSpPr>
        <p:grpSpPr>
          <a:xfrm>
            <a:off x="4065327" y="477376"/>
            <a:ext cx="2766325" cy="5215354"/>
            <a:chOff x="4078975" y="340896"/>
            <a:chExt cx="2766325" cy="5215354"/>
          </a:xfrm>
        </p:grpSpPr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EE12F3BB-E856-2838-BC6B-3C919A519FFA}"/>
                </a:ext>
              </a:extLst>
            </p:cNvPr>
            <p:cNvSpPr txBox="1"/>
            <p:nvPr/>
          </p:nvSpPr>
          <p:spPr>
            <a:xfrm>
              <a:off x="4429383" y="693824"/>
              <a:ext cx="224861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HGF (h)   0   24    48     72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53F1E74E-7472-7AD1-9888-0640130C6947}"/>
                </a:ext>
              </a:extLst>
            </p:cNvPr>
            <p:cNvSpPr txBox="1"/>
            <p:nvPr/>
          </p:nvSpPr>
          <p:spPr>
            <a:xfrm>
              <a:off x="4571695" y="4815858"/>
              <a:ext cx="762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Actin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989F94FB-F79C-F2A3-8C78-43729F28A566}"/>
                </a:ext>
              </a:extLst>
            </p:cNvPr>
            <p:cNvSpPr txBox="1"/>
            <p:nvPr/>
          </p:nvSpPr>
          <p:spPr>
            <a:xfrm>
              <a:off x="4078975" y="2537048"/>
              <a:ext cx="10868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E-cadherin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31CFD8A3-205E-0F9D-B42D-A981F65502C1}"/>
                </a:ext>
              </a:extLst>
            </p:cNvPr>
            <p:cNvSpPr txBox="1"/>
            <p:nvPr/>
          </p:nvSpPr>
          <p:spPr>
            <a:xfrm>
              <a:off x="4392639" y="1185440"/>
              <a:ext cx="8382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TWIST1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6923B5B3-6F66-CF99-167B-1F5D7C3A60BB}"/>
                </a:ext>
              </a:extLst>
            </p:cNvPr>
            <p:cNvSpPr txBox="1"/>
            <p:nvPr/>
          </p:nvSpPr>
          <p:spPr>
            <a:xfrm>
              <a:off x="4250975" y="3956050"/>
              <a:ext cx="10868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Vimentin</a:t>
              </a:r>
            </a:p>
          </p:txBody>
        </p:sp>
        <p:grpSp>
          <p:nvGrpSpPr>
            <p:cNvPr id="97" name="Group 96">
              <a:extLst>
                <a:ext uri="{FF2B5EF4-FFF2-40B4-BE49-F238E27FC236}">
                  <a16:creationId xmlns:a16="http://schemas.microsoft.com/office/drawing/2014/main" id="{2BB44B52-981D-A175-DAC4-FDC388F1B9A9}"/>
                </a:ext>
              </a:extLst>
            </p:cNvPr>
            <p:cNvGrpSpPr/>
            <p:nvPr/>
          </p:nvGrpSpPr>
          <p:grpSpPr>
            <a:xfrm>
              <a:off x="5139323" y="340896"/>
              <a:ext cx="1705977" cy="5215354"/>
              <a:chOff x="5139323" y="340896"/>
              <a:chExt cx="1705977" cy="5215354"/>
            </a:xfrm>
          </p:grpSpPr>
          <p:grpSp>
            <p:nvGrpSpPr>
              <p:cNvPr id="80" name="Group 79">
                <a:extLst>
                  <a:ext uri="{FF2B5EF4-FFF2-40B4-BE49-F238E27FC236}">
                    <a16:creationId xmlns:a16="http://schemas.microsoft.com/office/drawing/2014/main" id="{BFF64DEC-2AD8-D775-6904-3389C87E6A2C}"/>
                  </a:ext>
                </a:extLst>
              </p:cNvPr>
              <p:cNvGrpSpPr/>
              <p:nvPr/>
            </p:nvGrpSpPr>
            <p:grpSpPr>
              <a:xfrm>
                <a:off x="5139323" y="938933"/>
                <a:ext cx="1705977" cy="4617317"/>
                <a:chOff x="-2264472" y="2996333"/>
                <a:chExt cx="1705977" cy="4617317"/>
              </a:xfrm>
            </p:grpSpPr>
            <p:pic>
              <p:nvPicPr>
                <p:cNvPr id="71" name="Picture 70" descr="A picture containing schematic&#10;&#10;Description automatically generated">
                  <a:extLst>
                    <a:ext uri="{FF2B5EF4-FFF2-40B4-BE49-F238E27FC236}">
                      <a16:creationId xmlns:a16="http://schemas.microsoft.com/office/drawing/2014/main" id="{99EB5184-EABD-6175-BB7C-A2AEFE4A969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0735" t="8733" r="32380" b="85091"/>
                <a:stretch/>
              </p:blipFill>
              <p:spPr>
                <a:xfrm>
                  <a:off x="-2264472" y="6585850"/>
                  <a:ext cx="1705977" cy="1027800"/>
                </a:xfrm>
                <a:prstGeom prst="rect">
                  <a:avLst/>
                </a:prstGeom>
              </p:spPr>
            </p:pic>
            <p:pic>
              <p:nvPicPr>
                <p:cNvPr id="72" name="Picture 71" descr="A picture containing schematic&#10;&#10;Description automatically generated">
                  <a:extLst>
                    <a:ext uri="{FF2B5EF4-FFF2-40B4-BE49-F238E27FC236}">
                      <a16:creationId xmlns:a16="http://schemas.microsoft.com/office/drawing/2014/main" id="{A6FE2562-1945-AC14-12C9-79570359692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0695" t="64515" r="33382" b="28059"/>
                <a:stretch/>
              </p:blipFill>
              <p:spPr>
                <a:xfrm>
                  <a:off x="-2243226" y="4193825"/>
                  <a:ext cx="1656751" cy="1272577"/>
                </a:xfrm>
                <a:prstGeom prst="rect">
                  <a:avLst/>
                </a:prstGeom>
              </p:spPr>
            </p:pic>
            <p:pic>
              <p:nvPicPr>
                <p:cNvPr id="73" name="Picture 72" descr="A picture containing schematic&#10;&#10;Description automatically generated">
                  <a:extLst>
                    <a:ext uri="{FF2B5EF4-FFF2-40B4-BE49-F238E27FC236}">
                      <a16:creationId xmlns:a16="http://schemas.microsoft.com/office/drawing/2014/main" id="{A9AF78E0-228D-D800-D300-755BB11E48F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1345" t="78164" r="32925" b="15234"/>
                <a:stretch/>
              </p:blipFill>
              <p:spPr>
                <a:xfrm>
                  <a:off x="-2234574" y="2996333"/>
                  <a:ext cx="1636705" cy="1131453"/>
                </a:xfrm>
                <a:prstGeom prst="rect">
                  <a:avLst/>
                </a:prstGeom>
              </p:spPr>
            </p:pic>
            <p:pic>
              <p:nvPicPr>
                <p:cNvPr id="74" name="Picture 73" descr="A picture containing text, sign, sale&#10;&#10;Description automatically generated">
                  <a:extLst>
                    <a:ext uri="{FF2B5EF4-FFF2-40B4-BE49-F238E27FC236}">
                      <a16:creationId xmlns:a16="http://schemas.microsoft.com/office/drawing/2014/main" id="{A68E6DF1-D527-7574-D2F2-839BEF02917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6347" t="54864" r="37372" b="37389"/>
                <a:stretch/>
              </p:blipFill>
              <p:spPr>
                <a:xfrm>
                  <a:off x="-2222500" y="5534642"/>
                  <a:ext cx="1608730" cy="990600"/>
                </a:xfrm>
                <a:prstGeom prst="rect">
                  <a:avLst/>
                </a:prstGeom>
              </p:spPr>
            </p:pic>
            <p:sp>
              <p:nvSpPr>
                <p:cNvPr id="75" name="Rectangle: Rounded Corners 74">
                  <a:extLst>
                    <a:ext uri="{FF2B5EF4-FFF2-40B4-BE49-F238E27FC236}">
                      <a16:creationId xmlns:a16="http://schemas.microsoft.com/office/drawing/2014/main" id="{C3D7C3F6-6527-D3CE-0951-FD582D32DF7C}"/>
                    </a:ext>
                  </a:extLst>
                </p:cNvPr>
                <p:cNvSpPr/>
                <p:nvPr/>
              </p:nvSpPr>
              <p:spPr>
                <a:xfrm>
                  <a:off x="-2249796" y="6856193"/>
                  <a:ext cx="1467382" cy="376457"/>
                </a:xfrm>
                <a:prstGeom prst="roundRect">
                  <a:avLst/>
                </a:prstGeom>
                <a:noFill/>
                <a:ln w="28575"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76" name="Rectangle: Rounded Corners 75">
                  <a:extLst>
                    <a:ext uri="{FF2B5EF4-FFF2-40B4-BE49-F238E27FC236}">
                      <a16:creationId xmlns:a16="http://schemas.microsoft.com/office/drawing/2014/main" id="{14BF7B91-62FE-14F1-5416-9FD028D05B70}"/>
                    </a:ext>
                  </a:extLst>
                </p:cNvPr>
                <p:cNvSpPr/>
                <p:nvPr/>
              </p:nvSpPr>
              <p:spPr>
                <a:xfrm>
                  <a:off x="-2208852" y="6116946"/>
                  <a:ext cx="1467382" cy="152400"/>
                </a:xfrm>
                <a:prstGeom prst="roundRect">
                  <a:avLst/>
                </a:prstGeom>
                <a:noFill/>
                <a:ln w="28575"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77" name="Rectangle: Rounded Corners 76">
                  <a:extLst>
                    <a:ext uri="{FF2B5EF4-FFF2-40B4-BE49-F238E27FC236}">
                      <a16:creationId xmlns:a16="http://schemas.microsoft.com/office/drawing/2014/main" id="{2022AC3B-9C11-7B0D-F5DB-5B47DC192215}"/>
                    </a:ext>
                  </a:extLst>
                </p:cNvPr>
                <p:cNvSpPr/>
                <p:nvPr/>
              </p:nvSpPr>
              <p:spPr>
                <a:xfrm>
                  <a:off x="-2165636" y="4600906"/>
                  <a:ext cx="1467382" cy="376457"/>
                </a:xfrm>
                <a:prstGeom prst="roundRect">
                  <a:avLst/>
                </a:prstGeom>
                <a:noFill/>
                <a:ln w="28575"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79" name="Rectangle: Rounded Corners 78">
                  <a:extLst>
                    <a:ext uri="{FF2B5EF4-FFF2-40B4-BE49-F238E27FC236}">
                      <a16:creationId xmlns:a16="http://schemas.microsoft.com/office/drawing/2014/main" id="{AEEBE5C5-1DAB-C9D2-0E93-E1AFF7032731}"/>
                    </a:ext>
                  </a:extLst>
                </p:cNvPr>
                <p:cNvSpPr/>
                <p:nvPr/>
              </p:nvSpPr>
              <p:spPr>
                <a:xfrm rot="21369205">
                  <a:off x="-2206580" y="3283898"/>
                  <a:ext cx="1467382" cy="201304"/>
                </a:xfrm>
                <a:prstGeom prst="roundRect">
                  <a:avLst/>
                </a:prstGeom>
                <a:noFill/>
                <a:ln w="28575"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  <p:cxnSp>
            <p:nvCxnSpPr>
              <p:cNvPr id="95" name="Straight Connector 94">
                <a:extLst>
                  <a:ext uri="{FF2B5EF4-FFF2-40B4-BE49-F238E27FC236}">
                    <a16:creationId xmlns:a16="http://schemas.microsoft.com/office/drawing/2014/main" id="{B7669CB6-E0C2-1CA1-D936-DB94F115EE83}"/>
                  </a:ext>
                </a:extLst>
              </p:cNvPr>
              <p:cNvCxnSpPr/>
              <p:nvPr/>
            </p:nvCxnSpPr>
            <p:spPr>
              <a:xfrm>
                <a:off x="5307652" y="672992"/>
                <a:ext cx="118872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FD190A32-EC43-FBED-3AE1-8DCCD1F38CDB}"/>
                  </a:ext>
                </a:extLst>
              </p:cNvPr>
              <p:cNvSpPr txBox="1"/>
              <p:nvPr/>
            </p:nvSpPr>
            <p:spPr>
              <a:xfrm>
                <a:off x="5608955" y="340896"/>
                <a:ext cx="85825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/>
                  <a:t>11-18</a:t>
                </a:r>
              </a:p>
            </p:txBody>
          </p:sp>
        </p:grpSp>
      </p:grpSp>
      <p:sp>
        <p:nvSpPr>
          <p:cNvPr id="99" name="TextBox 98">
            <a:extLst>
              <a:ext uri="{FF2B5EF4-FFF2-40B4-BE49-F238E27FC236}">
                <a16:creationId xmlns:a16="http://schemas.microsoft.com/office/drawing/2014/main" id="{104B538F-93FA-A7FA-5172-1BDCE4BBF5D4}"/>
              </a:ext>
            </a:extLst>
          </p:cNvPr>
          <p:cNvSpPr txBox="1"/>
          <p:nvPr/>
        </p:nvSpPr>
        <p:spPr>
          <a:xfrm>
            <a:off x="63500" y="4718050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.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E74DE3D1-FAE3-8A98-F29B-0D9592A6012E}"/>
              </a:ext>
            </a:extLst>
          </p:cNvPr>
          <p:cNvSpPr txBox="1"/>
          <p:nvPr/>
        </p:nvSpPr>
        <p:spPr>
          <a:xfrm>
            <a:off x="612940" y="5251450"/>
            <a:ext cx="22486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HGF (h)     0   24   48  72</a:t>
            </a:r>
          </a:p>
        </p:txBody>
      </p:sp>
      <p:pic>
        <p:nvPicPr>
          <p:cNvPr id="58" name="Picture 57" descr="A picture containing schematic&#10;&#10;Description automatically generated">
            <a:extLst>
              <a:ext uri="{FF2B5EF4-FFF2-40B4-BE49-F238E27FC236}">
                <a16:creationId xmlns:a16="http://schemas.microsoft.com/office/drawing/2014/main" id="{CCE6FA18-A13D-15FB-4822-82F303B1BEDA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227" t="9283" r="47786" b="85279"/>
          <a:stretch/>
        </p:blipFill>
        <p:spPr>
          <a:xfrm>
            <a:off x="1222540" y="8070850"/>
            <a:ext cx="1643064" cy="866273"/>
          </a:xfrm>
          <a:prstGeom prst="rect">
            <a:avLst/>
          </a:prstGeom>
        </p:spPr>
      </p:pic>
      <p:pic>
        <p:nvPicPr>
          <p:cNvPr id="59" name="Picture 58" descr="A picture containing schematic&#10;&#10;Description automatically generated">
            <a:extLst>
              <a:ext uri="{FF2B5EF4-FFF2-40B4-BE49-F238E27FC236}">
                <a16:creationId xmlns:a16="http://schemas.microsoft.com/office/drawing/2014/main" id="{A1D00A61-C648-AF21-FD72-FC55ECC4A063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585" t="33668" r="47170" b="61065"/>
          <a:stretch/>
        </p:blipFill>
        <p:spPr>
          <a:xfrm>
            <a:off x="1222539" y="6570914"/>
            <a:ext cx="1656644" cy="884653"/>
          </a:xfrm>
          <a:prstGeom prst="rect">
            <a:avLst/>
          </a:prstGeom>
        </p:spPr>
      </p:pic>
      <p:pic>
        <p:nvPicPr>
          <p:cNvPr id="60" name="Picture 59" descr="Diagram, schematic&#10;&#10;Description automatically generated">
            <a:extLst>
              <a:ext uri="{FF2B5EF4-FFF2-40B4-BE49-F238E27FC236}">
                <a16:creationId xmlns:a16="http://schemas.microsoft.com/office/drawing/2014/main" id="{9A834501-0B3E-088D-01E6-ED8FEFA4C07D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843" t="3194" r="42467" b="88483"/>
          <a:stretch/>
        </p:blipFill>
        <p:spPr>
          <a:xfrm>
            <a:off x="1222540" y="5513804"/>
            <a:ext cx="1637349" cy="996950"/>
          </a:xfrm>
          <a:prstGeom prst="rect">
            <a:avLst/>
          </a:prstGeom>
        </p:spPr>
      </p:pic>
      <p:sp>
        <p:nvSpPr>
          <p:cNvPr id="62" name="TextBox 61">
            <a:extLst>
              <a:ext uri="{FF2B5EF4-FFF2-40B4-BE49-F238E27FC236}">
                <a16:creationId xmlns:a16="http://schemas.microsoft.com/office/drawing/2014/main" id="{6AD61A2A-E0B1-D9C1-67F5-B285EBDDC7EA}"/>
              </a:ext>
            </a:extLst>
          </p:cNvPr>
          <p:cNvSpPr txBox="1"/>
          <p:nvPr/>
        </p:nvSpPr>
        <p:spPr>
          <a:xfrm>
            <a:off x="637004" y="8275386"/>
            <a:ext cx="76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Actin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46648BD4-E193-2B0B-2881-4732748103F7}"/>
              </a:ext>
            </a:extLst>
          </p:cNvPr>
          <p:cNvSpPr txBox="1"/>
          <p:nvPr/>
        </p:nvSpPr>
        <p:spPr>
          <a:xfrm>
            <a:off x="139700" y="6879722"/>
            <a:ext cx="10868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E-cadherin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2C613B18-513F-E0DC-2620-C67ABD9A4555}"/>
              </a:ext>
            </a:extLst>
          </p:cNvPr>
          <p:cNvSpPr txBox="1"/>
          <p:nvPr/>
        </p:nvSpPr>
        <p:spPr>
          <a:xfrm>
            <a:off x="412420" y="5824954"/>
            <a:ext cx="838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TWIST1</a:t>
            </a:r>
          </a:p>
        </p:txBody>
      </p:sp>
      <p:sp>
        <p:nvSpPr>
          <p:cNvPr id="66" name="Rectangle: Rounded Corners 65">
            <a:extLst>
              <a:ext uri="{FF2B5EF4-FFF2-40B4-BE49-F238E27FC236}">
                <a16:creationId xmlns:a16="http://schemas.microsoft.com/office/drawing/2014/main" id="{B497DDD8-37EC-059D-C782-59B5B7425361}"/>
              </a:ext>
            </a:extLst>
          </p:cNvPr>
          <p:cNvSpPr/>
          <p:nvPr/>
        </p:nvSpPr>
        <p:spPr>
          <a:xfrm>
            <a:off x="1394996" y="5829497"/>
            <a:ext cx="1467382" cy="376457"/>
          </a:xfrm>
          <a:prstGeom prst="round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7" name="Rectangle: Rounded Corners 66">
            <a:extLst>
              <a:ext uri="{FF2B5EF4-FFF2-40B4-BE49-F238E27FC236}">
                <a16:creationId xmlns:a16="http://schemas.microsoft.com/office/drawing/2014/main" id="{6FA4D8A1-598D-921F-B36B-8031FA4579B8}"/>
              </a:ext>
            </a:extLst>
          </p:cNvPr>
          <p:cNvSpPr/>
          <p:nvPr/>
        </p:nvSpPr>
        <p:spPr>
          <a:xfrm>
            <a:off x="1310772" y="6827586"/>
            <a:ext cx="1467382" cy="376457"/>
          </a:xfrm>
          <a:prstGeom prst="round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8" name="Rectangle: Rounded Corners 67">
            <a:extLst>
              <a:ext uri="{FF2B5EF4-FFF2-40B4-BE49-F238E27FC236}">
                <a16:creationId xmlns:a16="http://schemas.microsoft.com/office/drawing/2014/main" id="{DEA2D342-A7E0-D5FC-531F-6C66E497E2EF}"/>
              </a:ext>
            </a:extLst>
          </p:cNvPr>
          <p:cNvSpPr/>
          <p:nvPr/>
        </p:nvSpPr>
        <p:spPr>
          <a:xfrm>
            <a:off x="1310772" y="8291961"/>
            <a:ext cx="1467382" cy="376457"/>
          </a:xfrm>
          <a:prstGeom prst="round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E06C800B-A6D4-C5C2-9A5C-178488EB8C21}"/>
              </a:ext>
            </a:extLst>
          </p:cNvPr>
          <p:cNvCxnSpPr/>
          <p:nvPr/>
        </p:nvCxnSpPr>
        <p:spPr>
          <a:xfrm>
            <a:off x="1528132" y="5270786"/>
            <a:ext cx="11887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TextBox 100">
            <a:extLst>
              <a:ext uri="{FF2B5EF4-FFF2-40B4-BE49-F238E27FC236}">
                <a16:creationId xmlns:a16="http://schemas.microsoft.com/office/drawing/2014/main" id="{A26C14D9-BA78-E651-1E24-5C78311EA87F}"/>
              </a:ext>
            </a:extLst>
          </p:cNvPr>
          <p:cNvSpPr txBox="1"/>
          <p:nvPr/>
        </p:nvSpPr>
        <p:spPr>
          <a:xfrm>
            <a:off x="1681811" y="4938690"/>
            <a:ext cx="11192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HCC-827</a:t>
            </a:r>
          </a:p>
        </p:txBody>
      </p:sp>
      <p:grpSp>
        <p:nvGrpSpPr>
          <p:cNvPr id="113" name="Group 112">
            <a:extLst>
              <a:ext uri="{FF2B5EF4-FFF2-40B4-BE49-F238E27FC236}">
                <a16:creationId xmlns:a16="http://schemas.microsoft.com/office/drawing/2014/main" id="{DD51F9FB-9D7C-FCE5-E721-B4B6DA85268C}"/>
              </a:ext>
            </a:extLst>
          </p:cNvPr>
          <p:cNvGrpSpPr/>
          <p:nvPr/>
        </p:nvGrpSpPr>
        <p:grpSpPr>
          <a:xfrm>
            <a:off x="4178300" y="6141621"/>
            <a:ext cx="2676525" cy="2759637"/>
            <a:chOff x="4178300" y="6141621"/>
            <a:chExt cx="2676525" cy="2759637"/>
          </a:xfrm>
        </p:grpSpPr>
        <p:grpSp>
          <p:nvGrpSpPr>
            <p:cNvPr id="46" name="Group 45">
              <a:extLst>
                <a:ext uri="{FF2B5EF4-FFF2-40B4-BE49-F238E27FC236}">
                  <a16:creationId xmlns:a16="http://schemas.microsoft.com/office/drawing/2014/main" id="{B9D9D27D-56CD-C3FA-5481-285BC2845719}"/>
                </a:ext>
              </a:extLst>
            </p:cNvPr>
            <p:cNvGrpSpPr/>
            <p:nvPr/>
          </p:nvGrpSpPr>
          <p:grpSpPr>
            <a:xfrm>
              <a:off x="4199908" y="8126980"/>
              <a:ext cx="2351721" cy="774278"/>
              <a:chOff x="3460412" y="1886372"/>
              <a:chExt cx="2351721" cy="774278"/>
            </a:xfrm>
          </p:grpSpPr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ED0439CE-0E9F-8F77-637D-D5B3F0935A7D}"/>
                  </a:ext>
                </a:extLst>
              </p:cNvPr>
              <p:cNvSpPr txBox="1"/>
              <p:nvPr/>
            </p:nvSpPr>
            <p:spPr>
              <a:xfrm>
                <a:off x="3460412" y="2207359"/>
                <a:ext cx="85825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/>
                  <a:t>GAPDH</a:t>
                </a:r>
              </a:p>
            </p:txBody>
          </p:sp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A8597543-0F87-CE77-9D43-6CB435EB875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3371" t="15350" r="3746" b="15728"/>
              <a:stretch/>
            </p:blipFill>
            <p:spPr>
              <a:xfrm>
                <a:off x="4233479" y="1886372"/>
                <a:ext cx="1578654" cy="774278"/>
              </a:xfrm>
              <a:prstGeom prst="rect">
                <a:avLst/>
              </a:prstGeom>
            </p:spPr>
          </p:pic>
          <p:sp>
            <p:nvSpPr>
              <p:cNvPr id="12" name="Rectangle: Rounded Corners 11">
                <a:extLst>
                  <a:ext uri="{FF2B5EF4-FFF2-40B4-BE49-F238E27FC236}">
                    <a16:creationId xmlns:a16="http://schemas.microsoft.com/office/drawing/2014/main" id="{049CE177-B2AB-E2AB-1489-4F8BA53FFE42}"/>
                  </a:ext>
                </a:extLst>
              </p:cNvPr>
              <p:cNvSpPr/>
              <p:nvPr/>
            </p:nvSpPr>
            <p:spPr>
              <a:xfrm>
                <a:off x="4233479" y="2179386"/>
                <a:ext cx="1560786" cy="322138"/>
              </a:xfrm>
              <a:prstGeom prst="roundRect">
                <a:avLst/>
              </a:prstGeom>
              <a:noFill/>
              <a:ln w="285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4E14227D-66B9-EC00-FF14-5196710CEF42}"/>
                </a:ext>
              </a:extLst>
            </p:cNvPr>
            <p:cNvGrpSpPr/>
            <p:nvPr/>
          </p:nvGrpSpPr>
          <p:grpSpPr>
            <a:xfrm>
              <a:off x="4178300" y="6775450"/>
              <a:ext cx="2326212" cy="1295400"/>
              <a:chOff x="1082172" y="1365250"/>
              <a:chExt cx="2326212" cy="1295400"/>
            </a:xfrm>
          </p:grpSpPr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4497055C-E984-9441-36D9-F5323534E923}"/>
                  </a:ext>
                </a:extLst>
              </p:cNvPr>
              <p:cNvGrpSpPr/>
              <p:nvPr/>
            </p:nvGrpSpPr>
            <p:grpSpPr>
              <a:xfrm>
                <a:off x="1892300" y="1365250"/>
                <a:ext cx="1516084" cy="1295400"/>
                <a:chOff x="444500" y="984250"/>
                <a:chExt cx="2125684" cy="1835444"/>
              </a:xfrm>
            </p:grpSpPr>
            <p:pic>
              <p:nvPicPr>
                <p:cNvPr id="3" name="Picture 2">
                  <a:extLst>
                    <a:ext uri="{FF2B5EF4-FFF2-40B4-BE49-F238E27FC236}">
                      <a16:creationId xmlns:a16="http://schemas.microsoft.com/office/drawing/2014/main" id="{C51885F4-FC55-9876-C8EE-4ADE943B8B5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/>
                <a:srcRect l="19148" r="52290" b="19240"/>
                <a:stretch/>
              </p:blipFill>
              <p:spPr>
                <a:xfrm>
                  <a:off x="444500" y="984250"/>
                  <a:ext cx="2125684" cy="1835444"/>
                </a:xfrm>
                <a:prstGeom prst="rect">
                  <a:avLst/>
                </a:prstGeom>
              </p:spPr>
            </p:pic>
            <p:sp>
              <p:nvSpPr>
                <p:cNvPr id="5" name="Rectangle: Rounded Corners 4">
                  <a:extLst>
                    <a:ext uri="{FF2B5EF4-FFF2-40B4-BE49-F238E27FC236}">
                      <a16:creationId xmlns:a16="http://schemas.microsoft.com/office/drawing/2014/main" id="{F3FCF723-FC69-FB60-A6AB-D6E09DCA0168}"/>
                    </a:ext>
                  </a:extLst>
                </p:cNvPr>
                <p:cNvSpPr/>
                <p:nvPr/>
              </p:nvSpPr>
              <p:spPr>
                <a:xfrm>
                  <a:off x="495110" y="1416119"/>
                  <a:ext cx="2057399" cy="533400"/>
                </a:xfrm>
                <a:prstGeom prst="roundRect">
                  <a:avLst/>
                </a:prstGeom>
                <a:noFill/>
                <a:ln w="28575"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F1032A67-9D92-05B0-DE69-4A94EABD19A9}"/>
                  </a:ext>
                </a:extLst>
              </p:cNvPr>
              <p:cNvSpPr txBox="1"/>
              <p:nvPr/>
            </p:nvSpPr>
            <p:spPr>
              <a:xfrm>
                <a:off x="1082172" y="1670050"/>
                <a:ext cx="9144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/>
                  <a:t>TWIST1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47E820FA-25F5-AEA1-E191-950C71C0FCF3}"/>
                  </a:ext>
                </a:extLst>
              </p:cNvPr>
              <p:cNvSpPr txBox="1"/>
              <p:nvPr/>
            </p:nvSpPr>
            <p:spPr>
              <a:xfrm>
                <a:off x="1350876" y="1365250"/>
                <a:ext cx="20574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/>
                  <a:t>HGF      -      +      -      +</a:t>
                </a:r>
              </a:p>
            </p:txBody>
          </p:sp>
        </p:grpSp>
        <p:cxnSp>
          <p:nvCxnSpPr>
            <p:cNvPr id="108" name="Straight Connector 107">
              <a:extLst>
                <a:ext uri="{FF2B5EF4-FFF2-40B4-BE49-F238E27FC236}">
                  <a16:creationId xmlns:a16="http://schemas.microsoft.com/office/drawing/2014/main" id="{7B1C985C-BFE8-5463-5688-2A63490548A2}"/>
                </a:ext>
              </a:extLst>
            </p:cNvPr>
            <p:cNvCxnSpPr/>
            <p:nvPr/>
          </p:nvCxnSpPr>
          <p:spPr>
            <a:xfrm>
              <a:off x="5102225" y="6708775"/>
              <a:ext cx="45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23DA51BC-46D7-C714-BAD0-DDEA0C48DD04}"/>
                </a:ext>
              </a:extLst>
            </p:cNvPr>
            <p:cNvSpPr txBox="1"/>
            <p:nvPr/>
          </p:nvSpPr>
          <p:spPr>
            <a:xfrm>
              <a:off x="4797425" y="6141621"/>
              <a:ext cx="20574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H460 W118 TWIST1</a:t>
              </a:r>
            </a:p>
          </p:txBody>
        </p:sp>
        <p:cxnSp>
          <p:nvCxnSpPr>
            <p:cNvPr id="110" name="Straight Connector 109">
              <a:extLst>
                <a:ext uri="{FF2B5EF4-FFF2-40B4-BE49-F238E27FC236}">
                  <a16:creationId xmlns:a16="http://schemas.microsoft.com/office/drawing/2014/main" id="{3863EE04-D6D1-13D2-AACD-D1C99E4BD074}"/>
                </a:ext>
              </a:extLst>
            </p:cNvPr>
            <p:cNvCxnSpPr/>
            <p:nvPr/>
          </p:nvCxnSpPr>
          <p:spPr>
            <a:xfrm>
              <a:off x="5854700" y="6708775"/>
              <a:ext cx="45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796A20B1-F33F-6E94-C0A3-64B78D5437E6}"/>
                </a:ext>
              </a:extLst>
            </p:cNvPr>
            <p:cNvSpPr txBox="1"/>
            <p:nvPr/>
          </p:nvSpPr>
          <p:spPr>
            <a:xfrm>
              <a:off x="5064125" y="6408321"/>
              <a:ext cx="14478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24h          48h</a:t>
              </a:r>
            </a:p>
          </p:txBody>
        </p:sp>
        <p:cxnSp>
          <p:nvCxnSpPr>
            <p:cNvPr id="112" name="Straight Connector 111">
              <a:extLst>
                <a:ext uri="{FF2B5EF4-FFF2-40B4-BE49-F238E27FC236}">
                  <a16:creationId xmlns:a16="http://schemas.microsoft.com/office/drawing/2014/main" id="{E40145F0-6C88-FA95-D3F9-F268C502C6C8}"/>
                </a:ext>
              </a:extLst>
            </p:cNvPr>
            <p:cNvCxnSpPr/>
            <p:nvPr/>
          </p:nvCxnSpPr>
          <p:spPr>
            <a:xfrm>
              <a:off x="5092700" y="6461125"/>
              <a:ext cx="128016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0" name="Picture 9">
            <a:extLst>
              <a:ext uri="{FF2B5EF4-FFF2-40B4-BE49-F238E27FC236}">
                <a16:creationId xmlns:a16="http://schemas.microsoft.com/office/drawing/2014/main" id="{2C0FB325-AFCB-1BBA-BD36-A0E3D9E0FF1E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2327" t="39074" r="45247" b="46136"/>
          <a:stretch/>
        </p:blipFill>
        <p:spPr>
          <a:xfrm>
            <a:off x="977900" y="1237451"/>
            <a:ext cx="1800254" cy="880303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89CB7596-9A09-329C-1B66-EFDCCC00F440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16611" t="37684" r="37057" b="41972"/>
          <a:stretch/>
        </p:blipFill>
        <p:spPr>
          <a:xfrm>
            <a:off x="1022425" y="2169782"/>
            <a:ext cx="1730614" cy="933406"/>
          </a:xfrm>
          <a:prstGeom prst="rect">
            <a:avLst/>
          </a:prstGeom>
        </p:spPr>
      </p:pic>
      <p:sp>
        <p:nvSpPr>
          <p:cNvPr id="15" name="Rectangle: Rounded Corners 14">
            <a:extLst>
              <a:ext uri="{FF2B5EF4-FFF2-40B4-BE49-F238E27FC236}">
                <a16:creationId xmlns:a16="http://schemas.microsoft.com/office/drawing/2014/main" id="{05A06B24-7CEF-0D6B-3D57-B532BF7E0825}"/>
              </a:ext>
            </a:extLst>
          </p:cNvPr>
          <p:cNvSpPr/>
          <p:nvPr/>
        </p:nvSpPr>
        <p:spPr>
          <a:xfrm>
            <a:off x="1212660" y="1625749"/>
            <a:ext cx="1467382" cy="376457"/>
          </a:xfrm>
          <a:prstGeom prst="round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9A895C9-5122-C103-859D-46536945217C}"/>
              </a:ext>
            </a:extLst>
          </p:cNvPr>
          <p:cNvSpPr txBox="1"/>
          <p:nvPr/>
        </p:nvSpPr>
        <p:spPr>
          <a:xfrm>
            <a:off x="-32756" y="1636296"/>
            <a:ext cx="10868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E-cadherin</a:t>
            </a:r>
          </a:p>
        </p:txBody>
      </p:sp>
      <p:sp>
        <p:nvSpPr>
          <p:cNvPr id="18" name="Rectangle: Rounded Corners 17">
            <a:extLst>
              <a:ext uri="{FF2B5EF4-FFF2-40B4-BE49-F238E27FC236}">
                <a16:creationId xmlns:a16="http://schemas.microsoft.com/office/drawing/2014/main" id="{B7CE24D0-485E-25E6-53FB-3271C7A045D2}"/>
              </a:ext>
            </a:extLst>
          </p:cNvPr>
          <p:cNvSpPr/>
          <p:nvPr/>
        </p:nvSpPr>
        <p:spPr>
          <a:xfrm>
            <a:off x="1394996" y="2581033"/>
            <a:ext cx="1093569" cy="376457"/>
          </a:xfrm>
          <a:prstGeom prst="round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F4A6331-F4BD-CDCC-25D2-E4C4663DDFF3}"/>
              </a:ext>
            </a:extLst>
          </p:cNvPr>
          <p:cNvSpPr txBox="1"/>
          <p:nvPr/>
        </p:nvSpPr>
        <p:spPr>
          <a:xfrm>
            <a:off x="43444" y="2617400"/>
            <a:ext cx="10868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Vimentin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2D523576-7ACE-D077-AA84-8FEFA3121AE2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0300" y="7624786"/>
            <a:ext cx="1844744" cy="231834"/>
          </a:xfrm>
          <a:prstGeom prst="rect">
            <a:avLst/>
          </a:prstGeom>
          <a:ln w="19050">
            <a:noFill/>
          </a:ln>
        </p:spPr>
      </p:pic>
      <p:sp>
        <p:nvSpPr>
          <p:cNvPr id="21" name="Rectangle: Rounded Corners 20">
            <a:extLst>
              <a:ext uri="{FF2B5EF4-FFF2-40B4-BE49-F238E27FC236}">
                <a16:creationId xmlns:a16="http://schemas.microsoft.com/office/drawing/2014/main" id="{E0FCF2B8-23CF-2621-F7C7-01ECB15A57B8}"/>
              </a:ext>
            </a:extLst>
          </p:cNvPr>
          <p:cNvSpPr/>
          <p:nvPr/>
        </p:nvSpPr>
        <p:spPr>
          <a:xfrm>
            <a:off x="1113771" y="7497877"/>
            <a:ext cx="1765411" cy="376457"/>
          </a:xfrm>
          <a:prstGeom prst="round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79F4F0D-A229-CE4A-EEC8-5E273531EFC8}"/>
              </a:ext>
            </a:extLst>
          </p:cNvPr>
          <p:cNvSpPr txBox="1"/>
          <p:nvPr/>
        </p:nvSpPr>
        <p:spPr>
          <a:xfrm>
            <a:off x="98451" y="7535780"/>
            <a:ext cx="10868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Vimentin</a:t>
            </a:r>
          </a:p>
        </p:txBody>
      </p:sp>
    </p:spTree>
    <p:extLst>
      <p:ext uri="{BB962C8B-B14F-4D97-AF65-F5344CB8AC3E}">
        <p14:creationId xmlns:p14="http://schemas.microsoft.com/office/powerpoint/2010/main" val="39485858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oup 23">
            <a:extLst>
              <a:ext uri="{FF2B5EF4-FFF2-40B4-BE49-F238E27FC236}">
                <a16:creationId xmlns:a16="http://schemas.microsoft.com/office/drawing/2014/main" id="{9C9840C6-9420-1F49-A00C-2275A649CDD2}"/>
              </a:ext>
            </a:extLst>
          </p:cNvPr>
          <p:cNvGrpSpPr/>
          <p:nvPr/>
        </p:nvGrpSpPr>
        <p:grpSpPr>
          <a:xfrm>
            <a:off x="215900" y="450850"/>
            <a:ext cx="1540078" cy="3607761"/>
            <a:chOff x="292100" y="298450"/>
            <a:chExt cx="1540078" cy="3607761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C40D50FF-53B1-B7C3-CF2D-16D8BCB2813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49064" t="41154" r="47076" b="49786"/>
            <a:stretch/>
          </p:blipFill>
          <p:spPr>
            <a:xfrm>
              <a:off x="1086204" y="1257192"/>
              <a:ext cx="745974" cy="870058"/>
            </a:xfrm>
            <a:prstGeom prst="rect">
              <a:avLst/>
            </a:prstGeom>
          </p:spPr>
        </p:pic>
        <p:sp>
          <p:nvSpPr>
            <p:cNvPr id="18" name="Rectangle: Rounded Corners 17">
              <a:extLst>
                <a:ext uri="{FF2B5EF4-FFF2-40B4-BE49-F238E27FC236}">
                  <a16:creationId xmlns:a16="http://schemas.microsoft.com/office/drawing/2014/main" id="{B8532D2A-0FDD-1C6E-2C99-2425266E51E7}"/>
                </a:ext>
              </a:extLst>
            </p:cNvPr>
            <p:cNvSpPr/>
            <p:nvPr/>
          </p:nvSpPr>
          <p:spPr>
            <a:xfrm>
              <a:off x="1086204" y="1377035"/>
              <a:ext cx="678158" cy="239685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88EBB550-8AC8-691D-E3DD-33A0E9E508CD}"/>
                </a:ext>
              </a:extLst>
            </p:cNvPr>
            <p:cNvSpPr txBox="1"/>
            <p:nvPr/>
          </p:nvSpPr>
          <p:spPr>
            <a:xfrm>
              <a:off x="292100" y="1328907"/>
              <a:ext cx="1152868" cy="2662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TWIST1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76A4F3AF-7BD0-BF89-8B54-1A2A286BD64D}"/>
                </a:ext>
              </a:extLst>
            </p:cNvPr>
            <p:cNvSpPr txBox="1"/>
            <p:nvPr/>
          </p:nvSpPr>
          <p:spPr>
            <a:xfrm rot="16200000">
              <a:off x="766651" y="657130"/>
              <a:ext cx="1018663" cy="3013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FVBW-17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5DBBD448-57A1-10A0-B354-F79F11B03804}"/>
                </a:ext>
              </a:extLst>
            </p:cNvPr>
            <p:cNvSpPr txBox="1"/>
            <p:nvPr/>
          </p:nvSpPr>
          <p:spPr>
            <a:xfrm rot="16200000">
              <a:off x="1080299" y="657130"/>
              <a:ext cx="1018663" cy="3013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FVBCH-17</a:t>
              </a:r>
            </a:p>
          </p:txBody>
        </p: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3239D883-063A-B99D-F8A2-292BA66087A0}"/>
                </a:ext>
              </a:extLst>
            </p:cNvPr>
            <p:cNvGrpSpPr/>
            <p:nvPr/>
          </p:nvGrpSpPr>
          <p:grpSpPr>
            <a:xfrm>
              <a:off x="596900" y="2162506"/>
              <a:ext cx="1222875" cy="858873"/>
              <a:chOff x="2613740" y="4260850"/>
              <a:chExt cx="1374060" cy="1092200"/>
            </a:xfrm>
          </p:grpSpPr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F454653B-927D-B5FC-C8EB-16ABE33B132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59413" t="35699" r="14803" b="17889"/>
              <a:stretch/>
            </p:blipFill>
            <p:spPr>
              <a:xfrm>
                <a:off x="3187700" y="4260850"/>
                <a:ext cx="800100" cy="1092200"/>
              </a:xfrm>
              <a:prstGeom prst="rect">
                <a:avLst/>
              </a:prstGeom>
            </p:spPr>
          </p:pic>
          <p:sp>
            <p:nvSpPr>
              <p:cNvPr id="13" name="Rectangle: Rounded Corners 12">
                <a:extLst>
                  <a:ext uri="{FF2B5EF4-FFF2-40B4-BE49-F238E27FC236}">
                    <a16:creationId xmlns:a16="http://schemas.microsoft.com/office/drawing/2014/main" id="{E4563F4B-FB3D-0A22-6828-6F82882A5B2B}"/>
                  </a:ext>
                </a:extLst>
              </p:cNvPr>
              <p:cNvSpPr/>
              <p:nvPr/>
            </p:nvSpPr>
            <p:spPr>
              <a:xfrm>
                <a:off x="3187700" y="4718050"/>
                <a:ext cx="762000" cy="457200"/>
              </a:xfrm>
              <a:prstGeom prst="roundRect">
                <a:avLst/>
              </a:prstGeom>
              <a:noFill/>
              <a:ln w="285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 b="1" dirty="0"/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F6ADA623-1118-6DF1-878A-393A100C3CDD}"/>
                  </a:ext>
                </a:extLst>
              </p:cNvPr>
              <p:cNvSpPr txBox="1"/>
              <p:nvPr/>
            </p:nvSpPr>
            <p:spPr>
              <a:xfrm>
                <a:off x="2613740" y="4746625"/>
                <a:ext cx="6096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/>
                  <a:t>E2A</a:t>
                </a:r>
              </a:p>
            </p:txBody>
          </p:sp>
        </p:grp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61E9AFC6-6F7F-9A88-78A2-598F96749174}"/>
                </a:ext>
              </a:extLst>
            </p:cNvPr>
            <p:cNvGrpSpPr/>
            <p:nvPr/>
          </p:nvGrpSpPr>
          <p:grpSpPr>
            <a:xfrm>
              <a:off x="354652" y="3047338"/>
              <a:ext cx="1446667" cy="858873"/>
              <a:chOff x="4137740" y="4260850"/>
              <a:chExt cx="1625520" cy="1092200"/>
            </a:xfrm>
          </p:grpSpPr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8CF03B62-80B2-7250-2360-BE8DAE11757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b="15686"/>
              <a:stretch/>
            </p:blipFill>
            <p:spPr>
              <a:xfrm>
                <a:off x="5016500" y="4260850"/>
                <a:ext cx="746760" cy="1092200"/>
              </a:xfrm>
              <a:prstGeom prst="rect">
                <a:avLst/>
              </a:prstGeom>
            </p:spPr>
          </p:pic>
          <p:sp>
            <p:nvSpPr>
              <p:cNvPr id="8" name="Rectangle: Rounded Corners 7">
                <a:extLst>
                  <a:ext uri="{FF2B5EF4-FFF2-40B4-BE49-F238E27FC236}">
                    <a16:creationId xmlns:a16="http://schemas.microsoft.com/office/drawing/2014/main" id="{693E03BA-EF77-CF81-CB71-59C480978A52}"/>
                  </a:ext>
                </a:extLst>
              </p:cNvPr>
              <p:cNvSpPr/>
              <p:nvPr/>
            </p:nvSpPr>
            <p:spPr>
              <a:xfrm>
                <a:off x="4987925" y="4622800"/>
                <a:ext cx="762000" cy="457200"/>
              </a:xfrm>
              <a:prstGeom prst="roundRect">
                <a:avLst/>
              </a:prstGeom>
              <a:noFill/>
              <a:ln w="285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 b="1" dirty="0"/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604F25AB-FC54-E7E6-86F6-D5138EE3A745}"/>
                  </a:ext>
                </a:extLst>
              </p:cNvPr>
              <p:cNvSpPr txBox="1"/>
              <p:nvPr/>
            </p:nvSpPr>
            <p:spPr>
              <a:xfrm>
                <a:off x="4137740" y="4611249"/>
                <a:ext cx="9906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/>
                  <a:t>GAPDH</a:t>
                </a:r>
              </a:p>
            </p:txBody>
          </p:sp>
        </p:grp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7B7E5254-1B7D-D55A-311A-48F62AF978BE}"/>
              </a:ext>
            </a:extLst>
          </p:cNvPr>
          <p:cNvSpPr txBox="1"/>
          <p:nvPr/>
        </p:nvSpPr>
        <p:spPr>
          <a:xfrm>
            <a:off x="0" y="18671"/>
            <a:ext cx="4106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E. </a:t>
            </a:r>
          </a:p>
        </p:txBody>
      </p:sp>
      <p:grpSp>
        <p:nvGrpSpPr>
          <p:cNvPr id="25" name="Group 24">
            <a:extLst>
              <a:ext uri="{FF2B5EF4-FFF2-40B4-BE49-F238E27FC236}">
                <a16:creationId xmlns:a16="http://schemas.microsoft.com/office/drawing/2014/main" id="{249E9BD1-79CF-9930-4562-A8825301E5B0}"/>
              </a:ext>
            </a:extLst>
          </p:cNvPr>
          <p:cNvGrpSpPr/>
          <p:nvPr/>
        </p:nvGrpSpPr>
        <p:grpSpPr>
          <a:xfrm>
            <a:off x="2487394" y="5318"/>
            <a:ext cx="4954806" cy="2807732"/>
            <a:chOff x="1814294" y="6866659"/>
            <a:chExt cx="4954806" cy="2807732"/>
          </a:xfrm>
        </p:grpSpPr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0D27D2C5-C5D9-C3A6-8264-CFB8BF0C74B7}"/>
                </a:ext>
              </a:extLst>
            </p:cNvPr>
            <p:cNvSpPr txBox="1"/>
            <p:nvPr/>
          </p:nvSpPr>
          <p:spPr>
            <a:xfrm>
              <a:off x="2044700" y="9064671"/>
              <a:ext cx="12954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TWIST1</a:t>
              </a:r>
            </a:p>
          </p:txBody>
        </p:sp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C81E436A-EC79-8259-540D-F872A552285B}"/>
                </a:ext>
              </a:extLst>
            </p:cNvPr>
            <p:cNvGrpSpPr/>
            <p:nvPr/>
          </p:nvGrpSpPr>
          <p:grpSpPr>
            <a:xfrm>
              <a:off x="1814294" y="6866659"/>
              <a:ext cx="4954806" cy="2807732"/>
              <a:chOff x="1738094" y="6866539"/>
              <a:chExt cx="4954806" cy="2807732"/>
            </a:xfrm>
          </p:grpSpPr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17098AA9-5907-8B57-98F4-D1AD2035DB66}"/>
                  </a:ext>
                </a:extLst>
              </p:cNvPr>
              <p:cNvSpPr txBox="1"/>
              <p:nvPr/>
            </p:nvSpPr>
            <p:spPr>
              <a:xfrm>
                <a:off x="1738094" y="6866539"/>
                <a:ext cx="44595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H. </a:t>
                </a:r>
              </a:p>
            </p:txBody>
          </p:sp>
          <p:grpSp>
            <p:nvGrpSpPr>
              <p:cNvPr id="29" name="Group 28">
                <a:extLst>
                  <a:ext uri="{FF2B5EF4-FFF2-40B4-BE49-F238E27FC236}">
                    <a16:creationId xmlns:a16="http://schemas.microsoft.com/office/drawing/2014/main" id="{AB87AD35-4563-CFA3-F25E-E22E933CA773}"/>
                  </a:ext>
                </a:extLst>
              </p:cNvPr>
              <p:cNvGrpSpPr/>
              <p:nvPr/>
            </p:nvGrpSpPr>
            <p:grpSpPr>
              <a:xfrm>
                <a:off x="2120900" y="7616871"/>
                <a:ext cx="4572000" cy="2057400"/>
                <a:chOff x="1511300" y="6775450"/>
                <a:chExt cx="4572000" cy="2057400"/>
              </a:xfrm>
            </p:grpSpPr>
            <p:grpSp>
              <p:nvGrpSpPr>
                <p:cNvPr id="30" name="Group 29">
                  <a:extLst>
                    <a:ext uri="{FF2B5EF4-FFF2-40B4-BE49-F238E27FC236}">
                      <a16:creationId xmlns:a16="http://schemas.microsoft.com/office/drawing/2014/main" id="{518B1922-D75A-56CB-B320-E2D781EBC137}"/>
                    </a:ext>
                  </a:extLst>
                </p:cNvPr>
                <p:cNvGrpSpPr/>
                <p:nvPr/>
              </p:nvGrpSpPr>
              <p:grpSpPr>
                <a:xfrm>
                  <a:off x="2197100" y="6775450"/>
                  <a:ext cx="3886200" cy="2057400"/>
                  <a:chOff x="1054100" y="3879850"/>
                  <a:chExt cx="4572000" cy="2743200"/>
                </a:xfrm>
              </p:grpSpPr>
              <p:pic>
                <p:nvPicPr>
                  <p:cNvPr id="34" name="Picture 33">
                    <a:extLst>
                      <a:ext uri="{FF2B5EF4-FFF2-40B4-BE49-F238E27FC236}">
                        <a16:creationId xmlns:a16="http://schemas.microsoft.com/office/drawing/2014/main" id="{1AE09EBA-E394-67C0-F719-C8CC28CA067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5"/>
                  <a:srcRect l="7979" t="3212" r="22893" b="6056"/>
                  <a:stretch/>
                </p:blipFill>
                <p:spPr>
                  <a:xfrm>
                    <a:off x="1054100" y="4870450"/>
                    <a:ext cx="4023574" cy="1752600"/>
                  </a:xfrm>
                  <a:prstGeom prst="rect">
                    <a:avLst/>
                  </a:prstGeom>
                </p:spPr>
              </p:pic>
              <p:sp>
                <p:nvSpPr>
                  <p:cNvPr id="35" name="TextBox 34">
                    <a:extLst>
                      <a:ext uri="{FF2B5EF4-FFF2-40B4-BE49-F238E27FC236}">
                        <a16:creationId xmlns:a16="http://schemas.microsoft.com/office/drawing/2014/main" id="{665B57D5-3CDA-42FF-6A8A-24560BFA5E8F}"/>
                      </a:ext>
                    </a:extLst>
                  </p:cNvPr>
                  <p:cNvSpPr txBox="1"/>
                  <p:nvPr/>
                </p:nvSpPr>
                <p:spPr>
                  <a:xfrm>
                    <a:off x="1358900" y="4515208"/>
                    <a:ext cx="4038600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600" b="1" dirty="0"/>
                      <a:t>-         +      -       +        -      +     -       +</a:t>
                    </a:r>
                  </a:p>
                </p:txBody>
              </p:sp>
              <p:sp>
                <p:nvSpPr>
                  <p:cNvPr id="36" name="TextBox 35">
                    <a:extLst>
                      <a:ext uri="{FF2B5EF4-FFF2-40B4-BE49-F238E27FC236}">
                        <a16:creationId xmlns:a16="http://schemas.microsoft.com/office/drawing/2014/main" id="{8711DB53-0DF7-C23C-5732-7E382E60FCFA}"/>
                      </a:ext>
                    </a:extLst>
                  </p:cNvPr>
                  <p:cNvSpPr txBox="1"/>
                  <p:nvPr/>
                </p:nvSpPr>
                <p:spPr>
                  <a:xfrm>
                    <a:off x="1302662" y="4260850"/>
                    <a:ext cx="4323438" cy="45140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600" b="1" dirty="0"/>
                      <a:t>Vector     TWIST1    TWIST1  TWIST1-S68D</a:t>
                    </a:r>
                  </a:p>
                </p:txBody>
              </p:sp>
              <p:cxnSp>
                <p:nvCxnSpPr>
                  <p:cNvPr id="37" name="Straight Connector 36">
                    <a:extLst>
                      <a:ext uri="{FF2B5EF4-FFF2-40B4-BE49-F238E27FC236}">
                        <a16:creationId xmlns:a16="http://schemas.microsoft.com/office/drawing/2014/main" id="{AAFCCD0B-30C3-7572-B96C-FB51A04E7206}"/>
                      </a:ext>
                    </a:extLst>
                  </p:cNvPr>
                  <p:cNvCxnSpPr/>
                  <p:nvPr/>
                </p:nvCxnSpPr>
                <p:spPr>
                  <a:xfrm>
                    <a:off x="1358900" y="4260850"/>
                    <a:ext cx="1554480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8" name="TextBox 37">
                    <a:extLst>
                      <a:ext uri="{FF2B5EF4-FFF2-40B4-BE49-F238E27FC236}">
                        <a16:creationId xmlns:a16="http://schemas.microsoft.com/office/drawing/2014/main" id="{5AD03A3D-8D26-BF1E-6180-D22E7191C388}"/>
                      </a:ext>
                    </a:extLst>
                  </p:cNvPr>
                  <p:cNvSpPr txBox="1"/>
                  <p:nvPr/>
                </p:nvSpPr>
                <p:spPr>
                  <a:xfrm>
                    <a:off x="1460858" y="3904534"/>
                    <a:ext cx="1650642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600" b="1" dirty="0"/>
                      <a:t>ERK inhibitor</a:t>
                    </a:r>
                  </a:p>
                </p:txBody>
              </p:sp>
              <p:cxnSp>
                <p:nvCxnSpPr>
                  <p:cNvPr id="39" name="Straight Connector 38">
                    <a:extLst>
                      <a:ext uri="{FF2B5EF4-FFF2-40B4-BE49-F238E27FC236}">
                        <a16:creationId xmlns:a16="http://schemas.microsoft.com/office/drawing/2014/main" id="{83CF0F19-8BE4-C6C0-A661-52DD164D8E41}"/>
                      </a:ext>
                    </a:extLst>
                  </p:cNvPr>
                  <p:cNvCxnSpPr/>
                  <p:nvPr/>
                </p:nvCxnSpPr>
                <p:spPr>
                  <a:xfrm>
                    <a:off x="3187700" y="4260850"/>
                    <a:ext cx="2011680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0" name="TextBox 39">
                    <a:extLst>
                      <a:ext uri="{FF2B5EF4-FFF2-40B4-BE49-F238E27FC236}">
                        <a16:creationId xmlns:a16="http://schemas.microsoft.com/office/drawing/2014/main" id="{E5C55098-2813-26AD-6496-18CC2572C1BE}"/>
                      </a:ext>
                    </a:extLst>
                  </p:cNvPr>
                  <p:cNvSpPr txBox="1"/>
                  <p:nvPr/>
                </p:nvSpPr>
                <p:spPr>
                  <a:xfrm>
                    <a:off x="3594458" y="3879850"/>
                    <a:ext cx="1650642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600" b="1" dirty="0"/>
                      <a:t>MET TKI</a:t>
                    </a:r>
                  </a:p>
                </p:txBody>
              </p:sp>
            </p:grp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279C7BB5-42BF-B0D3-1496-DBBCF25816C7}"/>
                    </a:ext>
                  </a:extLst>
                </p:cNvPr>
                <p:cNvSpPr txBox="1"/>
                <p:nvPr/>
              </p:nvSpPr>
              <p:spPr>
                <a:xfrm>
                  <a:off x="1511300" y="7537450"/>
                  <a:ext cx="76200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b="1" dirty="0"/>
                    <a:t>Actin</a:t>
                  </a:r>
                </a:p>
              </p:txBody>
            </p:sp>
            <p:sp>
              <p:nvSpPr>
                <p:cNvPr id="32" name="Rectangle: Rounded Corners 31">
                  <a:extLst>
                    <a:ext uri="{FF2B5EF4-FFF2-40B4-BE49-F238E27FC236}">
                      <a16:creationId xmlns:a16="http://schemas.microsoft.com/office/drawing/2014/main" id="{3564D752-2DF0-04C8-04BA-A83178BE0407}"/>
                    </a:ext>
                  </a:extLst>
                </p:cNvPr>
                <p:cNvSpPr/>
                <p:nvPr/>
              </p:nvSpPr>
              <p:spPr>
                <a:xfrm>
                  <a:off x="2197100" y="8223250"/>
                  <a:ext cx="3352800" cy="376457"/>
                </a:xfrm>
                <a:prstGeom prst="roundRect">
                  <a:avLst/>
                </a:prstGeom>
                <a:noFill/>
                <a:ln w="28575"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33" name="Rectangle: Rounded Corners 32">
                  <a:extLst>
                    <a:ext uri="{FF2B5EF4-FFF2-40B4-BE49-F238E27FC236}">
                      <a16:creationId xmlns:a16="http://schemas.microsoft.com/office/drawing/2014/main" id="{AD11164D-D201-0157-2006-394755B511A2}"/>
                    </a:ext>
                  </a:extLst>
                </p:cNvPr>
                <p:cNvSpPr/>
                <p:nvPr/>
              </p:nvSpPr>
              <p:spPr>
                <a:xfrm>
                  <a:off x="2221164" y="7597610"/>
                  <a:ext cx="3352800" cy="376457"/>
                </a:xfrm>
                <a:prstGeom prst="roundRect">
                  <a:avLst/>
                </a:prstGeom>
                <a:noFill/>
                <a:ln w="28575"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50126765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0FBC7C5-F52E-9A9B-D88B-A242D961AC1E}"/>
              </a:ext>
            </a:extLst>
          </p:cNvPr>
          <p:cNvSpPr txBox="1"/>
          <p:nvPr/>
        </p:nvSpPr>
        <p:spPr>
          <a:xfrm>
            <a:off x="0" y="22627"/>
            <a:ext cx="43288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Western blot full image related to Figure 4 </a:t>
            </a:r>
          </a:p>
        </p:txBody>
      </p:sp>
      <p:grpSp>
        <p:nvGrpSpPr>
          <p:cNvPr id="35" name="Group 34">
            <a:extLst>
              <a:ext uri="{FF2B5EF4-FFF2-40B4-BE49-F238E27FC236}">
                <a16:creationId xmlns:a16="http://schemas.microsoft.com/office/drawing/2014/main" id="{84C818F3-34AB-A874-4F45-CF63E81D556B}"/>
              </a:ext>
            </a:extLst>
          </p:cNvPr>
          <p:cNvGrpSpPr/>
          <p:nvPr/>
        </p:nvGrpSpPr>
        <p:grpSpPr>
          <a:xfrm>
            <a:off x="2626228" y="603250"/>
            <a:ext cx="2494545" cy="3352800"/>
            <a:chOff x="73028" y="603250"/>
            <a:chExt cx="2962272" cy="3810000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F7D5C3E1-046C-C954-8AFE-0601EA2D92D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5400" r="21629" b="4771"/>
            <a:stretch/>
          </p:blipFill>
          <p:spPr>
            <a:xfrm>
              <a:off x="1054100" y="1289050"/>
              <a:ext cx="1371110" cy="3124200"/>
            </a:xfrm>
            <a:prstGeom prst="rect">
              <a:avLst/>
            </a:prstGeom>
          </p:spPr>
        </p:pic>
        <p:sp>
          <p:nvSpPr>
            <p:cNvPr id="5" name="Rectangle: Rounded Corners 20">
              <a:extLst>
                <a:ext uri="{FF2B5EF4-FFF2-40B4-BE49-F238E27FC236}">
                  <a16:creationId xmlns:a16="http://schemas.microsoft.com/office/drawing/2014/main" id="{CFF3B1DB-C8CA-ED66-9727-07890582971A}"/>
                </a:ext>
              </a:extLst>
            </p:cNvPr>
            <p:cNvSpPr/>
            <p:nvPr/>
          </p:nvSpPr>
          <p:spPr>
            <a:xfrm>
              <a:off x="1054100" y="1783813"/>
              <a:ext cx="1219200" cy="381000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28262D2-FE74-61A8-8A48-31083EDC1E23}"/>
                </a:ext>
              </a:extLst>
            </p:cNvPr>
            <p:cNvSpPr txBox="1"/>
            <p:nvPr/>
          </p:nvSpPr>
          <p:spPr>
            <a:xfrm>
              <a:off x="73028" y="3022141"/>
              <a:ext cx="1095375" cy="3847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TWIST1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11E8C2B-CA39-F367-DC4F-0381C198BDDE}"/>
                </a:ext>
              </a:extLst>
            </p:cNvPr>
            <p:cNvSpPr txBox="1"/>
            <p:nvPr/>
          </p:nvSpPr>
          <p:spPr>
            <a:xfrm>
              <a:off x="311148" y="1795105"/>
              <a:ext cx="914400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Actin</a:t>
              </a:r>
            </a:p>
          </p:txBody>
        </p:sp>
        <p:sp>
          <p:nvSpPr>
            <p:cNvPr id="8" name="Rectangle: Rounded Corners 20">
              <a:extLst>
                <a:ext uri="{FF2B5EF4-FFF2-40B4-BE49-F238E27FC236}">
                  <a16:creationId xmlns:a16="http://schemas.microsoft.com/office/drawing/2014/main" id="{0AD6F688-1FE6-62A9-7CE2-D6004C6C0EA4}"/>
                </a:ext>
              </a:extLst>
            </p:cNvPr>
            <p:cNvSpPr/>
            <p:nvPr/>
          </p:nvSpPr>
          <p:spPr>
            <a:xfrm>
              <a:off x="1054100" y="3042724"/>
              <a:ext cx="1219200" cy="381000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C6645C5-102F-2731-05E1-A9F4C073E67C}"/>
                </a:ext>
              </a:extLst>
            </p:cNvPr>
            <p:cNvSpPr txBox="1"/>
            <p:nvPr/>
          </p:nvSpPr>
          <p:spPr>
            <a:xfrm>
              <a:off x="749300" y="984250"/>
              <a:ext cx="2286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Control   TWIST1</a:t>
              </a:r>
            </a:p>
          </p:txBody>
        </p: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0271B8A6-B34E-8D8C-7988-491AB73715D3}"/>
                </a:ext>
              </a:extLst>
            </p:cNvPr>
            <p:cNvCxnSpPr/>
            <p:nvPr/>
          </p:nvCxnSpPr>
          <p:spPr>
            <a:xfrm>
              <a:off x="871220" y="1001675"/>
              <a:ext cx="155448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734C69EC-4203-4377-157B-3054DB75AB7E}"/>
                </a:ext>
              </a:extLst>
            </p:cNvPr>
            <p:cNvSpPr txBox="1"/>
            <p:nvPr/>
          </p:nvSpPr>
          <p:spPr>
            <a:xfrm>
              <a:off x="1358900" y="603250"/>
              <a:ext cx="8382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H596</a:t>
              </a:r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D4C0077C-1EEB-D0CF-CB93-13C92A0180BE}"/>
              </a:ext>
            </a:extLst>
          </p:cNvPr>
          <p:cNvGrpSpPr/>
          <p:nvPr/>
        </p:nvGrpSpPr>
        <p:grpSpPr>
          <a:xfrm>
            <a:off x="366658" y="627934"/>
            <a:ext cx="2363842" cy="1889451"/>
            <a:chOff x="2983243" y="627934"/>
            <a:chExt cx="2807062" cy="2147103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571AC455-6043-9740-FAEF-4ECA8736B29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1762" t="8665" r="26341" b="55044"/>
            <a:stretch/>
          </p:blipFill>
          <p:spPr>
            <a:xfrm>
              <a:off x="3961505" y="2139055"/>
              <a:ext cx="1399161" cy="635982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F302FA9A-E832-E9B7-3208-97268D825F7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lum contrast="17000"/>
            </a:blip>
            <a:srcRect l="27613" t="16951" r="31228" b="46643"/>
            <a:stretch/>
          </p:blipFill>
          <p:spPr>
            <a:xfrm>
              <a:off x="3961505" y="1398170"/>
              <a:ext cx="1399161" cy="655062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845EF6DD-08AE-BEBA-CBFF-84CC9237103A}"/>
                </a:ext>
              </a:extLst>
            </p:cNvPr>
            <p:cNvSpPr txBox="1"/>
            <p:nvPr/>
          </p:nvSpPr>
          <p:spPr>
            <a:xfrm>
              <a:off x="3784421" y="1021813"/>
              <a:ext cx="200588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Control   TWIST1 </a:t>
              </a:r>
            </a:p>
          </p:txBody>
        </p: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339146BF-7AF3-92FE-BCFE-A8526AE0EC49}"/>
                </a:ext>
              </a:extLst>
            </p:cNvPr>
            <p:cNvCxnSpPr/>
            <p:nvPr/>
          </p:nvCxnSpPr>
          <p:spPr>
            <a:xfrm>
              <a:off x="3821984" y="1008934"/>
              <a:ext cx="155448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CC1AF8A6-BC3C-3C2E-D677-DE8C0E3C82D5}"/>
                </a:ext>
              </a:extLst>
            </p:cNvPr>
            <p:cNvSpPr txBox="1"/>
            <p:nvPr/>
          </p:nvSpPr>
          <p:spPr>
            <a:xfrm>
              <a:off x="4266305" y="627934"/>
              <a:ext cx="1143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H1437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6CC6F1C5-05E1-D250-6230-E894A0895998}"/>
                </a:ext>
              </a:extLst>
            </p:cNvPr>
            <p:cNvSpPr txBox="1"/>
            <p:nvPr/>
          </p:nvSpPr>
          <p:spPr>
            <a:xfrm>
              <a:off x="2983243" y="2265697"/>
              <a:ext cx="99229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TWIST1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13801797-3EC6-017F-2FE4-70F6DD6CACFC}"/>
                </a:ext>
              </a:extLst>
            </p:cNvPr>
            <p:cNvSpPr txBox="1"/>
            <p:nvPr/>
          </p:nvSpPr>
          <p:spPr>
            <a:xfrm>
              <a:off x="3022954" y="1541260"/>
              <a:ext cx="99229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GAPDH</a:t>
              </a:r>
            </a:p>
          </p:txBody>
        </p:sp>
        <p:sp>
          <p:nvSpPr>
            <p:cNvPr id="22" name="Rectangle: Rounded Corners 20">
              <a:extLst>
                <a:ext uri="{FF2B5EF4-FFF2-40B4-BE49-F238E27FC236}">
                  <a16:creationId xmlns:a16="http://schemas.microsoft.com/office/drawing/2014/main" id="{04D5F491-4895-C2C2-CE0E-14705CCE2526}"/>
                </a:ext>
              </a:extLst>
            </p:cNvPr>
            <p:cNvSpPr/>
            <p:nvPr/>
          </p:nvSpPr>
          <p:spPr>
            <a:xfrm>
              <a:off x="3980554" y="2279650"/>
              <a:ext cx="1416945" cy="381000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  <p:sp>
          <p:nvSpPr>
            <p:cNvPr id="23" name="Rectangle: Rounded Corners 20">
              <a:extLst>
                <a:ext uri="{FF2B5EF4-FFF2-40B4-BE49-F238E27FC236}">
                  <a16:creationId xmlns:a16="http://schemas.microsoft.com/office/drawing/2014/main" id="{5133D086-0C5A-620F-C04F-5386CE573F5C}"/>
                </a:ext>
              </a:extLst>
            </p:cNvPr>
            <p:cNvSpPr/>
            <p:nvPr/>
          </p:nvSpPr>
          <p:spPr>
            <a:xfrm>
              <a:off x="3966266" y="1568092"/>
              <a:ext cx="1404065" cy="381000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</p:grpSp>
      <p:grpSp>
        <p:nvGrpSpPr>
          <p:cNvPr id="34" name="Group 33">
            <a:extLst>
              <a:ext uri="{FF2B5EF4-FFF2-40B4-BE49-F238E27FC236}">
                <a16:creationId xmlns:a16="http://schemas.microsoft.com/office/drawing/2014/main" id="{F54FCB98-7904-4A04-9578-5725393B565B}"/>
              </a:ext>
            </a:extLst>
          </p:cNvPr>
          <p:cNvGrpSpPr/>
          <p:nvPr/>
        </p:nvGrpSpPr>
        <p:grpSpPr>
          <a:xfrm>
            <a:off x="4940300" y="603251"/>
            <a:ext cx="2467550" cy="3161076"/>
            <a:chOff x="3953721" y="3564319"/>
            <a:chExt cx="2930216" cy="3592131"/>
          </a:xfrm>
        </p:grpSpPr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E07B2531-8B2C-E8DC-7E38-EA49EE6FA8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2813" t="2577" r="22233" b="15646"/>
            <a:stretch/>
          </p:blipFill>
          <p:spPr>
            <a:xfrm>
              <a:off x="4940300" y="4260850"/>
              <a:ext cx="1126936" cy="2895600"/>
            </a:xfrm>
            <a:prstGeom prst="rect">
              <a:avLst/>
            </a:prstGeom>
          </p:spPr>
        </p:pic>
        <p:sp>
          <p:nvSpPr>
            <p:cNvPr id="27" name="Rectangle: Rounded Corners 20">
              <a:extLst>
                <a:ext uri="{FF2B5EF4-FFF2-40B4-BE49-F238E27FC236}">
                  <a16:creationId xmlns:a16="http://schemas.microsoft.com/office/drawing/2014/main" id="{266E0286-71E7-1816-E896-7BAB3A4C4A83}"/>
                </a:ext>
              </a:extLst>
            </p:cNvPr>
            <p:cNvSpPr/>
            <p:nvPr/>
          </p:nvSpPr>
          <p:spPr>
            <a:xfrm>
              <a:off x="4927421" y="4616092"/>
              <a:ext cx="1143000" cy="381000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8695357D-776D-03CE-85AB-1E8EDB13B6DC}"/>
                </a:ext>
              </a:extLst>
            </p:cNvPr>
            <p:cNvSpPr txBox="1"/>
            <p:nvPr/>
          </p:nvSpPr>
          <p:spPr>
            <a:xfrm>
              <a:off x="3953721" y="5785876"/>
              <a:ext cx="1090075" cy="3847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TWIST1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C66F1703-919B-3287-E895-363F803BC2EE}"/>
                </a:ext>
              </a:extLst>
            </p:cNvPr>
            <p:cNvSpPr txBox="1"/>
            <p:nvPr/>
          </p:nvSpPr>
          <p:spPr>
            <a:xfrm>
              <a:off x="4153745" y="4641849"/>
              <a:ext cx="9144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Actin</a:t>
              </a:r>
            </a:p>
          </p:txBody>
        </p:sp>
        <p:sp>
          <p:nvSpPr>
            <p:cNvPr id="30" name="Rectangle: Rounded Corners 20">
              <a:extLst>
                <a:ext uri="{FF2B5EF4-FFF2-40B4-BE49-F238E27FC236}">
                  <a16:creationId xmlns:a16="http://schemas.microsoft.com/office/drawing/2014/main" id="{DF80C0CE-5CE8-F718-13B7-43C032DEBA07}"/>
                </a:ext>
              </a:extLst>
            </p:cNvPr>
            <p:cNvSpPr/>
            <p:nvPr/>
          </p:nvSpPr>
          <p:spPr>
            <a:xfrm>
              <a:off x="4964984" y="5747287"/>
              <a:ext cx="1066800" cy="381000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E44D37A2-2EA8-54A4-B64F-1ECFB93B78C4}"/>
                </a:ext>
              </a:extLst>
            </p:cNvPr>
            <p:cNvSpPr txBox="1"/>
            <p:nvPr/>
          </p:nvSpPr>
          <p:spPr>
            <a:xfrm>
              <a:off x="4597937" y="3945319"/>
              <a:ext cx="2286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Control  TWIST1</a:t>
              </a:r>
            </a:p>
          </p:txBody>
        </p: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49060472-09C6-B6CB-0FF4-DAACC66DE239}"/>
                </a:ext>
              </a:extLst>
            </p:cNvPr>
            <p:cNvCxnSpPr/>
            <p:nvPr/>
          </p:nvCxnSpPr>
          <p:spPr>
            <a:xfrm>
              <a:off x="4719857" y="3962744"/>
              <a:ext cx="155448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707073B4-8491-B410-5598-EC1FCEE8FEF2}"/>
                </a:ext>
              </a:extLst>
            </p:cNvPr>
            <p:cNvSpPr txBox="1"/>
            <p:nvPr/>
          </p:nvSpPr>
          <p:spPr>
            <a:xfrm>
              <a:off x="5048565" y="3564319"/>
              <a:ext cx="1125764" cy="3847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H1993</a:t>
              </a:r>
            </a:p>
          </p:txBody>
        </p:sp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id="{D2AB444E-E9BC-899E-F793-B1C055F3EFDA}"/>
              </a:ext>
            </a:extLst>
          </p:cNvPr>
          <p:cNvSpPr txBox="1"/>
          <p:nvPr/>
        </p:nvSpPr>
        <p:spPr>
          <a:xfrm>
            <a:off x="79064" y="374650"/>
            <a:ext cx="7363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.                                                B.                                        C.</a:t>
            </a: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6970C0BE-8814-C445-6796-DD95F2120F7C}"/>
              </a:ext>
            </a:extLst>
          </p:cNvPr>
          <p:cNvGrpSpPr/>
          <p:nvPr/>
        </p:nvGrpSpPr>
        <p:grpSpPr>
          <a:xfrm>
            <a:off x="368300" y="4946650"/>
            <a:ext cx="5056727" cy="3581399"/>
            <a:chOff x="296104" y="4946651"/>
            <a:chExt cx="5056727" cy="3581399"/>
          </a:xfrm>
        </p:grpSpPr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E4D13177-1827-E066-DC18-88705869F1CF}"/>
                </a:ext>
              </a:extLst>
            </p:cNvPr>
            <p:cNvSpPr txBox="1"/>
            <p:nvPr/>
          </p:nvSpPr>
          <p:spPr>
            <a:xfrm>
              <a:off x="296104" y="5754193"/>
              <a:ext cx="48006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    Capmatinib (</a:t>
              </a:r>
              <a:r>
                <a:rPr lang="en-US" sz="1600" b="1" dirty="0" err="1"/>
                <a:t>nM</a:t>
              </a:r>
              <a:r>
                <a:rPr lang="en-US" sz="1600" b="1" dirty="0"/>
                <a:t>)      0        5        10       0        5        10</a:t>
              </a:r>
            </a:p>
          </p:txBody>
        </p: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92B71164-2B03-D3DF-86ED-3D6DD6D554F7}"/>
                </a:ext>
              </a:extLst>
            </p:cNvPr>
            <p:cNvGrpSpPr/>
            <p:nvPr/>
          </p:nvGrpSpPr>
          <p:grpSpPr>
            <a:xfrm>
              <a:off x="1282700" y="4946651"/>
              <a:ext cx="4070131" cy="3581399"/>
              <a:chOff x="1282700" y="4946651"/>
              <a:chExt cx="4070131" cy="3581399"/>
            </a:xfrm>
          </p:grpSpPr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66343826-FC5D-988A-9F64-D4F19FE8DBD5}"/>
                  </a:ext>
                </a:extLst>
              </p:cNvPr>
              <p:cNvSpPr txBox="1"/>
              <p:nvPr/>
            </p:nvSpPr>
            <p:spPr>
              <a:xfrm>
                <a:off x="1358900" y="6688201"/>
                <a:ext cx="78795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/>
                  <a:t>Twist 1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74357236-3129-95D0-11A8-BD84EB42DC3C}"/>
                  </a:ext>
                </a:extLst>
              </p:cNvPr>
              <p:cNvSpPr txBox="1"/>
              <p:nvPr/>
            </p:nvSpPr>
            <p:spPr>
              <a:xfrm>
                <a:off x="1282700" y="6098163"/>
                <a:ext cx="94781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/>
                  <a:t>cl-PARP</a:t>
                </a:r>
              </a:p>
            </p:txBody>
          </p:sp>
          <p:pic>
            <p:nvPicPr>
              <p:cNvPr id="41" name="Picture 40">
                <a:extLst>
                  <a:ext uri="{FF2B5EF4-FFF2-40B4-BE49-F238E27FC236}">
                    <a16:creationId xmlns:a16="http://schemas.microsoft.com/office/drawing/2014/main" id="{288CCA2E-E773-36E0-9A10-8252B43AFD5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9994" t="24406" r="5201" b="35708"/>
              <a:stretch/>
            </p:blipFill>
            <p:spPr>
              <a:xfrm>
                <a:off x="2167251" y="6605247"/>
                <a:ext cx="2924348" cy="498173"/>
              </a:xfrm>
              <a:prstGeom prst="rect">
                <a:avLst/>
              </a:prstGeom>
            </p:spPr>
          </p:pic>
          <p:pic>
            <p:nvPicPr>
              <p:cNvPr id="42" name="Picture 41">
                <a:extLst>
                  <a:ext uri="{FF2B5EF4-FFF2-40B4-BE49-F238E27FC236}">
                    <a16:creationId xmlns:a16="http://schemas.microsoft.com/office/drawing/2014/main" id="{7AC2EDDA-9497-A706-ECB6-E4434BC0935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11744" t="10150" r="6162" b="51177"/>
              <a:stretch/>
            </p:blipFill>
            <p:spPr>
              <a:xfrm>
                <a:off x="2156983" y="6064785"/>
                <a:ext cx="2927600" cy="478827"/>
              </a:xfrm>
              <a:prstGeom prst="rect">
                <a:avLst/>
              </a:prstGeom>
            </p:spPr>
          </p:pic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BD18DA10-E156-1F0B-5DB2-B95B7A16B264}"/>
                  </a:ext>
                </a:extLst>
              </p:cNvPr>
              <p:cNvSpPr txBox="1"/>
              <p:nvPr/>
            </p:nvSpPr>
            <p:spPr>
              <a:xfrm>
                <a:off x="1697176" y="7229024"/>
                <a:ext cx="580055" cy="2759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/>
                  <a:t>p27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0F9F7BC8-0B1B-DACD-E54E-E474547F09A3}"/>
                  </a:ext>
                </a:extLst>
              </p:cNvPr>
              <p:cNvSpPr txBox="1"/>
              <p:nvPr/>
            </p:nvSpPr>
            <p:spPr>
              <a:xfrm>
                <a:off x="2120900" y="5381481"/>
                <a:ext cx="323193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/>
                  <a:t>     W118 </a:t>
                </a:r>
                <a:r>
                  <a:rPr lang="el-GR" sz="1600" b="1" dirty="0"/>
                  <a:t>Δ</a:t>
                </a:r>
                <a:r>
                  <a:rPr lang="en-US" sz="1600" b="1" dirty="0"/>
                  <a:t>                W118 TWIST1</a:t>
                </a:r>
              </a:p>
            </p:txBody>
          </p:sp>
          <p:cxnSp>
            <p:nvCxnSpPr>
              <p:cNvPr id="45" name="Straight Connector 44">
                <a:extLst>
                  <a:ext uri="{FF2B5EF4-FFF2-40B4-BE49-F238E27FC236}">
                    <a16:creationId xmlns:a16="http://schemas.microsoft.com/office/drawing/2014/main" id="{D5FB7389-13C5-AD31-0929-5F2D15E9304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247436" y="5319362"/>
                <a:ext cx="2704896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Straight Connector 45">
                <a:extLst>
                  <a:ext uri="{FF2B5EF4-FFF2-40B4-BE49-F238E27FC236}">
                    <a16:creationId xmlns:a16="http://schemas.microsoft.com/office/drawing/2014/main" id="{60577434-1E51-54EE-7280-B252633027B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241769" y="5692074"/>
                <a:ext cx="1169685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Straight Connector 46">
                <a:extLst>
                  <a:ext uri="{FF2B5EF4-FFF2-40B4-BE49-F238E27FC236}">
                    <a16:creationId xmlns:a16="http://schemas.microsoft.com/office/drawing/2014/main" id="{DBB36165-00D0-0A2E-7B04-E0A413E9BD5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716059" y="5692074"/>
                <a:ext cx="1023474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BAC8A5AC-3DCB-501E-DCA0-9724E3E895B3}"/>
                  </a:ext>
                </a:extLst>
              </p:cNvPr>
              <p:cNvSpPr txBox="1"/>
              <p:nvPr/>
            </p:nvSpPr>
            <p:spPr>
              <a:xfrm>
                <a:off x="3340100" y="4946651"/>
                <a:ext cx="913816" cy="2759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/>
                  <a:t>H1993</a:t>
                </a:r>
              </a:p>
            </p:txBody>
          </p:sp>
          <p:pic>
            <p:nvPicPr>
              <p:cNvPr id="52" name="Picture 51">
                <a:extLst>
                  <a:ext uri="{FF2B5EF4-FFF2-40B4-BE49-F238E27FC236}">
                    <a16:creationId xmlns:a16="http://schemas.microsoft.com/office/drawing/2014/main" id="{7B48A15E-5FC3-8ECA-D818-D5974D5D574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8924" t="25544" r="23188" b="27802"/>
              <a:stretch/>
            </p:blipFill>
            <p:spPr>
              <a:xfrm>
                <a:off x="2180848" y="7870354"/>
                <a:ext cx="2885867" cy="657696"/>
              </a:xfrm>
              <a:prstGeom prst="rect">
                <a:avLst/>
              </a:prstGeom>
            </p:spPr>
          </p:pic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6861DBF5-C698-0599-1C2E-2A09F5166DFE}"/>
                  </a:ext>
                </a:extLst>
              </p:cNvPr>
              <p:cNvSpPr txBox="1"/>
              <p:nvPr/>
            </p:nvSpPr>
            <p:spPr>
              <a:xfrm>
                <a:off x="1554321" y="8047687"/>
                <a:ext cx="650717" cy="2759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/>
                  <a:t>Actin</a:t>
                </a:r>
              </a:p>
            </p:txBody>
          </p:sp>
          <p:pic>
            <p:nvPicPr>
              <p:cNvPr id="54" name="Picture 53">
                <a:extLst>
                  <a:ext uri="{FF2B5EF4-FFF2-40B4-BE49-F238E27FC236}">
                    <a16:creationId xmlns:a16="http://schemas.microsoft.com/office/drawing/2014/main" id="{B5AC51C2-B49F-8C74-E465-C4E7879101D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12788" t="33956" r="6159" b="38361"/>
              <a:stretch/>
            </p:blipFill>
            <p:spPr>
              <a:xfrm>
                <a:off x="2180890" y="7187049"/>
                <a:ext cx="2939884" cy="585048"/>
              </a:xfrm>
              <a:prstGeom prst="rect">
                <a:avLst/>
              </a:prstGeom>
            </p:spPr>
          </p:pic>
          <p:sp>
            <p:nvSpPr>
              <p:cNvPr id="61" name="Rectangle: Rounded Corners 20">
                <a:extLst>
                  <a:ext uri="{FF2B5EF4-FFF2-40B4-BE49-F238E27FC236}">
                    <a16:creationId xmlns:a16="http://schemas.microsoft.com/office/drawing/2014/main" id="{07083F25-C2EA-BED3-50C3-996A6E9BF6A8}"/>
                  </a:ext>
                </a:extLst>
              </p:cNvPr>
              <p:cNvSpPr/>
              <p:nvPr/>
            </p:nvSpPr>
            <p:spPr>
              <a:xfrm>
                <a:off x="2168055" y="6126904"/>
                <a:ext cx="2924212" cy="310593"/>
              </a:xfrm>
              <a:prstGeom prst="roundRect">
                <a:avLst/>
              </a:prstGeom>
              <a:noFill/>
              <a:ln w="285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 b="1" dirty="0"/>
              </a:p>
            </p:txBody>
          </p:sp>
          <p:sp>
            <p:nvSpPr>
              <p:cNvPr id="62" name="Rectangle: Rounded Corners 20">
                <a:extLst>
                  <a:ext uri="{FF2B5EF4-FFF2-40B4-BE49-F238E27FC236}">
                    <a16:creationId xmlns:a16="http://schemas.microsoft.com/office/drawing/2014/main" id="{2BA85945-7B11-27EE-0538-7D3B6F589045}"/>
                  </a:ext>
                </a:extLst>
              </p:cNvPr>
              <p:cNvSpPr/>
              <p:nvPr/>
            </p:nvSpPr>
            <p:spPr>
              <a:xfrm>
                <a:off x="2169937" y="6697097"/>
                <a:ext cx="2924212" cy="310593"/>
              </a:xfrm>
              <a:prstGeom prst="roundRect">
                <a:avLst/>
              </a:prstGeom>
              <a:noFill/>
              <a:ln w="285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 b="1" dirty="0"/>
              </a:p>
            </p:txBody>
          </p:sp>
          <p:sp>
            <p:nvSpPr>
              <p:cNvPr id="63" name="Rectangle: Rounded Corners 20">
                <a:extLst>
                  <a:ext uri="{FF2B5EF4-FFF2-40B4-BE49-F238E27FC236}">
                    <a16:creationId xmlns:a16="http://schemas.microsoft.com/office/drawing/2014/main" id="{F83BA2B7-B2CB-EAA7-8970-7013C26F0EF4}"/>
                  </a:ext>
                </a:extLst>
              </p:cNvPr>
              <p:cNvSpPr/>
              <p:nvPr/>
            </p:nvSpPr>
            <p:spPr>
              <a:xfrm>
                <a:off x="2171754" y="7245038"/>
                <a:ext cx="2924212" cy="310593"/>
              </a:xfrm>
              <a:prstGeom prst="roundRect">
                <a:avLst/>
              </a:prstGeom>
              <a:noFill/>
              <a:ln w="285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 b="1" dirty="0"/>
              </a:p>
            </p:txBody>
          </p:sp>
          <p:sp>
            <p:nvSpPr>
              <p:cNvPr id="64" name="Rectangle: Rounded Corners 20">
                <a:extLst>
                  <a:ext uri="{FF2B5EF4-FFF2-40B4-BE49-F238E27FC236}">
                    <a16:creationId xmlns:a16="http://schemas.microsoft.com/office/drawing/2014/main" id="{3A16F362-32EB-C377-72A0-46C24139606C}"/>
                  </a:ext>
                </a:extLst>
              </p:cNvPr>
              <p:cNvSpPr/>
              <p:nvPr/>
            </p:nvSpPr>
            <p:spPr>
              <a:xfrm>
                <a:off x="2137474" y="8034965"/>
                <a:ext cx="2924212" cy="310593"/>
              </a:xfrm>
              <a:prstGeom prst="roundRect">
                <a:avLst/>
              </a:prstGeom>
              <a:noFill/>
              <a:ln w="285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 b="1" dirty="0"/>
              </a:p>
            </p:txBody>
          </p:sp>
        </p:grp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AD1A1433-8D8F-3402-0275-76840E948103}"/>
              </a:ext>
            </a:extLst>
          </p:cNvPr>
          <p:cNvSpPr txBox="1"/>
          <p:nvPr/>
        </p:nvSpPr>
        <p:spPr>
          <a:xfrm>
            <a:off x="82550" y="48133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J.                                </a:t>
            </a:r>
          </a:p>
        </p:txBody>
      </p:sp>
    </p:spTree>
    <p:extLst>
      <p:ext uri="{BB962C8B-B14F-4D97-AF65-F5344CB8AC3E}">
        <p14:creationId xmlns:p14="http://schemas.microsoft.com/office/powerpoint/2010/main" val="377405707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Group 41">
            <a:extLst>
              <a:ext uri="{FF2B5EF4-FFF2-40B4-BE49-F238E27FC236}">
                <a16:creationId xmlns:a16="http://schemas.microsoft.com/office/drawing/2014/main" id="{688DA036-C315-3035-C46D-FF8674FC96FF}"/>
              </a:ext>
            </a:extLst>
          </p:cNvPr>
          <p:cNvGrpSpPr/>
          <p:nvPr/>
        </p:nvGrpSpPr>
        <p:grpSpPr>
          <a:xfrm>
            <a:off x="444500" y="222250"/>
            <a:ext cx="4757383" cy="4879072"/>
            <a:chOff x="-380341" y="318354"/>
            <a:chExt cx="5771257" cy="5599846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7F2057F9-AEDF-68A8-FC61-601D4C441B2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3150" t="5657" r="7547" b="22378"/>
            <a:stretch/>
          </p:blipFill>
          <p:spPr>
            <a:xfrm>
              <a:off x="1663700" y="3727450"/>
              <a:ext cx="3200400" cy="1219200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B45D334F-6E8E-A933-2CBD-422A12DBAE7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6789" t="23809" r="14769" b="47102"/>
            <a:stretch/>
          </p:blipFill>
          <p:spPr>
            <a:xfrm>
              <a:off x="1657350" y="5054600"/>
              <a:ext cx="3207476" cy="863600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66315FDC-4F43-5CC4-F79C-7C975C12DB0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0656" r="16977" b="70133"/>
            <a:stretch/>
          </p:blipFill>
          <p:spPr>
            <a:xfrm>
              <a:off x="1663700" y="1539454"/>
              <a:ext cx="3200399" cy="1121196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8CABFBBC-B250-13D5-D58A-8CA58A68B45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7941" t="19123" r="33786" b="19643"/>
            <a:stretch/>
          </p:blipFill>
          <p:spPr>
            <a:xfrm>
              <a:off x="1663700" y="2726389"/>
              <a:ext cx="3200400" cy="943911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D47BC60C-C63D-03C8-0466-609E68106F37}"/>
                </a:ext>
              </a:extLst>
            </p:cNvPr>
            <p:cNvSpPr txBox="1"/>
            <p:nvPr/>
          </p:nvSpPr>
          <p:spPr>
            <a:xfrm>
              <a:off x="481975" y="2984499"/>
              <a:ext cx="1208521" cy="3974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TWIST1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8F52E95-6021-C775-50BC-BAC784092154}"/>
                </a:ext>
              </a:extLst>
            </p:cNvPr>
            <p:cNvSpPr txBox="1"/>
            <p:nvPr/>
          </p:nvSpPr>
          <p:spPr>
            <a:xfrm>
              <a:off x="574415" y="2031360"/>
              <a:ext cx="1259715" cy="3885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cl-PARP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24A1674-70D8-1CEA-096B-1E05CFF7AA3A}"/>
                </a:ext>
              </a:extLst>
            </p:cNvPr>
            <p:cNvSpPr txBox="1"/>
            <p:nvPr/>
          </p:nvSpPr>
          <p:spPr>
            <a:xfrm>
              <a:off x="1036611" y="4222750"/>
              <a:ext cx="72553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p27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837866C-D371-F4F0-8982-3157923780C9}"/>
                </a:ext>
              </a:extLst>
            </p:cNvPr>
            <p:cNvSpPr txBox="1"/>
            <p:nvPr/>
          </p:nvSpPr>
          <p:spPr>
            <a:xfrm>
              <a:off x="1733316" y="773434"/>
              <a:ext cx="3657600" cy="3885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     W118 </a:t>
              </a:r>
              <a:r>
                <a:rPr lang="el-GR" sz="1600" b="1" dirty="0"/>
                <a:t>Δ</a:t>
              </a:r>
              <a:r>
                <a:rPr lang="en-US" sz="1600" b="1" dirty="0"/>
                <a:t>              W118 TWIST1</a:t>
              </a:r>
            </a:p>
          </p:txBody>
        </p: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B9CFBABE-61D4-CC55-8891-B5D2CFA50DB3}"/>
                </a:ext>
              </a:extLst>
            </p:cNvPr>
            <p:cNvCxnSpPr>
              <a:cxnSpLocks/>
            </p:cNvCxnSpPr>
            <p:nvPr/>
          </p:nvCxnSpPr>
          <p:spPr>
            <a:xfrm>
              <a:off x="1739901" y="712899"/>
              <a:ext cx="310896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121C4601-6B5E-14A5-0C7D-AF48796F6402}"/>
                </a:ext>
              </a:extLst>
            </p:cNvPr>
            <p:cNvCxnSpPr>
              <a:cxnSpLocks/>
            </p:cNvCxnSpPr>
            <p:nvPr/>
          </p:nvCxnSpPr>
          <p:spPr>
            <a:xfrm>
              <a:off x="1873249" y="1185764"/>
              <a:ext cx="1463041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5DEF638E-DAAC-CA46-049A-FD4759EC4AF6}"/>
                </a:ext>
              </a:extLst>
            </p:cNvPr>
            <p:cNvCxnSpPr>
              <a:cxnSpLocks/>
            </p:cNvCxnSpPr>
            <p:nvPr/>
          </p:nvCxnSpPr>
          <p:spPr>
            <a:xfrm>
              <a:off x="3564890" y="1185764"/>
              <a:ext cx="128016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C10FAE3A-3E27-977C-9C9E-74714BC28EC6}"/>
                </a:ext>
              </a:extLst>
            </p:cNvPr>
            <p:cNvSpPr txBox="1"/>
            <p:nvPr/>
          </p:nvSpPr>
          <p:spPr>
            <a:xfrm>
              <a:off x="-380341" y="1212850"/>
              <a:ext cx="5638800" cy="3885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    </a:t>
              </a:r>
              <a:r>
                <a:rPr lang="en-US" sz="1600" b="1" dirty="0" err="1"/>
                <a:t>Tepotinib</a:t>
              </a:r>
              <a:r>
                <a:rPr lang="en-US" sz="1600" b="1" dirty="0"/>
                <a:t> (µM)          0      1      2.5     0     1     2.5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C15693CC-BFE8-0889-2EE0-B93CA0FCD96F}"/>
                </a:ext>
              </a:extLst>
            </p:cNvPr>
            <p:cNvSpPr txBox="1"/>
            <p:nvPr/>
          </p:nvSpPr>
          <p:spPr>
            <a:xfrm>
              <a:off x="2959100" y="318354"/>
              <a:ext cx="1143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H596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CA55D5EE-E8DD-620D-9205-89DF36511B89}"/>
                </a:ext>
              </a:extLst>
            </p:cNvPr>
            <p:cNvSpPr txBox="1"/>
            <p:nvPr/>
          </p:nvSpPr>
          <p:spPr>
            <a:xfrm>
              <a:off x="851733" y="5289550"/>
              <a:ext cx="81391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Actin</a:t>
              </a:r>
            </a:p>
          </p:txBody>
        </p:sp>
        <p:sp>
          <p:nvSpPr>
            <p:cNvPr id="24" name="Rectangle: Rounded Corners 23">
              <a:extLst>
                <a:ext uri="{FF2B5EF4-FFF2-40B4-BE49-F238E27FC236}">
                  <a16:creationId xmlns:a16="http://schemas.microsoft.com/office/drawing/2014/main" id="{8A5A8FFC-5ADD-A5B9-0B47-74F4D85B8BC5}"/>
                </a:ext>
              </a:extLst>
            </p:cNvPr>
            <p:cNvSpPr/>
            <p:nvPr/>
          </p:nvSpPr>
          <p:spPr>
            <a:xfrm>
              <a:off x="1626224" y="5327650"/>
              <a:ext cx="3200400" cy="304800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  <p:sp>
          <p:nvSpPr>
            <p:cNvPr id="26" name="Rectangle: Rounded Corners 25">
              <a:extLst>
                <a:ext uri="{FF2B5EF4-FFF2-40B4-BE49-F238E27FC236}">
                  <a16:creationId xmlns:a16="http://schemas.microsoft.com/office/drawing/2014/main" id="{2A7D8791-FC58-455D-CEB2-E32ECCB85FEA}"/>
                </a:ext>
              </a:extLst>
            </p:cNvPr>
            <p:cNvSpPr/>
            <p:nvPr/>
          </p:nvSpPr>
          <p:spPr>
            <a:xfrm>
              <a:off x="1682750" y="4222750"/>
              <a:ext cx="3200400" cy="304800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  <p:sp>
          <p:nvSpPr>
            <p:cNvPr id="27" name="Rectangle: Rounded Corners 26">
              <a:extLst>
                <a:ext uri="{FF2B5EF4-FFF2-40B4-BE49-F238E27FC236}">
                  <a16:creationId xmlns:a16="http://schemas.microsoft.com/office/drawing/2014/main" id="{D47EE8A1-DD93-BD31-E306-430278893743}"/>
                </a:ext>
              </a:extLst>
            </p:cNvPr>
            <p:cNvSpPr/>
            <p:nvPr/>
          </p:nvSpPr>
          <p:spPr>
            <a:xfrm>
              <a:off x="1644650" y="3041650"/>
              <a:ext cx="3200400" cy="304800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  <p:sp>
          <p:nvSpPr>
            <p:cNvPr id="28" name="Rectangle: Rounded Corners 27">
              <a:extLst>
                <a:ext uri="{FF2B5EF4-FFF2-40B4-BE49-F238E27FC236}">
                  <a16:creationId xmlns:a16="http://schemas.microsoft.com/office/drawing/2014/main" id="{CDAD8D63-5834-9607-A89F-45D2EEA6F518}"/>
                </a:ext>
              </a:extLst>
            </p:cNvPr>
            <p:cNvSpPr/>
            <p:nvPr/>
          </p:nvSpPr>
          <p:spPr>
            <a:xfrm>
              <a:off x="1682750" y="1936750"/>
              <a:ext cx="3200400" cy="457200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</p:grpSp>
      <p:sp>
        <p:nvSpPr>
          <p:cNvPr id="43" name="TextBox 42">
            <a:extLst>
              <a:ext uri="{FF2B5EF4-FFF2-40B4-BE49-F238E27FC236}">
                <a16:creationId xmlns:a16="http://schemas.microsoft.com/office/drawing/2014/main" id="{7E7E787B-030F-473D-5955-C721124B4651}"/>
              </a:ext>
            </a:extLst>
          </p:cNvPr>
          <p:cNvSpPr txBox="1"/>
          <p:nvPr/>
        </p:nvSpPr>
        <p:spPr>
          <a:xfrm>
            <a:off x="25400" y="13284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K.                                </a:t>
            </a:r>
          </a:p>
        </p:txBody>
      </p:sp>
    </p:spTree>
    <p:extLst>
      <p:ext uri="{BB962C8B-B14F-4D97-AF65-F5344CB8AC3E}">
        <p14:creationId xmlns:p14="http://schemas.microsoft.com/office/powerpoint/2010/main" val="79627824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D7C0F74-9452-C4D9-2D19-088D7FEE2727}"/>
              </a:ext>
            </a:extLst>
          </p:cNvPr>
          <p:cNvSpPr txBox="1"/>
          <p:nvPr/>
        </p:nvSpPr>
        <p:spPr>
          <a:xfrm>
            <a:off x="0" y="22627"/>
            <a:ext cx="58195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Western blot full image related to Supplementary Figure 4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77800B5-5BAC-660E-8C3B-E1DDB2034E65}"/>
              </a:ext>
            </a:extLst>
          </p:cNvPr>
          <p:cNvSpPr txBox="1"/>
          <p:nvPr/>
        </p:nvSpPr>
        <p:spPr>
          <a:xfrm>
            <a:off x="0" y="450850"/>
            <a:ext cx="3754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.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5C057C27-A70D-2A55-9A4E-F09395ECFDC1}"/>
              </a:ext>
            </a:extLst>
          </p:cNvPr>
          <p:cNvGrpSpPr/>
          <p:nvPr/>
        </p:nvGrpSpPr>
        <p:grpSpPr>
          <a:xfrm>
            <a:off x="901700" y="603250"/>
            <a:ext cx="4724400" cy="3438010"/>
            <a:chOff x="139700" y="746640"/>
            <a:chExt cx="5257800" cy="3890205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33B26AD9-75E3-8B74-A52E-A5340DB2409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1143" t="67655" r="43245" b="23465"/>
            <a:stretch/>
          </p:blipFill>
          <p:spPr>
            <a:xfrm>
              <a:off x="2337469" y="2507051"/>
              <a:ext cx="2846801" cy="774237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3490288A-A360-0D11-ECB9-EAD39CBA25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9310" t="31546" r="46312" b="53931"/>
            <a:stretch/>
          </p:blipFill>
          <p:spPr>
            <a:xfrm>
              <a:off x="2349500" y="3346450"/>
              <a:ext cx="2822736" cy="1290395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807B3613-B52A-8A62-231C-3C87A9B5B1B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20148" r="3972"/>
            <a:stretch/>
          </p:blipFill>
          <p:spPr>
            <a:xfrm>
              <a:off x="2349500" y="1737241"/>
              <a:ext cx="2795855" cy="711076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6B2C41F-EB45-5C07-B07F-014944536F53}"/>
                </a:ext>
              </a:extLst>
            </p:cNvPr>
            <p:cNvSpPr txBox="1"/>
            <p:nvPr/>
          </p:nvSpPr>
          <p:spPr>
            <a:xfrm>
              <a:off x="1511300" y="1857558"/>
              <a:ext cx="99239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cl-PARP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549433BA-A009-9C74-08F6-F9410C780635}"/>
                </a:ext>
              </a:extLst>
            </p:cNvPr>
            <p:cNvSpPr txBox="1"/>
            <p:nvPr/>
          </p:nvSpPr>
          <p:spPr>
            <a:xfrm>
              <a:off x="1816100" y="2808048"/>
              <a:ext cx="72553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p27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5DDC87D-EB21-C7D6-0813-35BB8D3FA855}"/>
                </a:ext>
              </a:extLst>
            </p:cNvPr>
            <p:cNvSpPr txBox="1"/>
            <p:nvPr/>
          </p:nvSpPr>
          <p:spPr>
            <a:xfrm>
              <a:off x="139700" y="1051440"/>
              <a:ext cx="52578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    Capmatinib (</a:t>
              </a:r>
              <a:r>
                <a:rPr lang="en-US" sz="1600" b="1" dirty="0" err="1"/>
                <a:t>nM</a:t>
              </a:r>
              <a:r>
                <a:rPr lang="en-US" sz="1600" b="1" dirty="0"/>
                <a:t>)        0    50 100 250  0  50  100 250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EBFA6F46-1C4B-37B4-E4D0-862691678FCC}"/>
                </a:ext>
              </a:extLst>
            </p:cNvPr>
            <p:cNvSpPr txBox="1"/>
            <p:nvPr/>
          </p:nvSpPr>
          <p:spPr>
            <a:xfrm>
              <a:off x="3263900" y="746640"/>
              <a:ext cx="1143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H1993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90E8F1B5-475F-6996-A098-E633E439947D}"/>
                </a:ext>
              </a:extLst>
            </p:cNvPr>
            <p:cNvSpPr txBox="1"/>
            <p:nvPr/>
          </p:nvSpPr>
          <p:spPr>
            <a:xfrm>
              <a:off x="1655676" y="3361504"/>
              <a:ext cx="81391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Actin</a:t>
              </a:r>
            </a:p>
          </p:txBody>
        </p:sp>
        <p:sp>
          <p:nvSpPr>
            <p:cNvPr id="14" name="Rectangle: Rounded Corners 13">
              <a:extLst>
                <a:ext uri="{FF2B5EF4-FFF2-40B4-BE49-F238E27FC236}">
                  <a16:creationId xmlns:a16="http://schemas.microsoft.com/office/drawing/2014/main" id="{763A6950-3E92-6A74-C882-C9C0254FFD79}"/>
                </a:ext>
              </a:extLst>
            </p:cNvPr>
            <p:cNvSpPr/>
            <p:nvPr/>
          </p:nvSpPr>
          <p:spPr>
            <a:xfrm>
              <a:off x="2349500" y="3413640"/>
              <a:ext cx="2819400" cy="381000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B8E71907-F3A0-6054-2545-CEC488F2D4E8}"/>
                </a:ext>
              </a:extLst>
            </p:cNvPr>
            <p:cNvSpPr txBox="1"/>
            <p:nvPr/>
          </p:nvSpPr>
          <p:spPr>
            <a:xfrm>
              <a:off x="1435100" y="3870840"/>
              <a:ext cx="96631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TWIST1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441209A7-A2D5-9EFD-1851-216535C3979B}"/>
                </a:ext>
              </a:extLst>
            </p:cNvPr>
            <p:cNvSpPr txBox="1"/>
            <p:nvPr/>
          </p:nvSpPr>
          <p:spPr>
            <a:xfrm>
              <a:off x="536740" y="1432440"/>
              <a:ext cx="486076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    Dox (500 ng/ml)   -     -     -      -    +    +     +    +</a:t>
              </a:r>
            </a:p>
          </p:txBody>
        </p:sp>
        <p:sp>
          <p:nvSpPr>
            <p:cNvPr id="17" name="Rectangle: Rounded Corners 16">
              <a:extLst>
                <a:ext uri="{FF2B5EF4-FFF2-40B4-BE49-F238E27FC236}">
                  <a16:creationId xmlns:a16="http://schemas.microsoft.com/office/drawing/2014/main" id="{B4940A41-F726-382F-9AFF-89021304BF0A}"/>
                </a:ext>
              </a:extLst>
            </p:cNvPr>
            <p:cNvSpPr/>
            <p:nvPr/>
          </p:nvSpPr>
          <p:spPr>
            <a:xfrm>
              <a:off x="2349500" y="3947040"/>
              <a:ext cx="2819400" cy="381000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  <p:sp>
          <p:nvSpPr>
            <p:cNvPr id="18" name="Rectangle: Rounded Corners 17">
              <a:extLst>
                <a:ext uri="{FF2B5EF4-FFF2-40B4-BE49-F238E27FC236}">
                  <a16:creationId xmlns:a16="http://schemas.microsoft.com/office/drawing/2014/main" id="{A3A19EF3-37D4-0EE3-45CE-C2D62028F1AC}"/>
                </a:ext>
              </a:extLst>
            </p:cNvPr>
            <p:cNvSpPr/>
            <p:nvPr/>
          </p:nvSpPr>
          <p:spPr>
            <a:xfrm>
              <a:off x="2349500" y="2804040"/>
              <a:ext cx="2819400" cy="381000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  <p:sp>
          <p:nvSpPr>
            <p:cNvPr id="19" name="Rectangle: Rounded Corners 18">
              <a:extLst>
                <a:ext uri="{FF2B5EF4-FFF2-40B4-BE49-F238E27FC236}">
                  <a16:creationId xmlns:a16="http://schemas.microsoft.com/office/drawing/2014/main" id="{E7541DBC-305A-A6B9-8AF3-4909A0C46123}"/>
                </a:ext>
              </a:extLst>
            </p:cNvPr>
            <p:cNvSpPr/>
            <p:nvPr/>
          </p:nvSpPr>
          <p:spPr>
            <a:xfrm>
              <a:off x="2349500" y="1889640"/>
              <a:ext cx="2819400" cy="381000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</p:grpSp>
      <p:grpSp>
        <p:nvGrpSpPr>
          <p:cNvPr id="20" name="Group 19">
            <a:extLst>
              <a:ext uri="{FF2B5EF4-FFF2-40B4-BE49-F238E27FC236}">
                <a16:creationId xmlns:a16="http://schemas.microsoft.com/office/drawing/2014/main" id="{F276BB61-BBB4-3BE4-B110-A4608ACCB020}"/>
              </a:ext>
            </a:extLst>
          </p:cNvPr>
          <p:cNvGrpSpPr/>
          <p:nvPr/>
        </p:nvGrpSpPr>
        <p:grpSpPr>
          <a:xfrm>
            <a:off x="1054100" y="4870450"/>
            <a:ext cx="4876800" cy="4343400"/>
            <a:chOff x="596900" y="5378450"/>
            <a:chExt cx="4876800" cy="4343400"/>
          </a:xfrm>
        </p:grpSpPr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970B1C5B-D01D-6B22-E528-B1BDCD0990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689" t="13033" r="25419" b="2232"/>
            <a:stretch/>
          </p:blipFill>
          <p:spPr>
            <a:xfrm>
              <a:off x="2112662" y="8969824"/>
              <a:ext cx="2702011" cy="752026"/>
            </a:xfrm>
            <a:prstGeom prst="rect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1807E21A-1207-CFF0-31E8-C084D735611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6375" t="7853" r="24618" b="52092"/>
            <a:stretch/>
          </p:blipFill>
          <p:spPr>
            <a:xfrm>
              <a:off x="2112662" y="7010686"/>
              <a:ext cx="2730160" cy="1045813"/>
            </a:xfrm>
            <a:prstGeom prst="rect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32C70CE8-8B99-9F02-5FAA-8744822490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4693" t="9796" r="17933" b="19256"/>
            <a:stretch/>
          </p:blipFill>
          <p:spPr>
            <a:xfrm>
              <a:off x="2112662" y="8126220"/>
              <a:ext cx="2730471" cy="766930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CDC139CC-0F37-26DF-8E01-76B12927AD4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7737" t="26810" r="34605" b="68099"/>
            <a:stretch/>
          </p:blipFill>
          <p:spPr>
            <a:xfrm>
              <a:off x="2112662" y="6452919"/>
              <a:ext cx="2717808" cy="418325"/>
            </a:xfrm>
            <a:prstGeom prst="rect">
              <a:avLst/>
            </a:prstGeom>
          </p:spPr>
        </p:pic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642D9092-AF96-9775-94AC-BA05D4CB15B4}"/>
                </a:ext>
              </a:extLst>
            </p:cNvPr>
            <p:cNvSpPr txBox="1"/>
            <p:nvPr/>
          </p:nvSpPr>
          <p:spPr>
            <a:xfrm>
              <a:off x="1206500" y="7232650"/>
              <a:ext cx="120118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TWIST1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413ABC43-19D1-0380-50F5-8408C5C3F750}"/>
                </a:ext>
              </a:extLst>
            </p:cNvPr>
            <p:cNvSpPr txBox="1"/>
            <p:nvPr/>
          </p:nvSpPr>
          <p:spPr>
            <a:xfrm>
              <a:off x="1305354" y="6533316"/>
              <a:ext cx="858284" cy="309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cl-PARP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67F81C8B-680C-08F6-291E-C55379895EDC}"/>
                </a:ext>
              </a:extLst>
            </p:cNvPr>
            <p:cNvSpPr txBox="1"/>
            <p:nvPr/>
          </p:nvSpPr>
          <p:spPr>
            <a:xfrm>
              <a:off x="1618392" y="8283092"/>
              <a:ext cx="627487" cy="309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p27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D3F257EA-F0F8-54DE-4A67-CA7B6F88858E}"/>
                </a:ext>
              </a:extLst>
            </p:cNvPr>
            <p:cNvSpPr txBox="1"/>
            <p:nvPr/>
          </p:nvSpPr>
          <p:spPr>
            <a:xfrm>
              <a:off x="1470111" y="9137173"/>
              <a:ext cx="703927" cy="309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Actin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849FD1B5-DDB1-7ECF-B8AE-44DCE97367FB}"/>
                </a:ext>
              </a:extLst>
            </p:cNvPr>
            <p:cNvSpPr txBox="1"/>
            <p:nvPr/>
          </p:nvSpPr>
          <p:spPr>
            <a:xfrm>
              <a:off x="2121415" y="5696666"/>
              <a:ext cx="3031524" cy="309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      W118 </a:t>
              </a:r>
              <a:r>
                <a:rPr lang="el-GR" sz="1600" b="1" dirty="0"/>
                <a:t>Δ</a:t>
              </a:r>
              <a:r>
                <a:rPr lang="en-US" sz="1600" b="1" dirty="0"/>
                <a:t>              W118 TWIST1</a:t>
              </a:r>
            </a:p>
          </p:txBody>
        </p: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AB391853-AD13-CD11-212E-1B7F29C6D4F7}"/>
                </a:ext>
              </a:extLst>
            </p:cNvPr>
            <p:cNvCxnSpPr>
              <a:cxnSpLocks/>
            </p:cNvCxnSpPr>
            <p:nvPr/>
          </p:nvCxnSpPr>
          <p:spPr>
            <a:xfrm>
              <a:off x="2244468" y="5708650"/>
              <a:ext cx="2530664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4A0C4552-47D4-8E76-87D9-C980D963F5DA}"/>
                </a:ext>
              </a:extLst>
            </p:cNvPr>
            <p:cNvCxnSpPr>
              <a:cxnSpLocks/>
            </p:cNvCxnSpPr>
            <p:nvPr/>
          </p:nvCxnSpPr>
          <p:spPr>
            <a:xfrm>
              <a:off x="2343322" y="6069455"/>
              <a:ext cx="1186249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86B25556-84C6-BC1D-5859-F396E95C1902}"/>
                </a:ext>
              </a:extLst>
            </p:cNvPr>
            <p:cNvCxnSpPr>
              <a:cxnSpLocks/>
            </p:cNvCxnSpPr>
            <p:nvPr/>
          </p:nvCxnSpPr>
          <p:spPr>
            <a:xfrm>
              <a:off x="3740459" y="6069455"/>
              <a:ext cx="948999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2C3514AA-210A-20CF-2B48-7DE15BF47FFA}"/>
                </a:ext>
              </a:extLst>
            </p:cNvPr>
            <p:cNvSpPr txBox="1"/>
            <p:nvPr/>
          </p:nvSpPr>
          <p:spPr>
            <a:xfrm>
              <a:off x="596900" y="6114991"/>
              <a:ext cx="4876800" cy="309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    </a:t>
              </a:r>
              <a:r>
                <a:rPr lang="en-US" sz="1600" b="1" dirty="0" err="1"/>
                <a:t>Tepotinib</a:t>
              </a:r>
              <a:r>
                <a:rPr lang="en-US" sz="1600" b="1" dirty="0"/>
                <a:t> (µM)           0      1      2.5    0     1     2.5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7F0F63F5-EEEC-0A74-67EB-08085F6A3FC6}"/>
                </a:ext>
              </a:extLst>
            </p:cNvPr>
            <p:cNvSpPr txBox="1"/>
            <p:nvPr/>
          </p:nvSpPr>
          <p:spPr>
            <a:xfrm>
              <a:off x="3298911" y="5378450"/>
              <a:ext cx="988541" cy="309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H1437</a:t>
              </a:r>
            </a:p>
          </p:txBody>
        </p:sp>
        <p:sp>
          <p:nvSpPr>
            <p:cNvPr id="35" name="Rectangle: Rounded Corners 34">
              <a:extLst>
                <a:ext uri="{FF2B5EF4-FFF2-40B4-BE49-F238E27FC236}">
                  <a16:creationId xmlns:a16="http://schemas.microsoft.com/office/drawing/2014/main" id="{D5FF7EA4-82A8-DFEA-F893-F9D926275B96}"/>
                </a:ext>
              </a:extLst>
            </p:cNvPr>
            <p:cNvSpPr/>
            <p:nvPr/>
          </p:nvSpPr>
          <p:spPr>
            <a:xfrm>
              <a:off x="2112662" y="9102312"/>
              <a:ext cx="2767914" cy="348604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  <p:sp>
          <p:nvSpPr>
            <p:cNvPr id="36" name="Rectangle: Rounded Corners 35">
              <a:extLst>
                <a:ext uri="{FF2B5EF4-FFF2-40B4-BE49-F238E27FC236}">
                  <a16:creationId xmlns:a16="http://schemas.microsoft.com/office/drawing/2014/main" id="{180C4396-BC58-48C9-552F-D9CDF4154CA4}"/>
                </a:ext>
              </a:extLst>
            </p:cNvPr>
            <p:cNvSpPr/>
            <p:nvPr/>
          </p:nvSpPr>
          <p:spPr>
            <a:xfrm>
              <a:off x="2112662" y="8195941"/>
              <a:ext cx="2767914" cy="348604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  <p:sp>
          <p:nvSpPr>
            <p:cNvPr id="37" name="Rectangle: Rounded Corners 36">
              <a:extLst>
                <a:ext uri="{FF2B5EF4-FFF2-40B4-BE49-F238E27FC236}">
                  <a16:creationId xmlns:a16="http://schemas.microsoft.com/office/drawing/2014/main" id="{ADA4F771-770D-476D-763A-5E94D041F625}"/>
                </a:ext>
              </a:extLst>
            </p:cNvPr>
            <p:cNvSpPr/>
            <p:nvPr/>
          </p:nvSpPr>
          <p:spPr>
            <a:xfrm>
              <a:off x="2096186" y="7272140"/>
              <a:ext cx="2767914" cy="348604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  <p:sp>
          <p:nvSpPr>
            <p:cNvPr id="38" name="Rectangle: Rounded Corners 37">
              <a:extLst>
                <a:ext uri="{FF2B5EF4-FFF2-40B4-BE49-F238E27FC236}">
                  <a16:creationId xmlns:a16="http://schemas.microsoft.com/office/drawing/2014/main" id="{EA479018-29FA-0867-F7B1-DA31590782CF}"/>
                </a:ext>
              </a:extLst>
            </p:cNvPr>
            <p:cNvSpPr/>
            <p:nvPr/>
          </p:nvSpPr>
          <p:spPr>
            <a:xfrm>
              <a:off x="2112662" y="6522640"/>
              <a:ext cx="2767914" cy="348604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</p:grpSp>
      <p:sp>
        <p:nvSpPr>
          <p:cNvPr id="39" name="TextBox 38">
            <a:extLst>
              <a:ext uri="{FF2B5EF4-FFF2-40B4-BE49-F238E27FC236}">
                <a16:creationId xmlns:a16="http://schemas.microsoft.com/office/drawing/2014/main" id="{91A48592-4B7D-F3E9-BBC3-51E8CBAFD18B}"/>
              </a:ext>
            </a:extLst>
          </p:cNvPr>
          <p:cNvSpPr txBox="1"/>
          <p:nvPr/>
        </p:nvSpPr>
        <p:spPr>
          <a:xfrm>
            <a:off x="596900" y="485775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I.                                </a:t>
            </a:r>
          </a:p>
        </p:txBody>
      </p:sp>
    </p:spTree>
    <p:extLst>
      <p:ext uri="{BB962C8B-B14F-4D97-AF65-F5344CB8AC3E}">
        <p14:creationId xmlns:p14="http://schemas.microsoft.com/office/powerpoint/2010/main" val="307728731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45B1E29C-9F33-D0AB-EA9A-340FCA1EAE09}"/>
              </a:ext>
            </a:extLst>
          </p:cNvPr>
          <p:cNvGrpSpPr/>
          <p:nvPr/>
        </p:nvGrpSpPr>
        <p:grpSpPr>
          <a:xfrm>
            <a:off x="2455271" y="527050"/>
            <a:ext cx="4999632" cy="4800600"/>
            <a:chOff x="1674077" y="298450"/>
            <a:chExt cx="5780823" cy="5867400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F11BF96D-42FC-929F-E425-00A05A7A1E6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4958" t="24715" r="2920" b="19194"/>
            <a:stretch/>
          </p:blipFill>
          <p:spPr>
            <a:xfrm>
              <a:off x="3502793" y="5535936"/>
              <a:ext cx="3888607" cy="629914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D6EE19D3-24BC-4BE7-9E84-E910FDD5F56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7593" t="21198" r="9586" b="20989"/>
            <a:stretch/>
          </p:blipFill>
          <p:spPr>
            <a:xfrm>
              <a:off x="3502793" y="2945136"/>
              <a:ext cx="3876153" cy="715346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A7213F4E-0A58-F833-3FAF-EFB29D5D1EB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8773" r="22803"/>
            <a:stretch/>
          </p:blipFill>
          <p:spPr>
            <a:xfrm>
              <a:off x="3502793" y="3720784"/>
              <a:ext cx="3886200" cy="1737827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C697701B-8A40-8714-3079-5EC906EE88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5731" r="8613" b="19831"/>
            <a:stretch/>
          </p:blipFill>
          <p:spPr>
            <a:xfrm>
              <a:off x="3502793" y="1497336"/>
              <a:ext cx="3876215" cy="1371600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00C2D1C5-A8B3-C524-DE43-B4BDBFADD40C}"/>
                </a:ext>
              </a:extLst>
            </p:cNvPr>
            <p:cNvSpPr txBox="1"/>
            <p:nvPr/>
          </p:nvSpPr>
          <p:spPr>
            <a:xfrm>
              <a:off x="2601471" y="2030735"/>
              <a:ext cx="99239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cl-PARP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67F284D0-475B-B4BF-C4C6-E3335A980A63}"/>
                </a:ext>
              </a:extLst>
            </p:cNvPr>
            <p:cNvSpPr txBox="1"/>
            <p:nvPr/>
          </p:nvSpPr>
          <p:spPr>
            <a:xfrm>
              <a:off x="2906271" y="3097534"/>
              <a:ext cx="72553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p27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5CF44AB-5236-731C-0D4B-218B0FDF6E7A}"/>
                </a:ext>
              </a:extLst>
            </p:cNvPr>
            <p:cNvSpPr txBox="1"/>
            <p:nvPr/>
          </p:nvSpPr>
          <p:spPr>
            <a:xfrm>
              <a:off x="3949700" y="755650"/>
              <a:ext cx="35052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     </a:t>
              </a:r>
              <a:r>
                <a:rPr lang="en-US" sz="1600" b="1" dirty="0" err="1"/>
                <a:t>Scr</a:t>
              </a:r>
              <a:r>
                <a:rPr lang="en-US" sz="1600" b="1" dirty="0"/>
                <a:t>                        </a:t>
              </a:r>
              <a:r>
                <a:rPr lang="en-US" sz="1600" b="1" dirty="0" err="1"/>
                <a:t>sh</a:t>
              </a:r>
              <a:r>
                <a:rPr lang="en-US" sz="1600" b="1" dirty="0"/>
                <a:t> p27-1</a:t>
              </a:r>
            </a:p>
          </p:txBody>
        </p: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A48FAF25-A435-41AE-726A-798F62BC8DC4}"/>
                </a:ext>
              </a:extLst>
            </p:cNvPr>
            <p:cNvCxnSpPr>
              <a:cxnSpLocks/>
            </p:cNvCxnSpPr>
            <p:nvPr/>
          </p:nvCxnSpPr>
          <p:spPr>
            <a:xfrm>
              <a:off x="3810000" y="755650"/>
              <a:ext cx="310896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D8B5AFF6-1073-D286-6152-06D53D72798D}"/>
                </a:ext>
              </a:extLst>
            </p:cNvPr>
            <p:cNvCxnSpPr>
              <a:cxnSpLocks/>
            </p:cNvCxnSpPr>
            <p:nvPr/>
          </p:nvCxnSpPr>
          <p:spPr>
            <a:xfrm>
              <a:off x="3886200" y="1136650"/>
              <a:ext cx="146304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3B59111B-FAFF-4713-62C7-B9E7AB68F1FC}"/>
                </a:ext>
              </a:extLst>
            </p:cNvPr>
            <p:cNvCxnSpPr>
              <a:cxnSpLocks/>
            </p:cNvCxnSpPr>
            <p:nvPr/>
          </p:nvCxnSpPr>
          <p:spPr>
            <a:xfrm>
              <a:off x="5578520" y="1136650"/>
              <a:ext cx="128016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54074112-8F59-5275-40BB-87EEBCAE0746}"/>
                </a:ext>
              </a:extLst>
            </p:cNvPr>
            <p:cNvSpPr txBox="1"/>
            <p:nvPr/>
          </p:nvSpPr>
          <p:spPr>
            <a:xfrm>
              <a:off x="1674077" y="1112764"/>
              <a:ext cx="563880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    Capmatinib (</a:t>
              </a:r>
              <a:r>
                <a:rPr lang="en-US" sz="1600" b="1" dirty="0" err="1"/>
                <a:t>nM</a:t>
              </a:r>
              <a:r>
                <a:rPr lang="en-US" sz="1600" b="1" dirty="0"/>
                <a:t>)        0     1     5   10    0    1     5     10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1BCDC3C3-63CB-4A66-1D5E-F12D54C198F0}"/>
                </a:ext>
              </a:extLst>
            </p:cNvPr>
            <p:cNvSpPr txBox="1"/>
            <p:nvPr/>
          </p:nvSpPr>
          <p:spPr>
            <a:xfrm>
              <a:off x="5029200" y="298450"/>
              <a:ext cx="1143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H1993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E0D6AD99-83EC-9656-15F6-1D6B804DCE03}"/>
                </a:ext>
              </a:extLst>
            </p:cNvPr>
            <p:cNvSpPr txBox="1"/>
            <p:nvPr/>
          </p:nvSpPr>
          <p:spPr>
            <a:xfrm>
              <a:off x="2830071" y="5612134"/>
              <a:ext cx="81391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Actin</a:t>
              </a:r>
            </a:p>
          </p:txBody>
        </p:sp>
        <p:sp>
          <p:nvSpPr>
            <p:cNvPr id="21" name="Rectangle: Rounded Corners 20">
              <a:extLst>
                <a:ext uri="{FF2B5EF4-FFF2-40B4-BE49-F238E27FC236}">
                  <a16:creationId xmlns:a16="http://schemas.microsoft.com/office/drawing/2014/main" id="{9B187CE4-CC00-C60F-A5E9-8D50849DE073}"/>
                </a:ext>
              </a:extLst>
            </p:cNvPr>
            <p:cNvSpPr/>
            <p:nvPr/>
          </p:nvSpPr>
          <p:spPr>
            <a:xfrm>
              <a:off x="3657600" y="5632450"/>
              <a:ext cx="3657600" cy="381000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  <p:sp>
          <p:nvSpPr>
            <p:cNvPr id="22" name="Rectangle: Rounded Corners 21">
              <a:extLst>
                <a:ext uri="{FF2B5EF4-FFF2-40B4-BE49-F238E27FC236}">
                  <a16:creationId xmlns:a16="http://schemas.microsoft.com/office/drawing/2014/main" id="{277614ED-DF93-F9AC-680A-28B6837F6115}"/>
                </a:ext>
              </a:extLst>
            </p:cNvPr>
            <p:cNvSpPr/>
            <p:nvPr/>
          </p:nvSpPr>
          <p:spPr>
            <a:xfrm>
              <a:off x="3657600" y="4440546"/>
              <a:ext cx="3505200" cy="304800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  <p:sp>
          <p:nvSpPr>
            <p:cNvPr id="23" name="Rectangle: Rounded Corners 22">
              <a:extLst>
                <a:ext uri="{FF2B5EF4-FFF2-40B4-BE49-F238E27FC236}">
                  <a16:creationId xmlns:a16="http://schemas.microsoft.com/office/drawing/2014/main" id="{E76E0884-1344-DF06-4B49-E171D1E2E465}"/>
                </a:ext>
              </a:extLst>
            </p:cNvPr>
            <p:cNvSpPr/>
            <p:nvPr/>
          </p:nvSpPr>
          <p:spPr>
            <a:xfrm>
              <a:off x="3505200" y="3090554"/>
              <a:ext cx="3810000" cy="381000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  <p:sp>
          <p:nvSpPr>
            <p:cNvPr id="24" name="Rectangle: Rounded Corners 23">
              <a:extLst>
                <a:ext uri="{FF2B5EF4-FFF2-40B4-BE49-F238E27FC236}">
                  <a16:creationId xmlns:a16="http://schemas.microsoft.com/office/drawing/2014/main" id="{0953A13E-CEE7-19EB-C5FF-89BA7EA7EC53}"/>
                </a:ext>
              </a:extLst>
            </p:cNvPr>
            <p:cNvSpPr/>
            <p:nvPr/>
          </p:nvSpPr>
          <p:spPr>
            <a:xfrm>
              <a:off x="3733800" y="2029442"/>
              <a:ext cx="3505200" cy="457200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37595595-064E-20D1-DBC1-937A78F62681}"/>
                </a:ext>
              </a:extLst>
            </p:cNvPr>
            <p:cNvSpPr txBox="1"/>
            <p:nvPr/>
          </p:nvSpPr>
          <p:spPr>
            <a:xfrm>
              <a:off x="2906271" y="4406585"/>
              <a:ext cx="72553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p21</a:t>
              </a:r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3DEB61DB-3F15-F60E-F9B3-CB138BA69DDE}"/>
              </a:ext>
            </a:extLst>
          </p:cNvPr>
          <p:cNvGrpSpPr/>
          <p:nvPr/>
        </p:nvGrpSpPr>
        <p:grpSpPr>
          <a:xfrm>
            <a:off x="604861" y="1593851"/>
            <a:ext cx="2157484" cy="3124200"/>
            <a:chOff x="8710" y="1714407"/>
            <a:chExt cx="2739056" cy="3657600"/>
          </a:xfrm>
        </p:grpSpPr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D4AD556B-B6ED-5B22-C06B-4065AA093F8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58918" t="6600" r="17295" b="2420"/>
            <a:stretch/>
          </p:blipFill>
          <p:spPr>
            <a:xfrm>
              <a:off x="770719" y="4000407"/>
              <a:ext cx="1371600" cy="1371600"/>
            </a:xfrm>
            <a:prstGeom prst="rect">
              <a:avLst/>
            </a:prstGeom>
          </p:spPr>
        </p:pic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65B3E99A-CB4C-2994-F19F-F475D70BCD0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50115" t="28556" r="26962" b="34852"/>
            <a:stretch/>
          </p:blipFill>
          <p:spPr>
            <a:xfrm>
              <a:off x="756950" y="2478208"/>
              <a:ext cx="1395795" cy="1384627"/>
            </a:xfrm>
            <a:prstGeom prst="rect">
              <a:avLst/>
            </a:prstGeom>
          </p:spPr>
        </p:pic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AF59935B-CC8F-F598-B2F5-0D1EE7A0E713}"/>
                </a:ext>
              </a:extLst>
            </p:cNvPr>
            <p:cNvSpPr txBox="1"/>
            <p:nvPr/>
          </p:nvSpPr>
          <p:spPr>
            <a:xfrm>
              <a:off x="166823" y="2898350"/>
              <a:ext cx="1054753" cy="396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p27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9132462B-95F5-9967-B08E-2736D377A4FE}"/>
                </a:ext>
              </a:extLst>
            </p:cNvPr>
            <p:cNvSpPr txBox="1"/>
            <p:nvPr/>
          </p:nvSpPr>
          <p:spPr>
            <a:xfrm>
              <a:off x="8710" y="4485872"/>
              <a:ext cx="813916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Actin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338FC74C-15A5-04B7-B24A-B3983A14C2DE}"/>
                </a:ext>
              </a:extLst>
            </p:cNvPr>
            <p:cNvSpPr txBox="1"/>
            <p:nvPr/>
          </p:nvSpPr>
          <p:spPr>
            <a:xfrm>
              <a:off x="385566" y="2095408"/>
              <a:ext cx="2362200" cy="396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     </a:t>
              </a:r>
              <a:r>
                <a:rPr lang="en-US" sz="1600" b="1" dirty="0" err="1"/>
                <a:t>Scr</a:t>
              </a:r>
              <a:r>
                <a:rPr lang="en-US" sz="1600" b="1" dirty="0"/>
                <a:t>     </a:t>
              </a:r>
              <a:r>
                <a:rPr lang="en-US" sz="1600" b="1" dirty="0" err="1"/>
                <a:t>sh</a:t>
              </a:r>
              <a:r>
                <a:rPr lang="en-US" sz="1600" b="1" dirty="0"/>
                <a:t> p27-1</a:t>
              </a:r>
            </a:p>
          </p:txBody>
        </p: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3FA06EFC-3A59-0BE4-664D-720F58858235}"/>
                </a:ext>
              </a:extLst>
            </p:cNvPr>
            <p:cNvCxnSpPr>
              <a:cxnSpLocks/>
            </p:cNvCxnSpPr>
            <p:nvPr/>
          </p:nvCxnSpPr>
          <p:spPr>
            <a:xfrm>
              <a:off x="674465" y="2095407"/>
              <a:ext cx="155448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89F43E97-B95C-9CB8-E14F-1F5D2CFE2CDA}"/>
                </a:ext>
              </a:extLst>
            </p:cNvPr>
            <p:cNvSpPr txBox="1"/>
            <p:nvPr/>
          </p:nvSpPr>
          <p:spPr>
            <a:xfrm>
              <a:off x="1085945" y="1714407"/>
              <a:ext cx="1143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H1993</a:t>
              </a:r>
            </a:p>
          </p:txBody>
        </p:sp>
        <p:sp>
          <p:nvSpPr>
            <p:cNvPr id="35" name="Rectangle: Rounded Corners 34">
              <a:extLst>
                <a:ext uri="{FF2B5EF4-FFF2-40B4-BE49-F238E27FC236}">
                  <a16:creationId xmlns:a16="http://schemas.microsoft.com/office/drawing/2014/main" id="{4DAFC16B-C43A-131C-A5E1-3F6034CF406D}"/>
                </a:ext>
              </a:extLst>
            </p:cNvPr>
            <p:cNvSpPr/>
            <p:nvPr/>
          </p:nvSpPr>
          <p:spPr>
            <a:xfrm>
              <a:off x="749300" y="4489450"/>
              <a:ext cx="1143000" cy="457200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  <p:sp>
          <p:nvSpPr>
            <p:cNvPr id="36" name="Rectangle: Rounded Corners 35">
              <a:extLst>
                <a:ext uri="{FF2B5EF4-FFF2-40B4-BE49-F238E27FC236}">
                  <a16:creationId xmlns:a16="http://schemas.microsoft.com/office/drawing/2014/main" id="{0BEDD98E-D19E-2227-5612-2EFCB7474B49}"/>
                </a:ext>
              </a:extLst>
            </p:cNvPr>
            <p:cNvSpPr/>
            <p:nvPr/>
          </p:nvSpPr>
          <p:spPr>
            <a:xfrm>
              <a:off x="825500" y="2889250"/>
              <a:ext cx="1295400" cy="457200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80C0B262-AFDA-79AE-6887-7378961A1943}"/>
              </a:ext>
            </a:extLst>
          </p:cNvPr>
          <p:cNvGrpSpPr/>
          <p:nvPr/>
        </p:nvGrpSpPr>
        <p:grpSpPr>
          <a:xfrm>
            <a:off x="985860" y="6173806"/>
            <a:ext cx="2155400" cy="2582839"/>
            <a:chOff x="435020" y="6158500"/>
            <a:chExt cx="2706240" cy="3162269"/>
          </a:xfrm>
        </p:grpSpPr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C4E2E521-9E92-72AD-BD81-382D6D26EF3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16181" t="6373" r="18809" b="56565"/>
            <a:stretch/>
          </p:blipFill>
          <p:spPr>
            <a:xfrm>
              <a:off x="1213115" y="8617898"/>
              <a:ext cx="1928145" cy="702871"/>
            </a:xfrm>
            <a:prstGeom prst="rect">
              <a:avLst/>
            </a:prstGeom>
          </p:spPr>
        </p:pic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B3F5966E-6974-E6DD-8CB3-9749C432356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15210" t="18214" r="21010" b="13948"/>
            <a:stretch/>
          </p:blipFill>
          <p:spPr>
            <a:xfrm>
              <a:off x="1206500" y="7676202"/>
              <a:ext cx="1918647" cy="854844"/>
            </a:xfrm>
            <a:prstGeom prst="rect">
              <a:avLst/>
            </a:prstGeom>
          </p:spPr>
        </p:pic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590C4091-DCD7-F77A-66A1-19275A5A0BA0}"/>
                </a:ext>
              </a:extLst>
            </p:cNvPr>
            <p:cNvSpPr txBox="1"/>
            <p:nvPr/>
          </p:nvSpPr>
          <p:spPr>
            <a:xfrm>
              <a:off x="586432" y="7833970"/>
              <a:ext cx="72553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p27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464BF5B9-9209-C313-51F9-CBDF5DBC32FF}"/>
                </a:ext>
              </a:extLst>
            </p:cNvPr>
            <p:cNvSpPr txBox="1"/>
            <p:nvPr/>
          </p:nvSpPr>
          <p:spPr>
            <a:xfrm>
              <a:off x="435020" y="8702058"/>
              <a:ext cx="81391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Actin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6EF62D7B-EF91-4AB0-3C92-1545832FBB0C}"/>
                </a:ext>
              </a:extLst>
            </p:cNvPr>
            <p:cNvSpPr txBox="1"/>
            <p:nvPr/>
          </p:nvSpPr>
          <p:spPr>
            <a:xfrm rot="16200000">
              <a:off x="1466395" y="6249419"/>
              <a:ext cx="1219201" cy="16616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 </a:t>
              </a:r>
              <a:r>
                <a:rPr lang="en-US" sz="1600" b="1" dirty="0" err="1"/>
                <a:t>Scr</a:t>
              </a:r>
              <a:r>
                <a:rPr lang="en-US" sz="1600" b="1" dirty="0"/>
                <a:t>      </a:t>
              </a:r>
            </a:p>
            <a:p>
              <a:endParaRPr lang="en-US" sz="1600" b="1" dirty="0"/>
            </a:p>
            <a:p>
              <a:r>
                <a:rPr lang="en-US" sz="1600" b="1" dirty="0" err="1"/>
                <a:t>sh</a:t>
              </a:r>
              <a:r>
                <a:rPr lang="en-US" sz="1600" b="1" dirty="0"/>
                <a:t> p27-2</a:t>
              </a:r>
            </a:p>
            <a:p>
              <a:endParaRPr lang="en-US" sz="1600" b="1" dirty="0"/>
            </a:p>
            <a:p>
              <a:r>
                <a:rPr lang="en-US" sz="1600" b="1" dirty="0" err="1"/>
                <a:t>Sh</a:t>
              </a:r>
              <a:r>
                <a:rPr lang="en-US" sz="1600" b="1" dirty="0"/>
                <a:t> p27-3</a:t>
              </a:r>
            </a:p>
          </p:txBody>
        </p:sp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4437FF3C-6D5B-8007-5FBF-B38F6B2F2E3A}"/>
                </a:ext>
              </a:extLst>
            </p:cNvPr>
            <p:cNvCxnSpPr>
              <a:cxnSpLocks/>
            </p:cNvCxnSpPr>
            <p:nvPr/>
          </p:nvCxnSpPr>
          <p:spPr>
            <a:xfrm>
              <a:off x="1358900" y="6598991"/>
              <a:ext cx="1554479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08E4B454-FF7C-261A-91A4-E1C3B6967555}"/>
                </a:ext>
              </a:extLst>
            </p:cNvPr>
            <p:cNvSpPr txBox="1"/>
            <p:nvPr/>
          </p:nvSpPr>
          <p:spPr>
            <a:xfrm>
              <a:off x="1816100" y="6158500"/>
              <a:ext cx="1143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H1993</a:t>
              </a:r>
            </a:p>
          </p:txBody>
        </p:sp>
        <p:sp>
          <p:nvSpPr>
            <p:cNvPr id="45" name="Rectangle: Rounded Corners 44">
              <a:extLst>
                <a:ext uri="{FF2B5EF4-FFF2-40B4-BE49-F238E27FC236}">
                  <a16:creationId xmlns:a16="http://schemas.microsoft.com/office/drawing/2014/main" id="{CEBC6B2D-1BD2-1F1D-A738-031D1D9748F9}"/>
                </a:ext>
              </a:extLst>
            </p:cNvPr>
            <p:cNvSpPr/>
            <p:nvPr/>
          </p:nvSpPr>
          <p:spPr>
            <a:xfrm>
              <a:off x="1206500" y="8680450"/>
              <a:ext cx="1905000" cy="457200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  <p:sp>
          <p:nvSpPr>
            <p:cNvPr id="46" name="Rectangle: Rounded Corners 45">
              <a:extLst>
                <a:ext uri="{FF2B5EF4-FFF2-40B4-BE49-F238E27FC236}">
                  <a16:creationId xmlns:a16="http://schemas.microsoft.com/office/drawing/2014/main" id="{D4D171FF-20C4-20AF-1BF7-4417E7AE5E58}"/>
                </a:ext>
              </a:extLst>
            </p:cNvPr>
            <p:cNvSpPr/>
            <p:nvPr/>
          </p:nvSpPr>
          <p:spPr>
            <a:xfrm>
              <a:off x="1206500" y="7877506"/>
              <a:ext cx="1905000" cy="457200"/>
            </a:xfrm>
            <a:prstGeom prst="roundRect">
              <a:avLst/>
            </a:prstGeom>
            <a:noFill/>
            <a:ln w="285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/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8594A58D-A230-9192-2A3C-2FCFB1AEF16C}"/>
              </a:ext>
            </a:extLst>
          </p:cNvPr>
          <p:cNvSpPr txBox="1"/>
          <p:nvPr/>
        </p:nvSpPr>
        <p:spPr>
          <a:xfrm>
            <a:off x="0" y="22627"/>
            <a:ext cx="43288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Western blot full image related to Figure 5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186FA0A-D205-DB98-74A3-748A2410CCFE}"/>
              </a:ext>
            </a:extLst>
          </p:cNvPr>
          <p:cNvSpPr txBox="1"/>
          <p:nvPr/>
        </p:nvSpPr>
        <p:spPr>
          <a:xfrm>
            <a:off x="63500" y="344280"/>
            <a:ext cx="9885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A.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57A0C40-FDE2-CA25-3526-706E7BAD8832}"/>
              </a:ext>
            </a:extLst>
          </p:cNvPr>
          <p:cNvSpPr txBox="1"/>
          <p:nvPr/>
        </p:nvSpPr>
        <p:spPr>
          <a:xfrm>
            <a:off x="3340100" y="340896"/>
            <a:ext cx="9885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B.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B05195B-DE4E-86D0-3FC6-CC6A7BEFDFFC}"/>
              </a:ext>
            </a:extLst>
          </p:cNvPr>
          <p:cNvSpPr txBox="1"/>
          <p:nvPr/>
        </p:nvSpPr>
        <p:spPr>
          <a:xfrm>
            <a:off x="139700" y="5784850"/>
            <a:ext cx="5943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Western blot full image related to Supplementary Figure 4 A. </a:t>
            </a:r>
          </a:p>
        </p:txBody>
      </p:sp>
    </p:spTree>
    <p:extLst>
      <p:ext uri="{BB962C8B-B14F-4D97-AF65-F5344CB8AC3E}">
        <p14:creationId xmlns:p14="http://schemas.microsoft.com/office/powerpoint/2010/main" val="30667165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707</TotalTime>
  <Words>536</Words>
  <Application>Microsoft Office PowerPoint</Application>
  <PresentationFormat>Custom</PresentationFormat>
  <Paragraphs>182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5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P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urns, Timothy</dc:creator>
  <cp:lastModifiedBy>Kumar, Vinod</cp:lastModifiedBy>
  <cp:revision>230</cp:revision>
  <cp:lastPrinted>2015-12-15T14:05:04Z</cp:lastPrinted>
  <dcterms:created xsi:type="dcterms:W3CDTF">2015-09-22T14:13:33Z</dcterms:created>
  <dcterms:modified xsi:type="dcterms:W3CDTF">2024-01-11T16:06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5e4b1be8-281e-475d-98b0-21c3457e5a46_Enabled">
    <vt:lpwstr>true</vt:lpwstr>
  </property>
  <property fmtid="{D5CDD505-2E9C-101B-9397-08002B2CF9AE}" pid="3" name="MSIP_Label_5e4b1be8-281e-475d-98b0-21c3457e5a46_SetDate">
    <vt:lpwstr>2022-11-02T20:29:07Z</vt:lpwstr>
  </property>
  <property fmtid="{D5CDD505-2E9C-101B-9397-08002B2CF9AE}" pid="4" name="MSIP_Label_5e4b1be8-281e-475d-98b0-21c3457e5a46_Method">
    <vt:lpwstr>Standard</vt:lpwstr>
  </property>
  <property fmtid="{D5CDD505-2E9C-101B-9397-08002B2CF9AE}" pid="5" name="MSIP_Label_5e4b1be8-281e-475d-98b0-21c3457e5a46_Name">
    <vt:lpwstr>Public</vt:lpwstr>
  </property>
  <property fmtid="{D5CDD505-2E9C-101B-9397-08002B2CF9AE}" pid="6" name="MSIP_Label_5e4b1be8-281e-475d-98b0-21c3457e5a46_SiteId">
    <vt:lpwstr>8b3dd73e-4e72-4679-b191-56da1588712b</vt:lpwstr>
  </property>
  <property fmtid="{D5CDD505-2E9C-101B-9397-08002B2CF9AE}" pid="7" name="MSIP_Label_5e4b1be8-281e-475d-98b0-21c3457e5a46_ActionId">
    <vt:lpwstr>15f993b8-f611-491b-9c49-2a10b823d971</vt:lpwstr>
  </property>
  <property fmtid="{D5CDD505-2E9C-101B-9397-08002B2CF9AE}" pid="8" name="MSIP_Label_5e4b1be8-281e-475d-98b0-21c3457e5a46_ContentBits">
    <vt:lpwstr>0</vt:lpwstr>
  </property>
</Properties>
</file>